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6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0" d="100"/>
          <a:sy n="80" d="100"/>
        </p:scale>
        <p:origin x="-979" y="-8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533723B-6C7A-4578-93EE-D56F58540DEA}" type="datetimeFigureOut">
              <a:rPr lang="en-US" smtClean="0"/>
              <a:t>5/23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A1E245C-D060-4FD0-BDE5-020B358B71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65679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A1E245C-D060-4FD0-BDE5-020B358B711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259191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A1E245C-D060-4FD0-BDE5-020B358B7113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177455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936CA-4B48-4CBA-9406-369749A84F3F}" type="datetimeFigureOut">
              <a:rPr lang="en-US" smtClean="0"/>
              <a:t>5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424D9-8EB9-4166-9667-5445240595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24622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936CA-4B48-4CBA-9406-369749A84F3F}" type="datetimeFigureOut">
              <a:rPr lang="en-US" smtClean="0"/>
              <a:t>5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424D9-8EB9-4166-9667-5445240595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64324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936CA-4B48-4CBA-9406-369749A84F3F}" type="datetimeFigureOut">
              <a:rPr lang="en-US" smtClean="0"/>
              <a:t>5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424D9-8EB9-4166-9667-5445240595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64282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936CA-4B48-4CBA-9406-369749A84F3F}" type="datetimeFigureOut">
              <a:rPr lang="en-US" smtClean="0"/>
              <a:t>5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424D9-8EB9-4166-9667-5445240595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40734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936CA-4B48-4CBA-9406-369749A84F3F}" type="datetimeFigureOut">
              <a:rPr lang="en-US" smtClean="0"/>
              <a:t>5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424D9-8EB9-4166-9667-5445240595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90535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936CA-4B48-4CBA-9406-369749A84F3F}" type="datetimeFigureOut">
              <a:rPr lang="en-US" smtClean="0"/>
              <a:t>5/2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424D9-8EB9-4166-9667-5445240595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76320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936CA-4B48-4CBA-9406-369749A84F3F}" type="datetimeFigureOut">
              <a:rPr lang="en-US" smtClean="0"/>
              <a:t>5/23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424D9-8EB9-4166-9667-5445240595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69357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936CA-4B48-4CBA-9406-369749A84F3F}" type="datetimeFigureOut">
              <a:rPr lang="en-US" smtClean="0"/>
              <a:t>5/23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424D9-8EB9-4166-9667-5445240595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21811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936CA-4B48-4CBA-9406-369749A84F3F}" type="datetimeFigureOut">
              <a:rPr lang="en-US" smtClean="0"/>
              <a:t>5/23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424D9-8EB9-4166-9667-5445240595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54288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936CA-4B48-4CBA-9406-369749A84F3F}" type="datetimeFigureOut">
              <a:rPr lang="en-US" smtClean="0"/>
              <a:t>5/2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424D9-8EB9-4166-9667-5445240595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488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936CA-4B48-4CBA-9406-369749A84F3F}" type="datetimeFigureOut">
              <a:rPr lang="en-US" smtClean="0"/>
              <a:t>5/2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424D9-8EB9-4166-9667-5445240595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12019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5936CA-4B48-4CBA-9406-369749A84F3F}" type="datetimeFigureOut">
              <a:rPr lang="en-US" smtClean="0"/>
              <a:t>5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D424D9-8EB9-4166-9667-5445240595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02232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8"/>
          <p:cNvSpPr>
            <a:spLocks noChangeArrowheads="1"/>
          </p:cNvSpPr>
          <p:nvPr/>
        </p:nvSpPr>
        <p:spPr bwMode="auto">
          <a:xfrm>
            <a:off x="1520967" y="3887927"/>
            <a:ext cx="206375" cy="1038225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8" name="Rectangle 9"/>
          <p:cNvSpPr>
            <a:spLocks noChangeArrowheads="1"/>
          </p:cNvSpPr>
          <p:nvPr/>
        </p:nvSpPr>
        <p:spPr bwMode="auto">
          <a:xfrm>
            <a:off x="1790842" y="3502165"/>
            <a:ext cx="207962" cy="1423988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9" name="Rectangle 10"/>
          <p:cNvSpPr>
            <a:spLocks noChangeArrowheads="1"/>
          </p:cNvSpPr>
          <p:nvPr/>
        </p:nvSpPr>
        <p:spPr bwMode="auto">
          <a:xfrm>
            <a:off x="2062305" y="477977"/>
            <a:ext cx="206375" cy="4448175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" name="Rectangle 11"/>
          <p:cNvSpPr>
            <a:spLocks noChangeArrowheads="1"/>
          </p:cNvSpPr>
          <p:nvPr/>
        </p:nvSpPr>
        <p:spPr bwMode="auto">
          <a:xfrm>
            <a:off x="2332180" y="1625740"/>
            <a:ext cx="207962" cy="3300413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1" name="Rectangle 12"/>
          <p:cNvSpPr>
            <a:spLocks noChangeArrowheads="1"/>
          </p:cNvSpPr>
          <p:nvPr/>
        </p:nvSpPr>
        <p:spPr bwMode="auto">
          <a:xfrm>
            <a:off x="2602055" y="3146565"/>
            <a:ext cx="207962" cy="1779588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2" name="Rectangle 13"/>
          <p:cNvSpPr>
            <a:spLocks noChangeArrowheads="1"/>
          </p:cNvSpPr>
          <p:nvPr/>
        </p:nvSpPr>
        <p:spPr bwMode="auto">
          <a:xfrm>
            <a:off x="2871930" y="816115"/>
            <a:ext cx="209550" cy="4110038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3" name="Rectangle 14"/>
          <p:cNvSpPr>
            <a:spLocks noChangeArrowheads="1"/>
          </p:cNvSpPr>
          <p:nvPr/>
        </p:nvSpPr>
        <p:spPr bwMode="auto">
          <a:xfrm>
            <a:off x="3413267" y="3302140"/>
            <a:ext cx="209550" cy="1624013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4" name="Rectangle 15"/>
          <p:cNvSpPr>
            <a:spLocks noChangeArrowheads="1"/>
          </p:cNvSpPr>
          <p:nvPr/>
        </p:nvSpPr>
        <p:spPr bwMode="auto">
          <a:xfrm>
            <a:off x="3684730" y="2579827"/>
            <a:ext cx="207962" cy="2346325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5" name="Rectangle 16"/>
          <p:cNvSpPr>
            <a:spLocks noChangeArrowheads="1"/>
          </p:cNvSpPr>
          <p:nvPr/>
        </p:nvSpPr>
        <p:spPr bwMode="auto">
          <a:xfrm>
            <a:off x="3954605" y="3846652"/>
            <a:ext cx="209550" cy="1079500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6" name="Rectangle 17"/>
          <p:cNvSpPr>
            <a:spLocks noChangeArrowheads="1"/>
          </p:cNvSpPr>
          <p:nvPr/>
        </p:nvSpPr>
        <p:spPr bwMode="auto">
          <a:xfrm>
            <a:off x="4226067" y="3991115"/>
            <a:ext cx="206375" cy="935038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7" name="Rectangle 18"/>
          <p:cNvSpPr>
            <a:spLocks noChangeArrowheads="1"/>
          </p:cNvSpPr>
          <p:nvPr/>
        </p:nvSpPr>
        <p:spPr bwMode="auto">
          <a:xfrm>
            <a:off x="4767405" y="3314840"/>
            <a:ext cx="206375" cy="1611313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8" name="Rectangle 19"/>
          <p:cNvSpPr>
            <a:spLocks noChangeArrowheads="1"/>
          </p:cNvSpPr>
          <p:nvPr/>
        </p:nvSpPr>
        <p:spPr bwMode="auto">
          <a:xfrm>
            <a:off x="5037280" y="4407040"/>
            <a:ext cx="207962" cy="519113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9" name="Rectangle 20"/>
          <p:cNvSpPr>
            <a:spLocks noChangeArrowheads="1"/>
          </p:cNvSpPr>
          <p:nvPr/>
        </p:nvSpPr>
        <p:spPr bwMode="auto">
          <a:xfrm>
            <a:off x="5308742" y="4465777"/>
            <a:ext cx="206375" cy="460375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" name="Rectangle 21"/>
          <p:cNvSpPr>
            <a:spLocks noChangeArrowheads="1"/>
          </p:cNvSpPr>
          <p:nvPr/>
        </p:nvSpPr>
        <p:spPr bwMode="auto">
          <a:xfrm>
            <a:off x="5578617" y="2036902"/>
            <a:ext cx="207962" cy="2889250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1" name="Rectangle 22"/>
          <p:cNvSpPr>
            <a:spLocks noChangeArrowheads="1"/>
          </p:cNvSpPr>
          <p:nvPr/>
        </p:nvSpPr>
        <p:spPr bwMode="auto">
          <a:xfrm>
            <a:off x="5848492" y="3286265"/>
            <a:ext cx="207962" cy="1639888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2" name="Rectangle 23"/>
          <p:cNvSpPr>
            <a:spLocks noChangeArrowheads="1"/>
          </p:cNvSpPr>
          <p:nvPr/>
        </p:nvSpPr>
        <p:spPr bwMode="auto">
          <a:xfrm>
            <a:off x="6118367" y="3702190"/>
            <a:ext cx="209550" cy="1223963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3" name="Rectangle 24"/>
          <p:cNvSpPr>
            <a:spLocks noChangeArrowheads="1"/>
          </p:cNvSpPr>
          <p:nvPr/>
        </p:nvSpPr>
        <p:spPr bwMode="auto">
          <a:xfrm>
            <a:off x="6388242" y="2913202"/>
            <a:ext cx="209550" cy="2012950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4" name="Rectangle 25"/>
          <p:cNvSpPr>
            <a:spLocks noChangeArrowheads="1"/>
          </p:cNvSpPr>
          <p:nvPr/>
        </p:nvSpPr>
        <p:spPr bwMode="auto">
          <a:xfrm>
            <a:off x="6929580" y="1735277"/>
            <a:ext cx="209550" cy="3190875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5" name="Rectangle 26"/>
          <p:cNvSpPr>
            <a:spLocks noChangeArrowheads="1"/>
          </p:cNvSpPr>
          <p:nvPr/>
        </p:nvSpPr>
        <p:spPr bwMode="auto">
          <a:xfrm>
            <a:off x="7470917" y="1313002"/>
            <a:ext cx="207962" cy="3613150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" name="Rectangle 27"/>
          <p:cNvSpPr>
            <a:spLocks noChangeArrowheads="1"/>
          </p:cNvSpPr>
          <p:nvPr/>
        </p:nvSpPr>
        <p:spPr bwMode="auto">
          <a:xfrm>
            <a:off x="7742380" y="1138377"/>
            <a:ext cx="206375" cy="3787775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" name="Rectangle 28"/>
          <p:cNvSpPr>
            <a:spLocks noChangeArrowheads="1"/>
          </p:cNvSpPr>
          <p:nvPr/>
        </p:nvSpPr>
        <p:spPr bwMode="auto">
          <a:xfrm>
            <a:off x="8012255" y="3133865"/>
            <a:ext cx="207962" cy="1792288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8" name="Rectangle 29"/>
          <p:cNvSpPr>
            <a:spLocks noChangeArrowheads="1"/>
          </p:cNvSpPr>
          <p:nvPr/>
        </p:nvSpPr>
        <p:spPr bwMode="auto">
          <a:xfrm>
            <a:off x="8553592" y="4591190"/>
            <a:ext cx="207962" cy="334963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9" name="Rectangle 30"/>
          <p:cNvSpPr>
            <a:spLocks noChangeArrowheads="1"/>
          </p:cNvSpPr>
          <p:nvPr/>
        </p:nvSpPr>
        <p:spPr bwMode="auto">
          <a:xfrm>
            <a:off x="8823467" y="2641740"/>
            <a:ext cx="207962" cy="2284413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0" name="Freeform 31"/>
          <p:cNvSpPr>
            <a:spLocks noEditPoints="1"/>
          </p:cNvSpPr>
          <p:nvPr/>
        </p:nvSpPr>
        <p:spPr bwMode="auto">
          <a:xfrm>
            <a:off x="1595580" y="3737115"/>
            <a:ext cx="57150" cy="301625"/>
          </a:xfrm>
          <a:custGeom>
            <a:avLst/>
            <a:gdLst>
              <a:gd name="T0" fmla="*/ 15 w 36"/>
              <a:gd name="T1" fmla="*/ 187 h 190"/>
              <a:gd name="T2" fmla="*/ 15 w 36"/>
              <a:gd name="T3" fmla="*/ 95 h 190"/>
              <a:gd name="T4" fmla="*/ 15 w 36"/>
              <a:gd name="T5" fmla="*/ 3 h 190"/>
              <a:gd name="T6" fmla="*/ 21 w 36"/>
              <a:gd name="T7" fmla="*/ 3 h 190"/>
              <a:gd name="T8" fmla="*/ 21 w 36"/>
              <a:gd name="T9" fmla="*/ 95 h 190"/>
              <a:gd name="T10" fmla="*/ 21 w 36"/>
              <a:gd name="T11" fmla="*/ 187 h 190"/>
              <a:gd name="T12" fmla="*/ 15 w 36"/>
              <a:gd name="T13" fmla="*/ 187 h 190"/>
              <a:gd name="T14" fmla="*/ 0 w 36"/>
              <a:gd name="T15" fmla="*/ 184 h 190"/>
              <a:gd name="T16" fmla="*/ 36 w 36"/>
              <a:gd name="T17" fmla="*/ 184 h 190"/>
              <a:gd name="T18" fmla="*/ 36 w 36"/>
              <a:gd name="T19" fmla="*/ 190 h 190"/>
              <a:gd name="T20" fmla="*/ 0 w 36"/>
              <a:gd name="T21" fmla="*/ 190 h 190"/>
              <a:gd name="T22" fmla="*/ 0 w 36"/>
              <a:gd name="T23" fmla="*/ 184 h 190"/>
              <a:gd name="T24" fmla="*/ 0 w 36"/>
              <a:gd name="T25" fmla="*/ 0 h 190"/>
              <a:gd name="T26" fmla="*/ 36 w 36"/>
              <a:gd name="T27" fmla="*/ 0 h 190"/>
              <a:gd name="T28" fmla="*/ 36 w 36"/>
              <a:gd name="T29" fmla="*/ 6 h 190"/>
              <a:gd name="T30" fmla="*/ 0 w 36"/>
              <a:gd name="T31" fmla="*/ 6 h 190"/>
              <a:gd name="T32" fmla="*/ 0 w 36"/>
              <a:gd name="T33" fmla="*/ 0 h 19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6" h="190">
                <a:moveTo>
                  <a:pt x="15" y="187"/>
                </a:moveTo>
                <a:lnTo>
                  <a:pt x="15" y="95"/>
                </a:lnTo>
                <a:lnTo>
                  <a:pt x="15" y="3"/>
                </a:lnTo>
                <a:lnTo>
                  <a:pt x="21" y="3"/>
                </a:lnTo>
                <a:lnTo>
                  <a:pt x="21" y="95"/>
                </a:lnTo>
                <a:lnTo>
                  <a:pt x="21" y="187"/>
                </a:lnTo>
                <a:lnTo>
                  <a:pt x="15" y="187"/>
                </a:lnTo>
                <a:close/>
                <a:moveTo>
                  <a:pt x="0" y="184"/>
                </a:moveTo>
                <a:lnTo>
                  <a:pt x="36" y="184"/>
                </a:lnTo>
                <a:lnTo>
                  <a:pt x="36" y="190"/>
                </a:lnTo>
                <a:lnTo>
                  <a:pt x="0" y="190"/>
                </a:lnTo>
                <a:lnTo>
                  <a:pt x="0" y="184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36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1" name="Freeform 32"/>
          <p:cNvSpPr>
            <a:spLocks noEditPoints="1"/>
          </p:cNvSpPr>
          <p:nvPr/>
        </p:nvSpPr>
        <p:spPr bwMode="auto">
          <a:xfrm>
            <a:off x="1867042" y="3367227"/>
            <a:ext cx="55562" cy="268288"/>
          </a:xfrm>
          <a:custGeom>
            <a:avLst/>
            <a:gdLst>
              <a:gd name="T0" fmla="*/ 15 w 35"/>
              <a:gd name="T1" fmla="*/ 166 h 169"/>
              <a:gd name="T2" fmla="*/ 15 w 35"/>
              <a:gd name="T3" fmla="*/ 85 h 169"/>
              <a:gd name="T4" fmla="*/ 15 w 35"/>
              <a:gd name="T5" fmla="*/ 3 h 169"/>
              <a:gd name="T6" fmla="*/ 21 w 35"/>
              <a:gd name="T7" fmla="*/ 3 h 169"/>
              <a:gd name="T8" fmla="*/ 21 w 35"/>
              <a:gd name="T9" fmla="*/ 85 h 169"/>
              <a:gd name="T10" fmla="*/ 21 w 35"/>
              <a:gd name="T11" fmla="*/ 166 h 169"/>
              <a:gd name="T12" fmla="*/ 15 w 35"/>
              <a:gd name="T13" fmla="*/ 166 h 169"/>
              <a:gd name="T14" fmla="*/ 0 w 35"/>
              <a:gd name="T15" fmla="*/ 164 h 169"/>
              <a:gd name="T16" fmla="*/ 35 w 35"/>
              <a:gd name="T17" fmla="*/ 164 h 169"/>
              <a:gd name="T18" fmla="*/ 35 w 35"/>
              <a:gd name="T19" fmla="*/ 169 h 169"/>
              <a:gd name="T20" fmla="*/ 0 w 35"/>
              <a:gd name="T21" fmla="*/ 169 h 169"/>
              <a:gd name="T22" fmla="*/ 0 w 35"/>
              <a:gd name="T23" fmla="*/ 164 h 169"/>
              <a:gd name="T24" fmla="*/ 0 w 35"/>
              <a:gd name="T25" fmla="*/ 0 h 169"/>
              <a:gd name="T26" fmla="*/ 35 w 35"/>
              <a:gd name="T27" fmla="*/ 0 h 169"/>
              <a:gd name="T28" fmla="*/ 35 w 35"/>
              <a:gd name="T29" fmla="*/ 6 h 169"/>
              <a:gd name="T30" fmla="*/ 0 w 35"/>
              <a:gd name="T31" fmla="*/ 6 h 169"/>
              <a:gd name="T32" fmla="*/ 0 w 35"/>
              <a:gd name="T33" fmla="*/ 0 h 16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5" h="169">
                <a:moveTo>
                  <a:pt x="15" y="166"/>
                </a:moveTo>
                <a:lnTo>
                  <a:pt x="15" y="85"/>
                </a:lnTo>
                <a:lnTo>
                  <a:pt x="15" y="3"/>
                </a:lnTo>
                <a:lnTo>
                  <a:pt x="21" y="3"/>
                </a:lnTo>
                <a:lnTo>
                  <a:pt x="21" y="85"/>
                </a:lnTo>
                <a:lnTo>
                  <a:pt x="21" y="166"/>
                </a:lnTo>
                <a:lnTo>
                  <a:pt x="15" y="166"/>
                </a:lnTo>
                <a:close/>
                <a:moveTo>
                  <a:pt x="0" y="164"/>
                </a:moveTo>
                <a:lnTo>
                  <a:pt x="35" y="164"/>
                </a:lnTo>
                <a:lnTo>
                  <a:pt x="35" y="169"/>
                </a:lnTo>
                <a:lnTo>
                  <a:pt x="0" y="169"/>
                </a:lnTo>
                <a:lnTo>
                  <a:pt x="0" y="164"/>
                </a:lnTo>
                <a:close/>
                <a:moveTo>
                  <a:pt x="0" y="0"/>
                </a:moveTo>
                <a:lnTo>
                  <a:pt x="35" y="0"/>
                </a:lnTo>
                <a:lnTo>
                  <a:pt x="35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24" name="Freeform 33"/>
          <p:cNvSpPr>
            <a:spLocks noEditPoints="1"/>
          </p:cNvSpPr>
          <p:nvPr/>
        </p:nvSpPr>
        <p:spPr bwMode="auto">
          <a:xfrm>
            <a:off x="2136917" y="403365"/>
            <a:ext cx="57150" cy="149225"/>
          </a:xfrm>
          <a:custGeom>
            <a:avLst/>
            <a:gdLst>
              <a:gd name="T0" fmla="*/ 15 w 36"/>
              <a:gd name="T1" fmla="*/ 91 h 94"/>
              <a:gd name="T2" fmla="*/ 15 w 36"/>
              <a:gd name="T3" fmla="*/ 47 h 94"/>
              <a:gd name="T4" fmla="*/ 15 w 36"/>
              <a:gd name="T5" fmla="*/ 3 h 94"/>
              <a:gd name="T6" fmla="*/ 21 w 36"/>
              <a:gd name="T7" fmla="*/ 3 h 94"/>
              <a:gd name="T8" fmla="*/ 21 w 36"/>
              <a:gd name="T9" fmla="*/ 47 h 94"/>
              <a:gd name="T10" fmla="*/ 21 w 36"/>
              <a:gd name="T11" fmla="*/ 91 h 94"/>
              <a:gd name="T12" fmla="*/ 15 w 36"/>
              <a:gd name="T13" fmla="*/ 91 h 94"/>
              <a:gd name="T14" fmla="*/ 0 w 36"/>
              <a:gd name="T15" fmla="*/ 88 h 94"/>
              <a:gd name="T16" fmla="*/ 36 w 36"/>
              <a:gd name="T17" fmla="*/ 88 h 94"/>
              <a:gd name="T18" fmla="*/ 36 w 36"/>
              <a:gd name="T19" fmla="*/ 94 h 94"/>
              <a:gd name="T20" fmla="*/ 0 w 36"/>
              <a:gd name="T21" fmla="*/ 94 h 94"/>
              <a:gd name="T22" fmla="*/ 0 w 36"/>
              <a:gd name="T23" fmla="*/ 88 h 94"/>
              <a:gd name="T24" fmla="*/ 0 w 36"/>
              <a:gd name="T25" fmla="*/ 0 h 94"/>
              <a:gd name="T26" fmla="*/ 36 w 36"/>
              <a:gd name="T27" fmla="*/ 0 h 94"/>
              <a:gd name="T28" fmla="*/ 36 w 36"/>
              <a:gd name="T29" fmla="*/ 6 h 94"/>
              <a:gd name="T30" fmla="*/ 0 w 36"/>
              <a:gd name="T31" fmla="*/ 6 h 94"/>
              <a:gd name="T32" fmla="*/ 0 w 36"/>
              <a:gd name="T33" fmla="*/ 0 h 9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6" h="94">
                <a:moveTo>
                  <a:pt x="15" y="91"/>
                </a:moveTo>
                <a:lnTo>
                  <a:pt x="15" y="47"/>
                </a:lnTo>
                <a:lnTo>
                  <a:pt x="15" y="3"/>
                </a:lnTo>
                <a:lnTo>
                  <a:pt x="21" y="3"/>
                </a:lnTo>
                <a:lnTo>
                  <a:pt x="21" y="47"/>
                </a:lnTo>
                <a:lnTo>
                  <a:pt x="21" y="91"/>
                </a:lnTo>
                <a:lnTo>
                  <a:pt x="15" y="91"/>
                </a:lnTo>
                <a:close/>
                <a:moveTo>
                  <a:pt x="0" y="88"/>
                </a:moveTo>
                <a:lnTo>
                  <a:pt x="36" y="88"/>
                </a:lnTo>
                <a:lnTo>
                  <a:pt x="36" y="94"/>
                </a:lnTo>
                <a:lnTo>
                  <a:pt x="0" y="94"/>
                </a:lnTo>
                <a:lnTo>
                  <a:pt x="0" y="88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36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25" name="Freeform 34"/>
          <p:cNvSpPr>
            <a:spLocks noEditPoints="1"/>
          </p:cNvSpPr>
          <p:nvPr/>
        </p:nvSpPr>
        <p:spPr bwMode="auto">
          <a:xfrm>
            <a:off x="2408380" y="773252"/>
            <a:ext cx="55562" cy="1703388"/>
          </a:xfrm>
          <a:custGeom>
            <a:avLst/>
            <a:gdLst>
              <a:gd name="T0" fmla="*/ 15 w 35"/>
              <a:gd name="T1" fmla="*/ 1070 h 1073"/>
              <a:gd name="T2" fmla="*/ 15 w 35"/>
              <a:gd name="T3" fmla="*/ 537 h 1073"/>
              <a:gd name="T4" fmla="*/ 15 w 35"/>
              <a:gd name="T5" fmla="*/ 3 h 1073"/>
              <a:gd name="T6" fmla="*/ 21 w 35"/>
              <a:gd name="T7" fmla="*/ 3 h 1073"/>
              <a:gd name="T8" fmla="*/ 21 w 35"/>
              <a:gd name="T9" fmla="*/ 537 h 1073"/>
              <a:gd name="T10" fmla="*/ 21 w 35"/>
              <a:gd name="T11" fmla="*/ 1070 h 1073"/>
              <a:gd name="T12" fmla="*/ 15 w 35"/>
              <a:gd name="T13" fmla="*/ 1070 h 1073"/>
              <a:gd name="T14" fmla="*/ 0 w 35"/>
              <a:gd name="T15" fmla="*/ 1067 h 1073"/>
              <a:gd name="T16" fmla="*/ 35 w 35"/>
              <a:gd name="T17" fmla="*/ 1067 h 1073"/>
              <a:gd name="T18" fmla="*/ 35 w 35"/>
              <a:gd name="T19" fmla="*/ 1073 h 1073"/>
              <a:gd name="T20" fmla="*/ 0 w 35"/>
              <a:gd name="T21" fmla="*/ 1073 h 1073"/>
              <a:gd name="T22" fmla="*/ 0 w 35"/>
              <a:gd name="T23" fmla="*/ 1067 h 1073"/>
              <a:gd name="T24" fmla="*/ 0 w 35"/>
              <a:gd name="T25" fmla="*/ 0 h 1073"/>
              <a:gd name="T26" fmla="*/ 35 w 35"/>
              <a:gd name="T27" fmla="*/ 0 h 1073"/>
              <a:gd name="T28" fmla="*/ 35 w 35"/>
              <a:gd name="T29" fmla="*/ 6 h 1073"/>
              <a:gd name="T30" fmla="*/ 0 w 35"/>
              <a:gd name="T31" fmla="*/ 6 h 1073"/>
              <a:gd name="T32" fmla="*/ 0 w 35"/>
              <a:gd name="T33" fmla="*/ 0 h 107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5" h="1073">
                <a:moveTo>
                  <a:pt x="15" y="1070"/>
                </a:moveTo>
                <a:lnTo>
                  <a:pt x="15" y="537"/>
                </a:lnTo>
                <a:lnTo>
                  <a:pt x="15" y="3"/>
                </a:lnTo>
                <a:lnTo>
                  <a:pt x="21" y="3"/>
                </a:lnTo>
                <a:lnTo>
                  <a:pt x="21" y="537"/>
                </a:lnTo>
                <a:lnTo>
                  <a:pt x="21" y="1070"/>
                </a:lnTo>
                <a:lnTo>
                  <a:pt x="15" y="1070"/>
                </a:lnTo>
                <a:close/>
                <a:moveTo>
                  <a:pt x="0" y="1067"/>
                </a:moveTo>
                <a:lnTo>
                  <a:pt x="35" y="1067"/>
                </a:lnTo>
                <a:lnTo>
                  <a:pt x="35" y="1073"/>
                </a:lnTo>
                <a:lnTo>
                  <a:pt x="0" y="1073"/>
                </a:lnTo>
                <a:lnTo>
                  <a:pt x="0" y="1067"/>
                </a:lnTo>
                <a:close/>
                <a:moveTo>
                  <a:pt x="0" y="0"/>
                </a:moveTo>
                <a:lnTo>
                  <a:pt x="35" y="0"/>
                </a:lnTo>
                <a:lnTo>
                  <a:pt x="35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29" name="Freeform 35"/>
          <p:cNvSpPr>
            <a:spLocks noEditPoints="1"/>
          </p:cNvSpPr>
          <p:nvPr/>
        </p:nvSpPr>
        <p:spPr bwMode="auto">
          <a:xfrm>
            <a:off x="2676667" y="2751277"/>
            <a:ext cx="58737" cy="792163"/>
          </a:xfrm>
          <a:custGeom>
            <a:avLst/>
            <a:gdLst>
              <a:gd name="T0" fmla="*/ 16 w 37"/>
              <a:gd name="T1" fmla="*/ 496 h 499"/>
              <a:gd name="T2" fmla="*/ 16 w 37"/>
              <a:gd name="T3" fmla="*/ 249 h 499"/>
              <a:gd name="T4" fmla="*/ 16 w 37"/>
              <a:gd name="T5" fmla="*/ 2 h 499"/>
              <a:gd name="T6" fmla="*/ 22 w 37"/>
              <a:gd name="T7" fmla="*/ 2 h 499"/>
              <a:gd name="T8" fmla="*/ 22 w 37"/>
              <a:gd name="T9" fmla="*/ 249 h 499"/>
              <a:gd name="T10" fmla="*/ 22 w 37"/>
              <a:gd name="T11" fmla="*/ 496 h 499"/>
              <a:gd name="T12" fmla="*/ 16 w 37"/>
              <a:gd name="T13" fmla="*/ 496 h 499"/>
              <a:gd name="T14" fmla="*/ 0 w 37"/>
              <a:gd name="T15" fmla="*/ 493 h 499"/>
              <a:gd name="T16" fmla="*/ 37 w 37"/>
              <a:gd name="T17" fmla="*/ 493 h 499"/>
              <a:gd name="T18" fmla="*/ 37 w 37"/>
              <a:gd name="T19" fmla="*/ 499 h 499"/>
              <a:gd name="T20" fmla="*/ 0 w 37"/>
              <a:gd name="T21" fmla="*/ 499 h 499"/>
              <a:gd name="T22" fmla="*/ 0 w 37"/>
              <a:gd name="T23" fmla="*/ 493 h 499"/>
              <a:gd name="T24" fmla="*/ 0 w 37"/>
              <a:gd name="T25" fmla="*/ 0 h 499"/>
              <a:gd name="T26" fmla="*/ 37 w 37"/>
              <a:gd name="T27" fmla="*/ 0 h 499"/>
              <a:gd name="T28" fmla="*/ 37 w 37"/>
              <a:gd name="T29" fmla="*/ 5 h 499"/>
              <a:gd name="T30" fmla="*/ 0 w 37"/>
              <a:gd name="T31" fmla="*/ 5 h 499"/>
              <a:gd name="T32" fmla="*/ 0 w 37"/>
              <a:gd name="T33" fmla="*/ 0 h 49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7" h="499">
                <a:moveTo>
                  <a:pt x="16" y="496"/>
                </a:moveTo>
                <a:lnTo>
                  <a:pt x="16" y="249"/>
                </a:lnTo>
                <a:lnTo>
                  <a:pt x="16" y="2"/>
                </a:lnTo>
                <a:lnTo>
                  <a:pt x="22" y="2"/>
                </a:lnTo>
                <a:lnTo>
                  <a:pt x="22" y="249"/>
                </a:lnTo>
                <a:lnTo>
                  <a:pt x="22" y="496"/>
                </a:lnTo>
                <a:lnTo>
                  <a:pt x="16" y="496"/>
                </a:lnTo>
                <a:close/>
                <a:moveTo>
                  <a:pt x="0" y="493"/>
                </a:moveTo>
                <a:lnTo>
                  <a:pt x="37" y="493"/>
                </a:lnTo>
                <a:lnTo>
                  <a:pt x="37" y="499"/>
                </a:lnTo>
                <a:lnTo>
                  <a:pt x="0" y="499"/>
                </a:lnTo>
                <a:lnTo>
                  <a:pt x="0" y="493"/>
                </a:lnTo>
                <a:close/>
                <a:moveTo>
                  <a:pt x="0" y="0"/>
                </a:moveTo>
                <a:lnTo>
                  <a:pt x="37" y="0"/>
                </a:lnTo>
                <a:lnTo>
                  <a:pt x="37" y="5"/>
                </a:lnTo>
                <a:lnTo>
                  <a:pt x="0" y="5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30" name="Freeform 36"/>
          <p:cNvSpPr>
            <a:spLocks noEditPoints="1"/>
          </p:cNvSpPr>
          <p:nvPr/>
        </p:nvSpPr>
        <p:spPr bwMode="auto">
          <a:xfrm>
            <a:off x="2948130" y="616090"/>
            <a:ext cx="57150" cy="403225"/>
          </a:xfrm>
          <a:custGeom>
            <a:avLst/>
            <a:gdLst>
              <a:gd name="T0" fmla="*/ 15 w 36"/>
              <a:gd name="T1" fmla="*/ 251 h 254"/>
              <a:gd name="T2" fmla="*/ 15 w 36"/>
              <a:gd name="T3" fmla="*/ 126 h 254"/>
              <a:gd name="T4" fmla="*/ 15 w 36"/>
              <a:gd name="T5" fmla="*/ 2 h 254"/>
              <a:gd name="T6" fmla="*/ 21 w 36"/>
              <a:gd name="T7" fmla="*/ 2 h 254"/>
              <a:gd name="T8" fmla="*/ 21 w 36"/>
              <a:gd name="T9" fmla="*/ 126 h 254"/>
              <a:gd name="T10" fmla="*/ 21 w 36"/>
              <a:gd name="T11" fmla="*/ 251 h 254"/>
              <a:gd name="T12" fmla="*/ 15 w 36"/>
              <a:gd name="T13" fmla="*/ 251 h 254"/>
              <a:gd name="T14" fmla="*/ 0 w 36"/>
              <a:gd name="T15" fmla="*/ 248 h 254"/>
              <a:gd name="T16" fmla="*/ 36 w 36"/>
              <a:gd name="T17" fmla="*/ 248 h 254"/>
              <a:gd name="T18" fmla="*/ 36 w 36"/>
              <a:gd name="T19" fmla="*/ 254 h 254"/>
              <a:gd name="T20" fmla="*/ 0 w 36"/>
              <a:gd name="T21" fmla="*/ 254 h 254"/>
              <a:gd name="T22" fmla="*/ 0 w 36"/>
              <a:gd name="T23" fmla="*/ 248 h 254"/>
              <a:gd name="T24" fmla="*/ 0 w 36"/>
              <a:gd name="T25" fmla="*/ 0 h 254"/>
              <a:gd name="T26" fmla="*/ 36 w 36"/>
              <a:gd name="T27" fmla="*/ 0 h 254"/>
              <a:gd name="T28" fmla="*/ 36 w 36"/>
              <a:gd name="T29" fmla="*/ 5 h 254"/>
              <a:gd name="T30" fmla="*/ 0 w 36"/>
              <a:gd name="T31" fmla="*/ 5 h 254"/>
              <a:gd name="T32" fmla="*/ 0 w 36"/>
              <a:gd name="T33" fmla="*/ 0 h 25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6" h="254">
                <a:moveTo>
                  <a:pt x="15" y="251"/>
                </a:moveTo>
                <a:lnTo>
                  <a:pt x="15" y="126"/>
                </a:lnTo>
                <a:lnTo>
                  <a:pt x="15" y="2"/>
                </a:lnTo>
                <a:lnTo>
                  <a:pt x="21" y="2"/>
                </a:lnTo>
                <a:lnTo>
                  <a:pt x="21" y="126"/>
                </a:lnTo>
                <a:lnTo>
                  <a:pt x="21" y="251"/>
                </a:lnTo>
                <a:lnTo>
                  <a:pt x="15" y="251"/>
                </a:lnTo>
                <a:close/>
                <a:moveTo>
                  <a:pt x="0" y="248"/>
                </a:moveTo>
                <a:lnTo>
                  <a:pt x="36" y="248"/>
                </a:lnTo>
                <a:lnTo>
                  <a:pt x="36" y="254"/>
                </a:lnTo>
                <a:lnTo>
                  <a:pt x="0" y="254"/>
                </a:lnTo>
                <a:lnTo>
                  <a:pt x="0" y="248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36" y="5"/>
                </a:lnTo>
                <a:lnTo>
                  <a:pt x="0" y="5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31" name="Freeform 37"/>
          <p:cNvSpPr>
            <a:spLocks noEditPoints="1"/>
          </p:cNvSpPr>
          <p:nvPr/>
        </p:nvSpPr>
        <p:spPr bwMode="auto">
          <a:xfrm>
            <a:off x="3489467" y="2608402"/>
            <a:ext cx="57150" cy="1385888"/>
          </a:xfrm>
          <a:custGeom>
            <a:avLst/>
            <a:gdLst>
              <a:gd name="T0" fmla="*/ 15 w 36"/>
              <a:gd name="T1" fmla="*/ 870 h 873"/>
              <a:gd name="T2" fmla="*/ 15 w 36"/>
              <a:gd name="T3" fmla="*/ 437 h 873"/>
              <a:gd name="T4" fmla="*/ 15 w 36"/>
              <a:gd name="T5" fmla="*/ 3 h 873"/>
              <a:gd name="T6" fmla="*/ 20 w 36"/>
              <a:gd name="T7" fmla="*/ 3 h 873"/>
              <a:gd name="T8" fmla="*/ 20 w 36"/>
              <a:gd name="T9" fmla="*/ 437 h 873"/>
              <a:gd name="T10" fmla="*/ 20 w 36"/>
              <a:gd name="T11" fmla="*/ 870 h 873"/>
              <a:gd name="T12" fmla="*/ 15 w 36"/>
              <a:gd name="T13" fmla="*/ 870 h 873"/>
              <a:gd name="T14" fmla="*/ 0 w 36"/>
              <a:gd name="T15" fmla="*/ 867 h 873"/>
              <a:gd name="T16" fmla="*/ 36 w 36"/>
              <a:gd name="T17" fmla="*/ 867 h 873"/>
              <a:gd name="T18" fmla="*/ 36 w 36"/>
              <a:gd name="T19" fmla="*/ 873 h 873"/>
              <a:gd name="T20" fmla="*/ 0 w 36"/>
              <a:gd name="T21" fmla="*/ 873 h 873"/>
              <a:gd name="T22" fmla="*/ 0 w 36"/>
              <a:gd name="T23" fmla="*/ 867 h 873"/>
              <a:gd name="T24" fmla="*/ 0 w 36"/>
              <a:gd name="T25" fmla="*/ 0 h 873"/>
              <a:gd name="T26" fmla="*/ 36 w 36"/>
              <a:gd name="T27" fmla="*/ 0 h 873"/>
              <a:gd name="T28" fmla="*/ 36 w 36"/>
              <a:gd name="T29" fmla="*/ 6 h 873"/>
              <a:gd name="T30" fmla="*/ 0 w 36"/>
              <a:gd name="T31" fmla="*/ 6 h 873"/>
              <a:gd name="T32" fmla="*/ 0 w 36"/>
              <a:gd name="T33" fmla="*/ 0 h 87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6" h="873">
                <a:moveTo>
                  <a:pt x="15" y="870"/>
                </a:moveTo>
                <a:lnTo>
                  <a:pt x="15" y="437"/>
                </a:lnTo>
                <a:lnTo>
                  <a:pt x="15" y="3"/>
                </a:lnTo>
                <a:lnTo>
                  <a:pt x="20" y="3"/>
                </a:lnTo>
                <a:lnTo>
                  <a:pt x="20" y="437"/>
                </a:lnTo>
                <a:lnTo>
                  <a:pt x="20" y="870"/>
                </a:lnTo>
                <a:lnTo>
                  <a:pt x="15" y="870"/>
                </a:lnTo>
                <a:close/>
                <a:moveTo>
                  <a:pt x="0" y="867"/>
                </a:moveTo>
                <a:lnTo>
                  <a:pt x="36" y="867"/>
                </a:lnTo>
                <a:lnTo>
                  <a:pt x="36" y="873"/>
                </a:lnTo>
                <a:lnTo>
                  <a:pt x="0" y="873"/>
                </a:lnTo>
                <a:lnTo>
                  <a:pt x="0" y="867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36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32" name="Freeform 38"/>
          <p:cNvSpPr>
            <a:spLocks noEditPoints="1"/>
          </p:cNvSpPr>
          <p:nvPr/>
        </p:nvSpPr>
        <p:spPr bwMode="auto">
          <a:xfrm>
            <a:off x="3759342" y="2032140"/>
            <a:ext cx="58737" cy="1093788"/>
          </a:xfrm>
          <a:custGeom>
            <a:avLst/>
            <a:gdLst>
              <a:gd name="T0" fmla="*/ 15 w 37"/>
              <a:gd name="T1" fmla="*/ 686 h 689"/>
              <a:gd name="T2" fmla="*/ 15 w 37"/>
              <a:gd name="T3" fmla="*/ 345 h 689"/>
              <a:gd name="T4" fmla="*/ 15 w 37"/>
              <a:gd name="T5" fmla="*/ 3 h 689"/>
              <a:gd name="T6" fmla="*/ 21 w 37"/>
              <a:gd name="T7" fmla="*/ 3 h 689"/>
              <a:gd name="T8" fmla="*/ 21 w 37"/>
              <a:gd name="T9" fmla="*/ 345 h 689"/>
              <a:gd name="T10" fmla="*/ 21 w 37"/>
              <a:gd name="T11" fmla="*/ 686 h 689"/>
              <a:gd name="T12" fmla="*/ 15 w 37"/>
              <a:gd name="T13" fmla="*/ 686 h 689"/>
              <a:gd name="T14" fmla="*/ 0 w 37"/>
              <a:gd name="T15" fmla="*/ 683 h 689"/>
              <a:gd name="T16" fmla="*/ 37 w 37"/>
              <a:gd name="T17" fmla="*/ 683 h 689"/>
              <a:gd name="T18" fmla="*/ 37 w 37"/>
              <a:gd name="T19" fmla="*/ 689 h 689"/>
              <a:gd name="T20" fmla="*/ 0 w 37"/>
              <a:gd name="T21" fmla="*/ 689 h 689"/>
              <a:gd name="T22" fmla="*/ 0 w 37"/>
              <a:gd name="T23" fmla="*/ 683 h 689"/>
              <a:gd name="T24" fmla="*/ 0 w 37"/>
              <a:gd name="T25" fmla="*/ 0 h 689"/>
              <a:gd name="T26" fmla="*/ 37 w 37"/>
              <a:gd name="T27" fmla="*/ 0 h 689"/>
              <a:gd name="T28" fmla="*/ 37 w 37"/>
              <a:gd name="T29" fmla="*/ 6 h 689"/>
              <a:gd name="T30" fmla="*/ 0 w 37"/>
              <a:gd name="T31" fmla="*/ 6 h 689"/>
              <a:gd name="T32" fmla="*/ 0 w 37"/>
              <a:gd name="T33" fmla="*/ 0 h 68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7" h="689">
                <a:moveTo>
                  <a:pt x="15" y="686"/>
                </a:moveTo>
                <a:lnTo>
                  <a:pt x="15" y="345"/>
                </a:lnTo>
                <a:lnTo>
                  <a:pt x="15" y="3"/>
                </a:lnTo>
                <a:lnTo>
                  <a:pt x="21" y="3"/>
                </a:lnTo>
                <a:lnTo>
                  <a:pt x="21" y="345"/>
                </a:lnTo>
                <a:lnTo>
                  <a:pt x="21" y="686"/>
                </a:lnTo>
                <a:lnTo>
                  <a:pt x="15" y="686"/>
                </a:lnTo>
                <a:close/>
                <a:moveTo>
                  <a:pt x="0" y="683"/>
                </a:moveTo>
                <a:lnTo>
                  <a:pt x="37" y="683"/>
                </a:lnTo>
                <a:lnTo>
                  <a:pt x="37" y="689"/>
                </a:lnTo>
                <a:lnTo>
                  <a:pt x="0" y="689"/>
                </a:lnTo>
                <a:lnTo>
                  <a:pt x="0" y="683"/>
                </a:lnTo>
                <a:close/>
                <a:moveTo>
                  <a:pt x="0" y="0"/>
                </a:moveTo>
                <a:lnTo>
                  <a:pt x="37" y="0"/>
                </a:lnTo>
                <a:lnTo>
                  <a:pt x="37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33" name="Freeform 39"/>
          <p:cNvSpPr>
            <a:spLocks noEditPoints="1"/>
          </p:cNvSpPr>
          <p:nvPr/>
        </p:nvSpPr>
        <p:spPr bwMode="auto">
          <a:xfrm>
            <a:off x="4030805" y="3325952"/>
            <a:ext cx="57150" cy="1042988"/>
          </a:xfrm>
          <a:custGeom>
            <a:avLst/>
            <a:gdLst>
              <a:gd name="T0" fmla="*/ 14 w 36"/>
              <a:gd name="T1" fmla="*/ 654 h 657"/>
              <a:gd name="T2" fmla="*/ 14 w 36"/>
              <a:gd name="T3" fmla="*/ 328 h 657"/>
              <a:gd name="T4" fmla="*/ 14 w 36"/>
              <a:gd name="T5" fmla="*/ 2 h 657"/>
              <a:gd name="T6" fmla="*/ 20 w 36"/>
              <a:gd name="T7" fmla="*/ 2 h 657"/>
              <a:gd name="T8" fmla="*/ 20 w 36"/>
              <a:gd name="T9" fmla="*/ 328 h 657"/>
              <a:gd name="T10" fmla="*/ 20 w 36"/>
              <a:gd name="T11" fmla="*/ 654 h 657"/>
              <a:gd name="T12" fmla="*/ 14 w 36"/>
              <a:gd name="T13" fmla="*/ 654 h 657"/>
              <a:gd name="T14" fmla="*/ 0 w 36"/>
              <a:gd name="T15" fmla="*/ 651 h 657"/>
              <a:gd name="T16" fmla="*/ 36 w 36"/>
              <a:gd name="T17" fmla="*/ 651 h 657"/>
              <a:gd name="T18" fmla="*/ 36 w 36"/>
              <a:gd name="T19" fmla="*/ 657 h 657"/>
              <a:gd name="T20" fmla="*/ 0 w 36"/>
              <a:gd name="T21" fmla="*/ 657 h 657"/>
              <a:gd name="T22" fmla="*/ 0 w 36"/>
              <a:gd name="T23" fmla="*/ 651 h 657"/>
              <a:gd name="T24" fmla="*/ 0 w 36"/>
              <a:gd name="T25" fmla="*/ 0 h 657"/>
              <a:gd name="T26" fmla="*/ 36 w 36"/>
              <a:gd name="T27" fmla="*/ 0 h 657"/>
              <a:gd name="T28" fmla="*/ 36 w 36"/>
              <a:gd name="T29" fmla="*/ 5 h 657"/>
              <a:gd name="T30" fmla="*/ 0 w 36"/>
              <a:gd name="T31" fmla="*/ 5 h 657"/>
              <a:gd name="T32" fmla="*/ 0 w 36"/>
              <a:gd name="T33" fmla="*/ 0 h 65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6" h="657">
                <a:moveTo>
                  <a:pt x="14" y="654"/>
                </a:moveTo>
                <a:lnTo>
                  <a:pt x="14" y="328"/>
                </a:lnTo>
                <a:lnTo>
                  <a:pt x="14" y="2"/>
                </a:lnTo>
                <a:lnTo>
                  <a:pt x="20" y="2"/>
                </a:lnTo>
                <a:lnTo>
                  <a:pt x="20" y="328"/>
                </a:lnTo>
                <a:lnTo>
                  <a:pt x="20" y="654"/>
                </a:lnTo>
                <a:lnTo>
                  <a:pt x="14" y="654"/>
                </a:lnTo>
                <a:close/>
                <a:moveTo>
                  <a:pt x="0" y="651"/>
                </a:moveTo>
                <a:lnTo>
                  <a:pt x="36" y="651"/>
                </a:lnTo>
                <a:lnTo>
                  <a:pt x="36" y="657"/>
                </a:lnTo>
                <a:lnTo>
                  <a:pt x="0" y="657"/>
                </a:lnTo>
                <a:lnTo>
                  <a:pt x="0" y="651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36" y="5"/>
                </a:lnTo>
                <a:lnTo>
                  <a:pt x="0" y="5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34" name="Freeform 40"/>
          <p:cNvSpPr>
            <a:spLocks noEditPoints="1"/>
          </p:cNvSpPr>
          <p:nvPr/>
        </p:nvSpPr>
        <p:spPr bwMode="auto">
          <a:xfrm>
            <a:off x="4300680" y="3678377"/>
            <a:ext cx="57150" cy="623888"/>
          </a:xfrm>
          <a:custGeom>
            <a:avLst/>
            <a:gdLst>
              <a:gd name="T0" fmla="*/ 15 w 36"/>
              <a:gd name="T1" fmla="*/ 390 h 393"/>
              <a:gd name="T2" fmla="*/ 15 w 36"/>
              <a:gd name="T3" fmla="*/ 197 h 393"/>
              <a:gd name="T4" fmla="*/ 15 w 36"/>
              <a:gd name="T5" fmla="*/ 3 h 393"/>
              <a:gd name="T6" fmla="*/ 21 w 36"/>
              <a:gd name="T7" fmla="*/ 3 h 393"/>
              <a:gd name="T8" fmla="*/ 21 w 36"/>
              <a:gd name="T9" fmla="*/ 197 h 393"/>
              <a:gd name="T10" fmla="*/ 21 w 36"/>
              <a:gd name="T11" fmla="*/ 390 h 393"/>
              <a:gd name="T12" fmla="*/ 15 w 36"/>
              <a:gd name="T13" fmla="*/ 390 h 393"/>
              <a:gd name="T14" fmla="*/ 0 w 36"/>
              <a:gd name="T15" fmla="*/ 387 h 393"/>
              <a:gd name="T16" fmla="*/ 36 w 36"/>
              <a:gd name="T17" fmla="*/ 387 h 393"/>
              <a:gd name="T18" fmla="*/ 36 w 36"/>
              <a:gd name="T19" fmla="*/ 393 h 393"/>
              <a:gd name="T20" fmla="*/ 0 w 36"/>
              <a:gd name="T21" fmla="*/ 393 h 393"/>
              <a:gd name="T22" fmla="*/ 0 w 36"/>
              <a:gd name="T23" fmla="*/ 387 h 393"/>
              <a:gd name="T24" fmla="*/ 0 w 36"/>
              <a:gd name="T25" fmla="*/ 0 h 393"/>
              <a:gd name="T26" fmla="*/ 36 w 36"/>
              <a:gd name="T27" fmla="*/ 0 h 393"/>
              <a:gd name="T28" fmla="*/ 36 w 36"/>
              <a:gd name="T29" fmla="*/ 6 h 393"/>
              <a:gd name="T30" fmla="*/ 0 w 36"/>
              <a:gd name="T31" fmla="*/ 6 h 393"/>
              <a:gd name="T32" fmla="*/ 0 w 36"/>
              <a:gd name="T33" fmla="*/ 0 h 39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6" h="393">
                <a:moveTo>
                  <a:pt x="15" y="390"/>
                </a:moveTo>
                <a:lnTo>
                  <a:pt x="15" y="197"/>
                </a:lnTo>
                <a:lnTo>
                  <a:pt x="15" y="3"/>
                </a:lnTo>
                <a:lnTo>
                  <a:pt x="21" y="3"/>
                </a:lnTo>
                <a:lnTo>
                  <a:pt x="21" y="197"/>
                </a:lnTo>
                <a:lnTo>
                  <a:pt x="21" y="390"/>
                </a:lnTo>
                <a:lnTo>
                  <a:pt x="15" y="390"/>
                </a:lnTo>
                <a:close/>
                <a:moveTo>
                  <a:pt x="0" y="387"/>
                </a:moveTo>
                <a:lnTo>
                  <a:pt x="36" y="387"/>
                </a:lnTo>
                <a:lnTo>
                  <a:pt x="36" y="393"/>
                </a:lnTo>
                <a:lnTo>
                  <a:pt x="0" y="393"/>
                </a:lnTo>
                <a:lnTo>
                  <a:pt x="0" y="387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36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35" name="Freeform 41"/>
          <p:cNvSpPr>
            <a:spLocks noEditPoints="1"/>
          </p:cNvSpPr>
          <p:nvPr/>
        </p:nvSpPr>
        <p:spPr bwMode="auto">
          <a:xfrm>
            <a:off x="4842017" y="2870340"/>
            <a:ext cx="57150" cy="887413"/>
          </a:xfrm>
          <a:custGeom>
            <a:avLst/>
            <a:gdLst>
              <a:gd name="T0" fmla="*/ 15 w 36"/>
              <a:gd name="T1" fmla="*/ 556 h 559"/>
              <a:gd name="T2" fmla="*/ 15 w 36"/>
              <a:gd name="T3" fmla="*/ 280 h 559"/>
              <a:gd name="T4" fmla="*/ 15 w 36"/>
              <a:gd name="T5" fmla="*/ 3 h 559"/>
              <a:gd name="T6" fmla="*/ 21 w 36"/>
              <a:gd name="T7" fmla="*/ 3 h 559"/>
              <a:gd name="T8" fmla="*/ 21 w 36"/>
              <a:gd name="T9" fmla="*/ 280 h 559"/>
              <a:gd name="T10" fmla="*/ 21 w 36"/>
              <a:gd name="T11" fmla="*/ 556 h 559"/>
              <a:gd name="T12" fmla="*/ 15 w 36"/>
              <a:gd name="T13" fmla="*/ 556 h 559"/>
              <a:gd name="T14" fmla="*/ 0 w 36"/>
              <a:gd name="T15" fmla="*/ 553 h 559"/>
              <a:gd name="T16" fmla="*/ 36 w 36"/>
              <a:gd name="T17" fmla="*/ 553 h 559"/>
              <a:gd name="T18" fmla="*/ 36 w 36"/>
              <a:gd name="T19" fmla="*/ 559 h 559"/>
              <a:gd name="T20" fmla="*/ 0 w 36"/>
              <a:gd name="T21" fmla="*/ 559 h 559"/>
              <a:gd name="T22" fmla="*/ 0 w 36"/>
              <a:gd name="T23" fmla="*/ 553 h 559"/>
              <a:gd name="T24" fmla="*/ 0 w 36"/>
              <a:gd name="T25" fmla="*/ 0 h 559"/>
              <a:gd name="T26" fmla="*/ 36 w 36"/>
              <a:gd name="T27" fmla="*/ 0 h 559"/>
              <a:gd name="T28" fmla="*/ 36 w 36"/>
              <a:gd name="T29" fmla="*/ 6 h 559"/>
              <a:gd name="T30" fmla="*/ 0 w 36"/>
              <a:gd name="T31" fmla="*/ 6 h 559"/>
              <a:gd name="T32" fmla="*/ 0 w 36"/>
              <a:gd name="T33" fmla="*/ 0 h 55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6" h="559">
                <a:moveTo>
                  <a:pt x="15" y="556"/>
                </a:moveTo>
                <a:lnTo>
                  <a:pt x="15" y="280"/>
                </a:lnTo>
                <a:lnTo>
                  <a:pt x="15" y="3"/>
                </a:lnTo>
                <a:lnTo>
                  <a:pt x="21" y="3"/>
                </a:lnTo>
                <a:lnTo>
                  <a:pt x="21" y="280"/>
                </a:lnTo>
                <a:lnTo>
                  <a:pt x="21" y="556"/>
                </a:lnTo>
                <a:lnTo>
                  <a:pt x="15" y="556"/>
                </a:lnTo>
                <a:close/>
                <a:moveTo>
                  <a:pt x="0" y="553"/>
                </a:moveTo>
                <a:lnTo>
                  <a:pt x="36" y="553"/>
                </a:lnTo>
                <a:lnTo>
                  <a:pt x="36" y="559"/>
                </a:lnTo>
                <a:lnTo>
                  <a:pt x="0" y="559"/>
                </a:lnTo>
                <a:lnTo>
                  <a:pt x="0" y="553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36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36" name="Freeform 42"/>
          <p:cNvSpPr>
            <a:spLocks noEditPoints="1"/>
          </p:cNvSpPr>
          <p:nvPr/>
        </p:nvSpPr>
        <p:spPr bwMode="auto">
          <a:xfrm>
            <a:off x="5113480" y="3886340"/>
            <a:ext cx="55562" cy="1042988"/>
          </a:xfrm>
          <a:custGeom>
            <a:avLst/>
            <a:gdLst>
              <a:gd name="T0" fmla="*/ 14 w 35"/>
              <a:gd name="T1" fmla="*/ 655 h 657"/>
              <a:gd name="T2" fmla="*/ 14 w 35"/>
              <a:gd name="T3" fmla="*/ 328 h 657"/>
              <a:gd name="T4" fmla="*/ 14 w 35"/>
              <a:gd name="T5" fmla="*/ 3 h 657"/>
              <a:gd name="T6" fmla="*/ 20 w 35"/>
              <a:gd name="T7" fmla="*/ 3 h 657"/>
              <a:gd name="T8" fmla="*/ 20 w 35"/>
              <a:gd name="T9" fmla="*/ 328 h 657"/>
              <a:gd name="T10" fmla="*/ 20 w 35"/>
              <a:gd name="T11" fmla="*/ 655 h 657"/>
              <a:gd name="T12" fmla="*/ 14 w 35"/>
              <a:gd name="T13" fmla="*/ 655 h 657"/>
              <a:gd name="T14" fmla="*/ 0 w 35"/>
              <a:gd name="T15" fmla="*/ 652 h 657"/>
              <a:gd name="T16" fmla="*/ 35 w 35"/>
              <a:gd name="T17" fmla="*/ 652 h 657"/>
              <a:gd name="T18" fmla="*/ 35 w 35"/>
              <a:gd name="T19" fmla="*/ 657 h 657"/>
              <a:gd name="T20" fmla="*/ 0 w 35"/>
              <a:gd name="T21" fmla="*/ 657 h 657"/>
              <a:gd name="T22" fmla="*/ 0 w 35"/>
              <a:gd name="T23" fmla="*/ 652 h 657"/>
              <a:gd name="T24" fmla="*/ 0 w 35"/>
              <a:gd name="T25" fmla="*/ 0 h 657"/>
              <a:gd name="T26" fmla="*/ 35 w 35"/>
              <a:gd name="T27" fmla="*/ 0 h 657"/>
              <a:gd name="T28" fmla="*/ 35 w 35"/>
              <a:gd name="T29" fmla="*/ 6 h 657"/>
              <a:gd name="T30" fmla="*/ 0 w 35"/>
              <a:gd name="T31" fmla="*/ 6 h 657"/>
              <a:gd name="T32" fmla="*/ 0 w 35"/>
              <a:gd name="T33" fmla="*/ 0 h 65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5" h="657">
                <a:moveTo>
                  <a:pt x="14" y="655"/>
                </a:moveTo>
                <a:lnTo>
                  <a:pt x="14" y="328"/>
                </a:lnTo>
                <a:lnTo>
                  <a:pt x="14" y="3"/>
                </a:lnTo>
                <a:lnTo>
                  <a:pt x="20" y="3"/>
                </a:lnTo>
                <a:lnTo>
                  <a:pt x="20" y="328"/>
                </a:lnTo>
                <a:lnTo>
                  <a:pt x="20" y="655"/>
                </a:lnTo>
                <a:lnTo>
                  <a:pt x="14" y="655"/>
                </a:lnTo>
                <a:close/>
                <a:moveTo>
                  <a:pt x="0" y="652"/>
                </a:moveTo>
                <a:lnTo>
                  <a:pt x="35" y="652"/>
                </a:lnTo>
                <a:lnTo>
                  <a:pt x="35" y="657"/>
                </a:lnTo>
                <a:lnTo>
                  <a:pt x="0" y="657"/>
                </a:lnTo>
                <a:lnTo>
                  <a:pt x="0" y="652"/>
                </a:lnTo>
                <a:close/>
                <a:moveTo>
                  <a:pt x="0" y="0"/>
                </a:moveTo>
                <a:lnTo>
                  <a:pt x="35" y="0"/>
                </a:lnTo>
                <a:lnTo>
                  <a:pt x="35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37" name="Freeform 43"/>
          <p:cNvSpPr>
            <a:spLocks noEditPoints="1"/>
          </p:cNvSpPr>
          <p:nvPr/>
        </p:nvSpPr>
        <p:spPr bwMode="auto">
          <a:xfrm>
            <a:off x="5383355" y="4249877"/>
            <a:ext cx="57150" cy="430213"/>
          </a:xfrm>
          <a:custGeom>
            <a:avLst/>
            <a:gdLst>
              <a:gd name="T0" fmla="*/ 15 w 36"/>
              <a:gd name="T1" fmla="*/ 268 h 271"/>
              <a:gd name="T2" fmla="*/ 15 w 36"/>
              <a:gd name="T3" fmla="*/ 136 h 271"/>
              <a:gd name="T4" fmla="*/ 15 w 36"/>
              <a:gd name="T5" fmla="*/ 3 h 271"/>
              <a:gd name="T6" fmla="*/ 21 w 36"/>
              <a:gd name="T7" fmla="*/ 3 h 271"/>
              <a:gd name="T8" fmla="*/ 21 w 36"/>
              <a:gd name="T9" fmla="*/ 136 h 271"/>
              <a:gd name="T10" fmla="*/ 21 w 36"/>
              <a:gd name="T11" fmla="*/ 268 h 271"/>
              <a:gd name="T12" fmla="*/ 15 w 36"/>
              <a:gd name="T13" fmla="*/ 268 h 271"/>
              <a:gd name="T14" fmla="*/ 0 w 36"/>
              <a:gd name="T15" fmla="*/ 265 h 271"/>
              <a:gd name="T16" fmla="*/ 36 w 36"/>
              <a:gd name="T17" fmla="*/ 265 h 271"/>
              <a:gd name="T18" fmla="*/ 36 w 36"/>
              <a:gd name="T19" fmla="*/ 271 h 271"/>
              <a:gd name="T20" fmla="*/ 0 w 36"/>
              <a:gd name="T21" fmla="*/ 271 h 271"/>
              <a:gd name="T22" fmla="*/ 0 w 36"/>
              <a:gd name="T23" fmla="*/ 265 h 271"/>
              <a:gd name="T24" fmla="*/ 0 w 36"/>
              <a:gd name="T25" fmla="*/ 0 h 271"/>
              <a:gd name="T26" fmla="*/ 36 w 36"/>
              <a:gd name="T27" fmla="*/ 0 h 271"/>
              <a:gd name="T28" fmla="*/ 36 w 36"/>
              <a:gd name="T29" fmla="*/ 6 h 271"/>
              <a:gd name="T30" fmla="*/ 0 w 36"/>
              <a:gd name="T31" fmla="*/ 6 h 271"/>
              <a:gd name="T32" fmla="*/ 0 w 36"/>
              <a:gd name="T33" fmla="*/ 0 h 27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6" h="271">
                <a:moveTo>
                  <a:pt x="15" y="268"/>
                </a:moveTo>
                <a:lnTo>
                  <a:pt x="15" y="136"/>
                </a:lnTo>
                <a:lnTo>
                  <a:pt x="15" y="3"/>
                </a:lnTo>
                <a:lnTo>
                  <a:pt x="21" y="3"/>
                </a:lnTo>
                <a:lnTo>
                  <a:pt x="21" y="136"/>
                </a:lnTo>
                <a:lnTo>
                  <a:pt x="21" y="268"/>
                </a:lnTo>
                <a:lnTo>
                  <a:pt x="15" y="268"/>
                </a:lnTo>
                <a:close/>
                <a:moveTo>
                  <a:pt x="0" y="265"/>
                </a:moveTo>
                <a:lnTo>
                  <a:pt x="36" y="265"/>
                </a:lnTo>
                <a:lnTo>
                  <a:pt x="36" y="271"/>
                </a:lnTo>
                <a:lnTo>
                  <a:pt x="0" y="271"/>
                </a:lnTo>
                <a:lnTo>
                  <a:pt x="0" y="265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36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38" name="Freeform 44"/>
          <p:cNvSpPr>
            <a:spLocks noEditPoints="1"/>
          </p:cNvSpPr>
          <p:nvPr/>
        </p:nvSpPr>
        <p:spPr bwMode="auto">
          <a:xfrm>
            <a:off x="5654817" y="1192352"/>
            <a:ext cx="55562" cy="1687513"/>
          </a:xfrm>
          <a:custGeom>
            <a:avLst/>
            <a:gdLst>
              <a:gd name="T0" fmla="*/ 14 w 35"/>
              <a:gd name="T1" fmla="*/ 1060 h 1063"/>
              <a:gd name="T2" fmla="*/ 14 w 35"/>
              <a:gd name="T3" fmla="*/ 532 h 1063"/>
              <a:gd name="T4" fmla="*/ 14 w 35"/>
              <a:gd name="T5" fmla="*/ 3 h 1063"/>
              <a:gd name="T6" fmla="*/ 20 w 35"/>
              <a:gd name="T7" fmla="*/ 3 h 1063"/>
              <a:gd name="T8" fmla="*/ 20 w 35"/>
              <a:gd name="T9" fmla="*/ 532 h 1063"/>
              <a:gd name="T10" fmla="*/ 20 w 35"/>
              <a:gd name="T11" fmla="*/ 1060 h 1063"/>
              <a:gd name="T12" fmla="*/ 14 w 35"/>
              <a:gd name="T13" fmla="*/ 1060 h 1063"/>
              <a:gd name="T14" fmla="*/ 0 w 35"/>
              <a:gd name="T15" fmla="*/ 1057 h 1063"/>
              <a:gd name="T16" fmla="*/ 35 w 35"/>
              <a:gd name="T17" fmla="*/ 1057 h 1063"/>
              <a:gd name="T18" fmla="*/ 35 w 35"/>
              <a:gd name="T19" fmla="*/ 1063 h 1063"/>
              <a:gd name="T20" fmla="*/ 0 w 35"/>
              <a:gd name="T21" fmla="*/ 1063 h 1063"/>
              <a:gd name="T22" fmla="*/ 0 w 35"/>
              <a:gd name="T23" fmla="*/ 1057 h 1063"/>
              <a:gd name="T24" fmla="*/ 0 w 35"/>
              <a:gd name="T25" fmla="*/ 0 h 1063"/>
              <a:gd name="T26" fmla="*/ 35 w 35"/>
              <a:gd name="T27" fmla="*/ 0 h 1063"/>
              <a:gd name="T28" fmla="*/ 35 w 35"/>
              <a:gd name="T29" fmla="*/ 6 h 1063"/>
              <a:gd name="T30" fmla="*/ 0 w 35"/>
              <a:gd name="T31" fmla="*/ 6 h 1063"/>
              <a:gd name="T32" fmla="*/ 0 w 35"/>
              <a:gd name="T33" fmla="*/ 0 h 106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5" h="1063">
                <a:moveTo>
                  <a:pt x="14" y="1060"/>
                </a:moveTo>
                <a:lnTo>
                  <a:pt x="14" y="532"/>
                </a:lnTo>
                <a:lnTo>
                  <a:pt x="14" y="3"/>
                </a:lnTo>
                <a:lnTo>
                  <a:pt x="20" y="3"/>
                </a:lnTo>
                <a:lnTo>
                  <a:pt x="20" y="532"/>
                </a:lnTo>
                <a:lnTo>
                  <a:pt x="20" y="1060"/>
                </a:lnTo>
                <a:lnTo>
                  <a:pt x="14" y="1060"/>
                </a:lnTo>
                <a:close/>
                <a:moveTo>
                  <a:pt x="0" y="1057"/>
                </a:moveTo>
                <a:lnTo>
                  <a:pt x="35" y="1057"/>
                </a:lnTo>
                <a:lnTo>
                  <a:pt x="35" y="1063"/>
                </a:lnTo>
                <a:lnTo>
                  <a:pt x="0" y="1063"/>
                </a:lnTo>
                <a:lnTo>
                  <a:pt x="0" y="1057"/>
                </a:lnTo>
                <a:close/>
                <a:moveTo>
                  <a:pt x="0" y="0"/>
                </a:moveTo>
                <a:lnTo>
                  <a:pt x="35" y="0"/>
                </a:lnTo>
                <a:lnTo>
                  <a:pt x="35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39" name="Freeform 45"/>
          <p:cNvSpPr>
            <a:spLocks noEditPoints="1"/>
          </p:cNvSpPr>
          <p:nvPr/>
        </p:nvSpPr>
        <p:spPr bwMode="auto">
          <a:xfrm>
            <a:off x="5923105" y="2925902"/>
            <a:ext cx="58737" cy="719138"/>
          </a:xfrm>
          <a:custGeom>
            <a:avLst/>
            <a:gdLst>
              <a:gd name="T0" fmla="*/ 16 w 37"/>
              <a:gd name="T1" fmla="*/ 450 h 453"/>
              <a:gd name="T2" fmla="*/ 16 w 37"/>
              <a:gd name="T3" fmla="*/ 227 h 453"/>
              <a:gd name="T4" fmla="*/ 16 w 37"/>
              <a:gd name="T5" fmla="*/ 3 h 453"/>
              <a:gd name="T6" fmla="*/ 22 w 37"/>
              <a:gd name="T7" fmla="*/ 3 h 453"/>
              <a:gd name="T8" fmla="*/ 22 w 37"/>
              <a:gd name="T9" fmla="*/ 227 h 453"/>
              <a:gd name="T10" fmla="*/ 22 w 37"/>
              <a:gd name="T11" fmla="*/ 450 h 453"/>
              <a:gd name="T12" fmla="*/ 16 w 37"/>
              <a:gd name="T13" fmla="*/ 450 h 453"/>
              <a:gd name="T14" fmla="*/ 0 w 37"/>
              <a:gd name="T15" fmla="*/ 447 h 453"/>
              <a:gd name="T16" fmla="*/ 37 w 37"/>
              <a:gd name="T17" fmla="*/ 447 h 453"/>
              <a:gd name="T18" fmla="*/ 37 w 37"/>
              <a:gd name="T19" fmla="*/ 453 h 453"/>
              <a:gd name="T20" fmla="*/ 0 w 37"/>
              <a:gd name="T21" fmla="*/ 453 h 453"/>
              <a:gd name="T22" fmla="*/ 0 w 37"/>
              <a:gd name="T23" fmla="*/ 447 h 453"/>
              <a:gd name="T24" fmla="*/ 0 w 37"/>
              <a:gd name="T25" fmla="*/ 0 h 453"/>
              <a:gd name="T26" fmla="*/ 37 w 37"/>
              <a:gd name="T27" fmla="*/ 0 h 453"/>
              <a:gd name="T28" fmla="*/ 37 w 37"/>
              <a:gd name="T29" fmla="*/ 6 h 453"/>
              <a:gd name="T30" fmla="*/ 0 w 37"/>
              <a:gd name="T31" fmla="*/ 6 h 453"/>
              <a:gd name="T32" fmla="*/ 0 w 37"/>
              <a:gd name="T33" fmla="*/ 0 h 45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7" h="453">
                <a:moveTo>
                  <a:pt x="16" y="450"/>
                </a:moveTo>
                <a:lnTo>
                  <a:pt x="16" y="227"/>
                </a:lnTo>
                <a:lnTo>
                  <a:pt x="16" y="3"/>
                </a:lnTo>
                <a:lnTo>
                  <a:pt x="22" y="3"/>
                </a:lnTo>
                <a:lnTo>
                  <a:pt x="22" y="227"/>
                </a:lnTo>
                <a:lnTo>
                  <a:pt x="22" y="450"/>
                </a:lnTo>
                <a:lnTo>
                  <a:pt x="16" y="450"/>
                </a:lnTo>
                <a:close/>
                <a:moveTo>
                  <a:pt x="0" y="447"/>
                </a:moveTo>
                <a:lnTo>
                  <a:pt x="37" y="447"/>
                </a:lnTo>
                <a:lnTo>
                  <a:pt x="37" y="453"/>
                </a:lnTo>
                <a:lnTo>
                  <a:pt x="0" y="453"/>
                </a:lnTo>
                <a:lnTo>
                  <a:pt x="0" y="447"/>
                </a:lnTo>
                <a:close/>
                <a:moveTo>
                  <a:pt x="0" y="0"/>
                </a:moveTo>
                <a:lnTo>
                  <a:pt x="37" y="0"/>
                </a:lnTo>
                <a:lnTo>
                  <a:pt x="37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40" name="Freeform 46"/>
          <p:cNvSpPr>
            <a:spLocks noEditPoints="1"/>
          </p:cNvSpPr>
          <p:nvPr/>
        </p:nvSpPr>
        <p:spPr bwMode="auto">
          <a:xfrm>
            <a:off x="6194567" y="3254515"/>
            <a:ext cx="57150" cy="892175"/>
          </a:xfrm>
          <a:custGeom>
            <a:avLst/>
            <a:gdLst>
              <a:gd name="T0" fmla="*/ 15 w 36"/>
              <a:gd name="T1" fmla="*/ 559 h 562"/>
              <a:gd name="T2" fmla="*/ 15 w 36"/>
              <a:gd name="T3" fmla="*/ 282 h 562"/>
              <a:gd name="T4" fmla="*/ 15 w 36"/>
              <a:gd name="T5" fmla="*/ 3 h 562"/>
              <a:gd name="T6" fmla="*/ 20 w 36"/>
              <a:gd name="T7" fmla="*/ 3 h 562"/>
              <a:gd name="T8" fmla="*/ 20 w 36"/>
              <a:gd name="T9" fmla="*/ 282 h 562"/>
              <a:gd name="T10" fmla="*/ 20 w 36"/>
              <a:gd name="T11" fmla="*/ 559 h 562"/>
              <a:gd name="T12" fmla="*/ 15 w 36"/>
              <a:gd name="T13" fmla="*/ 559 h 562"/>
              <a:gd name="T14" fmla="*/ 0 w 36"/>
              <a:gd name="T15" fmla="*/ 556 h 562"/>
              <a:gd name="T16" fmla="*/ 36 w 36"/>
              <a:gd name="T17" fmla="*/ 556 h 562"/>
              <a:gd name="T18" fmla="*/ 36 w 36"/>
              <a:gd name="T19" fmla="*/ 562 h 562"/>
              <a:gd name="T20" fmla="*/ 0 w 36"/>
              <a:gd name="T21" fmla="*/ 562 h 562"/>
              <a:gd name="T22" fmla="*/ 0 w 36"/>
              <a:gd name="T23" fmla="*/ 556 h 562"/>
              <a:gd name="T24" fmla="*/ 0 w 36"/>
              <a:gd name="T25" fmla="*/ 0 h 562"/>
              <a:gd name="T26" fmla="*/ 36 w 36"/>
              <a:gd name="T27" fmla="*/ 0 h 562"/>
              <a:gd name="T28" fmla="*/ 36 w 36"/>
              <a:gd name="T29" fmla="*/ 6 h 562"/>
              <a:gd name="T30" fmla="*/ 0 w 36"/>
              <a:gd name="T31" fmla="*/ 6 h 562"/>
              <a:gd name="T32" fmla="*/ 0 w 36"/>
              <a:gd name="T33" fmla="*/ 0 h 56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6" h="562">
                <a:moveTo>
                  <a:pt x="15" y="559"/>
                </a:moveTo>
                <a:lnTo>
                  <a:pt x="15" y="282"/>
                </a:lnTo>
                <a:lnTo>
                  <a:pt x="15" y="3"/>
                </a:lnTo>
                <a:lnTo>
                  <a:pt x="20" y="3"/>
                </a:lnTo>
                <a:lnTo>
                  <a:pt x="20" y="282"/>
                </a:lnTo>
                <a:lnTo>
                  <a:pt x="20" y="559"/>
                </a:lnTo>
                <a:lnTo>
                  <a:pt x="15" y="559"/>
                </a:lnTo>
                <a:close/>
                <a:moveTo>
                  <a:pt x="0" y="556"/>
                </a:moveTo>
                <a:lnTo>
                  <a:pt x="36" y="556"/>
                </a:lnTo>
                <a:lnTo>
                  <a:pt x="36" y="562"/>
                </a:lnTo>
                <a:lnTo>
                  <a:pt x="0" y="562"/>
                </a:lnTo>
                <a:lnTo>
                  <a:pt x="0" y="556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36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41" name="Freeform 47"/>
          <p:cNvSpPr>
            <a:spLocks noEditPoints="1"/>
          </p:cNvSpPr>
          <p:nvPr/>
        </p:nvSpPr>
        <p:spPr bwMode="auto">
          <a:xfrm>
            <a:off x="6464442" y="2481402"/>
            <a:ext cx="57150" cy="865188"/>
          </a:xfrm>
          <a:custGeom>
            <a:avLst/>
            <a:gdLst>
              <a:gd name="T0" fmla="*/ 16 w 36"/>
              <a:gd name="T1" fmla="*/ 542 h 545"/>
              <a:gd name="T2" fmla="*/ 16 w 36"/>
              <a:gd name="T3" fmla="*/ 272 h 545"/>
              <a:gd name="T4" fmla="*/ 16 w 36"/>
              <a:gd name="T5" fmla="*/ 3 h 545"/>
              <a:gd name="T6" fmla="*/ 21 w 36"/>
              <a:gd name="T7" fmla="*/ 3 h 545"/>
              <a:gd name="T8" fmla="*/ 21 w 36"/>
              <a:gd name="T9" fmla="*/ 272 h 545"/>
              <a:gd name="T10" fmla="*/ 21 w 36"/>
              <a:gd name="T11" fmla="*/ 542 h 545"/>
              <a:gd name="T12" fmla="*/ 16 w 36"/>
              <a:gd name="T13" fmla="*/ 542 h 545"/>
              <a:gd name="T14" fmla="*/ 0 w 36"/>
              <a:gd name="T15" fmla="*/ 539 h 545"/>
              <a:gd name="T16" fmla="*/ 36 w 36"/>
              <a:gd name="T17" fmla="*/ 539 h 545"/>
              <a:gd name="T18" fmla="*/ 36 w 36"/>
              <a:gd name="T19" fmla="*/ 545 h 545"/>
              <a:gd name="T20" fmla="*/ 0 w 36"/>
              <a:gd name="T21" fmla="*/ 545 h 545"/>
              <a:gd name="T22" fmla="*/ 0 w 36"/>
              <a:gd name="T23" fmla="*/ 539 h 545"/>
              <a:gd name="T24" fmla="*/ 0 w 36"/>
              <a:gd name="T25" fmla="*/ 0 h 545"/>
              <a:gd name="T26" fmla="*/ 36 w 36"/>
              <a:gd name="T27" fmla="*/ 0 h 545"/>
              <a:gd name="T28" fmla="*/ 36 w 36"/>
              <a:gd name="T29" fmla="*/ 5 h 545"/>
              <a:gd name="T30" fmla="*/ 0 w 36"/>
              <a:gd name="T31" fmla="*/ 5 h 545"/>
              <a:gd name="T32" fmla="*/ 0 w 36"/>
              <a:gd name="T33" fmla="*/ 0 h 54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6" h="545">
                <a:moveTo>
                  <a:pt x="16" y="542"/>
                </a:moveTo>
                <a:lnTo>
                  <a:pt x="16" y="272"/>
                </a:lnTo>
                <a:lnTo>
                  <a:pt x="16" y="3"/>
                </a:lnTo>
                <a:lnTo>
                  <a:pt x="21" y="3"/>
                </a:lnTo>
                <a:lnTo>
                  <a:pt x="21" y="272"/>
                </a:lnTo>
                <a:lnTo>
                  <a:pt x="21" y="542"/>
                </a:lnTo>
                <a:lnTo>
                  <a:pt x="16" y="542"/>
                </a:lnTo>
                <a:close/>
                <a:moveTo>
                  <a:pt x="0" y="539"/>
                </a:moveTo>
                <a:lnTo>
                  <a:pt x="36" y="539"/>
                </a:lnTo>
                <a:lnTo>
                  <a:pt x="36" y="545"/>
                </a:lnTo>
                <a:lnTo>
                  <a:pt x="0" y="545"/>
                </a:lnTo>
                <a:lnTo>
                  <a:pt x="0" y="539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36" y="5"/>
                </a:lnTo>
                <a:lnTo>
                  <a:pt x="0" y="5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42" name="Freeform 48"/>
          <p:cNvSpPr>
            <a:spLocks noEditPoints="1"/>
          </p:cNvSpPr>
          <p:nvPr/>
        </p:nvSpPr>
        <p:spPr bwMode="auto">
          <a:xfrm>
            <a:off x="7005780" y="1246327"/>
            <a:ext cx="57150" cy="979488"/>
          </a:xfrm>
          <a:custGeom>
            <a:avLst/>
            <a:gdLst>
              <a:gd name="T0" fmla="*/ 15 w 36"/>
              <a:gd name="T1" fmla="*/ 614 h 617"/>
              <a:gd name="T2" fmla="*/ 15 w 36"/>
              <a:gd name="T3" fmla="*/ 308 h 617"/>
              <a:gd name="T4" fmla="*/ 15 w 36"/>
              <a:gd name="T5" fmla="*/ 3 h 617"/>
              <a:gd name="T6" fmla="*/ 21 w 36"/>
              <a:gd name="T7" fmla="*/ 3 h 617"/>
              <a:gd name="T8" fmla="*/ 21 w 36"/>
              <a:gd name="T9" fmla="*/ 308 h 617"/>
              <a:gd name="T10" fmla="*/ 21 w 36"/>
              <a:gd name="T11" fmla="*/ 614 h 617"/>
              <a:gd name="T12" fmla="*/ 15 w 36"/>
              <a:gd name="T13" fmla="*/ 614 h 617"/>
              <a:gd name="T14" fmla="*/ 0 w 36"/>
              <a:gd name="T15" fmla="*/ 612 h 617"/>
              <a:gd name="T16" fmla="*/ 36 w 36"/>
              <a:gd name="T17" fmla="*/ 612 h 617"/>
              <a:gd name="T18" fmla="*/ 36 w 36"/>
              <a:gd name="T19" fmla="*/ 617 h 617"/>
              <a:gd name="T20" fmla="*/ 0 w 36"/>
              <a:gd name="T21" fmla="*/ 617 h 617"/>
              <a:gd name="T22" fmla="*/ 0 w 36"/>
              <a:gd name="T23" fmla="*/ 612 h 617"/>
              <a:gd name="T24" fmla="*/ 0 w 36"/>
              <a:gd name="T25" fmla="*/ 0 h 617"/>
              <a:gd name="T26" fmla="*/ 36 w 36"/>
              <a:gd name="T27" fmla="*/ 0 h 617"/>
              <a:gd name="T28" fmla="*/ 36 w 36"/>
              <a:gd name="T29" fmla="*/ 6 h 617"/>
              <a:gd name="T30" fmla="*/ 0 w 36"/>
              <a:gd name="T31" fmla="*/ 6 h 617"/>
              <a:gd name="T32" fmla="*/ 0 w 36"/>
              <a:gd name="T33" fmla="*/ 0 h 61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6" h="617">
                <a:moveTo>
                  <a:pt x="15" y="614"/>
                </a:moveTo>
                <a:lnTo>
                  <a:pt x="15" y="308"/>
                </a:lnTo>
                <a:lnTo>
                  <a:pt x="15" y="3"/>
                </a:lnTo>
                <a:lnTo>
                  <a:pt x="21" y="3"/>
                </a:lnTo>
                <a:lnTo>
                  <a:pt x="21" y="308"/>
                </a:lnTo>
                <a:lnTo>
                  <a:pt x="21" y="614"/>
                </a:lnTo>
                <a:lnTo>
                  <a:pt x="15" y="614"/>
                </a:lnTo>
                <a:close/>
                <a:moveTo>
                  <a:pt x="0" y="612"/>
                </a:moveTo>
                <a:lnTo>
                  <a:pt x="36" y="612"/>
                </a:lnTo>
                <a:lnTo>
                  <a:pt x="36" y="617"/>
                </a:lnTo>
                <a:lnTo>
                  <a:pt x="0" y="617"/>
                </a:lnTo>
                <a:lnTo>
                  <a:pt x="0" y="612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36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43" name="Freeform 49"/>
          <p:cNvSpPr>
            <a:spLocks noEditPoints="1"/>
          </p:cNvSpPr>
          <p:nvPr/>
        </p:nvSpPr>
        <p:spPr bwMode="auto">
          <a:xfrm>
            <a:off x="7547117" y="963752"/>
            <a:ext cx="55562" cy="698500"/>
          </a:xfrm>
          <a:custGeom>
            <a:avLst/>
            <a:gdLst>
              <a:gd name="T0" fmla="*/ 15 w 35"/>
              <a:gd name="T1" fmla="*/ 437 h 440"/>
              <a:gd name="T2" fmla="*/ 15 w 35"/>
              <a:gd name="T3" fmla="*/ 220 h 440"/>
              <a:gd name="T4" fmla="*/ 15 w 35"/>
              <a:gd name="T5" fmla="*/ 3 h 440"/>
              <a:gd name="T6" fmla="*/ 21 w 35"/>
              <a:gd name="T7" fmla="*/ 3 h 440"/>
              <a:gd name="T8" fmla="*/ 21 w 35"/>
              <a:gd name="T9" fmla="*/ 220 h 440"/>
              <a:gd name="T10" fmla="*/ 21 w 35"/>
              <a:gd name="T11" fmla="*/ 437 h 440"/>
              <a:gd name="T12" fmla="*/ 15 w 35"/>
              <a:gd name="T13" fmla="*/ 437 h 440"/>
              <a:gd name="T14" fmla="*/ 0 w 35"/>
              <a:gd name="T15" fmla="*/ 434 h 440"/>
              <a:gd name="T16" fmla="*/ 35 w 35"/>
              <a:gd name="T17" fmla="*/ 434 h 440"/>
              <a:gd name="T18" fmla="*/ 35 w 35"/>
              <a:gd name="T19" fmla="*/ 440 h 440"/>
              <a:gd name="T20" fmla="*/ 0 w 35"/>
              <a:gd name="T21" fmla="*/ 440 h 440"/>
              <a:gd name="T22" fmla="*/ 0 w 35"/>
              <a:gd name="T23" fmla="*/ 434 h 440"/>
              <a:gd name="T24" fmla="*/ 0 w 35"/>
              <a:gd name="T25" fmla="*/ 0 h 440"/>
              <a:gd name="T26" fmla="*/ 35 w 35"/>
              <a:gd name="T27" fmla="*/ 0 h 440"/>
              <a:gd name="T28" fmla="*/ 35 w 35"/>
              <a:gd name="T29" fmla="*/ 6 h 440"/>
              <a:gd name="T30" fmla="*/ 0 w 35"/>
              <a:gd name="T31" fmla="*/ 6 h 440"/>
              <a:gd name="T32" fmla="*/ 0 w 35"/>
              <a:gd name="T33" fmla="*/ 0 h 4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5" h="440">
                <a:moveTo>
                  <a:pt x="15" y="437"/>
                </a:moveTo>
                <a:lnTo>
                  <a:pt x="15" y="220"/>
                </a:lnTo>
                <a:lnTo>
                  <a:pt x="15" y="3"/>
                </a:lnTo>
                <a:lnTo>
                  <a:pt x="21" y="3"/>
                </a:lnTo>
                <a:lnTo>
                  <a:pt x="21" y="220"/>
                </a:lnTo>
                <a:lnTo>
                  <a:pt x="21" y="437"/>
                </a:lnTo>
                <a:lnTo>
                  <a:pt x="15" y="437"/>
                </a:lnTo>
                <a:close/>
                <a:moveTo>
                  <a:pt x="0" y="434"/>
                </a:moveTo>
                <a:lnTo>
                  <a:pt x="35" y="434"/>
                </a:lnTo>
                <a:lnTo>
                  <a:pt x="35" y="440"/>
                </a:lnTo>
                <a:lnTo>
                  <a:pt x="0" y="440"/>
                </a:lnTo>
                <a:lnTo>
                  <a:pt x="0" y="434"/>
                </a:lnTo>
                <a:close/>
                <a:moveTo>
                  <a:pt x="0" y="0"/>
                </a:moveTo>
                <a:lnTo>
                  <a:pt x="35" y="0"/>
                </a:lnTo>
                <a:lnTo>
                  <a:pt x="35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44" name="Freeform 50"/>
          <p:cNvSpPr>
            <a:spLocks noEditPoints="1"/>
          </p:cNvSpPr>
          <p:nvPr/>
        </p:nvSpPr>
        <p:spPr bwMode="auto">
          <a:xfrm>
            <a:off x="7816992" y="951052"/>
            <a:ext cx="57150" cy="376238"/>
          </a:xfrm>
          <a:custGeom>
            <a:avLst/>
            <a:gdLst>
              <a:gd name="T0" fmla="*/ 15 w 36"/>
              <a:gd name="T1" fmla="*/ 234 h 237"/>
              <a:gd name="T2" fmla="*/ 15 w 36"/>
              <a:gd name="T3" fmla="*/ 118 h 237"/>
              <a:gd name="T4" fmla="*/ 15 w 36"/>
              <a:gd name="T5" fmla="*/ 3 h 237"/>
              <a:gd name="T6" fmla="*/ 21 w 36"/>
              <a:gd name="T7" fmla="*/ 3 h 237"/>
              <a:gd name="T8" fmla="*/ 21 w 36"/>
              <a:gd name="T9" fmla="*/ 118 h 237"/>
              <a:gd name="T10" fmla="*/ 21 w 36"/>
              <a:gd name="T11" fmla="*/ 234 h 237"/>
              <a:gd name="T12" fmla="*/ 15 w 36"/>
              <a:gd name="T13" fmla="*/ 234 h 237"/>
              <a:gd name="T14" fmla="*/ 0 w 36"/>
              <a:gd name="T15" fmla="*/ 231 h 237"/>
              <a:gd name="T16" fmla="*/ 36 w 36"/>
              <a:gd name="T17" fmla="*/ 231 h 237"/>
              <a:gd name="T18" fmla="*/ 36 w 36"/>
              <a:gd name="T19" fmla="*/ 237 h 237"/>
              <a:gd name="T20" fmla="*/ 0 w 36"/>
              <a:gd name="T21" fmla="*/ 237 h 237"/>
              <a:gd name="T22" fmla="*/ 0 w 36"/>
              <a:gd name="T23" fmla="*/ 231 h 237"/>
              <a:gd name="T24" fmla="*/ 0 w 36"/>
              <a:gd name="T25" fmla="*/ 0 h 237"/>
              <a:gd name="T26" fmla="*/ 36 w 36"/>
              <a:gd name="T27" fmla="*/ 0 h 237"/>
              <a:gd name="T28" fmla="*/ 36 w 36"/>
              <a:gd name="T29" fmla="*/ 6 h 237"/>
              <a:gd name="T30" fmla="*/ 0 w 36"/>
              <a:gd name="T31" fmla="*/ 6 h 237"/>
              <a:gd name="T32" fmla="*/ 0 w 36"/>
              <a:gd name="T33" fmla="*/ 0 h 23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6" h="237">
                <a:moveTo>
                  <a:pt x="15" y="234"/>
                </a:moveTo>
                <a:lnTo>
                  <a:pt x="15" y="118"/>
                </a:lnTo>
                <a:lnTo>
                  <a:pt x="15" y="3"/>
                </a:lnTo>
                <a:lnTo>
                  <a:pt x="21" y="3"/>
                </a:lnTo>
                <a:lnTo>
                  <a:pt x="21" y="118"/>
                </a:lnTo>
                <a:lnTo>
                  <a:pt x="21" y="234"/>
                </a:lnTo>
                <a:lnTo>
                  <a:pt x="15" y="234"/>
                </a:lnTo>
                <a:close/>
                <a:moveTo>
                  <a:pt x="0" y="231"/>
                </a:moveTo>
                <a:lnTo>
                  <a:pt x="36" y="231"/>
                </a:lnTo>
                <a:lnTo>
                  <a:pt x="36" y="237"/>
                </a:lnTo>
                <a:lnTo>
                  <a:pt x="0" y="237"/>
                </a:lnTo>
                <a:lnTo>
                  <a:pt x="0" y="231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36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45" name="Freeform 51"/>
          <p:cNvSpPr>
            <a:spLocks noEditPoints="1"/>
          </p:cNvSpPr>
          <p:nvPr/>
        </p:nvSpPr>
        <p:spPr bwMode="auto">
          <a:xfrm>
            <a:off x="8088455" y="2703652"/>
            <a:ext cx="55562" cy="858838"/>
          </a:xfrm>
          <a:custGeom>
            <a:avLst/>
            <a:gdLst>
              <a:gd name="T0" fmla="*/ 15 w 35"/>
              <a:gd name="T1" fmla="*/ 538 h 541"/>
              <a:gd name="T2" fmla="*/ 15 w 35"/>
              <a:gd name="T3" fmla="*/ 271 h 541"/>
              <a:gd name="T4" fmla="*/ 15 w 35"/>
              <a:gd name="T5" fmla="*/ 3 h 541"/>
              <a:gd name="T6" fmla="*/ 21 w 35"/>
              <a:gd name="T7" fmla="*/ 3 h 541"/>
              <a:gd name="T8" fmla="*/ 21 w 35"/>
              <a:gd name="T9" fmla="*/ 271 h 541"/>
              <a:gd name="T10" fmla="*/ 21 w 35"/>
              <a:gd name="T11" fmla="*/ 538 h 541"/>
              <a:gd name="T12" fmla="*/ 15 w 35"/>
              <a:gd name="T13" fmla="*/ 538 h 541"/>
              <a:gd name="T14" fmla="*/ 0 w 35"/>
              <a:gd name="T15" fmla="*/ 536 h 541"/>
              <a:gd name="T16" fmla="*/ 35 w 35"/>
              <a:gd name="T17" fmla="*/ 536 h 541"/>
              <a:gd name="T18" fmla="*/ 35 w 35"/>
              <a:gd name="T19" fmla="*/ 541 h 541"/>
              <a:gd name="T20" fmla="*/ 0 w 35"/>
              <a:gd name="T21" fmla="*/ 541 h 541"/>
              <a:gd name="T22" fmla="*/ 0 w 35"/>
              <a:gd name="T23" fmla="*/ 536 h 541"/>
              <a:gd name="T24" fmla="*/ 0 w 35"/>
              <a:gd name="T25" fmla="*/ 0 h 541"/>
              <a:gd name="T26" fmla="*/ 35 w 35"/>
              <a:gd name="T27" fmla="*/ 0 h 541"/>
              <a:gd name="T28" fmla="*/ 35 w 35"/>
              <a:gd name="T29" fmla="*/ 6 h 541"/>
              <a:gd name="T30" fmla="*/ 0 w 35"/>
              <a:gd name="T31" fmla="*/ 6 h 541"/>
              <a:gd name="T32" fmla="*/ 0 w 35"/>
              <a:gd name="T33" fmla="*/ 0 h 54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5" h="541">
                <a:moveTo>
                  <a:pt x="15" y="538"/>
                </a:moveTo>
                <a:lnTo>
                  <a:pt x="15" y="271"/>
                </a:lnTo>
                <a:lnTo>
                  <a:pt x="15" y="3"/>
                </a:lnTo>
                <a:lnTo>
                  <a:pt x="21" y="3"/>
                </a:lnTo>
                <a:lnTo>
                  <a:pt x="21" y="271"/>
                </a:lnTo>
                <a:lnTo>
                  <a:pt x="21" y="538"/>
                </a:lnTo>
                <a:lnTo>
                  <a:pt x="15" y="538"/>
                </a:lnTo>
                <a:close/>
                <a:moveTo>
                  <a:pt x="0" y="536"/>
                </a:moveTo>
                <a:lnTo>
                  <a:pt x="35" y="536"/>
                </a:lnTo>
                <a:lnTo>
                  <a:pt x="35" y="541"/>
                </a:lnTo>
                <a:lnTo>
                  <a:pt x="0" y="541"/>
                </a:lnTo>
                <a:lnTo>
                  <a:pt x="0" y="536"/>
                </a:lnTo>
                <a:close/>
                <a:moveTo>
                  <a:pt x="0" y="0"/>
                </a:moveTo>
                <a:lnTo>
                  <a:pt x="35" y="0"/>
                </a:lnTo>
                <a:lnTo>
                  <a:pt x="35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46" name="Freeform 52"/>
          <p:cNvSpPr>
            <a:spLocks noEditPoints="1"/>
          </p:cNvSpPr>
          <p:nvPr/>
        </p:nvSpPr>
        <p:spPr bwMode="auto">
          <a:xfrm>
            <a:off x="8629792" y="4319727"/>
            <a:ext cx="55562" cy="541338"/>
          </a:xfrm>
          <a:custGeom>
            <a:avLst/>
            <a:gdLst>
              <a:gd name="T0" fmla="*/ 15 w 35"/>
              <a:gd name="T1" fmla="*/ 338 h 341"/>
              <a:gd name="T2" fmla="*/ 15 w 35"/>
              <a:gd name="T3" fmla="*/ 171 h 341"/>
              <a:gd name="T4" fmla="*/ 15 w 35"/>
              <a:gd name="T5" fmla="*/ 3 h 341"/>
              <a:gd name="T6" fmla="*/ 21 w 35"/>
              <a:gd name="T7" fmla="*/ 3 h 341"/>
              <a:gd name="T8" fmla="*/ 21 w 35"/>
              <a:gd name="T9" fmla="*/ 171 h 341"/>
              <a:gd name="T10" fmla="*/ 21 w 35"/>
              <a:gd name="T11" fmla="*/ 338 h 341"/>
              <a:gd name="T12" fmla="*/ 15 w 35"/>
              <a:gd name="T13" fmla="*/ 338 h 341"/>
              <a:gd name="T14" fmla="*/ 0 w 35"/>
              <a:gd name="T15" fmla="*/ 335 h 341"/>
              <a:gd name="T16" fmla="*/ 35 w 35"/>
              <a:gd name="T17" fmla="*/ 335 h 341"/>
              <a:gd name="T18" fmla="*/ 35 w 35"/>
              <a:gd name="T19" fmla="*/ 341 h 341"/>
              <a:gd name="T20" fmla="*/ 0 w 35"/>
              <a:gd name="T21" fmla="*/ 341 h 341"/>
              <a:gd name="T22" fmla="*/ 0 w 35"/>
              <a:gd name="T23" fmla="*/ 335 h 341"/>
              <a:gd name="T24" fmla="*/ 0 w 35"/>
              <a:gd name="T25" fmla="*/ 0 h 341"/>
              <a:gd name="T26" fmla="*/ 35 w 35"/>
              <a:gd name="T27" fmla="*/ 0 h 341"/>
              <a:gd name="T28" fmla="*/ 35 w 35"/>
              <a:gd name="T29" fmla="*/ 6 h 341"/>
              <a:gd name="T30" fmla="*/ 0 w 35"/>
              <a:gd name="T31" fmla="*/ 6 h 341"/>
              <a:gd name="T32" fmla="*/ 0 w 35"/>
              <a:gd name="T33" fmla="*/ 0 h 34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5" h="341">
                <a:moveTo>
                  <a:pt x="15" y="338"/>
                </a:moveTo>
                <a:lnTo>
                  <a:pt x="15" y="171"/>
                </a:lnTo>
                <a:lnTo>
                  <a:pt x="15" y="3"/>
                </a:lnTo>
                <a:lnTo>
                  <a:pt x="21" y="3"/>
                </a:lnTo>
                <a:lnTo>
                  <a:pt x="21" y="171"/>
                </a:lnTo>
                <a:lnTo>
                  <a:pt x="21" y="338"/>
                </a:lnTo>
                <a:lnTo>
                  <a:pt x="15" y="338"/>
                </a:lnTo>
                <a:close/>
                <a:moveTo>
                  <a:pt x="0" y="335"/>
                </a:moveTo>
                <a:lnTo>
                  <a:pt x="35" y="335"/>
                </a:lnTo>
                <a:lnTo>
                  <a:pt x="35" y="341"/>
                </a:lnTo>
                <a:lnTo>
                  <a:pt x="0" y="341"/>
                </a:lnTo>
                <a:lnTo>
                  <a:pt x="0" y="335"/>
                </a:lnTo>
                <a:close/>
                <a:moveTo>
                  <a:pt x="0" y="0"/>
                </a:moveTo>
                <a:lnTo>
                  <a:pt x="35" y="0"/>
                </a:lnTo>
                <a:lnTo>
                  <a:pt x="35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47" name="Freeform 53"/>
          <p:cNvSpPr>
            <a:spLocks noEditPoints="1"/>
          </p:cNvSpPr>
          <p:nvPr/>
        </p:nvSpPr>
        <p:spPr bwMode="auto">
          <a:xfrm>
            <a:off x="8899667" y="1800365"/>
            <a:ext cx="57150" cy="1685925"/>
          </a:xfrm>
          <a:custGeom>
            <a:avLst/>
            <a:gdLst>
              <a:gd name="T0" fmla="*/ 15 w 36"/>
              <a:gd name="T1" fmla="*/ 1059 h 1062"/>
              <a:gd name="T2" fmla="*/ 15 w 36"/>
              <a:gd name="T3" fmla="*/ 530 h 1062"/>
              <a:gd name="T4" fmla="*/ 15 w 36"/>
              <a:gd name="T5" fmla="*/ 2 h 1062"/>
              <a:gd name="T6" fmla="*/ 21 w 36"/>
              <a:gd name="T7" fmla="*/ 2 h 1062"/>
              <a:gd name="T8" fmla="*/ 21 w 36"/>
              <a:gd name="T9" fmla="*/ 530 h 1062"/>
              <a:gd name="T10" fmla="*/ 21 w 36"/>
              <a:gd name="T11" fmla="*/ 1059 h 1062"/>
              <a:gd name="T12" fmla="*/ 15 w 36"/>
              <a:gd name="T13" fmla="*/ 1059 h 1062"/>
              <a:gd name="T14" fmla="*/ 0 w 36"/>
              <a:gd name="T15" fmla="*/ 1057 h 1062"/>
              <a:gd name="T16" fmla="*/ 36 w 36"/>
              <a:gd name="T17" fmla="*/ 1057 h 1062"/>
              <a:gd name="T18" fmla="*/ 36 w 36"/>
              <a:gd name="T19" fmla="*/ 1062 h 1062"/>
              <a:gd name="T20" fmla="*/ 0 w 36"/>
              <a:gd name="T21" fmla="*/ 1062 h 1062"/>
              <a:gd name="T22" fmla="*/ 0 w 36"/>
              <a:gd name="T23" fmla="*/ 1057 h 1062"/>
              <a:gd name="T24" fmla="*/ 0 w 36"/>
              <a:gd name="T25" fmla="*/ 0 h 1062"/>
              <a:gd name="T26" fmla="*/ 36 w 36"/>
              <a:gd name="T27" fmla="*/ 0 h 1062"/>
              <a:gd name="T28" fmla="*/ 36 w 36"/>
              <a:gd name="T29" fmla="*/ 5 h 1062"/>
              <a:gd name="T30" fmla="*/ 0 w 36"/>
              <a:gd name="T31" fmla="*/ 5 h 1062"/>
              <a:gd name="T32" fmla="*/ 0 w 36"/>
              <a:gd name="T33" fmla="*/ 0 h 106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6" h="1062">
                <a:moveTo>
                  <a:pt x="15" y="1059"/>
                </a:moveTo>
                <a:lnTo>
                  <a:pt x="15" y="530"/>
                </a:lnTo>
                <a:lnTo>
                  <a:pt x="15" y="2"/>
                </a:lnTo>
                <a:lnTo>
                  <a:pt x="21" y="2"/>
                </a:lnTo>
                <a:lnTo>
                  <a:pt x="21" y="530"/>
                </a:lnTo>
                <a:lnTo>
                  <a:pt x="21" y="1059"/>
                </a:lnTo>
                <a:lnTo>
                  <a:pt x="15" y="1059"/>
                </a:lnTo>
                <a:close/>
                <a:moveTo>
                  <a:pt x="0" y="1057"/>
                </a:moveTo>
                <a:lnTo>
                  <a:pt x="36" y="1057"/>
                </a:lnTo>
                <a:lnTo>
                  <a:pt x="36" y="1062"/>
                </a:lnTo>
                <a:lnTo>
                  <a:pt x="0" y="1062"/>
                </a:lnTo>
                <a:lnTo>
                  <a:pt x="0" y="1057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36" y="5"/>
                </a:lnTo>
                <a:lnTo>
                  <a:pt x="0" y="5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48" name="Rectangle 54"/>
          <p:cNvSpPr>
            <a:spLocks noChangeArrowheads="1"/>
          </p:cNvSpPr>
          <p:nvPr/>
        </p:nvSpPr>
        <p:spPr bwMode="auto">
          <a:xfrm>
            <a:off x="1487630" y="266840"/>
            <a:ext cx="3175" cy="4659313"/>
          </a:xfrm>
          <a:prstGeom prst="rect">
            <a:avLst/>
          </a:pr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49" name="Freeform 55"/>
          <p:cNvSpPr>
            <a:spLocks noEditPoints="1"/>
          </p:cNvSpPr>
          <p:nvPr/>
        </p:nvSpPr>
        <p:spPr bwMode="auto">
          <a:xfrm>
            <a:off x="1443180" y="265252"/>
            <a:ext cx="46037" cy="4662488"/>
          </a:xfrm>
          <a:custGeom>
            <a:avLst/>
            <a:gdLst>
              <a:gd name="T0" fmla="*/ 0 w 29"/>
              <a:gd name="T1" fmla="*/ 2935 h 2937"/>
              <a:gd name="T2" fmla="*/ 29 w 29"/>
              <a:gd name="T3" fmla="*/ 2935 h 2937"/>
              <a:gd name="T4" fmla="*/ 29 w 29"/>
              <a:gd name="T5" fmla="*/ 2937 h 2937"/>
              <a:gd name="T6" fmla="*/ 0 w 29"/>
              <a:gd name="T7" fmla="*/ 2937 h 2937"/>
              <a:gd name="T8" fmla="*/ 0 w 29"/>
              <a:gd name="T9" fmla="*/ 2935 h 2937"/>
              <a:gd name="T10" fmla="*/ 0 w 29"/>
              <a:gd name="T11" fmla="*/ 2348 h 2937"/>
              <a:gd name="T12" fmla="*/ 29 w 29"/>
              <a:gd name="T13" fmla="*/ 2348 h 2937"/>
              <a:gd name="T14" fmla="*/ 29 w 29"/>
              <a:gd name="T15" fmla="*/ 2350 h 2937"/>
              <a:gd name="T16" fmla="*/ 0 w 29"/>
              <a:gd name="T17" fmla="*/ 2350 h 2937"/>
              <a:gd name="T18" fmla="*/ 0 w 29"/>
              <a:gd name="T19" fmla="*/ 2348 h 2937"/>
              <a:gd name="T20" fmla="*/ 0 w 29"/>
              <a:gd name="T21" fmla="*/ 1760 h 2937"/>
              <a:gd name="T22" fmla="*/ 29 w 29"/>
              <a:gd name="T23" fmla="*/ 1760 h 2937"/>
              <a:gd name="T24" fmla="*/ 29 w 29"/>
              <a:gd name="T25" fmla="*/ 1762 h 2937"/>
              <a:gd name="T26" fmla="*/ 0 w 29"/>
              <a:gd name="T27" fmla="*/ 1762 h 2937"/>
              <a:gd name="T28" fmla="*/ 0 w 29"/>
              <a:gd name="T29" fmla="*/ 1760 h 2937"/>
              <a:gd name="T30" fmla="*/ 0 w 29"/>
              <a:gd name="T31" fmla="*/ 1174 h 2937"/>
              <a:gd name="T32" fmla="*/ 29 w 29"/>
              <a:gd name="T33" fmla="*/ 1174 h 2937"/>
              <a:gd name="T34" fmla="*/ 29 w 29"/>
              <a:gd name="T35" fmla="*/ 1176 h 2937"/>
              <a:gd name="T36" fmla="*/ 0 w 29"/>
              <a:gd name="T37" fmla="*/ 1176 h 2937"/>
              <a:gd name="T38" fmla="*/ 0 w 29"/>
              <a:gd name="T39" fmla="*/ 1174 h 2937"/>
              <a:gd name="T40" fmla="*/ 0 w 29"/>
              <a:gd name="T41" fmla="*/ 586 h 2937"/>
              <a:gd name="T42" fmla="*/ 29 w 29"/>
              <a:gd name="T43" fmla="*/ 586 h 2937"/>
              <a:gd name="T44" fmla="*/ 29 w 29"/>
              <a:gd name="T45" fmla="*/ 588 h 2937"/>
              <a:gd name="T46" fmla="*/ 0 w 29"/>
              <a:gd name="T47" fmla="*/ 588 h 2937"/>
              <a:gd name="T48" fmla="*/ 0 w 29"/>
              <a:gd name="T49" fmla="*/ 586 h 2937"/>
              <a:gd name="T50" fmla="*/ 0 w 29"/>
              <a:gd name="T51" fmla="*/ 0 h 2937"/>
              <a:gd name="T52" fmla="*/ 29 w 29"/>
              <a:gd name="T53" fmla="*/ 0 h 2937"/>
              <a:gd name="T54" fmla="*/ 29 w 29"/>
              <a:gd name="T55" fmla="*/ 2 h 2937"/>
              <a:gd name="T56" fmla="*/ 0 w 29"/>
              <a:gd name="T57" fmla="*/ 2 h 2937"/>
              <a:gd name="T58" fmla="*/ 0 w 29"/>
              <a:gd name="T59" fmla="*/ 0 h 293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</a:cxnLst>
            <a:rect l="0" t="0" r="r" b="b"/>
            <a:pathLst>
              <a:path w="29" h="2937">
                <a:moveTo>
                  <a:pt x="0" y="2935"/>
                </a:moveTo>
                <a:lnTo>
                  <a:pt x="29" y="2935"/>
                </a:lnTo>
                <a:lnTo>
                  <a:pt x="29" y="2937"/>
                </a:lnTo>
                <a:lnTo>
                  <a:pt x="0" y="2937"/>
                </a:lnTo>
                <a:lnTo>
                  <a:pt x="0" y="2935"/>
                </a:lnTo>
                <a:close/>
                <a:moveTo>
                  <a:pt x="0" y="2348"/>
                </a:moveTo>
                <a:lnTo>
                  <a:pt x="29" y="2348"/>
                </a:lnTo>
                <a:lnTo>
                  <a:pt x="29" y="2350"/>
                </a:lnTo>
                <a:lnTo>
                  <a:pt x="0" y="2350"/>
                </a:lnTo>
                <a:lnTo>
                  <a:pt x="0" y="2348"/>
                </a:lnTo>
                <a:close/>
                <a:moveTo>
                  <a:pt x="0" y="1760"/>
                </a:moveTo>
                <a:lnTo>
                  <a:pt x="29" y="1760"/>
                </a:lnTo>
                <a:lnTo>
                  <a:pt x="29" y="1762"/>
                </a:lnTo>
                <a:lnTo>
                  <a:pt x="0" y="1762"/>
                </a:lnTo>
                <a:lnTo>
                  <a:pt x="0" y="1760"/>
                </a:lnTo>
                <a:close/>
                <a:moveTo>
                  <a:pt x="0" y="1174"/>
                </a:moveTo>
                <a:lnTo>
                  <a:pt x="29" y="1174"/>
                </a:lnTo>
                <a:lnTo>
                  <a:pt x="29" y="1176"/>
                </a:lnTo>
                <a:lnTo>
                  <a:pt x="0" y="1176"/>
                </a:lnTo>
                <a:lnTo>
                  <a:pt x="0" y="1174"/>
                </a:lnTo>
                <a:close/>
                <a:moveTo>
                  <a:pt x="0" y="586"/>
                </a:moveTo>
                <a:lnTo>
                  <a:pt x="29" y="586"/>
                </a:lnTo>
                <a:lnTo>
                  <a:pt x="29" y="588"/>
                </a:lnTo>
                <a:lnTo>
                  <a:pt x="0" y="588"/>
                </a:lnTo>
                <a:lnTo>
                  <a:pt x="0" y="586"/>
                </a:lnTo>
                <a:close/>
                <a:moveTo>
                  <a:pt x="0" y="0"/>
                </a:moveTo>
                <a:lnTo>
                  <a:pt x="29" y="0"/>
                </a:lnTo>
                <a:lnTo>
                  <a:pt x="29" y="2"/>
                </a:lnTo>
                <a:lnTo>
                  <a:pt x="0" y="2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50" name="Rectangle 56"/>
          <p:cNvSpPr>
            <a:spLocks noChangeArrowheads="1"/>
          </p:cNvSpPr>
          <p:nvPr/>
        </p:nvSpPr>
        <p:spPr bwMode="auto">
          <a:xfrm>
            <a:off x="1489217" y="4924565"/>
            <a:ext cx="7573962" cy="3175"/>
          </a:xfrm>
          <a:prstGeom prst="rect">
            <a:avLst/>
          </a:pr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1" name="Rectangle 57"/>
          <p:cNvSpPr>
            <a:spLocks noChangeArrowheads="1"/>
          </p:cNvSpPr>
          <p:nvPr/>
        </p:nvSpPr>
        <p:spPr bwMode="auto">
          <a:xfrm>
            <a:off x="1213028" y="4810847"/>
            <a:ext cx="11381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0</a:t>
            </a:r>
            <a:endParaRPr kumimoji="0" lang="en-US" altLang="en-US" sz="1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52" name="Rectangle 58"/>
          <p:cNvSpPr>
            <a:spLocks noChangeArrowheads="1"/>
          </p:cNvSpPr>
          <p:nvPr/>
        </p:nvSpPr>
        <p:spPr bwMode="auto">
          <a:xfrm>
            <a:off x="1128890" y="3888315"/>
            <a:ext cx="22762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20</a:t>
            </a:r>
            <a:endParaRPr kumimoji="0" lang="en-US" altLang="en-US" sz="1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53" name="Rectangle 59"/>
          <p:cNvSpPr>
            <a:spLocks noChangeArrowheads="1"/>
          </p:cNvSpPr>
          <p:nvPr/>
        </p:nvSpPr>
        <p:spPr bwMode="auto">
          <a:xfrm>
            <a:off x="1128890" y="2937791"/>
            <a:ext cx="22762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40</a:t>
            </a:r>
            <a:endParaRPr kumimoji="0" lang="en-US" altLang="en-US" sz="1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54" name="Rectangle 60"/>
          <p:cNvSpPr>
            <a:spLocks noChangeArrowheads="1"/>
          </p:cNvSpPr>
          <p:nvPr/>
        </p:nvSpPr>
        <p:spPr bwMode="auto">
          <a:xfrm>
            <a:off x="1128890" y="2013319"/>
            <a:ext cx="22762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60</a:t>
            </a:r>
            <a:endParaRPr kumimoji="0" lang="en-US" altLang="en-US" sz="1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55" name="Rectangle 61"/>
          <p:cNvSpPr>
            <a:spLocks noChangeArrowheads="1"/>
          </p:cNvSpPr>
          <p:nvPr/>
        </p:nvSpPr>
        <p:spPr bwMode="auto">
          <a:xfrm>
            <a:off x="1128890" y="1077664"/>
            <a:ext cx="22762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80</a:t>
            </a:r>
            <a:endParaRPr kumimoji="0" lang="en-US" altLang="en-US" sz="1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56" name="Rectangle 62"/>
          <p:cNvSpPr>
            <a:spLocks noChangeArrowheads="1"/>
          </p:cNvSpPr>
          <p:nvPr/>
        </p:nvSpPr>
        <p:spPr bwMode="auto">
          <a:xfrm>
            <a:off x="1043165" y="144602"/>
            <a:ext cx="34144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00</a:t>
            </a:r>
            <a:endParaRPr kumimoji="0" lang="en-US" altLang="en-US" sz="1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57" name="Freeform 63"/>
          <p:cNvSpPr>
            <a:spLocks noEditPoints="1"/>
          </p:cNvSpPr>
          <p:nvPr/>
        </p:nvSpPr>
        <p:spPr bwMode="auto">
          <a:xfrm>
            <a:off x="1057417" y="5035690"/>
            <a:ext cx="581025" cy="582613"/>
          </a:xfrm>
          <a:custGeom>
            <a:avLst/>
            <a:gdLst>
              <a:gd name="T0" fmla="*/ 419 w 3054"/>
              <a:gd name="T1" fmla="*/ 2985 h 3059"/>
              <a:gd name="T2" fmla="*/ 13 w 3054"/>
              <a:gd name="T3" fmla="*/ 2855 h 3059"/>
              <a:gd name="T4" fmla="*/ 303 w 3054"/>
              <a:gd name="T5" fmla="*/ 2601 h 3059"/>
              <a:gd name="T6" fmla="*/ 63 w 3054"/>
              <a:gd name="T7" fmla="*/ 2759 h 3059"/>
              <a:gd name="T8" fmla="*/ 304 w 3054"/>
              <a:gd name="T9" fmla="*/ 2991 h 3059"/>
              <a:gd name="T10" fmla="*/ 465 w 3054"/>
              <a:gd name="T11" fmla="*/ 2683 h 3059"/>
              <a:gd name="T12" fmla="*/ 690 w 3054"/>
              <a:gd name="T13" fmla="*/ 2452 h 3059"/>
              <a:gd name="T14" fmla="*/ 591 w 3054"/>
              <a:gd name="T15" fmla="*/ 2746 h 3059"/>
              <a:gd name="T16" fmla="*/ 673 w 3054"/>
              <a:gd name="T17" fmla="*/ 2663 h 3059"/>
              <a:gd name="T18" fmla="*/ 486 w 3054"/>
              <a:gd name="T19" fmla="*/ 2476 h 3059"/>
              <a:gd name="T20" fmla="*/ 625 w 3054"/>
              <a:gd name="T21" fmla="*/ 2280 h 3059"/>
              <a:gd name="T22" fmla="*/ 782 w 3054"/>
              <a:gd name="T23" fmla="*/ 2128 h 3059"/>
              <a:gd name="T24" fmla="*/ 1066 w 3054"/>
              <a:gd name="T25" fmla="*/ 2326 h 3059"/>
              <a:gd name="T26" fmla="*/ 797 w 3054"/>
              <a:gd name="T27" fmla="*/ 2183 h 3059"/>
              <a:gd name="T28" fmla="*/ 909 w 3054"/>
              <a:gd name="T29" fmla="*/ 2483 h 3059"/>
              <a:gd name="T30" fmla="*/ 1196 w 3054"/>
              <a:gd name="T31" fmla="*/ 2202 h 3059"/>
              <a:gd name="T32" fmla="*/ 925 w 3054"/>
              <a:gd name="T33" fmla="*/ 2045 h 3059"/>
              <a:gd name="T34" fmla="*/ 832 w 3054"/>
              <a:gd name="T35" fmla="*/ 1952 h 3059"/>
              <a:gd name="T36" fmla="*/ 1007 w 3054"/>
              <a:gd name="T37" fmla="*/ 1962 h 3059"/>
              <a:gd name="T38" fmla="*/ 1148 w 3054"/>
              <a:gd name="T39" fmla="*/ 2168 h 3059"/>
              <a:gd name="T40" fmla="*/ 1015 w 3054"/>
              <a:gd name="T41" fmla="*/ 1891 h 3059"/>
              <a:gd name="T42" fmla="*/ 1099 w 3054"/>
              <a:gd name="T43" fmla="*/ 1795 h 3059"/>
              <a:gd name="T44" fmla="*/ 1123 w 3054"/>
              <a:gd name="T45" fmla="*/ 1872 h 3059"/>
              <a:gd name="T46" fmla="*/ 1258 w 3054"/>
              <a:gd name="T47" fmla="*/ 2134 h 3059"/>
              <a:gd name="T48" fmla="*/ 1382 w 3054"/>
              <a:gd name="T49" fmla="*/ 1578 h 3059"/>
              <a:gd name="T50" fmla="*/ 1521 w 3054"/>
              <a:gd name="T51" fmla="*/ 1882 h 3059"/>
              <a:gd name="T52" fmla="*/ 1413 w 3054"/>
              <a:gd name="T53" fmla="*/ 1876 h 3059"/>
              <a:gd name="T54" fmla="*/ 1375 w 3054"/>
              <a:gd name="T55" fmla="*/ 1634 h 3059"/>
              <a:gd name="T56" fmla="*/ 1676 w 3054"/>
              <a:gd name="T57" fmla="*/ 1716 h 3059"/>
              <a:gd name="T58" fmla="*/ 1676 w 3054"/>
              <a:gd name="T59" fmla="*/ 1716 h 3059"/>
              <a:gd name="T60" fmla="*/ 1744 w 3054"/>
              <a:gd name="T61" fmla="*/ 1591 h 3059"/>
              <a:gd name="T62" fmla="*/ 1702 w 3054"/>
              <a:gd name="T63" fmla="*/ 1200 h 3059"/>
              <a:gd name="T64" fmla="*/ 1582 w 3054"/>
              <a:gd name="T65" fmla="*/ 1338 h 3059"/>
              <a:gd name="T66" fmla="*/ 1651 w 3054"/>
              <a:gd name="T67" fmla="*/ 1120 h 3059"/>
              <a:gd name="T68" fmla="*/ 1786 w 3054"/>
              <a:gd name="T69" fmla="*/ 1397 h 3059"/>
              <a:gd name="T70" fmla="*/ 1887 w 3054"/>
              <a:gd name="T71" fmla="*/ 928 h 3059"/>
              <a:gd name="T72" fmla="*/ 1887 w 3054"/>
              <a:gd name="T73" fmla="*/ 928 h 3059"/>
              <a:gd name="T74" fmla="*/ 2216 w 3054"/>
              <a:gd name="T75" fmla="*/ 1176 h 3059"/>
              <a:gd name="T76" fmla="*/ 2078 w 3054"/>
              <a:gd name="T77" fmla="*/ 642 h 3059"/>
              <a:gd name="T78" fmla="*/ 2305 w 3054"/>
              <a:gd name="T79" fmla="*/ 609 h 3059"/>
              <a:gd name="T80" fmla="*/ 2332 w 3054"/>
              <a:gd name="T81" fmla="*/ 1060 h 3059"/>
              <a:gd name="T82" fmla="*/ 2288 w 3054"/>
              <a:gd name="T83" fmla="*/ 719 h 3059"/>
              <a:gd name="T84" fmla="*/ 2122 w 3054"/>
              <a:gd name="T85" fmla="*/ 678 h 3059"/>
              <a:gd name="T86" fmla="*/ 2514 w 3054"/>
              <a:gd name="T87" fmla="*/ 655 h 3059"/>
              <a:gd name="T88" fmla="*/ 2728 w 3054"/>
              <a:gd name="T89" fmla="*/ 581 h 3059"/>
              <a:gd name="T90" fmla="*/ 2630 w 3054"/>
              <a:gd name="T91" fmla="*/ 484 h 3059"/>
              <a:gd name="T92" fmla="*/ 2347 w 3054"/>
              <a:gd name="T93" fmla="*/ 546 h 3059"/>
              <a:gd name="T94" fmla="*/ 2451 w 3054"/>
              <a:gd name="T95" fmla="*/ 282 h 3059"/>
              <a:gd name="T96" fmla="*/ 2489 w 3054"/>
              <a:gd name="T97" fmla="*/ 331 h 3059"/>
              <a:gd name="T98" fmla="*/ 2430 w 3054"/>
              <a:gd name="T99" fmla="*/ 517 h 3059"/>
              <a:gd name="T100" fmla="*/ 2756 w 3054"/>
              <a:gd name="T101" fmla="*/ 446 h 3059"/>
              <a:gd name="T102" fmla="*/ 2643 w 3054"/>
              <a:gd name="T103" fmla="*/ 734 h 3059"/>
              <a:gd name="T104" fmla="*/ 3013 w 3054"/>
              <a:gd name="T105" fmla="*/ 379 h 3059"/>
              <a:gd name="T106" fmla="*/ 2677 w 3054"/>
              <a:gd name="T107" fmla="*/ 208 h 3059"/>
              <a:gd name="T108" fmla="*/ 3054 w 3054"/>
              <a:gd name="T109" fmla="*/ 338 h 305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</a:cxnLst>
            <a:rect l="0" t="0" r="r" b="b"/>
            <a:pathLst>
              <a:path w="3054" h="3059">
                <a:moveTo>
                  <a:pt x="390" y="2766"/>
                </a:moveTo>
                <a:lnTo>
                  <a:pt x="446" y="2733"/>
                </a:lnTo>
                <a:cubicBezTo>
                  <a:pt x="473" y="2779"/>
                  <a:pt x="484" y="2824"/>
                  <a:pt x="479" y="2867"/>
                </a:cubicBezTo>
                <a:cubicBezTo>
                  <a:pt x="474" y="2910"/>
                  <a:pt x="454" y="2950"/>
                  <a:pt x="419" y="2985"/>
                </a:cubicBezTo>
                <a:cubicBezTo>
                  <a:pt x="383" y="3021"/>
                  <a:pt x="346" y="3043"/>
                  <a:pt x="309" y="3051"/>
                </a:cubicBezTo>
                <a:cubicBezTo>
                  <a:pt x="271" y="3059"/>
                  <a:pt x="232" y="3055"/>
                  <a:pt x="193" y="3039"/>
                </a:cubicBezTo>
                <a:cubicBezTo>
                  <a:pt x="153" y="3022"/>
                  <a:pt x="117" y="2998"/>
                  <a:pt x="85" y="2966"/>
                </a:cubicBezTo>
                <a:cubicBezTo>
                  <a:pt x="50" y="2931"/>
                  <a:pt x="26" y="2894"/>
                  <a:pt x="13" y="2855"/>
                </a:cubicBezTo>
                <a:cubicBezTo>
                  <a:pt x="1" y="2815"/>
                  <a:pt x="0" y="2776"/>
                  <a:pt x="11" y="2738"/>
                </a:cubicBezTo>
                <a:cubicBezTo>
                  <a:pt x="22" y="2700"/>
                  <a:pt x="43" y="2666"/>
                  <a:pt x="72" y="2636"/>
                </a:cubicBezTo>
                <a:cubicBezTo>
                  <a:pt x="106" y="2603"/>
                  <a:pt x="143" y="2583"/>
                  <a:pt x="183" y="2577"/>
                </a:cubicBezTo>
                <a:cubicBezTo>
                  <a:pt x="223" y="2571"/>
                  <a:pt x="263" y="2579"/>
                  <a:pt x="303" y="2601"/>
                </a:cubicBezTo>
                <a:lnTo>
                  <a:pt x="269" y="2656"/>
                </a:lnTo>
                <a:cubicBezTo>
                  <a:pt x="237" y="2639"/>
                  <a:pt x="208" y="2632"/>
                  <a:pt x="182" y="2636"/>
                </a:cubicBezTo>
                <a:cubicBezTo>
                  <a:pt x="156" y="2640"/>
                  <a:pt x="132" y="2653"/>
                  <a:pt x="109" y="2675"/>
                </a:cubicBezTo>
                <a:cubicBezTo>
                  <a:pt x="83" y="2701"/>
                  <a:pt x="68" y="2729"/>
                  <a:pt x="63" y="2759"/>
                </a:cubicBezTo>
                <a:cubicBezTo>
                  <a:pt x="58" y="2788"/>
                  <a:pt x="63" y="2817"/>
                  <a:pt x="76" y="2845"/>
                </a:cubicBezTo>
                <a:cubicBezTo>
                  <a:pt x="90" y="2873"/>
                  <a:pt x="108" y="2898"/>
                  <a:pt x="130" y="2920"/>
                </a:cubicBezTo>
                <a:cubicBezTo>
                  <a:pt x="159" y="2949"/>
                  <a:pt x="188" y="2969"/>
                  <a:pt x="218" y="2982"/>
                </a:cubicBezTo>
                <a:cubicBezTo>
                  <a:pt x="247" y="2995"/>
                  <a:pt x="276" y="2998"/>
                  <a:pt x="304" y="2991"/>
                </a:cubicBezTo>
                <a:cubicBezTo>
                  <a:pt x="333" y="2984"/>
                  <a:pt x="357" y="2971"/>
                  <a:pt x="377" y="2950"/>
                </a:cubicBezTo>
                <a:cubicBezTo>
                  <a:pt x="402" y="2925"/>
                  <a:pt x="416" y="2897"/>
                  <a:pt x="419" y="2865"/>
                </a:cubicBezTo>
                <a:cubicBezTo>
                  <a:pt x="422" y="2834"/>
                  <a:pt x="412" y="2801"/>
                  <a:pt x="390" y="2766"/>
                </a:cubicBezTo>
                <a:close/>
                <a:moveTo>
                  <a:pt x="465" y="2683"/>
                </a:moveTo>
                <a:cubicBezTo>
                  <a:pt x="420" y="2638"/>
                  <a:pt x="399" y="2592"/>
                  <a:pt x="403" y="2546"/>
                </a:cubicBezTo>
                <a:cubicBezTo>
                  <a:pt x="406" y="2507"/>
                  <a:pt x="422" y="2472"/>
                  <a:pt x="452" y="2442"/>
                </a:cubicBezTo>
                <a:cubicBezTo>
                  <a:pt x="486" y="2409"/>
                  <a:pt x="524" y="2392"/>
                  <a:pt x="567" y="2393"/>
                </a:cubicBezTo>
                <a:cubicBezTo>
                  <a:pt x="610" y="2393"/>
                  <a:pt x="651" y="2413"/>
                  <a:pt x="690" y="2452"/>
                </a:cubicBezTo>
                <a:cubicBezTo>
                  <a:pt x="721" y="2483"/>
                  <a:pt x="741" y="2513"/>
                  <a:pt x="750" y="2540"/>
                </a:cubicBezTo>
                <a:cubicBezTo>
                  <a:pt x="758" y="2567"/>
                  <a:pt x="759" y="2595"/>
                  <a:pt x="751" y="2623"/>
                </a:cubicBezTo>
                <a:cubicBezTo>
                  <a:pt x="743" y="2651"/>
                  <a:pt x="728" y="2675"/>
                  <a:pt x="707" y="2696"/>
                </a:cubicBezTo>
                <a:cubicBezTo>
                  <a:pt x="673" y="2731"/>
                  <a:pt x="634" y="2747"/>
                  <a:pt x="591" y="2746"/>
                </a:cubicBezTo>
                <a:cubicBezTo>
                  <a:pt x="548" y="2745"/>
                  <a:pt x="506" y="2725"/>
                  <a:pt x="465" y="2683"/>
                </a:cubicBezTo>
                <a:close/>
                <a:moveTo>
                  <a:pt x="508" y="2641"/>
                </a:moveTo>
                <a:cubicBezTo>
                  <a:pt x="539" y="2672"/>
                  <a:pt x="569" y="2689"/>
                  <a:pt x="598" y="2691"/>
                </a:cubicBezTo>
                <a:cubicBezTo>
                  <a:pt x="627" y="2693"/>
                  <a:pt x="652" y="2683"/>
                  <a:pt x="673" y="2663"/>
                </a:cubicBezTo>
                <a:cubicBezTo>
                  <a:pt x="693" y="2642"/>
                  <a:pt x="702" y="2617"/>
                  <a:pt x="700" y="2588"/>
                </a:cubicBezTo>
                <a:cubicBezTo>
                  <a:pt x="698" y="2559"/>
                  <a:pt x="681" y="2528"/>
                  <a:pt x="650" y="2496"/>
                </a:cubicBezTo>
                <a:cubicBezTo>
                  <a:pt x="619" y="2466"/>
                  <a:pt x="590" y="2450"/>
                  <a:pt x="561" y="2448"/>
                </a:cubicBezTo>
                <a:cubicBezTo>
                  <a:pt x="531" y="2447"/>
                  <a:pt x="507" y="2456"/>
                  <a:pt x="486" y="2476"/>
                </a:cubicBezTo>
                <a:cubicBezTo>
                  <a:pt x="466" y="2497"/>
                  <a:pt x="456" y="2522"/>
                  <a:pt x="458" y="2551"/>
                </a:cubicBezTo>
                <a:cubicBezTo>
                  <a:pt x="460" y="2580"/>
                  <a:pt x="476" y="2610"/>
                  <a:pt x="508" y="2641"/>
                </a:cubicBezTo>
                <a:close/>
                <a:moveTo>
                  <a:pt x="868" y="2524"/>
                </a:moveTo>
                <a:lnTo>
                  <a:pt x="625" y="2280"/>
                </a:lnTo>
                <a:lnTo>
                  <a:pt x="662" y="2243"/>
                </a:lnTo>
                <a:lnTo>
                  <a:pt x="696" y="2278"/>
                </a:lnTo>
                <a:cubicBezTo>
                  <a:pt x="688" y="2233"/>
                  <a:pt x="700" y="2194"/>
                  <a:pt x="734" y="2160"/>
                </a:cubicBezTo>
                <a:cubicBezTo>
                  <a:pt x="749" y="2146"/>
                  <a:pt x="765" y="2135"/>
                  <a:pt x="782" y="2128"/>
                </a:cubicBezTo>
                <a:cubicBezTo>
                  <a:pt x="800" y="2121"/>
                  <a:pt x="816" y="2118"/>
                  <a:pt x="831" y="2121"/>
                </a:cubicBezTo>
                <a:cubicBezTo>
                  <a:pt x="845" y="2123"/>
                  <a:pt x="860" y="2129"/>
                  <a:pt x="874" y="2139"/>
                </a:cubicBezTo>
                <a:cubicBezTo>
                  <a:pt x="883" y="2145"/>
                  <a:pt x="897" y="2157"/>
                  <a:pt x="916" y="2176"/>
                </a:cubicBezTo>
                <a:lnTo>
                  <a:pt x="1066" y="2326"/>
                </a:lnTo>
                <a:lnTo>
                  <a:pt x="1025" y="2367"/>
                </a:lnTo>
                <a:lnTo>
                  <a:pt x="877" y="2219"/>
                </a:lnTo>
                <a:cubicBezTo>
                  <a:pt x="860" y="2202"/>
                  <a:pt x="846" y="2191"/>
                  <a:pt x="834" y="2186"/>
                </a:cubicBezTo>
                <a:cubicBezTo>
                  <a:pt x="823" y="2181"/>
                  <a:pt x="810" y="2180"/>
                  <a:pt x="797" y="2183"/>
                </a:cubicBezTo>
                <a:cubicBezTo>
                  <a:pt x="784" y="2187"/>
                  <a:pt x="772" y="2194"/>
                  <a:pt x="761" y="2205"/>
                </a:cubicBezTo>
                <a:cubicBezTo>
                  <a:pt x="743" y="2222"/>
                  <a:pt x="734" y="2243"/>
                  <a:pt x="732" y="2267"/>
                </a:cubicBezTo>
                <a:cubicBezTo>
                  <a:pt x="731" y="2291"/>
                  <a:pt x="745" y="2318"/>
                  <a:pt x="776" y="2350"/>
                </a:cubicBezTo>
                <a:lnTo>
                  <a:pt x="909" y="2483"/>
                </a:lnTo>
                <a:lnTo>
                  <a:pt x="868" y="2524"/>
                </a:lnTo>
                <a:close/>
                <a:moveTo>
                  <a:pt x="1182" y="2137"/>
                </a:moveTo>
                <a:lnTo>
                  <a:pt x="1224" y="2167"/>
                </a:lnTo>
                <a:cubicBezTo>
                  <a:pt x="1215" y="2181"/>
                  <a:pt x="1206" y="2193"/>
                  <a:pt x="1196" y="2202"/>
                </a:cubicBezTo>
                <a:cubicBezTo>
                  <a:pt x="1182" y="2217"/>
                  <a:pt x="1168" y="2226"/>
                  <a:pt x="1155" y="2230"/>
                </a:cubicBezTo>
                <a:cubicBezTo>
                  <a:pt x="1142" y="2233"/>
                  <a:pt x="1130" y="2233"/>
                  <a:pt x="1118" y="2228"/>
                </a:cubicBezTo>
                <a:cubicBezTo>
                  <a:pt x="1107" y="2224"/>
                  <a:pt x="1089" y="2210"/>
                  <a:pt x="1065" y="2185"/>
                </a:cubicBezTo>
                <a:lnTo>
                  <a:pt x="925" y="2045"/>
                </a:lnTo>
                <a:lnTo>
                  <a:pt x="894" y="2075"/>
                </a:lnTo>
                <a:lnTo>
                  <a:pt x="862" y="2043"/>
                </a:lnTo>
                <a:lnTo>
                  <a:pt x="893" y="2013"/>
                </a:lnTo>
                <a:lnTo>
                  <a:pt x="832" y="1952"/>
                </a:lnTo>
                <a:lnTo>
                  <a:pt x="848" y="1887"/>
                </a:lnTo>
                <a:lnTo>
                  <a:pt x="934" y="1972"/>
                </a:lnTo>
                <a:lnTo>
                  <a:pt x="975" y="1930"/>
                </a:lnTo>
                <a:lnTo>
                  <a:pt x="1007" y="1962"/>
                </a:lnTo>
                <a:lnTo>
                  <a:pt x="966" y="2004"/>
                </a:lnTo>
                <a:lnTo>
                  <a:pt x="1108" y="2146"/>
                </a:lnTo>
                <a:cubicBezTo>
                  <a:pt x="1120" y="2158"/>
                  <a:pt x="1128" y="2165"/>
                  <a:pt x="1133" y="2167"/>
                </a:cubicBezTo>
                <a:cubicBezTo>
                  <a:pt x="1138" y="2168"/>
                  <a:pt x="1143" y="2169"/>
                  <a:pt x="1148" y="2168"/>
                </a:cubicBezTo>
                <a:cubicBezTo>
                  <a:pt x="1153" y="2166"/>
                  <a:pt x="1159" y="2162"/>
                  <a:pt x="1165" y="2156"/>
                </a:cubicBezTo>
                <a:cubicBezTo>
                  <a:pt x="1170" y="2152"/>
                  <a:pt x="1175" y="2145"/>
                  <a:pt x="1182" y="2137"/>
                </a:cubicBezTo>
                <a:close/>
                <a:moveTo>
                  <a:pt x="1258" y="2134"/>
                </a:moveTo>
                <a:lnTo>
                  <a:pt x="1015" y="1891"/>
                </a:lnTo>
                <a:lnTo>
                  <a:pt x="1052" y="1853"/>
                </a:lnTo>
                <a:lnTo>
                  <a:pt x="1089" y="1890"/>
                </a:lnTo>
                <a:cubicBezTo>
                  <a:pt x="1081" y="1864"/>
                  <a:pt x="1078" y="1843"/>
                  <a:pt x="1081" y="1830"/>
                </a:cubicBezTo>
                <a:cubicBezTo>
                  <a:pt x="1083" y="1816"/>
                  <a:pt x="1089" y="1805"/>
                  <a:pt x="1099" y="1795"/>
                </a:cubicBezTo>
                <a:cubicBezTo>
                  <a:pt x="1113" y="1781"/>
                  <a:pt x="1131" y="1772"/>
                  <a:pt x="1155" y="1766"/>
                </a:cubicBezTo>
                <a:lnTo>
                  <a:pt x="1179" y="1819"/>
                </a:lnTo>
                <a:cubicBezTo>
                  <a:pt x="1163" y="1823"/>
                  <a:pt x="1150" y="1830"/>
                  <a:pt x="1140" y="1840"/>
                </a:cubicBezTo>
                <a:cubicBezTo>
                  <a:pt x="1131" y="1849"/>
                  <a:pt x="1125" y="1860"/>
                  <a:pt x="1123" y="1872"/>
                </a:cubicBezTo>
                <a:cubicBezTo>
                  <a:pt x="1122" y="1885"/>
                  <a:pt x="1124" y="1898"/>
                  <a:pt x="1131" y="1910"/>
                </a:cubicBezTo>
                <a:cubicBezTo>
                  <a:pt x="1141" y="1930"/>
                  <a:pt x="1154" y="1948"/>
                  <a:pt x="1172" y="1965"/>
                </a:cubicBezTo>
                <a:lnTo>
                  <a:pt x="1299" y="2093"/>
                </a:lnTo>
                <a:lnTo>
                  <a:pt x="1258" y="2134"/>
                </a:lnTo>
                <a:close/>
                <a:moveTo>
                  <a:pt x="1280" y="1869"/>
                </a:moveTo>
                <a:cubicBezTo>
                  <a:pt x="1235" y="1824"/>
                  <a:pt x="1214" y="1778"/>
                  <a:pt x="1217" y="1731"/>
                </a:cubicBezTo>
                <a:cubicBezTo>
                  <a:pt x="1220" y="1692"/>
                  <a:pt x="1237" y="1658"/>
                  <a:pt x="1267" y="1627"/>
                </a:cubicBezTo>
                <a:cubicBezTo>
                  <a:pt x="1300" y="1594"/>
                  <a:pt x="1339" y="1578"/>
                  <a:pt x="1382" y="1578"/>
                </a:cubicBezTo>
                <a:cubicBezTo>
                  <a:pt x="1425" y="1579"/>
                  <a:pt x="1466" y="1599"/>
                  <a:pt x="1504" y="1637"/>
                </a:cubicBezTo>
                <a:cubicBezTo>
                  <a:pt x="1536" y="1669"/>
                  <a:pt x="1556" y="1698"/>
                  <a:pt x="1564" y="1725"/>
                </a:cubicBezTo>
                <a:cubicBezTo>
                  <a:pt x="1573" y="1753"/>
                  <a:pt x="1573" y="1780"/>
                  <a:pt x="1565" y="1808"/>
                </a:cubicBezTo>
                <a:cubicBezTo>
                  <a:pt x="1557" y="1836"/>
                  <a:pt x="1542" y="1861"/>
                  <a:pt x="1521" y="1882"/>
                </a:cubicBezTo>
                <a:cubicBezTo>
                  <a:pt x="1487" y="1916"/>
                  <a:pt x="1449" y="1933"/>
                  <a:pt x="1406" y="1932"/>
                </a:cubicBezTo>
                <a:cubicBezTo>
                  <a:pt x="1363" y="1931"/>
                  <a:pt x="1321" y="1910"/>
                  <a:pt x="1280" y="1869"/>
                </a:cubicBezTo>
                <a:close/>
                <a:moveTo>
                  <a:pt x="1322" y="1826"/>
                </a:moveTo>
                <a:cubicBezTo>
                  <a:pt x="1353" y="1858"/>
                  <a:pt x="1384" y="1874"/>
                  <a:pt x="1413" y="1876"/>
                </a:cubicBezTo>
                <a:cubicBezTo>
                  <a:pt x="1442" y="1878"/>
                  <a:pt x="1467" y="1869"/>
                  <a:pt x="1487" y="1848"/>
                </a:cubicBezTo>
                <a:cubicBezTo>
                  <a:pt x="1508" y="1827"/>
                  <a:pt x="1517" y="1803"/>
                  <a:pt x="1515" y="1773"/>
                </a:cubicBezTo>
                <a:cubicBezTo>
                  <a:pt x="1513" y="1744"/>
                  <a:pt x="1496" y="1714"/>
                  <a:pt x="1464" y="1682"/>
                </a:cubicBezTo>
                <a:cubicBezTo>
                  <a:pt x="1434" y="1652"/>
                  <a:pt x="1404" y="1636"/>
                  <a:pt x="1375" y="1634"/>
                </a:cubicBezTo>
                <a:cubicBezTo>
                  <a:pt x="1346" y="1632"/>
                  <a:pt x="1321" y="1641"/>
                  <a:pt x="1301" y="1662"/>
                </a:cubicBezTo>
                <a:cubicBezTo>
                  <a:pt x="1280" y="1682"/>
                  <a:pt x="1271" y="1707"/>
                  <a:pt x="1273" y="1736"/>
                </a:cubicBezTo>
                <a:cubicBezTo>
                  <a:pt x="1275" y="1765"/>
                  <a:pt x="1291" y="1795"/>
                  <a:pt x="1322" y="1826"/>
                </a:cubicBezTo>
                <a:close/>
                <a:moveTo>
                  <a:pt x="1676" y="1716"/>
                </a:moveTo>
                <a:lnTo>
                  <a:pt x="1340" y="1380"/>
                </a:lnTo>
                <a:lnTo>
                  <a:pt x="1381" y="1339"/>
                </a:lnTo>
                <a:lnTo>
                  <a:pt x="1717" y="1675"/>
                </a:lnTo>
                <a:lnTo>
                  <a:pt x="1676" y="1716"/>
                </a:lnTo>
                <a:close/>
                <a:moveTo>
                  <a:pt x="1950" y="1362"/>
                </a:moveTo>
                <a:lnTo>
                  <a:pt x="1990" y="1402"/>
                </a:lnTo>
                <a:lnTo>
                  <a:pt x="1768" y="1624"/>
                </a:lnTo>
                <a:cubicBezTo>
                  <a:pt x="1758" y="1615"/>
                  <a:pt x="1750" y="1603"/>
                  <a:pt x="1744" y="1591"/>
                </a:cubicBezTo>
                <a:cubicBezTo>
                  <a:pt x="1735" y="1570"/>
                  <a:pt x="1729" y="1546"/>
                  <a:pt x="1726" y="1519"/>
                </a:cubicBezTo>
                <a:cubicBezTo>
                  <a:pt x="1724" y="1492"/>
                  <a:pt x="1725" y="1457"/>
                  <a:pt x="1730" y="1414"/>
                </a:cubicBezTo>
                <a:cubicBezTo>
                  <a:pt x="1736" y="1348"/>
                  <a:pt x="1737" y="1299"/>
                  <a:pt x="1732" y="1269"/>
                </a:cubicBezTo>
                <a:cubicBezTo>
                  <a:pt x="1728" y="1238"/>
                  <a:pt x="1718" y="1215"/>
                  <a:pt x="1702" y="1200"/>
                </a:cubicBezTo>
                <a:cubicBezTo>
                  <a:pt x="1686" y="1184"/>
                  <a:pt x="1666" y="1176"/>
                  <a:pt x="1643" y="1176"/>
                </a:cubicBezTo>
                <a:cubicBezTo>
                  <a:pt x="1620" y="1176"/>
                  <a:pt x="1599" y="1186"/>
                  <a:pt x="1581" y="1205"/>
                </a:cubicBezTo>
                <a:cubicBezTo>
                  <a:pt x="1561" y="1225"/>
                  <a:pt x="1551" y="1247"/>
                  <a:pt x="1551" y="1270"/>
                </a:cubicBezTo>
                <a:cubicBezTo>
                  <a:pt x="1551" y="1294"/>
                  <a:pt x="1561" y="1317"/>
                  <a:pt x="1582" y="1338"/>
                </a:cubicBezTo>
                <a:lnTo>
                  <a:pt x="1535" y="1376"/>
                </a:lnTo>
                <a:cubicBezTo>
                  <a:pt x="1507" y="1342"/>
                  <a:pt x="1493" y="1307"/>
                  <a:pt x="1496" y="1271"/>
                </a:cubicBezTo>
                <a:cubicBezTo>
                  <a:pt x="1498" y="1236"/>
                  <a:pt x="1515" y="1202"/>
                  <a:pt x="1547" y="1170"/>
                </a:cubicBezTo>
                <a:cubicBezTo>
                  <a:pt x="1580" y="1138"/>
                  <a:pt x="1614" y="1121"/>
                  <a:pt x="1651" y="1120"/>
                </a:cubicBezTo>
                <a:cubicBezTo>
                  <a:pt x="1687" y="1119"/>
                  <a:pt x="1719" y="1132"/>
                  <a:pt x="1745" y="1158"/>
                </a:cubicBezTo>
                <a:cubicBezTo>
                  <a:pt x="1759" y="1172"/>
                  <a:pt x="1769" y="1188"/>
                  <a:pt x="1777" y="1206"/>
                </a:cubicBezTo>
                <a:cubicBezTo>
                  <a:pt x="1784" y="1225"/>
                  <a:pt x="1789" y="1248"/>
                  <a:pt x="1790" y="1275"/>
                </a:cubicBezTo>
                <a:cubicBezTo>
                  <a:pt x="1792" y="1302"/>
                  <a:pt x="1791" y="1343"/>
                  <a:pt x="1786" y="1397"/>
                </a:cubicBezTo>
                <a:cubicBezTo>
                  <a:pt x="1782" y="1443"/>
                  <a:pt x="1780" y="1473"/>
                  <a:pt x="1781" y="1487"/>
                </a:cubicBezTo>
                <a:cubicBezTo>
                  <a:pt x="1781" y="1502"/>
                  <a:pt x="1783" y="1515"/>
                  <a:pt x="1786" y="1527"/>
                </a:cubicBezTo>
                <a:lnTo>
                  <a:pt x="1950" y="1362"/>
                </a:lnTo>
                <a:close/>
                <a:moveTo>
                  <a:pt x="1887" y="928"/>
                </a:moveTo>
                <a:lnTo>
                  <a:pt x="1839" y="881"/>
                </a:lnTo>
                <a:lnTo>
                  <a:pt x="1880" y="840"/>
                </a:lnTo>
                <a:lnTo>
                  <a:pt x="1928" y="887"/>
                </a:lnTo>
                <a:lnTo>
                  <a:pt x="1887" y="928"/>
                </a:lnTo>
                <a:close/>
                <a:moveTo>
                  <a:pt x="2175" y="1217"/>
                </a:moveTo>
                <a:lnTo>
                  <a:pt x="1932" y="973"/>
                </a:lnTo>
                <a:lnTo>
                  <a:pt x="1973" y="932"/>
                </a:lnTo>
                <a:lnTo>
                  <a:pt x="2216" y="1176"/>
                </a:lnTo>
                <a:lnTo>
                  <a:pt x="2175" y="1217"/>
                </a:lnTo>
                <a:close/>
                <a:moveTo>
                  <a:pt x="2288" y="1104"/>
                </a:moveTo>
                <a:lnTo>
                  <a:pt x="1952" y="768"/>
                </a:lnTo>
                <a:lnTo>
                  <a:pt x="2078" y="642"/>
                </a:lnTo>
                <a:cubicBezTo>
                  <a:pt x="2101" y="619"/>
                  <a:pt x="2119" y="603"/>
                  <a:pt x="2133" y="594"/>
                </a:cubicBezTo>
                <a:cubicBezTo>
                  <a:pt x="2152" y="580"/>
                  <a:pt x="2171" y="571"/>
                  <a:pt x="2190" y="568"/>
                </a:cubicBezTo>
                <a:cubicBezTo>
                  <a:pt x="2209" y="564"/>
                  <a:pt x="2229" y="566"/>
                  <a:pt x="2249" y="573"/>
                </a:cubicBezTo>
                <a:cubicBezTo>
                  <a:pt x="2270" y="580"/>
                  <a:pt x="2289" y="592"/>
                  <a:pt x="2305" y="609"/>
                </a:cubicBezTo>
                <a:cubicBezTo>
                  <a:pt x="2334" y="638"/>
                  <a:pt x="2349" y="671"/>
                  <a:pt x="2351" y="709"/>
                </a:cubicBezTo>
                <a:cubicBezTo>
                  <a:pt x="2352" y="747"/>
                  <a:pt x="2329" y="790"/>
                  <a:pt x="2282" y="837"/>
                </a:cubicBezTo>
                <a:lnTo>
                  <a:pt x="2196" y="923"/>
                </a:lnTo>
                <a:lnTo>
                  <a:pt x="2332" y="1060"/>
                </a:lnTo>
                <a:lnTo>
                  <a:pt x="2288" y="1104"/>
                </a:lnTo>
                <a:close/>
                <a:moveTo>
                  <a:pt x="2156" y="884"/>
                </a:moveTo>
                <a:lnTo>
                  <a:pt x="2243" y="797"/>
                </a:lnTo>
                <a:cubicBezTo>
                  <a:pt x="2271" y="768"/>
                  <a:pt x="2287" y="742"/>
                  <a:pt x="2288" y="719"/>
                </a:cubicBezTo>
                <a:cubicBezTo>
                  <a:pt x="2289" y="697"/>
                  <a:pt x="2280" y="676"/>
                  <a:pt x="2261" y="656"/>
                </a:cubicBezTo>
                <a:cubicBezTo>
                  <a:pt x="2247" y="642"/>
                  <a:pt x="2231" y="634"/>
                  <a:pt x="2214" y="631"/>
                </a:cubicBezTo>
                <a:cubicBezTo>
                  <a:pt x="2197" y="628"/>
                  <a:pt x="2181" y="631"/>
                  <a:pt x="2166" y="639"/>
                </a:cubicBezTo>
                <a:cubicBezTo>
                  <a:pt x="2157" y="645"/>
                  <a:pt x="2142" y="657"/>
                  <a:pt x="2122" y="678"/>
                </a:cubicBezTo>
                <a:lnTo>
                  <a:pt x="2036" y="764"/>
                </a:lnTo>
                <a:lnTo>
                  <a:pt x="2156" y="884"/>
                </a:lnTo>
                <a:close/>
                <a:moveTo>
                  <a:pt x="2476" y="700"/>
                </a:moveTo>
                <a:lnTo>
                  <a:pt x="2514" y="655"/>
                </a:lnTo>
                <a:cubicBezTo>
                  <a:pt x="2533" y="670"/>
                  <a:pt x="2551" y="679"/>
                  <a:pt x="2569" y="682"/>
                </a:cubicBezTo>
                <a:cubicBezTo>
                  <a:pt x="2587" y="686"/>
                  <a:pt x="2607" y="683"/>
                  <a:pt x="2629" y="675"/>
                </a:cubicBezTo>
                <a:cubicBezTo>
                  <a:pt x="2651" y="666"/>
                  <a:pt x="2672" y="652"/>
                  <a:pt x="2691" y="633"/>
                </a:cubicBezTo>
                <a:cubicBezTo>
                  <a:pt x="2708" y="616"/>
                  <a:pt x="2720" y="599"/>
                  <a:pt x="2728" y="581"/>
                </a:cubicBezTo>
                <a:cubicBezTo>
                  <a:pt x="2736" y="562"/>
                  <a:pt x="2739" y="546"/>
                  <a:pt x="2736" y="531"/>
                </a:cubicBezTo>
                <a:cubicBezTo>
                  <a:pt x="2734" y="516"/>
                  <a:pt x="2727" y="503"/>
                  <a:pt x="2717" y="492"/>
                </a:cubicBezTo>
                <a:cubicBezTo>
                  <a:pt x="2707" y="482"/>
                  <a:pt x="2694" y="476"/>
                  <a:pt x="2680" y="474"/>
                </a:cubicBezTo>
                <a:cubicBezTo>
                  <a:pt x="2666" y="472"/>
                  <a:pt x="2650" y="476"/>
                  <a:pt x="2630" y="484"/>
                </a:cubicBezTo>
                <a:cubicBezTo>
                  <a:pt x="2618" y="490"/>
                  <a:pt x="2592" y="504"/>
                  <a:pt x="2554" y="528"/>
                </a:cubicBezTo>
                <a:cubicBezTo>
                  <a:pt x="2516" y="551"/>
                  <a:pt x="2487" y="566"/>
                  <a:pt x="2468" y="572"/>
                </a:cubicBezTo>
                <a:cubicBezTo>
                  <a:pt x="2444" y="579"/>
                  <a:pt x="2421" y="581"/>
                  <a:pt x="2401" y="576"/>
                </a:cubicBezTo>
                <a:cubicBezTo>
                  <a:pt x="2381" y="572"/>
                  <a:pt x="2363" y="562"/>
                  <a:pt x="2347" y="546"/>
                </a:cubicBezTo>
                <a:cubicBezTo>
                  <a:pt x="2330" y="529"/>
                  <a:pt x="2319" y="509"/>
                  <a:pt x="2314" y="484"/>
                </a:cubicBezTo>
                <a:cubicBezTo>
                  <a:pt x="2309" y="460"/>
                  <a:pt x="2312" y="435"/>
                  <a:pt x="2323" y="409"/>
                </a:cubicBezTo>
                <a:cubicBezTo>
                  <a:pt x="2334" y="382"/>
                  <a:pt x="2350" y="358"/>
                  <a:pt x="2373" y="335"/>
                </a:cubicBezTo>
                <a:cubicBezTo>
                  <a:pt x="2398" y="311"/>
                  <a:pt x="2424" y="293"/>
                  <a:pt x="2451" y="282"/>
                </a:cubicBezTo>
                <a:cubicBezTo>
                  <a:pt x="2478" y="271"/>
                  <a:pt x="2504" y="268"/>
                  <a:pt x="2530" y="273"/>
                </a:cubicBezTo>
                <a:cubicBezTo>
                  <a:pt x="2556" y="278"/>
                  <a:pt x="2579" y="291"/>
                  <a:pt x="2600" y="310"/>
                </a:cubicBezTo>
                <a:lnTo>
                  <a:pt x="2560" y="355"/>
                </a:lnTo>
                <a:cubicBezTo>
                  <a:pt x="2537" y="336"/>
                  <a:pt x="2513" y="328"/>
                  <a:pt x="2489" y="331"/>
                </a:cubicBezTo>
                <a:cubicBezTo>
                  <a:pt x="2465" y="333"/>
                  <a:pt x="2440" y="347"/>
                  <a:pt x="2414" y="373"/>
                </a:cubicBezTo>
                <a:cubicBezTo>
                  <a:pt x="2387" y="400"/>
                  <a:pt x="2372" y="424"/>
                  <a:pt x="2370" y="446"/>
                </a:cubicBezTo>
                <a:cubicBezTo>
                  <a:pt x="2368" y="469"/>
                  <a:pt x="2373" y="487"/>
                  <a:pt x="2387" y="501"/>
                </a:cubicBezTo>
                <a:cubicBezTo>
                  <a:pt x="2399" y="513"/>
                  <a:pt x="2414" y="518"/>
                  <a:pt x="2430" y="517"/>
                </a:cubicBezTo>
                <a:cubicBezTo>
                  <a:pt x="2446" y="516"/>
                  <a:pt x="2477" y="502"/>
                  <a:pt x="2521" y="474"/>
                </a:cubicBezTo>
                <a:cubicBezTo>
                  <a:pt x="2565" y="446"/>
                  <a:pt x="2597" y="429"/>
                  <a:pt x="2617" y="421"/>
                </a:cubicBezTo>
                <a:cubicBezTo>
                  <a:pt x="2645" y="411"/>
                  <a:pt x="2671" y="408"/>
                  <a:pt x="2695" y="412"/>
                </a:cubicBezTo>
                <a:cubicBezTo>
                  <a:pt x="2718" y="417"/>
                  <a:pt x="2738" y="428"/>
                  <a:pt x="2756" y="446"/>
                </a:cubicBezTo>
                <a:cubicBezTo>
                  <a:pt x="2774" y="464"/>
                  <a:pt x="2786" y="486"/>
                  <a:pt x="2791" y="512"/>
                </a:cubicBezTo>
                <a:cubicBezTo>
                  <a:pt x="2797" y="538"/>
                  <a:pt x="2795" y="565"/>
                  <a:pt x="2784" y="593"/>
                </a:cubicBezTo>
                <a:cubicBezTo>
                  <a:pt x="2774" y="621"/>
                  <a:pt x="2757" y="647"/>
                  <a:pt x="2733" y="671"/>
                </a:cubicBezTo>
                <a:cubicBezTo>
                  <a:pt x="2702" y="701"/>
                  <a:pt x="2672" y="722"/>
                  <a:pt x="2643" y="734"/>
                </a:cubicBezTo>
                <a:cubicBezTo>
                  <a:pt x="2614" y="746"/>
                  <a:pt x="2584" y="748"/>
                  <a:pt x="2555" y="742"/>
                </a:cubicBezTo>
                <a:cubicBezTo>
                  <a:pt x="2525" y="736"/>
                  <a:pt x="2499" y="722"/>
                  <a:pt x="2476" y="700"/>
                </a:cubicBezTo>
                <a:close/>
                <a:moveTo>
                  <a:pt x="3054" y="338"/>
                </a:moveTo>
                <a:lnTo>
                  <a:pt x="3013" y="379"/>
                </a:lnTo>
                <a:lnTo>
                  <a:pt x="2750" y="116"/>
                </a:lnTo>
                <a:cubicBezTo>
                  <a:pt x="2750" y="136"/>
                  <a:pt x="2746" y="158"/>
                  <a:pt x="2739" y="184"/>
                </a:cubicBezTo>
                <a:cubicBezTo>
                  <a:pt x="2733" y="209"/>
                  <a:pt x="2725" y="231"/>
                  <a:pt x="2717" y="248"/>
                </a:cubicBezTo>
                <a:lnTo>
                  <a:pt x="2677" y="208"/>
                </a:lnTo>
                <a:cubicBezTo>
                  <a:pt x="2690" y="175"/>
                  <a:pt x="2697" y="141"/>
                  <a:pt x="2698" y="109"/>
                </a:cubicBezTo>
                <a:cubicBezTo>
                  <a:pt x="2700" y="76"/>
                  <a:pt x="2698" y="49"/>
                  <a:pt x="2690" y="27"/>
                </a:cubicBezTo>
                <a:lnTo>
                  <a:pt x="2717" y="0"/>
                </a:lnTo>
                <a:lnTo>
                  <a:pt x="3054" y="338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8" name="Freeform 64"/>
          <p:cNvSpPr>
            <a:spLocks noEditPoints="1"/>
          </p:cNvSpPr>
          <p:nvPr/>
        </p:nvSpPr>
        <p:spPr bwMode="auto">
          <a:xfrm>
            <a:off x="1327292" y="5034102"/>
            <a:ext cx="593725" cy="584200"/>
          </a:xfrm>
          <a:custGeom>
            <a:avLst/>
            <a:gdLst>
              <a:gd name="T0" fmla="*/ 419 w 3116"/>
              <a:gd name="T1" fmla="*/ 2992 h 3066"/>
              <a:gd name="T2" fmla="*/ 13 w 3116"/>
              <a:gd name="T3" fmla="*/ 2862 h 3066"/>
              <a:gd name="T4" fmla="*/ 303 w 3116"/>
              <a:gd name="T5" fmla="*/ 2608 h 3066"/>
              <a:gd name="T6" fmla="*/ 63 w 3116"/>
              <a:gd name="T7" fmla="*/ 2766 h 3066"/>
              <a:gd name="T8" fmla="*/ 304 w 3116"/>
              <a:gd name="T9" fmla="*/ 2998 h 3066"/>
              <a:gd name="T10" fmla="*/ 465 w 3116"/>
              <a:gd name="T11" fmla="*/ 2690 h 3066"/>
              <a:gd name="T12" fmla="*/ 690 w 3116"/>
              <a:gd name="T13" fmla="*/ 2459 h 3066"/>
              <a:gd name="T14" fmla="*/ 591 w 3116"/>
              <a:gd name="T15" fmla="*/ 2753 h 3066"/>
              <a:gd name="T16" fmla="*/ 673 w 3116"/>
              <a:gd name="T17" fmla="*/ 2670 h 3066"/>
              <a:gd name="T18" fmla="*/ 486 w 3116"/>
              <a:gd name="T19" fmla="*/ 2483 h 3066"/>
              <a:gd name="T20" fmla="*/ 625 w 3116"/>
              <a:gd name="T21" fmla="*/ 2287 h 3066"/>
              <a:gd name="T22" fmla="*/ 782 w 3116"/>
              <a:gd name="T23" fmla="*/ 2135 h 3066"/>
              <a:gd name="T24" fmla="*/ 1066 w 3116"/>
              <a:gd name="T25" fmla="*/ 2333 h 3066"/>
              <a:gd name="T26" fmla="*/ 797 w 3116"/>
              <a:gd name="T27" fmla="*/ 2190 h 3066"/>
              <a:gd name="T28" fmla="*/ 909 w 3116"/>
              <a:gd name="T29" fmla="*/ 2490 h 3066"/>
              <a:gd name="T30" fmla="*/ 1196 w 3116"/>
              <a:gd name="T31" fmla="*/ 2209 h 3066"/>
              <a:gd name="T32" fmla="*/ 924 w 3116"/>
              <a:gd name="T33" fmla="*/ 2052 h 3066"/>
              <a:gd name="T34" fmla="*/ 832 w 3116"/>
              <a:gd name="T35" fmla="*/ 1959 h 3066"/>
              <a:gd name="T36" fmla="*/ 1007 w 3116"/>
              <a:gd name="T37" fmla="*/ 1969 h 3066"/>
              <a:gd name="T38" fmla="*/ 1148 w 3116"/>
              <a:gd name="T39" fmla="*/ 2175 h 3066"/>
              <a:gd name="T40" fmla="*/ 1014 w 3116"/>
              <a:gd name="T41" fmla="*/ 1898 h 3066"/>
              <a:gd name="T42" fmla="*/ 1099 w 3116"/>
              <a:gd name="T43" fmla="*/ 1802 h 3066"/>
              <a:gd name="T44" fmla="*/ 1123 w 3116"/>
              <a:gd name="T45" fmla="*/ 1879 h 3066"/>
              <a:gd name="T46" fmla="*/ 1258 w 3116"/>
              <a:gd name="T47" fmla="*/ 2141 h 3066"/>
              <a:gd name="T48" fmla="*/ 1382 w 3116"/>
              <a:gd name="T49" fmla="*/ 1585 h 3066"/>
              <a:gd name="T50" fmla="*/ 1521 w 3116"/>
              <a:gd name="T51" fmla="*/ 1889 h 3066"/>
              <a:gd name="T52" fmla="*/ 1413 w 3116"/>
              <a:gd name="T53" fmla="*/ 1883 h 3066"/>
              <a:gd name="T54" fmla="*/ 1375 w 3116"/>
              <a:gd name="T55" fmla="*/ 1641 h 3066"/>
              <a:gd name="T56" fmla="*/ 1676 w 3116"/>
              <a:gd name="T57" fmla="*/ 1723 h 3066"/>
              <a:gd name="T58" fmla="*/ 1676 w 3116"/>
              <a:gd name="T59" fmla="*/ 1723 h 3066"/>
              <a:gd name="T60" fmla="*/ 1744 w 3116"/>
              <a:gd name="T61" fmla="*/ 1598 h 3066"/>
              <a:gd name="T62" fmla="*/ 1702 w 3116"/>
              <a:gd name="T63" fmla="*/ 1207 h 3066"/>
              <a:gd name="T64" fmla="*/ 1582 w 3116"/>
              <a:gd name="T65" fmla="*/ 1345 h 3066"/>
              <a:gd name="T66" fmla="*/ 1651 w 3116"/>
              <a:gd name="T67" fmla="*/ 1127 h 3066"/>
              <a:gd name="T68" fmla="*/ 1786 w 3116"/>
              <a:gd name="T69" fmla="*/ 1404 h 3066"/>
              <a:gd name="T70" fmla="*/ 1886 w 3116"/>
              <a:gd name="T71" fmla="*/ 935 h 3066"/>
              <a:gd name="T72" fmla="*/ 1886 w 3116"/>
              <a:gd name="T73" fmla="*/ 935 h 3066"/>
              <a:gd name="T74" fmla="*/ 2216 w 3116"/>
              <a:gd name="T75" fmla="*/ 1183 h 3066"/>
              <a:gd name="T76" fmla="*/ 2078 w 3116"/>
              <a:gd name="T77" fmla="*/ 649 h 3066"/>
              <a:gd name="T78" fmla="*/ 2305 w 3116"/>
              <a:gd name="T79" fmla="*/ 616 h 3066"/>
              <a:gd name="T80" fmla="*/ 2332 w 3116"/>
              <a:gd name="T81" fmla="*/ 1067 h 3066"/>
              <a:gd name="T82" fmla="*/ 2288 w 3116"/>
              <a:gd name="T83" fmla="*/ 726 h 3066"/>
              <a:gd name="T84" fmla="*/ 2122 w 3116"/>
              <a:gd name="T85" fmla="*/ 685 h 3066"/>
              <a:gd name="T86" fmla="*/ 2514 w 3116"/>
              <a:gd name="T87" fmla="*/ 662 h 3066"/>
              <a:gd name="T88" fmla="*/ 2728 w 3116"/>
              <a:gd name="T89" fmla="*/ 588 h 3066"/>
              <a:gd name="T90" fmla="*/ 2630 w 3116"/>
              <a:gd name="T91" fmla="*/ 491 h 3066"/>
              <a:gd name="T92" fmla="*/ 2347 w 3116"/>
              <a:gd name="T93" fmla="*/ 553 h 3066"/>
              <a:gd name="T94" fmla="*/ 2451 w 3116"/>
              <a:gd name="T95" fmla="*/ 289 h 3066"/>
              <a:gd name="T96" fmla="*/ 2489 w 3116"/>
              <a:gd name="T97" fmla="*/ 338 h 3066"/>
              <a:gd name="T98" fmla="*/ 2430 w 3116"/>
              <a:gd name="T99" fmla="*/ 524 h 3066"/>
              <a:gd name="T100" fmla="*/ 2756 w 3116"/>
              <a:gd name="T101" fmla="*/ 453 h 3066"/>
              <a:gd name="T102" fmla="*/ 2643 w 3116"/>
              <a:gd name="T103" fmla="*/ 741 h 3066"/>
              <a:gd name="T104" fmla="*/ 3116 w 3116"/>
              <a:gd name="T105" fmla="*/ 283 h 3066"/>
              <a:gd name="T106" fmla="*/ 2855 w 3116"/>
              <a:gd name="T107" fmla="*/ 295 h 3066"/>
              <a:gd name="T108" fmla="*/ 2706 w 3116"/>
              <a:gd name="T109" fmla="*/ 86 h 3066"/>
              <a:gd name="T110" fmla="*/ 2621 w 3116"/>
              <a:gd name="T111" fmla="*/ 152 h 3066"/>
              <a:gd name="T112" fmla="*/ 2902 w 3116"/>
              <a:gd name="T113" fmla="*/ 88 h 3066"/>
              <a:gd name="T114" fmla="*/ 2911 w 3116"/>
              <a:gd name="T115" fmla="*/ 409 h 306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</a:cxnLst>
            <a:rect l="0" t="0" r="r" b="b"/>
            <a:pathLst>
              <a:path w="3116" h="3066">
                <a:moveTo>
                  <a:pt x="390" y="2773"/>
                </a:moveTo>
                <a:lnTo>
                  <a:pt x="446" y="2740"/>
                </a:lnTo>
                <a:cubicBezTo>
                  <a:pt x="473" y="2786"/>
                  <a:pt x="484" y="2831"/>
                  <a:pt x="479" y="2874"/>
                </a:cubicBezTo>
                <a:cubicBezTo>
                  <a:pt x="474" y="2917"/>
                  <a:pt x="454" y="2957"/>
                  <a:pt x="419" y="2992"/>
                </a:cubicBezTo>
                <a:cubicBezTo>
                  <a:pt x="383" y="3028"/>
                  <a:pt x="346" y="3050"/>
                  <a:pt x="308" y="3058"/>
                </a:cubicBezTo>
                <a:cubicBezTo>
                  <a:pt x="271" y="3066"/>
                  <a:pt x="232" y="3062"/>
                  <a:pt x="192" y="3046"/>
                </a:cubicBezTo>
                <a:cubicBezTo>
                  <a:pt x="153" y="3029"/>
                  <a:pt x="117" y="3005"/>
                  <a:pt x="85" y="2973"/>
                </a:cubicBezTo>
                <a:cubicBezTo>
                  <a:pt x="50" y="2938"/>
                  <a:pt x="26" y="2901"/>
                  <a:pt x="13" y="2862"/>
                </a:cubicBezTo>
                <a:cubicBezTo>
                  <a:pt x="0" y="2822"/>
                  <a:pt x="0" y="2783"/>
                  <a:pt x="11" y="2745"/>
                </a:cubicBezTo>
                <a:cubicBezTo>
                  <a:pt x="22" y="2707"/>
                  <a:pt x="42" y="2673"/>
                  <a:pt x="72" y="2643"/>
                </a:cubicBezTo>
                <a:cubicBezTo>
                  <a:pt x="106" y="2610"/>
                  <a:pt x="142" y="2590"/>
                  <a:pt x="183" y="2584"/>
                </a:cubicBezTo>
                <a:cubicBezTo>
                  <a:pt x="223" y="2578"/>
                  <a:pt x="263" y="2586"/>
                  <a:pt x="303" y="2608"/>
                </a:cubicBezTo>
                <a:lnTo>
                  <a:pt x="269" y="2663"/>
                </a:lnTo>
                <a:cubicBezTo>
                  <a:pt x="237" y="2646"/>
                  <a:pt x="208" y="2639"/>
                  <a:pt x="182" y="2643"/>
                </a:cubicBezTo>
                <a:cubicBezTo>
                  <a:pt x="156" y="2647"/>
                  <a:pt x="132" y="2660"/>
                  <a:pt x="109" y="2682"/>
                </a:cubicBezTo>
                <a:cubicBezTo>
                  <a:pt x="83" y="2708"/>
                  <a:pt x="68" y="2736"/>
                  <a:pt x="63" y="2766"/>
                </a:cubicBezTo>
                <a:cubicBezTo>
                  <a:pt x="58" y="2795"/>
                  <a:pt x="62" y="2824"/>
                  <a:pt x="76" y="2852"/>
                </a:cubicBezTo>
                <a:cubicBezTo>
                  <a:pt x="90" y="2880"/>
                  <a:pt x="108" y="2905"/>
                  <a:pt x="130" y="2927"/>
                </a:cubicBezTo>
                <a:cubicBezTo>
                  <a:pt x="159" y="2956"/>
                  <a:pt x="188" y="2976"/>
                  <a:pt x="218" y="2989"/>
                </a:cubicBezTo>
                <a:cubicBezTo>
                  <a:pt x="247" y="3002"/>
                  <a:pt x="276" y="3005"/>
                  <a:pt x="304" y="2998"/>
                </a:cubicBezTo>
                <a:cubicBezTo>
                  <a:pt x="332" y="2991"/>
                  <a:pt x="357" y="2978"/>
                  <a:pt x="377" y="2957"/>
                </a:cubicBezTo>
                <a:cubicBezTo>
                  <a:pt x="402" y="2932"/>
                  <a:pt x="416" y="2904"/>
                  <a:pt x="419" y="2872"/>
                </a:cubicBezTo>
                <a:cubicBezTo>
                  <a:pt x="422" y="2841"/>
                  <a:pt x="412" y="2808"/>
                  <a:pt x="390" y="2773"/>
                </a:cubicBezTo>
                <a:close/>
                <a:moveTo>
                  <a:pt x="465" y="2690"/>
                </a:moveTo>
                <a:cubicBezTo>
                  <a:pt x="420" y="2645"/>
                  <a:pt x="399" y="2599"/>
                  <a:pt x="402" y="2553"/>
                </a:cubicBezTo>
                <a:cubicBezTo>
                  <a:pt x="405" y="2514"/>
                  <a:pt x="422" y="2479"/>
                  <a:pt x="452" y="2449"/>
                </a:cubicBezTo>
                <a:cubicBezTo>
                  <a:pt x="485" y="2416"/>
                  <a:pt x="524" y="2399"/>
                  <a:pt x="567" y="2400"/>
                </a:cubicBezTo>
                <a:cubicBezTo>
                  <a:pt x="610" y="2400"/>
                  <a:pt x="651" y="2420"/>
                  <a:pt x="690" y="2459"/>
                </a:cubicBezTo>
                <a:cubicBezTo>
                  <a:pt x="721" y="2490"/>
                  <a:pt x="741" y="2520"/>
                  <a:pt x="750" y="2547"/>
                </a:cubicBezTo>
                <a:cubicBezTo>
                  <a:pt x="758" y="2574"/>
                  <a:pt x="758" y="2602"/>
                  <a:pt x="750" y="2630"/>
                </a:cubicBezTo>
                <a:cubicBezTo>
                  <a:pt x="742" y="2658"/>
                  <a:pt x="728" y="2682"/>
                  <a:pt x="706" y="2703"/>
                </a:cubicBezTo>
                <a:cubicBezTo>
                  <a:pt x="672" y="2738"/>
                  <a:pt x="634" y="2754"/>
                  <a:pt x="591" y="2753"/>
                </a:cubicBezTo>
                <a:cubicBezTo>
                  <a:pt x="548" y="2752"/>
                  <a:pt x="506" y="2732"/>
                  <a:pt x="465" y="2690"/>
                </a:cubicBezTo>
                <a:close/>
                <a:moveTo>
                  <a:pt x="507" y="2648"/>
                </a:moveTo>
                <a:cubicBezTo>
                  <a:pt x="539" y="2679"/>
                  <a:pt x="569" y="2696"/>
                  <a:pt x="598" y="2698"/>
                </a:cubicBezTo>
                <a:cubicBezTo>
                  <a:pt x="627" y="2700"/>
                  <a:pt x="652" y="2690"/>
                  <a:pt x="673" y="2670"/>
                </a:cubicBezTo>
                <a:cubicBezTo>
                  <a:pt x="693" y="2649"/>
                  <a:pt x="702" y="2624"/>
                  <a:pt x="700" y="2595"/>
                </a:cubicBezTo>
                <a:cubicBezTo>
                  <a:pt x="698" y="2566"/>
                  <a:pt x="681" y="2535"/>
                  <a:pt x="649" y="2503"/>
                </a:cubicBezTo>
                <a:cubicBezTo>
                  <a:pt x="619" y="2473"/>
                  <a:pt x="590" y="2457"/>
                  <a:pt x="560" y="2455"/>
                </a:cubicBezTo>
                <a:cubicBezTo>
                  <a:pt x="531" y="2454"/>
                  <a:pt x="506" y="2463"/>
                  <a:pt x="486" y="2483"/>
                </a:cubicBezTo>
                <a:cubicBezTo>
                  <a:pt x="466" y="2504"/>
                  <a:pt x="456" y="2529"/>
                  <a:pt x="458" y="2558"/>
                </a:cubicBezTo>
                <a:cubicBezTo>
                  <a:pt x="460" y="2587"/>
                  <a:pt x="476" y="2617"/>
                  <a:pt x="507" y="2648"/>
                </a:cubicBezTo>
                <a:close/>
                <a:moveTo>
                  <a:pt x="868" y="2531"/>
                </a:moveTo>
                <a:lnTo>
                  <a:pt x="625" y="2287"/>
                </a:lnTo>
                <a:lnTo>
                  <a:pt x="662" y="2250"/>
                </a:lnTo>
                <a:lnTo>
                  <a:pt x="696" y="2285"/>
                </a:lnTo>
                <a:cubicBezTo>
                  <a:pt x="687" y="2240"/>
                  <a:pt x="700" y="2201"/>
                  <a:pt x="734" y="2167"/>
                </a:cubicBezTo>
                <a:cubicBezTo>
                  <a:pt x="748" y="2153"/>
                  <a:pt x="764" y="2142"/>
                  <a:pt x="782" y="2135"/>
                </a:cubicBezTo>
                <a:cubicBezTo>
                  <a:pt x="800" y="2128"/>
                  <a:pt x="816" y="2125"/>
                  <a:pt x="830" y="2128"/>
                </a:cubicBezTo>
                <a:cubicBezTo>
                  <a:pt x="845" y="2130"/>
                  <a:pt x="860" y="2136"/>
                  <a:pt x="874" y="2146"/>
                </a:cubicBezTo>
                <a:cubicBezTo>
                  <a:pt x="883" y="2152"/>
                  <a:pt x="897" y="2164"/>
                  <a:pt x="916" y="2183"/>
                </a:cubicBezTo>
                <a:lnTo>
                  <a:pt x="1066" y="2333"/>
                </a:lnTo>
                <a:lnTo>
                  <a:pt x="1025" y="2374"/>
                </a:lnTo>
                <a:lnTo>
                  <a:pt x="877" y="2226"/>
                </a:lnTo>
                <a:cubicBezTo>
                  <a:pt x="860" y="2209"/>
                  <a:pt x="846" y="2198"/>
                  <a:pt x="834" y="2193"/>
                </a:cubicBezTo>
                <a:cubicBezTo>
                  <a:pt x="822" y="2188"/>
                  <a:pt x="810" y="2187"/>
                  <a:pt x="797" y="2190"/>
                </a:cubicBezTo>
                <a:cubicBezTo>
                  <a:pt x="784" y="2194"/>
                  <a:pt x="772" y="2201"/>
                  <a:pt x="761" y="2212"/>
                </a:cubicBezTo>
                <a:cubicBezTo>
                  <a:pt x="743" y="2229"/>
                  <a:pt x="734" y="2250"/>
                  <a:pt x="732" y="2274"/>
                </a:cubicBezTo>
                <a:cubicBezTo>
                  <a:pt x="730" y="2298"/>
                  <a:pt x="745" y="2325"/>
                  <a:pt x="776" y="2357"/>
                </a:cubicBezTo>
                <a:lnTo>
                  <a:pt x="909" y="2490"/>
                </a:lnTo>
                <a:lnTo>
                  <a:pt x="868" y="2531"/>
                </a:lnTo>
                <a:close/>
                <a:moveTo>
                  <a:pt x="1181" y="2144"/>
                </a:moveTo>
                <a:lnTo>
                  <a:pt x="1224" y="2174"/>
                </a:lnTo>
                <a:cubicBezTo>
                  <a:pt x="1215" y="2188"/>
                  <a:pt x="1206" y="2200"/>
                  <a:pt x="1196" y="2209"/>
                </a:cubicBezTo>
                <a:cubicBezTo>
                  <a:pt x="1181" y="2224"/>
                  <a:pt x="1167" y="2233"/>
                  <a:pt x="1154" y="2237"/>
                </a:cubicBezTo>
                <a:cubicBezTo>
                  <a:pt x="1141" y="2240"/>
                  <a:pt x="1129" y="2240"/>
                  <a:pt x="1118" y="2235"/>
                </a:cubicBezTo>
                <a:cubicBezTo>
                  <a:pt x="1107" y="2231"/>
                  <a:pt x="1089" y="2217"/>
                  <a:pt x="1065" y="2192"/>
                </a:cubicBezTo>
                <a:lnTo>
                  <a:pt x="924" y="2052"/>
                </a:lnTo>
                <a:lnTo>
                  <a:pt x="894" y="2082"/>
                </a:lnTo>
                <a:lnTo>
                  <a:pt x="862" y="2050"/>
                </a:lnTo>
                <a:lnTo>
                  <a:pt x="892" y="2020"/>
                </a:lnTo>
                <a:lnTo>
                  <a:pt x="832" y="1959"/>
                </a:lnTo>
                <a:lnTo>
                  <a:pt x="848" y="1894"/>
                </a:lnTo>
                <a:lnTo>
                  <a:pt x="933" y="1979"/>
                </a:lnTo>
                <a:lnTo>
                  <a:pt x="975" y="1937"/>
                </a:lnTo>
                <a:lnTo>
                  <a:pt x="1007" y="1969"/>
                </a:lnTo>
                <a:lnTo>
                  <a:pt x="965" y="2011"/>
                </a:lnTo>
                <a:lnTo>
                  <a:pt x="1108" y="2153"/>
                </a:lnTo>
                <a:cubicBezTo>
                  <a:pt x="1120" y="2165"/>
                  <a:pt x="1128" y="2172"/>
                  <a:pt x="1133" y="2174"/>
                </a:cubicBezTo>
                <a:cubicBezTo>
                  <a:pt x="1138" y="2175"/>
                  <a:pt x="1143" y="2176"/>
                  <a:pt x="1148" y="2175"/>
                </a:cubicBezTo>
                <a:cubicBezTo>
                  <a:pt x="1153" y="2173"/>
                  <a:pt x="1159" y="2169"/>
                  <a:pt x="1165" y="2163"/>
                </a:cubicBezTo>
                <a:cubicBezTo>
                  <a:pt x="1170" y="2159"/>
                  <a:pt x="1175" y="2152"/>
                  <a:pt x="1181" y="2144"/>
                </a:cubicBezTo>
                <a:close/>
                <a:moveTo>
                  <a:pt x="1258" y="2141"/>
                </a:moveTo>
                <a:lnTo>
                  <a:pt x="1014" y="1898"/>
                </a:lnTo>
                <a:lnTo>
                  <a:pt x="1052" y="1860"/>
                </a:lnTo>
                <a:lnTo>
                  <a:pt x="1088" y="1897"/>
                </a:lnTo>
                <a:cubicBezTo>
                  <a:pt x="1081" y="1871"/>
                  <a:pt x="1078" y="1850"/>
                  <a:pt x="1081" y="1837"/>
                </a:cubicBezTo>
                <a:cubicBezTo>
                  <a:pt x="1083" y="1823"/>
                  <a:pt x="1089" y="1812"/>
                  <a:pt x="1099" y="1802"/>
                </a:cubicBezTo>
                <a:cubicBezTo>
                  <a:pt x="1113" y="1788"/>
                  <a:pt x="1131" y="1779"/>
                  <a:pt x="1155" y="1773"/>
                </a:cubicBezTo>
                <a:lnTo>
                  <a:pt x="1179" y="1826"/>
                </a:lnTo>
                <a:cubicBezTo>
                  <a:pt x="1163" y="1830"/>
                  <a:pt x="1149" y="1837"/>
                  <a:pt x="1139" y="1847"/>
                </a:cubicBezTo>
                <a:cubicBezTo>
                  <a:pt x="1130" y="1856"/>
                  <a:pt x="1125" y="1867"/>
                  <a:pt x="1123" y="1879"/>
                </a:cubicBezTo>
                <a:cubicBezTo>
                  <a:pt x="1121" y="1892"/>
                  <a:pt x="1124" y="1905"/>
                  <a:pt x="1130" y="1917"/>
                </a:cubicBezTo>
                <a:cubicBezTo>
                  <a:pt x="1141" y="1937"/>
                  <a:pt x="1154" y="1955"/>
                  <a:pt x="1172" y="1972"/>
                </a:cubicBezTo>
                <a:lnTo>
                  <a:pt x="1299" y="2100"/>
                </a:lnTo>
                <a:lnTo>
                  <a:pt x="1258" y="2141"/>
                </a:lnTo>
                <a:close/>
                <a:moveTo>
                  <a:pt x="1280" y="1876"/>
                </a:moveTo>
                <a:cubicBezTo>
                  <a:pt x="1235" y="1831"/>
                  <a:pt x="1214" y="1785"/>
                  <a:pt x="1217" y="1738"/>
                </a:cubicBezTo>
                <a:cubicBezTo>
                  <a:pt x="1220" y="1699"/>
                  <a:pt x="1236" y="1665"/>
                  <a:pt x="1267" y="1634"/>
                </a:cubicBezTo>
                <a:cubicBezTo>
                  <a:pt x="1300" y="1601"/>
                  <a:pt x="1338" y="1585"/>
                  <a:pt x="1382" y="1585"/>
                </a:cubicBezTo>
                <a:cubicBezTo>
                  <a:pt x="1425" y="1586"/>
                  <a:pt x="1466" y="1606"/>
                  <a:pt x="1504" y="1644"/>
                </a:cubicBezTo>
                <a:cubicBezTo>
                  <a:pt x="1536" y="1676"/>
                  <a:pt x="1556" y="1705"/>
                  <a:pt x="1564" y="1732"/>
                </a:cubicBezTo>
                <a:cubicBezTo>
                  <a:pt x="1573" y="1760"/>
                  <a:pt x="1573" y="1787"/>
                  <a:pt x="1565" y="1815"/>
                </a:cubicBezTo>
                <a:cubicBezTo>
                  <a:pt x="1557" y="1843"/>
                  <a:pt x="1542" y="1868"/>
                  <a:pt x="1521" y="1889"/>
                </a:cubicBezTo>
                <a:cubicBezTo>
                  <a:pt x="1487" y="1923"/>
                  <a:pt x="1449" y="1940"/>
                  <a:pt x="1406" y="1939"/>
                </a:cubicBezTo>
                <a:cubicBezTo>
                  <a:pt x="1363" y="1938"/>
                  <a:pt x="1321" y="1917"/>
                  <a:pt x="1280" y="1876"/>
                </a:cubicBezTo>
                <a:close/>
                <a:moveTo>
                  <a:pt x="1322" y="1833"/>
                </a:moveTo>
                <a:cubicBezTo>
                  <a:pt x="1353" y="1865"/>
                  <a:pt x="1383" y="1881"/>
                  <a:pt x="1413" y="1883"/>
                </a:cubicBezTo>
                <a:cubicBezTo>
                  <a:pt x="1442" y="1885"/>
                  <a:pt x="1467" y="1876"/>
                  <a:pt x="1487" y="1855"/>
                </a:cubicBezTo>
                <a:cubicBezTo>
                  <a:pt x="1508" y="1834"/>
                  <a:pt x="1517" y="1810"/>
                  <a:pt x="1515" y="1780"/>
                </a:cubicBezTo>
                <a:cubicBezTo>
                  <a:pt x="1513" y="1751"/>
                  <a:pt x="1496" y="1721"/>
                  <a:pt x="1464" y="1689"/>
                </a:cubicBezTo>
                <a:cubicBezTo>
                  <a:pt x="1434" y="1659"/>
                  <a:pt x="1404" y="1643"/>
                  <a:pt x="1375" y="1641"/>
                </a:cubicBezTo>
                <a:cubicBezTo>
                  <a:pt x="1346" y="1639"/>
                  <a:pt x="1321" y="1648"/>
                  <a:pt x="1301" y="1669"/>
                </a:cubicBezTo>
                <a:cubicBezTo>
                  <a:pt x="1280" y="1689"/>
                  <a:pt x="1271" y="1714"/>
                  <a:pt x="1273" y="1743"/>
                </a:cubicBezTo>
                <a:cubicBezTo>
                  <a:pt x="1274" y="1772"/>
                  <a:pt x="1291" y="1802"/>
                  <a:pt x="1322" y="1833"/>
                </a:cubicBezTo>
                <a:close/>
                <a:moveTo>
                  <a:pt x="1676" y="1723"/>
                </a:moveTo>
                <a:lnTo>
                  <a:pt x="1340" y="1387"/>
                </a:lnTo>
                <a:lnTo>
                  <a:pt x="1381" y="1346"/>
                </a:lnTo>
                <a:lnTo>
                  <a:pt x="1717" y="1682"/>
                </a:lnTo>
                <a:lnTo>
                  <a:pt x="1676" y="1723"/>
                </a:lnTo>
                <a:close/>
                <a:moveTo>
                  <a:pt x="1950" y="1369"/>
                </a:moveTo>
                <a:lnTo>
                  <a:pt x="1990" y="1409"/>
                </a:lnTo>
                <a:lnTo>
                  <a:pt x="1768" y="1631"/>
                </a:lnTo>
                <a:cubicBezTo>
                  <a:pt x="1757" y="1622"/>
                  <a:pt x="1750" y="1610"/>
                  <a:pt x="1744" y="1598"/>
                </a:cubicBezTo>
                <a:cubicBezTo>
                  <a:pt x="1734" y="1577"/>
                  <a:pt x="1729" y="1553"/>
                  <a:pt x="1726" y="1526"/>
                </a:cubicBezTo>
                <a:cubicBezTo>
                  <a:pt x="1724" y="1499"/>
                  <a:pt x="1725" y="1464"/>
                  <a:pt x="1729" y="1421"/>
                </a:cubicBezTo>
                <a:cubicBezTo>
                  <a:pt x="1736" y="1355"/>
                  <a:pt x="1737" y="1306"/>
                  <a:pt x="1732" y="1276"/>
                </a:cubicBezTo>
                <a:cubicBezTo>
                  <a:pt x="1728" y="1245"/>
                  <a:pt x="1718" y="1222"/>
                  <a:pt x="1702" y="1207"/>
                </a:cubicBezTo>
                <a:cubicBezTo>
                  <a:pt x="1686" y="1191"/>
                  <a:pt x="1666" y="1183"/>
                  <a:pt x="1643" y="1183"/>
                </a:cubicBezTo>
                <a:cubicBezTo>
                  <a:pt x="1620" y="1183"/>
                  <a:pt x="1599" y="1193"/>
                  <a:pt x="1580" y="1212"/>
                </a:cubicBezTo>
                <a:cubicBezTo>
                  <a:pt x="1561" y="1232"/>
                  <a:pt x="1551" y="1254"/>
                  <a:pt x="1551" y="1277"/>
                </a:cubicBezTo>
                <a:cubicBezTo>
                  <a:pt x="1551" y="1301"/>
                  <a:pt x="1561" y="1324"/>
                  <a:pt x="1582" y="1345"/>
                </a:cubicBezTo>
                <a:lnTo>
                  <a:pt x="1535" y="1383"/>
                </a:lnTo>
                <a:cubicBezTo>
                  <a:pt x="1507" y="1349"/>
                  <a:pt x="1493" y="1314"/>
                  <a:pt x="1496" y="1278"/>
                </a:cubicBezTo>
                <a:cubicBezTo>
                  <a:pt x="1498" y="1243"/>
                  <a:pt x="1515" y="1209"/>
                  <a:pt x="1547" y="1177"/>
                </a:cubicBezTo>
                <a:cubicBezTo>
                  <a:pt x="1579" y="1145"/>
                  <a:pt x="1614" y="1128"/>
                  <a:pt x="1651" y="1127"/>
                </a:cubicBezTo>
                <a:cubicBezTo>
                  <a:pt x="1687" y="1126"/>
                  <a:pt x="1719" y="1139"/>
                  <a:pt x="1745" y="1165"/>
                </a:cubicBezTo>
                <a:cubicBezTo>
                  <a:pt x="1759" y="1179"/>
                  <a:pt x="1769" y="1195"/>
                  <a:pt x="1777" y="1213"/>
                </a:cubicBezTo>
                <a:cubicBezTo>
                  <a:pt x="1784" y="1232"/>
                  <a:pt x="1789" y="1255"/>
                  <a:pt x="1790" y="1282"/>
                </a:cubicBezTo>
                <a:cubicBezTo>
                  <a:pt x="1792" y="1309"/>
                  <a:pt x="1790" y="1350"/>
                  <a:pt x="1786" y="1404"/>
                </a:cubicBezTo>
                <a:cubicBezTo>
                  <a:pt x="1782" y="1450"/>
                  <a:pt x="1780" y="1480"/>
                  <a:pt x="1780" y="1494"/>
                </a:cubicBezTo>
                <a:cubicBezTo>
                  <a:pt x="1781" y="1509"/>
                  <a:pt x="1782" y="1522"/>
                  <a:pt x="1785" y="1534"/>
                </a:cubicBezTo>
                <a:lnTo>
                  <a:pt x="1950" y="1369"/>
                </a:lnTo>
                <a:close/>
                <a:moveTo>
                  <a:pt x="1886" y="935"/>
                </a:moveTo>
                <a:lnTo>
                  <a:pt x="1839" y="888"/>
                </a:lnTo>
                <a:lnTo>
                  <a:pt x="1880" y="847"/>
                </a:lnTo>
                <a:lnTo>
                  <a:pt x="1928" y="894"/>
                </a:lnTo>
                <a:lnTo>
                  <a:pt x="1886" y="935"/>
                </a:lnTo>
                <a:close/>
                <a:moveTo>
                  <a:pt x="2175" y="1224"/>
                </a:moveTo>
                <a:lnTo>
                  <a:pt x="1932" y="980"/>
                </a:lnTo>
                <a:lnTo>
                  <a:pt x="1973" y="939"/>
                </a:lnTo>
                <a:lnTo>
                  <a:pt x="2216" y="1183"/>
                </a:lnTo>
                <a:lnTo>
                  <a:pt x="2175" y="1224"/>
                </a:lnTo>
                <a:close/>
                <a:moveTo>
                  <a:pt x="2288" y="1111"/>
                </a:moveTo>
                <a:lnTo>
                  <a:pt x="1951" y="775"/>
                </a:lnTo>
                <a:lnTo>
                  <a:pt x="2078" y="649"/>
                </a:lnTo>
                <a:cubicBezTo>
                  <a:pt x="2101" y="626"/>
                  <a:pt x="2119" y="610"/>
                  <a:pt x="2133" y="601"/>
                </a:cubicBezTo>
                <a:cubicBezTo>
                  <a:pt x="2152" y="587"/>
                  <a:pt x="2171" y="578"/>
                  <a:pt x="2190" y="575"/>
                </a:cubicBezTo>
                <a:cubicBezTo>
                  <a:pt x="2209" y="571"/>
                  <a:pt x="2228" y="573"/>
                  <a:pt x="2249" y="580"/>
                </a:cubicBezTo>
                <a:cubicBezTo>
                  <a:pt x="2270" y="587"/>
                  <a:pt x="2289" y="599"/>
                  <a:pt x="2305" y="616"/>
                </a:cubicBezTo>
                <a:cubicBezTo>
                  <a:pt x="2334" y="645"/>
                  <a:pt x="2349" y="678"/>
                  <a:pt x="2350" y="716"/>
                </a:cubicBezTo>
                <a:cubicBezTo>
                  <a:pt x="2352" y="754"/>
                  <a:pt x="2329" y="797"/>
                  <a:pt x="2282" y="844"/>
                </a:cubicBezTo>
                <a:lnTo>
                  <a:pt x="2195" y="930"/>
                </a:lnTo>
                <a:lnTo>
                  <a:pt x="2332" y="1067"/>
                </a:lnTo>
                <a:lnTo>
                  <a:pt x="2288" y="1111"/>
                </a:lnTo>
                <a:close/>
                <a:moveTo>
                  <a:pt x="2156" y="891"/>
                </a:moveTo>
                <a:lnTo>
                  <a:pt x="2243" y="804"/>
                </a:lnTo>
                <a:cubicBezTo>
                  <a:pt x="2271" y="775"/>
                  <a:pt x="2286" y="749"/>
                  <a:pt x="2288" y="726"/>
                </a:cubicBezTo>
                <a:cubicBezTo>
                  <a:pt x="2289" y="704"/>
                  <a:pt x="2280" y="683"/>
                  <a:pt x="2261" y="663"/>
                </a:cubicBezTo>
                <a:cubicBezTo>
                  <a:pt x="2247" y="649"/>
                  <a:pt x="2231" y="641"/>
                  <a:pt x="2214" y="638"/>
                </a:cubicBezTo>
                <a:cubicBezTo>
                  <a:pt x="2197" y="635"/>
                  <a:pt x="2181" y="638"/>
                  <a:pt x="2166" y="646"/>
                </a:cubicBezTo>
                <a:cubicBezTo>
                  <a:pt x="2157" y="652"/>
                  <a:pt x="2142" y="664"/>
                  <a:pt x="2122" y="685"/>
                </a:cubicBezTo>
                <a:lnTo>
                  <a:pt x="2036" y="771"/>
                </a:lnTo>
                <a:lnTo>
                  <a:pt x="2156" y="891"/>
                </a:lnTo>
                <a:close/>
                <a:moveTo>
                  <a:pt x="2476" y="707"/>
                </a:moveTo>
                <a:lnTo>
                  <a:pt x="2514" y="662"/>
                </a:lnTo>
                <a:cubicBezTo>
                  <a:pt x="2533" y="677"/>
                  <a:pt x="2551" y="686"/>
                  <a:pt x="2569" y="689"/>
                </a:cubicBezTo>
                <a:cubicBezTo>
                  <a:pt x="2587" y="693"/>
                  <a:pt x="2607" y="690"/>
                  <a:pt x="2629" y="682"/>
                </a:cubicBezTo>
                <a:cubicBezTo>
                  <a:pt x="2651" y="673"/>
                  <a:pt x="2671" y="659"/>
                  <a:pt x="2691" y="640"/>
                </a:cubicBezTo>
                <a:cubicBezTo>
                  <a:pt x="2708" y="623"/>
                  <a:pt x="2720" y="606"/>
                  <a:pt x="2728" y="588"/>
                </a:cubicBezTo>
                <a:cubicBezTo>
                  <a:pt x="2736" y="569"/>
                  <a:pt x="2739" y="553"/>
                  <a:pt x="2736" y="538"/>
                </a:cubicBezTo>
                <a:cubicBezTo>
                  <a:pt x="2734" y="523"/>
                  <a:pt x="2727" y="510"/>
                  <a:pt x="2717" y="499"/>
                </a:cubicBezTo>
                <a:cubicBezTo>
                  <a:pt x="2706" y="489"/>
                  <a:pt x="2694" y="483"/>
                  <a:pt x="2680" y="481"/>
                </a:cubicBezTo>
                <a:cubicBezTo>
                  <a:pt x="2666" y="479"/>
                  <a:pt x="2649" y="483"/>
                  <a:pt x="2630" y="491"/>
                </a:cubicBezTo>
                <a:cubicBezTo>
                  <a:pt x="2618" y="497"/>
                  <a:pt x="2592" y="511"/>
                  <a:pt x="2554" y="535"/>
                </a:cubicBezTo>
                <a:cubicBezTo>
                  <a:pt x="2516" y="558"/>
                  <a:pt x="2487" y="573"/>
                  <a:pt x="2468" y="579"/>
                </a:cubicBezTo>
                <a:cubicBezTo>
                  <a:pt x="2444" y="586"/>
                  <a:pt x="2421" y="588"/>
                  <a:pt x="2401" y="583"/>
                </a:cubicBezTo>
                <a:cubicBezTo>
                  <a:pt x="2380" y="579"/>
                  <a:pt x="2363" y="569"/>
                  <a:pt x="2347" y="553"/>
                </a:cubicBezTo>
                <a:cubicBezTo>
                  <a:pt x="2330" y="536"/>
                  <a:pt x="2319" y="516"/>
                  <a:pt x="2314" y="491"/>
                </a:cubicBezTo>
                <a:cubicBezTo>
                  <a:pt x="2309" y="467"/>
                  <a:pt x="2312" y="442"/>
                  <a:pt x="2323" y="416"/>
                </a:cubicBezTo>
                <a:cubicBezTo>
                  <a:pt x="2333" y="389"/>
                  <a:pt x="2350" y="365"/>
                  <a:pt x="2373" y="342"/>
                </a:cubicBezTo>
                <a:cubicBezTo>
                  <a:pt x="2398" y="318"/>
                  <a:pt x="2424" y="300"/>
                  <a:pt x="2451" y="289"/>
                </a:cubicBezTo>
                <a:cubicBezTo>
                  <a:pt x="2478" y="278"/>
                  <a:pt x="2504" y="275"/>
                  <a:pt x="2530" y="280"/>
                </a:cubicBezTo>
                <a:cubicBezTo>
                  <a:pt x="2556" y="285"/>
                  <a:pt x="2579" y="298"/>
                  <a:pt x="2600" y="317"/>
                </a:cubicBezTo>
                <a:lnTo>
                  <a:pt x="2560" y="362"/>
                </a:lnTo>
                <a:cubicBezTo>
                  <a:pt x="2537" y="343"/>
                  <a:pt x="2513" y="335"/>
                  <a:pt x="2489" y="338"/>
                </a:cubicBezTo>
                <a:cubicBezTo>
                  <a:pt x="2465" y="340"/>
                  <a:pt x="2440" y="354"/>
                  <a:pt x="2414" y="380"/>
                </a:cubicBezTo>
                <a:cubicBezTo>
                  <a:pt x="2387" y="407"/>
                  <a:pt x="2372" y="431"/>
                  <a:pt x="2370" y="453"/>
                </a:cubicBezTo>
                <a:cubicBezTo>
                  <a:pt x="2367" y="476"/>
                  <a:pt x="2373" y="494"/>
                  <a:pt x="2387" y="508"/>
                </a:cubicBezTo>
                <a:cubicBezTo>
                  <a:pt x="2399" y="520"/>
                  <a:pt x="2413" y="525"/>
                  <a:pt x="2430" y="524"/>
                </a:cubicBezTo>
                <a:cubicBezTo>
                  <a:pt x="2446" y="523"/>
                  <a:pt x="2477" y="509"/>
                  <a:pt x="2521" y="481"/>
                </a:cubicBezTo>
                <a:cubicBezTo>
                  <a:pt x="2565" y="453"/>
                  <a:pt x="2597" y="436"/>
                  <a:pt x="2617" y="428"/>
                </a:cubicBezTo>
                <a:cubicBezTo>
                  <a:pt x="2645" y="418"/>
                  <a:pt x="2671" y="415"/>
                  <a:pt x="2694" y="419"/>
                </a:cubicBezTo>
                <a:cubicBezTo>
                  <a:pt x="2718" y="424"/>
                  <a:pt x="2738" y="435"/>
                  <a:pt x="2756" y="453"/>
                </a:cubicBezTo>
                <a:cubicBezTo>
                  <a:pt x="2774" y="471"/>
                  <a:pt x="2786" y="493"/>
                  <a:pt x="2791" y="519"/>
                </a:cubicBezTo>
                <a:cubicBezTo>
                  <a:pt x="2797" y="545"/>
                  <a:pt x="2795" y="572"/>
                  <a:pt x="2784" y="600"/>
                </a:cubicBezTo>
                <a:cubicBezTo>
                  <a:pt x="2774" y="628"/>
                  <a:pt x="2757" y="654"/>
                  <a:pt x="2733" y="678"/>
                </a:cubicBezTo>
                <a:cubicBezTo>
                  <a:pt x="2702" y="708"/>
                  <a:pt x="2672" y="729"/>
                  <a:pt x="2643" y="741"/>
                </a:cubicBezTo>
                <a:cubicBezTo>
                  <a:pt x="2613" y="753"/>
                  <a:pt x="2584" y="755"/>
                  <a:pt x="2554" y="749"/>
                </a:cubicBezTo>
                <a:cubicBezTo>
                  <a:pt x="2525" y="743"/>
                  <a:pt x="2499" y="729"/>
                  <a:pt x="2476" y="707"/>
                </a:cubicBezTo>
                <a:close/>
                <a:moveTo>
                  <a:pt x="3076" y="244"/>
                </a:moveTo>
                <a:lnTo>
                  <a:pt x="3116" y="283"/>
                </a:lnTo>
                <a:lnTo>
                  <a:pt x="2893" y="506"/>
                </a:lnTo>
                <a:cubicBezTo>
                  <a:pt x="2883" y="496"/>
                  <a:pt x="2875" y="485"/>
                  <a:pt x="2870" y="472"/>
                </a:cubicBezTo>
                <a:cubicBezTo>
                  <a:pt x="2860" y="451"/>
                  <a:pt x="2854" y="427"/>
                  <a:pt x="2852" y="400"/>
                </a:cubicBezTo>
                <a:cubicBezTo>
                  <a:pt x="2850" y="373"/>
                  <a:pt x="2851" y="338"/>
                  <a:pt x="2855" y="295"/>
                </a:cubicBezTo>
                <a:cubicBezTo>
                  <a:pt x="2862" y="229"/>
                  <a:pt x="2863" y="180"/>
                  <a:pt x="2858" y="150"/>
                </a:cubicBezTo>
                <a:cubicBezTo>
                  <a:pt x="2853" y="120"/>
                  <a:pt x="2843" y="97"/>
                  <a:pt x="2828" y="81"/>
                </a:cubicBezTo>
                <a:cubicBezTo>
                  <a:pt x="2811" y="65"/>
                  <a:pt x="2792" y="57"/>
                  <a:pt x="2769" y="57"/>
                </a:cubicBezTo>
                <a:cubicBezTo>
                  <a:pt x="2746" y="58"/>
                  <a:pt x="2725" y="67"/>
                  <a:pt x="2706" y="86"/>
                </a:cubicBezTo>
                <a:cubicBezTo>
                  <a:pt x="2686" y="106"/>
                  <a:pt x="2676" y="128"/>
                  <a:pt x="2676" y="152"/>
                </a:cubicBezTo>
                <a:cubicBezTo>
                  <a:pt x="2676" y="176"/>
                  <a:pt x="2687" y="198"/>
                  <a:pt x="2708" y="219"/>
                </a:cubicBezTo>
                <a:lnTo>
                  <a:pt x="2661" y="257"/>
                </a:lnTo>
                <a:cubicBezTo>
                  <a:pt x="2632" y="223"/>
                  <a:pt x="2619" y="188"/>
                  <a:pt x="2621" y="152"/>
                </a:cubicBezTo>
                <a:cubicBezTo>
                  <a:pt x="2624" y="117"/>
                  <a:pt x="2641" y="83"/>
                  <a:pt x="2673" y="51"/>
                </a:cubicBezTo>
                <a:cubicBezTo>
                  <a:pt x="2705" y="19"/>
                  <a:pt x="2740" y="2"/>
                  <a:pt x="2776" y="1"/>
                </a:cubicBezTo>
                <a:cubicBezTo>
                  <a:pt x="2813" y="0"/>
                  <a:pt x="2845" y="13"/>
                  <a:pt x="2871" y="40"/>
                </a:cubicBezTo>
                <a:cubicBezTo>
                  <a:pt x="2884" y="53"/>
                  <a:pt x="2895" y="69"/>
                  <a:pt x="2902" y="88"/>
                </a:cubicBezTo>
                <a:cubicBezTo>
                  <a:pt x="2910" y="106"/>
                  <a:pt x="2914" y="129"/>
                  <a:pt x="2916" y="156"/>
                </a:cubicBezTo>
                <a:cubicBezTo>
                  <a:pt x="2918" y="183"/>
                  <a:pt x="2916" y="224"/>
                  <a:pt x="2912" y="279"/>
                </a:cubicBezTo>
                <a:cubicBezTo>
                  <a:pt x="2908" y="324"/>
                  <a:pt x="2906" y="354"/>
                  <a:pt x="2906" y="369"/>
                </a:cubicBezTo>
                <a:cubicBezTo>
                  <a:pt x="2907" y="383"/>
                  <a:pt x="2908" y="396"/>
                  <a:pt x="2911" y="409"/>
                </a:cubicBezTo>
                <a:lnTo>
                  <a:pt x="3076" y="244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9" name="Freeform 65"/>
          <p:cNvSpPr>
            <a:spLocks noEditPoints="1"/>
          </p:cNvSpPr>
          <p:nvPr/>
        </p:nvSpPr>
        <p:spPr bwMode="auto">
          <a:xfrm>
            <a:off x="1597167" y="5035690"/>
            <a:ext cx="584200" cy="582613"/>
          </a:xfrm>
          <a:custGeom>
            <a:avLst/>
            <a:gdLst>
              <a:gd name="T0" fmla="*/ 420 w 3064"/>
              <a:gd name="T1" fmla="*/ 2982 h 3056"/>
              <a:gd name="T2" fmla="*/ 14 w 3064"/>
              <a:gd name="T3" fmla="*/ 2852 h 3056"/>
              <a:gd name="T4" fmla="*/ 303 w 3064"/>
              <a:gd name="T5" fmla="*/ 2598 h 3056"/>
              <a:gd name="T6" fmla="*/ 64 w 3064"/>
              <a:gd name="T7" fmla="*/ 2756 h 3056"/>
              <a:gd name="T8" fmla="*/ 305 w 3064"/>
              <a:gd name="T9" fmla="*/ 2988 h 3056"/>
              <a:gd name="T10" fmla="*/ 466 w 3064"/>
              <a:gd name="T11" fmla="*/ 2680 h 3056"/>
              <a:gd name="T12" fmla="*/ 691 w 3064"/>
              <a:gd name="T13" fmla="*/ 2449 h 3056"/>
              <a:gd name="T14" fmla="*/ 592 w 3064"/>
              <a:gd name="T15" fmla="*/ 2743 h 3056"/>
              <a:gd name="T16" fmla="*/ 673 w 3064"/>
              <a:gd name="T17" fmla="*/ 2660 h 3056"/>
              <a:gd name="T18" fmla="*/ 487 w 3064"/>
              <a:gd name="T19" fmla="*/ 2473 h 3056"/>
              <a:gd name="T20" fmla="*/ 625 w 3064"/>
              <a:gd name="T21" fmla="*/ 2277 h 3056"/>
              <a:gd name="T22" fmla="*/ 783 w 3064"/>
              <a:gd name="T23" fmla="*/ 2125 h 3056"/>
              <a:gd name="T24" fmla="*/ 1067 w 3064"/>
              <a:gd name="T25" fmla="*/ 2323 h 3056"/>
              <a:gd name="T26" fmla="*/ 798 w 3064"/>
              <a:gd name="T27" fmla="*/ 2180 h 3056"/>
              <a:gd name="T28" fmla="*/ 910 w 3064"/>
              <a:gd name="T29" fmla="*/ 2480 h 3056"/>
              <a:gd name="T30" fmla="*/ 1197 w 3064"/>
              <a:gd name="T31" fmla="*/ 2199 h 3056"/>
              <a:gd name="T32" fmla="*/ 925 w 3064"/>
              <a:gd name="T33" fmla="*/ 2042 h 3056"/>
              <a:gd name="T34" fmla="*/ 833 w 3064"/>
              <a:gd name="T35" fmla="*/ 1949 h 3056"/>
              <a:gd name="T36" fmla="*/ 1008 w 3064"/>
              <a:gd name="T37" fmla="*/ 1959 h 3056"/>
              <a:gd name="T38" fmla="*/ 1149 w 3064"/>
              <a:gd name="T39" fmla="*/ 2165 h 3056"/>
              <a:gd name="T40" fmla="*/ 1015 w 3064"/>
              <a:gd name="T41" fmla="*/ 1888 h 3056"/>
              <a:gd name="T42" fmla="*/ 1100 w 3064"/>
              <a:gd name="T43" fmla="*/ 1792 h 3056"/>
              <a:gd name="T44" fmla="*/ 1124 w 3064"/>
              <a:gd name="T45" fmla="*/ 1869 h 3056"/>
              <a:gd name="T46" fmla="*/ 1259 w 3064"/>
              <a:gd name="T47" fmla="*/ 2131 h 3056"/>
              <a:gd name="T48" fmla="*/ 1382 w 3064"/>
              <a:gd name="T49" fmla="*/ 1575 h 3056"/>
              <a:gd name="T50" fmla="*/ 1522 w 3064"/>
              <a:gd name="T51" fmla="*/ 1879 h 3056"/>
              <a:gd name="T52" fmla="*/ 1413 w 3064"/>
              <a:gd name="T53" fmla="*/ 1873 h 3056"/>
              <a:gd name="T54" fmla="*/ 1376 w 3064"/>
              <a:gd name="T55" fmla="*/ 1631 h 3056"/>
              <a:gd name="T56" fmla="*/ 1677 w 3064"/>
              <a:gd name="T57" fmla="*/ 1713 h 3056"/>
              <a:gd name="T58" fmla="*/ 1677 w 3064"/>
              <a:gd name="T59" fmla="*/ 1713 h 3056"/>
              <a:gd name="T60" fmla="*/ 1745 w 3064"/>
              <a:gd name="T61" fmla="*/ 1588 h 3056"/>
              <a:gd name="T62" fmla="*/ 1703 w 3064"/>
              <a:gd name="T63" fmla="*/ 1197 h 3056"/>
              <a:gd name="T64" fmla="*/ 1583 w 3064"/>
              <a:gd name="T65" fmla="*/ 1335 h 3056"/>
              <a:gd name="T66" fmla="*/ 1651 w 3064"/>
              <a:gd name="T67" fmla="*/ 1117 h 3056"/>
              <a:gd name="T68" fmla="*/ 1787 w 3064"/>
              <a:gd name="T69" fmla="*/ 1394 h 3056"/>
              <a:gd name="T70" fmla="*/ 1887 w 3064"/>
              <a:gd name="T71" fmla="*/ 925 h 3056"/>
              <a:gd name="T72" fmla="*/ 1887 w 3064"/>
              <a:gd name="T73" fmla="*/ 925 h 3056"/>
              <a:gd name="T74" fmla="*/ 2217 w 3064"/>
              <a:gd name="T75" fmla="*/ 1173 h 3056"/>
              <a:gd name="T76" fmla="*/ 2079 w 3064"/>
              <a:gd name="T77" fmla="*/ 639 h 3056"/>
              <a:gd name="T78" fmla="*/ 2306 w 3064"/>
              <a:gd name="T79" fmla="*/ 606 h 3056"/>
              <a:gd name="T80" fmla="*/ 2333 w 3064"/>
              <a:gd name="T81" fmla="*/ 1057 h 3056"/>
              <a:gd name="T82" fmla="*/ 2289 w 3064"/>
              <a:gd name="T83" fmla="*/ 716 h 3056"/>
              <a:gd name="T84" fmla="*/ 2122 w 3064"/>
              <a:gd name="T85" fmla="*/ 675 h 3056"/>
              <a:gd name="T86" fmla="*/ 2515 w 3064"/>
              <a:gd name="T87" fmla="*/ 652 h 3056"/>
              <a:gd name="T88" fmla="*/ 2729 w 3064"/>
              <a:gd name="T89" fmla="*/ 578 h 3056"/>
              <a:gd name="T90" fmla="*/ 2631 w 3064"/>
              <a:gd name="T91" fmla="*/ 481 h 3056"/>
              <a:gd name="T92" fmla="*/ 2348 w 3064"/>
              <a:gd name="T93" fmla="*/ 543 h 3056"/>
              <a:gd name="T94" fmla="*/ 2452 w 3064"/>
              <a:gd name="T95" fmla="*/ 279 h 3056"/>
              <a:gd name="T96" fmla="*/ 2490 w 3064"/>
              <a:gd name="T97" fmla="*/ 328 h 3056"/>
              <a:gd name="T98" fmla="*/ 2431 w 3064"/>
              <a:gd name="T99" fmla="*/ 514 h 3056"/>
              <a:gd name="T100" fmla="*/ 2757 w 3064"/>
              <a:gd name="T101" fmla="*/ 443 h 3056"/>
              <a:gd name="T102" fmla="*/ 2644 w 3064"/>
              <a:gd name="T103" fmla="*/ 731 h 3056"/>
              <a:gd name="T104" fmla="*/ 2847 w 3064"/>
              <a:gd name="T105" fmla="*/ 355 h 3056"/>
              <a:gd name="T106" fmla="*/ 2978 w 3064"/>
              <a:gd name="T107" fmla="*/ 215 h 3056"/>
              <a:gd name="T108" fmla="*/ 2790 w 3064"/>
              <a:gd name="T109" fmla="*/ 209 h 3056"/>
              <a:gd name="T110" fmla="*/ 2757 w 3064"/>
              <a:gd name="T111" fmla="*/ 56 h 3056"/>
              <a:gd name="T112" fmla="*/ 2654 w 3064"/>
              <a:gd name="T113" fmla="*/ 236 h 3056"/>
              <a:gd name="T114" fmla="*/ 2798 w 3064"/>
              <a:gd name="T115" fmla="*/ 5 h 3056"/>
              <a:gd name="T116" fmla="*/ 2950 w 3064"/>
              <a:gd name="T117" fmla="*/ 133 h 3056"/>
              <a:gd name="T118" fmla="*/ 2913 w 3064"/>
              <a:gd name="T119" fmla="*/ 436 h 305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</a:cxnLst>
            <a:rect l="0" t="0" r="r" b="b"/>
            <a:pathLst>
              <a:path w="3064" h="3056">
                <a:moveTo>
                  <a:pt x="391" y="2763"/>
                </a:moveTo>
                <a:lnTo>
                  <a:pt x="447" y="2730"/>
                </a:lnTo>
                <a:cubicBezTo>
                  <a:pt x="474" y="2776"/>
                  <a:pt x="485" y="2821"/>
                  <a:pt x="480" y="2864"/>
                </a:cubicBezTo>
                <a:cubicBezTo>
                  <a:pt x="475" y="2907"/>
                  <a:pt x="455" y="2947"/>
                  <a:pt x="420" y="2982"/>
                </a:cubicBezTo>
                <a:cubicBezTo>
                  <a:pt x="384" y="3018"/>
                  <a:pt x="347" y="3040"/>
                  <a:pt x="309" y="3048"/>
                </a:cubicBezTo>
                <a:cubicBezTo>
                  <a:pt x="272" y="3056"/>
                  <a:pt x="233" y="3052"/>
                  <a:pt x="193" y="3036"/>
                </a:cubicBezTo>
                <a:cubicBezTo>
                  <a:pt x="154" y="3019"/>
                  <a:pt x="118" y="2995"/>
                  <a:pt x="85" y="2963"/>
                </a:cubicBezTo>
                <a:cubicBezTo>
                  <a:pt x="50" y="2928"/>
                  <a:pt x="27" y="2891"/>
                  <a:pt x="14" y="2852"/>
                </a:cubicBezTo>
                <a:cubicBezTo>
                  <a:pt x="1" y="2812"/>
                  <a:pt x="0" y="2773"/>
                  <a:pt x="12" y="2735"/>
                </a:cubicBezTo>
                <a:cubicBezTo>
                  <a:pt x="23" y="2697"/>
                  <a:pt x="43" y="2663"/>
                  <a:pt x="73" y="2633"/>
                </a:cubicBezTo>
                <a:cubicBezTo>
                  <a:pt x="106" y="2600"/>
                  <a:pt x="143" y="2580"/>
                  <a:pt x="183" y="2574"/>
                </a:cubicBezTo>
                <a:cubicBezTo>
                  <a:pt x="223" y="2568"/>
                  <a:pt x="263" y="2576"/>
                  <a:pt x="303" y="2598"/>
                </a:cubicBezTo>
                <a:lnTo>
                  <a:pt x="270" y="2653"/>
                </a:lnTo>
                <a:cubicBezTo>
                  <a:pt x="238" y="2636"/>
                  <a:pt x="209" y="2629"/>
                  <a:pt x="183" y="2633"/>
                </a:cubicBezTo>
                <a:cubicBezTo>
                  <a:pt x="157" y="2637"/>
                  <a:pt x="132" y="2650"/>
                  <a:pt x="110" y="2672"/>
                </a:cubicBezTo>
                <a:cubicBezTo>
                  <a:pt x="84" y="2698"/>
                  <a:pt x="69" y="2726"/>
                  <a:pt x="64" y="2756"/>
                </a:cubicBezTo>
                <a:cubicBezTo>
                  <a:pt x="59" y="2785"/>
                  <a:pt x="63" y="2814"/>
                  <a:pt x="77" y="2842"/>
                </a:cubicBezTo>
                <a:cubicBezTo>
                  <a:pt x="91" y="2870"/>
                  <a:pt x="109" y="2895"/>
                  <a:pt x="131" y="2917"/>
                </a:cubicBezTo>
                <a:cubicBezTo>
                  <a:pt x="160" y="2946"/>
                  <a:pt x="189" y="2966"/>
                  <a:pt x="218" y="2979"/>
                </a:cubicBezTo>
                <a:cubicBezTo>
                  <a:pt x="248" y="2992"/>
                  <a:pt x="277" y="2995"/>
                  <a:pt x="305" y="2988"/>
                </a:cubicBezTo>
                <a:cubicBezTo>
                  <a:pt x="333" y="2981"/>
                  <a:pt x="358" y="2968"/>
                  <a:pt x="378" y="2947"/>
                </a:cubicBezTo>
                <a:cubicBezTo>
                  <a:pt x="403" y="2922"/>
                  <a:pt x="417" y="2894"/>
                  <a:pt x="420" y="2862"/>
                </a:cubicBezTo>
                <a:cubicBezTo>
                  <a:pt x="423" y="2831"/>
                  <a:pt x="413" y="2798"/>
                  <a:pt x="391" y="2763"/>
                </a:cubicBezTo>
                <a:close/>
                <a:moveTo>
                  <a:pt x="466" y="2680"/>
                </a:moveTo>
                <a:cubicBezTo>
                  <a:pt x="421" y="2635"/>
                  <a:pt x="400" y="2589"/>
                  <a:pt x="403" y="2543"/>
                </a:cubicBezTo>
                <a:cubicBezTo>
                  <a:pt x="406" y="2504"/>
                  <a:pt x="423" y="2469"/>
                  <a:pt x="453" y="2439"/>
                </a:cubicBezTo>
                <a:cubicBezTo>
                  <a:pt x="486" y="2406"/>
                  <a:pt x="525" y="2389"/>
                  <a:pt x="568" y="2390"/>
                </a:cubicBezTo>
                <a:cubicBezTo>
                  <a:pt x="611" y="2390"/>
                  <a:pt x="652" y="2410"/>
                  <a:pt x="691" y="2449"/>
                </a:cubicBezTo>
                <a:cubicBezTo>
                  <a:pt x="722" y="2480"/>
                  <a:pt x="742" y="2510"/>
                  <a:pt x="750" y="2537"/>
                </a:cubicBezTo>
                <a:cubicBezTo>
                  <a:pt x="759" y="2564"/>
                  <a:pt x="759" y="2592"/>
                  <a:pt x="751" y="2620"/>
                </a:cubicBezTo>
                <a:cubicBezTo>
                  <a:pt x="743" y="2648"/>
                  <a:pt x="729" y="2672"/>
                  <a:pt x="707" y="2693"/>
                </a:cubicBezTo>
                <a:cubicBezTo>
                  <a:pt x="673" y="2728"/>
                  <a:pt x="635" y="2744"/>
                  <a:pt x="592" y="2743"/>
                </a:cubicBezTo>
                <a:cubicBezTo>
                  <a:pt x="549" y="2742"/>
                  <a:pt x="507" y="2722"/>
                  <a:pt x="466" y="2680"/>
                </a:cubicBezTo>
                <a:close/>
                <a:moveTo>
                  <a:pt x="508" y="2638"/>
                </a:moveTo>
                <a:cubicBezTo>
                  <a:pt x="540" y="2669"/>
                  <a:pt x="570" y="2686"/>
                  <a:pt x="599" y="2688"/>
                </a:cubicBezTo>
                <a:cubicBezTo>
                  <a:pt x="628" y="2690"/>
                  <a:pt x="653" y="2680"/>
                  <a:pt x="673" y="2660"/>
                </a:cubicBezTo>
                <a:cubicBezTo>
                  <a:pt x="694" y="2639"/>
                  <a:pt x="703" y="2614"/>
                  <a:pt x="701" y="2585"/>
                </a:cubicBezTo>
                <a:cubicBezTo>
                  <a:pt x="699" y="2556"/>
                  <a:pt x="682" y="2525"/>
                  <a:pt x="650" y="2493"/>
                </a:cubicBezTo>
                <a:cubicBezTo>
                  <a:pt x="620" y="2463"/>
                  <a:pt x="590" y="2447"/>
                  <a:pt x="561" y="2445"/>
                </a:cubicBezTo>
                <a:cubicBezTo>
                  <a:pt x="532" y="2444"/>
                  <a:pt x="507" y="2453"/>
                  <a:pt x="487" y="2473"/>
                </a:cubicBezTo>
                <a:cubicBezTo>
                  <a:pt x="466" y="2494"/>
                  <a:pt x="457" y="2519"/>
                  <a:pt x="459" y="2548"/>
                </a:cubicBezTo>
                <a:cubicBezTo>
                  <a:pt x="461" y="2577"/>
                  <a:pt x="477" y="2607"/>
                  <a:pt x="508" y="2638"/>
                </a:cubicBezTo>
                <a:close/>
                <a:moveTo>
                  <a:pt x="869" y="2521"/>
                </a:moveTo>
                <a:lnTo>
                  <a:pt x="625" y="2277"/>
                </a:lnTo>
                <a:lnTo>
                  <a:pt x="663" y="2240"/>
                </a:lnTo>
                <a:lnTo>
                  <a:pt x="697" y="2275"/>
                </a:lnTo>
                <a:cubicBezTo>
                  <a:pt x="688" y="2230"/>
                  <a:pt x="701" y="2191"/>
                  <a:pt x="735" y="2157"/>
                </a:cubicBezTo>
                <a:cubicBezTo>
                  <a:pt x="749" y="2143"/>
                  <a:pt x="765" y="2132"/>
                  <a:pt x="783" y="2125"/>
                </a:cubicBezTo>
                <a:cubicBezTo>
                  <a:pt x="800" y="2118"/>
                  <a:pt x="817" y="2115"/>
                  <a:pt x="831" y="2118"/>
                </a:cubicBezTo>
                <a:cubicBezTo>
                  <a:pt x="846" y="2120"/>
                  <a:pt x="860" y="2126"/>
                  <a:pt x="875" y="2136"/>
                </a:cubicBezTo>
                <a:cubicBezTo>
                  <a:pt x="884" y="2142"/>
                  <a:pt x="898" y="2154"/>
                  <a:pt x="917" y="2173"/>
                </a:cubicBezTo>
                <a:lnTo>
                  <a:pt x="1067" y="2323"/>
                </a:lnTo>
                <a:lnTo>
                  <a:pt x="1025" y="2364"/>
                </a:lnTo>
                <a:lnTo>
                  <a:pt x="877" y="2216"/>
                </a:lnTo>
                <a:cubicBezTo>
                  <a:pt x="861" y="2199"/>
                  <a:pt x="846" y="2188"/>
                  <a:pt x="835" y="2183"/>
                </a:cubicBezTo>
                <a:cubicBezTo>
                  <a:pt x="823" y="2178"/>
                  <a:pt x="811" y="2177"/>
                  <a:pt x="798" y="2180"/>
                </a:cubicBezTo>
                <a:cubicBezTo>
                  <a:pt x="785" y="2184"/>
                  <a:pt x="773" y="2191"/>
                  <a:pt x="762" y="2202"/>
                </a:cubicBezTo>
                <a:cubicBezTo>
                  <a:pt x="744" y="2219"/>
                  <a:pt x="734" y="2240"/>
                  <a:pt x="733" y="2264"/>
                </a:cubicBezTo>
                <a:cubicBezTo>
                  <a:pt x="731" y="2288"/>
                  <a:pt x="746" y="2315"/>
                  <a:pt x="777" y="2347"/>
                </a:cubicBezTo>
                <a:lnTo>
                  <a:pt x="910" y="2480"/>
                </a:lnTo>
                <a:lnTo>
                  <a:pt x="869" y="2521"/>
                </a:lnTo>
                <a:close/>
                <a:moveTo>
                  <a:pt x="1182" y="2134"/>
                </a:moveTo>
                <a:lnTo>
                  <a:pt x="1225" y="2164"/>
                </a:lnTo>
                <a:cubicBezTo>
                  <a:pt x="1216" y="2178"/>
                  <a:pt x="1206" y="2190"/>
                  <a:pt x="1197" y="2199"/>
                </a:cubicBezTo>
                <a:cubicBezTo>
                  <a:pt x="1182" y="2214"/>
                  <a:pt x="1168" y="2223"/>
                  <a:pt x="1155" y="2227"/>
                </a:cubicBezTo>
                <a:cubicBezTo>
                  <a:pt x="1142" y="2230"/>
                  <a:pt x="1130" y="2230"/>
                  <a:pt x="1119" y="2225"/>
                </a:cubicBezTo>
                <a:cubicBezTo>
                  <a:pt x="1108" y="2221"/>
                  <a:pt x="1090" y="2207"/>
                  <a:pt x="1065" y="2182"/>
                </a:cubicBezTo>
                <a:lnTo>
                  <a:pt x="925" y="2042"/>
                </a:lnTo>
                <a:lnTo>
                  <a:pt x="895" y="2072"/>
                </a:lnTo>
                <a:lnTo>
                  <a:pt x="863" y="2040"/>
                </a:lnTo>
                <a:lnTo>
                  <a:pt x="893" y="2010"/>
                </a:lnTo>
                <a:lnTo>
                  <a:pt x="833" y="1949"/>
                </a:lnTo>
                <a:lnTo>
                  <a:pt x="849" y="1884"/>
                </a:lnTo>
                <a:lnTo>
                  <a:pt x="934" y="1969"/>
                </a:lnTo>
                <a:lnTo>
                  <a:pt x="976" y="1927"/>
                </a:lnTo>
                <a:lnTo>
                  <a:pt x="1008" y="1959"/>
                </a:lnTo>
                <a:lnTo>
                  <a:pt x="966" y="2001"/>
                </a:lnTo>
                <a:lnTo>
                  <a:pt x="1109" y="2143"/>
                </a:lnTo>
                <a:cubicBezTo>
                  <a:pt x="1120" y="2155"/>
                  <a:pt x="1129" y="2162"/>
                  <a:pt x="1134" y="2164"/>
                </a:cubicBezTo>
                <a:cubicBezTo>
                  <a:pt x="1138" y="2165"/>
                  <a:pt x="1143" y="2166"/>
                  <a:pt x="1149" y="2165"/>
                </a:cubicBezTo>
                <a:cubicBezTo>
                  <a:pt x="1154" y="2163"/>
                  <a:pt x="1160" y="2159"/>
                  <a:pt x="1166" y="2153"/>
                </a:cubicBezTo>
                <a:cubicBezTo>
                  <a:pt x="1170" y="2149"/>
                  <a:pt x="1176" y="2142"/>
                  <a:pt x="1182" y="2134"/>
                </a:cubicBezTo>
                <a:close/>
                <a:moveTo>
                  <a:pt x="1259" y="2131"/>
                </a:moveTo>
                <a:lnTo>
                  <a:pt x="1015" y="1888"/>
                </a:lnTo>
                <a:lnTo>
                  <a:pt x="1052" y="1850"/>
                </a:lnTo>
                <a:lnTo>
                  <a:pt x="1089" y="1887"/>
                </a:lnTo>
                <a:cubicBezTo>
                  <a:pt x="1082" y="1861"/>
                  <a:pt x="1079" y="1840"/>
                  <a:pt x="1081" y="1827"/>
                </a:cubicBezTo>
                <a:cubicBezTo>
                  <a:pt x="1084" y="1813"/>
                  <a:pt x="1090" y="1802"/>
                  <a:pt x="1100" y="1792"/>
                </a:cubicBezTo>
                <a:cubicBezTo>
                  <a:pt x="1114" y="1778"/>
                  <a:pt x="1132" y="1769"/>
                  <a:pt x="1155" y="1763"/>
                </a:cubicBezTo>
                <a:lnTo>
                  <a:pt x="1179" y="1816"/>
                </a:lnTo>
                <a:cubicBezTo>
                  <a:pt x="1163" y="1820"/>
                  <a:pt x="1150" y="1827"/>
                  <a:pt x="1140" y="1837"/>
                </a:cubicBezTo>
                <a:cubicBezTo>
                  <a:pt x="1131" y="1846"/>
                  <a:pt x="1126" y="1857"/>
                  <a:pt x="1124" y="1869"/>
                </a:cubicBezTo>
                <a:cubicBezTo>
                  <a:pt x="1122" y="1882"/>
                  <a:pt x="1125" y="1895"/>
                  <a:pt x="1131" y="1907"/>
                </a:cubicBezTo>
                <a:cubicBezTo>
                  <a:pt x="1141" y="1927"/>
                  <a:pt x="1155" y="1945"/>
                  <a:pt x="1173" y="1962"/>
                </a:cubicBezTo>
                <a:lnTo>
                  <a:pt x="1300" y="2090"/>
                </a:lnTo>
                <a:lnTo>
                  <a:pt x="1259" y="2131"/>
                </a:lnTo>
                <a:close/>
                <a:moveTo>
                  <a:pt x="1281" y="1866"/>
                </a:moveTo>
                <a:cubicBezTo>
                  <a:pt x="1235" y="1821"/>
                  <a:pt x="1215" y="1775"/>
                  <a:pt x="1218" y="1728"/>
                </a:cubicBezTo>
                <a:cubicBezTo>
                  <a:pt x="1221" y="1689"/>
                  <a:pt x="1237" y="1655"/>
                  <a:pt x="1267" y="1624"/>
                </a:cubicBezTo>
                <a:cubicBezTo>
                  <a:pt x="1301" y="1591"/>
                  <a:pt x="1339" y="1575"/>
                  <a:pt x="1382" y="1575"/>
                </a:cubicBezTo>
                <a:cubicBezTo>
                  <a:pt x="1426" y="1576"/>
                  <a:pt x="1467" y="1596"/>
                  <a:pt x="1505" y="1634"/>
                </a:cubicBezTo>
                <a:cubicBezTo>
                  <a:pt x="1537" y="1666"/>
                  <a:pt x="1556" y="1695"/>
                  <a:pt x="1565" y="1722"/>
                </a:cubicBezTo>
                <a:cubicBezTo>
                  <a:pt x="1574" y="1750"/>
                  <a:pt x="1574" y="1777"/>
                  <a:pt x="1566" y="1805"/>
                </a:cubicBezTo>
                <a:cubicBezTo>
                  <a:pt x="1558" y="1833"/>
                  <a:pt x="1543" y="1858"/>
                  <a:pt x="1522" y="1879"/>
                </a:cubicBezTo>
                <a:cubicBezTo>
                  <a:pt x="1488" y="1913"/>
                  <a:pt x="1449" y="1930"/>
                  <a:pt x="1406" y="1929"/>
                </a:cubicBezTo>
                <a:cubicBezTo>
                  <a:pt x="1364" y="1928"/>
                  <a:pt x="1322" y="1907"/>
                  <a:pt x="1281" y="1866"/>
                </a:cubicBezTo>
                <a:close/>
                <a:moveTo>
                  <a:pt x="1323" y="1823"/>
                </a:moveTo>
                <a:cubicBezTo>
                  <a:pt x="1354" y="1855"/>
                  <a:pt x="1384" y="1871"/>
                  <a:pt x="1413" y="1873"/>
                </a:cubicBezTo>
                <a:cubicBezTo>
                  <a:pt x="1442" y="1875"/>
                  <a:pt x="1467" y="1866"/>
                  <a:pt x="1488" y="1845"/>
                </a:cubicBezTo>
                <a:cubicBezTo>
                  <a:pt x="1508" y="1824"/>
                  <a:pt x="1518" y="1800"/>
                  <a:pt x="1516" y="1770"/>
                </a:cubicBezTo>
                <a:cubicBezTo>
                  <a:pt x="1514" y="1741"/>
                  <a:pt x="1497" y="1711"/>
                  <a:pt x="1465" y="1679"/>
                </a:cubicBezTo>
                <a:cubicBezTo>
                  <a:pt x="1435" y="1649"/>
                  <a:pt x="1405" y="1633"/>
                  <a:pt x="1376" y="1631"/>
                </a:cubicBezTo>
                <a:cubicBezTo>
                  <a:pt x="1347" y="1629"/>
                  <a:pt x="1322" y="1638"/>
                  <a:pt x="1302" y="1659"/>
                </a:cubicBezTo>
                <a:cubicBezTo>
                  <a:pt x="1281" y="1679"/>
                  <a:pt x="1272" y="1704"/>
                  <a:pt x="1273" y="1733"/>
                </a:cubicBezTo>
                <a:cubicBezTo>
                  <a:pt x="1275" y="1762"/>
                  <a:pt x="1292" y="1792"/>
                  <a:pt x="1323" y="1823"/>
                </a:cubicBezTo>
                <a:close/>
                <a:moveTo>
                  <a:pt x="1677" y="1713"/>
                </a:moveTo>
                <a:lnTo>
                  <a:pt x="1341" y="1377"/>
                </a:lnTo>
                <a:lnTo>
                  <a:pt x="1382" y="1336"/>
                </a:lnTo>
                <a:lnTo>
                  <a:pt x="1718" y="1672"/>
                </a:lnTo>
                <a:lnTo>
                  <a:pt x="1677" y="1713"/>
                </a:lnTo>
                <a:close/>
                <a:moveTo>
                  <a:pt x="1951" y="1359"/>
                </a:moveTo>
                <a:lnTo>
                  <a:pt x="1991" y="1399"/>
                </a:lnTo>
                <a:lnTo>
                  <a:pt x="1769" y="1621"/>
                </a:lnTo>
                <a:cubicBezTo>
                  <a:pt x="1758" y="1612"/>
                  <a:pt x="1750" y="1600"/>
                  <a:pt x="1745" y="1588"/>
                </a:cubicBezTo>
                <a:cubicBezTo>
                  <a:pt x="1735" y="1567"/>
                  <a:pt x="1729" y="1543"/>
                  <a:pt x="1727" y="1516"/>
                </a:cubicBezTo>
                <a:cubicBezTo>
                  <a:pt x="1725" y="1489"/>
                  <a:pt x="1726" y="1454"/>
                  <a:pt x="1730" y="1411"/>
                </a:cubicBezTo>
                <a:cubicBezTo>
                  <a:pt x="1737" y="1345"/>
                  <a:pt x="1738" y="1296"/>
                  <a:pt x="1733" y="1266"/>
                </a:cubicBezTo>
                <a:cubicBezTo>
                  <a:pt x="1728" y="1235"/>
                  <a:pt x="1718" y="1212"/>
                  <a:pt x="1703" y="1197"/>
                </a:cubicBezTo>
                <a:cubicBezTo>
                  <a:pt x="1686" y="1181"/>
                  <a:pt x="1667" y="1173"/>
                  <a:pt x="1644" y="1173"/>
                </a:cubicBezTo>
                <a:cubicBezTo>
                  <a:pt x="1621" y="1173"/>
                  <a:pt x="1600" y="1183"/>
                  <a:pt x="1581" y="1202"/>
                </a:cubicBezTo>
                <a:cubicBezTo>
                  <a:pt x="1561" y="1222"/>
                  <a:pt x="1551" y="1244"/>
                  <a:pt x="1551" y="1267"/>
                </a:cubicBezTo>
                <a:cubicBezTo>
                  <a:pt x="1551" y="1291"/>
                  <a:pt x="1562" y="1314"/>
                  <a:pt x="1583" y="1335"/>
                </a:cubicBezTo>
                <a:lnTo>
                  <a:pt x="1536" y="1373"/>
                </a:lnTo>
                <a:cubicBezTo>
                  <a:pt x="1507" y="1339"/>
                  <a:pt x="1494" y="1304"/>
                  <a:pt x="1497" y="1268"/>
                </a:cubicBezTo>
                <a:cubicBezTo>
                  <a:pt x="1499" y="1233"/>
                  <a:pt x="1516" y="1199"/>
                  <a:pt x="1548" y="1167"/>
                </a:cubicBezTo>
                <a:cubicBezTo>
                  <a:pt x="1580" y="1135"/>
                  <a:pt x="1615" y="1118"/>
                  <a:pt x="1651" y="1117"/>
                </a:cubicBezTo>
                <a:cubicBezTo>
                  <a:pt x="1688" y="1116"/>
                  <a:pt x="1720" y="1129"/>
                  <a:pt x="1746" y="1155"/>
                </a:cubicBezTo>
                <a:cubicBezTo>
                  <a:pt x="1760" y="1169"/>
                  <a:pt x="1770" y="1185"/>
                  <a:pt x="1778" y="1203"/>
                </a:cubicBezTo>
                <a:cubicBezTo>
                  <a:pt x="1785" y="1222"/>
                  <a:pt x="1790" y="1245"/>
                  <a:pt x="1791" y="1272"/>
                </a:cubicBezTo>
                <a:cubicBezTo>
                  <a:pt x="1793" y="1299"/>
                  <a:pt x="1791" y="1340"/>
                  <a:pt x="1787" y="1394"/>
                </a:cubicBezTo>
                <a:cubicBezTo>
                  <a:pt x="1783" y="1440"/>
                  <a:pt x="1781" y="1470"/>
                  <a:pt x="1781" y="1484"/>
                </a:cubicBezTo>
                <a:cubicBezTo>
                  <a:pt x="1782" y="1499"/>
                  <a:pt x="1783" y="1512"/>
                  <a:pt x="1786" y="1524"/>
                </a:cubicBezTo>
                <a:lnTo>
                  <a:pt x="1951" y="1359"/>
                </a:lnTo>
                <a:close/>
                <a:moveTo>
                  <a:pt x="1887" y="925"/>
                </a:moveTo>
                <a:lnTo>
                  <a:pt x="1840" y="878"/>
                </a:lnTo>
                <a:lnTo>
                  <a:pt x="1881" y="837"/>
                </a:lnTo>
                <a:lnTo>
                  <a:pt x="1928" y="884"/>
                </a:lnTo>
                <a:lnTo>
                  <a:pt x="1887" y="925"/>
                </a:lnTo>
                <a:close/>
                <a:moveTo>
                  <a:pt x="2176" y="1214"/>
                </a:moveTo>
                <a:lnTo>
                  <a:pt x="1932" y="970"/>
                </a:lnTo>
                <a:lnTo>
                  <a:pt x="1974" y="929"/>
                </a:lnTo>
                <a:lnTo>
                  <a:pt x="2217" y="1173"/>
                </a:lnTo>
                <a:lnTo>
                  <a:pt x="2176" y="1214"/>
                </a:lnTo>
                <a:close/>
                <a:moveTo>
                  <a:pt x="2288" y="1101"/>
                </a:moveTo>
                <a:lnTo>
                  <a:pt x="1952" y="765"/>
                </a:lnTo>
                <a:lnTo>
                  <a:pt x="2079" y="639"/>
                </a:lnTo>
                <a:cubicBezTo>
                  <a:pt x="2101" y="616"/>
                  <a:pt x="2119" y="600"/>
                  <a:pt x="2133" y="591"/>
                </a:cubicBezTo>
                <a:cubicBezTo>
                  <a:pt x="2153" y="577"/>
                  <a:pt x="2172" y="568"/>
                  <a:pt x="2191" y="565"/>
                </a:cubicBezTo>
                <a:cubicBezTo>
                  <a:pt x="2209" y="561"/>
                  <a:pt x="2229" y="563"/>
                  <a:pt x="2250" y="570"/>
                </a:cubicBezTo>
                <a:cubicBezTo>
                  <a:pt x="2271" y="577"/>
                  <a:pt x="2289" y="589"/>
                  <a:pt x="2306" y="606"/>
                </a:cubicBezTo>
                <a:cubicBezTo>
                  <a:pt x="2335" y="635"/>
                  <a:pt x="2350" y="668"/>
                  <a:pt x="2351" y="706"/>
                </a:cubicBezTo>
                <a:cubicBezTo>
                  <a:pt x="2353" y="744"/>
                  <a:pt x="2330" y="787"/>
                  <a:pt x="2282" y="834"/>
                </a:cubicBezTo>
                <a:lnTo>
                  <a:pt x="2196" y="920"/>
                </a:lnTo>
                <a:lnTo>
                  <a:pt x="2333" y="1057"/>
                </a:lnTo>
                <a:lnTo>
                  <a:pt x="2288" y="1101"/>
                </a:lnTo>
                <a:close/>
                <a:moveTo>
                  <a:pt x="2157" y="881"/>
                </a:moveTo>
                <a:lnTo>
                  <a:pt x="2243" y="794"/>
                </a:lnTo>
                <a:cubicBezTo>
                  <a:pt x="2272" y="765"/>
                  <a:pt x="2287" y="739"/>
                  <a:pt x="2289" y="716"/>
                </a:cubicBezTo>
                <a:cubicBezTo>
                  <a:pt x="2290" y="694"/>
                  <a:pt x="2281" y="673"/>
                  <a:pt x="2262" y="653"/>
                </a:cubicBezTo>
                <a:cubicBezTo>
                  <a:pt x="2247" y="639"/>
                  <a:pt x="2232" y="631"/>
                  <a:pt x="2215" y="628"/>
                </a:cubicBezTo>
                <a:cubicBezTo>
                  <a:pt x="2198" y="625"/>
                  <a:pt x="2182" y="628"/>
                  <a:pt x="2167" y="636"/>
                </a:cubicBezTo>
                <a:cubicBezTo>
                  <a:pt x="2157" y="642"/>
                  <a:pt x="2143" y="654"/>
                  <a:pt x="2122" y="675"/>
                </a:cubicBezTo>
                <a:lnTo>
                  <a:pt x="2036" y="761"/>
                </a:lnTo>
                <a:lnTo>
                  <a:pt x="2157" y="881"/>
                </a:lnTo>
                <a:close/>
                <a:moveTo>
                  <a:pt x="2476" y="697"/>
                </a:moveTo>
                <a:lnTo>
                  <a:pt x="2515" y="652"/>
                </a:lnTo>
                <a:cubicBezTo>
                  <a:pt x="2533" y="667"/>
                  <a:pt x="2552" y="676"/>
                  <a:pt x="2570" y="679"/>
                </a:cubicBezTo>
                <a:cubicBezTo>
                  <a:pt x="2588" y="683"/>
                  <a:pt x="2608" y="680"/>
                  <a:pt x="2630" y="672"/>
                </a:cubicBezTo>
                <a:cubicBezTo>
                  <a:pt x="2652" y="663"/>
                  <a:pt x="2672" y="649"/>
                  <a:pt x="2691" y="630"/>
                </a:cubicBezTo>
                <a:cubicBezTo>
                  <a:pt x="2708" y="613"/>
                  <a:pt x="2721" y="596"/>
                  <a:pt x="2729" y="578"/>
                </a:cubicBezTo>
                <a:cubicBezTo>
                  <a:pt x="2737" y="559"/>
                  <a:pt x="2740" y="543"/>
                  <a:pt x="2737" y="528"/>
                </a:cubicBezTo>
                <a:cubicBezTo>
                  <a:pt x="2735" y="513"/>
                  <a:pt x="2728" y="500"/>
                  <a:pt x="2718" y="489"/>
                </a:cubicBezTo>
                <a:cubicBezTo>
                  <a:pt x="2707" y="479"/>
                  <a:pt x="2695" y="473"/>
                  <a:pt x="2681" y="471"/>
                </a:cubicBezTo>
                <a:cubicBezTo>
                  <a:pt x="2667" y="469"/>
                  <a:pt x="2650" y="473"/>
                  <a:pt x="2631" y="481"/>
                </a:cubicBezTo>
                <a:cubicBezTo>
                  <a:pt x="2618" y="487"/>
                  <a:pt x="2593" y="501"/>
                  <a:pt x="2555" y="525"/>
                </a:cubicBezTo>
                <a:cubicBezTo>
                  <a:pt x="2516" y="548"/>
                  <a:pt x="2488" y="563"/>
                  <a:pt x="2469" y="569"/>
                </a:cubicBezTo>
                <a:cubicBezTo>
                  <a:pt x="2444" y="576"/>
                  <a:pt x="2422" y="578"/>
                  <a:pt x="2402" y="573"/>
                </a:cubicBezTo>
                <a:cubicBezTo>
                  <a:pt x="2381" y="569"/>
                  <a:pt x="2363" y="559"/>
                  <a:pt x="2348" y="543"/>
                </a:cubicBezTo>
                <a:cubicBezTo>
                  <a:pt x="2331" y="526"/>
                  <a:pt x="2320" y="506"/>
                  <a:pt x="2315" y="481"/>
                </a:cubicBezTo>
                <a:cubicBezTo>
                  <a:pt x="2310" y="457"/>
                  <a:pt x="2313" y="432"/>
                  <a:pt x="2323" y="406"/>
                </a:cubicBezTo>
                <a:cubicBezTo>
                  <a:pt x="2334" y="379"/>
                  <a:pt x="2351" y="355"/>
                  <a:pt x="2374" y="332"/>
                </a:cubicBezTo>
                <a:cubicBezTo>
                  <a:pt x="2399" y="308"/>
                  <a:pt x="2425" y="290"/>
                  <a:pt x="2452" y="279"/>
                </a:cubicBezTo>
                <a:cubicBezTo>
                  <a:pt x="2479" y="268"/>
                  <a:pt x="2505" y="265"/>
                  <a:pt x="2531" y="270"/>
                </a:cubicBezTo>
                <a:cubicBezTo>
                  <a:pt x="2557" y="275"/>
                  <a:pt x="2580" y="288"/>
                  <a:pt x="2600" y="307"/>
                </a:cubicBezTo>
                <a:lnTo>
                  <a:pt x="2561" y="352"/>
                </a:lnTo>
                <a:cubicBezTo>
                  <a:pt x="2537" y="333"/>
                  <a:pt x="2514" y="325"/>
                  <a:pt x="2490" y="328"/>
                </a:cubicBezTo>
                <a:cubicBezTo>
                  <a:pt x="2465" y="330"/>
                  <a:pt x="2441" y="344"/>
                  <a:pt x="2415" y="370"/>
                </a:cubicBezTo>
                <a:cubicBezTo>
                  <a:pt x="2388" y="397"/>
                  <a:pt x="2373" y="421"/>
                  <a:pt x="2371" y="443"/>
                </a:cubicBezTo>
                <a:cubicBezTo>
                  <a:pt x="2368" y="466"/>
                  <a:pt x="2374" y="484"/>
                  <a:pt x="2388" y="498"/>
                </a:cubicBezTo>
                <a:cubicBezTo>
                  <a:pt x="2400" y="510"/>
                  <a:pt x="2414" y="515"/>
                  <a:pt x="2431" y="514"/>
                </a:cubicBezTo>
                <a:cubicBezTo>
                  <a:pt x="2447" y="513"/>
                  <a:pt x="2477" y="499"/>
                  <a:pt x="2522" y="471"/>
                </a:cubicBezTo>
                <a:cubicBezTo>
                  <a:pt x="2566" y="443"/>
                  <a:pt x="2598" y="426"/>
                  <a:pt x="2618" y="418"/>
                </a:cubicBezTo>
                <a:cubicBezTo>
                  <a:pt x="2646" y="408"/>
                  <a:pt x="2672" y="405"/>
                  <a:pt x="2695" y="409"/>
                </a:cubicBezTo>
                <a:cubicBezTo>
                  <a:pt x="2718" y="414"/>
                  <a:pt x="2739" y="425"/>
                  <a:pt x="2757" y="443"/>
                </a:cubicBezTo>
                <a:cubicBezTo>
                  <a:pt x="2775" y="461"/>
                  <a:pt x="2787" y="483"/>
                  <a:pt x="2792" y="509"/>
                </a:cubicBezTo>
                <a:cubicBezTo>
                  <a:pt x="2798" y="535"/>
                  <a:pt x="2795" y="562"/>
                  <a:pt x="2785" y="590"/>
                </a:cubicBezTo>
                <a:cubicBezTo>
                  <a:pt x="2775" y="618"/>
                  <a:pt x="2757" y="644"/>
                  <a:pt x="2733" y="668"/>
                </a:cubicBezTo>
                <a:cubicBezTo>
                  <a:pt x="2703" y="698"/>
                  <a:pt x="2673" y="719"/>
                  <a:pt x="2644" y="731"/>
                </a:cubicBezTo>
                <a:cubicBezTo>
                  <a:pt x="2614" y="743"/>
                  <a:pt x="2585" y="745"/>
                  <a:pt x="2555" y="739"/>
                </a:cubicBezTo>
                <a:cubicBezTo>
                  <a:pt x="2526" y="733"/>
                  <a:pt x="2499" y="719"/>
                  <a:pt x="2476" y="697"/>
                </a:cubicBezTo>
                <a:close/>
                <a:moveTo>
                  <a:pt x="2811" y="401"/>
                </a:moveTo>
                <a:lnTo>
                  <a:pt x="2847" y="355"/>
                </a:lnTo>
                <a:cubicBezTo>
                  <a:pt x="2875" y="373"/>
                  <a:pt x="2900" y="382"/>
                  <a:pt x="2922" y="381"/>
                </a:cubicBezTo>
                <a:cubicBezTo>
                  <a:pt x="2943" y="380"/>
                  <a:pt x="2962" y="371"/>
                  <a:pt x="2979" y="355"/>
                </a:cubicBezTo>
                <a:cubicBezTo>
                  <a:pt x="2998" y="335"/>
                  <a:pt x="3008" y="312"/>
                  <a:pt x="3008" y="285"/>
                </a:cubicBezTo>
                <a:cubicBezTo>
                  <a:pt x="3008" y="259"/>
                  <a:pt x="2998" y="235"/>
                  <a:pt x="2978" y="215"/>
                </a:cubicBezTo>
                <a:cubicBezTo>
                  <a:pt x="2959" y="196"/>
                  <a:pt x="2937" y="187"/>
                  <a:pt x="2912" y="187"/>
                </a:cubicBezTo>
                <a:cubicBezTo>
                  <a:pt x="2888" y="187"/>
                  <a:pt x="2866" y="197"/>
                  <a:pt x="2847" y="216"/>
                </a:cubicBezTo>
                <a:cubicBezTo>
                  <a:pt x="2839" y="224"/>
                  <a:pt x="2831" y="235"/>
                  <a:pt x="2822" y="250"/>
                </a:cubicBezTo>
                <a:lnTo>
                  <a:pt x="2790" y="209"/>
                </a:lnTo>
                <a:cubicBezTo>
                  <a:pt x="2793" y="206"/>
                  <a:pt x="2796" y="204"/>
                  <a:pt x="2798" y="203"/>
                </a:cubicBezTo>
                <a:cubicBezTo>
                  <a:pt x="2815" y="185"/>
                  <a:pt x="2826" y="165"/>
                  <a:pt x="2831" y="141"/>
                </a:cubicBezTo>
                <a:cubicBezTo>
                  <a:pt x="2836" y="118"/>
                  <a:pt x="2829" y="97"/>
                  <a:pt x="2810" y="78"/>
                </a:cubicBezTo>
                <a:cubicBezTo>
                  <a:pt x="2795" y="63"/>
                  <a:pt x="2777" y="55"/>
                  <a:pt x="2757" y="56"/>
                </a:cubicBezTo>
                <a:cubicBezTo>
                  <a:pt x="2737" y="56"/>
                  <a:pt x="2719" y="64"/>
                  <a:pt x="2702" y="80"/>
                </a:cubicBezTo>
                <a:cubicBezTo>
                  <a:pt x="2686" y="96"/>
                  <a:pt x="2678" y="115"/>
                  <a:pt x="2677" y="136"/>
                </a:cubicBezTo>
                <a:cubicBezTo>
                  <a:pt x="2677" y="156"/>
                  <a:pt x="2685" y="178"/>
                  <a:pt x="2702" y="202"/>
                </a:cubicBezTo>
                <a:lnTo>
                  <a:pt x="2654" y="236"/>
                </a:lnTo>
                <a:cubicBezTo>
                  <a:pt x="2631" y="203"/>
                  <a:pt x="2621" y="170"/>
                  <a:pt x="2624" y="137"/>
                </a:cubicBezTo>
                <a:cubicBezTo>
                  <a:pt x="2626" y="104"/>
                  <a:pt x="2641" y="74"/>
                  <a:pt x="2668" y="47"/>
                </a:cubicBezTo>
                <a:cubicBezTo>
                  <a:pt x="2686" y="29"/>
                  <a:pt x="2707" y="16"/>
                  <a:pt x="2730" y="8"/>
                </a:cubicBezTo>
                <a:cubicBezTo>
                  <a:pt x="2753" y="1"/>
                  <a:pt x="2776" y="0"/>
                  <a:pt x="2798" y="5"/>
                </a:cubicBezTo>
                <a:cubicBezTo>
                  <a:pt x="2819" y="11"/>
                  <a:pt x="2838" y="21"/>
                  <a:pt x="2853" y="36"/>
                </a:cubicBezTo>
                <a:cubicBezTo>
                  <a:pt x="2868" y="51"/>
                  <a:pt x="2877" y="68"/>
                  <a:pt x="2881" y="88"/>
                </a:cubicBezTo>
                <a:cubicBezTo>
                  <a:pt x="2885" y="107"/>
                  <a:pt x="2883" y="128"/>
                  <a:pt x="2875" y="151"/>
                </a:cubicBezTo>
                <a:cubicBezTo>
                  <a:pt x="2899" y="135"/>
                  <a:pt x="2924" y="129"/>
                  <a:pt x="2950" y="133"/>
                </a:cubicBezTo>
                <a:cubicBezTo>
                  <a:pt x="2975" y="136"/>
                  <a:pt x="2999" y="149"/>
                  <a:pt x="3021" y="171"/>
                </a:cubicBezTo>
                <a:cubicBezTo>
                  <a:pt x="3050" y="200"/>
                  <a:pt x="3064" y="236"/>
                  <a:pt x="3063" y="277"/>
                </a:cubicBezTo>
                <a:cubicBezTo>
                  <a:pt x="3062" y="319"/>
                  <a:pt x="3045" y="356"/>
                  <a:pt x="3013" y="389"/>
                </a:cubicBezTo>
                <a:cubicBezTo>
                  <a:pt x="2983" y="419"/>
                  <a:pt x="2950" y="434"/>
                  <a:pt x="2913" y="436"/>
                </a:cubicBezTo>
                <a:cubicBezTo>
                  <a:pt x="2876" y="438"/>
                  <a:pt x="2842" y="426"/>
                  <a:pt x="2811" y="401"/>
                </a:cubicBez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0" name="Freeform 66"/>
          <p:cNvSpPr>
            <a:spLocks noEditPoints="1"/>
          </p:cNvSpPr>
          <p:nvPr/>
        </p:nvSpPr>
        <p:spPr bwMode="auto">
          <a:xfrm>
            <a:off x="1868630" y="5035690"/>
            <a:ext cx="581025" cy="582613"/>
          </a:xfrm>
          <a:custGeom>
            <a:avLst/>
            <a:gdLst>
              <a:gd name="T0" fmla="*/ 420 w 3055"/>
              <a:gd name="T1" fmla="*/ 2985 h 3059"/>
              <a:gd name="T2" fmla="*/ 14 w 3055"/>
              <a:gd name="T3" fmla="*/ 2855 h 3059"/>
              <a:gd name="T4" fmla="*/ 303 w 3055"/>
              <a:gd name="T5" fmla="*/ 2601 h 3059"/>
              <a:gd name="T6" fmla="*/ 64 w 3055"/>
              <a:gd name="T7" fmla="*/ 2759 h 3059"/>
              <a:gd name="T8" fmla="*/ 305 w 3055"/>
              <a:gd name="T9" fmla="*/ 2991 h 3059"/>
              <a:gd name="T10" fmla="*/ 466 w 3055"/>
              <a:gd name="T11" fmla="*/ 2683 h 3059"/>
              <a:gd name="T12" fmla="*/ 690 w 3055"/>
              <a:gd name="T13" fmla="*/ 2452 h 3059"/>
              <a:gd name="T14" fmla="*/ 592 w 3055"/>
              <a:gd name="T15" fmla="*/ 2746 h 3059"/>
              <a:gd name="T16" fmla="*/ 673 w 3055"/>
              <a:gd name="T17" fmla="*/ 2663 h 3059"/>
              <a:gd name="T18" fmla="*/ 487 w 3055"/>
              <a:gd name="T19" fmla="*/ 2476 h 3059"/>
              <a:gd name="T20" fmla="*/ 625 w 3055"/>
              <a:gd name="T21" fmla="*/ 2280 h 3059"/>
              <a:gd name="T22" fmla="*/ 783 w 3055"/>
              <a:gd name="T23" fmla="*/ 2128 h 3059"/>
              <a:gd name="T24" fmla="*/ 1067 w 3055"/>
              <a:gd name="T25" fmla="*/ 2326 h 3059"/>
              <a:gd name="T26" fmla="*/ 798 w 3055"/>
              <a:gd name="T27" fmla="*/ 2183 h 3059"/>
              <a:gd name="T28" fmla="*/ 910 w 3055"/>
              <a:gd name="T29" fmla="*/ 2483 h 3059"/>
              <a:gd name="T30" fmla="*/ 1197 w 3055"/>
              <a:gd name="T31" fmla="*/ 2202 h 3059"/>
              <a:gd name="T32" fmla="*/ 925 w 3055"/>
              <a:gd name="T33" fmla="*/ 2045 h 3059"/>
              <a:gd name="T34" fmla="*/ 833 w 3055"/>
              <a:gd name="T35" fmla="*/ 1952 h 3059"/>
              <a:gd name="T36" fmla="*/ 1008 w 3055"/>
              <a:gd name="T37" fmla="*/ 1962 h 3059"/>
              <a:gd name="T38" fmla="*/ 1149 w 3055"/>
              <a:gd name="T39" fmla="*/ 2168 h 3059"/>
              <a:gd name="T40" fmla="*/ 1015 w 3055"/>
              <a:gd name="T41" fmla="*/ 1891 h 3059"/>
              <a:gd name="T42" fmla="*/ 1099 w 3055"/>
              <a:gd name="T43" fmla="*/ 1795 h 3059"/>
              <a:gd name="T44" fmla="*/ 1124 w 3055"/>
              <a:gd name="T45" fmla="*/ 1872 h 3059"/>
              <a:gd name="T46" fmla="*/ 1259 w 3055"/>
              <a:gd name="T47" fmla="*/ 2134 h 3059"/>
              <a:gd name="T48" fmla="*/ 1382 w 3055"/>
              <a:gd name="T49" fmla="*/ 1578 h 3059"/>
              <a:gd name="T50" fmla="*/ 1522 w 3055"/>
              <a:gd name="T51" fmla="*/ 1882 h 3059"/>
              <a:gd name="T52" fmla="*/ 1413 w 3055"/>
              <a:gd name="T53" fmla="*/ 1876 h 3059"/>
              <a:gd name="T54" fmla="*/ 1376 w 3055"/>
              <a:gd name="T55" fmla="*/ 1634 h 3059"/>
              <a:gd name="T56" fmla="*/ 1677 w 3055"/>
              <a:gd name="T57" fmla="*/ 1716 h 3059"/>
              <a:gd name="T58" fmla="*/ 1677 w 3055"/>
              <a:gd name="T59" fmla="*/ 1716 h 3059"/>
              <a:gd name="T60" fmla="*/ 1614 w 3055"/>
              <a:gd name="T61" fmla="*/ 1309 h 3059"/>
              <a:gd name="T62" fmla="*/ 1565 w 3055"/>
              <a:gd name="T63" fmla="*/ 1153 h 3059"/>
              <a:gd name="T64" fmla="*/ 1840 w 3055"/>
              <a:gd name="T65" fmla="*/ 881 h 3059"/>
              <a:gd name="T66" fmla="*/ 2176 w 3055"/>
              <a:gd name="T67" fmla="*/ 1217 h 3059"/>
              <a:gd name="T68" fmla="*/ 2176 w 3055"/>
              <a:gd name="T69" fmla="*/ 1217 h 3059"/>
              <a:gd name="T70" fmla="*/ 2133 w 3055"/>
              <a:gd name="T71" fmla="*/ 594 h 3059"/>
              <a:gd name="T72" fmla="*/ 2351 w 3055"/>
              <a:gd name="T73" fmla="*/ 709 h 3059"/>
              <a:gd name="T74" fmla="*/ 2288 w 3055"/>
              <a:gd name="T75" fmla="*/ 1104 h 3059"/>
              <a:gd name="T76" fmla="*/ 2261 w 3055"/>
              <a:gd name="T77" fmla="*/ 656 h 3059"/>
              <a:gd name="T78" fmla="*/ 2036 w 3055"/>
              <a:gd name="T79" fmla="*/ 764 h 3059"/>
              <a:gd name="T80" fmla="*/ 2570 w 3055"/>
              <a:gd name="T81" fmla="*/ 682 h 3059"/>
              <a:gd name="T82" fmla="*/ 2737 w 3055"/>
              <a:gd name="T83" fmla="*/ 531 h 3059"/>
              <a:gd name="T84" fmla="*/ 2555 w 3055"/>
              <a:gd name="T85" fmla="*/ 528 h 3059"/>
              <a:gd name="T86" fmla="*/ 2315 w 3055"/>
              <a:gd name="T87" fmla="*/ 484 h 3059"/>
              <a:gd name="T88" fmla="*/ 2531 w 3055"/>
              <a:gd name="T89" fmla="*/ 273 h 3059"/>
              <a:gd name="T90" fmla="*/ 2415 w 3055"/>
              <a:gd name="T91" fmla="*/ 373 h 3059"/>
              <a:gd name="T92" fmla="*/ 2522 w 3055"/>
              <a:gd name="T93" fmla="*/ 474 h 3059"/>
              <a:gd name="T94" fmla="*/ 2792 w 3055"/>
              <a:gd name="T95" fmla="*/ 512 h 3059"/>
              <a:gd name="T96" fmla="*/ 2555 w 3055"/>
              <a:gd name="T97" fmla="*/ 742 h 3059"/>
              <a:gd name="T98" fmla="*/ 2751 w 3055"/>
              <a:gd name="T99" fmla="*/ 116 h 3059"/>
              <a:gd name="T100" fmla="*/ 2699 w 3055"/>
              <a:gd name="T101" fmla="*/ 109 h 305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</a:cxnLst>
            <a:rect l="0" t="0" r="r" b="b"/>
            <a:pathLst>
              <a:path w="3055" h="3059">
                <a:moveTo>
                  <a:pt x="391" y="2766"/>
                </a:moveTo>
                <a:lnTo>
                  <a:pt x="446" y="2733"/>
                </a:lnTo>
                <a:cubicBezTo>
                  <a:pt x="474" y="2779"/>
                  <a:pt x="485" y="2824"/>
                  <a:pt x="480" y="2867"/>
                </a:cubicBezTo>
                <a:cubicBezTo>
                  <a:pt x="475" y="2910"/>
                  <a:pt x="455" y="2950"/>
                  <a:pt x="420" y="2985"/>
                </a:cubicBezTo>
                <a:cubicBezTo>
                  <a:pt x="383" y="3021"/>
                  <a:pt x="347" y="3043"/>
                  <a:pt x="309" y="3051"/>
                </a:cubicBezTo>
                <a:cubicBezTo>
                  <a:pt x="272" y="3059"/>
                  <a:pt x="233" y="3055"/>
                  <a:pt x="193" y="3039"/>
                </a:cubicBezTo>
                <a:cubicBezTo>
                  <a:pt x="153" y="3022"/>
                  <a:pt x="117" y="2998"/>
                  <a:pt x="85" y="2966"/>
                </a:cubicBezTo>
                <a:cubicBezTo>
                  <a:pt x="50" y="2931"/>
                  <a:pt x="26" y="2894"/>
                  <a:pt x="14" y="2855"/>
                </a:cubicBezTo>
                <a:cubicBezTo>
                  <a:pt x="1" y="2815"/>
                  <a:pt x="0" y="2776"/>
                  <a:pt x="11" y="2738"/>
                </a:cubicBezTo>
                <a:cubicBezTo>
                  <a:pt x="23" y="2700"/>
                  <a:pt x="43" y="2666"/>
                  <a:pt x="73" y="2636"/>
                </a:cubicBezTo>
                <a:cubicBezTo>
                  <a:pt x="106" y="2603"/>
                  <a:pt x="143" y="2583"/>
                  <a:pt x="183" y="2577"/>
                </a:cubicBezTo>
                <a:cubicBezTo>
                  <a:pt x="223" y="2571"/>
                  <a:pt x="263" y="2579"/>
                  <a:pt x="303" y="2601"/>
                </a:cubicBezTo>
                <a:lnTo>
                  <a:pt x="270" y="2656"/>
                </a:lnTo>
                <a:cubicBezTo>
                  <a:pt x="238" y="2639"/>
                  <a:pt x="209" y="2632"/>
                  <a:pt x="183" y="2636"/>
                </a:cubicBezTo>
                <a:cubicBezTo>
                  <a:pt x="157" y="2640"/>
                  <a:pt x="132" y="2653"/>
                  <a:pt x="110" y="2675"/>
                </a:cubicBezTo>
                <a:cubicBezTo>
                  <a:pt x="84" y="2701"/>
                  <a:pt x="69" y="2729"/>
                  <a:pt x="64" y="2759"/>
                </a:cubicBezTo>
                <a:cubicBezTo>
                  <a:pt x="59" y="2788"/>
                  <a:pt x="63" y="2817"/>
                  <a:pt x="77" y="2845"/>
                </a:cubicBezTo>
                <a:cubicBezTo>
                  <a:pt x="91" y="2873"/>
                  <a:pt x="109" y="2898"/>
                  <a:pt x="131" y="2920"/>
                </a:cubicBezTo>
                <a:cubicBezTo>
                  <a:pt x="160" y="2949"/>
                  <a:pt x="189" y="2969"/>
                  <a:pt x="218" y="2982"/>
                </a:cubicBezTo>
                <a:cubicBezTo>
                  <a:pt x="248" y="2995"/>
                  <a:pt x="277" y="2998"/>
                  <a:pt x="305" y="2991"/>
                </a:cubicBezTo>
                <a:cubicBezTo>
                  <a:pt x="333" y="2984"/>
                  <a:pt x="357" y="2971"/>
                  <a:pt x="378" y="2950"/>
                </a:cubicBezTo>
                <a:cubicBezTo>
                  <a:pt x="403" y="2925"/>
                  <a:pt x="417" y="2897"/>
                  <a:pt x="420" y="2865"/>
                </a:cubicBezTo>
                <a:cubicBezTo>
                  <a:pt x="422" y="2834"/>
                  <a:pt x="413" y="2801"/>
                  <a:pt x="391" y="2766"/>
                </a:cubicBezTo>
                <a:close/>
                <a:moveTo>
                  <a:pt x="466" y="2683"/>
                </a:moveTo>
                <a:cubicBezTo>
                  <a:pt x="421" y="2638"/>
                  <a:pt x="400" y="2592"/>
                  <a:pt x="403" y="2546"/>
                </a:cubicBezTo>
                <a:cubicBezTo>
                  <a:pt x="406" y="2507"/>
                  <a:pt x="423" y="2472"/>
                  <a:pt x="453" y="2442"/>
                </a:cubicBezTo>
                <a:cubicBezTo>
                  <a:pt x="486" y="2409"/>
                  <a:pt x="524" y="2392"/>
                  <a:pt x="568" y="2393"/>
                </a:cubicBezTo>
                <a:cubicBezTo>
                  <a:pt x="611" y="2393"/>
                  <a:pt x="652" y="2413"/>
                  <a:pt x="690" y="2452"/>
                </a:cubicBezTo>
                <a:cubicBezTo>
                  <a:pt x="722" y="2483"/>
                  <a:pt x="742" y="2513"/>
                  <a:pt x="750" y="2540"/>
                </a:cubicBezTo>
                <a:cubicBezTo>
                  <a:pt x="759" y="2567"/>
                  <a:pt x="759" y="2595"/>
                  <a:pt x="751" y="2623"/>
                </a:cubicBezTo>
                <a:cubicBezTo>
                  <a:pt x="743" y="2651"/>
                  <a:pt x="728" y="2675"/>
                  <a:pt x="707" y="2696"/>
                </a:cubicBezTo>
                <a:cubicBezTo>
                  <a:pt x="673" y="2731"/>
                  <a:pt x="635" y="2747"/>
                  <a:pt x="592" y="2746"/>
                </a:cubicBezTo>
                <a:cubicBezTo>
                  <a:pt x="549" y="2745"/>
                  <a:pt x="507" y="2725"/>
                  <a:pt x="466" y="2683"/>
                </a:cubicBezTo>
                <a:close/>
                <a:moveTo>
                  <a:pt x="508" y="2641"/>
                </a:moveTo>
                <a:cubicBezTo>
                  <a:pt x="539" y="2672"/>
                  <a:pt x="570" y="2689"/>
                  <a:pt x="599" y="2691"/>
                </a:cubicBezTo>
                <a:cubicBezTo>
                  <a:pt x="628" y="2693"/>
                  <a:pt x="653" y="2683"/>
                  <a:pt x="673" y="2663"/>
                </a:cubicBezTo>
                <a:cubicBezTo>
                  <a:pt x="694" y="2642"/>
                  <a:pt x="703" y="2617"/>
                  <a:pt x="701" y="2588"/>
                </a:cubicBezTo>
                <a:cubicBezTo>
                  <a:pt x="699" y="2559"/>
                  <a:pt x="682" y="2528"/>
                  <a:pt x="650" y="2496"/>
                </a:cubicBezTo>
                <a:cubicBezTo>
                  <a:pt x="620" y="2466"/>
                  <a:pt x="590" y="2450"/>
                  <a:pt x="561" y="2448"/>
                </a:cubicBezTo>
                <a:cubicBezTo>
                  <a:pt x="532" y="2447"/>
                  <a:pt x="507" y="2456"/>
                  <a:pt x="487" y="2476"/>
                </a:cubicBezTo>
                <a:cubicBezTo>
                  <a:pt x="466" y="2497"/>
                  <a:pt x="457" y="2522"/>
                  <a:pt x="459" y="2551"/>
                </a:cubicBezTo>
                <a:cubicBezTo>
                  <a:pt x="460" y="2580"/>
                  <a:pt x="477" y="2610"/>
                  <a:pt x="508" y="2641"/>
                </a:cubicBezTo>
                <a:close/>
                <a:moveTo>
                  <a:pt x="869" y="2524"/>
                </a:moveTo>
                <a:lnTo>
                  <a:pt x="625" y="2280"/>
                </a:lnTo>
                <a:lnTo>
                  <a:pt x="662" y="2243"/>
                </a:lnTo>
                <a:lnTo>
                  <a:pt x="697" y="2278"/>
                </a:lnTo>
                <a:cubicBezTo>
                  <a:pt x="688" y="2233"/>
                  <a:pt x="701" y="2194"/>
                  <a:pt x="734" y="2160"/>
                </a:cubicBezTo>
                <a:cubicBezTo>
                  <a:pt x="749" y="2146"/>
                  <a:pt x="765" y="2135"/>
                  <a:pt x="783" y="2128"/>
                </a:cubicBezTo>
                <a:cubicBezTo>
                  <a:pt x="800" y="2121"/>
                  <a:pt x="816" y="2118"/>
                  <a:pt x="831" y="2121"/>
                </a:cubicBezTo>
                <a:cubicBezTo>
                  <a:pt x="846" y="2123"/>
                  <a:pt x="860" y="2129"/>
                  <a:pt x="874" y="2139"/>
                </a:cubicBezTo>
                <a:cubicBezTo>
                  <a:pt x="884" y="2145"/>
                  <a:pt x="898" y="2157"/>
                  <a:pt x="917" y="2176"/>
                </a:cubicBezTo>
                <a:lnTo>
                  <a:pt x="1067" y="2326"/>
                </a:lnTo>
                <a:lnTo>
                  <a:pt x="1025" y="2367"/>
                </a:lnTo>
                <a:lnTo>
                  <a:pt x="877" y="2219"/>
                </a:lnTo>
                <a:cubicBezTo>
                  <a:pt x="860" y="2202"/>
                  <a:pt x="846" y="2191"/>
                  <a:pt x="835" y="2186"/>
                </a:cubicBezTo>
                <a:cubicBezTo>
                  <a:pt x="823" y="2181"/>
                  <a:pt x="811" y="2180"/>
                  <a:pt x="798" y="2183"/>
                </a:cubicBezTo>
                <a:cubicBezTo>
                  <a:pt x="785" y="2187"/>
                  <a:pt x="772" y="2194"/>
                  <a:pt x="761" y="2205"/>
                </a:cubicBezTo>
                <a:cubicBezTo>
                  <a:pt x="744" y="2222"/>
                  <a:pt x="734" y="2243"/>
                  <a:pt x="733" y="2267"/>
                </a:cubicBezTo>
                <a:cubicBezTo>
                  <a:pt x="731" y="2291"/>
                  <a:pt x="746" y="2318"/>
                  <a:pt x="777" y="2350"/>
                </a:cubicBezTo>
                <a:lnTo>
                  <a:pt x="910" y="2483"/>
                </a:lnTo>
                <a:lnTo>
                  <a:pt x="869" y="2524"/>
                </a:lnTo>
                <a:close/>
                <a:moveTo>
                  <a:pt x="1182" y="2137"/>
                </a:moveTo>
                <a:lnTo>
                  <a:pt x="1225" y="2167"/>
                </a:lnTo>
                <a:cubicBezTo>
                  <a:pt x="1215" y="2181"/>
                  <a:pt x="1206" y="2193"/>
                  <a:pt x="1197" y="2202"/>
                </a:cubicBezTo>
                <a:cubicBezTo>
                  <a:pt x="1182" y="2217"/>
                  <a:pt x="1168" y="2226"/>
                  <a:pt x="1155" y="2230"/>
                </a:cubicBezTo>
                <a:cubicBezTo>
                  <a:pt x="1142" y="2233"/>
                  <a:pt x="1130" y="2233"/>
                  <a:pt x="1119" y="2228"/>
                </a:cubicBezTo>
                <a:cubicBezTo>
                  <a:pt x="1108" y="2224"/>
                  <a:pt x="1090" y="2210"/>
                  <a:pt x="1065" y="2185"/>
                </a:cubicBezTo>
                <a:lnTo>
                  <a:pt x="925" y="2045"/>
                </a:lnTo>
                <a:lnTo>
                  <a:pt x="895" y="2075"/>
                </a:lnTo>
                <a:lnTo>
                  <a:pt x="863" y="2043"/>
                </a:lnTo>
                <a:lnTo>
                  <a:pt x="893" y="2013"/>
                </a:lnTo>
                <a:lnTo>
                  <a:pt x="833" y="1952"/>
                </a:lnTo>
                <a:lnTo>
                  <a:pt x="849" y="1887"/>
                </a:lnTo>
                <a:lnTo>
                  <a:pt x="934" y="1972"/>
                </a:lnTo>
                <a:lnTo>
                  <a:pt x="976" y="1930"/>
                </a:lnTo>
                <a:lnTo>
                  <a:pt x="1008" y="1962"/>
                </a:lnTo>
                <a:lnTo>
                  <a:pt x="966" y="2004"/>
                </a:lnTo>
                <a:lnTo>
                  <a:pt x="1109" y="2146"/>
                </a:lnTo>
                <a:cubicBezTo>
                  <a:pt x="1120" y="2158"/>
                  <a:pt x="1129" y="2165"/>
                  <a:pt x="1133" y="2167"/>
                </a:cubicBezTo>
                <a:cubicBezTo>
                  <a:pt x="1138" y="2168"/>
                  <a:pt x="1143" y="2169"/>
                  <a:pt x="1149" y="2168"/>
                </a:cubicBezTo>
                <a:cubicBezTo>
                  <a:pt x="1154" y="2166"/>
                  <a:pt x="1160" y="2162"/>
                  <a:pt x="1166" y="2156"/>
                </a:cubicBezTo>
                <a:cubicBezTo>
                  <a:pt x="1170" y="2152"/>
                  <a:pt x="1176" y="2145"/>
                  <a:pt x="1182" y="2137"/>
                </a:cubicBezTo>
                <a:close/>
                <a:moveTo>
                  <a:pt x="1259" y="2134"/>
                </a:moveTo>
                <a:lnTo>
                  <a:pt x="1015" y="1891"/>
                </a:lnTo>
                <a:lnTo>
                  <a:pt x="1052" y="1853"/>
                </a:lnTo>
                <a:lnTo>
                  <a:pt x="1089" y="1890"/>
                </a:lnTo>
                <a:cubicBezTo>
                  <a:pt x="1081" y="1864"/>
                  <a:pt x="1079" y="1843"/>
                  <a:pt x="1081" y="1830"/>
                </a:cubicBezTo>
                <a:cubicBezTo>
                  <a:pt x="1084" y="1816"/>
                  <a:pt x="1090" y="1805"/>
                  <a:pt x="1099" y="1795"/>
                </a:cubicBezTo>
                <a:cubicBezTo>
                  <a:pt x="1113" y="1781"/>
                  <a:pt x="1132" y="1772"/>
                  <a:pt x="1155" y="1766"/>
                </a:cubicBezTo>
                <a:lnTo>
                  <a:pt x="1179" y="1819"/>
                </a:lnTo>
                <a:cubicBezTo>
                  <a:pt x="1163" y="1823"/>
                  <a:pt x="1150" y="1830"/>
                  <a:pt x="1140" y="1840"/>
                </a:cubicBezTo>
                <a:cubicBezTo>
                  <a:pt x="1131" y="1849"/>
                  <a:pt x="1126" y="1860"/>
                  <a:pt x="1124" y="1872"/>
                </a:cubicBezTo>
                <a:cubicBezTo>
                  <a:pt x="1122" y="1885"/>
                  <a:pt x="1125" y="1898"/>
                  <a:pt x="1131" y="1910"/>
                </a:cubicBezTo>
                <a:cubicBezTo>
                  <a:pt x="1141" y="1930"/>
                  <a:pt x="1155" y="1948"/>
                  <a:pt x="1172" y="1965"/>
                </a:cubicBezTo>
                <a:lnTo>
                  <a:pt x="1300" y="2093"/>
                </a:lnTo>
                <a:lnTo>
                  <a:pt x="1259" y="2134"/>
                </a:lnTo>
                <a:close/>
                <a:moveTo>
                  <a:pt x="1280" y="1869"/>
                </a:moveTo>
                <a:cubicBezTo>
                  <a:pt x="1235" y="1824"/>
                  <a:pt x="1214" y="1778"/>
                  <a:pt x="1218" y="1731"/>
                </a:cubicBezTo>
                <a:cubicBezTo>
                  <a:pt x="1221" y="1692"/>
                  <a:pt x="1237" y="1658"/>
                  <a:pt x="1267" y="1627"/>
                </a:cubicBezTo>
                <a:cubicBezTo>
                  <a:pt x="1301" y="1594"/>
                  <a:pt x="1339" y="1578"/>
                  <a:pt x="1382" y="1578"/>
                </a:cubicBezTo>
                <a:cubicBezTo>
                  <a:pt x="1425" y="1579"/>
                  <a:pt x="1466" y="1599"/>
                  <a:pt x="1505" y="1637"/>
                </a:cubicBezTo>
                <a:cubicBezTo>
                  <a:pt x="1536" y="1669"/>
                  <a:pt x="1556" y="1698"/>
                  <a:pt x="1565" y="1725"/>
                </a:cubicBezTo>
                <a:cubicBezTo>
                  <a:pt x="1573" y="1753"/>
                  <a:pt x="1574" y="1780"/>
                  <a:pt x="1566" y="1808"/>
                </a:cubicBezTo>
                <a:cubicBezTo>
                  <a:pt x="1558" y="1836"/>
                  <a:pt x="1543" y="1861"/>
                  <a:pt x="1522" y="1882"/>
                </a:cubicBezTo>
                <a:cubicBezTo>
                  <a:pt x="1488" y="1916"/>
                  <a:pt x="1449" y="1933"/>
                  <a:pt x="1406" y="1932"/>
                </a:cubicBezTo>
                <a:cubicBezTo>
                  <a:pt x="1363" y="1931"/>
                  <a:pt x="1321" y="1910"/>
                  <a:pt x="1280" y="1869"/>
                </a:cubicBezTo>
                <a:close/>
                <a:moveTo>
                  <a:pt x="1323" y="1826"/>
                </a:moveTo>
                <a:cubicBezTo>
                  <a:pt x="1354" y="1858"/>
                  <a:pt x="1384" y="1874"/>
                  <a:pt x="1413" y="1876"/>
                </a:cubicBezTo>
                <a:cubicBezTo>
                  <a:pt x="1442" y="1878"/>
                  <a:pt x="1467" y="1869"/>
                  <a:pt x="1488" y="1848"/>
                </a:cubicBezTo>
                <a:cubicBezTo>
                  <a:pt x="1508" y="1827"/>
                  <a:pt x="1518" y="1803"/>
                  <a:pt x="1516" y="1773"/>
                </a:cubicBezTo>
                <a:cubicBezTo>
                  <a:pt x="1514" y="1744"/>
                  <a:pt x="1497" y="1714"/>
                  <a:pt x="1465" y="1682"/>
                </a:cubicBezTo>
                <a:cubicBezTo>
                  <a:pt x="1435" y="1652"/>
                  <a:pt x="1405" y="1636"/>
                  <a:pt x="1376" y="1634"/>
                </a:cubicBezTo>
                <a:cubicBezTo>
                  <a:pt x="1347" y="1632"/>
                  <a:pt x="1322" y="1641"/>
                  <a:pt x="1301" y="1662"/>
                </a:cubicBezTo>
                <a:cubicBezTo>
                  <a:pt x="1281" y="1682"/>
                  <a:pt x="1271" y="1707"/>
                  <a:pt x="1273" y="1736"/>
                </a:cubicBezTo>
                <a:cubicBezTo>
                  <a:pt x="1275" y="1765"/>
                  <a:pt x="1292" y="1795"/>
                  <a:pt x="1323" y="1826"/>
                </a:cubicBezTo>
                <a:close/>
                <a:moveTo>
                  <a:pt x="1677" y="1716"/>
                </a:moveTo>
                <a:lnTo>
                  <a:pt x="1341" y="1380"/>
                </a:lnTo>
                <a:lnTo>
                  <a:pt x="1382" y="1339"/>
                </a:lnTo>
                <a:lnTo>
                  <a:pt x="1718" y="1675"/>
                </a:lnTo>
                <a:lnTo>
                  <a:pt x="1677" y="1716"/>
                </a:lnTo>
                <a:close/>
                <a:moveTo>
                  <a:pt x="1929" y="1464"/>
                </a:moveTo>
                <a:lnTo>
                  <a:pt x="1888" y="1505"/>
                </a:lnTo>
                <a:lnTo>
                  <a:pt x="1625" y="1242"/>
                </a:lnTo>
                <a:cubicBezTo>
                  <a:pt x="1624" y="1261"/>
                  <a:pt x="1621" y="1284"/>
                  <a:pt x="1614" y="1309"/>
                </a:cubicBezTo>
                <a:cubicBezTo>
                  <a:pt x="1608" y="1335"/>
                  <a:pt x="1600" y="1357"/>
                  <a:pt x="1592" y="1374"/>
                </a:cubicBezTo>
                <a:lnTo>
                  <a:pt x="1552" y="1334"/>
                </a:lnTo>
                <a:cubicBezTo>
                  <a:pt x="1564" y="1300"/>
                  <a:pt x="1571" y="1267"/>
                  <a:pt x="1573" y="1234"/>
                </a:cubicBezTo>
                <a:cubicBezTo>
                  <a:pt x="1575" y="1202"/>
                  <a:pt x="1572" y="1174"/>
                  <a:pt x="1565" y="1153"/>
                </a:cubicBezTo>
                <a:lnTo>
                  <a:pt x="1592" y="1126"/>
                </a:lnTo>
                <a:lnTo>
                  <a:pt x="1929" y="1464"/>
                </a:lnTo>
                <a:close/>
                <a:moveTo>
                  <a:pt x="1887" y="928"/>
                </a:moveTo>
                <a:lnTo>
                  <a:pt x="1840" y="881"/>
                </a:lnTo>
                <a:lnTo>
                  <a:pt x="1881" y="840"/>
                </a:lnTo>
                <a:lnTo>
                  <a:pt x="1928" y="887"/>
                </a:lnTo>
                <a:lnTo>
                  <a:pt x="1887" y="928"/>
                </a:lnTo>
                <a:close/>
                <a:moveTo>
                  <a:pt x="2176" y="1217"/>
                </a:moveTo>
                <a:lnTo>
                  <a:pt x="1932" y="973"/>
                </a:lnTo>
                <a:lnTo>
                  <a:pt x="1973" y="932"/>
                </a:lnTo>
                <a:lnTo>
                  <a:pt x="2217" y="1176"/>
                </a:lnTo>
                <a:lnTo>
                  <a:pt x="2176" y="1217"/>
                </a:lnTo>
                <a:close/>
                <a:moveTo>
                  <a:pt x="2288" y="1104"/>
                </a:moveTo>
                <a:lnTo>
                  <a:pt x="1952" y="768"/>
                </a:lnTo>
                <a:lnTo>
                  <a:pt x="2079" y="642"/>
                </a:lnTo>
                <a:cubicBezTo>
                  <a:pt x="2101" y="619"/>
                  <a:pt x="2119" y="603"/>
                  <a:pt x="2133" y="594"/>
                </a:cubicBezTo>
                <a:cubicBezTo>
                  <a:pt x="2153" y="580"/>
                  <a:pt x="2172" y="571"/>
                  <a:pt x="2190" y="568"/>
                </a:cubicBezTo>
                <a:cubicBezTo>
                  <a:pt x="2209" y="564"/>
                  <a:pt x="2229" y="566"/>
                  <a:pt x="2250" y="573"/>
                </a:cubicBezTo>
                <a:cubicBezTo>
                  <a:pt x="2271" y="580"/>
                  <a:pt x="2289" y="592"/>
                  <a:pt x="2306" y="609"/>
                </a:cubicBezTo>
                <a:cubicBezTo>
                  <a:pt x="2334" y="638"/>
                  <a:pt x="2350" y="671"/>
                  <a:pt x="2351" y="709"/>
                </a:cubicBezTo>
                <a:cubicBezTo>
                  <a:pt x="2353" y="747"/>
                  <a:pt x="2330" y="790"/>
                  <a:pt x="2282" y="837"/>
                </a:cubicBezTo>
                <a:lnTo>
                  <a:pt x="2196" y="923"/>
                </a:lnTo>
                <a:lnTo>
                  <a:pt x="2333" y="1060"/>
                </a:lnTo>
                <a:lnTo>
                  <a:pt x="2288" y="1104"/>
                </a:lnTo>
                <a:close/>
                <a:moveTo>
                  <a:pt x="2156" y="884"/>
                </a:moveTo>
                <a:lnTo>
                  <a:pt x="2243" y="797"/>
                </a:lnTo>
                <a:cubicBezTo>
                  <a:pt x="2272" y="768"/>
                  <a:pt x="2287" y="742"/>
                  <a:pt x="2288" y="719"/>
                </a:cubicBezTo>
                <a:cubicBezTo>
                  <a:pt x="2290" y="697"/>
                  <a:pt x="2281" y="676"/>
                  <a:pt x="2261" y="656"/>
                </a:cubicBezTo>
                <a:cubicBezTo>
                  <a:pt x="2247" y="642"/>
                  <a:pt x="2232" y="634"/>
                  <a:pt x="2215" y="631"/>
                </a:cubicBezTo>
                <a:cubicBezTo>
                  <a:pt x="2198" y="628"/>
                  <a:pt x="2182" y="631"/>
                  <a:pt x="2167" y="639"/>
                </a:cubicBezTo>
                <a:cubicBezTo>
                  <a:pt x="2157" y="645"/>
                  <a:pt x="2142" y="657"/>
                  <a:pt x="2122" y="678"/>
                </a:cubicBezTo>
                <a:lnTo>
                  <a:pt x="2036" y="764"/>
                </a:lnTo>
                <a:lnTo>
                  <a:pt x="2156" y="884"/>
                </a:lnTo>
                <a:close/>
                <a:moveTo>
                  <a:pt x="2476" y="700"/>
                </a:moveTo>
                <a:lnTo>
                  <a:pt x="2515" y="655"/>
                </a:lnTo>
                <a:cubicBezTo>
                  <a:pt x="2533" y="670"/>
                  <a:pt x="2552" y="679"/>
                  <a:pt x="2570" y="682"/>
                </a:cubicBezTo>
                <a:cubicBezTo>
                  <a:pt x="2588" y="686"/>
                  <a:pt x="2608" y="683"/>
                  <a:pt x="2630" y="675"/>
                </a:cubicBezTo>
                <a:cubicBezTo>
                  <a:pt x="2652" y="666"/>
                  <a:pt x="2672" y="652"/>
                  <a:pt x="2691" y="633"/>
                </a:cubicBezTo>
                <a:cubicBezTo>
                  <a:pt x="2708" y="616"/>
                  <a:pt x="2721" y="599"/>
                  <a:pt x="2729" y="581"/>
                </a:cubicBezTo>
                <a:cubicBezTo>
                  <a:pt x="2737" y="562"/>
                  <a:pt x="2739" y="546"/>
                  <a:pt x="2737" y="531"/>
                </a:cubicBezTo>
                <a:cubicBezTo>
                  <a:pt x="2734" y="516"/>
                  <a:pt x="2728" y="503"/>
                  <a:pt x="2718" y="492"/>
                </a:cubicBezTo>
                <a:cubicBezTo>
                  <a:pt x="2707" y="482"/>
                  <a:pt x="2695" y="476"/>
                  <a:pt x="2681" y="474"/>
                </a:cubicBezTo>
                <a:cubicBezTo>
                  <a:pt x="2667" y="472"/>
                  <a:pt x="2650" y="476"/>
                  <a:pt x="2631" y="484"/>
                </a:cubicBezTo>
                <a:cubicBezTo>
                  <a:pt x="2618" y="490"/>
                  <a:pt x="2593" y="504"/>
                  <a:pt x="2555" y="528"/>
                </a:cubicBezTo>
                <a:cubicBezTo>
                  <a:pt x="2516" y="551"/>
                  <a:pt x="2488" y="566"/>
                  <a:pt x="2469" y="572"/>
                </a:cubicBezTo>
                <a:cubicBezTo>
                  <a:pt x="2444" y="579"/>
                  <a:pt x="2422" y="581"/>
                  <a:pt x="2401" y="576"/>
                </a:cubicBezTo>
                <a:cubicBezTo>
                  <a:pt x="2381" y="572"/>
                  <a:pt x="2363" y="562"/>
                  <a:pt x="2348" y="546"/>
                </a:cubicBezTo>
                <a:cubicBezTo>
                  <a:pt x="2331" y="529"/>
                  <a:pt x="2320" y="509"/>
                  <a:pt x="2315" y="484"/>
                </a:cubicBezTo>
                <a:cubicBezTo>
                  <a:pt x="2310" y="460"/>
                  <a:pt x="2312" y="435"/>
                  <a:pt x="2323" y="409"/>
                </a:cubicBezTo>
                <a:cubicBezTo>
                  <a:pt x="2334" y="382"/>
                  <a:pt x="2351" y="358"/>
                  <a:pt x="2374" y="335"/>
                </a:cubicBezTo>
                <a:cubicBezTo>
                  <a:pt x="2398" y="311"/>
                  <a:pt x="2424" y="293"/>
                  <a:pt x="2451" y="282"/>
                </a:cubicBezTo>
                <a:cubicBezTo>
                  <a:pt x="2479" y="271"/>
                  <a:pt x="2505" y="268"/>
                  <a:pt x="2531" y="273"/>
                </a:cubicBezTo>
                <a:cubicBezTo>
                  <a:pt x="2557" y="278"/>
                  <a:pt x="2580" y="291"/>
                  <a:pt x="2600" y="310"/>
                </a:cubicBezTo>
                <a:lnTo>
                  <a:pt x="2561" y="355"/>
                </a:lnTo>
                <a:cubicBezTo>
                  <a:pt x="2537" y="336"/>
                  <a:pt x="2513" y="328"/>
                  <a:pt x="2489" y="331"/>
                </a:cubicBezTo>
                <a:cubicBezTo>
                  <a:pt x="2465" y="333"/>
                  <a:pt x="2440" y="347"/>
                  <a:pt x="2415" y="373"/>
                </a:cubicBezTo>
                <a:cubicBezTo>
                  <a:pt x="2388" y="400"/>
                  <a:pt x="2373" y="424"/>
                  <a:pt x="2371" y="446"/>
                </a:cubicBezTo>
                <a:cubicBezTo>
                  <a:pt x="2368" y="469"/>
                  <a:pt x="2374" y="487"/>
                  <a:pt x="2388" y="501"/>
                </a:cubicBezTo>
                <a:cubicBezTo>
                  <a:pt x="2400" y="513"/>
                  <a:pt x="2414" y="518"/>
                  <a:pt x="2431" y="517"/>
                </a:cubicBezTo>
                <a:cubicBezTo>
                  <a:pt x="2447" y="516"/>
                  <a:pt x="2477" y="502"/>
                  <a:pt x="2522" y="474"/>
                </a:cubicBezTo>
                <a:cubicBezTo>
                  <a:pt x="2566" y="446"/>
                  <a:pt x="2598" y="429"/>
                  <a:pt x="2617" y="421"/>
                </a:cubicBezTo>
                <a:cubicBezTo>
                  <a:pt x="2646" y="411"/>
                  <a:pt x="2672" y="408"/>
                  <a:pt x="2695" y="412"/>
                </a:cubicBezTo>
                <a:cubicBezTo>
                  <a:pt x="2718" y="417"/>
                  <a:pt x="2739" y="428"/>
                  <a:pt x="2757" y="446"/>
                </a:cubicBezTo>
                <a:cubicBezTo>
                  <a:pt x="2775" y="464"/>
                  <a:pt x="2786" y="486"/>
                  <a:pt x="2792" y="512"/>
                </a:cubicBezTo>
                <a:cubicBezTo>
                  <a:pt x="2798" y="538"/>
                  <a:pt x="2795" y="565"/>
                  <a:pt x="2785" y="593"/>
                </a:cubicBezTo>
                <a:cubicBezTo>
                  <a:pt x="2774" y="621"/>
                  <a:pt x="2757" y="647"/>
                  <a:pt x="2733" y="671"/>
                </a:cubicBezTo>
                <a:cubicBezTo>
                  <a:pt x="2703" y="701"/>
                  <a:pt x="2673" y="722"/>
                  <a:pt x="2643" y="734"/>
                </a:cubicBezTo>
                <a:cubicBezTo>
                  <a:pt x="2614" y="746"/>
                  <a:pt x="2585" y="748"/>
                  <a:pt x="2555" y="742"/>
                </a:cubicBezTo>
                <a:cubicBezTo>
                  <a:pt x="2526" y="736"/>
                  <a:pt x="2499" y="722"/>
                  <a:pt x="2476" y="700"/>
                </a:cubicBezTo>
                <a:close/>
                <a:moveTo>
                  <a:pt x="3055" y="338"/>
                </a:moveTo>
                <a:lnTo>
                  <a:pt x="3014" y="379"/>
                </a:lnTo>
                <a:lnTo>
                  <a:pt x="2751" y="116"/>
                </a:lnTo>
                <a:cubicBezTo>
                  <a:pt x="2750" y="136"/>
                  <a:pt x="2747" y="158"/>
                  <a:pt x="2740" y="184"/>
                </a:cubicBezTo>
                <a:cubicBezTo>
                  <a:pt x="2733" y="209"/>
                  <a:pt x="2726" y="231"/>
                  <a:pt x="2718" y="248"/>
                </a:cubicBezTo>
                <a:lnTo>
                  <a:pt x="2678" y="208"/>
                </a:lnTo>
                <a:cubicBezTo>
                  <a:pt x="2690" y="175"/>
                  <a:pt x="2697" y="141"/>
                  <a:pt x="2699" y="109"/>
                </a:cubicBezTo>
                <a:cubicBezTo>
                  <a:pt x="2701" y="76"/>
                  <a:pt x="2698" y="49"/>
                  <a:pt x="2691" y="27"/>
                </a:cubicBezTo>
                <a:lnTo>
                  <a:pt x="2717" y="0"/>
                </a:lnTo>
                <a:lnTo>
                  <a:pt x="3055" y="338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1" name="Freeform 67"/>
          <p:cNvSpPr>
            <a:spLocks noEditPoints="1"/>
          </p:cNvSpPr>
          <p:nvPr/>
        </p:nvSpPr>
        <p:spPr bwMode="auto">
          <a:xfrm>
            <a:off x="2138505" y="5034102"/>
            <a:ext cx="593725" cy="584200"/>
          </a:xfrm>
          <a:custGeom>
            <a:avLst/>
            <a:gdLst>
              <a:gd name="T0" fmla="*/ 419 w 3116"/>
              <a:gd name="T1" fmla="*/ 2992 h 3066"/>
              <a:gd name="T2" fmla="*/ 14 w 3116"/>
              <a:gd name="T3" fmla="*/ 2862 h 3066"/>
              <a:gd name="T4" fmla="*/ 303 w 3116"/>
              <a:gd name="T5" fmla="*/ 2608 h 3066"/>
              <a:gd name="T6" fmla="*/ 64 w 3116"/>
              <a:gd name="T7" fmla="*/ 2766 h 3066"/>
              <a:gd name="T8" fmla="*/ 305 w 3116"/>
              <a:gd name="T9" fmla="*/ 2998 h 3066"/>
              <a:gd name="T10" fmla="*/ 466 w 3116"/>
              <a:gd name="T11" fmla="*/ 2690 h 3066"/>
              <a:gd name="T12" fmla="*/ 690 w 3116"/>
              <a:gd name="T13" fmla="*/ 2459 h 3066"/>
              <a:gd name="T14" fmla="*/ 592 w 3116"/>
              <a:gd name="T15" fmla="*/ 2753 h 3066"/>
              <a:gd name="T16" fmla="*/ 673 w 3116"/>
              <a:gd name="T17" fmla="*/ 2670 h 3066"/>
              <a:gd name="T18" fmla="*/ 487 w 3116"/>
              <a:gd name="T19" fmla="*/ 2483 h 3066"/>
              <a:gd name="T20" fmla="*/ 625 w 3116"/>
              <a:gd name="T21" fmla="*/ 2287 h 3066"/>
              <a:gd name="T22" fmla="*/ 783 w 3116"/>
              <a:gd name="T23" fmla="*/ 2135 h 3066"/>
              <a:gd name="T24" fmla="*/ 1066 w 3116"/>
              <a:gd name="T25" fmla="*/ 2333 h 3066"/>
              <a:gd name="T26" fmla="*/ 798 w 3116"/>
              <a:gd name="T27" fmla="*/ 2190 h 3066"/>
              <a:gd name="T28" fmla="*/ 910 w 3116"/>
              <a:gd name="T29" fmla="*/ 2490 h 3066"/>
              <a:gd name="T30" fmla="*/ 1197 w 3116"/>
              <a:gd name="T31" fmla="*/ 2209 h 3066"/>
              <a:gd name="T32" fmla="*/ 925 w 3116"/>
              <a:gd name="T33" fmla="*/ 2052 h 3066"/>
              <a:gd name="T34" fmla="*/ 833 w 3116"/>
              <a:gd name="T35" fmla="*/ 1959 h 3066"/>
              <a:gd name="T36" fmla="*/ 1008 w 3116"/>
              <a:gd name="T37" fmla="*/ 1969 h 3066"/>
              <a:gd name="T38" fmla="*/ 1148 w 3116"/>
              <a:gd name="T39" fmla="*/ 2175 h 3066"/>
              <a:gd name="T40" fmla="*/ 1015 w 3116"/>
              <a:gd name="T41" fmla="*/ 1898 h 3066"/>
              <a:gd name="T42" fmla="*/ 1099 w 3116"/>
              <a:gd name="T43" fmla="*/ 1802 h 3066"/>
              <a:gd name="T44" fmla="*/ 1124 w 3116"/>
              <a:gd name="T45" fmla="*/ 1879 h 3066"/>
              <a:gd name="T46" fmla="*/ 1258 w 3116"/>
              <a:gd name="T47" fmla="*/ 2141 h 3066"/>
              <a:gd name="T48" fmla="*/ 1382 w 3116"/>
              <a:gd name="T49" fmla="*/ 1585 h 3066"/>
              <a:gd name="T50" fmla="*/ 1522 w 3116"/>
              <a:gd name="T51" fmla="*/ 1889 h 3066"/>
              <a:gd name="T52" fmla="*/ 1413 w 3116"/>
              <a:gd name="T53" fmla="*/ 1883 h 3066"/>
              <a:gd name="T54" fmla="*/ 1376 w 3116"/>
              <a:gd name="T55" fmla="*/ 1641 h 3066"/>
              <a:gd name="T56" fmla="*/ 1677 w 3116"/>
              <a:gd name="T57" fmla="*/ 1723 h 3066"/>
              <a:gd name="T58" fmla="*/ 1677 w 3116"/>
              <a:gd name="T59" fmla="*/ 1723 h 3066"/>
              <a:gd name="T60" fmla="*/ 1614 w 3116"/>
              <a:gd name="T61" fmla="*/ 1316 h 3066"/>
              <a:gd name="T62" fmla="*/ 1565 w 3116"/>
              <a:gd name="T63" fmla="*/ 1160 h 3066"/>
              <a:gd name="T64" fmla="*/ 1839 w 3116"/>
              <a:gd name="T65" fmla="*/ 888 h 3066"/>
              <a:gd name="T66" fmla="*/ 2176 w 3116"/>
              <a:gd name="T67" fmla="*/ 1224 h 3066"/>
              <a:gd name="T68" fmla="*/ 2176 w 3116"/>
              <a:gd name="T69" fmla="*/ 1224 h 3066"/>
              <a:gd name="T70" fmla="*/ 2133 w 3116"/>
              <a:gd name="T71" fmla="*/ 601 h 3066"/>
              <a:gd name="T72" fmla="*/ 2351 w 3116"/>
              <a:gd name="T73" fmla="*/ 716 h 3066"/>
              <a:gd name="T74" fmla="*/ 2288 w 3116"/>
              <a:gd name="T75" fmla="*/ 1111 h 3066"/>
              <a:gd name="T76" fmla="*/ 2261 w 3116"/>
              <a:gd name="T77" fmla="*/ 663 h 3066"/>
              <a:gd name="T78" fmla="*/ 2036 w 3116"/>
              <a:gd name="T79" fmla="*/ 771 h 3066"/>
              <a:gd name="T80" fmla="*/ 2570 w 3116"/>
              <a:gd name="T81" fmla="*/ 689 h 3066"/>
              <a:gd name="T82" fmla="*/ 2737 w 3116"/>
              <a:gd name="T83" fmla="*/ 538 h 3066"/>
              <a:gd name="T84" fmla="*/ 2554 w 3116"/>
              <a:gd name="T85" fmla="*/ 535 h 3066"/>
              <a:gd name="T86" fmla="*/ 2315 w 3116"/>
              <a:gd name="T87" fmla="*/ 491 h 3066"/>
              <a:gd name="T88" fmla="*/ 2531 w 3116"/>
              <a:gd name="T89" fmla="*/ 280 h 3066"/>
              <a:gd name="T90" fmla="*/ 2414 w 3116"/>
              <a:gd name="T91" fmla="*/ 380 h 3066"/>
              <a:gd name="T92" fmla="*/ 2521 w 3116"/>
              <a:gd name="T93" fmla="*/ 481 h 3066"/>
              <a:gd name="T94" fmla="*/ 2792 w 3116"/>
              <a:gd name="T95" fmla="*/ 519 h 3066"/>
              <a:gd name="T96" fmla="*/ 2555 w 3116"/>
              <a:gd name="T97" fmla="*/ 749 h 3066"/>
              <a:gd name="T98" fmla="*/ 2894 w 3116"/>
              <a:gd name="T99" fmla="*/ 506 h 3066"/>
              <a:gd name="T100" fmla="*/ 2859 w 3116"/>
              <a:gd name="T101" fmla="*/ 150 h 3066"/>
              <a:gd name="T102" fmla="*/ 2677 w 3116"/>
              <a:gd name="T103" fmla="*/ 152 h 3066"/>
              <a:gd name="T104" fmla="*/ 2673 w 3116"/>
              <a:gd name="T105" fmla="*/ 51 h 3066"/>
              <a:gd name="T106" fmla="*/ 2917 w 3116"/>
              <a:gd name="T107" fmla="*/ 156 h 3066"/>
              <a:gd name="T108" fmla="*/ 3076 w 3116"/>
              <a:gd name="T109" fmla="*/ 244 h 306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</a:cxnLst>
            <a:rect l="0" t="0" r="r" b="b"/>
            <a:pathLst>
              <a:path w="3116" h="3066">
                <a:moveTo>
                  <a:pt x="391" y="2773"/>
                </a:moveTo>
                <a:lnTo>
                  <a:pt x="446" y="2740"/>
                </a:lnTo>
                <a:cubicBezTo>
                  <a:pt x="473" y="2786"/>
                  <a:pt x="485" y="2831"/>
                  <a:pt x="479" y="2874"/>
                </a:cubicBezTo>
                <a:cubicBezTo>
                  <a:pt x="474" y="2917"/>
                  <a:pt x="454" y="2957"/>
                  <a:pt x="419" y="2992"/>
                </a:cubicBezTo>
                <a:cubicBezTo>
                  <a:pt x="383" y="3028"/>
                  <a:pt x="346" y="3050"/>
                  <a:pt x="309" y="3058"/>
                </a:cubicBezTo>
                <a:cubicBezTo>
                  <a:pt x="271" y="3066"/>
                  <a:pt x="233" y="3062"/>
                  <a:pt x="193" y="3046"/>
                </a:cubicBezTo>
                <a:cubicBezTo>
                  <a:pt x="153" y="3029"/>
                  <a:pt x="117" y="3005"/>
                  <a:pt x="85" y="2973"/>
                </a:cubicBezTo>
                <a:cubicBezTo>
                  <a:pt x="50" y="2938"/>
                  <a:pt x="26" y="2901"/>
                  <a:pt x="14" y="2862"/>
                </a:cubicBezTo>
                <a:cubicBezTo>
                  <a:pt x="1" y="2822"/>
                  <a:pt x="0" y="2783"/>
                  <a:pt x="11" y="2745"/>
                </a:cubicBezTo>
                <a:cubicBezTo>
                  <a:pt x="23" y="2707"/>
                  <a:pt x="43" y="2673"/>
                  <a:pt x="73" y="2643"/>
                </a:cubicBezTo>
                <a:cubicBezTo>
                  <a:pt x="106" y="2610"/>
                  <a:pt x="143" y="2590"/>
                  <a:pt x="183" y="2584"/>
                </a:cubicBezTo>
                <a:cubicBezTo>
                  <a:pt x="223" y="2578"/>
                  <a:pt x="263" y="2586"/>
                  <a:pt x="303" y="2608"/>
                </a:cubicBezTo>
                <a:lnTo>
                  <a:pt x="270" y="2663"/>
                </a:lnTo>
                <a:cubicBezTo>
                  <a:pt x="237" y="2646"/>
                  <a:pt x="208" y="2639"/>
                  <a:pt x="182" y="2643"/>
                </a:cubicBezTo>
                <a:cubicBezTo>
                  <a:pt x="156" y="2647"/>
                  <a:pt x="132" y="2660"/>
                  <a:pt x="110" y="2682"/>
                </a:cubicBezTo>
                <a:cubicBezTo>
                  <a:pt x="84" y="2708"/>
                  <a:pt x="68" y="2736"/>
                  <a:pt x="64" y="2766"/>
                </a:cubicBezTo>
                <a:cubicBezTo>
                  <a:pt x="59" y="2795"/>
                  <a:pt x="63" y="2824"/>
                  <a:pt x="77" y="2852"/>
                </a:cubicBezTo>
                <a:cubicBezTo>
                  <a:pt x="91" y="2880"/>
                  <a:pt x="109" y="2905"/>
                  <a:pt x="131" y="2927"/>
                </a:cubicBezTo>
                <a:cubicBezTo>
                  <a:pt x="159" y="2956"/>
                  <a:pt x="188" y="2976"/>
                  <a:pt x="218" y="2989"/>
                </a:cubicBezTo>
                <a:cubicBezTo>
                  <a:pt x="248" y="3002"/>
                  <a:pt x="277" y="3005"/>
                  <a:pt x="305" y="2998"/>
                </a:cubicBezTo>
                <a:cubicBezTo>
                  <a:pt x="333" y="2991"/>
                  <a:pt x="357" y="2978"/>
                  <a:pt x="378" y="2957"/>
                </a:cubicBezTo>
                <a:cubicBezTo>
                  <a:pt x="403" y="2932"/>
                  <a:pt x="417" y="2904"/>
                  <a:pt x="419" y="2872"/>
                </a:cubicBezTo>
                <a:cubicBezTo>
                  <a:pt x="422" y="2841"/>
                  <a:pt x="413" y="2808"/>
                  <a:pt x="391" y="2773"/>
                </a:cubicBezTo>
                <a:close/>
                <a:moveTo>
                  <a:pt x="466" y="2690"/>
                </a:moveTo>
                <a:cubicBezTo>
                  <a:pt x="421" y="2645"/>
                  <a:pt x="400" y="2599"/>
                  <a:pt x="403" y="2553"/>
                </a:cubicBezTo>
                <a:cubicBezTo>
                  <a:pt x="406" y="2514"/>
                  <a:pt x="422" y="2479"/>
                  <a:pt x="453" y="2449"/>
                </a:cubicBezTo>
                <a:cubicBezTo>
                  <a:pt x="486" y="2416"/>
                  <a:pt x="524" y="2399"/>
                  <a:pt x="568" y="2400"/>
                </a:cubicBezTo>
                <a:cubicBezTo>
                  <a:pt x="611" y="2400"/>
                  <a:pt x="652" y="2420"/>
                  <a:pt x="690" y="2459"/>
                </a:cubicBezTo>
                <a:cubicBezTo>
                  <a:pt x="722" y="2490"/>
                  <a:pt x="742" y="2520"/>
                  <a:pt x="750" y="2547"/>
                </a:cubicBezTo>
                <a:cubicBezTo>
                  <a:pt x="759" y="2574"/>
                  <a:pt x="759" y="2602"/>
                  <a:pt x="751" y="2630"/>
                </a:cubicBezTo>
                <a:cubicBezTo>
                  <a:pt x="743" y="2658"/>
                  <a:pt x="728" y="2682"/>
                  <a:pt x="707" y="2703"/>
                </a:cubicBezTo>
                <a:cubicBezTo>
                  <a:pt x="673" y="2738"/>
                  <a:pt x="634" y="2754"/>
                  <a:pt x="592" y="2753"/>
                </a:cubicBezTo>
                <a:cubicBezTo>
                  <a:pt x="549" y="2752"/>
                  <a:pt x="507" y="2732"/>
                  <a:pt x="466" y="2690"/>
                </a:cubicBezTo>
                <a:close/>
                <a:moveTo>
                  <a:pt x="508" y="2648"/>
                </a:moveTo>
                <a:cubicBezTo>
                  <a:pt x="539" y="2679"/>
                  <a:pt x="569" y="2696"/>
                  <a:pt x="598" y="2698"/>
                </a:cubicBezTo>
                <a:cubicBezTo>
                  <a:pt x="628" y="2700"/>
                  <a:pt x="652" y="2690"/>
                  <a:pt x="673" y="2670"/>
                </a:cubicBezTo>
                <a:cubicBezTo>
                  <a:pt x="694" y="2649"/>
                  <a:pt x="703" y="2624"/>
                  <a:pt x="701" y="2595"/>
                </a:cubicBezTo>
                <a:cubicBezTo>
                  <a:pt x="699" y="2566"/>
                  <a:pt x="682" y="2535"/>
                  <a:pt x="650" y="2503"/>
                </a:cubicBezTo>
                <a:cubicBezTo>
                  <a:pt x="620" y="2473"/>
                  <a:pt x="590" y="2457"/>
                  <a:pt x="561" y="2455"/>
                </a:cubicBezTo>
                <a:cubicBezTo>
                  <a:pt x="532" y="2454"/>
                  <a:pt x="507" y="2463"/>
                  <a:pt x="487" y="2483"/>
                </a:cubicBezTo>
                <a:cubicBezTo>
                  <a:pt x="466" y="2504"/>
                  <a:pt x="457" y="2529"/>
                  <a:pt x="459" y="2558"/>
                </a:cubicBezTo>
                <a:cubicBezTo>
                  <a:pt x="460" y="2587"/>
                  <a:pt x="477" y="2617"/>
                  <a:pt x="508" y="2648"/>
                </a:cubicBezTo>
                <a:close/>
                <a:moveTo>
                  <a:pt x="869" y="2531"/>
                </a:moveTo>
                <a:lnTo>
                  <a:pt x="625" y="2287"/>
                </a:lnTo>
                <a:lnTo>
                  <a:pt x="662" y="2250"/>
                </a:lnTo>
                <a:lnTo>
                  <a:pt x="697" y="2285"/>
                </a:lnTo>
                <a:cubicBezTo>
                  <a:pt x="688" y="2240"/>
                  <a:pt x="700" y="2201"/>
                  <a:pt x="734" y="2167"/>
                </a:cubicBezTo>
                <a:cubicBezTo>
                  <a:pt x="749" y="2153"/>
                  <a:pt x="765" y="2142"/>
                  <a:pt x="783" y="2135"/>
                </a:cubicBezTo>
                <a:cubicBezTo>
                  <a:pt x="800" y="2128"/>
                  <a:pt x="816" y="2125"/>
                  <a:pt x="831" y="2128"/>
                </a:cubicBezTo>
                <a:cubicBezTo>
                  <a:pt x="846" y="2130"/>
                  <a:pt x="860" y="2136"/>
                  <a:pt x="874" y="2146"/>
                </a:cubicBezTo>
                <a:cubicBezTo>
                  <a:pt x="883" y="2152"/>
                  <a:pt x="898" y="2164"/>
                  <a:pt x="917" y="2183"/>
                </a:cubicBezTo>
                <a:lnTo>
                  <a:pt x="1066" y="2333"/>
                </a:lnTo>
                <a:lnTo>
                  <a:pt x="1025" y="2374"/>
                </a:lnTo>
                <a:lnTo>
                  <a:pt x="877" y="2226"/>
                </a:lnTo>
                <a:cubicBezTo>
                  <a:pt x="860" y="2209"/>
                  <a:pt x="846" y="2198"/>
                  <a:pt x="835" y="2193"/>
                </a:cubicBezTo>
                <a:cubicBezTo>
                  <a:pt x="823" y="2188"/>
                  <a:pt x="811" y="2187"/>
                  <a:pt x="798" y="2190"/>
                </a:cubicBezTo>
                <a:cubicBezTo>
                  <a:pt x="784" y="2194"/>
                  <a:pt x="772" y="2201"/>
                  <a:pt x="761" y="2212"/>
                </a:cubicBezTo>
                <a:cubicBezTo>
                  <a:pt x="744" y="2229"/>
                  <a:pt x="734" y="2250"/>
                  <a:pt x="733" y="2274"/>
                </a:cubicBezTo>
                <a:cubicBezTo>
                  <a:pt x="731" y="2298"/>
                  <a:pt x="746" y="2325"/>
                  <a:pt x="777" y="2357"/>
                </a:cubicBezTo>
                <a:lnTo>
                  <a:pt x="910" y="2490"/>
                </a:lnTo>
                <a:lnTo>
                  <a:pt x="869" y="2531"/>
                </a:lnTo>
                <a:close/>
                <a:moveTo>
                  <a:pt x="1182" y="2144"/>
                </a:moveTo>
                <a:lnTo>
                  <a:pt x="1224" y="2174"/>
                </a:lnTo>
                <a:cubicBezTo>
                  <a:pt x="1215" y="2188"/>
                  <a:pt x="1206" y="2200"/>
                  <a:pt x="1197" y="2209"/>
                </a:cubicBezTo>
                <a:cubicBezTo>
                  <a:pt x="1182" y="2224"/>
                  <a:pt x="1168" y="2233"/>
                  <a:pt x="1155" y="2237"/>
                </a:cubicBezTo>
                <a:cubicBezTo>
                  <a:pt x="1142" y="2240"/>
                  <a:pt x="1130" y="2240"/>
                  <a:pt x="1119" y="2235"/>
                </a:cubicBezTo>
                <a:cubicBezTo>
                  <a:pt x="1108" y="2231"/>
                  <a:pt x="1090" y="2217"/>
                  <a:pt x="1065" y="2192"/>
                </a:cubicBezTo>
                <a:lnTo>
                  <a:pt x="925" y="2052"/>
                </a:lnTo>
                <a:lnTo>
                  <a:pt x="895" y="2082"/>
                </a:lnTo>
                <a:lnTo>
                  <a:pt x="863" y="2050"/>
                </a:lnTo>
                <a:lnTo>
                  <a:pt x="893" y="2020"/>
                </a:lnTo>
                <a:lnTo>
                  <a:pt x="833" y="1959"/>
                </a:lnTo>
                <a:lnTo>
                  <a:pt x="849" y="1894"/>
                </a:lnTo>
                <a:lnTo>
                  <a:pt x="934" y="1979"/>
                </a:lnTo>
                <a:lnTo>
                  <a:pt x="975" y="1937"/>
                </a:lnTo>
                <a:lnTo>
                  <a:pt x="1008" y="1969"/>
                </a:lnTo>
                <a:lnTo>
                  <a:pt x="966" y="2011"/>
                </a:lnTo>
                <a:lnTo>
                  <a:pt x="1108" y="2153"/>
                </a:lnTo>
                <a:cubicBezTo>
                  <a:pt x="1120" y="2165"/>
                  <a:pt x="1128" y="2172"/>
                  <a:pt x="1133" y="2174"/>
                </a:cubicBezTo>
                <a:cubicBezTo>
                  <a:pt x="1138" y="2175"/>
                  <a:pt x="1143" y="2176"/>
                  <a:pt x="1148" y="2175"/>
                </a:cubicBezTo>
                <a:cubicBezTo>
                  <a:pt x="1154" y="2173"/>
                  <a:pt x="1159" y="2169"/>
                  <a:pt x="1165" y="2163"/>
                </a:cubicBezTo>
                <a:cubicBezTo>
                  <a:pt x="1170" y="2159"/>
                  <a:pt x="1176" y="2152"/>
                  <a:pt x="1182" y="2144"/>
                </a:cubicBezTo>
                <a:close/>
                <a:moveTo>
                  <a:pt x="1258" y="2141"/>
                </a:moveTo>
                <a:lnTo>
                  <a:pt x="1015" y="1898"/>
                </a:lnTo>
                <a:lnTo>
                  <a:pt x="1052" y="1860"/>
                </a:lnTo>
                <a:lnTo>
                  <a:pt x="1089" y="1897"/>
                </a:lnTo>
                <a:cubicBezTo>
                  <a:pt x="1081" y="1871"/>
                  <a:pt x="1079" y="1850"/>
                  <a:pt x="1081" y="1837"/>
                </a:cubicBezTo>
                <a:cubicBezTo>
                  <a:pt x="1084" y="1823"/>
                  <a:pt x="1090" y="1812"/>
                  <a:pt x="1099" y="1802"/>
                </a:cubicBezTo>
                <a:cubicBezTo>
                  <a:pt x="1113" y="1788"/>
                  <a:pt x="1132" y="1779"/>
                  <a:pt x="1155" y="1773"/>
                </a:cubicBezTo>
                <a:lnTo>
                  <a:pt x="1179" y="1826"/>
                </a:lnTo>
                <a:cubicBezTo>
                  <a:pt x="1163" y="1830"/>
                  <a:pt x="1150" y="1837"/>
                  <a:pt x="1140" y="1847"/>
                </a:cubicBezTo>
                <a:cubicBezTo>
                  <a:pt x="1131" y="1856"/>
                  <a:pt x="1126" y="1867"/>
                  <a:pt x="1124" y="1879"/>
                </a:cubicBezTo>
                <a:cubicBezTo>
                  <a:pt x="1122" y="1892"/>
                  <a:pt x="1124" y="1905"/>
                  <a:pt x="1131" y="1917"/>
                </a:cubicBezTo>
                <a:cubicBezTo>
                  <a:pt x="1141" y="1937"/>
                  <a:pt x="1155" y="1955"/>
                  <a:pt x="1172" y="1972"/>
                </a:cubicBezTo>
                <a:lnTo>
                  <a:pt x="1300" y="2100"/>
                </a:lnTo>
                <a:lnTo>
                  <a:pt x="1258" y="2141"/>
                </a:lnTo>
                <a:close/>
                <a:moveTo>
                  <a:pt x="1280" y="1876"/>
                </a:moveTo>
                <a:cubicBezTo>
                  <a:pt x="1235" y="1831"/>
                  <a:pt x="1214" y="1785"/>
                  <a:pt x="1218" y="1738"/>
                </a:cubicBezTo>
                <a:cubicBezTo>
                  <a:pt x="1221" y="1699"/>
                  <a:pt x="1237" y="1665"/>
                  <a:pt x="1267" y="1634"/>
                </a:cubicBezTo>
                <a:cubicBezTo>
                  <a:pt x="1301" y="1601"/>
                  <a:pt x="1339" y="1585"/>
                  <a:pt x="1382" y="1585"/>
                </a:cubicBezTo>
                <a:cubicBezTo>
                  <a:pt x="1425" y="1586"/>
                  <a:pt x="1466" y="1606"/>
                  <a:pt x="1505" y="1644"/>
                </a:cubicBezTo>
                <a:cubicBezTo>
                  <a:pt x="1536" y="1676"/>
                  <a:pt x="1556" y="1705"/>
                  <a:pt x="1565" y="1732"/>
                </a:cubicBezTo>
                <a:cubicBezTo>
                  <a:pt x="1573" y="1760"/>
                  <a:pt x="1574" y="1787"/>
                  <a:pt x="1566" y="1815"/>
                </a:cubicBezTo>
                <a:cubicBezTo>
                  <a:pt x="1557" y="1843"/>
                  <a:pt x="1543" y="1868"/>
                  <a:pt x="1522" y="1889"/>
                </a:cubicBezTo>
                <a:cubicBezTo>
                  <a:pt x="1488" y="1923"/>
                  <a:pt x="1449" y="1940"/>
                  <a:pt x="1406" y="1939"/>
                </a:cubicBezTo>
                <a:cubicBezTo>
                  <a:pt x="1363" y="1938"/>
                  <a:pt x="1321" y="1917"/>
                  <a:pt x="1280" y="1876"/>
                </a:cubicBezTo>
                <a:close/>
                <a:moveTo>
                  <a:pt x="1323" y="1833"/>
                </a:moveTo>
                <a:cubicBezTo>
                  <a:pt x="1354" y="1865"/>
                  <a:pt x="1384" y="1881"/>
                  <a:pt x="1413" y="1883"/>
                </a:cubicBezTo>
                <a:cubicBezTo>
                  <a:pt x="1442" y="1885"/>
                  <a:pt x="1467" y="1876"/>
                  <a:pt x="1488" y="1855"/>
                </a:cubicBezTo>
                <a:cubicBezTo>
                  <a:pt x="1508" y="1834"/>
                  <a:pt x="1517" y="1810"/>
                  <a:pt x="1515" y="1780"/>
                </a:cubicBezTo>
                <a:cubicBezTo>
                  <a:pt x="1513" y="1751"/>
                  <a:pt x="1496" y="1721"/>
                  <a:pt x="1465" y="1689"/>
                </a:cubicBezTo>
                <a:cubicBezTo>
                  <a:pt x="1434" y="1659"/>
                  <a:pt x="1405" y="1643"/>
                  <a:pt x="1376" y="1641"/>
                </a:cubicBezTo>
                <a:cubicBezTo>
                  <a:pt x="1346" y="1639"/>
                  <a:pt x="1322" y="1648"/>
                  <a:pt x="1301" y="1669"/>
                </a:cubicBezTo>
                <a:cubicBezTo>
                  <a:pt x="1281" y="1689"/>
                  <a:pt x="1271" y="1714"/>
                  <a:pt x="1273" y="1743"/>
                </a:cubicBezTo>
                <a:cubicBezTo>
                  <a:pt x="1275" y="1772"/>
                  <a:pt x="1291" y="1802"/>
                  <a:pt x="1323" y="1833"/>
                </a:cubicBezTo>
                <a:close/>
                <a:moveTo>
                  <a:pt x="1677" y="1723"/>
                </a:moveTo>
                <a:lnTo>
                  <a:pt x="1341" y="1387"/>
                </a:lnTo>
                <a:lnTo>
                  <a:pt x="1382" y="1346"/>
                </a:lnTo>
                <a:lnTo>
                  <a:pt x="1718" y="1682"/>
                </a:lnTo>
                <a:lnTo>
                  <a:pt x="1677" y="1723"/>
                </a:lnTo>
                <a:close/>
                <a:moveTo>
                  <a:pt x="1929" y="1471"/>
                </a:moveTo>
                <a:lnTo>
                  <a:pt x="1888" y="1512"/>
                </a:lnTo>
                <a:lnTo>
                  <a:pt x="1625" y="1249"/>
                </a:lnTo>
                <a:cubicBezTo>
                  <a:pt x="1624" y="1268"/>
                  <a:pt x="1621" y="1291"/>
                  <a:pt x="1614" y="1316"/>
                </a:cubicBezTo>
                <a:cubicBezTo>
                  <a:pt x="1607" y="1342"/>
                  <a:pt x="1600" y="1364"/>
                  <a:pt x="1592" y="1381"/>
                </a:cubicBezTo>
                <a:lnTo>
                  <a:pt x="1552" y="1341"/>
                </a:lnTo>
                <a:cubicBezTo>
                  <a:pt x="1564" y="1307"/>
                  <a:pt x="1571" y="1274"/>
                  <a:pt x="1573" y="1241"/>
                </a:cubicBezTo>
                <a:cubicBezTo>
                  <a:pt x="1575" y="1209"/>
                  <a:pt x="1572" y="1181"/>
                  <a:pt x="1565" y="1160"/>
                </a:cubicBezTo>
                <a:lnTo>
                  <a:pt x="1592" y="1133"/>
                </a:lnTo>
                <a:lnTo>
                  <a:pt x="1929" y="1471"/>
                </a:lnTo>
                <a:close/>
                <a:moveTo>
                  <a:pt x="1887" y="935"/>
                </a:moveTo>
                <a:lnTo>
                  <a:pt x="1839" y="888"/>
                </a:lnTo>
                <a:lnTo>
                  <a:pt x="1881" y="847"/>
                </a:lnTo>
                <a:lnTo>
                  <a:pt x="1928" y="894"/>
                </a:lnTo>
                <a:lnTo>
                  <a:pt x="1887" y="935"/>
                </a:lnTo>
                <a:close/>
                <a:moveTo>
                  <a:pt x="2176" y="1224"/>
                </a:moveTo>
                <a:lnTo>
                  <a:pt x="1932" y="980"/>
                </a:lnTo>
                <a:lnTo>
                  <a:pt x="1973" y="939"/>
                </a:lnTo>
                <a:lnTo>
                  <a:pt x="2217" y="1183"/>
                </a:lnTo>
                <a:lnTo>
                  <a:pt x="2176" y="1224"/>
                </a:lnTo>
                <a:close/>
                <a:moveTo>
                  <a:pt x="2288" y="1111"/>
                </a:moveTo>
                <a:lnTo>
                  <a:pt x="1952" y="775"/>
                </a:lnTo>
                <a:lnTo>
                  <a:pt x="2079" y="649"/>
                </a:lnTo>
                <a:cubicBezTo>
                  <a:pt x="2101" y="626"/>
                  <a:pt x="2119" y="610"/>
                  <a:pt x="2133" y="601"/>
                </a:cubicBezTo>
                <a:cubicBezTo>
                  <a:pt x="2152" y="587"/>
                  <a:pt x="2171" y="578"/>
                  <a:pt x="2190" y="575"/>
                </a:cubicBezTo>
                <a:cubicBezTo>
                  <a:pt x="2209" y="571"/>
                  <a:pt x="2229" y="573"/>
                  <a:pt x="2250" y="580"/>
                </a:cubicBezTo>
                <a:cubicBezTo>
                  <a:pt x="2270" y="587"/>
                  <a:pt x="2289" y="599"/>
                  <a:pt x="2306" y="616"/>
                </a:cubicBezTo>
                <a:cubicBezTo>
                  <a:pt x="2334" y="645"/>
                  <a:pt x="2349" y="678"/>
                  <a:pt x="2351" y="716"/>
                </a:cubicBezTo>
                <a:cubicBezTo>
                  <a:pt x="2353" y="754"/>
                  <a:pt x="2330" y="797"/>
                  <a:pt x="2282" y="844"/>
                </a:cubicBezTo>
                <a:lnTo>
                  <a:pt x="2196" y="930"/>
                </a:lnTo>
                <a:lnTo>
                  <a:pt x="2333" y="1067"/>
                </a:lnTo>
                <a:lnTo>
                  <a:pt x="2288" y="1111"/>
                </a:lnTo>
                <a:close/>
                <a:moveTo>
                  <a:pt x="2156" y="891"/>
                </a:moveTo>
                <a:lnTo>
                  <a:pt x="2243" y="804"/>
                </a:lnTo>
                <a:cubicBezTo>
                  <a:pt x="2272" y="775"/>
                  <a:pt x="2287" y="749"/>
                  <a:pt x="2288" y="726"/>
                </a:cubicBezTo>
                <a:cubicBezTo>
                  <a:pt x="2290" y="704"/>
                  <a:pt x="2281" y="683"/>
                  <a:pt x="2261" y="663"/>
                </a:cubicBezTo>
                <a:cubicBezTo>
                  <a:pt x="2247" y="649"/>
                  <a:pt x="2232" y="641"/>
                  <a:pt x="2214" y="638"/>
                </a:cubicBezTo>
                <a:cubicBezTo>
                  <a:pt x="2197" y="635"/>
                  <a:pt x="2181" y="638"/>
                  <a:pt x="2167" y="646"/>
                </a:cubicBezTo>
                <a:cubicBezTo>
                  <a:pt x="2157" y="652"/>
                  <a:pt x="2142" y="664"/>
                  <a:pt x="2122" y="685"/>
                </a:cubicBezTo>
                <a:lnTo>
                  <a:pt x="2036" y="771"/>
                </a:lnTo>
                <a:lnTo>
                  <a:pt x="2156" y="891"/>
                </a:lnTo>
                <a:close/>
                <a:moveTo>
                  <a:pt x="2476" y="707"/>
                </a:moveTo>
                <a:lnTo>
                  <a:pt x="2514" y="662"/>
                </a:lnTo>
                <a:cubicBezTo>
                  <a:pt x="2533" y="677"/>
                  <a:pt x="2552" y="686"/>
                  <a:pt x="2570" y="689"/>
                </a:cubicBezTo>
                <a:cubicBezTo>
                  <a:pt x="2588" y="693"/>
                  <a:pt x="2608" y="690"/>
                  <a:pt x="2630" y="682"/>
                </a:cubicBezTo>
                <a:cubicBezTo>
                  <a:pt x="2652" y="673"/>
                  <a:pt x="2672" y="659"/>
                  <a:pt x="2691" y="640"/>
                </a:cubicBezTo>
                <a:cubicBezTo>
                  <a:pt x="2708" y="623"/>
                  <a:pt x="2721" y="606"/>
                  <a:pt x="2728" y="588"/>
                </a:cubicBezTo>
                <a:cubicBezTo>
                  <a:pt x="2736" y="569"/>
                  <a:pt x="2739" y="553"/>
                  <a:pt x="2737" y="538"/>
                </a:cubicBezTo>
                <a:cubicBezTo>
                  <a:pt x="2734" y="523"/>
                  <a:pt x="2728" y="510"/>
                  <a:pt x="2717" y="499"/>
                </a:cubicBezTo>
                <a:cubicBezTo>
                  <a:pt x="2707" y="489"/>
                  <a:pt x="2695" y="483"/>
                  <a:pt x="2681" y="481"/>
                </a:cubicBezTo>
                <a:cubicBezTo>
                  <a:pt x="2667" y="479"/>
                  <a:pt x="2650" y="483"/>
                  <a:pt x="2631" y="491"/>
                </a:cubicBezTo>
                <a:cubicBezTo>
                  <a:pt x="2618" y="497"/>
                  <a:pt x="2593" y="511"/>
                  <a:pt x="2554" y="535"/>
                </a:cubicBezTo>
                <a:cubicBezTo>
                  <a:pt x="2516" y="558"/>
                  <a:pt x="2487" y="573"/>
                  <a:pt x="2469" y="579"/>
                </a:cubicBezTo>
                <a:cubicBezTo>
                  <a:pt x="2444" y="586"/>
                  <a:pt x="2422" y="588"/>
                  <a:pt x="2401" y="583"/>
                </a:cubicBezTo>
                <a:cubicBezTo>
                  <a:pt x="2381" y="579"/>
                  <a:pt x="2363" y="569"/>
                  <a:pt x="2348" y="553"/>
                </a:cubicBezTo>
                <a:cubicBezTo>
                  <a:pt x="2331" y="536"/>
                  <a:pt x="2320" y="516"/>
                  <a:pt x="2315" y="491"/>
                </a:cubicBezTo>
                <a:cubicBezTo>
                  <a:pt x="2309" y="467"/>
                  <a:pt x="2312" y="442"/>
                  <a:pt x="2323" y="416"/>
                </a:cubicBezTo>
                <a:cubicBezTo>
                  <a:pt x="2334" y="389"/>
                  <a:pt x="2351" y="365"/>
                  <a:pt x="2373" y="342"/>
                </a:cubicBezTo>
                <a:cubicBezTo>
                  <a:pt x="2398" y="318"/>
                  <a:pt x="2424" y="300"/>
                  <a:pt x="2451" y="289"/>
                </a:cubicBezTo>
                <a:cubicBezTo>
                  <a:pt x="2478" y="278"/>
                  <a:pt x="2505" y="275"/>
                  <a:pt x="2531" y="280"/>
                </a:cubicBezTo>
                <a:cubicBezTo>
                  <a:pt x="2556" y="285"/>
                  <a:pt x="2580" y="298"/>
                  <a:pt x="2600" y="317"/>
                </a:cubicBezTo>
                <a:lnTo>
                  <a:pt x="2561" y="362"/>
                </a:lnTo>
                <a:cubicBezTo>
                  <a:pt x="2537" y="343"/>
                  <a:pt x="2513" y="335"/>
                  <a:pt x="2489" y="338"/>
                </a:cubicBezTo>
                <a:cubicBezTo>
                  <a:pt x="2465" y="340"/>
                  <a:pt x="2440" y="354"/>
                  <a:pt x="2414" y="380"/>
                </a:cubicBezTo>
                <a:cubicBezTo>
                  <a:pt x="2388" y="407"/>
                  <a:pt x="2373" y="431"/>
                  <a:pt x="2370" y="453"/>
                </a:cubicBezTo>
                <a:cubicBezTo>
                  <a:pt x="2368" y="476"/>
                  <a:pt x="2374" y="494"/>
                  <a:pt x="2388" y="508"/>
                </a:cubicBezTo>
                <a:cubicBezTo>
                  <a:pt x="2400" y="520"/>
                  <a:pt x="2414" y="525"/>
                  <a:pt x="2430" y="524"/>
                </a:cubicBezTo>
                <a:cubicBezTo>
                  <a:pt x="2447" y="523"/>
                  <a:pt x="2477" y="509"/>
                  <a:pt x="2521" y="481"/>
                </a:cubicBezTo>
                <a:cubicBezTo>
                  <a:pt x="2566" y="453"/>
                  <a:pt x="2598" y="436"/>
                  <a:pt x="2617" y="428"/>
                </a:cubicBezTo>
                <a:cubicBezTo>
                  <a:pt x="2646" y="418"/>
                  <a:pt x="2672" y="415"/>
                  <a:pt x="2695" y="419"/>
                </a:cubicBezTo>
                <a:cubicBezTo>
                  <a:pt x="2718" y="424"/>
                  <a:pt x="2739" y="435"/>
                  <a:pt x="2757" y="453"/>
                </a:cubicBezTo>
                <a:cubicBezTo>
                  <a:pt x="2775" y="471"/>
                  <a:pt x="2786" y="493"/>
                  <a:pt x="2792" y="519"/>
                </a:cubicBezTo>
                <a:cubicBezTo>
                  <a:pt x="2797" y="545"/>
                  <a:pt x="2795" y="572"/>
                  <a:pt x="2785" y="600"/>
                </a:cubicBezTo>
                <a:cubicBezTo>
                  <a:pt x="2774" y="628"/>
                  <a:pt x="2757" y="654"/>
                  <a:pt x="2733" y="678"/>
                </a:cubicBezTo>
                <a:cubicBezTo>
                  <a:pt x="2703" y="708"/>
                  <a:pt x="2673" y="729"/>
                  <a:pt x="2643" y="741"/>
                </a:cubicBezTo>
                <a:cubicBezTo>
                  <a:pt x="2614" y="753"/>
                  <a:pt x="2584" y="755"/>
                  <a:pt x="2555" y="749"/>
                </a:cubicBezTo>
                <a:cubicBezTo>
                  <a:pt x="2525" y="743"/>
                  <a:pt x="2499" y="729"/>
                  <a:pt x="2476" y="707"/>
                </a:cubicBezTo>
                <a:close/>
                <a:moveTo>
                  <a:pt x="3076" y="244"/>
                </a:moveTo>
                <a:lnTo>
                  <a:pt x="3116" y="283"/>
                </a:lnTo>
                <a:lnTo>
                  <a:pt x="2894" y="506"/>
                </a:lnTo>
                <a:cubicBezTo>
                  <a:pt x="2884" y="496"/>
                  <a:pt x="2876" y="485"/>
                  <a:pt x="2870" y="472"/>
                </a:cubicBezTo>
                <a:cubicBezTo>
                  <a:pt x="2861" y="451"/>
                  <a:pt x="2855" y="427"/>
                  <a:pt x="2853" y="400"/>
                </a:cubicBezTo>
                <a:cubicBezTo>
                  <a:pt x="2850" y="373"/>
                  <a:pt x="2851" y="338"/>
                  <a:pt x="2856" y="295"/>
                </a:cubicBezTo>
                <a:cubicBezTo>
                  <a:pt x="2862" y="229"/>
                  <a:pt x="2863" y="180"/>
                  <a:pt x="2859" y="150"/>
                </a:cubicBezTo>
                <a:cubicBezTo>
                  <a:pt x="2854" y="120"/>
                  <a:pt x="2844" y="97"/>
                  <a:pt x="2828" y="81"/>
                </a:cubicBezTo>
                <a:cubicBezTo>
                  <a:pt x="2812" y="65"/>
                  <a:pt x="2792" y="57"/>
                  <a:pt x="2769" y="57"/>
                </a:cubicBezTo>
                <a:cubicBezTo>
                  <a:pt x="2746" y="58"/>
                  <a:pt x="2725" y="67"/>
                  <a:pt x="2707" y="86"/>
                </a:cubicBezTo>
                <a:cubicBezTo>
                  <a:pt x="2687" y="106"/>
                  <a:pt x="2677" y="128"/>
                  <a:pt x="2677" y="152"/>
                </a:cubicBezTo>
                <a:cubicBezTo>
                  <a:pt x="2677" y="176"/>
                  <a:pt x="2687" y="198"/>
                  <a:pt x="2708" y="219"/>
                </a:cubicBezTo>
                <a:lnTo>
                  <a:pt x="2662" y="257"/>
                </a:lnTo>
                <a:cubicBezTo>
                  <a:pt x="2633" y="223"/>
                  <a:pt x="2620" y="188"/>
                  <a:pt x="2622" y="152"/>
                </a:cubicBezTo>
                <a:cubicBezTo>
                  <a:pt x="2624" y="117"/>
                  <a:pt x="2641" y="83"/>
                  <a:pt x="2673" y="51"/>
                </a:cubicBezTo>
                <a:cubicBezTo>
                  <a:pt x="2706" y="19"/>
                  <a:pt x="2740" y="2"/>
                  <a:pt x="2777" y="1"/>
                </a:cubicBezTo>
                <a:cubicBezTo>
                  <a:pt x="2814" y="0"/>
                  <a:pt x="2845" y="13"/>
                  <a:pt x="2872" y="40"/>
                </a:cubicBezTo>
                <a:cubicBezTo>
                  <a:pt x="2885" y="53"/>
                  <a:pt x="2895" y="69"/>
                  <a:pt x="2903" y="88"/>
                </a:cubicBezTo>
                <a:cubicBezTo>
                  <a:pt x="2910" y="106"/>
                  <a:pt x="2915" y="129"/>
                  <a:pt x="2917" y="156"/>
                </a:cubicBezTo>
                <a:cubicBezTo>
                  <a:pt x="2918" y="183"/>
                  <a:pt x="2917" y="224"/>
                  <a:pt x="2912" y="279"/>
                </a:cubicBezTo>
                <a:cubicBezTo>
                  <a:pt x="2908" y="324"/>
                  <a:pt x="2906" y="354"/>
                  <a:pt x="2907" y="369"/>
                </a:cubicBezTo>
                <a:cubicBezTo>
                  <a:pt x="2907" y="383"/>
                  <a:pt x="2909" y="396"/>
                  <a:pt x="2912" y="409"/>
                </a:cubicBezTo>
                <a:lnTo>
                  <a:pt x="3076" y="244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2" name="Freeform 68"/>
          <p:cNvSpPr>
            <a:spLocks noEditPoints="1"/>
          </p:cNvSpPr>
          <p:nvPr/>
        </p:nvSpPr>
        <p:spPr bwMode="auto">
          <a:xfrm>
            <a:off x="2409967" y="5035690"/>
            <a:ext cx="582612" cy="582613"/>
          </a:xfrm>
          <a:custGeom>
            <a:avLst/>
            <a:gdLst>
              <a:gd name="T0" fmla="*/ 419 w 3064"/>
              <a:gd name="T1" fmla="*/ 2982 h 3056"/>
              <a:gd name="T2" fmla="*/ 13 w 3064"/>
              <a:gd name="T3" fmla="*/ 2852 h 3056"/>
              <a:gd name="T4" fmla="*/ 303 w 3064"/>
              <a:gd name="T5" fmla="*/ 2598 h 3056"/>
              <a:gd name="T6" fmla="*/ 63 w 3064"/>
              <a:gd name="T7" fmla="*/ 2756 h 3056"/>
              <a:gd name="T8" fmla="*/ 305 w 3064"/>
              <a:gd name="T9" fmla="*/ 2988 h 3056"/>
              <a:gd name="T10" fmla="*/ 465 w 3064"/>
              <a:gd name="T11" fmla="*/ 2680 h 3056"/>
              <a:gd name="T12" fmla="*/ 690 w 3064"/>
              <a:gd name="T13" fmla="*/ 2449 h 3056"/>
              <a:gd name="T14" fmla="*/ 591 w 3064"/>
              <a:gd name="T15" fmla="*/ 2743 h 3056"/>
              <a:gd name="T16" fmla="*/ 673 w 3064"/>
              <a:gd name="T17" fmla="*/ 2660 h 3056"/>
              <a:gd name="T18" fmla="*/ 487 w 3064"/>
              <a:gd name="T19" fmla="*/ 2473 h 3056"/>
              <a:gd name="T20" fmla="*/ 625 w 3064"/>
              <a:gd name="T21" fmla="*/ 2277 h 3056"/>
              <a:gd name="T22" fmla="*/ 782 w 3064"/>
              <a:gd name="T23" fmla="*/ 2125 h 3056"/>
              <a:gd name="T24" fmla="*/ 1066 w 3064"/>
              <a:gd name="T25" fmla="*/ 2323 h 3056"/>
              <a:gd name="T26" fmla="*/ 797 w 3064"/>
              <a:gd name="T27" fmla="*/ 2180 h 3056"/>
              <a:gd name="T28" fmla="*/ 910 w 3064"/>
              <a:gd name="T29" fmla="*/ 2480 h 3056"/>
              <a:gd name="T30" fmla="*/ 1197 w 3064"/>
              <a:gd name="T31" fmla="*/ 2199 h 3056"/>
              <a:gd name="T32" fmla="*/ 925 w 3064"/>
              <a:gd name="T33" fmla="*/ 2042 h 3056"/>
              <a:gd name="T34" fmla="*/ 832 w 3064"/>
              <a:gd name="T35" fmla="*/ 1949 h 3056"/>
              <a:gd name="T36" fmla="*/ 1007 w 3064"/>
              <a:gd name="T37" fmla="*/ 1959 h 3056"/>
              <a:gd name="T38" fmla="*/ 1148 w 3064"/>
              <a:gd name="T39" fmla="*/ 2165 h 3056"/>
              <a:gd name="T40" fmla="*/ 1015 w 3064"/>
              <a:gd name="T41" fmla="*/ 1888 h 3056"/>
              <a:gd name="T42" fmla="*/ 1099 w 3064"/>
              <a:gd name="T43" fmla="*/ 1792 h 3056"/>
              <a:gd name="T44" fmla="*/ 1124 w 3064"/>
              <a:gd name="T45" fmla="*/ 1869 h 3056"/>
              <a:gd name="T46" fmla="*/ 1258 w 3064"/>
              <a:gd name="T47" fmla="*/ 2131 h 3056"/>
              <a:gd name="T48" fmla="*/ 1382 w 3064"/>
              <a:gd name="T49" fmla="*/ 1575 h 3056"/>
              <a:gd name="T50" fmla="*/ 1521 w 3064"/>
              <a:gd name="T51" fmla="*/ 1879 h 3056"/>
              <a:gd name="T52" fmla="*/ 1413 w 3064"/>
              <a:gd name="T53" fmla="*/ 1873 h 3056"/>
              <a:gd name="T54" fmla="*/ 1375 w 3064"/>
              <a:gd name="T55" fmla="*/ 1631 h 3056"/>
              <a:gd name="T56" fmla="*/ 1676 w 3064"/>
              <a:gd name="T57" fmla="*/ 1713 h 3056"/>
              <a:gd name="T58" fmla="*/ 1676 w 3064"/>
              <a:gd name="T59" fmla="*/ 1713 h 3056"/>
              <a:gd name="T60" fmla="*/ 1614 w 3064"/>
              <a:gd name="T61" fmla="*/ 1306 h 3056"/>
              <a:gd name="T62" fmla="*/ 1565 w 3064"/>
              <a:gd name="T63" fmla="*/ 1150 h 3056"/>
              <a:gd name="T64" fmla="*/ 1839 w 3064"/>
              <a:gd name="T65" fmla="*/ 878 h 3056"/>
              <a:gd name="T66" fmla="*/ 2175 w 3064"/>
              <a:gd name="T67" fmla="*/ 1214 h 3056"/>
              <a:gd name="T68" fmla="*/ 2175 w 3064"/>
              <a:gd name="T69" fmla="*/ 1214 h 3056"/>
              <a:gd name="T70" fmla="*/ 2133 w 3064"/>
              <a:gd name="T71" fmla="*/ 591 h 3056"/>
              <a:gd name="T72" fmla="*/ 2351 w 3064"/>
              <a:gd name="T73" fmla="*/ 706 h 3056"/>
              <a:gd name="T74" fmla="*/ 2288 w 3064"/>
              <a:gd name="T75" fmla="*/ 1101 h 3056"/>
              <a:gd name="T76" fmla="*/ 2261 w 3064"/>
              <a:gd name="T77" fmla="*/ 653 h 3056"/>
              <a:gd name="T78" fmla="*/ 2036 w 3064"/>
              <a:gd name="T79" fmla="*/ 761 h 3056"/>
              <a:gd name="T80" fmla="*/ 2569 w 3064"/>
              <a:gd name="T81" fmla="*/ 679 h 3056"/>
              <a:gd name="T82" fmla="*/ 2737 w 3064"/>
              <a:gd name="T83" fmla="*/ 528 h 3056"/>
              <a:gd name="T84" fmla="*/ 2554 w 3064"/>
              <a:gd name="T85" fmla="*/ 525 h 3056"/>
              <a:gd name="T86" fmla="*/ 2314 w 3064"/>
              <a:gd name="T87" fmla="*/ 481 h 3056"/>
              <a:gd name="T88" fmla="*/ 2530 w 3064"/>
              <a:gd name="T89" fmla="*/ 270 h 3056"/>
              <a:gd name="T90" fmla="*/ 2414 w 3064"/>
              <a:gd name="T91" fmla="*/ 370 h 3056"/>
              <a:gd name="T92" fmla="*/ 2521 w 3064"/>
              <a:gd name="T93" fmla="*/ 471 h 3056"/>
              <a:gd name="T94" fmla="*/ 2792 w 3064"/>
              <a:gd name="T95" fmla="*/ 509 h 3056"/>
              <a:gd name="T96" fmla="*/ 2555 w 3064"/>
              <a:gd name="T97" fmla="*/ 739 h 3056"/>
              <a:gd name="T98" fmla="*/ 2921 w 3064"/>
              <a:gd name="T99" fmla="*/ 381 h 3056"/>
              <a:gd name="T100" fmla="*/ 2912 w 3064"/>
              <a:gd name="T101" fmla="*/ 187 h 3056"/>
              <a:gd name="T102" fmla="*/ 2797 w 3064"/>
              <a:gd name="T103" fmla="*/ 203 h 3056"/>
              <a:gd name="T104" fmla="*/ 2702 w 3064"/>
              <a:gd name="T105" fmla="*/ 80 h 3056"/>
              <a:gd name="T106" fmla="*/ 2623 w 3064"/>
              <a:gd name="T107" fmla="*/ 137 h 3056"/>
              <a:gd name="T108" fmla="*/ 2853 w 3064"/>
              <a:gd name="T109" fmla="*/ 36 h 3056"/>
              <a:gd name="T110" fmla="*/ 3020 w 3064"/>
              <a:gd name="T111" fmla="*/ 171 h 3056"/>
              <a:gd name="T112" fmla="*/ 2811 w 3064"/>
              <a:gd name="T113" fmla="*/ 401 h 305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</a:cxnLst>
            <a:rect l="0" t="0" r="r" b="b"/>
            <a:pathLst>
              <a:path w="3064" h="3056">
                <a:moveTo>
                  <a:pt x="390" y="2763"/>
                </a:moveTo>
                <a:lnTo>
                  <a:pt x="446" y="2730"/>
                </a:lnTo>
                <a:cubicBezTo>
                  <a:pt x="473" y="2776"/>
                  <a:pt x="484" y="2821"/>
                  <a:pt x="479" y="2864"/>
                </a:cubicBezTo>
                <a:cubicBezTo>
                  <a:pt x="474" y="2907"/>
                  <a:pt x="454" y="2947"/>
                  <a:pt x="419" y="2982"/>
                </a:cubicBezTo>
                <a:cubicBezTo>
                  <a:pt x="383" y="3018"/>
                  <a:pt x="346" y="3040"/>
                  <a:pt x="309" y="3048"/>
                </a:cubicBezTo>
                <a:cubicBezTo>
                  <a:pt x="271" y="3056"/>
                  <a:pt x="233" y="3052"/>
                  <a:pt x="193" y="3036"/>
                </a:cubicBezTo>
                <a:cubicBezTo>
                  <a:pt x="153" y="3019"/>
                  <a:pt x="117" y="2995"/>
                  <a:pt x="85" y="2963"/>
                </a:cubicBezTo>
                <a:cubicBezTo>
                  <a:pt x="50" y="2928"/>
                  <a:pt x="26" y="2891"/>
                  <a:pt x="13" y="2852"/>
                </a:cubicBezTo>
                <a:cubicBezTo>
                  <a:pt x="1" y="2812"/>
                  <a:pt x="0" y="2773"/>
                  <a:pt x="11" y="2735"/>
                </a:cubicBezTo>
                <a:cubicBezTo>
                  <a:pt x="22" y="2697"/>
                  <a:pt x="43" y="2663"/>
                  <a:pt x="72" y="2633"/>
                </a:cubicBezTo>
                <a:cubicBezTo>
                  <a:pt x="106" y="2600"/>
                  <a:pt x="143" y="2580"/>
                  <a:pt x="183" y="2574"/>
                </a:cubicBezTo>
                <a:cubicBezTo>
                  <a:pt x="223" y="2568"/>
                  <a:pt x="263" y="2576"/>
                  <a:pt x="303" y="2598"/>
                </a:cubicBezTo>
                <a:lnTo>
                  <a:pt x="270" y="2653"/>
                </a:lnTo>
                <a:cubicBezTo>
                  <a:pt x="237" y="2636"/>
                  <a:pt x="208" y="2629"/>
                  <a:pt x="182" y="2633"/>
                </a:cubicBezTo>
                <a:cubicBezTo>
                  <a:pt x="156" y="2637"/>
                  <a:pt x="132" y="2650"/>
                  <a:pt x="110" y="2672"/>
                </a:cubicBezTo>
                <a:cubicBezTo>
                  <a:pt x="84" y="2698"/>
                  <a:pt x="68" y="2726"/>
                  <a:pt x="63" y="2756"/>
                </a:cubicBezTo>
                <a:cubicBezTo>
                  <a:pt x="58" y="2785"/>
                  <a:pt x="63" y="2814"/>
                  <a:pt x="77" y="2842"/>
                </a:cubicBezTo>
                <a:cubicBezTo>
                  <a:pt x="90" y="2870"/>
                  <a:pt x="108" y="2895"/>
                  <a:pt x="131" y="2917"/>
                </a:cubicBezTo>
                <a:cubicBezTo>
                  <a:pt x="159" y="2946"/>
                  <a:pt x="188" y="2966"/>
                  <a:pt x="218" y="2979"/>
                </a:cubicBezTo>
                <a:cubicBezTo>
                  <a:pt x="248" y="2992"/>
                  <a:pt x="277" y="2995"/>
                  <a:pt x="305" y="2988"/>
                </a:cubicBezTo>
                <a:cubicBezTo>
                  <a:pt x="333" y="2981"/>
                  <a:pt x="357" y="2968"/>
                  <a:pt x="378" y="2947"/>
                </a:cubicBezTo>
                <a:cubicBezTo>
                  <a:pt x="402" y="2922"/>
                  <a:pt x="416" y="2894"/>
                  <a:pt x="419" y="2862"/>
                </a:cubicBezTo>
                <a:cubicBezTo>
                  <a:pt x="422" y="2831"/>
                  <a:pt x="413" y="2798"/>
                  <a:pt x="390" y="2763"/>
                </a:cubicBezTo>
                <a:close/>
                <a:moveTo>
                  <a:pt x="465" y="2680"/>
                </a:moveTo>
                <a:cubicBezTo>
                  <a:pt x="420" y="2635"/>
                  <a:pt x="400" y="2589"/>
                  <a:pt x="403" y="2543"/>
                </a:cubicBezTo>
                <a:cubicBezTo>
                  <a:pt x="406" y="2504"/>
                  <a:pt x="422" y="2469"/>
                  <a:pt x="452" y="2439"/>
                </a:cubicBezTo>
                <a:cubicBezTo>
                  <a:pt x="486" y="2406"/>
                  <a:pt x="524" y="2389"/>
                  <a:pt x="567" y="2390"/>
                </a:cubicBezTo>
                <a:cubicBezTo>
                  <a:pt x="611" y="2390"/>
                  <a:pt x="651" y="2410"/>
                  <a:pt x="690" y="2449"/>
                </a:cubicBezTo>
                <a:cubicBezTo>
                  <a:pt x="721" y="2480"/>
                  <a:pt x="741" y="2510"/>
                  <a:pt x="750" y="2537"/>
                </a:cubicBezTo>
                <a:cubicBezTo>
                  <a:pt x="759" y="2564"/>
                  <a:pt x="759" y="2592"/>
                  <a:pt x="751" y="2620"/>
                </a:cubicBezTo>
                <a:cubicBezTo>
                  <a:pt x="743" y="2648"/>
                  <a:pt x="728" y="2672"/>
                  <a:pt x="707" y="2693"/>
                </a:cubicBezTo>
                <a:cubicBezTo>
                  <a:pt x="673" y="2728"/>
                  <a:pt x="634" y="2744"/>
                  <a:pt x="591" y="2743"/>
                </a:cubicBezTo>
                <a:cubicBezTo>
                  <a:pt x="549" y="2742"/>
                  <a:pt x="507" y="2722"/>
                  <a:pt x="465" y="2680"/>
                </a:cubicBezTo>
                <a:close/>
                <a:moveTo>
                  <a:pt x="508" y="2638"/>
                </a:moveTo>
                <a:cubicBezTo>
                  <a:pt x="539" y="2669"/>
                  <a:pt x="569" y="2686"/>
                  <a:pt x="598" y="2688"/>
                </a:cubicBezTo>
                <a:cubicBezTo>
                  <a:pt x="627" y="2690"/>
                  <a:pt x="652" y="2680"/>
                  <a:pt x="673" y="2660"/>
                </a:cubicBezTo>
                <a:cubicBezTo>
                  <a:pt x="693" y="2639"/>
                  <a:pt x="703" y="2614"/>
                  <a:pt x="701" y="2585"/>
                </a:cubicBezTo>
                <a:cubicBezTo>
                  <a:pt x="699" y="2556"/>
                  <a:pt x="682" y="2525"/>
                  <a:pt x="650" y="2493"/>
                </a:cubicBezTo>
                <a:cubicBezTo>
                  <a:pt x="620" y="2463"/>
                  <a:pt x="590" y="2447"/>
                  <a:pt x="561" y="2445"/>
                </a:cubicBezTo>
                <a:cubicBezTo>
                  <a:pt x="532" y="2444"/>
                  <a:pt x="507" y="2453"/>
                  <a:pt x="487" y="2473"/>
                </a:cubicBezTo>
                <a:cubicBezTo>
                  <a:pt x="466" y="2494"/>
                  <a:pt x="457" y="2519"/>
                  <a:pt x="458" y="2548"/>
                </a:cubicBezTo>
                <a:cubicBezTo>
                  <a:pt x="460" y="2577"/>
                  <a:pt x="477" y="2607"/>
                  <a:pt x="508" y="2638"/>
                </a:cubicBezTo>
                <a:close/>
                <a:moveTo>
                  <a:pt x="868" y="2521"/>
                </a:moveTo>
                <a:lnTo>
                  <a:pt x="625" y="2277"/>
                </a:lnTo>
                <a:lnTo>
                  <a:pt x="662" y="2240"/>
                </a:lnTo>
                <a:lnTo>
                  <a:pt x="697" y="2275"/>
                </a:lnTo>
                <a:cubicBezTo>
                  <a:pt x="688" y="2230"/>
                  <a:pt x="700" y="2191"/>
                  <a:pt x="734" y="2157"/>
                </a:cubicBezTo>
                <a:cubicBezTo>
                  <a:pt x="749" y="2143"/>
                  <a:pt x="765" y="2132"/>
                  <a:pt x="782" y="2125"/>
                </a:cubicBezTo>
                <a:cubicBezTo>
                  <a:pt x="800" y="2118"/>
                  <a:pt x="816" y="2115"/>
                  <a:pt x="831" y="2118"/>
                </a:cubicBezTo>
                <a:cubicBezTo>
                  <a:pt x="846" y="2120"/>
                  <a:pt x="860" y="2126"/>
                  <a:pt x="874" y="2136"/>
                </a:cubicBezTo>
                <a:cubicBezTo>
                  <a:pt x="883" y="2142"/>
                  <a:pt x="897" y="2154"/>
                  <a:pt x="917" y="2173"/>
                </a:cubicBezTo>
                <a:lnTo>
                  <a:pt x="1066" y="2323"/>
                </a:lnTo>
                <a:lnTo>
                  <a:pt x="1025" y="2364"/>
                </a:lnTo>
                <a:lnTo>
                  <a:pt x="877" y="2216"/>
                </a:lnTo>
                <a:cubicBezTo>
                  <a:pt x="860" y="2199"/>
                  <a:pt x="846" y="2188"/>
                  <a:pt x="834" y="2183"/>
                </a:cubicBezTo>
                <a:cubicBezTo>
                  <a:pt x="823" y="2178"/>
                  <a:pt x="811" y="2177"/>
                  <a:pt x="797" y="2180"/>
                </a:cubicBezTo>
                <a:cubicBezTo>
                  <a:pt x="784" y="2184"/>
                  <a:pt x="772" y="2191"/>
                  <a:pt x="761" y="2202"/>
                </a:cubicBezTo>
                <a:cubicBezTo>
                  <a:pt x="744" y="2219"/>
                  <a:pt x="734" y="2240"/>
                  <a:pt x="732" y="2264"/>
                </a:cubicBezTo>
                <a:cubicBezTo>
                  <a:pt x="731" y="2288"/>
                  <a:pt x="746" y="2315"/>
                  <a:pt x="777" y="2347"/>
                </a:cubicBezTo>
                <a:lnTo>
                  <a:pt x="910" y="2480"/>
                </a:lnTo>
                <a:lnTo>
                  <a:pt x="868" y="2521"/>
                </a:lnTo>
                <a:close/>
                <a:moveTo>
                  <a:pt x="1182" y="2134"/>
                </a:moveTo>
                <a:lnTo>
                  <a:pt x="1224" y="2164"/>
                </a:lnTo>
                <a:cubicBezTo>
                  <a:pt x="1215" y="2178"/>
                  <a:pt x="1206" y="2190"/>
                  <a:pt x="1197" y="2199"/>
                </a:cubicBezTo>
                <a:cubicBezTo>
                  <a:pt x="1182" y="2214"/>
                  <a:pt x="1168" y="2223"/>
                  <a:pt x="1155" y="2227"/>
                </a:cubicBezTo>
                <a:cubicBezTo>
                  <a:pt x="1142" y="2230"/>
                  <a:pt x="1130" y="2230"/>
                  <a:pt x="1119" y="2225"/>
                </a:cubicBezTo>
                <a:cubicBezTo>
                  <a:pt x="1108" y="2221"/>
                  <a:pt x="1090" y="2207"/>
                  <a:pt x="1065" y="2182"/>
                </a:cubicBezTo>
                <a:lnTo>
                  <a:pt x="925" y="2042"/>
                </a:lnTo>
                <a:lnTo>
                  <a:pt x="895" y="2072"/>
                </a:lnTo>
                <a:lnTo>
                  <a:pt x="862" y="2040"/>
                </a:lnTo>
                <a:lnTo>
                  <a:pt x="893" y="2010"/>
                </a:lnTo>
                <a:lnTo>
                  <a:pt x="832" y="1949"/>
                </a:lnTo>
                <a:lnTo>
                  <a:pt x="849" y="1884"/>
                </a:lnTo>
                <a:lnTo>
                  <a:pt x="934" y="1969"/>
                </a:lnTo>
                <a:lnTo>
                  <a:pt x="975" y="1927"/>
                </a:lnTo>
                <a:lnTo>
                  <a:pt x="1007" y="1959"/>
                </a:lnTo>
                <a:lnTo>
                  <a:pt x="966" y="2001"/>
                </a:lnTo>
                <a:lnTo>
                  <a:pt x="1108" y="2143"/>
                </a:lnTo>
                <a:cubicBezTo>
                  <a:pt x="1120" y="2155"/>
                  <a:pt x="1128" y="2162"/>
                  <a:pt x="1133" y="2164"/>
                </a:cubicBezTo>
                <a:cubicBezTo>
                  <a:pt x="1138" y="2165"/>
                  <a:pt x="1143" y="2166"/>
                  <a:pt x="1148" y="2165"/>
                </a:cubicBezTo>
                <a:cubicBezTo>
                  <a:pt x="1154" y="2163"/>
                  <a:pt x="1159" y="2159"/>
                  <a:pt x="1165" y="2153"/>
                </a:cubicBezTo>
                <a:cubicBezTo>
                  <a:pt x="1170" y="2149"/>
                  <a:pt x="1175" y="2142"/>
                  <a:pt x="1182" y="2134"/>
                </a:cubicBezTo>
                <a:close/>
                <a:moveTo>
                  <a:pt x="1258" y="2131"/>
                </a:moveTo>
                <a:lnTo>
                  <a:pt x="1015" y="1888"/>
                </a:lnTo>
                <a:lnTo>
                  <a:pt x="1052" y="1850"/>
                </a:lnTo>
                <a:lnTo>
                  <a:pt x="1089" y="1887"/>
                </a:lnTo>
                <a:cubicBezTo>
                  <a:pt x="1081" y="1861"/>
                  <a:pt x="1078" y="1840"/>
                  <a:pt x="1081" y="1827"/>
                </a:cubicBezTo>
                <a:cubicBezTo>
                  <a:pt x="1083" y="1813"/>
                  <a:pt x="1090" y="1802"/>
                  <a:pt x="1099" y="1792"/>
                </a:cubicBezTo>
                <a:cubicBezTo>
                  <a:pt x="1113" y="1778"/>
                  <a:pt x="1132" y="1769"/>
                  <a:pt x="1155" y="1763"/>
                </a:cubicBezTo>
                <a:lnTo>
                  <a:pt x="1179" y="1816"/>
                </a:lnTo>
                <a:cubicBezTo>
                  <a:pt x="1163" y="1820"/>
                  <a:pt x="1150" y="1827"/>
                  <a:pt x="1140" y="1837"/>
                </a:cubicBezTo>
                <a:cubicBezTo>
                  <a:pt x="1131" y="1846"/>
                  <a:pt x="1125" y="1857"/>
                  <a:pt x="1124" y="1869"/>
                </a:cubicBezTo>
                <a:cubicBezTo>
                  <a:pt x="1122" y="1882"/>
                  <a:pt x="1124" y="1895"/>
                  <a:pt x="1131" y="1907"/>
                </a:cubicBezTo>
                <a:cubicBezTo>
                  <a:pt x="1141" y="1927"/>
                  <a:pt x="1155" y="1945"/>
                  <a:pt x="1172" y="1962"/>
                </a:cubicBezTo>
                <a:lnTo>
                  <a:pt x="1300" y="2090"/>
                </a:lnTo>
                <a:lnTo>
                  <a:pt x="1258" y="2131"/>
                </a:lnTo>
                <a:close/>
                <a:moveTo>
                  <a:pt x="1280" y="1866"/>
                </a:moveTo>
                <a:cubicBezTo>
                  <a:pt x="1235" y="1821"/>
                  <a:pt x="1214" y="1775"/>
                  <a:pt x="1217" y="1728"/>
                </a:cubicBezTo>
                <a:cubicBezTo>
                  <a:pt x="1220" y="1689"/>
                  <a:pt x="1237" y="1655"/>
                  <a:pt x="1267" y="1624"/>
                </a:cubicBezTo>
                <a:cubicBezTo>
                  <a:pt x="1300" y="1591"/>
                  <a:pt x="1339" y="1575"/>
                  <a:pt x="1382" y="1575"/>
                </a:cubicBezTo>
                <a:cubicBezTo>
                  <a:pt x="1425" y="1576"/>
                  <a:pt x="1466" y="1596"/>
                  <a:pt x="1505" y="1634"/>
                </a:cubicBezTo>
                <a:cubicBezTo>
                  <a:pt x="1536" y="1666"/>
                  <a:pt x="1556" y="1695"/>
                  <a:pt x="1565" y="1722"/>
                </a:cubicBezTo>
                <a:cubicBezTo>
                  <a:pt x="1573" y="1750"/>
                  <a:pt x="1573" y="1777"/>
                  <a:pt x="1565" y="1805"/>
                </a:cubicBezTo>
                <a:cubicBezTo>
                  <a:pt x="1557" y="1833"/>
                  <a:pt x="1543" y="1858"/>
                  <a:pt x="1521" y="1879"/>
                </a:cubicBezTo>
                <a:cubicBezTo>
                  <a:pt x="1487" y="1913"/>
                  <a:pt x="1449" y="1930"/>
                  <a:pt x="1406" y="1929"/>
                </a:cubicBezTo>
                <a:cubicBezTo>
                  <a:pt x="1363" y="1928"/>
                  <a:pt x="1321" y="1907"/>
                  <a:pt x="1280" y="1866"/>
                </a:cubicBezTo>
                <a:close/>
                <a:moveTo>
                  <a:pt x="1322" y="1823"/>
                </a:moveTo>
                <a:cubicBezTo>
                  <a:pt x="1354" y="1855"/>
                  <a:pt x="1384" y="1871"/>
                  <a:pt x="1413" y="1873"/>
                </a:cubicBezTo>
                <a:cubicBezTo>
                  <a:pt x="1442" y="1875"/>
                  <a:pt x="1467" y="1866"/>
                  <a:pt x="1488" y="1845"/>
                </a:cubicBezTo>
                <a:cubicBezTo>
                  <a:pt x="1508" y="1824"/>
                  <a:pt x="1517" y="1800"/>
                  <a:pt x="1515" y="1770"/>
                </a:cubicBezTo>
                <a:cubicBezTo>
                  <a:pt x="1513" y="1741"/>
                  <a:pt x="1496" y="1711"/>
                  <a:pt x="1464" y="1679"/>
                </a:cubicBezTo>
                <a:cubicBezTo>
                  <a:pt x="1434" y="1649"/>
                  <a:pt x="1405" y="1633"/>
                  <a:pt x="1375" y="1631"/>
                </a:cubicBezTo>
                <a:cubicBezTo>
                  <a:pt x="1346" y="1629"/>
                  <a:pt x="1321" y="1638"/>
                  <a:pt x="1301" y="1659"/>
                </a:cubicBezTo>
                <a:cubicBezTo>
                  <a:pt x="1281" y="1679"/>
                  <a:pt x="1271" y="1704"/>
                  <a:pt x="1273" y="1733"/>
                </a:cubicBezTo>
                <a:cubicBezTo>
                  <a:pt x="1275" y="1762"/>
                  <a:pt x="1291" y="1792"/>
                  <a:pt x="1322" y="1823"/>
                </a:cubicBezTo>
                <a:close/>
                <a:moveTo>
                  <a:pt x="1676" y="1713"/>
                </a:moveTo>
                <a:lnTo>
                  <a:pt x="1340" y="1377"/>
                </a:lnTo>
                <a:lnTo>
                  <a:pt x="1382" y="1336"/>
                </a:lnTo>
                <a:lnTo>
                  <a:pt x="1718" y="1672"/>
                </a:lnTo>
                <a:lnTo>
                  <a:pt x="1676" y="1713"/>
                </a:lnTo>
                <a:close/>
                <a:moveTo>
                  <a:pt x="1929" y="1461"/>
                </a:moveTo>
                <a:lnTo>
                  <a:pt x="1888" y="1502"/>
                </a:lnTo>
                <a:lnTo>
                  <a:pt x="1625" y="1239"/>
                </a:lnTo>
                <a:cubicBezTo>
                  <a:pt x="1624" y="1258"/>
                  <a:pt x="1621" y="1281"/>
                  <a:pt x="1614" y="1306"/>
                </a:cubicBezTo>
                <a:cubicBezTo>
                  <a:pt x="1607" y="1332"/>
                  <a:pt x="1600" y="1354"/>
                  <a:pt x="1592" y="1371"/>
                </a:cubicBezTo>
                <a:lnTo>
                  <a:pt x="1552" y="1331"/>
                </a:lnTo>
                <a:cubicBezTo>
                  <a:pt x="1564" y="1297"/>
                  <a:pt x="1571" y="1264"/>
                  <a:pt x="1573" y="1231"/>
                </a:cubicBezTo>
                <a:cubicBezTo>
                  <a:pt x="1575" y="1199"/>
                  <a:pt x="1572" y="1171"/>
                  <a:pt x="1565" y="1150"/>
                </a:cubicBezTo>
                <a:lnTo>
                  <a:pt x="1591" y="1123"/>
                </a:lnTo>
                <a:lnTo>
                  <a:pt x="1929" y="1461"/>
                </a:lnTo>
                <a:close/>
                <a:moveTo>
                  <a:pt x="1887" y="925"/>
                </a:moveTo>
                <a:lnTo>
                  <a:pt x="1839" y="878"/>
                </a:lnTo>
                <a:lnTo>
                  <a:pt x="1881" y="837"/>
                </a:lnTo>
                <a:lnTo>
                  <a:pt x="1928" y="884"/>
                </a:lnTo>
                <a:lnTo>
                  <a:pt x="1887" y="925"/>
                </a:lnTo>
                <a:close/>
                <a:moveTo>
                  <a:pt x="2175" y="1214"/>
                </a:moveTo>
                <a:lnTo>
                  <a:pt x="1932" y="970"/>
                </a:lnTo>
                <a:lnTo>
                  <a:pt x="1973" y="929"/>
                </a:lnTo>
                <a:lnTo>
                  <a:pt x="2217" y="1173"/>
                </a:lnTo>
                <a:lnTo>
                  <a:pt x="2175" y="1214"/>
                </a:lnTo>
                <a:close/>
                <a:moveTo>
                  <a:pt x="2288" y="1101"/>
                </a:moveTo>
                <a:lnTo>
                  <a:pt x="1952" y="765"/>
                </a:lnTo>
                <a:lnTo>
                  <a:pt x="2079" y="639"/>
                </a:lnTo>
                <a:cubicBezTo>
                  <a:pt x="2101" y="616"/>
                  <a:pt x="2119" y="600"/>
                  <a:pt x="2133" y="591"/>
                </a:cubicBezTo>
                <a:cubicBezTo>
                  <a:pt x="2152" y="577"/>
                  <a:pt x="2171" y="568"/>
                  <a:pt x="2190" y="565"/>
                </a:cubicBezTo>
                <a:cubicBezTo>
                  <a:pt x="2209" y="561"/>
                  <a:pt x="2229" y="563"/>
                  <a:pt x="2250" y="570"/>
                </a:cubicBezTo>
                <a:cubicBezTo>
                  <a:pt x="2270" y="577"/>
                  <a:pt x="2289" y="589"/>
                  <a:pt x="2306" y="606"/>
                </a:cubicBezTo>
                <a:cubicBezTo>
                  <a:pt x="2334" y="635"/>
                  <a:pt x="2349" y="668"/>
                  <a:pt x="2351" y="706"/>
                </a:cubicBezTo>
                <a:cubicBezTo>
                  <a:pt x="2352" y="744"/>
                  <a:pt x="2329" y="787"/>
                  <a:pt x="2282" y="834"/>
                </a:cubicBezTo>
                <a:lnTo>
                  <a:pt x="2196" y="920"/>
                </a:lnTo>
                <a:lnTo>
                  <a:pt x="2332" y="1057"/>
                </a:lnTo>
                <a:lnTo>
                  <a:pt x="2288" y="1101"/>
                </a:lnTo>
                <a:close/>
                <a:moveTo>
                  <a:pt x="2156" y="881"/>
                </a:moveTo>
                <a:lnTo>
                  <a:pt x="2243" y="794"/>
                </a:lnTo>
                <a:cubicBezTo>
                  <a:pt x="2272" y="765"/>
                  <a:pt x="2287" y="739"/>
                  <a:pt x="2288" y="716"/>
                </a:cubicBezTo>
                <a:cubicBezTo>
                  <a:pt x="2290" y="694"/>
                  <a:pt x="2281" y="673"/>
                  <a:pt x="2261" y="653"/>
                </a:cubicBezTo>
                <a:cubicBezTo>
                  <a:pt x="2247" y="639"/>
                  <a:pt x="2231" y="631"/>
                  <a:pt x="2214" y="628"/>
                </a:cubicBezTo>
                <a:cubicBezTo>
                  <a:pt x="2197" y="625"/>
                  <a:pt x="2181" y="628"/>
                  <a:pt x="2166" y="636"/>
                </a:cubicBezTo>
                <a:cubicBezTo>
                  <a:pt x="2157" y="642"/>
                  <a:pt x="2142" y="654"/>
                  <a:pt x="2122" y="675"/>
                </a:cubicBezTo>
                <a:lnTo>
                  <a:pt x="2036" y="761"/>
                </a:lnTo>
                <a:lnTo>
                  <a:pt x="2156" y="881"/>
                </a:lnTo>
                <a:close/>
                <a:moveTo>
                  <a:pt x="2476" y="697"/>
                </a:moveTo>
                <a:lnTo>
                  <a:pt x="2514" y="652"/>
                </a:lnTo>
                <a:cubicBezTo>
                  <a:pt x="2533" y="667"/>
                  <a:pt x="2551" y="676"/>
                  <a:pt x="2569" y="679"/>
                </a:cubicBezTo>
                <a:cubicBezTo>
                  <a:pt x="2588" y="683"/>
                  <a:pt x="2607" y="680"/>
                  <a:pt x="2629" y="672"/>
                </a:cubicBezTo>
                <a:cubicBezTo>
                  <a:pt x="2651" y="663"/>
                  <a:pt x="2672" y="649"/>
                  <a:pt x="2691" y="630"/>
                </a:cubicBezTo>
                <a:cubicBezTo>
                  <a:pt x="2708" y="613"/>
                  <a:pt x="2720" y="596"/>
                  <a:pt x="2728" y="578"/>
                </a:cubicBezTo>
                <a:cubicBezTo>
                  <a:pt x="2736" y="559"/>
                  <a:pt x="2739" y="543"/>
                  <a:pt x="2737" y="528"/>
                </a:cubicBezTo>
                <a:cubicBezTo>
                  <a:pt x="2734" y="513"/>
                  <a:pt x="2728" y="500"/>
                  <a:pt x="2717" y="489"/>
                </a:cubicBezTo>
                <a:cubicBezTo>
                  <a:pt x="2707" y="479"/>
                  <a:pt x="2695" y="473"/>
                  <a:pt x="2681" y="471"/>
                </a:cubicBezTo>
                <a:cubicBezTo>
                  <a:pt x="2667" y="469"/>
                  <a:pt x="2650" y="473"/>
                  <a:pt x="2630" y="481"/>
                </a:cubicBezTo>
                <a:cubicBezTo>
                  <a:pt x="2618" y="487"/>
                  <a:pt x="2593" y="501"/>
                  <a:pt x="2554" y="525"/>
                </a:cubicBezTo>
                <a:cubicBezTo>
                  <a:pt x="2516" y="548"/>
                  <a:pt x="2487" y="563"/>
                  <a:pt x="2468" y="569"/>
                </a:cubicBezTo>
                <a:cubicBezTo>
                  <a:pt x="2444" y="576"/>
                  <a:pt x="2422" y="578"/>
                  <a:pt x="2401" y="573"/>
                </a:cubicBezTo>
                <a:cubicBezTo>
                  <a:pt x="2381" y="569"/>
                  <a:pt x="2363" y="559"/>
                  <a:pt x="2348" y="543"/>
                </a:cubicBezTo>
                <a:cubicBezTo>
                  <a:pt x="2331" y="526"/>
                  <a:pt x="2320" y="506"/>
                  <a:pt x="2314" y="481"/>
                </a:cubicBezTo>
                <a:cubicBezTo>
                  <a:pt x="2309" y="457"/>
                  <a:pt x="2312" y="432"/>
                  <a:pt x="2323" y="406"/>
                </a:cubicBezTo>
                <a:cubicBezTo>
                  <a:pt x="2334" y="379"/>
                  <a:pt x="2351" y="355"/>
                  <a:pt x="2373" y="332"/>
                </a:cubicBezTo>
                <a:cubicBezTo>
                  <a:pt x="2398" y="308"/>
                  <a:pt x="2424" y="290"/>
                  <a:pt x="2451" y="279"/>
                </a:cubicBezTo>
                <a:cubicBezTo>
                  <a:pt x="2478" y="268"/>
                  <a:pt x="2505" y="265"/>
                  <a:pt x="2530" y="270"/>
                </a:cubicBezTo>
                <a:cubicBezTo>
                  <a:pt x="2556" y="275"/>
                  <a:pt x="2579" y="288"/>
                  <a:pt x="2600" y="307"/>
                </a:cubicBezTo>
                <a:lnTo>
                  <a:pt x="2561" y="352"/>
                </a:lnTo>
                <a:cubicBezTo>
                  <a:pt x="2537" y="333"/>
                  <a:pt x="2513" y="325"/>
                  <a:pt x="2489" y="328"/>
                </a:cubicBezTo>
                <a:cubicBezTo>
                  <a:pt x="2465" y="330"/>
                  <a:pt x="2440" y="344"/>
                  <a:pt x="2414" y="370"/>
                </a:cubicBezTo>
                <a:cubicBezTo>
                  <a:pt x="2387" y="397"/>
                  <a:pt x="2373" y="421"/>
                  <a:pt x="2370" y="443"/>
                </a:cubicBezTo>
                <a:cubicBezTo>
                  <a:pt x="2368" y="466"/>
                  <a:pt x="2374" y="484"/>
                  <a:pt x="2387" y="498"/>
                </a:cubicBezTo>
                <a:cubicBezTo>
                  <a:pt x="2400" y="510"/>
                  <a:pt x="2414" y="515"/>
                  <a:pt x="2430" y="514"/>
                </a:cubicBezTo>
                <a:cubicBezTo>
                  <a:pt x="2447" y="513"/>
                  <a:pt x="2477" y="499"/>
                  <a:pt x="2521" y="471"/>
                </a:cubicBezTo>
                <a:cubicBezTo>
                  <a:pt x="2566" y="443"/>
                  <a:pt x="2598" y="426"/>
                  <a:pt x="2617" y="418"/>
                </a:cubicBezTo>
                <a:cubicBezTo>
                  <a:pt x="2646" y="408"/>
                  <a:pt x="2672" y="405"/>
                  <a:pt x="2695" y="409"/>
                </a:cubicBezTo>
                <a:cubicBezTo>
                  <a:pt x="2718" y="414"/>
                  <a:pt x="2739" y="425"/>
                  <a:pt x="2757" y="443"/>
                </a:cubicBezTo>
                <a:cubicBezTo>
                  <a:pt x="2774" y="461"/>
                  <a:pt x="2786" y="483"/>
                  <a:pt x="2792" y="509"/>
                </a:cubicBezTo>
                <a:cubicBezTo>
                  <a:pt x="2797" y="535"/>
                  <a:pt x="2795" y="562"/>
                  <a:pt x="2785" y="590"/>
                </a:cubicBezTo>
                <a:cubicBezTo>
                  <a:pt x="2774" y="618"/>
                  <a:pt x="2757" y="644"/>
                  <a:pt x="2733" y="668"/>
                </a:cubicBezTo>
                <a:cubicBezTo>
                  <a:pt x="2703" y="698"/>
                  <a:pt x="2673" y="719"/>
                  <a:pt x="2643" y="731"/>
                </a:cubicBezTo>
                <a:cubicBezTo>
                  <a:pt x="2614" y="743"/>
                  <a:pt x="2584" y="745"/>
                  <a:pt x="2555" y="739"/>
                </a:cubicBezTo>
                <a:cubicBezTo>
                  <a:pt x="2525" y="733"/>
                  <a:pt x="2499" y="719"/>
                  <a:pt x="2476" y="697"/>
                </a:cubicBezTo>
                <a:close/>
                <a:moveTo>
                  <a:pt x="2811" y="401"/>
                </a:moveTo>
                <a:lnTo>
                  <a:pt x="2846" y="355"/>
                </a:lnTo>
                <a:cubicBezTo>
                  <a:pt x="2874" y="373"/>
                  <a:pt x="2899" y="382"/>
                  <a:pt x="2921" y="381"/>
                </a:cubicBezTo>
                <a:cubicBezTo>
                  <a:pt x="2943" y="380"/>
                  <a:pt x="2962" y="371"/>
                  <a:pt x="2978" y="355"/>
                </a:cubicBezTo>
                <a:cubicBezTo>
                  <a:pt x="2998" y="335"/>
                  <a:pt x="3007" y="312"/>
                  <a:pt x="3007" y="285"/>
                </a:cubicBezTo>
                <a:cubicBezTo>
                  <a:pt x="3007" y="259"/>
                  <a:pt x="2997" y="235"/>
                  <a:pt x="2977" y="215"/>
                </a:cubicBezTo>
                <a:cubicBezTo>
                  <a:pt x="2958" y="196"/>
                  <a:pt x="2936" y="187"/>
                  <a:pt x="2912" y="187"/>
                </a:cubicBezTo>
                <a:cubicBezTo>
                  <a:pt x="2887" y="187"/>
                  <a:pt x="2865" y="197"/>
                  <a:pt x="2846" y="216"/>
                </a:cubicBezTo>
                <a:cubicBezTo>
                  <a:pt x="2838" y="224"/>
                  <a:pt x="2830" y="235"/>
                  <a:pt x="2822" y="250"/>
                </a:cubicBezTo>
                <a:lnTo>
                  <a:pt x="2790" y="209"/>
                </a:lnTo>
                <a:cubicBezTo>
                  <a:pt x="2793" y="206"/>
                  <a:pt x="2795" y="204"/>
                  <a:pt x="2797" y="203"/>
                </a:cubicBezTo>
                <a:cubicBezTo>
                  <a:pt x="2815" y="185"/>
                  <a:pt x="2826" y="165"/>
                  <a:pt x="2831" y="141"/>
                </a:cubicBezTo>
                <a:cubicBezTo>
                  <a:pt x="2836" y="118"/>
                  <a:pt x="2829" y="97"/>
                  <a:pt x="2809" y="78"/>
                </a:cubicBezTo>
                <a:cubicBezTo>
                  <a:pt x="2794" y="63"/>
                  <a:pt x="2777" y="55"/>
                  <a:pt x="2756" y="56"/>
                </a:cubicBezTo>
                <a:cubicBezTo>
                  <a:pt x="2736" y="56"/>
                  <a:pt x="2718" y="64"/>
                  <a:pt x="2702" y="80"/>
                </a:cubicBezTo>
                <a:cubicBezTo>
                  <a:pt x="2686" y="96"/>
                  <a:pt x="2678" y="115"/>
                  <a:pt x="2677" y="136"/>
                </a:cubicBezTo>
                <a:cubicBezTo>
                  <a:pt x="2676" y="156"/>
                  <a:pt x="2685" y="178"/>
                  <a:pt x="2702" y="202"/>
                </a:cubicBezTo>
                <a:lnTo>
                  <a:pt x="2653" y="236"/>
                </a:lnTo>
                <a:cubicBezTo>
                  <a:pt x="2630" y="203"/>
                  <a:pt x="2621" y="170"/>
                  <a:pt x="2623" y="137"/>
                </a:cubicBezTo>
                <a:cubicBezTo>
                  <a:pt x="2626" y="104"/>
                  <a:pt x="2640" y="74"/>
                  <a:pt x="2667" y="47"/>
                </a:cubicBezTo>
                <a:cubicBezTo>
                  <a:pt x="2685" y="29"/>
                  <a:pt x="2706" y="16"/>
                  <a:pt x="2730" y="8"/>
                </a:cubicBezTo>
                <a:cubicBezTo>
                  <a:pt x="2753" y="1"/>
                  <a:pt x="2775" y="0"/>
                  <a:pt x="2797" y="5"/>
                </a:cubicBezTo>
                <a:cubicBezTo>
                  <a:pt x="2819" y="11"/>
                  <a:pt x="2837" y="21"/>
                  <a:pt x="2853" y="36"/>
                </a:cubicBezTo>
                <a:cubicBezTo>
                  <a:pt x="2867" y="51"/>
                  <a:pt x="2877" y="68"/>
                  <a:pt x="2881" y="88"/>
                </a:cubicBezTo>
                <a:cubicBezTo>
                  <a:pt x="2885" y="107"/>
                  <a:pt x="2883" y="128"/>
                  <a:pt x="2875" y="151"/>
                </a:cubicBezTo>
                <a:cubicBezTo>
                  <a:pt x="2899" y="135"/>
                  <a:pt x="2924" y="129"/>
                  <a:pt x="2949" y="133"/>
                </a:cubicBezTo>
                <a:cubicBezTo>
                  <a:pt x="2975" y="136"/>
                  <a:pt x="2998" y="149"/>
                  <a:pt x="3020" y="171"/>
                </a:cubicBezTo>
                <a:cubicBezTo>
                  <a:pt x="3049" y="200"/>
                  <a:pt x="3064" y="236"/>
                  <a:pt x="3063" y="277"/>
                </a:cubicBezTo>
                <a:cubicBezTo>
                  <a:pt x="3062" y="319"/>
                  <a:pt x="3045" y="356"/>
                  <a:pt x="3012" y="389"/>
                </a:cubicBezTo>
                <a:cubicBezTo>
                  <a:pt x="2983" y="419"/>
                  <a:pt x="2949" y="434"/>
                  <a:pt x="2912" y="436"/>
                </a:cubicBezTo>
                <a:cubicBezTo>
                  <a:pt x="2875" y="438"/>
                  <a:pt x="2841" y="426"/>
                  <a:pt x="2811" y="401"/>
                </a:cubicBez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3" name="Freeform 69"/>
          <p:cNvSpPr>
            <a:spLocks noEditPoints="1"/>
          </p:cNvSpPr>
          <p:nvPr/>
        </p:nvSpPr>
        <p:spPr bwMode="auto">
          <a:xfrm>
            <a:off x="2692542" y="5035690"/>
            <a:ext cx="839787" cy="839788"/>
          </a:xfrm>
          <a:custGeom>
            <a:avLst/>
            <a:gdLst>
              <a:gd name="T0" fmla="*/ 238 w 4406"/>
              <a:gd name="T1" fmla="*/ 3871 h 4408"/>
              <a:gd name="T2" fmla="*/ 244 w 4406"/>
              <a:gd name="T3" fmla="*/ 4227 h 4408"/>
              <a:gd name="T4" fmla="*/ 336 w 4406"/>
              <a:gd name="T5" fmla="*/ 4023 h 4408"/>
              <a:gd name="T6" fmla="*/ 84 w 4406"/>
              <a:gd name="T7" fmla="*/ 4067 h 4408"/>
              <a:gd name="T8" fmla="*/ 513 w 4406"/>
              <a:gd name="T9" fmla="*/ 3579 h 4408"/>
              <a:gd name="T10" fmla="*/ 740 w 4406"/>
              <a:gd name="T11" fmla="*/ 3707 h 4408"/>
              <a:gd name="T12" fmla="*/ 779 w 4406"/>
              <a:gd name="T13" fmla="*/ 3965 h 4408"/>
              <a:gd name="T14" fmla="*/ 621 w 4406"/>
              <a:gd name="T15" fmla="*/ 3692 h 4408"/>
              <a:gd name="T16" fmla="*/ 399 w 4406"/>
              <a:gd name="T17" fmla="*/ 3752 h 4408"/>
              <a:gd name="T18" fmla="*/ 785 w 4406"/>
              <a:gd name="T19" fmla="*/ 3859 h 4408"/>
              <a:gd name="T20" fmla="*/ 618 w 4406"/>
              <a:gd name="T21" fmla="*/ 3816 h 4408"/>
              <a:gd name="T22" fmla="*/ 744 w 4406"/>
              <a:gd name="T23" fmla="*/ 3328 h 4408"/>
              <a:gd name="T24" fmla="*/ 1131 w 4406"/>
              <a:gd name="T25" fmla="*/ 3409 h 4408"/>
              <a:gd name="T26" fmla="*/ 964 w 4406"/>
              <a:gd name="T27" fmla="*/ 3780 h 4408"/>
              <a:gd name="T28" fmla="*/ 1081 w 4406"/>
              <a:gd name="T29" fmla="*/ 3451 h 4408"/>
              <a:gd name="T30" fmla="*/ 712 w 4406"/>
              <a:gd name="T31" fmla="*/ 3439 h 4408"/>
              <a:gd name="T32" fmla="*/ 1627 w 4406"/>
              <a:gd name="T33" fmla="*/ 3304 h 4408"/>
              <a:gd name="T34" fmla="*/ 1414 w 4406"/>
              <a:gd name="T35" fmla="*/ 2664 h 4408"/>
              <a:gd name="T36" fmla="*/ 1563 w 4406"/>
              <a:gd name="T37" fmla="*/ 2908 h 4408"/>
              <a:gd name="T38" fmla="*/ 1524 w 4406"/>
              <a:gd name="T39" fmla="*/ 2867 h 4408"/>
              <a:gd name="T40" fmla="*/ 1403 w 4406"/>
              <a:gd name="T41" fmla="*/ 2748 h 4408"/>
              <a:gd name="T42" fmla="*/ 1788 w 4406"/>
              <a:gd name="T43" fmla="*/ 2284 h 4408"/>
              <a:gd name="T44" fmla="*/ 1958 w 4406"/>
              <a:gd name="T45" fmla="*/ 2478 h 4408"/>
              <a:gd name="T46" fmla="*/ 1881 w 4406"/>
              <a:gd name="T47" fmla="*/ 2863 h 4408"/>
              <a:gd name="T48" fmla="*/ 2042 w 4406"/>
              <a:gd name="T49" fmla="*/ 2202 h 4408"/>
              <a:gd name="T50" fmla="*/ 2166 w 4406"/>
              <a:gd name="T51" fmla="*/ 2223 h 4408"/>
              <a:gd name="T52" fmla="*/ 2184 w 4406"/>
              <a:gd name="T53" fmla="*/ 2326 h 4408"/>
              <a:gd name="T54" fmla="*/ 2343 w 4406"/>
              <a:gd name="T55" fmla="*/ 1875 h 4408"/>
              <a:gd name="T56" fmla="*/ 2283 w 4406"/>
              <a:gd name="T57" fmla="*/ 1786 h 4408"/>
              <a:gd name="T58" fmla="*/ 2531 w 4406"/>
              <a:gd name="T59" fmla="*/ 1790 h 4408"/>
              <a:gd name="T60" fmla="*/ 2472 w 4406"/>
              <a:gd name="T61" fmla="*/ 1608 h 4408"/>
              <a:gd name="T62" fmla="*/ 2532 w 4406"/>
              <a:gd name="T63" fmla="*/ 1621 h 4408"/>
              <a:gd name="T64" fmla="*/ 2608 w 4406"/>
              <a:gd name="T65" fmla="*/ 1713 h 4408"/>
              <a:gd name="T66" fmla="*/ 2901 w 4406"/>
              <a:gd name="T67" fmla="*/ 1760 h 4408"/>
              <a:gd name="T68" fmla="*/ 2885 w 4406"/>
              <a:gd name="T69" fmla="*/ 1653 h 4408"/>
              <a:gd name="T70" fmla="*/ 2685 w 4406"/>
              <a:gd name="T71" fmla="*/ 1595 h 4408"/>
              <a:gd name="T72" fmla="*/ 2895 w 4406"/>
              <a:gd name="T73" fmla="*/ 1488 h 4408"/>
              <a:gd name="T74" fmla="*/ 2746 w 4406"/>
              <a:gd name="T75" fmla="*/ 1631 h 4408"/>
              <a:gd name="T76" fmla="*/ 2968 w 4406"/>
              <a:gd name="T77" fmla="*/ 1562 h 4408"/>
              <a:gd name="T78" fmla="*/ 2900 w 4406"/>
              <a:gd name="T79" fmla="*/ 1816 h 4408"/>
              <a:gd name="T80" fmla="*/ 3096 w 4406"/>
              <a:gd name="T81" fmla="*/ 1591 h 4408"/>
              <a:gd name="T82" fmla="*/ 2995 w 4406"/>
              <a:gd name="T83" fmla="*/ 1176 h 4408"/>
              <a:gd name="T84" fmla="*/ 2848 w 4406"/>
              <a:gd name="T85" fmla="*/ 1271 h 4408"/>
              <a:gd name="T86" fmla="*/ 3142 w 4406"/>
              <a:gd name="T87" fmla="*/ 1275 h 4408"/>
              <a:gd name="T88" fmla="*/ 3238 w 4406"/>
              <a:gd name="T89" fmla="*/ 928 h 4408"/>
              <a:gd name="T90" fmla="*/ 3527 w 4406"/>
              <a:gd name="T91" fmla="*/ 1217 h 4408"/>
              <a:gd name="T92" fmla="*/ 3640 w 4406"/>
              <a:gd name="T93" fmla="*/ 1104 h 4408"/>
              <a:gd name="T94" fmla="*/ 3601 w 4406"/>
              <a:gd name="T95" fmla="*/ 573 h 4408"/>
              <a:gd name="T96" fmla="*/ 3684 w 4406"/>
              <a:gd name="T97" fmla="*/ 1060 h 4408"/>
              <a:gd name="T98" fmla="*/ 3613 w 4406"/>
              <a:gd name="T99" fmla="*/ 656 h 4408"/>
              <a:gd name="T100" fmla="*/ 3508 w 4406"/>
              <a:gd name="T101" fmla="*/ 884 h 4408"/>
              <a:gd name="T102" fmla="*/ 4043 w 4406"/>
              <a:gd name="T103" fmla="*/ 633 h 4408"/>
              <a:gd name="T104" fmla="*/ 3982 w 4406"/>
              <a:gd name="T105" fmla="*/ 484 h 4408"/>
              <a:gd name="T106" fmla="*/ 3666 w 4406"/>
              <a:gd name="T107" fmla="*/ 484 h 4408"/>
              <a:gd name="T108" fmla="*/ 3952 w 4406"/>
              <a:gd name="T109" fmla="*/ 310 h 4408"/>
              <a:gd name="T110" fmla="*/ 3739 w 4406"/>
              <a:gd name="T111" fmla="*/ 501 h 4408"/>
              <a:gd name="T112" fmla="*/ 4108 w 4406"/>
              <a:gd name="T113" fmla="*/ 446 h 4408"/>
              <a:gd name="T114" fmla="*/ 3906 w 4406"/>
              <a:gd name="T115" fmla="*/ 742 h 4408"/>
              <a:gd name="T116" fmla="*/ 4091 w 4406"/>
              <a:gd name="T117" fmla="*/ 184 h 4408"/>
              <a:gd name="T118" fmla="*/ 4069 w 4406"/>
              <a:gd name="T119" fmla="*/ 0 h 440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</a:cxnLst>
            <a:rect l="0" t="0" r="r" b="b"/>
            <a:pathLst>
              <a:path w="4406" h="4408">
                <a:moveTo>
                  <a:pt x="336" y="4408"/>
                </a:moveTo>
                <a:lnTo>
                  <a:pt x="0" y="4072"/>
                </a:lnTo>
                <a:lnTo>
                  <a:pt x="127" y="3945"/>
                </a:lnTo>
                <a:cubicBezTo>
                  <a:pt x="149" y="3923"/>
                  <a:pt x="167" y="3907"/>
                  <a:pt x="181" y="3897"/>
                </a:cubicBezTo>
                <a:cubicBezTo>
                  <a:pt x="200" y="3883"/>
                  <a:pt x="219" y="3875"/>
                  <a:pt x="238" y="3871"/>
                </a:cubicBezTo>
                <a:cubicBezTo>
                  <a:pt x="257" y="3868"/>
                  <a:pt x="277" y="3870"/>
                  <a:pt x="298" y="3877"/>
                </a:cubicBezTo>
                <a:cubicBezTo>
                  <a:pt x="318" y="3884"/>
                  <a:pt x="337" y="3896"/>
                  <a:pt x="354" y="3913"/>
                </a:cubicBezTo>
                <a:cubicBezTo>
                  <a:pt x="382" y="3941"/>
                  <a:pt x="397" y="3974"/>
                  <a:pt x="399" y="4012"/>
                </a:cubicBezTo>
                <a:cubicBezTo>
                  <a:pt x="401" y="4050"/>
                  <a:pt x="378" y="4093"/>
                  <a:pt x="330" y="4141"/>
                </a:cubicBezTo>
                <a:lnTo>
                  <a:pt x="244" y="4227"/>
                </a:lnTo>
                <a:lnTo>
                  <a:pt x="380" y="4364"/>
                </a:lnTo>
                <a:lnTo>
                  <a:pt x="336" y="4408"/>
                </a:lnTo>
                <a:close/>
                <a:moveTo>
                  <a:pt x="204" y="4187"/>
                </a:moveTo>
                <a:lnTo>
                  <a:pt x="291" y="4100"/>
                </a:lnTo>
                <a:cubicBezTo>
                  <a:pt x="320" y="4072"/>
                  <a:pt x="335" y="4046"/>
                  <a:pt x="336" y="4023"/>
                </a:cubicBezTo>
                <a:cubicBezTo>
                  <a:pt x="338" y="4000"/>
                  <a:pt x="329" y="3979"/>
                  <a:pt x="309" y="3960"/>
                </a:cubicBezTo>
                <a:cubicBezTo>
                  <a:pt x="295" y="3946"/>
                  <a:pt x="280" y="3937"/>
                  <a:pt x="262" y="3934"/>
                </a:cubicBezTo>
                <a:cubicBezTo>
                  <a:pt x="245" y="3931"/>
                  <a:pt x="229" y="3934"/>
                  <a:pt x="215" y="3943"/>
                </a:cubicBezTo>
                <a:cubicBezTo>
                  <a:pt x="205" y="3948"/>
                  <a:pt x="190" y="3961"/>
                  <a:pt x="170" y="3981"/>
                </a:cubicBezTo>
                <a:lnTo>
                  <a:pt x="84" y="4067"/>
                </a:lnTo>
                <a:lnTo>
                  <a:pt x="204" y="4187"/>
                </a:lnTo>
                <a:close/>
                <a:moveTo>
                  <a:pt x="651" y="4093"/>
                </a:moveTo>
                <a:lnTo>
                  <a:pt x="315" y="3757"/>
                </a:lnTo>
                <a:lnTo>
                  <a:pt x="441" y="3631"/>
                </a:lnTo>
                <a:cubicBezTo>
                  <a:pt x="467" y="3605"/>
                  <a:pt x="491" y="3588"/>
                  <a:pt x="513" y="3579"/>
                </a:cubicBezTo>
                <a:cubicBezTo>
                  <a:pt x="535" y="3571"/>
                  <a:pt x="558" y="3569"/>
                  <a:pt x="581" y="3574"/>
                </a:cubicBezTo>
                <a:cubicBezTo>
                  <a:pt x="604" y="3580"/>
                  <a:pt x="623" y="3590"/>
                  <a:pt x="638" y="3605"/>
                </a:cubicBezTo>
                <a:cubicBezTo>
                  <a:pt x="653" y="3620"/>
                  <a:pt x="662" y="3637"/>
                  <a:pt x="667" y="3658"/>
                </a:cubicBezTo>
                <a:cubicBezTo>
                  <a:pt x="672" y="3678"/>
                  <a:pt x="671" y="3700"/>
                  <a:pt x="663" y="3724"/>
                </a:cubicBezTo>
                <a:cubicBezTo>
                  <a:pt x="689" y="3709"/>
                  <a:pt x="715" y="3704"/>
                  <a:pt x="740" y="3707"/>
                </a:cubicBezTo>
                <a:cubicBezTo>
                  <a:pt x="765" y="3711"/>
                  <a:pt x="788" y="3722"/>
                  <a:pt x="807" y="3742"/>
                </a:cubicBezTo>
                <a:cubicBezTo>
                  <a:pt x="823" y="3758"/>
                  <a:pt x="834" y="3776"/>
                  <a:pt x="841" y="3796"/>
                </a:cubicBezTo>
                <a:cubicBezTo>
                  <a:pt x="848" y="3816"/>
                  <a:pt x="850" y="3835"/>
                  <a:pt x="848" y="3852"/>
                </a:cubicBezTo>
                <a:cubicBezTo>
                  <a:pt x="845" y="3869"/>
                  <a:pt x="839" y="3887"/>
                  <a:pt x="828" y="3905"/>
                </a:cubicBezTo>
                <a:cubicBezTo>
                  <a:pt x="817" y="3924"/>
                  <a:pt x="801" y="3944"/>
                  <a:pt x="779" y="3965"/>
                </a:cubicBezTo>
                <a:lnTo>
                  <a:pt x="651" y="4093"/>
                </a:lnTo>
                <a:close/>
                <a:moveTo>
                  <a:pt x="501" y="3854"/>
                </a:moveTo>
                <a:lnTo>
                  <a:pt x="573" y="3781"/>
                </a:lnTo>
                <a:cubicBezTo>
                  <a:pt x="593" y="3761"/>
                  <a:pt x="606" y="3746"/>
                  <a:pt x="612" y="3735"/>
                </a:cubicBezTo>
                <a:cubicBezTo>
                  <a:pt x="620" y="3720"/>
                  <a:pt x="623" y="3706"/>
                  <a:pt x="621" y="3692"/>
                </a:cubicBezTo>
                <a:cubicBezTo>
                  <a:pt x="619" y="3679"/>
                  <a:pt x="612" y="3666"/>
                  <a:pt x="600" y="3654"/>
                </a:cubicBezTo>
                <a:cubicBezTo>
                  <a:pt x="589" y="3643"/>
                  <a:pt x="576" y="3636"/>
                  <a:pt x="562" y="3633"/>
                </a:cubicBezTo>
                <a:cubicBezTo>
                  <a:pt x="549" y="3630"/>
                  <a:pt x="535" y="3632"/>
                  <a:pt x="522" y="3639"/>
                </a:cubicBezTo>
                <a:cubicBezTo>
                  <a:pt x="509" y="3645"/>
                  <a:pt x="490" y="3661"/>
                  <a:pt x="466" y="3685"/>
                </a:cubicBezTo>
                <a:lnTo>
                  <a:pt x="399" y="3752"/>
                </a:lnTo>
                <a:lnTo>
                  <a:pt x="501" y="3854"/>
                </a:lnTo>
                <a:close/>
                <a:moveTo>
                  <a:pt x="656" y="4009"/>
                </a:moveTo>
                <a:lnTo>
                  <a:pt x="739" y="3925"/>
                </a:lnTo>
                <a:cubicBezTo>
                  <a:pt x="754" y="3911"/>
                  <a:pt x="763" y="3900"/>
                  <a:pt x="768" y="3893"/>
                </a:cubicBezTo>
                <a:cubicBezTo>
                  <a:pt x="777" y="3881"/>
                  <a:pt x="782" y="3870"/>
                  <a:pt x="785" y="3859"/>
                </a:cubicBezTo>
                <a:cubicBezTo>
                  <a:pt x="787" y="3847"/>
                  <a:pt x="787" y="3835"/>
                  <a:pt x="783" y="3823"/>
                </a:cubicBezTo>
                <a:cubicBezTo>
                  <a:pt x="779" y="3810"/>
                  <a:pt x="772" y="3799"/>
                  <a:pt x="761" y="3788"/>
                </a:cubicBezTo>
                <a:cubicBezTo>
                  <a:pt x="749" y="3775"/>
                  <a:pt x="735" y="3768"/>
                  <a:pt x="719" y="3765"/>
                </a:cubicBezTo>
                <a:cubicBezTo>
                  <a:pt x="703" y="3762"/>
                  <a:pt x="688" y="3764"/>
                  <a:pt x="673" y="3772"/>
                </a:cubicBezTo>
                <a:cubicBezTo>
                  <a:pt x="658" y="3780"/>
                  <a:pt x="639" y="3794"/>
                  <a:pt x="618" y="3816"/>
                </a:cubicBezTo>
                <a:lnTo>
                  <a:pt x="540" y="3893"/>
                </a:lnTo>
                <a:lnTo>
                  <a:pt x="656" y="4009"/>
                </a:lnTo>
                <a:close/>
                <a:moveTo>
                  <a:pt x="964" y="3780"/>
                </a:moveTo>
                <a:lnTo>
                  <a:pt x="628" y="3444"/>
                </a:lnTo>
                <a:lnTo>
                  <a:pt x="744" y="3328"/>
                </a:lnTo>
                <a:cubicBezTo>
                  <a:pt x="770" y="3302"/>
                  <a:pt x="791" y="3284"/>
                  <a:pt x="808" y="3273"/>
                </a:cubicBezTo>
                <a:cubicBezTo>
                  <a:pt x="832" y="3258"/>
                  <a:pt x="856" y="3250"/>
                  <a:pt x="882" y="3248"/>
                </a:cubicBezTo>
                <a:cubicBezTo>
                  <a:pt x="914" y="3245"/>
                  <a:pt x="947" y="3251"/>
                  <a:pt x="979" y="3266"/>
                </a:cubicBezTo>
                <a:cubicBezTo>
                  <a:pt x="1011" y="3280"/>
                  <a:pt x="1042" y="3302"/>
                  <a:pt x="1072" y="3332"/>
                </a:cubicBezTo>
                <a:cubicBezTo>
                  <a:pt x="1097" y="3358"/>
                  <a:pt x="1117" y="3383"/>
                  <a:pt x="1131" y="3409"/>
                </a:cubicBezTo>
                <a:cubicBezTo>
                  <a:pt x="1145" y="3435"/>
                  <a:pt x="1153" y="3459"/>
                  <a:pt x="1157" y="3481"/>
                </a:cubicBezTo>
                <a:cubicBezTo>
                  <a:pt x="1160" y="3503"/>
                  <a:pt x="1160" y="3524"/>
                  <a:pt x="1157" y="3542"/>
                </a:cubicBezTo>
                <a:cubicBezTo>
                  <a:pt x="1153" y="3561"/>
                  <a:pt x="1145" y="3580"/>
                  <a:pt x="1133" y="3599"/>
                </a:cubicBezTo>
                <a:cubicBezTo>
                  <a:pt x="1122" y="3619"/>
                  <a:pt x="1106" y="3638"/>
                  <a:pt x="1085" y="3659"/>
                </a:cubicBezTo>
                <a:lnTo>
                  <a:pt x="964" y="3780"/>
                </a:lnTo>
                <a:close/>
                <a:moveTo>
                  <a:pt x="969" y="3696"/>
                </a:moveTo>
                <a:lnTo>
                  <a:pt x="1040" y="3624"/>
                </a:lnTo>
                <a:cubicBezTo>
                  <a:pt x="1063" y="3602"/>
                  <a:pt x="1078" y="3583"/>
                  <a:pt x="1086" y="3566"/>
                </a:cubicBezTo>
                <a:cubicBezTo>
                  <a:pt x="1095" y="3549"/>
                  <a:pt x="1099" y="3533"/>
                  <a:pt x="1099" y="3518"/>
                </a:cubicBezTo>
                <a:cubicBezTo>
                  <a:pt x="1099" y="3497"/>
                  <a:pt x="1093" y="3475"/>
                  <a:pt x="1081" y="3451"/>
                </a:cubicBezTo>
                <a:cubicBezTo>
                  <a:pt x="1069" y="3427"/>
                  <a:pt x="1051" y="3403"/>
                  <a:pt x="1025" y="3378"/>
                </a:cubicBezTo>
                <a:cubicBezTo>
                  <a:pt x="990" y="3342"/>
                  <a:pt x="957" y="3321"/>
                  <a:pt x="927" y="3314"/>
                </a:cubicBezTo>
                <a:cubicBezTo>
                  <a:pt x="897" y="3306"/>
                  <a:pt x="870" y="3308"/>
                  <a:pt x="847" y="3318"/>
                </a:cubicBezTo>
                <a:cubicBezTo>
                  <a:pt x="830" y="3325"/>
                  <a:pt x="809" y="3342"/>
                  <a:pt x="783" y="3369"/>
                </a:cubicBezTo>
                <a:lnTo>
                  <a:pt x="712" y="3439"/>
                </a:lnTo>
                <a:lnTo>
                  <a:pt x="969" y="3696"/>
                </a:lnTo>
                <a:close/>
                <a:moveTo>
                  <a:pt x="1353" y="3577"/>
                </a:moveTo>
                <a:lnTo>
                  <a:pt x="1324" y="3548"/>
                </a:lnTo>
                <a:lnTo>
                  <a:pt x="1597" y="3274"/>
                </a:lnTo>
                <a:lnTo>
                  <a:pt x="1627" y="3304"/>
                </a:lnTo>
                <a:lnTo>
                  <a:pt x="1353" y="3577"/>
                </a:lnTo>
                <a:close/>
                <a:moveTo>
                  <a:pt x="1569" y="3175"/>
                </a:moveTo>
                <a:lnTo>
                  <a:pt x="1233" y="2839"/>
                </a:lnTo>
                <a:lnTo>
                  <a:pt x="1360" y="2712"/>
                </a:lnTo>
                <a:cubicBezTo>
                  <a:pt x="1382" y="2690"/>
                  <a:pt x="1400" y="2674"/>
                  <a:pt x="1414" y="2664"/>
                </a:cubicBezTo>
                <a:cubicBezTo>
                  <a:pt x="1433" y="2650"/>
                  <a:pt x="1453" y="2642"/>
                  <a:pt x="1471" y="2638"/>
                </a:cubicBezTo>
                <a:cubicBezTo>
                  <a:pt x="1490" y="2635"/>
                  <a:pt x="1510" y="2637"/>
                  <a:pt x="1531" y="2644"/>
                </a:cubicBezTo>
                <a:cubicBezTo>
                  <a:pt x="1552" y="2651"/>
                  <a:pt x="1570" y="2663"/>
                  <a:pt x="1587" y="2679"/>
                </a:cubicBezTo>
                <a:cubicBezTo>
                  <a:pt x="1615" y="2708"/>
                  <a:pt x="1631" y="2741"/>
                  <a:pt x="1632" y="2779"/>
                </a:cubicBezTo>
                <a:cubicBezTo>
                  <a:pt x="1634" y="2817"/>
                  <a:pt x="1611" y="2860"/>
                  <a:pt x="1563" y="2908"/>
                </a:cubicBezTo>
                <a:lnTo>
                  <a:pt x="1477" y="2994"/>
                </a:lnTo>
                <a:lnTo>
                  <a:pt x="1614" y="3130"/>
                </a:lnTo>
                <a:lnTo>
                  <a:pt x="1569" y="3175"/>
                </a:lnTo>
                <a:close/>
                <a:moveTo>
                  <a:pt x="1437" y="2954"/>
                </a:moveTo>
                <a:lnTo>
                  <a:pt x="1524" y="2867"/>
                </a:lnTo>
                <a:cubicBezTo>
                  <a:pt x="1553" y="2838"/>
                  <a:pt x="1568" y="2813"/>
                  <a:pt x="1569" y="2790"/>
                </a:cubicBezTo>
                <a:cubicBezTo>
                  <a:pt x="1571" y="2767"/>
                  <a:pt x="1562" y="2746"/>
                  <a:pt x="1542" y="2727"/>
                </a:cubicBezTo>
                <a:cubicBezTo>
                  <a:pt x="1528" y="2713"/>
                  <a:pt x="1513" y="2704"/>
                  <a:pt x="1496" y="2701"/>
                </a:cubicBezTo>
                <a:cubicBezTo>
                  <a:pt x="1478" y="2698"/>
                  <a:pt x="1463" y="2701"/>
                  <a:pt x="1448" y="2709"/>
                </a:cubicBezTo>
                <a:cubicBezTo>
                  <a:pt x="1438" y="2715"/>
                  <a:pt x="1423" y="2728"/>
                  <a:pt x="1403" y="2748"/>
                </a:cubicBezTo>
                <a:lnTo>
                  <a:pt x="1317" y="2834"/>
                </a:lnTo>
                <a:lnTo>
                  <a:pt x="1437" y="2954"/>
                </a:lnTo>
                <a:close/>
                <a:moveTo>
                  <a:pt x="1881" y="2863"/>
                </a:moveTo>
                <a:lnTo>
                  <a:pt x="1545" y="2527"/>
                </a:lnTo>
                <a:lnTo>
                  <a:pt x="1788" y="2284"/>
                </a:lnTo>
                <a:lnTo>
                  <a:pt x="1828" y="2323"/>
                </a:lnTo>
                <a:lnTo>
                  <a:pt x="1629" y="2522"/>
                </a:lnTo>
                <a:lnTo>
                  <a:pt x="1732" y="2625"/>
                </a:lnTo>
                <a:lnTo>
                  <a:pt x="1918" y="2439"/>
                </a:lnTo>
                <a:lnTo>
                  <a:pt x="1958" y="2478"/>
                </a:lnTo>
                <a:lnTo>
                  <a:pt x="1772" y="2664"/>
                </a:lnTo>
                <a:lnTo>
                  <a:pt x="1886" y="2779"/>
                </a:lnTo>
                <a:lnTo>
                  <a:pt x="2092" y="2572"/>
                </a:lnTo>
                <a:lnTo>
                  <a:pt x="2132" y="2612"/>
                </a:lnTo>
                <a:lnTo>
                  <a:pt x="1881" y="2863"/>
                </a:lnTo>
                <a:close/>
                <a:moveTo>
                  <a:pt x="2163" y="2581"/>
                </a:moveTo>
                <a:lnTo>
                  <a:pt x="2118" y="2276"/>
                </a:lnTo>
                <a:lnTo>
                  <a:pt x="1842" y="2230"/>
                </a:lnTo>
                <a:lnTo>
                  <a:pt x="1895" y="2177"/>
                </a:lnTo>
                <a:lnTo>
                  <a:pt x="2042" y="2202"/>
                </a:lnTo>
                <a:cubicBezTo>
                  <a:pt x="2073" y="2207"/>
                  <a:pt x="2096" y="2212"/>
                  <a:pt x="2111" y="2216"/>
                </a:cubicBezTo>
                <a:cubicBezTo>
                  <a:pt x="2106" y="2196"/>
                  <a:pt x="2102" y="2175"/>
                  <a:pt x="2099" y="2151"/>
                </a:cubicBezTo>
                <a:lnTo>
                  <a:pt x="2077" y="1994"/>
                </a:lnTo>
                <a:lnTo>
                  <a:pt x="2126" y="1946"/>
                </a:lnTo>
                <a:lnTo>
                  <a:pt x="2166" y="2223"/>
                </a:lnTo>
                <a:lnTo>
                  <a:pt x="2471" y="2273"/>
                </a:lnTo>
                <a:lnTo>
                  <a:pt x="2416" y="2328"/>
                </a:lnTo>
                <a:lnTo>
                  <a:pt x="2212" y="2293"/>
                </a:lnTo>
                <a:cubicBezTo>
                  <a:pt x="2200" y="2291"/>
                  <a:pt x="2188" y="2288"/>
                  <a:pt x="2174" y="2285"/>
                </a:cubicBezTo>
                <a:cubicBezTo>
                  <a:pt x="2179" y="2305"/>
                  <a:pt x="2182" y="2318"/>
                  <a:pt x="2184" y="2326"/>
                </a:cubicBezTo>
                <a:lnTo>
                  <a:pt x="2216" y="2528"/>
                </a:lnTo>
                <a:lnTo>
                  <a:pt x="2163" y="2581"/>
                </a:lnTo>
                <a:close/>
                <a:moveTo>
                  <a:pt x="2647" y="2097"/>
                </a:moveTo>
                <a:lnTo>
                  <a:pt x="2606" y="2138"/>
                </a:lnTo>
                <a:lnTo>
                  <a:pt x="2343" y="1875"/>
                </a:lnTo>
                <a:cubicBezTo>
                  <a:pt x="2342" y="1895"/>
                  <a:pt x="2339" y="1917"/>
                  <a:pt x="2332" y="1943"/>
                </a:cubicBezTo>
                <a:cubicBezTo>
                  <a:pt x="2325" y="1969"/>
                  <a:pt x="2318" y="1990"/>
                  <a:pt x="2310" y="2008"/>
                </a:cubicBezTo>
                <a:lnTo>
                  <a:pt x="2270" y="1968"/>
                </a:lnTo>
                <a:cubicBezTo>
                  <a:pt x="2282" y="1934"/>
                  <a:pt x="2289" y="1901"/>
                  <a:pt x="2291" y="1868"/>
                </a:cubicBezTo>
                <a:cubicBezTo>
                  <a:pt x="2293" y="1835"/>
                  <a:pt x="2290" y="1808"/>
                  <a:pt x="2283" y="1786"/>
                </a:cubicBezTo>
                <a:lnTo>
                  <a:pt x="2309" y="1760"/>
                </a:lnTo>
                <a:lnTo>
                  <a:pt x="2647" y="2097"/>
                </a:lnTo>
                <a:close/>
                <a:moveTo>
                  <a:pt x="2779" y="1965"/>
                </a:moveTo>
                <a:lnTo>
                  <a:pt x="2567" y="1754"/>
                </a:lnTo>
                <a:lnTo>
                  <a:pt x="2531" y="1790"/>
                </a:lnTo>
                <a:lnTo>
                  <a:pt x="2499" y="1758"/>
                </a:lnTo>
                <a:lnTo>
                  <a:pt x="2535" y="1722"/>
                </a:lnTo>
                <a:lnTo>
                  <a:pt x="2509" y="1696"/>
                </a:lnTo>
                <a:cubicBezTo>
                  <a:pt x="2493" y="1680"/>
                  <a:pt x="2482" y="1666"/>
                  <a:pt x="2477" y="1655"/>
                </a:cubicBezTo>
                <a:cubicBezTo>
                  <a:pt x="2471" y="1640"/>
                  <a:pt x="2469" y="1625"/>
                  <a:pt x="2472" y="1608"/>
                </a:cubicBezTo>
                <a:cubicBezTo>
                  <a:pt x="2476" y="1591"/>
                  <a:pt x="2486" y="1574"/>
                  <a:pt x="2504" y="1556"/>
                </a:cubicBezTo>
                <a:cubicBezTo>
                  <a:pt x="2516" y="1544"/>
                  <a:pt x="2530" y="1533"/>
                  <a:pt x="2547" y="1522"/>
                </a:cubicBezTo>
                <a:lnTo>
                  <a:pt x="2577" y="1564"/>
                </a:lnTo>
                <a:cubicBezTo>
                  <a:pt x="2567" y="1571"/>
                  <a:pt x="2558" y="1578"/>
                  <a:pt x="2550" y="1586"/>
                </a:cubicBezTo>
                <a:cubicBezTo>
                  <a:pt x="2538" y="1598"/>
                  <a:pt x="2531" y="1610"/>
                  <a:pt x="2532" y="1621"/>
                </a:cubicBezTo>
                <a:cubicBezTo>
                  <a:pt x="2532" y="1631"/>
                  <a:pt x="2539" y="1644"/>
                  <a:pt x="2554" y="1658"/>
                </a:cubicBezTo>
                <a:lnTo>
                  <a:pt x="2576" y="1681"/>
                </a:lnTo>
                <a:lnTo>
                  <a:pt x="2624" y="1633"/>
                </a:lnTo>
                <a:lnTo>
                  <a:pt x="2656" y="1665"/>
                </a:lnTo>
                <a:lnTo>
                  <a:pt x="2608" y="1713"/>
                </a:lnTo>
                <a:lnTo>
                  <a:pt x="2820" y="1924"/>
                </a:lnTo>
                <a:lnTo>
                  <a:pt x="2779" y="1965"/>
                </a:lnTo>
                <a:close/>
                <a:moveTo>
                  <a:pt x="2810" y="1789"/>
                </a:moveTo>
                <a:lnTo>
                  <a:pt x="2844" y="1742"/>
                </a:lnTo>
                <a:cubicBezTo>
                  <a:pt x="2863" y="1756"/>
                  <a:pt x="2882" y="1762"/>
                  <a:pt x="2901" y="1760"/>
                </a:cubicBezTo>
                <a:cubicBezTo>
                  <a:pt x="2920" y="1758"/>
                  <a:pt x="2939" y="1748"/>
                  <a:pt x="2958" y="1729"/>
                </a:cubicBezTo>
                <a:cubicBezTo>
                  <a:pt x="2977" y="1710"/>
                  <a:pt x="2987" y="1692"/>
                  <a:pt x="2988" y="1676"/>
                </a:cubicBezTo>
                <a:cubicBezTo>
                  <a:pt x="2990" y="1659"/>
                  <a:pt x="2985" y="1645"/>
                  <a:pt x="2975" y="1635"/>
                </a:cubicBezTo>
                <a:cubicBezTo>
                  <a:pt x="2966" y="1625"/>
                  <a:pt x="2954" y="1622"/>
                  <a:pt x="2941" y="1625"/>
                </a:cubicBezTo>
                <a:cubicBezTo>
                  <a:pt x="2932" y="1627"/>
                  <a:pt x="2913" y="1636"/>
                  <a:pt x="2885" y="1653"/>
                </a:cubicBezTo>
                <a:cubicBezTo>
                  <a:pt x="2847" y="1676"/>
                  <a:pt x="2819" y="1690"/>
                  <a:pt x="2802" y="1696"/>
                </a:cubicBezTo>
                <a:cubicBezTo>
                  <a:pt x="2785" y="1702"/>
                  <a:pt x="2768" y="1703"/>
                  <a:pt x="2752" y="1699"/>
                </a:cubicBezTo>
                <a:cubicBezTo>
                  <a:pt x="2736" y="1696"/>
                  <a:pt x="2722" y="1688"/>
                  <a:pt x="2711" y="1676"/>
                </a:cubicBezTo>
                <a:cubicBezTo>
                  <a:pt x="2700" y="1665"/>
                  <a:pt x="2692" y="1652"/>
                  <a:pt x="2688" y="1638"/>
                </a:cubicBezTo>
                <a:cubicBezTo>
                  <a:pt x="2684" y="1624"/>
                  <a:pt x="2683" y="1610"/>
                  <a:pt x="2685" y="1595"/>
                </a:cubicBezTo>
                <a:cubicBezTo>
                  <a:pt x="2687" y="1584"/>
                  <a:pt x="2691" y="1571"/>
                  <a:pt x="2699" y="1557"/>
                </a:cubicBezTo>
                <a:cubicBezTo>
                  <a:pt x="2707" y="1542"/>
                  <a:pt x="2717" y="1529"/>
                  <a:pt x="2730" y="1516"/>
                </a:cubicBezTo>
                <a:cubicBezTo>
                  <a:pt x="2749" y="1497"/>
                  <a:pt x="2769" y="1483"/>
                  <a:pt x="2789" y="1474"/>
                </a:cubicBezTo>
                <a:cubicBezTo>
                  <a:pt x="2809" y="1465"/>
                  <a:pt x="2827" y="1462"/>
                  <a:pt x="2843" y="1464"/>
                </a:cubicBezTo>
                <a:cubicBezTo>
                  <a:pt x="2859" y="1467"/>
                  <a:pt x="2876" y="1475"/>
                  <a:pt x="2895" y="1488"/>
                </a:cubicBezTo>
                <a:lnTo>
                  <a:pt x="2860" y="1534"/>
                </a:lnTo>
                <a:cubicBezTo>
                  <a:pt x="2846" y="1523"/>
                  <a:pt x="2831" y="1519"/>
                  <a:pt x="2815" y="1520"/>
                </a:cubicBezTo>
                <a:cubicBezTo>
                  <a:pt x="2799" y="1522"/>
                  <a:pt x="2783" y="1531"/>
                  <a:pt x="2767" y="1547"/>
                </a:cubicBezTo>
                <a:cubicBezTo>
                  <a:pt x="2748" y="1566"/>
                  <a:pt x="2738" y="1583"/>
                  <a:pt x="2736" y="1597"/>
                </a:cubicBezTo>
                <a:cubicBezTo>
                  <a:pt x="2734" y="1611"/>
                  <a:pt x="2737" y="1623"/>
                  <a:pt x="2746" y="1631"/>
                </a:cubicBezTo>
                <a:cubicBezTo>
                  <a:pt x="2751" y="1637"/>
                  <a:pt x="2757" y="1640"/>
                  <a:pt x="2765" y="1641"/>
                </a:cubicBezTo>
                <a:cubicBezTo>
                  <a:pt x="2773" y="1642"/>
                  <a:pt x="2782" y="1640"/>
                  <a:pt x="2792" y="1636"/>
                </a:cubicBezTo>
                <a:cubicBezTo>
                  <a:pt x="2798" y="1633"/>
                  <a:pt x="2813" y="1625"/>
                  <a:pt x="2839" y="1610"/>
                </a:cubicBezTo>
                <a:cubicBezTo>
                  <a:pt x="2876" y="1588"/>
                  <a:pt x="2903" y="1574"/>
                  <a:pt x="2919" y="1568"/>
                </a:cubicBezTo>
                <a:cubicBezTo>
                  <a:pt x="2936" y="1561"/>
                  <a:pt x="2952" y="1559"/>
                  <a:pt x="2968" y="1562"/>
                </a:cubicBezTo>
                <a:cubicBezTo>
                  <a:pt x="2984" y="1565"/>
                  <a:pt x="2999" y="1574"/>
                  <a:pt x="3013" y="1588"/>
                </a:cubicBezTo>
                <a:cubicBezTo>
                  <a:pt x="3027" y="1602"/>
                  <a:pt x="3036" y="1619"/>
                  <a:pt x="3040" y="1639"/>
                </a:cubicBezTo>
                <a:cubicBezTo>
                  <a:pt x="3044" y="1659"/>
                  <a:pt x="3042" y="1680"/>
                  <a:pt x="3033" y="1702"/>
                </a:cubicBezTo>
                <a:cubicBezTo>
                  <a:pt x="3025" y="1723"/>
                  <a:pt x="3011" y="1744"/>
                  <a:pt x="2992" y="1763"/>
                </a:cubicBezTo>
                <a:cubicBezTo>
                  <a:pt x="2960" y="1795"/>
                  <a:pt x="2930" y="1812"/>
                  <a:pt x="2900" y="1816"/>
                </a:cubicBezTo>
                <a:cubicBezTo>
                  <a:pt x="2870" y="1819"/>
                  <a:pt x="2840" y="1810"/>
                  <a:pt x="2810" y="1789"/>
                </a:cubicBezTo>
                <a:close/>
                <a:moveTo>
                  <a:pt x="3302" y="1362"/>
                </a:moveTo>
                <a:lnTo>
                  <a:pt x="3342" y="1402"/>
                </a:lnTo>
                <a:lnTo>
                  <a:pt x="3120" y="1624"/>
                </a:lnTo>
                <a:cubicBezTo>
                  <a:pt x="3110" y="1615"/>
                  <a:pt x="3102" y="1603"/>
                  <a:pt x="3096" y="1591"/>
                </a:cubicBezTo>
                <a:cubicBezTo>
                  <a:pt x="3086" y="1570"/>
                  <a:pt x="3081" y="1546"/>
                  <a:pt x="3078" y="1519"/>
                </a:cubicBezTo>
                <a:cubicBezTo>
                  <a:pt x="3076" y="1492"/>
                  <a:pt x="3077" y="1457"/>
                  <a:pt x="3082" y="1414"/>
                </a:cubicBezTo>
                <a:cubicBezTo>
                  <a:pt x="3088" y="1348"/>
                  <a:pt x="3089" y="1299"/>
                  <a:pt x="3084" y="1269"/>
                </a:cubicBezTo>
                <a:cubicBezTo>
                  <a:pt x="3080" y="1238"/>
                  <a:pt x="3070" y="1215"/>
                  <a:pt x="3054" y="1200"/>
                </a:cubicBezTo>
                <a:cubicBezTo>
                  <a:pt x="3038" y="1184"/>
                  <a:pt x="3018" y="1176"/>
                  <a:pt x="2995" y="1176"/>
                </a:cubicBezTo>
                <a:cubicBezTo>
                  <a:pt x="2972" y="1176"/>
                  <a:pt x="2951" y="1186"/>
                  <a:pt x="2932" y="1205"/>
                </a:cubicBezTo>
                <a:cubicBezTo>
                  <a:pt x="2913" y="1225"/>
                  <a:pt x="2903" y="1247"/>
                  <a:pt x="2903" y="1270"/>
                </a:cubicBezTo>
                <a:cubicBezTo>
                  <a:pt x="2903" y="1294"/>
                  <a:pt x="2913" y="1317"/>
                  <a:pt x="2934" y="1338"/>
                </a:cubicBezTo>
                <a:lnTo>
                  <a:pt x="2887" y="1376"/>
                </a:lnTo>
                <a:cubicBezTo>
                  <a:pt x="2859" y="1342"/>
                  <a:pt x="2845" y="1307"/>
                  <a:pt x="2848" y="1271"/>
                </a:cubicBezTo>
                <a:cubicBezTo>
                  <a:pt x="2850" y="1236"/>
                  <a:pt x="2867" y="1202"/>
                  <a:pt x="2899" y="1170"/>
                </a:cubicBezTo>
                <a:cubicBezTo>
                  <a:pt x="2932" y="1138"/>
                  <a:pt x="2966" y="1121"/>
                  <a:pt x="3003" y="1120"/>
                </a:cubicBezTo>
                <a:cubicBezTo>
                  <a:pt x="3039" y="1119"/>
                  <a:pt x="3071" y="1132"/>
                  <a:pt x="3097" y="1158"/>
                </a:cubicBezTo>
                <a:cubicBezTo>
                  <a:pt x="3111" y="1172"/>
                  <a:pt x="3121" y="1188"/>
                  <a:pt x="3129" y="1206"/>
                </a:cubicBezTo>
                <a:cubicBezTo>
                  <a:pt x="3136" y="1225"/>
                  <a:pt x="3141" y="1248"/>
                  <a:pt x="3142" y="1275"/>
                </a:cubicBezTo>
                <a:cubicBezTo>
                  <a:pt x="3144" y="1302"/>
                  <a:pt x="3142" y="1343"/>
                  <a:pt x="3138" y="1397"/>
                </a:cubicBezTo>
                <a:cubicBezTo>
                  <a:pt x="3134" y="1443"/>
                  <a:pt x="3132" y="1473"/>
                  <a:pt x="3133" y="1487"/>
                </a:cubicBezTo>
                <a:cubicBezTo>
                  <a:pt x="3133" y="1502"/>
                  <a:pt x="3135" y="1515"/>
                  <a:pt x="3137" y="1527"/>
                </a:cubicBezTo>
                <a:lnTo>
                  <a:pt x="3302" y="1362"/>
                </a:lnTo>
                <a:close/>
                <a:moveTo>
                  <a:pt x="3238" y="928"/>
                </a:moveTo>
                <a:lnTo>
                  <a:pt x="3191" y="881"/>
                </a:lnTo>
                <a:lnTo>
                  <a:pt x="3232" y="840"/>
                </a:lnTo>
                <a:lnTo>
                  <a:pt x="3280" y="887"/>
                </a:lnTo>
                <a:lnTo>
                  <a:pt x="3238" y="928"/>
                </a:lnTo>
                <a:close/>
                <a:moveTo>
                  <a:pt x="3527" y="1217"/>
                </a:moveTo>
                <a:lnTo>
                  <a:pt x="3284" y="973"/>
                </a:lnTo>
                <a:lnTo>
                  <a:pt x="3325" y="932"/>
                </a:lnTo>
                <a:lnTo>
                  <a:pt x="3568" y="1176"/>
                </a:lnTo>
                <a:lnTo>
                  <a:pt x="3527" y="1217"/>
                </a:lnTo>
                <a:close/>
                <a:moveTo>
                  <a:pt x="3640" y="1104"/>
                </a:moveTo>
                <a:lnTo>
                  <a:pt x="3304" y="768"/>
                </a:lnTo>
                <a:lnTo>
                  <a:pt x="3430" y="642"/>
                </a:lnTo>
                <a:cubicBezTo>
                  <a:pt x="3453" y="619"/>
                  <a:pt x="3471" y="603"/>
                  <a:pt x="3485" y="594"/>
                </a:cubicBezTo>
                <a:cubicBezTo>
                  <a:pt x="3504" y="580"/>
                  <a:pt x="3523" y="571"/>
                  <a:pt x="3542" y="568"/>
                </a:cubicBezTo>
                <a:cubicBezTo>
                  <a:pt x="3561" y="564"/>
                  <a:pt x="3581" y="566"/>
                  <a:pt x="3601" y="573"/>
                </a:cubicBezTo>
                <a:cubicBezTo>
                  <a:pt x="3622" y="580"/>
                  <a:pt x="3641" y="592"/>
                  <a:pt x="3657" y="609"/>
                </a:cubicBezTo>
                <a:cubicBezTo>
                  <a:pt x="3686" y="638"/>
                  <a:pt x="3701" y="671"/>
                  <a:pt x="3703" y="709"/>
                </a:cubicBezTo>
                <a:cubicBezTo>
                  <a:pt x="3704" y="747"/>
                  <a:pt x="3681" y="790"/>
                  <a:pt x="3634" y="837"/>
                </a:cubicBezTo>
                <a:lnTo>
                  <a:pt x="3547" y="923"/>
                </a:lnTo>
                <a:lnTo>
                  <a:pt x="3684" y="1060"/>
                </a:lnTo>
                <a:lnTo>
                  <a:pt x="3640" y="1104"/>
                </a:lnTo>
                <a:close/>
                <a:moveTo>
                  <a:pt x="3508" y="884"/>
                </a:moveTo>
                <a:lnTo>
                  <a:pt x="3595" y="797"/>
                </a:lnTo>
                <a:cubicBezTo>
                  <a:pt x="3623" y="768"/>
                  <a:pt x="3638" y="742"/>
                  <a:pt x="3640" y="719"/>
                </a:cubicBezTo>
                <a:cubicBezTo>
                  <a:pt x="3641" y="697"/>
                  <a:pt x="3632" y="676"/>
                  <a:pt x="3613" y="656"/>
                </a:cubicBezTo>
                <a:cubicBezTo>
                  <a:pt x="3599" y="642"/>
                  <a:pt x="3583" y="634"/>
                  <a:pt x="3566" y="631"/>
                </a:cubicBezTo>
                <a:cubicBezTo>
                  <a:pt x="3549" y="628"/>
                  <a:pt x="3533" y="631"/>
                  <a:pt x="3518" y="639"/>
                </a:cubicBezTo>
                <a:cubicBezTo>
                  <a:pt x="3509" y="645"/>
                  <a:pt x="3494" y="657"/>
                  <a:pt x="3474" y="678"/>
                </a:cubicBezTo>
                <a:lnTo>
                  <a:pt x="3388" y="764"/>
                </a:lnTo>
                <a:lnTo>
                  <a:pt x="3508" y="884"/>
                </a:lnTo>
                <a:close/>
                <a:moveTo>
                  <a:pt x="3828" y="700"/>
                </a:moveTo>
                <a:lnTo>
                  <a:pt x="3866" y="655"/>
                </a:lnTo>
                <a:cubicBezTo>
                  <a:pt x="3885" y="670"/>
                  <a:pt x="3903" y="679"/>
                  <a:pt x="3921" y="682"/>
                </a:cubicBezTo>
                <a:cubicBezTo>
                  <a:pt x="3939" y="686"/>
                  <a:pt x="3959" y="683"/>
                  <a:pt x="3981" y="675"/>
                </a:cubicBezTo>
                <a:cubicBezTo>
                  <a:pt x="4003" y="666"/>
                  <a:pt x="4024" y="652"/>
                  <a:pt x="4043" y="633"/>
                </a:cubicBezTo>
                <a:cubicBezTo>
                  <a:pt x="4060" y="616"/>
                  <a:pt x="4072" y="599"/>
                  <a:pt x="4080" y="581"/>
                </a:cubicBezTo>
                <a:cubicBezTo>
                  <a:pt x="4088" y="562"/>
                  <a:pt x="4091" y="546"/>
                  <a:pt x="4088" y="531"/>
                </a:cubicBezTo>
                <a:cubicBezTo>
                  <a:pt x="4086" y="516"/>
                  <a:pt x="4079" y="503"/>
                  <a:pt x="4069" y="492"/>
                </a:cubicBezTo>
                <a:cubicBezTo>
                  <a:pt x="4058" y="482"/>
                  <a:pt x="4046" y="476"/>
                  <a:pt x="4032" y="474"/>
                </a:cubicBezTo>
                <a:cubicBezTo>
                  <a:pt x="4018" y="472"/>
                  <a:pt x="4002" y="476"/>
                  <a:pt x="3982" y="484"/>
                </a:cubicBezTo>
                <a:cubicBezTo>
                  <a:pt x="3970" y="490"/>
                  <a:pt x="3944" y="504"/>
                  <a:pt x="3906" y="528"/>
                </a:cubicBezTo>
                <a:cubicBezTo>
                  <a:pt x="3868" y="551"/>
                  <a:pt x="3839" y="566"/>
                  <a:pt x="3820" y="572"/>
                </a:cubicBezTo>
                <a:cubicBezTo>
                  <a:pt x="3796" y="579"/>
                  <a:pt x="3773" y="581"/>
                  <a:pt x="3753" y="576"/>
                </a:cubicBezTo>
                <a:cubicBezTo>
                  <a:pt x="3733" y="572"/>
                  <a:pt x="3715" y="562"/>
                  <a:pt x="3699" y="546"/>
                </a:cubicBezTo>
                <a:cubicBezTo>
                  <a:pt x="3682" y="529"/>
                  <a:pt x="3671" y="509"/>
                  <a:pt x="3666" y="484"/>
                </a:cubicBezTo>
                <a:cubicBezTo>
                  <a:pt x="3661" y="460"/>
                  <a:pt x="3664" y="435"/>
                  <a:pt x="3675" y="409"/>
                </a:cubicBezTo>
                <a:cubicBezTo>
                  <a:pt x="3686" y="382"/>
                  <a:pt x="3702" y="358"/>
                  <a:pt x="3725" y="335"/>
                </a:cubicBezTo>
                <a:cubicBezTo>
                  <a:pt x="3750" y="311"/>
                  <a:pt x="3776" y="293"/>
                  <a:pt x="3803" y="282"/>
                </a:cubicBezTo>
                <a:cubicBezTo>
                  <a:pt x="3830" y="271"/>
                  <a:pt x="3856" y="268"/>
                  <a:pt x="3882" y="273"/>
                </a:cubicBezTo>
                <a:cubicBezTo>
                  <a:pt x="3908" y="278"/>
                  <a:pt x="3931" y="291"/>
                  <a:pt x="3952" y="310"/>
                </a:cubicBezTo>
                <a:lnTo>
                  <a:pt x="3912" y="355"/>
                </a:lnTo>
                <a:cubicBezTo>
                  <a:pt x="3889" y="336"/>
                  <a:pt x="3865" y="328"/>
                  <a:pt x="3841" y="331"/>
                </a:cubicBezTo>
                <a:cubicBezTo>
                  <a:pt x="3817" y="333"/>
                  <a:pt x="3792" y="347"/>
                  <a:pt x="3766" y="373"/>
                </a:cubicBezTo>
                <a:cubicBezTo>
                  <a:pt x="3739" y="400"/>
                  <a:pt x="3724" y="424"/>
                  <a:pt x="3722" y="446"/>
                </a:cubicBezTo>
                <a:cubicBezTo>
                  <a:pt x="3719" y="469"/>
                  <a:pt x="3725" y="487"/>
                  <a:pt x="3739" y="501"/>
                </a:cubicBezTo>
                <a:cubicBezTo>
                  <a:pt x="3751" y="513"/>
                  <a:pt x="3766" y="518"/>
                  <a:pt x="3782" y="517"/>
                </a:cubicBezTo>
                <a:cubicBezTo>
                  <a:pt x="3798" y="516"/>
                  <a:pt x="3829" y="502"/>
                  <a:pt x="3873" y="474"/>
                </a:cubicBezTo>
                <a:cubicBezTo>
                  <a:pt x="3917" y="446"/>
                  <a:pt x="3949" y="429"/>
                  <a:pt x="3969" y="421"/>
                </a:cubicBezTo>
                <a:cubicBezTo>
                  <a:pt x="3997" y="411"/>
                  <a:pt x="4023" y="408"/>
                  <a:pt x="4046" y="412"/>
                </a:cubicBezTo>
                <a:cubicBezTo>
                  <a:pt x="4070" y="417"/>
                  <a:pt x="4090" y="428"/>
                  <a:pt x="4108" y="446"/>
                </a:cubicBezTo>
                <a:cubicBezTo>
                  <a:pt x="4126" y="464"/>
                  <a:pt x="4138" y="486"/>
                  <a:pt x="4143" y="512"/>
                </a:cubicBezTo>
                <a:cubicBezTo>
                  <a:pt x="4149" y="538"/>
                  <a:pt x="4147" y="565"/>
                  <a:pt x="4136" y="593"/>
                </a:cubicBezTo>
                <a:cubicBezTo>
                  <a:pt x="4126" y="621"/>
                  <a:pt x="4109" y="647"/>
                  <a:pt x="4085" y="671"/>
                </a:cubicBezTo>
                <a:cubicBezTo>
                  <a:pt x="4054" y="701"/>
                  <a:pt x="4024" y="722"/>
                  <a:pt x="3995" y="734"/>
                </a:cubicBezTo>
                <a:cubicBezTo>
                  <a:pt x="3965" y="746"/>
                  <a:pt x="3936" y="748"/>
                  <a:pt x="3906" y="742"/>
                </a:cubicBezTo>
                <a:cubicBezTo>
                  <a:pt x="3877" y="736"/>
                  <a:pt x="3851" y="722"/>
                  <a:pt x="3828" y="700"/>
                </a:cubicBezTo>
                <a:close/>
                <a:moveTo>
                  <a:pt x="4406" y="338"/>
                </a:moveTo>
                <a:lnTo>
                  <a:pt x="4365" y="379"/>
                </a:lnTo>
                <a:lnTo>
                  <a:pt x="4102" y="116"/>
                </a:lnTo>
                <a:cubicBezTo>
                  <a:pt x="4102" y="136"/>
                  <a:pt x="4098" y="158"/>
                  <a:pt x="4091" y="184"/>
                </a:cubicBezTo>
                <a:cubicBezTo>
                  <a:pt x="4085" y="209"/>
                  <a:pt x="4077" y="231"/>
                  <a:pt x="4069" y="248"/>
                </a:cubicBezTo>
                <a:lnTo>
                  <a:pt x="4029" y="208"/>
                </a:lnTo>
                <a:cubicBezTo>
                  <a:pt x="4042" y="175"/>
                  <a:pt x="4049" y="141"/>
                  <a:pt x="4050" y="109"/>
                </a:cubicBezTo>
                <a:cubicBezTo>
                  <a:pt x="4052" y="76"/>
                  <a:pt x="4050" y="49"/>
                  <a:pt x="4042" y="27"/>
                </a:cubicBezTo>
                <a:lnTo>
                  <a:pt x="4069" y="0"/>
                </a:lnTo>
                <a:lnTo>
                  <a:pt x="4406" y="338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4" name="Freeform 70"/>
          <p:cNvSpPr>
            <a:spLocks noEditPoints="1"/>
          </p:cNvSpPr>
          <p:nvPr/>
        </p:nvSpPr>
        <p:spPr bwMode="auto">
          <a:xfrm>
            <a:off x="2964005" y="5034102"/>
            <a:ext cx="850900" cy="841375"/>
          </a:xfrm>
          <a:custGeom>
            <a:avLst/>
            <a:gdLst>
              <a:gd name="T0" fmla="*/ 238 w 4468"/>
              <a:gd name="T1" fmla="*/ 3878 h 4415"/>
              <a:gd name="T2" fmla="*/ 244 w 4468"/>
              <a:gd name="T3" fmla="*/ 4234 h 4415"/>
              <a:gd name="T4" fmla="*/ 336 w 4468"/>
              <a:gd name="T5" fmla="*/ 4030 h 4415"/>
              <a:gd name="T6" fmla="*/ 84 w 4468"/>
              <a:gd name="T7" fmla="*/ 4074 h 4415"/>
              <a:gd name="T8" fmla="*/ 513 w 4468"/>
              <a:gd name="T9" fmla="*/ 3586 h 4415"/>
              <a:gd name="T10" fmla="*/ 740 w 4468"/>
              <a:gd name="T11" fmla="*/ 3714 h 4415"/>
              <a:gd name="T12" fmla="*/ 779 w 4468"/>
              <a:gd name="T13" fmla="*/ 3972 h 4415"/>
              <a:gd name="T14" fmla="*/ 620 w 4468"/>
              <a:gd name="T15" fmla="*/ 3699 h 4415"/>
              <a:gd name="T16" fmla="*/ 399 w 4468"/>
              <a:gd name="T17" fmla="*/ 3759 h 4415"/>
              <a:gd name="T18" fmla="*/ 784 w 4468"/>
              <a:gd name="T19" fmla="*/ 3866 h 4415"/>
              <a:gd name="T20" fmla="*/ 618 w 4468"/>
              <a:gd name="T21" fmla="*/ 3823 h 4415"/>
              <a:gd name="T22" fmla="*/ 743 w 4468"/>
              <a:gd name="T23" fmla="*/ 3335 h 4415"/>
              <a:gd name="T24" fmla="*/ 1131 w 4468"/>
              <a:gd name="T25" fmla="*/ 3416 h 4415"/>
              <a:gd name="T26" fmla="*/ 964 w 4468"/>
              <a:gd name="T27" fmla="*/ 3787 h 4415"/>
              <a:gd name="T28" fmla="*/ 1081 w 4468"/>
              <a:gd name="T29" fmla="*/ 3458 h 4415"/>
              <a:gd name="T30" fmla="*/ 712 w 4468"/>
              <a:gd name="T31" fmla="*/ 3446 h 4415"/>
              <a:gd name="T32" fmla="*/ 1627 w 4468"/>
              <a:gd name="T33" fmla="*/ 3311 h 4415"/>
              <a:gd name="T34" fmla="*/ 1414 w 4468"/>
              <a:gd name="T35" fmla="*/ 2671 h 4415"/>
              <a:gd name="T36" fmla="*/ 1563 w 4468"/>
              <a:gd name="T37" fmla="*/ 2915 h 4415"/>
              <a:gd name="T38" fmla="*/ 1524 w 4468"/>
              <a:gd name="T39" fmla="*/ 2874 h 4415"/>
              <a:gd name="T40" fmla="*/ 1403 w 4468"/>
              <a:gd name="T41" fmla="*/ 2755 h 4415"/>
              <a:gd name="T42" fmla="*/ 1788 w 4468"/>
              <a:gd name="T43" fmla="*/ 2291 h 4415"/>
              <a:gd name="T44" fmla="*/ 1957 w 4468"/>
              <a:gd name="T45" fmla="*/ 2485 h 4415"/>
              <a:gd name="T46" fmla="*/ 1881 w 4468"/>
              <a:gd name="T47" fmla="*/ 2870 h 4415"/>
              <a:gd name="T48" fmla="*/ 2042 w 4468"/>
              <a:gd name="T49" fmla="*/ 2209 h 4415"/>
              <a:gd name="T50" fmla="*/ 2166 w 4468"/>
              <a:gd name="T51" fmla="*/ 2230 h 4415"/>
              <a:gd name="T52" fmla="*/ 2183 w 4468"/>
              <a:gd name="T53" fmla="*/ 2333 h 4415"/>
              <a:gd name="T54" fmla="*/ 2343 w 4468"/>
              <a:gd name="T55" fmla="*/ 1882 h 4415"/>
              <a:gd name="T56" fmla="*/ 2283 w 4468"/>
              <a:gd name="T57" fmla="*/ 1793 h 4415"/>
              <a:gd name="T58" fmla="*/ 2531 w 4468"/>
              <a:gd name="T59" fmla="*/ 1797 h 4415"/>
              <a:gd name="T60" fmla="*/ 2472 w 4468"/>
              <a:gd name="T61" fmla="*/ 1615 h 4415"/>
              <a:gd name="T62" fmla="*/ 2531 w 4468"/>
              <a:gd name="T63" fmla="*/ 1628 h 4415"/>
              <a:gd name="T64" fmla="*/ 2608 w 4468"/>
              <a:gd name="T65" fmla="*/ 1720 h 4415"/>
              <a:gd name="T66" fmla="*/ 2901 w 4468"/>
              <a:gd name="T67" fmla="*/ 1767 h 4415"/>
              <a:gd name="T68" fmla="*/ 2885 w 4468"/>
              <a:gd name="T69" fmla="*/ 1660 h 4415"/>
              <a:gd name="T70" fmla="*/ 2685 w 4468"/>
              <a:gd name="T71" fmla="*/ 1602 h 4415"/>
              <a:gd name="T72" fmla="*/ 2895 w 4468"/>
              <a:gd name="T73" fmla="*/ 1495 h 4415"/>
              <a:gd name="T74" fmla="*/ 2745 w 4468"/>
              <a:gd name="T75" fmla="*/ 1638 h 4415"/>
              <a:gd name="T76" fmla="*/ 2968 w 4468"/>
              <a:gd name="T77" fmla="*/ 1569 h 4415"/>
              <a:gd name="T78" fmla="*/ 2900 w 4468"/>
              <a:gd name="T79" fmla="*/ 1823 h 4415"/>
              <a:gd name="T80" fmla="*/ 3096 w 4468"/>
              <a:gd name="T81" fmla="*/ 1598 h 4415"/>
              <a:gd name="T82" fmla="*/ 2995 w 4468"/>
              <a:gd name="T83" fmla="*/ 1183 h 4415"/>
              <a:gd name="T84" fmla="*/ 2848 w 4468"/>
              <a:gd name="T85" fmla="*/ 1278 h 4415"/>
              <a:gd name="T86" fmla="*/ 3142 w 4468"/>
              <a:gd name="T87" fmla="*/ 1282 h 4415"/>
              <a:gd name="T88" fmla="*/ 3238 w 4468"/>
              <a:gd name="T89" fmla="*/ 935 h 4415"/>
              <a:gd name="T90" fmla="*/ 3527 w 4468"/>
              <a:gd name="T91" fmla="*/ 1224 h 4415"/>
              <a:gd name="T92" fmla="*/ 3639 w 4468"/>
              <a:gd name="T93" fmla="*/ 1111 h 4415"/>
              <a:gd name="T94" fmla="*/ 3601 w 4468"/>
              <a:gd name="T95" fmla="*/ 580 h 4415"/>
              <a:gd name="T96" fmla="*/ 3684 w 4468"/>
              <a:gd name="T97" fmla="*/ 1067 h 4415"/>
              <a:gd name="T98" fmla="*/ 3613 w 4468"/>
              <a:gd name="T99" fmla="*/ 663 h 4415"/>
              <a:gd name="T100" fmla="*/ 3508 w 4468"/>
              <a:gd name="T101" fmla="*/ 891 h 4415"/>
              <a:gd name="T102" fmla="*/ 4043 w 4468"/>
              <a:gd name="T103" fmla="*/ 640 h 4415"/>
              <a:gd name="T104" fmla="*/ 3982 w 4468"/>
              <a:gd name="T105" fmla="*/ 491 h 4415"/>
              <a:gd name="T106" fmla="*/ 3666 w 4468"/>
              <a:gd name="T107" fmla="*/ 491 h 4415"/>
              <a:gd name="T108" fmla="*/ 3952 w 4468"/>
              <a:gd name="T109" fmla="*/ 317 h 4415"/>
              <a:gd name="T110" fmla="*/ 3739 w 4468"/>
              <a:gd name="T111" fmla="*/ 508 h 4415"/>
              <a:gd name="T112" fmla="*/ 4108 w 4468"/>
              <a:gd name="T113" fmla="*/ 453 h 4415"/>
              <a:gd name="T114" fmla="*/ 3906 w 4468"/>
              <a:gd name="T115" fmla="*/ 749 h 4415"/>
              <a:gd name="T116" fmla="*/ 4222 w 4468"/>
              <a:gd name="T117" fmla="*/ 472 h 4415"/>
              <a:gd name="T118" fmla="*/ 4121 w 4468"/>
              <a:gd name="T119" fmla="*/ 57 h 4415"/>
              <a:gd name="T120" fmla="*/ 3973 w 4468"/>
              <a:gd name="T121" fmla="*/ 152 h 4415"/>
              <a:gd name="T122" fmla="*/ 4268 w 4468"/>
              <a:gd name="T123" fmla="*/ 156 h 441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  <a:cxn ang="0">
                <a:pos x="T122" y="T123"/>
              </a:cxn>
            </a:cxnLst>
            <a:rect l="0" t="0" r="r" b="b"/>
            <a:pathLst>
              <a:path w="4468" h="4415">
                <a:moveTo>
                  <a:pt x="336" y="4415"/>
                </a:moveTo>
                <a:lnTo>
                  <a:pt x="0" y="4079"/>
                </a:lnTo>
                <a:lnTo>
                  <a:pt x="127" y="3952"/>
                </a:lnTo>
                <a:cubicBezTo>
                  <a:pt x="149" y="3930"/>
                  <a:pt x="167" y="3914"/>
                  <a:pt x="181" y="3904"/>
                </a:cubicBezTo>
                <a:cubicBezTo>
                  <a:pt x="200" y="3890"/>
                  <a:pt x="219" y="3882"/>
                  <a:pt x="238" y="3878"/>
                </a:cubicBezTo>
                <a:cubicBezTo>
                  <a:pt x="257" y="3875"/>
                  <a:pt x="277" y="3877"/>
                  <a:pt x="297" y="3884"/>
                </a:cubicBezTo>
                <a:cubicBezTo>
                  <a:pt x="318" y="3891"/>
                  <a:pt x="337" y="3903"/>
                  <a:pt x="354" y="3920"/>
                </a:cubicBezTo>
                <a:cubicBezTo>
                  <a:pt x="382" y="3948"/>
                  <a:pt x="397" y="3981"/>
                  <a:pt x="399" y="4019"/>
                </a:cubicBezTo>
                <a:cubicBezTo>
                  <a:pt x="400" y="4057"/>
                  <a:pt x="377" y="4100"/>
                  <a:pt x="330" y="4148"/>
                </a:cubicBezTo>
                <a:lnTo>
                  <a:pt x="244" y="4234"/>
                </a:lnTo>
                <a:lnTo>
                  <a:pt x="380" y="4371"/>
                </a:lnTo>
                <a:lnTo>
                  <a:pt x="336" y="4415"/>
                </a:lnTo>
                <a:close/>
                <a:moveTo>
                  <a:pt x="204" y="4194"/>
                </a:moveTo>
                <a:lnTo>
                  <a:pt x="291" y="4107"/>
                </a:lnTo>
                <a:cubicBezTo>
                  <a:pt x="320" y="4079"/>
                  <a:pt x="335" y="4053"/>
                  <a:pt x="336" y="4030"/>
                </a:cubicBezTo>
                <a:cubicBezTo>
                  <a:pt x="337" y="4007"/>
                  <a:pt x="328" y="3986"/>
                  <a:pt x="309" y="3967"/>
                </a:cubicBezTo>
                <a:cubicBezTo>
                  <a:pt x="295" y="3953"/>
                  <a:pt x="279" y="3944"/>
                  <a:pt x="262" y="3941"/>
                </a:cubicBezTo>
                <a:cubicBezTo>
                  <a:pt x="245" y="3938"/>
                  <a:pt x="229" y="3941"/>
                  <a:pt x="214" y="3950"/>
                </a:cubicBezTo>
                <a:cubicBezTo>
                  <a:pt x="205" y="3955"/>
                  <a:pt x="190" y="3968"/>
                  <a:pt x="170" y="3988"/>
                </a:cubicBezTo>
                <a:lnTo>
                  <a:pt x="84" y="4074"/>
                </a:lnTo>
                <a:lnTo>
                  <a:pt x="204" y="4194"/>
                </a:lnTo>
                <a:close/>
                <a:moveTo>
                  <a:pt x="651" y="4100"/>
                </a:moveTo>
                <a:lnTo>
                  <a:pt x="315" y="3764"/>
                </a:lnTo>
                <a:lnTo>
                  <a:pt x="441" y="3638"/>
                </a:lnTo>
                <a:cubicBezTo>
                  <a:pt x="466" y="3612"/>
                  <a:pt x="490" y="3595"/>
                  <a:pt x="513" y="3586"/>
                </a:cubicBezTo>
                <a:cubicBezTo>
                  <a:pt x="535" y="3578"/>
                  <a:pt x="558" y="3576"/>
                  <a:pt x="581" y="3581"/>
                </a:cubicBezTo>
                <a:cubicBezTo>
                  <a:pt x="604" y="3587"/>
                  <a:pt x="623" y="3597"/>
                  <a:pt x="638" y="3612"/>
                </a:cubicBezTo>
                <a:cubicBezTo>
                  <a:pt x="653" y="3627"/>
                  <a:pt x="662" y="3644"/>
                  <a:pt x="667" y="3665"/>
                </a:cubicBezTo>
                <a:cubicBezTo>
                  <a:pt x="672" y="3685"/>
                  <a:pt x="670" y="3707"/>
                  <a:pt x="663" y="3731"/>
                </a:cubicBezTo>
                <a:cubicBezTo>
                  <a:pt x="689" y="3716"/>
                  <a:pt x="715" y="3711"/>
                  <a:pt x="740" y="3714"/>
                </a:cubicBezTo>
                <a:cubicBezTo>
                  <a:pt x="765" y="3718"/>
                  <a:pt x="788" y="3729"/>
                  <a:pt x="807" y="3749"/>
                </a:cubicBezTo>
                <a:cubicBezTo>
                  <a:pt x="823" y="3765"/>
                  <a:pt x="834" y="3783"/>
                  <a:pt x="841" y="3803"/>
                </a:cubicBezTo>
                <a:cubicBezTo>
                  <a:pt x="848" y="3823"/>
                  <a:pt x="850" y="3842"/>
                  <a:pt x="848" y="3859"/>
                </a:cubicBezTo>
                <a:cubicBezTo>
                  <a:pt x="845" y="3876"/>
                  <a:pt x="839" y="3894"/>
                  <a:pt x="828" y="3912"/>
                </a:cubicBezTo>
                <a:cubicBezTo>
                  <a:pt x="817" y="3931"/>
                  <a:pt x="800" y="3951"/>
                  <a:pt x="779" y="3972"/>
                </a:cubicBezTo>
                <a:lnTo>
                  <a:pt x="651" y="4100"/>
                </a:lnTo>
                <a:close/>
                <a:moveTo>
                  <a:pt x="500" y="3861"/>
                </a:moveTo>
                <a:lnTo>
                  <a:pt x="573" y="3788"/>
                </a:lnTo>
                <a:cubicBezTo>
                  <a:pt x="593" y="3768"/>
                  <a:pt x="606" y="3753"/>
                  <a:pt x="612" y="3742"/>
                </a:cubicBezTo>
                <a:cubicBezTo>
                  <a:pt x="620" y="3727"/>
                  <a:pt x="622" y="3713"/>
                  <a:pt x="620" y="3699"/>
                </a:cubicBezTo>
                <a:cubicBezTo>
                  <a:pt x="618" y="3686"/>
                  <a:pt x="611" y="3673"/>
                  <a:pt x="600" y="3661"/>
                </a:cubicBezTo>
                <a:cubicBezTo>
                  <a:pt x="589" y="3650"/>
                  <a:pt x="576" y="3643"/>
                  <a:pt x="562" y="3640"/>
                </a:cubicBezTo>
                <a:cubicBezTo>
                  <a:pt x="548" y="3637"/>
                  <a:pt x="535" y="3639"/>
                  <a:pt x="522" y="3646"/>
                </a:cubicBezTo>
                <a:cubicBezTo>
                  <a:pt x="509" y="3652"/>
                  <a:pt x="490" y="3668"/>
                  <a:pt x="466" y="3692"/>
                </a:cubicBezTo>
                <a:lnTo>
                  <a:pt x="399" y="3759"/>
                </a:lnTo>
                <a:lnTo>
                  <a:pt x="500" y="3861"/>
                </a:lnTo>
                <a:close/>
                <a:moveTo>
                  <a:pt x="656" y="4016"/>
                </a:moveTo>
                <a:lnTo>
                  <a:pt x="739" y="3932"/>
                </a:lnTo>
                <a:cubicBezTo>
                  <a:pt x="754" y="3918"/>
                  <a:pt x="763" y="3907"/>
                  <a:pt x="768" y="3900"/>
                </a:cubicBezTo>
                <a:cubicBezTo>
                  <a:pt x="776" y="3888"/>
                  <a:pt x="782" y="3877"/>
                  <a:pt x="784" y="3866"/>
                </a:cubicBezTo>
                <a:cubicBezTo>
                  <a:pt x="787" y="3854"/>
                  <a:pt x="786" y="3842"/>
                  <a:pt x="783" y="3830"/>
                </a:cubicBezTo>
                <a:cubicBezTo>
                  <a:pt x="779" y="3817"/>
                  <a:pt x="772" y="3806"/>
                  <a:pt x="761" y="3795"/>
                </a:cubicBezTo>
                <a:cubicBezTo>
                  <a:pt x="749" y="3782"/>
                  <a:pt x="734" y="3775"/>
                  <a:pt x="719" y="3772"/>
                </a:cubicBezTo>
                <a:cubicBezTo>
                  <a:pt x="703" y="3769"/>
                  <a:pt x="688" y="3771"/>
                  <a:pt x="673" y="3779"/>
                </a:cubicBezTo>
                <a:cubicBezTo>
                  <a:pt x="657" y="3787"/>
                  <a:pt x="639" y="3801"/>
                  <a:pt x="618" y="3823"/>
                </a:cubicBezTo>
                <a:lnTo>
                  <a:pt x="540" y="3900"/>
                </a:lnTo>
                <a:lnTo>
                  <a:pt x="656" y="4016"/>
                </a:lnTo>
                <a:close/>
                <a:moveTo>
                  <a:pt x="964" y="3787"/>
                </a:moveTo>
                <a:lnTo>
                  <a:pt x="628" y="3451"/>
                </a:lnTo>
                <a:lnTo>
                  <a:pt x="743" y="3335"/>
                </a:lnTo>
                <a:cubicBezTo>
                  <a:pt x="770" y="3309"/>
                  <a:pt x="791" y="3291"/>
                  <a:pt x="808" y="3280"/>
                </a:cubicBezTo>
                <a:cubicBezTo>
                  <a:pt x="832" y="3265"/>
                  <a:pt x="856" y="3257"/>
                  <a:pt x="881" y="3255"/>
                </a:cubicBezTo>
                <a:cubicBezTo>
                  <a:pt x="914" y="3252"/>
                  <a:pt x="947" y="3258"/>
                  <a:pt x="979" y="3273"/>
                </a:cubicBezTo>
                <a:cubicBezTo>
                  <a:pt x="1011" y="3287"/>
                  <a:pt x="1042" y="3309"/>
                  <a:pt x="1072" y="3339"/>
                </a:cubicBezTo>
                <a:cubicBezTo>
                  <a:pt x="1097" y="3365"/>
                  <a:pt x="1117" y="3390"/>
                  <a:pt x="1131" y="3416"/>
                </a:cubicBezTo>
                <a:cubicBezTo>
                  <a:pt x="1144" y="3442"/>
                  <a:pt x="1153" y="3466"/>
                  <a:pt x="1157" y="3488"/>
                </a:cubicBezTo>
                <a:cubicBezTo>
                  <a:pt x="1160" y="3510"/>
                  <a:pt x="1160" y="3531"/>
                  <a:pt x="1157" y="3549"/>
                </a:cubicBezTo>
                <a:cubicBezTo>
                  <a:pt x="1153" y="3568"/>
                  <a:pt x="1145" y="3587"/>
                  <a:pt x="1133" y="3606"/>
                </a:cubicBezTo>
                <a:cubicBezTo>
                  <a:pt x="1121" y="3626"/>
                  <a:pt x="1105" y="3645"/>
                  <a:pt x="1085" y="3666"/>
                </a:cubicBezTo>
                <a:lnTo>
                  <a:pt x="964" y="3787"/>
                </a:lnTo>
                <a:close/>
                <a:moveTo>
                  <a:pt x="969" y="3703"/>
                </a:moveTo>
                <a:lnTo>
                  <a:pt x="1040" y="3631"/>
                </a:lnTo>
                <a:cubicBezTo>
                  <a:pt x="1063" y="3609"/>
                  <a:pt x="1078" y="3590"/>
                  <a:pt x="1086" y="3573"/>
                </a:cubicBezTo>
                <a:cubicBezTo>
                  <a:pt x="1095" y="3556"/>
                  <a:pt x="1099" y="3540"/>
                  <a:pt x="1099" y="3525"/>
                </a:cubicBezTo>
                <a:cubicBezTo>
                  <a:pt x="1099" y="3504"/>
                  <a:pt x="1093" y="3482"/>
                  <a:pt x="1081" y="3458"/>
                </a:cubicBezTo>
                <a:cubicBezTo>
                  <a:pt x="1069" y="3434"/>
                  <a:pt x="1051" y="3410"/>
                  <a:pt x="1025" y="3385"/>
                </a:cubicBezTo>
                <a:cubicBezTo>
                  <a:pt x="990" y="3349"/>
                  <a:pt x="957" y="3328"/>
                  <a:pt x="927" y="3321"/>
                </a:cubicBezTo>
                <a:cubicBezTo>
                  <a:pt x="896" y="3313"/>
                  <a:pt x="870" y="3315"/>
                  <a:pt x="847" y="3325"/>
                </a:cubicBezTo>
                <a:cubicBezTo>
                  <a:pt x="830" y="3332"/>
                  <a:pt x="809" y="3349"/>
                  <a:pt x="782" y="3376"/>
                </a:cubicBezTo>
                <a:lnTo>
                  <a:pt x="712" y="3446"/>
                </a:lnTo>
                <a:lnTo>
                  <a:pt x="969" y="3703"/>
                </a:lnTo>
                <a:close/>
                <a:moveTo>
                  <a:pt x="1353" y="3584"/>
                </a:moveTo>
                <a:lnTo>
                  <a:pt x="1323" y="3555"/>
                </a:lnTo>
                <a:lnTo>
                  <a:pt x="1597" y="3281"/>
                </a:lnTo>
                <a:lnTo>
                  <a:pt x="1627" y="3311"/>
                </a:lnTo>
                <a:lnTo>
                  <a:pt x="1353" y="3584"/>
                </a:lnTo>
                <a:close/>
                <a:moveTo>
                  <a:pt x="1569" y="3182"/>
                </a:moveTo>
                <a:lnTo>
                  <a:pt x="1233" y="2846"/>
                </a:lnTo>
                <a:lnTo>
                  <a:pt x="1360" y="2719"/>
                </a:lnTo>
                <a:cubicBezTo>
                  <a:pt x="1382" y="2697"/>
                  <a:pt x="1400" y="2681"/>
                  <a:pt x="1414" y="2671"/>
                </a:cubicBezTo>
                <a:cubicBezTo>
                  <a:pt x="1433" y="2657"/>
                  <a:pt x="1452" y="2649"/>
                  <a:pt x="1471" y="2645"/>
                </a:cubicBezTo>
                <a:cubicBezTo>
                  <a:pt x="1490" y="2642"/>
                  <a:pt x="1510" y="2644"/>
                  <a:pt x="1531" y="2651"/>
                </a:cubicBezTo>
                <a:cubicBezTo>
                  <a:pt x="1551" y="2658"/>
                  <a:pt x="1570" y="2670"/>
                  <a:pt x="1587" y="2686"/>
                </a:cubicBezTo>
                <a:cubicBezTo>
                  <a:pt x="1615" y="2715"/>
                  <a:pt x="1630" y="2748"/>
                  <a:pt x="1632" y="2786"/>
                </a:cubicBezTo>
                <a:cubicBezTo>
                  <a:pt x="1634" y="2824"/>
                  <a:pt x="1611" y="2867"/>
                  <a:pt x="1563" y="2915"/>
                </a:cubicBezTo>
                <a:lnTo>
                  <a:pt x="1477" y="3001"/>
                </a:lnTo>
                <a:lnTo>
                  <a:pt x="1614" y="3137"/>
                </a:lnTo>
                <a:lnTo>
                  <a:pt x="1569" y="3182"/>
                </a:lnTo>
                <a:close/>
                <a:moveTo>
                  <a:pt x="1437" y="2961"/>
                </a:moveTo>
                <a:lnTo>
                  <a:pt x="1524" y="2874"/>
                </a:lnTo>
                <a:cubicBezTo>
                  <a:pt x="1553" y="2845"/>
                  <a:pt x="1568" y="2820"/>
                  <a:pt x="1569" y="2797"/>
                </a:cubicBezTo>
                <a:cubicBezTo>
                  <a:pt x="1571" y="2774"/>
                  <a:pt x="1562" y="2753"/>
                  <a:pt x="1542" y="2734"/>
                </a:cubicBezTo>
                <a:cubicBezTo>
                  <a:pt x="1528" y="2720"/>
                  <a:pt x="1513" y="2711"/>
                  <a:pt x="1495" y="2708"/>
                </a:cubicBezTo>
                <a:cubicBezTo>
                  <a:pt x="1478" y="2705"/>
                  <a:pt x="1462" y="2708"/>
                  <a:pt x="1448" y="2716"/>
                </a:cubicBezTo>
                <a:cubicBezTo>
                  <a:pt x="1438" y="2722"/>
                  <a:pt x="1423" y="2735"/>
                  <a:pt x="1403" y="2755"/>
                </a:cubicBezTo>
                <a:lnTo>
                  <a:pt x="1317" y="2841"/>
                </a:lnTo>
                <a:lnTo>
                  <a:pt x="1437" y="2961"/>
                </a:lnTo>
                <a:close/>
                <a:moveTo>
                  <a:pt x="1881" y="2870"/>
                </a:moveTo>
                <a:lnTo>
                  <a:pt x="1545" y="2534"/>
                </a:lnTo>
                <a:lnTo>
                  <a:pt x="1788" y="2291"/>
                </a:lnTo>
                <a:lnTo>
                  <a:pt x="1828" y="2330"/>
                </a:lnTo>
                <a:lnTo>
                  <a:pt x="1629" y="2529"/>
                </a:lnTo>
                <a:lnTo>
                  <a:pt x="1732" y="2632"/>
                </a:lnTo>
                <a:lnTo>
                  <a:pt x="1918" y="2446"/>
                </a:lnTo>
                <a:lnTo>
                  <a:pt x="1957" y="2485"/>
                </a:lnTo>
                <a:lnTo>
                  <a:pt x="1772" y="2671"/>
                </a:lnTo>
                <a:lnTo>
                  <a:pt x="1886" y="2786"/>
                </a:lnTo>
                <a:lnTo>
                  <a:pt x="2092" y="2579"/>
                </a:lnTo>
                <a:lnTo>
                  <a:pt x="2132" y="2619"/>
                </a:lnTo>
                <a:lnTo>
                  <a:pt x="1881" y="2870"/>
                </a:lnTo>
                <a:close/>
                <a:moveTo>
                  <a:pt x="2163" y="2588"/>
                </a:moveTo>
                <a:lnTo>
                  <a:pt x="2118" y="2283"/>
                </a:lnTo>
                <a:lnTo>
                  <a:pt x="1842" y="2237"/>
                </a:lnTo>
                <a:lnTo>
                  <a:pt x="1895" y="2184"/>
                </a:lnTo>
                <a:lnTo>
                  <a:pt x="2042" y="2209"/>
                </a:lnTo>
                <a:cubicBezTo>
                  <a:pt x="2073" y="2214"/>
                  <a:pt x="2096" y="2219"/>
                  <a:pt x="2111" y="2223"/>
                </a:cubicBezTo>
                <a:cubicBezTo>
                  <a:pt x="2106" y="2203"/>
                  <a:pt x="2102" y="2182"/>
                  <a:pt x="2099" y="2158"/>
                </a:cubicBezTo>
                <a:lnTo>
                  <a:pt x="2077" y="2001"/>
                </a:lnTo>
                <a:lnTo>
                  <a:pt x="2126" y="1953"/>
                </a:lnTo>
                <a:lnTo>
                  <a:pt x="2166" y="2230"/>
                </a:lnTo>
                <a:lnTo>
                  <a:pt x="2471" y="2280"/>
                </a:lnTo>
                <a:lnTo>
                  <a:pt x="2416" y="2335"/>
                </a:lnTo>
                <a:lnTo>
                  <a:pt x="2211" y="2300"/>
                </a:lnTo>
                <a:cubicBezTo>
                  <a:pt x="2200" y="2298"/>
                  <a:pt x="2187" y="2295"/>
                  <a:pt x="2174" y="2292"/>
                </a:cubicBezTo>
                <a:cubicBezTo>
                  <a:pt x="2179" y="2312"/>
                  <a:pt x="2182" y="2325"/>
                  <a:pt x="2183" y="2333"/>
                </a:cubicBezTo>
                <a:lnTo>
                  <a:pt x="2216" y="2535"/>
                </a:lnTo>
                <a:lnTo>
                  <a:pt x="2163" y="2588"/>
                </a:lnTo>
                <a:close/>
                <a:moveTo>
                  <a:pt x="2647" y="2104"/>
                </a:moveTo>
                <a:lnTo>
                  <a:pt x="2606" y="2145"/>
                </a:lnTo>
                <a:lnTo>
                  <a:pt x="2343" y="1882"/>
                </a:lnTo>
                <a:cubicBezTo>
                  <a:pt x="2342" y="1902"/>
                  <a:pt x="2339" y="1924"/>
                  <a:pt x="2332" y="1950"/>
                </a:cubicBezTo>
                <a:cubicBezTo>
                  <a:pt x="2325" y="1976"/>
                  <a:pt x="2318" y="1997"/>
                  <a:pt x="2310" y="2015"/>
                </a:cubicBezTo>
                <a:lnTo>
                  <a:pt x="2270" y="1975"/>
                </a:lnTo>
                <a:cubicBezTo>
                  <a:pt x="2282" y="1941"/>
                  <a:pt x="2289" y="1908"/>
                  <a:pt x="2291" y="1875"/>
                </a:cubicBezTo>
                <a:cubicBezTo>
                  <a:pt x="2293" y="1842"/>
                  <a:pt x="2290" y="1815"/>
                  <a:pt x="2283" y="1793"/>
                </a:cubicBezTo>
                <a:lnTo>
                  <a:pt x="2309" y="1767"/>
                </a:lnTo>
                <a:lnTo>
                  <a:pt x="2647" y="2104"/>
                </a:lnTo>
                <a:close/>
                <a:moveTo>
                  <a:pt x="2779" y="1972"/>
                </a:moveTo>
                <a:lnTo>
                  <a:pt x="2567" y="1761"/>
                </a:lnTo>
                <a:lnTo>
                  <a:pt x="2531" y="1797"/>
                </a:lnTo>
                <a:lnTo>
                  <a:pt x="2499" y="1765"/>
                </a:lnTo>
                <a:lnTo>
                  <a:pt x="2535" y="1729"/>
                </a:lnTo>
                <a:lnTo>
                  <a:pt x="2509" y="1703"/>
                </a:lnTo>
                <a:cubicBezTo>
                  <a:pt x="2493" y="1687"/>
                  <a:pt x="2482" y="1673"/>
                  <a:pt x="2477" y="1662"/>
                </a:cubicBezTo>
                <a:cubicBezTo>
                  <a:pt x="2470" y="1647"/>
                  <a:pt x="2469" y="1632"/>
                  <a:pt x="2472" y="1615"/>
                </a:cubicBezTo>
                <a:cubicBezTo>
                  <a:pt x="2475" y="1598"/>
                  <a:pt x="2486" y="1581"/>
                  <a:pt x="2504" y="1563"/>
                </a:cubicBezTo>
                <a:cubicBezTo>
                  <a:pt x="2516" y="1551"/>
                  <a:pt x="2530" y="1540"/>
                  <a:pt x="2547" y="1529"/>
                </a:cubicBezTo>
                <a:lnTo>
                  <a:pt x="2577" y="1571"/>
                </a:lnTo>
                <a:cubicBezTo>
                  <a:pt x="2566" y="1578"/>
                  <a:pt x="2558" y="1585"/>
                  <a:pt x="2550" y="1593"/>
                </a:cubicBezTo>
                <a:cubicBezTo>
                  <a:pt x="2537" y="1605"/>
                  <a:pt x="2531" y="1617"/>
                  <a:pt x="2531" y="1628"/>
                </a:cubicBezTo>
                <a:cubicBezTo>
                  <a:pt x="2532" y="1638"/>
                  <a:pt x="2539" y="1651"/>
                  <a:pt x="2554" y="1665"/>
                </a:cubicBezTo>
                <a:lnTo>
                  <a:pt x="2576" y="1688"/>
                </a:lnTo>
                <a:lnTo>
                  <a:pt x="2624" y="1640"/>
                </a:lnTo>
                <a:lnTo>
                  <a:pt x="2656" y="1672"/>
                </a:lnTo>
                <a:lnTo>
                  <a:pt x="2608" y="1720"/>
                </a:lnTo>
                <a:lnTo>
                  <a:pt x="2820" y="1931"/>
                </a:lnTo>
                <a:lnTo>
                  <a:pt x="2779" y="1972"/>
                </a:lnTo>
                <a:close/>
                <a:moveTo>
                  <a:pt x="2810" y="1796"/>
                </a:moveTo>
                <a:lnTo>
                  <a:pt x="2844" y="1749"/>
                </a:lnTo>
                <a:cubicBezTo>
                  <a:pt x="2863" y="1763"/>
                  <a:pt x="2882" y="1769"/>
                  <a:pt x="2901" y="1767"/>
                </a:cubicBezTo>
                <a:cubicBezTo>
                  <a:pt x="2920" y="1765"/>
                  <a:pt x="2939" y="1755"/>
                  <a:pt x="2958" y="1736"/>
                </a:cubicBezTo>
                <a:cubicBezTo>
                  <a:pt x="2977" y="1717"/>
                  <a:pt x="2987" y="1699"/>
                  <a:pt x="2988" y="1683"/>
                </a:cubicBezTo>
                <a:cubicBezTo>
                  <a:pt x="2990" y="1666"/>
                  <a:pt x="2985" y="1652"/>
                  <a:pt x="2975" y="1642"/>
                </a:cubicBezTo>
                <a:cubicBezTo>
                  <a:pt x="2966" y="1632"/>
                  <a:pt x="2954" y="1629"/>
                  <a:pt x="2941" y="1632"/>
                </a:cubicBezTo>
                <a:cubicBezTo>
                  <a:pt x="2931" y="1634"/>
                  <a:pt x="2913" y="1643"/>
                  <a:pt x="2885" y="1660"/>
                </a:cubicBezTo>
                <a:cubicBezTo>
                  <a:pt x="2847" y="1683"/>
                  <a:pt x="2819" y="1697"/>
                  <a:pt x="2802" y="1703"/>
                </a:cubicBezTo>
                <a:cubicBezTo>
                  <a:pt x="2785" y="1709"/>
                  <a:pt x="2768" y="1710"/>
                  <a:pt x="2752" y="1706"/>
                </a:cubicBezTo>
                <a:cubicBezTo>
                  <a:pt x="2736" y="1703"/>
                  <a:pt x="2722" y="1695"/>
                  <a:pt x="2710" y="1683"/>
                </a:cubicBezTo>
                <a:cubicBezTo>
                  <a:pt x="2699" y="1672"/>
                  <a:pt x="2692" y="1659"/>
                  <a:pt x="2688" y="1645"/>
                </a:cubicBezTo>
                <a:cubicBezTo>
                  <a:pt x="2683" y="1631"/>
                  <a:pt x="2682" y="1617"/>
                  <a:pt x="2685" y="1602"/>
                </a:cubicBezTo>
                <a:cubicBezTo>
                  <a:pt x="2687" y="1591"/>
                  <a:pt x="2691" y="1578"/>
                  <a:pt x="2699" y="1564"/>
                </a:cubicBezTo>
                <a:cubicBezTo>
                  <a:pt x="2707" y="1549"/>
                  <a:pt x="2717" y="1536"/>
                  <a:pt x="2730" y="1523"/>
                </a:cubicBezTo>
                <a:cubicBezTo>
                  <a:pt x="2749" y="1504"/>
                  <a:pt x="2768" y="1490"/>
                  <a:pt x="2788" y="1481"/>
                </a:cubicBezTo>
                <a:cubicBezTo>
                  <a:pt x="2808" y="1472"/>
                  <a:pt x="2826" y="1469"/>
                  <a:pt x="2843" y="1471"/>
                </a:cubicBezTo>
                <a:cubicBezTo>
                  <a:pt x="2859" y="1474"/>
                  <a:pt x="2876" y="1482"/>
                  <a:pt x="2895" y="1495"/>
                </a:cubicBezTo>
                <a:lnTo>
                  <a:pt x="2860" y="1541"/>
                </a:lnTo>
                <a:cubicBezTo>
                  <a:pt x="2845" y="1530"/>
                  <a:pt x="2830" y="1526"/>
                  <a:pt x="2815" y="1527"/>
                </a:cubicBezTo>
                <a:cubicBezTo>
                  <a:pt x="2799" y="1529"/>
                  <a:pt x="2783" y="1538"/>
                  <a:pt x="2767" y="1554"/>
                </a:cubicBezTo>
                <a:cubicBezTo>
                  <a:pt x="2748" y="1573"/>
                  <a:pt x="2737" y="1590"/>
                  <a:pt x="2736" y="1604"/>
                </a:cubicBezTo>
                <a:cubicBezTo>
                  <a:pt x="2734" y="1618"/>
                  <a:pt x="2737" y="1630"/>
                  <a:pt x="2745" y="1638"/>
                </a:cubicBezTo>
                <a:cubicBezTo>
                  <a:pt x="2751" y="1644"/>
                  <a:pt x="2757" y="1647"/>
                  <a:pt x="2765" y="1648"/>
                </a:cubicBezTo>
                <a:cubicBezTo>
                  <a:pt x="2773" y="1649"/>
                  <a:pt x="2782" y="1647"/>
                  <a:pt x="2792" y="1643"/>
                </a:cubicBezTo>
                <a:cubicBezTo>
                  <a:pt x="2797" y="1640"/>
                  <a:pt x="2813" y="1632"/>
                  <a:pt x="2839" y="1617"/>
                </a:cubicBezTo>
                <a:cubicBezTo>
                  <a:pt x="2876" y="1595"/>
                  <a:pt x="2902" y="1581"/>
                  <a:pt x="2919" y="1575"/>
                </a:cubicBezTo>
                <a:cubicBezTo>
                  <a:pt x="2935" y="1568"/>
                  <a:pt x="2952" y="1566"/>
                  <a:pt x="2968" y="1569"/>
                </a:cubicBezTo>
                <a:cubicBezTo>
                  <a:pt x="2984" y="1572"/>
                  <a:pt x="2999" y="1581"/>
                  <a:pt x="3013" y="1595"/>
                </a:cubicBezTo>
                <a:cubicBezTo>
                  <a:pt x="3027" y="1609"/>
                  <a:pt x="3036" y="1626"/>
                  <a:pt x="3040" y="1646"/>
                </a:cubicBezTo>
                <a:cubicBezTo>
                  <a:pt x="3044" y="1666"/>
                  <a:pt x="3042" y="1687"/>
                  <a:pt x="3033" y="1709"/>
                </a:cubicBezTo>
                <a:cubicBezTo>
                  <a:pt x="3025" y="1730"/>
                  <a:pt x="3011" y="1751"/>
                  <a:pt x="2992" y="1770"/>
                </a:cubicBezTo>
                <a:cubicBezTo>
                  <a:pt x="2960" y="1802"/>
                  <a:pt x="2930" y="1819"/>
                  <a:pt x="2900" y="1823"/>
                </a:cubicBezTo>
                <a:cubicBezTo>
                  <a:pt x="2870" y="1826"/>
                  <a:pt x="2840" y="1817"/>
                  <a:pt x="2810" y="1796"/>
                </a:cubicBezTo>
                <a:close/>
                <a:moveTo>
                  <a:pt x="3302" y="1369"/>
                </a:moveTo>
                <a:lnTo>
                  <a:pt x="3342" y="1409"/>
                </a:lnTo>
                <a:lnTo>
                  <a:pt x="3120" y="1631"/>
                </a:lnTo>
                <a:cubicBezTo>
                  <a:pt x="3109" y="1622"/>
                  <a:pt x="3101" y="1610"/>
                  <a:pt x="3096" y="1598"/>
                </a:cubicBezTo>
                <a:cubicBezTo>
                  <a:pt x="3086" y="1577"/>
                  <a:pt x="3080" y="1553"/>
                  <a:pt x="3078" y="1526"/>
                </a:cubicBezTo>
                <a:cubicBezTo>
                  <a:pt x="3076" y="1499"/>
                  <a:pt x="3077" y="1464"/>
                  <a:pt x="3081" y="1421"/>
                </a:cubicBezTo>
                <a:cubicBezTo>
                  <a:pt x="3088" y="1355"/>
                  <a:pt x="3089" y="1306"/>
                  <a:pt x="3084" y="1276"/>
                </a:cubicBezTo>
                <a:cubicBezTo>
                  <a:pt x="3080" y="1245"/>
                  <a:pt x="3069" y="1222"/>
                  <a:pt x="3054" y="1207"/>
                </a:cubicBezTo>
                <a:cubicBezTo>
                  <a:pt x="3037" y="1191"/>
                  <a:pt x="3018" y="1183"/>
                  <a:pt x="2995" y="1183"/>
                </a:cubicBezTo>
                <a:cubicBezTo>
                  <a:pt x="2972" y="1183"/>
                  <a:pt x="2951" y="1193"/>
                  <a:pt x="2932" y="1212"/>
                </a:cubicBezTo>
                <a:cubicBezTo>
                  <a:pt x="2912" y="1232"/>
                  <a:pt x="2903" y="1254"/>
                  <a:pt x="2903" y="1277"/>
                </a:cubicBezTo>
                <a:cubicBezTo>
                  <a:pt x="2903" y="1301"/>
                  <a:pt x="2913" y="1324"/>
                  <a:pt x="2934" y="1345"/>
                </a:cubicBezTo>
                <a:lnTo>
                  <a:pt x="2887" y="1383"/>
                </a:lnTo>
                <a:cubicBezTo>
                  <a:pt x="2858" y="1349"/>
                  <a:pt x="2845" y="1314"/>
                  <a:pt x="2848" y="1278"/>
                </a:cubicBezTo>
                <a:cubicBezTo>
                  <a:pt x="2850" y="1243"/>
                  <a:pt x="2867" y="1209"/>
                  <a:pt x="2899" y="1177"/>
                </a:cubicBezTo>
                <a:cubicBezTo>
                  <a:pt x="2931" y="1145"/>
                  <a:pt x="2966" y="1128"/>
                  <a:pt x="3002" y="1127"/>
                </a:cubicBezTo>
                <a:cubicBezTo>
                  <a:pt x="3039" y="1126"/>
                  <a:pt x="3071" y="1139"/>
                  <a:pt x="3097" y="1165"/>
                </a:cubicBezTo>
                <a:cubicBezTo>
                  <a:pt x="3111" y="1179"/>
                  <a:pt x="3121" y="1195"/>
                  <a:pt x="3129" y="1213"/>
                </a:cubicBezTo>
                <a:cubicBezTo>
                  <a:pt x="3136" y="1232"/>
                  <a:pt x="3141" y="1255"/>
                  <a:pt x="3142" y="1282"/>
                </a:cubicBezTo>
                <a:cubicBezTo>
                  <a:pt x="3144" y="1309"/>
                  <a:pt x="3142" y="1350"/>
                  <a:pt x="3138" y="1404"/>
                </a:cubicBezTo>
                <a:cubicBezTo>
                  <a:pt x="3134" y="1450"/>
                  <a:pt x="3132" y="1480"/>
                  <a:pt x="3132" y="1494"/>
                </a:cubicBezTo>
                <a:cubicBezTo>
                  <a:pt x="3133" y="1509"/>
                  <a:pt x="3134" y="1522"/>
                  <a:pt x="3137" y="1534"/>
                </a:cubicBezTo>
                <a:lnTo>
                  <a:pt x="3302" y="1369"/>
                </a:lnTo>
                <a:close/>
                <a:moveTo>
                  <a:pt x="3238" y="935"/>
                </a:moveTo>
                <a:lnTo>
                  <a:pt x="3191" y="888"/>
                </a:lnTo>
                <a:lnTo>
                  <a:pt x="3232" y="847"/>
                </a:lnTo>
                <a:lnTo>
                  <a:pt x="3280" y="894"/>
                </a:lnTo>
                <a:lnTo>
                  <a:pt x="3238" y="935"/>
                </a:lnTo>
                <a:close/>
                <a:moveTo>
                  <a:pt x="3527" y="1224"/>
                </a:moveTo>
                <a:lnTo>
                  <a:pt x="3283" y="980"/>
                </a:lnTo>
                <a:lnTo>
                  <a:pt x="3325" y="939"/>
                </a:lnTo>
                <a:lnTo>
                  <a:pt x="3568" y="1183"/>
                </a:lnTo>
                <a:lnTo>
                  <a:pt x="3527" y="1224"/>
                </a:lnTo>
                <a:close/>
                <a:moveTo>
                  <a:pt x="3639" y="1111"/>
                </a:moveTo>
                <a:lnTo>
                  <a:pt x="3303" y="775"/>
                </a:lnTo>
                <a:lnTo>
                  <a:pt x="3430" y="649"/>
                </a:lnTo>
                <a:cubicBezTo>
                  <a:pt x="3452" y="626"/>
                  <a:pt x="3471" y="610"/>
                  <a:pt x="3484" y="601"/>
                </a:cubicBezTo>
                <a:cubicBezTo>
                  <a:pt x="3504" y="587"/>
                  <a:pt x="3523" y="578"/>
                  <a:pt x="3542" y="575"/>
                </a:cubicBezTo>
                <a:cubicBezTo>
                  <a:pt x="3561" y="571"/>
                  <a:pt x="3580" y="573"/>
                  <a:pt x="3601" y="580"/>
                </a:cubicBezTo>
                <a:cubicBezTo>
                  <a:pt x="3622" y="587"/>
                  <a:pt x="3640" y="599"/>
                  <a:pt x="3657" y="616"/>
                </a:cubicBezTo>
                <a:cubicBezTo>
                  <a:pt x="3686" y="645"/>
                  <a:pt x="3701" y="678"/>
                  <a:pt x="3702" y="716"/>
                </a:cubicBezTo>
                <a:cubicBezTo>
                  <a:pt x="3704" y="754"/>
                  <a:pt x="3681" y="797"/>
                  <a:pt x="3634" y="844"/>
                </a:cubicBezTo>
                <a:lnTo>
                  <a:pt x="3547" y="930"/>
                </a:lnTo>
                <a:lnTo>
                  <a:pt x="3684" y="1067"/>
                </a:lnTo>
                <a:lnTo>
                  <a:pt x="3639" y="1111"/>
                </a:lnTo>
                <a:close/>
                <a:moveTo>
                  <a:pt x="3508" y="891"/>
                </a:moveTo>
                <a:lnTo>
                  <a:pt x="3595" y="804"/>
                </a:lnTo>
                <a:cubicBezTo>
                  <a:pt x="3623" y="775"/>
                  <a:pt x="3638" y="749"/>
                  <a:pt x="3640" y="726"/>
                </a:cubicBezTo>
                <a:cubicBezTo>
                  <a:pt x="3641" y="704"/>
                  <a:pt x="3632" y="683"/>
                  <a:pt x="3613" y="663"/>
                </a:cubicBezTo>
                <a:cubicBezTo>
                  <a:pt x="3599" y="649"/>
                  <a:pt x="3583" y="641"/>
                  <a:pt x="3566" y="638"/>
                </a:cubicBezTo>
                <a:cubicBezTo>
                  <a:pt x="3549" y="635"/>
                  <a:pt x="3533" y="638"/>
                  <a:pt x="3518" y="646"/>
                </a:cubicBezTo>
                <a:cubicBezTo>
                  <a:pt x="3508" y="652"/>
                  <a:pt x="3494" y="664"/>
                  <a:pt x="3473" y="685"/>
                </a:cubicBezTo>
                <a:lnTo>
                  <a:pt x="3388" y="771"/>
                </a:lnTo>
                <a:lnTo>
                  <a:pt x="3508" y="891"/>
                </a:lnTo>
                <a:close/>
                <a:moveTo>
                  <a:pt x="3827" y="707"/>
                </a:moveTo>
                <a:lnTo>
                  <a:pt x="3866" y="662"/>
                </a:lnTo>
                <a:cubicBezTo>
                  <a:pt x="3885" y="677"/>
                  <a:pt x="3903" y="686"/>
                  <a:pt x="3921" y="689"/>
                </a:cubicBezTo>
                <a:cubicBezTo>
                  <a:pt x="3939" y="693"/>
                  <a:pt x="3959" y="690"/>
                  <a:pt x="3981" y="682"/>
                </a:cubicBezTo>
                <a:cubicBezTo>
                  <a:pt x="4003" y="673"/>
                  <a:pt x="4023" y="659"/>
                  <a:pt x="4043" y="640"/>
                </a:cubicBezTo>
                <a:cubicBezTo>
                  <a:pt x="4059" y="623"/>
                  <a:pt x="4072" y="606"/>
                  <a:pt x="4080" y="588"/>
                </a:cubicBezTo>
                <a:cubicBezTo>
                  <a:pt x="4088" y="569"/>
                  <a:pt x="4091" y="553"/>
                  <a:pt x="4088" y="538"/>
                </a:cubicBezTo>
                <a:cubicBezTo>
                  <a:pt x="4086" y="523"/>
                  <a:pt x="4079" y="510"/>
                  <a:pt x="4069" y="499"/>
                </a:cubicBezTo>
                <a:cubicBezTo>
                  <a:pt x="4058" y="489"/>
                  <a:pt x="4046" y="483"/>
                  <a:pt x="4032" y="481"/>
                </a:cubicBezTo>
                <a:cubicBezTo>
                  <a:pt x="4018" y="479"/>
                  <a:pt x="4001" y="483"/>
                  <a:pt x="3982" y="491"/>
                </a:cubicBezTo>
                <a:cubicBezTo>
                  <a:pt x="3969" y="497"/>
                  <a:pt x="3944" y="511"/>
                  <a:pt x="3906" y="535"/>
                </a:cubicBezTo>
                <a:cubicBezTo>
                  <a:pt x="3867" y="558"/>
                  <a:pt x="3839" y="573"/>
                  <a:pt x="3820" y="579"/>
                </a:cubicBezTo>
                <a:cubicBezTo>
                  <a:pt x="3795" y="586"/>
                  <a:pt x="3773" y="588"/>
                  <a:pt x="3753" y="583"/>
                </a:cubicBezTo>
                <a:cubicBezTo>
                  <a:pt x="3732" y="579"/>
                  <a:pt x="3715" y="569"/>
                  <a:pt x="3699" y="553"/>
                </a:cubicBezTo>
                <a:cubicBezTo>
                  <a:pt x="3682" y="536"/>
                  <a:pt x="3671" y="516"/>
                  <a:pt x="3666" y="491"/>
                </a:cubicBezTo>
                <a:cubicBezTo>
                  <a:pt x="3661" y="467"/>
                  <a:pt x="3664" y="442"/>
                  <a:pt x="3675" y="416"/>
                </a:cubicBezTo>
                <a:cubicBezTo>
                  <a:pt x="3685" y="389"/>
                  <a:pt x="3702" y="365"/>
                  <a:pt x="3725" y="342"/>
                </a:cubicBezTo>
                <a:cubicBezTo>
                  <a:pt x="3750" y="318"/>
                  <a:pt x="3776" y="300"/>
                  <a:pt x="3803" y="289"/>
                </a:cubicBezTo>
                <a:cubicBezTo>
                  <a:pt x="3830" y="278"/>
                  <a:pt x="3856" y="275"/>
                  <a:pt x="3882" y="280"/>
                </a:cubicBezTo>
                <a:cubicBezTo>
                  <a:pt x="3908" y="285"/>
                  <a:pt x="3931" y="298"/>
                  <a:pt x="3952" y="317"/>
                </a:cubicBezTo>
                <a:lnTo>
                  <a:pt x="3912" y="362"/>
                </a:lnTo>
                <a:cubicBezTo>
                  <a:pt x="3889" y="343"/>
                  <a:pt x="3865" y="335"/>
                  <a:pt x="3841" y="338"/>
                </a:cubicBezTo>
                <a:cubicBezTo>
                  <a:pt x="3817" y="340"/>
                  <a:pt x="3792" y="354"/>
                  <a:pt x="3766" y="380"/>
                </a:cubicBezTo>
                <a:cubicBezTo>
                  <a:pt x="3739" y="407"/>
                  <a:pt x="3724" y="431"/>
                  <a:pt x="3722" y="453"/>
                </a:cubicBezTo>
                <a:cubicBezTo>
                  <a:pt x="3719" y="476"/>
                  <a:pt x="3725" y="494"/>
                  <a:pt x="3739" y="508"/>
                </a:cubicBezTo>
                <a:cubicBezTo>
                  <a:pt x="3751" y="520"/>
                  <a:pt x="3765" y="525"/>
                  <a:pt x="3782" y="524"/>
                </a:cubicBezTo>
                <a:cubicBezTo>
                  <a:pt x="3798" y="523"/>
                  <a:pt x="3829" y="509"/>
                  <a:pt x="3873" y="481"/>
                </a:cubicBezTo>
                <a:cubicBezTo>
                  <a:pt x="3917" y="453"/>
                  <a:pt x="3949" y="436"/>
                  <a:pt x="3969" y="428"/>
                </a:cubicBezTo>
                <a:cubicBezTo>
                  <a:pt x="3997" y="418"/>
                  <a:pt x="4023" y="415"/>
                  <a:pt x="4046" y="419"/>
                </a:cubicBezTo>
                <a:cubicBezTo>
                  <a:pt x="4069" y="424"/>
                  <a:pt x="4090" y="435"/>
                  <a:pt x="4108" y="453"/>
                </a:cubicBezTo>
                <a:cubicBezTo>
                  <a:pt x="4126" y="471"/>
                  <a:pt x="4138" y="493"/>
                  <a:pt x="4143" y="519"/>
                </a:cubicBezTo>
                <a:cubicBezTo>
                  <a:pt x="4149" y="545"/>
                  <a:pt x="4146" y="572"/>
                  <a:pt x="4136" y="600"/>
                </a:cubicBezTo>
                <a:cubicBezTo>
                  <a:pt x="4126" y="628"/>
                  <a:pt x="4108" y="654"/>
                  <a:pt x="4084" y="678"/>
                </a:cubicBezTo>
                <a:cubicBezTo>
                  <a:pt x="4054" y="708"/>
                  <a:pt x="4024" y="729"/>
                  <a:pt x="3995" y="741"/>
                </a:cubicBezTo>
                <a:cubicBezTo>
                  <a:pt x="3965" y="753"/>
                  <a:pt x="3936" y="755"/>
                  <a:pt x="3906" y="749"/>
                </a:cubicBezTo>
                <a:cubicBezTo>
                  <a:pt x="3877" y="743"/>
                  <a:pt x="3851" y="729"/>
                  <a:pt x="3827" y="707"/>
                </a:cubicBezTo>
                <a:close/>
                <a:moveTo>
                  <a:pt x="4428" y="244"/>
                </a:moveTo>
                <a:lnTo>
                  <a:pt x="4468" y="283"/>
                </a:lnTo>
                <a:lnTo>
                  <a:pt x="4245" y="506"/>
                </a:lnTo>
                <a:cubicBezTo>
                  <a:pt x="4235" y="496"/>
                  <a:pt x="4227" y="485"/>
                  <a:pt x="4222" y="472"/>
                </a:cubicBezTo>
                <a:cubicBezTo>
                  <a:pt x="4212" y="451"/>
                  <a:pt x="4206" y="427"/>
                  <a:pt x="4204" y="400"/>
                </a:cubicBezTo>
                <a:cubicBezTo>
                  <a:pt x="4202" y="373"/>
                  <a:pt x="4203" y="338"/>
                  <a:pt x="4207" y="295"/>
                </a:cubicBezTo>
                <a:cubicBezTo>
                  <a:pt x="4214" y="229"/>
                  <a:pt x="4215" y="180"/>
                  <a:pt x="4210" y="150"/>
                </a:cubicBezTo>
                <a:cubicBezTo>
                  <a:pt x="4205" y="120"/>
                  <a:pt x="4195" y="97"/>
                  <a:pt x="4180" y="81"/>
                </a:cubicBezTo>
                <a:cubicBezTo>
                  <a:pt x="4163" y="65"/>
                  <a:pt x="4144" y="57"/>
                  <a:pt x="4121" y="57"/>
                </a:cubicBezTo>
                <a:cubicBezTo>
                  <a:pt x="4098" y="58"/>
                  <a:pt x="4077" y="67"/>
                  <a:pt x="4058" y="86"/>
                </a:cubicBezTo>
                <a:cubicBezTo>
                  <a:pt x="4038" y="106"/>
                  <a:pt x="4028" y="128"/>
                  <a:pt x="4028" y="152"/>
                </a:cubicBezTo>
                <a:cubicBezTo>
                  <a:pt x="4028" y="176"/>
                  <a:pt x="4039" y="198"/>
                  <a:pt x="4060" y="219"/>
                </a:cubicBezTo>
                <a:lnTo>
                  <a:pt x="4013" y="257"/>
                </a:lnTo>
                <a:cubicBezTo>
                  <a:pt x="3984" y="223"/>
                  <a:pt x="3971" y="188"/>
                  <a:pt x="3973" y="152"/>
                </a:cubicBezTo>
                <a:cubicBezTo>
                  <a:pt x="3976" y="117"/>
                  <a:pt x="3993" y="83"/>
                  <a:pt x="4025" y="51"/>
                </a:cubicBezTo>
                <a:cubicBezTo>
                  <a:pt x="4057" y="19"/>
                  <a:pt x="4092" y="2"/>
                  <a:pt x="4128" y="1"/>
                </a:cubicBezTo>
                <a:cubicBezTo>
                  <a:pt x="4165" y="0"/>
                  <a:pt x="4196" y="13"/>
                  <a:pt x="4223" y="40"/>
                </a:cubicBezTo>
                <a:cubicBezTo>
                  <a:pt x="4236" y="53"/>
                  <a:pt x="4247" y="69"/>
                  <a:pt x="4254" y="88"/>
                </a:cubicBezTo>
                <a:cubicBezTo>
                  <a:pt x="4262" y="106"/>
                  <a:pt x="4266" y="129"/>
                  <a:pt x="4268" y="156"/>
                </a:cubicBezTo>
                <a:cubicBezTo>
                  <a:pt x="4270" y="183"/>
                  <a:pt x="4268" y="224"/>
                  <a:pt x="4263" y="279"/>
                </a:cubicBezTo>
                <a:cubicBezTo>
                  <a:pt x="4260" y="324"/>
                  <a:pt x="4258" y="354"/>
                  <a:pt x="4258" y="369"/>
                </a:cubicBezTo>
                <a:cubicBezTo>
                  <a:pt x="4258" y="383"/>
                  <a:pt x="4260" y="396"/>
                  <a:pt x="4263" y="409"/>
                </a:cubicBezTo>
                <a:lnTo>
                  <a:pt x="4428" y="244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5" name="Freeform 71"/>
          <p:cNvSpPr>
            <a:spLocks noEditPoints="1"/>
          </p:cNvSpPr>
          <p:nvPr/>
        </p:nvSpPr>
        <p:spPr bwMode="auto">
          <a:xfrm>
            <a:off x="3233880" y="5035690"/>
            <a:ext cx="839787" cy="839788"/>
          </a:xfrm>
          <a:custGeom>
            <a:avLst/>
            <a:gdLst>
              <a:gd name="T0" fmla="*/ 238 w 4406"/>
              <a:gd name="T1" fmla="*/ 3871 h 4408"/>
              <a:gd name="T2" fmla="*/ 244 w 4406"/>
              <a:gd name="T3" fmla="*/ 4227 h 4408"/>
              <a:gd name="T4" fmla="*/ 336 w 4406"/>
              <a:gd name="T5" fmla="*/ 4023 h 4408"/>
              <a:gd name="T6" fmla="*/ 84 w 4406"/>
              <a:gd name="T7" fmla="*/ 4067 h 4408"/>
              <a:gd name="T8" fmla="*/ 513 w 4406"/>
              <a:gd name="T9" fmla="*/ 3579 h 4408"/>
              <a:gd name="T10" fmla="*/ 740 w 4406"/>
              <a:gd name="T11" fmla="*/ 3707 h 4408"/>
              <a:gd name="T12" fmla="*/ 779 w 4406"/>
              <a:gd name="T13" fmla="*/ 3965 h 4408"/>
              <a:gd name="T14" fmla="*/ 620 w 4406"/>
              <a:gd name="T15" fmla="*/ 3692 h 4408"/>
              <a:gd name="T16" fmla="*/ 399 w 4406"/>
              <a:gd name="T17" fmla="*/ 3752 h 4408"/>
              <a:gd name="T18" fmla="*/ 784 w 4406"/>
              <a:gd name="T19" fmla="*/ 3859 h 4408"/>
              <a:gd name="T20" fmla="*/ 618 w 4406"/>
              <a:gd name="T21" fmla="*/ 3816 h 4408"/>
              <a:gd name="T22" fmla="*/ 743 w 4406"/>
              <a:gd name="T23" fmla="*/ 3328 h 4408"/>
              <a:gd name="T24" fmla="*/ 1131 w 4406"/>
              <a:gd name="T25" fmla="*/ 3409 h 4408"/>
              <a:gd name="T26" fmla="*/ 964 w 4406"/>
              <a:gd name="T27" fmla="*/ 3780 h 4408"/>
              <a:gd name="T28" fmla="*/ 1081 w 4406"/>
              <a:gd name="T29" fmla="*/ 3451 h 4408"/>
              <a:gd name="T30" fmla="*/ 712 w 4406"/>
              <a:gd name="T31" fmla="*/ 3439 h 4408"/>
              <a:gd name="T32" fmla="*/ 1627 w 4406"/>
              <a:gd name="T33" fmla="*/ 3304 h 4408"/>
              <a:gd name="T34" fmla="*/ 1414 w 4406"/>
              <a:gd name="T35" fmla="*/ 2664 h 4408"/>
              <a:gd name="T36" fmla="*/ 1563 w 4406"/>
              <a:gd name="T37" fmla="*/ 2908 h 4408"/>
              <a:gd name="T38" fmla="*/ 1524 w 4406"/>
              <a:gd name="T39" fmla="*/ 2867 h 4408"/>
              <a:gd name="T40" fmla="*/ 1403 w 4406"/>
              <a:gd name="T41" fmla="*/ 2748 h 4408"/>
              <a:gd name="T42" fmla="*/ 1788 w 4406"/>
              <a:gd name="T43" fmla="*/ 2284 h 4408"/>
              <a:gd name="T44" fmla="*/ 1957 w 4406"/>
              <a:gd name="T45" fmla="*/ 2478 h 4408"/>
              <a:gd name="T46" fmla="*/ 1881 w 4406"/>
              <a:gd name="T47" fmla="*/ 2863 h 4408"/>
              <a:gd name="T48" fmla="*/ 2042 w 4406"/>
              <a:gd name="T49" fmla="*/ 2202 h 4408"/>
              <a:gd name="T50" fmla="*/ 2166 w 4406"/>
              <a:gd name="T51" fmla="*/ 2223 h 4408"/>
              <a:gd name="T52" fmla="*/ 2183 w 4406"/>
              <a:gd name="T53" fmla="*/ 2326 h 4408"/>
              <a:gd name="T54" fmla="*/ 2342 w 4406"/>
              <a:gd name="T55" fmla="*/ 1875 h 4408"/>
              <a:gd name="T56" fmla="*/ 2283 w 4406"/>
              <a:gd name="T57" fmla="*/ 1786 h 4408"/>
              <a:gd name="T58" fmla="*/ 2531 w 4406"/>
              <a:gd name="T59" fmla="*/ 1790 h 4408"/>
              <a:gd name="T60" fmla="*/ 2472 w 4406"/>
              <a:gd name="T61" fmla="*/ 1608 h 4408"/>
              <a:gd name="T62" fmla="*/ 2531 w 4406"/>
              <a:gd name="T63" fmla="*/ 1621 h 4408"/>
              <a:gd name="T64" fmla="*/ 2608 w 4406"/>
              <a:gd name="T65" fmla="*/ 1713 h 4408"/>
              <a:gd name="T66" fmla="*/ 2901 w 4406"/>
              <a:gd name="T67" fmla="*/ 1760 h 4408"/>
              <a:gd name="T68" fmla="*/ 2884 w 4406"/>
              <a:gd name="T69" fmla="*/ 1653 h 4408"/>
              <a:gd name="T70" fmla="*/ 2685 w 4406"/>
              <a:gd name="T71" fmla="*/ 1595 h 4408"/>
              <a:gd name="T72" fmla="*/ 2895 w 4406"/>
              <a:gd name="T73" fmla="*/ 1488 h 4408"/>
              <a:gd name="T74" fmla="*/ 2745 w 4406"/>
              <a:gd name="T75" fmla="*/ 1631 h 4408"/>
              <a:gd name="T76" fmla="*/ 2968 w 4406"/>
              <a:gd name="T77" fmla="*/ 1562 h 4408"/>
              <a:gd name="T78" fmla="*/ 2900 w 4406"/>
              <a:gd name="T79" fmla="*/ 1816 h 4408"/>
              <a:gd name="T80" fmla="*/ 2965 w 4406"/>
              <a:gd name="T81" fmla="*/ 1309 h 4408"/>
              <a:gd name="T82" fmla="*/ 2943 w 4406"/>
              <a:gd name="T83" fmla="*/ 1126 h 4408"/>
              <a:gd name="T84" fmla="*/ 3279 w 4406"/>
              <a:gd name="T85" fmla="*/ 887 h 4408"/>
              <a:gd name="T86" fmla="*/ 3568 w 4406"/>
              <a:gd name="T87" fmla="*/ 1176 h 4408"/>
              <a:gd name="T88" fmla="*/ 3484 w 4406"/>
              <a:gd name="T89" fmla="*/ 594 h 4408"/>
              <a:gd name="T90" fmla="*/ 3633 w 4406"/>
              <a:gd name="T91" fmla="*/ 837 h 4408"/>
              <a:gd name="T92" fmla="*/ 3594 w 4406"/>
              <a:gd name="T93" fmla="*/ 797 h 4408"/>
              <a:gd name="T94" fmla="*/ 3473 w 4406"/>
              <a:gd name="T95" fmla="*/ 678 h 4408"/>
              <a:gd name="T96" fmla="*/ 3921 w 4406"/>
              <a:gd name="T97" fmla="*/ 682 h 4408"/>
              <a:gd name="T98" fmla="*/ 4069 w 4406"/>
              <a:gd name="T99" fmla="*/ 492 h 4408"/>
              <a:gd name="T100" fmla="*/ 3753 w 4406"/>
              <a:gd name="T101" fmla="*/ 576 h 4408"/>
              <a:gd name="T102" fmla="*/ 3803 w 4406"/>
              <a:gd name="T103" fmla="*/ 282 h 4408"/>
              <a:gd name="T104" fmla="*/ 3766 w 4406"/>
              <a:gd name="T105" fmla="*/ 373 h 4408"/>
              <a:gd name="T106" fmla="*/ 3969 w 4406"/>
              <a:gd name="T107" fmla="*/ 421 h 4408"/>
              <a:gd name="T108" fmla="*/ 4084 w 4406"/>
              <a:gd name="T109" fmla="*/ 671 h 4408"/>
              <a:gd name="T110" fmla="*/ 4365 w 4406"/>
              <a:gd name="T111" fmla="*/ 379 h 4408"/>
              <a:gd name="T112" fmla="*/ 4050 w 4406"/>
              <a:gd name="T113" fmla="*/ 109 h 440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</a:cxnLst>
            <a:rect l="0" t="0" r="r" b="b"/>
            <a:pathLst>
              <a:path w="4406" h="4408">
                <a:moveTo>
                  <a:pt x="336" y="4408"/>
                </a:moveTo>
                <a:lnTo>
                  <a:pt x="0" y="4072"/>
                </a:lnTo>
                <a:lnTo>
                  <a:pt x="126" y="3945"/>
                </a:lnTo>
                <a:cubicBezTo>
                  <a:pt x="149" y="3923"/>
                  <a:pt x="167" y="3907"/>
                  <a:pt x="181" y="3897"/>
                </a:cubicBezTo>
                <a:cubicBezTo>
                  <a:pt x="200" y="3883"/>
                  <a:pt x="219" y="3875"/>
                  <a:pt x="238" y="3871"/>
                </a:cubicBezTo>
                <a:cubicBezTo>
                  <a:pt x="257" y="3868"/>
                  <a:pt x="277" y="3870"/>
                  <a:pt x="297" y="3877"/>
                </a:cubicBezTo>
                <a:cubicBezTo>
                  <a:pt x="318" y="3884"/>
                  <a:pt x="337" y="3896"/>
                  <a:pt x="353" y="3913"/>
                </a:cubicBezTo>
                <a:cubicBezTo>
                  <a:pt x="382" y="3941"/>
                  <a:pt x="397" y="3974"/>
                  <a:pt x="399" y="4012"/>
                </a:cubicBezTo>
                <a:cubicBezTo>
                  <a:pt x="400" y="4050"/>
                  <a:pt x="377" y="4093"/>
                  <a:pt x="330" y="4141"/>
                </a:cubicBezTo>
                <a:lnTo>
                  <a:pt x="244" y="4227"/>
                </a:lnTo>
                <a:lnTo>
                  <a:pt x="380" y="4364"/>
                </a:lnTo>
                <a:lnTo>
                  <a:pt x="336" y="4408"/>
                </a:lnTo>
                <a:close/>
                <a:moveTo>
                  <a:pt x="204" y="4187"/>
                </a:moveTo>
                <a:lnTo>
                  <a:pt x="291" y="4100"/>
                </a:lnTo>
                <a:cubicBezTo>
                  <a:pt x="320" y="4072"/>
                  <a:pt x="335" y="4046"/>
                  <a:pt x="336" y="4023"/>
                </a:cubicBezTo>
                <a:cubicBezTo>
                  <a:pt x="337" y="4000"/>
                  <a:pt x="328" y="3979"/>
                  <a:pt x="309" y="3960"/>
                </a:cubicBezTo>
                <a:cubicBezTo>
                  <a:pt x="295" y="3946"/>
                  <a:pt x="279" y="3937"/>
                  <a:pt x="262" y="3934"/>
                </a:cubicBezTo>
                <a:cubicBezTo>
                  <a:pt x="245" y="3931"/>
                  <a:pt x="229" y="3934"/>
                  <a:pt x="214" y="3943"/>
                </a:cubicBezTo>
                <a:cubicBezTo>
                  <a:pt x="205" y="3948"/>
                  <a:pt x="190" y="3961"/>
                  <a:pt x="170" y="3981"/>
                </a:cubicBezTo>
                <a:lnTo>
                  <a:pt x="84" y="4067"/>
                </a:lnTo>
                <a:lnTo>
                  <a:pt x="204" y="4187"/>
                </a:lnTo>
                <a:close/>
                <a:moveTo>
                  <a:pt x="651" y="4093"/>
                </a:moveTo>
                <a:lnTo>
                  <a:pt x="315" y="3757"/>
                </a:lnTo>
                <a:lnTo>
                  <a:pt x="441" y="3631"/>
                </a:lnTo>
                <a:cubicBezTo>
                  <a:pt x="466" y="3605"/>
                  <a:pt x="490" y="3588"/>
                  <a:pt x="513" y="3579"/>
                </a:cubicBezTo>
                <a:cubicBezTo>
                  <a:pt x="535" y="3571"/>
                  <a:pt x="558" y="3569"/>
                  <a:pt x="581" y="3574"/>
                </a:cubicBezTo>
                <a:cubicBezTo>
                  <a:pt x="603" y="3580"/>
                  <a:pt x="623" y="3590"/>
                  <a:pt x="638" y="3605"/>
                </a:cubicBezTo>
                <a:cubicBezTo>
                  <a:pt x="652" y="3620"/>
                  <a:pt x="662" y="3637"/>
                  <a:pt x="667" y="3658"/>
                </a:cubicBezTo>
                <a:cubicBezTo>
                  <a:pt x="672" y="3678"/>
                  <a:pt x="670" y="3700"/>
                  <a:pt x="662" y="3724"/>
                </a:cubicBezTo>
                <a:cubicBezTo>
                  <a:pt x="689" y="3709"/>
                  <a:pt x="714" y="3704"/>
                  <a:pt x="740" y="3707"/>
                </a:cubicBezTo>
                <a:cubicBezTo>
                  <a:pt x="765" y="3711"/>
                  <a:pt x="787" y="3722"/>
                  <a:pt x="807" y="3742"/>
                </a:cubicBezTo>
                <a:cubicBezTo>
                  <a:pt x="823" y="3758"/>
                  <a:pt x="834" y="3776"/>
                  <a:pt x="841" y="3796"/>
                </a:cubicBezTo>
                <a:cubicBezTo>
                  <a:pt x="848" y="3816"/>
                  <a:pt x="850" y="3835"/>
                  <a:pt x="848" y="3852"/>
                </a:cubicBezTo>
                <a:cubicBezTo>
                  <a:pt x="845" y="3869"/>
                  <a:pt x="838" y="3887"/>
                  <a:pt x="827" y="3905"/>
                </a:cubicBezTo>
                <a:cubicBezTo>
                  <a:pt x="816" y="3924"/>
                  <a:pt x="800" y="3944"/>
                  <a:pt x="779" y="3965"/>
                </a:cubicBezTo>
                <a:lnTo>
                  <a:pt x="651" y="4093"/>
                </a:lnTo>
                <a:close/>
                <a:moveTo>
                  <a:pt x="500" y="3854"/>
                </a:moveTo>
                <a:lnTo>
                  <a:pt x="573" y="3781"/>
                </a:lnTo>
                <a:cubicBezTo>
                  <a:pt x="593" y="3761"/>
                  <a:pt x="605" y="3746"/>
                  <a:pt x="611" y="3735"/>
                </a:cubicBezTo>
                <a:cubicBezTo>
                  <a:pt x="619" y="3720"/>
                  <a:pt x="622" y="3706"/>
                  <a:pt x="620" y="3692"/>
                </a:cubicBezTo>
                <a:cubicBezTo>
                  <a:pt x="618" y="3679"/>
                  <a:pt x="611" y="3666"/>
                  <a:pt x="600" y="3654"/>
                </a:cubicBezTo>
                <a:cubicBezTo>
                  <a:pt x="588" y="3643"/>
                  <a:pt x="576" y="3636"/>
                  <a:pt x="562" y="3633"/>
                </a:cubicBezTo>
                <a:cubicBezTo>
                  <a:pt x="548" y="3630"/>
                  <a:pt x="535" y="3632"/>
                  <a:pt x="522" y="3639"/>
                </a:cubicBezTo>
                <a:cubicBezTo>
                  <a:pt x="509" y="3645"/>
                  <a:pt x="490" y="3661"/>
                  <a:pt x="466" y="3685"/>
                </a:cubicBezTo>
                <a:lnTo>
                  <a:pt x="399" y="3752"/>
                </a:lnTo>
                <a:lnTo>
                  <a:pt x="500" y="3854"/>
                </a:lnTo>
                <a:close/>
                <a:moveTo>
                  <a:pt x="655" y="4009"/>
                </a:moveTo>
                <a:lnTo>
                  <a:pt x="739" y="3925"/>
                </a:lnTo>
                <a:cubicBezTo>
                  <a:pt x="754" y="3911"/>
                  <a:pt x="763" y="3900"/>
                  <a:pt x="768" y="3893"/>
                </a:cubicBezTo>
                <a:cubicBezTo>
                  <a:pt x="776" y="3881"/>
                  <a:pt x="782" y="3870"/>
                  <a:pt x="784" y="3859"/>
                </a:cubicBezTo>
                <a:cubicBezTo>
                  <a:pt x="787" y="3847"/>
                  <a:pt x="786" y="3835"/>
                  <a:pt x="783" y="3823"/>
                </a:cubicBezTo>
                <a:cubicBezTo>
                  <a:pt x="779" y="3810"/>
                  <a:pt x="772" y="3799"/>
                  <a:pt x="761" y="3788"/>
                </a:cubicBezTo>
                <a:cubicBezTo>
                  <a:pt x="748" y="3775"/>
                  <a:pt x="734" y="3768"/>
                  <a:pt x="719" y="3765"/>
                </a:cubicBezTo>
                <a:cubicBezTo>
                  <a:pt x="703" y="3762"/>
                  <a:pt x="688" y="3764"/>
                  <a:pt x="672" y="3772"/>
                </a:cubicBezTo>
                <a:cubicBezTo>
                  <a:pt x="657" y="3780"/>
                  <a:pt x="639" y="3794"/>
                  <a:pt x="618" y="3816"/>
                </a:cubicBezTo>
                <a:lnTo>
                  <a:pt x="540" y="3893"/>
                </a:lnTo>
                <a:lnTo>
                  <a:pt x="655" y="4009"/>
                </a:lnTo>
                <a:close/>
                <a:moveTo>
                  <a:pt x="964" y="3780"/>
                </a:moveTo>
                <a:lnTo>
                  <a:pt x="628" y="3444"/>
                </a:lnTo>
                <a:lnTo>
                  <a:pt x="743" y="3328"/>
                </a:lnTo>
                <a:cubicBezTo>
                  <a:pt x="769" y="3302"/>
                  <a:pt x="791" y="3284"/>
                  <a:pt x="808" y="3273"/>
                </a:cubicBezTo>
                <a:cubicBezTo>
                  <a:pt x="832" y="3258"/>
                  <a:pt x="856" y="3250"/>
                  <a:pt x="881" y="3248"/>
                </a:cubicBezTo>
                <a:cubicBezTo>
                  <a:pt x="914" y="3245"/>
                  <a:pt x="946" y="3251"/>
                  <a:pt x="979" y="3266"/>
                </a:cubicBezTo>
                <a:cubicBezTo>
                  <a:pt x="1011" y="3280"/>
                  <a:pt x="1042" y="3302"/>
                  <a:pt x="1072" y="3332"/>
                </a:cubicBezTo>
                <a:cubicBezTo>
                  <a:pt x="1097" y="3358"/>
                  <a:pt x="1117" y="3383"/>
                  <a:pt x="1131" y="3409"/>
                </a:cubicBezTo>
                <a:cubicBezTo>
                  <a:pt x="1144" y="3435"/>
                  <a:pt x="1153" y="3459"/>
                  <a:pt x="1157" y="3481"/>
                </a:cubicBezTo>
                <a:cubicBezTo>
                  <a:pt x="1160" y="3503"/>
                  <a:pt x="1160" y="3524"/>
                  <a:pt x="1156" y="3542"/>
                </a:cubicBezTo>
                <a:cubicBezTo>
                  <a:pt x="1153" y="3561"/>
                  <a:pt x="1145" y="3580"/>
                  <a:pt x="1133" y="3599"/>
                </a:cubicBezTo>
                <a:cubicBezTo>
                  <a:pt x="1121" y="3619"/>
                  <a:pt x="1105" y="3638"/>
                  <a:pt x="1085" y="3659"/>
                </a:cubicBezTo>
                <a:lnTo>
                  <a:pt x="964" y="3780"/>
                </a:lnTo>
                <a:close/>
                <a:moveTo>
                  <a:pt x="968" y="3696"/>
                </a:moveTo>
                <a:lnTo>
                  <a:pt x="1040" y="3624"/>
                </a:lnTo>
                <a:cubicBezTo>
                  <a:pt x="1062" y="3602"/>
                  <a:pt x="1078" y="3583"/>
                  <a:pt x="1086" y="3566"/>
                </a:cubicBezTo>
                <a:cubicBezTo>
                  <a:pt x="1095" y="3549"/>
                  <a:pt x="1099" y="3533"/>
                  <a:pt x="1099" y="3518"/>
                </a:cubicBezTo>
                <a:cubicBezTo>
                  <a:pt x="1099" y="3497"/>
                  <a:pt x="1093" y="3475"/>
                  <a:pt x="1081" y="3451"/>
                </a:cubicBezTo>
                <a:cubicBezTo>
                  <a:pt x="1069" y="3427"/>
                  <a:pt x="1050" y="3403"/>
                  <a:pt x="1025" y="3378"/>
                </a:cubicBezTo>
                <a:cubicBezTo>
                  <a:pt x="990" y="3342"/>
                  <a:pt x="957" y="3321"/>
                  <a:pt x="927" y="3314"/>
                </a:cubicBezTo>
                <a:cubicBezTo>
                  <a:pt x="896" y="3306"/>
                  <a:pt x="870" y="3308"/>
                  <a:pt x="847" y="3318"/>
                </a:cubicBezTo>
                <a:cubicBezTo>
                  <a:pt x="830" y="3325"/>
                  <a:pt x="809" y="3342"/>
                  <a:pt x="782" y="3369"/>
                </a:cubicBezTo>
                <a:lnTo>
                  <a:pt x="712" y="3439"/>
                </a:lnTo>
                <a:lnTo>
                  <a:pt x="968" y="3696"/>
                </a:lnTo>
                <a:close/>
                <a:moveTo>
                  <a:pt x="1353" y="3577"/>
                </a:moveTo>
                <a:lnTo>
                  <a:pt x="1323" y="3548"/>
                </a:lnTo>
                <a:lnTo>
                  <a:pt x="1597" y="3274"/>
                </a:lnTo>
                <a:lnTo>
                  <a:pt x="1627" y="3304"/>
                </a:lnTo>
                <a:lnTo>
                  <a:pt x="1353" y="3577"/>
                </a:lnTo>
                <a:close/>
                <a:moveTo>
                  <a:pt x="1569" y="3175"/>
                </a:moveTo>
                <a:lnTo>
                  <a:pt x="1233" y="2839"/>
                </a:lnTo>
                <a:lnTo>
                  <a:pt x="1360" y="2712"/>
                </a:lnTo>
                <a:cubicBezTo>
                  <a:pt x="1382" y="2690"/>
                  <a:pt x="1400" y="2674"/>
                  <a:pt x="1414" y="2664"/>
                </a:cubicBezTo>
                <a:cubicBezTo>
                  <a:pt x="1433" y="2650"/>
                  <a:pt x="1452" y="2642"/>
                  <a:pt x="1471" y="2638"/>
                </a:cubicBezTo>
                <a:cubicBezTo>
                  <a:pt x="1490" y="2635"/>
                  <a:pt x="1510" y="2637"/>
                  <a:pt x="1531" y="2644"/>
                </a:cubicBezTo>
                <a:cubicBezTo>
                  <a:pt x="1551" y="2651"/>
                  <a:pt x="1570" y="2663"/>
                  <a:pt x="1587" y="2679"/>
                </a:cubicBezTo>
                <a:cubicBezTo>
                  <a:pt x="1615" y="2708"/>
                  <a:pt x="1630" y="2741"/>
                  <a:pt x="1632" y="2779"/>
                </a:cubicBezTo>
                <a:cubicBezTo>
                  <a:pt x="1633" y="2817"/>
                  <a:pt x="1610" y="2860"/>
                  <a:pt x="1563" y="2908"/>
                </a:cubicBezTo>
                <a:lnTo>
                  <a:pt x="1477" y="2994"/>
                </a:lnTo>
                <a:lnTo>
                  <a:pt x="1613" y="3130"/>
                </a:lnTo>
                <a:lnTo>
                  <a:pt x="1569" y="3175"/>
                </a:lnTo>
                <a:close/>
                <a:moveTo>
                  <a:pt x="1437" y="2954"/>
                </a:moveTo>
                <a:lnTo>
                  <a:pt x="1524" y="2867"/>
                </a:lnTo>
                <a:cubicBezTo>
                  <a:pt x="1553" y="2838"/>
                  <a:pt x="1568" y="2813"/>
                  <a:pt x="1569" y="2790"/>
                </a:cubicBezTo>
                <a:cubicBezTo>
                  <a:pt x="1571" y="2767"/>
                  <a:pt x="1561" y="2746"/>
                  <a:pt x="1542" y="2727"/>
                </a:cubicBezTo>
                <a:cubicBezTo>
                  <a:pt x="1528" y="2713"/>
                  <a:pt x="1512" y="2704"/>
                  <a:pt x="1495" y="2701"/>
                </a:cubicBezTo>
                <a:cubicBezTo>
                  <a:pt x="1478" y="2698"/>
                  <a:pt x="1462" y="2701"/>
                  <a:pt x="1447" y="2709"/>
                </a:cubicBezTo>
                <a:cubicBezTo>
                  <a:pt x="1438" y="2715"/>
                  <a:pt x="1423" y="2728"/>
                  <a:pt x="1403" y="2748"/>
                </a:cubicBezTo>
                <a:lnTo>
                  <a:pt x="1317" y="2834"/>
                </a:lnTo>
                <a:lnTo>
                  <a:pt x="1437" y="2954"/>
                </a:lnTo>
                <a:close/>
                <a:moveTo>
                  <a:pt x="1881" y="2863"/>
                </a:moveTo>
                <a:lnTo>
                  <a:pt x="1545" y="2527"/>
                </a:lnTo>
                <a:lnTo>
                  <a:pt x="1788" y="2284"/>
                </a:lnTo>
                <a:lnTo>
                  <a:pt x="1828" y="2323"/>
                </a:lnTo>
                <a:lnTo>
                  <a:pt x="1629" y="2522"/>
                </a:lnTo>
                <a:lnTo>
                  <a:pt x="1732" y="2625"/>
                </a:lnTo>
                <a:lnTo>
                  <a:pt x="1918" y="2439"/>
                </a:lnTo>
                <a:lnTo>
                  <a:pt x="1957" y="2478"/>
                </a:lnTo>
                <a:lnTo>
                  <a:pt x="1771" y="2664"/>
                </a:lnTo>
                <a:lnTo>
                  <a:pt x="1886" y="2779"/>
                </a:lnTo>
                <a:lnTo>
                  <a:pt x="2092" y="2572"/>
                </a:lnTo>
                <a:lnTo>
                  <a:pt x="2132" y="2612"/>
                </a:lnTo>
                <a:lnTo>
                  <a:pt x="1881" y="2863"/>
                </a:lnTo>
                <a:close/>
                <a:moveTo>
                  <a:pt x="2163" y="2581"/>
                </a:moveTo>
                <a:lnTo>
                  <a:pt x="2117" y="2276"/>
                </a:lnTo>
                <a:lnTo>
                  <a:pt x="1842" y="2230"/>
                </a:lnTo>
                <a:lnTo>
                  <a:pt x="1895" y="2177"/>
                </a:lnTo>
                <a:lnTo>
                  <a:pt x="2042" y="2202"/>
                </a:lnTo>
                <a:cubicBezTo>
                  <a:pt x="2073" y="2207"/>
                  <a:pt x="2095" y="2212"/>
                  <a:pt x="2110" y="2216"/>
                </a:cubicBezTo>
                <a:cubicBezTo>
                  <a:pt x="2106" y="2196"/>
                  <a:pt x="2102" y="2175"/>
                  <a:pt x="2099" y="2151"/>
                </a:cubicBezTo>
                <a:lnTo>
                  <a:pt x="2077" y="1994"/>
                </a:lnTo>
                <a:lnTo>
                  <a:pt x="2126" y="1946"/>
                </a:lnTo>
                <a:lnTo>
                  <a:pt x="2166" y="2223"/>
                </a:lnTo>
                <a:lnTo>
                  <a:pt x="2471" y="2273"/>
                </a:lnTo>
                <a:lnTo>
                  <a:pt x="2416" y="2328"/>
                </a:lnTo>
                <a:lnTo>
                  <a:pt x="2211" y="2293"/>
                </a:lnTo>
                <a:cubicBezTo>
                  <a:pt x="2200" y="2291"/>
                  <a:pt x="2187" y="2288"/>
                  <a:pt x="2174" y="2285"/>
                </a:cubicBezTo>
                <a:cubicBezTo>
                  <a:pt x="2179" y="2305"/>
                  <a:pt x="2182" y="2318"/>
                  <a:pt x="2183" y="2326"/>
                </a:cubicBezTo>
                <a:lnTo>
                  <a:pt x="2216" y="2528"/>
                </a:lnTo>
                <a:lnTo>
                  <a:pt x="2163" y="2581"/>
                </a:lnTo>
                <a:close/>
                <a:moveTo>
                  <a:pt x="2647" y="2097"/>
                </a:moveTo>
                <a:lnTo>
                  <a:pt x="2605" y="2138"/>
                </a:lnTo>
                <a:lnTo>
                  <a:pt x="2342" y="1875"/>
                </a:lnTo>
                <a:cubicBezTo>
                  <a:pt x="2342" y="1895"/>
                  <a:pt x="2338" y="1917"/>
                  <a:pt x="2332" y="1943"/>
                </a:cubicBezTo>
                <a:cubicBezTo>
                  <a:pt x="2325" y="1969"/>
                  <a:pt x="2318" y="1990"/>
                  <a:pt x="2310" y="2008"/>
                </a:cubicBezTo>
                <a:lnTo>
                  <a:pt x="2270" y="1968"/>
                </a:lnTo>
                <a:cubicBezTo>
                  <a:pt x="2282" y="1934"/>
                  <a:pt x="2289" y="1901"/>
                  <a:pt x="2291" y="1868"/>
                </a:cubicBezTo>
                <a:cubicBezTo>
                  <a:pt x="2293" y="1835"/>
                  <a:pt x="2290" y="1808"/>
                  <a:pt x="2283" y="1786"/>
                </a:cubicBezTo>
                <a:lnTo>
                  <a:pt x="2309" y="1760"/>
                </a:lnTo>
                <a:lnTo>
                  <a:pt x="2647" y="2097"/>
                </a:lnTo>
                <a:close/>
                <a:moveTo>
                  <a:pt x="2778" y="1965"/>
                </a:moveTo>
                <a:lnTo>
                  <a:pt x="2567" y="1754"/>
                </a:lnTo>
                <a:lnTo>
                  <a:pt x="2531" y="1790"/>
                </a:lnTo>
                <a:lnTo>
                  <a:pt x="2498" y="1758"/>
                </a:lnTo>
                <a:lnTo>
                  <a:pt x="2535" y="1722"/>
                </a:lnTo>
                <a:lnTo>
                  <a:pt x="2509" y="1696"/>
                </a:lnTo>
                <a:cubicBezTo>
                  <a:pt x="2493" y="1680"/>
                  <a:pt x="2482" y="1666"/>
                  <a:pt x="2477" y="1655"/>
                </a:cubicBezTo>
                <a:cubicBezTo>
                  <a:pt x="2470" y="1640"/>
                  <a:pt x="2469" y="1625"/>
                  <a:pt x="2472" y="1608"/>
                </a:cubicBezTo>
                <a:cubicBezTo>
                  <a:pt x="2475" y="1591"/>
                  <a:pt x="2486" y="1574"/>
                  <a:pt x="2504" y="1556"/>
                </a:cubicBezTo>
                <a:cubicBezTo>
                  <a:pt x="2516" y="1544"/>
                  <a:pt x="2530" y="1533"/>
                  <a:pt x="2547" y="1522"/>
                </a:cubicBezTo>
                <a:lnTo>
                  <a:pt x="2576" y="1564"/>
                </a:lnTo>
                <a:cubicBezTo>
                  <a:pt x="2566" y="1571"/>
                  <a:pt x="2557" y="1578"/>
                  <a:pt x="2550" y="1586"/>
                </a:cubicBezTo>
                <a:cubicBezTo>
                  <a:pt x="2537" y="1598"/>
                  <a:pt x="2531" y="1610"/>
                  <a:pt x="2531" y="1621"/>
                </a:cubicBezTo>
                <a:cubicBezTo>
                  <a:pt x="2531" y="1631"/>
                  <a:pt x="2539" y="1644"/>
                  <a:pt x="2553" y="1658"/>
                </a:cubicBezTo>
                <a:lnTo>
                  <a:pt x="2576" y="1681"/>
                </a:lnTo>
                <a:lnTo>
                  <a:pt x="2623" y="1633"/>
                </a:lnTo>
                <a:lnTo>
                  <a:pt x="2656" y="1665"/>
                </a:lnTo>
                <a:lnTo>
                  <a:pt x="2608" y="1713"/>
                </a:lnTo>
                <a:lnTo>
                  <a:pt x="2819" y="1924"/>
                </a:lnTo>
                <a:lnTo>
                  <a:pt x="2778" y="1965"/>
                </a:lnTo>
                <a:close/>
                <a:moveTo>
                  <a:pt x="2809" y="1789"/>
                </a:moveTo>
                <a:lnTo>
                  <a:pt x="2844" y="1742"/>
                </a:lnTo>
                <a:cubicBezTo>
                  <a:pt x="2862" y="1756"/>
                  <a:pt x="2881" y="1762"/>
                  <a:pt x="2901" y="1760"/>
                </a:cubicBezTo>
                <a:cubicBezTo>
                  <a:pt x="2920" y="1758"/>
                  <a:pt x="2939" y="1748"/>
                  <a:pt x="2958" y="1729"/>
                </a:cubicBezTo>
                <a:cubicBezTo>
                  <a:pt x="2977" y="1710"/>
                  <a:pt x="2987" y="1692"/>
                  <a:pt x="2988" y="1676"/>
                </a:cubicBezTo>
                <a:cubicBezTo>
                  <a:pt x="2990" y="1659"/>
                  <a:pt x="2985" y="1645"/>
                  <a:pt x="2975" y="1635"/>
                </a:cubicBezTo>
                <a:cubicBezTo>
                  <a:pt x="2965" y="1625"/>
                  <a:pt x="2954" y="1622"/>
                  <a:pt x="2941" y="1625"/>
                </a:cubicBezTo>
                <a:cubicBezTo>
                  <a:pt x="2931" y="1627"/>
                  <a:pt x="2913" y="1636"/>
                  <a:pt x="2884" y="1653"/>
                </a:cubicBezTo>
                <a:cubicBezTo>
                  <a:pt x="2847" y="1676"/>
                  <a:pt x="2819" y="1690"/>
                  <a:pt x="2802" y="1696"/>
                </a:cubicBezTo>
                <a:cubicBezTo>
                  <a:pt x="2784" y="1702"/>
                  <a:pt x="2768" y="1703"/>
                  <a:pt x="2752" y="1699"/>
                </a:cubicBezTo>
                <a:cubicBezTo>
                  <a:pt x="2736" y="1696"/>
                  <a:pt x="2722" y="1688"/>
                  <a:pt x="2710" y="1676"/>
                </a:cubicBezTo>
                <a:cubicBezTo>
                  <a:pt x="2699" y="1665"/>
                  <a:pt x="2692" y="1652"/>
                  <a:pt x="2687" y="1638"/>
                </a:cubicBezTo>
                <a:cubicBezTo>
                  <a:pt x="2683" y="1624"/>
                  <a:pt x="2682" y="1610"/>
                  <a:pt x="2685" y="1595"/>
                </a:cubicBezTo>
                <a:cubicBezTo>
                  <a:pt x="2686" y="1584"/>
                  <a:pt x="2691" y="1571"/>
                  <a:pt x="2699" y="1557"/>
                </a:cubicBezTo>
                <a:cubicBezTo>
                  <a:pt x="2707" y="1542"/>
                  <a:pt x="2717" y="1529"/>
                  <a:pt x="2730" y="1516"/>
                </a:cubicBezTo>
                <a:cubicBezTo>
                  <a:pt x="2749" y="1497"/>
                  <a:pt x="2768" y="1483"/>
                  <a:pt x="2788" y="1474"/>
                </a:cubicBezTo>
                <a:cubicBezTo>
                  <a:pt x="2808" y="1465"/>
                  <a:pt x="2826" y="1462"/>
                  <a:pt x="2843" y="1464"/>
                </a:cubicBezTo>
                <a:cubicBezTo>
                  <a:pt x="2859" y="1467"/>
                  <a:pt x="2876" y="1475"/>
                  <a:pt x="2895" y="1488"/>
                </a:cubicBezTo>
                <a:lnTo>
                  <a:pt x="2860" y="1534"/>
                </a:lnTo>
                <a:cubicBezTo>
                  <a:pt x="2845" y="1523"/>
                  <a:pt x="2830" y="1519"/>
                  <a:pt x="2814" y="1520"/>
                </a:cubicBezTo>
                <a:cubicBezTo>
                  <a:pt x="2799" y="1522"/>
                  <a:pt x="2783" y="1531"/>
                  <a:pt x="2767" y="1547"/>
                </a:cubicBezTo>
                <a:cubicBezTo>
                  <a:pt x="2748" y="1566"/>
                  <a:pt x="2737" y="1583"/>
                  <a:pt x="2735" y="1597"/>
                </a:cubicBezTo>
                <a:cubicBezTo>
                  <a:pt x="2734" y="1611"/>
                  <a:pt x="2737" y="1623"/>
                  <a:pt x="2745" y="1631"/>
                </a:cubicBezTo>
                <a:cubicBezTo>
                  <a:pt x="2751" y="1637"/>
                  <a:pt x="2757" y="1640"/>
                  <a:pt x="2765" y="1641"/>
                </a:cubicBezTo>
                <a:cubicBezTo>
                  <a:pt x="2773" y="1642"/>
                  <a:pt x="2781" y="1640"/>
                  <a:pt x="2792" y="1636"/>
                </a:cubicBezTo>
                <a:cubicBezTo>
                  <a:pt x="2797" y="1633"/>
                  <a:pt x="2813" y="1625"/>
                  <a:pt x="2839" y="1610"/>
                </a:cubicBezTo>
                <a:cubicBezTo>
                  <a:pt x="2876" y="1588"/>
                  <a:pt x="2902" y="1574"/>
                  <a:pt x="2919" y="1568"/>
                </a:cubicBezTo>
                <a:cubicBezTo>
                  <a:pt x="2935" y="1561"/>
                  <a:pt x="2952" y="1559"/>
                  <a:pt x="2968" y="1562"/>
                </a:cubicBezTo>
                <a:cubicBezTo>
                  <a:pt x="2984" y="1565"/>
                  <a:pt x="2999" y="1574"/>
                  <a:pt x="3013" y="1588"/>
                </a:cubicBezTo>
                <a:cubicBezTo>
                  <a:pt x="3027" y="1602"/>
                  <a:pt x="3036" y="1619"/>
                  <a:pt x="3040" y="1639"/>
                </a:cubicBezTo>
                <a:cubicBezTo>
                  <a:pt x="3044" y="1659"/>
                  <a:pt x="3042" y="1680"/>
                  <a:pt x="3033" y="1702"/>
                </a:cubicBezTo>
                <a:cubicBezTo>
                  <a:pt x="3025" y="1723"/>
                  <a:pt x="3011" y="1744"/>
                  <a:pt x="2992" y="1763"/>
                </a:cubicBezTo>
                <a:cubicBezTo>
                  <a:pt x="2960" y="1795"/>
                  <a:pt x="2929" y="1812"/>
                  <a:pt x="2900" y="1816"/>
                </a:cubicBezTo>
                <a:cubicBezTo>
                  <a:pt x="2870" y="1819"/>
                  <a:pt x="2840" y="1810"/>
                  <a:pt x="2809" y="1789"/>
                </a:cubicBezTo>
                <a:close/>
                <a:moveTo>
                  <a:pt x="3280" y="1464"/>
                </a:moveTo>
                <a:lnTo>
                  <a:pt x="3239" y="1505"/>
                </a:lnTo>
                <a:lnTo>
                  <a:pt x="2976" y="1242"/>
                </a:lnTo>
                <a:cubicBezTo>
                  <a:pt x="2976" y="1261"/>
                  <a:pt x="2972" y="1284"/>
                  <a:pt x="2965" y="1309"/>
                </a:cubicBezTo>
                <a:cubicBezTo>
                  <a:pt x="2959" y="1335"/>
                  <a:pt x="2951" y="1357"/>
                  <a:pt x="2943" y="1374"/>
                </a:cubicBezTo>
                <a:lnTo>
                  <a:pt x="2903" y="1334"/>
                </a:lnTo>
                <a:cubicBezTo>
                  <a:pt x="2916" y="1300"/>
                  <a:pt x="2923" y="1267"/>
                  <a:pt x="2924" y="1234"/>
                </a:cubicBezTo>
                <a:cubicBezTo>
                  <a:pt x="2926" y="1202"/>
                  <a:pt x="2923" y="1174"/>
                  <a:pt x="2916" y="1153"/>
                </a:cubicBezTo>
                <a:lnTo>
                  <a:pt x="2943" y="1126"/>
                </a:lnTo>
                <a:lnTo>
                  <a:pt x="3280" y="1464"/>
                </a:lnTo>
                <a:close/>
                <a:moveTo>
                  <a:pt x="3238" y="928"/>
                </a:moveTo>
                <a:lnTo>
                  <a:pt x="3191" y="881"/>
                </a:lnTo>
                <a:lnTo>
                  <a:pt x="3232" y="840"/>
                </a:lnTo>
                <a:lnTo>
                  <a:pt x="3279" y="887"/>
                </a:lnTo>
                <a:lnTo>
                  <a:pt x="3238" y="928"/>
                </a:lnTo>
                <a:close/>
                <a:moveTo>
                  <a:pt x="3527" y="1217"/>
                </a:moveTo>
                <a:lnTo>
                  <a:pt x="3283" y="973"/>
                </a:lnTo>
                <a:lnTo>
                  <a:pt x="3325" y="932"/>
                </a:lnTo>
                <a:lnTo>
                  <a:pt x="3568" y="1176"/>
                </a:lnTo>
                <a:lnTo>
                  <a:pt x="3527" y="1217"/>
                </a:lnTo>
                <a:close/>
                <a:moveTo>
                  <a:pt x="3639" y="1104"/>
                </a:moveTo>
                <a:lnTo>
                  <a:pt x="3303" y="768"/>
                </a:lnTo>
                <a:lnTo>
                  <a:pt x="3430" y="642"/>
                </a:lnTo>
                <a:cubicBezTo>
                  <a:pt x="3452" y="619"/>
                  <a:pt x="3470" y="603"/>
                  <a:pt x="3484" y="594"/>
                </a:cubicBezTo>
                <a:cubicBezTo>
                  <a:pt x="3504" y="580"/>
                  <a:pt x="3523" y="571"/>
                  <a:pt x="3542" y="568"/>
                </a:cubicBezTo>
                <a:cubicBezTo>
                  <a:pt x="3560" y="564"/>
                  <a:pt x="3580" y="566"/>
                  <a:pt x="3601" y="573"/>
                </a:cubicBezTo>
                <a:cubicBezTo>
                  <a:pt x="3622" y="580"/>
                  <a:pt x="3640" y="592"/>
                  <a:pt x="3657" y="609"/>
                </a:cubicBezTo>
                <a:cubicBezTo>
                  <a:pt x="3686" y="638"/>
                  <a:pt x="3701" y="671"/>
                  <a:pt x="3702" y="709"/>
                </a:cubicBezTo>
                <a:cubicBezTo>
                  <a:pt x="3704" y="747"/>
                  <a:pt x="3681" y="790"/>
                  <a:pt x="3633" y="837"/>
                </a:cubicBezTo>
                <a:lnTo>
                  <a:pt x="3547" y="923"/>
                </a:lnTo>
                <a:lnTo>
                  <a:pt x="3684" y="1060"/>
                </a:lnTo>
                <a:lnTo>
                  <a:pt x="3639" y="1104"/>
                </a:lnTo>
                <a:close/>
                <a:moveTo>
                  <a:pt x="3507" y="884"/>
                </a:moveTo>
                <a:lnTo>
                  <a:pt x="3594" y="797"/>
                </a:lnTo>
                <a:cubicBezTo>
                  <a:pt x="3623" y="768"/>
                  <a:pt x="3638" y="742"/>
                  <a:pt x="3640" y="719"/>
                </a:cubicBezTo>
                <a:cubicBezTo>
                  <a:pt x="3641" y="697"/>
                  <a:pt x="3632" y="676"/>
                  <a:pt x="3612" y="656"/>
                </a:cubicBezTo>
                <a:cubicBezTo>
                  <a:pt x="3598" y="642"/>
                  <a:pt x="3583" y="634"/>
                  <a:pt x="3566" y="631"/>
                </a:cubicBezTo>
                <a:cubicBezTo>
                  <a:pt x="3549" y="628"/>
                  <a:pt x="3533" y="631"/>
                  <a:pt x="3518" y="639"/>
                </a:cubicBezTo>
                <a:cubicBezTo>
                  <a:pt x="3508" y="645"/>
                  <a:pt x="3494" y="657"/>
                  <a:pt x="3473" y="678"/>
                </a:cubicBezTo>
                <a:lnTo>
                  <a:pt x="3387" y="764"/>
                </a:lnTo>
                <a:lnTo>
                  <a:pt x="3507" y="884"/>
                </a:lnTo>
                <a:close/>
                <a:moveTo>
                  <a:pt x="3827" y="700"/>
                </a:moveTo>
                <a:lnTo>
                  <a:pt x="3866" y="655"/>
                </a:lnTo>
                <a:cubicBezTo>
                  <a:pt x="3884" y="670"/>
                  <a:pt x="3903" y="679"/>
                  <a:pt x="3921" y="682"/>
                </a:cubicBezTo>
                <a:cubicBezTo>
                  <a:pt x="3939" y="686"/>
                  <a:pt x="3959" y="683"/>
                  <a:pt x="3981" y="675"/>
                </a:cubicBezTo>
                <a:cubicBezTo>
                  <a:pt x="4003" y="666"/>
                  <a:pt x="4023" y="652"/>
                  <a:pt x="4042" y="633"/>
                </a:cubicBezTo>
                <a:cubicBezTo>
                  <a:pt x="4059" y="616"/>
                  <a:pt x="4072" y="599"/>
                  <a:pt x="4080" y="581"/>
                </a:cubicBezTo>
                <a:cubicBezTo>
                  <a:pt x="4088" y="562"/>
                  <a:pt x="4090" y="546"/>
                  <a:pt x="4088" y="531"/>
                </a:cubicBezTo>
                <a:cubicBezTo>
                  <a:pt x="4086" y="516"/>
                  <a:pt x="4079" y="503"/>
                  <a:pt x="4069" y="492"/>
                </a:cubicBezTo>
                <a:cubicBezTo>
                  <a:pt x="4058" y="482"/>
                  <a:pt x="4046" y="476"/>
                  <a:pt x="4032" y="474"/>
                </a:cubicBezTo>
                <a:cubicBezTo>
                  <a:pt x="4018" y="472"/>
                  <a:pt x="4001" y="476"/>
                  <a:pt x="3982" y="484"/>
                </a:cubicBezTo>
                <a:cubicBezTo>
                  <a:pt x="3969" y="490"/>
                  <a:pt x="3944" y="504"/>
                  <a:pt x="3906" y="528"/>
                </a:cubicBezTo>
                <a:cubicBezTo>
                  <a:pt x="3867" y="551"/>
                  <a:pt x="3839" y="566"/>
                  <a:pt x="3820" y="572"/>
                </a:cubicBezTo>
                <a:cubicBezTo>
                  <a:pt x="3795" y="579"/>
                  <a:pt x="3773" y="581"/>
                  <a:pt x="3753" y="576"/>
                </a:cubicBezTo>
                <a:cubicBezTo>
                  <a:pt x="3732" y="572"/>
                  <a:pt x="3714" y="562"/>
                  <a:pt x="3699" y="546"/>
                </a:cubicBezTo>
                <a:cubicBezTo>
                  <a:pt x="3682" y="529"/>
                  <a:pt x="3671" y="509"/>
                  <a:pt x="3666" y="484"/>
                </a:cubicBezTo>
                <a:cubicBezTo>
                  <a:pt x="3661" y="460"/>
                  <a:pt x="3664" y="435"/>
                  <a:pt x="3674" y="409"/>
                </a:cubicBezTo>
                <a:cubicBezTo>
                  <a:pt x="3685" y="382"/>
                  <a:pt x="3702" y="358"/>
                  <a:pt x="3725" y="335"/>
                </a:cubicBezTo>
                <a:cubicBezTo>
                  <a:pt x="3750" y="311"/>
                  <a:pt x="3776" y="293"/>
                  <a:pt x="3803" y="282"/>
                </a:cubicBezTo>
                <a:cubicBezTo>
                  <a:pt x="3830" y="271"/>
                  <a:pt x="3856" y="268"/>
                  <a:pt x="3882" y="273"/>
                </a:cubicBezTo>
                <a:cubicBezTo>
                  <a:pt x="3908" y="278"/>
                  <a:pt x="3931" y="291"/>
                  <a:pt x="3951" y="310"/>
                </a:cubicBezTo>
                <a:lnTo>
                  <a:pt x="3912" y="355"/>
                </a:lnTo>
                <a:cubicBezTo>
                  <a:pt x="3888" y="336"/>
                  <a:pt x="3865" y="328"/>
                  <a:pt x="3841" y="331"/>
                </a:cubicBezTo>
                <a:cubicBezTo>
                  <a:pt x="3816" y="333"/>
                  <a:pt x="3791" y="347"/>
                  <a:pt x="3766" y="373"/>
                </a:cubicBezTo>
                <a:cubicBezTo>
                  <a:pt x="3739" y="400"/>
                  <a:pt x="3724" y="424"/>
                  <a:pt x="3722" y="446"/>
                </a:cubicBezTo>
                <a:cubicBezTo>
                  <a:pt x="3719" y="469"/>
                  <a:pt x="3725" y="487"/>
                  <a:pt x="3739" y="501"/>
                </a:cubicBezTo>
                <a:cubicBezTo>
                  <a:pt x="3751" y="513"/>
                  <a:pt x="3765" y="518"/>
                  <a:pt x="3782" y="517"/>
                </a:cubicBezTo>
                <a:cubicBezTo>
                  <a:pt x="3798" y="516"/>
                  <a:pt x="3828" y="502"/>
                  <a:pt x="3873" y="474"/>
                </a:cubicBezTo>
                <a:cubicBezTo>
                  <a:pt x="3917" y="446"/>
                  <a:pt x="3949" y="429"/>
                  <a:pt x="3969" y="421"/>
                </a:cubicBezTo>
                <a:cubicBezTo>
                  <a:pt x="3997" y="411"/>
                  <a:pt x="4023" y="408"/>
                  <a:pt x="4046" y="412"/>
                </a:cubicBezTo>
                <a:cubicBezTo>
                  <a:pt x="4069" y="417"/>
                  <a:pt x="4090" y="428"/>
                  <a:pt x="4108" y="446"/>
                </a:cubicBezTo>
                <a:cubicBezTo>
                  <a:pt x="4126" y="464"/>
                  <a:pt x="4138" y="486"/>
                  <a:pt x="4143" y="512"/>
                </a:cubicBezTo>
                <a:cubicBezTo>
                  <a:pt x="4149" y="538"/>
                  <a:pt x="4146" y="565"/>
                  <a:pt x="4136" y="593"/>
                </a:cubicBezTo>
                <a:cubicBezTo>
                  <a:pt x="4126" y="621"/>
                  <a:pt x="4108" y="647"/>
                  <a:pt x="4084" y="671"/>
                </a:cubicBezTo>
                <a:cubicBezTo>
                  <a:pt x="4054" y="701"/>
                  <a:pt x="4024" y="722"/>
                  <a:pt x="3995" y="734"/>
                </a:cubicBezTo>
                <a:cubicBezTo>
                  <a:pt x="3965" y="746"/>
                  <a:pt x="3936" y="748"/>
                  <a:pt x="3906" y="742"/>
                </a:cubicBezTo>
                <a:cubicBezTo>
                  <a:pt x="3877" y="736"/>
                  <a:pt x="3850" y="722"/>
                  <a:pt x="3827" y="700"/>
                </a:cubicBezTo>
                <a:close/>
                <a:moveTo>
                  <a:pt x="4406" y="338"/>
                </a:moveTo>
                <a:lnTo>
                  <a:pt x="4365" y="379"/>
                </a:lnTo>
                <a:lnTo>
                  <a:pt x="4102" y="116"/>
                </a:lnTo>
                <a:cubicBezTo>
                  <a:pt x="4101" y="136"/>
                  <a:pt x="4098" y="158"/>
                  <a:pt x="4091" y="184"/>
                </a:cubicBezTo>
                <a:cubicBezTo>
                  <a:pt x="4084" y="209"/>
                  <a:pt x="4077" y="231"/>
                  <a:pt x="4069" y="248"/>
                </a:cubicBezTo>
                <a:lnTo>
                  <a:pt x="4029" y="208"/>
                </a:lnTo>
                <a:cubicBezTo>
                  <a:pt x="4041" y="175"/>
                  <a:pt x="4048" y="141"/>
                  <a:pt x="4050" y="109"/>
                </a:cubicBezTo>
                <a:cubicBezTo>
                  <a:pt x="4052" y="76"/>
                  <a:pt x="4049" y="49"/>
                  <a:pt x="4042" y="27"/>
                </a:cubicBezTo>
                <a:lnTo>
                  <a:pt x="4068" y="0"/>
                </a:lnTo>
                <a:lnTo>
                  <a:pt x="4406" y="338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6" name="Freeform 72"/>
          <p:cNvSpPr>
            <a:spLocks noEditPoints="1"/>
          </p:cNvSpPr>
          <p:nvPr/>
        </p:nvSpPr>
        <p:spPr bwMode="auto">
          <a:xfrm>
            <a:off x="3503755" y="5034102"/>
            <a:ext cx="852487" cy="841375"/>
          </a:xfrm>
          <a:custGeom>
            <a:avLst/>
            <a:gdLst>
              <a:gd name="T0" fmla="*/ 239 w 4468"/>
              <a:gd name="T1" fmla="*/ 3878 h 4415"/>
              <a:gd name="T2" fmla="*/ 244 w 4468"/>
              <a:gd name="T3" fmla="*/ 4234 h 4415"/>
              <a:gd name="T4" fmla="*/ 337 w 4468"/>
              <a:gd name="T5" fmla="*/ 4030 h 4415"/>
              <a:gd name="T6" fmla="*/ 85 w 4468"/>
              <a:gd name="T7" fmla="*/ 4074 h 4415"/>
              <a:gd name="T8" fmla="*/ 513 w 4468"/>
              <a:gd name="T9" fmla="*/ 3586 h 4415"/>
              <a:gd name="T10" fmla="*/ 741 w 4468"/>
              <a:gd name="T11" fmla="*/ 3714 h 4415"/>
              <a:gd name="T12" fmla="*/ 780 w 4468"/>
              <a:gd name="T13" fmla="*/ 3972 h 4415"/>
              <a:gd name="T14" fmla="*/ 621 w 4468"/>
              <a:gd name="T15" fmla="*/ 3699 h 4415"/>
              <a:gd name="T16" fmla="*/ 400 w 4468"/>
              <a:gd name="T17" fmla="*/ 3759 h 4415"/>
              <a:gd name="T18" fmla="*/ 785 w 4468"/>
              <a:gd name="T19" fmla="*/ 3866 h 4415"/>
              <a:gd name="T20" fmla="*/ 618 w 4468"/>
              <a:gd name="T21" fmla="*/ 3823 h 4415"/>
              <a:gd name="T22" fmla="*/ 744 w 4468"/>
              <a:gd name="T23" fmla="*/ 3335 h 4415"/>
              <a:gd name="T24" fmla="*/ 1131 w 4468"/>
              <a:gd name="T25" fmla="*/ 3416 h 4415"/>
              <a:gd name="T26" fmla="*/ 964 w 4468"/>
              <a:gd name="T27" fmla="*/ 3787 h 4415"/>
              <a:gd name="T28" fmla="*/ 1082 w 4468"/>
              <a:gd name="T29" fmla="*/ 3458 h 4415"/>
              <a:gd name="T30" fmla="*/ 713 w 4468"/>
              <a:gd name="T31" fmla="*/ 3446 h 4415"/>
              <a:gd name="T32" fmla="*/ 1627 w 4468"/>
              <a:gd name="T33" fmla="*/ 3311 h 4415"/>
              <a:gd name="T34" fmla="*/ 1415 w 4468"/>
              <a:gd name="T35" fmla="*/ 2671 h 4415"/>
              <a:gd name="T36" fmla="*/ 1564 w 4468"/>
              <a:gd name="T37" fmla="*/ 2915 h 4415"/>
              <a:gd name="T38" fmla="*/ 1525 w 4468"/>
              <a:gd name="T39" fmla="*/ 2874 h 4415"/>
              <a:gd name="T40" fmla="*/ 1404 w 4468"/>
              <a:gd name="T41" fmla="*/ 2755 h 4415"/>
              <a:gd name="T42" fmla="*/ 1789 w 4468"/>
              <a:gd name="T43" fmla="*/ 2291 h 4415"/>
              <a:gd name="T44" fmla="*/ 1958 w 4468"/>
              <a:gd name="T45" fmla="*/ 2485 h 4415"/>
              <a:gd name="T46" fmla="*/ 1882 w 4468"/>
              <a:gd name="T47" fmla="*/ 2870 h 4415"/>
              <a:gd name="T48" fmla="*/ 2043 w 4468"/>
              <a:gd name="T49" fmla="*/ 2209 h 4415"/>
              <a:gd name="T50" fmla="*/ 2167 w 4468"/>
              <a:gd name="T51" fmla="*/ 2230 h 4415"/>
              <a:gd name="T52" fmla="*/ 2184 w 4468"/>
              <a:gd name="T53" fmla="*/ 2333 h 4415"/>
              <a:gd name="T54" fmla="*/ 2343 w 4468"/>
              <a:gd name="T55" fmla="*/ 1882 h 4415"/>
              <a:gd name="T56" fmla="*/ 2283 w 4468"/>
              <a:gd name="T57" fmla="*/ 1793 h 4415"/>
              <a:gd name="T58" fmla="*/ 2531 w 4468"/>
              <a:gd name="T59" fmla="*/ 1797 h 4415"/>
              <a:gd name="T60" fmla="*/ 2473 w 4468"/>
              <a:gd name="T61" fmla="*/ 1615 h 4415"/>
              <a:gd name="T62" fmla="*/ 2532 w 4468"/>
              <a:gd name="T63" fmla="*/ 1628 h 4415"/>
              <a:gd name="T64" fmla="*/ 2609 w 4468"/>
              <a:gd name="T65" fmla="*/ 1720 h 4415"/>
              <a:gd name="T66" fmla="*/ 2901 w 4468"/>
              <a:gd name="T67" fmla="*/ 1767 h 4415"/>
              <a:gd name="T68" fmla="*/ 2885 w 4468"/>
              <a:gd name="T69" fmla="*/ 1660 h 4415"/>
              <a:gd name="T70" fmla="*/ 2686 w 4468"/>
              <a:gd name="T71" fmla="*/ 1602 h 4415"/>
              <a:gd name="T72" fmla="*/ 2895 w 4468"/>
              <a:gd name="T73" fmla="*/ 1495 h 4415"/>
              <a:gd name="T74" fmla="*/ 2746 w 4468"/>
              <a:gd name="T75" fmla="*/ 1638 h 4415"/>
              <a:gd name="T76" fmla="*/ 2968 w 4468"/>
              <a:gd name="T77" fmla="*/ 1569 h 4415"/>
              <a:gd name="T78" fmla="*/ 2901 w 4468"/>
              <a:gd name="T79" fmla="*/ 1823 h 4415"/>
              <a:gd name="T80" fmla="*/ 2966 w 4468"/>
              <a:gd name="T81" fmla="*/ 1316 h 4415"/>
              <a:gd name="T82" fmla="*/ 2944 w 4468"/>
              <a:gd name="T83" fmla="*/ 1133 h 4415"/>
              <a:gd name="T84" fmla="*/ 3280 w 4468"/>
              <a:gd name="T85" fmla="*/ 894 h 4415"/>
              <a:gd name="T86" fmla="*/ 3569 w 4468"/>
              <a:gd name="T87" fmla="*/ 1183 h 4415"/>
              <a:gd name="T88" fmla="*/ 3485 w 4468"/>
              <a:gd name="T89" fmla="*/ 601 h 4415"/>
              <a:gd name="T90" fmla="*/ 3634 w 4468"/>
              <a:gd name="T91" fmla="*/ 844 h 4415"/>
              <a:gd name="T92" fmla="*/ 3595 w 4468"/>
              <a:gd name="T93" fmla="*/ 804 h 4415"/>
              <a:gd name="T94" fmla="*/ 3474 w 4468"/>
              <a:gd name="T95" fmla="*/ 685 h 4415"/>
              <a:gd name="T96" fmla="*/ 3922 w 4468"/>
              <a:gd name="T97" fmla="*/ 689 h 4415"/>
              <a:gd name="T98" fmla="*/ 4070 w 4468"/>
              <a:gd name="T99" fmla="*/ 499 h 4415"/>
              <a:gd name="T100" fmla="*/ 3753 w 4468"/>
              <a:gd name="T101" fmla="*/ 583 h 4415"/>
              <a:gd name="T102" fmla="*/ 3803 w 4468"/>
              <a:gd name="T103" fmla="*/ 289 h 4415"/>
              <a:gd name="T104" fmla="*/ 3767 w 4468"/>
              <a:gd name="T105" fmla="*/ 380 h 4415"/>
              <a:gd name="T106" fmla="*/ 3969 w 4468"/>
              <a:gd name="T107" fmla="*/ 428 h 4415"/>
              <a:gd name="T108" fmla="*/ 4085 w 4468"/>
              <a:gd name="T109" fmla="*/ 678 h 4415"/>
              <a:gd name="T110" fmla="*/ 4468 w 4468"/>
              <a:gd name="T111" fmla="*/ 283 h 4415"/>
              <a:gd name="T112" fmla="*/ 4211 w 4468"/>
              <a:gd name="T113" fmla="*/ 150 h 4415"/>
              <a:gd name="T114" fmla="*/ 4060 w 4468"/>
              <a:gd name="T115" fmla="*/ 219 h 4415"/>
              <a:gd name="T116" fmla="*/ 4224 w 4468"/>
              <a:gd name="T117" fmla="*/ 40 h 4415"/>
              <a:gd name="T118" fmla="*/ 4264 w 4468"/>
              <a:gd name="T119" fmla="*/ 409 h 441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</a:cxnLst>
            <a:rect l="0" t="0" r="r" b="b"/>
            <a:pathLst>
              <a:path w="4468" h="4415">
                <a:moveTo>
                  <a:pt x="337" y="4415"/>
                </a:moveTo>
                <a:lnTo>
                  <a:pt x="0" y="4079"/>
                </a:lnTo>
                <a:lnTo>
                  <a:pt x="127" y="3952"/>
                </a:lnTo>
                <a:cubicBezTo>
                  <a:pt x="150" y="3930"/>
                  <a:pt x="168" y="3914"/>
                  <a:pt x="182" y="3904"/>
                </a:cubicBezTo>
                <a:cubicBezTo>
                  <a:pt x="201" y="3890"/>
                  <a:pt x="220" y="3882"/>
                  <a:pt x="239" y="3878"/>
                </a:cubicBezTo>
                <a:cubicBezTo>
                  <a:pt x="258" y="3875"/>
                  <a:pt x="277" y="3877"/>
                  <a:pt x="298" y="3884"/>
                </a:cubicBezTo>
                <a:cubicBezTo>
                  <a:pt x="319" y="3891"/>
                  <a:pt x="338" y="3903"/>
                  <a:pt x="354" y="3920"/>
                </a:cubicBezTo>
                <a:cubicBezTo>
                  <a:pt x="383" y="3948"/>
                  <a:pt x="398" y="3981"/>
                  <a:pt x="399" y="4019"/>
                </a:cubicBezTo>
                <a:cubicBezTo>
                  <a:pt x="401" y="4057"/>
                  <a:pt x="378" y="4100"/>
                  <a:pt x="331" y="4148"/>
                </a:cubicBezTo>
                <a:lnTo>
                  <a:pt x="244" y="4234"/>
                </a:lnTo>
                <a:lnTo>
                  <a:pt x="381" y="4371"/>
                </a:lnTo>
                <a:lnTo>
                  <a:pt x="337" y="4415"/>
                </a:lnTo>
                <a:close/>
                <a:moveTo>
                  <a:pt x="205" y="4194"/>
                </a:moveTo>
                <a:lnTo>
                  <a:pt x="292" y="4107"/>
                </a:lnTo>
                <a:cubicBezTo>
                  <a:pt x="320" y="4079"/>
                  <a:pt x="335" y="4053"/>
                  <a:pt x="337" y="4030"/>
                </a:cubicBezTo>
                <a:cubicBezTo>
                  <a:pt x="338" y="4007"/>
                  <a:pt x="329" y="3986"/>
                  <a:pt x="310" y="3967"/>
                </a:cubicBezTo>
                <a:cubicBezTo>
                  <a:pt x="296" y="3953"/>
                  <a:pt x="280" y="3944"/>
                  <a:pt x="263" y="3941"/>
                </a:cubicBezTo>
                <a:cubicBezTo>
                  <a:pt x="246" y="3938"/>
                  <a:pt x="230" y="3941"/>
                  <a:pt x="215" y="3950"/>
                </a:cubicBezTo>
                <a:cubicBezTo>
                  <a:pt x="206" y="3955"/>
                  <a:pt x="191" y="3968"/>
                  <a:pt x="171" y="3988"/>
                </a:cubicBezTo>
                <a:lnTo>
                  <a:pt x="85" y="4074"/>
                </a:lnTo>
                <a:lnTo>
                  <a:pt x="205" y="4194"/>
                </a:lnTo>
                <a:close/>
                <a:moveTo>
                  <a:pt x="652" y="4100"/>
                </a:moveTo>
                <a:lnTo>
                  <a:pt x="315" y="3764"/>
                </a:lnTo>
                <a:lnTo>
                  <a:pt x="442" y="3638"/>
                </a:lnTo>
                <a:cubicBezTo>
                  <a:pt x="467" y="3612"/>
                  <a:pt x="491" y="3595"/>
                  <a:pt x="513" y="3586"/>
                </a:cubicBezTo>
                <a:cubicBezTo>
                  <a:pt x="536" y="3578"/>
                  <a:pt x="558" y="3576"/>
                  <a:pt x="581" y="3581"/>
                </a:cubicBezTo>
                <a:cubicBezTo>
                  <a:pt x="604" y="3587"/>
                  <a:pt x="623" y="3597"/>
                  <a:pt x="639" y="3612"/>
                </a:cubicBezTo>
                <a:cubicBezTo>
                  <a:pt x="653" y="3627"/>
                  <a:pt x="663" y="3644"/>
                  <a:pt x="668" y="3665"/>
                </a:cubicBezTo>
                <a:cubicBezTo>
                  <a:pt x="673" y="3685"/>
                  <a:pt x="671" y="3707"/>
                  <a:pt x="663" y="3731"/>
                </a:cubicBezTo>
                <a:cubicBezTo>
                  <a:pt x="689" y="3716"/>
                  <a:pt x="715" y="3711"/>
                  <a:pt x="741" y="3714"/>
                </a:cubicBezTo>
                <a:cubicBezTo>
                  <a:pt x="766" y="3718"/>
                  <a:pt x="788" y="3729"/>
                  <a:pt x="808" y="3749"/>
                </a:cubicBezTo>
                <a:cubicBezTo>
                  <a:pt x="824" y="3765"/>
                  <a:pt x="835" y="3783"/>
                  <a:pt x="842" y="3803"/>
                </a:cubicBezTo>
                <a:cubicBezTo>
                  <a:pt x="849" y="3823"/>
                  <a:pt x="851" y="3842"/>
                  <a:pt x="848" y="3859"/>
                </a:cubicBezTo>
                <a:cubicBezTo>
                  <a:pt x="846" y="3876"/>
                  <a:pt x="839" y="3894"/>
                  <a:pt x="828" y="3912"/>
                </a:cubicBezTo>
                <a:cubicBezTo>
                  <a:pt x="817" y="3931"/>
                  <a:pt x="801" y="3951"/>
                  <a:pt x="780" y="3972"/>
                </a:cubicBezTo>
                <a:lnTo>
                  <a:pt x="652" y="4100"/>
                </a:lnTo>
                <a:close/>
                <a:moveTo>
                  <a:pt x="501" y="3861"/>
                </a:moveTo>
                <a:lnTo>
                  <a:pt x="574" y="3788"/>
                </a:lnTo>
                <a:cubicBezTo>
                  <a:pt x="594" y="3768"/>
                  <a:pt x="606" y="3753"/>
                  <a:pt x="612" y="3742"/>
                </a:cubicBezTo>
                <a:cubicBezTo>
                  <a:pt x="620" y="3727"/>
                  <a:pt x="623" y="3713"/>
                  <a:pt x="621" y="3699"/>
                </a:cubicBezTo>
                <a:cubicBezTo>
                  <a:pt x="619" y="3686"/>
                  <a:pt x="612" y="3673"/>
                  <a:pt x="600" y="3661"/>
                </a:cubicBezTo>
                <a:cubicBezTo>
                  <a:pt x="589" y="3650"/>
                  <a:pt x="577" y="3643"/>
                  <a:pt x="563" y="3640"/>
                </a:cubicBezTo>
                <a:cubicBezTo>
                  <a:pt x="549" y="3637"/>
                  <a:pt x="536" y="3639"/>
                  <a:pt x="523" y="3646"/>
                </a:cubicBezTo>
                <a:cubicBezTo>
                  <a:pt x="509" y="3652"/>
                  <a:pt x="491" y="3668"/>
                  <a:pt x="467" y="3692"/>
                </a:cubicBezTo>
                <a:lnTo>
                  <a:pt x="400" y="3759"/>
                </a:lnTo>
                <a:lnTo>
                  <a:pt x="501" y="3861"/>
                </a:lnTo>
                <a:close/>
                <a:moveTo>
                  <a:pt x="656" y="4016"/>
                </a:moveTo>
                <a:lnTo>
                  <a:pt x="740" y="3932"/>
                </a:lnTo>
                <a:cubicBezTo>
                  <a:pt x="754" y="3918"/>
                  <a:pt x="764" y="3907"/>
                  <a:pt x="769" y="3900"/>
                </a:cubicBezTo>
                <a:cubicBezTo>
                  <a:pt x="777" y="3888"/>
                  <a:pt x="783" y="3877"/>
                  <a:pt x="785" y="3866"/>
                </a:cubicBezTo>
                <a:cubicBezTo>
                  <a:pt x="788" y="3854"/>
                  <a:pt x="787" y="3842"/>
                  <a:pt x="783" y="3830"/>
                </a:cubicBezTo>
                <a:cubicBezTo>
                  <a:pt x="780" y="3817"/>
                  <a:pt x="772" y="3806"/>
                  <a:pt x="762" y="3795"/>
                </a:cubicBezTo>
                <a:cubicBezTo>
                  <a:pt x="749" y="3782"/>
                  <a:pt x="735" y="3775"/>
                  <a:pt x="719" y="3772"/>
                </a:cubicBezTo>
                <a:cubicBezTo>
                  <a:pt x="704" y="3769"/>
                  <a:pt x="688" y="3771"/>
                  <a:pt x="673" y="3779"/>
                </a:cubicBezTo>
                <a:cubicBezTo>
                  <a:pt x="658" y="3787"/>
                  <a:pt x="640" y="3801"/>
                  <a:pt x="618" y="3823"/>
                </a:cubicBezTo>
                <a:lnTo>
                  <a:pt x="541" y="3900"/>
                </a:lnTo>
                <a:lnTo>
                  <a:pt x="656" y="4016"/>
                </a:lnTo>
                <a:close/>
                <a:moveTo>
                  <a:pt x="964" y="3787"/>
                </a:moveTo>
                <a:lnTo>
                  <a:pt x="628" y="3451"/>
                </a:lnTo>
                <a:lnTo>
                  <a:pt x="744" y="3335"/>
                </a:lnTo>
                <a:cubicBezTo>
                  <a:pt x="770" y="3309"/>
                  <a:pt x="792" y="3291"/>
                  <a:pt x="809" y="3280"/>
                </a:cubicBezTo>
                <a:cubicBezTo>
                  <a:pt x="832" y="3265"/>
                  <a:pt x="857" y="3257"/>
                  <a:pt x="882" y="3255"/>
                </a:cubicBezTo>
                <a:cubicBezTo>
                  <a:pt x="915" y="3252"/>
                  <a:pt x="947" y="3258"/>
                  <a:pt x="979" y="3273"/>
                </a:cubicBezTo>
                <a:cubicBezTo>
                  <a:pt x="1011" y="3287"/>
                  <a:pt x="1042" y="3309"/>
                  <a:pt x="1072" y="3339"/>
                </a:cubicBezTo>
                <a:cubicBezTo>
                  <a:pt x="1098" y="3365"/>
                  <a:pt x="1118" y="3390"/>
                  <a:pt x="1131" y="3416"/>
                </a:cubicBezTo>
                <a:cubicBezTo>
                  <a:pt x="1145" y="3442"/>
                  <a:pt x="1154" y="3466"/>
                  <a:pt x="1157" y="3488"/>
                </a:cubicBezTo>
                <a:cubicBezTo>
                  <a:pt x="1161" y="3510"/>
                  <a:pt x="1161" y="3531"/>
                  <a:pt x="1157" y="3549"/>
                </a:cubicBezTo>
                <a:cubicBezTo>
                  <a:pt x="1154" y="3568"/>
                  <a:pt x="1146" y="3587"/>
                  <a:pt x="1134" y="3606"/>
                </a:cubicBezTo>
                <a:cubicBezTo>
                  <a:pt x="1122" y="3626"/>
                  <a:pt x="1106" y="3645"/>
                  <a:pt x="1086" y="3666"/>
                </a:cubicBezTo>
                <a:lnTo>
                  <a:pt x="964" y="3787"/>
                </a:lnTo>
                <a:close/>
                <a:moveTo>
                  <a:pt x="969" y="3703"/>
                </a:moveTo>
                <a:lnTo>
                  <a:pt x="1041" y="3631"/>
                </a:lnTo>
                <a:cubicBezTo>
                  <a:pt x="1063" y="3609"/>
                  <a:pt x="1079" y="3590"/>
                  <a:pt x="1087" y="3573"/>
                </a:cubicBezTo>
                <a:cubicBezTo>
                  <a:pt x="1095" y="3556"/>
                  <a:pt x="1100" y="3540"/>
                  <a:pt x="1100" y="3525"/>
                </a:cubicBezTo>
                <a:cubicBezTo>
                  <a:pt x="1100" y="3504"/>
                  <a:pt x="1094" y="3482"/>
                  <a:pt x="1082" y="3458"/>
                </a:cubicBezTo>
                <a:cubicBezTo>
                  <a:pt x="1070" y="3434"/>
                  <a:pt x="1051" y="3410"/>
                  <a:pt x="1026" y="3385"/>
                </a:cubicBezTo>
                <a:cubicBezTo>
                  <a:pt x="991" y="3349"/>
                  <a:pt x="958" y="3328"/>
                  <a:pt x="928" y="3321"/>
                </a:cubicBezTo>
                <a:cubicBezTo>
                  <a:pt x="897" y="3313"/>
                  <a:pt x="870" y="3315"/>
                  <a:pt x="848" y="3325"/>
                </a:cubicBezTo>
                <a:cubicBezTo>
                  <a:pt x="831" y="3332"/>
                  <a:pt x="810" y="3349"/>
                  <a:pt x="783" y="3376"/>
                </a:cubicBezTo>
                <a:lnTo>
                  <a:pt x="713" y="3446"/>
                </a:lnTo>
                <a:lnTo>
                  <a:pt x="969" y="3703"/>
                </a:lnTo>
                <a:close/>
                <a:moveTo>
                  <a:pt x="1354" y="3584"/>
                </a:moveTo>
                <a:lnTo>
                  <a:pt x="1324" y="3555"/>
                </a:lnTo>
                <a:lnTo>
                  <a:pt x="1598" y="3281"/>
                </a:lnTo>
                <a:lnTo>
                  <a:pt x="1627" y="3311"/>
                </a:lnTo>
                <a:lnTo>
                  <a:pt x="1354" y="3584"/>
                </a:lnTo>
                <a:close/>
                <a:moveTo>
                  <a:pt x="1570" y="3182"/>
                </a:moveTo>
                <a:lnTo>
                  <a:pt x="1234" y="2846"/>
                </a:lnTo>
                <a:lnTo>
                  <a:pt x="1360" y="2719"/>
                </a:lnTo>
                <a:cubicBezTo>
                  <a:pt x="1383" y="2697"/>
                  <a:pt x="1401" y="2681"/>
                  <a:pt x="1415" y="2671"/>
                </a:cubicBezTo>
                <a:cubicBezTo>
                  <a:pt x="1434" y="2657"/>
                  <a:pt x="1453" y="2649"/>
                  <a:pt x="1472" y="2645"/>
                </a:cubicBezTo>
                <a:cubicBezTo>
                  <a:pt x="1491" y="2642"/>
                  <a:pt x="1511" y="2644"/>
                  <a:pt x="1531" y="2651"/>
                </a:cubicBezTo>
                <a:cubicBezTo>
                  <a:pt x="1552" y="2658"/>
                  <a:pt x="1571" y="2670"/>
                  <a:pt x="1587" y="2686"/>
                </a:cubicBezTo>
                <a:cubicBezTo>
                  <a:pt x="1616" y="2715"/>
                  <a:pt x="1631" y="2748"/>
                  <a:pt x="1633" y="2786"/>
                </a:cubicBezTo>
                <a:cubicBezTo>
                  <a:pt x="1634" y="2824"/>
                  <a:pt x="1611" y="2867"/>
                  <a:pt x="1564" y="2915"/>
                </a:cubicBezTo>
                <a:lnTo>
                  <a:pt x="1478" y="3001"/>
                </a:lnTo>
                <a:lnTo>
                  <a:pt x="1614" y="3137"/>
                </a:lnTo>
                <a:lnTo>
                  <a:pt x="1570" y="3182"/>
                </a:lnTo>
                <a:close/>
                <a:moveTo>
                  <a:pt x="1438" y="2961"/>
                </a:moveTo>
                <a:lnTo>
                  <a:pt x="1525" y="2874"/>
                </a:lnTo>
                <a:cubicBezTo>
                  <a:pt x="1554" y="2845"/>
                  <a:pt x="1569" y="2820"/>
                  <a:pt x="1570" y="2797"/>
                </a:cubicBezTo>
                <a:cubicBezTo>
                  <a:pt x="1571" y="2774"/>
                  <a:pt x="1562" y="2753"/>
                  <a:pt x="1543" y="2734"/>
                </a:cubicBezTo>
                <a:cubicBezTo>
                  <a:pt x="1529" y="2720"/>
                  <a:pt x="1513" y="2711"/>
                  <a:pt x="1496" y="2708"/>
                </a:cubicBezTo>
                <a:cubicBezTo>
                  <a:pt x="1479" y="2705"/>
                  <a:pt x="1463" y="2708"/>
                  <a:pt x="1448" y="2716"/>
                </a:cubicBezTo>
                <a:cubicBezTo>
                  <a:pt x="1439" y="2722"/>
                  <a:pt x="1424" y="2735"/>
                  <a:pt x="1404" y="2755"/>
                </a:cubicBezTo>
                <a:lnTo>
                  <a:pt x="1318" y="2841"/>
                </a:lnTo>
                <a:lnTo>
                  <a:pt x="1438" y="2961"/>
                </a:lnTo>
                <a:close/>
                <a:moveTo>
                  <a:pt x="1882" y="2870"/>
                </a:moveTo>
                <a:lnTo>
                  <a:pt x="1546" y="2534"/>
                </a:lnTo>
                <a:lnTo>
                  <a:pt x="1789" y="2291"/>
                </a:lnTo>
                <a:lnTo>
                  <a:pt x="1828" y="2330"/>
                </a:lnTo>
                <a:lnTo>
                  <a:pt x="1630" y="2529"/>
                </a:lnTo>
                <a:lnTo>
                  <a:pt x="1733" y="2632"/>
                </a:lnTo>
                <a:lnTo>
                  <a:pt x="1919" y="2446"/>
                </a:lnTo>
                <a:lnTo>
                  <a:pt x="1958" y="2485"/>
                </a:lnTo>
                <a:lnTo>
                  <a:pt x="1772" y="2671"/>
                </a:lnTo>
                <a:lnTo>
                  <a:pt x="1887" y="2786"/>
                </a:lnTo>
                <a:lnTo>
                  <a:pt x="2093" y="2579"/>
                </a:lnTo>
                <a:lnTo>
                  <a:pt x="2133" y="2619"/>
                </a:lnTo>
                <a:lnTo>
                  <a:pt x="1882" y="2870"/>
                </a:lnTo>
                <a:close/>
                <a:moveTo>
                  <a:pt x="2163" y="2588"/>
                </a:moveTo>
                <a:lnTo>
                  <a:pt x="2118" y="2283"/>
                </a:lnTo>
                <a:lnTo>
                  <a:pt x="1843" y="2237"/>
                </a:lnTo>
                <a:lnTo>
                  <a:pt x="1896" y="2184"/>
                </a:lnTo>
                <a:lnTo>
                  <a:pt x="2043" y="2209"/>
                </a:lnTo>
                <a:cubicBezTo>
                  <a:pt x="2073" y="2214"/>
                  <a:pt x="2096" y="2219"/>
                  <a:pt x="2111" y="2223"/>
                </a:cubicBezTo>
                <a:cubicBezTo>
                  <a:pt x="2106" y="2203"/>
                  <a:pt x="2103" y="2182"/>
                  <a:pt x="2100" y="2158"/>
                </a:cubicBezTo>
                <a:lnTo>
                  <a:pt x="2078" y="2001"/>
                </a:lnTo>
                <a:lnTo>
                  <a:pt x="2126" y="1953"/>
                </a:lnTo>
                <a:lnTo>
                  <a:pt x="2167" y="2230"/>
                </a:lnTo>
                <a:lnTo>
                  <a:pt x="2472" y="2280"/>
                </a:lnTo>
                <a:lnTo>
                  <a:pt x="2417" y="2335"/>
                </a:lnTo>
                <a:lnTo>
                  <a:pt x="2212" y="2300"/>
                </a:lnTo>
                <a:cubicBezTo>
                  <a:pt x="2200" y="2298"/>
                  <a:pt x="2188" y="2295"/>
                  <a:pt x="2175" y="2292"/>
                </a:cubicBezTo>
                <a:cubicBezTo>
                  <a:pt x="2180" y="2312"/>
                  <a:pt x="2183" y="2325"/>
                  <a:pt x="2184" y="2333"/>
                </a:cubicBezTo>
                <a:lnTo>
                  <a:pt x="2217" y="2535"/>
                </a:lnTo>
                <a:lnTo>
                  <a:pt x="2163" y="2588"/>
                </a:lnTo>
                <a:close/>
                <a:moveTo>
                  <a:pt x="2647" y="2104"/>
                </a:moveTo>
                <a:lnTo>
                  <a:pt x="2606" y="2145"/>
                </a:lnTo>
                <a:lnTo>
                  <a:pt x="2343" y="1882"/>
                </a:lnTo>
                <a:cubicBezTo>
                  <a:pt x="2343" y="1902"/>
                  <a:pt x="2339" y="1924"/>
                  <a:pt x="2333" y="1950"/>
                </a:cubicBezTo>
                <a:cubicBezTo>
                  <a:pt x="2326" y="1976"/>
                  <a:pt x="2319" y="1997"/>
                  <a:pt x="2310" y="2015"/>
                </a:cubicBezTo>
                <a:lnTo>
                  <a:pt x="2271" y="1975"/>
                </a:lnTo>
                <a:cubicBezTo>
                  <a:pt x="2283" y="1941"/>
                  <a:pt x="2290" y="1908"/>
                  <a:pt x="2292" y="1875"/>
                </a:cubicBezTo>
                <a:cubicBezTo>
                  <a:pt x="2294" y="1842"/>
                  <a:pt x="2291" y="1815"/>
                  <a:pt x="2283" y="1793"/>
                </a:cubicBezTo>
                <a:lnTo>
                  <a:pt x="2310" y="1767"/>
                </a:lnTo>
                <a:lnTo>
                  <a:pt x="2647" y="2104"/>
                </a:lnTo>
                <a:close/>
                <a:moveTo>
                  <a:pt x="2779" y="1972"/>
                </a:moveTo>
                <a:lnTo>
                  <a:pt x="2568" y="1761"/>
                </a:lnTo>
                <a:lnTo>
                  <a:pt x="2531" y="1797"/>
                </a:lnTo>
                <a:lnTo>
                  <a:pt x="2499" y="1765"/>
                </a:lnTo>
                <a:lnTo>
                  <a:pt x="2536" y="1729"/>
                </a:lnTo>
                <a:lnTo>
                  <a:pt x="2510" y="1703"/>
                </a:lnTo>
                <a:cubicBezTo>
                  <a:pt x="2494" y="1687"/>
                  <a:pt x="2483" y="1673"/>
                  <a:pt x="2478" y="1662"/>
                </a:cubicBezTo>
                <a:cubicBezTo>
                  <a:pt x="2471" y="1647"/>
                  <a:pt x="2469" y="1632"/>
                  <a:pt x="2473" y="1615"/>
                </a:cubicBezTo>
                <a:cubicBezTo>
                  <a:pt x="2476" y="1598"/>
                  <a:pt x="2487" y="1581"/>
                  <a:pt x="2505" y="1563"/>
                </a:cubicBezTo>
                <a:cubicBezTo>
                  <a:pt x="2516" y="1551"/>
                  <a:pt x="2531" y="1540"/>
                  <a:pt x="2547" y="1529"/>
                </a:cubicBezTo>
                <a:lnTo>
                  <a:pt x="2577" y="1571"/>
                </a:lnTo>
                <a:cubicBezTo>
                  <a:pt x="2567" y="1578"/>
                  <a:pt x="2558" y="1585"/>
                  <a:pt x="2551" y="1593"/>
                </a:cubicBezTo>
                <a:cubicBezTo>
                  <a:pt x="2538" y="1605"/>
                  <a:pt x="2532" y="1617"/>
                  <a:pt x="2532" y="1628"/>
                </a:cubicBezTo>
                <a:cubicBezTo>
                  <a:pt x="2532" y="1638"/>
                  <a:pt x="2540" y="1651"/>
                  <a:pt x="2554" y="1665"/>
                </a:cubicBezTo>
                <a:lnTo>
                  <a:pt x="2577" y="1688"/>
                </a:lnTo>
                <a:lnTo>
                  <a:pt x="2624" y="1640"/>
                </a:lnTo>
                <a:lnTo>
                  <a:pt x="2656" y="1672"/>
                </a:lnTo>
                <a:lnTo>
                  <a:pt x="2609" y="1720"/>
                </a:lnTo>
                <a:lnTo>
                  <a:pt x="2820" y="1931"/>
                </a:lnTo>
                <a:lnTo>
                  <a:pt x="2779" y="1972"/>
                </a:lnTo>
                <a:close/>
                <a:moveTo>
                  <a:pt x="2810" y="1796"/>
                </a:moveTo>
                <a:lnTo>
                  <a:pt x="2845" y="1749"/>
                </a:lnTo>
                <a:cubicBezTo>
                  <a:pt x="2863" y="1763"/>
                  <a:pt x="2882" y="1769"/>
                  <a:pt x="2901" y="1767"/>
                </a:cubicBezTo>
                <a:cubicBezTo>
                  <a:pt x="2921" y="1765"/>
                  <a:pt x="2940" y="1755"/>
                  <a:pt x="2958" y="1736"/>
                </a:cubicBezTo>
                <a:cubicBezTo>
                  <a:pt x="2977" y="1717"/>
                  <a:pt x="2988" y="1699"/>
                  <a:pt x="2989" y="1683"/>
                </a:cubicBezTo>
                <a:cubicBezTo>
                  <a:pt x="2990" y="1666"/>
                  <a:pt x="2986" y="1652"/>
                  <a:pt x="2976" y="1642"/>
                </a:cubicBezTo>
                <a:cubicBezTo>
                  <a:pt x="2966" y="1632"/>
                  <a:pt x="2955" y="1629"/>
                  <a:pt x="2941" y="1632"/>
                </a:cubicBezTo>
                <a:cubicBezTo>
                  <a:pt x="2932" y="1634"/>
                  <a:pt x="2913" y="1643"/>
                  <a:pt x="2885" y="1660"/>
                </a:cubicBezTo>
                <a:cubicBezTo>
                  <a:pt x="2847" y="1683"/>
                  <a:pt x="2820" y="1697"/>
                  <a:pt x="2803" y="1703"/>
                </a:cubicBezTo>
                <a:cubicBezTo>
                  <a:pt x="2785" y="1709"/>
                  <a:pt x="2769" y="1710"/>
                  <a:pt x="2753" y="1706"/>
                </a:cubicBezTo>
                <a:cubicBezTo>
                  <a:pt x="2737" y="1703"/>
                  <a:pt x="2723" y="1695"/>
                  <a:pt x="2711" y="1683"/>
                </a:cubicBezTo>
                <a:cubicBezTo>
                  <a:pt x="2700" y="1672"/>
                  <a:pt x="2693" y="1659"/>
                  <a:pt x="2688" y="1645"/>
                </a:cubicBezTo>
                <a:cubicBezTo>
                  <a:pt x="2684" y="1631"/>
                  <a:pt x="2683" y="1617"/>
                  <a:pt x="2686" y="1602"/>
                </a:cubicBezTo>
                <a:cubicBezTo>
                  <a:pt x="2687" y="1591"/>
                  <a:pt x="2692" y="1578"/>
                  <a:pt x="2700" y="1564"/>
                </a:cubicBezTo>
                <a:cubicBezTo>
                  <a:pt x="2708" y="1549"/>
                  <a:pt x="2718" y="1536"/>
                  <a:pt x="2731" y="1523"/>
                </a:cubicBezTo>
                <a:cubicBezTo>
                  <a:pt x="2750" y="1504"/>
                  <a:pt x="2769" y="1490"/>
                  <a:pt x="2789" y="1481"/>
                </a:cubicBezTo>
                <a:cubicBezTo>
                  <a:pt x="2809" y="1472"/>
                  <a:pt x="2827" y="1469"/>
                  <a:pt x="2843" y="1471"/>
                </a:cubicBezTo>
                <a:cubicBezTo>
                  <a:pt x="2860" y="1474"/>
                  <a:pt x="2877" y="1482"/>
                  <a:pt x="2895" y="1495"/>
                </a:cubicBezTo>
                <a:lnTo>
                  <a:pt x="2861" y="1541"/>
                </a:lnTo>
                <a:cubicBezTo>
                  <a:pt x="2846" y="1530"/>
                  <a:pt x="2831" y="1526"/>
                  <a:pt x="2815" y="1527"/>
                </a:cubicBezTo>
                <a:cubicBezTo>
                  <a:pt x="2799" y="1529"/>
                  <a:pt x="2783" y="1538"/>
                  <a:pt x="2767" y="1554"/>
                </a:cubicBezTo>
                <a:cubicBezTo>
                  <a:pt x="2748" y="1573"/>
                  <a:pt x="2738" y="1590"/>
                  <a:pt x="2736" y="1604"/>
                </a:cubicBezTo>
                <a:cubicBezTo>
                  <a:pt x="2734" y="1618"/>
                  <a:pt x="2738" y="1630"/>
                  <a:pt x="2746" y="1638"/>
                </a:cubicBezTo>
                <a:cubicBezTo>
                  <a:pt x="2751" y="1644"/>
                  <a:pt x="2758" y="1647"/>
                  <a:pt x="2766" y="1648"/>
                </a:cubicBezTo>
                <a:cubicBezTo>
                  <a:pt x="2773" y="1649"/>
                  <a:pt x="2782" y="1647"/>
                  <a:pt x="2792" y="1643"/>
                </a:cubicBezTo>
                <a:cubicBezTo>
                  <a:pt x="2798" y="1640"/>
                  <a:pt x="2814" y="1632"/>
                  <a:pt x="2839" y="1617"/>
                </a:cubicBezTo>
                <a:cubicBezTo>
                  <a:pt x="2876" y="1595"/>
                  <a:pt x="2903" y="1581"/>
                  <a:pt x="2920" y="1575"/>
                </a:cubicBezTo>
                <a:cubicBezTo>
                  <a:pt x="2936" y="1568"/>
                  <a:pt x="2952" y="1566"/>
                  <a:pt x="2968" y="1569"/>
                </a:cubicBezTo>
                <a:cubicBezTo>
                  <a:pt x="2985" y="1572"/>
                  <a:pt x="3000" y="1581"/>
                  <a:pt x="3014" y="1595"/>
                </a:cubicBezTo>
                <a:cubicBezTo>
                  <a:pt x="3027" y="1609"/>
                  <a:pt x="3036" y="1626"/>
                  <a:pt x="3040" y="1646"/>
                </a:cubicBezTo>
                <a:cubicBezTo>
                  <a:pt x="3045" y="1666"/>
                  <a:pt x="3042" y="1687"/>
                  <a:pt x="3034" y="1709"/>
                </a:cubicBezTo>
                <a:cubicBezTo>
                  <a:pt x="3025" y="1730"/>
                  <a:pt x="3012" y="1751"/>
                  <a:pt x="2993" y="1770"/>
                </a:cubicBezTo>
                <a:cubicBezTo>
                  <a:pt x="2961" y="1802"/>
                  <a:pt x="2930" y="1819"/>
                  <a:pt x="2901" y="1823"/>
                </a:cubicBezTo>
                <a:cubicBezTo>
                  <a:pt x="2871" y="1826"/>
                  <a:pt x="2841" y="1817"/>
                  <a:pt x="2810" y="1796"/>
                </a:cubicBezTo>
                <a:close/>
                <a:moveTo>
                  <a:pt x="3281" y="1471"/>
                </a:moveTo>
                <a:lnTo>
                  <a:pt x="3240" y="1512"/>
                </a:lnTo>
                <a:lnTo>
                  <a:pt x="2977" y="1249"/>
                </a:lnTo>
                <a:cubicBezTo>
                  <a:pt x="2976" y="1268"/>
                  <a:pt x="2973" y="1291"/>
                  <a:pt x="2966" y="1316"/>
                </a:cubicBezTo>
                <a:cubicBezTo>
                  <a:pt x="2960" y="1342"/>
                  <a:pt x="2952" y="1364"/>
                  <a:pt x="2944" y="1381"/>
                </a:cubicBezTo>
                <a:lnTo>
                  <a:pt x="2904" y="1341"/>
                </a:lnTo>
                <a:cubicBezTo>
                  <a:pt x="2916" y="1307"/>
                  <a:pt x="2923" y="1274"/>
                  <a:pt x="2925" y="1241"/>
                </a:cubicBezTo>
                <a:cubicBezTo>
                  <a:pt x="2927" y="1209"/>
                  <a:pt x="2924" y="1181"/>
                  <a:pt x="2917" y="1160"/>
                </a:cubicBezTo>
                <a:lnTo>
                  <a:pt x="2944" y="1133"/>
                </a:lnTo>
                <a:lnTo>
                  <a:pt x="3281" y="1471"/>
                </a:lnTo>
                <a:close/>
                <a:moveTo>
                  <a:pt x="3239" y="935"/>
                </a:moveTo>
                <a:lnTo>
                  <a:pt x="3192" y="888"/>
                </a:lnTo>
                <a:lnTo>
                  <a:pt x="3233" y="847"/>
                </a:lnTo>
                <a:lnTo>
                  <a:pt x="3280" y="894"/>
                </a:lnTo>
                <a:lnTo>
                  <a:pt x="3239" y="935"/>
                </a:lnTo>
                <a:close/>
                <a:moveTo>
                  <a:pt x="3528" y="1224"/>
                </a:moveTo>
                <a:lnTo>
                  <a:pt x="3284" y="980"/>
                </a:lnTo>
                <a:lnTo>
                  <a:pt x="3325" y="939"/>
                </a:lnTo>
                <a:lnTo>
                  <a:pt x="3569" y="1183"/>
                </a:lnTo>
                <a:lnTo>
                  <a:pt x="3528" y="1224"/>
                </a:lnTo>
                <a:close/>
                <a:moveTo>
                  <a:pt x="3640" y="1111"/>
                </a:moveTo>
                <a:lnTo>
                  <a:pt x="3304" y="775"/>
                </a:lnTo>
                <a:lnTo>
                  <a:pt x="3431" y="649"/>
                </a:lnTo>
                <a:cubicBezTo>
                  <a:pt x="3453" y="626"/>
                  <a:pt x="3471" y="610"/>
                  <a:pt x="3485" y="601"/>
                </a:cubicBezTo>
                <a:cubicBezTo>
                  <a:pt x="3504" y="587"/>
                  <a:pt x="3524" y="578"/>
                  <a:pt x="3542" y="575"/>
                </a:cubicBezTo>
                <a:cubicBezTo>
                  <a:pt x="3561" y="571"/>
                  <a:pt x="3581" y="573"/>
                  <a:pt x="3602" y="580"/>
                </a:cubicBezTo>
                <a:cubicBezTo>
                  <a:pt x="3622" y="587"/>
                  <a:pt x="3641" y="599"/>
                  <a:pt x="3658" y="616"/>
                </a:cubicBezTo>
                <a:cubicBezTo>
                  <a:pt x="3686" y="645"/>
                  <a:pt x="3701" y="678"/>
                  <a:pt x="3703" y="716"/>
                </a:cubicBezTo>
                <a:cubicBezTo>
                  <a:pt x="3705" y="754"/>
                  <a:pt x="3682" y="797"/>
                  <a:pt x="3634" y="844"/>
                </a:cubicBezTo>
                <a:lnTo>
                  <a:pt x="3548" y="930"/>
                </a:lnTo>
                <a:lnTo>
                  <a:pt x="3685" y="1067"/>
                </a:lnTo>
                <a:lnTo>
                  <a:pt x="3640" y="1111"/>
                </a:lnTo>
                <a:close/>
                <a:moveTo>
                  <a:pt x="3508" y="891"/>
                </a:moveTo>
                <a:lnTo>
                  <a:pt x="3595" y="804"/>
                </a:lnTo>
                <a:cubicBezTo>
                  <a:pt x="3624" y="775"/>
                  <a:pt x="3639" y="749"/>
                  <a:pt x="3640" y="726"/>
                </a:cubicBezTo>
                <a:cubicBezTo>
                  <a:pt x="3642" y="704"/>
                  <a:pt x="3633" y="683"/>
                  <a:pt x="3613" y="663"/>
                </a:cubicBezTo>
                <a:cubicBezTo>
                  <a:pt x="3599" y="649"/>
                  <a:pt x="3584" y="641"/>
                  <a:pt x="3567" y="638"/>
                </a:cubicBezTo>
                <a:cubicBezTo>
                  <a:pt x="3549" y="635"/>
                  <a:pt x="3533" y="638"/>
                  <a:pt x="3519" y="646"/>
                </a:cubicBezTo>
                <a:cubicBezTo>
                  <a:pt x="3509" y="652"/>
                  <a:pt x="3494" y="664"/>
                  <a:pt x="3474" y="685"/>
                </a:cubicBezTo>
                <a:lnTo>
                  <a:pt x="3388" y="771"/>
                </a:lnTo>
                <a:lnTo>
                  <a:pt x="3508" y="891"/>
                </a:lnTo>
                <a:close/>
                <a:moveTo>
                  <a:pt x="3828" y="707"/>
                </a:moveTo>
                <a:lnTo>
                  <a:pt x="3866" y="662"/>
                </a:lnTo>
                <a:cubicBezTo>
                  <a:pt x="3885" y="677"/>
                  <a:pt x="3904" y="686"/>
                  <a:pt x="3922" y="689"/>
                </a:cubicBezTo>
                <a:cubicBezTo>
                  <a:pt x="3940" y="693"/>
                  <a:pt x="3960" y="690"/>
                  <a:pt x="3982" y="682"/>
                </a:cubicBezTo>
                <a:cubicBezTo>
                  <a:pt x="4004" y="673"/>
                  <a:pt x="4024" y="659"/>
                  <a:pt x="4043" y="640"/>
                </a:cubicBezTo>
                <a:cubicBezTo>
                  <a:pt x="4060" y="623"/>
                  <a:pt x="4073" y="606"/>
                  <a:pt x="4081" y="588"/>
                </a:cubicBezTo>
                <a:cubicBezTo>
                  <a:pt x="4089" y="569"/>
                  <a:pt x="4091" y="553"/>
                  <a:pt x="4089" y="538"/>
                </a:cubicBezTo>
                <a:cubicBezTo>
                  <a:pt x="4086" y="523"/>
                  <a:pt x="4080" y="510"/>
                  <a:pt x="4070" y="499"/>
                </a:cubicBezTo>
                <a:cubicBezTo>
                  <a:pt x="4059" y="489"/>
                  <a:pt x="4047" y="483"/>
                  <a:pt x="4033" y="481"/>
                </a:cubicBezTo>
                <a:cubicBezTo>
                  <a:pt x="4019" y="479"/>
                  <a:pt x="4002" y="483"/>
                  <a:pt x="3983" y="491"/>
                </a:cubicBezTo>
                <a:cubicBezTo>
                  <a:pt x="3970" y="497"/>
                  <a:pt x="3945" y="511"/>
                  <a:pt x="3906" y="535"/>
                </a:cubicBezTo>
                <a:cubicBezTo>
                  <a:pt x="3868" y="558"/>
                  <a:pt x="3840" y="573"/>
                  <a:pt x="3821" y="579"/>
                </a:cubicBezTo>
                <a:cubicBezTo>
                  <a:pt x="3796" y="586"/>
                  <a:pt x="3774" y="588"/>
                  <a:pt x="3753" y="583"/>
                </a:cubicBezTo>
                <a:cubicBezTo>
                  <a:pt x="3733" y="579"/>
                  <a:pt x="3715" y="569"/>
                  <a:pt x="3700" y="553"/>
                </a:cubicBezTo>
                <a:cubicBezTo>
                  <a:pt x="3683" y="536"/>
                  <a:pt x="3672" y="516"/>
                  <a:pt x="3667" y="491"/>
                </a:cubicBezTo>
                <a:cubicBezTo>
                  <a:pt x="3662" y="467"/>
                  <a:pt x="3664" y="442"/>
                  <a:pt x="3675" y="416"/>
                </a:cubicBezTo>
                <a:cubicBezTo>
                  <a:pt x="3686" y="389"/>
                  <a:pt x="3703" y="365"/>
                  <a:pt x="3725" y="342"/>
                </a:cubicBezTo>
                <a:cubicBezTo>
                  <a:pt x="3750" y="318"/>
                  <a:pt x="3776" y="300"/>
                  <a:pt x="3803" y="289"/>
                </a:cubicBezTo>
                <a:cubicBezTo>
                  <a:pt x="3830" y="278"/>
                  <a:pt x="3857" y="275"/>
                  <a:pt x="3883" y="280"/>
                </a:cubicBezTo>
                <a:cubicBezTo>
                  <a:pt x="3909" y="285"/>
                  <a:pt x="3932" y="298"/>
                  <a:pt x="3952" y="317"/>
                </a:cubicBezTo>
                <a:lnTo>
                  <a:pt x="3913" y="362"/>
                </a:lnTo>
                <a:cubicBezTo>
                  <a:pt x="3889" y="343"/>
                  <a:pt x="3865" y="335"/>
                  <a:pt x="3841" y="338"/>
                </a:cubicBezTo>
                <a:cubicBezTo>
                  <a:pt x="3817" y="340"/>
                  <a:pt x="3792" y="354"/>
                  <a:pt x="3767" y="380"/>
                </a:cubicBezTo>
                <a:cubicBezTo>
                  <a:pt x="3740" y="407"/>
                  <a:pt x="3725" y="431"/>
                  <a:pt x="3722" y="453"/>
                </a:cubicBezTo>
                <a:cubicBezTo>
                  <a:pt x="3720" y="476"/>
                  <a:pt x="3726" y="494"/>
                  <a:pt x="3740" y="508"/>
                </a:cubicBezTo>
                <a:cubicBezTo>
                  <a:pt x="3752" y="520"/>
                  <a:pt x="3766" y="525"/>
                  <a:pt x="3783" y="524"/>
                </a:cubicBezTo>
                <a:cubicBezTo>
                  <a:pt x="3799" y="523"/>
                  <a:pt x="3829" y="509"/>
                  <a:pt x="3874" y="481"/>
                </a:cubicBezTo>
                <a:cubicBezTo>
                  <a:pt x="3918" y="453"/>
                  <a:pt x="3950" y="436"/>
                  <a:pt x="3969" y="428"/>
                </a:cubicBezTo>
                <a:cubicBezTo>
                  <a:pt x="3998" y="418"/>
                  <a:pt x="4024" y="415"/>
                  <a:pt x="4047" y="419"/>
                </a:cubicBezTo>
                <a:cubicBezTo>
                  <a:pt x="4070" y="424"/>
                  <a:pt x="4091" y="435"/>
                  <a:pt x="4109" y="453"/>
                </a:cubicBezTo>
                <a:cubicBezTo>
                  <a:pt x="4127" y="471"/>
                  <a:pt x="4138" y="493"/>
                  <a:pt x="4144" y="519"/>
                </a:cubicBezTo>
                <a:cubicBezTo>
                  <a:pt x="4150" y="545"/>
                  <a:pt x="4147" y="572"/>
                  <a:pt x="4137" y="600"/>
                </a:cubicBezTo>
                <a:cubicBezTo>
                  <a:pt x="4126" y="628"/>
                  <a:pt x="4109" y="654"/>
                  <a:pt x="4085" y="678"/>
                </a:cubicBezTo>
                <a:cubicBezTo>
                  <a:pt x="4055" y="708"/>
                  <a:pt x="4025" y="729"/>
                  <a:pt x="3995" y="741"/>
                </a:cubicBezTo>
                <a:cubicBezTo>
                  <a:pt x="3966" y="753"/>
                  <a:pt x="3937" y="755"/>
                  <a:pt x="3907" y="749"/>
                </a:cubicBezTo>
                <a:cubicBezTo>
                  <a:pt x="3878" y="743"/>
                  <a:pt x="3851" y="729"/>
                  <a:pt x="3828" y="707"/>
                </a:cubicBezTo>
                <a:close/>
                <a:moveTo>
                  <a:pt x="4429" y="244"/>
                </a:moveTo>
                <a:lnTo>
                  <a:pt x="4468" y="283"/>
                </a:lnTo>
                <a:lnTo>
                  <a:pt x="4246" y="506"/>
                </a:lnTo>
                <a:cubicBezTo>
                  <a:pt x="4236" y="496"/>
                  <a:pt x="4228" y="485"/>
                  <a:pt x="4222" y="472"/>
                </a:cubicBezTo>
                <a:cubicBezTo>
                  <a:pt x="4213" y="451"/>
                  <a:pt x="4207" y="427"/>
                  <a:pt x="4205" y="400"/>
                </a:cubicBezTo>
                <a:cubicBezTo>
                  <a:pt x="4202" y="373"/>
                  <a:pt x="4203" y="338"/>
                  <a:pt x="4208" y="295"/>
                </a:cubicBezTo>
                <a:cubicBezTo>
                  <a:pt x="4214" y="229"/>
                  <a:pt x="4215" y="180"/>
                  <a:pt x="4211" y="150"/>
                </a:cubicBezTo>
                <a:cubicBezTo>
                  <a:pt x="4206" y="120"/>
                  <a:pt x="4196" y="97"/>
                  <a:pt x="4180" y="81"/>
                </a:cubicBezTo>
                <a:cubicBezTo>
                  <a:pt x="4164" y="65"/>
                  <a:pt x="4144" y="57"/>
                  <a:pt x="4121" y="57"/>
                </a:cubicBezTo>
                <a:cubicBezTo>
                  <a:pt x="4098" y="58"/>
                  <a:pt x="4078" y="67"/>
                  <a:pt x="4059" y="86"/>
                </a:cubicBezTo>
                <a:cubicBezTo>
                  <a:pt x="4039" y="106"/>
                  <a:pt x="4029" y="128"/>
                  <a:pt x="4029" y="152"/>
                </a:cubicBezTo>
                <a:cubicBezTo>
                  <a:pt x="4029" y="176"/>
                  <a:pt x="4039" y="198"/>
                  <a:pt x="4060" y="219"/>
                </a:cubicBezTo>
                <a:lnTo>
                  <a:pt x="4014" y="257"/>
                </a:lnTo>
                <a:cubicBezTo>
                  <a:pt x="3985" y="223"/>
                  <a:pt x="3972" y="188"/>
                  <a:pt x="3974" y="152"/>
                </a:cubicBezTo>
                <a:cubicBezTo>
                  <a:pt x="3976" y="117"/>
                  <a:pt x="3994" y="83"/>
                  <a:pt x="4026" y="51"/>
                </a:cubicBezTo>
                <a:cubicBezTo>
                  <a:pt x="4058" y="19"/>
                  <a:pt x="4092" y="2"/>
                  <a:pt x="4129" y="1"/>
                </a:cubicBezTo>
                <a:cubicBezTo>
                  <a:pt x="4166" y="0"/>
                  <a:pt x="4197" y="13"/>
                  <a:pt x="4224" y="40"/>
                </a:cubicBezTo>
                <a:cubicBezTo>
                  <a:pt x="4237" y="53"/>
                  <a:pt x="4248" y="69"/>
                  <a:pt x="4255" y="88"/>
                </a:cubicBezTo>
                <a:cubicBezTo>
                  <a:pt x="4262" y="106"/>
                  <a:pt x="4267" y="129"/>
                  <a:pt x="4269" y="156"/>
                </a:cubicBezTo>
                <a:cubicBezTo>
                  <a:pt x="4270" y="183"/>
                  <a:pt x="4269" y="224"/>
                  <a:pt x="4264" y="279"/>
                </a:cubicBezTo>
                <a:cubicBezTo>
                  <a:pt x="4260" y="324"/>
                  <a:pt x="4258" y="354"/>
                  <a:pt x="4259" y="369"/>
                </a:cubicBezTo>
                <a:cubicBezTo>
                  <a:pt x="4259" y="383"/>
                  <a:pt x="4261" y="396"/>
                  <a:pt x="4264" y="409"/>
                </a:cubicBezTo>
                <a:lnTo>
                  <a:pt x="4429" y="244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7" name="Freeform 73"/>
          <p:cNvSpPr>
            <a:spLocks noEditPoints="1"/>
          </p:cNvSpPr>
          <p:nvPr/>
        </p:nvSpPr>
        <p:spPr bwMode="auto">
          <a:xfrm>
            <a:off x="3995880" y="5035690"/>
            <a:ext cx="889000" cy="889000"/>
          </a:xfrm>
          <a:custGeom>
            <a:avLst/>
            <a:gdLst>
              <a:gd name="T0" fmla="*/ 238 w 4666"/>
              <a:gd name="T1" fmla="*/ 4131 h 4668"/>
              <a:gd name="T2" fmla="*/ 243 w 4666"/>
              <a:gd name="T3" fmla="*/ 4487 h 4668"/>
              <a:gd name="T4" fmla="*/ 336 w 4666"/>
              <a:gd name="T5" fmla="*/ 4283 h 4668"/>
              <a:gd name="T6" fmla="*/ 84 w 4666"/>
              <a:gd name="T7" fmla="*/ 4327 h 4668"/>
              <a:gd name="T8" fmla="*/ 513 w 4666"/>
              <a:gd name="T9" fmla="*/ 3839 h 4668"/>
              <a:gd name="T10" fmla="*/ 740 w 4666"/>
              <a:gd name="T11" fmla="*/ 3967 h 4668"/>
              <a:gd name="T12" fmla="*/ 779 w 4666"/>
              <a:gd name="T13" fmla="*/ 4225 h 4668"/>
              <a:gd name="T14" fmla="*/ 620 w 4666"/>
              <a:gd name="T15" fmla="*/ 3952 h 4668"/>
              <a:gd name="T16" fmla="*/ 399 w 4666"/>
              <a:gd name="T17" fmla="*/ 4012 h 4668"/>
              <a:gd name="T18" fmla="*/ 784 w 4666"/>
              <a:gd name="T19" fmla="*/ 4118 h 4668"/>
              <a:gd name="T20" fmla="*/ 618 w 4666"/>
              <a:gd name="T21" fmla="*/ 4075 h 4668"/>
              <a:gd name="T22" fmla="*/ 743 w 4666"/>
              <a:gd name="T23" fmla="*/ 3588 h 4668"/>
              <a:gd name="T24" fmla="*/ 1130 w 4666"/>
              <a:gd name="T25" fmla="*/ 3669 h 4668"/>
              <a:gd name="T26" fmla="*/ 964 w 4666"/>
              <a:gd name="T27" fmla="*/ 4040 h 4668"/>
              <a:gd name="T28" fmla="*/ 1081 w 4666"/>
              <a:gd name="T29" fmla="*/ 3711 h 4668"/>
              <a:gd name="T30" fmla="*/ 712 w 4666"/>
              <a:gd name="T31" fmla="*/ 3699 h 4668"/>
              <a:gd name="T32" fmla="*/ 1626 w 4666"/>
              <a:gd name="T33" fmla="*/ 3563 h 4668"/>
              <a:gd name="T34" fmla="*/ 1414 w 4666"/>
              <a:gd name="T35" fmla="*/ 2924 h 4668"/>
              <a:gd name="T36" fmla="*/ 1563 w 4666"/>
              <a:gd name="T37" fmla="*/ 3167 h 4668"/>
              <a:gd name="T38" fmla="*/ 1524 w 4666"/>
              <a:gd name="T39" fmla="*/ 3127 h 4668"/>
              <a:gd name="T40" fmla="*/ 1403 w 4666"/>
              <a:gd name="T41" fmla="*/ 3008 h 4668"/>
              <a:gd name="T42" fmla="*/ 1788 w 4666"/>
              <a:gd name="T43" fmla="*/ 2543 h 4668"/>
              <a:gd name="T44" fmla="*/ 1957 w 4666"/>
              <a:gd name="T45" fmla="*/ 2738 h 4668"/>
              <a:gd name="T46" fmla="*/ 1881 w 4666"/>
              <a:gd name="T47" fmla="*/ 3122 h 4668"/>
              <a:gd name="T48" fmla="*/ 2042 w 4666"/>
              <a:gd name="T49" fmla="*/ 2462 h 4668"/>
              <a:gd name="T50" fmla="*/ 2166 w 4666"/>
              <a:gd name="T51" fmla="*/ 2482 h 4668"/>
              <a:gd name="T52" fmla="*/ 2183 w 4666"/>
              <a:gd name="T53" fmla="*/ 2586 h 4668"/>
              <a:gd name="T54" fmla="*/ 2342 w 4666"/>
              <a:gd name="T55" fmla="*/ 2135 h 4668"/>
              <a:gd name="T56" fmla="*/ 2282 w 4666"/>
              <a:gd name="T57" fmla="*/ 2046 h 4668"/>
              <a:gd name="T58" fmla="*/ 2562 w 4666"/>
              <a:gd name="T59" fmla="*/ 1954 h 4668"/>
              <a:gd name="T60" fmla="*/ 2742 w 4666"/>
              <a:gd name="T61" fmla="*/ 1849 h 4668"/>
              <a:gd name="T62" fmla="*/ 3057 w 4666"/>
              <a:gd name="T63" fmla="*/ 1946 h 4668"/>
              <a:gd name="T64" fmla="*/ 2775 w 4666"/>
              <a:gd name="T65" fmla="*/ 1836 h 4668"/>
              <a:gd name="T66" fmla="*/ 2704 w 4666"/>
              <a:gd name="T67" fmla="*/ 1901 h 4668"/>
              <a:gd name="T68" fmla="*/ 2810 w 4666"/>
              <a:gd name="T69" fmla="*/ 2194 h 4668"/>
              <a:gd name="T70" fmla="*/ 3218 w 4666"/>
              <a:gd name="T71" fmla="*/ 1729 h 4668"/>
              <a:gd name="T72" fmla="*/ 3062 w 4666"/>
              <a:gd name="T73" fmla="*/ 1695 h 4668"/>
              <a:gd name="T74" fmla="*/ 2959 w 4666"/>
              <a:gd name="T75" fmla="*/ 1556 h 4668"/>
              <a:gd name="T76" fmla="*/ 3120 w 4666"/>
              <a:gd name="T77" fmla="*/ 1533 h 4668"/>
              <a:gd name="T78" fmla="*/ 3025 w 4666"/>
              <a:gd name="T79" fmla="*/ 1640 h 4668"/>
              <a:gd name="T80" fmla="*/ 3273 w 4666"/>
              <a:gd name="T81" fmla="*/ 1587 h 4668"/>
              <a:gd name="T82" fmla="*/ 3070 w 4666"/>
              <a:gd name="T83" fmla="*/ 1788 h 4668"/>
              <a:gd name="T84" fmla="*/ 3203 w 4666"/>
              <a:gd name="T85" fmla="*/ 1374 h 4668"/>
              <a:gd name="T86" fmla="*/ 3540 w 4666"/>
              <a:gd name="T87" fmla="*/ 1463 h 4668"/>
              <a:gd name="T88" fmla="*/ 3498 w 4666"/>
              <a:gd name="T89" fmla="*/ 928 h 4668"/>
              <a:gd name="T90" fmla="*/ 3787 w 4666"/>
              <a:gd name="T91" fmla="*/ 1216 h 4668"/>
              <a:gd name="T92" fmla="*/ 3802 w 4666"/>
              <a:gd name="T93" fmla="*/ 567 h 4668"/>
              <a:gd name="T94" fmla="*/ 3807 w 4666"/>
              <a:gd name="T95" fmla="*/ 923 h 4668"/>
              <a:gd name="T96" fmla="*/ 3900 w 4666"/>
              <a:gd name="T97" fmla="*/ 719 h 4668"/>
              <a:gd name="T98" fmla="*/ 3647 w 4666"/>
              <a:gd name="T99" fmla="*/ 763 h 4668"/>
              <a:gd name="T100" fmla="*/ 4241 w 4666"/>
              <a:gd name="T101" fmla="*/ 674 h 4668"/>
              <a:gd name="T102" fmla="*/ 4292 w 4666"/>
              <a:gd name="T103" fmla="*/ 473 h 4668"/>
              <a:gd name="T104" fmla="*/ 3959 w 4666"/>
              <a:gd name="T105" fmla="*/ 546 h 4668"/>
              <a:gd name="T106" fmla="*/ 4142 w 4666"/>
              <a:gd name="T107" fmla="*/ 273 h 4668"/>
              <a:gd name="T108" fmla="*/ 3982 w 4666"/>
              <a:gd name="T109" fmla="*/ 446 h 4668"/>
              <a:gd name="T110" fmla="*/ 4306 w 4666"/>
              <a:gd name="T111" fmla="*/ 412 h 4668"/>
              <a:gd name="T112" fmla="*/ 4255 w 4666"/>
              <a:gd name="T113" fmla="*/ 733 h 4668"/>
              <a:gd name="T114" fmla="*/ 4362 w 4666"/>
              <a:gd name="T115" fmla="*/ 116 h 4668"/>
              <a:gd name="T116" fmla="*/ 4302 w 4666"/>
              <a:gd name="T117" fmla="*/ 26 h 466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</a:cxnLst>
            <a:rect l="0" t="0" r="r" b="b"/>
            <a:pathLst>
              <a:path w="4666" h="4668">
                <a:moveTo>
                  <a:pt x="336" y="4668"/>
                </a:moveTo>
                <a:lnTo>
                  <a:pt x="0" y="4332"/>
                </a:lnTo>
                <a:lnTo>
                  <a:pt x="126" y="4205"/>
                </a:lnTo>
                <a:cubicBezTo>
                  <a:pt x="149" y="4182"/>
                  <a:pt x="167" y="4166"/>
                  <a:pt x="181" y="4157"/>
                </a:cubicBezTo>
                <a:cubicBezTo>
                  <a:pt x="200" y="4143"/>
                  <a:pt x="219" y="4135"/>
                  <a:pt x="238" y="4131"/>
                </a:cubicBezTo>
                <a:cubicBezTo>
                  <a:pt x="257" y="4128"/>
                  <a:pt x="277" y="4129"/>
                  <a:pt x="297" y="4137"/>
                </a:cubicBezTo>
                <a:cubicBezTo>
                  <a:pt x="318" y="4144"/>
                  <a:pt x="337" y="4156"/>
                  <a:pt x="353" y="4172"/>
                </a:cubicBezTo>
                <a:cubicBezTo>
                  <a:pt x="382" y="4201"/>
                  <a:pt x="397" y="4234"/>
                  <a:pt x="399" y="4272"/>
                </a:cubicBezTo>
                <a:cubicBezTo>
                  <a:pt x="400" y="4310"/>
                  <a:pt x="377" y="4353"/>
                  <a:pt x="330" y="4400"/>
                </a:cubicBezTo>
                <a:lnTo>
                  <a:pt x="243" y="4487"/>
                </a:lnTo>
                <a:lnTo>
                  <a:pt x="380" y="4623"/>
                </a:lnTo>
                <a:lnTo>
                  <a:pt x="336" y="4668"/>
                </a:lnTo>
                <a:close/>
                <a:moveTo>
                  <a:pt x="204" y="4447"/>
                </a:moveTo>
                <a:lnTo>
                  <a:pt x="291" y="4360"/>
                </a:lnTo>
                <a:cubicBezTo>
                  <a:pt x="319" y="4331"/>
                  <a:pt x="334" y="4305"/>
                  <a:pt x="336" y="4283"/>
                </a:cubicBezTo>
                <a:cubicBezTo>
                  <a:pt x="337" y="4260"/>
                  <a:pt x="328" y="4239"/>
                  <a:pt x="309" y="4219"/>
                </a:cubicBezTo>
                <a:cubicBezTo>
                  <a:pt x="295" y="4205"/>
                  <a:pt x="279" y="4197"/>
                  <a:pt x="262" y="4194"/>
                </a:cubicBezTo>
                <a:cubicBezTo>
                  <a:pt x="245" y="4191"/>
                  <a:pt x="229" y="4194"/>
                  <a:pt x="214" y="4202"/>
                </a:cubicBezTo>
                <a:cubicBezTo>
                  <a:pt x="205" y="4208"/>
                  <a:pt x="190" y="4221"/>
                  <a:pt x="170" y="4241"/>
                </a:cubicBezTo>
                <a:lnTo>
                  <a:pt x="84" y="4327"/>
                </a:lnTo>
                <a:lnTo>
                  <a:pt x="204" y="4447"/>
                </a:lnTo>
                <a:close/>
                <a:moveTo>
                  <a:pt x="651" y="4353"/>
                </a:moveTo>
                <a:lnTo>
                  <a:pt x="314" y="4017"/>
                </a:lnTo>
                <a:lnTo>
                  <a:pt x="441" y="3891"/>
                </a:lnTo>
                <a:cubicBezTo>
                  <a:pt x="466" y="3865"/>
                  <a:pt x="490" y="3848"/>
                  <a:pt x="513" y="3839"/>
                </a:cubicBezTo>
                <a:cubicBezTo>
                  <a:pt x="535" y="3830"/>
                  <a:pt x="557" y="3829"/>
                  <a:pt x="580" y="3834"/>
                </a:cubicBezTo>
                <a:cubicBezTo>
                  <a:pt x="603" y="3839"/>
                  <a:pt x="623" y="3850"/>
                  <a:pt x="638" y="3865"/>
                </a:cubicBezTo>
                <a:cubicBezTo>
                  <a:pt x="652" y="3879"/>
                  <a:pt x="662" y="3897"/>
                  <a:pt x="667" y="3917"/>
                </a:cubicBezTo>
                <a:cubicBezTo>
                  <a:pt x="672" y="3938"/>
                  <a:pt x="670" y="3960"/>
                  <a:pt x="662" y="3983"/>
                </a:cubicBezTo>
                <a:cubicBezTo>
                  <a:pt x="689" y="3969"/>
                  <a:pt x="714" y="3964"/>
                  <a:pt x="740" y="3967"/>
                </a:cubicBezTo>
                <a:cubicBezTo>
                  <a:pt x="765" y="3970"/>
                  <a:pt x="787" y="3982"/>
                  <a:pt x="807" y="4001"/>
                </a:cubicBezTo>
                <a:cubicBezTo>
                  <a:pt x="823" y="4017"/>
                  <a:pt x="834" y="4035"/>
                  <a:pt x="841" y="4055"/>
                </a:cubicBezTo>
                <a:cubicBezTo>
                  <a:pt x="848" y="4076"/>
                  <a:pt x="850" y="4094"/>
                  <a:pt x="848" y="4111"/>
                </a:cubicBezTo>
                <a:cubicBezTo>
                  <a:pt x="845" y="4128"/>
                  <a:pt x="838" y="4146"/>
                  <a:pt x="827" y="4165"/>
                </a:cubicBezTo>
                <a:cubicBezTo>
                  <a:pt x="816" y="4183"/>
                  <a:pt x="800" y="4203"/>
                  <a:pt x="779" y="4225"/>
                </a:cubicBezTo>
                <a:lnTo>
                  <a:pt x="651" y="4353"/>
                </a:lnTo>
                <a:close/>
                <a:moveTo>
                  <a:pt x="500" y="4113"/>
                </a:moveTo>
                <a:lnTo>
                  <a:pt x="573" y="4041"/>
                </a:lnTo>
                <a:cubicBezTo>
                  <a:pt x="593" y="4021"/>
                  <a:pt x="605" y="4006"/>
                  <a:pt x="611" y="3994"/>
                </a:cubicBezTo>
                <a:cubicBezTo>
                  <a:pt x="619" y="3980"/>
                  <a:pt x="622" y="3966"/>
                  <a:pt x="620" y="3952"/>
                </a:cubicBezTo>
                <a:cubicBezTo>
                  <a:pt x="618" y="3939"/>
                  <a:pt x="611" y="3926"/>
                  <a:pt x="599" y="3914"/>
                </a:cubicBezTo>
                <a:cubicBezTo>
                  <a:pt x="588" y="3903"/>
                  <a:pt x="576" y="3896"/>
                  <a:pt x="562" y="3893"/>
                </a:cubicBezTo>
                <a:cubicBezTo>
                  <a:pt x="548" y="3890"/>
                  <a:pt x="535" y="3891"/>
                  <a:pt x="522" y="3898"/>
                </a:cubicBezTo>
                <a:cubicBezTo>
                  <a:pt x="509" y="3905"/>
                  <a:pt x="490" y="3920"/>
                  <a:pt x="466" y="3945"/>
                </a:cubicBezTo>
                <a:lnTo>
                  <a:pt x="399" y="4012"/>
                </a:lnTo>
                <a:lnTo>
                  <a:pt x="500" y="4113"/>
                </a:lnTo>
                <a:close/>
                <a:moveTo>
                  <a:pt x="655" y="4269"/>
                </a:moveTo>
                <a:lnTo>
                  <a:pt x="739" y="4185"/>
                </a:lnTo>
                <a:cubicBezTo>
                  <a:pt x="753" y="4171"/>
                  <a:pt x="763" y="4160"/>
                  <a:pt x="768" y="4153"/>
                </a:cubicBezTo>
                <a:cubicBezTo>
                  <a:pt x="776" y="4141"/>
                  <a:pt x="782" y="4129"/>
                  <a:pt x="784" y="4118"/>
                </a:cubicBezTo>
                <a:cubicBezTo>
                  <a:pt x="787" y="4107"/>
                  <a:pt x="786" y="4095"/>
                  <a:pt x="783" y="4083"/>
                </a:cubicBezTo>
                <a:cubicBezTo>
                  <a:pt x="779" y="4070"/>
                  <a:pt x="772" y="4058"/>
                  <a:pt x="761" y="4048"/>
                </a:cubicBezTo>
                <a:cubicBezTo>
                  <a:pt x="748" y="4035"/>
                  <a:pt x="734" y="4027"/>
                  <a:pt x="719" y="4025"/>
                </a:cubicBezTo>
                <a:cubicBezTo>
                  <a:pt x="703" y="4022"/>
                  <a:pt x="687" y="4024"/>
                  <a:pt x="672" y="4032"/>
                </a:cubicBezTo>
                <a:cubicBezTo>
                  <a:pt x="657" y="4039"/>
                  <a:pt x="639" y="4054"/>
                  <a:pt x="618" y="4075"/>
                </a:cubicBezTo>
                <a:lnTo>
                  <a:pt x="540" y="4153"/>
                </a:lnTo>
                <a:lnTo>
                  <a:pt x="655" y="4269"/>
                </a:lnTo>
                <a:close/>
                <a:moveTo>
                  <a:pt x="964" y="4040"/>
                </a:moveTo>
                <a:lnTo>
                  <a:pt x="627" y="3704"/>
                </a:lnTo>
                <a:lnTo>
                  <a:pt x="743" y="3588"/>
                </a:lnTo>
                <a:cubicBezTo>
                  <a:pt x="769" y="3562"/>
                  <a:pt x="791" y="3543"/>
                  <a:pt x="808" y="3533"/>
                </a:cubicBezTo>
                <a:cubicBezTo>
                  <a:pt x="832" y="3518"/>
                  <a:pt x="856" y="3510"/>
                  <a:pt x="881" y="3508"/>
                </a:cubicBezTo>
                <a:cubicBezTo>
                  <a:pt x="914" y="3505"/>
                  <a:pt x="946" y="3511"/>
                  <a:pt x="978" y="3525"/>
                </a:cubicBezTo>
                <a:cubicBezTo>
                  <a:pt x="1011" y="3540"/>
                  <a:pt x="1042" y="3562"/>
                  <a:pt x="1072" y="3592"/>
                </a:cubicBezTo>
                <a:cubicBezTo>
                  <a:pt x="1097" y="3618"/>
                  <a:pt x="1117" y="3643"/>
                  <a:pt x="1130" y="3669"/>
                </a:cubicBezTo>
                <a:cubicBezTo>
                  <a:pt x="1144" y="3694"/>
                  <a:pt x="1153" y="3718"/>
                  <a:pt x="1156" y="3741"/>
                </a:cubicBezTo>
                <a:cubicBezTo>
                  <a:pt x="1160" y="3763"/>
                  <a:pt x="1160" y="3783"/>
                  <a:pt x="1156" y="3802"/>
                </a:cubicBezTo>
                <a:cubicBezTo>
                  <a:pt x="1153" y="3820"/>
                  <a:pt x="1145" y="3839"/>
                  <a:pt x="1133" y="3859"/>
                </a:cubicBezTo>
                <a:cubicBezTo>
                  <a:pt x="1121" y="3878"/>
                  <a:pt x="1105" y="3898"/>
                  <a:pt x="1085" y="3918"/>
                </a:cubicBezTo>
                <a:lnTo>
                  <a:pt x="964" y="4040"/>
                </a:lnTo>
                <a:close/>
                <a:moveTo>
                  <a:pt x="968" y="3956"/>
                </a:moveTo>
                <a:lnTo>
                  <a:pt x="1040" y="3884"/>
                </a:lnTo>
                <a:cubicBezTo>
                  <a:pt x="1062" y="3862"/>
                  <a:pt x="1078" y="3842"/>
                  <a:pt x="1086" y="3825"/>
                </a:cubicBezTo>
                <a:cubicBezTo>
                  <a:pt x="1095" y="3809"/>
                  <a:pt x="1099" y="3793"/>
                  <a:pt x="1099" y="3778"/>
                </a:cubicBezTo>
                <a:cubicBezTo>
                  <a:pt x="1099" y="3757"/>
                  <a:pt x="1093" y="3734"/>
                  <a:pt x="1081" y="3711"/>
                </a:cubicBezTo>
                <a:cubicBezTo>
                  <a:pt x="1069" y="3687"/>
                  <a:pt x="1050" y="3663"/>
                  <a:pt x="1025" y="3637"/>
                </a:cubicBezTo>
                <a:cubicBezTo>
                  <a:pt x="990" y="3602"/>
                  <a:pt x="957" y="3581"/>
                  <a:pt x="927" y="3573"/>
                </a:cubicBezTo>
                <a:cubicBezTo>
                  <a:pt x="896" y="3566"/>
                  <a:pt x="870" y="3567"/>
                  <a:pt x="847" y="3578"/>
                </a:cubicBezTo>
                <a:cubicBezTo>
                  <a:pt x="830" y="3585"/>
                  <a:pt x="809" y="3602"/>
                  <a:pt x="782" y="3628"/>
                </a:cubicBezTo>
                <a:lnTo>
                  <a:pt x="712" y="3699"/>
                </a:lnTo>
                <a:lnTo>
                  <a:pt x="968" y="3956"/>
                </a:lnTo>
                <a:close/>
                <a:moveTo>
                  <a:pt x="1353" y="3837"/>
                </a:moveTo>
                <a:lnTo>
                  <a:pt x="1323" y="3807"/>
                </a:lnTo>
                <a:lnTo>
                  <a:pt x="1597" y="3534"/>
                </a:lnTo>
                <a:lnTo>
                  <a:pt x="1626" y="3563"/>
                </a:lnTo>
                <a:lnTo>
                  <a:pt x="1353" y="3837"/>
                </a:lnTo>
                <a:close/>
                <a:moveTo>
                  <a:pt x="1569" y="3434"/>
                </a:moveTo>
                <a:lnTo>
                  <a:pt x="1233" y="3098"/>
                </a:lnTo>
                <a:lnTo>
                  <a:pt x="1360" y="2972"/>
                </a:lnTo>
                <a:cubicBezTo>
                  <a:pt x="1382" y="2949"/>
                  <a:pt x="1400" y="2933"/>
                  <a:pt x="1414" y="2924"/>
                </a:cubicBezTo>
                <a:cubicBezTo>
                  <a:pt x="1433" y="2910"/>
                  <a:pt x="1452" y="2901"/>
                  <a:pt x="1471" y="2898"/>
                </a:cubicBezTo>
                <a:cubicBezTo>
                  <a:pt x="1490" y="2894"/>
                  <a:pt x="1510" y="2896"/>
                  <a:pt x="1530" y="2903"/>
                </a:cubicBezTo>
                <a:cubicBezTo>
                  <a:pt x="1551" y="2910"/>
                  <a:pt x="1570" y="2922"/>
                  <a:pt x="1586" y="2939"/>
                </a:cubicBezTo>
                <a:cubicBezTo>
                  <a:pt x="1615" y="2968"/>
                  <a:pt x="1630" y="3001"/>
                  <a:pt x="1632" y="3039"/>
                </a:cubicBezTo>
                <a:cubicBezTo>
                  <a:pt x="1633" y="3077"/>
                  <a:pt x="1610" y="3120"/>
                  <a:pt x="1563" y="3167"/>
                </a:cubicBezTo>
                <a:lnTo>
                  <a:pt x="1477" y="3253"/>
                </a:lnTo>
                <a:lnTo>
                  <a:pt x="1613" y="3390"/>
                </a:lnTo>
                <a:lnTo>
                  <a:pt x="1569" y="3434"/>
                </a:lnTo>
                <a:close/>
                <a:moveTo>
                  <a:pt x="1437" y="3214"/>
                </a:moveTo>
                <a:lnTo>
                  <a:pt x="1524" y="3127"/>
                </a:lnTo>
                <a:cubicBezTo>
                  <a:pt x="1553" y="3098"/>
                  <a:pt x="1568" y="3072"/>
                  <a:pt x="1569" y="3050"/>
                </a:cubicBezTo>
                <a:cubicBezTo>
                  <a:pt x="1570" y="3027"/>
                  <a:pt x="1561" y="3006"/>
                  <a:pt x="1542" y="2986"/>
                </a:cubicBezTo>
                <a:cubicBezTo>
                  <a:pt x="1528" y="2972"/>
                  <a:pt x="1512" y="2964"/>
                  <a:pt x="1495" y="2961"/>
                </a:cubicBezTo>
                <a:cubicBezTo>
                  <a:pt x="1478" y="2958"/>
                  <a:pt x="1462" y="2961"/>
                  <a:pt x="1447" y="2969"/>
                </a:cubicBezTo>
                <a:cubicBezTo>
                  <a:pt x="1438" y="2975"/>
                  <a:pt x="1423" y="2987"/>
                  <a:pt x="1403" y="3008"/>
                </a:cubicBezTo>
                <a:lnTo>
                  <a:pt x="1317" y="3094"/>
                </a:lnTo>
                <a:lnTo>
                  <a:pt x="1437" y="3214"/>
                </a:lnTo>
                <a:close/>
                <a:moveTo>
                  <a:pt x="1881" y="3122"/>
                </a:moveTo>
                <a:lnTo>
                  <a:pt x="1545" y="2786"/>
                </a:lnTo>
                <a:lnTo>
                  <a:pt x="1788" y="2543"/>
                </a:lnTo>
                <a:lnTo>
                  <a:pt x="1827" y="2583"/>
                </a:lnTo>
                <a:lnTo>
                  <a:pt x="1629" y="2781"/>
                </a:lnTo>
                <a:lnTo>
                  <a:pt x="1732" y="2884"/>
                </a:lnTo>
                <a:lnTo>
                  <a:pt x="1918" y="2699"/>
                </a:lnTo>
                <a:lnTo>
                  <a:pt x="1957" y="2738"/>
                </a:lnTo>
                <a:lnTo>
                  <a:pt x="1771" y="2924"/>
                </a:lnTo>
                <a:lnTo>
                  <a:pt x="1886" y="3038"/>
                </a:lnTo>
                <a:lnTo>
                  <a:pt x="2092" y="2832"/>
                </a:lnTo>
                <a:lnTo>
                  <a:pt x="2132" y="2872"/>
                </a:lnTo>
                <a:lnTo>
                  <a:pt x="1881" y="3122"/>
                </a:lnTo>
                <a:close/>
                <a:moveTo>
                  <a:pt x="2163" y="2841"/>
                </a:moveTo>
                <a:lnTo>
                  <a:pt x="2117" y="2536"/>
                </a:lnTo>
                <a:lnTo>
                  <a:pt x="1842" y="2489"/>
                </a:lnTo>
                <a:lnTo>
                  <a:pt x="1895" y="2436"/>
                </a:lnTo>
                <a:lnTo>
                  <a:pt x="2042" y="2462"/>
                </a:lnTo>
                <a:cubicBezTo>
                  <a:pt x="2073" y="2467"/>
                  <a:pt x="2095" y="2471"/>
                  <a:pt x="2110" y="2476"/>
                </a:cubicBezTo>
                <a:cubicBezTo>
                  <a:pt x="2106" y="2456"/>
                  <a:pt x="2102" y="2434"/>
                  <a:pt x="2099" y="2411"/>
                </a:cubicBezTo>
                <a:lnTo>
                  <a:pt x="2077" y="2254"/>
                </a:lnTo>
                <a:lnTo>
                  <a:pt x="2125" y="2206"/>
                </a:lnTo>
                <a:lnTo>
                  <a:pt x="2166" y="2482"/>
                </a:lnTo>
                <a:lnTo>
                  <a:pt x="2471" y="2533"/>
                </a:lnTo>
                <a:lnTo>
                  <a:pt x="2416" y="2588"/>
                </a:lnTo>
                <a:lnTo>
                  <a:pt x="2211" y="2552"/>
                </a:lnTo>
                <a:cubicBezTo>
                  <a:pt x="2200" y="2550"/>
                  <a:pt x="2187" y="2548"/>
                  <a:pt x="2174" y="2544"/>
                </a:cubicBezTo>
                <a:cubicBezTo>
                  <a:pt x="2179" y="2564"/>
                  <a:pt x="2182" y="2578"/>
                  <a:pt x="2183" y="2586"/>
                </a:cubicBezTo>
                <a:lnTo>
                  <a:pt x="2216" y="2787"/>
                </a:lnTo>
                <a:lnTo>
                  <a:pt x="2163" y="2841"/>
                </a:lnTo>
                <a:close/>
                <a:moveTo>
                  <a:pt x="2647" y="2357"/>
                </a:moveTo>
                <a:lnTo>
                  <a:pt x="2605" y="2398"/>
                </a:lnTo>
                <a:lnTo>
                  <a:pt x="2342" y="2135"/>
                </a:lnTo>
                <a:cubicBezTo>
                  <a:pt x="2342" y="2154"/>
                  <a:pt x="2338" y="2177"/>
                  <a:pt x="2332" y="2203"/>
                </a:cubicBezTo>
                <a:cubicBezTo>
                  <a:pt x="2325" y="2228"/>
                  <a:pt x="2318" y="2250"/>
                  <a:pt x="2310" y="2267"/>
                </a:cubicBezTo>
                <a:lnTo>
                  <a:pt x="2270" y="2227"/>
                </a:lnTo>
                <a:cubicBezTo>
                  <a:pt x="2282" y="2193"/>
                  <a:pt x="2289" y="2160"/>
                  <a:pt x="2291" y="2127"/>
                </a:cubicBezTo>
                <a:cubicBezTo>
                  <a:pt x="2293" y="2095"/>
                  <a:pt x="2290" y="2068"/>
                  <a:pt x="2282" y="2046"/>
                </a:cubicBezTo>
                <a:lnTo>
                  <a:pt x="2309" y="2019"/>
                </a:lnTo>
                <a:lnTo>
                  <a:pt x="2647" y="2357"/>
                </a:lnTo>
                <a:close/>
                <a:moveTo>
                  <a:pt x="2768" y="2235"/>
                </a:moveTo>
                <a:lnTo>
                  <a:pt x="2525" y="1991"/>
                </a:lnTo>
                <a:lnTo>
                  <a:pt x="2562" y="1954"/>
                </a:lnTo>
                <a:lnTo>
                  <a:pt x="2596" y="1989"/>
                </a:lnTo>
                <a:cubicBezTo>
                  <a:pt x="2592" y="1969"/>
                  <a:pt x="2592" y="1949"/>
                  <a:pt x="2598" y="1929"/>
                </a:cubicBezTo>
                <a:cubicBezTo>
                  <a:pt x="2603" y="1909"/>
                  <a:pt x="2614" y="1891"/>
                  <a:pt x="2630" y="1875"/>
                </a:cubicBezTo>
                <a:cubicBezTo>
                  <a:pt x="2648" y="1857"/>
                  <a:pt x="2667" y="1846"/>
                  <a:pt x="2686" y="1842"/>
                </a:cubicBezTo>
                <a:cubicBezTo>
                  <a:pt x="2705" y="1838"/>
                  <a:pt x="2723" y="1840"/>
                  <a:pt x="2742" y="1849"/>
                </a:cubicBezTo>
                <a:cubicBezTo>
                  <a:pt x="2732" y="1801"/>
                  <a:pt x="2743" y="1762"/>
                  <a:pt x="2774" y="1731"/>
                </a:cubicBezTo>
                <a:cubicBezTo>
                  <a:pt x="2798" y="1707"/>
                  <a:pt x="2824" y="1695"/>
                  <a:pt x="2850" y="1695"/>
                </a:cubicBezTo>
                <a:cubicBezTo>
                  <a:pt x="2876" y="1696"/>
                  <a:pt x="2903" y="1710"/>
                  <a:pt x="2931" y="1738"/>
                </a:cubicBezTo>
                <a:lnTo>
                  <a:pt x="3098" y="1905"/>
                </a:lnTo>
                <a:lnTo>
                  <a:pt x="3057" y="1946"/>
                </a:lnTo>
                <a:lnTo>
                  <a:pt x="2904" y="1793"/>
                </a:lnTo>
                <a:cubicBezTo>
                  <a:pt x="2887" y="1776"/>
                  <a:pt x="2874" y="1766"/>
                  <a:pt x="2864" y="1761"/>
                </a:cubicBezTo>
                <a:cubicBezTo>
                  <a:pt x="2854" y="1756"/>
                  <a:pt x="2844" y="1755"/>
                  <a:pt x="2832" y="1758"/>
                </a:cubicBezTo>
                <a:cubicBezTo>
                  <a:pt x="2821" y="1761"/>
                  <a:pt x="2810" y="1767"/>
                  <a:pt x="2801" y="1776"/>
                </a:cubicBezTo>
                <a:cubicBezTo>
                  <a:pt x="2784" y="1793"/>
                  <a:pt x="2775" y="1813"/>
                  <a:pt x="2775" y="1836"/>
                </a:cubicBezTo>
                <a:cubicBezTo>
                  <a:pt x="2775" y="1858"/>
                  <a:pt x="2788" y="1882"/>
                  <a:pt x="2813" y="1907"/>
                </a:cubicBezTo>
                <a:lnTo>
                  <a:pt x="2954" y="2049"/>
                </a:lnTo>
                <a:lnTo>
                  <a:pt x="2913" y="2090"/>
                </a:lnTo>
                <a:lnTo>
                  <a:pt x="2755" y="1932"/>
                </a:lnTo>
                <a:cubicBezTo>
                  <a:pt x="2737" y="1914"/>
                  <a:pt x="2719" y="1903"/>
                  <a:pt x="2704" y="1901"/>
                </a:cubicBezTo>
                <a:cubicBezTo>
                  <a:pt x="2688" y="1898"/>
                  <a:pt x="2672" y="1905"/>
                  <a:pt x="2657" y="1920"/>
                </a:cubicBezTo>
                <a:cubicBezTo>
                  <a:pt x="2645" y="1932"/>
                  <a:pt x="2638" y="1945"/>
                  <a:pt x="2634" y="1961"/>
                </a:cubicBezTo>
                <a:cubicBezTo>
                  <a:pt x="2630" y="1977"/>
                  <a:pt x="2632" y="1993"/>
                  <a:pt x="2639" y="2010"/>
                </a:cubicBezTo>
                <a:cubicBezTo>
                  <a:pt x="2646" y="2026"/>
                  <a:pt x="2661" y="2045"/>
                  <a:pt x="2683" y="2067"/>
                </a:cubicBezTo>
                <a:lnTo>
                  <a:pt x="2810" y="2194"/>
                </a:lnTo>
                <a:lnTo>
                  <a:pt x="2768" y="2235"/>
                </a:lnTo>
                <a:close/>
                <a:moveTo>
                  <a:pt x="3070" y="1788"/>
                </a:moveTo>
                <a:lnTo>
                  <a:pt x="3104" y="1741"/>
                </a:lnTo>
                <a:cubicBezTo>
                  <a:pt x="3123" y="1755"/>
                  <a:pt x="3142" y="1761"/>
                  <a:pt x="3161" y="1760"/>
                </a:cubicBezTo>
                <a:cubicBezTo>
                  <a:pt x="3180" y="1758"/>
                  <a:pt x="3199" y="1748"/>
                  <a:pt x="3218" y="1729"/>
                </a:cubicBezTo>
                <a:cubicBezTo>
                  <a:pt x="3237" y="1710"/>
                  <a:pt x="3247" y="1692"/>
                  <a:pt x="3248" y="1675"/>
                </a:cubicBezTo>
                <a:cubicBezTo>
                  <a:pt x="3250" y="1658"/>
                  <a:pt x="3245" y="1644"/>
                  <a:pt x="3235" y="1634"/>
                </a:cubicBezTo>
                <a:cubicBezTo>
                  <a:pt x="3226" y="1625"/>
                  <a:pt x="3214" y="1621"/>
                  <a:pt x="3201" y="1624"/>
                </a:cubicBezTo>
                <a:cubicBezTo>
                  <a:pt x="3191" y="1626"/>
                  <a:pt x="3173" y="1636"/>
                  <a:pt x="3145" y="1652"/>
                </a:cubicBezTo>
                <a:cubicBezTo>
                  <a:pt x="3107" y="1675"/>
                  <a:pt x="3079" y="1689"/>
                  <a:pt x="3062" y="1695"/>
                </a:cubicBezTo>
                <a:cubicBezTo>
                  <a:pt x="3045" y="1702"/>
                  <a:pt x="3028" y="1703"/>
                  <a:pt x="3012" y="1699"/>
                </a:cubicBezTo>
                <a:cubicBezTo>
                  <a:pt x="2996" y="1695"/>
                  <a:pt x="2982" y="1687"/>
                  <a:pt x="2970" y="1675"/>
                </a:cubicBezTo>
                <a:cubicBezTo>
                  <a:pt x="2959" y="1664"/>
                  <a:pt x="2952" y="1652"/>
                  <a:pt x="2948" y="1638"/>
                </a:cubicBezTo>
                <a:cubicBezTo>
                  <a:pt x="2943" y="1623"/>
                  <a:pt x="2942" y="1609"/>
                  <a:pt x="2945" y="1594"/>
                </a:cubicBezTo>
                <a:cubicBezTo>
                  <a:pt x="2947" y="1583"/>
                  <a:pt x="2951" y="1570"/>
                  <a:pt x="2959" y="1556"/>
                </a:cubicBezTo>
                <a:cubicBezTo>
                  <a:pt x="2967" y="1542"/>
                  <a:pt x="2977" y="1528"/>
                  <a:pt x="2990" y="1516"/>
                </a:cubicBezTo>
                <a:cubicBezTo>
                  <a:pt x="3009" y="1496"/>
                  <a:pt x="3028" y="1482"/>
                  <a:pt x="3048" y="1473"/>
                </a:cubicBezTo>
                <a:cubicBezTo>
                  <a:pt x="3068" y="1464"/>
                  <a:pt x="3086" y="1461"/>
                  <a:pt x="3103" y="1464"/>
                </a:cubicBezTo>
                <a:cubicBezTo>
                  <a:pt x="3119" y="1466"/>
                  <a:pt x="3136" y="1474"/>
                  <a:pt x="3155" y="1487"/>
                </a:cubicBezTo>
                <a:lnTo>
                  <a:pt x="3120" y="1533"/>
                </a:lnTo>
                <a:cubicBezTo>
                  <a:pt x="3105" y="1522"/>
                  <a:pt x="3090" y="1518"/>
                  <a:pt x="3075" y="1520"/>
                </a:cubicBezTo>
                <a:cubicBezTo>
                  <a:pt x="3059" y="1522"/>
                  <a:pt x="3043" y="1530"/>
                  <a:pt x="3027" y="1546"/>
                </a:cubicBezTo>
                <a:cubicBezTo>
                  <a:pt x="3008" y="1565"/>
                  <a:pt x="2997" y="1582"/>
                  <a:pt x="2996" y="1596"/>
                </a:cubicBezTo>
                <a:cubicBezTo>
                  <a:pt x="2994" y="1611"/>
                  <a:pt x="2997" y="1622"/>
                  <a:pt x="3005" y="1631"/>
                </a:cubicBezTo>
                <a:cubicBezTo>
                  <a:pt x="3011" y="1636"/>
                  <a:pt x="3017" y="1639"/>
                  <a:pt x="3025" y="1640"/>
                </a:cubicBezTo>
                <a:cubicBezTo>
                  <a:pt x="3033" y="1641"/>
                  <a:pt x="3042" y="1639"/>
                  <a:pt x="3052" y="1635"/>
                </a:cubicBezTo>
                <a:cubicBezTo>
                  <a:pt x="3057" y="1633"/>
                  <a:pt x="3073" y="1624"/>
                  <a:pt x="3099" y="1609"/>
                </a:cubicBezTo>
                <a:cubicBezTo>
                  <a:pt x="3136" y="1588"/>
                  <a:pt x="3162" y="1574"/>
                  <a:pt x="3179" y="1567"/>
                </a:cubicBezTo>
                <a:cubicBezTo>
                  <a:pt x="3195" y="1561"/>
                  <a:pt x="3212" y="1559"/>
                  <a:pt x="3228" y="1562"/>
                </a:cubicBezTo>
                <a:cubicBezTo>
                  <a:pt x="3244" y="1565"/>
                  <a:pt x="3259" y="1573"/>
                  <a:pt x="3273" y="1587"/>
                </a:cubicBezTo>
                <a:cubicBezTo>
                  <a:pt x="3287" y="1601"/>
                  <a:pt x="3296" y="1618"/>
                  <a:pt x="3300" y="1638"/>
                </a:cubicBezTo>
                <a:cubicBezTo>
                  <a:pt x="3304" y="1658"/>
                  <a:pt x="3302" y="1679"/>
                  <a:pt x="3293" y="1701"/>
                </a:cubicBezTo>
                <a:cubicBezTo>
                  <a:pt x="3285" y="1723"/>
                  <a:pt x="3271" y="1743"/>
                  <a:pt x="3252" y="1762"/>
                </a:cubicBezTo>
                <a:cubicBezTo>
                  <a:pt x="3220" y="1794"/>
                  <a:pt x="3190" y="1812"/>
                  <a:pt x="3160" y="1815"/>
                </a:cubicBezTo>
                <a:cubicBezTo>
                  <a:pt x="3130" y="1818"/>
                  <a:pt x="3100" y="1810"/>
                  <a:pt x="3070" y="1788"/>
                </a:cubicBezTo>
                <a:close/>
                <a:moveTo>
                  <a:pt x="3540" y="1463"/>
                </a:moveTo>
                <a:lnTo>
                  <a:pt x="3499" y="1504"/>
                </a:lnTo>
                <a:lnTo>
                  <a:pt x="3236" y="1241"/>
                </a:lnTo>
                <a:cubicBezTo>
                  <a:pt x="3236" y="1261"/>
                  <a:pt x="3232" y="1283"/>
                  <a:pt x="3225" y="1309"/>
                </a:cubicBezTo>
                <a:cubicBezTo>
                  <a:pt x="3219" y="1334"/>
                  <a:pt x="3211" y="1356"/>
                  <a:pt x="3203" y="1374"/>
                </a:cubicBezTo>
                <a:lnTo>
                  <a:pt x="3163" y="1334"/>
                </a:lnTo>
                <a:cubicBezTo>
                  <a:pt x="3176" y="1300"/>
                  <a:pt x="3183" y="1266"/>
                  <a:pt x="3185" y="1234"/>
                </a:cubicBezTo>
                <a:cubicBezTo>
                  <a:pt x="3186" y="1201"/>
                  <a:pt x="3184" y="1174"/>
                  <a:pt x="3176" y="1152"/>
                </a:cubicBezTo>
                <a:lnTo>
                  <a:pt x="3203" y="1125"/>
                </a:lnTo>
                <a:lnTo>
                  <a:pt x="3540" y="1463"/>
                </a:lnTo>
                <a:close/>
                <a:moveTo>
                  <a:pt x="3498" y="928"/>
                </a:moveTo>
                <a:lnTo>
                  <a:pt x="3451" y="880"/>
                </a:lnTo>
                <a:lnTo>
                  <a:pt x="3492" y="839"/>
                </a:lnTo>
                <a:lnTo>
                  <a:pt x="3540" y="886"/>
                </a:lnTo>
                <a:lnTo>
                  <a:pt x="3498" y="928"/>
                </a:lnTo>
                <a:close/>
                <a:moveTo>
                  <a:pt x="3787" y="1216"/>
                </a:moveTo>
                <a:lnTo>
                  <a:pt x="3543" y="973"/>
                </a:lnTo>
                <a:lnTo>
                  <a:pt x="3585" y="932"/>
                </a:lnTo>
                <a:lnTo>
                  <a:pt x="3828" y="1175"/>
                </a:lnTo>
                <a:lnTo>
                  <a:pt x="3787" y="1216"/>
                </a:lnTo>
                <a:close/>
                <a:moveTo>
                  <a:pt x="3899" y="1104"/>
                </a:moveTo>
                <a:lnTo>
                  <a:pt x="3563" y="768"/>
                </a:lnTo>
                <a:lnTo>
                  <a:pt x="3690" y="641"/>
                </a:lnTo>
                <a:cubicBezTo>
                  <a:pt x="3712" y="619"/>
                  <a:pt x="3731" y="603"/>
                  <a:pt x="3744" y="593"/>
                </a:cubicBezTo>
                <a:cubicBezTo>
                  <a:pt x="3764" y="579"/>
                  <a:pt x="3783" y="571"/>
                  <a:pt x="3802" y="567"/>
                </a:cubicBezTo>
                <a:cubicBezTo>
                  <a:pt x="3821" y="564"/>
                  <a:pt x="3840" y="566"/>
                  <a:pt x="3861" y="573"/>
                </a:cubicBezTo>
                <a:cubicBezTo>
                  <a:pt x="3882" y="580"/>
                  <a:pt x="3900" y="592"/>
                  <a:pt x="3917" y="608"/>
                </a:cubicBezTo>
                <a:cubicBezTo>
                  <a:pt x="3946" y="637"/>
                  <a:pt x="3961" y="670"/>
                  <a:pt x="3962" y="708"/>
                </a:cubicBezTo>
                <a:cubicBezTo>
                  <a:pt x="3964" y="746"/>
                  <a:pt x="3941" y="789"/>
                  <a:pt x="3893" y="837"/>
                </a:cubicBezTo>
                <a:lnTo>
                  <a:pt x="3807" y="923"/>
                </a:lnTo>
                <a:lnTo>
                  <a:pt x="3944" y="1059"/>
                </a:lnTo>
                <a:lnTo>
                  <a:pt x="3899" y="1104"/>
                </a:lnTo>
                <a:close/>
                <a:moveTo>
                  <a:pt x="3768" y="883"/>
                </a:moveTo>
                <a:lnTo>
                  <a:pt x="3855" y="796"/>
                </a:lnTo>
                <a:cubicBezTo>
                  <a:pt x="3883" y="767"/>
                  <a:pt x="3898" y="742"/>
                  <a:pt x="3900" y="719"/>
                </a:cubicBezTo>
                <a:cubicBezTo>
                  <a:pt x="3901" y="696"/>
                  <a:pt x="3892" y="675"/>
                  <a:pt x="3873" y="656"/>
                </a:cubicBezTo>
                <a:cubicBezTo>
                  <a:pt x="3859" y="642"/>
                  <a:pt x="3843" y="633"/>
                  <a:pt x="3826" y="630"/>
                </a:cubicBezTo>
                <a:cubicBezTo>
                  <a:pt x="3809" y="627"/>
                  <a:pt x="3793" y="630"/>
                  <a:pt x="3778" y="638"/>
                </a:cubicBezTo>
                <a:cubicBezTo>
                  <a:pt x="3768" y="644"/>
                  <a:pt x="3754" y="657"/>
                  <a:pt x="3733" y="677"/>
                </a:cubicBezTo>
                <a:lnTo>
                  <a:pt x="3647" y="763"/>
                </a:lnTo>
                <a:lnTo>
                  <a:pt x="3768" y="883"/>
                </a:lnTo>
                <a:close/>
                <a:moveTo>
                  <a:pt x="4087" y="700"/>
                </a:moveTo>
                <a:lnTo>
                  <a:pt x="4126" y="654"/>
                </a:lnTo>
                <a:cubicBezTo>
                  <a:pt x="4145" y="669"/>
                  <a:pt x="4163" y="678"/>
                  <a:pt x="4181" y="682"/>
                </a:cubicBezTo>
                <a:cubicBezTo>
                  <a:pt x="4199" y="685"/>
                  <a:pt x="4219" y="683"/>
                  <a:pt x="4241" y="674"/>
                </a:cubicBezTo>
                <a:cubicBezTo>
                  <a:pt x="4263" y="665"/>
                  <a:pt x="4283" y="652"/>
                  <a:pt x="4302" y="632"/>
                </a:cubicBezTo>
                <a:cubicBezTo>
                  <a:pt x="4319" y="615"/>
                  <a:pt x="4332" y="598"/>
                  <a:pt x="4340" y="580"/>
                </a:cubicBezTo>
                <a:cubicBezTo>
                  <a:pt x="4348" y="562"/>
                  <a:pt x="4351" y="545"/>
                  <a:pt x="4348" y="530"/>
                </a:cubicBezTo>
                <a:cubicBezTo>
                  <a:pt x="4346" y="515"/>
                  <a:pt x="4339" y="502"/>
                  <a:pt x="4329" y="492"/>
                </a:cubicBezTo>
                <a:cubicBezTo>
                  <a:pt x="4318" y="481"/>
                  <a:pt x="4306" y="475"/>
                  <a:pt x="4292" y="473"/>
                </a:cubicBezTo>
                <a:cubicBezTo>
                  <a:pt x="4278" y="472"/>
                  <a:pt x="4261" y="475"/>
                  <a:pt x="4242" y="484"/>
                </a:cubicBezTo>
                <a:cubicBezTo>
                  <a:pt x="4229" y="489"/>
                  <a:pt x="4204" y="504"/>
                  <a:pt x="4166" y="527"/>
                </a:cubicBezTo>
                <a:cubicBezTo>
                  <a:pt x="4127" y="551"/>
                  <a:pt x="4099" y="565"/>
                  <a:pt x="4080" y="571"/>
                </a:cubicBezTo>
                <a:cubicBezTo>
                  <a:pt x="4055" y="579"/>
                  <a:pt x="4033" y="580"/>
                  <a:pt x="4013" y="576"/>
                </a:cubicBezTo>
                <a:cubicBezTo>
                  <a:pt x="3992" y="571"/>
                  <a:pt x="3975" y="561"/>
                  <a:pt x="3959" y="546"/>
                </a:cubicBezTo>
                <a:cubicBezTo>
                  <a:pt x="3942" y="529"/>
                  <a:pt x="3931" y="508"/>
                  <a:pt x="3926" y="484"/>
                </a:cubicBezTo>
                <a:cubicBezTo>
                  <a:pt x="3921" y="459"/>
                  <a:pt x="3924" y="434"/>
                  <a:pt x="3935" y="408"/>
                </a:cubicBezTo>
                <a:cubicBezTo>
                  <a:pt x="3945" y="382"/>
                  <a:pt x="3962" y="357"/>
                  <a:pt x="3985" y="335"/>
                </a:cubicBezTo>
                <a:cubicBezTo>
                  <a:pt x="4010" y="310"/>
                  <a:pt x="4036" y="292"/>
                  <a:pt x="4063" y="281"/>
                </a:cubicBezTo>
                <a:cubicBezTo>
                  <a:pt x="4090" y="270"/>
                  <a:pt x="4116" y="267"/>
                  <a:pt x="4142" y="273"/>
                </a:cubicBezTo>
                <a:cubicBezTo>
                  <a:pt x="4168" y="278"/>
                  <a:pt x="4191" y="290"/>
                  <a:pt x="4211" y="309"/>
                </a:cubicBezTo>
                <a:lnTo>
                  <a:pt x="4172" y="355"/>
                </a:lnTo>
                <a:cubicBezTo>
                  <a:pt x="4149" y="336"/>
                  <a:pt x="4125" y="328"/>
                  <a:pt x="4101" y="330"/>
                </a:cubicBezTo>
                <a:cubicBezTo>
                  <a:pt x="4077" y="332"/>
                  <a:pt x="4052" y="346"/>
                  <a:pt x="4026" y="372"/>
                </a:cubicBezTo>
                <a:cubicBezTo>
                  <a:pt x="3999" y="399"/>
                  <a:pt x="3984" y="424"/>
                  <a:pt x="3982" y="446"/>
                </a:cubicBezTo>
                <a:cubicBezTo>
                  <a:pt x="3979" y="468"/>
                  <a:pt x="3985" y="486"/>
                  <a:pt x="3999" y="500"/>
                </a:cubicBezTo>
                <a:cubicBezTo>
                  <a:pt x="4011" y="512"/>
                  <a:pt x="4025" y="518"/>
                  <a:pt x="4042" y="517"/>
                </a:cubicBezTo>
                <a:cubicBezTo>
                  <a:pt x="4058" y="516"/>
                  <a:pt x="4089" y="502"/>
                  <a:pt x="4133" y="474"/>
                </a:cubicBezTo>
                <a:cubicBezTo>
                  <a:pt x="4177" y="446"/>
                  <a:pt x="4209" y="428"/>
                  <a:pt x="4229" y="421"/>
                </a:cubicBezTo>
                <a:cubicBezTo>
                  <a:pt x="4257" y="410"/>
                  <a:pt x="4283" y="407"/>
                  <a:pt x="4306" y="412"/>
                </a:cubicBezTo>
                <a:cubicBezTo>
                  <a:pt x="4329" y="416"/>
                  <a:pt x="4350" y="427"/>
                  <a:pt x="4368" y="445"/>
                </a:cubicBezTo>
                <a:cubicBezTo>
                  <a:pt x="4386" y="463"/>
                  <a:pt x="4398" y="485"/>
                  <a:pt x="4403" y="511"/>
                </a:cubicBezTo>
                <a:cubicBezTo>
                  <a:pt x="4409" y="537"/>
                  <a:pt x="4406" y="564"/>
                  <a:pt x="4396" y="592"/>
                </a:cubicBezTo>
                <a:cubicBezTo>
                  <a:pt x="4386" y="620"/>
                  <a:pt x="4368" y="646"/>
                  <a:pt x="4344" y="670"/>
                </a:cubicBezTo>
                <a:cubicBezTo>
                  <a:pt x="4314" y="701"/>
                  <a:pt x="4284" y="722"/>
                  <a:pt x="4255" y="733"/>
                </a:cubicBezTo>
                <a:cubicBezTo>
                  <a:pt x="4225" y="745"/>
                  <a:pt x="4196" y="748"/>
                  <a:pt x="4166" y="742"/>
                </a:cubicBezTo>
                <a:cubicBezTo>
                  <a:pt x="4137" y="736"/>
                  <a:pt x="4111" y="722"/>
                  <a:pt x="4087" y="700"/>
                </a:cubicBezTo>
                <a:close/>
                <a:moveTo>
                  <a:pt x="4666" y="337"/>
                </a:moveTo>
                <a:lnTo>
                  <a:pt x="4625" y="378"/>
                </a:lnTo>
                <a:lnTo>
                  <a:pt x="4362" y="116"/>
                </a:lnTo>
                <a:cubicBezTo>
                  <a:pt x="4361" y="135"/>
                  <a:pt x="4358" y="157"/>
                  <a:pt x="4351" y="183"/>
                </a:cubicBezTo>
                <a:cubicBezTo>
                  <a:pt x="4345" y="209"/>
                  <a:pt x="4337" y="230"/>
                  <a:pt x="4329" y="248"/>
                </a:cubicBezTo>
                <a:lnTo>
                  <a:pt x="4289" y="208"/>
                </a:lnTo>
                <a:cubicBezTo>
                  <a:pt x="4301" y="174"/>
                  <a:pt x="4308" y="141"/>
                  <a:pt x="4310" y="108"/>
                </a:cubicBezTo>
                <a:cubicBezTo>
                  <a:pt x="4312" y="75"/>
                  <a:pt x="4309" y="48"/>
                  <a:pt x="4302" y="26"/>
                </a:cubicBezTo>
                <a:lnTo>
                  <a:pt x="4329" y="0"/>
                </a:lnTo>
                <a:lnTo>
                  <a:pt x="4666" y="337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8" name="Freeform 74"/>
          <p:cNvSpPr>
            <a:spLocks noEditPoints="1"/>
          </p:cNvSpPr>
          <p:nvPr/>
        </p:nvSpPr>
        <p:spPr bwMode="auto">
          <a:xfrm>
            <a:off x="4265755" y="5034102"/>
            <a:ext cx="901700" cy="890588"/>
          </a:xfrm>
          <a:custGeom>
            <a:avLst/>
            <a:gdLst>
              <a:gd name="T0" fmla="*/ 239 w 4728"/>
              <a:gd name="T1" fmla="*/ 4138 h 4675"/>
              <a:gd name="T2" fmla="*/ 244 w 4728"/>
              <a:gd name="T3" fmla="*/ 4494 h 4675"/>
              <a:gd name="T4" fmla="*/ 337 w 4728"/>
              <a:gd name="T5" fmla="*/ 4290 h 4675"/>
              <a:gd name="T6" fmla="*/ 85 w 4728"/>
              <a:gd name="T7" fmla="*/ 4334 h 4675"/>
              <a:gd name="T8" fmla="*/ 513 w 4728"/>
              <a:gd name="T9" fmla="*/ 3846 h 4675"/>
              <a:gd name="T10" fmla="*/ 740 w 4728"/>
              <a:gd name="T11" fmla="*/ 3974 h 4675"/>
              <a:gd name="T12" fmla="*/ 780 w 4728"/>
              <a:gd name="T13" fmla="*/ 4232 h 4675"/>
              <a:gd name="T14" fmla="*/ 621 w 4728"/>
              <a:gd name="T15" fmla="*/ 3959 h 4675"/>
              <a:gd name="T16" fmla="*/ 399 w 4728"/>
              <a:gd name="T17" fmla="*/ 4019 h 4675"/>
              <a:gd name="T18" fmla="*/ 785 w 4728"/>
              <a:gd name="T19" fmla="*/ 4125 h 4675"/>
              <a:gd name="T20" fmla="*/ 618 w 4728"/>
              <a:gd name="T21" fmla="*/ 4082 h 4675"/>
              <a:gd name="T22" fmla="*/ 744 w 4728"/>
              <a:gd name="T23" fmla="*/ 3595 h 4675"/>
              <a:gd name="T24" fmla="*/ 1131 w 4728"/>
              <a:gd name="T25" fmla="*/ 3676 h 4675"/>
              <a:gd name="T26" fmla="*/ 964 w 4728"/>
              <a:gd name="T27" fmla="*/ 4047 h 4675"/>
              <a:gd name="T28" fmla="*/ 1082 w 4728"/>
              <a:gd name="T29" fmla="*/ 3718 h 4675"/>
              <a:gd name="T30" fmla="*/ 712 w 4728"/>
              <a:gd name="T31" fmla="*/ 3706 h 4675"/>
              <a:gd name="T32" fmla="*/ 1627 w 4728"/>
              <a:gd name="T33" fmla="*/ 3570 h 4675"/>
              <a:gd name="T34" fmla="*/ 1415 w 4728"/>
              <a:gd name="T35" fmla="*/ 2931 h 4675"/>
              <a:gd name="T36" fmla="*/ 1564 w 4728"/>
              <a:gd name="T37" fmla="*/ 3174 h 4675"/>
              <a:gd name="T38" fmla="*/ 1525 w 4728"/>
              <a:gd name="T39" fmla="*/ 3134 h 4675"/>
              <a:gd name="T40" fmla="*/ 1404 w 4728"/>
              <a:gd name="T41" fmla="*/ 3015 h 4675"/>
              <a:gd name="T42" fmla="*/ 1789 w 4728"/>
              <a:gd name="T43" fmla="*/ 2550 h 4675"/>
              <a:gd name="T44" fmla="*/ 1958 w 4728"/>
              <a:gd name="T45" fmla="*/ 2745 h 4675"/>
              <a:gd name="T46" fmla="*/ 1882 w 4728"/>
              <a:gd name="T47" fmla="*/ 3129 h 4675"/>
              <a:gd name="T48" fmla="*/ 2043 w 4728"/>
              <a:gd name="T49" fmla="*/ 2469 h 4675"/>
              <a:gd name="T50" fmla="*/ 2167 w 4728"/>
              <a:gd name="T51" fmla="*/ 2489 h 4675"/>
              <a:gd name="T52" fmla="*/ 2184 w 4728"/>
              <a:gd name="T53" fmla="*/ 2593 h 4675"/>
              <a:gd name="T54" fmla="*/ 2343 w 4728"/>
              <a:gd name="T55" fmla="*/ 2142 h 4675"/>
              <a:gd name="T56" fmla="*/ 2283 w 4728"/>
              <a:gd name="T57" fmla="*/ 2053 h 4675"/>
              <a:gd name="T58" fmla="*/ 2563 w 4728"/>
              <a:gd name="T59" fmla="*/ 1961 h 4675"/>
              <a:gd name="T60" fmla="*/ 2742 w 4728"/>
              <a:gd name="T61" fmla="*/ 1856 h 4675"/>
              <a:gd name="T62" fmla="*/ 3058 w 4728"/>
              <a:gd name="T63" fmla="*/ 1953 h 4675"/>
              <a:gd name="T64" fmla="*/ 2776 w 4728"/>
              <a:gd name="T65" fmla="*/ 1843 h 4675"/>
              <a:gd name="T66" fmla="*/ 2704 w 4728"/>
              <a:gd name="T67" fmla="*/ 1908 h 4675"/>
              <a:gd name="T68" fmla="*/ 2811 w 4728"/>
              <a:gd name="T69" fmla="*/ 2201 h 4675"/>
              <a:gd name="T70" fmla="*/ 3219 w 4728"/>
              <a:gd name="T71" fmla="*/ 1736 h 4675"/>
              <a:gd name="T72" fmla="*/ 3063 w 4728"/>
              <a:gd name="T73" fmla="*/ 1702 h 4675"/>
              <a:gd name="T74" fmla="*/ 2960 w 4728"/>
              <a:gd name="T75" fmla="*/ 1563 h 4675"/>
              <a:gd name="T76" fmla="*/ 3121 w 4728"/>
              <a:gd name="T77" fmla="*/ 1540 h 4675"/>
              <a:gd name="T78" fmla="*/ 3026 w 4728"/>
              <a:gd name="T79" fmla="*/ 1647 h 4675"/>
              <a:gd name="T80" fmla="*/ 3274 w 4728"/>
              <a:gd name="T81" fmla="*/ 1594 h 4675"/>
              <a:gd name="T82" fmla="*/ 3070 w 4728"/>
              <a:gd name="T83" fmla="*/ 1795 h 4675"/>
              <a:gd name="T84" fmla="*/ 3204 w 4728"/>
              <a:gd name="T85" fmla="*/ 1381 h 4675"/>
              <a:gd name="T86" fmla="*/ 3541 w 4728"/>
              <a:gd name="T87" fmla="*/ 1470 h 4675"/>
              <a:gd name="T88" fmla="*/ 3499 w 4728"/>
              <a:gd name="T89" fmla="*/ 935 h 4675"/>
              <a:gd name="T90" fmla="*/ 3788 w 4728"/>
              <a:gd name="T91" fmla="*/ 1223 h 4675"/>
              <a:gd name="T92" fmla="*/ 3803 w 4728"/>
              <a:gd name="T93" fmla="*/ 574 h 4675"/>
              <a:gd name="T94" fmla="*/ 3808 w 4728"/>
              <a:gd name="T95" fmla="*/ 930 h 4675"/>
              <a:gd name="T96" fmla="*/ 3901 w 4728"/>
              <a:gd name="T97" fmla="*/ 726 h 4675"/>
              <a:gd name="T98" fmla="*/ 3648 w 4728"/>
              <a:gd name="T99" fmla="*/ 770 h 4675"/>
              <a:gd name="T100" fmla="*/ 4242 w 4728"/>
              <a:gd name="T101" fmla="*/ 681 h 4675"/>
              <a:gd name="T102" fmla="*/ 4293 w 4728"/>
              <a:gd name="T103" fmla="*/ 480 h 4675"/>
              <a:gd name="T104" fmla="*/ 3960 w 4728"/>
              <a:gd name="T105" fmla="*/ 553 h 4675"/>
              <a:gd name="T106" fmla="*/ 4143 w 4728"/>
              <a:gd name="T107" fmla="*/ 280 h 4675"/>
              <a:gd name="T108" fmla="*/ 3983 w 4728"/>
              <a:gd name="T109" fmla="*/ 453 h 4675"/>
              <a:gd name="T110" fmla="*/ 4307 w 4728"/>
              <a:gd name="T111" fmla="*/ 419 h 4675"/>
              <a:gd name="T112" fmla="*/ 4256 w 4728"/>
              <a:gd name="T113" fmla="*/ 740 h 4675"/>
              <a:gd name="T114" fmla="*/ 4506 w 4728"/>
              <a:gd name="T115" fmla="*/ 505 h 4675"/>
              <a:gd name="T116" fmla="*/ 4440 w 4728"/>
              <a:gd name="T117" fmla="*/ 81 h 4675"/>
              <a:gd name="T118" fmla="*/ 4274 w 4728"/>
              <a:gd name="T119" fmla="*/ 257 h 4675"/>
              <a:gd name="T120" fmla="*/ 4515 w 4728"/>
              <a:gd name="T121" fmla="*/ 87 h 4675"/>
              <a:gd name="T122" fmla="*/ 4689 w 4728"/>
              <a:gd name="T123" fmla="*/ 243 h 467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  <a:cxn ang="0">
                <a:pos x="T122" y="T123"/>
              </a:cxn>
            </a:cxnLst>
            <a:rect l="0" t="0" r="r" b="b"/>
            <a:pathLst>
              <a:path w="4728" h="4675">
                <a:moveTo>
                  <a:pt x="336" y="4675"/>
                </a:moveTo>
                <a:lnTo>
                  <a:pt x="0" y="4339"/>
                </a:lnTo>
                <a:lnTo>
                  <a:pt x="127" y="4212"/>
                </a:lnTo>
                <a:cubicBezTo>
                  <a:pt x="149" y="4189"/>
                  <a:pt x="168" y="4173"/>
                  <a:pt x="181" y="4164"/>
                </a:cubicBezTo>
                <a:cubicBezTo>
                  <a:pt x="201" y="4150"/>
                  <a:pt x="220" y="4142"/>
                  <a:pt x="239" y="4138"/>
                </a:cubicBezTo>
                <a:cubicBezTo>
                  <a:pt x="258" y="4135"/>
                  <a:pt x="277" y="4136"/>
                  <a:pt x="298" y="4144"/>
                </a:cubicBezTo>
                <a:cubicBezTo>
                  <a:pt x="319" y="4151"/>
                  <a:pt x="337" y="4163"/>
                  <a:pt x="354" y="4179"/>
                </a:cubicBezTo>
                <a:cubicBezTo>
                  <a:pt x="383" y="4208"/>
                  <a:pt x="398" y="4241"/>
                  <a:pt x="399" y="4279"/>
                </a:cubicBezTo>
                <a:cubicBezTo>
                  <a:pt x="401" y="4317"/>
                  <a:pt x="378" y="4360"/>
                  <a:pt x="331" y="4407"/>
                </a:cubicBezTo>
                <a:lnTo>
                  <a:pt x="244" y="4494"/>
                </a:lnTo>
                <a:lnTo>
                  <a:pt x="381" y="4630"/>
                </a:lnTo>
                <a:lnTo>
                  <a:pt x="336" y="4675"/>
                </a:lnTo>
                <a:close/>
                <a:moveTo>
                  <a:pt x="205" y="4454"/>
                </a:moveTo>
                <a:lnTo>
                  <a:pt x="292" y="4367"/>
                </a:lnTo>
                <a:cubicBezTo>
                  <a:pt x="320" y="4338"/>
                  <a:pt x="335" y="4312"/>
                  <a:pt x="337" y="4290"/>
                </a:cubicBezTo>
                <a:cubicBezTo>
                  <a:pt x="338" y="4267"/>
                  <a:pt x="329" y="4246"/>
                  <a:pt x="310" y="4226"/>
                </a:cubicBezTo>
                <a:cubicBezTo>
                  <a:pt x="296" y="4212"/>
                  <a:pt x="280" y="4204"/>
                  <a:pt x="263" y="4201"/>
                </a:cubicBezTo>
                <a:cubicBezTo>
                  <a:pt x="246" y="4198"/>
                  <a:pt x="230" y="4201"/>
                  <a:pt x="215" y="4209"/>
                </a:cubicBezTo>
                <a:cubicBezTo>
                  <a:pt x="205" y="4215"/>
                  <a:pt x="191" y="4228"/>
                  <a:pt x="170" y="4248"/>
                </a:cubicBezTo>
                <a:lnTo>
                  <a:pt x="85" y="4334"/>
                </a:lnTo>
                <a:lnTo>
                  <a:pt x="205" y="4454"/>
                </a:lnTo>
                <a:close/>
                <a:moveTo>
                  <a:pt x="651" y="4360"/>
                </a:moveTo>
                <a:lnTo>
                  <a:pt x="315" y="4024"/>
                </a:lnTo>
                <a:lnTo>
                  <a:pt x="441" y="3898"/>
                </a:lnTo>
                <a:cubicBezTo>
                  <a:pt x="467" y="3872"/>
                  <a:pt x="491" y="3855"/>
                  <a:pt x="513" y="3846"/>
                </a:cubicBezTo>
                <a:cubicBezTo>
                  <a:pt x="536" y="3837"/>
                  <a:pt x="558" y="3836"/>
                  <a:pt x="581" y="3841"/>
                </a:cubicBezTo>
                <a:cubicBezTo>
                  <a:pt x="604" y="3846"/>
                  <a:pt x="623" y="3857"/>
                  <a:pt x="639" y="3872"/>
                </a:cubicBezTo>
                <a:cubicBezTo>
                  <a:pt x="653" y="3886"/>
                  <a:pt x="663" y="3904"/>
                  <a:pt x="668" y="3924"/>
                </a:cubicBezTo>
                <a:cubicBezTo>
                  <a:pt x="673" y="3945"/>
                  <a:pt x="671" y="3967"/>
                  <a:pt x="663" y="3990"/>
                </a:cubicBezTo>
                <a:cubicBezTo>
                  <a:pt x="689" y="3976"/>
                  <a:pt x="715" y="3971"/>
                  <a:pt x="740" y="3974"/>
                </a:cubicBezTo>
                <a:cubicBezTo>
                  <a:pt x="766" y="3977"/>
                  <a:pt x="788" y="3989"/>
                  <a:pt x="808" y="4008"/>
                </a:cubicBezTo>
                <a:cubicBezTo>
                  <a:pt x="824" y="4024"/>
                  <a:pt x="835" y="4042"/>
                  <a:pt x="842" y="4062"/>
                </a:cubicBezTo>
                <a:cubicBezTo>
                  <a:pt x="849" y="4083"/>
                  <a:pt x="851" y="4101"/>
                  <a:pt x="848" y="4118"/>
                </a:cubicBezTo>
                <a:cubicBezTo>
                  <a:pt x="846" y="4135"/>
                  <a:pt x="839" y="4153"/>
                  <a:pt x="828" y="4172"/>
                </a:cubicBezTo>
                <a:cubicBezTo>
                  <a:pt x="817" y="4190"/>
                  <a:pt x="801" y="4210"/>
                  <a:pt x="780" y="4232"/>
                </a:cubicBezTo>
                <a:lnTo>
                  <a:pt x="651" y="4360"/>
                </a:lnTo>
                <a:close/>
                <a:moveTo>
                  <a:pt x="501" y="4120"/>
                </a:moveTo>
                <a:lnTo>
                  <a:pt x="574" y="4048"/>
                </a:lnTo>
                <a:cubicBezTo>
                  <a:pt x="593" y="4028"/>
                  <a:pt x="606" y="4013"/>
                  <a:pt x="612" y="4001"/>
                </a:cubicBezTo>
                <a:cubicBezTo>
                  <a:pt x="620" y="3987"/>
                  <a:pt x="623" y="3973"/>
                  <a:pt x="621" y="3959"/>
                </a:cubicBezTo>
                <a:cubicBezTo>
                  <a:pt x="619" y="3946"/>
                  <a:pt x="612" y="3933"/>
                  <a:pt x="600" y="3921"/>
                </a:cubicBezTo>
                <a:cubicBezTo>
                  <a:pt x="589" y="3910"/>
                  <a:pt x="577" y="3903"/>
                  <a:pt x="563" y="3900"/>
                </a:cubicBezTo>
                <a:cubicBezTo>
                  <a:pt x="549" y="3897"/>
                  <a:pt x="536" y="3898"/>
                  <a:pt x="522" y="3905"/>
                </a:cubicBezTo>
                <a:cubicBezTo>
                  <a:pt x="509" y="3912"/>
                  <a:pt x="491" y="3927"/>
                  <a:pt x="467" y="3952"/>
                </a:cubicBezTo>
                <a:lnTo>
                  <a:pt x="399" y="4019"/>
                </a:lnTo>
                <a:lnTo>
                  <a:pt x="501" y="4120"/>
                </a:lnTo>
                <a:close/>
                <a:moveTo>
                  <a:pt x="656" y="4276"/>
                </a:moveTo>
                <a:lnTo>
                  <a:pt x="740" y="4192"/>
                </a:lnTo>
                <a:cubicBezTo>
                  <a:pt x="754" y="4178"/>
                  <a:pt x="764" y="4167"/>
                  <a:pt x="769" y="4160"/>
                </a:cubicBezTo>
                <a:cubicBezTo>
                  <a:pt x="777" y="4148"/>
                  <a:pt x="782" y="4136"/>
                  <a:pt x="785" y="4125"/>
                </a:cubicBezTo>
                <a:cubicBezTo>
                  <a:pt x="788" y="4114"/>
                  <a:pt x="787" y="4102"/>
                  <a:pt x="783" y="4090"/>
                </a:cubicBezTo>
                <a:cubicBezTo>
                  <a:pt x="780" y="4077"/>
                  <a:pt x="772" y="4065"/>
                  <a:pt x="762" y="4055"/>
                </a:cubicBezTo>
                <a:cubicBezTo>
                  <a:pt x="749" y="4042"/>
                  <a:pt x="735" y="4034"/>
                  <a:pt x="719" y="4032"/>
                </a:cubicBezTo>
                <a:cubicBezTo>
                  <a:pt x="704" y="4029"/>
                  <a:pt x="688" y="4031"/>
                  <a:pt x="673" y="4039"/>
                </a:cubicBezTo>
                <a:cubicBezTo>
                  <a:pt x="658" y="4046"/>
                  <a:pt x="640" y="4061"/>
                  <a:pt x="618" y="4082"/>
                </a:cubicBezTo>
                <a:lnTo>
                  <a:pt x="541" y="4160"/>
                </a:lnTo>
                <a:lnTo>
                  <a:pt x="656" y="4276"/>
                </a:lnTo>
                <a:close/>
                <a:moveTo>
                  <a:pt x="964" y="4047"/>
                </a:moveTo>
                <a:lnTo>
                  <a:pt x="628" y="3711"/>
                </a:lnTo>
                <a:lnTo>
                  <a:pt x="744" y="3595"/>
                </a:lnTo>
                <a:cubicBezTo>
                  <a:pt x="770" y="3569"/>
                  <a:pt x="792" y="3550"/>
                  <a:pt x="809" y="3540"/>
                </a:cubicBezTo>
                <a:cubicBezTo>
                  <a:pt x="832" y="3525"/>
                  <a:pt x="857" y="3517"/>
                  <a:pt x="882" y="3515"/>
                </a:cubicBezTo>
                <a:cubicBezTo>
                  <a:pt x="915" y="3512"/>
                  <a:pt x="947" y="3518"/>
                  <a:pt x="979" y="3532"/>
                </a:cubicBezTo>
                <a:cubicBezTo>
                  <a:pt x="1011" y="3547"/>
                  <a:pt x="1042" y="3569"/>
                  <a:pt x="1072" y="3599"/>
                </a:cubicBezTo>
                <a:cubicBezTo>
                  <a:pt x="1098" y="3625"/>
                  <a:pt x="1118" y="3650"/>
                  <a:pt x="1131" y="3676"/>
                </a:cubicBezTo>
                <a:cubicBezTo>
                  <a:pt x="1145" y="3701"/>
                  <a:pt x="1154" y="3725"/>
                  <a:pt x="1157" y="3748"/>
                </a:cubicBezTo>
                <a:cubicBezTo>
                  <a:pt x="1161" y="3770"/>
                  <a:pt x="1161" y="3790"/>
                  <a:pt x="1157" y="3809"/>
                </a:cubicBezTo>
                <a:cubicBezTo>
                  <a:pt x="1154" y="3827"/>
                  <a:pt x="1146" y="3846"/>
                  <a:pt x="1134" y="3866"/>
                </a:cubicBezTo>
                <a:cubicBezTo>
                  <a:pt x="1122" y="3885"/>
                  <a:pt x="1106" y="3905"/>
                  <a:pt x="1086" y="3925"/>
                </a:cubicBezTo>
                <a:lnTo>
                  <a:pt x="964" y="4047"/>
                </a:lnTo>
                <a:close/>
                <a:moveTo>
                  <a:pt x="969" y="3963"/>
                </a:moveTo>
                <a:lnTo>
                  <a:pt x="1041" y="3891"/>
                </a:lnTo>
                <a:cubicBezTo>
                  <a:pt x="1063" y="3869"/>
                  <a:pt x="1078" y="3849"/>
                  <a:pt x="1087" y="3832"/>
                </a:cubicBezTo>
                <a:cubicBezTo>
                  <a:pt x="1095" y="3816"/>
                  <a:pt x="1100" y="3800"/>
                  <a:pt x="1100" y="3785"/>
                </a:cubicBezTo>
                <a:cubicBezTo>
                  <a:pt x="1100" y="3764"/>
                  <a:pt x="1094" y="3741"/>
                  <a:pt x="1082" y="3718"/>
                </a:cubicBezTo>
                <a:cubicBezTo>
                  <a:pt x="1070" y="3694"/>
                  <a:pt x="1051" y="3670"/>
                  <a:pt x="1026" y="3644"/>
                </a:cubicBezTo>
                <a:cubicBezTo>
                  <a:pt x="991" y="3609"/>
                  <a:pt x="958" y="3588"/>
                  <a:pt x="927" y="3580"/>
                </a:cubicBezTo>
                <a:cubicBezTo>
                  <a:pt x="897" y="3573"/>
                  <a:pt x="870" y="3574"/>
                  <a:pt x="847" y="3585"/>
                </a:cubicBezTo>
                <a:cubicBezTo>
                  <a:pt x="831" y="3592"/>
                  <a:pt x="809" y="3609"/>
                  <a:pt x="783" y="3635"/>
                </a:cubicBezTo>
                <a:lnTo>
                  <a:pt x="712" y="3706"/>
                </a:lnTo>
                <a:lnTo>
                  <a:pt x="969" y="3963"/>
                </a:lnTo>
                <a:close/>
                <a:moveTo>
                  <a:pt x="1354" y="3844"/>
                </a:moveTo>
                <a:lnTo>
                  <a:pt x="1324" y="3814"/>
                </a:lnTo>
                <a:lnTo>
                  <a:pt x="1597" y="3541"/>
                </a:lnTo>
                <a:lnTo>
                  <a:pt x="1627" y="3570"/>
                </a:lnTo>
                <a:lnTo>
                  <a:pt x="1354" y="3844"/>
                </a:lnTo>
                <a:close/>
                <a:moveTo>
                  <a:pt x="1570" y="3441"/>
                </a:moveTo>
                <a:lnTo>
                  <a:pt x="1234" y="3105"/>
                </a:lnTo>
                <a:lnTo>
                  <a:pt x="1360" y="2979"/>
                </a:lnTo>
                <a:cubicBezTo>
                  <a:pt x="1383" y="2956"/>
                  <a:pt x="1401" y="2940"/>
                  <a:pt x="1415" y="2931"/>
                </a:cubicBezTo>
                <a:cubicBezTo>
                  <a:pt x="1434" y="2917"/>
                  <a:pt x="1453" y="2908"/>
                  <a:pt x="1472" y="2905"/>
                </a:cubicBezTo>
                <a:cubicBezTo>
                  <a:pt x="1491" y="2901"/>
                  <a:pt x="1511" y="2903"/>
                  <a:pt x="1531" y="2910"/>
                </a:cubicBezTo>
                <a:cubicBezTo>
                  <a:pt x="1552" y="2917"/>
                  <a:pt x="1571" y="2929"/>
                  <a:pt x="1587" y="2946"/>
                </a:cubicBezTo>
                <a:cubicBezTo>
                  <a:pt x="1616" y="2975"/>
                  <a:pt x="1631" y="3008"/>
                  <a:pt x="1633" y="3046"/>
                </a:cubicBezTo>
                <a:cubicBezTo>
                  <a:pt x="1634" y="3084"/>
                  <a:pt x="1611" y="3127"/>
                  <a:pt x="1564" y="3174"/>
                </a:cubicBezTo>
                <a:lnTo>
                  <a:pt x="1478" y="3260"/>
                </a:lnTo>
                <a:lnTo>
                  <a:pt x="1614" y="3397"/>
                </a:lnTo>
                <a:lnTo>
                  <a:pt x="1570" y="3441"/>
                </a:lnTo>
                <a:close/>
                <a:moveTo>
                  <a:pt x="1438" y="3221"/>
                </a:moveTo>
                <a:lnTo>
                  <a:pt x="1525" y="3134"/>
                </a:lnTo>
                <a:cubicBezTo>
                  <a:pt x="1553" y="3105"/>
                  <a:pt x="1569" y="3079"/>
                  <a:pt x="1570" y="3057"/>
                </a:cubicBezTo>
                <a:cubicBezTo>
                  <a:pt x="1571" y="3034"/>
                  <a:pt x="1562" y="3013"/>
                  <a:pt x="1543" y="2993"/>
                </a:cubicBezTo>
                <a:cubicBezTo>
                  <a:pt x="1529" y="2979"/>
                  <a:pt x="1513" y="2971"/>
                  <a:pt x="1496" y="2968"/>
                </a:cubicBezTo>
                <a:cubicBezTo>
                  <a:pt x="1479" y="2965"/>
                  <a:pt x="1463" y="2968"/>
                  <a:pt x="1448" y="2976"/>
                </a:cubicBezTo>
                <a:cubicBezTo>
                  <a:pt x="1439" y="2982"/>
                  <a:pt x="1424" y="2994"/>
                  <a:pt x="1404" y="3015"/>
                </a:cubicBezTo>
                <a:lnTo>
                  <a:pt x="1318" y="3101"/>
                </a:lnTo>
                <a:lnTo>
                  <a:pt x="1438" y="3221"/>
                </a:lnTo>
                <a:close/>
                <a:moveTo>
                  <a:pt x="1882" y="3129"/>
                </a:moveTo>
                <a:lnTo>
                  <a:pt x="1546" y="2793"/>
                </a:lnTo>
                <a:lnTo>
                  <a:pt x="1789" y="2550"/>
                </a:lnTo>
                <a:lnTo>
                  <a:pt x="1828" y="2590"/>
                </a:lnTo>
                <a:lnTo>
                  <a:pt x="1630" y="2788"/>
                </a:lnTo>
                <a:lnTo>
                  <a:pt x="1733" y="2891"/>
                </a:lnTo>
                <a:lnTo>
                  <a:pt x="1919" y="2706"/>
                </a:lnTo>
                <a:lnTo>
                  <a:pt x="1958" y="2745"/>
                </a:lnTo>
                <a:lnTo>
                  <a:pt x="1772" y="2931"/>
                </a:lnTo>
                <a:lnTo>
                  <a:pt x="1887" y="3045"/>
                </a:lnTo>
                <a:lnTo>
                  <a:pt x="2093" y="2839"/>
                </a:lnTo>
                <a:lnTo>
                  <a:pt x="2133" y="2879"/>
                </a:lnTo>
                <a:lnTo>
                  <a:pt x="1882" y="3129"/>
                </a:lnTo>
                <a:close/>
                <a:moveTo>
                  <a:pt x="2163" y="2848"/>
                </a:moveTo>
                <a:lnTo>
                  <a:pt x="2118" y="2543"/>
                </a:lnTo>
                <a:lnTo>
                  <a:pt x="1843" y="2496"/>
                </a:lnTo>
                <a:lnTo>
                  <a:pt x="1896" y="2443"/>
                </a:lnTo>
                <a:lnTo>
                  <a:pt x="2043" y="2469"/>
                </a:lnTo>
                <a:cubicBezTo>
                  <a:pt x="2073" y="2474"/>
                  <a:pt x="2096" y="2478"/>
                  <a:pt x="2111" y="2483"/>
                </a:cubicBezTo>
                <a:cubicBezTo>
                  <a:pt x="2106" y="2463"/>
                  <a:pt x="2103" y="2441"/>
                  <a:pt x="2099" y="2418"/>
                </a:cubicBezTo>
                <a:lnTo>
                  <a:pt x="2078" y="2261"/>
                </a:lnTo>
                <a:lnTo>
                  <a:pt x="2126" y="2213"/>
                </a:lnTo>
                <a:lnTo>
                  <a:pt x="2167" y="2489"/>
                </a:lnTo>
                <a:lnTo>
                  <a:pt x="2472" y="2540"/>
                </a:lnTo>
                <a:lnTo>
                  <a:pt x="2417" y="2595"/>
                </a:lnTo>
                <a:lnTo>
                  <a:pt x="2212" y="2559"/>
                </a:lnTo>
                <a:cubicBezTo>
                  <a:pt x="2200" y="2557"/>
                  <a:pt x="2188" y="2555"/>
                  <a:pt x="2175" y="2551"/>
                </a:cubicBezTo>
                <a:cubicBezTo>
                  <a:pt x="2180" y="2571"/>
                  <a:pt x="2183" y="2585"/>
                  <a:pt x="2184" y="2593"/>
                </a:cubicBezTo>
                <a:lnTo>
                  <a:pt x="2217" y="2794"/>
                </a:lnTo>
                <a:lnTo>
                  <a:pt x="2163" y="2848"/>
                </a:lnTo>
                <a:close/>
                <a:moveTo>
                  <a:pt x="2647" y="2364"/>
                </a:moveTo>
                <a:lnTo>
                  <a:pt x="2606" y="2405"/>
                </a:lnTo>
                <a:lnTo>
                  <a:pt x="2343" y="2142"/>
                </a:lnTo>
                <a:cubicBezTo>
                  <a:pt x="2343" y="2161"/>
                  <a:pt x="2339" y="2184"/>
                  <a:pt x="2333" y="2210"/>
                </a:cubicBezTo>
                <a:cubicBezTo>
                  <a:pt x="2326" y="2235"/>
                  <a:pt x="2318" y="2257"/>
                  <a:pt x="2310" y="2274"/>
                </a:cubicBezTo>
                <a:lnTo>
                  <a:pt x="2271" y="2234"/>
                </a:lnTo>
                <a:cubicBezTo>
                  <a:pt x="2283" y="2200"/>
                  <a:pt x="2290" y="2167"/>
                  <a:pt x="2292" y="2134"/>
                </a:cubicBezTo>
                <a:cubicBezTo>
                  <a:pt x="2293" y="2102"/>
                  <a:pt x="2291" y="2075"/>
                  <a:pt x="2283" y="2053"/>
                </a:cubicBezTo>
                <a:lnTo>
                  <a:pt x="2310" y="2026"/>
                </a:lnTo>
                <a:lnTo>
                  <a:pt x="2647" y="2364"/>
                </a:lnTo>
                <a:close/>
                <a:moveTo>
                  <a:pt x="2769" y="2242"/>
                </a:moveTo>
                <a:lnTo>
                  <a:pt x="2526" y="1998"/>
                </a:lnTo>
                <a:lnTo>
                  <a:pt x="2563" y="1961"/>
                </a:lnTo>
                <a:lnTo>
                  <a:pt x="2597" y="1996"/>
                </a:lnTo>
                <a:cubicBezTo>
                  <a:pt x="2593" y="1976"/>
                  <a:pt x="2593" y="1956"/>
                  <a:pt x="2599" y="1936"/>
                </a:cubicBezTo>
                <a:cubicBezTo>
                  <a:pt x="2604" y="1916"/>
                  <a:pt x="2615" y="1898"/>
                  <a:pt x="2631" y="1882"/>
                </a:cubicBezTo>
                <a:cubicBezTo>
                  <a:pt x="2649" y="1864"/>
                  <a:pt x="2668" y="1853"/>
                  <a:pt x="2687" y="1849"/>
                </a:cubicBezTo>
                <a:cubicBezTo>
                  <a:pt x="2706" y="1845"/>
                  <a:pt x="2724" y="1847"/>
                  <a:pt x="2742" y="1856"/>
                </a:cubicBezTo>
                <a:cubicBezTo>
                  <a:pt x="2733" y="1808"/>
                  <a:pt x="2744" y="1769"/>
                  <a:pt x="2775" y="1738"/>
                </a:cubicBezTo>
                <a:cubicBezTo>
                  <a:pt x="2799" y="1714"/>
                  <a:pt x="2824" y="1702"/>
                  <a:pt x="2851" y="1702"/>
                </a:cubicBezTo>
                <a:cubicBezTo>
                  <a:pt x="2877" y="1703"/>
                  <a:pt x="2904" y="1717"/>
                  <a:pt x="2932" y="1745"/>
                </a:cubicBezTo>
                <a:lnTo>
                  <a:pt x="3099" y="1912"/>
                </a:lnTo>
                <a:lnTo>
                  <a:pt x="3058" y="1953"/>
                </a:lnTo>
                <a:lnTo>
                  <a:pt x="2905" y="1800"/>
                </a:lnTo>
                <a:cubicBezTo>
                  <a:pt x="2888" y="1783"/>
                  <a:pt x="2875" y="1773"/>
                  <a:pt x="2865" y="1768"/>
                </a:cubicBezTo>
                <a:cubicBezTo>
                  <a:pt x="2855" y="1763"/>
                  <a:pt x="2844" y="1762"/>
                  <a:pt x="2833" y="1765"/>
                </a:cubicBezTo>
                <a:cubicBezTo>
                  <a:pt x="2822" y="1768"/>
                  <a:pt x="2811" y="1774"/>
                  <a:pt x="2802" y="1783"/>
                </a:cubicBezTo>
                <a:cubicBezTo>
                  <a:pt x="2785" y="1800"/>
                  <a:pt x="2776" y="1820"/>
                  <a:pt x="2776" y="1843"/>
                </a:cubicBezTo>
                <a:cubicBezTo>
                  <a:pt x="2776" y="1865"/>
                  <a:pt x="2789" y="1889"/>
                  <a:pt x="2814" y="1914"/>
                </a:cubicBezTo>
                <a:lnTo>
                  <a:pt x="2955" y="2056"/>
                </a:lnTo>
                <a:lnTo>
                  <a:pt x="2914" y="2097"/>
                </a:lnTo>
                <a:lnTo>
                  <a:pt x="2756" y="1939"/>
                </a:lnTo>
                <a:cubicBezTo>
                  <a:pt x="2737" y="1921"/>
                  <a:pt x="2720" y="1910"/>
                  <a:pt x="2704" y="1908"/>
                </a:cubicBezTo>
                <a:cubicBezTo>
                  <a:pt x="2689" y="1905"/>
                  <a:pt x="2673" y="1912"/>
                  <a:pt x="2658" y="1927"/>
                </a:cubicBezTo>
                <a:cubicBezTo>
                  <a:pt x="2646" y="1939"/>
                  <a:pt x="2638" y="1952"/>
                  <a:pt x="2635" y="1968"/>
                </a:cubicBezTo>
                <a:cubicBezTo>
                  <a:pt x="2631" y="1984"/>
                  <a:pt x="2633" y="2000"/>
                  <a:pt x="2640" y="2017"/>
                </a:cubicBezTo>
                <a:cubicBezTo>
                  <a:pt x="2647" y="2033"/>
                  <a:pt x="2662" y="2052"/>
                  <a:pt x="2684" y="2074"/>
                </a:cubicBezTo>
                <a:lnTo>
                  <a:pt x="2811" y="2201"/>
                </a:lnTo>
                <a:lnTo>
                  <a:pt x="2769" y="2242"/>
                </a:lnTo>
                <a:close/>
                <a:moveTo>
                  <a:pt x="3070" y="1795"/>
                </a:moveTo>
                <a:lnTo>
                  <a:pt x="3105" y="1748"/>
                </a:lnTo>
                <a:cubicBezTo>
                  <a:pt x="3123" y="1762"/>
                  <a:pt x="3142" y="1768"/>
                  <a:pt x="3162" y="1767"/>
                </a:cubicBezTo>
                <a:cubicBezTo>
                  <a:pt x="3181" y="1765"/>
                  <a:pt x="3200" y="1755"/>
                  <a:pt x="3219" y="1736"/>
                </a:cubicBezTo>
                <a:cubicBezTo>
                  <a:pt x="3237" y="1717"/>
                  <a:pt x="3248" y="1699"/>
                  <a:pt x="3249" y="1682"/>
                </a:cubicBezTo>
                <a:cubicBezTo>
                  <a:pt x="3251" y="1665"/>
                  <a:pt x="3246" y="1651"/>
                  <a:pt x="3236" y="1641"/>
                </a:cubicBezTo>
                <a:cubicBezTo>
                  <a:pt x="3226" y="1632"/>
                  <a:pt x="3215" y="1628"/>
                  <a:pt x="3202" y="1631"/>
                </a:cubicBezTo>
                <a:cubicBezTo>
                  <a:pt x="3192" y="1633"/>
                  <a:pt x="3174" y="1643"/>
                  <a:pt x="3145" y="1659"/>
                </a:cubicBezTo>
                <a:cubicBezTo>
                  <a:pt x="3108" y="1682"/>
                  <a:pt x="3080" y="1696"/>
                  <a:pt x="3063" y="1702"/>
                </a:cubicBezTo>
                <a:cubicBezTo>
                  <a:pt x="3045" y="1709"/>
                  <a:pt x="3029" y="1710"/>
                  <a:pt x="3013" y="1706"/>
                </a:cubicBezTo>
                <a:cubicBezTo>
                  <a:pt x="2997" y="1702"/>
                  <a:pt x="2983" y="1694"/>
                  <a:pt x="2971" y="1682"/>
                </a:cubicBezTo>
                <a:cubicBezTo>
                  <a:pt x="2960" y="1671"/>
                  <a:pt x="2953" y="1659"/>
                  <a:pt x="2948" y="1645"/>
                </a:cubicBezTo>
                <a:cubicBezTo>
                  <a:pt x="2944" y="1630"/>
                  <a:pt x="2943" y="1616"/>
                  <a:pt x="2946" y="1601"/>
                </a:cubicBezTo>
                <a:cubicBezTo>
                  <a:pt x="2947" y="1590"/>
                  <a:pt x="2952" y="1577"/>
                  <a:pt x="2960" y="1563"/>
                </a:cubicBezTo>
                <a:cubicBezTo>
                  <a:pt x="2968" y="1549"/>
                  <a:pt x="2978" y="1535"/>
                  <a:pt x="2991" y="1523"/>
                </a:cubicBezTo>
                <a:cubicBezTo>
                  <a:pt x="3010" y="1503"/>
                  <a:pt x="3029" y="1489"/>
                  <a:pt x="3049" y="1480"/>
                </a:cubicBezTo>
                <a:cubicBezTo>
                  <a:pt x="3069" y="1471"/>
                  <a:pt x="3087" y="1468"/>
                  <a:pt x="3104" y="1471"/>
                </a:cubicBezTo>
                <a:cubicBezTo>
                  <a:pt x="3120" y="1473"/>
                  <a:pt x="3137" y="1481"/>
                  <a:pt x="3155" y="1494"/>
                </a:cubicBezTo>
                <a:lnTo>
                  <a:pt x="3121" y="1540"/>
                </a:lnTo>
                <a:cubicBezTo>
                  <a:pt x="3106" y="1529"/>
                  <a:pt x="3091" y="1525"/>
                  <a:pt x="3075" y="1527"/>
                </a:cubicBezTo>
                <a:cubicBezTo>
                  <a:pt x="3060" y="1529"/>
                  <a:pt x="3044" y="1537"/>
                  <a:pt x="3028" y="1553"/>
                </a:cubicBezTo>
                <a:cubicBezTo>
                  <a:pt x="3009" y="1572"/>
                  <a:pt x="2998" y="1589"/>
                  <a:pt x="2996" y="1603"/>
                </a:cubicBezTo>
                <a:cubicBezTo>
                  <a:pt x="2995" y="1618"/>
                  <a:pt x="2998" y="1629"/>
                  <a:pt x="3006" y="1638"/>
                </a:cubicBezTo>
                <a:cubicBezTo>
                  <a:pt x="3012" y="1643"/>
                  <a:pt x="3018" y="1646"/>
                  <a:pt x="3026" y="1647"/>
                </a:cubicBezTo>
                <a:cubicBezTo>
                  <a:pt x="3034" y="1648"/>
                  <a:pt x="3042" y="1646"/>
                  <a:pt x="3053" y="1642"/>
                </a:cubicBezTo>
                <a:cubicBezTo>
                  <a:pt x="3058" y="1640"/>
                  <a:pt x="3074" y="1631"/>
                  <a:pt x="3100" y="1616"/>
                </a:cubicBezTo>
                <a:cubicBezTo>
                  <a:pt x="3137" y="1595"/>
                  <a:pt x="3163" y="1581"/>
                  <a:pt x="3180" y="1574"/>
                </a:cubicBezTo>
                <a:cubicBezTo>
                  <a:pt x="3196" y="1568"/>
                  <a:pt x="3213" y="1566"/>
                  <a:pt x="3229" y="1569"/>
                </a:cubicBezTo>
                <a:cubicBezTo>
                  <a:pt x="3245" y="1572"/>
                  <a:pt x="3260" y="1580"/>
                  <a:pt x="3274" y="1594"/>
                </a:cubicBezTo>
                <a:cubicBezTo>
                  <a:pt x="3288" y="1608"/>
                  <a:pt x="3296" y="1625"/>
                  <a:pt x="3301" y="1645"/>
                </a:cubicBezTo>
                <a:cubicBezTo>
                  <a:pt x="3305" y="1665"/>
                  <a:pt x="3303" y="1686"/>
                  <a:pt x="3294" y="1708"/>
                </a:cubicBezTo>
                <a:cubicBezTo>
                  <a:pt x="3286" y="1730"/>
                  <a:pt x="3272" y="1750"/>
                  <a:pt x="3253" y="1769"/>
                </a:cubicBezTo>
                <a:cubicBezTo>
                  <a:pt x="3221" y="1801"/>
                  <a:pt x="3190" y="1819"/>
                  <a:pt x="3161" y="1822"/>
                </a:cubicBezTo>
                <a:cubicBezTo>
                  <a:pt x="3131" y="1825"/>
                  <a:pt x="3101" y="1817"/>
                  <a:pt x="3070" y="1795"/>
                </a:cubicBezTo>
                <a:close/>
                <a:moveTo>
                  <a:pt x="3541" y="1470"/>
                </a:moveTo>
                <a:lnTo>
                  <a:pt x="3500" y="1511"/>
                </a:lnTo>
                <a:lnTo>
                  <a:pt x="3237" y="1248"/>
                </a:lnTo>
                <a:cubicBezTo>
                  <a:pt x="3237" y="1268"/>
                  <a:pt x="3233" y="1290"/>
                  <a:pt x="3226" y="1316"/>
                </a:cubicBezTo>
                <a:cubicBezTo>
                  <a:pt x="3220" y="1341"/>
                  <a:pt x="3212" y="1363"/>
                  <a:pt x="3204" y="1381"/>
                </a:cubicBezTo>
                <a:lnTo>
                  <a:pt x="3164" y="1341"/>
                </a:lnTo>
                <a:cubicBezTo>
                  <a:pt x="3177" y="1307"/>
                  <a:pt x="3184" y="1273"/>
                  <a:pt x="3185" y="1241"/>
                </a:cubicBezTo>
                <a:cubicBezTo>
                  <a:pt x="3187" y="1208"/>
                  <a:pt x="3184" y="1181"/>
                  <a:pt x="3177" y="1159"/>
                </a:cubicBezTo>
                <a:lnTo>
                  <a:pt x="3204" y="1132"/>
                </a:lnTo>
                <a:lnTo>
                  <a:pt x="3541" y="1470"/>
                </a:lnTo>
                <a:close/>
                <a:moveTo>
                  <a:pt x="3499" y="935"/>
                </a:moveTo>
                <a:lnTo>
                  <a:pt x="3452" y="887"/>
                </a:lnTo>
                <a:lnTo>
                  <a:pt x="3493" y="846"/>
                </a:lnTo>
                <a:lnTo>
                  <a:pt x="3540" y="893"/>
                </a:lnTo>
                <a:lnTo>
                  <a:pt x="3499" y="935"/>
                </a:lnTo>
                <a:close/>
                <a:moveTo>
                  <a:pt x="3788" y="1223"/>
                </a:moveTo>
                <a:lnTo>
                  <a:pt x="3544" y="980"/>
                </a:lnTo>
                <a:lnTo>
                  <a:pt x="3586" y="939"/>
                </a:lnTo>
                <a:lnTo>
                  <a:pt x="3829" y="1182"/>
                </a:lnTo>
                <a:lnTo>
                  <a:pt x="3788" y="1223"/>
                </a:lnTo>
                <a:close/>
                <a:moveTo>
                  <a:pt x="3900" y="1111"/>
                </a:moveTo>
                <a:lnTo>
                  <a:pt x="3564" y="775"/>
                </a:lnTo>
                <a:lnTo>
                  <a:pt x="3691" y="648"/>
                </a:lnTo>
                <a:cubicBezTo>
                  <a:pt x="3713" y="626"/>
                  <a:pt x="3731" y="610"/>
                  <a:pt x="3745" y="600"/>
                </a:cubicBezTo>
                <a:cubicBezTo>
                  <a:pt x="3765" y="586"/>
                  <a:pt x="3784" y="578"/>
                  <a:pt x="3803" y="574"/>
                </a:cubicBezTo>
                <a:cubicBezTo>
                  <a:pt x="3821" y="571"/>
                  <a:pt x="3841" y="573"/>
                  <a:pt x="3862" y="580"/>
                </a:cubicBezTo>
                <a:cubicBezTo>
                  <a:pt x="3883" y="587"/>
                  <a:pt x="3901" y="599"/>
                  <a:pt x="3918" y="615"/>
                </a:cubicBezTo>
                <a:cubicBezTo>
                  <a:pt x="3947" y="644"/>
                  <a:pt x="3962" y="677"/>
                  <a:pt x="3963" y="715"/>
                </a:cubicBezTo>
                <a:cubicBezTo>
                  <a:pt x="3965" y="753"/>
                  <a:pt x="3942" y="796"/>
                  <a:pt x="3894" y="844"/>
                </a:cubicBezTo>
                <a:lnTo>
                  <a:pt x="3808" y="930"/>
                </a:lnTo>
                <a:lnTo>
                  <a:pt x="3945" y="1066"/>
                </a:lnTo>
                <a:lnTo>
                  <a:pt x="3900" y="1111"/>
                </a:lnTo>
                <a:close/>
                <a:moveTo>
                  <a:pt x="3768" y="890"/>
                </a:moveTo>
                <a:lnTo>
                  <a:pt x="3855" y="803"/>
                </a:lnTo>
                <a:cubicBezTo>
                  <a:pt x="3884" y="774"/>
                  <a:pt x="3899" y="749"/>
                  <a:pt x="3901" y="726"/>
                </a:cubicBezTo>
                <a:cubicBezTo>
                  <a:pt x="3902" y="703"/>
                  <a:pt x="3893" y="682"/>
                  <a:pt x="3873" y="663"/>
                </a:cubicBezTo>
                <a:cubicBezTo>
                  <a:pt x="3859" y="649"/>
                  <a:pt x="3844" y="640"/>
                  <a:pt x="3827" y="637"/>
                </a:cubicBezTo>
                <a:cubicBezTo>
                  <a:pt x="3810" y="634"/>
                  <a:pt x="3794" y="637"/>
                  <a:pt x="3779" y="645"/>
                </a:cubicBezTo>
                <a:cubicBezTo>
                  <a:pt x="3769" y="651"/>
                  <a:pt x="3754" y="664"/>
                  <a:pt x="3734" y="684"/>
                </a:cubicBezTo>
                <a:lnTo>
                  <a:pt x="3648" y="770"/>
                </a:lnTo>
                <a:lnTo>
                  <a:pt x="3768" y="890"/>
                </a:lnTo>
                <a:close/>
                <a:moveTo>
                  <a:pt x="4088" y="707"/>
                </a:moveTo>
                <a:lnTo>
                  <a:pt x="4127" y="661"/>
                </a:lnTo>
                <a:cubicBezTo>
                  <a:pt x="4145" y="676"/>
                  <a:pt x="4164" y="685"/>
                  <a:pt x="4182" y="689"/>
                </a:cubicBezTo>
                <a:cubicBezTo>
                  <a:pt x="4200" y="692"/>
                  <a:pt x="4220" y="690"/>
                  <a:pt x="4242" y="681"/>
                </a:cubicBezTo>
                <a:cubicBezTo>
                  <a:pt x="4264" y="672"/>
                  <a:pt x="4284" y="659"/>
                  <a:pt x="4303" y="639"/>
                </a:cubicBezTo>
                <a:cubicBezTo>
                  <a:pt x="4320" y="622"/>
                  <a:pt x="4333" y="605"/>
                  <a:pt x="4341" y="587"/>
                </a:cubicBezTo>
                <a:cubicBezTo>
                  <a:pt x="4349" y="569"/>
                  <a:pt x="4351" y="552"/>
                  <a:pt x="4349" y="537"/>
                </a:cubicBezTo>
                <a:cubicBezTo>
                  <a:pt x="4347" y="522"/>
                  <a:pt x="4340" y="509"/>
                  <a:pt x="4330" y="499"/>
                </a:cubicBezTo>
                <a:cubicBezTo>
                  <a:pt x="4319" y="488"/>
                  <a:pt x="4307" y="482"/>
                  <a:pt x="4293" y="480"/>
                </a:cubicBezTo>
                <a:cubicBezTo>
                  <a:pt x="4279" y="479"/>
                  <a:pt x="4262" y="482"/>
                  <a:pt x="4243" y="491"/>
                </a:cubicBezTo>
                <a:cubicBezTo>
                  <a:pt x="4230" y="496"/>
                  <a:pt x="4205" y="511"/>
                  <a:pt x="4167" y="534"/>
                </a:cubicBezTo>
                <a:cubicBezTo>
                  <a:pt x="4128" y="558"/>
                  <a:pt x="4100" y="572"/>
                  <a:pt x="4081" y="578"/>
                </a:cubicBezTo>
                <a:cubicBezTo>
                  <a:pt x="4056" y="586"/>
                  <a:pt x="4034" y="587"/>
                  <a:pt x="4014" y="583"/>
                </a:cubicBezTo>
                <a:cubicBezTo>
                  <a:pt x="3993" y="578"/>
                  <a:pt x="3975" y="568"/>
                  <a:pt x="3960" y="553"/>
                </a:cubicBezTo>
                <a:cubicBezTo>
                  <a:pt x="3943" y="536"/>
                  <a:pt x="3932" y="515"/>
                  <a:pt x="3927" y="491"/>
                </a:cubicBezTo>
                <a:cubicBezTo>
                  <a:pt x="3922" y="466"/>
                  <a:pt x="3925" y="441"/>
                  <a:pt x="3935" y="415"/>
                </a:cubicBezTo>
                <a:cubicBezTo>
                  <a:pt x="3946" y="389"/>
                  <a:pt x="3963" y="364"/>
                  <a:pt x="3986" y="342"/>
                </a:cubicBezTo>
                <a:cubicBezTo>
                  <a:pt x="4011" y="317"/>
                  <a:pt x="4036" y="299"/>
                  <a:pt x="4064" y="288"/>
                </a:cubicBezTo>
                <a:cubicBezTo>
                  <a:pt x="4091" y="277"/>
                  <a:pt x="4117" y="274"/>
                  <a:pt x="4143" y="280"/>
                </a:cubicBezTo>
                <a:cubicBezTo>
                  <a:pt x="4169" y="285"/>
                  <a:pt x="4192" y="297"/>
                  <a:pt x="4212" y="316"/>
                </a:cubicBezTo>
                <a:lnTo>
                  <a:pt x="4173" y="362"/>
                </a:lnTo>
                <a:cubicBezTo>
                  <a:pt x="4149" y="343"/>
                  <a:pt x="4126" y="335"/>
                  <a:pt x="4101" y="337"/>
                </a:cubicBezTo>
                <a:cubicBezTo>
                  <a:pt x="4077" y="339"/>
                  <a:pt x="4052" y="353"/>
                  <a:pt x="4027" y="379"/>
                </a:cubicBezTo>
                <a:cubicBezTo>
                  <a:pt x="4000" y="406"/>
                  <a:pt x="3985" y="431"/>
                  <a:pt x="3983" y="453"/>
                </a:cubicBezTo>
                <a:cubicBezTo>
                  <a:pt x="3980" y="475"/>
                  <a:pt x="3986" y="493"/>
                  <a:pt x="4000" y="507"/>
                </a:cubicBezTo>
                <a:cubicBezTo>
                  <a:pt x="4012" y="519"/>
                  <a:pt x="4026" y="525"/>
                  <a:pt x="4043" y="524"/>
                </a:cubicBezTo>
                <a:cubicBezTo>
                  <a:pt x="4059" y="523"/>
                  <a:pt x="4089" y="509"/>
                  <a:pt x="4134" y="481"/>
                </a:cubicBezTo>
                <a:cubicBezTo>
                  <a:pt x="4178" y="453"/>
                  <a:pt x="4210" y="435"/>
                  <a:pt x="4230" y="428"/>
                </a:cubicBezTo>
                <a:cubicBezTo>
                  <a:pt x="4258" y="417"/>
                  <a:pt x="4284" y="414"/>
                  <a:pt x="4307" y="419"/>
                </a:cubicBezTo>
                <a:cubicBezTo>
                  <a:pt x="4330" y="423"/>
                  <a:pt x="4351" y="434"/>
                  <a:pt x="4369" y="452"/>
                </a:cubicBezTo>
                <a:cubicBezTo>
                  <a:pt x="4387" y="470"/>
                  <a:pt x="4399" y="492"/>
                  <a:pt x="4404" y="518"/>
                </a:cubicBezTo>
                <a:cubicBezTo>
                  <a:pt x="4410" y="544"/>
                  <a:pt x="4407" y="571"/>
                  <a:pt x="4397" y="599"/>
                </a:cubicBezTo>
                <a:cubicBezTo>
                  <a:pt x="4386" y="627"/>
                  <a:pt x="4369" y="653"/>
                  <a:pt x="4345" y="677"/>
                </a:cubicBezTo>
                <a:cubicBezTo>
                  <a:pt x="4315" y="708"/>
                  <a:pt x="4285" y="729"/>
                  <a:pt x="4256" y="740"/>
                </a:cubicBezTo>
                <a:cubicBezTo>
                  <a:pt x="4226" y="752"/>
                  <a:pt x="4197" y="755"/>
                  <a:pt x="4167" y="749"/>
                </a:cubicBezTo>
                <a:cubicBezTo>
                  <a:pt x="4138" y="743"/>
                  <a:pt x="4111" y="729"/>
                  <a:pt x="4088" y="707"/>
                </a:cubicBezTo>
                <a:close/>
                <a:moveTo>
                  <a:pt x="4689" y="243"/>
                </a:moveTo>
                <a:lnTo>
                  <a:pt x="4728" y="283"/>
                </a:lnTo>
                <a:lnTo>
                  <a:pt x="4506" y="505"/>
                </a:lnTo>
                <a:cubicBezTo>
                  <a:pt x="4496" y="495"/>
                  <a:pt x="4488" y="484"/>
                  <a:pt x="4482" y="471"/>
                </a:cubicBezTo>
                <a:cubicBezTo>
                  <a:pt x="4473" y="451"/>
                  <a:pt x="4467" y="427"/>
                  <a:pt x="4465" y="400"/>
                </a:cubicBezTo>
                <a:cubicBezTo>
                  <a:pt x="4463" y="372"/>
                  <a:pt x="4464" y="337"/>
                  <a:pt x="4468" y="295"/>
                </a:cubicBezTo>
                <a:cubicBezTo>
                  <a:pt x="4474" y="228"/>
                  <a:pt x="4475" y="180"/>
                  <a:pt x="4471" y="149"/>
                </a:cubicBezTo>
                <a:cubicBezTo>
                  <a:pt x="4466" y="119"/>
                  <a:pt x="4456" y="96"/>
                  <a:pt x="4440" y="81"/>
                </a:cubicBezTo>
                <a:cubicBezTo>
                  <a:pt x="4424" y="64"/>
                  <a:pt x="4404" y="56"/>
                  <a:pt x="4381" y="57"/>
                </a:cubicBezTo>
                <a:cubicBezTo>
                  <a:pt x="4359" y="57"/>
                  <a:pt x="4338" y="67"/>
                  <a:pt x="4319" y="86"/>
                </a:cubicBezTo>
                <a:cubicBezTo>
                  <a:pt x="4299" y="105"/>
                  <a:pt x="4289" y="127"/>
                  <a:pt x="4289" y="151"/>
                </a:cubicBezTo>
                <a:cubicBezTo>
                  <a:pt x="4289" y="175"/>
                  <a:pt x="4300" y="198"/>
                  <a:pt x="4320" y="219"/>
                </a:cubicBezTo>
                <a:lnTo>
                  <a:pt x="4274" y="257"/>
                </a:lnTo>
                <a:cubicBezTo>
                  <a:pt x="4245" y="222"/>
                  <a:pt x="4232" y="187"/>
                  <a:pt x="4234" y="152"/>
                </a:cubicBezTo>
                <a:cubicBezTo>
                  <a:pt x="4237" y="116"/>
                  <a:pt x="4254" y="82"/>
                  <a:pt x="4286" y="51"/>
                </a:cubicBezTo>
                <a:cubicBezTo>
                  <a:pt x="4318" y="18"/>
                  <a:pt x="4352" y="2"/>
                  <a:pt x="4389" y="1"/>
                </a:cubicBezTo>
                <a:cubicBezTo>
                  <a:pt x="4426" y="0"/>
                  <a:pt x="4457" y="13"/>
                  <a:pt x="4484" y="39"/>
                </a:cubicBezTo>
                <a:cubicBezTo>
                  <a:pt x="4497" y="53"/>
                  <a:pt x="4508" y="68"/>
                  <a:pt x="4515" y="87"/>
                </a:cubicBezTo>
                <a:cubicBezTo>
                  <a:pt x="4523" y="105"/>
                  <a:pt x="4527" y="128"/>
                  <a:pt x="4529" y="155"/>
                </a:cubicBezTo>
                <a:cubicBezTo>
                  <a:pt x="4530" y="183"/>
                  <a:pt x="4529" y="223"/>
                  <a:pt x="4524" y="278"/>
                </a:cubicBezTo>
                <a:cubicBezTo>
                  <a:pt x="4520" y="324"/>
                  <a:pt x="4519" y="354"/>
                  <a:pt x="4519" y="368"/>
                </a:cubicBezTo>
                <a:cubicBezTo>
                  <a:pt x="4519" y="383"/>
                  <a:pt x="4521" y="396"/>
                  <a:pt x="4524" y="408"/>
                </a:cubicBezTo>
                <a:lnTo>
                  <a:pt x="4689" y="243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9" name="Freeform 75"/>
          <p:cNvSpPr>
            <a:spLocks noEditPoints="1"/>
          </p:cNvSpPr>
          <p:nvPr/>
        </p:nvSpPr>
        <p:spPr bwMode="auto">
          <a:xfrm>
            <a:off x="4537217" y="5035690"/>
            <a:ext cx="890587" cy="889000"/>
          </a:xfrm>
          <a:custGeom>
            <a:avLst/>
            <a:gdLst>
              <a:gd name="T0" fmla="*/ 239 w 4676"/>
              <a:gd name="T1" fmla="*/ 4129 h 4666"/>
              <a:gd name="T2" fmla="*/ 244 w 4676"/>
              <a:gd name="T3" fmla="*/ 4485 h 4666"/>
              <a:gd name="T4" fmla="*/ 337 w 4676"/>
              <a:gd name="T5" fmla="*/ 4281 h 4666"/>
              <a:gd name="T6" fmla="*/ 84 w 4676"/>
              <a:gd name="T7" fmla="*/ 4325 h 4666"/>
              <a:gd name="T8" fmla="*/ 513 w 4676"/>
              <a:gd name="T9" fmla="*/ 3837 h 4666"/>
              <a:gd name="T10" fmla="*/ 740 w 4676"/>
              <a:gd name="T11" fmla="*/ 3965 h 4666"/>
              <a:gd name="T12" fmla="*/ 779 w 4676"/>
              <a:gd name="T13" fmla="*/ 4223 h 4666"/>
              <a:gd name="T14" fmla="*/ 621 w 4676"/>
              <a:gd name="T15" fmla="*/ 3950 h 4666"/>
              <a:gd name="T16" fmla="*/ 399 w 4676"/>
              <a:gd name="T17" fmla="*/ 4010 h 4666"/>
              <a:gd name="T18" fmla="*/ 785 w 4676"/>
              <a:gd name="T19" fmla="*/ 4116 h 4666"/>
              <a:gd name="T20" fmla="*/ 618 w 4676"/>
              <a:gd name="T21" fmla="*/ 4073 h 4666"/>
              <a:gd name="T22" fmla="*/ 744 w 4676"/>
              <a:gd name="T23" fmla="*/ 3586 h 4666"/>
              <a:gd name="T24" fmla="*/ 1131 w 4676"/>
              <a:gd name="T25" fmla="*/ 3667 h 4666"/>
              <a:gd name="T26" fmla="*/ 964 w 4676"/>
              <a:gd name="T27" fmla="*/ 4038 h 4666"/>
              <a:gd name="T28" fmla="*/ 1082 w 4676"/>
              <a:gd name="T29" fmla="*/ 3709 h 4666"/>
              <a:gd name="T30" fmla="*/ 712 w 4676"/>
              <a:gd name="T31" fmla="*/ 3697 h 4666"/>
              <a:gd name="T32" fmla="*/ 1627 w 4676"/>
              <a:gd name="T33" fmla="*/ 3561 h 4666"/>
              <a:gd name="T34" fmla="*/ 1415 w 4676"/>
              <a:gd name="T35" fmla="*/ 2922 h 4666"/>
              <a:gd name="T36" fmla="*/ 1564 w 4676"/>
              <a:gd name="T37" fmla="*/ 3165 h 4666"/>
              <a:gd name="T38" fmla="*/ 1525 w 4676"/>
              <a:gd name="T39" fmla="*/ 3125 h 4666"/>
              <a:gd name="T40" fmla="*/ 1404 w 4676"/>
              <a:gd name="T41" fmla="*/ 3006 h 4666"/>
              <a:gd name="T42" fmla="*/ 1788 w 4676"/>
              <a:gd name="T43" fmla="*/ 2541 h 4666"/>
              <a:gd name="T44" fmla="*/ 1958 w 4676"/>
              <a:gd name="T45" fmla="*/ 2736 h 4666"/>
              <a:gd name="T46" fmla="*/ 1882 w 4676"/>
              <a:gd name="T47" fmla="*/ 3120 h 4666"/>
              <a:gd name="T48" fmla="*/ 2043 w 4676"/>
              <a:gd name="T49" fmla="*/ 2460 h 4666"/>
              <a:gd name="T50" fmla="*/ 2166 w 4676"/>
              <a:gd name="T51" fmla="*/ 2480 h 4666"/>
              <a:gd name="T52" fmla="*/ 2184 w 4676"/>
              <a:gd name="T53" fmla="*/ 2584 h 4666"/>
              <a:gd name="T54" fmla="*/ 2343 w 4676"/>
              <a:gd name="T55" fmla="*/ 2133 h 4666"/>
              <a:gd name="T56" fmla="*/ 2283 w 4676"/>
              <a:gd name="T57" fmla="*/ 2044 h 4666"/>
              <a:gd name="T58" fmla="*/ 2563 w 4676"/>
              <a:gd name="T59" fmla="*/ 1952 h 4666"/>
              <a:gd name="T60" fmla="*/ 2742 w 4676"/>
              <a:gd name="T61" fmla="*/ 1847 h 4666"/>
              <a:gd name="T62" fmla="*/ 3058 w 4676"/>
              <a:gd name="T63" fmla="*/ 1944 h 4666"/>
              <a:gd name="T64" fmla="*/ 2776 w 4676"/>
              <a:gd name="T65" fmla="*/ 1834 h 4666"/>
              <a:gd name="T66" fmla="*/ 2704 w 4676"/>
              <a:gd name="T67" fmla="*/ 1899 h 4666"/>
              <a:gd name="T68" fmla="*/ 2810 w 4676"/>
              <a:gd name="T69" fmla="*/ 2192 h 4666"/>
              <a:gd name="T70" fmla="*/ 3218 w 4676"/>
              <a:gd name="T71" fmla="*/ 1727 h 4666"/>
              <a:gd name="T72" fmla="*/ 3063 w 4676"/>
              <a:gd name="T73" fmla="*/ 1693 h 4666"/>
              <a:gd name="T74" fmla="*/ 2960 w 4676"/>
              <a:gd name="T75" fmla="*/ 1554 h 4666"/>
              <a:gd name="T76" fmla="*/ 3121 w 4676"/>
              <a:gd name="T77" fmla="*/ 1531 h 4666"/>
              <a:gd name="T78" fmla="*/ 3026 w 4676"/>
              <a:gd name="T79" fmla="*/ 1638 h 4666"/>
              <a:gd name="T80" fmla="*/ 3274 w 4676"/>
              <a:gd name="T81" fmla="*/ 1585 h 4666"/>
              <a:gd name="T82" fmla="*/ 3070 w 4676"/>
              <a:gd name="T83" fmla="*/ 1786 h 4666"/>
              <a:gd name="T84" fmla="*/ 3204 w 4676"/>
              <a:gd name="T85" fmla="*/ 1372 h 4666"/>
              <a:gd name="T86" fmla="*/ 3541 w 4676"/>
              <a:gd name="T87" fmla="*/ 1461 h 4666"/>
              <a:gd name="T88" fmla="*/ 3499 w 4676"/>
              <a:gd name="T89" fmla="*/ 926 h 4666"/>
              <a:gd name="T90" fmla="*/ 3788 w 4676"/>
              <a:gd name="T91" fmla="*/ 1214 h 4666"/>
              <a:gd name="T92" fmla="*/ 3802 w 4676"/>
              <a:gd name="T93" fmla="*/ 565 h 4666"/>
              <a:gd name="T94" fmla="*/ 3808 w 4676"/>
              <a:gd name="T95" fmla="*/ 921 h 4666"/>
              <a:gd name="T96" fmla="*/ 3900 w 4676"/>
              <a:gd name="T97" fmla="*/ 717 h 4666"/>
              <a:gd name="T98" fmla="*/ 3648 w 4676"/>
              <a:gd name="T99" fmla="*/ 761 h 4666"/>
              <a:gd name="T100" fmla="*/ 4242 w 4676"/>
              <a:gd name="T101" fmla="*/ 672 h 4666"/>
              <a:gd name="T102" fmla="*/ 4293 w 4676"/>
              <a:gd name="T103" fmla="*/ 471 h 4666"/>
              <a:gd name="T104" fmla="*/ 3960 w 4676"/>
              <a:gd name="T105" fmla="*/ 544 h 4666"/>
              <a:gd name="T106" fmla="*/ 4143 w 4676"/>
              <a:gd name="T107" fmla="*/ 271 h 4666"/>
              <a:gd name="T108" fmla="*/ 3982 w 4676"/>
              <a:gd name="T109" fmla="*/ 444 h 4666"/>
              <a:gd name="T110" fmla="*/ 4307 w 4676"/>
              <a:gd name="T111" fmla="*/ 410 h 4666"/>
              <a:gd name="T112" fmla="*/ 4255 w 4676"/>
              <a:gd name="T113" fmla="*/ 731 h 4666"/>
              <a:gd name="T114" fmla="*/ 4533 w 4676"/>
              <a:gd name="T115" fmla="*/ 381 h 4666"/>
              <a:gd name="T116" fmla="*/ 4458 w 4676"/>
              <a:gd name="T117" fmla="*/ 216 h 4666"/>
              <a:gd name="T118" fmla="*/ 4422 w 4676"/>
              <a:gd name="T119" fmla="*/ 78 h 4666"/>
              <a:gd name="T120" fmla="*/ 4265 w 4676"/>
              <a:gd name="T121" fmla="*/ 236 h 4666"/>
              <a:gd name="T122" fmla="*/ 4465 w 4676"/>
              <a:gd name="T123" fmla="*/ 37 h 4666"/>
              <a:gd name="T124" fmla="*/ 4675 w 4676"/>
              <a:gd name="T125" fmla="*/ 278 h 466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  <a:cxn ang="0">
                <a:pos x="T122" y="T123"/>
              </a:cxn>
              <a:cxn ang="0">
                <a:pos x="T124" y="T125"/>
              </a:cxn>
            </a:cxnLst>
            <a:rect l="0" t="0" r="r" b="b"/>
            <a:pathLst>
              <a:path w="4676" h="4666">
                <a:moveTo>
                  <a:pt x="336" y="4666"/>
                </a:moveTo>
                <a:lnTo>
                  <a:pt x="0" y="4330"/>
                </a:lnTo>
                <a:lnTo>
                  <a:pt x="127" y="4203"/>
                </a:lnTo>
                <a:cubicBezTo>
                  <a:pt x="149" y="4180"/>
                  <a:pt x="167" y="4164"/>
                  <a:pt x="181" y="4155"/>
                </a:cubicBezTo>
                <a:cubicBezTo>
                  <a:pt x="201" y="4141"/>
                  <a:pt x="220" y="4133"/>
                  <a:pt x="239" y="4129"/>
                </a:cubicBezTo>
                <a:cubicBezTo>
                  <a:pt x="257" y="4126"/>
                  <a:pt x="277" y="4127"/>
                  <a:pt x="298" y="4135"/>
                </a:cubicBezTo>
                <a:cubicBezTo>
                  <a:pt x="319" y="4142"/>
                  <a:pt x="337" y="4154"/>
                  <a:pt x="354" y="4170"/>
                </a:cubicBezTo>
                <a:cubicBezTo>
                  <a:pt x="383" y="4199"/>
                  <a:pt x="398" y="4232"/>
                  <a:pt x="399" y="4270"/>
                </a:cubicBezTo>
                <a:cubicBezTo>
                  <a:pt x="401" y="4308"/>
                  <a:pt x="378" y="4351"/>
                  <a:pt x="330" y="4398"/>
                </a:cubicBezTo>
                <a:lnTo>
                  <a:pt x="244" y="4485"/>
                </a:lnTo>
                <a:lnTo>
                  <a:pt x="381" y="4621"/>
                </a:lnTo>
                <a:lnTo>
                  <a:pt x="336" y="4666"/>
                </a:lnTo>
                <a:close/>
                <a:moveTo>
                  <a:pt x="204" y="4445"/>
                </a:moveTo>
                <a:lnTo>
                  <a:pt x="291" y="4358"/>
                </a:lnTo>
                <a:cubicBezTo>
                  <a:pt x="320" y="4329"/>
                  <a:pt x="335" y="4303"/>
                  <a:pt x="337" y="4281"/>
                </a:cubicBezTo>
                <a:cubicBezTo>
                  <a:pt x="338" y="4258"/>
                  <a:pt x="329" y="4237"/>
                  <a:pt x="309" y="4217"/>
                </a:cubicBezTo>
                <a:cubicBezTo>
                  <a:pt x="295" y="4203"/>
                  <a:pt x="280" y="4195"/>
                  <a:pt x="263" y="4192"/>
                </a:cubicBezTo>
                <a:cubicBezTo>
                  <a:pt x="246" y="4189"/>
                  <a:pt x="230" y="4192"/>
                  <a:pt x="215" y="4200"/>
                </a:cubicBezTo>
                <a:cubicBezTo>
                  <a:pt x="205" y="4206"/>
                  <a:pt x="191" y="4219"/>
                  <a:pt x="170" y="4239"/>
                </a:cubicBezTo>
                <a:lnTo>
                  <a:pt x="84" y="4325"/>
                </a:lnTo>
                <a:lnTo>
                  <a:pt x="204" y="4445"/>
                </a:lnTo>
                <a:close/>
                <a:moveTo>
                  <a:pt x="651" y="4351"/>
                </a:moveTo>
                <a:lnTo>
                  <a:pt x="315" y="4015"/>
                </a:lnTo>
                <a:lnTo>
                  <a:pt x="441" y="3889"/>
                </a:lnTo>
                <a:cubicBezTo>
                  <a:pt x="467" y="3863"/>
                  <a:pt x="491" y="3846"/>
                  <a:pt x="513" y="3837"/>
                </a:cubicBezTo>
                <a:cubicBezTo>
                  <a:pt x="536" y="3828"/>
                  <a:pt x="558" y="3827"/>
                  <a:pt x="581" y="3832"/>
                </a:cubicBezTo>
                <a:cubicBezTo>
                  <a:pt x="604" y="3837"/>
                  <a:pt x="623" y="3848"/>
                  <a:pt x="639" y="3863"/>
                </a:cubicBezTo>
                <a:cubicBezTo>
                  <a:pt x="653" y="3877"/>
                  <a:pt x="663" y="3895"/>
                  <a:pt x="668" y="3915"/>
                </a:cubicBezTo>
                <a:cubicBezTo>
                  <a:pt x="672" y="3936"/>
                  <a:pt x="671" y="3958"/>
                  <a:pt x="663" y="3981"/>
                </a:cubicBezTo>
                <a:cubicBezTo>
                  <a:pt x="689" y="3967"/>
                  <a:pt x="715" y="3962"/>
                  <a:pt x="740" y="3965"/>
                </a:cubicBezTo>
                <a:cubicBezTo>
                  <a:pt x="766" y="3968"/>
                  <a:pt x="788" y="3980"/>
                  <a:pt x="808" y="3999"/>
                </a:cubicBezTo>
                <a:cubicBezTo>
                  <a:pt x="823" y="4015"/>
                  <a:pt x="835" y="4033"/>
                  <a:pt x="842" y="4053"/>
                </a:cubicBezTo>
                <a:cubicBezTo>
                  <a:pt x="848" y="4074"/>
                  <a:pt x="851" y="4092"/>
                  <a:pt x="848" y="4109"/>
                </a:cubicBezTo>
                <a:cubicBezTo>
                  <a:pt x="846" y="4126"/>
                  <a:pt x="839" y="4144"/>
                  <a:pt x="828" y="4163"/>
                </a:cubicBezTo>
                <a:cubicBezTo>
                  <a:pt x="817" y="4181"/>
                  <a:pt x="801" y="4201"/>
                  <a:pt x="779" y="4223"/>
                </a:cubicBezTo>
                <a:lnTo>
                  <a:pt x="651" y="4351"/>
                </a:lnTo>
                <a:close/>
                <a:moveTo>
                  <a:pt x="501" y="4111"/>
                </a:moveTo>
                <a:lnTo>
                  <a:pt x="574" y="4039"/>
                </a:lnTo>
                <a:cubicBezTo>
                  <a:pt x="593" y="4019"/>
                  <a:pt x="606" y="4004"/>
                  <a:pt x="612" y="3992"/>
                </a:cubicBezTo>
                <a:cubicBezTo>
                  <a:pt x="620" y="3978"/>
                  <a:pt x="623" y="3964"/>
                  <a:pt x="621" y="3950"/>
                </a:cubicBezTo>
                <a:cubicBezTo>
                  <a:pt x="619" y="3937"/>
                  <a:pt x="612" y="3924"/>
                  <a:pt x="600" y="3912"/>
                </a:cubicBezTo>
                <a:cubicBezTo>
                  <a:pt x="589" y="3901"/>
                  <a:pt x="576" y="3894"/>
                  <a:pt x="563" y="3891"/>
                </a:cubicBezTo>
                <a:cubicBezTo>
                  <a:pt x="549" y="3888"/>
                  <a:pt x="535" y="3889"/>
                  <a:pt x="522" y="3896"/>
                </a:cubicBezTo>
                <a:cubicBezTo>
                  <a:pt x="509" y="3903"/>
                  <a:pt x="491" y="3918"/>
                  <a:pt x="466" y="3943"/>
                </a:cubicBezTo>
                <a:lnTo>
                  <a:pt x="399" y="4010"/>
                </a:lnTo>
                <a:lnTo>
                  <a:pt x="501" y="4111"/>
                </a:lnTo>
                <a:close/>
                <a:moveTo>
                  <a:pt x="656" y="4267"/>
                </a:moveTo>
                <a:lnTo>
                  <a:pt x="740" y="4183"/>
                </a:lnTo>
                <a:cubicBezTo>
                  <a:pt x="754" y="4169"/>
                  <a:pt x="764" y="4158"/>
                  <a:pt x="768" y="4151"/>
                </a:cubicBezTo>
                <a:cubicBezTo>
                  <a:pt x="777" y="4139"/>
                  <a:pt x="782" y="4127"/>
                  <a:pt x="785" y="4116"/>
                </a:cubicBezTo>
                <a:cubicBezTo>
                  <a:pt x="788" y="4105"/>
                  <a:pt x="787" y="4093"/>
                  <a:pt x="783" y="4081"/>
                </a:cubicBezTo>
                <a:cubicBezTo>
                  <a:pt x="779" y="4068"/>
                  <a:pt x="772" y="4056"/>
                  <a:pt x="762" y="4046"/>
                </a:cubicBezTo>
                <a:cubicBezTo>
                  <a:pt x="749" y="4033"/>
                  <a:pt x="735" y="4025"/>
                  <a:pt x="719" y="4023"/>
                </a:cubicBezTo>
                <a:cubicBezTo>
                  <a:pt x="704" y="4020"/>
                  <a:pt x="688" y="4022"/>
                  <a:pt x="673" y="4030"/>
                </a:cubicBezTo>
                <a:cubicBezTo>
                  <a:pt x="658" y="4037"/>
                  <a:pt x="640" y="4052"/>
                  <a:pt x="618" y="4073"/>
                </a:cubicBezTo>
                <a:lnTo>
                  <a:pt x="541" y="4151"/>
                </a:lnTo>
                <a:lnTo>
                  <a:pt x="656" y="4267"/>
                </a:lnTo>
                <a:close/>
                <a:moveTo>
                  <a:pt x="964" y="4038"/>
                </a:moveTo>
                <a:lnTo>
                  <a:pt x="628" y="3702"/>
                </a:lnTo>
                <a:lnTo>
                  <a:pt x="744" y="3586"/>
                </a:lnTo>
                <a:cubicBezTo>
                  <a:pt x="770" y="3560"/>
                  <a:pt x="792" y="3541"/>
                  <a:pt x="809" y="3531"/>
                </a:cubicBezTo>
                <a:cubicBezTo>
                  <a:pt x="832" y="3516"/>
                  <a:pt x="857" y="3508"/>
                  <a:pt x="882" y="3506"/>
                </a:cubicBezTo>
                <a:cubicBezTo>
                  <a:pt x="915" y="3503"/>
                  <a:pt x="947" y="3509"/>
                  <a:pt x="979" y="3523"/>
                </a:cubicBezTo>
                <a:cubicBezTo>
                  <a:pt x="1011" y="3538"/>
                  <a:pt x="1042" y="3560"/>
                  <a:pt x="1072" y="3590"/>
                </a:cubicBezTo>
                <a:cubicBezTo>
                  <a:pt x="1098" y="3616"/>
                  <a:pt x="1117" y="3641"/>
                  <a:pt x="1131" y="3667"/>
                </a:cubicBezTo>
                <a:cubicBezTo>
                  <a:pt x="1145" y="3692"/>
                  <a:pt x="1154" y="3716"/>
                  <a:pt x="1157" y="3739"/>
                </a:cubicBezTo>
                <a:cubicBezTo>
                  <a:pt x="1161" y="3761"/>
                  <a:pt x="1161" y="3781"/>
                  <a:pt x="1157" y="3800"/>
                </a:cubicBezTo>
                <a:cubicBezTo>
                  <a:pt x="1153" y="3818"/>
                  <a:pt x="1146" y="3837"/>
                  <a:pt x="1134" y="3857"/>
                </a:cubicBezTo>
                <a:cubicBezTo>
                  <a:pt x="1122" y="3876"/>
                  <a:pt x="1106" y="3896"/>
                  <a:pt x="1086" y="3916"/>
                </a:cubicBezTo>
                <a:lnTo>
                  <a:pt x="964" y="4038"/>
                </a:lnTo>
                <a:close/>
                <a:moveTo>
                  <a:pt x="969" y="3954"/>
                </a:moveTo>
                <a:lnTo>
                  <a:pt x="1041" y="3882"/>
                </a:lnTo>
                <a:cubicBezTo>
                  <a:pt x="1063" y="3860"/>
                  <a:pt x="1078" y="3840"/>
                  <a:pt x="1087" y="3823"/>
                </a:cubicBezTo>
                <a:cubicBezTo>
                  <a:pt x="1095" y="3807"/>
                  <a:pt x="1099" y="3791"/>
                  <a:pt x="1099" y="3776"/>
                </a:cubicBezTo>
                <a:cubicBezTo>
                  <a:pt x="1099" y="3755"/>
                  <a:pt x="1094" y="3732"/>
                  <a:pt x="1082" y="3709"/>
                </a:cubicBezTo>
                <a:cubicBezTo>
                  <a:pt x="1070" y="3685"/>
                  <a:pt x="1051" y="3661"/>
                  <a:pt x="1026" y="3635"/>
                </a:cubicBezTo>
                <a:cubicBezTo>
                  <a:pt x="991" y="3600"/>
                  <a:pt x="958" y="3579"/>
                  <a:pt x="927" y="3571"/>
                </a:cubicBezTo>
                <a:cubicBezTo>
                  <a:pt x="897" y="3564"/>
                  <a:pt x="870" y="3565"/>
                  <a:pt x="847" y="3576"/>
                </a:cubicBezTo>
                <a:cubicBezTo>
                  <a:pt x="831" y="3583"/>
                  <a:pt x="809" y="3600"/>
                  <a:pt x="783" y="3626"/>
                </a:cubicBezTo>
                <a:lnTo>
                  <a:pt x="712" y="3697"/>
                </a:lnTo>
                <a:lnTo>
                  <a:pt x="969" y="3954"/>
                </a:lnTo>
                <a:close/>
                <a:moveTo>
                  <a:pt x="1354" y="3835"/>
                </a:moveTo>
                <a:lnTo>
                  <a:pt x="1324" y="3805"/>
                </a:lnTo>
                <a:lnTo>
                  <a:pt x="1597" y="3532"/>
                </a:lnTo>
                <a:lnTo>
                  <a:pt x="1627" y="3561"/>
                </a:lnTo>
                <a:lnTo>
                  <a:pt x="1354" y="3835"/>
                </a:lnTo>
                <a:close/>
                <a:moveTo>
                  <a:pt x="1570" y="3432"/>
                </a:moveTo>
                <a:lnTo>
                  <a:pt x="1233" y="3096"/>
                </a:lnTo>
                <a:lnTo>
                  <a:pt x="1360" y="2970"/>
                </a:lnTo>
                <a:cubicBezTo>
                  <a:pt x="1383" y="2947"/>
                  <a:pt x="1401" y="2931"/>
                  <a:pt x="1415" y="2922"/>
                </a:cubicBezTo>
                <a:cubicBezTo>
                  <a:pt x="1434" y="2908"/>
                  <a:pt x="1453" y="2899"/>
                  <a:pt x="1472" y="2896"/>
                </a:cubicBezTo>
                <a:cubicBezTo>
                  <a:pt x="1491" y="2892"/>
                  <a:pt x="1510" y="2894"/>
                  <a:pt x="1531" y="2901"/>
                </a:cubicBezTo>
                <a:cubicBezTo>
                  <a:pt x="1552" y="2908"/>
                  <a:pt x="1571" y="2920"/>
                  <a:pt x="1587" y="2937"/>
                </a:cubicBezTo>
                <a:cubicBezTo>
                  <a:pt x="1616" y="2966"/>
                  <a:pt x="1631" y="2999"/>
                  <a:pt x="1632" y="3037"/>
                </a:cubicBezTo>
                <a:cubicBezTo>
                  <a:pt x="1634" y="3075"/>
                  <a:pt x="1611" y="3118"/>
                  <a:pt x="1564" y="3165"/>
                </a:cubicBezTo>
                <a:lnTo>
                  <a:pt x="1477" y="3251"/>
                </a:lnTo>
                <a:lnTo>
                  <a:pt x="1614" y="3388"/>
                </a:lnTo>
                <a:lnTo>
                  <a:pt x="1570" y="3432"/>
                </a:lnTo>
                <a:close/>
                <a:moveTo>
                  <a:pt x="1438" y="3212"/>
                </a:moveTo>
                <a:lnTo>
                  <a:pt x="1525" y="3125"/>
                </a:lnTo>
                <a:cubicBezTo>
                  <a:pt x="1553" y="3096"/>
                  <a:pt x="1568" y="3070"/>
                  <a:pt x="1570" y="3048"/>
                </a:cubicBezTo>
                <a:cubicBezTo>
                  <a:pt x="1571" y="3025"/>
                  <a:pt x="1562" y="3004"/>
                  <a:pt x="1543" y="2984"/>
                </a:cubicBezTo>
                <a:cubicBezTo>
                  <a:pt x="1529" y="2970"/>
                  <a:pt x="1513" y="2962"/>
                  <a:pt x="1496" y="2959"/>
                </a:cubicBezTo>
                <a:cubicBezTo>
                  <a:pt x="1479" y="2956"/>
                  <a:pt x="1463" y="2959"/>
                  <a:pt x="1448" y="2967"/>
                </a:cubicBezTo>
                <a:cubicBezTo>
                  <a:pt x="1439" y="2973"/>
                  <a:pt x="1424" y="2985"/>
                  <a:pt x="1404" y="3006"/>
                </a:cubicBezTo>
                <a:lnTo>
                  <a:pt x="1318" y="3092"/>
                </a:lnTo>
                <a:lnTo>
                  <a:pt x="1438" y="3212"/>
                </a:lnTo>
                <a:close/>
                <a:moveTo>
                  <a:pt x="1882" y="3120"/>
                </a:moveTo>
                <a:lnTo>
                  <a:pt x="1545" y="2784"/>
                </a:lnTo>
                <a:lnTo>
                  <a:pt x="1788" y="2541"/>
                </a:lnTo>
                <a:lnTo>
                  <a:pt x="1828" y="2581"/>
                </a:lnTo>
                <a:lnTo>
                  <a:pt x="1630" y="2779"/>
                </a:lnTo>
                <a:lnTo>
                  <a:pt x="1733" y="2882"/>
                </a:lnTo>
                <a:lnTo>
                  <a:pt x="1918" y="2697"/>
                </a:lnTo>
                <a:lnTo>
                  <a:pt x="1958" y="2736"/>
                </a:lnTo>
                <a:lnTo>
                  <a:pt x="1772" y="2922"/>
                </a:lnTo>
                <a:lnTo>
                  <a:pt x="1886" y="3036"/>
                </a:lnTo>
                <a:lnTo>
                  <a:pt x="2093" y="2830"/>
                </a:lnTo>
                <a:lnTo>
                  <a:pt x="2132" y="2870"/>
                </a:lnTo>
                <a:lnTo>
                  <a:pt x="1882" y="3120"/>
                </a:lnTo>
                <a:close/>
                <a:moveTo>
                  <a:pt x="2163" y="2839"/>
                </a:moveTo>
                <a:lnTo>
                  <a:pt x="2118" y="2534"/>
                </a:lnTo>
                <a:lnTo>
                  <a:pt x="1843" y="2487"/>
                </a:lnTo>
                <a:lnTo>
                  <a:pt x="1895" y="2434"/>
                </a:lnTo>
                <a:lnTo>
                  <a:pt x="2043" y="2460"/>
                </a:lnTo>
                <a:cubicBezTo>
                  <a:pt x="2073" y="2465"/>
                  <a:pt x="2096" y="2469"/>
                  <a:pt x="2111" y="2474"/>
                </a:cubicBezTo>
                <a:cubicBezTo>
                  <a:pt x="2106" y="2454"/>
                  <a:pt x="2102" y="2432"/>
                  <a:pt x="2099" y="2409"/>
                </a:cubicBezTo>
                <a:lnTo>
                  <a:pt x="2078" y="2252"/>
                </a:lnTo>
                <a:lnTo>
                  <a:pt x="2126" y="2204"/>
                </a:lnTo>
                <a:lnTo>
                  <a:pt x="2166" y="2480"/>
                </a:lnTo>
                <a:lnTo>
                  <a:pt x="2471" y="2531"/>
                </a:lnTo>
                <a:lnTo>
                  <a:pt x="2416" y="2586"/>
                </a:lnTo>
                <a:lnTo>
                  <a:pt x="2212" y="2550"/>
                </a:lnTo>
                <a:cubicBezTo>
                  <a:pt x="2200" y="2548"/>
                  <a:pt x="2188" y="2546"/>
                  <a:pt x="2175" y="2542"/>
                </a:cubicBezTo>
                <a:cubicBezTo>
                  <a:pt x="2179" y="2562"/>
                  <a:pt x="2183" y="2576"/>
                  <a:pt x="2184" y="2584"/>
                </a:cubicBezTo>
                <a:lnTo>
                  <a:pt x="2217" y="2785"/>
                </a:lnTo>
                <a:lnTo>
                  <a:pt x="2163" y="2839"/>
                </a:lnTo>
                <a:close/>
                <a:moveTo>
                  <a:pt x="2647" y="2355"/>
                </a:moveTo>
                <a:lnTo>
                  <a:pt x="2606" y="2396"/>
                </a:lnTo>
                <a:lnTo>
                  <a:pt x="2343" y="2133"/>
                </a:lnTo>
                <a:cubicBezTo>
                  <a:pt x="2343" y="2152"/>
                  <a:pt x="2339" y="2175"/>
                  <a:pt x="2332" y="2201"/>
                </a:cubicBezTo>
                <a:cubicBezTo>
                  <a:pt x="2326" y="2226"/>
                  <a:pt x="2318" y="2248"/>
                  <a:pt x="2310" y="2265"/>
                </a:cubicBezTo>
                <a:lnTo>
                  <a:pt x="2270" y="2225"/>
                </a:lnTo>
                <a:cubicBezTo>
                  <a:pt x="2283" y="2191"/>
                  <a:pt x="2290" y="2158"/>
                  <a:pt x="2291" y="2125"/>
                </a:cubicBezTo>
                <a:cubicBezTo>
                  <a:pt x="2293" y="2093"/>
                  <a:pt x="2291" y="2066"/>
                  <a:pt x="2283" y="2044"/>
                </a:cubicBezTo>
                <a:lnTo>
                  <a:pt x="2310" y="2017"/>
                </a:lnTo>
                <a:lnTo>
                  <a:pt x="2647" y="2355"/>
                </a:lnTo>
                <a:close/>
                <a:moveTo>
                  <a:pt x="2769" y="2233"/>
                </a:moveTo>
                <a:lnTo>
                  <a:pt x="2526" y="1989"/>
                </a:lnTo>
                <a:lnTo>
                  <a:pt x="2563" y="1952"/>
                </a:lnTo>
                <a:lnTo>
                  <a:pt x="2597" y="1987"/>
                </a:lnTo>
                <a:cubicBezTo>
                  <a:pt x="2592" y="1967"/>
                  <a:pt x="2593" y="1947"/>
                  <a:pt x="2598" y="1927"/>
                </a:cubicBezTo>
                <a:cubicBezTo>
                  <a:pt x="2604" y="1907"/>
                  <a:pt x="2615" y="1889"/>
                  <a:pt x="2631" y="1873"/>
                </a:cubicBezTo>
                <a:cubicBezTo>
                  <a:pt x="2649" y="1855"/>
                  <a:pt x="2667" y="1844"/>
                  <a:pt x="2687" y="1840"/>
                </a:cubicBezTo>
                <a:cubicBezTo>
                  <a:pt x="2706" y="1836"/>
                  <a:pt x="2724" y="1838"/>
                  <a:pt x="2742" y="1847"/>
                </a:cubicBezTo>
                <a:cubicBezTo>
                  <a:pt x="2733" y="1799"/>
                  <a:pt x="2744" y="1760"/>
                  <a:pt x="2775" y="1729"/>
                </a:cubicBezTo>
                <a:cubicBezTo>
                  <a:pt x="2799" y="1705"/>
                  <a:pt x="2824" y="1693"/>
                  <a:pt x="2851" y="1693"/>
                </a:cubicBezTo>
                <a:cubicBezTo>
                  <a:pt x="2877" y="1694"/>
                  <a:pt x="2904" y="1708"/>
                  <a:pt x="2932" y="1736"/>
                </a:cubicBezTo>
                <a:lnTo>
                  <a:pt x="3099" y="1903"/>
                </a:lnTo>
                <a:lnTo>
                  <a:pt x="3058" y="1944"/>
                </a:lnTo>
                <a:lnTo>
                  <a:pt x="2905" y="1791"/>
                </a:lnTo>
                <a:cubicBezTo>
                  <a:pt x="2888" y="1774"/>
                  <a:pt x="2875" y="1764"/>
                  <a:pt x="2865" y="1759"/>
                </a:cubicBezTo>
                <a:cubicBezTo>
                  <a:pt x="2855" y="1754"/>
                  <a:pt x="2844" y="1753"/>
                  <a:pt x="2833" y="1756"/>
                </a:cubicBezTo>
                <a:cubicBezTo>
                  <a:pt x="2821" y="1759"/>
                  <a:pt x="2811" y="1765"/>
                  <a:pt x="2801" y="1774"/>
                </a:cubicBezTo>
                <a:cubicBezTo>
                  <a:pt x="2784" y="1791"/>
                  <a:pt x="2776" y="1811"/>
                  <a:pt x="2776" y="1834"/>
                </a:cubicBezTo>
                <a:cubicBezTo>
                  <a:pt x="2776" y="1856"/>
                  <a:pt x="2789" y="1880"/>
                  <a:pt x="2814" y="1905"/>
                </a:cubicBezTo>
                <a:lnTo>
                  <a:pt x="2955" y="2047"/>
                </a:lnTo>
                <a:lnTo>
                  <a:pt x="2914" y="2088"/>
                </a:lnTo>
                <a:lnTo>
                  <a:pt x="2756" y="1930"/>
                </a:lnTo>
                <a:cubicBezTo>
                  <a:pt x="2737" y="1912"/>
                  <a:pt x="2720" y="1901"/>
                  <a:pt x="2704" y="1899"/>
                </a:cubicBezTo>
                <a:cubicBezTo>
                  <a:pt x="2688" y="1896"/>
                  <a:pt x="2673" y="1903"/>
                  <a:pt x="2658" y="1918"/>
                </a:cubicBezTo>
                <a:cubicBezTo>
                  <a:pt x="2646" y="1930"/>
                  <a:pt x="2638" y="1943"/>
                  <a:pt x="2634" y="1959"/>
                </a:cubicBezTo>
                <a:cubicBezTo>
                  <a:pt x="2631" y="1975"/>
                  <a:pt x="2633" y="1991"/>
                  <a:pt x="2640" y="2008"/>
                </a:cubicBezTo>
                <a:cubicBezTo>
                  <a:pt x="2647" y="2024"/>
                  <a:pt x="2662" y="2043"/>
                  <a:pt x="2684" y="2065"/>
                </a:cubicBezTo>
                <a:lnTo>
                  <a:pt x="2810" y="2192"/>
                </a:lnTo>
                <a:lnTo>
                  <a:pt x="2769" y="2233"/>
                </a:lnTo>
                <a:close/>
                <a:moveTo>
                  <a:pt x="3070" y="1786"/>
                </a:moveTo>
                <a:lnTo>
                  <a:pt x="3105" y="1739"/>
                </a:lnTo>
                <a:cubicBezTo>
                  <a:pt x="3123" y="1753"/>
                  <a:pt x="3142" y="1759"/>
                  <a:pt x="3161" y="1758"/>
                </a:cubicBezTo>
                <a:cubicBezTo>
                  <a:pt x="3181" y="1756"/>
                  <a:pt x="3200" y="1746"/>
                  <a:pt x="3218" y="1727"/>
                </a:cubicBezTo>
                <a:cubicBezTo>
                  <a:pt x="3237" y="1708"/>
                  <a:pt x="3248" y="1690"/>
                  <a:pt x="3249" y="1673"/>
                </a:cubicBezTo>
                <a:cubicBezTo>
                  <a:pt x="3250" y="1656"/>
                  <a:pt x="3246" y="1642"/>
                  <a:pt x="3236" y="1632"/>
                </a:cubicBezTo>
                <a:cubicBezTo>
                  <a:pt x="3226" y="1623"/>
                  <a:pt x="3215" y="1619"/>
                  <a:pt x="3201" y="1622"/>
                </a:cubicBezTo>
                <a:cubicBezTo>
                  <a:pt x="3192" y="1624"/>
                  <a:pt x="3173" y="1634"/>
                  <a:pt x="3145" y="1650"/>
                </a:cubicBezTo>
                <a:cubicBezTo>
                  <a:pt x="3107" y="1673"/>
                  <a:pt x="3080" y="1687"/>
                  <a:pt x="3063" y="1693"/>
                </a:cubicBezTo>
                <a:cubicBezTo>
                  <a:pt x="3045" y="1700"/>
                  <a:pt x="3029" y="1701"/>
                  <a:pt x="3013" y="1697"/>
                </a:cubicBezTo>
                <a:cubicBezTo>
                  <a:pt x="2997" y="1693"/>
                  <a:pt x="2983" y="1685"/>
                  <a:pt x="2971" y="1673"/>
                </a:cubicBezTo>
                <a:cubicBezTo>
                  <a:pt x="2960" y="1662"/>
                  <a:pt x="2953" y="1650"/>
                  <a:pt x="2948" y="1636"/>
                </a:cubicBezTo>
                <a:cubicBezTo>
                  <a:pt x="2944" y="1621"/>
                  <a:pt x="2943" y="1607"/>
                  <a:pt x="2946" y="1592"/>
                </a:cubicBezTo>
                <a:cubicBezTo>
                  <a:pt x="2947" y="1581"/>
                  <a:pt x="2952" y="1568"/>
                  <a:pt x="2960" y="1554"/>
                </a:cubicBezTo>
                <a:cubicBezTo>
                  <a:pt x="2968" y="1540"/>
                  <a:pt x="2978" y="1526"/>
                  <a:pt x="2991" y="1514"/>
                </a:cubicBezTo>
                <a:cubicBezTo>
                  <a:pt x="3010" y="1494"/>
                  <a:pt x="3029" y="1480"/>
                  <a:pt x="3049" y="1471"/>
                </a:cubicBezTo>
                <a:cubicBezTo>
                  <a:pt x="3069" y="1462"/>
                  <a:pt x="3087" y="1459"/>
                  <a:pt x="3103" y="1462"/>
                </a:cubicBezTo>
                <a:cubicBezTo>
                  <a:pt x="3120" y="1464"/>
                  <a:pt x="3137" y="1472"/>
                  <a:pt x="3155" y="1485"/>
                </a:cubicBezTo>
                <a:lnTo>
                  <a:pt x="3121" y="1531"/>
                </a:lnTo>
                <a:cubicBezTo>
                  <a:pt x="3106" y="1520"/>
                  <a:pt x="3091" y="1516"/>
                  <a:pt x="3075" y="1518"/>
                </a:cubicBezTo>
                <a:cubicBezTo>
                  <a:pt x="3059" y="1520"/>
                  <a:pt x="3043" y="1528"/>
                  <a:pt x="3027" y="1544"/>
                </a:cubicBezTo>
                <a:cubicBezTo>
                  <a:pt x="3008" y="1563"/>
                  <a:pt x="2998" y="1580"/>
                  <a:pt x="2996" y="1594"/>
                </a:cubicBezTo>
                <a:cubicBezTo>
                  <a:pt x="2994" y="1609"/>
                  <a:pt x="2998" y="1620"/>
                  <a:pt x="3006" y="1629"/>
                </a:cubicBezTo>
                <a:cubicBezTo>
                  <a:pt x="3011" y="1634"/>
                  <a:pt x="3018" y="1637"/>
                  <a:pt x="3026" y="1638"/>
                </a:cubicBezTo>
                <a:cubicBezTo>
                  <a:pt x="3033" y="1639"/>
                  <a:pt x="3042" y="1637"/>
                  <a:pt x="3052" y="1633"/>
                </a:cubicBezTo>
                <a:cubicBezTo>
                  <a:pt x="3058" y="1631"/>
                  <a:pt x="3074" y="1622"/>
                  <a:pt x="3099" y="1607"/>
                </a:cubicBezTo>
                <a:cubicBezTo>
                  <a:pt x="3136" y="1586"/>
                  <a:pt x="3163" y="1572"/>
                  <a:pt x="3180" y="1565"/>
                </a:cubicBezTo>
                <a:cubicBezTo>
                  <a:pt x="3196" y="1559"/>
                  <a:pt x="3212" y="1557"/>
                  <a:pt x="3228" y="1560"/>
                </a:cubicBezTo>
                <a:cubicBezTo>
                  <a:pt x="3245" y="1563"/>
                  <a:pt x="3260" y="1571"/>
                  <a:pt x="3274" y="1585"/>
                </a:cubicBezTo>
                <a:cubicBezTo>
                  <a:pt x="3287" y="1599"/>
                  <a:pt x="3296" y="1616"/>
                  <a:pt x="3300" y="1636"/>
                </a:cubicBezTo>
                <a:cubicBezTo>
                  <a:pt x="3305" y="1656"/>
                  <a:pt x="3302" y="1677"/>
                  <a:pt x="3294" y="1699"/>
                </a:cubicBezTo>
                <a:cubicBezTo>
                  <a:pt x="3285" y="1721"/>
                  <a:pt x="3272" y="1741"/>
                  <a:pt x="3253" y="1760"/>
                </a:cubicBezTo>
                <a:cubicBezTo>
                  <a:pt x="3221" y="1792"/>
                  <a:pt x="3190" y="1810"/>
                  <a:pt x="3161" y="1813"/>
                </a:cubicBezTo>
                <a:cubicBezTo>
                  <a:pt x="3131" y="1816"/>
                  <a:pt x="3101" y="1808"/>
                  <a:pt x="3070" y="1786"/>
                </a:cubicBezTo>
                <a:close/>
                <a:moveTo>
                  <a:pt x="3541" y="1461"/>
                </a:moveTo>
                <a:lnTo>
                  <a:pt x="3500" y="1502"/>
                </a:lnTo>
                <a:lnTo>
                  <a:pt x="3237" y="1239"/>
                </a:lnTo>
                <a:cubicBezTo>
                  <a:pt x="3236" y="1259"/>
                  <a:pt x="3233" y="1281"/>
                  <a:pt x="3226" y="1307"/>
                </a:cubicBezTo>
                <a:cubicBezTo>
                  <a:pt x="3220" y="1332"/>
                  <a:pt x="3212" y="1354"/>
                  <a:pt x="3204" y="1372"/>
                </a:cubicBezTo>
                <a:lnTo>
                  <a:pt x="3164" y="1332"/>
                </a:lnTo>
                <a:cubicBezTo>
                  <a:pt x="3176" y="1298"/>
                  <a:pt x="3183" y="1264"/>
                  <a:pt x="3185" y="1232"/>
                </a:cubicBezTo>
                <a:cubicBezTo>
                  <a:pt x="3187" y="1199"/>
                  <a:pt x="3184" y="1172"/>
                  <a:pt x="3177" y="1150"/>
                </a:cubicBezTo>
                <a:lnTo>
                  <a:pt x="3204" y="1123"/>
                </a:lnTo>
                <a:lnTo>
                  <a:pt x="3541" y="1461"/>
                </a:lnTo>
                <a:close/>
                <a:moveTo>
                  <a:pt x="3499" y="926"/>
                </a:moveTo>
                <a:lnTo>
                  <a:pt x="3452" y="878"/>
                </a:lnTo>
                <a:lnTo>
                  <a:pt x="3493" y="837"/>
                </a:lnTo>
                <a:lnTo>
                  <a:pt x="3540" y="884"/>
                </a:lnTo>
                <a:lnTo>
                  <a:pt x="3499" y="926"/>
                </a:lnTo>
                <a:close/>
                <a:moveTo>
                  <a:pt x="3788" y="1214"/>
                </a:moveTo>
                <a:lnTo>
                  <a:pt x="3544" y="971"/>
                </a:lnTo>
                <a:lnTo>
                  <a:pt x="3585" y="930"/>
                </a:lnTo>
                <a:lnTo>
                  <a:pt x="3829" y="1173"/>
                </a:lnTo>
                <a:lnTo>
                  <a:pt x="3788" y="1214"/>
                </a:lnTo>
                <a:close/>
                <a:moveTo>
                  <a:pt x="3900" y="1102"/>
                </a:moveTo>
                <a:lnTo>
                  <a:pt x="3564" y="766"/>
                </a:lnTo>
                <a:lnTo>
                  <a:pt x="3691" y="639"/>
                </a:lnTo>
                <a:cubicBezTo>
                  <a:pt x="3713" y="617"/>
                  <a:pt x="3731" y="601"/>
                  <a:pt x="3745" y="591"/>
                </a:cubicBezTo>
                <a:cubicBezTo>
                  <a:pt x="3764" y="577"/>
                  <a:pt x="3783" y="569"/>
                  <a:pt x="3802" y="565"/>
                </a:cubicBezTo>
                <a:cubicBezTo>
                  <a:pt x="3821" y="562"/>
                  <a:pt x="3841" y="564"/>
                  <a:pt x="3862" y="571"/>
                </a:cubicBezTo>
                <a:cubicBezTo>
                  <a:pt x="3882" y="578"/>
                  <a:pt x="3901" y="590"/>
                  <a:pt x="3918" y="606"/>
                </a:cubicBezTo>
                <a:cubicBezTo>
                  <a:pt x="3946" y="635"/>
                  <a:pt x="3961" y="668"/>
                  <a:pt x="3963" y="706"/>
                </a:cubicBezTo>
                <a:cubicBezTo>
                  <a:pt x="3965" y="744"/>
                  <a:pt x="3942" y="787"/>
                  <a:pt x="3894" y="835"/>
                </a:cubicBezTo>
                <a:lnTo>
                  <a:pt x="3808" y="921"/>
                </a:lnTo>
                <a:lnTo>
                  <a:pt x="3945" y="1057"/>
                </a:lnTo>
                <a:lnTo>
                  <a:pt x="3900" y="1102"/>
                </a:lnTo>
                <a:close/>
                <a:moveTo>
                  <a:pt x="3768" y="881"/>
                </a:moveTo>
                <a:lnTo>
                  <a:pt x="3855" y="794"/>
                </a:lnTo>
                <a:cubicBezTo>
                  <a:pt x="3884" y="765"/>
                  <a:pt x="3899" y="740"/>
                  <a:pt x="3900" y="717"/>
                </a:cubicBezTo>
                <a:cubicBezTo>
                  <a:pt x="3902" y="694"/>
                  <a:pt x="3893" y="673"/>
                  <a:pt x="3873" y="654"/>
                </a:cubicBezTo>
                <a:cubicBezTo>
                  <a:pt x="3859" y="640"/>
                  <a:pt x="3844" y="631"/>
                  <a:pt x="3827" y="628"/>
                </a:cubicBezTo>
                <a:cubicBezTo>
                  <a:pt x="3809" y="625"/>
                  <a:pt x="3793" y="628"/>
                  <a:pt x="3779" y="636"/>
                </a:cubicBezTo>
                <a:cubicBezTo>
                  <a:pt x="3769" y="642"/>
                  <a:pt x="3754" y="655"/>
                  <a:pt x="3734" y="675"/>
                </a:cubicBezTo>
                <a:lnTo>
                  <a:pt x="3648" y="761"/>
                </a:lnTo>
                <a:lnTo>
                  <a:pt x="3768" y="881"/>
                </a:lnTo>
                <a:close/>
                <a:moveTo>
                  <a:pt x="4088" y="698"/>
                </a:moveTo>
                <a:lnTo>
                  <a:pt x="4126" y="652"/>
                </a:lnTo>
                <a:cubicBezTo>
                  <a:pt x="4145" y="667"/>
                  <a:pt x="4164" y="676"/>
                  <a:pt x="4182" y="680"/>
                </a:cubicBezTo>
                <a:cubicBezTo>
                  <a:pt x="4200" y="683"/>
                  <a:pt x="4220" y="681"/>
                  <a:pt x="4242" y="672"/>
                </a:cubicBezTo>
                <a:cubicBezTo>
                  <a:pt x="4264" y="663"/>
                  <a:pt x="4284" y="650"/>
                  <a:pt x="4303" y="630"/>
                </a:cubicBezTo>
                <a:cubicBezTo>
                  <a:pt x="4320" y="613"/>
                  <a:pt x="4333" y="596"/>
                  <a:pt x="4341" y="578"/>
                </a:cubicBezTo>
                <a:cubicBezTo>
                  <a:pt x="4349" y="560"/>
                  <a:pt x="4351" y="543"/>
                  <a:pt x="4349" y="528"/>
                </a:cubicBezTo>
                <a:cubicBezTo>
                  <a:pt x="4346" y="513"/>
                  <a:pt x="4340" y="500"/>
                  <a:pt x="4330" y="490"/>
                </a:cubicBezTo>
                <a:cubicBezTo>
                  <a:pt x="4319" y="479"/>
                  <a:pt x="4307" y="473"/>
                  <a:pt x="4293" y="471"/>
                </a:cubicBezTo>
                <a:cubicBezTo>
                  <a:pt x="4279" y="470"/>
                  <a:pt x="4262" y="473"/>
                  <a:pt x="4243" y="482"/>
                </a:cubicBezTo>
                <a:cubicBezTo>
                  <a:pt x="4230" y="487"/>
                  <a:pt x="4205" y="502"/>
                  <a:pt x="4166" y="525"/>
                </a:cubicBezTo>
                <a:cubicBezTo>
                  <a:pt x="4128" y="549"/>
                  <a:pt x="4100" y="563"/>
                  <a:pt x="4081" y="569"/>
                </a:cubicBezTo>
                <a:cubicBezTo>
                  <a:pt x="4056" y="577"/>
                  <a:pt x="4034" y="578"/>
                  <a:pt x="4013" y="574"/>
                </a:cubicBezTo>
                <a:cubicBezTo>
                  <a:pt x="3993" y="569"/>
                  <a:pt x="3975" y="559"/>
                  <a:pt x="3960" y="544"/>
                </a:cubicBezTo>
                <a:cubicBezTo>
                  <a:pt x="3943" y="527"/>
                  <a:pt x="3932" y="506"/>
                  <a:pt x="3927" y="482"/>
                </a:cubicBezTo>
                <a:cubicBezTo>
                  <a:pt x="3922" y="457"/>
                  <a:pt x="3924" y="432"/>
                  <a:pt x="3935" y="406"/>
                </a:cubicBezTo>
                <a:cubicBezTo>
                  <a:pt x="3946" y="380"/>
                  <a:pt x="3963" y="355"/>
                  <a:pt x="3985" y="333"/>
                </a:cubicBezTo>
                <a:cubicBezTo>
                  <a:pt x="4010" y="308"/>
                  <a:pt x="4036" y="290"/>
                  <a:pt x="4063" y="279"/>
                </a:cubicBezTo>
                <a:cubicBezTo>
                  <a:pt x="4090" y="268"/>
                  <a:pt x="4117" y="265"/>
                  <a:pt x="4143" y="271"/>
                </a:cubicBezTo>
                <a:cubicBezTo>
                  <a:pt x="4169" y="276"/>
                  <a:pt x="4192" y="288"/>
                  <a:pt x="4212" y="307"/>
                </a:cubicBezTo>
                <a:lnTo>
                  <a:pt x="4173" y="353"/>
                </a:lnTo>
                <a:cubicBezTo>
                  <a:pt x="4149" y="334"/>
                  <a:pt x="4125" y="326"/>
                  <a:pt x="4101" y="328"/>
                </a:cubicBezTo>
                <a:cubicBezTo>
                  <a:pt x="4077" y="330"/>
                  <a:pt x="4052" y="344"/>
                  <a:pt x="4026" y="370"/>
                </a:cubicBezTo>
                <a:cubicBezTo>
                  <a:pt x="4000" y="397"/>
                  <a:pt x="3985" y="422"/>
                  <a:pt x="3982" y="444"/>
                </a:cubicBezTo>
                <a:cubicBezTo>
                  <a:pt x="3980" y="466"/>
                  <a:pt x="3986" y="484"/>
                  <a:pt x="4000" y="498"/>
                </a:cubicBezTo>
                <a:cubicBezTo>
                  <a:pt x="4012" y="510"/>
                  <a:pt x="4026" y="516"/>
                  <a:pt x="4043" y="515"/>
                </a:cubicBezTo>
                <a:cubicBezTo>
                  <a:pt x="4059" y="514"/>
                  <a:pt x="4089" y="500"/>
                  <a:pt x="4134" y="472"/>
                </a:cubicBezTo>
                <a:cubicBezTo>
                  <a:pt x="4178" y="444"/>
                  <a:pt x="4210" y="426"/>
                  <a:pt x="4229" y="419"/>
                </a:cubicBezTo>
                <a:cubicBezTo>
                  <a:pt x="4258" y="408"/>
                  <a:pt x="4284" y="405"/>
                  <a:pt x="4307" y="410"/>
                </a:cubicBezTo>
                <a:cubicBezTo>
                  <a:pt x="4330" y="414"/>
                  <a:pt x="4351" y="425"/>
                  <a:pt x="4369" y="443"/>
                </a:cubicBezTo>
                <a:cubicBezTo>
                  <a:pt x="4387" y="461"/>
                  <a:pt x="4398" y="483"/>
                  <a:pt x="4404" y="509"/>
                </a:cubicBezTo>
                <a:cubicBezTo>
                  <a:pt x="4410" y="535"/>
                  <a:pt x="4407" y="562"/>
                  <a:pt x="4397" y="590"/>
                </a:cubicBezTo>
                <a:cubicBezTo>
                  <a:pt x="4386" y="618"/>
                  <a:pt x="4369" y="644"/>
                  <a:pt x="4345" y="668"/>
                </a:cubicBezTo>
                <a:cubicBezTo>
                  <a:pt x="4315" y="699"/>
                  <a:pt x="4285" y="720"/>
                  <a:pt x="4255" y="731"/>
                </a:cubicBezTo>
                <a:cubicBezTo>
                  <a:pt x="4226" y="743"/>
                  <a:pt x="4197" y="746"/>
                  <a:pt x="4167" y="740"/>
                </a:cubicBezTo>
                <a:cubicBezTo>
                  <a:pt x="4138" y="734"/>
                  <a:pt x="4111" y="720"/>
                  <a:pt x="4088" y="698"/>
                </a:cubicBezTo>
                <a:close/>
                <a:moveTo>
                  <a:pt x="4423" y="402"/>
                </a:moveTo>
                <a:lnTo>
                  <a:pt x="4459" y="355"/>
                </a:lnTo>
                <a:cubicBezTo>
                  <a:pt x="4487" y="374"/>
                  <a:pt x="4512" y="382"/>
                  <a:pt x="4533" y="381"/>
                </a:cubicBezTo>
                <a:cubicBezTo>
                  <a:pt x="4555" y="380"/>
                  <a:pt x="4574" y="372"/>
                  <a:pt x="4590" y="355"/>
                </a:cubicBezTo>
                <a:cubicBezTo>
                  <a:pt x="4610" y="336"/>
                  <a:pt x="4619" y="313"/>
                  <a:pt x="4619" y="286"/>
                </a:cubicBezTo>
                <a:cubicBezTo>
                  <a:pt x="4619" y="259"/>
                  <a:pt x="4609" y="236"/>
                  <a:pt x="4589" y="216"/>
                </a:cubicBezTo>
                <a:cubicBezTo>
                  <a:pt x="4571" y="197"/>
                  <a:pt x="4549" y="187"/>
                  <a:pt x="4524" y="187"/>
                </a:cubicBezTo>
                <a:cubicBezTo>
                  <a:pt x="4499" y="188"/>
                  <a:pt x="4477" y="197"/>
                  <a:pt x="4458" y="216"/>
                </a:cubicBezTo>
                <a:cubicBezTo>
                  <a:pt x="4451" y="224"/>
                  <a:pt x="4442" y="235"/>
                  <a:pt x="4434" y="250"/>
                </a:cubicBezTo>
                <a:lnTo>
                  <a:pt x="4402" y="209"/>
                </a:lnTo>
                <a:cubicBezTo>
                  <a:pt x="4405" y="207"/>
                  <a:pt x="4408" y="205"/>
                  <a:pt x="4409" y="203"/>
                </a:cubicBezTo>
                <a:cubicBezTo>
                  <a:pt x="4427" y="185"/>
                  <a:pt x="4438" y="165"/>
                  <a:pt x="4443" y="142"/>
                </a:cubicBezTo>
                <a:cubicBezTo>
                  <a:pt x="4448" y="118"/>
                  <a:pt x="4441" y="97"/>
                  <a:pt x="4422" y="78"/>
                </a:cubicBezTo>
                <a:cubicBezTo>
                  <a:pt x="4407" y="63"/>
                  <a:pt x="4389" y="56"/>
                  <a:pt x="4369" y="56"/>
                </a:cubicBezTo>
                <a:cubicBezTo>
                  <a:pt x="4349" y="56"/>
                  <a:pt x="4330" y="65"/>
                  <a:pt x="4314" y="81"/>
                </a:cubicBezTo>
                <a:cubicBezTo>
                  <a:pt x="4298" y="97"/>
                  <a:pt x="4290" y="115"/>
                  <a:pt x="4289" y="136"/>
                </a:cubicBezTo>
                <a:cubicBezTo>
                  <a:pt x="4289" y="157"/>
                  <a:pt x="4297" y="179"/>
                  <a:pt x="4314" y="202"/>
                </a:cubicBezTo>
                <a:lnTo>
                  <a:pt x="4265" y="236"/>
                </a:lnTo>
                <a:cubicBezTo>
                  <a:pt x="4243" y="203"/>
                  <a:pt x="4233" y="170"/>
                  <a:pt x="4235" y="137"/>
                </a:cubicBezTo>
                <a:cubicBezTo>
                  <a:pt x="4238" y="104"/>
                  <a:pt x="4253" y="74"/>
                  <a:pt x="4279" y="48"/>
                </a:cubicBezTo>
                <a:cubicBezTo>
                  <a:pt x="4298" y="29"/>
                  <a:pt x="4318" y="16"/>
                  <a:pt x="4342" y="9"/>
                </a:cubicBezTo>
                <a:cubicBezTo>
                  <a:pt x="4365" y="1"/>
                  <a:pt x="4388" y="0"/>
                  <a:pt x="4409" y="6"/>
                </a:cubicBezTo>
                <a:cubicBezTo>
                  <a:pt x="4431" y="11"/>
                  <a:pt x="4450" y="21"/>
                  <a:pt x="4465" y="37"/>
                </a:cubicBezTo>
                <a:cubicBezTo>
                  <a:pt x="4480" y="51"/>
                  <a:pt x="4489" y="68"/>
                  <a:pt x="4493" y="88"/>
                </a:cubicBezTo>
                <a:cubicBezTo>
                  <a:pt x="4497" y="108"/>
                  <a:pt x="4495" y="129"/>
                  <a:pt x="4487" y="151"/>
                </a:cubicBezTo>
                <a:cubicBezTo>
                  <a:pt x="4511" y="136"/>
                  <a:pt x="4536" y="130"/>
                  <a:pt x="4562" y="133"/>
                </a:cubicBezTo>
                <a:cubicBezTo>
                  <a:pt x="4587" y="137"/>
                  <a:pt x="4611" y="149"/>
                  <a:pt x="4632" y="171"/>
                </a:cubicBezTo>
                <a:cubicBezTo>
                  <a:pt x="4662" y="200"/>
                  <a:pt x="4676" y="236"/>
                  <a:pt x="4675" y="278"/>
                </a:cubicBezTo>
                <a:cubicBezTo>
                  <a:pt x="4674" y="320"/>
                  <a:pt x="4657" y="357"/>
                  <a:pt x="4624" y="390"/>
                </a:cubicBezTo>
                <a:cubicBezTo>
                  <a:pt x="4595" y="419"/>
                  <a:pt x="4562" y="435"/>
                  <a:pt x="4524" y="437"/>
                </a:cubicBezTo>
                <a:cubicBezTo>
                  <a:pt x="4487" y="439"/>
                  <a:pt x="4454" y="427"/>
                  <a:pt x="4423" y="402"/>
                </a:cubicBez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0" name="Freeform 76"/>
          <p:cNvSpPr>
            <a:spLocks noEditPoints="1"/>
          </p:cNvSpPr>
          <p:nvPr/>
        </p:nvSpPr>
        <p:spPr bwMode="auto">
          <a:xfrm>
            <a:off x="4807092" y="5032515"/>
            <a:ext cx="892175" cy="892175"/>
          </a:xfrm>
          <a:custGeom>
            <a:avLst/>
            <a:gdLst>
              <a:gd name="T0" fmla="*/ 238 w 4685"/>
              <a:gd name="T1" fmla="*/ 4148 h 4685"/>
              <a:gd name="T2" fmla="*/ 244 w 4685"/>
              <a:gd name="T3" fmla="*/ 4504 h 4685"/>
              <a:gd name="T4" fmla="*/ 336 w 4685"/>
              <a:gd name="T5" fmla="*/ 4300 h 4685"/>
              <a:gd name="T6" fmla="*/ 84 w 4685"/>
              <a:gd name="T7" fmla="*/ 4344 h 4685"/>
              <a:gd name="T8" fmla="*/ 513 w 4685"/>
              <a:gd name="T9" fmla="*/ 3856 h 4685"/>
              <a:gd name="T10" fmla="*/ 740 w 4685"/>
              <a:gd name="T11" fmla="*/ 3984 h 4685"/>
              <a:gd name="T12" fmla="*/ 779 w 4685"/>
              <a:gd name="T13" fmla="*/ 4242 h 4685"/>
              <a:gd name="T14" fmla="*/ 621 w 4685"/>
              <a:gd name="T15" fmla="*/ 3969 h 4685"/>
              <a:gd name="T16" fmla="*/ 399 w 4685"/>
              <a:gd name="T17" fmla="*/ 4029 h 4685"/>
              <a:gd name="T18" fmla="*/ 785 w 4685"/>
              <a:gd name="T19" fmla="*/ 4135 h 4685"/>
              <a:gd name="T20" fmla="*/ 618 w 4685"/>
              <a:gd name="T21" fmla="*/ 4092 h 4685"/>
              <a:gd name="T22" fmla="*/ 744 w 4685"/>
              <a:gd name="T23" fmla="*/ 3605 h 4685"/>
              <a:gd name="T24" fmla="*/ 1131 w 4685"/>
              <a:gd name="T25" fmla="*/ 3686 h 4685"/>
              <a:gd name="T26" fmla="*/ 964 w 4685"/>
              <a:gd name="T27" fmla="*/ 4057 h 4685"/>
              <a:gd name="T28" fmla="*/ 1081 w 4685"/>
              <a:gd name="T29" fmla="*/ 3728 h 4685"/>
              <a:gd name="T30" fmla="*/ 712 w 4685"/>
              <a:gd name="T31" fmla="*/ 3716 h 4685"/>
              <a:gd name="T32" fmla="*/ 1627 w 4685"/>
              <a:gd name="T33" fmla="*/ 3580 h 4685"/>
              <a:gd name="T34" fmla="*/ 1414 w 4685"/>
              <a:gd name="T35" fmla="*/ 2941 h 4685"/>
              <a:gd name="T36" fmla="*/ 1563 w 4685"/>
              <a:gd name="T37" fmla="*/ 3184 h 4685"/>
              <a:gd name="T38" fmla="*/ 1524 w 4685"/>
              <a:gd name="T39" fmla="*/ 3144 h 4685"/>
              <a:gd name="T40" fmla="*/ 1403 w 4685"/>
              <a:gd name="T41" fmla="*/ 3025 h 4685"/>
              <a:gd name="T42" fmla="*/ 1788 w 4685"/>
              <a:gd name="T43" fmla="*/ 2560 h 4685"/>
              <a:gd name="T44" fmla="*/ 1958 w 4685"/>
              <a:gd name="T45" fmla="*/ 2755 h 4685"/>
              <a:gd name="T46" fmla="*/ 1881 w 4685"/>
              <a:gd name="T47" fmla="*/ 3139 h 4685"/>
              <a:gd name="T48" fmla="*/ 2043 w 4685"/>
              <a:gd name="T49" fmla="*/ 2479 h 4685"/>
              <a:gd name="T50" fmla="*/ 2166 w 4685"/>
              <a:gd name="T51" fmla="*/ 2499 h 4685"/>
              <a:gd name="T52" fmla="*/ 2184 w 4685"/>
              <a:gd name="T53" fmla="*/ 2603 h 4685"/>
              <a:gd name="T54" fmla="*/ 2343 w 4685"/>
              <a:gd name="T55" fmla="*/ 2152 h 4685"/>
              <a:gd name="T56" fmla="*/ 2283 w 4685"/>
              <a:gd name="T57" fmla="*/ 2063 h 4685"/>
              <a:gd name="T58" fmla="*/ 2562 w 4685"/>
              <a:gd name="T59" fmla="*/ 1971 h 4685"/>
              <a:gd name="T60" fmla="*/ 2742 w 4685"/>
              <a:gd name="T61" fmla="*/ 1866 h 4685"/>
              <a:gd name="T62" fmla="*/ 3058 w 4685"/>
              <a:gd name="T63" fmla="*/ 1963 h 4685"/>
              <a:gd name="T64" fmla="*/ 2776 w 4685"/>
              <a:gd name="T65" fmla="*/ 1853 h 4685"/>
              <a:gd name="T66" fmla="*/ 2704 w 4685"/>
              <a:gd name="T67" fmla="*/ 1918 h 4685"/>
              <a:gd name="T68" fmla="*/ 2810 w 4685"/>
              <a:gd name="T69" fmla="*/ 2211 h 4685"/>
              <a:gd name="T70" fmla="*/ 3218 w 4685"/>
              <a:gd name="T71" fmla="*/ 1746 h 4685"/>
              <a:gd name="T72" fmla="*/ 3062 w 4685"/>
              <a:gd name="T73" fmla="*/ 1712 h 4685"/>
              <a:gd name="T74" fmla="*/ 2960 w 4685"/>
              <a:gd name="T75" fmla="*/ 1573 h 4685"/>
              <a:gd name="T76" fmla="*/ 3120 w 4685"/>
              <a:gd name="T77" fmla="*/ 1550 h 4685"/>
              <a:gd name="T78" fmla="*/ 3025 w 4685"/>
              <a:gd name="T79" fmla="*/ 1657 h 4685"/>
              <a:gd name="T80" fmla="*/ 3273 w 4685"/>
              <a:gd name="T81" fmla="*/ 1604 h 4685"/>
              <a:gd name="T82" fmla="*/ 3070 w 4685"/>
              <a:gd name="T83" fmla="*/ 1805 h 4685"/>
              <a:gd name="T84" fmla="*/ 3204 w 4685"/>
              <a:gd name="T85" fmla="*/ 1391 h 4685"/>
              <a:gd name="T86" fmla="*/ 3541 w 4685"/>
              <a:gd name="T87" fmla="*/ 1480 h 4685"/>
              <a:gd name="T88" fmla="*/ 3499 w 4685"/>
              <a:gd name="T89" fmla="*/ 945 h 4685"/>
              <a:gd name="T90" fmla="*/ 3787 w 4685"/>
              <a:gd name="T91" fmla="*/ 1233 h 4685"/>
              <a:gd name="T92" fmla="*/ 3802 w 4685"/>
              <a:gd name="T93" fmla="*/ 584 h 4685"/>
              <a:gd name="T94" fmla="*/ 3808 w 4685"/>
              <a:gd name="T95" fmla="*/ 940 h 4685"/>
              <a:gd name="T96" fmla="*/ 3900 w 4685"/>
              <a:gd name="T97" fmla="*/ 736 h 4685"/>
              <a:gd name="T98" fmla="*/ 3648 w 4685"/>
              <a:gd name="T99" fmla="*/ 780 h 4685"/>
              <a:gd name="T100" fmla="*/ 4241 w 4685"/>
              <a:gd name="T101" fmla="*/ 691 h 4685"/>
              <a:gd name="T102" fmla="*/ 4293 w 4685"/>
              <a:gd name="T103" fmla="*/ 490 h 4685"/>
              <a:gd name="T104" fmla="*/ 3960 w 4685"/>
              <a:gd name="T105" fmla="*/ 563 h 4685"/>
              <a:gd name="T106" fmla="*/ 4143 w 4685"/>
              <a:gd name="T107" fmla="*/ 290 h 4685"/>
              <a:gd name="T108" fmla="*/ 3982 w 4685"/>
              <a:gd name="T109" fmla="*/ 463 h 4685"/>
              <a:gd name="T110" fmla="*/ 4307 w 4685"/>
              <a:gd name="T111" fmla="*/ 429 h 4685"/>
              <a:gd name="T112" fmla="*/ 4255 w 4685"/>
              <a:gd name="T113" fmla="*/ 750 h 4685"/>
              <a:gd name="T114" fmla="*/ 4417 w 4685"/>
              <a:gd name="T115" fmla="*/ 443 h 4685"/>
              <a:gd name="T116" fmla="*/ 4612 w 4685"/>
              <a:gd name="T117" fmla="*/ 172 h 4685"/>
              <a:gd name="T118" fmla="*/ 4525 w 4685"/>
              <a:gd name="T119" fmla="*/ 259 h 468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</a:cxnLst>
            <a:rect l="0" t="0" r="r" b="b"/>
            <a:pathLst>
              <a:path w="4685" h="4685">
                <a:moveTo>
                  <a:pt x="336" y="4685"/>
                </a:moveTo>
                <a:lnTo>
                  <a:pt x="0" y="4349"/>
                </a:lnTo>
                <a:lnTo>
                  <a:pt x="127" y="4222"/>
                </a:lnTo>
                <a:cubicBezTo>
                  <a:pt x="149" y="4199"/>
                  <a:pt x="167" y="4183"/>
                  <a:pt x="181" y="4174"/>
                </a:cubicBezTo>
                <a:cubicBezTo>
                  <a:pt x="200" y="4160"/>
                  <a:pt x="220" y="4152"/>
                  <a:pt x="238" y="4148"/>
                </a:cubicBezTo>
                <a:cubicBezTo>
                  <a:pt x="257" y="4145"/>
                  <a:pt x="277" y="4146"/>
                  <a:pt x="298" y="4154"/>
                </a:cubicBezTo>
                <a:cubicBezTo>
                  <a:pt x="318" y="4161"/>
                  <a:pt x="337" y="4173"/>
                  <a:pt x="354" y="4189"/>
                </a:cubicBezTo>
                <a:cubicBezTo>
                  <a:pt x="382" y="4218"/>
                  <a:pt x="397" y="4251"/>
                  <a:pt x="399" y="4289"/>
                </a:cubicBezTo>
                <a:cubicBezTo>
                  <a:pt x="401" y="4327"/>
                  <a:pt x="378" y="4370"/>
                  <a:pt x="330" y="4417"/>
                </a:cubicBezTo>
                <a:lnTo>
                  <a:pt x="244" y="4504"/>
                </a:lnTo>
                <a:lnTo>
                  <a:pt x="381" y="4640"/>
                </a:lnTo>
                <a:lnTo>
                  <a:pt x="336" y="4685"/>
                </a:lnTo>
                <a:close/>
                <a:moveTo>
                  <a:pt x="204" y="4464"/>
                </a:moveTo>
                <a:lnTo>
                  <a:pt x="291" y="4377"/>
                </a:lnTo>
                <a:cubicBezTo>
                  <a:pt x="320" y="4348"/>
                  <a:pt x="335" y="4322"/>
                  <a:pt x="336" y="4300"/>
                </a:cubicBezTo>
                <a:cubicBezTo>
                  <a:pt x="338" y="4277"/>
                  <a:pt x="329" y="4256"/>
                  <a:pt x="309" y="4236"/>
                </a:cubicBezTo>
                <a:cubicBezTo>
                  <a:pt x="295" y="4222"/>
                  <a:pt x="280" y="4214"/>
                  <a:pt x="263" y="4211"/>
                </a:cubicBezTo>
                <a:cubicBezTo>
                  <a:pt x="245" y="4208"/>
                  <a:pt x="229" y="4211"/>
                  <a:pt x="215" y="4219"/>
                </a:cubicBezTo>
                <a:cubicBezTo>
                  <a:pt x="205" y="4225"/>
                  <a:pt x="190" y="4238"/>
                  <a:pt x="170" y="4258"/>
                </a:cubicBezTo>
                <a:lnTo>
                  <a:pt x="84" y="4344"/>
                </a:lnTo>
                <a:lnTo>
                  <a:pt x="204" y="4464"/>
                </a:lnTo>
                <a:close/>
                <a:moveTo>
                  <a:pt x="651" y="4370"/>
                </a:moveTo>
                <a:lnTo>
                  <a:pt x="315" y="4034"/>
                </a:lnTo>
                <a:lnTo>
                  <a:pt x="441" y="3908"/>
                </a:lnTo>
                <a:cubicBezTo>
                  <a:pt x="467" y="3882"/>
                  <a:pt x="491" y="3865"/>
                  <a:pt x="513" y="3856"/>
                </a:cubicBezTo>
                <a:cubicBezTo>
                  <a:pt x="535" y="3847"/>
                  <a:pt x="558" y="3846"/>
                  <a:pt x="581" y="3851"/>
                </a:cubicBezTo>
                <a:cubicBezTo>
                  <a:pt x="604" y="3856"/>
                  <a:pt x="623" y="3867"/>
                  <a:pt x="639" y="3882"/>
                </a:cubicBezTo>
                <a:cubicBezTo>
                  <a:pt x="653" y="3896"/>
                  <a:pt x="663" y="3914"/>
                  <a:pt x="667" y="3934"/>
                </a:cubicBezTo>
                <a:cubicBezTo>
                  <a:pt x="672" y="3955"/>
                  <a:pt x="671" y="3977"/>
                  <a:pt x="663" y="4000"/>
                </a:cubicBezTo>
                <a:cubicBezTo>
                  <a:pt x="689" y="3986"/>
                  <a:pt x="715" y="3981"/>
                  <a:pt x="740" y="3984"/>
                </a:cubicBezTo>
                <a:cubicBezTo>
                  <a:pt x="765" y="3987"/>
                  <a:pt x="788" y="3999"/>
                  <a:pt x="807" y="4018"/>
                </a:cubicBezTo>
                <a:cubicBezTo>
                  <a:pt x="823" y="4034"/>
                  <a:pt x="835" y="4052"/>
                  <a:pt x="841" y="4072"/>
                </a:cubicBezTo>
                <a:cubicBezTo>
                  <a:pt x="848" y="4093"/>
                  <a:pt x="850" y="4111"/>
                  <a:pt x="848" y="4128"/>
                </a:cubicBezTo>
                <a:cubicBezTo>
                  <a:pt x="846" y="4145"/>
                  <a:pt x="839" y="4163"/>
                  <a:pt x="828" y="4182"/>
                </a:cubicBezTo>
                <a:cubicBezTo>
                  <a:pt x="817" y="4200"/>
                  <a:pt x="801" y="4220"/>
                  <a:pt x="779" y="4242"/>
                </a:cubicBezTo>
                <a:lnTo>
                  <a:pt x="651" y="4370"/>
                </a:lnTo>
                <a:close/>
                <a:moveTo>
                  <a:pt x="501" y="4130"/>
                </a:moveTo>
                <a:lnTo>
                  <a:pt x="573" y="4058"/>
                </a:lnTo>
                <a:cubicBezTo>
                  <a:pt x="593" y="4038"/>
                  <a:pt x="606" y="4023"/>
                  <a:pt x="612" y="4011"/>
                </a:cubicBezTo>
                <a:cubicBezTo>
                  <a:pt x="620" y="3997"/>
                  <a:pt x="623" y="3983"/>
                  <a:pt x="621" y="3969"/>
                </a:cubicBezTo>
                <a:cubicBezTo>
                  <a:pt x="619" y="3956"/>
                  <a:pt x="612" y="3943"/>
                  <a:pt x="600" y="3931"/>
                </a:cubicBezTo>
                <a:cubicBezTo>
                  <a:pt x="589" y="3920"/>
                  <a:pt x="576" y="3913"/>
                  <a:pt x="563" y="3910"/>
                </a:cubicBezTo>
                <a:cubicBezTo>
                  <a:pt x="549" y="3907"/>
                  <a:pt x="535" y="3908"/>
                  <a:pt x="522" y="3915"/>
                </a:cubicBezTo>
                <a:cubicBezTo>
                  <a:pt x="509" y="3922"/>
                  <a:pt x="490" y="3937"/>
                  <a:pt x="466" y="3962"/>
                </a:cubicBezTo>
                <a:lnTo>
                  <a:pt x="399" y="4029"/>
                </a:lnTo>
                <a:lnTo>
                  <a:pt x="501" y="4130"/>
                </a:lnTo>
                <a:close/>
                <a:moveTo>
                  <a:pt x="656" y="4286"/>
                </a:moveTo>
                <a:lnTo>
                  <a:pt x="740" y="4202"/>
                </a:lnTo>
                <a:cubicBezTo>
                  <a:pt x="754" y="4188"/>
                  <a:pt x="764" y="4177"/>
                  <a:pt x="768" y="4170"/>
                </a:cubicBezTo>
                <a:cubicBezTo>
                  <a:pt x="777" y="4158"/>
                  <a:pt x="782" y="4146"/>
                  <a:pt x="785" y="4135"/>
                </a:cubicBezTo>
                <a:cubicBezTo>
                  <a:pt x="787" y="4124"/>
                  <a:pt x="787" y="4112"/>
                  <a:pt x="783" y="4100"/>
                </a:cubicBezTo>
                <a:cubicBezTo>
                  <a:pt x="779" y="4087"/>
                  <a:pt x="772" y="4075"/>
                  <a:pt x="761" y="4065"/>
                </a:cubicBezTo>
                <a:cubicBezTo>
                  <a:pt x="749" y="4052"/>
                  <a:pt x="735" y="4044"/>
                  <a:pt x="719" y="4042"/>
                </a:cubicBezTo>
                <a:cubicBezTo>
                  <a:pt x="703" y="4039"/>
                  <a:pt x="688" y="4041"/>
                  <a:pt x="673" y="4049"/>
                </a:cubicBezTo>
                <a:cubicBezTo>
                  <a:pt x="658" y="4056"/>
                  <a:pt x="640" y="4071"/>
                  <a:pt x="618" y="4092"/>
                </a:cubicBezTo>
                <a:lnTo>
                  <a:pt x="540" y="4170"/>
                </a:lnTo>
                <a:lnTo>
                  <a:pt x="656" y="4286"/>
                </a:lnTo>
                <a:close/>
                <a:moveTo>
                  <a:pt x="964" y="4057"/>
                </a:moveTo>
                <a:lnTo>
                  <a:pt x="628" y="3721"/>
                </a:lnTo>
                <a:lnTo>
                  <a:pt x="744" y="3605"/>
                </a:lnTo>
                <a:cubicBezTo>
                  <a:pt x="770" y="3579"/>
                  <a:pt x="791" y="3560"/>
                  <a:pt x="808" y="3550"/>
                </a:cubicBezTo>
                <a:cubicBezTo>
                  <a:pt x="832" y="3535"/>
                  <a:pt x="857" y="3527"/>
                  <a:pt x="882" y="3525"/>
                </a:cubicBezTo>
                <a:cubicBezTo>
                  <a:pt x="914" y="3522"/>
                  <a:pt x="947" y="3528"/>
                  <a:pt x="979" y="3542"/>
                </a:cubicBezTo>
                <a:cubicBezTo>
                  <a:pt x="1011" y="3557"/>
                  <a:pt x="1042" y="3579"/>
                  <a:pt x="1072" y="3609"/>
                </a:cubicBezTo>
                <a:cubicBezTo>
                  <a:pt x="1098" y="3635"/>
                  <a:pt x="1117" y="3660"/>
                  <a:pt x="1131" y="3686"/>
                </a:cubicBezTo>
                <a:cubicBezTo>
                  <a:pt x="1145" y="3711"/>
                  <a:pt x="1153" y="3735"/>
                  <a:pt x="1157" y="3758"/>
                </a:cubicBezTo>
                <a:cubicBezTo>
                  <a:pt x="1161" y="3780"/>
                  <a:pt x="1161" y="3800"/>
                  <a:pt x="1157" y="3819"/>
                </a:cubicBezTo>
                <a:cubicBezTo>
                  <a:pt x="1153" y="3837"/>
                  <a:pt x="1145" y="3856"/>
                  <a:pt x="1134" y="3876"/>
                </a:cubicBezTo>
                <a:cubicBezTo>
                  <a:pt x="1122" y="3895"/>
                  <a:pt x="1106" y="3915"/>
                  <a:pt x="1085" y="3935"/>
                </a:cubicBezTo>
                <a:lnTo>
                  <a:pt x="964" y="4057"/>
                </a:lnTo>
                <a:close/>
                <a:moveTo>
                  <a:pt x="969" y="3973"/>
                </a:moveTo>
                <a:lnTo>
                  <a:pt x="1041" y="3901"/>
                </a:lnTo>
                <a:cubicBezTo>
                  <a:pt x="1063" y="3879"/>
                  <a:pt x="1078" y="3859"/>
                  <a:pt x="1087" y="3842"/>
                </a:cubicBezTo>
                <a:cubicBezTo>
                  <a:pt x="1095" y="3826"/>
                  <a:pt x="1099" y="3810"/>
                  <a:pt x="1099" y="3795"/>
                </a:cubicBezTo>
                <a:cubicBezTo>
                  <a:pt x="1099" y="3774"/>
                  <a:pt x="1093" y="3751"/>
                  <a:pt x="1081" y="3728"/>
                </a:cubicBezTo>
                <a:cubicBezTo>
                  <a:pt x="1070" y="3704"/>
                  <a:pt x="1051" y="3680"/>
                  <a:pt x="1026" y="3654"/>
                </a:cubicBezTo>
                <a:cubicBezTo>
                  <a:pt x="990" y="3619"/>
                  <a:pt x="958" y="3598"/>
                  <a:pt x="927" y="3590"/>
                </a:cubicBezTo>
                <a:cubicBezTo>
                  <a:pt x="897" y="3583"/>
                  <a:pt x="870" y="3584"/>
                  <a:pt x="847" y="3595"/>
                </a:cubicBezTo>
                <a:cubicBezTo>
                  <a:pt x="831" y="3602"/>
                  <a:pt x="809" y="3619"/>
                  <a:pt x="783" y="3645"/>
                </a:cubicBezTo>
                <a:lnTo>
                  <a:pt x="712" y="3716"/>
                </a:lnTo>
                <a:lnTo>
                  <a:pt x="969" y="3973"/>
                </a:lnTo>
                <a:close/>
                <a:moveTo>
                  <a:pt x="1353" y="3854"/>
                </a:moveTo>
                <a:lnTo>
                  <a:pt x="1324" y="3824"/>
                </a:lnTo>
                <a:lnTo>
                  <a:pt x="1597" y="3551"/>
                </a:lnTo>
                <a:lnTo>
                  <a:pt x="1627" y="3580"/>
                </a:lnTo>
                <a:lnTo>
                  <a:pt x="1353" y="3854"/>
                </a:lnTo>
                <a:close/>
                <a:moveTo>
                  <a:pt x="1569" y="3451"/>
                </a:moveTo>
                <a:lnTo>
                  <a:pt x="1233" y="3115"/>
                </a:lnTo>
                <a:lnTo>
                  <a:pt x="1360" y="2989"/>
                </a:lnTo>
                <a:cubicBezTo>
                  <a:pt x="1382" y="2966"/>
                  <a:pt x="1400" y="2950"/>
                  <a:pt x="1414" y="2941"/>
                </a:cubicBezTo>
                <a:cubicBezTo>
                  <a:pt x="1434" y="2927"/>
                  <a:pt x="1453" y="2918"/>
                  <a:pt x="1472" y="2915"/>
                </a:cubicBezTo>
                <a:cubicBezTo>
                  <a:pt x="1490" y="2911"/>
                  <a:pt x="1510" y="2913"/>
                  <a:pt x="1531" y="2920"/>
                </a:cubicBezTo>
                <a:cubicBezTo>
                  <a:pt x="1552" y="2927"/>
                  <a:pt x="1570" y="2939"/>
                  <a:pt x="1587" y="2956"/>
                </a:cubicBezTo>
                <a:cubicBezTo>
                  <a:pt x="1616" y="2985"/>
                  <a:pt x="1631" y="3018"/>
                  <a:pt x="1632" y="3056"/>
                </a:cubicBezTo>
                <a:cubicBezTo>
                  <a:pt x="1634" y="3094"/>
                  <a:pt x="1611" y="3137"/>
                  <a:pt x="1563" y="3184"/>
                </a:cubicBezTo>
                <a:lnTo>
                  <a:pt x="1477" y="3270"/>
                </a:lnTo>
                <a:lnTo>
                  <a:pt x="1614" y="3407"/>
                </a:lnTo>
                <a:lnTo>
                  <a:pt x="1569" y="3451"/>
                </a:lnTo>
                <a:close/>
                <a:moveTo>
                  <a:pt x="1438" y="3231"/>
                </a:moveTo>
                <a:lnTo>
                  <a:pt x="1524" y="3144"/>
                </a:lnTo>
                <a:cubicBezTo>
                  <a:pt x="1553" y="3115"/>
                  <a:pt x="1568" y="3089"/>
                  <a:pt x="1570" y="3067"/>
                </a:cubicBezTo>
                <a:cubicBezTo>
                  <a:pt x="1571" y="3044"/>
                  <a:pt x="1562" y="3023"/>
                  <a:pt x="1543" y="3003"/>
                </a:cubicBezTo>
                <a:cubicBezTo>
                  <a:pt x="1528" y="2989"/>
                  <a:pt x="1513" y="2981"/>
                  <a:pt x="1496" y="2978"/>
                </a:cubicBezTo>
                <a:cubicBezTo>
                  <a:pt x="1479" y="2975"/>
                  <a:pt x="1463" y="2978"/>
                  <a:pt x="1448" y="2986"/>
                </a:cubicBezTo>
                <a:cubicBezTo>
                  <a:pt x="1438" y="2992"/>
                  <a:pt x="1424" y="3004"/>
                  <a:pt x="1403" y="3025"/>
                </a:cubicBezTo>
                <a:lnTo>
                  <a:pt x="1317" y="3111"/>
                </a:lnTo>
                <a:lnTo>
                  <a:pt x="1438" y="3231"/>
                </a:lnTo>
                <a:close/>
                <a:moveTo>
                  <a:pt x="1881" y="3139"/>
                </a:moveTo>
                <a:lnTo>
                  <a:pt x="1545" y="2803"/>
                </a:lnTo>
                <a:lnTo>
                  <a:pt x="1788" y="2560"/>
                </a:lnTo>
                <a:lnTo>
                  <a:pt x="1828" y="2600"/>
                </a:lnTo>
                <a:lnTo>
                  <a:pt x="1629" y="2798"/>
                </a:lnTo>
                <a:lnTo>
                  <a:pt x="1732" y="2901"/>
                </a:lnTo>
                <a:lnTo>
                  <a:pt x="1918" y="2716"/>
                </a:lnTo>
                <a:lnTo>
                  <a:pt x="1958" y="2755"/>
                </a:lnTo>
                <a:lnTo>
                  <a:pt x="1772" y="2941"/>
                </a:lnTo>
                <a:lnTo>
                  <a:pt x="1886" y="3055"/>
                </a:lnTo>
                <a:lnTo>
                  <a:pt x="2093" y="2849"/>
                </a:lnTo>
                <a:lnTo>
                  <a:pt x="2132" y="2889"/>
                </a:lnTo>
                <a:lnTo>
                  <a:pt x="1881" y="3139"/>
                </a:lnTo>
                <a:close/>
                <a:moveTo>
                  <a:pt x="2163" y="2858"/>
                </a:moveTo>
                <a:lnTo>
                  <a:pt x="2118" y="2553"/>
                </a:lnTo>
                <a:lnTo>
                  <a:pt x="1842" y="2506"/>
                </a:lnTo>
                <a:lnTo>
                  <a:pt x="1895" y="2453"/>
                </a:lnTo>
                <a:lnTo>
                  <a:pt x="2043" y="2479"/>
                </a:lnTo>
                <a:cubicBezTo>
                  <a:pt x="2073" y="2484"/>
                  <a:pt x="2096" y="2488"/>
                  <a:pt x="2111" y="2493"/>
                </a:cubicBezTo>
                <a:cubicBezTo>
                  <a:pt x="2106" y="2473"/>
                  <a:pt x="2102" y="2451"/>
                  <a:pt x="2099" y="2428"/>
                </a:cubicBezTo>
                <a:lnTo>
                  <a:pt x="2078" y="2271"/>
                </a:lnTo>
                <a:lnTo>
                  <a:pt x="2126" y="2223"/>
                </a:lnTo>
                <a:lnTo>
                  <a:pt x="2166" y="2499"/>
                </a:lnTo>
                <a:lnTo>
                  <a:pt x="2471" y="2550"/>
                </a:lnTo>
                <a:lnTo>
                  <a:pt x="2416" y="2605"/>
                </a:lnTo>
                <a:lnTo>
                  <a:pt x="2212" y="2569"/>
                </a:lnTo>
                <a:cubicBezTo>
                  <a:pt x="2200" y="2567"/>
                  <a:pt x="2188" y="2565"/>
                  <a:pt x="2175" y="2561"/>
                </a:cubicBezTo>
                <a:cubicBezTo>
                  <a:pt x="2179" y="2581"/>
                  <a:pt x="2182" y="2595"/>
                  <a:pt x="2184" y="2603"/>
                </a:cubicBezTo>
                <a:lnTo>
                  <a:pt x="2217" y="2804"/>
                </a:lnTo>
                <a:lnTo>
                  <a:pt x="2163" y="2858"/>
                </a:lnTo>
                <a:close/>
                <a:moveTo>
                  <a:pt x="2647" y="2374"/>
                </a:moveTo>
                <a:lnTo>
                  <a:pt x="2606" y="2415"/>
                </a:lnTo>
                <a:lnTo>
                  <a:pt x="2343" y="2152"/>
                </a:lnTo>
                <a:cubicBezTo>
                  <a:pt x="2342" y="2171"/>
                  <a:pt x="2339" y="2194"/>
                  <a:pt x="2332" y="2220"/>
                </a:cubicBezTo>
                <a:cubicBezTo>
                  <a:pt x="2326" y="2245"/>
                  <a:pt x="2318" y="2267"/>
                  <a:pt x="2310" y="2284"/>
                </a:cubicBezTo>
                <a:lnTo>
                  <a:pt x="2270" y="2244"/>
                </a:lnTo>
                <a:cubicBezTo>
                  <a:pt x="2282" y="2210"/>
                  <a:pt x="2289" y="2177"/>
                  <a:pt x="2291" y="2144"/>
                </a:cubicBezTo>
                <a:cubicBezTo>
                  <a:pt x="2293" y="2112"/>
                  <a:pt x="2290" y="2085"/>
                  <a:pt x="2283" y="2063"/>
                </a:cubicBezTo>
                <a:lnTo>
                  <a:pt x="2310" y="2036"/>
                </a:lnTo>
                <a:lnTo>
                  <a:pt x="2647" y="2374"/>
                </a:lnTo>
                <a:close/>
                <a:moveTo>
                  <a:pt x="2769" y="2252"/>
                </a:moveTo>
                <a:lnTo>
                  <a:pt x="2526" y="2008"/>
                </a:lnTo>
                <a:lnTo>
                  <a:pt x="2562" y="1971"/>
                </a:lnTo>
                <a:lnTo>
                  <a:pt x="2597" y="2006"/>
                </a:lnTo>
                <a:cubicBezTo>
                  <a:pt x="2592" y="1986"/>
                  <a:pt x="2593" y="1966"/>
                  <a:pt x="2598" y="1946"/>
                </a:cubicBezTo>
                <a:cubicBezTo>
                  <a:pt x="2604" y="1926"/>
                  <a:pt x="2615" y="1908"/>
                  <a:pt x="2631" y="1892"/>
                </a:cubicBezTo>
                <a:cubicBezTo>
                  <a:pt x="2649" y="1874"/>
                  <a:pt x="2667" y="1863"/>
                  <a:pt x="2686" y="1859"/>
                </a:cubicBezTo>
                <a:cubicBezTo>
                  <a:pt x="2705" y="1855"/>
                  <a:pt x="2724" y="1857"/>
                  <a:pt x="2742" y="1866"/>
                </a:cubicBezTo>
                <a:cubicBezTo>
                  <a:pt x="2733" y="1818"/>
                  <a:pt x="2744" y="1779"/>
                  <a:pt x="2775" y="1748"/>
                </a:cubicBezTo>
                <a:cubicBezTo>
                  <a:pt x="2799" y="1724"/>
                  <a:pt x="2824" y="1712"/>
                  <a:pt x="2851" y="1712"/>
                </a:cubicBezTo>
                <a:cubicBezTo>
                  <a:pt x="2877" y="1713"/>
                  <a:pt x="2904" y="1727"/>
                  <a:pt x="2932" y="1755"/>
                </a:cubicBezTo>
                <a:lnTo>
                  <a:pt x="3099" y="1922"/>
                </a:lnTo>
                <a:lnTo>
                  <a:pt x="3058" y="1963"/>
                </a:lnTo>
                <a:lnTo>
                  <a:pt x="2904" y="1810"/>
                </a:lnTo>
                <a:cubicBezTo>
                  <a:pt x="2888" y="1793"/>
                  <a:pt x="2875" y="1783"/>
                  <a:pt x="2865" y="1778"/>
                </a:cubicBezTo>
                <a:cubicBezTo>
                  <a:pt x="2855" y="1773"/>
                  <a:pt x="2844" y="1772"/>
                  <a:pt x="2833" y="1775"/>
                </a:cubicBezTo>
                <a:cubicBezTo>
                  <a:pt x="2821" y="1778"/>
                  <a:pt x="2811" y="1784"/>
                  <a:pt x="2801" y="1793"/>
                </a:cubicBezTo>
                <a:cubicBezTo>
                  <a:pt x="2784" y="1810"/>
                  <a:pt x="2776" y="1830"/>
                  <a:pt x="2776" y="1853"/>
                </a:cubicBezTo>
                <a:cubicBezTo>
                  <a:pt x="2776" y="1875"/>
                  <a:pt x="2788" y="1899"/>
                  <a:pt x="2813" y="1924"/>
                </a:cubicBezTo>
                <a:lnTo>
                  <a:pt x="2955" y="2066"/>
                </a:lnTo>
                <a:lnTo>
                  <a:pt x="2914" y="2107"/>
                </a:lnTo>
                <a:lnTo>
                  <a:pt x="2755" y="1949"/>
                </a:lnTo>
                <a:cubicBezTo>
                  <a:pt x="2737" y="1931"/>
                  <a:pt x="2720" y="1920"/>
                  <a:pt x="2704" y="1918"/>
                </a:cubicBezTo>
                <a:cubicBezTo>
                  <a:pt x="2688" y="1915"/>
                  <a:pt x="2673" y="1922"/>
                  <a:pt x="2657" y="1937"/>
                </a:cubicBezTo>
                <a:cubicBezTo>
                  <a:pt x="2646" y="1949"/>
                  <a:pt x="2638" y="1962"/>
                  <a:pt x="2634" y="1978"/>
                </a:cubicBezTo>
                <a:cubicBezTo>
                  <a:pt x="2631" y="1994"/>
                  <a:pt x="2632" y="2010"/>
                  <a:pt x="2640" y="2027"/>
                </a:cubicBezTo>
                <a:cubicBezTo>
                  <a:pt x="2647" y="2043"/>
                  <a:pt x="2662" y="2062"/>
                  <a:pt x="2684" y="2084"/>
                </a:cubicBezTo>
                <a:lnTo>
                  <a:pt x="2810" y="2211"/>
                </a:lnTo>
                <a:lnTo>
                  <a:pt x="2769" y="2252"/>
                </a:lnTo>
                <a:close/>
                <a:moveTo>
                  <a:pt x="3070" y="1805"/>
                </a:moveTo>
                <a:lnTo>
                  <a:pt x="3105" y="1758"/>
                </a:lnTo>
                <a:cubicBezTo>
                  <a:pt x="3123" y="1772"/>
                  <a:pt x="3142" y="1778"/>
                  <a:pt x="3161" y="1777"/>
                </a:cubicBezTo>
                <a:cubicBezTo>
                  <a:pt x="3180" y="1775"/>
                  <a:pt x="3199" y="1765"/>
                  <a:pt x="3218" y="1746"/>
                </a:cubicBezTo>
                <a:cubicBezTo>
                  <a:pt x="3237" y="1727"/>
                  <a:pt x="3247" y="1709"/>
                  <a:pt x="3249" y="1692"/>
                </a:cubicBezTo>
                <a:cubicBezTo>
                  <a:pt x="3250" y="1675"/>
                  <a:pt x="3246" y="1661"/>
                  <a:pt x="3235" y="1651"/>
                </a:cubicBezTo>
                <a:cubicBezTo>
                  <a:pt x="3226" y="1642"/>
                  <a:pt x="3215" y="1638"/>
                  <a:pt x="3201" y="1641"/>
                </a:cubicBezTo>
                <a:cubicBezTo>
                  <a:pt x="3192" y="1643"/>
                  <a:pt x="3173" y="1653"/>
                  <a:pt x="3145" y="1669"/>
                </a:cubicBezTo>
                <a:cubicBezTo>
                  <a:pt x="3107" y="1692"/>
                  <a:pt x="3080" y="1706"/>
                  <a:pt x="3062" y="1712"/>
                </a:cubicBezTo>
                <a:cubicBezTo>
                  <a:pt x="3045" y="1719"/>
                  <a:pt x="3028" y="1720"/>
                  <a:pt x="3013" y="1716"/>
                </a:cubicBezTo>
                <a:cubicBezTo>
                  <a:pt x="2997" y="1712"/>
                  <a:pt x="2983" y="1704"/>
                  <a:pt x="2971" y="1692"/>
                </a:cubicBezTo>
                <a:cubicBezTo>
                  <a:pt x="2960" y="1681"/>
                  <a:pt x="2952" y="1669"/>
                  <a:pt x="2948" y="1655"/>
                </a:cubicBezTo>
                <a:cubicBezTo>
                  <a:pt x="2944" y="1640"/>
                  <a:pt x="2943" y="1626"/>
                  <a:pt x="2945" y="1611"/>
                </a:cubicBezTo>
                <a:cubicBezTo>
                  <a:pt x="2947" y="1600"/>
                  <a:pt x="2952" y="1587"/>
                  <a:pt x="2960" y="1573"/>
                </a:cubicBezTo>
                <a:cubicBezTo>
                  <a:pt x="2967" y="1559"/>
                  <a:pt x="2978" y="1545"/>
                  <a:pt x="2990" y="1533"/>
                </a:cubicBezTo>
                <a:cubicBezTo>
                  <a:pt x="3009" y="1513"/>
                  <a:pt x="3029" y="1499"/>
                  <a:pt x="3049" y="1490"/>
                </a:cubicBezTo>
                <a:cubicBezTo>
                  <a:pt x="3069" y="1481"/>
                  <a:pt x="3087" y="1478"/>
                  <a:pt x="3103" y="1481"/>
                </a:cubicBezTo>
                <a:cubicBezTo>
                  <a:pt x="3120" y="1483"/>
                  <a:pt x="3137" y="1491"/>
                  <a:pt x="3155" y="1504"/>
                </a:cubicBezTo>
                <a:lnTo>
                  <a:pt x="3120" y="1550"/>
                </a:lnTo>
                <a:cubicBezTo>
                  <a:pt x="3106" y="1539"/>
                  <a:pt x="3091" y="1535"/>
                  <a:pt x="3075" y="1537"/>
                </a:cubicBezTo>
                <a:cubicBezTo>
                  <a:pt x="3059" y="1539"/>
                  <a:pt x="3043" y="1547"/>
                  <a:pt x="3027" y="1563"/>
                </a:cubicBezTo>
                <a:cubicBezTo>
                  <a:pt x="3008" y="1582"/>
                  <a:pt x="2998" y="1599"/>
                  <a:pt x="2996" y="1613"/>
                </a:cubicBezTo>
                <a:cubicBezTo>
                  <a:pt x="2994" y="1628"/>
                  <a:pt x="2998" y="1639"/>
                  <a:pt x="3006" y="1648"/>
                </a:cubicBezTo>
                <a:cubicBezTo>
                  <a:pt x="3011" y="1653"/>
                  <a:pt x="3018" y="1656"/>
                  <a:pt x="3025" y="1657"/>
                </a:cubicBezTo>
                <a:cubicBezTo>
                  <a:pt x="3033" y="1658"/>
                  <a:pt x="3042" y="1656"/>
                  <a:pt x="3052" y="1652"/>
                </a:cubicBezTo>
                <a:cubicBezTo>
                  <a:pt x="3058" y="1650"/>
                  <a:pt x="3074" y="1641"/>
                  <a:pt x="3099" y="1626"/>
                </a:cubicBezTo>
                <a:cubicBezTo>
                  <a:pt x="3136" y="1605"/>
                  <a:pt x="3163" y="1591"/>
                  <a:pt x="3179" y="1584"/>
                </a:cubicBezTo>
                <a:cubicBezTo>
                  <a:pt x="3196" y="1578"/>
                  <a:pt x="3212" y="1576"/>
                  <a:pt x="3228" y="1579"/>
                </a:cubicBezTo>
                <a:cubicBezTo>
                  <a:pt x="3244" y="1582"/>
                  <a:pt x="3259" y="1590"/>
                  <a:pt x="3273" y="1604"/>
                </a:cubicBezTo>
                <a:cubicBezTo>
                  <a:pt x="3287" y="1618"/>
                  <a:pt x="3296" y="1635"/>
                  <a:pt x="3300" y="1655"/>
                </a:cubicBezTo>
                <a:cubicBezTo>
                  <a:pt x="3304" y="1675"/>
                  <a:pt x="3302" y="1696"/>
                  <a:pt x="3294" y="1718"/>
                </a:cubicBezTo>
                <a:cubicBezTo>
                  <a:pt x="3285" y="1740"/>
                  <a:pt x="3272" y="1760"/>
                  <a:pt x="3252" y="1779"/>
                </a:cubicBezTo>
                <a:cubicBezTo>
                  <a:pt x="3221" y="1811"/>
                  <a:pt x="3190" y="1829"/>
                  <a:pt x="3160" y="1832"/>
                </a:cubicBezTo>
                <a:cubicBezTo>
                  <a:pt x="3131" y="1835"/>
                  <a:pt x="3101" y="1827"/>
                  <a:pt x="3070" y="1805"/>
                </a:cubicBezTo>
                <a:close/>
                <a:moveTo>
                  <a:pt x="3541" y="1480"/>
                </a:moveTo>
                <a:lnTo>
                  <a:pt x="3500" y="1521"/>
                </a:lnTo>
                <a:lnTo>
                  <a:pt x="3237" y="1258"/>
                </a:lnTo>
                <a:cubicBezTo>
                  <a:pt x="3236" y="1278"/>
                  <a:pt x="3233" y="1300"/>
                  <a:pt x="3226" y="1326"/>
                </a:cubicBezTo>
                <a:cubicBezTo>
                  <a:pt x="3219" y="1351"/>
                  <a:pt x="3212" y="1373"/>
                  <a:pt x="3204" y="1391"/>
                </a:cubicBezTo>
                <a:lnTo>
                  <a:pt x="3164" y="1351"/>
                </a:lnTo>
                <a:cubicBezTo>
                  <a:pt x="3176" y="1317"/>
                  <a:pt x="3183" y="1283"/>
                  <a:pt x="3185" y="1251"/>
                </a:cubicBezTo>
                <a:cubicBezTo>
                  <a:pt x="3187" y="1218"/>
                  <a:pt x="3184" y="1191"/>
                  <a:pt x="3177" y="1169"/>
                </a:cubicBezTo>
                <a:lnTo>
                  <a:pt x="3203" y="1142"/>
                </a:lnTo>
                <a:lnTo>
                  <a:pt x="3541" y="1480"/>
                </a:lnTo>
                <a:close/>
                <a:moveTo>
                  <a:pt x="3499" y="945"/>
                </a:moveTo>
                <a:lnTo>
                  <a:pt x="3451" y="897"/>
                </a:lnTo>
                <a:lnTo>
                  <a:pt x="3493" y="856"/>
                </a:lnTo>
                <a:lnTo>
                  <a:pt x="3540" y="903"/>
                </a:lnTo>
                <a:lnTo>
                  <a:pt x="3499" y="945"/>
                </a:lnTo>
                <a:close/>
                <a:moveTo>
                  <a:pt x="3787" y="1233"/>
                </a:moveTo>
                <a:lnTo>
                  <a:pt x="3544" y="990"/>
                </a:lnTo>
                <a:lnTo>
                  <a:pt x="3585" y="949"/>
                </a:lnTo>
                <a:lnTo>
                  <a:pt x="3829" y="1192"/>
                </a:lnTo>
                <a:lnTo>
                  <a:pt x="3787" y="1233"/>
                </a:lnTo>
                <a:close/>
                <a:moveTo>
                  <a:pt x="3900" y="1121"/>
                </a:moveTo>
                <a:lnTo>
                  <a:pt x="3564" y="785"/>
                </a:lnTo>
                <a:lnTo>
                  <a:pt x="3691" y="658"/>
                </a:lnTo>
                <a:cubicBezTo>
                  <a:pt x="3713" y="636"/>
                  <a:pt x="3731" y="620"/>
                  <a:pt x="3745" y="610"/>
                </a:cubicBezTo>
                <a:cubicBezTo>
                  <a:pt x="3764" y="596"/>
                  <a:pt x="3783" y="588"/>
                  <a:pt x="3802" y="584"/>
                </a:cubicBezTo>
                <a:cubicBezTo>
                  <a:pt x="3821" y="581"/>
                  <a:pt x="3841" y="583"/>
                  <a:pt x="3862" y="590"/>
                </a:cubicBezTo>
                <a:cubicBezTo>
                  <a:pt x="3882" y="597"/>
                  <a:pt x="3901" y="609"/>
                  <a:pt x="3918" y="625"/>
                </a:cubicBezTo>
                <a:cubicBezTo>
                  <a:pt x="3946" y="654"/>
                  <a:pt x="3961" y="687"/>
                  <a:pt x="3963" y="725"/>
                </a:cubicBezTo>
                <a:cubicBezTo>
                  <a:pt x="3965" y="763"/>
                  <a:pt x="3942" y="806"/>
                  <a:pt x="3894" y="854"/>
                </a:cubicBezTo>
                <a:lnTo>
                  <a:pt x="3808" y="940"/>
                </a:lnTo>
                <a:lnTo>
                  <a:pt x="3944" y="1076"/>
                </a:lnTo>
                <a:lnTo>
                  <a:pt x="3900" y="1121"/>
                </a:lnTo>
                <a:close/>
                <a:moveTo>
                  <a:pt x="3768" y="900"/>
                </a:moveTo>
                <a:lnTo>
                  <a:pt x="3855" y="813"/>
                </a:lnTo>
                <a:cubicBezTo>
                  <a:pt x="3884" y="784"/>
                  <a:pt x="3899" y="759"/>
                  <a:pt x="3900" y="736"/>
                </a:cubicBezTo>
                <a:cubicBezTo>
                  <a:pt x="3902" y="713"/>
                  <a:pt x="3893" y="692"/>
                  <a:pt x="3873" y="673"/>
                </a:cubicBezTo>
                <a:cubicBezTo>
                  <a:pt x="3859" y="659"/>
                  <a:pt x="3844" y="650"/>
                  <a:pt x="3826" y="647"/>
                </a:cubicBezTo>
                <a:cubicBezTo>
                  <a:pt x="3809" y="644"/>
                  <a:pt x="3793" y="647"/>
                  <a:pt x="3778" y="655"/>
                </a:cubicBezTo>
                <a:cubicBezTo>
                  <a:pt x="3769" y="661"/>
                  <a:pt x="3754" y="674"/>
                  <a:pt x="3734" y="694"/>
                </a:cubicBezTo>
                <a:lnTo>
                  <a:pt x="3648" y="780"/>
                </a:lnTo>
                <a:lnTo>
                  <a:pt x="3768" y="900"/>
                </a:lnTo>
                <a:close/>
                <a:moveTo>
                  <a:pt x="4088" y="717"/>
                </a:moveTo>
                <a:lnTo>
                  <a:pt x="4126" y="671"/>
                </a:lnTo>
                <a:cubicBezTo>
                  <a:pt x="4145" y="686"/>
                  <a:pt x="4164" y="695"/>
                  <a:pt x="4182" y="699"/>
                </a:cubicBezTo>
                <a:cubicBezTo>
                  <a:pt x="4200" y="702"/>
                  <a:pt x="4220" y="700"/>
                  <a:pt x="4241" y="691"/>
                </a:cubicBezTo>
                <a:cubicBezTo>
                  <a:pt x="4263" y="682"/>
                  <a:pt x="4284" y="669"/>
                  <a:pt x="4303" y="649"/>
                </a:cubicBezTo>
                <a:cubicBezTo>
                  <a:pt x="4320" y="632"/>
                  <a:pt x="4332" y="615"/>
                  <a:pt x="4340" y="597"/>
                </a:cubicBezTo>
                <a:cubicBezTo>
                  <a:pt x="4348" y="579"/>
                  <a:pt x="4351" y="562"/>
                  <a:pt x="4349" y="547"/>
                </a:cubicBezTo>
                <a:cubicBezTo>
                  <a:pt x="4346" y="532"/>
                  <a:pt x="4340" y="519"/>
                  <a:pt x="4329" y="509"/>
                </a:cubicBezTo>
                <a:cubicBezTo>
                  <a:pt x="4319" y="498"/>
                  <a:pt x="4307" y="492"/>
                  <a:pt x="4293" y="490"/>
                </a:cubicBezTo>
                <a:cubicBezTo>
                  <a:pt x="4279" y="489"/>
                  <a:pt x="4262" y="492"/>
                  <a:pt x="4243" y="501"/>
                </a:cubicBezTo>
                <a:cubicBezTo>
                  <a:pt x="4230" y="506"/>
                  <a:pt x="4205" y="521"/>
                  <a:pt x="4166" y="544"/>
                </a:cubicBezTo>
                <a:cubicBezTo>
                  <a:pt x="4128" y="568"/>
                  <a:pt x="4099" y="582"/>
                  <a:pt x="4080" y="588"/>
                </a:cubicBezTo>
                <a:cubicBezTo>
                  <a:pt x="4056" y="596"/>
                  <a:pt x="4034" y="597"/>
                  <a:pt x="4013" y="593"/>
                </a:cubicBezTo>
                <a:cubicBezTo>
                  <a:pt x="3993" y="588"/>
                  <a:pt x="3975" y="578"/>
                  <a:pt x="3960" y="563"/>
                </a:cubicBezTo>
                <a:cubicBezTo>
                  <a:pt x="3943" y="546"/>
                  <a:pt x="3932" y="525"/>
                  <a:pt x="3926" y="501"/>
                </a:cubicBezTo>
                <a:cubicBezTo>
                  <a:pt x="3921" y="476"/>
                  <a:pt x="3924" y="451"/>
                  <a:pt x="3935" y="425"/>
                </a:cubicBezTo>
                <a:cubicBezTo>
                  <a:pt x="3946" y="399"/>
                  <a:pt x="3963" y="374"/>
                  <a:pt x="3985" y="352"/>
                </a:cubicBezTo>
                <a:cubicBezTo>
                  <a:pt x="4010" y="327"/>
                  <a:pt x="4036" y="309"/>
                  <a:pt x="4063" y="298"/>
                </a:cubicBezTo>
                <a:cubicBezTo>
                  <a:pt x="4090" y="287"/>
                  <a:pt x="4117" y="284"/>
                  <a:pt x="4143" y="290"/>
                </a:cubicBezTo>
                <a:cubicBezTo>
                  <a:pt x="4168" y="295"/>
                  <a:pt x="4192" y="307"/>
                  <a:pt x="4212" y="326"/>
                </a:cubicBezTo>
                <a:lnTo>
                  <a:pt x="4173" y="372"/>
                </a:lnTo>
                <a:cubicBezTo>
                  <a:pt x="4149" y="353"/>
                  <a:pt x="4125" y="345"/>
                  <a:pt x="4101" y="347"/>
                </a:cubicBezTo>
                <a:cubicBezTo>
                  <a:pt x="4077" y="349"/>
                  <a:pt x="4052" y="363"/>
                  <a:pt x="4026" y="389"/>
                </a:cubicBezTo>
                <a:cubicBezTo>
                  <a:pt x="3999" y="416"/>
                  <a:pt x="3985" y="441"/>
                  <a:pt x="3982" y="463"/>
                </a:cubicBezTo>
                <a:cubicBezTo>
                  <a:pt x="3980" y="485"/>
                  <a:pt x="3986" y="503"/>
                  <a:pt x="4000" y="517"/>
                </a:cubicBezTo>
                <a:cubicBezTo>
                  <a:pt x="4012" y="529"/>
                  <a:pt x="4026" y="535"/>
                  <a:pt x="4042" y="534"/>
                </a:cubicBezTo>
                <a:cubicBezTo>
                  <a:pt x="4059" y="533"/>
                  <a:pt x="4089" y="519"/>
                  <a:pt x="4133" y="491"/>
                </a:cubicBezTo>
                <a:cubicBezTo>
                  <a:pt x="4178" y="463"/>
                  <a:pt x="4210" y="445"/>
                  <a:pt x="4229" y="438"/>
                </a:cubicBezTo>
                <a:cubicBezTo>
                  <a:pt x="4258" y="427"/>
                  <a:pt x="4284" y="424"/>
                  <a:pt x="4307" y="429"/>
                </a:cubicBezTo>
                <a:cubicBezTo>
                  <a:pt x="4330" y="433"/>
                  <a:pt x="4351" y="444"/>
                  <a:pt x="4369" y="462"/>
                </a:cubicBezTo>
                <a:cubicBezTo>
                  <a:pt x="4386" y="480"/>
                  <a:pt x="4398" y="502"/>
                  <a:pt x="4404" y="528"/>
                </a:cubicBezTo>
                <a:cubicBezTo>
                  <a:pt x="4409" y="554"/>
                  <a:pt x="4407" y="581"/>
                  <a:pt x="4397" y="609"/>
                </a:cubicBezTo>
                <a:cubicBezTo>
                  <a:pt x="4386" y="637"/>
                  <a:pt x="4369" y="663"/>
                  <a:pt x="4345" y="687"/>
                </a:cubicBezTo>
                <a:cubicBezTo>
                  <a:pt x="4315" y="718"/>
                  <a:pt x="4285" y="739"/>
                  <a:pt x="4255" y="750"/>
                </a:cubicBezTo>
                <a:cubicBezTo>
                  <a:pt x="4226" y="762"/>
                  <a:pt x="4196" y="765"/>
                  <a:pt x="4167" y="759"/>
                </a:cubicBezTo>
                <a:cubicBezTo>
                  <a:pt x="4137" y="753"/>
                  <a:pt x="4111" y="739"/>
                  <a:pt x="4088" y="717"/>
                </a:cubicBezTo>
                <a:close/>
                <a:moveTo>
                  <a:pt x="4643" y="377"/>
                </a:moveTo>
                <a:lnTo>
                  <a:pt x="4563" y="297"/>
                </a:lnTo>
                <a:lnTo>
                  <a:pt x="4417" y="443"/>
                </a:lnTo>
                <a:lnTo>
                  <a:pt x="4379" y="405"/>
                </a:lnTo>
                <a:lnTo>
                  <a:pt x="4315" y="34"/>
                </a:lnTo>
                <a:lnTo>
                  <a:pt x="4349" y="0"/>
                </a:lnTo>
                <a:lnTo>
                  <a:pt x="4566" y="218"/>
                </a:lnTo>
                <a:lnTo>
                  <a:pt x="4612" y="172"/>
                </a:lnTo>
                <a:lnTo>
                  <a:pt x="4650" y="210"/>
                </a:lnTo>
                <a:lnTo>
                  <a:pt x="4604" y="256"/>
                </a:lnTo>
                <a:lnTo>
                  <a:pt x="4685" y="336"/>
                </a:lnTo>
                <a:lnTo>
                  <a:pt x="4643" y="377"/>
                </a:lnTo>
                <a:close/>
                <a:moveTo>
                  <a:pt x="4525" y="259"/>
                </a:moveTo>
                <a:lnTo>
                  <a:pt x="4374" y="108"/>
                </a:lnTo>
                <a:lnTo>
                  <a:pt x="4420" y="364"/>
                </a:lnTo>
                <a:lnTo>
                  <a:pt x="4525" y="259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1" name="Freeform 77"/>
          <p:cNvSpPr>
            <a:spLocks noEditPoints="1"/>
          </p:cNvSpPr>
          <p:nvPr/>
        </p:nvSpPr>
        <p:spPr bwMode="auto">
          <a:xfrm>
            <a:off x="5076967" y="5026165"/>
            <a:ext cx="892175" cy="898525"/>
          </a:xfrm>
          <a:custGeom>
            <a:avLst/>
            <a:gdLst>
              <a:gd name="T0" fmla="*/ 238 w 4678"/>
              <a:gd name="T1" fmla="*/ 4177 h 4714"/>
              <a:gd name="T2" fmla="*/ 244 w 4678"/>
              <a:gd name="T3" fmla="*/ 4533 h 4714"/>
              <a:gd name="T4" fmla="*/ 336 w 4678"/>
              <a:gd name="T5" fmla="*/ 4329 h 4714"/>
              <a:gd name="T6" fmla="*/ 84 w 4678"/>
              <a:gd name="T7" fmla="*/ 4373 h 4714"/>
              <a:gd name="T8" fmla="*/ 513 w 4678"/>
              <a:gd name="T9" fmla="*/ 3885 h 4714"/>
              <a:gd name="T10" fmla="*/ 740 w 4678"/>
              <a:gd name="T11" fmla="*/ 4013 h 4714"/>
              <a:gd name="T12" fmla="*/ 779 w 4678"/>
              <a:gd name="T13" fmla="*/ 4271 h 4714"/>
              <a:gd name="T14" fmla="*/ 621 w 4678"/>
              <a:gd name="T15" fmla="*/ 3998 h 4714"/>
              <a:gd name="T16" fmla="*/ 399 w 4678"/>
              <a:gd name="T17" fmla="*/ 4058 h 4714"/>
              <a:gd name="T18" fmla="*/ 785 w 4678"/>
              <a:gd name="T19" fmla="*/ 4164 h 4714"/>
              <a:gd name="T20" fmla="*/ 618 w 4678"/>
              <a:gd name="T21" fmla="*/ 4121 h 4714"/>
              <a:gd name="T22" fmla="*/ 744 w 4678"/>
              <a:gd name="T23" fmla="*/ 3634 h 4714"/>
              <a:gd name="T24" fmla="*/ 1131 w 4678"/>
              <a:gd name="T25" fmla="*/ 3715 h 4714"/>
              <a:gd name="T26" fmla="*/ 964 w 4678"/>
              <a:gd name="T27" fmla="*/ 4086 h 4714"/>
              <a:gd name="T28" fmla="*/ 1081 w 4678"/>
              <a:gd name="T29" fmla="*/ 3757 h 4714"/>
              <a:gd name="T30" fmla="*/ 712 w 4678"/>
              <a:gd name="T31" fmla="*/ 3745 h 4714"/>
              <a:gd name="T32" fmla="*/ 1627 w 4678"/>
              <a:gd name="T33" fmla="*/ 3609 h 4714"/>
              <a:gd name="T34" fmla="*/ 1414 w 4678"/>
              <a:gd name="T35" fmla="*/ 2970 h 4714"/>
              <a:gd name="T36" fmla="*/ 1563 w 4678"/>
              <a:gd name="T37" fmla="*/ 3213 h 4714"/>
              <a:gd name="T38" fmla="*/ 1524 w 4678"/>
              <a:gd name="T39" fmla="*/ 3173 h 4714"/>
              <a:gd name="T40" fmla="*/ 1403 w 4678"/>
              <a:gd name="T41" fmla="*/ 3054 h 4714"/>
              <a:gd name="T42" fmla="*/ 1788 w 4678"/>
              <a:gd name="T43" fmla="*/ 2589 h 4714"/>
              <a:gd name="T44" fmla="*/ 1958 w 4678"/>
              <a:gd name="T45" fmla="*/ 2784 h 4714"/>
              <a:gd name="T46" fmla="*/ 1881 w 4678"/>
              <a:gd name="T47" fmla="*/ 3168 h 4714"/>
              <a:gd name="T48" fmla="*/ 2042 w 4678"/>
              <a:gd name="T49" fmla="*/ 2508 h 4714"/>
              <a:gd name="T50" fmla="*/ 2166 w 4678"/>
              <a:gd name="T51" fmla="*/ 2528 h 4714"/>
              <a:gd name="T52" fmla="*/ 2184 w 4678"/>
              <a:gd name="T53" fmla="*/ 2632 h 4714"/>
              <a:gd name="T54" fmla="*/ 2343 w 4678"/>
              <a:gd name="T55" fmla="*/ 2181 h 4714"/>
              <a:gd name="T56" fmla="*/ 2283 w 4678"/>
              <a:gd name="T57" fmla="*/ 2092 h 4714"/>
              <a:gd name="T58" fmla="*/ 2562 w 4678"/>
              <a:gd name="T59" fmla="*/ 2000 h 4714"/>
              <a:gd name="T60" fmla="*/ 2742 w 4678"/>
              <a:gd name="T61" fmla="*/ 1895 h 4714"/>
              <a:gd name="T62" fmla="*/ 3058 w 4678"/>
              <a:gd name="T63" fmla="*/ 1992 h 4714"/>
              <a:gd name="T64" fmla="*/ 2776 w 4678"/>
              <a:gd name="T65" fmla="*/ 1882 h 4714"/>
              <a:gd name="T66" fmla="*/ 2704 w 4678"/>
              <a:gd name="T67" fmla="*/ 1947 h 4714"/>
              <a:gd name="T68" fmla="*/ 2810 w 4678"/>
              <a:gd name="T69" fmla="*/ 2240 h 4714"/>
              <a:gd name="T70" fmla="*/ 3218 w 4678"/>
              <a:gd name="T71" fmla="*/ 1775 h 4714"/>
              <a:gd name="T72" fmla="*/ 3062 w 4678"/>
              <a:gd name="T73" fmla="*/ 1741 h 4714"/>
              <a:gd name="T74" fmla="*/ 2959 w 4678"/>
              <a:gd name="T75" fmla="*/ 1602 h 4714"/>
              <a:gd name="T76" fmla="*/ 3120 w 4678"/>
              <a:gd name="T77" fmla="*/ 1579 h 4714"/>
              <a:gd name="T78" fmla="*/ 3025 w 4678"/>
              <a:gd name="T79" fmla="*/ 1686 h 4714"/>
              <a:gd name="T80" fmla="*/ 3273 w 4678"/>
              <a:gd name="T81" fmla="*/ 1633 h 4714"/>
              <a:gd name="T82" fmla="*/ 3070 w 4678"/>
              <a:gd name="T83" fmla="*/ 1834 h 4714"/>
              <a:gd name="T84" fmla="*/ 3204 w 4678"/>
              <a:gd name="T85" fmla="*/ 1420 h 4714"/>
              <a:gd name="T86" fmla="*/ 3541 w 4678"/>
              <a:gd name="T87" fmla="*/ 1509 h 4714"/>
              <a:gd name="T88" fmla="*/ 3499 w 4678"/>
              <a:gd name="T89" fmla="*/ 974 h 4714"/>
              <a:gd name="T90" fmla="*/ 3787 w 4678"/>
              <a:gd name="T91" fmla="*/ 1262 h 4714"/>
              <a:gd name="T92" fmla="*/ 3802 w 4678"/>
              <a:gd name="T93" fmla="*/ 613 h 4714"/>
              <a:gd name="T94" fmla="*/ 3808 w 4678"/>
              <a:gd name="T95" fmla="*/ 969 h 4714"/>
              <a:gd name="T96" fmla="*/ 3900 w 4678"/>
              <a:gd name="T97" fmla="*/ 765 h 4714"/>
              <a:gd name="T98" fmla="*/ 3648 w 4678"/>
              <a:gd name="T99" fmla="*/ 809 h 4714"/>
              <a:gd name="T100" fmla="*/ 4241 w 4678"/>
              <a:gd name="T101" fmla="*/ 720 h 4714"/>
              <a:gd name="T102" fmla="*/ 4292 w 4678"/>
              <a:gd name="T103" fmla="*/ 519 h 4714"/>
              <a:gd name="T104" fmla="*/ 3959 w 4678"/>
              <a:gd name="T105" fmla="*/ 592 h 4714"/>
              <a:gd name="T106" fmla="*/ 4142 w 4678"/>
              <a:gd name="T107" fmla="*/ 319 h 4714"/>
              <a:gd name="T108" fmla="*/ 3982 w 4678"/>
              <a:gd name="T109" fmla="*/ 492 h 4714"/>
              <a:gd name="T110" fmla="*/ 4307 w 4678"/>
              <a:gd name="T111" fmla="*/ 458 h 4714"/>
              <a:gd name="T112" fmla="*/ 4255 w 4678"/>
              <a:gd name="T113" fmla="*/ 779 h 4714"/>
              <a:gd name="T114" fmla="*/ 4533 w 4678"/>
              <a:gd name="T115" fmla="*/ 429 h 4714"/>
              <a:gd name="T116" fmla="*/ 4432 w 4678"/>
              <a:gd name="T117" fmla="*/ 245 h 4714"/>
              <a:gd name="T118" fmla="*/ 4387 w 4678"/>
              <a:gd name="T119" fmla="*/ 0 h 4714"/>
              <a:gd name="T120" fmla="*/ 4511 w 4678"/>
              <a:gd name="T121" fmla="*/ 154 h 4714"/>
              <a:gd name="T122" fmla="*/ 4423 w 4678"/>
              <a:gd name="T123" fmla="*/ 451 h 47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  <a:cxn ang="0">
                <a:pos x="T122" y="T123"/>
              </a:cxn>
            </a:cxnLst>
            <a:rect l="0" t="0" r="r" b="b"/>
            <a:pathLst>
              <a:path w="4678" h="4714">
                <a:moveTo>
                  <a:pt x="336" y="4714"/>
                </a:moveTo>
                <a:lnTo>
                  <a:pt x="0" y="4378"/>
                </a:lnTo>
                <a:lnTo>
                  <a:pt x="127" y="4251"/>
                </a:lnTo>
                <a:cubicBezTo>
                  <a:pt x="149" y="4228"/>
                  <a:pt x="167" y="4212"/>
                  <a:pt x="181" y="4203"/>
                </a:cubicBezTo>
                <a:cubicBezTo>
                  <a:pt x="200" y="4189"/>
                  <a:pt x="219" y="4181"/>
                  <a:pt x="238" y="4177"/>
                </a:cubicBezTo>
                <a:cubicBezTo>
                  <a:pt x="257" y="4174"/>
                  <a:pt x="277" y="4175"/>
                  <a:pt x="298" y="4183"/>
                </a:cubicBezTo>
                <a:cubicBezTo>
                  <a:pt x="318" y="4190"/>
                  <a:pt x="337" y="4202"/>
                  <a:pt x="354" y="4218"/>
                </a:cubicBezTo>
                <a:cubicBezTo>
                  <a:pt x="382" y="4247"/>
                  <a:pt x="397" y="4280"/>
                  <a:pt x="399" y="4318"/>
                </a:cubicBezTo>
                <a:cubicBezTo>
                  <a:pt x="401" y="4356"/>
                  <a:pt x="378" y="4399"/>
                  <a:pt x="330" y="4446"/>
                </a:cubicBezTo>
                <a:lnTo>
                  <a:pt x="244" y="4533"/>
                </a:lnTo>
                <a:lnTo>
                  <a:pt x="380" y="4669"/>
                </a:lnTo>
                <a:lnTo>
                  <a:pt x="336" y="4714"/>
                </a:lnTo>
                <a:close/>
                <a:moveTo>
                  <a:pt x="204" y="4493"/>
                </a:moveTo>
                <a:lnTo>
                  <a:pt x="291" y="4406"/>
                </a:lnTo>
                <a:cubicBezTo>
                  <a:pt x="320" y="4377"/>
                  <a:pt x="335" y="4351"/>
                  <a:pt x="336" y="4329"/>
                </a:cubicBezTo>
                <a:cubicBezTo>
                  <a:pt x="338" y="4306"/>
                  <a:pt x="329" y="4285"/>
                  <a:pt x="309" y="4265"/>
                </a:cubicBezTo>
                <a:cubicBezTo>
                  <a:pt x="295" y="4251"/>
                  <a:pt x="280" y="4243"/>
                  <a:pt x="262" y="4240"/>
                </a:cubicBezTo>
                <a:cubicBezTo>
                  <a:pt x="245" y="4237"/>
                  <a:pt x="229" y="4240"/>
                  <a:pt x="215" y="4248"/>
                </a:cubicBezTo>
                <a:cubicBezTo>
                  <a:pt x="205" y="4254"/>
                  <a:pt x="190" y="4267"/>
                  <a:pt x="170" y="4287"/>
                </a:cubicBezTo>
                <a:lnTo>
                  <a:pt x="84" y="4373"/>
                </a:lnTo>
                <a:lnTo>
                  <a:pt x="204" y="4493"/>
                </a:lnTo>
                <a:close/>
                <a:moveTo>
                  <a:pt x="651" y="4399"/>
                </a:moveTo>
                <a:lnTo>
                  <a:pt x="315" y="4063"/>
                </a:lnTo>
                <a:lnTo>
                  <a:pt x="441" y="3937"/>
                </a:lnTo>
                <a:cubicBezTo>
                  <a:pt x="467" y="3911"/>
                  <a:pt x="491" y="3894"/>
                  <a:pt x="513" y="3885"/>
                </a:cubicBezTo>
                <a:cubicBezTo>
                  <a:pt x="535" y="3876"/>
                  <a:pt x="558" y="3875"/>
                  <a:pt x="581" y="3880"/>
                </a:cubicBezTo>
                <a:cubicBezTo>
                  <a:pt x="604" y="3885"/>
                  <a:pt x="623" y="3896"/>
                  <a:pt x="638" y="3911"/>
                </a:cubicBezTo>
                <a:cubicBezTo>
                  <a:pt x="653" y="3925"/>
                  <a:pt x="662" y="3943"/>
                  <a:pt x="667" y="3963"/>
                </a:cubicBezTo>
                <a:cubicBezTo>
                  <a:pt x="672" y="3984"/>
                  <a:pt x="671" y="4006"/>
                  <a:pt x="663" y="4029"/>
                </a:cubicBezTo>
                <a:cubicBezTo>
                  <a:pt x="689" y="4015"/>
                  <a:pt x="715" y="4010"/>
                  <a:pt x="740" y="4013"/>
                </a:cubicBezTo>
                <a:cubicBezTo>
                  <a:pt x="765" y="4016"/>
                  <a:pt x="788" y="4028"/>
                  <a:pt x="807" y="4047"/>
                </a:cubicBezTo>
                <a:cubicBezTo>
                  <a:pt x="823" y="4063"/>
                  <a:pt x="834" y="4081"/>
                  <a:pt x="841" y="4101"/>
                </a:cubicBezTo>
                <a:cubicBezTo>
                  <a:pt x="848" y="4122"/>
                  <a:pt x="850" y="4140"/>
                  <a:pt x="848" y="4157"/>
                </a:cubicBezTo>
                <a:cubicBezTo>
                  <a:pt x="845" y="4174"/>
                  <a:pt x="839" y="4192"/>
                  <a:pt x="828" y="4211"/>
                </a:cubicBezTo>
                <a:cubicBezTo>
                  <a:pt x="817" y="4229"/>
                  <a:pt x="801" y="4249"/>
                  <a:pt x="779" y="4271"/>
                </a:cubicBezTo>
                <a:lnTo>
                  <a:pt x="651" y="4399"/>
                </a:lnTo>
                <a:close/>
                <a:moveTo>
                  <a:pt x="501" y="4159"/>
                </a:moveTo>
                <a:lnTo>
                  <a:pt x="573" y="4087"/>
                </a:lnTo>
                <a:cubicBezTo>
                  <a:pt x="593" y="4067"/>
                  <a:pt x="606" y="4052"/>
                  <a:pt x="612" y="4040"/>
                </a:cubicBezTo>
                <a:cubicBezTo>
                  <a:pt x="620" y="4026"/>
                  <a:pt x="623" y="4012"/>
                  <a:pt x="621" y="3998"/>
                </a:cubicBezTo>
                <a:cubicBezTo>
                  <a:pt x="619" y="3985"/>
                  <a:pt x="612" y="3972"/>
                  <a:pt x="600" y="3960"/>
                </a:cubicBezTo>
                <a:cubicBezTo>
                  <a:pt x="589" y="3949"/>
                  <a:pt x="576" y="3942"/>
                  <a:pt x="562" y="3939"/>
                </a:cubicBezTo>
                <a:cubicBezTo>
                  <a:pt x="549" y="3936"/>
                  <a:pt x="535" y="3937"/>
                  <a:pt x="522" y="3944"/>
                </a:cubicBezTo>
                <a:cubicBezTo>
                  <a:pt x="509" y="3951"/>
                  <a:pt x="490" y="3966"/>
                  <a:pt x="466" y="3991"/>
                </a:cubicBezTo>
                <a:lnTo>
                  <a:pt x="399" y="4058"/>
                </a:lnTo>
                <a:lnTo>
                  <a:pt x="501" y="4159"/>
                </a:lnTo>
                <a:close/>
                <a:moveTo>
                  <a:pt x="656" y="4315"/>
                </a:moveTo>
                <a:lnTo>
                  <a:pt x="739" y="4231"/>
                </a:lnTo>
                <a:cubicBezTo>
                  <a:pt x="754" y="4217"/>
                  <a:pt x="763" y="4206"/>
                  <a:pt x="768" y="4199"/>
                </a:cubicBezTo>
                <a:cubicBezTo>
                  <a:pt x="777" y="4187"/>
                  <a:pt x="782" y="4175"/>
                  <a:pt x="785" y="4164"/>
                </a:cubicBezTo>
                <a:cubicBezTo>
                  <a:pt x="787" y="4153"/>
                  <a:pt x="787" y="4141"/>
                  <a:pt x="783" y="4129"/>
                </a:cubicBezTo>
                <a:cubicBezTo>
                  <a:pt x="779" y="4116"/>
                  <a:pt x="772" y="4104"/>
                  <a:pt x="761" y="4094"/>
                </a:cubicBezTo>
                <a:cubicBezTo>
                  <a:pt x="749" y="4081"/>
                  <a:pt x="735" y="4073"/>
                  <a:pt x="719" y="4071"/>
                </a:cubicBezTo>
                <a:cubicBezTo>
                  <a:pt x="703" y="4068"/>
                  <a:pt x="688" y="4070"/>
                  <a:pt x="673" y="4078"/>
                </a:cubicBezTo>
                <a:cubicBezTo>
                  <a:pt x="658" y="4085"/>
                  <a:pt x="639" y="4100"/>
                  <a:pt x="618" y="4121"/>
                </a:cubicBezTo>
                <a:lnTo>
                  <a:pt x="540" y="4199"/>
                </a:lnTo>
                <a:lnTo>
                  <a:pt x="656" y="4315"/>
                </a:lnTo>
                <a:close/>
                <a:moveTo>
                  <a:pt x="964" y="4086"/>
                </a:moveTo>
                <a:lnTo>
                  <a:pt x="628" y="3750"/>
                </a:lnTo>
                <a:lnTo>
                  <a:pt x="744" y="3634"/>
                </a:lnTo>
                <a:cubicBezTo>
                  <a:pt x="770" y="3608"/>
                  <a:pt x="791" y="3589"/>
                  <a:pt x="808" y="3579"/>
                </a:cubicBezTo>
                <a:cubicBezTo>
                  <a:pt x="832" y="3564"/>
                  <a:pt x="856" y="3556"/>
                  <a:pt x="882" y="3554"/>
                </a:cubicBezTo>
                <a:cubicBezTo>
                  <a:pt x="914" y="3551"/>
                  <a:pt x="947" y="3557"/>
                  <a:pt x="979" y="3571"/>
                </a:cubicBezTo>
                <a:cubicBezTo>
                  <a:pt x="1011" y="3586"/>
                  <a:pt x="1042" y="3608"/>
                  <a:pt x="1072" y="3638"/>
                </a:cubicBezTo>
                <a:cubicBezTo>
                  <a:pt x="1097" y="3664"/>
                  <a:pt x="1117" y="3689"/>
                  <a:pt x="1131" y="3715"/>
                </a:cubicBezTo>
                <a:cubicBezTo>
                  <a:pt x="1145" y="3740"/>
                  <a:pt x="1153" y="3764"/>
                  <a:pt x="1157" y="3787"/>
                </a:cubicBezTo>
                <a:cubicBezTo>
                  <a:pt x="1160" y="3809"/>
                  <a:pt x="1160" y="3829"/>
                  <a:pt x="1157" y="3848"/>
                </a:cubicBezTo>
                <a:cubicBezTo>
                  <a:pt x="1153" y="3866"/>
                  <a:pt x="1145" y="3885"/>
                  <a:pt x="1133" y="3905"/>
                </a:cubicBezTo>
                <a:cubicBezTo>
                  <a:pt x="1122" y="3924"/>
                  <a:pt x="1106" y="3944"/>
                  <a:pt x="1085" y="3964"/>
                </a:cubicBezTo>
                <a:lnTo>
                  <a:pt x="964" y="4086"/>
                </a:lnTo>
                <a:close/>
                <a:moveTo>
                  <a:pt x="969" y="4002"/>
                </a:moveTo>
                <a:lnTo>
                  <a:pt x="1041" y="3930"/>
                </a:lnTo>
                <a:cubicBezTo>
                  <a:pt x="1063" y="3908"/>
                  <a:pt x="1078" y="3888"/>
                  <a:pt x="1086" y="3871"/>
                </a:cubicBezTo>
                <a:cubicBezTo>
                  <a:pt x="1095" y="3855"/>
                  <a:pt x="1099" y="3839"/>
                  <a:pt x="1099" y="3824"/>
                </a:cubicBezTo>
                <a:cubicBezTo>
                  <a:pt x="1099" y="3803"/>
                  <a:pt x="1093" y="3780"/>
                  <a:pt x="1081" y="3757"/>
                </a:cubicBezTo>
                <a:cubicBezTo>
                  <a:pt x="1069" y="3733"/>
                  <a:pt x="1051" y="3709"/>
                  <a:pt x="1025" y="3683"/>
                </a:cubicBezTo>
                <a:cubicBezTo>
                  <a:pt x="990" y="3648"/>
                  <a:pt x="957" y="3627"/>
                  <a:pt x="927" y="3619"/>
                </a:cubicBezTo>
                <a:cubicBezTo>
                  <a:pt x="897" y="3612"/>
                  <a:pt x="870" y="3613"/>
                  <a:pt x="847" y="3624"/>
                </a:cubicBezTo>
                <a:cubicBezTo>
                  <a:pt x="831" y="3631"/>
                  <a:pt x="809" y="3648"/>
                  <a:pt x="783" y="3674"/>
                </a:cubicBezTo>
                <a:lnTo>
                  <a:pt x="712" y="3745"/>
                </a:lnTo>
                <a:lnTo>
                  <a:pt x="969" y="4002"/>
                </a:lnTo>
                <a:close/>
                <a:moveTo>
                  <a:pt x="1353" y="3883"/>
                </a:moveTo>
                <a:lnTo>
                  <a:pt x="1324" y="3853"/>
                </a:lnTo>
                <a:lnTo>
                  <a:pt x="1597" y="3580"/>
                </a:lnTo>
                <a:lnTo>
                  <a:pt x="1627" y="3609"/>
                </a:lnTo>
                <a:lnTo>
                  <a:pt x="1353" y="3883"/>
                </a:lnTo>
                <a:close/>
                <a:moveTo>
                  <a:pt x="1569" y="3480"/>
                </a:moveTo>
                <a:lnTo>
                  <a:pt x="1233" y="3144"/>
                </a:lnTo>
                <a:lnTo>
                  <a:pt x="1360" y="3018"/>
                </a:lnTo>
                <a:cubicBezTo>
                  <a:pt x="1382" y="2995"/>
                  <a:pt x="1400" y="2979"/>
                  <a:pt x="1414" y="2970"/>
                </a:cubicBezTo>
                <a:cubicBezTo>
                  <a:pt x="1433" y="2956"/>
                  <a:pt x="1453" y="2947"/>
                  <a:pt x="1471" y="2944"/>
                </a:cubicBezTo>
                <a:cubicBezTo>
                  <a:pt x="1490" y="2940"/>
                  <a:pt x="1510" y="2942"/>
                  <a:pt x="1531" y="2949"/>
                </a:cubicBezTo>
                <a:cubicBezTo>
                  <a:pt x="1552" y="2956"/>
                  <a:pt x="1570" y="2968"/>
                  <a:pt x="1587" y="2985"/>
                </a:cubicBezTo>
                <a:cubicBezTo>
                  <a:pt x="1615" y="3014"/>
                  <a:pt x="1631" y="3047"/>
                  <a:pt x="1632" y="3085"/>
                </a:cubicBezTo>
                <a:cubicBezTo>
                  <a:pt x="1634" y="3123"/>
                  <a:pt x="1611" y="3166"/>
                  <a:pt x="1563" y="3213"/>
                </a:cubicBezTo>
                <a:lnTo>
                  <a:pt x="1477" y="3299"/>
                </a:lnTo>
                <a:lnTo>
                  <a:pt x="1614" y="3436"/>
                </a:lnTo>
                <a:lnTo>
                  <a:pt x="1569" y="3480"/>
                </a:lnTo>
                <a:close/>
                <a:moveTo>
                  <a:pt x="1437" y="3260"/>
                </a:moveTo>
                <a:lnTo>
                  <a:pt x="1524" y="3173"/>
                </a:lnTo>
                <a:cubicBezTo>
                  <a:pt x="1553" y="3144"/>
                  <a:pt x="1568" y="3118"/>
                  <a:pt x="1569" y="3096"/>
                </a:cubicBezTo>
                <a:cubicBezTo>
                  <a:pt x="1571" y="3073"/>
                  <a:pt x="1562" y="3052"/>
                  <a:pt x="1542" y="3032"/>
                </a:cubicBezTo>
                <a:cubicBezTo>
                  <a:pt x="1528" y="3018"/>
                  <a:pt x="1513" y="3010"/>
                  <a:pt x="1496" y="3007"/>
                </a:cubicBezTo>
                <a:cubicBezTo>
                  <a:pt x="1479" y="3004"/>
                  <a:pt x="1463" y="3007"/>
                  <a:pt x="1448" y="3015"/>
                </a:cubicBezTo>
                <a:cubicBezTo>
                  <a:pt x="1438" y="3021"/>
                  <a:pt x="1423" y="3033"/>
                  <a:pt x="1403" y="3054"/>
                </a:cubicBezTo>
                <a:lnTo>
                  <a:pt x="1317" y="3140"/>
                </a:lnTo>
                <a:lnTo>
                  <a:pt x="1437" y="3260"/>
                </a:lnTo>
                <a:close/>
                <a:moveTo>
                  <a:pt x="1881" y="3168"/>
                </a:moveTo>
                <a:lnTo>
                  <a:pt x="1545" y="2832"/>
                </a:lnTo>
                <a:lnTo>
                  <a:pt x="1788" y="2589"/>
                </a:lnTo>
                <a:lnTo>
                  <a:pt x="1828" y="2629"/>
                </a:lnTo>
                <a:lnTo>
                  <a:pt x="1629" y="2827"/>
                </a:lnTo>
                <a:lnTo>
                  <a:pt x="1732" y="2930"/>
                </a:lnTo>
                <a:lnTo>
                  <a:pt x="1918" y="2745"/>
                </a:lnTo>
                <a:lnTo>
                  <a:pt x="1958" y="2784"/>
                </a:lnTo>
                <a:lnTo>
                  <a:pt x="1772" y="2970"/>
                </a:lnTo>
                <a:lnTo>
                  <a:pt x="1886" y="3084"/>
                </a:lnTo>
                <a:lnTo>
                  <a:pt x="2092" y="2878"/>
                </a:lnTo>
                <a:lnTo>
                  <a:pt x="2132" y="2918"/>
                </a:lnTo>
                <a:lnTo>
                  <a:pt x="1881" y="3168"/>
                </a:lnTo>
                <a:close/>
                <a:moveTo>
                  <a:pt x="2163" y="2887"/>
                </a:moveTo>
                <a:lnTo>
                  <a:pt x="2118" y="2582"/>
                </a:lnTo>
                <a:lnTo>
                  <a:pt x="1842" y="2535"/>
                </a:lnTo>
                <a:lnTo>
                  <a:pt x="1895" y="2482"/>
                </a:lnTo>
                <a:lnTo>
                  <a:pt x="2042" y="2508"/>
                </a:lnTo>
                <a:cubicBezTo>
                  <a:pt x="2073" y="2513"/>
                  <a:pt x="2096" y="2517"/>
                  <a:pt x="2111" y="2522"/>
                </a:cubicBezTo>
                <a:cubicBezTo>
                  <a:pt x="2106" y="2502"/>
                  <a:pt x="2102" y="2480"/>
                  <a:pt x="2099" y="2457"/>
                </a:cubicBezTo>
                <a:lnTo>
                  <a:pt x="2077" y="2300"/>
                </a:lnTo>
                <a:lnTo>
                  <a:pt x="2126" y="2252"/>
                </a:lnTo>
                <a:lnTo>
                  <a:pt x="2166" y="2528"/>
                </a:lnTo>
                <a:lnTo>
                  <a:pt x="2471" y="2579"/>
                </a:lnTo>
                <a:lnTo>
                  <a:pt x="2416" y="2634"/>
                </a:lnTo>
                <a:lnTo>
                  <a:pt x="2212" y="2598"/>
                </a:lnTo>
                <a:cubicBezTo>
                  <a:pt x="2200" y="2596"/>
                  <a:pt x="2188" y="2594"/>
                  <a:pt x="2174" y="2590"/>
                </a:cubicBezTo>
                <a:cubicBezTo>
                  <a:pt x="2179" y="2610"/>
                  <a:pt x="2182" y="2624"/>
                  <a:pt x="2184" y="2632"/>
                </a:cubicBezTo>
                <a:lnTo>
                  <a:pt x="2216" y="2833"/>
                </a:lnTo>
                <a:lnTo>
                  <a:pt x="2163" y="2887"/>
                </a:lnTo>
                <a:close/>
                <a:moveTo>
                  <a:pt x="2647" y="2403"/>
                </a:moveTo>
                <a:lnTo>
                  <a:pt x="2606" y="2444"/>
                </a:lnTo>
                <a:lnTo>
                  <a:pt x="2343" y="2181"/>
                </a:lnTo>
                <a:cubicBezTo>
                  <a:pt x="2342" y="2200"/>
                  <a:pt x="2339" y="2223"/>
                  <a:pt x="2332" y="2249"/>
                </a:cubicBezTo>
                <a:cubicBezTo>
                  <a:pt x="2325" y="2274"/>
                  <a:pt x="2318" y="2296"/>
                  <a:pt x="2310" y="2313"/>
                </a:cubicBezTo>
                <a:lnTo>
                  <a:pt x="2270" y="2273"/>
                </a:lnTo>
                <a:cubicBezTo>
                  <a:pt x="2282" y="2239"/>
                  <a:pt x="2289" y="2206"/>
                  <a:pt x="2291" y="2173"/>
                </a:cubicBezTo>
                <a:cubicBezTo>
                  <a:pt x="2293" y="2141"/>
                  <a:pt x="2290" y="2114"/>
                  <a:pt x="2283" y="2092"/>
                </a:cubicBezTo>
                <a:lnTo>
                  <a:pt x="2309" y="2065"/>
                </a:lnTo>
                <a:lnTo>
                  <a:pt x="2647" y="2403"/>
                </a:lnTo>
                <a:close/>
                <a:moveTo>
                  <a:pt x="2769" y="2281"/>
                </a:moveTo>
                <a:lnTo>
                  <a:pt x="2525" y="2037"/>
                </a:lnTo>
                <a:lnTo>
                  <a:pt x="2562" y="2000"/>
                </a:lnTo>
                <a:lnTo>
                  <a:pt x="2596" y="2035"/>
                </a:lnTo>
                <a:cubicBezTo>
                  <a:pt x="2592" y="2015"/>
                  <a:pt x="2593" y="1995"/>
                  <a:pt x="2598" y="1975"/>
                </a:cubicBezTo>
                <a:cubicBezTo>
                  <a:pt x="2604" y="1955"/>
                  <a:pt x="2614" y="1937"/>
                  <a:pt x="2631" y="1921"/>
                </a:cubicBezTo>
                <a:cubicBezTo>
                  <a:pt x="2649" y="1903"/>
                  <a:pt x="2667" y="1892"/>
                  <a:pt x="2686" y="1888"/>
                </a:cubicBezTo>
                <a:cubicBezTo>
                  <a:pt x="2705" y="1884"/>
                  <a:pt x="2724" y="1886"/>
                  <a:pt x="2742" y="1895"/>
                </a:cubicBezTo>
                <a:cubicBezTo>
                  <a:pt x="2733" y="1847"/>
                  <a:pt x="2744" y="1808"/>
                  <a:pt x="2775" y="1777"/>
                </a:cubicBezTo>
                <a:cubicBezTo>
                  <a:pt x="2799" y="1753"/>
                  <a:pt x="2824" y="1741"/>
                  <a:pt x="2850" y="1741"/>
                </a:cubicBezTo>
                <a:cubicBezTo>
                  <a:pt x="2877" y="1742"/>
                  <a:pt x="2904" y="1756"/>
                  <a:pt x="2932" y="1784"/>
                </a:cubicBezTo>
                <a:lnTo>
                  <a:pt x="3099" y="1951"/>
                </a:lnTo>
                <a:lnTo>
                  <a:pt x="3058" y="1992"/>
                </a:lnTo>
                <a:lnTo>
                  <a:pt x="2904" y="1839"/>
                </a:lnTo>
                <a:cubicBezTo>
                  <a:pt x="2888" y="1822"/>
                  <a:pt x="2875" y="1812"/>
                  <a:pt x="2865" y="1807"/>
                </a:cubicBezTo>
                <a:cubicBezTo>
                  <a:pt x="2855" y="1802"/>
                  <a:pt x="2844" y="1801"/>
                  <a:pt x="2833" y="1804"/>
                </a:cubicBezTo>
                <a:cubicBezTo>
                  <a:pt x="2821" y="1807"/>
                  <a:pt x="2811" y="1813"/>
                  <a:pt x="2801" y="1822"/>
                </a:cubicBezTo>
                <a:cubicBezTo>
                  <a:pt x="2784" y="1839"/>
                  <a:pt x="2776" y="1859"/>
                  <a:pt x="2776" y="1882"/>
                </a:cubicBezTo>
                <a:cubicBezTo>
                  <a:pt x="2776" y="1904"/>
                  <a:pt x="2788" y="1928"/>
                  <a:pt x="2813" y="1953"/>
                </a:cubicBezTo>
                <a:lnTo>
                  <a:pt x="2955" y="2095"/>
                </a:lnTo>
                <a:lnTo>
                  <a:pt x="2914" y="2136"/>
                </a:lnTo>
                <a:lnTo>
                  <a:pt x="2755" y="1978"/>
                </a:lnTo>
                <a:cubicBezTo>
                  <a:pt x="2737" y="1960"/>
                  <a:pt x="2720" y="1949"/>
                  <a:pt x="2704" y="1947"/>
                </a:cubicBezTo>
                <a:cubicBezTo>
                  <a:pt x="2688" y="1944"/>
                  <a:pt x="2672" y="1951"/>
                  <a:pt x="2657" y="1966"/>
                </a:cubicBezTo>
                <a:cubicBezTo>
                  <a:pt x="2646" y="1978"/>
                  <a:pt x="2638" y="1991"/>
                  <a:pt x="2634" y="2007"/>
                </a:cubicBezTo>
                <a:cubicBezTo>
                  <a:pt x="2630" y="2023"/>
                  <a:pt x="2632" y="2039"/>
                  <a:pt x="2640" y="2056"/>
                </a:cubicBezTo>
                <a:cubicBezTo>
                  <a:pt x="2647" y="2072"/>
                  <a:pt x="2662" y="2091"/>
                  <a:pt x="2684" y="2113"/>
                </a:cubicBezTo>
                <a:lnTo>
                  <a:pt x="2810" y="2240"/>
                </a:lnTo>
                <a:lnTo>
                  <a:pt x="2769" y="2281"/>
                </a:lnTo>
                <a:close/>
                <a:moveTo>
                  <a:pt x="3070" y="1834"/>
                </a:moveTo>
                <a:lnTo>
                  <a:pt x="3104" y="1787"/>
                </a:lnTo>
                <a:cubicBezTo>
                  <a:pt x="3123" y="1801"/>
                  <a:pt x="3142" y="1807"/>
                  <a:pt x="3161" y="1806"/>
                </a:cubicBezTo>
                <a:cubicBezTo>
                  <a:pt x="3180" y="1804"/>
                  <a:pt x="3199" y="1794"/>
                  <a:pt x="3218" y="1775"/>
                </a:cubicBezTo>
                <a:cubicBezTo>
                  <a:pt x="3237" y="1756"/>
                  <a:pt x="3247" y="1738"/>
                  <a:pt x="3249" y="1721"/>
                </a:cubicBezTo>
                <a:cubicBezTo>
                  <a:pt x="3250" y="1704"/>
                  <a:pt x="3246" y="1690"/>
                  <a:pt x="3235" y="1680"/>
                </a:cubicBezTo>
                <a:cubicBezTo>
                  <a:pt x="3226" y="1671"/>
                  <a:pt x="3215" y="1667"/>
                  <a:pt x="3201" y="1670"/>
                </a:cubicBezTo>
                <a:cubicBezTo>
                  <a:pt x="3192" y="1672"/>
                  <a:pt x="3173" y="1682"/>
                  <a:pt x="3145" y="1698"/>
                </a:cubicBezTo>
                <a:cubicBezTo>
                  <a:pt x="3107" y="1721"/>
                  <a:pt x="3079" y="1735"/>
                  <a:pt x="3062" y="1741"/>
                </a:cubicBezTo>
                <a:cubicBezTo>
                  <a:pt x="3045" y="1748"/>
                  <a:pt x="3028" y="1749"/>
                  <a:pt x="3012" y="1745"/>
                </a:cubicBezTo>
                <a:cubicBezTo>
                  <a:pt x="2997" y="1741"/>
                  <a:pt x="2983" y="1733"/>
                  <a:pt x="2971" y="1721"/>
                </a:cubicBezTo>
                <a:cubicBezTo>
                  <a:pt x="2960" y="1710"/>
                  <a:pt x="2952" y="1698"/>
                  <a:pt x="2948" y="1684"/>
                </a:cubicBezTo>
                <a:cubicBezTo>
                  <a:pt x="2944" y="1669"/>
                  <a:pt x="2943" y="1655"/>
                  <a:pt x="2945" y="1640"/>
                </a:cubicBezTo>
                <a:cubicBezTo>
                  <a:pt x="2947" y="1629"/>
                  <a:pt x="2952" y="1616"/>
                  <a:pt x="2959" y="1602"/>
                </a:cubicBezTo>
                <a:cubicBezTo>
                  <a:pt x="2967" y="1588"/>
                  <a:pt x="2978" y="1574"/>
                  <a:pt x="2990" y="1562"/>
                </a:cubicBezTo>
                <a:cubicBezTo>
                  <a:pt x="3009" y="1542"/>
                  <a:pt x="3029" y="1528"/>
                  <a:pt x="3049" y="1519"/>
                </a:cubicBezTo>
                <a:cubicBezTo>
                  <a:pt x="3069" y="1510"/>
                  <a:pt x="3087" y="1507"/>
                  <a:pt x="3103" y="1510"/>
                </a:cubicBezTo>
                <a:cubicBezTo>
                  <a:pt x="3119" y="1512"/>
                  <a:pt x="3137" y="1520"/>
                  <a:pt x="3155" y="1533"/>
                </a:cubicBezTo>
                <a:lnTo>
                  <a:pt x="3120" y="1579"/>
                </a:lnTo>
                <a:cubicBezTo>
                  <a:pt x="3106" y="1568"/>
                  <a:pt x="3091" y="1564"/>
                  <a:pt x="3075" y="1566"/>
                </a:cubicBezTo>
                <a:cubicBezTo>
                  <a:pt x="3059" y="1568"/>
                  <a:pt x="3043" y="1576"/>
                  <a:pt x="3027" y="1592"/>
                </a:cubicBezTo>
                <a:cubicBezTo>
                  <a:pt x="3008" y="1611"/>
                  <a:pt x="2998" y="1628"/>
                  <a:pt x="2996" y="1642"/>
                </a:cubicBezTo>
                <a:cubicBezTo>
                  <a:pt x="2994" y="1657"/>
                  <a:pt x="2997" y="1668"/>
                  <a:pt x="3006" y="1677"/>
                </a:cubicBezTo>
                <a:cubicBezTo>
                  <a:pt x="3011" y="1682"/>
                  <a:pt x="3018" y="1685"/>
                  <a:pt x="3025" y="1686"/>
                </a:cubicBezTo>
                <a:cubicBezTo>
                  <a:pt x="3033" y="1687"/>
                  <a:pt x="3042" y="1685"/>
                  <a:pt x="3052" y="1681"/>
                </a:cubicBezTo>
                <a:cubicBezTo>
                  <a:pt x="3058" y="1679"/>
                  <a:pt x="3073" y="1670"/>
                  <a:pt x="3099" y="1655"/>
                </a:cubicBezTo>
                <a:cubicBezTo>
                  <a:pt x="3136" y="1634"/>
                  <a:pt x="3163" y="1620"/>
                  <a:pt x="3179" y="1613"/>
                </a:cubicBezTo>
                <a:cubicBezTo>
                  <a:pt x="3196" y="1607"/>
                  <a:pt x="3212" y="1605"/>
                  <a:pt x="3228" y="1608"/>
                </a:cubicBezTo>
                <a:cubicBezTo>
                  <a:pt x="3244" y="1611"/>
                  <a:pt x="3259" y="1619"/>
                  <a:pt x="3273" y="1633"/>
                </a:cubicBezTo>
                <a:cubicBezTo>
                  <a:pt x="3287" y="1647"/>
                  <a:pt x="3296" y="1664"/>
                  <a:pt x="3300" y="1684"/>
                </a:cubicBezTo>
                <a:cubicBezTo>
                  <a:pt x="3304" y="1704"/>
                  <a:pt x="3302" y="1725"/>
                  <a:pt x="3294" y="1747"/>
                </a:cubicBezTo>
                <a:cubicBezTo>
                  <a:pt x="3285" y="1769"/>
                  <a:pt x="3271" y="1789"/>
                  <a:pt x="3252" y="1808"/>
                </a:cubicBezTo>
                <a:cubicBezTo>
                  <a:pt x="3221" y="1840"/>
                  <a:pt x="3190" y="1858"/>
                  <a:pt x="3160" y="1861"/>
                </a:cubicBezTo>
                <a:cubicBezTo>
                  <a:pt x="3130" y="1864"/>
                  <a:pt x="3100" y="1856"/>
                  <a:pt x="3070" y="1834"/>
                </a:cubicBezTo>
                <a:close/>
                <a:moveTo>
                  <a:pt x="3541" y="1509"/>
                </a:moveTo>
                <a:lnTo>
                  <a:pt x="3499" y="1550"/>
                </a:lnTo>
                <a:lnTo>
                  <a:pt x="3237" y="1287"/>
                </a:lnTo>
                <a:cubicBezTo>
                  <a:pt x="3236" y="1307"/>
                  <a:pt x="3232" y="1329"/>
                  <a:pt x="3226" y="1355"/>
                </a:cubicBezTo>
                <a:cubicBezTo>
                  <a:pt x="3219" y="1380"/>
                  <a:pt x="3212" y="1402"/>
                  <a:pt x="3204" y="1420"/>
                </a:cubicBezTo>
                <a:lnTo>
                  <a:pt x="3164" y="1380"/>
                </a:lnTo>
                <a:cubicBezTo>
                  <a:pt x="3176" y="1346"/>
                  <a:pt x="3183" y="1312"/>
                  <a:pt x="3185" y="1280"/>
                </a:cubicBezTo>
                <a:cubicBezTo>
                  <a:pt x="3187" y="1247"/>
                  <a:pt x="3184" y="1220"/>
                  <a:pt x="3177" y="1198"/>
                </a:cubicBezTo>
                <a:lnTo>
                  <a:pt x="3203" y="1171"/>
                </a:lnTo>
                <a:lnTo>
                  <a:pt x="3541" y="1509"/>
                </a:lnTo>
                <a:close/>
                <a:moveTo>
                  <a:pt x="3499" y="974"/>
                </a:moveTo>
                <a:lnTo>
                  <a:pt x="3451" y="926"/>
                </a:lnTo>
                <a:lnTo>
                  <a:pt x="3492" y="885"/>
                </a:lnTo>
                <a:lnTo>
                  <a:pt x="3540" y="932"/>
                </a:lnTo>
                <a:lnTo>
                  <a:pt x="3499" y="974"/>
                </a:lnTo>
                <a:close/>
                <a:moveTo>
                  <a:pt x="3787" y="1262"/>
                </a:moveTo>
                <a:lnTo>
                  <a:pt x="3544" y="1019"/>
                </a:lnTo>
                <a:lnTo>
                  <a:pt x="3585" y="978"/>
                </a:lnTo>
                <a:lnTo>
                  <a:pt x="3829" y="1221"/>
                </a:lnTo>
                <a:lnTo>
                  <a:pt x="3787" y="1262"/>
                </a:lnTo>
                <a:close/>
                <a:moveTo>
                  <a:pt x="3900" y="1150"/>
                </a:moveTo>
                <a:lnTo>
                  <a:pt x="3564" y="814"/>
                </a:lnTo>
                <a:lnTo>
                  <a:pt x="3691" y="687"/>
                </a:lnTo>
                <a:cubicBezTo>
                  <a:pt x="3713" y="665"/>
                  <a:pt x="3731" y="649"/>
                  <a:pt x="3745" y="639"/>
                </a:cubicBezTo>
                <a:cubicBezTo>
                  <a:pt x="3764" y="625"/>
                  <a:pt x="3783" y="617"/>
                  <a:pt x="3802" y="613"/>
                </a:cubicBezTo>
                <a:cubicBezTo>
                  <a:pt x="3821" y="610"/>
                  <a:pt x="3841" y="612"/>
                  <a:pt x="3861" y="619"/>
                </a:cubicBezTo>
                <a:cubicBezTo>
                  <a:pt x="3882" y="626"/>
                  <a:pt x="3901" y="638"/>
                  <a:pt x="3917" y="654"/>
                </a:cubicBezTo>
                <a:cubicBezTo>
                  <a:pt x="3946" y="683"/>
                  <a:pt x="3961" y="716"/>
                  <a:pt x="3963" y="754"/>
                </a:cubicBezTo>
                <a:cubicBezTo>
                  <a:pt x="3964" y="792"/>
                  <a:pt x="3941" y="835"/>
                  <a:pt x="3894" y="883"/>
                </a:cubicBezTo>
                <a:lnTo>
                  <a:pt x="3808" y="969"/>
                </a:lnTo>
                <a:lnTo>
                  <a:pt x="3944" y="1105"/>
                </a:lnTo>
                <a:lnTo>
                  <a:pt x="3900" y="1150"/>
                </a:lnTo>
                <a:close/>
                <a:moveTo>
                  <a:pt x="3768" y="929"/>
                </a:moveTo>
                <a:lnTo>
                  <a:pt x="3855" y="842"/>
                </a:lnTo>
                <a:cubicBezTo>
                  <a:pt x="3884" y="813"/>
                  <a:pt x="3899" y="788"/>
                  <a:pt x="3900" y="765"/>
                </a:cubicBezTo>
                <a:cubicBezTo>
                  <a:pt x="3901" y="742"/>
                  <a:pt x="3892" y="721"/>
                  <a:pt x="3873" y="702"/>
                </a:cubicBezTo>
                <a:cubicBezTo>
                  <a:pt x="3859" y="688"/>
                  <a:pt x="3843" y="679"/>
                  <a:pt x="3826" y="676"/>
                </a:cubicBezTo>
                <a:cubicBezTo>
                  <a:pt x="3809" y="673"/>
                  <a:pt x="3793" y="676"/>
                  <a:pt x="3778" y="684"/>
                </a:cubicBezTo>
                <a:cubicBezTo>
                  <a:pt x="3769" y="690"/>
                  <a:pt x="3754" y="703"/>
                  <a:pt x="3734" y="723"/>
                </a:cubicBezTo>
                <a:lnTo>
                  <a:pt x="3648" y="809"/>
                </a:lnTo>
                <a:lnTo>
                  <a:pt x="3768" y="929"/>
                </a:lnTo>
                <a:close/>
                <a:moveTo>
                  <a:pt x="4088" y="746"/>
                </a:moveTo>
                <a:lnTo>
                  <a:pt x="4126" y="700"/>
                </a:lnTo>
                <a:cubicBezTo>
                  <a:pt x="4145" y="715"/>
                  <a:pt x="4163" y="724"/>
                  <a:pt x="4181" y="728"/>
                </a:cubicBezTo>
                <a:cubicBezTo>
                  <a:pt x="4199" y="731"/>
                  <a:pt x="4219" y="729"/>
                  <a:pt x="4241" y="720"/>
                </a:cubicBezTo>
                <a:cubicBezTo>
                  <a:pt x="4263" y="711"/>
                  <a:pt x="4284" y="698"/>
                  <a:pt x="4303" y="678"/>
                </a:cubicBezTo>
                <a:cubicBezTo>
                  <a:pt x="4320" y="661"/>
                  <a:pt x="4332" y="644"/>
                  <a:pt x="4340" y="626"/>
                </a:cubicBezTo>
                <a:cubicBezTo>
                  <a:pt x="4348" y="608"/>
                  <a:pt x="4351" y="591"/>
                  <a:pt x="4349" y="576"/>
                </a:cubicBezTo>
                <a:cubicBezTo>
                  <a:pt x="4346" y="561"/>
                  <a:pt x="4340" y="548"/>
                  <a:pt x="4329" y="538"/>
                </a:cubicBezTo>
                <a:cubicBezTo>
                  <a:pt x="4319" y="527"/>
                  <a:pt x="4306" y="521"/>
                  <a:pt x="4292" y="519"/>
                </a:cubicBezTo>
                <a:cubicBezTo>
                  <a:pt x="4278" y="518"/>
                  <a:pt x="4262" y="521"/>
                  <a:pt x="4242" y="530"/>
                </a:cubicBezTo>
                <a:cubicBezTo>
                  <a:pt x="4230" y="535"/>
                  <a:pt x="4204" y="550"/>
                  <a:pt x="4166" y="573"/>
                </a:cubicBezTo>
                <a:cubicBezTo>
                  <a:pt x="4128" y="597"/>
                  <a:pt x="4099" y="611"/>
                  <a:pt x="4080" y="617"/>
                </a:cubicBezTo>
                <a:cubicBezTo>
                  <a:pt x="4056" y="625"/>
                  <a:pt x="4033" y="626"/>
                  <a:pt x="4013" y="622"/>
                </a:cubicBezTo>
                <a:cubicBezTo>
                  <a:pt x="3993" y="617"/>
                  <a:pt x="3975" y="607"/>
                  <a:pt x="3959" y="592"/>
                </a:cubicBezTo>
                <a:cubicBezTo>
                  <a:pt x="3943" y="575"/>
                  <a:pt x="3931" y="554"/>
                  <a:pt x="3926" y="530"/>
                </a:cubicBezTo>
                <a:cubicBezTo>
                  <a:pt x="3921" y="505"/>
                  <a:pt x="3924" y="480"/>
                  <a:pt x="3935" y="454"/>
                </a:cubicBezTo>
                <a:cubicBezTo>
                  <a:pt x="3946" y="428"/>
                  <a:pt x="3963" y="403"/>
                  <a:pt x="3985" y="381"/>
                </a:cubicBezTo>
                <a:cubicBezTo>
                  <a:pt x="4010" y="356"/>
                  <a:pt x="4036" y="338"/>
                  <a:pt x="4063" y="327"/>
                </a:cubicBezTo>
                <a:cubicBezTo>
                  <a:pt x="4090" y="316"/>
                  <a:pt x="4117" y="313"/>
                  <a:pt x="4142" y="319"/>
                </a:cubicBezTo>
                <a:cubicBezTo>
                  <a:pt x="4168" y="324"/>
                  <a:pt x="4191" y="336"/>
                  <a:pt x="4212" y="355"/>
                </a:cubicBezTo>
                <a:lnTo>
                  <a:pt x="4172" y="401"/>
                </a:lnTo>
                <a:cubicBezTo>
                  <a:pt x="4149" y="382"/>
                  <a:pt x="4125" y="374"/>
                  <a:pt x="4101" y="376"/>
                </a:cubicBezTo>
                <a:cubicBezTo>
                  <a:pt x="4077" y="378"/>
                  <a:pt x="4052" y="392"/>
                  <a:pt x="4026" y="418"/>
                </a:cubicBezTo>
                <a:cubicBezTo>
                  <a:pt x="3999" y="445"/>
                  <a:pt x="3985" y="470"/>
                  <a:pt x="3982" y="492"/>
                </a:cubicBezTo>
                <a:cubicBezTo>
                  <a:pt x="3980" y="514"/>
                  <a:pt x="3985" y="532"/>
                  <a:pt x="3999" y="546"/>
                </a:cubicBezTo>
                <a:cubicBezTo>
                  <a:pt x="4011" y="558"/>
                  <a:pt x="4026" y="564"/>
                  <a:pt x="4042" y="563"/>
                </a:cubicBezTo>
                <a:cubicBezTo>
                  <a:pt x="4059" y="562"/>
                  <a:pt x="4089" y="548"/>
                  <a:pt x="4133" y="520"/>
                </a:cubicBezTo>
                <a:cubicBezTo>
                  <a:pt x="4178" y="492"/>
                  <a:pt x="4210" y="474"/>
                  <a:pt x="4229" y="467"/>
                </a:cubicBezTo>
                <a:cubicBezTo>
                  <a:pt x="4258" y="456"/>
                  <a:pt x="4284" y="453"/>
                  <a:pt x="4307" y="458"/>
                </a:cubicBezTo>
                <a:cubicBezTo>
                  <a:pt x="4330" y="462"/>
                  <a:pt x="4350" y="473"/>
                  <a:pt x="4368" y="491"/>
                </a:cubicBezTo>
                <a:cubicBezTo>
                  <a:pt x="4386" y="509"/>
                  <a:pt x="4398" y="531"/>
                  <a:pt x="4404" y="557"/>
                </a:cubicBezTo>
                <a:cubicBezTo>
                  <a:pt x="4409" y="583"/>
                  <a:pt x="4407" y="610"/>
                  <a:pt x="4396" y="638"/>
                </a:cubicBezTo>
                <a:cubicBezTo>
                  <a:pt x="4386" y="666"/>
                  <a:pt x="4369" y="692"/>
                  <a:pt x="4345" y="716"/>
                </a:cubicBezTo>
                <a:cubicBezTo>
                  <a:pt x="4314" y="747"/>
                  <a:pt x="4285" y="768"/>
                  <a:pt x="4255" y="779"/>
                </a:cubicBezTo>
                <a:cubicBezTo>
                  <a:pt x="4226" y="791"/>
                  <a:pt x="4196" y="794"/>
                  <a:pt x="4167" y="788"/>
                </a:cubicBezTo>
                <a:cubicBezTo>
                  <a:pt x="4137" y="782"/>
                  <a:pt x="4111" y="768"/>
                  <a:pt x="4088" y="746"/>
                </a:cubicBezTo>
                <a:close/>
                <a:moveTo>
                  <a:pt x="4423" y="451"/>
                </a:moveTo>
                <a:lnTo>
                  <a:pt x="4463" y="404"/>
                </a:lnTo>
                <a:cubicBezTo>
                  <a:pt x="4487" y="421"/>
                  <a:pt x="4510" y="430"/>
                  <a:pt x="4533" y="429"/>
                </a:cubicBezTo>
                <a:cubicBezTo>
                  <a:pt x="4555" y="428"/>
                  <a:pt x="4574" y="419"/>
                  <a:pt x="4591" y="402"/>
                </a:cubicBezTo>
                <a:cubicBezTo>
                  <a:pt x="4611" y="383"/>
                  <a:pt x="4620" y="358"/>
                  <a:pt x="4619" y="330"/>
                </a:cubicBezTo>
                <a:cubicBezTo>
                  <a:pt x="4618" y="301"/>
                  <a:pt x="4605" y="274"/>
                  <a:pt x="4580" y="249"/>
                </a:cubicBezTo>
                <a:cubicBezTo>
                  <a:pt x="4556" y="226"/>
                  <a:pt x="4531" y="214"/>
                  <a:pt x="4504" y="213"/>
                </a:cubicBezTo>
                <a:cubicBezTo>
                  <a:pt x="4477" y="213"/>
                  <a:pt x="4453" y="224"/>
                  <a:pt x="4432" y="245"/>
                </a:cubicBezTo>
                <a:cubicBezTo>
                  <a:pt x="4419" y="258"/>
                  <a:pt x="4410" y="273"/>
                  <a:pt x="4405" y="290"/>
                </a:cubicBezTo>
                <a:cubicBezTo>
                  <a:pt x="4400" y="307"/>
                  <a:pt x="4400" y="323"/>
                  <a:pt x="4403" y="339"/>
                </a:cubicBezTo>
                <a:lnTo>
                  <a:pt x="4359" y="372"/>
                </a:lnTo>
                <a:lnTo>
                  <a:pt x="4219" y="167"/>
                </a:lnTo>
                <a:lnTo>
                  <a:pt x="4387" y="0"/>
                </a:lnTo>
                <a:lnTo>
                  <a:pt x="4426" y="40"/>
                </a:lnTo>
                <a:lnTo>
                  <a:pt x="4292" y="174"/>
                </a:lnTo>
                <a:lnTo>
                  <a:pt x="4364" y="282"/>
                </a:lnTo>
                <a:cubicBezTo>
                  <a:pt x="4370" y="248"/>
                  <a:pt x="4384" y="220"/>
                  <a:pt x="4406" y="198"/>
                </a:cubicBezTo>
                <a:cubicBezTo>
                  <a:pt x="4436" y="168"/>
                  <a:pt x="4471" y="154"/>
                  <a:pt x="4511" y="154"/>
                </a:cubicBezTo>
                <a:cubicBezTo>
                  <a:pt x="4552" y="154"/>
                  <a:pt x="4588" y="170"/>
                  <a:pt x="4620" y="202"/>
                </a:cubicBezTo>
                <a:cubicBezTo>
                  <a:pt x="4650" y="232"/>
                  <a:pt x="4668" y="267"/>
                  <a:pt x="4672" y="307"/>
                </a:cubicBezTo>
                <a:cubicBezTo>
                  <a:pt x="4678" y="356"/>
                  <a:pt x="4662" y="399"/>
                  <a:pt x="4625" y="436"/>
                </a:cubicBezTo>
                <a:cubicBezTo>
                  <a:pt x="4594" y="467"/>
                  <a:pt x="4561" y="483"/>
                  <a:pt x="4524" y="486"/>
                </a:cubicBezTo>
                <a:cubicBezTo>
                  <a:pt x="4488" y="488"/>
                  <a:pt x="4454" y="476"/>
                  <a:pt x="4423" y="451"/>
                </a:cubicBez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2" name="Freeform 78"/>
          <p:cNvSpPr>
            <a:spLocks noEditPoints="1"/>
          </p:cNvSpPr>
          <p:nvPr/>
        </p:nvSpPr>
        <p:spPr bwMode="auto">
          <a:xfrm>
            <a:off x="5348430" y="5035690"/>
            <a:ext cx="889000" cy="889000"/>
          </a:xfrm>
          <a:custGeom>
            <a:avLst/>
            <a:gdLst>
              <a:gd name="T0" fmla="*/ 238 w 4666"/>
              <a:gd name="T1" fmla="*/ 4131 h 4668"/>
              <a:gd name="T2" fmla="*/ 244 w 4666"/>
              <a:gd name="T3" fmla="*/ 4487 h 4668"/>
              <a:gd name="T4" fmla="*/ 336 w 4666"/>
              <a:gd name="T5" fmla="*/ 4283 h 4668"/>
              <a:gd name="T6" fmla="*/ 84 w 4666"/>
              <a:gd name="T7" fmla="*/ 4327 h 4668"/>
              <a:gd name="T8" fmla="*/ 513 w 4666"/>
              <a:gd name="T9" fmla="*/ 3839 h 4668"/>
              <a:gd name="T10" fmla="*/ 740 w 4666"/>
              <a:gd name="T11" fmla="*/ 3967 h 4668"/>
              <a:gd name="T12" fmla="*/ 779 w 4666"/>
              <a:gd name="T13" fmla="*/ 4225 h 4668"/>
              <a:gd name="T14" fmla="*/ 620 w 4666"/>
              <a:gd name="T15" fmla="*/ 3952 h 4668"/>
              <a:gd name="T16" fmla="*/ 399 w 4666"/>
              <a:gd name="T17" fmla="*/ 4012 h 4668"/>
              <a:gd name="T18" fmla="*/ 784 w 4666"/>
              <a:gd name="T19" fmla="*/ 4118 h 4668"/>
              <a:gd name="T20" fmla="*/ 618 w 4666"/>
              <a:gd name="T21" fmla="*/ 4075 h 4668"/>
              <a:gd name="T22" fmla="*/ 743 w 4666"/>
              <a:gd name="T23" fmla="*/ 3588 h 4668"/>
              <a:gd name="T24" fmla="*/ 1131 w 4666"/>
              <a:gd name="T25" fmla="*/ 3669 h 4668"/>
              <a:gd name="T26" fmla="*/ 964 w 4666"/>
              <a:gd name="T27" fmla="*/ 4040 h 4668"/>
              <a:gd name="T28" fmla="*/ 1081 w 4666"/>
              <a:gd name="T29" fmla="*/ 3711 h 4668"/>
              <a:gd name="T30" fmla="*/ 712 w 4666"/>
              <a:gd name="T31" fmla="*/ 3699 h 4668"/>
              <a:gd name="T32" fmla="*/ 1627 w 4666"/>
              <a:gd name="T33" fmla="*/ 3563 h 4668"/>
              <a:gd name="T34" fmla="*/ 1414 w 4666"/>
              <a:gd name="T35" fmla="*/ 2924 h 4668"/>
              <a:gd name="T36" fmla="*/ 1563 w 4666"/>
              <a:gd name="T37" fmla="*/ 3167 h 4668"/>
              <a:gd name="T38" fmla="*/ 1524 w 4666"/>
              <a:gd name="T39" fmla="*/ 3127 h 4668"/>
              <a:gd name="T40" fmla="*/ 1403 w 4666"/>
              <a:gd name="T41" fmla="*/ 3008 h 4668"/>
              <a:gd name="T42" fmla="*/ 1788 w 4666"/>
              <a:gd name="T43" fmla="*/ 2543 h 4668"/>
              <a:gd name="T44" fmla="*/ 1957 w 4666"/>
              <a:gd name="T45" fmla="*/ 2738 h 4668"/>
              <a:gd name="T46" fmla="*/ 1881 w 4666"/>
              <a:gd name="T47" fmla="*/ 3122 h 4668"/>
              <a:gd name="T48" fmla="*/ 2042 w 4666"/>
              <a:gd name="T49" fmla="*/ 2462 h 4668"/>
              <a:gd name="T50" fmla="*/ 2166 w 4666"/>
              <a:gd name="T51" fmla="*/ 2482 h 4668"/>
              <a:gd name="T52" fmla="*/ 2183 w 4666"/>
              <a:gd name="T53" fmla="*/ 2586 h 4668"/>
              <a:gd name="T54" fmla="*/ 2343 w 4666"/>
              <a:gd name="T55" fmla="*/ 2135 h 4668"/>
              <a:gd name="T56" fmla="*/ 2283 w 4666"/>
              <a:gd name="T57" fmla="*/ 2046 h 4668"/>
              <a:gd name="T58" fmla="*/ 2562 w 4666"/>
              <a:gd name="T59" fmla="*/ 1954 h 4668"/>
              <a:gd name="T60" fmla="*/ 2742 w 4666"/>
              <a:gd name="T61" fmla="*/ 1849 h 4668"/>
              <a:gd name="T62" fmla="*/ 3058 w 4666"/>
              <a:gd name="T63" fmla="*/ 1946 h 4668"/>
              <a:gd name="T64" fmla="*/ 2775 w 4666"/>
              <a:gd name="T65" fmla="*/ 1836 h 4668"/>
              <a:gd name="T66" fmla="*/ 2704 w 4666"/>
              <a:gd name="T67" fmla="*/ 1901 h 4668"/>
              <a:gd name="T68" fmla="*/ 2810 w 4666"/>
              <a:gd name="T69" fmla="*/ 2194 h 4668"/>
              <a:gd name="T70" fmla="*/ 3218 w 4666"/>
              <a:gd name="T71" fmla="*/ 1729 h 4668"/>
              <a:gd name="T72" fmla="*/ 3062 w 4666"/>
              <a:gd name="T73" fmla="*/ 1695 h 4668"/>
              <a:gd name="T74" fmla="*/ 2959 w 4666"/>
              <a:gd name="T75" fmla="*/ 1556 h 4668"/>
              <a:gd name="T76" fmla="*/ 3120 w 4666"/>
              <a:gd name="T77" fmla="*/ 1533 h 4668"/>
              <a:gd name="T78" fmla="*/ 3025 w 4666"/>
              <a:gd name="T79" fmla="*/ 1640 h 4668"/>
              <a:gd name="T80" fmla="*/ 3273 w 4666"/>
              <a:gd name="T81" fmla="*/ 1587 h 4668"/>
              <a:gd name="T82" fmla="*/ 3070 w 4666"/>
              <a:gd name="T83" fmla="*/ 1788 h 4668"/>
              <a:gd name="T84" fmla="*/ 3338 w 4666"/>
              <a:gd name="T85" fmla="*/ 1518 h 4668"/>
              <a:gd name="T86" fmla="*/ 3193 w 4666"/>
              <a:gd name="T87" fmla="*/ 1204 h 4668"/>
              <a:gd name="T88" fmla="*/ 3159 w 4666"/>
              <a:gd name="T89" fmla="*/ 1169 h 4668"/>
              <a:gd name="T90" fmla="*/ 3398 w 4666"/>
              <a:gd name="T91" fmla="*/ 1397 h 4668"/>
              <a:gd name="T92" fmla="*/ 3451 w 4666"/>
              <a:gd name="T93" fmla="*/ 880 h 4668"/>
              <a:gd name="T94" fmla="*/ 3544 w 4666"/>
              <a:gd name="T95" fmla="*/ 973 h 4668"/>
              <a:gd name="T96" fmla="*/ 3564 w 4666"/>
              <a:gd name="T97" fmla="*/ 768 h 4668"/>
              <a:gd name="T98" fmla="*/ 3917 w 4666"/>
              <a:gd name="T99" fmla="*/ 608 h 4668"/>
              <a:gd name="T100" fmla="*/ 3900 w 4666"/>
              <a:gd name="T101" fmla="*/ 1104 h 4668"/>
              <a:gd name="T102" fmla="*/ 3826 w 4666"/>
              <a:gd name="T103" fmla="*/ 630 h 4668"/>
              <a:gd name="T104" fmla="*/ 4088 w 4666"/>
              <a:gd name="T105" fmla="*/ 700 h 4668"/>
              <a:gd name="T106" fmla="*/ 4340 w 4666"/>
              <a:gd name="T107" fmla="*/ 580 h 4668"/>
              <a:gd name="T108" fmla="*/ 4166 w 4666"/>
              <a:gd name="T109" fmla="*/ 527 h 4668"/>
              <a:gd name="T110" fmla="*/ 3935 w 4666"/>
              <a:gd name="T111" fmla="*/ 408 h 4668"/>
              <a:gd name="T112" fmla="*/ 4172 w 4666"/>
              <a:gd name="T113" fmla="*/ 355 h 4668"/>
              <a:gd name="T114" fmla="*/ 4042 w 4666"/>
              <a:gd name="T115" fmla="*/ 517 h 4668"/>
              <a:gd name="T116" fmla="*/ 4404 w 4666"/>
              <a:gd name="T117" fmla="*/ 511 h 4668"/>
              <a:gd name="T118" fmla="*/ 4088 w 4666"/>
              <a:gd name="T119" fmla="*/ 700 h 4668"/>
              <a:gd name="T120" fmla="*/ 4329 w 4666"/>
              <a:gd name="T121" fmla="*/ 248 h 4668"/>
              <a:gd name="T122" fmla="*/ 4666 w 4666"/>
              <a:gd name="T123" fmla="*/ 337 h 466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  <a:cxn ang="0">
                <a:pos x="T122" y="T123"/>
              </a:cxn>
            </a:cxnLst>
            <a:rect l="0" t="0" r="r" b="b"/>
            <a:pathLst>
              <a:path w="4666" h="4668">
                <a:moveTo>
                  <a:pt x="336" y="4668"/>
                </a:moveTo>
                <a:lnTo>
                  <a:pt x="0" y="4332"/>
                </a:lnTo>
                <a:lnTo>
                  <a:pt x="127" y="4205"/>
                </a:lnTo>
                <a:cubicBezTo>
                  <a:pt x="149" y="4182"/>
                  <a:pt x="167" y="4166"/>
                  <a:pt x="181" y="4157"/>
                </a:cubicBezTo>
                <a:cubicBezTo>
                  <a:pt x="200" y="4143"/>
                  <a:pt x="219" y="4135"/>
                  <a:pt x="238" y="4131"/>
                </a:cubicBezTo>
                <a:cubicBezTo>
                  <a:pt x="257" y="4128"/>
                  <a:pt x="277" y="4129"/>
                  <a:pt x="297" y="4137"/>
                </a:cubicBezTo>
                <a:cubicBezTo>
                  <a:pt x="318" y="4144"/>
                  <a:pt x="337" y="4156"/>
                  <a:pt x="354" y="4172"/>
                </a:cubicBezTo>
                <a:cubicBezTo>
                  <a:pt x="382" y="4201"/>
                  <a:pt x="397" y="4234"/>
                  <a:pt x="399" y="4272"/>
                </a:cubicBezTo>
                <a:cubicBezTo>
                  <a:pt x="400" y="4310"/>
                  <a:pt x="377" y="4353"/>
                  <a:pt x="330" y="4400"/>
                </a:cubicBezTo>
                <a:lnTo>
                  <a:pt x="244" y="4487"/>
                </a:lnTo>
                <a:lnTo>
                  <a:pt x="380" y="4623"/>
                </a:lnTo>
                <a:lnTo>
                  <a:pt x="336" y="4668"/>
                </a:lnTo>
                <a:close/>
                <a:moveTo>
                  <a:pt x="204" y="4447"/>
                </a:moveTo>
                <a:lnTo>
                  <a:pt x="291" y="4360"/>
                </a:lnTo>
                <a:cubicBezTo>
                  <a:pt x="320" y="4331"/>
                  <a:pt x="335" y="4305"/>
                  <a:pt x="336" y="4283"/>
                </a:cubicBezTo>
                <a:cubicBezTo>
                  <a:pt x="337" y="4260"/>
                  <a:pt x="328" y="4239"/>
                  <a:pt x="309" y="4219"/>
                </a:cubicBezTo>
                <a:cubicBezTo>
                  <a:pt x="295" y="4205"/>
                  <a:pt x="279" y="4197"/>
                  <a:pt x="262" y="4194"/>
                </a:cubicBezTo>
                <a:cubicBezTo>
                  <a:pt x="245" y="4191"/>
                  <a:pt x="229" y="4194"/>
                  <a:pt x="214" y="4202"/>
                </a:cubicBezTo>
                <a:cubicBezTo>
                  <a:pt x="205" y="4208"/>
                  <a:pt x="190" y="4221"/>
                  <a:pt x="170" y="4241"/>
                </a:cubicBezTo>
                <a:lnTo>
                  <a:pt x="84" y="4327"/>
                </a:lnTo>
                <a:lnTo>
                  <a:pt x="204" y="4447"/>
                </a:lnTo>
                <a:close/>
                <a:moveTo>
                  <a:pt x="651" y="4353"/>
                </a:moveTo>
                <a:lnTo>
                  <a:pt x="315" y="4017"/>
                </a:lnTo>
                <a:lnTo>
                  <a:pt x="441" y="3891"/>
                </a:lnTo>
                <a:cubicBezTo>
                  <a:pt x="466" y="3865"/>
                  <a:pt x="490" y="3848"/>
                  <a:pt x="513" y="3839"/>
                </a:cubicBezTo>
                <a:cubicBezTo>
                  <a:pt x="535" y="3830"/>
                  <a:pt x="558" y="3829"/>
                  <a:pt x="581" y="3834"/>
                </a:cubicBezTo>
                <a:cubicBezTo>
                  <a:pt x="604" y="3839"/>
                  <a:pt x="623" y="3850"/>
                  <a:pt x="638" y="3865"/>
                </a:cubicBezTo>
                <a:cubicBezTo>
                  <a:pt x="653" y="3879"/>
                  <a:pt x="662" y="3897"/>
                  <a:pt x="667" y="3917"/>
                </a:cubicBezTo>
                <a:cubicBezTo>
                  <a:pt x="672" y="3938"/>
                  <a:pt x="670" y="3960"/>
                  <a:pt x="663" y="3983"/>
                </a:cubicBezTo>
                <a:cubicBezTo>
                  <a:pt x="689" y="3969"/>
                  <a:pt x="715" y="3964"/>
                  <a:pt x="740" y="3967"/>
                </a:cubicBezTo>
                <a:cubicBezTo>
                  <a:pt x="765" y="3970"/>
                  <a:pt x="788" y="3982"/>
                  <a:pt x="807" y="4001"/>
                </a:cubicBezTo>
                <a:cubicBezTo>
                  <a:pt x="823" y="4017"/>
                  <a:pt x="834" y="4035"/>
                  <a:pt x="841" y="4055"/>
                </a:cubicBezTo>
                <a:cubicBezTo>
                  <a:pt x="848" y="4076"/>
                  <a:pt x="850" y="4094"/>
                  <a:pt x="848" y="4111"/>
                </a:cubicBezTo>
                <a:cubicBezTo>
                  <a:pt x="845" y="4128"/>
                  <a:pt x="839" y="4146"/>
                  <a:pt x="828" y="4165"/>
                </a:cubicBezTo>
                <a:cubicBezTo>
                  <a:pt x="817" y="4183"/>
                  <a:pt x="800" y="4203"/>
                  <a:pt x="779" y="4225"/>
                </a:cubicBezTo>
                <a:lnTo>
                  <a:pt x="651" y="4353"/>
                </a:lnTo>
                <a:close/>
                <a:moveTo>
                  <a:pt x="500" y="4113"/>
                </a:moveTo>
                <a:lnTo>
                  <a:pt x="573" y="4041"/>
                </a:lnTo>
                <a:cubicBezTo>
                  <a:pt x="593" y="4021"/>
                  <a:pt x="606" y="4006"/>
                  <a:pt x="612" y="3994"/>
                </a:cubicBezTo>
                <a:cubicBezTo>
                  <a:pt x="620" y="3980"/>
                  <a:pt x="623" y="3966"/>
                  <a:pt x="620" y="3952"/>
                </a:cubicBezTo>
                <a:cubicBezTo>
                  <a:pt x="618" y="3939"/>
                  <a:pt x="611" y="3926"/>
                  <a:pt x="600" y="3914"/>
                </a:cubicBezTo>
                <a:cubicBezTo>
                  <a:pt x="589" y="3903"/>
                  <a:pt x="576" y="3896"/>
                  <a:pt x="562" y="3893"/>
                </a:cubicBezTo>
                <a:cubicBezTo>
                  <a:pt x="548" y="3890"/>
                  <a:pt x="535" y="3891"/>
                  <a:pt x="522" y="3898"/>
                </a:cubicBezTo>
                <a:cubicBezTo>
                  <a:pt x="509" y="3905"/>
                  <a:pt x="490" y="3920"/>
                  <a:pt x="466" y="3945"/>
                </a:cubicBezTo>
                <a:lnTo>
                  <a:pt x="399" y="4012"/>
                </a:lnTo>
                <a:lnTo>
                  <a:pt x="500" y="4113"/>
                </a:lnTo>
                <a:close/>
                <a:moveTo>
                  <a:pt x="656" y="4269"/>
                </a:moveTo>
                <a:lnTo>
                  <a:pt x="739" y="4185"/>
                </a:lnTo>
                <a:cubicBezTo>
                  <a:pt x="754" y="4171"/>
                  <a:pt x="763" y="4160"/>
                  <a:pt x="768" y="4153"/>
                </a:cubicBezTo>
                <a:cubicBezTo>
                  <a:pt x="776" y="4141"/>
                  <a:pt x="782" y="4129"/>
                  <a:pt x="784" y="4118"/>
                </a:cubicBezTo>
                <a:cubicBezTo>
                  <a:pt x="787" y="4107"/>
                  <a:pt x="786" y="4095"/>
                  <a:pt x="783" y="4083"/>
                </a:cubicBezTo>
                <a:cubicBezTo>
                  <a:pt x="779" y="4070"/>
                  <a:pt x="772" y="4058"/>
                  <a:pt x="761" y="4048"/>
                </a:cubicBezTo>
                <a:cubicBezTo>
                  <a:pt x="749" y="4035"/>
                  <a:pt x="734" y="4027"/>
                  <a:pt x="719" y="4025"/>
                </a:cubicBezTo>
                <a:cubicBezTo>
                  <a:pt x="703" y="4022"/>
                  <a:pt x="688" y="4024"/>
                  <a:pt x="673" y="4032"/>
                </a:cubicBezTo>
                <a:cubicBezTo>
                  <a:pt x="657" y="4039"/>
                  <a:pt x="639" y="4054"/>
                  <a:pt x="618" y="4075"/>
                </a:cubicBezTo>
                <a:lnTo>
                  <a:pt x="540" y="4153"/>
                </a:lnTo>
                <a:lnTo>
                  <a:pt x="656" y="4269"/>
                </a:lnTo>
                <a:close/>
                <a:moveTo>
                  <a:pt x="964" y="4040"/>
                </a:moveTo>
                <a:lnTo>
                  <a:pt x="628" y="3704"/>
                </a:lnTo>
                <a:lnTo>
                  <a:pt x="743" y="3588"/>
                </a:lnTo>
                <a:cubicBezTo>
                  <a:pt x="770" y="3562"/>
                  <a:pt x="791" y="3543"/>
                  <a:pt x="808" y="3533"/>
                </a:cubicBezTo>
                <a:cubicBezTo>
                  <a:pt x="832" y="3518"/>
                  <a:pt x="856" y="3510"/>
                  <a:pt x="881" y="3508"/>
                </a:cubicBezTo>
                <a:cubicBezTo>
                  <a:pt x="914" y="3505"/>
                  <a:pt x="947" y="3511"/>
                  <a:pt x="979" y="3525"/>
                </a:cubicBezTo>
                <a:cubicBezTo>
                  <a:pt x="1011" y="3540"/>
                  <a:pt x="1042" y="3562"/>
                  <a:pt x="1072" y="3592"/>
                </a:cubicBezTo>
                <a:cubicBezTo>
                  <a:pt x="1097" y="3618"/>
                  <a:pt x="1117" y="3643"/>
                  <a:pt x="1131" y="3669"/>
                </a:cubicBezTo>
                <a:cubicBezTo>
                  <a:pt x="1144" y="3694"/>
                  <a:pt x="1153" y="3718"/>
                  <a:pt x="1157" y="3741"/>
                </a:cubicBezTo>
                <a:cubicBezTo>
                  <a:pt x="1160" y="3763"/>
                  <a:pt x="1160" y="3783"/>
                  <a:pt x="1157" y="3802"/>
                </a:cubicBezTo>
                <a:cubicBezTo>
                  <a:pt x="1153" y="3820"/>
                  <a:pt x="1145" y="3839"/>
                  <a:pt x="1133" y="3859"/>
                </a:cubicBezTo>
                <a:cubicBezTo>
                  <a:pt x="1121" y="3878"/>
                  <a:pt x="1105" y="3898"/>
                  <a:pt x="1085" y="3918"/>
                </a:cubicBezTo>
                <a:lnTo>
                  <a:pt x="964" y="4040"/>
                </a:lnTo>
                <a:close/>
                <a:moveTo>
                  <a:pt x="969" y="3956"/>
                </a:moveTo>
                <a:lnTo>
                  <a:pt x="1040" y="3884"/>
                </a:lnTo>
                <a:cubicBezTo>
                  <a:pt x="1063" y="3862"/>
                  <a:pt x="1078" y="3842"/>
                  <a:pt x="1086" y="3825"/>
                </a:cubicBezTo>
                <a:cubicBezTo>
                  <a:pt x="1095" y="3809"/>
                  <a:pt x="1099" y="3793"/>
                  <a:pt x="1099" y="3778"/>
                </a:cubicBezTo>
                <a:cubicBezTo>
                  <a:pt x="1099" y="3757"/>
                  <a:pt x="1093" y="3734"/>
                  <a:pt x="1081" y="3711"/>
                </a:cubicBezTo>
                <a:cubicBezTo>
                  <a:pt x="1069" y="3687"/>
                  <a:pt x="1051" y="3663"/>
                  <a:pt x="1025" y="3637"/>
                </a:cubicBezTo>
                <a:cubicBezTo>
                  <a:pt x="990" y="3602"/>
                  <a:pt x="957" y="3581"/>
                  <a:pt x="927" y="3573"/>
                </a:cubicBezTo>
                <a:cubicBezTo>
                  <a:pt x="896" y="3566"/>
                  <a:pt x="870" y="3567"/>
                  <a:pt x="847" y="3578"/>
                </a:cubicBezTo>
                <a:cubicBezTo>
                  <a:pt x="830" y="3585"/>
                  <a:pt x="809" y="3602"/>
                  <a:pt x="782" y="3628"/>
                </a:cubicBezTo>
                <a:lnTo>
                  <a:pt x="712" y="3699"/>
                </a:lnTo>
                <a:lnTo>
                  <a:pt x="969" y="3956"/>
                </a:lnTo>
                <a:close/>
                <a:moveTo>
                  <a:pt x="1353" y="3837"/>
                </a:moveTo>
                <a:lnTo>
                  <a:pt x="1323" y="3807"/>
                </a:lnTo>
                <a:lnTo>
                  <a:pt x="1597" y="3534"/>
                </a:lnTo>
                <a:lnTo>
                  <a:pt x="1627" y="3563"/>
                </a:lnTo>
                <a:lnTo>
                  <a:pt x="1353" y="3837"/>
                </a:lnTo>
                <a:close/>
                <a:moveTo>
                  <a:pt x="1569" y="3434"/>
                </a:moveTo>
                <a:lnTo>
                  <a:pt x="1233" y="3098"/>
                </a:lnTo>
                <a:lnTo>
                  <a:pt x="1360" y="2972"/>
                </a:lnTo>
                <a:cubicBezTo>
                  <a:pt x="1382" y="2949"/>
                  <a:pt x="1400" y="2933"/>
                  <a:pt x="1414" y="2924"/>
                </a:cubicBezTo>
                <a:cubicBezTo>
                  <a:pt x="1433" y="2910"/>
                  <a:pt x="1452" y="2901"/>
                  <a:pt x="1471" y="2898"/>
                </a:cubicBezTo>
                <a:cubicBezTo>
                  <a:pt x="1490" y="2894"/>
                  <a:pt x="1510" y="2896"/>
                  <a:pt x="1531" y="2903"/>
                </a:cubicBezTo>
                <a:cubicBezTo>
                  <a:pt x="1551" y="2910"/>
                  <a:pt x="1570" y="2922"/>
                  <a:pt x="1587" y="2939"/>
                </a:cubicBezTo>
                <a:cubicBezTo>
                  <a:pt x="1615" y="2968"/>
                  <a:pt x="1630" y="3001"/>
                  <a:pt x="1632" y="3039"/>
                </a:cubicBezTo>
                <a:cubicBezTo>
                  <a:pt x="1634" y="3077"/>
                  <a:pt x="1611" y="3120"/>
                  <a:pt x="1563" y="3167"/>
                </a:cubicBezTo>
                <a:lnTo>
                  <a:pt x="1477" y="3253"/>
                </a:lnTo>
                <a:lnTo>
                  <a:pt x="1614" y="3390"/>
                </a:lnTo>
                <a:lnTo>
                  <a:pt x="1569" y="3434"/>
                </a:lnTo>
                <a:close/>
                <a:moveTo>
                  <a:pt x="1437" y="3214"/>
                </a:moveTo>
                <a:lnTo>
                  <a:pt x="1524" y="3127"/>
                </a:lnTo>
                <a:cubicBezTo>
                  <a:pt x="1553" y="3098"/>
                  <a:pt x="1568" y="3072"/>
                  <a:pt x="1569" y="3050"/>
                </a:cubicBezTo>
                <a:cubicBezTo>
                  <a:pt x="1571" y="3027"/>
                  <a:pt x="1562" y="3006"/>
                  <a:pt x="1542" y="2986"/>
                </a:cubicBezTo>
                <a:cubicBezTo>
                  <a:pt x="1528" y="2972"/>
                  <a:pt x="1513" y="2964"/>
                  <a:pt x="1495" y="2961"/>
                </a:cubicBezTo>
                <a:cubicBezTo>
                  <a:pt x="1478" y="2958"/>
                  <a:pt x="1462" y="2961"/>
                  <a:pt x="1448" y="2969"/>
                </a:cubicBezTo>
                <a:cubicBezTo>
                  <a:pt x="1438" y="2975"/>
                  <a:pt x="1423" y="2987"/>
                  <a:pt x="1403" y="3008"/>
                </a:cubicBezTo>
                <a:lnTo>
                  <a:pt x="1317" y="3094"/>
                </a:lnTo>
                <a:lnTo>
                  <a:pt x="1437" y="3214"/>
                </a:lnTo>
                <a:close/>
                <a:moveTo>
                  <a:pt x="1881" y="3122"/>
                </a:moveTo>
                <a:lnTo>
                  <a:pt x="1545" y="2786"/>
                </a:lnTo>
                <a:lnTo>
                  <a:pt x="1788" y="2543"/>
                </a:lnTo>
                <a:lnTo>
                  <a:pt x="1828" y="2583"/>
                </a:lnTo>
                <a:lnTo>
                  <a:pt x="1629" y="2781"/>
                </a:lnTo>
                <a:lnTo>
                  <a:pt x="1732" y="2884"/>
                </a:lnTo>
                <a:lnTo>
                  <a:pt x="1918" y="2699"/>
                </a:lnTo>
                <a:lnTo>
                  <a:pt x="1957" y="2738"/>
                </a:lnTo>
                <a:lnTo>
                  <a:pt x="1772" y="2924"/>
                </a:lnTo>
                <a:lnTo>
                  <a:pt x="1886" y="3038"/>
                </a:lnTo>
                <a:lnTo>
                  <a:pt x="2092" y="2832"/>
                </a:lnTo>
                <a:lnTo>
                  <a:pt x="2132" y="2872"/>
                </a:lnTo>
                <a:lnTo>
                  <a:pt x="1881" y="3122"/>
                </a:lnTo>
                <a:close/>
                <a:moveTo>
                  <a:pt x="2163" y="2841"/>
                </a:moveTo>
                <a:lnTo>
                  <a:pt x="2118" y="2536"/>
                </a:lnTo>
                <a:lnTo>
                  <a:pt x="1842" y="2489"/>
                </a:lnTo>
                <a:lnTo>
                  <a:pt x="1895" y="2436"/>
                </a:lnTo>
                <a:lnTo>
                  <a:pt x="2042" y="2462"/>
                </a:lnTo>
                <a:cubicBezTo>
                  <a:pt x="2073" y="2467"/>
                  <a:pt x="2096" y="2471"/>
                  <a:pt x="2111" y="2476"/>
                </a:cubicBezTo>
                <a:cubicBezTo>
                  <a:pt x="2106" y="2456"/>
                  <a:pt x="2102" y="2434"/>
                  <a:pt x="2099" y="2411"/>
                </a:cubicBezTo>
                <a:lnTo>
                  <a:pt x="2077" y="2254"/>
                </a:lnTo>
                <a:lnTo>
                  <a:pt x="2126" y="2206"/>
                </a:lnTo>
                <a:lnTo>
                  <a:pt x="2166" y="2482"/>
                </a:lnTo>
                <a:lnTo>
                  <a:pt x="2471" y="2533"/>
                </a:lnTo>
                <a:lnTo>
                  <a:pt x="2416" y="2588"/>
                </a:lnTo>
                <a:lnTo>
                  <a:pt x="2211" y="2552"/>
                </a:lnTo>
                <a:cubicBezTo>
                  <a:pt x="2200" y="2550"/>
                  <a:pt x="2187" y="2548"/>
                  <a:pt x="2174" y="2544"/>
                </a:cubicBezTo>
                <a:cubicBezTo>
                  <a:pt x="2179" y="2564"/>
                  <a:pt x="2182" y="2578"/>
                  <a:pt x="2183" y="2586"/>
                </a:cubicBezTo>
                <a:lnTo>
                  <a:pt x="2216" y="2787"/>
                </a:lnTo>
                <a:lnTo>
                  <a:pt x="2163" y="2841"/>
                </a:lnTo>
                <a:close/>
                <a:moveTo>
                  <a:pt x="2647" y="2357"/>
                </a:moveTo>
                <a:lnTo>
                  <a:pt x="2606" y="2398"/>
                </a:lnTo>
                <a:lnTo>
                  <a:pt x="2343" y="2135"/>
                </a:lnTo>
                <a:cubicBezTo>
                  <a:pt x="2342" y="2154"/>
                  <a:pt x="2339" y="2177"/>
                  <a:pt x="2332" y="2203"/>
                </a:cubicBezTo>
                <a:cubicBezTo>
                  <a:pt x="2325" y="2228"/>
                  <a:pt x="2318" y="2250"/>
                  <a:pt x="2310" y="2267"/>
                </a:cubicBezTo>
                <a:lnTo>
                  <a:pt x="2270" y="2227"/>
                </a:lnTo>
                <a:cubicBezTo>
                  <a:pt x="2282" y="2193"/>
                  <a:pt x="2289" y="2160"/>
                  <a:pt x="2291" y="2127"/>
                </a:cubicBezTo>
                <a:cubicBezTo>
                  <a:pt x="2293" y="2095"/>
                  <a:pt x="2290" y="2068"/>
                  <a:pt x="2283" y="2046"/>
                </a:cubicBezTo>
                <a:lnTo>
                  <a:pt x="2309" y="2019"/>
                </a:lnTo>
                <a:lnTo>
                  <a:pt x="2647" y="2357"/>
                </a:lnTo>
                <a:close/>
                <a:moveTo>
                  <a:pt x="2769" y="2235"/>
                </a:moveTo>
                <a:lnTo>
                  <a:pt x="2525" y="1991"/>
                </a:lnTo>
                <a:lnTo>
                  <a:pt x="2562" y="1954"/>
                </a:lnTo>
                <a:lnTo>
                  <a:pt x="2596" y="1989"/>
                </a:lnTo>
                <a:cubicBezTo>
                  <a:pt x="2592" y="1969"/>
                  <a:pt x="2593" y="1949"/>
                  <a:pt x="2598" y="1929"/>
                </a:cubicBezTo>
                <a:cubicBezTo>
                  <a:pt x="2603" y="1909"/>
                  <a:pt x="2614" y="1891"/>
                  <a:pt x="2630" y="1875"/>
                </a:cubicBezTo>
                <a:cubicBezTo>
                  <a:pt x="2648" y="1857"/>
                  <a:pt x="2667" y="1846"/>
                  <a:pt x="2686" y="1842"/>
                </a:cubicBezTo>
                <a:cubicBezTo>
                  <a:pt x="2705" y="1838"/>
                  <a:pt x="2724" y="1840"/>
                  <a:pt x="2742" y="1849"/>
                </a:cubicBezTo>
                <a:cubicBezTo>
                  <a:pt x="2733" y="1801"/>
                  <a:pt x="2744" y="1762"/>
                  <a:pt x="2774" y="1731"/>
                </a:cubicBezTo>
                <a:cubicBezTo>
                  <a:pt x="2799" y="1707"/>
                  <a:pt x="2824" y="1695"/>
                  <a:pt x="2850" y="1695"/>
                </a:cubicBezTo>
                <a:cubicBezTo>
                  <a:pt x="2877" y="1696"/>
                  <a:pt x="2904" y="1710"/>
                  <a:pt x="2931" y="1738"/>
                </a:cubicBezTo>
                <a:lnTo>
                  <a:pt x="3099" y="1905"/>
                </a:lnTo>
                <a:lnTo>
                  <a:pt x="3058" y="1946"/>
                </a:lnTo>
                <a:lnTo>
                  <a:pt x="2904" y="1793"/>
                </a:lnTo>
                <a:cubicBezTo>
                  <a:pt x="2888" y="1776"/>
                  <a:pt x="2874" y="1766"/>
                  <a:pt x="2865" y="1761"/>
                </a:cubicBezTo>
                <a:cubicBezTo>
                  <a:pt x="2855" y="1756"/>
                  <a:pt x="2844" y="1755"/>
                  <a:pt x="2832" y="1758"/>
                </a:cubicBezTo>
                <a:cubicBezTo>
                  <a:pt x="2821" y="1761"/>
                  <a:pt x="2810" y="1767"/>
                  <a:pt x="2801" y="1776"/>
                </a:cubicBezTo>
                <a:cubicBezTo>
                  <a:pt x="2784" y="1793"/>
                  <a:pt x="2775" y="1813"/>
                  <a:pt x="2775" y="1836"/>
                </a:cubicBezTo>
                <a:cubicBezTo>
                  <a:pt x="2776" y="1858"/>
                  <a:pt x="2788" y="1882"/>
                  <a:pt x="2813" y="1907"/>
                </a:cubicBezTo>
                <a:lnTo>
                  <a:pt x="2955" y="2049"/>
                </a:lnTo>
                <a:lnTo>
                  <a:pt x="2913" y="2090"/>
                </a:lnTo>
                <a:lnTo>
                  <a:pt x="2755" y="1932"/>
                </a:lnTo>
                <a:cubicBezTo>
                  <a:pt x="2737" y="1914"/>
                  <a:pt x="2720" y="1903"/>
                  <a:pt x="2704" y="1901"/>
                </a:cubicBezTo>
                <a:cubicBezTo>
                  <a:pt x="2688" y="1898"/>
                  <a:pt x="2672" y="1905"/>
                  <a:pt x="2657" y="1920"/>
                </a:cubicBezTo>
                <a:cubicBezTo>
                  <a:pt x="2645" y="1932"/>
                  <a:pt x="2638" y="1945"/>
                  <a:pt x="2634" y="1961"/>
                </a:cubicBezTo>
                <a:cubicBezTo>
                  <a:pt x="2630" y="1977"/>
                  <a:pt x="2632" y="1993"/>
                  <a:pt x="2639" y="2010"/>
                </a:cubicBezTo>
                <a:cubicBezTo>
                  <a:pt x="2647" y="2026"/>
                  <a:pt x="2661" y="2045"/>
                  <a:pt x="2684" y="2067"/>
                </a:cubicBezTo>
                <a:lnTo>
                  <a:pt x="2810" y="2194"/>
                </a:lnTo>
                <a:lnTo>
                  <a:pt x="2769" y="2235"/>
                </a:lnTo>
                <a:close/>
                <a:moveTo>
                  <a:pt x="3070" y="1788"/>
                </a:moveTo>
                <a:lnTo>
                  <a:pt x="3104" y="1741"/>
                </a:lnTo>
                <a:cubicBezTo>
                  <a:pt x="3123" y="1755"/>
                  <a:pt x="3142" y="1761"/>
                  <a:pt x="3161" y="1760"/>
                </a:cubicBezTo>
                <a:cubicBezTo>
                  <a:pt x="3180" y="1758"/>
                  <a:pt x="3199" y="1748"/>
                  <a:pt x="3218" y="1729"/>
                </a:cubicBezTo>
                <a:cubicBezTo>
                  <a:pt x="3237" y="1710"/>
                  <a:pt x="3247" y="1692"/>
                  <a:pt x="3249" y="1675"/>
                </a:cubicBezTo>
                <a:cubicBezTo>
                  <a:pt x="3250" y="1658"/>
                  <a:pt x="3246" y="1644"/>
                  <a:pt x="3235" y="1634"/>
                </a:cubicBezTo>
                <a:cubicBezTo>
                  <a:pt x="3226" y="1625"/>
                  <a:pt x="3214" y="1621"/>
                  <a:pt x="3201" y="1624"/>
                </a:cubicBezTo>
                <a:cubicBezTo>
                  <a:pt x="3192" y="1626"/>
                  <a:pt x="3173" y="1636"/>
                  <a:pt x="3145" y="1652"/>
                </a:cubicBezTo>
                <a:cubicBezTo>
                  <a:pt x="3107" y="1675"/>
                  <a:pt x="3079" y="1689"/>
                  <a:pt x="3062" y="1695"/>
                </a:cubicBezTo>
                <a:cubicBezTo>
                  <a:pt x="3045" y="1702"/>
                  <a:pt x="3028" y="1703"/>
                  <a:pt x="3012" y="1699"/>
                </a:cubicBezTo>
                <a:cubicBezTo>
                  <a:pt x="2996" y="1695"/>
                  <a:pt x="2982" y="1687"/>
                  <a:pt x="2971" y="1675"/>
                </a:cubicBezTo>
                <a:cubicBezTo>
                  <a:pt x="2960" y="1664"/>
                  <a:pt x="2952" y="1652"/>
                  <a:pt x="2948" y="1638"/>
                </a:cubicBezTo>
                <a:cubicBezTo>
                  <a:pt x="2944" y="1623"/>
                  <a:pt x="2943" y="1609"/>
                  <a:pt x="2945" y="1594"/>
                </a:cubicBezTo>
                <a:cubicBezTo>
                  <a:pt x="2947" y="1583"/>
                  <a:pt x="2952" y="1570"/>
                  <a:pt x="2959" y="1556"/>
                </a:cubicBezTo>
                <a:cubicBezTo>
                  <a:pt x="2967" y="1542"/>
                  <a:pt x="2977" y="1528"/>
                  <a:pt x="2990" y="1516"/>
                </a:cubicBezTo>
                <a:cubicBezTo>
                  <a:pt x="3009" y="1496"/>
                  <a:pt x="3029" y="1482"/>
                  <a:pt x="3049" y="1473"/>
                </a:cubicBezTo>
                <a:cubicBezTo>
                  <a:pt x="3069" y="1464"/>
                  <a:pt x="3087" y="1461"/>
                  <a:pt x="3103" y="1464"/>
                </a:cubicBezTo>
                <a:cubicBezTo>
                  <a:pt x="3119" y="1466"/>
                  <a:pt x="3137" y="1474"/>
                  <a:pt x="3155" y="1487"/>
                </a:cubicBezTo>
                <a:lnTo>
                  <a:pt x="3120" y="1533"/>
                </a:lnTo>
                <a:cubicBezTo>
                  <a:pt x="3106" y="1522"/>
                  <a:pt x="3091" y="1518"/>
                  <a:pt x="3075" y="1520"/>
                </a:cubicBezTo>
                <a:cubicBezTo>
                  <a:pt x="3059" y="1522"/>
                  <a:pt x="3043" y="1530"/>
                  <a:pt x="3027" y="1546"/>
                </a:cubicBezTo>
                <a:cubicBezTo>
                  <a:pt x="3008" y="1565"/>
                  <a:pt x="2998" y="1582"/>
                  <a:pt x="2996" y="1596"/>
                </a:cubicBezTo>
                <a:cubicBezTo>
                  <a:pt x="2994" y="1611"/>
                  <a:pt x="2997" y="1622"/>
                  <a:pt x="3006" y="1631"/>
                </a:cubicBezTo>
                <a:cubicBezTo>
                  <a:pt x="3011" y="1636"/>
                  <a:pt x="3017" y="1639"/>
                  <a:pt x="3025" y="1640"/>
                </a:cubicBezTo>
                <a:cubicBezTo>
                  <a:pt x="3033" y="1641"/>
                  <a:pt x="3042" y="1639"/>
                  <a:pt x="3052" y="1635"/>
                </a:cubicBezTo>
                <a:cubicBezTo>
                  <a:pt x="3058" y="1633"/>
                  <a:pt x="3073" y="1624"/>
                  <a:pt x="3099" y="1609"/>
                </a:cubicBezTo>
                <a:cubicBezTo>
                  <a:pt x="3136" y="1588"/>
                  <a:pt x="3163" y="1574"/>
                  <a:pt x="3179" y="1567"/>
                </a:cubicBezTo>
                <a:cubicBezTo>
                  <a:pt x="3196" y="1561"/>
                  <a:pt x="3212" y="1559"/>
                  <a:pt x="3228" y="1562"/>
                </a:cubicBezTo>
                <a:cubicBezTo>
                  <a:pt x="3244" y="1565"/>
                  <a:pt x="3259" y="1573"/>
                  <a:pt x="3273" y="1587"/>
                </a:cubicBezTo>
                <a:cubicBezTo>
                  <a:pt x="3287" y="1601"/>
                  <a:pt x="3296" y="1618"/>
                  <a:pt x="3300" y="1638"/>
                </a:cubicBezTo>
                <a:cubicBezTo>
                  <a:pt x="3304" y="1658"/>
                  <a:pt x="3302" y="1679"/>
                  <a:pt x="3293" y="1701"/>
                </a:cubicBezTo>
                <a:cubicBezTo>
                  <a:pt x="3285" y="1723"/>
                  <a:pt x="3271" y="1743"/>
                  <a:pt x="3252" y="1762"/>
                </a:cubicBezTo>
                <a:cubicBezTo>
                  <a:pt x="3220" y="1794"/>
                  <a:pt x="3190" y="1812"/>
                  <a:pt x="3160" y="1815"/>
                </a:cubicBezTo>
                <a:cubicBezTo>
                  <a:pt x="3130" y="1818"/>
                  <a:pt x="3100" y="1810"/>
                  <a:pt x="3070" y="1788"/>
                </a:cubicBezTo>
                <a:close/>
                <a:moveTo>
                  <a:pt x="3562" y="1362"/>
                </a:moveTo>
                <a:lnTo>
                  <a:pt x="3602" y="1401"/>
                </a:lnTo>
                <a:lnTo>
                  <a:pt x="3380" y="1624"/>
                </a:lnTo>
                <a:cubicBezTo>
                  <a:pt x="3370" y="1614"/>
                  <a:pt x="3362" y="1603"/>
                  <a:pt x="3356" y="1590"/>
                </a:cubicBezTo>
                <a:cubicBezTo>
                  <a:pt x="3347" y="1569"/>
                  <a:pt x="3341" y="1545"/>
                  <a:pt x="3338" y="1518"/>
                </a:cubicBezTo>
                <a:cubicBezTo>
                  <a:pt x="3336" y="1491"/>
                  <a:pt x="3337" y="1456"/>
                  <a:pt x="3342" y="1413"/>
                </a:cubicBezTo>
                <a:cubicBezTo>
                  <a:pt x="3348" y="1347"/>
                  <a:pt x="3349" y="1299"/>
                  <a:pt x="3344" y="1268"/>
                </a:cubicBezTo>
                <a:cubicBezTo>
                  <a:pt x="3340" y="1238"/>
                  <a:pt x="3330" y="1215"/>
                  <a:pt x="3314" y="1199"/>
                </a:cubicBezTo>
                <a:cubicBezTo>
                  <a:pt x="3298" y="1183"/>
                  <a:pt x="3278" y="1175"/>
                  <a:pt x="3255" y="1175"/>
                </a:cubicBezTo>
                <a:cubicBezTo>
                  <a:pt x="3232" y="1176"/>
                  <a:pt x="3211" y="1186"/>
                  <a:pt x="3193" y="1204"/>
                </a:cubicBezTo>
                <a:cubicBezTo>
                  <a:pt x="3173" y="1224"/>
                  <a:pt x="3163" y="1246"/>
                  <a:pt x="3163" y="1270"/>
                </a:cubicBezTo>
                <a:cubicBezTo>
                  <a:pt x="3163" y="1294"/>
                  <a:pt x="3173" y="1316"/>
                  <a:pt x="3194" y="1338"/>
                </a:cubicBezTo>
                <a:lnTo>
                  <a:pt x="3147" y="1376"/>
                </a:lnTo>
                <a:cubicBezTo>
                  <a:pt x="3119" y="1341"/>
                  <a:pt x="3105" y="1306"/>
                  <a:pt x="3108" y="1270"/>
                </a:cubicBezTo>
                <a:cubicBezTo>
                  <a:pt x="3110" y="1235"/>
                  <a:pt x="3127" y="1201"/>
                  <a:pt x="3159" y="1169"/>
                </a:cubicBezTo>
                <a:cubicBezTo>
                  <a:pt x="3192" y="1137"/>
                  <a:pt x="3226" y="1120"/>
                  <a:pt x="3263" y="1119"/>
                </a:cubicBezTo>
                <a:cubicBezTo>
                  <a:pt x="3299" y="1119"/>
                  <a:pt x="3331" y="1131"/>
                  <a:pt x="3357" y="1158"/>
                </a:cubicBezTo>
                <a:cubicBezTo>
                  <a:pt x="3371" y="1171"/>
                  <a:pt x="3381" y="1187"/>
                  <a:pt x="3389" y="1206"/>
                </a:cubicBezTo>
                <a:cubicBezTo>
                  <a:pt x="3396" y="1224"/>
                  <a:pt x="3401" y="1247"/>
                  <a:pt x="3402" y="1274"/>
                </a:cubicBezTo>
                <a:cubicBezTo>
                  <a:pt x="3404" y="1301"/>
                  <a:pt x="3403" y="1342"/>
                  <a:pt x="3398" y="1397"/>
                </a:cubicBezTo>
                <a:cubicBezTo>
                  <a:pt x="3394" y="1442"/>
                  <a:pt x="3392" y="1472"/>
                  <a:pt x="3393" y="1487"/>
                </a:cubicBezTo>
                <a:cubicBezTo>
                  <a:pt x="3393" y="1501"/>
                  <a:pt x="3395" y="1515"/>
                  <a:pt x="3398" y="1527"/>
                </a:cubicBezTo>
                <a:lnTo>
                  <a:pt x="3562" y="1362"/>
                </a:lnTo>
                <a:close/>
                <a:moveTo>
                  <a:pt x="3499" y="928"/>
                </a:moveTo>
                <a:lnTo>
                  <a:pt x="3451" y="880"/>
                </a:lnTo>
                <a:lnTo>
                  <a:pt x="3492" y="839"/>
                </a:lnTo>
                <a:lnTo>
                  <a:pt x="3540" y="886"/>
                </a:lnTo>
                <a:lnTo>
                  <a:pt x="3499" y="928"/>
                </a:lnTo>
                <a:close/>
                <a:moveTo>
                  <a:pt x="3787" y="1216"/>
                </a:moveTo>
                <a:lnTo>
                  <a:pt x="3544" y="973"/>
                </a:lnTo>
                <a:lnTo>
                  <a:pt x="3585" y="932"/>
                </a:lnTo>
                <a:lnTo>
                  <a:pt x="3828" y="1175"/>
                </a:lnTo>
                <a:lnTo>
                  <a:pt x="3787" y="1216"/>
                </a:lnTo>
                <a:close/>
                <a:moveTo>
                  <a:pt x="3900" y="1104"/>
                </a:moveTo>
                <a:lnTo>
                  <a:pt x="3564" y="768"/>
                </a:lnTo>
                <a:lnTo>
                  <a:pt x="3690" y="641"/>
                </a:lnTo>
                <a:cubicBezTo>
                  <a:pt x="3713" y="619"/>
                  <a:pt x="3731" y="603"/>
                  <a:pt x="3745" y="593"/>
                </a:cubicBezTo>
                <a:cubicBezTo>
                  <a:pt x="3764" y="579"/>
                  <a:pt x="3783" y="571"/>
                  <a:pt x="3802" y="567"/>
                </a:cubicBezTo>
                <a:cubicBezTo>
                  <a:pt x="3821" y="564"/>
                  <a:pt x="3841" y="566"/>
                  <a:pt x="3861" y="573"/>
                </a:cubicBezTo>
                <a:cubicBezTo>
                  <a:pt x="3882" y="580"/>
                  <a:pt x="3901" y="592"/>
                  <a:pt x="3917" y="608"/>
                </a:cubicBezTo>
                <a:cubicBezTo>
                  <a:pt x="3946" y="637"/>
                  <a:pt x="3961" y="670"/>
                  <a:pt x="3963" y="708"/>
                </a:cubicBezTo>
                <a:cubicBezTo>
                  <a:pt x="3964" y="746"/>
                  <a:pt x="3941" y="789"/>
                  <a:pt x="3894" y="837"/>
                </a:cubicBezTo>
                <a:lnTo>
                  <a:pt x="3808" y="923"/>
                </a:lnTo>
                <a:lnTo>
                  <a:pt x="3944" y="1059"/>
                </a:lnTo>
                <a:lnTo>
                  <a:pt x="3900" y="1104"/>
                </a:lnTo>
                <a:close/>
                <a:moveTo>
                  <a:pt x="3768" y="883"/>
                </a:moveTo>
                <a:lnTo>
                  <a:pt x="3855" y="796"/>
                </a:lnTo>
                <a:cubicBezTo>
                  <a:pt x="3883" y="767"/>
                  <a:pt x="3899" y="742"/>
                  <a:pt x="3900" y="719"/>
                </a:cubicBezTo>
                <a:cubicBezTo>
                  <a:pt x="3901" y="696"/>
                  <a:pt x="3892" y="675"/>
                  <a:pt x="3873" y="656"/>
                </a:cubicBezTo>
                <a:cubicBezTo>
                  <a:pt x="3859" y="642"/>
                  <a:pt x="3843" y="633"/>
                  <a:pt x="3826" y="630"/>
                </a:cubicBezTo>
                <a:cubicBezTo>
                  <a:pt x="3809" y="627"/>
                  <a:pt x="3793" y="630"/>
                  <a:pt x="3778" y="638"/>
                </a:cubicBezTo>
                <a:cubicBezTo>
                  <a:pt x="3769" y="644"/>
                  <a:pt x="3754" y="657"/>
                  <a:pt x="3734" y="677"/>
                </a:cubicBezTo>
                <a:lnTo>
                  <a:pt x="3648" y="763"/>
                </a:lnTo>
                <a:lnTo>
                  <a:pt x="3768" y="883"/>
                </a:lnTo>
                <a:close/>
                <a:moveTo>
                  <a:pt x="4088" y="700"/>
                </a:moveTo>
                <a:lnTo>
                  <a:pt x="4126" y="654"/>
                </a:lnTo>
                <a:cubicBezTo>
                  <a:pt x="4145" y="669"/>
                  <a:pt x="4163" y="678"/>
                  <a:pt x="4181" y="682"/>
                </a:cubicBezTo>
                <a:cubicBezTo>
                  <a:pt x="4199" y="685"/>
                  <a:pt x="4219" y="683"/>
                  <a:pt x="4241" y="674"/>
                </a:cubicBezTo>
                <a:cubicBezTo>
                  <a:pt x="4263" y="665"/>
                  <a:pt x="4284" y="652"/>
                  <a:pt x="4303" y="632"/>
                </a:cubicBezTo>
                <a:cubicBezTo>
                  <a:pt x="4320" y="615"/>
                  <a:pt x="4332" y="598"/>
                  <a:pt x="4340" y="580"/>
                </a:cubicBezTo>
                <a:cubicBezTo>
                  <a:pt x="4348" y="562"/>
                  <a:pt x="4351" y="545"/>
                  <a:pt x="4348" y="530"/>
                </a:cubicBezTo>
                <a:cubicBezTo>
                  <a:pt x="4346" y="515"/>
                  <a:pt x="4340" y="502"/>
                  <a:pt x="4329" y="492"/>
                </a:cubicBezTo>
                <a:cubicBezTo>
                  <a:pt x="4319" y="481"/>
                  <a:pt x="4306" y="475"/>
                  <a:pt x="4292" y="473"/>
                </a:cubicBezTo>
                <a:cubicBezTo>
                  <a:pt x="4278" y="472"/>
                  <a:pt x="4262" y="475"/>
                  <a:pt x="4242" y="484"/>
                </a:cubicBezTo>
                <a:cubicBezTo>
                  <a:pt x="4230" y="489"/>
                  <a:pt x="4204" y="504"/>
                  <a:pt x="4166" y="527"/>
                </a:cubicBezTo>
                <a:cubicBezTo>
                  <a:pt x="4128" y="551"/>
                  <a:pt x="4099" y="565"/>
                  <a:pt x="4080" y="571"/>
                </a:cubicBezTo>
                <a:cubicBezTo>
                  <a:pt x="4056" y="579"/>
                  <a:pt x="4033" y="580"/>
                  <a:pt x="4013" y="576"/>
                </a:cubicBezTo>
                <a:cubicBezTo>
                  <a:pt x="3993" y="571"/>
                  <a:pt x="3975" y="561"/>
                  <a:pt x="3959" y="546"/>
                </a:cubicBezTo>
                <a:cubicBezTo>
                  <a:pt x="3942" y="529"/>
                  <a:pt x="3931" y="508"/>
                  <a:pt x="3926" y="484"/>
                </a:cubicBezTo>
                <a:cubicBezTo>
                  <a:pt x="3921" y="459"/>
                  <a:pt x="3924" y="434"/>
                  <a:pt x="3935" y="408"/>
                </a:cubicBezTo>
                <a:cubicBezTo>
                  <a:pt x="3946" y="382"/>
                  <a:pt x="3962" y="357"/>
                  <a:pt x="3985" y="335"/>
                </a:cubicBezTo>
                <a:cubicBezTo>
                  <a:pt x="4010" y="310"/>
                  <a:pt x="4036" y="292"/>
                  <a:pt x="4063" y="281"/>
                </a:cubicBezTo>
                <a:cubicBezTo>
                  <a:pt x="4090" y="270"/>
                  <a:pt x="4116" y="267"/>
                  <a:pt x="4142" y="273"/>
                </a:cubicBezTo>
                <a:cubicBezTo>
                  <a:pt x="4168" y="278"/>
                  <a:pt x="4191" y="290"/>
                  <a:pt x="4212" y="309"/>
                </a:cubicBezTo>
                <a:lnTo>
                  <a:pt x="4172" y="355"/>
                </a:lnTo>
                <a:cubicBezTo>
                  <a:pt x="4149" y="336"/>
                  <a:pt x="4125" y="328"/>
                  <a:pt x="4101" y="330"/>
                </a:cubicBezTo>
                <a:cubicBezTo>
                  <a:pt x="4077" y="332"/>
                  <a:pt x="4052" y="346"/>
                  <a:pt x="4026" y="372"/>
                </a:cubicBezTo>
                <a:cubicBezTo>
                  <a:pt x="3999" y="399"/>
                  <a:pt x="3984" y="424"/>
                  <a:pt x="3982" y="446"/>
                </a:cubicBezTo>
                <a:cubicBezTo>
                  <a:pt x="3980" y="468"/>
                  <a:pt x="3985" y="486"/>
                  <a:pt x="3999" y="500"/>
                </a:cubicBezTo>
                <a:cubicBezTo>
                  <a:pt x="4011" y="512"/>
                  <a:pt x="4026" y="518"/>
                  <a:pt x="4042" y="517"/>
                </a:cubicBezTo>
                <a:cubicBezTo>
                  <a:pt x="4058" y="516"/>
                  <a:pt x="4089" y="502"/>
                  <a:pt x="4133" y="474"/>
                </a:cubicBezTo>
                <a:cubicBezTo>
                  <a:pt x="4177" y="446"/>
                  <a:pt x="4209" y="428"/>
                  <a:pt x="4229" y="421"/>
                </a:cubicBezTo>
                <a:cubicBezTo>
                  <a:pt x="4258" y="410"/>
                  <a:pt x="4283" y="407"/>
                  <a:pt x="4307" y="412"/>
                </a:cubicBezTo>
                <a:cubicBezTo>
                  <a:pt x="4330" y="416"/>
                  <a:pt x="4350" y="427"/>
                  <a:pt x="4368" y="445"/>
                </a:cubicBezTo>
                <a:cubicBezTo>
                  <a:pt x="4386" y="463"/>
                  <a:pt x="4398" y="485"/>
                  <a:pt x="4404" y="511"/>
                </a:cubicBezTo>
                <a:cubicBezTo>
                  <a:pt x="4409" y="537"/>
                  <a:pt x="4407" y="564"/>
                  <a:pt x="4396" y="592"/>
                </a:cubicBezTo>
                <a:cubicBezTo>
                  <a:pt x="4386" y="620"/>
                  <a:pt x="4369" y="646"/>
                  <a:pt x="4345" y="670"/>
                </a:cubicBezTo>
                <a:cubicBezTo>
                  <a:pt x="4314" y="701"/>
                  <a:pt x="4284" y="722"/>
                  <a:pt x="4255" y="733"/>
                </a:cubicBezTo>
                <a:cubicBezTo>
                  <a:pt x="4226" y="745"/>
                  <a:pt x="4196" y="748"/>
                  <a:pt x="4167" y="742"/>
                </a:cubicBezTo>
                <a:cubicBezTo>
                  <a:pt x="4137" y="736"/>
                  <a:pt x="4111" y="722"/>
                  <a:pt x="4088" y="700"/>
                </a:cubicBezTo>
                <a:close/>
                <a:moveTo>
                  <a:pt x="4666" y="337"/>
                </a:moveTo>
                <a:lnTo>
                  <a:pt x="4625" y="378"/>
                </a:lnTo>
                <a:lnTo>
                  <a:pt x="4362" y="116"/>
                </a:lnTo>
                <a:cubicBezTo>
                  <a:pt x="4362" y="135"/>
                  <a:pt x="4358" y="157"/>
                  <a:pt x="4351" y="183"/>
                </a:cubicBezTo>
                <a:cubicBezTo>
                  <a:pt x="4345" y="209"/>
                  <a:pt x="4337" y="230"/>
                  <a:pt x="4329" y="248"/>
                </a:cubicBezTo>
                <a:lnTo>
                  <a:pt x="4289" y="208"/>
                </a:lnTo>
                <a:cubicBezTo>
                  <a:pt x="4302" y="174"/>
                  <a:pt x="4309" y="141"/>
                  <a:pt x="4310" y="108"/>
                </a:cubicBezTo>
                <a:cubicBezTo>
                  <a:pt x="4312" y="75"/>
                  <a:pt x="4310" y="48"/>
                  <a:pt x="4302" y="26"/>
                </a:cubicBezTo>
                <a:lnTo>
                  <a:pt x="4329" y="0"/>
                </a:lnTo>
                <a:lnTo>
                  <a:pt x="4666" y="337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3" name="Freeform 79"/>
          <p:cNvSpPr>
            <a:spLocks noEditPoints="1"/>
          </p:cNvSpPr>
          <p:nvPr/>
        </p:nvSpPr>
        <p:spPr bwMode="auto">
          <a:xfrm>
            <a:off x="5618305" y="5034102"/>
            <a:ext cx="901700" cy="890588"/>
          </a:xfrm>
          <a:custGeom>
            <a:avLst/>
            <a:gdLst>
              <a:gd name="T0" fmla="*/ 297 w 4728"/>
              <a:gd name="T1" fmla="*/ 4144 h 4675"/>
              <a:gd name="T2" fmla="*/ 336 w 4728"/>
              <a:gd name="T3" fmla="*/ 4675 h 4675"/>
              <a:gd name="T4" fmla="*/ 214 w 4728"/>
              <a:gd name="T5" fmla="*/ 4209 h 4675"/>
              <a:gd name="T6" fmla="*/ 441 w 4728"/>
              <a:gd name="T7" fmla="*/ 3898 h 4675"/>
              <a:gd name="T8" fmla="*/ 740 w 4728"/>
              <a:gd name="T9" fmla="*/ 3974 h 4675"/>
              <a:gd name="T10" fmla="*/ 651 w 4728"/>
              <a:gd name="T11" fmla="*/ 4360 h 4675"/>
              <a:gd name="T12" fmla="*/ 562 w 4728"/>
              <a:gd name="T13" fmla="*/ 3900 h 4675"/>
              <a:gd name="T14" fmla="*/ 739 w 4728"/>
              <a:gd name="T15" fmla="*/ 4192 h 4675"/>
              <a:gd name="T16" fmla="*/ 672 w 4728"/>
              <a:gd name="T17" fmla="*/ 4039 h 4675"/>
              <a:gd name="T18" fmla="*/ 743 w 4728"/>
              <a:gd name="T19" fmla="*/ 3595 h 4675"/>
              <a:gd name="T20" fmla="*/ 1157 w 4728"/>
              <a:gd name="T21" fmla="*/ 3748 h 4675"/>
              <a:gd name="T22" fmla="*/ 1040 w 4728"/>
              <a:gd name="T23" fmla="*/ 3891 h 4675"/>
              <a:gd name="T24" fmla="*/ 847 w 4728"/>
              <a:gd name="T25" fmla="*/ 3585 h 4675"/>
              <a:gd name="T26" fmla="*/ 1597 w 4728"/>
              <a:gd name="T27" fmla="*/ 3541 h 4675"/>
              <a:gd name="T28" fmla="*/ 1414 w 4728"/>
              <a:gd name="T29" fmla="*/ 2931 h 4675"/>
              <a:gd name="T30" fmla="*/ 1477 w 4728"/>
              <a:gd name="T31" fmla="*/ 3260 h 4675"/>
              <a:gd name="T32" fmla="*/ 1542 w 4728"/>
              <a:gd name="T33" fmla="*/ 2993 h 4675"/>
              <a:gd name="T34" fmla="*/ 1881 w 4728"/>
              <a:gd name="T35" fmla="*/ 3129 h 4675"/>
              <a:gd name="T36" fmla="*/ 1918 w 4728"/>
              <a:gd name="T37" fmla="*/ 2706 h 4675"/>
              <a:gd name="T38" fmla="*/ 1881 w 4728"/>
              <a:gd name="T39" fmla="*/ 3129 h 4675"/>
              <a:gd name="T40" fmla="*/ 2110 w 4728"/>
              <a:gd name="T41" fmla="*/ 2483 h 4675"/>
              <a:gd name="T42" fmla="*/ 2416 w 4728"/>
              <a:gd name="T43" fmla="*/ 2595 h 4675"/>
              <a:gd name="T44" fmla="*/ 2647 w 4728"/>
              <a:gd name="T45" fmla="*/ 2364 h 4675"/>
              <a:gd name="T46" fmla="*/ 2291 w 4728"/>
              <a:gd name="T47" fmla="*/ 2134 h 4675"/>
              <a:gd name="T48" fmla="*/ 2562 w 4728"/>
              <a:gd name="T49" fmla="*/ 1961 h 4675"/>
              <a:gd name="T50" fmla="*/ 2774 w 4728"/>
              <a:gd name="T51" fmla="*/ 1738 h 4675"/>
              <a:gd name="T52" fmla="*/ 2864 w 4728"/>
              <a:gd name="T53" fmla="*/ 1768 h 4675"/>
              <a:gd name="T54" fmla="*/ 2913 w 4728"/>
              <a:gd name="T55" fmla="*/ 2097 h 4675"/>
              <a:gd name="T56" fmla="*/ 2683 w 4728"/>
              <a:gd name="T57" fmla="*/ 2074 h 4675"/>
              <a:gd name="T58" fmla="*/ 3218 w 4728"/>
              <a:gd name="T59" fmla="*/ 1736 h 4675"/>
              <a:gd name="T60" fmla="*/ 3012 w 4728"/>
              <a:gd name="T61" fmla="*/ 1706 h 4675"/>
              <a:gd name="T62" fmla="*/ 3048 w 4728"/>
              <a:gd name="T63" fmla="*/ 1480 h 4675"/>
              <a:gd name="T64" fmla="*/ 2996 w 4728"/>
              <a:gd name="T65" fmla="*/ 1603 h 4675"/>
              <a:gd name="T66" fmla="*/ 3228 w 4728"/>
              <a:gd name="T67" fmla="*/ 1569 h 4675"/>
              <a:gd name="T68" fmla="*/ 3070 w 4728"/>
              <a:gd name="T69" fmla="*/ 1795 h 4675"/>
              <a:gd name="T70" fmla="*/ 3341 w 4728"/>
              <a:gd name="T71" fmla="*/ 1420 h 4675"/>
              <a:gd name="T72" fmla="*/ 3194 w 4728"/>
              <a:gd name="T73" fmla="*/ 1345 h 4675"/>
              <a:gd name="T74" fmla="*/ 3389 w 4728"/>
              <a:gd name="T75" fmla="*/ 1213 h 4675"/>
              <a:gd name="T76" fmla="*/ 3498 w 4728"/>
              <a:gd name="T77" fmla="*/ 935 h 4675"/>
              <a:gd name="T78" fmla="*/ 3544 w 4728"/>
              <a:gd name="T79" fmla="*/ 980 h 4675"/>
              <a:gd name="T80" fmla="*/ 3690 w 4728"/>
              <a:gd name="T81" fmla="*/ 648 h 4675"/>
              <a:gd name="T82" fmla="*/ 3894 w 4728"/>
              <a:gd name="T83" fmla="*/ 844 h 4675"/>
              <a:gd name="T84" fmla="*/ 3900 w 4728"/>
              <a:gd name="T85" fmla="*/ 726 h 4675"/>
              <a:gd name="T86" fmla="*/ 3768 w 4728"/>
              <a:gd name="T87" fmla="*/ 890 h 4675"/>
              <a:gd name="T88" fmla="*/ 4340 w 4728"/>
              <a:gd name="T89" fmla="*/ 587 h 4675"/>
              <a:gd name="T90" fmla="*/ 4080 w 4728"/>
              <a:gd name="T91" fmla="*/ 578 h 4675"/>
              <a:gd name="T92" fmla="*/ 4063 w 4728"/>
              <a:gd name="T93" fmla="*/ 288 h 4675"/>
              <a:gd name="T94" fmla="*/ 3982 w 4728"/>
              <a:gd name="T95" fmla="*/ 453 h 4675"/>
              <a:gd name="T96" fmla="*/ 4368 w 4728"/>
              <a:gd name="T97" fmla="*/ 452 h 4675"/>
              <a:gd name="T98" fmla="*/ 4088 w 4728"/>
              <a:gd name="T99" fmla="*/ 707 h 4675"/>
              <a:gd name="T100" fmla="*/ 4467 w 4728"/>
              <a:gd name="T101" fmla="*/ 295 h 4675"/>
              <a:gd name="T102" fmla="*/ 4320 w 4728"/>
              <a:gd name="T103" fmla="*/ 219 h 4675"/>
              <a:gd name="T104" fmla="*/ 4514 w 4728"/>
              <a:gd name="T105" fmla="*/ 87 h 467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</a:cxnLst>
            <a:rect l="0" t="0" r="r" b="b"/>
            <a:pathLst>
              <a:path w="4728" h="4675">
                <a:moveTo>
                  <a:pt x="336" y="4675"/>
                </a:moveTo>
                <a:lnTo>
                  <a:pt x="0" y="4339"/>
                </a:lnTo>
                <a:lnTo>
                  <a:pt x="126" y="4212"/>
                </a:lnTo>
                <a:cubicBezTo>
                  <a:pt x="149" y="4189"/>
                  <a:pt x="167" y="4173"/>
                  <a:pt x="181" y="4164"/>
                </a:cubicBezTo>
                <a:cubicBezTo>
                  <a:pt x="200" y="4150"/>
                  <a:pt x="219" y="4142"/>
                  <a:pt x="238" y="4138"/>
                </a:cubicBezTo>
                <a:cubicBezTo>
                  <a:pt x="257" y="4135"/>
                  <a:pt x="277" y="4136"/>
                  <a:pt x="297" y="4144"/>
                </a:cubicBezTo>
                <a:cubicBezTo>
                  <a:pt x="318" y="4151"/>
                  <a:pt x="337" y="4163"/>
                  <a:pt x="353" y="4179"/>
                </a:cubicBezTo>
                <a:cubicBezTo>
                  <a:pt x="382" y="4208"/>
                  <a:pt x="397" y="4241"/>
                  <a:pt x="399" y="4279"/>
                </a:cubicBezTo>
                <a:cubicBezTo>
                  <a:pt x="400" y="4317"/>
                  <a:pt x="377" y="4360"/>
                  <a:pt x="330" y="4407"/>
                </a:cubicBezTo>
                <a:lnTo>
                  <a:pt x="244" y="4494"/>
                </a:lnTo>
                <a:lnTo>
                  <a:pt x="380" y="4630"/>
                </a:lnTo>
                <a:lnTo>
                  <a:pt x="336" y="4675"/>
                </a:lnTo>
                <a:close/>
                <a:moveTo>
                  <a:pt x="204" y="4454"/>
                </a:moveTo>
                <a:lnTo>
                  <a:pt x="291" y="4367"/>
                </a:lnTo>
                <a:cubicBezTo>
                  <a:pt x="320" y="4338"/>
                  <a:pt x="335" y="4312"/>
                  <a:pt x="336" y="4290"/>
                </a:cubicBezTo>
                <a:cubicBezTo>
                  <a:pt x="337" y="4267"/>
                  <a:pt x="328" y="4246"/>
                  <a:pt x="309" y="4226"/>
                </a:cubicBezTo>
                <a:cubicBezTo>
                  <a:pt x="295" y="4212"/>
                  <a:pt x="279" y="4204"/>
                  <a:pt x="262" y="4201"/>
                </a:cubicBezTo>
                <a:cubicBezTo>
                  <a:pt x="245" y="4198"/>
                  <a:pt x="229" y="4201"/>
                  <a:pt x="214" y="4209"/>
                </a:cubicBezTo>
                <a:cubicBezTo>
                  <a:pt x="205" y="4215"/>
                  <a:pt x="190" y="4228"/>
                  <a:pt x="170" y="4248"/>
                </a:cubicBezTo>
                <a:lnTo>
                  <a:pt x="84" y="4334"/>
                </a:lnTo>
                <a:lnTo>
                  <a:pt x="204" y="4454"/>
                </a:lnTo>
                <a:close/>
                <a:moveTo>
                  <a:pt x="651" y="4360"/>
                </a:moveTo>
                <a:lnTo>
                  <a:pt x="315" y="4024"/>
                </a:lnTo>
                <a:lnTo>
                  <a:pt x="441" y="3898"/>
                </a:lnTo>
                <a:cubicBezTo>
                  <a:pt x="466" y="3872"/>
                  <a:pt x="490" y="3855"/>
                  <a:pt x="513" y="3846"/>
                </a:cubicBezTo>
                <a:cubicBezTo>
                  <a:pt x="535" y="3837"/>
                  <a:pt x="558" y="3836"/>
                  <a:pt x="581" y="3841"/>
                </a:cubicBezTo>
                <a:cubicBezTo>
                  <a:pt x="603" y="3846"/>
                  <a:pt x="623" y="3857"/>
                  <a:pt x="638" y="3872"/>
                </a:cubicBezTo>
                <a:cubicBezTo>
                  <a:pt x="652" y="3886"/>
                  <a:pt x="662" y="3904"/>
                  <a:pt x="667" y="3924"/>
                </a:cubicBezTo>
                <a:cubicBezTo>
                  <a:pt x="672" y="3945"/>
                  <a:pt x="670" y="3967"/>
                  <a:pt x="662" y="3990"/>
                </a:cubicBezTo>
                <a:cubicBezTo>
                  <a:pt x="689" y="3976"/>
                  <a:pt x="714" y="3971"/>
                  <a:pt x="740" y="3974"/>
                </a:cubicBezTo>
                <a:cubicBezTo>
                  <a:pt x="765" y="3977"/>
                  <a:pt x="787" y="3989"/>
                  <a:pt x="807" y="4008"/>
                </a:cubicBezTo>
                <a:cubicBezTo>
                  <a:pt x="823" y="4024"/>
                  <a:pt x="834" y="4042"/>
                  <a:pt x="841" y="4062"/>
                </a:cubicBezTo>
                <a:cubicBezTo>
                  <a:pt x="848" y="4083"/>
                  <a:pt x="850" y="4101"/>
                  <a:pt x="848" y="4118"/>
                </a:cubicBezTo>
                <a:cubicBezTo>
                  <a:pt x="845" y="4135"/>
                  <a:pt x="838" y="4153"/>
                  <a:pt x="827" y="4172"/>
                </a:cubicBezTo>
                <a:cubicBezTo>
                  <a:pt x="816" y="4190"/>
                  <a:pt x="800" y="4210"/>
                  <a:pt x="779" y="4232"/>
                </a:cubicBezTo>
                <a:lnTo>
                  <a:pt x="651" y="4360"/>
                </a:lnTo>
                <a:close/>
                <a:moveTo>
                  <a:pt x="500" y="4120"/>
                </a:moveTo>
                <a:lnTo>
                  <a:pt x="573" y="4048"/>
                </a:lnTo>
                <a:cubicBezTo>
                  <a:pt x="593" y="4028"/>
                  <a:pt x="605" y="4013"/>
                  <a:pt x="611" y="4001"/>
                </a:cubicBezTo>
                <a:cubicBezTo>
                  <a:pt x="619" y="3987"/>
                  <a:pt x="622" y="3973"/>
                  <a:pt x="620" y="3959"/>
                </a:cubicBezTo>
                <a:cubicBezTo>
                  <a:pt x="618" y="3946"/>
                  <a:pt x="611" y="3933"/>
                  <a:pt x="600" y="3921"/>
                </a:cubicBezTo>
                <a:cubicBezTo>
                  <a:pt x="588" y="3910"/>
                  <a:pt x="576" y="3903"/>
                  <a:pt x="562" y="3900"/>
                </a:cubicBezTo>
                <a:cubicBezTo>
                  <a:pt x="548" y="3897"/>
                  <a:pt x="535" y="3898"/>
                  <a:pt x="522" y="3905"/>
                </a:cubicBezTo>
                <a:cubicBezTo>
                  <a:pt x="509" y="3912"/>
                  <a:pt x="490" y="3927"/>
                  <a:pt x="466" y="3952"/>
                </a:cubicBezTo>
                <a:lnTo>
                  <a:pt x="399" y="4019"/>
                </a:lnTo>
                <a:lnTo>
                  <a:pt x="500" y="4120"/>
                </a:lnTo>
                <a:close/>
                <a:moveTo>
                  <a:pt x="655" y="4276"/>
                </a:moveTo>
                <a:lnTo>
                  <a:pt x="739" y="4192"/>
                </a:lnTo>
                <a:cubicBezTo>
                  <a:pt x="754" y="4178"/>
                  <a:pt x="763" y="4167"/>
                  <a:pt x="768" y="4160"/>
                </a:cubicBezTo>
                <a:cubicBezTo>
                  <a:pt x="776" y="4148"/>
                  <a:pt x="782" y="4136"/>
                  <a:pt x="784" y="4125"/>
                </a:cubicBezTo>
                <a:cubicBezTo>
                  <a:pt x="787" y="4114"/>
                  <a:pt x="786" y="4102"/>
                  <a:pt x="783" y="4090"/>
                </a:cubicBezTo>
                <a:cubicBezTo>
                  <a:pt x="779" y="4077"/>
                  <a:pt x="772" y="4065"/>
                  <a:pt x="761" y="4055"/>
                </a:cubicBezTo>
                <a:cubicBezTo>
                  <a:pt x="748" y="4042"/>
                  <a:pt x="734" y="4034"/>
                  <a:pt x="719" y="4032"/>
                </a:cubicBezTo>
                <a:cubicBezTo>
                  <a:pt x="703" y="4029"/>
                  <a:pt x="688" y="4031"/>
                  <a:pt x="672" y="4039"/>
                </a:cubicBezTo>
                <a:cubicBezTo>
                  <a:pt x="657" y="4046"/>
                  <a:pt x="639" y="4061"/>
                  <a:pt x="618" y="4082"/>
                </a:cubicBezTo>
                <a:lnTo>
                  <a:pt x="540" y="4160"/>
                </a:lnTo>
                <a:lnTo>
                  <a:pt x="655" y="4276"/>
                </a:lnTo>
                <a:close/>
                <a:moveTo>
                  <a:pt x="964" y="4047"/>
                </a:moveTo>
                <a:lnTo>
                  <a:pt x="628" y="3711"/>
                </a:lnTo>
                <a:lnTo>
                  <a:pt x="743" y="3595"/>
                </a:lnTo>
                <a:cubicBezTo>
                  <a:pt x="769" y="3569"/>
                  <a:pt x="791" y="3550"/>
                  <a:pt x="808" y="3540"/>
                </a:cubicBezTo>
                <a:cubicBezTo>
                  <a:pt x="832" y="3525"/>
                  <a:pt x="856" y="3517"/>
                  <a:pt x="881" y="3515"/>
                </a:cubicBezTo>
                <a:cubicBezTo>
                  <a:pt x="914" y="3512"/>
                  <a:pt x="946" y="3518"/>
                  <a:pt x="979" y="3532"/>
                </a:cubicBezTo>
                <a:cubicBezTo>
                  <a:pt x="1011" y="3547"/>
                  <a:pt x="1042" y="3569"/>
                  <a:pt x="1072" y="3599"/>
                </a:cubicBezTo>
                <a:cubicBezTo>
                  <a:pt x="1097" y="3625"/>
                  <a:pt x="1117" y="3650"/>
                  <a:pt x="1131" y="3676"/>
                </a:cubicBezTo>
                <a:cubicBezTo>
                  <a:pt x="1144" y="3701"/>
                  <a:pt x="1153" y="3725"/>
                  <a:pt x="1157" y="3748"/>
                </a:cubicBezTo>
                <a:cubicBezTo>
                  <a:pt x="1160" y="3770"/>
                  <a:pt x="1160" y="3790"/>
                  <a:pt x="1156" y="3809"/>
                </a:cubicBezTo>
                <a:cubicBezTo>
                  <a:pt x="1153" y="3827"/>
                  <a:pt x="1145" y="3846"/>
                  <a:pt x="1133" y="3866"/>
                </a:cubicBezTo>
                <a:cubicBezTo>
                  <a:pt x="1121" y="3885"/>
                  <a:pt x="1105" y="3905"/>
                  <a:pt x="1085" y="3925"/>
                </a:cubicBezTo>
                <a:lnTo>
                  <a:pt x="964" y="4047"/>
                </a:lnTo>
                <a:close/>
                <a:moveTo>
                  <a:pt x="968" y="3963"/>
                </a:moveTo>
                <a:lnTo>
                  <a:pt x="1040" y="3891"/>
                </a:lnTo>
                <a:cubicBezTo>
                  <a:pt x="1062" y="3869"/>
                  <a:pt x="1078" y="3849"/>
                  <a:pt x="1086" y="3832"/>
                </a:cubicBezTo>
                <a:cubicBezTo>
                  <a:pt x="1095" y="3816"/>
                  <a:pt x="1099" y="3800"/>
                  <a:pt x="1099" y="3785"/>
                </a:cubicBezTo>
                <a:cubicBezTo>
                  <a:pt x="1099" y="3764"/>
                  <a:pt x="1093" y="3741"/>
                  <a:pt x="1081" y="3718"/>
                </a:cubicBezTo>
                <a:cubicBezTo>
                  <a:pt x="1069" y="3694"/>
                  <a:pt x="1050" y="3670"/>
                  <a:pt x="1025" y="3644"/>
                </a:cubicBezTo>
                <a:cubicBezTo>
                  <a:pt x="990" y="3609"/>
                  <a:pt x="957" y="3588"/>
                  <a:pt x="927" y="3580"/>
                </a:cubicBezTo>
                <a:cubicBezTo>
                  <a:pt x="896" y="3573"/>
                  <a:pt x="870" y="3574"/>
                  <a:pt x="847" y="3585"/>
                </a:cubicBezTo>
                <a:cubicBezTo>
                  <a:pt x="830" y="3592"/>
                  <a:pt x="809" y="3609"/>
                  <a:pt x="782" y="3635"/>
                </a:cubicBezTo>
                <a:lnTo>
                  <a:pt x="712" y="3706"/>
                </a:lnTo>
                <a:lnTo>
                  <a:pt x="968" y="3963"/>
                </a:lnTo>
                <a:close/>
                <a:moveTo>
                  <a:pt x="1353" y="3844"/>
                </a:moveTo>
                <a:lnTo>
                  <a:pt x="1323" y="3814"/>
                </a:lnTo>
                <a:lnTo>
                  <a:pt x="1597" y="3541"/>
                </a:lnTo>
                <a:lnTo>
                  <a:pt x="1627" y="3570"/>
                </a:lnTo>
                <a:lnTo>
                  <a:pt x="1353" y="3844"/>
                </a:lnTo>
                <a:close/>
                <a:moveTo>
                  <a:pt x="1569" y="3441"/>
                </a:moveTo>
                <a:lnTo>
                  <a:pt x="1233" y="3105"/>
                </a:lnTo>
                <a:lnTo>
                  <a:pt x="1360" y="2979"/>
                </a:lnTo>
                <a:cubicBezTo>
                  <a:pt x="1382" y="2956"/>
                  <a:pt x="1400" y="2940"/>
                  <a:pt x="1414" y="2931"/>
                </a:cubicBezTo>
                <a:cubicBezTo>
                  <a:pt x="1433" y="2917"/>
                  <a:pt x="1452" y="2908"/>
                  <a:pt x="1471" y="2905"/>
                </a:cubicBezTo>
                <a:cubicBezTo>
                  <a:pt x="1490" y="2901"/>
                  <a:pt x="1510" y="2903"/>
                  <a:pt x="1531" y="2910"/>
                </a:cubicBezTo>
                <a:cubicBezTo>
                  <a:pt x="1551" y="2917"/>
                  <a:pt x="1570" y="2929"/>
                  <a:pt x="1587" y="2946"/>
                </a:cubicBezTo>
                <a:cubicBezTo>
                  <a:pt x="1615" y="2975"/>
                  <a:pt x="1630" y="3008"/>
                  <a:pt x="1632" y="3046"/>
                </a:cubicBezTo>
                <a:cubicBezTo>
                  <a:pt x="1633" y="3084"/>
                  <a:pt x="1610" y="3127"/>
                  <a:pt x="1563" y="3174"/>
                </a:cubicBezTo>
                <a:lnTo>
                  <a:pt x="1477" y="3260"/>
                </a:lnTo>
                <a:lnTo>
                  <a:pt x="1613" y="3397"/>
                </a:lnTo>
                <a:lnTo>
                  <a:pt x="1569" y="3441"/>
                </a:lnTo>
                <a:close/>
                <a:moveTo>
                  <a:pt x="1437" y="3221"/>
                </a:moveTo>
                <a:lnTo>
                  <a:pt x="1524" y="3134"/>
                </a:lnTo>
                <a:cubicBezTo>
                  <a:pt x="1553" y="3105"/>
                  <a:pt x="1568" y="3079"/>
                  <a:pt x="1569" y="3057"/>
                </a:cubicBezTo>
                <a:cubicBezTo>
                  <a:pt x="1571" y="3034"/>
                  <a:pt x="1561" y="3013"/>
                  <a:pt x="1542" y="2993"/>
                </a:cubicBezTo>
                <a:cubicBezTo>
                  <a:pt x="1528" y="2979"/>
                  <a:pt x="1512" y="2971"/>
                  <a:pt x="1495" y="2968"/>
                </a:cubicBezTo>
                <a:cubicBezTo>
                  <a:pt x="1478" y="2965"/>
                  <a:pt x="1462" y="2968"/>
                  <a:pt x="1447" y="2976"/>
                </a:cubicBezTo>
                <a:cubicBezTo>
                  <a:pt x="1438" y="2982"/>
                  <a:pt x="1423" y="2994"/>
                  <a:pt x="1403" y="3015"/>
                </a:cubicBezTo>
                <a:lnTo>
                  <a:pt x="1317" y="3101"/>
                </a:lnTo>
                <a:lnTo>
                  <a:pt x="1437" y="3221"/>
                </a:lnTo>
                <a:close/>
                <a:moveTo>
                  <a:pt x="1881" y="3129"/>
                </a:moveTo>
                <a:lnTo>
                  <a:pt x="1545" y="2793"/>
                </a:lnTo>
                <a:lnTo>
                  <a:pt x="1788" y="2550"/>
                </a:lnTo>
                <a:lnTo>
                  <a:pt x="1828" y="2590"/>
                </a:lnTo>
                <a:lnTo>
                  <a:pt x="1629" y="2788"/>
                </a:lnTo>
                <a:lnTo>
                  <a:pt x="1732" y="2891"/>
                </a:lnTo>
                <a:lnTo>
                  <a:pt x="1918" y="2706"/>
                </a:lnTo>
                <a:lnTo>
                  <a:pt x="1957" y="2745"/>
                </a:lnTo>
                <a:lnTo>
                  <a:pt x="1771" y="2931"/>
                </a:lnTo>
                <a:lnTo>
                  <a:pt x="1886" y="3045"/>
                </a:lnTo>
                <a:lnTo>
                  <a:pt x="2092" y="2839"/>
                </a:lnTo>
                <a:lnTo>
                  <a:pt x="2132" y="2879"/>
                </a:lnTo>
                <a:lnTo>
                  <a:pt x="1881" y="3129"/>
                </a:lnTo>
                <a:close/>
                <a:moveTo>
                  <a:pt x="2163" y="2848"/>
                </a:moveTo>
                <a:lnTo>
                  <a:pt x="2117" y="2543"/>
                </a:lnTo>
                <a:lnTo>
                  <a:pt x="1842" y="2496"/>
                </a:lnTo>
                <a:lnTo>
                  <a:pt x="1895" y="2443"/>
                </a:lnTo>
                <a:lnTo>
                  <a:pt x="2042" y="2469"/>
                </a:lnTo>
                <a:cubicBezTo>
                  <a:pt x="2073" y="2474"/>
                  <a:pt x="2095" y="2478"/>
                  <a:pt x="2110" y="2483"/>
                </a:cubicBezTo>
                <a:cubicBezTo>
                  <a:pt x="2106" y="2463"/>
                  <a:pt x="2102" y="2441"/>
                  <a:pt x="2099" y="2418"/>
                </a:cubicBezTo>
                <a:lnTo>
                  <a:pt x="2077" y="2261"/>
                </a:lnTo>
                <a:lnTo>
                  <a:pt x="2126" y="2213"/>
                </a:lnTo>
                <a:lnTo>
                  <a:pt x="2166" y="2489"/>
                </a:lnTo>
                <a:lnTo>
                  <a:pt x="2471" y="2540"/>
                </a:lnTo>
                <a:lnTo>
                  <a:pt x="2416" y="2595"/>
                </a:lnTo>
                <a:lnTo>
                  <a:pt x="2211" y="2559"/>
                </a:lnTo>
                <a:cubicBezTo>
                  <a:pt x="2200" y="2557"/>
                  <a:pt x="2187" y="2555"/>
                  <a:pt x="2174" y="2551"/>
                </a:cubicBezTo>
                <a:cubicBezTo>
                  <a:pt x="2179" y="2571"/>
                  <a:pt x="2182" y="2585"/>
                  <a:pt x="2183" y="2593"/>
                </a:cubicBezTo>
                <a:lnTo>
                  <a:pt x="2216" y="2794"/>
                </a:lnTo>
                <a:lnTo>
                  <a:pt x="2163" y="2848"/>
                </a:lnTo>
                <a:close/>
                <a:moveTo>
                  <a:pt x="2647" y="2364"/>
                </a:moveTo>
                <a:lnTo>
                  <a:pt x="2605" y="2405"/>
                </a:lnTo>
                <a:lnTo>
                  <a:pt x="2342" y="2142"/>
                </a:lnTo>
                <a:cubicBezTo>
                  <a:pt x="2342" y="2161"/>
                  <a:pt x="2338" y="2184"/>
                  <a:pt x="2332" y="2210"/>
                </a:cubicBezTo>
                <a:cubicBezTo>
                  <a:pt x="2325" y="2235"/>
                  <a:pt x="2318" y="2257"/>
                  <a:pt x="2310" y="2274"/>
                </a:cubicBezTo>
                <a:lnTo>
                  <a:pt x="2270" y="2234"/>
                </a:lnTo>
                <a:cubicBezTo>
                  <a:pt x="2282" y="2200"/>
                  <a:pt x="2289" y="2167"/>
                  <a:pt x="2291" y="2134"/>
                </a:cubicBezTo>
                <a:cubicBezTo>
                  <a:pt x="2293" y="2102"/>
                  <a:pt x="2290" y="2075"/>
                  <a:pt x="2283" y="2053"/>
                </a:cubicBezTo>
                <a:lnTo>
                  <a:pt x="2309" y="2026"/>
                </a:lnTo>
                <a:lnTo>
                  <a:pt x="2647" y="2364"/>
                </a:lnTo>
                <a:close/>
                <a:moveTo>
                  <a:pt x="2769" y="2242"/>
                </a:moveTo>
                <a:lnTo>
                  <a:pt x="2525" y="1998"/>
                </a:lnTo>
                <a:lnTo>
                  <a:pt x="2562" y="1961"/>
                </a:lnTo>
                <a:lnTo>
                  <a:pt x="2596" y="1996"/>
                </a:lnTo>
                <a:cubicBezTo>
                  <a:pt x="2592" y="1976"/>
                  <a:pt x="2592" y="1956"/>
                  <a:pt x="2598" y="1936"/>
                </a:cubicBezTo>
                <a:cubicBezTo>
                  <a:pt x="2603" y="1916"/>
                  <a:pt x="2614" y="1898"/>
                  <a:pt x="2630" y="1882"/>
                </a:cubicBezTo>
                <a:cubicBezTo>
                  <a:pt x="2648" y="1864"/>
                  <a:pt x="2667" y="1853"/>
                  <a:pt x="2686" y="1849"/>
                </a:cubicBezTo>
                <a:cubicBezTo>
                  <a:pt x="2705" y="1845"/>
                  <a:pt x="2724" y="1847"/>
                  <a:pt x="2742" y="1856"/>
                </a:cubicBezTo>
                <a:cubicBezTo>
                  <a:pt x="2733" y="1808"/>
                  <a:pt x="2743" y="1769"/>
                  <a:pt x="2774" y="1738"/>
                </a:cubicBezTo>
                <a:cubicBezTo>
                  <a:pt x="2798" y="1714"/>
                  <a:pt x="2824" y="1702"/>
                  <a:pt x="2850" y="1702"/>
                </a:cubicBezTo>
                <a:cubicBezTo>
                  <a:pt x="2876" y="1703"/>
                  <a:pt x="2904" y="1717"/>
                  <a:pt x="2931" y="1745"/>
                </a:cubicBezTo>
                <a:lnTo>
                  <a:pt x="3098" y="1912"/>
                </a:lnTo>
                <a:lnTo>
                  <a:pt x="3057" y="1953"/>
                </a:lnTo>
                <a:lnTo>
                  <a:pt x="2904" y="1800"/>
                </a:lnTo>
                <a:cubicBezTo>
                  <a:pt x="2888" y="1783"/>
                  <a:pt x="2874" y="1773"/>
                  <a:pt x="2864" y="1768"/>
                </a:cubicBezTo>
                <a:cubicBezTo>
                  <a:pt x="2854" y="1763"/>
                  <a:pt x="2844" y="1762"/>
                  <a:pt x="2832" y="1765"/>
                </a:cubicBezTo>
                <a:cubicBezTo>
                  <a:pt x="2821" y="1768"/>
                  <a:pt x="2810" y="1774"/>
                  <a:pt x="2801" y="1783"/>
                </a:cubicBezTo>
                <a:cubicBezTo>
                  <a:pt x="2784" y="1800"/>
                  <a:pt x="2775" y="1820"/>
                  <a:pt x="2775" y="1843"/>
                </a:cubicBezTo>
                <a:cubicBezTo>
                  <a:pt x="2775" y="1865"/>
                  <a:pt x="2788" y="1889"/>
                  <a:pt x="2813" y="1914"/>
                </a:cubicBezTo>
                <a:lnTo>
                  <a:pt x="2954" y="2056"/>
                </a:lnTo>
                <a:lnTo>
                  <a:pt x="2913" y="2097"/>
                </a:lnTo>
                <a:lnTo>
                  <a:pt x="2755" y="1939"/>
                </a:lnTo>
                <a:cubicBezTo>
                  <a:pt x="2737" y="1921"/>
                  <a:pt x="2720" y="1910"/>
                  <a:pt x="2704" y="1908"/>
                </a:cubicBezTo>
                <a:cubicBezTo>
                  <a:pt x="2688" y="1905"/>
                  <a:pt x="2672" y="1912"/>
                  <a:pt x="2657" y="1927"/>
                </a:cubicBezTo>
                <a:cubicBezTo>
                  <a:pt x="2645" y="1939"/>
                  <a:pt x="2638" y="1952"/>
                  <a:pt x="2634" y="1968"/>
                </a:cubicBezTo>
                <a:cubicBezTo>
                  <a:pt x="2630" y="1984"/>
                  <a:pt x="2632" y="2000"/>
                  <a:pt x="2639" y="2017"/>
                </a:cubicBezTo>
                <a:cubicBezTo>
                  <a:pt x="2647" y="2033"/>
                  <a:pt x="2661" y="2052"/>
                  <a:pt x="2683" y="2074"/>
                </a:cubicBezTo>
                <a:lnTo>
                  <a:pt x="2810" y="2201"/>
                </a:lnTo>
                <a:lnTo>
                  <a:pt x="2769" y="2242"/>
                </a:lnTo>
                <a:close/>
                <a:moveTo>
                  <a:pt x="3070" y="1795"/>
                </a:moveTo>
                <a:lnTo>
                  <a:pt x="3104" y="1748"/>
                </a:lnTo>
                <a:cubicBezTo>
                  <a:pt x="3123" y="1762"/>
                  <a:pt x="3142" y="1768"/>
                  <a:pt x="3161" y="1767"/>
                </a:cubicBezTo>
                <a:cubicBezTo>
                  <a:pt x="3180" y="1765"/>
                  <a:pt x="3199" y="1755"/>
                  <a:pt x="3218" y="1736"/>
                </a:cubicBezTo>
                <a:cubicBezTo>
                  <a:pt x="3237" y="1717"/>
                  <a:pt x="3247" y="1699"/>
                  <a:pt x="3248" y="1682"/>
                </a:cubicBezTo>
                <a:cubicBezTo>
                  <a:pt x="3250" y="1665"/>
                  <a:pt x="3245" y="1651"/>
                  <a:pt x="3235" y="1641"/>
                </a:cubicBezTo>
                <a:cubicBezTo>
                  <a:pt x="3226" y="1632"/>
                  <a:pt x="3214" y="1628"/>
                  <a:pt x="3201" y="1631"/>
                </a:cubicBezTo>
                <a:cubicBezTo>
                  <a:pt x="3191" y="1633"/>
                  <a:pt x="3173" y="1643"/>
                  <a:pt x="3145" y="1659"/>
                </a:cubicBezTo>
                <a:cubicBezTo>
                  <a:pt x="3107" y="1682"/>
                  <a:pt x="3079" y="1696"/>
                  <a:pt x="3062" y="1702"/>
                </a:cubicBezTo>
                <a:cubicBezTo>
                  <a:pt x="3045" y="1709"/>
                  <a:pt x="3028" y="1710"/>
                  <a:pt x="3012" y="1706"/>
                </a:cubicBezTo>
                <a:cubicBezTo>
                  <a:pt x="2996" y="1702"/>
                  <a:pt x="2982" y="1694"/>
                  <a:pt x="2970" y="1682"/>
                </a:cubicBezTo>
                <a:cubicBezTo>
                  <a:pt x="2960" y="1671"/>
                  <a:pt x="2952" y="1659"/>
                  <a:pt x="2948" y="1645"/>
                </a:cubicBezTo>
                <a:cubicBezTo>
                  <a:pt x="2943" y="1630"/>
                  <a:pt x="2943" y="1616"/>
                  <a:pt x="2945" y="1601"/>
                </a:cubicBezTo>
                <a:cubicBezTo>
                  <a:pt x="2947" y="1590"/>
                  <a:pt x="2951" y="1577"/>
                  <a:pt x="2959" y="1563"/>
                </a:cubicBezTo>
                <a:cubicBezTo>
                  <a:pt x="2967" y="1549"/>
                  <a:pt x="2977" y="1535"/>
                  <a:pt x="2990" y="1523"/>
                </a:cubicBezTo>
                <a:cubicBezTo>
                  <a:pt x="3009" y="1503"/>
                  <a:pt x="3029" y="1489"/>
                  <a:pt x="3048" y="1480"/>
                </a:cubicBezTo>
                <a:cubicBezTo>
                  <a:pt x="3068" y="1471"/>
                  <a:pt x="3087" y="1468"/>
                  <a:pt x="3103" y="1471"/>
                </a:cubicBezTo>
                <a:cubicBezTo>
                  <a:pt x="3119" y="1473"/>
                  <a:pt x="3136" y="1481"/>
                  <a:pt x="3155" y="1494"/>
                </a:cubicBezTo>
                <a:lnTo>
                  <a:pt x="3120" y="1540"/>
                </a:lnTo>
                <a:cubicBezTo>
                  <a:pt x="3106" y="1529"/>
                  <a:pt x="3090" y="1525"/>
                  <a:pt x="3075" y="1527"/>
                </a:cubicBezTo>
                <a:cubicBezTo>
                  <a:pt x="3059" y="1529"/>
                  <a:pt x="3043" y="1537"/>
                  <a:pt x="3027" y="1553"/>
                </a:cubicBezTo>
                <a:cubicBezTo>
                  <a:pt x="3008" y="1572"/>
                  <a:pt x="2997" y="1589"/>
                  <a:pt x="2996" y="1603"/>
                </a:cubicBezTo>
                <a:cubicBezTo>
                  <a:pt x="2994" y="1618"/>
                  <a:pt x="2997" y="1629"/>
                  <a:pt x="3005" y="1638"/>
                </a:cubicBezTo>
                <a:cubicBezTo>
                  <a:pt x="3011" y="1643"/>
                  <a:pt x="3017" y="1646"/>
                  <a:pt x="3025" y="1647"/>
                </a:cubicBezTo>
                <a:cubicBezTo>
                  <a:pt x="3033" y="1648"/>
                  <a:pt x="3042" y="1646"/>
                  <a:pt x="3052" y="1642"/>
                </a:cubicBezTo>
                <a:cubicBezTo>
                  <a:pt x="3057" y="1640"/>
                  <a:pt x="3073" y="1631"/>
                  <a:pt x="3099" y="1616"/>
                </a:cubicBezTo>
                <a:cubicBezTo>
                  <a:pt x="3136" y="1595"/>
                  <a:pt x="3163" y="1581"/>
                  <a:pt x="3179" y="1574"/>
                </a:cubicBezTo>
                <a:cubicBezTo>
                  <a:pt x="3196" y="1568"/>
                  <a:pt x="3212" y="1566"/>
                  <a:pt x="3228" y="1569"/>
                </a:cubicBezTo>
                <a:cubicBezTo>
                  <a:pt x="3244" y="1572"/>
                  <a:pt x="3259" y="1580"/>
                  <a:pt x="3273" y="1594"/>
                </a:cubicBezTo>
                <a:cubicBezTo>
                  <a:pt x="3287" y="1608"/>
                  <a:pt x="3296" y="1625"/>
                  <a:pt x="3300" y="1645"/>
                </a:cubicBezTo>
                <a:cubicBezTo>
                  <a:pt x="3304" y="1665"/>
                  <a:pt x="3302" y="1686"/>
                  <a:pt x="3293" y="1708"/>
                </a:cubicBezTo>
                <a:cubicBezTo>
                  <a:pt x="3285" y="1730"/>
                  <a:pt x="3271" y="1750"/>
                  <a:pt x="3252" y="1769"/>
                </a:cubicBezTo>
                <a:cubicBezTo>
                  <a:pt x="3220" y="1801"/>
                  <a:pt x="3190" y="1819"/>
                  <a:pt x="3160" y="1822"/>
                </a:cubicBezTo>
                <a:cubicBezTo>
                  <a:pt x="3130" y="1825"/>
                  <a:pt x="3100" y="1817"/>
                  <a:pt x="3070" y="1795"/>
                </a:cubicBezTo>
                <a:close/>
                <a:moveTo>
                  <a:pt x="3562" y="1369"/>
                </a:moveTo>
                <a:lnTo>
                  <a:pt x="3602" y="1408"/>
                </a:lnTo>
                <a:lnTo>
                  <a:pt x="3380" y="1631"/>
                </a:lnTo>
                <a:cubicBezTo>
                  <a:pt x="3369" y="1621"/>
                  <a:pt x="3362" y="1610"/>
                  <a:pt x="3356" y="1597"/>
                </a:cubicBezTo>
                <a:cubicBezTo>
                  <a:pt x="3346" y="1576"/>
                  <a:pt x="3341" y="1552"/>
                  <a:pt x="3338" y="1525"/>
                </a:cubicBezTo>
                <a:cubicBezTo>
                  <a:pt x="3336" y="1498"/>
                  <a:pt x="3337" y="1463"/>
                  <a:pt x="3341" y="1420"/>
                </a:cubicBezTo>
                <a:cubicBezTo>
                  <a:pt x="3348" y="1354"/>
                  <a:pt x="3349" y="1306"/>
                  <a:pt x="3344" y="1275"/>
                </a:cubicBezTo>
                <a:cubicBezTo>
                  <a:pt x="3340" y="1245"/>
                  <a:pt x="3330" y="1222"/>
                  <a:pt x="3314" y="1206"/>
                </a:cubicBezTo>
                <a:cubicBezTo>
                  <a:pt x="3298" y="1190"/>
                  <a:pt x="3278" y="1182"/>
                  <a:pt x="3255" y="1182"/>
                </a:cubicBezTo>
                <a:cubicBezTo>
                  <a:pt x="3232" y="1183"/>
                  <a:pt x="3211" y="1193"/>
                  <a:pt x="3192" y="1211"/>
                </a:cubicBezTo>
                <a:cubicBezTo>
                  <a:pt x="3173" y="1231"/>
                  <a:pt x="3163" y="1253"/>
                  <a:pt x="3163" y="1277"/>
                </a:cubicBezTo>
                <a:cubicBezTo>
                  <a:pt x="3163" y="1301"/>
                  <a:pt x="3173" y="1323"/>
                  <a:pt x="3194" y="1345"/>
                </a:cubicBezTo>
                <a:lnTo>
                  <a:pt x="3147" y="1383"/>
                </a:lnTo>
                <a:cubicBezTo>
                  <a:pt x="3119" y="1348"/>
                  <a:pt x="3105" y="1313"/>
                  <a:pt x="3108" y="1277"/>
                </a:cubicBezTo>
                <a:cubicBezTo>
                  <a:pt x="3110" y="1242"/>
                  <a:pt x="3127" y="1208"/>
                  <a:pt x="3159" y="1176"/>
                </a:cubicBezTo>
                <a:cubicBezTo>
                  <a:pt x="3191" y="1144"/>
                  <a:pt x="3226" y="1127"/>
                  <a:pt x="3263" y="1126"/>
                </a:cubicBezTo>
                <a:cubicBezTo>
                  <a:pt x="3299" y="1126"/>
                  <a:pt x="3331" y="1138"/>
                  <a:pt x="3357" y="1165"/>
                </a:cubicBezTo>
                <a:cubicBezTo>
                  <a:pt x="3371" y="1178"/>
                  <a:pt x="3381" y="1194"/>
                  <a:pt x="3389" y="1213"/>
                </a:cubicBezTo>
                <a:cubicBezTo>
                  <a:pt x="3396" y="1231"/>
                  <a:pt x="3401" y="1254"/>
                  <a:pt x="3402" y="1281"/>
                </a:cubicBezTo>
                <a:cubicBezTo>
                  <a:pt x="3404" y="1308"/>
                  <a:pt x="3402" y="1349"/>
                  <a:pt x="3398" y="1404"/>
                </a:cubicBezTo>
                <a:cubicBezTo>
                  <a:pt x="3394" y="1449"/>
                  <a:pt x="3392" y="1479"/>
                  <a:pt x="3392" y="1494"/>
                </a:cubicBezTo>
                <a:cubicBezTo>
                  <a:pt x="3393" y="1508"/>
                  <a:pt x="3394" y="1522"/>
                  <a:pt x="3397" y="1534"/>
                </a:cubicBezTo>
                <a:lnTo>
                  <a:pt x="3562" y="1369"/>
                </a:lnTo>
                <a:close/>
                <a:moveTo>
                  <a:pt x="3498" y="935"/>
                </a:moveTo>
                <a:lnTo>
                  <a:pt x="3451" y="887"/>
                </a:lnTo>
                <a:lnTo>
                  <a:pt x="3492" y="846"/>
                </a:lnTo>
                <a:lnTo>
                  <a:pt x="3540" y="893"/>
                </a:lnTo>
                <a:lnTo>
                  <a:pt x="3498" y="935"/>
                </a:lnTo>
                <a:close/>
                <a:moveTo>
                  <a:pt x="3787" y="1223"/>
                </a:moveTo>
                <a:lnTo>
                  <a:pt x="3544" y="980"/>
                </a:lnTo>
                <a:lnTo>
                  <a:pt x="3585" y="939"/>
                </a:lnTo>
                <a:lnTo>
                  <a:pt x="3828" y="1182"/>
                </a:lnTo>
                <a:lnTo>
                  <a:pt x="3787" y="1223"/>
                </a:lnTo>
                <a:close/>
                <a:moveTo>
                  <a:pt x="3900" y="1111"/>
                </a:moveTo>
                <a:lnTo>
                  <a:pt x="3563" y="775"/>
                </a:lnTo>
                <a:lnTo>
                  <a:pt x="3690" y="648"/>
                </a:lnTo>
                <a:cubicBezTo>
                  <a:pt x="3713" y="626"/>
                  <a:pt x="3731" y="610"/>
                  <a:pt x="3745" y="600"/>
                </a:cubicBezTo>
                <a:cubicBezTo>
                  <a:pt x="3764" y="586"/>
                  <a:pt x="3783" y="578"/>
                  <a:pt x="3802" y="574"/>
                </a:cubicBezTo>
                <a:cubicBezTo>
                  <a:pt x="3821" y="571"/>
                  <a:pt x="3840" y="573"/>
                  <a:pt x="3861" y="580"/>
                </a:cubicBezTo>
                <a:cubicBezTo>
                  <a:pt x="3882" y="587"/>
                  <a:pt x="3901" y="599"/>
                  <a:pt x="3917" y="615"/>
                </a:cubicBezTo>
                <a:cubicBezTo>
                  <a:pt x="3946" y="644"/>
                  <a:pt x="3961" y="677"/>
                  <a:pt x="3962" y="715"/>
                </a:cubicBezTo>
                <a:cubicBezTo>
                  <a:pt x="3964" y="753"/>
                  <a:pt x="3941" y="796"/>
                  <a:pt x="3894" y="844"/>
                </a:cubicBezTo>
                <a:lnTo>
                  <a:pt x="3807" y="930"/>
                </a:lnTo>
                <a:lnTo>
                  <a:pt x="3944" y="1066"/>
                </a:lnTo>
                <a:lnTo>
                  <a:pt x="3900" y="1111"/>
                </a:lnTo>
                <a:close/>
                <a:moveTo>
                  <a:pt x="3768" y="890"/>
                </a:moveTo>
                <a:lnTo>
                  <a:pt x="3855" y="803"/>
                </a:lnTo>
                <a:cubicBezTo>
                  <a:pt x="3883" y="774"/>
                  <a:pt x="3898" y="749"/>
                  <a:pt x="3900" y="726"/>
                </a:cubicBezTo>
                <a:cubicBezTo>
                  <a:pt x="3901" y="703"/>
                  <a:pt x="3892" y="682"/>
                  <a:pt x="3873" y="663"/>
                </a:cubicBezTo>
                <a:cubicBezTo>
                  <a:pt x="3859" y="649"/>
                  <a:pt x="3843" y="640"/>
                  <a:pt x="3826" y="637"/>
                </a:cubicBezTo>
                <a:cubicBezTo>
                  <a:pt x="3809" y="634"/>
                  <a:pt x="3793" y="637"/>
                  <a:pt x="3778" y="645"/>
                </a:cubicBezTo>
                <a:cubicBezTo>
                  <a:pt x="3769" y="651"/>
                  <a:pt x="3754" y="664"/>
                  <a:pt x="3734" y="684"/>
                </a:cubicBezTo>
                <a:lnTo>
                  <a:pt x="3648" y="770"/>
                </a:lnTo>
                <a:lnTo>
                  <a:pt x="3768" y="890"/>
                </a:lnTo>
                <a:close/>
                <a:moveTo>
                  <a:pt x="4088" y="707"/>
                </a:moveTo>
                <a:lnTo>
                  <a:pt x="4126" y="661"/>
                </a:lnTo>
                <a:cubicBezTo>
                  <a:pt x="4145" y="676"/>
                  <a:pt x="4163" y="685"/>
                  <a:pt x="4181" y="689"/>
                </a:cubicBezTo>
                <a:cubicBezTo>
                  <a:pt x="4199" y="692"/>
                  <a:pt x="4219" y="690"/>
                  <a:pt x="4241" y="681"/>
                </a:cubicBezTo>
                <a:cubicBezTo>
                  <a:pt x="4263" y="672"/>
                  <a:pt x="4283" y="659"/>
                  <a:pt x="4303" y="639"/>
                </a:cubicBezTo>
                <a:cubicBezTo>
                  <a:pt x="4320" y="622"/>
                  <a:pt x="4332" y="605"/>
                  <a:pt x="4340" y="587"/>
                </a:cubicBezTo>
                <a:cubicBezTo>
                  <a:pt x="4348" y="569"/>
                  <a:pt x="4351" y="552"/>
                  <a:pt x="4348" y="537"/>
                </a:cubicBezTo>
                <a:cubicBezTo>
                  <a:pt x="4346" y="522"/>
                  <a:pt x="4339" y="509"/>
                  <a:pt x="4329" y="499"/>
                </a:cubicBezTo>
                <a:cubicBezTo>
                  <a:pt x="4318" y="488"/>
                  <a:pt x="4306" y="482"/>
                  <a:pt x="4292" y="480"/>
                </a:cubicBezTo>
                <a:cubicBezTo>
                  <a:pt x="4278" y="479"/>
                  <a:pt x="4261" y="482"/>
                  <a:pt x="4242" y="491"/>
                </a:cubicBezTo>
                <a:cubicBezTo>
                  <a:pt x="4230" y="496"/>
                  <a:pt x="4204" y="511"/>
                  <a:pt x="4166" y="534"/>
                </a:cubicBezTo>
                <a:cubicBezTo>
                  <a:pt x="4128" y="558"/>
                  <a:pt x="4099" y="572"/>
                  <a:pt x="4080" y="578"/>
                </a:cubicBezTo>
                <a:cubicBezTo>
                  <a:pt x="4056" y="586"/>
                  <a:pt x="4033" y="587"/>
                  <a:pt x="4013" y="583"/>
                </a:cubicBezTo>
                <a:cubicBezTo>
                  <a:pt x="3992" y="578"/>
                  <a:pt x="3975" y="568"/>
                  <a:pt x="3959" y="553"/>
                </a:cubicBezTo>
                <a:cubicBezTo>
                  <a:pt x="3942" y="536"/>
                  <a:pt x="3931" y="515"/>
                  <a:pt x="3926" y="491"/>
                </a:cubicBezTo>
                <a:cubicBezTo>
                  <a:pt x="3921" y="466"/>
                  <a:pt x="3924" y="441"/>
                  <a:pt x="3935" y="415"/>
                </a:cubicBezTo>
                <a:cubicBezTo>
                  <a:pt x="3945" y="389"/>
                  <a:pt x="3962" y="364"/>
                  <a:pt x="3985" y="342"/>
                </a:cubicBezTo>
                <a:cubicBezTo>
                  <a:pt x="4010" y="317"/>
                  <a:pt x="4036" y="299"/>
                  <a:pt x="4063" y="288"/>
                </a:cubicBezTo>
                <a:cubicBezTo>
                  <a:pt x="4090" y="277"/>
                  <a:pt x="4116" y="274"/>
                  <a:pt x="4142" y="280"/>
                </a:cubicBezTo>
                <a:cubicBezTo>
                  <a:pt x="4168" y="285"/>
                  <a:pt x="4191" y="297"/>
                  <a:pt x="4212" y="316"/>
                </a:cubicBezTo>
                <a:lnTo>
                  <a:pt x="4172" y="362"/>
                </a:lnTo>
                <a:cubicBezTo>
                  <a:pt x="4149" y="343"/>
                  <a:pt x="4125" y="335"/>
                  <a:pt x="4101" y="337"/>
                </a:cubicBezTo>
                <a:cubicBezTo>
                  <a:pt x="4077" y="339"/>
                  <a:pt x="4052" y="353"/>
                  <a:pt x="4026" y="379"/>
                </a:cubicBezTo>
                <a:cubicBezTo>
                  <a:pt x="3999" y="406"/>
                  <a:pt x="3984" y="431"/>
                  <a:pt x="3982" y="453"/>
                </a:cubicBezTo>
                <a:cubicBezTo>
                  <a:pt x="3979" y="475"/>
                  <a:pt x="3985" y="493"/>
                  <a:pt x="3999" y="507"/>
                </a:cubicBezTo>
                <a:cubicBezTo>
                  <a:pt x="4011" y="519"/>
                  <a:pt x="4025" y="525"/>
                  <a:pt x="4042" y="524"/>
                </a:cubicBezTo>
                <a:cubicBezTo>
                  <a:pt x="4058" y="523"/>
                  <a:pt x="4089" y="509"/>
                  <a:pt x="4133" y="481"/>
                </a:cubicBezTo>
                <a:cubicBezTo>
                  <a:pt x="4177" y="453"/>
                  <a:pt x="4209" y="435"/>
                  <a:pt x="4229" y="428"/>
                </a:cubicBezTo>
                <a:cubicBezTo>
                  <a:pt x="4257" y="417"/>
                  <a:pt x="4283" y="414"/>
                  <a:pt x="4306" y="419"/>
                </a:cubicBezTo>
                <a:cubicBezTo>
                  <a:pt x="4330" y="423"/>
                  <a:pt x="4350" y="434"/>
                  <a:pt x="4368" y="452"/>
                </a:cubicBezTo>
                <a:cubicBezTo>
                  <a:pt x="4386" y="470"/>
                  <a:pt x="4398" y="492"/>
                  <a:pt x="4403" y="518"/>
                </a:cubicBezTo>
                <a:cubicBezTo>
                  <a:pt x="4409" y="544"/>
                  <a:pt x="4407" y="571"/>
                  <a:pt x="4396" y="599"/>
                </a:cubicBezTo>
                <a:cubicBezTo>
                  <a:pt x="4386" y="627"/>
                  <a:pt x="4369" y="653"/>
                  <a:pt x="4345" y="677"/>
                </a:cubicBezTo>
                <a:cubicBezTo>
                  <a:pt x="4314" y="708"/>
                  <a:pt x="4284" y="729"/>
                  <a:pt x="4255" y="740"/>
                </a:cubicBezTo>
                <a:cubicBezTo>
                  <a:pt x="4225" y="752"/>
                  <a:pt x="4196" y="755"/>
                  <a:pt x="4166" y="749"/>
                </a:cubicBezTo>
                <a:cubicBezTo>
                  <a:pt x="4137" y="743"/>
                  <a:pt x="4111" y="729"/>
                  <a:pt x="4088" y="707"/>
                </a:cubicBezTo>
                <a:close/>
                <a:moveTo>
                  <a:pt x="4688" y="243"/>
                </a:moveTo>
                <a:lnTo>
                  <a:pt x="4728" y="283"/>
                </a:lnTo>
                <a:lnTo>
                  <a:pt x="4505" y="505"/>
                </a:lnTo>
                <a:cubicBezTo>
                  <a:pt x="4495" y="495"/>
                  <a:pt x="4487" y="484"/>
                  <a:pt x="4482" y="471"/>
                </a:cubicBezTo>
                <a:cubicBezTo>
                  <a:pt x="4472" y="451"/>
                  <a:pt x="4466" y="427"/>
                  <a:pt x="4464" y="400"/>
                </a:cubicBezTo>
                <a:cubicBezTo>
                  <a:pt x="4462" y="372"/>
                  <a:pt x="4463" y="337"/>
                  <a:pt x="4467" y="295"/>
                </a:cubicBezTo>
                <a:cubicBezTo>
                  <a:pt x="4474" y="228"/>
                  <a:pt x="4475" y="180"/>
                  <a:pt x="4470" y="149"/>
                </a:cubicBezTo>
                <a:cubicBezTo>
                  <a:pt x="4465" y="119"/>
                  <a:pt x="4455" y="96"/>
                  <a:pt x="4440" y="81"/>
                </a:cubicBezTo>
                <a:cubicBezTo>
                  <a:pt x="4423" y="64"/>
                  <a:pt x="4404" y="56"/>
                  <a:pt x="4381" y="57"/>
                </a:cubicBezTo>
                <a:cubicBezTo>
                  <a:pt x="4358" y="57"/>
                  <a:pt x="4337" y="67"/>
                  <a:pt x="4318" y="86"/>
                </a:cubicBezTo>
                <a:cubicBezTo>
                  <a:pt x="4298" y="105"/>
                  <a:pt x="4288" y="127"/>
                  <a:pt x="4288" y="151"/>
                </a:cubicBezTo>
                <a:cubicBezTo>
                  <a:pt x="4288" y="175"/>
                  <a:pt x="4299" y="198"/>
                  <a:pt x="4320" y="219"/>
                </a:cubicBezTo>
                <a:lnTo>
                  <a:pt x="4273" y="257"/>
                </a:lnTo>
                <a:cubicBezTo>
                  <a:pt x="4244" y="222"/>
                  <a:pt x="4231" y="187"/>
                  <a:pt x="4233" y="152"/>
                </a:cubicBezTo>
                <a:cubicBezTo>
                  <a:pt x="4236" y="116"/>
                  <a:pt x="4253" y="82"/>
                  <a:pt x="4285" y="51"/>
                </a:cubicBezTo>
                <a:cubicBezTo>
                  <a:pt x="4317" y="18"/>
                  <a:pt x="4352" y="2"/>
                  <a:pt x="4388" y="1"/>
                </a:cubicBezTo>
                <a:cubicBezTo>
                  <a:pt x="4425" y="0"/>
                  <a:pt x="4457" y="13"/>
                  <a:pt x="4483" y="39"/>
                </a:cubicBezTo>
                <a:cubicBezTo>
                  <a:pt x="4496" y="53"/>
                  <a:pt x="4507" y="68"/>
                  <a:pt x="4514" y="87"/>
                </a:cubicBezTo>
                <a:cubicBezTo>
                  <a:pt x="4522" y="105"/>
                  <a:pt x="4526" y="128"/>
                  <a:pt x="4528" y="155"/>
                </a:cubicBezTo>
                <a:cubicBezTo>
                  <a:pt x="4530" y="183"/>
                  <a:pt x="4528" y="223"/>
                  <a:pt x="4524" y="278"/>
                </a:cubicBezTo>
                <a:cubicBezTo>
                  <a:pt x="4520" y="324"/>
                  <a:pt x="4518" y="354"/>
                  <a:pt x="4518" y="368"/>
                </a:cubicBezTo>
                <a:cubicBezTo>
                  <a:pt x="4519" y="383"/>
                  <a:pt x="4520" y="396"/>
                  <a:pt x="4523" y="408"/>
                </a:cubicBezTo>
                <a:lnTo>
                  <a:pt x="4688" y="243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4" name="Freeform 80"/>
          <p:cNvSpPr>
            <a:spLocks noEditPoints="1"/>
          </p:cNvSpPr>
          <p:nvPr/>
        </p:nvSpPr>
        <p:spPr bwMode="auto">
          <a:xfrm>
            <a:off x="6278705" y="5034102"/>
            <a:ext cx="781050" cy="771525"/>
          </a:xfrm>
          <a:custGeom>
            <a:avLst/>
            <a:gdLst>
              <a:gd name="T0" fmla="*/ 119 w 2050"/>
              <a:gd name="T1" fmla="*/ 1755 h 2023"/>
              <a:gd name="T2" fmla="*/ 122 w 2050"/>
              <a:gd name="T3" fmla="*/ 1933 h 2023"/>
              <a:gd name="T4" fmla="*/ 168 w 2050"/>
              <a:gd name="T5" fmla="*/ 1831 h 2023"/>
              <a:gd name="T6" fmla="*/ 42 w 2050"/>
              <a:gd name="T7" fmla="*/ 1853 h 2023"/>
              <a:gd name="T8" fmla="*/ 257 w 2050"/>
              <a:gd name="T9" fmla="*/ 1609 h 2023"/>
              <a:gd name="T10" fmla="*/ 370 w 2050"/>
              <a:gd name="T11" fmla="*/ 1673 h 2023"/>
              <a:gd name="T12" fmla="*/ 390 w 2050"/>
              <a:gd name="T13" fmla="*/ 1802 h 2023"/>
              <a:gd name="T14" fmla="*/ 310 w 2050"/>
              <a:gd name="T15" fmla="*/ 1666 h 2023"/>
              <a:gd name="T16" fmla="*/ 200 w 2050"/>
              <a:gd name="T17" fmla="*/ 1695 h 2023"/>
              <a:gd name="T18" fmla="*/ 392 w 2050"/>
              <a:gd name="T19" fmla="*/ 1749 h 2023"/>
              <a:gd name="T20" fmla="*/ 309 w 2050"/>
              <a:gd name="T21" fmla="*/ 1727 h 2023"/>
              <a:gd name="T22" fmla="*/ 372 w 2050"/>
              <a:gd name="T23" fmla="*/ 1483 h 2023"/>
              <a:gd name="T24" fmla="*/ 566 w 2050"/>
              <a:gd name="T25" fmla="*/ 1524 h 2023"/>
              <a:gd name="T26" fmla="*/ 482 w 2050"/>
              <a:gd name="T27" fmla="*/ 1709 h 2023"/>
              <a:gd name="T28" fmla="*/ 541 w 2050"/>
              <a:gd name="T29" fmla="*/ 1545 h 2023"/>
              <a:gd name="T30" fmla="*/ 356 w 2050"/>
              <a:gd name="T31" fmla="*/ 1539 h 2023"/>
              <a:gd name="T32" fmla="*/ 814 w 2050"/>
              <a:gd name="T33" fmla="*/ 1471 h 2023"/>
              <a:gd name="T34" fmla="*/ 707 w 2050"/>
              <a:gd name="T35" fmla="*/ 1151 h 2023"/>
              <a:gd name="T36" fmla="*/ 782 w 2050"/>
              <a:gd name="T37" fmla="*/ 1273 h 2023"/>
              <a:gd name="T38" fmla="*/ 762 w 2050"/>
              <a:gd name="T39" fmla="*/ 1253 h 2023"/>
              <a:gd name="T40" fmla="*/ 702 w 2050"/>
              <a:gd name="T41" fmla="*/ 1193 h 2023"/>
              <a:gd name="T42" fmla="*/ 894 w 2050"/>
              <a:gd name="T43" fmla="*/ 961 h 2023"/>
              <a:gd name="T44" fmla="*/ 979 w 2050"/>
              <a:gd name="T45" fmla="*/ 1059 h 2023"/>
              <a:gd name="T46" fmla="*/ 941 w 2050"/>
              <a:gd name="T47" fmla="*/ 1251 h 2023"/>
              <a:gd name="T48" fmla="*/ 1021 w 2050"/>
              <a:gd name="T49" fmla="*/ 920 h 2023"/>
              <a:gd name="T50" fmla="*/ 1083 w 2050"/>
              <a:gd name="T51" fmla="*/ 931 h 2023"/>
              <a:gd name="T52" fmla="*/ 1092 w 2050"/>
              <a:gd name="T53" fmla="*/ 982 h 2023"/>
              <a:gd name="T54" fmla="*/ 1171 w 2050"/>
              <a:gd name="T55" fmla="*/ 757 h 2023"/>
              <a:gd name="T56" fmla="*/ 1142 w 2050"/>
              <a:gd name="T57" fmla="*/ 712 h 2023"/>
              <a:gd name="T58" fmla="*/ 1244 w 2050"/>
              <a:gd name="T59" fmla="*/ 629 h 2023"/>
              <a:gd name="T60" fmla="*/ 1406 w 2050"/>
              <a:gd name="T61" fmla="*/ 620 h 2023"/>
              <a:gd name="T62" fmla="*/ 1296 w 2050"/>
              <a:gd name="T63" fmla="*/ 730 h 2023"/>
              <a:gd name="T64" fmla="*/ 1384 w 2050"/>
              <a:gd name="T65" fmla="*/ 641 h 2023"/>
              <a:gd name="T66" fmla="*/ 1436 w 2050"/>
              <a:gd name="T67" fmla="*/ 467 h 2023"/>
              <a:gd name="T68" fmla="*/ 1580 w 2050"/>
              <a:gd name="T69" fmla="*/ 612 h 2023"/>
              <a:gd name="T70" fmla="*/ 1636 w 2050"/>
              <a:gd name="T71" fmla="*/ 555 h 2023"/>
              <a:gd name="T72" fmla="*/ 1617 w 2050"/>
              <a:gd name="T73" fmla="*/ 290 h 2023"/>
              <a:gd name="T74" fmla="*/ 1658 w 2050"/>
              <a:gd name="T75" fmla="*/ 533 h 2023"/>
              <a:gd name="T76" fmla="*/ 1623 w 2050"/>
              <a:gd name="T77" fmla="*/ 331 h 2023"/>
              <a:gd name="T78" fmla="*/ 1570 w 2050"/>
              <a:gd name="T79" fmla="*/ 445 h 2023"/>
              <a:gd name="T80" fmla="*/ 1838 w 2050"/>
              <a:gd name="T81" fmla="*/ 320 h 2023"/>
              <a:gd name="T82" fmla="*/ 1807 w 2050"/>
              <a:gd name="T83" fmla="*/ 245 h 2023"/>
              <a:gd name="T84" fmla="*/ 1649 w 2050"/>
              <a:gd name="T85" fmla="*/ 245 h 2023"/>
              <a:gd name="T86" fmla="*/ 1792 w 2050"/>
              <a:gd name="T87" fmla="*/ 158 h 2023"/>
              <a:gd name="T88" fmla="*/ 1686 w 2050"/>
              <a:gd name="T89" fmla="*/ 253 h 2023"/>
              <a:gd name="T90" fmla="*/ 1870 w 2050"/>
              <a:gd name="T91" fmla="*/ 226 h 2023"/>
              <a:gd name="T92" fmla="*/ 1770 w 2050"/>
              <a:gd name="T93" fmla="*/ 374 h 2023"/>
              <a:gd name="T94" fmla="*/ 1927 w 2050"/>
              <a:gd name="T95" fmla="*/ 236 h 2023"/>
              <a:gd name="T96" fmla="*/ 1877 w 2050"/>
              <a:gd name="T97" fmla="*/ 28 h 2023"/>
              <a:gd name="T98" fmla="*/ 1803 w 2050"/>
              <a:gd name="T99" fmla="*/ 76 h 2023"/>
              <a:gd name="T100" fmla="*/ 1950 w 2050"/>
              <a:gd name="T101" fmla="*/ 78 h 202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</a:cxnLst>
            <a:rect l="0" t="0" r="r" b="b"/>
            <a:pathLst>
              <a:path w="2050" h="2023">
                <a:moveTo>
                  <a:pt x="168" y="2023"/>
                </a:moveTo>
                <a:lnTo>
                  <a:pt x="0" y="1855"/>
                </a:lnTo>
                <a:lnTo>
                  <a:pt x="63" y="1792"/>
                </a:lnTo>
                <a:cubicBezTo>
                  <a:pt x="75" y="1781"/>
                  <a:pt x="84" y="1773"/>
                  <a:pt x="91" y="1768"/>
                </a:cubicBezTo>
                <a:cubicBezTo>
                  <a:pt x="100" y="1761"/>
                  <a:pt x="110" y="1757"/>
                  <a:pt x="119" y="1755"/>
                </a:cubicBezTo>
                <a:cubicBezTo>
                  <a:pt x="129" y="1753"/>
                  <a:pt x="139" y="1754"/>
                  <a:pt x="149" y="1758"/>
                </a:cubicBezTo>
                <a:cubicBezTo>
                  <a:pt x="159" y="1761"/>
                  <a:pt x="169" y="1767"/>
                  <a:pt x="177" y="1776"/>
                </a:cubicBezTo>
                <a:cubicBezTo>
                  <a:pt x="191" y="1790"/>
                  <a:pt x="199" y="1807"/>
                  <a:pt x="200" y="1826"/>
                </a:cubicBezTo>
                <a:cubicBezTo>
                  <a:pt x="200" y="1845"/>
                  <a:pt x="189" y="1866"/>
                  <a:pt x="165" y="1890"/>
                </a:cubicBezTo>
                <a:lnTo>
                  <a:pt x="122" y="1933"/>
                </a:lnTo>
                <a:lnTo>
                  <a:pt x="190" y="2001"/>
                </a:lnTo>
                <a:lnTo>
                  <a:pt x="168" y="2023"/>
                </a:lnTo>
                <a:close/>
                <a:moveTo>
                  <a:pt x="102" y="1913"/>
                </a:moveTo>
                <a:lnTo>
                  <a:pt x="146" y="1870"/>
                </a:lnTo>
                <a:cubicBezTo>
                  <a:pt x="160" y="1855"/>
                  <a:pt x="168" y="1842"/>
                  <a:pt x="168" y="1831"/>
                </a:cubicBezTo>
                <a:cubicBezTo>
                  <a:pt x="169" y="1820"/>
                  <a:pt x="164" y="1809"/>
                  <a:pt x="155" y="1799"/>
                </a:cubicBezTo>
                <a:cubicBezTo>
                  <a:pt x="148" y="1792"/>
                  <a:pt x="140" y="1788"/>
                  <a:pt x="131" y="1787"/>
                </a:cubicBezTo>
                <a:cubicBezTo>
                  <a:pt x="123" y="1785"/>
                  <a:pt x="115" y="1786"/>
                  <a:pt x="107" y="1791"/>
                </a:cubicBezTo>
                <a:cubicBezTo>
                  <a:pt x="103" y="1793"/>
                  <a:pt x="95" y="1800"/>
                  <a:pt x="85" y="1810"/>
                </a:cubicBezTo>
                <a:lnTo>
                  <a:pt x="42" y="1853"/>
                </a:lnTo>
                <a:lnTo>
                  <a:pt x="102" y="1913"/>
                </a:lnTo>
                <a:close/>
                <a:moveTo>
                  <a:pt x="326" y="1866"/>
                </a:moveTo>
                <a:lnTo>
                  <a:pt x="158" y="1698"/>
                </a:lnTo>
                <a:lnTo>
                  <a:pt x="221" y="1635"/>
                </a:lnTo>
                <a:cubicBezTo>
                  <a:pt x="233" y="1622"/>
                  <a:pt x="245" y="1613"/>
                  <a:pt x="257" y="1609"/>
                </a:cubicBezTo>
                <a:cubicBezTo>
                  <a:pt x="268" y="1605"/>
                  <a:pt x="279" y="1604"/>
                  <a:pt x="291" y="1606"/>
                </a:cubicBezTo>
                <a:cubicBezTo>
                  <a:pt x="302" y="1609"/>
                  <a:pt x="312" y="1614"/>
                  <a:pt x="319" y="1622"/>
                </a:cubicBezTo>
                <a:cubicBezTo>
                  <a:pt x="326" y="1629"/>
                  <a:pt x="331" y="1638"/>
                  <a:pt x="334" y="1648"/>
                </a:cubicBezTo>
                <a:cubicBezTo>
                  <a:pt x="336" y="1658"/>
                  <a:pt x="335" y="1669"/>
                  <a:pt x="331" y="1681"/>
                </a:cubicBezTo>
                <a:cubicBezTo>
                  <a:pt x="345" y="1674"/>
                  <a:pt x="357" y="1671"/>
                  <a:pt x="370" y="1673"/>
                </a:cubicBezTo>
                <a:cubicBezTo>
                  <a:pt x="383" y="1675"/>
                  <a:pt x="394" y="1680"/>
                  <a:pt x="404" y="1690"/>
                </a:cubicBezTo>
                <a:cubicBezTo>
                  <a:pt x="412" y="1698"/>
                  <a:pt x="417" y="1707"/>
                  <a:pt x="421" y="1717"/>
                </a:cubicBezTo>
                <a:cubicBezTo>
                  <a:pt x="424" y="1727"/>
                  <a:pt x="425" y="1737"/>
                  <a:pt x="424" y="1745"/>
                </a:cubicBezTo>
                <a:cubicBezTo>
                  <a:pt x="423" y="1754"/>
                  <a:pt x="419" y="1763"/>
                  <a:pt x="414" y="1772"/>
                </a:cubicBezTo>
                <a:cubicBezTo>
                  <a:pt x="408" y="1781"/>
                  <a:pt x="400" y="1791"/>
                  <a:pt x="390" y="1802"/>
                </a:cubicBezTo>
                <a:lnTo>
                  <a:pt x="326" y="1866"/>
                </a:lnTo>
                <a:close/>
                <a:moveTo>
                  <a:pt x="250" y="1746"/>
                </a:moveTo>
                <a:lnTo>
                  <a:pt x="287" y="1710"/>
                </a:lnTo>
                <a:cubicBezTo>
                  <a:pt x="297" y="1700"/>
                  <a:pt x="303" y="1692"/>
                  <a:pt x="306" y="1687"/>
                </a:cubicBezTo>
                <a:cubicBezTo>
                  <a:pt x="310" y="1679"/>
                  <a:pt x="311" y="1672"/>
                  <a:pt x="310" y="1666"/>
                </a:cubicBezTo>
                <a:cubicBezTo>
                  <a:pt x="309" y="1659"/>
                  <a:pt x="306" y="1652"/>
                  <a:pt x="300" y="1647"/>
                </a:cubicBezTo>
                <a:cubicBezTo>
                  <a:pt x="294" y="1641"/>
                  <a:pt x="288" y="1637"/>
                  <a:pt x="281" y="1636"/>
                </a:cubicBezTo>
                <a:cubicBezTo>
                  <a:pt x="274" y="1634"/>
                  <a:pt x="268" y="1635"/>
                  <a:pt x="261" y="1639"/>
                </a:cubicBezTo>
                <a:cubicBezTo>
                  <a:pt x="255" y="1642"/>
                  <a:pt x="245" y="1650"/>
                  <a:pt x="233" y="1662"/>
                </a:cubicBezTo>
                <a:lnTo>
                  <a:pt x="200" y="1695"/>
                </a:lnTo>
                <a:lnTo>
                  <a:pt x="250" y="1746"/>
                </a:lnTo>
                <a:close/>
                <a:moveTo>
                  <a:pt x="328" y="1824"/>
                </a:moveTo>
                <a:lnTo>
                  <a:pt x="370" y="1782"/>
                </a:lnTo>
                <a:cubicBezTo>
                  <a:pt x="377" y="1775"/>
                  <a:pt x="382" y="1769"/>
                  <a:pt x="384" y="1766"/>
                </a:cubicBezTo>
                <a:cubicBezTo>
                  <a:pt x="388" y="1760"/>
                  <a:pt x="391" y="1754"/>
                  <a:pt x="392" y="1749"/>
                </a:cubicBezTo>
                <a:cubicBezTo>
                  <a:pt x="394" y="1743"/>
                  <a:pt x="393" y="1737"/>
                  <a:pt x="392" y="1731"/>
                </a:cubicBezTo>
                <a:cubicBezTo>
                  <a:pt x="390" y="1724"/>
                  <a:pt x="386" y="1719"/>
                  <a:pt x="381" y="1713"/>
                </a:cubicBezTo>
                <a:cubicBezTo>
                  <a:pt x="374" y="1707"/>
                  <a:pt x="367" y="1703"/>
                  <a:pt x="360" y="1702"/>
                </a:cubicBezTo>
                <a:cubicBezTo>
                  <a:pt x="352" y="1700"/>
                  <a:pt x="344" y="1702"/>
                  <a:pt x="336" y="1705"/>
                </a:cubicBezTo>
                <a:cubicBezTo>
                  <a:pt x="329" y="1709"/>
                  <a:pt x="320" y="1716"/>
                  <a:pt x="309" y="1727"/>
                </a:cubicBezTo>
                <a:lnTo>
                  <a:pt x="270" y="1766"/>
                </a:lnTo>
                <a:lnTo>
                  <a:pt x="328" y="1824"/>
                </a:lnTo>
                <a:close/>
                <a:moveTo>
                  <a:pt x="482" y="1709"/>
                </a:moveTo>
                <a:lnTo>
                  <a:pt x="314" y="1541"/>
                </a:lnTo>
                <a:lnTo>
                  <a:pt x="372" y="1483"/>
                </a:lnTo>
                <a:cubicBezTo>
                  <a:pt x="385" y="1470"/>
                  <a:pt x="396" y="1461"/>
                  <a:pt x="404" y="1456"/>
                </a:cubicBezTo>
                <a:cubicBezTo>
                  <a:pt x="416" y="1449"/>
                  <a:pt x="428" y="1444"/>
                  <a:pt x="441" y="1443"/>
                </a:cubicBezTo>
                <a:cubicBezTo>
                  <a:pt x="457" y="1442"/>
                  <a:pt x="473" y="1445"/>
                  <a:pt x="490" y="1452"/>
                </a:cubicBezTo>
                <a:cubicBezTo>
                  <a:pt x="506" y="1459"/>
                  <a:pt x="521" y="1471"/>
                  <a:pt x="536" y="1486"/>
                </a:cubicBezTo>
                <a:cubicBezTo>
                  <a:pt x="549" y="1498"/>
                  <a:pt x="559" y="1511"/>
                  <a:pt x="566" y="1524"/>
                </a:cubicBezTo>
                <a:cubicBezTo>
                  <a:pt x="572" y="1537"/>
                  <a:pt x="577" y="1549"/>
                  <a:pt x="579" y="1560"/>
                </a:cubicBezTo>
                <a:cubicBezTo>
                  <a:pt x="580" y="1571"/>
                  <a:pt x="580" y="1581"/>
                  <a:pt x="578" y="1590"/>
                </a:cubicBezTo>
                <a:cubicBezTo>
                  <a:pt x="577" y="1600"/>
                  <a:pt x="573" y="1609"/>
                  <a:pt x="567" y="1619"/>
                </a:cubicBezTo>
                <a:cubicBezTo>
                  <a:pt x="561" y="1629"/>
                  <a:pt x="553" y="1639"/>
                  <a:pt x="543" y="1649"/>
                </a:cubicBezTo>
                <a:lnTo>
                  <a:pt x="482" y="1709"/>
                </a:lnTo>
                <a:close/>
                <a:moveTo>
                  <a:pt x="484" y="1667"/>
                </a:moveTo>
                <a:lnTo>
                  <a:pt x="520" y="1631"/>
                </a:lnTo>
                <a:cubicBezTo>
                  <a:pt x="531" y="1620"/>
                  <a:pt x="539" y="1611"/>
                  <a:pt x="543" y="1602"/>
                </a:cubicBezTo>
                <a:cubicBezTo>
                  <a:pt x="548" y="1594"/>
                  <a:pt x="550" y="1586"/>
                  <a:pt x="550" y="1579"/>
                </a:cubicBezTo>
                <a:cubicBezTo>
                  <a:pt x="550" y="1568"/>
                  <a:pt x="547" y="1557"/>
                  <a:pt x="541" y="1545"/>
                </a:cubicBezTo>
                <a:cubicBezTo>
                  <a:pt x="535" y="1533"/>
                  <a:pt x="525" y="1521"/>
                  <a:pt x="513" y="1508"/>
                </a:cubicBezTo>
                <a:cubicBezTo>
                  <a:pt x="495" y="1491"/>
                  <a:pt x="479" y="1480"/>
                  <a:pt x="464" y="1476"/>
                </a:cubicBezTo>
                <a:cubicBezTo>
                  <a:pt x="448" y="1473"/>
                  <a:pt x="435" y="1473"/>
                  <a:pt x="424" y="1478"/>
                </a:cubicBezTo>
                <a:cubicBezTo>
                  <a:pt x="415" y="1482"/>
                  <a:pt x="405" y="1490"/>
                  <a:pt x="391" y="1504"/>
                </a:cubicBezTo>
                <a:lnTo>
                  <a:pt x="356" y="1539"/>
                </a:lnTo>
                <a:lnTo>
                  <a:pt x="484" y="1667"/>
                </a:lnTo>
                <a:close/>
                <a:moveTo>
                  <a:pt x="677" y="1608"/>
                </a:moveTo>
                <a:lnTo>
                  <a:pt x="662" y="1593"/>
                </a:lnTo>
                <a:lnTo>
                  <a:pt x="799" y="1456"/>
                </a:lnTo>
                <a:lnTo>
                  <a:pt x="814" y="1471"/>
                </a:lnTo>
                <a:lnTo>
                  <a:pt x="677" y="1608"/>
                </a:lnTo>
                <a:close/>
                <a:moveTo>
                  <a:pt x="785" y="1407"/>
                </a:moveTo>
                <a:lnTo>
                  <a:pt x="617" y="1239"/>
                </a:lnTo>
                <a:lnTo>
                  <a:pt x="680" y="1175"/>
                </a:lnTo>
                <a:cubicBezTo>
                  <a:pt x="691" y="1164"/>
                  <a:pt x="700" y="1156"/>
                  <a:pt x="707" y="1151"/>
                </a:cubicBezTo>
                <a:cubicBezTo>
                  <a:pt x="717" y="1144"/>
                  <a:pt x="726" y="1140"/>
                  <a:pt x="736" y="1138"/>
                </a:cubicBezTo>
                <a:cubicBezTo>
                  <a:pt x="745" y="1137"/>
                  <a:pt x="755" y="1138"/>
                  <a:pt x="766" y="1141"/>
                </a:cubicBezTo>
                <a:cubicBezTo>
                  <a:pt x="776" y="1145"/>
                  <a:pt x="785" y="1151"/>
                  <a:pt x="794" y="1159"/>
                </a:cubicBezTo>
                <a:cubicBezTo>
                  <a:pt x="808" y="1173"/>
                  <a:pt x="815" y="1190"/>
                  <a:pt x="816" y="1209"/>
                </a:cubicBezTo>
                <a:cubicBezTo>
                  <a:pt x="817" y="1228"/>
                  <a:pt x="806" y="1249"/>
                  <a:pt x="782" y="1273"/>
                </a:cubicBezTo>
                <a:lnTo>
                  <a:pt x="739" y="1316"/>
                </a:lnTo>
                <a:lnTo>
                  <a:pt x="807" y="1385"/>
                </a:lnTo>
                <a:lnTo>
                  <a:pt x="785" y="1407"/>
                </a:lnTo>
                <a:close/>
                <a:moveTo>
                  <a:pt x="719" y="1296"/>
                </a:moveTo>
                <a:lnTo>
                  <a:pt x="762" y="1253"/>
                </a:lnTo>
                <a:cubicBezTo>
                  <a:pt x="777" y="1239"/>
                  <a:pt x="784" y="1226"/>
                  <a:pt x="785" y="1214"/>
                </a:cubicBezTo>
                <a:cubicBezTo>
                  <a:pt x="786" y="1203"/>
                  <a:pt x="781" y="1192"/>
                  <a:pt x="771" y="1183"/>
                </a:cubicBezTo>
                <a:cubicBezTo>
                  <a:pt x="764" y="1176"/>
                  <a:pt x="756" y="1171"/>
                  <a:pt x="748" y="1170"/>
                </a:cubicBezTo>
                <a:cubicBezTo>
                  <a:pt x="739" y="1168"/>
                  <a:pt x="731" y="1170"/>
                  <a:pt x="724" y="1174"/>
                </a:cubicBezTo>
                <a:cubicBezTo>
                  <a:pt x="719" y="1177"/>
                  <a:pt x="712" y="1183"/>
                  <a:pt x="702" y="1193"/>
                </a:cubicBezTo>
                <a:lnTo>
                  <a:pt x="659" y="1236"/>
                </a:lnTo>
                <a:lnTo>
                  <a:pt x="719" y="1296"/>
                </a:lnTo>
                <a:close/>
                <a:moveTo>
                  <a:pt x="941" y="1251"/>
                </a:moveTo>
                <a:lnTo>
                  <a:pt x="773" y="1083"/>
                </a:lnTo>
                <a:lnTo>
                  <a:pt x="894" y="961"/>
                </a:lnTo>
                <a:lnTo>
                  <a:pt x="914" y="981"/>
                </a:lnTo>
                <a:lnTo>
                  <a:pt x="815" y="1080"/>
                </a:lnTo>
                <a:lnTo>
                  <a:pt x="866" y="1132"/>
                </a:lnTo>
                <a:lnTo>
                  <a:pt x="959" y="1039"/>
                </a:lnTo>
                <a:lnTo>
                  <a:pt x="979" y="1059"/>
                </a:lnTo>
                <a:lnTo>
                  <a:pt x="886" y="1151"/>
                </a:lnTo>
                <a:lnTo>
                  <a:pt x="943" y="1209"/>
                </a:lnTo>
                <a:lnTo>
                  <a:pt x="1046" y="1106"/>
                </a:lnTo>
                <a:lnTo>
                  <a:pt x="1066" y="1125"/>
                </a:lnTo>
                <a:lnTo>
                  <a:pt x="941" y="1251"/>
                </a:lnTo>
                <a:close/>
                <a:moveTo>
                  <a:pt x="1082" y="1110"/>
                </a:moveTo>
                <a:lnTo>
                  <a:pt x="1059" y="957"/>
                </a:lnTo>
                <a:lnTo>
                  <a:pt x="921" y="934"/>
                </a:lnTo>
                <a:lnTo>
                  <a:pt x="948" y="908"/>
                </a:lnTo>
                <a:lnTo>
                  <a:pt x="1021" y="920"/>
                </a:lnTo>
                <a:cubicBezTo>
                  <a:pt x="1037" y="923"/>
                  <a:pt x="1048" y="925"/>
                  <a:pt x="1055" y="927"/>
                </a:cubicBezTo>
                <a:cubicBezTo>
                  <a:pt x="1053" y="918"/>
                  <a:pt x="1051" y="907"/>
                  <a:pt x="1050" y="895"/>
                </a:cubicBezTo>
                <a:lnTo>
                  <a:pt x="1039" y="817"/>
                </a:lnTo>
                <a:lnTo>
                  <a:pt x="1063" y="792"/>
                </a:lnTo>
                <a:lnTo>
                  <a:pt x="1083" y="931"/>
                </a:lnTo>
                <a:lnTo>
                  <a:pt x="1236" y="956"/>
                </a:lnTo>
                <a:lnTo>
                  <a:pt x="1208" y="983"/>
                </a:lnTo>
                <a:lnTo>
                  <a:pt x="1106" y="966"/>
                </a:lnTo>
                <a:cubicBezTo>
                  <a:pt x="1100" y="965"/>
                  <a:pt x="1094" y="963"/>
                  <a:pt x="1087" y="962"/>
                </a:cubicBezTo>
                <a:cubicBezTo>
                  <a:pt x="1090" y="972"/>
                  <a:pt x="1091" y="979"/>
                  <a:pt x="1092" y="982"/>
                </a:cubicBezTo>
                <a:lnTo>
                  <a:pt x="1108" y="1083"/>
                </a:lnTo>
                <a:lnTo>
                  <a:pt x="1082" y="1110"/>
                </a:lnTo>
                <a:close/>
                <a:moveTo>
                  <a:pt x="1324" y="868"/>
                </a:moveTo>
                <a:lnTo>
                  <a:pt x="1303" y="889"/>
                </a:lnTo>
                <a:lnTo>
                  <a:pt x="1171" y="757"/>
                </a:lnTo>
                <a:cubicBezTo>
                  <a:pt x="1171" y="767"/>
                  <a:pt x="1169" y="778"/>
                  <a:pt x="1166" y="791"/>
                </a:cubicBezTo>
                <a:cubicBezTo>
                  <a:pt x="1163" y="804"/>
                  <a:pt x="1159" y="814"/>
                  <a:pt x="1155" y="823"/>
                </a:cubicBezTo>
                <a:lnTo>
                  <a:pt x="1135" y="803"/>
                </a:lnTo>
                <a:cubicBezTo>
                  <a:pt x="1141" y="786"/>
                  <a:pt x="1145" y="770"/>
                  <a:pt x="1146" y="753"/>
                </a:cubicBezTo>
                <a:cubicBezTo>
                  <a:pt x="1147" y="737"/>
                  <a:pt x="1145" y="723"/>
                  <a:pt x="1142" y="712"/>
                </a:cubicBezTo>
                <a:lnTo>
                  <a:pt x="1155" y="699"/>
                </a:lnTo>
                <a:lnTo>
                  <a:pt x="1324" y="868"/>
                </a:lnTo>
                <a:close/>
                <a:moveTo>
                  <a:pt x="1296" y="730"/>
                </a:moveTo>
                <a:cubicBezTo>
                  <a:pt x="1276" y="710"/>
                  <a:pt x="1262" y="692"/>
                  <a:pt x="1254" y="676"/>
                </a:cubicBezTo>
                <a:cubicBezTo>
                  <a:pt x="1246" y="659"/>
                  <a:pt x="1243" y="644"/>
                  <a:pt x="1244" y="629"/>
                </a:cubicBezTo>
                <a:cubicBezTo>
                  <a:pt x="1246" y="615"/>
                  <a:pt x="1253" y="601"/>
                  <a:pt x="1265" y="589"/>
                </a:cubicBezTo>
                <a:cubicBezTo>
                  <a:pt x="1274" y="580"/>
                  <a:pt x="1284" y="574"/>
                  <a:pt x="1294" y="571"/>
                </a:cubicBezTo>
                <a:cubicBezTo>
                  <a:pt x="1304" y="568"/>
                  <a:pt x="1315" y="567"/>
                  <a:pt x="1327" y="570"/>
                </a:cubicBezTo>
                <a:cubicBezTo>
                  <a:pt x="1338" y="572"/>
                  <a:pt x="1350" y="577"/>
                  <a:pt x="1362" y="584"/>
                </a:cubicBezTo>
                <a:cubicBezTo>
                  <a:pt x="1374" y="592"/>
                  <a:pt x="1389" y="604"/>
                  <a:pt x="1406" y="620"/>
                </a:cubicBezTo>
                <a:cubicBezTo>
                  <a:pt x="1425" y="640"/>
                  <a:pt x="1439" y="658"/>
                  <a:pt x="1447" y="674"/>
                </a:cubicBezTo>
                <a:cubicBezTo>
                  <a:pt x="1455" y="690"/>
                  <a:pt x="1459" y="706"/>
                  <a:pt x="1457" y="720"/>
                </a:cubicBezTo>
                <a:cubicBezTo>
                  <a:pt x="1456" y="735"/>
                  <a:pt x="1449" y="748"/>
                  <a:pt x="1436" y="761"/>
                </a:cubicBezTo>
                <a:cubicBezTo>
                  <a:pt x="1420" y="777"/>
                  <a:pt x="1402" y="784"/>
                  <a:pt x="1381" y="782"/>
                </a:cubicBezTo>
                <a:cubicBezTo>
                  <a:pt x="1356" y="779"/>
                  <a:pt x="1327" y="761"/>
                  <a:pt x="1296" y="730"/>
                </a:cubicBezTo>
                <a:close/>
                <a:moveTo>
                  <a:pt x="1317" y="709"/>
                </a:moveTo>
                <a:cubicBezTo>
                  <a:pt x="1345" y="736"/>
                  <a:pt x="1366" y="751"/>
                  <a:pt x="1382" y="754"/>
                </a:cubicBezTo>
                <a:cubicBezTo>
                  <a:pt x="1397" y="757"/>
                  <a:pt x="1410" y="753"/>
                  <a:pt x="1420" y="744"/>
                </a:cubicBezTo>
                <a:cubicBezTo>
                  <a:pt x="1429" y="734"/>
                  <a:pt x="1432" y="722"/>
                  <a:pt x="1430" y="706"/>
                </a:cubicBezTo>
                <a:cubicBezTo>
                  <a:pt x="1427" y="691"/>
                  <a:pt x="1412" y="669"/>
                  <a:pt x="1384" y="641"/>
                </a:cubicBezTo>
                <a:cubicBezTo>
                  <a:pt x="1357" y="614"/>
                  <a:pt x="1335" y="599"/>
                  <a:pt x="1319" y="596"/>
                </a:cubicBezTo>
                <a:cubicBezTo>
                  <a:pt x="1304" y="593"/>
                  <a:pt x="1291" y="597"/>
                  <a:pt x="1282" y="606"/>
                </a:cubicBezTo>
                <a:cubicBezTo>
                  <a:pt x="1272" y="616"/>
                  <a:pt x="1269" y="628"/>
                  <a:pt x="1271" y="641"/>
                </a:cubicBezTo>
                <a:cubicBezTo>
                  <a:pt x="1274" y="659"/>
                  <a:pt x="1290" y="681"/>
                  <a:pt x="1317" y="709"/>
                </a:cubicBezTo>
                <a:close/>
                <a:moveTo>
                  <a:pt x="1436" y="467"/>
                </a:moveTo>
                <a:lnTo>
                  <a:pt x="1412" y="444"/>
                </a:lnTo>
                <a:lnTo>
                  <a:pt x="1432" y="423"/>
                </a:lnTo>
                <a:lnTo>
                  <a:pt x="1456" y="447"/>
                </a:lnTo>
                <a:lnTo>
                  <a:pt x="1436" y="467"/>
                </a:lnTo>
                <a:close/>
                <a:moveTo>
                  <a:pt x="1580" y="612"/>
                </a:moveTo>
                <a:lnTo>
                  <a:pt x="1458" y="490"/>
                </a:lnTo>
                <a:lnTo>
                  <a:pt x="1479" y="469"/>
                </a:lnTo>
                <a:lnTo>
                  <a:pt x="1600" y="591"/>
                </a:lnTo>
                <a:lnTo>
                  <a:pt x="1580" y="612"/>
                </a:lnTo>
                <a:close/>
                <a:moveTo>
                  <a:pt x="1636" y="555"/>
                </a:moveTo>
                <a:lnTo>
                  <a:pt x="1468" y="387"/>
                </a:lnTo>
                <a:lnTo>
                  <a:pt x="1531" y="324"/>
                </a:lnTo>
                <a:cubicBezTo>
                  <a:pt x="1543" y="313"/>
                  <a:pt x="1552" y="305"/>
                  <a:pt x="1559" y="300"/>
                </a:cubicBezTo>
                <a:cubicBezTo>
                  <a:pt x="1568" y="293"/>
                  <a:pt x="1578" y="289"/>
                  <a:pt x="1587" y="287"/>
                </a:cubicBezTo>
                <a:cubicBezTo>
                  <a:pt x="1597" y="285"/>
                  <a:pt x="1607" y="286"/>
                  <a:pt x="1617" y="290"/>
                </a:cubicBezTo>
                <a:cubicBezTo>
                  <a:pt x="1627" y="293"/>
                  <a:pt x="1637" y="299"/>
                  <a:pt x="1645" y="308"/>
                </a:cubicBezTo>
                <a:cubicBezTo>
                  <a:pt x="1659" y="322"/>
                  <a:pt x="1667" y="339"/>
                  <a:pt x="1668" y="358"/>
                </a:cubicBezTo>
                <a:cubicBezTo>
                  <a:pt x="1668" y="377"/>
                  <a:pt x="1657" y="398"/>
                  <a:pt x="1633" y="422"/>
                </a:cubicBezTo>
                <a:lnTo>
                  <a:pt x="1590" y="465"/>
                </a:lnTo>
                <a:lnTo>
                  <a:pt x="1658" y="533"/>
                </a:lnTo>
                <a:lnTo>
                  <a:pt x="1636" y="555"/>
                </a:lnTo>
                <a:close/>
                <a:moveTo>
                  <a:pt x="1570" y="445"/>
                </a:moveTo>
                <a:lnTo>
                  <a:pt x="1614" y="402"/>
                </a:lnTo>
                <a:cubicBezTo>
                  <a:pt x="1628" y="387"/>
                  <a:pt x="1636" y="374"/>
                  <a:pt x="1636" y="363"/>
                </a:cubicBezTo>
                <a:cubicBezTo>
                  <a:pt x="1637" y="352"/>
                  <a:pt x="1632" y="341"/>
                  <a:pt x="1623" y="331"/>
                </a:cubicBezTo>
                <a:cubicBezTo>
                  <a:pt x="1616" y="324"/>
                  <a:pt x="1608" y="320"/>
                  <a:pt x="1599" y="319"/>
                </a:cubicBezTo>
                <a:cubicBezTo>
                  <a:pt x="1591" y="317"/>
                  <a:pt x="1583" y="319"/>
                  <a:pt x="1575" y="323"/>
                </a:cubicBezTo>
                <a:cubicBezTo>
                  <a:pt x="1571" y="325"/>
                  <a:pt x="1563" y="332"/>
                  <a:pt x="1553" y="342"/>
                </a:cubicBezTo>
                <a:lnTo>
                  <a:pt x="1510" y="385"/>
                </a:lnTo>
                <a:lnTo>
                  <a:pt x="1570" y="445"/>
                </a:lnTo>
                <a:close/>
                <a:moveTo>
                  <a:pt x="1730" y="353"/>
                </a:moveTo>
                <a:lnTo>
                  <a:pt x="1749" y="331"/>
                </a:lnTo>
                <a:cubicBezTo>
                  <a:pt x="1759" y="338"/>
                  <a:pt x="1768" y="343"/>
                  <a:pt x="1777" y="344"/>
                </a:cubicBezTo>
                <a:cubicBezTo>
                  <a:pt x="1786" y="346"/>
                  <a:pt x="1796" y="345"/>
                  <a:pt x="1807" y="341"/>
                </a:cubicBezTo>
                <a:cubicBezTo>
                  <a:pt x="1818" y="336"/>
                  <a:pt x="1828" y="329"/>
                  <a:pt x="1838" y="320"/>
                </a:cubicBezTo>
                <a:cubicBezTo>
                  <a:pt x="1846" y="311"/>
                  <a:pt x="1852" y="302"/>
                  <a:pt x="1856" y="293"/>
                </a:cubicBezTo>
                <a:cubicBezTo>
                  <a:pt x="1860" y="284"/>
                  <a:pt x="1862" y="276"/>
                  <a:pt x="1860" y="269"/>
                </a:cubicBezTo>
                <a:cubicBezTo>
                  <a:pt x="1859" y="261"/>
                  <a:pt x="1856" y="255"/>
                  <a:pt x="1851" y="249"/>
                </a:cubicBezTo>
                <a:cubicBezTo>
                  <a:pt x="1846" y="244"/>
                  <a:pt x="1839" y="241"/>
                  <a:pt x="1832" y="240"/>
                </a:cubicBezTo>
                <a:cubicBezTo>
                  <a:pt x="1825" y="239"/>
                  <a:pt x="1817" y="241"/>
                  <a:pt x="1807" y="245"/>
                </a:cubicBezTo>
                <a:cubicBezTo>
                  <a:pt x="1801" y="248"/>
                  <a:pt x="1788" y="255"/>
                  <a:pt x="1769" y="267"/>
                </a:cubicBezTo>
                <a:cubicBezTo>
                  <a:pt x="1750" y="279"/>
                  <a:pt x="1736" y="286"/>
                  <a:pt x="1726" y="289"/>
                </a:cubicBezTo>
                <a:cubicBezTo>
                  <a:pt x="1714" y="293"/>
                  <a:pt x="1703" y="294"/>
                  <a:pt x="1693" y="291"/>
                </a:cubicBezTo>
                <a:cubicBezTo>
                  <a:pt x="1683" y="289"/>
                  <a:pt x="1674" y="284"/>
                  <a:pt x="1666" y="276"/>
                </a:cubicBezTo>
                <a:cubicBezTo>
                  <a:pt x="1657" y="268"/>
                  <a:pt x="1652" y="258"/>
                  <a:pt x="1649" y="245"/>
                </a:cubicBezTo>
                <a:cubicBezTo>
                  <a:pt x="1647" y="233"/>
                  <a:pt x="1648" y="221"/>
                  <a:pt x="1654" y="208"/>
                </a:cubicBezTo>
                <a:cubicBezTo>
                  <a:pt x="1659" y="194"/>
                  <a:pt x="1667" y="182"/>
                  <a:pt x="1679" y="171"/>
                </a:cubicBezTo>
                <a:cubicBezTo>
                  <a:pt x="1691" y="158"/>
                  <a:pt x="1704" y="149"/>
                  <a:pt x="1718" y="144"/>
                </a:cubicBezTo>
                <a:cubicBezTo>
                  <a:pt x="1731" y="138"/>
                  <a:pt x="1744" y="137"/>
                  <a:pt x="1757" y="140"/>
                </a:cubicBezTo>
                <a:cubicBezTo>
                  <a:pt x="1770" y="142"/>
                  <a:pt x="1782" y="149"/>
                  <a:pt x="1792" y="158"/>
                </a:cubicBezTo>
                <a:lnTo>
                  <a:pt x="1772" y="181"/>
                </a:lnTo>
                <a:cubicBezTo>
                  <a:pt x="1761" y="171"/>
                  <a:pt x="1749" y="167"/>
                  <a:pt x="1737" y="168"/>
                </a:cubicBezTo>
                <a:cubicBezTo>
                  <a:pt x="1725" y="170"/>
                  <a:pt x="1712" y="177"/>
                  <a:pt x="1699" y="190"/>
                </a:cubicBezTo>
                <a:cubicBezTo>
                  <a:pt x="1686" y="203"/>
                  <a:pt x="1678" y="215"/>
                  <a:pt x="1677" y="226"/>
                </a:cubicBezTo>
                <a:cubicBezTo>
                  <a:pt x="1676" y="237"/>
                  <a:pt x="1679" y="247"/>
                  <a:pt x="1686" y="253"/>
                </a:cubicBezTo>
                <a:cubicBezTo>
                  <a:pt x="1692" y="260"/>
                  <a:pt x="1699" y="262"/>
                  <a:pt x="1707" y="262"/>
                </a:cubicBezTo>
                <a:cubicBezTo>
                  <a:pt x="1715" y="261"/>
                  <a:pt x="1731" y="254"/>
                  <a:pt x="1753" y="240"/>
                </a:cubicBezTo>
                <a:cubicBezTo>
                  <a:pt x="1775" y="226"/>
                  <a:pt x="1791" y="217"/>
                  <a:pt x="1801" y="214"/>
                </a:cubicBezTo>
                <a:cubicBezTo>
                  <a:pt x="1815" y="209"/>
                  <a:pt x="1828" y="207"/>
                  <a:pt x="1840" y="209"/>
                </a:cubicBezTo>
                <a:cubicBezTo>
                  <a:pt x="1851" y="212"/>
                  <a:pt x="1861" y="217"/>
                  <a:pt x="1870" y="226"/>
                </a:cubicBezTo>
                <a:cubicBezTo>
                  <a:pt x="1879" y="235"/>
                  <a:pt x="1885" y="246"/>
                  <a:pt x="1888" y="259"/>
                </a:cubicBezTo>
                <a:cubicBezTo>
                  <a:pt x="1891" y="272"/>
                  <a:pt x="1890" y="286"/>
                  <a:pt x="1884" y="300"/>
                </a:cubicBezTo>
                <a:cubicBezTo>
                  <a:pt x="1879" y="314"/>
                  <a:pt x="1871" y="327"/>
                  <a:pt x="1859" y="339"/>
                </a:cubicBezTo>
                <a:cubicBezTo>
                  <a:pt x="1843" y="354"/>
                  <a:pt x="1828" y="364"/>
                  <a:pt x="1814" y="370"/>
                </a:cubicBezTo>
                <a:cubicBezTo>
                  <a:pt x="1799" y="376"/>
                  <a:pt x="1784" y="377"/>
                  <a:pt x="1770" y="374"/>
                </a:cubicBezTo>
                <a:cubicBezTo>
                  <a:pt x="1755" y="371"/>
                  <a:pt x="1742" y="364"/>
                  <a:pt x="1730" y="353"/>
                </a:cubicBezTo>
                <a:close/>
                <a:moveTo>
                  <a:pt x="2030" y="122"/>
                </a:moveTo>
                <a:lnTo>
                  <a:pt x="2050" y="141"/>
                </a:lnTo>
                <a:lnTo>
                  <a:pt x="1939" y="252"/>
                </a:lnTo>
                <a:cubicBezTo>
                  <a:pt x="1934" y="248"/>
                  <a:pt x="1930" y="242"/>
                  <a:pt x="1927" y="236"/>
                </a:cubicBezTo>
                <a:cubicBezTo>
                  <a:pt x="1922" y="225"/>
                  <a:pt x="1919" y="213"/>
                  <a:pt x="1918" y="200"/>
                </a:cubicBezTo>
                <a:cubicBezTo>
                  <a:pt x="1917" y="186"/>
                  <a:pt x="1918" y="169"/>
                  <a:pt x="1920" y="147"/>
                </a:cubicBezTo>
                <a:cubicBezTo>
                  <a:pt x="1923" y="114"/>
                  <a:pt x="1924" y="90"/>
                  <a:pt x="1921" y="75"/>
                </a:cubicBezTo>
                <a:cubicBezTo>
                  <a:pt x="1919" y="60"/>
                  <a:pt x="1914" y="48"/>
                  <a:pt x="1906" y="40"/>
                </a:cubicBezTo>
                <a:cubicBezTo>
                  <a:pt x="1898" y="32"/>
                  <a:pt x="1888" y="28"/>
                  <a:pt x="1877" y="28"/>
                </a:cubicBezTo>
                <a:cubicBezTo>
                  <a:pt x="1865" y="29"/>
                  <a:pt x="1855" y="33"/>
                  <a:pt x="1845" y="43"/>
                </a:cubicBezTo>
                <a:cubicBezTo>
                  <a:pt x="1835" y="53"/>
                  <a:pt x="1830" y="64"/>
                  <a:pt x="1830" y="76"/>
                </a:cubicBezTo>
                <a:cubicBezTo>
                  <a:pt x="1830" y="88"/>
                  <a:pt x="1836" y="99"/>
                  <a:pt x="1846" y="109"/>
                </a:cubicBezTo>
                <a:lnTo>
                  <a:pt x="1823" y="128"/>
                </a:lnTo>
                <a:cubicBezTo>
                  <a:pt x="1808" y="111"/>
                  <a:pt x="1802" y="94"/>
                  <a:pt x="1803" y="76"/>
                </a:cubicBezTo>
                <a:cubicBezTo>
                  <a:pt x="1804" y="58"/>
                  <a:pt x="1813" y="41"/>
                  <a:pt x="1829" y="25"/>
                </a:cubicBezTo>
                <a:cubicBezTo>
                  <a:pt x="1845" y="9"/>
                  <a:pt x="1862" y="1"/>
                  <a:pt x="1880" y="0"/>
                </a:cubicBezTo>
                <a:cubicBezTo>
                  <a:pt x="1899" y="0"/>
                  <a:pt x="1915" y="6"/>
                  <a:pt x="1928" y="20"/>
                </a:cubicBezTo>
                <a:cubicBezTo>
                  <a:pt x="1935" y="26"/>
                  <a:pt x="1940" y="34"/>
                  <a:pt x="1944" y="43"/>
                </a:cubicBezTo>
                <a:cubicBezTo>
                  <a:pt x="1947" y="53"/>
                  <a:pt x="1950" y="64"/>
                  <a:pt x="1950" y="78"/>
                </a:cubicBezTo>
                <a:cubicBezTo>
                  <a:pt x="1951" y="91"/>
                  <a:pt x="1950" y="112"/>
                  <a:pt x="1948" y="139"/>
                </a:cubicBezTo>
                <a:cubicBezTo>
                  <a:pt x="1946" y="162"/>
                  <a:pt x="1945" y="177"/>
                  <a:pt x="1945" y="184"/>
                </a:cubicBezTo>
                <a:cubicBezTo>
                  <a:pt x="1946" y="191"/>
                  <a:pt x="1946" y="198"/>
                  <a:pt x="1948" y="204"/>
                </a:cubicBezTo>
                <a:lnTo>
                  <a:pt x="2030" y="122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5" name="Freeform 81"/>
          <p:cNvSpPr>
            <a:spLocks noEditPoints="1"/>
          </p:cNvSpPr>
          <p:nvPr/>
        </p:nvSpPr>
        <p:spPr bwMode="auto">
          <a:xfrm>
            <a:off x="6820042" y="5035690"/>
            <a:ext cx="769937" cy="769938"/>
          </a:xfrm>
          <a:custGeom>
            <a:avLst/>
            <a:gdLst>
              <a:gd name="T0" fmla="*/ 90 w 2019"/>
              <a:gd name="T1" fmla="*/ 1765 h 2020"/>
              <a:gd name="T2" fmla="*/ 199 w 2019"/>
              <a:gd name="T3" fmla="*/ 1823 h 2020"/>
              <a:gd name="T4" fmla="*/ 168 w 2019"/>
              <a:gd name="T5" fmla="*/ 2020 h 2020"/>
              <a:gd name="T6" fmla="*/ 155 w 2019"/>
              <a:gd name="T7" fmla="*/ 1796 h 2020"/>
              <a:gd name="T8" fmla="*/ 42 w 2019"/>
              <a:gd name="T9" fmla="*/ 1850 h 2020"/>
              <a:gd name="T10" fmla="*/ 220 w 2019"/>
              <a:gd name="T11" fmla="*/ 1632 h 2020"/>
              <a:gd name="T12" fmla="*/ 334 w 2019"/>
              <a:gd name="T13" fmla="*/ 1645 h 2020"/>
              <a:gd name="T14" fmla="*/ 421 w 2019"/>
              <a:gd name="T15" fmla="*/ 1714 h 2020"/>
              <a:gd name="T16" fmla="*/ 325 w 2019"/>
              <a:gd name="T17" fmla="*/ 1863 h 2020"/>
              <a:gd name="T18" fmla="*/ 310 w 2019"/>
              <a:gd name="T19" fmla="*/ 1663 h 2020"/>
              <a:gd name="T20" fmla="*/ 233 w 2019"/>
              <a:gd name="T21" fmla="*/ 1659 h 2020"/>
              <a:gd name="T22" fmla="*/ 370 w 2019"/>
              <a:gd name="T23" fmla="*/ 1779 h 2020"/>
              <a:gd name="T24" fmla="*/ 381 w 2019"/>
              <a:gd name="T25" fmla="*/ 1710 h 2020"/>
              <a:gd name="T26" fmla="*/ 270 w 2019"/>
              <a:gd name="T27" fmla="*/ 1763 h 2020"/>
              <a:gd name="T28" fmla="*/ 372 w 2019"/>
              <a:gd name="T29" fmla="*/ 1480 h 2020"/>
              <a:gd name="T30" fmla="*/ 536 w 2019"/>
              <a:gd name="T31" fmla="*/ 1483 h 2020"/>
              <a:gd name="T32" fmla="*/ 567 w 2019"/>
              <a:gd name="T33" fmla="*/ 1616 h 2020"/>
              <a:gd name="T34" fmla="*/ 520 w 2019"/>
              <a:gd name="T35" fmla="*/ 1628 h 2020"/>
              <a:gd name="T36" fmla="*/ 513 w 2019"/>
              <a:gd name="T37" fmla="*/ 1505 h 2020"/>
              <a:gd name="T38" fmla="*/ 356 w 2019"/>
              <a:gd name="T39" fmla="*/ 1536 h 2020"/>
              <a:gd name="T40" fmla="*/ 798 w 2019"/>
              <a:gd name="T41" fmla="*/ 1453 h 2020"/>
              <a:gd name="T42" fmla="*/ 617 w 2019"/>
              <a:gd name="T43" fmla="*/ 1236 h 2020"/>
              <a:gd name="T44" fmla="*/ 765 w 2019"/>
              <a:gd name="T45" fmla="*/ 1138 h 2020"/>
              <a:gd name="T46" fmla="*/ 738 w 2019"/>
              <a:gd name="T47" fmla="*/ 1313 h 2020"/>
              <a:gd name="T48" fmla="*/ 762 w 2019"/>
              <a:gd name="T49" fmla="*/ 1250 h 2020"/>
              <a:gd name="T50" fmla="*/ 724 w 2019"/>
              <a:gd name="T51" fmla="*/ 1171 h 2020"/>
              <a:gd name="T52" fmla="*/ 941 w 2019"/>
              <a:gd name="T53" fmla="*/ 1248 h 2020"/>
              <a:gd name="T54" fmla="*/ 815 w 2019"/>
              <a:gd name="T55" fmla="*/ 1077 h 2020"/>
              <a:gd name="T56" fmla="*/ 886 w 2019"/>
              <a:gd name="T57" fmla="*/ 1148 h 2020"/>
              <a:gd name="T58" fmla="*/ 941 w 2019"/>
              <a:gd name="T59" fmla="*/ 1248 h 2020"/>
              <a:gd name="T60" fmla="*/ 948 w 2019"/>
              <a:gd name="T61" fmla="*/ 905 h 2020"/>
              <a:gd name="T62" fmla="*/ 1039 w 2019"/>
              <a:gd name="T63" fmla="*/ 814 h 2020"/>
              <a:gd name="T64" fmla="*/ 1208 w 2019"/>
              <a:gd name="T65" fmla="*/ 980 h 2020"/>
              <a:gd name="T66" fmla="*/ 1108 w 2019"/>
              <a:gd name="T67" fmla="*/ 1080 h 2020"/>
              <a:gd name="T68" fmla="*/ 1171 w 2019"/>
              <a:gd name="T69" fmla="*/ 754 h 2020"/>
              <a:gd name="T70" fmla="*/ 1146 w 2019"/>
              <a:gd name="T71" fmla="*/ 750 h 2020"/>
              <a:gd name="T72" fmla="*/ 1467 w 2019"/>
              <a:gd name="T73" fmla="*/ 681 h 2020"/>
              <a:gd name="T74" fmla="*/ 1355 w 2019"/>
              <a:gd name="T75" fmla="*/ 760 h 2020"/>
              <a:gd name="T76" fmla="*/ 1314 w 2019"/>
              <a:gd name="T77" fmla="*/ 588 h 2020"/>
              <a:gd name="T78" fmla="*/ 1260 w 2019"/>
              <a:gd name="T79" fmla="*/ 688 h 2020"/>
              <a:gd name="T80" fmla="*/ 1365 w 2019"/>
              <a:gd name="T81" fmla="*/ 579 h 2020"/>
              <a:gd name="T82" fmla="*/ 1382 w 2019"/>
              <a:gd name="T83" fmla="*/ 744 h 2020"/>
              <a:gd name="T84" fmla="*/ 1412 w 2019"/>
              <a:gd name="T85" fmla="*/ 441 h 2020"/>
              <a:gd name="T86" fmla="*/ 1580 w 2019"/>
              <a:gd name="T87" fmla="*/ 609 h 2020"/>
              <a:gd name="T88" fmla="*/ 1580 w 2019"/>
              <a:gd name="T89" fmla="*/ 609 h 2020"/>
              <a:gd name="T90" fmla="*/ 1558 w 2019"/>
              <a:gd name="T91" fmla="*/ 297 h 2020"/>
              <a:gd name="T92" fmla="*/ 1667 w 2019"/>
              <a:gd name="T93" fmla="*/ 355 h 2020"/>
              <a:gd name="T94" fmla="*/ 1636 w 2019"/>
              <a:gd name="T95" fmla="*/ 552 h 2020"/>
              <a:gd name="T96" fmla="*/ 1623 w 2019"/>
              <a:gd name="T97" fmla="*/ 328 h 2020"/>
              <a:gd name="T98" fmla="*/ 1510 w 2019"/>
              <a:gd name="T99" fmla="*/ 382 h 2020"/>
              <a:gd name="T100" fmla="*/ 1777 w 2019"/>
              <a:gd name="T101" fmla="*/ 341 h 2020"/>
              <a:gd name="T102" fmla="*/ 1860 w 2019"/>
              <a:gd name="T103" fmla="*/ 266 h 2020"/>
              <a:gd name="T104" fmla="*/ 1769 w 2019"/>
              <a:gd name="T105" fmla="*/ 264 h 2020"/>
              <a:gd name="T106" fmla="*/ 1649 w 2019"/>
              <a:gd name="T107" fmla="*/ 242 h 2020"/>
              <a:gd name="T108" fmla="*/ 1757 w 2019"/>
              <a:gd name="T109" fmla="*/ 137 h 2020"/>
              <a:gd name="T110" fmla="*/ 1699 w 2019"/>
              <a:gd name="T111" fmla="*/ 187 h 2020"/>
              <a:gd name="T112" fmla="*/ 1753 w 2019"/>
              <a:gd name="T113" fmla="*/ 237 h 2020"/>
              <a:gd name="T114" fmla="*/ 1888 w 2019"/>
              <a:gd name="T115" fmla="*/ 256 h 2020"/>
              <a:gd name="T116" fmla="*/ 1769 w 2019"/>
              <a:gd name="T117" fmla="*/ 371 h 2020"/>
              <a:gd name="T118" fmla="*/ 1867 w 2019"/>
              <a:gd name="T119" fmla="*/ 58 h 2020"/>
              <a:gd name="T120" fmla="*/ 1841 w 2019"/>
              <a:gd name="T121" fmla="*/ 54 h 202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</a:cxnLst>
            <a:rect l="0" t="0" r="r" b="b"/>
            <a:pathLst>
              <a:path w="2019" h="2020">
                <a:moveTo>
                  <a:pt x="168" y="2020"/>
                </a:moveTo>
                <a:lnTo>
                  <a:pt x="0" y="1852"/>
                </a:lnTo>
                <a:lnTo>
                  <a:pt x="63" y="1789"/>
                </a:lnTo>
                <a:cubicBezTo>
                  <a:pt x="74" y="1778"/>
                  <a:pt x="84" y="1770"/>
                  <a:pt x="90" y="1765"/>
                </a:cubicBezTo>
                <a:cubicBezTo>
                  <a:pt x="100" y="1758"/>
                  <a:pt x="110" y="1754"/>
                  <a:pt x="119" y="1752"/>
                </a:cubicBezTo>
                <a:cubicBezTo>
                  <a:pt x="129" y="1750"/>
                  <a:pt x="138" y="1751"/>
                  <a:pt x="149" y="1755"/>
                </a:cubicBezTo>
                <a:cubicBezTo>
                  <a:pt x="159" y="1758"/>
                  <a:pt x="168" y="1764"/>
                  <a:pt x="177" y="1773"/>
                </a:cubicBezTo>
                <a:cubicBezTo>
                  <a:pt x="191" y="1787"/>
                  <a:pt x="199" y="1804"/>
                  <a:pt x="199" y="1823"/>
                </a:cubicBezTo>
                <a:cubicBezTo>
                  <a:pt x="200" y="1842"/>
                  <a:pt x="189" y="1863"/>
                  <a:pt x="165" y="1887"/>
                </a:cubicBezTo>
                <a:lnTo>
                  <a:pt x="122" y="1930"/>
                </a:lnTo>
                <a:lnTo>
                  <a:pt x="190" y="1998"/>
                </a:lnTo>
                <a:lnTo>
                  <a:pt x="168" y="2020"/>
                </a:lnTo>
                <a:close/>
                <a:moveTo>
                  <a:pt x="102" y="1910"/>
                </a:moveTo>
                <a:lnTo>
                  <a:pt x="146" y="1867"/>
                </a:lnTo>
                <a:cubicBezTo>
                  <a:pt x="160" y="1852"/>
                  <a:pt x="167" y="1839"/>
                  <a:pt x="168" y="1828"/>
                </a:cubicBezTo>
                <a:cubicBezTo>
                  <a:pt x="169" y="1817"/>
                  <a:pt x="164" y="1806"/>
                  <a:pt x="155" y="1796"/>
                </a:cubicBezTo>
                <a:cubicBezTo>
                  <a:pt x="148" y="1789"/>
                  <a:pt x="140" y="1785"/>
                  <a:pt x="131" y="1784"/>
                </a:cubicBezTo>
                <a:cubicBezTo>
                  <a:pt x="123" y="1782"/>
                  <a:pt x="115" y="1783"/>
                  <a:pt x="107" y="1788"/>
                </a:cubicBezTo>
                <a:cubicBezTo>
                  <a:pt x="102" y="1790"/>
                  <a:pt x="95" y="1797"/>
                  <a:pt x="85" y="1807"/>
                </a:cubicBezTo>
                <a:lnTo>
                  <a:pt x="42" y="1850"/>
                </a:lnTo>
                <a:lnTo>
                  <a:pt x="102" y="1910"/>
                </a:lnTo>
                <a:close/>
                <a:moveTo>
                  <a:pt x="325" y="1863"/>
                </a:moveTo>
                <a:lnTo>
                  <a:pt x="157" y="1695"/>
                </a:lnTo>
                <a:lnTo>
                  <a:pt x="220" y="1632"/>
                </a:lnTo>
                <a:cubicBezTo>
                  <a:pt x="233" y="1619"/>
                  <a:pt x="245" y="1610"/>
                  <a:pt x="256" y="1606"/>
                </a:cubicBezTo>
                <a:cubicBezTo>
                  <a:pt x="268" y="1602"/>
                  <a:pt x="279" y="1601"/>
                  <a:pt x="290" y="1603"/>
                </a:cubicBezTo>
                <a:cubicBezTo>
                  <a:pt x="302" y="1606"/>
                  <a:pt x="311" y="1611"/>
                  <a:pt x="319" y="1619"/>
                </a:cubicBezTo>
                <a:cubicBezTo>
                  <a:pt x="326" y="1626"/>
                  <a:pt x="331" y="1635"/>
                  <a:pt x="334" y="1645"/>
                </a:cubicBezTo>
                <a:cubicBezTo>
                  <a:pt x="336" y="1655"/>
                  <a:pt x="335" y="1666"/>
                  <a:pt x="331" y="1678"/>
                </a:cubicBezTo>
                <a:cubicBezTo>
                  <a:pt x="344" y="1671"/>
                  <a:pt x="357" y="1668"/>
                  <a:pt x="370" y="1670"/>
                </a:cubicBezTo>
                <a:cubicBezTo>
                  <a:pt x="383" y="1672"/>
                  <a:pt x="394" y="1677"/>
                  <a:pt x="404" y="1687"/>
                </a:cubicBezTo>
                <a:cubicBezTo>
                  <a:pt x="411" y="1695"/>
                  <a:pt x="417" y="1704"/>
                  <a:pt x="421" y="1714"/>
                </a:cubicBezTo>
                <a:cubicBezTo>
                  <a:pt x="424" y="1724"/>
                  <a:pt x="425" y="1734"/>
                  <a:pt x="424" y="1742"/>
                </a:cubicBezTo>
                <a:cubicBezTo>
                  <a:pt x="423" y="1751"/>
                  <a:pt x="419" y="1760"/>
                  <a:pt x="414" y="1769"/>
                </a:cubicBezTo>
                <a:cubicBezTo>
                  <a:pt x="408" y="1778"/>
                  <a:pt x="400" y="1788"/>
                  <a:pt x="390" y="1799"/>
                </a:cubicBezTo>
                <a:lnTo>
                  <a:pt x="325" y="1863"/>
                </a:lnTo>
                <a:close/>
                <a:moveTo>
                  <a:pt x="250" y="1743"/>
                </a:moveTo>
                <a:lnTo>
                  <a:pt x="287" y="1707"/>
                </a:lnTo>
                <a:cubicBezTo>
                  <a:pt x="296" y="1697"/>
                  <a:pt x="303" y="1689"/>
                  <a:pt x="306" y="1684"/>
                </a:cubicBezTo>
                <a:cubicBezTo>
                  <a:pt x="310" y="1676"/>
                  <a:pt x="311" y="1669"/>
                  <a:pt x="310" y="1663"/>
                </a:cubicBezTo>
                <a:cubicBezTo>
                  <a:pt x="309" y="1656"/>
                  <a:pt x="306" y="1649"/>
                  <a:pt x="300" y="1644"/>
                </a:cubicBezTo>
                <a:cubicBezTo>
                  <a:pt x="294" y="1638"/>
                  <a:pt x="288" y="1634"/>
                  <a:pt x="281" y="1633"/>
                </a:cubicBezTo>
                <a:cubicBezTo>
                  <a:pt x="274" y="1631"/>
                  <a:pt x="268" y="1632"/>
                  <a:pt x="261" y="1636"/>
                </a:cubicBezTo>
                <a:cubicBezTo>
                  <a:pt x="254" y="1639"/>
                  <a:pt x="245" y="1647"/>
                  <a:pt x="233" y="1659"/>
                </a:cubicBezTo>
                <a:lnTo>
                  <a:pt x="199" y="1692"/>
                </a:lnTo>
                <a:lnTo>
                  <a:pt x="250" y="1743"/>
                </a:lnTo>
                <a:close/>
                <a:moveTo>
                  <a:pt x="328" y="1821"/>
                </a:moveTo>
                <a:lnTo>
                  <a:pt x="370" y="1779"/>
                </a:lnTo>
                <a:cubicBezTo>
                  <a:pt x="377" y="1772"/>
                  <a:pt x="382" y="1766"/>
                  <a:pt x="384" y="1763"/>
                </a:cubicBezTo>
                <a:cubicBezTo>
                  <a:pt x="388" y="1757"/>
                  <a:pt x="391" y="1751"/>
                  <a:pt x="392" y="1746"/>
                </a:cubicBezTo>
                <a:cubicBezTo>
                  <a:pt x="394" y="1740"/>
                  <a:pt x="393" y="1734"/>
                  <a:pt x="391" y="1728"/>
                </a:cubicBezTo>
                <a:cubicBezTo>
                  <a:pt x="390" y="1721"/>
                  <a:pt x="386" y="1716"/>
                  <a:pt x="381" y="1710"/>
                </a:cubicBezTo>
                <a:cubicBezTo>
                  <a:pt x="374" y="1704"/>
                  <a:pt x="367" y="1700"/>
                  <a:pt x="359" y="1699"/>
                </a:cubicBezTo>
                <a:cubicBezTo>
                  <a:pt x="352" y="1697"/>
                  <a:pt x="344" y="1699"/>
                  <a:pt x="336" y="1702"/>
                </a:cubicBezTo>
                <a:cubicBezTo>
                  <a:pt x="329" y="1706"/>
                  <a:pt x="320" y="1713"/>
                  <a:pt x="309" y="1724"/>
                </a:cubicBezTo>
                <a:lnTo>
                  <a:pt x="270" y="1763"/>
                </a:lnTo>
                <a:lnTo>
                  <a:pt x="328" y="1821"/>
                </a:lnTo>
                <a:close/>
                <a:moveTo>
                  <a:pt x="482" y="1706"/>
                </a:moveTo>
                <a:lnTo>
                  <a:pt x="314" y="1538"/>
                </a:lnTo>
                <a:lnTo>
                  <a:pt x="372" y="1480"/>
                </a:lnTo>
                <a:cubicBezTo>
                  <a:pt x="385" y="1467"/>
                  <a:pt x="396" y="1458"/>
                  <a:pt x="404" y="1453"/>
                </a:cubicBezTo>
                <a:cubicBezTo>
                  <a:pt x="416" y="1446"/>
                  <a:pt x="428" y="1441"/>
                  <a:pt x="441" y="1440"/>
                </a:cubicBezTo>
                <a:cubicBezTo>
                  <a:pt x="457" y="1439"/>
                  <a:pt x="473" y="1442"/>
                  <a:pt x="489" y="1449"/>
                </a:cubicBezTo>
                <a:cubicBezTo>
                  <a:pt x="505" y="1456"/>
                  <a:pt x="521" y="1468"/>
                  <a:pt x="536" y="1483"/>
                </a:cubicBezTo>
                <a:cubicBezTo>
                  <a:pt x="549" y="1495"/>
                  <a:pt x="559" y="1508"/>
                  <a:pt x="565" y="1521"/>
                </a:cubicBezTo>
                <a:cubicBezTo>
                  <a:pt x="572" y="1534"/>
                  <a:pt x="577" y="1546"/>
                  <a:pt x="578" y="1557"/>
                </a:cubicBezTo>
                <a:cubicBezTo>
                  <a:pt x="580" y="1568"/>
                  <a:pt x="580" y="1578"/>
                  <a:pt x="578" y="1587"/>
                </a:cubicBezTo>
                <a:cubicBezTo>
                  <a:pt x="576" y="1597"/>
                  <a:pt x="573" y="1606"/>
                  <a:pt x="567" y="1616"/>
                </a:cubicBezTo>
                <a:cubicBezTo>
                  <a:pt x="561" y="1626"/>
                  <a:pt x="553" y="1636"/>
                  <a:pt x="543" y="1646"/>
                </a:cubicBezTo>
                <a:lnTo>
                  <a:pt x="482" y="1706"/>
                </a:lnTo>
                <a:close/>
                <a:moveTo>
                  <a:pt x="484" y="1664"/>
                </a:moveTo>
                <a:lnTo>
                  <a:pt x="520" y="1628"/>
                </a:lnTo>
                <a:cubicBezTo>
                  <a:pt x="531" y="1617"/>
                  <a:pt x="539" y="1608"/>
                  <a:pt x="543" y="1599"/>
                </a:cubicBezTo>
                <a:cubicBezTo>
                  <a:pt x="547" y="1591"/>
                  <a:pt x="550" y="1583"/>
                  <a:pt x="550" y="1576"/>
                </a:cubicBezTo>
                <a:cubicBezTo>
                  <a:pt x="550" y="1565"/>
                  <a:pt x="547" y="1554"/>
                  <a:pt x="541" y="1542"/>
                </a:cubicBezTo>
                <a:cubicBezTo>
                  <a:pt x="535" y="1530"/>
                  <a:pt x="525" y="1518"/>
                  <a:pt x="513" y="1505"/>
                </a:cubicBezTo>
                <a:cubicBezTo>
                  <a:pt x="495" y="1488"/>
                  <a:pt x="479" y="1477"/>
                  <a:pt x="463" y="1473"/>
                </a:cubicBezTo>
                <a:cubicBezTo>
                  <a:pt x="448" y="1470"/>
                  <a:pt x="435" y="1470"/>
                  <a:pt x="423" y="1475"/>
                </a:cubicBezTo>
                <a:cubicBezTo>
                  <a:pt x="415" y="1479"/>
                  <a:pt x="404" y="1487"/>
                  <a:pt x="391" y="1501"/>
                </a:cubicBezTo>
                <a:lnTo>
                  <a:pt x="356" y="1536"/>
                </a:lnTo>
                <a:lnTo>
                  <a:pt x="484" y="1664"/>
                </a:lnTo>
                <a:close/>
                <a:moveTo>
                  <a:pt x="677" y="1605"/>
                </a:moveTo>
                <a:lnTo>
                  <a:pt x="662" y="1590"/>
                </a:lnTo>
                <a:lnTo>
                  <a:pt x="798" y="1453"/>
                </a:lnTo>
                <a:lnTo>
                  <a:pt x="813" y="1468"/>
                </a:lnTo>
                <a:lnTo>
                  <a:pt x="677" y="1605"/>
                </a:lnTo>
                <a:close/>
                <a:moveTo>
                  <a:pt x="785" y="1404"/>
                </a:moveTo>
                <a:lnTo>
                  <a:pt x="617" y="1236"/>
                </a:lnTo>
                <a:lnTo>
                  <a:pt x="680" y="1172"/>
                </a:lnTo>
                <a:cubicBezTo>
                  <a:pt x="691" y="1161"/>
                  <a:pt x="700" y="1153"/>
                  <a:pt x="707" y="1148"/>
                </a:cubicBezTo>
                <a:cubicBezTo>
                  <a:pt x="717" y="1141"/>
                  <a:pt x="726" y="1137"/>
                  <a:pt x="736" y="1135"/>
                </a:cubicBezTo>
                <a:cubicBezTo>
                  <a:pt x="745" y="1134"/>
                  <a:pt x="755" y="1135"/>
                  <a:pt x="765" y="1138"/>
                </a:cubicBezTo>
                <a:cubicBezTo>
                  <a:pt x="776" y="1142"/>
                  <a:pt x="785" y="1148"/>
                  <a:pt x="793" y="1156"/>
                </a:cubicBezTo>
                <a:cubicBezTo>
                  <a:pt x="808" y="1170"/>
                  <a:pt x="815" y="1187"/>
                  <a:pt x="816" y="1206"/>
                </a:cubicBezTo>
                <a:cubicBezTo>
                  <a:pt x="817" y="1225"/>
                  <a:pt x="805" y="1246"/>
                  <a:pt x="782" y="1270"/>
                </a:cubicBezTo>
                <a:lnTo>
                  <a:pt x="738" y="1313"/>
                </a:lnTo>
                <a:lnTo>
                  <a:pt x="807" y="1382"/>
                </a:lnTo>
                <a:lnTo>
                  <a:pt x="785" y="1404"/>
                </a:lnTo>
                <a:close/>
                <a:moveTo>
                  <a:pt x="719" y="1293"/>
                </a:moveTo>
                <a:lnTo>
                  <a:pt x="762" y="1250"/>
                </a:lnTo>
                <a:cubicBezTo>
                  <a:pt x="776" y="1236"/>
                  <a:pt x="784" y="1223"/>
                  <a:pt x="785" y="1211"/>
                </a:cubicBezTo>
                <a:cubicBezTo>
                  <a:pt x="785" y="1200"/>
                  <a:pt x="781" y="1189"/>
                  <a:pt x="771" y="1180"/>
                </a:cubicBezTo>
                <a:cubicBezTo>
                  <a:pt x="764" y="1173"/>
                  <a:pt x="756" y="1168"/>
                  <a:pt x="748" y="1167"/>
                </a:cubicBezTo>
                <a:cubicBezTo>
                  <a:pt x="739" y="1165"/>
                  <a:pt x="731" y="1167"/>
                  <a:pt x="724" y="1171"/>
                </a:cubicBezTo>
                <a:cubicBezTo>
                  <a:pt x="719" y="1174"/>
                  <a:pt x="712" y="1180"/>
                  <a:pt x="702" y="1190"/>
                </a:cubicBezTo>
                <a:lnTo>
                  <a:pt x="659" y="1233"/>
                </a:lnTo>
                <a:lnTo>
                  <a:pt x="719" y="1293"/>
                </a:lnTo>
                <a:close/>
                <a:moveTo>
                  <a:pt x="941" y="1248"/>
                </a:moveTo>
                <a:lnTo>
                  <a:pt x="773" y="1080"/>
                </a:lnTo>
                <a:lnTo>
                  <a:pt x="894" y="958"/>
                </a:lnTo>
                <a:lnTo>
                  <a:pt x="914" y="978"/>
                </a:lnTo>
                <a:lnTo>
                  <a:pt x="815" y="1077"/>
                </a:lnTo>
                <a:lnTo>
                  <a:pt x="866" y="1129"/>
                </a:lnTo>
                <a:lnTo>
                  <a:pt x="959" y="1036"/>
                </a:lnTo>
                <a:lnTo>
                  <a:pt x="979" y="1056"/>
                </a:lnTo>
                <a:lnTo>
                  <a:pt x="886" y="1148"/>
                </a:lnTo>
                <a:lnTo>
                  <a:pt x="943" y="1206"/>
                </a:lnTo>
                <a:lnTo>
                  <a:pt x="1046" y="1103"/>
                </a:lnTo>
                <a:lnTo>
                  <a:pt x="1066" y="1122"/>
                </a:lnTo>
                <a:lnTo>
                  <a:pt x="941" y="1248"/>
                </a:lnTo>
                <a:close/>
                <a:moveTo>
                  <a:pt x="1081" y="1107"/>
                </a:moveTo>
                <a:lnTo>
                  <a:pt x="1059" y="954"/>
                </a:lnTo>
                <a:lnTo>
                  <a:pt x="921" y="931"/>
                </a:lnTo>
                <a:lnTo>
                  <a:pt x="948" y="905"/>
                </a:lnTo>
                <a:lnTo>
                  <a:pt x="1021" y="917"/>
                </a:lnTo>
                <a:cubicBezTo>
                  <a:pt x="1036" y="920"/>
                  <a:pt x="1048" y="922"/>
                  <a:pt x="1055" y="924"/>
                </a:cubicBezTo>
                <a:cubicBezTo>
                  <a:pt x="1053" y="915"/>
                  <a:pt x="1051" y="904"/>
                  <a:pt x="1049" y="892"/>
                </a:cubicBezTo>
                <a:lnTo>
                  <a:pt x="1039" y="814"/>
                </a:lnTo>
                <a:lnTo>
                  <a:pt x="1063" y="789"/>
                </a:lnTo>
                <a:lnTo>
                  <a:pt x="1083" y="928"/>
                </a:lnTo>
                <a:lnTo>
                  <a:pt x="1236" y="953"/>
                </a:lnTo>
                <a:lnTo>
                  <a:pt x="1208" y="980"/>
                </a:lnTo>
                <a:lnTo>
                  <a:pt x="1106" y="963"/>
                </a:lnTo>
                <a:cubicBezTo>
                  <a:pt x="1100" y="962"/>
                  <a:pt x="1094" y="960"/>
                  <a:pt x="1087" y="959"/>
                </a:cubicBezTo>
                <a:cubicBezTo>
                  <a:pt x="1090" y="969"/>
                  <a:pt x="1091" y="976"/>
                  <a:pt x="1092" y="979"/>
                </a:cubicBezTo>
                <a:lnTo>
                  <a:pt x="1108" y="1080"/>
                </a:lnTo>
                <a:lnTo>
                  <a:pt x="1081" y="1107"/>
                </a:lnTo>
                <a:close/>
                <a:moveTo>
                  <a:pt x="1323" y="865"/>
                </a:moveTo>
                <a:lnTo>
                  <a:pt x="1303" y="886"/>
                </a:lnTo>
                <a:lnTo>
                  <a:pt x="1171" y="754"/>
                </a:lnTo>
                <a:cubicBezTo>
                  <a:pt x="1171" y="764"/>
                  <a:pt x="1169" y="775"/>
                  <a:pt x="1166" y="788"/>
                </a:cubicBezTo>
                <a:cubicBezTo>
                  <a:pt x="1163" y="801"/>
                  <a:pt x="1159" y="811"/>
                  <a:pt x="1155" y="820"/>
                </a:cubicBezTo>
                <a:lnTo>
                  <a:pt x="1135" y="800"/>
                </a:lnTo>
                <a:cubicBezTo>
                  <a:pt x="1141" y="783"/>
                  <a:pt x="1145" y="767"/>
                  <a:pt x="1146" y="750"/>
                </a:cubicBezTo>
                <a:cubicBezTo>
                  <a:pt x="1146" y="734"/>
                  <a:pt x="1145" y="720"/>
                  <a:pt x="1141" y="709"/>
                </a:cubicBezTo>
                <a:lnTo>
                  <a:pt x="1155" y="696"/>
                </a:lnTo>
                <a:lnTo>
                  <a:pt x="1323" y="865"/>
                </a:lnTo>
                <a:close/>
                <a:moveTo>
                  <a:pt x="1467" y="681"/>
                </a:moveTo>
                <a:lnTo>
                  <a:pt x="1487" y="701"/>
                </a:lnTo>
                <a:lnTo>
                  <a:pt x="1376" y="812"/>
                </a:lnTo>
                <a:cubicBezTo>
                  <a:pt x="1371" y="808"/>
                  <a:pt x="1367" y="802"/>
                  <a:pt x="1364" y="796"/>
                </a:cubicBezTo>
                <a:cubicBezTo>
                  <a:pt x="1359" y="785"/>
                  <a:pt x="1356" y="773"/>
                  <a:pt x="1355" y="760"/>
                </a:cubicBezTo>
                <a:cubicBezTo>
                  <a:pt x="1354" y="746"/>
                  <a:pt x="1355" y="729"/>
                  <a:pt x="1357" y="707"/>
                </a:cubicBezTo>
                <a:cubicBezTo>
                  <a:pt x="1360" y="674"/>
                  <a:pt x="1361" y="650"/>
                  <a:pt x="1358" y="635"/>
                </a:cubicBezTo>
                <a:cubicBezTo>
                  <a:pt x="1356" y="619"/>
                  <a:pt x="1351" y="608"/>
                  <a:pt x="1343" y="600"/>
                </a:cubicBezTo>
                <a:cubicBezTo>
                  <a:pt x="1335" y="592"/>
                  <a:pt x="1325" y="588"/>
                  <a:pt x="1314" y="588"/>
                </a:cubicBezTo>
                <a:cubicBezTo>
                  <a:pt x="1302" y="588"/>
                  <a:pt x="1292" y="593"/>
                  <a:pt x="1282" y="603"/>
                </a:cubicBezTo>
                <a:cubicBezTo>
                  <a:pt x="1272" y="613"/>
                  <a:pt x="1267" y="624"/>
                  <a:pt x="1267" y="635"/>
                </a:cubicBezTo>
                <a:cubicBezTo>
                  <a:pt x="1267" y="647"/>
                  <a:pt x="1273" y="659"/>
                  <a:pt x="1283" y="669"/>
                </a:cubicBezTo>
                <a:lnTo>
                  <a:pt x="1260" y="688"/>
                </a:lnTo>
                <a:cubicBezTo>
                  <a:pt x="1245" y="671"/>
                  <a:pt x="1239" y="653"/>
                  <a:pt x="1240" y="636"/>
                </a:cubicBezTo>
                <a:cubicBezTo>
                  <a:pt x="1241" y="618"/>
                  <a:pt x="1250" y="601"/>
                  <a:pt x="1266" y="585"/>
                </a:cubicBezTo>
                <a:cubicBezTo>
                  <a:pt x="1282" y="569"/>
                  <a:pt x="1299" y="561"/>
                  <a:pt x="1317" y="560"/>
                </a:cubicBezTo>
                <a:cubicBezTo>
                  <a:pt x="1336" y="560"/>
                  <a:pt x="1352" y="566"/>
                  <a:pt x="1365" y="579"/>
                </a:cubicBezTo>
                <a:cubicBezTo>
                  <a:pt x="1372" y="586"/>
                  <a:pt x="1377" y="594"/>
                  <a:pt x="1380" y="603"/>
                </a:cubicBezTo>
                <a:cubicBezTo>
                  <a:pt x="1384" y="613"/>
                  <a:pt x="1387" y="624"/>
                  <a:pt x="1387" y="638"/>
                </a:cubicBezTo>
                <a:cubicBezTo>
                  <a:pt x="1388" y="651"/>
                  <a:pt x="1387" y="672"/>
                  <a:pt x="1385" y="699"/>
                </a:cubicBezTo>
                <a:cubicBezTo>
                  <a:pt x="1383" y="722"/>
                  <a:pt x="1382" y="737"/>
                  <a:pt x="1382" y="744"/>
                </a:cubicBezTo>
                <a:cubicBezTo>
                  <a:pt x="1383" y="751"/>
                  <a:pt x="1383" y="758"/>
                  <a:pt x="1385" y="764"/>
                </a:cubicBezTo>
                <a:lnTo>
                  <a:pt x="1467" y="681"/>
                </a:lnTo>
                <a:close/>
                <a:moveTo>
                  <a:pt x="1435" y="464"/>
                </a:moveTo>
                <a:lnTo>
                  <a:pt x="1412" y="441"/>
                </a:lnTo>
                <a:lnTo>
                  <a:pt x="1432" y="420"/>
                </a:lnTo>
                <a:lnTo>
                  <a:pt x="1456" y="444"/>
                </a:lnTo>
                <a:lnTo>
                  <a:pt x="1435" y="464"/>
                </a:lnTo>
                <a:close/>
                <a:moveTo>
                  <a:pt x="1580" y="609"/>
                </a:moveTo>
                <a:lnTo>
                  <a:pt x="1458" y="487"/>
                </a:lnTo>
                <a:lnTo>
                  <a:pt x="1479" y="466"/>
                </a:lnTo>
                <a:lnTo>
                  <a:pt x="1600" y="588"/>
                </a:lnTo>
                <a:lnTo>
                  <a:pt x="1580" y="609"/>
                </a:lnTo>
                <a:close/>
                <a:moveTo>
                  <a:pt x="1636" y="552"/>
                </a:moveTo>
                <a:lnTo>
                  <a:pt x="1468" y="384"/>
                </a:lnTo>
                <a:lnTo>
                  <a:pt x="1531" y="321"/>
                </a:lnTo>
                <a:cubicBezTo>
                  <a:pt x="1542" y="310"/>
                  <a:pt x="1551" y="302"/>
                  <a:pt x="1558" y="297"/>
                </a:cubicBezTo>
                <a:cubicBezTo>
                  <a:pt x="1568" y="290"/>
                  <a:pt x="1578" y="286"/>
                  <a:pt x="1587" y="284"/>
                </a:cubicBezTo>
                <a:cubicBezTo>
                  <a:pt x="1596" y="282"/>
                  <a:pt x="1606" y="283"/>
                  <a:pt x="1617" y="287"/>
                </a:cubicBezTo>
                <a:cubicBezTo>
                  <a:pt x="1627" y="290"/>
                  <a:pt x="1636" y="296"/>
                  <a:pt x="1645" y="305"/>
                </a:cubicBezTo>
                <a:cubicBezTo>
                  <a:pt x="1659" y="319"/>
                  <a:pt x="1667" y="336"/>
                  <a:pt x="1667" y="355"/>
                </a:cubicBezTo>
                <a:cubicBezTo>
                  <a:pt x="1668" y="374"/>
                  <a:pt x="1657" y="395"/>
                  <a:pt x="1633" y="419"/>
                </a:cubicBezTo>
                <a:lnTo>
                  <a:pt x="1590" y="462"/>
                </a:lnTo>
                <a:lnTo>
                  <a:pt x="1658" y="530"/>
                </a:lnTo>
                <a:lnTo>
                  <a:pt x="1636" y="552"/>
                </a:lnTo>
                <a:close/>
                <a:moveTo>
                  <a:pt x="1570" y="442"/>
                </a:moveTo>
                <a:lnTo>
                  <a:pt x="1613" y="399"/>
                </a:lnTo>
                <a:cubicBezTo>
                  <a:pt x="1628" y="384"/>
                  <a:pt x="1635" y="371"/>
                  <a:pt x="1636" y="360"/>
                </a:cubicBezTo>
                <a:cubicBezTo>
                  <a:pt x="1637" y="349"/>
                  <a:pt x="1632" y="338"/>
                  <a:pt x="1623" y="328"/>
                </a:cubicBezTo>
                <a:cubicBezTo>
                  <a:pt x="1615" y="321"/>
                  <a:pt x="1608" y="317"/>
                  <a:pt x="1599" y="316"/>
                </a:cubicBezTo>
                <a:cubicBezTo>
                  <a:pt x="1591" y="314"/>
                  <a:pt x="1583" y="316"/>
                  <a:pt x="1575" y="320"/>
                </a:cubicBezTo>
                <a:cubicBezTo>
                  <a:pt x="1570" y="322"/>
                  <a:pt x="1563" y="329"/>
                  <a:pt x="1553" y="339"/>
                </a:cubicBezTo>
                <a:lnTo>
                  <a:pt x="1510" y="382"/>
                </a:lnTo>
                <a:lnTo>
                  <a:pt x="1570" y="442"/>
                </a:lnTo>
                <a:close/>
                <a:moveTo>
                  <a:pt x="1730" y="350"/>
                </a:moveTo>
                <a:lnTo>
                  <a:pt x="1749" y="328"/>
                </a:lnTo>
                <a:cubicBezTo>
                  <a:pt x="1758" y="335"/>
                  <a:pt x="1768" y="340"/>
                  <a:pt x="1777" y="341"/>
                </a:cubicBezTo>
                <a:cubicBezTo>
                  <a:pt x="1786" y="343"/>
                  <a:pt x="1796" y="342"/>
                  <a:pt x="1807" y="338"/>
                </a:cubicBezTo>
                <a:cubicBezTo>
                  <a:pt x="1818" y="333"/>
                  <a:pt x="1828" y="326"/>
                  <a:pt x="1837" y="317"/>
                </a:cubicBezTo>
                <a:cubicBezTo>
                  <a:pt x="1846" y="308"/>
                  <a:pt x="1852" y="299"/>
                  <a:pt x="1856" y="290"/>
                </a:cubicBezTo>
                <a:cubicBezTo>
                  <a:pt x="1860" y="281"/>
                  <a:pt x="1861" y="273"/>
                  <a:pt x="1860" y="266"/>
                </a:cubicBezTo>
                <a:cubicBezTo>
                  <a:pt x="1859" y="258"/>
                  <a:pt x="1856" y="252"/>
                  <a:pt x="1851" y="246"/>
                </a:cubicBezTo>
                <a:cubicBezTo>
                  <a:pt x="1845" y="241"/>
                  <a:pt x="1839" y="238"/>
                  <a:pt x="1832" y="237"/>
                </a:cubicBezTo>
                <a:cubicBezTo>
                  <a:pt x="1825" y="236"/>
                  <a:pt x="1817" y="238"/>
                  <a:pt x="1807" y="242"/>
                </a:cubicBezTo>
                <a:cubicBezTo>
                  <a:pt x="1801" y="245"/>
                  <a:pt x="1788" y="252"/>
                  <a:pt x="1769" y="264"/>
                </a:cubicBezTo>
                <a:cubicBezTo>
                  <a:pt x="1750" y="276"/>
                  <a:pt x="1736" y="283"/>
                  <a:pt x="1726" y="286"/>
                </a:cubicBezTo>
                <a:cubicBezTo>
                  <a:pt x="1714" y="290"/>
                  <a:pt x="1703" y="291"/>
                  <a:pt x="1693" y="288"/>
                </a:cubicBezTo>
                <a:cubicBezTo>
                  <a:pt x="1682" y="286"/>
                  <a:pt x="1673" y="281"/>
                  <a:pt x="1666" y="273"/>
                </a:cubicBezTo>
                <a:cubicBezTo>
                  <a:pt x="1657" y="265"/>
                  <a:pt x="1652" y="255"/>
                  <a:pt x="1649" y="242"/>
                </a:cubicBezTo>
                <a:cubicBezTo>
                  <a:pt x="1647" y="230"/>
                  <a:pt x="1648" y="218"/>
                  <a:pt x="1653" y="205"/>
                </a:cubicBezTo>
                <a:cubicBezTo>
                  <a:pt x="1659" y="191"/>
                  <a:pt x="1667" y="179"/>
                  <a:pt x="1679" y="168"/>
                </a:cubicBezTo>
                <a:cubicBezTo>
                  <a:pt x="1691" y="155"/>
                  <a:pt x="1704" y="146"/>
                  <a:pt x="1718" y="141"/>
                </a:cubicBezTo>
                <a:cubicBezTo>
                  <a:pt x="1731" y="135"/>
                  <a:pt x="1744" y="134"/>
                  <a:pt x="1757" y="137"/>
                </a:cubicBezTo>
                <a:cubicBezTo>
                  <a:pt x="1770" y="139"/>
                  <a:pt x="1782" y="146"/>
                  <a:pt x="1792" y="155"/>
                </a:cubicBezTo>
                <a:lnTo>
                  <a:pt x="1772" y="178"/>
                </a:lnTo>
                <a:cubicBezTo>
                  <a:pt x="1760" y="168"/>
                  <a:pt x="1749" y="164"/>
                  <a:pt x="1737" y="165"/>
                </a:cubicBezTo>
                <a:cubicBezTo>
                  <a:pt x="1724" y="167"/>
                  <a:pt x="1712" y="174"/>
                  <a:pt x="1699" y="187"/>
                </a:cubicBezTo>
                <a:cubicBezTo>
                  <a:pt x="1686" y="200"/>
                  <a:pt x="1678" y="212"/>
                  <a:pt x="1677" y="223"/>
                </a:cubicBezTo>
                <a:cubicBezTo>
                  <a:pt x="1676" y="234"/>
                  <a:pt x="1679" y="244"/>
                  <a:pt x="1686" y="250"/>
                </a:cubicBezTo>
                <a:cubicBezTo>
                  <a:pt x="1692" y="257"/>
                  <a:pt x="1699" y="259"/>
                  <a:pt x="1707" y="259"/>
                </a:cubicBezTo>
                <a:cubicBezTo>
                  <a:pt x="1715" y="258"/>
                  <a:pt x="1730" y="251"/>
                  <a:pt x="1753" y="237"/>
                </a:cubicBezTo>
                <a:cubicBezTo>
                  <a:pt x="1775" y="223"/>
                  <a:pt x="1791" y="214"/>
                  <a:pt x="1801" y="211"/>
                </a:cubicBezTo>
                <a:cubicBezTo>
                  <a:pt x="1815" y="206"/>
                  <a:pt x="1828" y="204"/>
                  <a:pt x="1839" y="206"/>
                </a:cubicBezTo>
                <a:cubicBezTo>
                  <a:pt x="1851" y="209"/>
                  <a:pt x="1861" y="214"/>
                  <a:pt x="1870" y="223"/>
                </a:cubicBezTo>
                <a:cubicBezTo>
                  <a:pt x="1879" y="232"/>
                  <a:pt x="1885" y="243"/>
                  <a:pt x="1888" y="256"/>
                </a:cubicBezTo>
                <a:cubicBezTo>
                  <a:pt x="1891" y="269"/>
                  <a:pt x="1889" y="283"/>
                  <a:pt x="1884" y="297"/>
                </a:cubicBezTo>
                <a:cubicBezTo>
                  <a:pt x="1879" y="311"/>
                  <a:pt x="1870" y="324"/>
                  <a:pt x="1858" y="336"/>
                </a:cubicBezTo>
                <a:cubicBezTo>
                  <a:pt x="1843" y="351"/>
                  <a:pt x="1828" y="361"/>
                  <a:pt x="1814" y="367"/>
                </a:cubicBezTo>
                <a:cubicBezTo>
                  <a:pt x="1799" y="373"/>
                  <a:pt x="1784" y="374"/>
                  <a:pt x="1769" y="371"/>
                </a:cubicBezTo>
                <a:cubicBezTo>
                  <a:pt x="1755" y="368"/>
                  <a:pt x="1741" y="361"/>
                  <a:pt x="1730" y="350"/>
                </a:cubicBezTo>
                <a:close/>
                <a:moveTo>
                  <a:pt x="2019" y="169"/>
                </a:moveTo>
                <a:lnTo>
                  <a:pt x="1999" y="190"/>
                </a:lnTo>
                <a:lnTo>
                  <a:pt x="1867" y="58"/>
                </a:lnTo>
                <a:cubicBezTo>
                  <a:pt x="1867" y="68"/>
                  <a:pt x="1865" y="79"/>
                  <a:pt x="1862" y="92"/>
                </a:cubicBezTo>
                <a:cubicBezTo>
                  <a:pt x="1858" y="105"/>
                  <a:pt x="1855" y="116"/>
                  <a:pt x="1851" y="124"/>
                </a:cubicBezTo>
                <a:lnTo>
                  <a:pt x="1831" y="104"/>
                </a:lnTo>
                <a:cubicBezTo>
                  <a:pt x="1837" y="87"/>
                  <a:pt x="1840" y="71"/>
                  <a:pt x="1841" y="54"/>
                </a:cubicBezTo>
                <a:cubicBezTo>
                  <a:pt x="1842" y="38"/>
                  <a:pt x="1841" y="25"/>
                  <a:pt x="1837" y="14"/>
                </a:cubicBezTo>
                <a:lnTo>
                  <a:pt x="1851" y="0"/>
                </a:lnTo>
                <a:lnTo>
                  <a:pt x="2019" y="169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6" name="Freeform 82"/>
          <p:cNvSpPr>
            <a:spLocks noEditPoints="1"/>
          </p:cNvSpPr>
          <p:nvPr/>
        </p:nvSpPr>
        <p:spPr bwMode="auto">
          <a:xfrm>
            <a:off x="7091505" y="5034102"/>
            <a:ext cx="781050" cy="771525"/>
          </a:xfrm>
          <a:custGeom>
            <a:avLst/>
            <a:gdLst>
              <a:gd name="T0" fmla="*/ 119 w 2050"/>
              <a:gd name="T1" fmla="*/ 1755 h 2023"/>
              <a:gd name="T2" fmla="*/ 122 w 2050"/>
              <a:gd name="T3" fmla="*/ 1933 h 2023"/>
              <a:gd name="T4" fmla="*/ 168 w 2050"/>
              <a:gd name="T5" fmla="*/ 1831 h 2023"/>
              <a:gd name="T6" fmla="*/ 42 w 2050"/>
              <a:gd name="T7" fmla="*/ 1853 h 2023"/>
              <a:gd name="T8" fmla="*/ 256 w 2050"/>
              <a:gd name="T9" fmla="*/ 1609 h 2023"/>
              <a:gd name="T10" fmla="*/ 370 w 2050"/>
              <a:gd name="T11" fmla="*/ 1673 h 2023"/>
              <a:gd name="T12" fmla="*/ 389 w 2050"/>
              <a:gd name="T13" fmla="*/ 1802 h 2023"/>
              <a:gd name="T14" fmla="*/ 310 w 2050"/>
              <a:gd name="T15" fmla="*/ 1666 h 2023"/>
              <a:gd name="T16" fmla="*/ 199 w 2050"/>
              <a:gd name="T17" fmla="*/ 1695 h 2023"/>
              <a:gd name="T18" fmla="*/ 392 w 2050"/>
              <a:gd name="T19" fmla="*/ 1749 h 2023"/>
              <a:gd name="T20" fmla="*/ 309 w 2050"/>
              <a:gd name="T21" fmla="*/ 1727 h 2023"/>
              <a:gd name="T22" fmla="*/ 372 w 2050"/>
              <a:gd name="T23" fmla="*/ 1483 h 2023"/>
              <a:gd name="T24" fmla="*/ 565 w 2050"/>
              <a:gd name="T25" fmla="*/ 1524 h 2023"/>
              <a:gd name="T26" fmla="*/ 482 w 2050"/>
              <a:gd name="T27" fmla="*/ 1709 h 2023"/>
              <a:gd name="T28" fmla="*/ 541 w 2050"/>
              <a:gd name="T29" fmla="*/ 1545 h 2023"/>
              <a:gd name="T30" fmla="*/ 356 w 2050"/>
              <a:gd name="T31" fmla="*/ 1539 h 2023"/>
              <a:gd name="T32" fmla="*/ 813 w 2050"/>
              <a:gd name="T33" fmla="*/ 1471 h 2023"/>
              <a:gd name="T34" fmla="*/ 707 w 2050"/>
              <a:gd name="T35" fmla="*/ 1151 h 2023"/>
              <a:gd name="T36" fmla="*/ 782 w 2050"/>
              <a:gd name="T37" fmla="*/ 1273 h 2023"/>
              <a:gd name="T38" fmla="*/ 762 w 2050"/>
              <a:gd name="T39" fmla="*/ 1253 h 2023"/>
              <a:gd name="T40" fmla="*/ 702 w 2050"/>
              <a:gd name="T41" fmla="*/ 1193 h 2023"/>
              <a:gd name="T42" fmla="*/ 894 w 2050"/>
              <a:gd name="T43" fmla="*/ 961 h 2023"/>
              <a:gd name="T44" fmla="*/ 979 w 2050"/>
              <a:gd name="T45" fmla="*/ 1059 h 2023"/>
              <a:gd name="T46" fmla="*/ 941 w 2050"/>
              <a:gd name="T47" fmla="*/ 1251 h 2023"/>
              <a:gd name="T48" fmla="*/ 1021 w 2050"/>
              <a:gd name="T49" fmla="*/ 920 h 2023"/>
              <a:gd name="T50" fmla="*/ 1083 w 2050"/>
              <a:gd name="T51" fmla="*/ 931 h 2023"/>
              <a:gd name="T52" fmla="*/ 1092 w 2050"/>
              <a:gd name="T53" fmla="*/ 982 h 2023"/>
              <a:gd name="T54" fmla="*/ 1171 w 2050"/>
              <a:gd name="T55" fmla="*/ 757 h 2023"/>
              <a:gd name="T56" fmla="*/ 1141 w 2050"/>
              <a:gd name="T57" fmla="*/ 712 h 2023"/>
              <a:gd name="T58" fmla="*/ 1376 w 2050"/>
              <a:gd name="T59" fmla="*/ 815 h 2023"/>
              <a:gd name="T60" fmla="*/ 1343 w 2050"/>
              <a:gd name="T61" fmla="*/ 603 h 2023"/>
              <a:gd name="T62" fmla="*/ 1260 w 2050"/>
              <a:gd name="T63" fmla="*/ 691 h 2023"/>
              <a:gd name="T64" fmla="*/ 1380 w 2050"/>
              <a:gd name="T65" fmla="*/ 606 h 2023"/>
              <a:gd name="T66" fmla="*/ 1467 w 2050"/>
              <a:gd name="T67" fmla="*/ 684 h 2023"/>
              <a:gd name="T68" fmla="*/ 1435 w 2050"/>
              <a:gd name="T69" fmla="*/ 467 h 2023"/>
              <a:gd name="T70" fmla="*/ 1580 w 2050"/>
              <a:gd name="T71" fmla="*/ 612 h 2023"/>
              <a:gd name="T72" fmla="*/ 1587 w 2050"/>
              <a:gd name="T73" fmla="*/ 287 h 2023"/>
              <a:gd name="T74" fmla="*/ 1590 w 2050"/>
              <a:gd name="T75" fmla="*/ 465 h 2023"/>
              <a:gd name="T76" fmla="*/ 1636 w 2050"/>
              <a:gd name="T77" fmla="*/ 363 h 2023"/>
              <a:gd name="T78" fmla="*/ 1510 w 2050"/>
              <a:gd name="T79" fmla="*/ 385 h 2023"/>
              <a:gd name="T80" fmla="*/ 1807 w 2050"/>
              <a:gd name="T81" fmla="*/ 341 h 2023"/>
              <a:gd name="T82" fmla="*/ 1832 w 2050"/>
              <a:gd name="T83" fmla="*/ 240 h 2023"/>
              <a:gd name="T84" fmla="*/ 1666 w 2050"/>
              <a:gd name="T85" fmla="*/ 276 h 2023"/>
              <a:gd name="T86" fmla="*/ 1757 w 2050"/>
              <a:gd name="T87" fmla="*/ 140 h 2023"/>
              <a:gd name="T88" fmla="*/ 1677 w 2050"/>
              <a:gd name="T89" fmla="*/ 226 h 2023"/>
              <a:gd name="T90" fmla="*/ 1839 w 2050"/>
              <a:gd name="T91" fmla="*/ 209 h 2023"/>
              <a:gd name="T92" fmla="*/ 1813 w 2050"/>
              <a:gd name="T93" fmla="*/ 370 h 2023"/>
              <a:gd name="T94" fmla="*/ 1939 w 2050"/>
              <a:gd name="T95" fmla="*/ 252 h 2023"/>
              <a:gd name="T96" fmla="*/ 1906 w 2050"/>
              <a:gd name="T97" fmla="*/ 40 h 2023"/>
              <a:gd name="T98" fmla="*/ 1823 w 2050"/>
              <a:gd name="T99" fmla="*/ 128 h 2023"/>
              <a:gd name="T100" fmla="*/ 1943 w 2050"/>
              <a:gd name="T101" fmla="*/ 43 h 2023"/>
              <a:gd name="T102" fmla="*/ 2030 w 2050"/>
              <a:gd name="T103" fmla="*/ 122 h 202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</a:cxnLst>
            <a:rect l="0" t="0" r="r" b="b"/>
            <a:pathLst>
              <a:path w="2050" h="2023">
                <a:moveTo>
                  <a:pt x="168" y="2023"/>
                </a:moveTo>
                <a:lnTo>
                  <a:pt x="0" y="1855"/>
                </a:lnTo>
                <a:lnTo>
                  <a:pt x="63" y="1792"/>
                </a:lnTo>
                <a:cubicBezTo>
                  <a:pt x="74" y="1781"/>
                  <a:pt x="83" y="1773"/>
                  <a:pt x="90" y="1768"/>
                </a:cubicBezTo>
                <a:cubicBezTo>
                  <a:pt x="100" y="1761"/>
                  <a:pt x="110" y="1757"/>
                  <a:pt x="119" y="1755"/>
                </a:cubicBezTo>
                <a:cubicBezTo>
                  <a:pt x="128" y="1753"/>
                  <a:pt x="138" y="1754"/>
                  <a:pt x="149" y="1758"/>
                </a:cubicBezTo>
                <a:cubicBezTo>
                  <a:pt x="159" y="1761"/>
                  <a:pt x="168" y="1767"/>
                  <a:pt x="177" y="1776"/>
                </a:cubicBezTo>
                <a:cubicBezTo>
                  <a:pt x="191" y="1790"/>
                  <a:pt x="199" y="1807"/>
                  <a:pt x="199" y="1826"/>
                </a:cubicBezTo>
                <a:cubicBezTo>
                  <a:pt x="200" y="1845"/>
                  <a:pt x="189" y="1866"/>
                  <a:pt x="165" y="1890"/>
                </a:cubicBezTo>
                <a:lnTo>
                  <a:pt x="122" y="1933"/>
                </a:lnTo>
                <a:lnTo>
                  <a:pt x="190" y="2001"/>
                </a:lnTo>
                <a:lnTo>
                  <a:pt x="168" y="2023"/>
                </a:lnTo>
                <a:close/>
                <a:moveTo>
                  <a:pt x="102" y="1913"/>
                </a:moveTo>
                <a:lnTo>
                  <a:pt x="145" y="1870"/>
                </a:lnTo>
                <a:cubicBezTo>
                  <a:pt x="160" y="1855"/>
                  <a:pt x="167" y="1842"/>
                  <a:pt x="168" y="1831"/>
                </a:cubicBezTo>
                <a:cubicBezTo>
                  <a:pt x="169" y="1820"/>
                  <a:pt x="164" y="1809"/>
                  <a:pt x="154" y="1799"/>
                </a:cubicBezTo>
                <a:cubicBezTo>
                  <a:pt x="147" y="1792"/>
                  <a:pt x="140" y="1788"/>
                  <a:pt x="131" y="1787"/>
                </a:cubicBezTo>
                <a:cubicBezTo>
                  <a:pt x="123" y="1785"/>
                  <a:pt x="115" y="1786"/>
                  <a:pt x="107" y="1791"/>
                </a:cubicBezTo>
                <a:cubicBezTo>
                  <a:pt x="102" y="1793"/>
                  <a:pt x="95" y="1800"/>
                  <a:pt x="85" y="1810"/>
                </a:cubicBezTo>
                <a:lnTo>
                  <a:pt x="42" y="1853"/>
                </a:lnTo>
                <a:lnTo>
                  <a:pt x="102" y="1913"/>
                </a:lnTo>
                <a:close/>
                <a:moveTo>
                  <a:pt x="325" y="1866"/>
                </a:moveTo>
                <a:lnTo>
                  <a:pt x="157" y="1698"/>
                </a:lnTo>
                <a:lnTo>
                  <a:pt x="220" y="1635"/>
                </a:lnTo>
                <a:cubicBezTo>
                  <a:pt x="233" y="1622"/>
                  <a:pt x="245" y="1613"/>
                  <a:pt x="256" y="1609"/>
                </a:cubicBezTo>
                <a:cubicBezTo>
                  <a:pt x="268" y="1605"/>
                  <a:pt x="279" y="1604"/>
                  <a:pt x="290" y="1606"/>
                </a:cubicBezTo>
                <a:cubicBezTo>
                  <a:pt x="302" y="1609"/>
                  <a:pt x="311" y="1614"/>
                  <a:pt x="319" y="1622"/>
                </a:cubicBezTo>
                <a:cubicBezTo>
                  <a:pt x="326" y="1629"/>
                  <a:pt x="331" y="1638"/>
                  <a:pt x="334" y="1648"/>
                </a:cubicBezTo>
                <a:cubicBezTo>
                  <a:pt x="336" y="1658"/>
                  <a:pt x="335" y="1669"/>
                  <a:pt x="331" y="1681"/>
                </a:cubicBezTo>
                <a:cubicBezTo>
                  <a:pt x="344" y="1674"/>
                  <a:pt x="357" y="1671"/>
                  <a:pt x="370" y="1673"/>
                </a:cubicBezTo>
                <a:cubicBezTo>
                  <a:pt x="383" y="1675"/>
                  <a:pt x="394" y="1680"/>
                  <a:pt x="404" y="1690"/>
                </a:cubicBezTo>
                <a:cubicBezTo>
                  <a:pt x="411" y="1698"/>
                  <a:pt x="417" y="1707"/>
                  <a:pt x="421" y="1717"/>
                </a:cubicBezTo>
                <a:cubicBezTo>
                  <a:pt x="424" y="1727"/>
                  <a:pt x="425" y="1737"/>
                  <a:pt x="424" y="1745"/>
                </a:cubicBezTo>
                <a:cubicBezTo>
                  <a:pt x="423" y="1754"/>
                  <a:pt x="419" y="1763"/>
                  <a:pt x="414" y="1772"/>
                </a:cubicBezTo>
                <a:cubicBezTo>
                  <a:pt x="408" y="1781"/>
                  <a:pt x="400" y="1791"/>
                  <a:pt x="389" y="1802"/>
                </a:cubicBezTo>
                <a:lnTo>
                  <a:pt x="325" y="1866"/>
                </a:lnTo>
                <a:close/>
                <a:moveTo>
                  <a:pt x="250" y="1746"/>
                </a:moveTo>
                <a:lnTo>
                  <a:pt x="287" y="1710"/>
                </a:lnTo>
                <a:cubicBezTo>
                  <a:pt x="296" y="1700"/>
                  <a:pt x="303" y="1692"/>
                  <a:pt x="306" y="1687"/>
                </a:cubicBezTo>
                <a:cubicBezTo>
                  <a:pt x="310" y="1679"/>
                  <a:pt x="311" y="1672"/>
                  <a:pt x="310" y="1666"/>
                </a:cubicBezTo>
                <a:cubicBezTo>
                  <a:pt x="309" y="1659"/>
                  <a:pt x="306" y="1652"/>
                  <a:pt x="300" y="1647"/>
                </a:cubicBezTo>
                <a:cubicBezTo>
                  <a:pt x="294" y="1641"/>
                  <a:pt x="288" y="1637"/>
                  <a:pt x="281" y="1636"/>
                </a:cubicBezTo>
                <a:cubicBezTo>
                  <a:pt x="274" y="1634"/>
                  <a:pt x="267" y="1635"/>
                  <a:pt x="261" y="1639"/>
                </a:cubicBezTo>
                <a:cubicBezTo>
                  <a:pt x="254" y="1642"/>
                  <a:pt x="245" y="1650"/>
                  <a:pt x="233" y="1662"/>
                </a:cubicBezTo>
                <a:lnTo>
                  <a:pt x="199" y="1695"/>
                </a:lnTo>
                <a:lnTo>
                  <a:pt x="250" y="1746"/>
                </a:lnTo>
                <a:close/>
                <a:moveTo>
                  <a:pt x="328" y="1824"/>
                </a:moveTo>
                <a:lnTo>
                  <a:pt x="370" y="1782"/>
                </a:lnTo>
                <a:cubicBezTo>
                  <a:pt x="377" y="1775"/>
                  <a:pt x="382" y="1769"/>
                  <a:pt x="384" y="1766"/>
                </a:cubicBezTo>
                <a:cubicBezTo>
                  <a:pt x="388" y="1760"/>
                  <a:pt x="391" y="1754"/>
                  <a:pt x="392" y="1749"/>
                </a:cubicBezTo>
                <a:cubicBezTo>
                  <a:pt x="394" y="1743"/>
                  <a:pt x="393" y="1737"/>
                  <a:pt x="391" y="1731"/>
                </a:cubicBezTo>
                <a:cubicBezTo>
                  <a:pt x="389" y="1724"/>
                  <a:pt x="386" y="1719"/>
                  <a:pt x="381" y="1713"/>
                </a:cubicBezTo>
                <a:cubicBezTo>
                  <a:pt x="374" y="1707"/>
                  <a:pt x="367" y="1703"/>
                  <a:pt x="359" y="1702"/>
                </a:cubicBezTo>
                <a:cubicBezTo>
                  <a:pt x="352" y="1700"/>
                  <a:pt x="344" y="1702"/>
                  <a:pt x="336" y="1705"/>
                </a:cubicBezTo>
                <a:cubicBezTo>
                  <a:pt x="329" y="1709"/>
                  <a:pt x="320" y="1716"/>
                  <a:pt x="309" y="1727"/>
                </a:cubicBezTo>
                <a:lnTo>
                  <a:pt x="270" y="1766"/>
                </a:lnTo>
                <a:lnTo>
                  <a:pt x="328" y="1824"/>
                </a:lnTo>
                <a:close/>
                <a:moveTo>
                  <a:pt x="482" y="1709"/>
                </a:moveTo>
                <a:lnTo>
                  <a:pt x="314" y="1541"/>
                </a:lnTo>
                <a:lnTo>
                  <a:pt x="372" y="1483"/>
                </a:lnTo>
                <a:cubicBezTo>
                  <a:pt x="385" y="1470"/>
                  <a:pt x="396" y="1461"/>
                  <a:pt x="404" y="1456"/>
                </a:cubicBezTo>
                <a:cubicBezTo>
                  <a:pt x="416" y="1449"/>
                  <a:pt x="428" y="1444"/>
                  <a:pt x="441" y="1443"/>
                </a:cubicBezTo>
                <a:cubicBezTo>
                  <a:pt x="457" y="1442"/>
                  <a:pt x="473" y="1445"/>
                  <a:pt x="489" y="1452"/>
                </a:cubicBezTo>
                <a:cubicBezTo>
                  <a:pt x="505" y="1459"/>
                  <a:pt x="521" y="1471"/>
                  <a:pt x="536" y="1486"/>
                </a:cubicBezTo>
                <a:cubicBezTo>
                  <a:pt x="549" y="1498"/>
                  <a:pt x="558" y="1511"/>
                  <a:pt x="565" y="1524"/>
                </a:cubicBezTo>
                <a:cubicBezTo>
                  <a:pt x="572" y="1537"/>
                  <a:pt x="577" y="1549"/>
                  <a:pt x="578" y="1560"/>
                </a:cubicBezTo>
                <a:cubicBezTo>
                  <a:pt x="580" y="1571"/>
                  <a:pt x="580" y="1581"/>
                  <a:pt x="578" y="1590"/>
                </a:cubicBezTo>
                <a:cubicBezTo>
                  <a:pt x="576" y="1600"/>
                  <a:pt x="573" y="1609"/>
                  <a:pt x="567" y="1619"/>
                </a:cubicBezTo>
                <a:cubicBezTo>
                  <a:pt x="561" y="1629"/>
                  <a:pt x="553" y="1639"/>
                  <a:pt x="542" y="1649"/>
                </a:cubicBezTo>
                <a:lnTo>
                  <a:pt x="482" y="1709"/>
                </a:lnTo>
                <a:close/>
                <a:moveTo>
                  <a:pt x="484" y="1667"/>
                </a:moveTo>
                <a:lnTo>
                  <a:pt x="520" y="1631"/>
                </a:lnTo>
                <a:cubicBezTo>
                  <a:pt x="531" y="1620"/>
                  <a:pt x="539" y="1611"/>
                  <a:pt x="543" y="1602"/>
                </a:cubicBezTo>
                <a:cubicBezTo>
                  <a:pt x="547" y="1594"/>
                  <a:pt x="549" y="1586"/>
                  <a:pt x="549" y="1579"/>
                </a:cubicBezTo>
                <a:cubicBezTo>
                  <a:pt x="549" y="1568"/>
                  <a:pt x="547" y="1557"/>
                  <a:pt x="541" y="1545"/>
                </a:cubicBezTo>
                <a:cubicBezTo>
                  <a:pt x="535" y="1533"/>
                  <a:pt x="525" y="1521"/>
                  <a:pt x="513" y="1508"/>
                </a:cubicBezTo>
                <a:cubicBezTo>
                  <a:pt x="495" y="1491"/>
                  <a:pt x="479" y="1480"/>
                  <a:pt x="463" y="1476"/>
                </a:cubicBezTo>
                <a:cubicBezTo>
                  <a:pt x="448" y="1473"/>
                  <a:pt x="435" y="1473"/>
                  <a:pt x="423" y="1478"/>
                </a:cubicBezTo>
                <a:cubicBezTo>
                  <a:pt x="415" y="1482"/>
                  <a:pt x="404" y="1490"/>
                  <a:pt x="391" y="1504"/>
                </a:cubicBezTo>
                <a:lnTo>
                  <a:pt x="356" y="1539"/>
                </a:lnTo>
                <a:lnTo>
                  <a:pt x="484" y="1667"/>
                </a:lnTo>
                <a:close/>
                <a:moveTo>
                  <a:pt x="677" y="1608"/>
                </a:moveTo>
                <a:lnTo>
                  <a:pt x="662" y="1593"/>
                </a:lnTo>
                <a:lnTo>
                  <a:pt x="798" y="1456"/>
                </a:lnTo>
                <a:lnTo>
                  <a:pt x="813" y="1471"/>
                </a:lnTo>
                <a:lnTo>
                  <a:pt x="677" y="1608"/>
                </a:lnTo>
                <a:close/>
                <a:moveTo>
                  <a:pt x="784" y="1407"/>
                </a:moveTo>
                <a:lnTo>
                  <a:pt x="616" y="1239"/>
                </a:lnTo>
                <a:lnTo>
                  <a:pt x="680" y="1175"/>
                </a:lnTo>
                <a:cubicBezTo>
                  <a:pt x="691" y="1164"/>
                  <a:pt x="700" y="1156"/>
                  <a:pt x="707" y="1151"/>
                </a:cubicBezTo>
                <a:cubicBezTo>
                  <a:pt x="717" y="1144"/>
                  <a:pt x="726" y="1140"/>
                  <a:pt x="736" y="1138"/>
                </a:cubicBezTo>
                <a:cubicBezTo>
                  <a:pt x="745" y="1137"/>
                  <a:pt x="755" y="1138"/>
                  <a:pt x="765" y="1141"/>
                </a:cubicBezTo>
                <a:cubicBezTo>
                  <a:pt x="776" y="1145"/>
                  <a:pt x="785" y="1151"/>
                  <a:pt x="793" y="1159"/>
                </a:cubicBezTo>
                <a:cubicBezTo>
                  <a:pt x="808" y="1173"/>
                  <a:pt x="815" y="1190"/>
                  <a:pt x="816" y="1209"/>
                </a:cubicBezTo>
                <a:cubicBezTo>
                  <a:pt x="817" y="1228"/>
                  <a:pt x="805" y="1249"/>
                  <a:pt x="782" y="1273"/>
                </a:cubicBezTo>
                <a:lnTo>
                  <a:pt x="738" y="1316"/>
                </a:lnTo>
                <a:lnTo>
                  <a:pt x="807" y="1385"/>
                </a:lnTo>
                <a:lnTo>
                  <a:pt x="784" y="1407"/>
                </a:lnTo>
                <a:close/>
                <a:moveTo>
                  <a:pt x="719" y="1296"/>
                </a:moveTo>
                <a:lnTo>
                  <a:pt x="762" y="1253"/>
                </a:lnTo>
                <a:cubicBezTo>
                  <a:pt x="776" y="1239"/>
                  <a:pt x="784" y="1226"/>
                  <a:pt x="785" y="1214"/>
                </a:cubicBezTo>
                <a:cubicBezTo>
                  <a:pt x="785" y="1203"/>
                  <a:pt x="781" y="1192"/>
                  <a:pt x="771" y="1183"/>
                </a:cubicBezTo>
                <a:cubicBezTo>
                  <a:pt x="764" y="1176"/>
                  <a:pt x="756" y="1171"/>
                  <a:pt x="748" y="1170"/>
                </a:cubicBezTo>
                <a:cubicBezTo>
                  <a:pt x="739" y="1168"/>
                  <a:pt x="731" y="1170"/>
                  <a:pt x="724" y="1174"/>
                </a:cubicBezTo>
                <a:cubicBezTo>
                  <a:pt x="719" y="1177"/>
                  <a:pt x="712" y="1183"/>
                  <a:pt x="702" y="1193"/>
                </a:cubicBezTo>
                <a:lnTo>
                  <a:pt x="659" y="1236"/>
                </a:lnTo>
                <a:lnTo>
                  <a:pt x="719" y="1296"/>
                </a:lnTo>
                <a:close/>
                <a:moveTo>
                  <a:pt x="941" y="1251"/>
                </a:moveTo>
                <a:lnTo>
                  <a:pt x="772" y="1083"/>
                </a:lnTo>
                <a:lnTo>
                  <a:pt x="894" y="961"/>
                </a:lnTo>
                <a:lnTo>
                  <a:pt x="914" y="981"/>
                </a:lnTo>
                <a:lnTo>
                  <a:pt x="815" y="1080"/>
                </a:lnTo>
                <a:lnTo>
                  <a:pt x="866" y="1132"/>
                </a:lnTo>
                <a:lnTo>
                  <a:pt x="959" y="1039"/>
                </a:lnTo>
                <a:lnTo>
                  <a:pt x="979" y="1059"/>
                </a:lnTo>
                <a:lnTo>
                  <a:pt x="886" y="1151"/>
                </a:lnTo>
                <a:lnTo>
                  <a:pt x="943" y="1209"/>
                </a:lnTo>
                <a:lnTo>
                  <a:pt x="1046" y="1106"/>
                </a:lnTo>
                <a:lnTo>
                  <a:pt x="1066" y="1125"/>
                </a:lnTo>
                <a:lnTo>
                  <a:pt x="941" y="1251"/>
                </a:lnTo>
                <a:close/>
                <a:moveTo>
                  <a:pt x="1081" y="1110"/>
                </a:moveTo>
                <a:lnTo>
                  <a:pt x="1059" y="957"/>
                </a:lnTo>
                <a:lnTo>
                  <a:pt x="921" y="934"/>
                </a:lnTo>
                <a:lnTo>
                  <a:pt x="947" y="908"/>
                </a:lnTo>
                <a:lnTo>
                  <a:pt x="1021" y="920"/>
                </a:lnTo>
                <a:cubicBezTo>
                  <a:pt x="1036" y="923"/>
                  <a:pt x="1048" y="925"/>
                  <a:pt x="1055" y="927"/>
                </a:cubicBezTo>
                <a:cubicBezTo>
                  <a:pt x="1053" y="918"/>
                  <a:pt x="1051" y="907"/>
                  <a:pt x="1049" y="895"/>
                </a:cubicBezTo>
                <a:lnTo>
                  <a:pt x="1039" y="817"/>
                </a:lnTo>
                <a:lnTo>
                  <a:pt x="1063" y="792"/>
                </a:lnTo>
                <a:lnTo>
                  <a:pt x="1083" y="931"/>
                </a:lnTo>
                <a:lnTo>
                  <a:pt x="1235" y="956"/>
                </a:lnTo>
                <a:lnTo>
                  <a:pt x="1208" y="983"/>
                </a:lnTo>
                <a:lnTo>
                  <a:pt x="1106" y="966"/>
                </a:lnTo>
                <a:cubicBezTo>
                  <a:pt x="1100" y="965"/>
                  <a:pt x="1094" y="963"/>
                  <a:pt x="1087" y="962"/>
                </a:cubicBezTo>
                <a:cubicBezTo>
                  <a:pt x="1089" y="972"/>
                  <a:pt x="1091" y="979"/>
                  <a:pt x="1092" y="982"/>
                </a:cubicBezTo>
                <a:lnTo>
                  <a:pt x="1108" y="1083"/>
                </a:lnTo>
                <a:lnTo>
                  <a:pt x="1081" y="1110"/>
                </a:lnTo>
                <a:close/>
                <a:moveTo>
                  <a:pt x="1323" y="868"/>
                </a:moveTo>
                <a:lnTo>
                  <a:pt x="1303" y="889"/>
                </a:lnTo>
                <a:lnTo>
                  <a:pt x="1171" y="757"/>
                </a:lnTo>
                <a:cubicBezTo>
                  <a:pt x="1171" y="767"/>
                  <a:pt x="1169" y="778"/>
                  <a:pt x="1166" y="791"/>
                </a:cubicBezTo>
                <a:cubicBezTo>
                  <a:pt x="1163" y="804"/>
                  <a:pt x="1159" y="814"/>
                  <a:pt x="1155" y="823"/>
                </a:cubicBezTo>
                <a:lnTo>
                  <a:pt x="1135" y="803"/>
                </a:lnTo>
                <a:cubicBezTo>
                  <a:pt x="1141" y="786"/>
                  <a:pt x="1145" y="770"/>
                  <a:pt x="1145" y="753"/>
                </a:cubicBezTo>
                <a:cubicBezTo>
                  <a:pt x="1146" y="737"/>
                  <a:pt x="1145" y="723"/>
                  <a:pt x="1141" y="712"/>
                </a:cubicBezTo>
                <a:lnTo>
                  <a:pt x="1155" y="699"/>
                </a:lnTo>
                <a:lnTo>
                  <a:pt x="1323" y="868"/>
                </a:lnTo>
                <a:close/>
                <a:moveTo>
                  <a:pt x="1467" y="684"/>
                </a:moveTo>
                <a:lnTo>
                  <a:pt x="1487" y="704"/>
                </a:lnTo>
                <a:lnTo>
                  <a:pt x="1376" y="815"/>
                </a:lnTo>
                <a:cubicBezTo>
                  <a:pt x="1371" y="811"/>
                  <a:pt x="1367" y="805"/>
                  <a:pt x="1364" y="799"/>
                </a:cubicBezTo>
                <a:cubicBezTo>
                  <a:pt x="1359" y="788"/>
                  <a:pt x="1356" y="776"/>
                  <a:pt x="1355" y="763"/>
                </a:cubicBezTo>
                <a:cubicBezTo>
                  <a:pt x="1354" y="749"/>
                  <a:pt x="1355" y="732"/>
                  <a:pt x="1357" y="710"/>
                </a:cubicBezTo>
                <a:cubicBezTo>
                  <a:pt x="1360" y="677"/>
                  <a:pt x="1361" y="653"/>
                  <a:pt x="1358" y="638"/>
                </a:cubicBezTo>
                <a:cubicBezTo>
                  <a:pt x="1356" y="622"/>
                  <a:pt x="1351" y="611"/>
                  <a:pt x="1343" y="603"/>
                </a:cubicBezTo>
                <a:cubicBezTo>
                  <a:pt x="1335" y="595"/>
                  <a:pt x="1325" y="591"/>
                  <a:pt x="1314" y="591"/>
                </a:cubicBezTo>
                <a:cubicBezTo>
                  <a:pt x="1302" y="591"/>
                  <a:pt x="1292" y="596"/>
                  <a:pt x="1282" y="606"/>
                </a:cubicBezTo>
                <a:cubicBezTo>
                  <a:pt x="1272" y="616"/>
                  <a:pt x="1267" y="627"/>
                  <a:pt x="1267" y="638"/>
                </a:cubicBezTo>
                <a:cubicBezTo>
                  <a:pt x="1267" y="650"/>
                  <a:pt x="1273" y="662"/>
                  <a:pt x="1283" y="672"/>
                </a:cubicBezTo>
                <a:lnTo>
                  <a:pt x="1260" y="691"/>
                </a:lnTo>
                <a:cubicBezTo>
                  <a:pt x="1245" y="674"/>
                  <a:pt x="1239" y="656"/>
                  <a:pt x="1240" y="639"/>
                </a:cubicBezTo>
                <a:cubicBezTo>
                  <a:pt x="1241" y="621"/>
                  <a:pt x="1250" y="604"/>
                  <a:pt x="1266" y="588"/>
                </a:cubicBezTo>
                <a:cubicBezTo>
                  <a:pt x="1282" y="572"/>
                  <a:pt x="1299" y="564"/>
                  <a:pt x="1317" y="563"/>
                </a:cubicBezTo>
                <a:cubicBezTo>
                  <a:pt x="1336" y="563"/>
                  <a:pt x="1351" y="569"/>
                  <a:pt x="1365" y="582"/>
                </a:cubicBezTo>
                <a:cubicBezTo>
                  <a:pt x="1371" y="589"/>
                  <a:pt x="1377" y="597"/>
                  <a:pt x="1380" y="606"/>
                </a:cubicBezTo>
                <a:cubicBezTo>
                  <a:pt x="1384" y="616"/>
                  <a:pt x="1386" y="627"/>
                  <a:pt x="1387" y="641"/>
                </a:cubicBezTo>
                <a:cubicBezTo>
                  <a:pt x="1388" y="654"/>
                  <a:pt x="1387" y="675"/>
                  <a:pt x="1385" y="702"/>
                </a:cubicBezTo>
                <a:cubicBezTo>
                  <a:pt x="1383" y="725"/>
                  <a:pt x="1382" y="740"/>
                  <a:pt x="1382" y="747"/>
                </a:cubicBezTo>
                <a:cubicBezTo>
                  <a:pt x="1383" y="754"/>
                  <a:pt x="1383" y="761"/>
                  <a:pt x="1385" y="767"/>
                </a:cubicBezTo>
                <a:lnTo>
                  <a:pt x="1467" y="684"/>
                </a:lnTo>
                <a:close/>
                <a:moveTo>
                  <a:pt x="1435" y="467"/>
                </a:moveTo>
                <a:lnTo>
                  <a:pt x="1412" y="444"/>
                </a:lnTo>
                <a:lnTo>
                  <a:pt x="1432" y="423"/>
                </a:lnTo>
                <a:lnTo>
                  <a:pt x="1456" y="447"/>
                </a:lnTo>
                <a:lnTo>
                  <a:pt x="1435" y="467"/>
                </a:lnTo>
                <a:close/>
                <a:moveTo>
                  <a:pt x="1580" y="612"/>
                </a:moveTo>
                <a:lnTo>
                  <a:pt x="1458" y="490"/>
                </a:lnTo>
                <a:lnTo>
                  <a:pt x="1478" y="469"/>
                </a:lnTo>
                <a:lnTo>
                  <a:pt x="1600" y="591"/>
                </a:lnTo>
                <a:lnTo>
                  <a:pt x="1580" y="612"/>
                </a:lnTo>
                <a:close/>
                <a:moveTo>
                  <a:pt x="1636" y="555"/>
                </a:moveTo>
                <a:lnTo>
                  <a:pt x="1468" y="387"/>
                </a:lnTo>
                <a:lnTo>
                  <a:pt x="1531" y="324"/>
                </a:lnTo>
                <a:cubicBezTo>
                  <a:pt x="1542" y="313"/>
                  <a:pt x="1551" y="305"/>
                  <a:pt x="1558" y="300"/>
                </a:cubicBezTo>
                <a:cubicBezTo>
                  <a:pt x="1568" y="293"/>
                  <a:pt x="1578" y="289"/>
                  <a:pt x="1587" y="287"/>
                </a:cubicBezTo>
                <a:cubicBezTo>
                  <a:pt x="1596" y="285"/>
                  <a:pt x="1606" y="286"/>
                  <a:pt x="1617" y="290"/>
                </a:cubicBezTo>
                <a:cubicBezTo>
                  <a:pt x="1627" y="293"/>
                  <a:pt x="1636" y="299"/>
                  <a:pt x="1645" y="308"/>
                </a:cubicBezTo>
                <a:cubicBezTo>
                  <a:pt x="1659" y="322"/>
                  <a:pt x="1667" y="339"/>
                  <a:pt x="1667" y="358"/>
                </a:cubicBezTo>
                <a:cubicBezTo>
                  <a:pt x="1668" y="377"/>
                  <a:pt x="1657" y="398"/>
                  <a:pt x="1633" y="422"/>
                </a:cubicBezTo>
                <a:lnTo>
                  <a:pt x="1590" y="465"/>
                </a:lnTo>
                <a:lnTo>
                  <a:pt x="1658" y="533"/>
                </a:lnTo>
                <a:lnTo>
                  <a:pt x="1636" y="555"/>
                </a:lnTo>
                <a:close/>
                <a:moveTo>
                  <a:pt x="1570" y="445"/>
                </a:moveTo>
                <a:lnTo>
                  <a:pt x="1613" y="402"/>
                </a:lnTo>
                <a:cubicBezTo>
                  <a:pt x="1628" y="387"/>
                  <a:pt x="1635" y="374"/>
                  <a:pt x="1636" y="363"/>
                </a:cubicBezTo>
                <a:cubicBezTo>
                  <a:pt x="1637" y="352"/>
                  <a:pt x="1632" y="341"/>
                  <a:pt x="1622" y="331"/>
                </a:cubicBezTo>
                <a:cubicBezTo>
                  <a:pt x="1615" y="324"/>
                  <a:pt x="1608" y="320"/>
                  <a:pt x="1599" y="319"/>
                </a:cubicBezTo>
                <a:cubicBezTo>
                  <a:pt x="1590" y="317"/>
                  <a:pt x="1583" y="319"/>
                  <a:pt x="1575" y="323"/>
                </a:cubicBezTo>
                <a:cubicBezTo>
                  <a:pt x="1570" y="325"/>
                  <a:pt x="1563" y="332"/>
                  <a:pt x="1553" y="342"/>
                </a:cubicBezTo>
                <a:lnTo>
                  <a:pt x="1510" y="385"/>
                </a:lnTo>
                <a:lnTo>
                  <a:pt x="1570" y="445"/>
                </a:lnTo>
                <a:close/>
                <a:moveTo>
                  <a:pt x="1730" y="353"/>
                </a:moveTo>
                <a:lnTo>
                  <a:pt x="1749" y="331"/>
                </a:lnTo>
                <a:cubicBezTo>
                  <a:pt x="1758" y="338"/>
                  <a:pt x="1768" y="343"/>
                  <a:pt x="1777" y="344"/>
                </a:cubicBezTo>
                <a:cubicBezTo>
                  <a:pt x="1786" y="346"/>
                  <a:pt x="1796" y="345"/>
                  <a:pt x="1807" y="341"/>
                </a:cubicBezTo>
                <a:cubicBezTo>
                  <a:pt x="1818" y="336"/>
                  <a:pt x="1828" y="329"/>
                  <a:pt x="1837" y="320"/>
                </a:cubicBezTo>
                <a:cubicBezTo>
                  <a:pt x="1846" y="311"/>
                  <a:pt x="1852" y="302"/>
                  <a:pt x="1856" y="293"/>
                </a:cubicBezTo>
                <a:cubicBezTo>
                  <a:pt x="1860" y="284"/>
                  <a:pt x="1861" y="276"/>
                  <a:pt x="1860" y="269"/>
                </a:cubicBezTo>
                <a:cubicBezTo>
                  <a:pt x="1859" y="261"/>
                  <a:pt x="1856" y="255"/>
                  <a:pt x="1851" y="249"/>
                </a:cubicBezTo>
                <a:cubicBezTo>
                  <a:pt x="1845" y="244"/>
                  <a:pt x="1839" y="241"/>
                  <a:pt x="1832" y="240"/>
                </a:cubicBezTo>
                <a:cubicBezTo>
                  <a:pt x="1825" y="239"/>
                  <a:pt x="1817" y="241"/>
                  <a:pt x="1807" y="245"/>
                </a:cubicBezTo>
                <a:cubicBezTo>
                  <a:pt x="1801" y="248"/>
                  <a:pt x="1788" y="255"/>
                  <a:pt x="1769" y="267"/>
                </a:cubicBezTo>
                <a:cubicBezTo>
                  <a:pt x="1750" y="279"/>
                  <a:pt x="1736" y="286"/>
                  <a:pt x="1726" y="289"/>
                </a:cubicBezTo>
                <a:cubicBezTo>
                  <a:pt x="1714" y="293"/>
                  <a:pt x="1703" y="294"/>
                  <a:pt x="1692" y="291"/>
                </a:cubicBezTo>
                <a:cubicBezTo>
                  <a:pt x="1682" y="289"/>
                  <a:pt x="1673" y="284"/>
                  <a:pt x="1666" y="276"/>
                </a:cubicBezTo>
                <a:cubicBezTo>
                  <a:pt x="1657" y="268"/>
                  <a:pt x="1652" y="258"/>
                  <a:pt x="1649" y="245"/>
                </a:cubicBezTo>
                <a:cubicBezTo>
                  <a:pt x="1647" y="233"/>
                  <a:pt x="1648" y="221"/>
                  <a:pt x="1653" y="208"/>
                </a:cubicBezTo>
                <a:cubicBezTo>
                  <a:pt x="1659" y="194"/>
                  <a:pt x="1667" y="182"/>
                  <a:pt x="1679" y="171"/>
                </a:cubicBezTo>
                <a:cubicBezTo>
                  <a:pt x="1691" y="158"/>
                  <a:pt x="1704" y="149"/>
                  <a:pt x="1717" y="144"/>
                </a:cubicBezTo>
                <a:cubicBezTo>
                  <a:pt x="1731" y="138"/>
                  <a:pt x="1744" y="137"/>
                  <a:pt x="1757" y="140"/>
                </a:cubicBezTo>
                <a:cubicBezTo>
                  <a:pt x="1770" y="142"/>
                  <a:pt x="1782" y="149"/>
                  <a:pt x="1792" y="158"/>
                </a:cubicBezTo>
                <a:lnTo>
                  <a:pt x="1772" y="181"/>
                </a:lnTo>
                <a:cubicBezTo>
                  <a:pt x="1760" y="171"/>
                  <a:pt x="1748" y="167"/>
                  <a:pt x="1736" y="168"/>
                </a:cubicBezTo>
                <a:cubicBezTo>
                  <a:pt x="1724" y="170"/>
                  <a:pt x="1712" y="177"/>
                  <a:pt x="1699" y="190"/>
                </a:cubicBezTo>
                <a:cubicBezTo>
                  <a:pt x="1686" y="203"/>
                  <a:pt x="1678" y="215"/>
                  <a:pt x="1677" y="226"/>
                </a:cubicBezTo>
                <a:cubicBezTo>
                  <a:pt x="1676" y="237"/>
                  <a:pt x="1679" y="247"/>
                  <a:pt x="1686" y="253"/>
                </a:cubicBezTo>
                <a:cubicBezTo>
                  <a:pt x="1692" y="260"/>
                  <a:pt x="1699" y="262"/>
                  <a:pt x="1707" y="262"/>
                </a:cubicBezTo>
                <a:cubicBezTo>
                  <a:pt x="1715" y="261"/>
                  <a:pt x="1730" y="254"/>
                  <a:pt x="1753" y="240"/>
                </a:cubicBezTo>
                <a:cubicBezTo>
                  <a:pt x="1775" y="226"/>
                  <a:pt x="1791" y="217"/>
                  <a:pt x="1800" y="214"/>
                </a:cubicBezTo>
                <a:cubicBezTo>
                  <a:pt x="1815" y="209"/>
                  <a:pt x="1828" y="207"/>
                  <a:pt x="1839" y="209"/>
                </a:cubicBezTo>
                <a:cubicBezTo>
                  <a:pt x="1851" y="212"/>
                  <a:pt x="1861" y="217"/>
                  <a:pt x="1870" y="226"/>
                </a:cubicBezTo>
                <a:cubicBezTo>
                  <a:pt x="1879" y="235"/>
                  <a:pt x="1885" y="246"/>
                  <a:pt x="1888" y="259"/>
                </a:cubicBezTo>
                <a:cubicBezTo>
                  <a:pt x="1891" y="272"/>
                  <a:pt x="1889" y="286"/>
                  <a:pt x="1884" y="300"/>
                </a:cubicBezTo>
                <a:cubicBezTo>
                  <a:pt x="1879" y="314"/>
                  <a:pt x="1870" y="327"/>
                  <a:pt x="1858" y="339"/>
                </a:cubicBezTo>
                <a:cubicBezTo>
                  <a:pt x="1843" y="354"/>
                  <a:pt x="1828" y="364"/>
                  <a:pt x="1813" y="370"/>
                </a:cubicBezTo>
                <a:cubicBezTo>
                  <a:pt x="1799" y="376"/>
                  <a:pt x="1784" y="377"/>
                  <a:pt x="1769" y="374"/>
                </a:cubicBezTo>
                <a:cubicBezTo>
                  <a:pt x="1755" y="371"/>
                  <a:pt x="1741" y="364"/>
                  <a:pt x="1730" y="353"/>
                </a:cubicBezTo>
                <a:close/>
                <a:moveTo>
                  <a:pt x="2030" y="122"/>
                </a:moveTo>
                <a:lnTo>
                  <a:pt x="2050" y="141"/>
                </a:lnTo>
                <a:lnTo>
                  <a:pt x="1939" y="252"/>
                </a:lnTo>
                <a:cubicBezTo>
                  <a:pt x="1934" y="248"/>
                  <a:pt x="1930" y="242"/>
                  <a:pt x="1927" y="236"/>
                </a:cubicBezTo>
                <a:cubicBezTo>
                  <a:pt x="1922" y="225"/>
                  <a:pt x="1919" y="213"/>
                  <a:pt x="1918" y="200"/>
                </a:cubicBezTo>
                <a:cubicBezTo>
                  <a:pt x="1917" y="186"/>
                  <a:pt x="1918" y="169"/>
                  <a:pt x="1920" y="147"/>
                </a:cubicBezTo>
                <a:cubicBezTo>
                  <a:pt x="1923" y="114"/>
                  <a:pt x="1923" y="90"/>
                  <a:pt x="1921" y="75"/>
                </a:cubicBezTo>
                <a:cubicBezTo>
                  <a:pt x="1919" y="60"/>
                  <a:pt x="1914" y="48"/>
                  <a:pt x="1906" y="40"/>
                </a:cubicBezTo>
                <a:cubicBezTo>
                  <a:pt x="1898" y="32"/>
                  <a:pt x="1888" y="28"/>
                  <a:pt x="1876" y="28"/>
                </a:cubicBezTo>
                <a:cubicBezTo>
                  <a:pt x="1865" y="29"/>
                  <a:pt x="1855" y="33"/>
                  <a:pt x="1845" y="43"/>
                </a:cubicBezTo>
                <a:cubicBezTo>
                  <a:pt x="1835" y="53"/>
                  <a:pt x="1830" y="64"/>
                  <a:pt x="1830" y="76"/>
                </a:cubicBezTo>
                <a:cubicBezTo>
                  <a:pt x="1830" y="88"/>
                  <a:pt x="1835" y="99"/>
                  <a:pt x="1846" y="109"/>
                </a:cubicBezTo>
                <a:lnTo>
                  <a:pt x="1823" y="128"/>
                </a:lnTo>
                <a:cubicBezTo>
                  <a:pt x="1808" y="111"/>
                  <a:pt x="1802" y="94"/>
                  <a:pt x="1803" y="76"/>
                </a:cubicBezTo>
                <a:cubicBezTo>
                  <a:pt x="1804" y="58"/>
                  <a:pt x="1813" y="41"/>
                  <a:pt x="1829" y="25"/>
                </a:cubicBezTo>
                <a:cubicBezTo>
                  <a:pt x="1845" y="9"/>
                  <a:pt x="1862" y="1"/>
                  <a:pt x="1880" y="0"/>
                </a:cubicBezTo>
                <a:cubicBezTo>
                  <a:pt x="1899" y="0"/>
                  <a:pt x="1914" y="6"/>
                  <a:pt x="1928" y="20"/>
                </a:cubicBezTo>
                <a:cubicBezTo>
                  <a:pt x="1934" y="26"/>
                  <a:pt x="1940" y="34"/>
                  <a:pt x="1943" y="43"/>
                </a:cubicBezTo>
                <a:cubicBezTo>
                  <a:pt x="1947" y="53"/>
                  <a:pt x="1949" y="64"/>
                  <a:pt x="1950" y="78"/>
                </a:cubicBezTo>
                <a:cubicBezTo>
                  <a:pt x="1951" y="91"/>
                  <a:pt x="1950" y="112"/>
                  <a:pt x="1948" y="139"/>
                </a:cubicBezTo>
                <a:cubicBezTo>
                  <a:pt x="1946" y="162"/>
                  <a:pt x="1945" y="177"/>
                  <a:pt x="1945" y="184"/>
                </a:cubicBezTo>
                <a:cubicBezTo>
                  <a:pt x="1945" y="191"/>
                  <a:pt x="1946" y="198"/>
                  <a:pt x="1948" y="204"/>
                </a:cubicBezTo>
                <a:lnTo>
                  <a:pt x="2030" y="122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7" name="Freeform 83"/>
          <p:cNvSpPr>
            <a:spLocks noEditPoints="1"/>
          </p:cNvSpPr>
          <p:nvPr/>
        </p:nvSpPr>
        <p:spPr bwMode="auto">
          <a:xfrm>
            <a:off x="7361380" y="5035690"/>
            <a:ext cx="771525" cy="769938"/>
          </a:xfrm>
          <a:custGeom>
            <a:avLst/>
            <a:gdLst>
              <a:gd name="T0" fmla="*/ 119 w 2024"/>
              <a:gd name="T1" fmla="*/ 1750 h 2018"/>
              <a:gd name="T2" fmla="*/ 122 w 2024"/>
              <a:gd name="T3" fmla="*/ 1928 h 2018"/>
              <a:gd name="T4" fmla="*/ 168 w 2024"/>
              <a:gd name="T5" fmla="*/ 1826 h 2018"/>
              <a:gd name="T6" fmla="*/ 42 w 2024"/>
              <a:gd name="T7" fmla="*/ 1848 h 2018"/>
              <a:gd name="T8" fmla="*/ 256 w 2024"/>
              <a:gd name="T9" fmla="*/ 1604 h 2018"/>
              <a:gd name="T10" fmla="*/ 370 w 2024"/>
              <a:gd name="T11" fmla="*/ 1668 h 2018"/>
              <a:gd name="T12" fmla="*/ 389 w 2024"/>
              <a:gd name="T13" fmla="*/ 1797 h 2018"/>
              <a:gd name="T14" fmla="*/ 310 w 2024"/>
              <a:gd name="T15" fmla="*/ 1661 h 2018"/>
              <a:gd name="T16" fmla="*/ 199 w 2024"/>
              <a:gd name="T17" fmla="*/ 1690 h 2018"/>
              <a:gd name="T18" fmla="*/ 392 w 2024"/>
              <a:gd name="T19" fmla="*/ 1744 h 2018"/>
              <a:gd name="T20" fmla="*/ 309 w 2024"/>
              <a:gd name="T21" fmla="*/ 1722 h 2018"/>
              <a:gd name="T22" fmla="*/ 372 w 2024"/>
              <a:gd name="T23" fmla="*/ 1478 h 2018"/>
              <a:gd name="T24" fmla="*/ 565 w 2024"/>
              <a:gd name="T25" fmla="*/ 1519 h 2018"/>
              <a:gd name="T26" fmla="*/ 482 w 2024"/>
              <a:gd name="T27" fmla="*/ 1704 h 2018"/>
              <a:gd name="T28" fmla="*/ 540 w 2024"/>
              <a:gd name="T29" fmla="*/ 1540 h 2018"/>
              <a:gd name="T30" fmla="*/ 356 w 2024"/>
              <a:gd name="T31" fmla="*/ 1534 h 2018"/>
              <a:gd name="T32" fmla="*/ 813 w 2024"/>
              <a:gd name="T33" fmla="*/ 1466 h 2018"/>
              <a:gd name="T34" fmla="*/ 707 w 2024"/>
              <a:gd name="T35" fmla="*/ 1146 h 2018"/>
              <a:gd name="T36" fmla="*/ 781 w 2024"/>
              <a:gd name="T37" fmla="*/ 1268 h 2018"/>
              <a:gd name="T38" fmla="*/ 762 w 2024"/>
              <a:gd name="T39" fmla="*/ 1248 h 2018"/>
              <a:gd name="T40" fmla="*/ 701 w 2024"/>
              <a:gd name="T41" fmla="*/ 1188 h 2018"/>
              <a:gd name="T42" fmla="*/ 894 w 2024"/>
              <a:gd name="T43" fmla="*/ 956 h 2018"/>
              <a:gd name="T44" fmla="*/ 979 w 2024"/>
              <a:gd name="T45" fmla="*/ 1054 h 2018"/>
              <a:gd name="T46" fmla="*/ 940 w 2024"/>
              <a:gd name="T47" fmla="*/ 1246 h 2018"/>
              <a:gd name="T48" fmla="*/ 1021 w 2024"/>
              <a:gd name="T49" fmla="*/ 915 h 2018"/>
              <a:gd name="T50" fmla="*/ 1083 w 2024"/>
              <a:gd name="T51" fmla="*/ 926 h 2018"/>
              <a:gd name="T52" fmla="*/ 1092 w 2024"/>
              <a:gd name="T53" fmla="*/ 977 h 2018"/>
              <a:gd name="T54" fmla="*/ 1171 w 2024"/>
              <a:gd name="T55" fmla="*/ 752 h 2018"/>
              <a:gd name="T56" fmla="*/ 1141 w 2024"/>
              <a:gd name="T57" fmla="*/ 707 h 2018"/>
              <a:gd name="T58" fmla="*/ 1376 w 2024"/>
              <a:gd name="T59" fmla="*/ 810 h 2018"/>
              <a:gd name="T60" fmla="*/ 1343 w 2024"/>
              <a:gd name="T61" fmla="*/ 598 h 2018"/>
              <a:gd name="T62" fmla="*/ 1260 w 2024"/>
              <a:gd name="T63" fmla="*/ 686 h 2018"/>
              <a:gd name="T64" fmla="*/ 1380 w 2024"/>
              <a:gd name="T65" fmla="*/ 601 h 2018"/>
              <a:gd name="T66" fmla="*/ 1467 w 2024"/>
              <a:gd name="T67" fmla="*/ 679 h 2018"/>
              <a:gd name="T68" fmla="*/ 1435 w 2024"/>
              <a:gd name="T69" fmla="*/ 462 h 2018"/>
              <a:gd name="T70" fmla="*/ 1580 w 2024"/>
              <a:gd name="T71" fmla="*/ 607 h 2018"/>
              <a:gd name="T72" fmla="*/ 1587 w 2024"/>
              <a:gd name="T73" fmla="*/ 282 h 2018"/>
              <a:gd name="T74" fmla="*/ 1590 w 2024"/>
              <a:gd name="T75" fmla="*/ 460 h 2018"/>
              <a:gd name="T76" fmla="*/ 1636 w 2024"/>
              <a:gd name="T77" fmla="*/ 358 h 2018"/>
              <a:gd name="T78" fmla="*/ 1510 w 2024"/>
              <a:gd name="T79" fmla="*/ 380 h 2018"/>
              <a:gd name="T80" fmla="*/ 1807 w 2024"/>
              <a:gd name="T81" fmla="*/ 336 h 2018"/>
              <a:gd name="T82" fmla="*/ 1832 w 2024"/>
              <a:gd name="T83" fmla="*/ 235 h 2018"/>
              <a:gd name="T84" fmla="*/ 1666 w 2024"/>
              <a:gd name="T85" fmla="*/ 271 h 2018"/>
              <a:gd name="T86" fmla="*/ 1757 w 2024"/>
              <a:gd name="T87" fmla="*/ 135 h 2018"/>
              <a:gd name="T88" fmla="*/ 1677 w 2024"/>
              <a:gd name="T89" fmla="*/ 221 h 2018"/>
              <a:gd name="T90" fmla="*/ 1839 w 2024"/>
              <a:gd name="T91" fmla="*/ 204 h 2018"/>
              <a:gd name="T92" fmla="*/ 1813 w 2024"/>
              <a:gd name="T93" fmla="*/ 365 h 2018"/>
              <a:gd name="T94" fmla="*/ 1952 w 2024"/>
              <a:gd name="T95" fmla="*/ 190 h 2018"/>
              <a:gd name="T96" fmla="*/ 1915 w 2024"/>
              <a:gd name="T97" fmla="*/ 108 h 2018"/>
              <a:gd name="T98" fmla="*/ 1897 w 2024"/>
              <a:gd name="T99" fmla="*/ 39 h 2018"/>
              <a:gd name="T100" fmla="*/ 1818 w 2024"/>
              <a:gd name="T101" fmla="*/ 117 h 2018"/>
              <a:gd name="T102" fmla="*/ 1918 w 2024"/>
              <a:gd name="T103" fmla="*/ 18 h 2018"/>
              <a:gd name="T104" fmla="*/ 2023 w 2024"/>
              <a:gd name="T105" fmla="*/ 138 h 201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</a:cxnLst>
            <a:rect l="0" t="0" r="r" b="b"/>
            <a:pathLst>
              <a:path w="2024" h="2018">
                <a:moveTo>
                  <a:pt x="168" y="2018"/>
                </a:moveTo>
                <a:lnTo>
                  <a:pt x="0" y="1850"/>
                </a:lnTo>
                <a:lnTo>
                  <a:pt x="63" y="1787"/>
                </a:lnTo>
                <a:cubicBezTo>
                  <a:pt x="74" y="1776"/>
                  <a:pt x="83" y="1768"/>
                  <a:pt x="90" y="1763"/>
                </a:cubicBezTo>
                <a:cubicBezTo>
                  <a:pt x="100" y="1756"/>
                  <a:pt x="109" y="1752"/>
                  <a:pt x="119" y="1750"/>
                </a:cubicBezTo>
                <a:cubicBezTo>
                  <a:pt x="128" y="1748"/>
                  <a:pt x="138" y="1749"/>
                  <a:pt x="149" y="1753"/>
                </a:cubicBezTo>
                <a:cubicBezTo>
                  <a:pt x="159" y="1756"/>
                  <a:pt x="168" y="1762"/>
                  <a:pt x="177" y="1771"/>
                </a:cubicBezTo>
                <a:cubicBezTo>
                  <a:pt x="191" y="1785"/>
                  <a:pt x="198" y="1802"/>
                  <a:pt x="199" y="1821"/>
                </a:cubicBezTo>
                <a:cubicBezTo>
                  <a:pt x="200" y="1840"/>
                  <a:pt x="189" y="1861"/>
                  <a:pt x="165" y="1885"/>
                </a:cubicBezTo>
                <a:lnTo>
                  <a:pt x="122" y="1928"/>
                </a:lnTo>
                <a:lnTo>
                  <a:pt x="190" y="1996"/>
                </a:lnTo>
                <a:lnTo>
                  <a:pt x="168" y="2018"/>
                </a:lnTo>
                <a:close/>
                <a:moveTo>
                  <a:pt x="102" y="1908"/>
                </a:moveTo>
                <a:lnTo>
                  <a:pt x="145" y="1865"/>
                </a:lnTo>
                <a:cubicBezTo>
                  <a:pt x="160" y="1850"/>
                  <a:pt x="167" y="1837"/>
                  <a:pt x="168" y="1826"/>
                </a:cubicBezTo>
                <a:cubicBezTo>
                  <a:pt x="169" y="1815"/>
                  <a:pt x="164" y="1804"/>
                  <a:pt x="154" y="1794"/>
                </a:cubicBezTo>
                <a:cubicBezTo>
                  <a:pt x="147" y="1787"/>
                  <a:pt x="140" y="1783"/>
                  <a:pt x="131" y="1782"/>
                </a:cubicBezTo>
                <a:cubicBezTo>
                  <a:pt x="122" y="1780"/>
                  <a:pt x="114" y="1781"/>
                  <a:pt x="107" y="1786"/>
                </a:cubicBezTo>
                <a:cubicBezTo>
                  <a:pt x="102" y="1788"/>
                  <a:pt x="95" y="1795"/>
                  <a:pt x="85" y="1805"/>
                </a:cubicBezTo>
                <a:lnTo>
                  <a:pt x="42" y="1848"/>
                </a:lnTo>
                <a:lnTo>
                  <a:pt x="102" y="1908"/>
                </a:lnTo>
                <a:close/>
                <a:moveTo>
                  <a:pt x="325" y="1861"/>
                </a:moveTo>
                <a:lnTo>
                  <a:pt x="157" y="1693"/>
                </a:lnTo>
                <a:lnTo>
                  <a:pt x="220" y="1630"/>
                </a:lnTo>
                <a:cubicBezTo>
                  <a:pt x="233" y="1617"/>
                  <a:pt x="245" y="1608"/>
                  <a:pt x="256" y="1604"/>
                </a:cubicBezTo>
                <a:cubicBezTo>
                  <a:pt x="267" y="1600"/>
                  <a:pt x="279" y="1599"/>
                  <a:pt x="290" y="1601"/>
                </a:cubicBezTo>
                <a:cubicBezTo>
                  <a:pt x="302" y="1604"/>
                  <a:pt x="311" y="1609"/>
                  <a:pt x="319" y="1617"/>
                </a:cubicBezTo>
                <a:cubicBezTo>
                  <a:pt x="326" y="1624"/>
                  <a:pt x="331" y="1633"/>
                  <a:pt x="333" y="1643"/>
                </a:cubicBezTo>
                <a:cubicBezTo>
                  <a:pt x="336" y="1653"/>
                  <a:pt x="335" y="1664"/>
                  <a:pt x="331" y="1676"/>
                </a:cubicBezTo>
                <a:cubicBezTo>
                  <a:pt x="344" y="1669"/>
                  <a:pt x="357" y="1666"/>
                  <a:pt x="370" y="1668"/>
                </a:cubicBezTo>
                <a:cubicBezTo>
                  <a:pt x="382" y="1670"/>
                  <a:pt x="394" y="1675"/>
                  <a:pt x="403" y="1685"/>
                </a:cubicBezTo>
                <a:cubicBezTo>
                  <a:pt x="411" y="1693"/>
                  <a:pt x="417" y="1702"/>
                  <a:pt x="420" y="1712"/>
                </a:cubicBezTo>
                <a:cubicBezTo>
                  <a:pt x="424" y="1722"/>
                  <a:pt x="425" y="1732"/>
                  <a:pt x="424" y="1740"/>
                </a:cubicBezTo>
                <a:cubicBezTo>
                  <a:pt x="423" y="1749"/>
                  <a:pt x="419" y="1758"/>
                  <a:pt x="414" y="1767"/>
                </a:cubicBezTo>
                <a:cubicBezTo>
                  <a:pt x="408" y="1776"/>
                  <a:pt x="400" y="1786"/>
                  <a:pt x="389" y="1797"/>
                </a:cubicBezTo>
                <a:lnTo>
                  <a:pt x="325" y="1861"/>
                </a:lnTo>
                <a:close/>
                <a:moveTo>
                  <a:pt x="250" y="1741"/>
                </a:moveTo>
                <a:lnTo>
                  <a:pt x="286" y="1705"/>
                </a:lnTo>
                <a:cubicBezTo>
                  <a:pt x="296" y="1695"/>
                  <a:pt x="303" y="1687"/>
                  <a:pt x="306" y="1682"/>
                </a:cubicBezTo>
                <a:cubicBezTo>
                  <a:pt x="310" y="1674"/>
                  <a:pt x="311" y="1667"/>
                  <a:pt x="310" y="1661"/>
                </a:cubicBezTo>
                <a:cubicBezTo>
                  <a:pt x="309" y="1654"/>
                  <a:pt x="306" y="1647"/>
                  <a:pt x="300" y="1642"/>
                </a:cubicBezTo>
                <a:cubicBezTo>
                  <a:pt x="294" y="1636"/>
                  <a:pt x="288" y="1632"/>
                  <a:pt x="281" y="1631"/>
                </a:cubicBezTo>
                <a:cubicBezTo>
                  <a:pt x="274" y="1629"/>
                  <a:pt x="267" y="1630"/>
                  <a:pt x="261" y="1634"/>
                </a:cubicBezTo>
                <a:cubicBezTo>
                  <a:pt x="254" y="1637"/>
                  <a:pt x="245" y="1645"/>
                  <a:pt x="233" y="1657"/>
                </a:cubicBezTo>
                <a:lnTo>
                  <a:pt x="199" y="1690"/>
                </a:lnTo>
                <a:lnTo>
                  <a:pt x="250" y="1741"/>
                </a:lnTo>
                <a:close/>
                <a:moveTo>
                  <a:pt x="328" y="1819"/>
                </a:moveTo>
                <a:lnTo>
                  <a:pt x="370" y="1777"/>
                </a:lnTo>
                <a:cubicBezTo>
                  <a:pt x="377" y="1770"/>
                  <a:pt x="382" y="1764"/>
                  <a:pt x="384" y="1761"/>
                </a:cubicBezTo>
                <a:cubicBezTo>
                  <a:pt x="388" y="1755"/>
                  <a:pt x="391" y="1749"/>
                  <a:pt x="392" y="1744"/>
                </a:cubicBezTo>
                <a:cubicBezTo>
                  <a:pt x="393" y="1738"/>
                  <a:pt x="393" y="1732"/>
                  <a:pt x="391" y="1726"/>
                </a:cubicBezTo>
                <a:cubicBezTo>
                  <a:pt x="389" y="1719"/>
                  <a:pt x="386" y="1714"/>
                  <a:pt x="380" y="1708"/>
                </a:cubicBezTo>
                <a:cubicBezTo>
                  <a:pt x="374" y="1702"/>
                  <a:pt x="367" y="1698"/>
                  <a:pt x="359" y="1697"/>
                </a:cubicBezTo>
                <a:cubicBezTo>
                  <a:pt x="351" y="1695"/>
                  <a:pt x="344" y="1697"/>
                  <a:pt x="336" y="1700"/>
                </a:cubicBezTo>
                <a:cubicBezTo>
                  <a:pt x="329" y="1704"/>
                  <a:pt x="319" y="1711"/>
                  <a:pt x="309" y="1722"/>
                </a:cubicBezTo>
                <a:lnTo>
                  <a:pt x="270" y="1761"/>
                </a:lnTo>
                <a:lnTo>
                  <a:pt x="328" y="1819"/>
                </a:lnTo>
                <a:close/>
                <a:moveTo>
                  <a:pt x="482" y="1704"/>
                </a:moveTo>
                <a:lnTo>
                  <a:pt x="314" y="1536"/>
                </a:lnTo>
                <a:lnTo>
                  <a:pt x="372" y="1478"/>
                </a:lnTo>
                <a:cubicBezTo>
                  <a:pt x="385" y="1465"/>
                  <a:pt x="395" y="1456"/>
                  <a:pt x="404" y="1451"/>
                </a:cubicBezTo>
                <a:cubicBezTo>
                  <a:pt x="416" y="1444"/>
                  <a:pt x="428" y="1439"/>
                  <a:pt x="441" y="1438"/>
                </a:cubicBezTo>
                <a:cubicBezTo>
                  <a:pt x="457" y="1437"/>
                  <a:pt x="473" y="1440"/>
                  <a:pt x="489" y="1447"/>
                </a:cubicBezTo>
                <a:cubicBezTo>
                  <a:pt x="505" y="1454"/>
                  <a:pt x="521" y="1466"/>
                  <a:pt x="536" y="1481"/>
                </a:cubicBezTo>
                <a:cubicBezTo>
                  <a:pt x="549" y="1493"/>
                  <a:pt x="558" y="1506"/>
                  <a:pt x="565" y="1519"/>
                </a:cubicBezTo>
                <a:cubicBezTo>
                  <a:pt x="572" y="1532"/>
                  <a:pt x="576" y="1544"/>
                  <a:pt x="578" y="1555"/>
                </a:cubicBezTo>
                <a:cubicBezTo>
                  <a:pt x="580" y="1566"/>
                  <a:pt x="580" y="1576"/>
                  <a:pt x="578" y="1585"/>
                </a:cubicBezTo>
                <a:cubicBezTo>
                  <a:pt x="576" y="1595"/>
                  <a:pt x="572" y="1604"/>
                  <a:pt x="567" y="1614"/>
                </a:cubicBezTo>
                <a:cubicBezTo>
                  <a:pt x="561" y="1624"/>
                  <a:pt x="553" y="1634"/>
                  <a:pt x="542" y="1644"/>
                </a:cubicBezTo>
                <a:lnTo>
                  <a:pt x="482" y="1704"/>
                </a:lnTo>
                <a:close/>
                <a:moveTo>
                  <a:pt x="484" y="1662"/>
                </a:moveTo>
                <a:lnTo>
                  <a:pt x="520" y="1626"/>
                </a:lnTo>
                <a:cubicBezTo>
                  <a:pt x="531" y="1615"/>
                  <a:pt x="539" y="1606"/>
                  <a:pt x="543" y="1597"/>
                </a:cubicBezTo>
                <a:cubicBezTo>
                  <a:pt x="547" y="1589"/>
                  <a:pt x="549" y="1581"/>
                  <a:pt x="549" y="1574"/>
                </a:cubicBezTo>
                <a:cubicBezTo>
                  <a:pt x="549" y="1563"/>
                  <a:pt x="546" y="1552"/>
                  <a:pt x="540" y="1540"/>
                </a:cubicBezTo>
                <a:cubicBezTo>
                  <a:pt x="535" y="1528"/>
                  <a:pt x="525" y="1516"/>
                  <a:pt x="512" y="1503"/>
                </a:cubicBezTo>
                <a:cubicBezTo>
                  <a:pt x="495" y="1486"/>
                  <a:pt x="479" y="1475"/>
                  <a:pt x="463" y="1471"/>
                </a:cubicBezTo>
                <a:cubicBezTo>
                  <a:pt x="448" y="1468"/>
                  <a:pt x="435" y="1468"/>
                  <a:pt x="423" y="1473"/>
                </a:cubicBezTo>
                <a:cubicBezTo>
                  <a:pt x="415" y="1477"/>
                  <a:pt x="404" y="1485"/>
                  <a:pt x="391" y="1499"/>
                </a:cubicBezTo>
                <a:lnTo>
                  <a:pt x="356" y="1534"/>
                </a:lnTo>
                <a:lnTo>
                  <a:pt x="484" y="1662"/>
                </a:lnTo>
                <a:close/>
                <a:moveTo>
                  <a:pt x="676" y="1603"/>
                </a:moveTo>
                <a:lnTo>
                  <a:pt x="662" y="1588"/>
                </a:lnTo>
                <a:lnTo>
                  <a:pt x="798" y="1451"/>
                </a:lnTo>
                <a:lnTo>
                  <a:pt x="813" y="1466"/>
                </a:lnTo>
                <a:lnTo>
                  <a:pt x="676" y="1603"/>
                </a:lnTo>
                <a:close/>
                <a:moveTo>
                  <a:pt x="784" y="1402"/>
                </a:moveTo>
                <a:lnTo>
                  <a:pt x="616" y="1234"/>
                </a:lnTo>
                <a:lnTo>
                  <a:pt x="680" y="1170"/>
                </a:lnTo>
                <a:cubicBezTo>
                  <a:pt x="691" y="1159"/>
                  <a:pt x="700" y="1151"/>
                  <a:pt x="707" y="1146"/>
                </a:cubicBezTo>
                <a:cubicBezTo>
                  <a:pt x="717" y="1139"/>
                  <a:pt x="726" y="1135"/>
                  <a:pt x="736" y="1133"/>
                </a:cubicBezTo>
                <a:cubicBezTo>
                  <a:pt x="745" y="1132"/>
                  <a:pt x="755" y="1133"/>
                  <a:pt x="765" y="1136"/>
                </a:cubicBezTo>
                <a:cubicBezTo>
                  <a:pt x="776" y="1140"/>
                  <a:pt x="785" y="1146"/>
                  <a:pt x="793" y="1154"/>
                </a:cubicBezTo>
                <a:cubicBezTo>
                  <a:pt x="808" y="1168"/>
                  <a:pt x="815" y="1185"/>
                  <a:pt x="816" y="1204"/>
                </a:cubicBezTo>
                <a:cubicBezTo>
                  <a:pt x="817" y="1223"/>
                  <a:pt x="805" y="1244"/>
                  <a:pt x="781" y="1268"/>
                </a:cubicBezTo>
                <a:lnTo>
                  <a:pt x="738" y="1311"/>
                </a:lnTo>
                <a:lnTo>
                  <a:pt x="807" y="1380"/>
                </a:lnTo>
                <a:lnTo>
                  <a:pt x="784" y="1402"/>
                </a:lnTo>
                <a:close/>
                <a:moveTo>
                  <a:pt x="719" y="1291"/>
                </a:moveTo>
                <a:lnTo>
                  <a:pt x="762" y="1248"/>
                </a:lnTo>
                <a:cubicBezTo>
                  <a:pt x="776" y="1234"/>
                  <a:pt x="784" y="1221"/>
                  <a:pt x="785" y="1209"/>
                </a:cubicBezTo>
                <a:cubicBezTo>
                  <a:pt x="785" y="1198"/>
                  <a:pt x="781" y="1187"/>
                  <a:pt x="771" y="1178"/>
                </a:cubicBezTo>
                <a:cubicBezTo>
                  <a:pt x="764" y="1171"/>
                  <a:pt x="756" y="1166"/>
                  <a:pt x="748" y="1165"/>
                </a:cubicBezTo>
                <a:cubicBezTo>
                  <a:pt x="739" y="1163"/>
                  <a:pt x="731" y="1165"/>
                  <a:pt x="724" y="1169"/>
                </a:cubicBezTo>
                <a:cubicBezTo>
                  <a:pt x="719" y="1172"/>
                  <a:pt x="712" y="1178"/>
                  <a:pt x="701" y="1188"/>
                </a:cubicBezTo>
                <a:lnTo>
                  <a:pt x="658" y="1231"/>
                </a:lnTo>
                <a:lnTo>
                  <a:pt x="719" y="1291"/>
                </a:lnTo>
                <a:close/>
                <a:moveTo>
                  <a:pt x="940" y="1246"/>
                </a:moveTo>
                <a:lnTo>
                  <a:pt x="772" y="1078"/>
                </a:lnTo>
                <a:lnTo>
                  <a:pt x="894" y="956"/>
                </a:lnTo>
                <a:lnTo>
                  <a:pt x="914" y="976"/>
                </a:lnTo>
                <a:lnTo>
                  <a:pt x="814" y="1075"/>
                </a:lnTo>
                <a:lnTo>
                  <a:pt x="866" y="1127"/>
                </a:lnTo>
                <a:lnTo>
                  <a:pt x="959" y="1034"/>
                </a:lnTo>
                <a:lnTo>
                  <a:pt x="979" y="1054"/>
                </a:lnTo>
                <a:lnTo>
                  <a:pt x="886" y="1146"/>
                </a:lnTo>
                <a:lnTo>
                  <a:pt x="943" y="1204"/>
                </a:lnTo>
                <a:lnTo>
                  <a:pt x="1046" y="1101"/>
                </a:lnTo>
                <a:lnTo>
                  <a:pt x="1066" y="1120"/>
                </a:lnTo>
                <a:lnTo>
                  <a:pt x="940" y="1246"/>
                </a:lnTo>
                <a:close/>
                <a:moveTo>
                  <a:pt x="1081" y="1105"/>
                </a:moveTo>
                <a:lnTo>
                  <a:pt x="1059" y="952"/>
                </a:lnTo>
                <a:lnTo>
                  <a:pt x="921" y="929"/>
                </a:lnTo>
                <a:lnTo>
                  <a:pt x="947" y="903"/>
                </a:lnTo>
                <a:lnTo>
                  <a:pt x="1021" y="915"/>
                </a:lnTo>
                <a:cubicBezTo>
                  <a:pt x="1036" y="918"/>
                  <a:pt x="1048" y="920"/>
                  <a:pt x="1055" y="922"/>
                </a:cubicBezTo>
                <a:cubicBezTo>
                  <a:pt x="1053" y="913"/>
                  <a:pt x="1051" y="902"/>
                  <a:pt x="1049" y="890"/>
                </a:cubicBezTo>
                <a:lnTo>
                  <a:pt x="1039" y="812"/>
                </a:lnTo>
                <a:lnTo>
                  <a:pt x="1063" y="787"/>
                </a:lnTo>
                <a:lnTo>
                  <a:pt x="1083" y="926"/>
                </a:lnTo>
                <a:lnTo>
                  <a:pt x="1235" y="951"/>
                </a:lnTo>
                <a:lnTo>
                  <a:pt x="1208" y="978"/>
                </a:lnTo>
                <a:lnTo>
                  <a:pt x="1106" y="961"/>
                </a:lnTo>
                <a:cubicBezTo>
                  <a:pt x="1100" y="960"/>
                  <a:pt x="1094" y="958"/>
                  <a:pt x="1087" y="957"/>
                </a:cubicBezTo>
                <a:cubicBezTo>
                  <a:pt x="1089" y="967"/>
                  <a:pt x="1091" y="974"/>
                  <a:pt x="1092" y="977"/>
                </a:cubicBezTo>
                <a:lnTo>
                  <a:pt x="1108" y="1078"/>
                </a:lnTo>
                <a:lnTo>
                  <a:pt x="1081" y="1105"/>
                </a:lnTo>
                <a:close/>
                <a:moveTo>
                  <a:pt x="1323" y="863"/>
                </a:moveTo>
                <a:lnTo>
                  <a:pt x="1303" y="884"/>
                </a:lnTo>
                <a:lnTo>
                  <a:pt x="1171" y="752"/>
                </a:lnTo>
                <a:cubicBezTo>
                  <a:pt x="1171" y="762"/>
                  <a:pt x="1169" y="773"/>
                  <a:pt x="1166" y="786"/>
                </a:cubicBezTo>
                <a:cubicBezTo>
                  <a:pt x="1163" y="799"/>
                  <a:pt x="1159" y="809"/>
                  <a:pt x="1155" y="818"/>
                </a:cubicBezTo>
                <a:lnTo>
                  <a:pt x="1135" y="798"/>
                </a:lnTo>
                <a:cubicBezTo>
                  <a:pt x="1141" y="781"/>
                  <a:pt x="1144" y="765"/>
                  <a:pt x="1145" y="748"/>
                </a:cubicBezTo>
                <a:cubicBezTo>
                  <a:pt x="1146" y="732"/>
                  <a:pt x="1145" y="718"/>
                  <a:pt x="1141" y="707"/>
                </a:cubicBezTo>
                <a:lnTo>
                  <a:pt x="1155" y="694"/>
                </a:lnTo>
                <a:lnTo>
                  <a:pt x="1323" y="863"/>
                </a:lnTo>
                <a:close/>
                <a:moveTo>
                  <a:pt x="1467" y="679"/>
                </a:moveTo>
                <a:lnTo>
                  <a:pt x="1487" y="699"/>
                </a:lnTo>
                <a:lnTo>
                  <a:pt x="1376" y="810"/>
                </a:lnTo>
                <a:cubicBezTo>
                  <a:pt x="1371" y="806"/>
                  <a:pt x="1367" y="800"/>
                  <a:pt x="1364" y="794"/>
                </a:cubicBezTo>
                <a:cubicBezTo>
                  <a:pt x="1359" y="783"/>
                  <a:pt x="1356" y="771"/>
                  <a:pt x="1355" y="758"/>
                </a:cubicBezTo>
                <a:cubicBezTo>
                  <a:pt x="1354" y="744"/>
                  <a:pt x="1355" y="727"/>
                  <a:pt x="1357" y="705"/>
                </a:cubicBezTo>
                <a:cubicBezTo>
                  <a:pt x="1360" y="672"/>
                  <a:pt x="1360" y="648"/>
                  <a:pt x="1358" y="633"/>
                </a:cubicBezTo>
                <a:cubicBezTo>
                  <a:pt x="1356" y="617"/>
                  <a:pt x="1351" y="606"/>
                  <a:pt x="1343" y="598"/>
                </a:cubicBezTo>
                <a:cubicBezTo>
                  <a:pt x="1335" y="590"/>
                  <a:pt x="1325" y="586"/>
                  <a:pt x="1314" y="586"/>
                </a:cubicBezTo>
                <a:cubicBezTo>
                  <a:pt x="1302" y="586"/>
                  <a:pt x="1292" y="591"/>
                  <a:pt x="1282" y="601"/>
                </a:cubicBezTo>
                <a:cubicBezTo>
                  <a:pt x="1272" y="611"/>
                  <a:pt x="1267" y="622"/>
                  <a:pt x="1267" y="633"/>
                </a:cubicBezTo>
                <a:cubicBezTo>
                  <a:pt x="1267" y="645"/>
                  <a:pt x="1273" y="657"/>
                  <a:pt x="1283" y="667"/>
                </a:cubicBezTo>
                <a:lnTo>
                  <a:pt x="1260" y="686"/>
                </a:lnTo>
                <a:cubicBezTo>
                  <a:pt x="1245" y="669"/>
                  <a:pt x="1239" y="651"/>
                  <a:pt x="1240" y="634"/>
                </a:cubicBezTo>
                <a:cubicBezTo>
                  <a:pt x="1241" y="616"/>
                  <a:pt x="1250" y="599"/>
                  <a:pt x="1266" y="583"/>
                </a:cubicBezTo>
                <a:cubicBezTo>
                  <a:pt x="1282" y="567"/>
                  <a:pt x="1299" y="559"/>
                  <a:pt x="1317" y="558"/>
                </a:cubicBezTo>
                <a:cubicBezTo>
                  <a:pt x="1336" y="558"/>
                  <a:pt x="1351" y="564"/>
                  <a:pt x="1365" y="577"/>
                </a:cubicBezTo>
                <a:cubicBezTo>
                  <a:pt x="1371" y="584"/>
                  <a:pt x="1377" y="592"/>
                  <a:pt x="1380" y="601"/>
                </a:cubicBezTo>
                <a:cubicBezTo>
                  <a:pt x="1384" y="611"/>
                  <a:pt x="1386" y="622"/>
                  <a:pt x="1387" y="636"/>
                </a:cubicBezTo>
                <a:cubicBezTo>
                  <a:pt x="1388" y="649"/>
                  <a:pt x="1387" y="670"/>
                  <a:pt x="1385" y="697"/>
                </a:cubicBezTo>
                <a:cubicBezTo>
                  <a:pt x="1383" y="720"/>
                  <a:pt x="1382" y="735"/>
                  <a:pt x="1382" y="742"/>
                </a:cubicBezTo>
                <a:cubicBezTo>
                  <a:pt x="1382" y="749"/>
                  <a:pt x="1383" y="756"/>
                  <a:pt x="1385" y="762"/>
                </a:cubicBezTo>
                <a:lnTo>
                  <a:pt x="1467" y="679"/>
                </a:lnTo>
                <a:close/>
                <a:moveTo>
                  <a:pt x="1435" y="462"/>
                </a:moveTo>
                <a:lnTo>
                  <a:pt x="1411" y="439"/>
                </a:lnTo>
                <a:lnTo>
                  <a:pt x="1432" y="418"/>
                </a:lnTo>
                <a:lnTo>
                  <a:pt x="1456" y="442"/>
                </a:lnTo>
                <a:lnTo>
                  <a:pt x="1435" y="462"/>
                </a:lnTo>
                <a:close/>
                <a:moveTo>
                  <a:pt x="1580" y="607"/>
                </a:moveTo>
                <a:lnTo>
                  <a:pt x="1458" y="485"/>
                </a:lnTo>
                <a:lnTo>
                  <a:pt x="1478" y="464"/>
                </a:lnTo>
                <a:lnTo>
                  <a:pt x="1600" y="586"/>
                </a:lnTo>
                <a:lnTo>
                  <a:pt x="1580" y="607"/>
                </a:lnTo>
                <a:close/>
                <a:moveTo>
                  <a:pt x="1636" y="550"/>
                </a:moveTo>
                <a:lnTo>
                  <a:pt x="1468" y="382"/>
                </a:lnTo>
                <a:lnTo>
                  <a:pt x="1531" y="319"/>
                </a:lnTo>
                <a:cubicBezTo>
                  <a:pt x="1542" y="308"/>
                  <a:pt x="1551" y="300"/>
                  <a:pt x="1558" y="295"/>
                </a:cubicBezTo>
                <a:cubicBezTo>
                  <a:pt x="1568" y="288"/>
                  <a:pt x="1577" y="284"/>
                  <a:pt x="1587" y="282"/>
                </a:cubicBezTo>
                <a:cubicBezTo>
                  <a:pt x="1596" y="280"/>
                  <a:pt x="1606" y="281"/>
                  <a:pt x="1617" y="285"/>
                </a:cubicBezTo>
                <a:cubicBezTo>
                  <a:pt x="1627" y="288"/>
                  <a:pt x="1636" y="294"/>
                  <a:pt x="1645" y="303"/>
                </a:cubicBezTo>
                <a:cubicBezTo>
                  <a:pt x="1659" y="317"/>
                  <a:pt x="1666" y="334"/>
                  <a:pt x="1667" y="353"/>
                </a:cubicBezTo>
                <a:cubicBezTo>
                  <a:pt x="1668" y="372"/>
                  <a:pt x="1657" y="393"/>
                  <a:pt x="1633" y="417"/>
                </a:cubicBezTo>
                <a:lnTo>
                  <a:pt x="1590" y="460"/>
                </a:lnTo>
                <a:lnTo>
                  <a:pt x="1658" y="528"/>
                </a:lnTo>
                <a:lnTo>
                  <a:pt x="1636" y="550"/>
                </a:lnTo>
                <a:close/>
                <a:moveTo>
                  <a:pt x="1570" y="440"/>
                </a:moveTo>
                <a:lnTo>
                  <a:pt x="1613" y="397"/>
                </a:lnTo>
                <a:cubicBezTo>
                  <a:pt x="1628" y="382"/>
                  <a:pt x="1635" y="369"/>
                  <a:pt x="1636" y="358"/>
                </a:cubicBezTo>
                <a:cubicBezTo>
                  <a:pt x="1637" y="347"/>
                  <a:pt x="1632" y="336"/>
                  <a:pt x="1622" y="326"/>
                </a:cubicBezTo>
                <a:cubicBezTo>
                  <a:pt x="1615" y="319"/>
                  <a:pt x="1608" y="315"/>
                  <a:pt x="1599" y="314"/>
                </a:cubicBezTo>
                <a:cubicBezTo>
                  <a:pt x="1590" y="312"/>
                  <a:pt x="1582" y="314"/>
                  <a:pt x="1575" y="318"/>
                </a:cubicBezTo>
                <a:cubicBezTo>
                  <a:pt x="1570" y="320"/>
                  <a:pt x="1563" y="327"/>
                  <a:pt x="1553" y="337"/>
                </a:cubicBezTo>
                <a:lnTo>
                  <a:pt x="1510" y="380"/>
                </a:lnTo>
                <a:lnTo>
                  <a:pt x="1570" y="440"/>
                </a:lnTo>
                <a:close/>
                <a:moveTo>
                  <a:pt x="1730" y="348"/>
                </a:moveTo>
                <a:lnTo>
                  <a:pt x="1749" y="326"/>
                </a:lnTo>
                <a:cubicBezTo>
                  <a:pt x="1758" y="333"/>
                  <a:pt x="1768" y="338"/>
                  <a:pt x="1777" y="339"/>
                </a:cubicBezTo>
                <a:cubicBezTo>
                  <a:pt x="1786" y="341"/>
                  <a:pt x="1796" y="340"/>
                  <a:pt x="1807" y="336"/>
                </a:cubicBezTo>
                <a:cubicBezTo>
                  <a:pt x="1817" y="331"/>
                  <a:pt x="1828" y="324"/>
                  <a:pt x="1837" y="315"/>
                </a:cubicBezTo>
                <a:cubicBezTo>
                  <a:pt x="1846" y="306"/>
                  <a:pt x="1852" y="297"/>
                  <a:pt x="1856" y="288"/>
                </a:cubicBezTo>
                <a:cubicBezTo>
                  <a:pt x="1860" y="279"/>
                  <a:pt x="1861" y="271"/>
                  <a:pt x="1860" y="264"/>
                </a:cubicBezTo>
                <a:cubicBezTo>
                  <a:pt x="1859" y="256"/>
                  <a:pt x="1856" y="250"/>
                  <a:pt x="1850" y="244"/>
                </a:cubicBezTo>
                <a:cubicBezTo>
                  <a:pt x="1845" y="239"/>
                  <a:pt x="1839" y="236"/>
                  <a:pt x="1832" y="235"/>
                </a:cubicBezTo>
                <a:cubicBezTo>
                  <a:pt x="1825" y="234"/>
                  <a:pt x="1817" y="236"/>
                  <a:pt x="1807" y="240"/>
                </a:cubicBezTo>
                <a:cubicBezTo>
                  <a:pt x="1801" y="243"/>
                  <a:pt x="1788" y="250"/>
                  <a:pt x="1769" y="262"/>
                </a:cubicBezTo>
                <a:cubicBezTo>
                  <a:pt x="1750" y="274"/>
                  <a:pt x="1735" y="281"/>
                  <a:pt x="1726" y="284"/>
                </a:cubicBezTo>
                <a:cubicBezTo>
                  <a:pt x="1714" y="288"/>
                  <a:pt x="1703" y="289"/>
                  <a:pt x="1692" y="286"/>
                </a:cubicBezTo>
                <a:cubicBezTo>
                  <a:pt x="1682" y="284"/>
                  <a:pt x="1673" y="279"/>
                  <a:pt x="1666" y="271"/>
                </a:cubicBezTo>
                <a:cubicBezTo>
                  <a:pt x="1657" y="263"/>
                  <a:pt x="1652" y="253"/>
                  <a:pt x="1649" y="240"/>
                </a:cubicBezTo>
                <a:cubicBezTo>
                  <a:pt x="1646" y="228"/>
                  <a:pt x="1648" y="216"/>
                  <a:pt x="1653" y="203"/>
                </a:cubicBezTo>
                <a:cubicBezTo>
                  <a:pt x="1659" y="189"/>
                  <a:pt x="1667" y="177"/>
                  <a:pt x="1678" y="166"/>
                </a:cubicBezTo>
                <a:cubicBezTo>
                  <a:pt x="1691" y="153"/>
                  <a:pt x="1704" y="144"/>
                  <a:pt x="1717" y="139"/>
                </a:cubicBezTo>
                <a:cubicBezTo>
                  <a:pt x="1731" y="133"/>
                  <a:pt x="1744" y="132"/>
                  <a:pt x="1757" y="135"/>
                </a:cubicBezTo>
                <a:cubicBezTo>
                  <a:pt x="1770" y="137"/>
                  <a:pt x="1782" y="144"/>
                  <a:pt x="1792" y="153"/>
                </a:cubicBezTo>
                <a:lnTo>
                  <a:pt x="1772" y="176"/>
                </a:lnTo>
                <a:cubicBezTo>
                  <a:pt x="1760" y="166"/>
                  <a:pt x="1748" y="162"/>
                  <a:pt x="1736" y="163"/>
                </a:cubicBezTo>
                <a:cubicBezTo>
                  <a:pt x="1724" y="165"/>
                  <a:pt x="1712" y="172"/>
                  <a:pt x="1699" y="185"/>
                </a:cubicBezTo>
                <a:cubicBezTo>
                  <a:pt x="1686" y="198"/>
                  <a:pt x="1678" y="210"/>
                  <a:pt x="1677" y="221"/>
                </a:cubicBezTo>
                <a:cubicBezTo>
                  <a:pt x="1676" y="232"/>
                  <a:pt x="1679" y="242"/>
                  <a:pt x="1686" y="248"/>
                </a:cubicBezTo>
                <a:cubicBezTo>
                  <a:pt x="1692" y="255"/>
                  <a:pt x="1699" y="257"/>
                  <a:pt x="1707" y="257"/>
                </a:cubicBezTo>
                <a:cubicBezTo>
                  <a:pt x="1715" y="256"/>
                  <a:pt x="1730" y="249"/>
                  <a:pt x="1752" y="235"/>
                </a:cubicBezTo>
                <a:cubicBezTo>
                  <a:pt x="1775" y="221"/>
                  <a:pt x="1791" y="212"/>
                  <a:pt x="1800" y="209"/>
                </a:cubicBezTo>
                <a:cubicBezTo>
                  <a:pt x="1815" y="204"/>
                  <a:pt x="1828" y="202"/>
                  <a:pt x="1839" y="204"/>
                </a:cubicBezTo>
                <a:cubicBezTo>
                  <a:pt x="1851" y="207"/>
                  <a:pt x="1861" y="212"/>
                  <a:pt x="1870" y="221"/>
                </a:cubicBezTo>
                <a:cubicBezTo>
                  <a:pt x="1879" y="230"/>
                  <a:pt x="1885" y="241"/>
                  <a:pt x="1888" y="254"/>
                </a:cubicBezTo>
                <a:cubicBezTo>
                  <a:pt x="1890" y="267"/>
                  <a:pt x="1889" y="281"/>
                  <a:pt x="1884" y="295"/>
                </a:cubicBezTo>
                <a:cubicBezTo>
                  <a:pt x="1879" y="309"/>
                  <a:pt x="1870" y="322"/>
                  <a:pt x="1858" y="334"/>
                </a:cubicBezTo>
                <a:cubicBezTo>
                  <a:pt x="1843" y="349"/>
                  <a:pt x="1828" y="359"/>
                  <a:pt x="1813" y="365"/>
                </a:cubicBezTo>
                <a:cubicBezTo>
                  <a:pt x="1799" y="371"/>
                  <a:pt x="1784" y="372"/>
                  <a:pt x="1769" y="369"/>
                </a:cubicBezTo>
                <a:cubicBezTo>
                  <a:pt x="1754" y="366"/>
                  <a:pt x="1741" y="359"/>
                  <a:pt x="1730" y="348"/>
                </a:cubicBezTo>
                <a:close/>
                <a:moveTo>
                  <a:pt x="1897" y="200"/>
                </a:moveTo>
                <a:lnTo>
                  <a:pt x="1915" y="177"/>
                </a:lnTo>
                <a:cubicBezTo>
                  <a:pt x="1929" y="186"/>
                  <a:pt x="1942" y="191"/>
                  <a:pt x="1952" y="190"/>
                </a:cubicBezTo>
                <a:cubicBezTo>
                  <a:pt x="1963" y="190"/>
                  <a:pt x="1973" y="185"/>
                  <a:pt x="1981" y="177"/>
                </a:cubicBezTo>
                <a:cubicBezTo>
                  <a:pt x="1991" y="167"/>
                  <a:pt x="1995" y="156"/>
                  <a:pt x="1995" y="142"/>
                </a:cubicBezTo>
                <a:cubicBezTo>
                  <a:pt x="1995" y="129"/>
                  <a:pt x="1990" y="117"/>
                  <a:pt x="1980" y="107"/>
                </a:cubicBezTo>
                <a:cubicBezTo>
                  <a:pt x="1971" y="98"/>
                  <a:pt x="1960" y="93"/>
                  <a:pt x="1948" y="93"/>
                </a:cubicBezTo>
                <a:cubicBezTo>
                  <a:pt x="1935" y="93"/>
                  <a:pt x="1924" y="98"/>
                  <a:pt x="1915" y="108"/>
                </a:cubicBezTo>
                <a:cubicBezTo>
                  <a:pt x="1911" y="112"/>
                  <a:pt x="1907" y="117"/>
                  <a:pt x="1903" y="124"/>
                </a:cubicBezTo>
                <a:lnTo>
                  <a:pt x="1887" y="104"/>
                </a:lnTo>
                <a:cubicBezTo>
                  <a:pt x="1888" y="103"/>
                  <a:pt x="1890" y="102"/>
                  <a:pt x="1890" y="101"/>
                </a:cubicBezTo>
                <a:cubicBezTo>
                  <a:pt x="1899" y="92"/>
                  <a:pt x="1905" y="82"/>
                  <a:pt x="1907" y="70"/>
                </a:cubicBezTo>
                <a:cubicBezTo>
                  <a:pt x="1910" y="59"/>
                  <a:pt x="1906" y="48"/>
                  <a:pt x="1897" y="39"/>
                </a:cubicBezTo>
                <a:cubicBezTo>
                  <a:pt x="1889" y="31"/>
                  <a:pt x="1880" y="27"/>
                  <a:pt x="1870" y="27"/>
                </a:cubicBezTo>
                <a:cubicBezTo>
                  <a:pt x="1860" y="28"/>
                  <a:pt x="1851" y="32"/>
                  <a:pt x="1843" y="40"/>
                </a:cubicBezTo>
                <a:cubicBezTo>
                  <a:pt x="1835" y="48"/>
                  <a:pt x="1831" y="57"/>
                  <a:pt x="1830" y="67"/>
                </a:cubicBezTo>
                <a:cubicBezTo>
                  <a:pt x="1830" y="78"/>
                  <a:pt x="1834" y="89"/>
                  <a:pt x="1843" y="101"/>
                </a:cubicBezTo>
                <a:lnTo>
                  <a:pt x="1818" y="117"/>
                </a:lnTo>
                <a:cubicBezTo>
                  <a:pt x="1807" y="101"/>
                  <a:pt x="1802" y="85"/>
                  <a:pt x="1803" y="68"/>
                </a:cubicBezTo>
                <a:cubicBezTo>
                  <a:pt x="1805" y="52"/>
                  <a:pt x="1812" y="37"/>
                  <a:pt x="1825" y="23"/>
                </a:cubicBezTo>
                <a:cubicBezTo>
                  <a:pt x="1835" y="14"/>
                  <a:pt x="1845" y="8"/>
                  <a:pt x="1857" y="4"/>
                </a:cubicBezTo>
                <a:cubicBezTo>
                  <a:pt x="1868" y="0"/>
                  <a:pt x="1880" y="0"/>
                  <a:pt x="1890" y="2"/>
                </a:cubicBezTo>
                <a:cubicBezTo>
                  <a:pt x="1901" y="5"/>
                  <a:pt x="1911" y="10"/>
                  <a:pt x="1918" y="18"/>
                </a:cubicBezTo>
                <a:cubicBezTo>
                  <a:pt x="1925" y="25"/>
                  <a:pt x="1930" y="34"/>
                  <a:pt x="1932" y="44"/>
                </a:cubicBezTo>
                <a:cubicBezTo>
                  <a:pt x="1934" y="53"/>
                  <a:pt x="1933" y="64"/>
                  <a:pt x="1929" y="75"/>
                </a:cubicBezTo>
                <a:cubicBezTo>
                  <a:pt x="1941" y="67"/>
                  <a:pt x="1954" y="64"/>
                  <a:pt x="1967" y="66"/>
                </a:cubicBezTo>
                <a:cubicBezTo>
                  <a:pt x="1979" y="68"/>
                  <a:pt x="1991" y="74"/>
                  <a:pt x="2002" y="85"/>
                </a:cubicBezTo>
                <a:cubicBezTo>
                  <a:pt x="2017" y="100"/>
                  <a:pt x="2024" y="117"/>
                  <a:pt x="2023" y="138"/>
                </a:cubicBezTo>
                <a:cubicBezTo>
                  <a:pt x="2023" y="159"/>
                  <a:pt x="2014" y="178"/>
                  <a:pt x="1998" y="194"/>
                </a:cubicBezTo>
                <a:cubicBezTo>
                  <a:pt x="1983" y="209"/>
                  <a:pt x="1966" y="217"/>
                  <a:pt x="1948" y="218"/>
                </a:cubicBezTo>
                <a:cubicBezTo>
                  <a:pt x="1929" y="219"/>
                  <a:pt x="1912" y="213"/>
                  <a:pt x="1897" y="200"/>
                </a:cubicBez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8" name="Freeform 84"/>
          <p:cNvSpPr>
            <a:spLocks noEditPoints="1"/>
          </p:cNvSpPr>
          <p:nvPr/>
        </p:nvSpPr>
        <p:spPr bwMode="auto">
          <a:xfrm>
            <a:off x="7902717" y="5035690"/>
            <a:ext cx="768350" cy="769938"/>
          </a:xfrm>
          <a:custGeom>
            <a:avLst/>
            <a:gdLst>
              <a:gd name="T0" fmla="*/ 119 w 2019"/>
              <a:gd name="T1" fmla="*/ 1752 h 2020"/>
              <a:gd name="T2" fmla="*/ 122 w 2019"/>
              <a:gd name="T3" fmla="*/ 1930 h 2020"/>
              <a:gd name="T4" fmla="*/ 168 w 2019"/>
              <a:gd name="T5" fmla="*/ 1828 h 2020"/>
              <a:gd name="T6" fmla="*/ 42 w 2019"/>
              <a:gd name="T7" fmla="*/ 1850 h 2020"/>
              <a:gd name="T8" fmla="*/ 256 w 2019"/>
              <a:gd name="T9" fmla="*/ 1606 h 2020"/>
              <a:gd name="T10" fmla="*/ 370 w 2019"/>
              <a:gd name="T11" fmla="*/ 1670 h 2020"/>
              <a:gd name="T12" fmla="*/ 389 w 2019"/>
              <a:gd name="T13" fmla="*/ 1799 h 2020"/>
              <a:gd name="T14" fmla="*/ 310 w 2019"/>
              <a:gd name="T15" fmla="*/ 1663 h 2020"/>
              <a:gd name="T16" fmla="*/ 199 w 2019"/>
              <a:gd name="T17" fmla="*/ 1692 h 2020"/>
              <a:gd name="T18" fmla="*/ 392 w 2019"/>
              <a:gd name="T19" fmla="*/ 1746 h 2020"/>
              <a:gd name="T20" fmla="*/ 309 w 2019"/>
              <a:gd name="T21" fmla="*/ 1724 h 2020"/>
              <a:gd name="T22" fmla="*/ 371 w 2019"/>
              <a:gd name="T23" fmla="*/ 1480 h 2020"/>
              <a:gd name="T24" fmla="*/ 565 w 2019"/>
              <a:gd name="T25" fmla="*/ 1521 h 2020"/>
              <a:gd name="T26" fmla="*/ 482 w 2019"/>
              <a:gd name="T27" fmla="*/ 1706 h 2020"/>
              <a:gd name="T28" fmla="*/ 540 w 2019"/>
              <a:gd name="T29" fmla="*/ 1542 h 2020"/>
              <a:gd name="T30" fmla="*/ 356 w 2019"/>
              <a:gd name="T31" fmla="*/ 1536 h 2020"/>
              <a:gd name="T32" fmla="*/ 813 w 2019"/>
              <a:gd name="T33" fmla="*/ 1468 h 2020"/>
              <a:gd name="T34" fmla="*/ 707 w 2019"/>
              <a:gd name="T35" fmla="*/ 1148 h 2020"/>
              <a:gd name="T36" fmla="*/ 781 w 2019"/>
              <a:gd name="T37" fmla="*/ 1270 h 2020"/>
              <a:gd name="T38" fmla="*/ 762 w 2019"/>
              <a:gd name="T39" fmla="*/ 1250 h 2020"/>
              <a:gd name="T40" fmla="*/ 701 w 2019"/>
              <a:gd name="T41" fmla="*/ 1190 h 2020"/>
              <a:gd name="T42" fmla="*/ 894 w 2019"/>
              <a:gd name="T43" fmla="*/ 958 h 2020"/>
              <a:gd name="T44" fmla="*/ 978 w 2019"/>
              <a:gd name="T45" fmla="*/ 1056 h 2020"/>
              <a:gd name="T46" fmla="*/ 940 w 2019"/>
              <a:gd name="T47" fmla="*/ 1248 h 2020"/>
              <a:gd name="T48" fmla="*/ 1021 w 2019"/>
              <a:gd name="T49" fmla="*/ 917 h 2020"/>
              <a:gd name="T50" fmla="*/ 1083 w 2019"/>
              <a:gd name="T51" fmla="*/ 928 h 2020"/>
              <a:gd name="T52" fmla="*/ 1091 w 2019"/>
              <a:gd name="T53" fmla="*/ 979 h 2020"/>
              <a:gd name="T54" fmla="*/ 1243 w 2019"/>
              <a:gd name="T55" fmla="*/ 945 h 2020"/>
              <a:gd name="T56" fmla="*/ 1210 w 2019"/>
              <a:gd name="T57" fmla="*/ 733 h 2020"/>
              <a:gd name="T58" fmla="*/ 1127 w 2019"/>
              <a:gd name="T59" fmla="*/ 821 h 2020"/>
              <a:gd name="T60" fmla="*/ 1247 w 2019"/>
              <a:gd name="T61" fmla="*/ 736 h 2020"/>
              <a:gd name="T62" fmla="*/ 1334 w 2019"/>
              <a:gd name="T63" fmla="*/ 814 h 2020"/>
              <a:gd name="T64" fmla="*/ 1273 w 2019"/>
              <a:gd name="T65" fmla="*/ 623 h 2020"/>
              <a:gd name="T66" fmla="*/ 1380 w 2019"/>
              <a:gd name="T67" fmla="*/ 620 h 2020"/>
              <a:gd name="T68" fmla="*/ 1378 w 2019"/>
              <a:gd name="T69" fmla="*/ 778 h 2020"/>
              <a:gd name="T70" fmla="*/ 1359 w 2019"/>
              <a:gd name="T71" fmla="*/ 576 h 2020"/>
              <a:gd name="T72" fmla="*/ 1433 w 2019"/>
              <a:gd name="T73" fmla="*/ 705 h 2020"/>
              <a:gd name="T74" fmla="*/ 1347 w 2019"/>
              <a:gd name="T75" fmla="*/ 732 h 2020"/>
              <a:gd name="T76" fmla="*/ 1435 w 2019"/>
              <a:gd name="T77" fmla="*/ 464 h 2020"/>
              <a:gd name="T78" fmla="*/ 1579 w 2019"/>
              <a:gd name="T79" fmla="*/ 609 h 2020"/>
              <a:gd name="T80" fmla="*/ 1587 w 2019"/>
              <a:gd name="T81" fmla="*/ 284 h 2020"/>
              <a:gd name="T82" fmla="*/ 1590 w 2019"/>
              <a:gd name="T83" fmla="*/ 462 h 2020"/>
              <a:gd name="T84" fmla="*/ 1636 w 2019"/>
              <a:gd name="T85" fmla="*/ 360 h 2020"/>
              <a:gd name="T86" fmla="*/ 1510 w 2019"/>
              <a:gd name="T87" fmla="*/ 382 h 2020"/>
              <a:gd name="T88" fmla="*/ 1806 w 2019"/>
              <a:gd name="T89" fmla="*/ 338 h 2020"/>
              <a:gd name="T90" fmla="*/ 1832 w 2019"/>
              <a:gd name="T91" fmla="*/ 237 h 2020"/>
              <a:gd name="T92" fmla="*/ 1665 w 2019"/>
              <a:gd name="T93" fmla="*/ 273 h 2020"/>
              <a:gd name="T94" fmla="*/ 1757 w 2019"/>
              <a:gd name="T95" fmla="*/ 137 h 2020"/>
              <a:gd name="T96" fmla="*/ 1677 w 2019"/>
              <a:gd name="T97" fmla="*/ 223 h 2020"/>
              <a:gd name="T98" fmla="*/ 1839 w 2019"/>
              <a:gd name="T99" fmla="*/ 206 h 2020"/>
              <a:gd name="T100" fmla="*/ 1813 w 2019"/>
              <a:gd name="T101" fmla="*/ 367 h 2020"/>
              <a:gd name="T102" fmla="*/ 1867 w 2019"/>
              <a:gd name="T103" fmla="*/ 58 h 2020"/>
              <a:gd name="T104" fmla="*/ 1837 w 2019"/>
              <a:gd name="T105" fmla="*/ 14 h 202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</a:cxnLst>
            <a:rect l="0" t="0" r="r" b="b"/>
            <a:pathLst>
              <a:path w="2019" h="2020">
                <a:moveTo>
                  <a:pt x="168" y="2020"/>
                </a:moveTo>
                <a:lnTo>
                  <a:pt x="0" y="1852"/>
                </a:lnTo>
                <a:lnTo>
                  <a:pt x="63" y="1789"/>
                </a:lnTo>
                <a:cubicBezTo>
                  <a:pt x="74" y="1778"/>
                  <a:pt x="83" y="1770"/>
                  <a:pt x="90" y="1765"/>
                </a:cubicBezTo>
                <a:cubicBezTo>
                  <a:pt x="100" y="1758"/>
                  <a:pt x="109" y="1754"/>
                  <a:pt x="119" y="1752"/>
                </a:cubicBezTo>
                <a:cubicBezTo>
                  <a:pt x="128" y="1750"/>
                  <a:pt x="138" y="1751"/>
                  <a:pt x="148" y="1755"/>
                </a:cubicBezTo>
                <a:cubicBezTo>
                  <a:pt x="159" y="1758"/>
                  <a:pt x="168" y="1764"/>
                  <a:pt x="176" y="1773"/>
                </a:cubicBezTo>
                <a:cubicBezTo>
                  <a:pt x="191" y="1787"/>
                  <a:pt x="198" y="1804"/>
                  <a:pt x="199" y="1823"/>
                </a:cubicBezTo>
                <a:cubicBezTo>
                  <a:pt x="200" y="1842"/>
                  <a:pt x="188" y="1863"/>
                  <a:pt x="165" y="1887"/>
                </a:cubicBezTo>
                <a:lnTo>
                  <a:pt x="122" y="1930"/>
                </a:lnTo>
                <a:lnTo>
                  <a:pt x="190" y="1998"/>
                </a:lnTo>
                <a:lnTo>
                  <a:pt x="168" y="2020"/>
                </a:lnTo>
                <a:close/>
                <a:moveTo>
                  <a:pt x="102" y="1910"/>
                </a:moveTo>
                <a:lnTo>
                  <a:pt x="145" y="1867"/>
                </a:lnTo>
                <a:cubicBezTo>
                  <a:pt x="160" y="1852"/>
                  <a:pt x="167" y="1839"/>
                  <a:pt x="168" y="1828"/>
                </a:cubicBezTo>
                <a:cubicBezTo>
                  <a:pt x="168" y="1817"/>
                  <a:pt x="164" y="1806"/>
                  <a:pt x="154" y="1796"/>
                </a:cubicBezTo>
                <a:cubicBezTo>
                  <a:pt x="147" y="1789"/>
                  <a:pt x="139" y="1785"/>
                  <a:pt x="131" y="1784"/>
                </a:cubicBezTo>
                <a:cubicBezTo>
                  <a:pt x="122" y="1782"/>
                  <a:pt x="114" y="1783"/>
                  <a:pt x="107" y="1788"/>
                </a:cubicBezTo>
                <a:cubicBezTo>
                  <a:pt x="102" y="1790"/>
                  <a:pt x="95" y="1797"/>
                  <a:pt x="85" y="1807"/>
                </a:cubicBezTo>
                <a:lnTo>
                  <a:pt x="42" y="1850"/>
                </a:lnTo>
                <a:lnTo>
                  <a:pt x="102" y="1910"/>
                </a:lnTo>
                <a:close/>
                <a:moveTo>
                  <a:pt x="325" y="1863"/>
                </a:moveTo>
                <a:lnTo>
                  <a:pt x="157" y="1695"/>
                </a:lnTo>
                <a:lnTo>
                  <a:pt x="220" y="1632"/>
                </a:lnTo>
                <a:cubicBezTo>
                  <a:pt x="233" y="1619"/>
                  <a:pt x="245" y="1610"/>
                  <a:pt x="256" y="1606"/>
                </a:cubicBezTo>
                <a:cubicBezTo>
                  <a:pt x="267" y="1602"/>
                  <a:pt x="279" y="1601"/>
                  <a:pt x="290" y="1603"/>
                </a:cubicBezTo>
                <a:cubicBezTo>
                  <a:pt x="302" y="1606"/>
                  <a:pt x="311" y="1611"/>
                  <a:pt x="319" y="1619"/>
                </a:cubicBezTo>
                <a:cubicBezTo>
                  <a:pt x="326" y="1626"/>
                  <a:pt x="331" y="1635"/>
                  <a:pt x="333" y="1645"/>
                </a:cubicBezTo>
                <a:cubicBezTo>
                  <a:pt x="336" y="1655"/>
                  <a:pt x="335" y="1666"/>
                  <a:pt x="331" y="1678"/>
                </a:cubicBezTo>
                <a:cubicBezTo>
                  <a:pt x="344" y="1671"/>
                  <a:pt x="357" y="1668"/>
                  <a:pt x="370" y="1670"/>
                </a:cubicBezTo>
                <a:cubicBezTo>
                  <a:pt x="382" y="1672"/>
                  <a:pt x="394" y="1677"/>
                  <a:pt x="403" y="1687"/>
                </a:cubicBezTo>
                <a:cubicBezTo>
                  <a:pt x="411" y="1695"/>
                  <a:pt x="417" y="1704"/>
                  <a:pt x="420" y="1714"/>
                </a:cubicBezTo>
                <a:cubicBezTo>
                  <a:pt x="424" y="1724"/>
                  <a:pt x="425" y="1734"/>
                  <a:pt x="424" y="1742"/>
                </a:cubicBezTo>
                <a:cubicBezTo>
                  <a:pt x="422" y="1751"/>
                  <a:pt x="419" y="1760"/>
                  <a:pt x="414" y="1769"/>
                </a:cubicBezTo>
                <a:cubicBezTo>
                  <a:pt x="408" y="1778"/>
                  <a:pt x="400" y="1788"/>
                  <a:pt x="389" y="1799"/>
                </a:cubicBezTo>
                <a:lnTo>
                  <a:pt x="325" y="1863"/>
                </a:lnTo>
                <a:close/>
                <a:moveTo>
                  <a:pt x="250" y="1743"/>
                </a:moveTo>
                <a:lnTo>
                  <a:pt x="286" y="1707"/>
                </a:lnTo>
                <a:cubicBezTo>
                  <a:pt x="296" y="1697"/>
                  <a:pt x="303" y="1689"/>
                  <a:pt x="306" y="1684"/>
                </a:cubicBezTo>
                <a:cubicBezTo>
                  <a:pt x="310" y="1676"/>
                  <a:pt x="311" y="1669"/>
                  <a:pt x="310" y="1663"/>
                </a:cubicBezTo>
                <a:cubicBezTo>
                  <a:pt x="309" y="1656"/>
                  <a:pt x="305" y="1649"/>
                  <a:pt x="300" y="1644"/>
                </a:cubicBezTo>
                <a:cubicBezTo>
                  <a:pt x="294" y="1638"/>
                  <a:pt x="288" y="1634"/>
                  <a:pt x="281" y="1633"/>
                </a:cubicBezTo>
                <a:cubicBezTo>
                  <a:pt x="274" y="1631"/>
                  <a:pt x="267" y="1632"/>
                  <a:pt x="261" y="1636"/>
                </a:cubicBezTo>
                <a:cubicBezTo>
                  <a:pt x="254" y="1639"/>
                  <a:pt x="245" y="1647"/>
                  <a:pt x="233" y="1659"/>
                </a:cubicBezTo>
                <a:lnTo>
                  <a:pt x="199" y="1692"/>
                </a:lnTo>
                <a:lnTo>
                  <a:pt x="250" y="1743"/>
                </a:lnTo>
                <a:close/>
                <a:moveTo>
                  <a:pt x="328" y="1821"/>
                </a:moveTo>
                <a:lnTo>
                  <a:pt x="369" y="1779"/>
                </a:lnTo>
                <a:cubicBezTo>
                  <a:pt x="377" y="1772"/>
                  <a:pt x="381" y="1766"/>
                  <a:pt x="384" y="1763"/>
                </a:cubicBezTo>
                <a:cubicBezTo>
                  <a:pt x="388" y="1757"/>
                  <a:pt x="391" y="1751"/>
                  <a:pt x="392" y="1746"/>
                </a:cubicBezTo>
                <a:cubicBezTo>
                  <a:pt x="393" y="1740"/>
                  <a:pt x="393" y="1734"/>
                  <a:pt x="391" y="1728"/>
                </a:cubicBezTo>
                <a:cubicBezTo>
                  <a:pt x="389" y="1721"/>
                  <a:pt x="386" y="1716"/>
                  <a:pt x="380" y="1710"/>
                </a:cubicBezTo>
                <a:cubicBezTo>
                  <a:pt x="374" y="1704"/>
                  <a:pt x="367" y="1700"/>
                  <a:pt x="359" y="1699"/>
                </a:cubicBezTo>
                <a:cubicBezTo>
                  <a:pt x="351" y="1697"/>
                  <a:pt x="344" y="1699"/>
                  <a:pt x="336" y="1702"/>
                </a:cubicBezTo>
                <a:cubicBezTo>
                  <a:pt x="328" y="1706"/>
                  <a:pt x="319" y="1713"/>
                  <a:pt x="309" y="1724"/>
                </a:cubicBezTo>
                <a:lnTo>
                  <a:pt x="270" y="1763"/>
                </a:lnTo>
                <a:lnTo>
                  <a:pt x="328" y="1821"/>
                </a:lnTo>
                <a:close/>
                <a:moveTo>
                  <a:pt x="482" y="1706"/>
                </a:moveTo>
                <a:lnTo>
                  <a:pt x="314" y="1538"/>
                </a:lnTo>
                <a:lnTo>
                  <a:pt x="371" y="1480"/>
                </a:lnTo>
                <a:cubicBezTo>
                  <a:pt x="385" y="1467"/>
                  <a:pt x="395" y="1458"/>
                  <a:pt x="404" y="1453"/>
                </a:cubicBezTo>
                <a:cubicBezTo>
                  <a:pt x="416" y="1446"/>
                  <a:pt x="428" y="1441"/>
                  <a:pt x="440" y="1440"/>
                </a:cubicBezTo>
                <a:cubicBezTo>
                  <a:pt x="457" y="1439"/>
                  <a:pt x="473" y="1442"/>
                  <a:pt x="489" y="1449"/>
                </a:cubicBezTo>
                <a:cubicBezTo>
                  <a:pt x="505" y="1456"/>
                  <a:pt x="521" y="1468"/>
                  <a:pt x="536" y="1483"/>
                </a:cubicBezTo>
                <a:cubicBezTo>
                  <a:pt x="548" y="1495"/>
                  <a:pt x="558" y="1508"/>
                  <a:pt x="565" y="1521"/>
                </a:cubicBezTo>
                <a:cubicBezTo>
                  <a:pt x="572" y="1534"/>
                  <a:pt x="576" y="1546"/>
                  <a:pt x="578" y="1557"/>
                </a:cubicBezTo>
                <a:cubicBezTo>
                  <a:pt x="580" y="1568"/>
                  <a:pt x="580" y="1578"/>
                  <a:pt x="578" y="1587"/>
                </a:cubicBezTo>
                <a:cubicBezTo>
                  <a:pt x="576" y="1597"/>
                  <a:pt x="572" y="1606"/>
                  <a:pt x="566" y="1616"/>
                </a:cubicBezTo>
                <a:cubicBezTo>
                  <a:pt x="560" y="1626"/>
                  <a:pt x="552" y="1636"/>
                  <a:pt x="542" y="1646"/>
                </a:cubicBezTo>
                <a:lnTo>
                  <a:pt x="482" y="1706"/>
                </a:lnTo>
                <a:close/>
                <a:moveTo>
                  <a:pt x="484" y="1664"/>
                </a:moveTo>
                <a:lnTo>
                  <a:pt x="520" y="1628"/>
                </a:lnTo>
                <a:cubicBezTo>
                  <a:pt x="531" y="1617"/>
                  <a:pt x="539" y="1608"/>
                  <a:pt x="543" y="1599"/>
                </a:cubicBezTo>
                <a:cubicBezTo>
                  <a:pt x="547" y="1591"/>
                  <a:pt x="549" y="1583"/>
                  <a:pt x="549" y="1576"/>
                </a:cubicBezTo>
                <a:cubicBezTo>
                  <a:pt x="549" y="1565"/>
                  <a:pt x="546" y="1554"/>
                  <a:pt x="540" y="1542"/>
                </a:cubicBezTo>
                <a:cubicBezTo>
                  <a:pt x="534" y="1530"/>
                  <a:pt x="525" y="1518"/>
                  <a:pt x="512" y="1505"/>
                </a:cubicBezTo>
                <a:cubicBezTo>
                  <a:pt x="495" y="1488"/>
                  <a:pt x="478" y="1477"/>
                  <a:pt x="463" y="1473"/>
                </a:cubicBezTo>
                <a:cubicBezTo>
                  <a:pt x="448" y="1470"/>
                  <a:pt x="435" y="1470"/>
                  <a:pt x="423" y="1475"/>
                </a:cubicBezTo>
                <a:cubicBezTo>
                  <a:pt x="415" y="1479"/>
                  <a:pt x="404" y="1487"/>
                  <a:pt x="391" y="1501"/>
                </a:cubicBezTo>
                <a:lnTo>
                  <a:pt x="356" y="1536"/>
                </a:lnTo>
                <a:lnTo>
                  <a:pt x="484" y="1664"/>
                </a:lnTo>
                <a:close/>
                <a:moveTo>
                  <a:pt x="676" y="1605"/>
                </a:moveTo>
                <a:lnTo>
                  <a:pt x="661" y="1590"/>
                </a:lnTo>
                <a:lnTo>
                  <a:pt x="798" y="1453"/>
                </a:lnTo>
                <a:lnTo>
                  <a:pt x="813" y="1468"/>
                </a:lnTo>
                <a:lnTo>
                  <a:pt x="676" y="1605"/>
                </a:lnTo>
                <a:close/>
                <a:moveTo>
                  <a:pt x="784" y="1404"/>
                </a:moveTo>
                <a:lnTo>
                  <a:pt x="616" y="1236"/>
                </a:lnTo>
                <a:lnTo>
                  <a:pt x="680" y="1172"/>
                </a:lnTo>
                <a:cubicBezTo>
                  <a:pt x="691" y="1161"/>
                  <a:pt x="700" y="1153"/>
                  <a:pt x="707" y="1148"/>
                </a:cubicBezTo>
                <a:cubicBezTo>
                  <a:pt x="716" y="1141"/>
                  <a:pt x="726" y="1137"/>
                  <a:pt x="735" y="1135"/>
                </a:cubicBezTo>
                <a:cubicBezTo>
                  <a:pt x="745" y="1134"/>
                  <a:pt x="755" y="1135"/>
                  <a:pt x="765" y="1138"/>
                </a:cubicBezTo>
                <a:cubicBezTo>
                  <a:pt x="775" y="1142"/>
                  <a:pt x="785" y="1148"/>
                  <a:pt x="793" y="1156"/>
                </a:cubicBezTo>
                <a:cubicBezTo>
                  <a:pt x="807" y="1170"/>
                  <a:pt x="815" y="1187"/>
                  <a:pt x="816" y="1206"/>
                </a:cubicBezTo>
                <a:cubicBezTo>
                  <a:pt x="817" y="1225"/>
                  <a:pt x="805" y="1246"/>
                  <a:pt x="781" y="1270"/>
                </a:cubicBezTo>
                <a:lnTo>
                  <a:pt x="738" y="1313"/>
                </a:lnTo>
                <a:lnTo>
                  <a:pt x="807" y="1382"/>
                </a:lnTo>
                <a:lnTo>
                  <a:pt x="784" y="1404"/>
                </a:lnTo>
                <a:close/>
                <a:moveTo>
                  <a:pt x="718" y="1293"/>
                </a:moveTo>
                <a:lnTo>
                  <a:pt x="762" y="1250"/>
                </a:lnTo>
                <a:cubicBezTo>
                  <a:pt x="776" y="1236"/>
                  <a:pt x="784" y="1223"/>
                  <a:pt x="784" y="1211"/>
                </a:cubicBezTo>
                <a:cubicBezTo>
                  <a:pt x="785" y="1200"/>
                  <a:pt x="781" y="1189"/>
                  <a:pt x="771" y="1180"/>
                </a:cubicBezTo>
                <a:cubicBezTo>
                  <a:pt x="764" y="1173"/>
                  <a:pt x="756" y="1168"/>
                  <a:pt x="747" y="1167"/>
                </a:cubicBezTo>
                <a:cubicBezTo>
                  <a:pt x="739" y="1165"/>
                  <a:pt x="731" y="1167"/>
                  <a:pt x="724" y="1171"/>
                </a:cubicBezTo>
                <a:cubicBezTo>
                  <a:pt x="719" y="1174"/>
                  <a:pt x="711" y="1180"/>
                  <a:pt x="701" y="1190"/>
                </a:cubicBezTo>
                <a:lnTo>
                  <a:pt x="658" y="1233"/>
                </a:lnTo>
                <a:lnTo>
                  <a:pt x="718" y="1293"/>
                </a:lnTo>
                <a:close/>
                <a:moveTo>
                  <a:pt x="940" y="1248"/>
                </a:moveTo>
                <a:lnTo>
                  <a:pt x="772" y="1080"/>
                </a:lnTo>
                <a:lnTo>
                  <a:pt x="894" y="958"/>
                </a:lnTo>
                <a:lnTo>
                  <a:pt x="914" y="978"/>
                </a:lnTo>
                <a:lnTo>
                  <a:pt x="814" y="1077"/>
                </a:lnTo>
                <a:lnTo>
                  <a:pt x="866" y="1129"/>
                </a:lnTo>
                <a:lnTo>
                  <a:pt x="959" y="1036"/>
                </a:lnTo>
                <a:lnTo>
                  <a:pt x="978" y="1056"/>
                </a:lnTo>
                <a:lnTo>
                  <a:pt x="885" y="1148"/>
                </a:lnTo>
                <a:lnTo>
                  <a:pt x="943" y="1206"/>
                </a:lnTo>
                <a:lnTo>
                  <a:pt x="1046" y="1103"/>
                </a:lnTo>
                <a:lnTo>
                  <a:pt x="1066" y="1122"/>
                </a:lnTo>
                <a:lnTo>
                  <a:pt x="940" y="1248"/>
                </a:lnTo>
                <a:close/>
                <a:moveTo>
                  <a:pt x="1081" y="1107"/>
                </a:moveTo>
                <a:lnTo>
                  <a:pt x="1059" y="954"/>
                </a:lnTo>
                <a:lnTo>
                  <a:pt x="921" y="931"/>
                </a:lnTo>
                <a:lnTo>
                  <a:pt x="947" y="905"/>
                </a:lnTo>
                <a:lnTo>
                  <a:pt x="1021" y="917"/>
                </a:lnTo>
                <a:cubicBezTo>
                  <a:pt x="1036" y="920"/>
                  <a:pt x="1048" y="922"/>
                  <a:pt x="1055" y="924"/>
                </a:cubicBezTo>
                <a:cubicBezTo>
                  <a:pt x="1053" y="915"/>
                  <a:pt x="1051" y="904"/>
                  <a:pt x="1049" y="892"/>
                </a:cubicBezTo>
                <a:lnTo>
                  <a:pt x="1038" y="814"/>
                </a:lnTo>
                <a:lnTo>
                  <a:pt x="1063" y="789"/>
                </a:lnTo>
                <a:lnTo>
                  <a:pt x="1083" y="928"/>
                </a:lnTo>
                <a:lnTo>
                  <a:pt x="1235" y="953"/>
                </a:lnTo>
                <a:lnTo>
                  <a:pt x="1208" y="980"/>
                </a:lnTo>
                <a:lnTo>
                  <a:pt x="1105" y="963"/>
                </a:lnTo>
                <a:cubicBezTo>
                  <a:pt x="1100" y="962"/>
                  <a:pt x="1093" y="960"/>
                  <a:pt x="1087" y="959"/>
                </a:cubicBezTo>
                <a:cubicBezTo>
                  <a:pt x="1089" y="969"/>
                  <a:pt x="1091" y="976"/>
                  <a:pt x="1091" y="979"/>
                </a:cubicBezTo>
                <a:lnTo>
                  <a:pt x="1108" y="1080"/>
                </a:lnTo>
                <a:lnTo>
                  <a:pt x="1081" y="1107"/>
                </a:lnTo>
                <a:close/>
                <a:moveTo>
                  <a:pt x="1334" y="814"/>
                </a:moveTo>
                <a:lnTo>
                  <a:pt x="1354" y="834"/>
                </a:lnTo>
                <a:lnTo>
                  <a:pt x="1243" y="945"/>
                </a:lnTo>
                <a:cubicBezTo>
                  <a:pt x="1238" y="940"/>
                  <a:pt x="1234" y="935"/>
                  <a:pt x="1231" y="929"/>
                </a:cubicBezTo>
                <a:cubicBezTo>
                  <a:pt x="1226" y="918"/>
                  <a:pt x="1223" y="906"/>
                  <a:pt x="1222" y="893"/>
                </a:cubicBezTo>
                <a:cubicBezTo>
                  <a:pt x="1221" y="879"/>
                  <a:pt x="1221" y="862"/>
                  <a:pt x="1224" y="840"/>
                </a:cubicBezTo>
                <a:cubicBezTo>
                  <a:pt x="1227" y="807"/>
                  <a:pt x="1227" y="783"/>
                  <a:pt x="1225" y="768"/>
                </a:cubicBezTo>
                <a:cubicBezTo>
                  <a:pt x="1223" y="752"/>
                  <a:pt x="1218" y="741"/>
                  <a:pt x="1210" y="733"/>
                </a:cubicBezTo>
                <a:cubicBezTo>
                  <a:pt x="1202" y="725"/>
                  <a:pt x="1192" y="721"/>
                  <a:pt x="1180" y="721"/>
                </a:cubicBezTo>
                <a:cubicBezTo>
                  <a:pt x="1169" y="721"/>
                  <a:pt x="1159" y="726"/>
                  <a:pt x="1149" y="736"/>
                </a:cubicBezTo>
                <a:cubicBezTo>
                  <a:pt x="1139" y="746"/>
                  <a:pt x="1134" y="756"/>
                  <a:pt x="1134" y="768"/>
                </a:cubicBezTo>
                <a:cubicBezTo>
                  <a:pt x="1134" y="780"/>
                  <a:pt x="1139" y="792"/>
                  <a:pt x="1150" y="802"/>
                </a:cubicBezTo>
                <a:lnTo>
                  <a:pt x="1127" y="821"/>
                </a:lnTo>
                <a:cubicBezTo>
                  <a:pt x="1112" y="804"/>
                  <a:pt x="1106" y="786"/>
                  <a:pt x="1107" y="769"/>
                </a:cubicBezTo>
                <a:cubicBezTo>
                  <a:pt x="1108" y="751"/>
                  <a:pt x="1117" y="734"/>
                  <a:pt x="1133" y="718"/>
                </a:cubicBezTo>
                <a:cubicBezTo>
                  <a:pt x="1149" y="702"/>
                  <a:pt x="1166" y="694"/>
                  <a:pt x="1184" y="693"/>
                </a:cubicBezTo>
                <a:cubicBezTo>
                  <a:pt x="1203" y="693"/>
                  <a:pt x="1218" y="699"/>
                  <a:pt x="1232" y="712"/>
                </a:cubicBezTo>
                <a:cubicBezTo>
                  <a:pt x="1238" y="719"/>
                  <a:pt x="1244" y="727"/>
                  <a:pt x="1247" y="736"/>
                </a:cubicBezTo>
                <a:cubicBezTo>
                  <a:pt x="1251" y="746"/>
                  <a:pt x="1253" y="757"/>
                  <a:pt x="1254" y="771"/>
                </a:cubicBezTo>
                <a:cubicBezTo>
                  <a:pt x="1255" y="784"/>
                  <a:pt x="1254" y="805"/>
                  <a:pt x="1252" y="832"/>
                </a:cubicBezTo>
                <a:cubicBezTo>
                  <a:pt x="1250" y="855"/>
                  <a:pt x="1249" y="870"/>
                  <a:pt x="1249" y="877"/>
                </a:cubicBezTo>
                <a:cubicBezTo>
                  <a:pt x="1249" y="884"/>
                  <a:pt x="1250" y="891"/>
                  <a:pt x="1252" y="897"/>
                </a:cubicBezTo>
                <a:lnTo>
                  <a:pt x="1334" y="814"/>
                </a:lnTo>
                <a:close/>
                <a:moveTo>
                  <a:pt x="1359" y="576"/>
                </a:moveTo>
                <a:lnTo>
                  <a:pt x="1340" y="598"/>
                </a:lnTo>
                <a:cubicBezTo>
                  <a:pt x="1330" y="592"/>
                  <a:pt x="1321" y="588"/>
                  <a:pt x="1314" y="588"/>
                </a:cubicBezTo>
                <a:cubicBezTo>
                  <a:pt x="1303" y="588"/>
                  <a:pt x="1293" y="592"/>
                  <a:pt x="1285" y="600"/>
                </a:cubicBezTo>
                <a:cubicBezTo>
                  <a:pt x="1278" y="606"/>
                  <a:pt x="1274" y="614"/>
                  <a:pt x="1273" y="623"/>
                </a:cubicBezTo>
                <a:cubicBezTo>
                  <a:pt x="1271" y="634"/>
                  <a:pt x="1273" y="646"/>
                  <a:pt x="1278" y="659"/>
                </a:cubicBezTo>
                <a:cubicBezTo>
                  <a:pt x="1284" y="672"/>
                  <a:pt x="1295" y="686"/>
                  <a:pt x="1311" y="703"/>
                </a:cubicBezTo>
                <a:cubicBezTo>
                  <a:pt x="1309" y="691"/>
                  <a:pt x="1309" y="679"/>
                  <a:pt x="1313" y="668"/>
                </a:cubicBezTo>
                <a:cubicBezTo>
                  <a:pt x="1316" y="657"/>
                  <a:pt x="1322" y="648"/>
                  <a:pt x="1330" y="640"/>
                </a:cubicBezTo>
                <a:cubicBezTo>
                  <a:pt x="1344" y="627"/>
                  <a:pt x="1360" y="620"/>
                  <a:pt x="1380" y="620"/>
                </a:cubicBezTo>
                <a:cubicBezTo>
                  <a:pt x="1400" y="621"/>
                  <a:pt x="1418" y="629"/>
                  <a:pt x="1434" y="645"/>
                </a:cubicBezTo>
                <a:cubicBezTo>
                  <a:pt x="1444" y="656"/>
                  <a:pt x="1452" y="668"/>
                  <a:pt x="1456" y="681"/>
                </a:cubicBezTo>
                <a:cubicBezTo>
                  <a:pt x="1461" y="695"/>
                  <a:pt x="1462" y="708"/>
                  <a:pt x="1458" y="721"/>
                </a:cubicBezTo>
                <a:cubicBezTo>
                  <a:pt x="1455" y="734"/>
                  <a:pt x="1449" y="745"/>
                  <a:pt x="1439" y="755"/>
                </a:cubicBezTo>
                <a:cubicBezTo>
                  <a:pt x="1421" y="772"/>
                  <a:pt x="1401" y="780"/>
                  <a:pt x="1378" y="778"/>
                </a:cubicBezTo>
                <a:cubicBezTo>
                  <a:pt x="1354" y="776"/>
                  <a:pt x="1328" y="761"/>
                  <a:pt x="1299" y="732"/>
                </a:cubicBezTo>
                <a:cubicBezTo>
                  <a:pt x="1266" y="699"/>
                  <a:pt x="1249" y="670"/>
                  <a:pt x="1246" y="643"/>
                </a:cubicBezTo>
                <a:cubicBezTo>
                  <a:pt x="1244" y="620"/>
                  <a:pt x="1251" y="599"/>
                  <a:pt x="1269" y="582"/>
                </a:cubicBezTo>
                <a:cubicBezTo>
                  <a:pt x="1282" y="568"/>
                  <a:pt x="1297" y="561"/>
                  <a:pt x="1313" y="560"/>
                </a:cubicBezTo>
                <a:cubicBezTo>
                  <a:pt x="1328" y="559"/>
                  <a:pt x="1344" y="564"/>
                  <a:pt x="1359" y="576"/>
                </a:cubicBezTo>
                <a:close/>
                <a:moveTo>
                  <a:pt x="1347" y="732"/>
                </a:moveTo>
                <a:cubicBezTo>
                  <a:pt x="1354" y="740"/>
                  <a:pt x="1362" y="745"/>
                  <a:pt x="1372" y="748"/>
                </a:cubicBezTo>
                <a:cubicBezTo>
                  <a:pt x="1381" y="752"/>
                  <a:pt x="1390" y="752"/>
                  <a:pt x="1399" y="750"/>
                </a:cubicBezTo>
                <a:cubicBezTo>
                  <a:pt x="1408" y="748"/>
                  <a:pt x="1415" y="744"/>
                  <a:pt x="1421" y="738"/>
                </a:cubicBezTo>
                <a:cubicBezTo>
                  <a:pt x="1430" y="730"/>
                  <a:pt x="1434" y="719"/>
                  <a:pt x="1433" y="705"/>
                </a:cubicBezTo>
                <a:cubicBezTo>
                  <a:pt x="1432" y="692"/>
                  <a:pt x="1426" y="680"/>
                  <a:pt x="1414" y="667"/>
                </a:cubicBezTo>
                <a:cubicBezTo>
                  <a:pt x="1402" y="656"/>
                  <a:pt x="1390" y="650"/>
                  <a:pt x="1377" y="649"/>
                </a:cubicBezTo>
                <a:cubicBezTo>
                  <a:pt x="1364" y="649"/>
                  <a:pt x="1353" y="653"/>
                  <a:pt x="1344" y="663"/>
                </a:cubicBezTo>
                <a:cubicBezTo>
                  <a:pt x="1335" y="672"/>
                  <a:pt x="1330" y="683"/>
                  <a:pt x="1330" y="696"/>
                </a:cubicBezTo>
                <a:cubicBezTo>
                  <a:pt x="1330" y="710"/>
                  <a:pt x="1336" y="722"/>
                  <a:pt x="1347" y="732"/>
                </a:cubicBezTo>
                <a:close/>
                <a:moveTo>
                  <a:pt x="1435" y="464"/>
                </a:moveTo>
                <a:lnTo>
                  <a:pt x="1411" y="441"/>
                </a:lnTo>
                <a:lnTo>
                  <a:pt x="1432" y="420"/>
                </a:lnTo>
                <a:lnTo>
                  <a:pt x="1456" y="444"/>
                </a:lnTo>
                <a:lnTo>
                  <a:pt x="1435" y="464"/>
                </a:lnTo>
                <a:close/>
                <a:moveTo>
                  <a:pt x="1579" y="609"/>
                </a:moveTo>
                <a:lnTo>
                  <a:pt x="1458" y="487"/>
                </a:lnTo>
                <a:lnTo>
                  <a:pt x="1478" y="466"/>
                </a:lnTo>
                <a:lnTo>
                  <a:pt x="1600" y="588"/>
                </a:lnTo>
                <a:lnTo>
                  <a:pt x="1579" y="609"/>
                </a:lnTo>
                <a:close/>
                <a:moveTo>
                  <a:pt x="1636" y="552"/>
                </a:moveTo>
                <a:lnTo>
                  <a:pt x="1468" y="384"/>
                </a:lnTo>
                <a:lnTo>
                  <a:pt x="1531" y="321"/>
                </a:lnTo>
                <a:cubicBezTo>
                  <a:pt x="1542" y="310"/>
                  <a:pt x="1551" y="302"/>
                  <a:pt x="1558" y="297"/>
                </a:cubicBezTo>
                <a:cubicBezTo>
                  <a:pt x="1568" y="290"/>
                  <a:pt x="1577" y="286"/>
                  <a:pt x="1587" y="284"/>
                </a:cubicBezTo>
                <a:cubicBezTo>
                  <a:pt x="1596" y="282"/>
                  <a:pt x="1606" y="283"/>
                  <a:pt x="1616" y="287"/>
                </a:cubicBezTo>
                <a:cubicBezTo>
                  <a:pt x="1627" y="290"/>
                  <a:pt x="1636" y="296"/>
                  <a:pt x="1644" y="305"/>
                </a:cubicBezTo>
                <a:cubicBezTo>
                  <a:pt x="1659" y="319"/>
                  <a:pt x="1666" y="336"/>
                  <a:pt x="1667" y="355"/>
                </a:cubicBezTo>
                <a:cubicBezTo>
                  <a:pt x="1668" y="374"/>
                  <a:pt x="1656" y="395"/>
                  <a:pt x="1633" y="419"/>
                </a:cubicBezTo>
                <a:lnTo>
                  <a:pt x="1590" y="462"/>
                </a:lnTo>
                <a:lnTo>
                  <a:pt x="1658" y="530"/>
                </a:lnTo>
                <a:lnTo>
                  <a:pt x="1636" y="552"/>
                </a:lnTo>
                <a:close/>
                <a:moveTo>
                  <a:pt x="1570" y="442"/>
                </a:moveTo>
                <a:lnTo>
                  <a:pt x="1613" y="399"/>
                </a:lnTo>
                <a:cubicBezTo>
                  <a:pt x="1628" y="384"/>
                  <a:pt x="1635" y="371"/>
                  <a:pt x="1636" y="360"/>
                </a:cubicBezTo>
                <a:cubicBezTo>
                  <a:pt x="1636" y="349"/>
                  <a:pt x="1632" y="338"/>
                  <a:pt x="1622" y="328"/>
                </a:cubicBezTo>
                <a:cubicBezTo>
                  <a:pt x="1615" y="321"/>
                  <a:pt x="1607" y="317"/>
                  <a:pt x="1599" y="316"/>
                </a:cubicBezTo>
                <a:cubicBezTo>
                  <a:pt x="1590" y="314"/>
                  <a:pt x="1582" y="316"/>
                  <a:pt x="1575" y="320"/>
                </a:cubicBezTo>
                <a:cubicBezTo>
                  <a:pt x="1570" y="322"/>
                  <a:pt x="1563" y="329"/>
                  <a:pt x="1553" y="339"/>
                </a:cubicBezTo>
                <a:lnTo>
                  <a:pt x="1510" y="382"/>
                </a:lnTo>
                <a:lnTo>
                  <a:pt x="1570" y="442"/>
                </a:lnTo>
                <a:close/>
                <a:moveTo>
                  <a:pt x="1730" y="350"/>
                </a:moveTo>
                <a:lnTo>
                  <a:pt x="1749" y="328"/>
                </a:lnTo>
                <a:cubicBezTo>
                  <a:pt x="1758" y="335"/>
                  <a:pt x="1767" y="340"/>
                  <a:pt x="1776" y="341"/>
                </a:cubicBezTo>
                <a:cubicBezTo>
                  <a:pt x="1785" y="343"/>
                  <a:pt x="1795" y="342"/>
                  <a:pt x="1806" y="338"/>
                </a:cubicBezTo>
                <a:cubicBezTo>
                  <a:pt x="1817" y="333"/>
                  <a:pt x="1828" y="326"/>
                  <a:pt x="1837" y="317"/>
                </a:cubicBezTo>
                <a:cubicBezTo>
                  <a:pt x="1846" y="308"/>
                  <a:pt x="1852" y="299"/>
                  <a:pt x="1856" y="290"/>
                </a:cubicBezTo>
                <a:cubicBezTo>
                  <a:pt x="1860" y="281"/>
                  <a:pt x="1861" y="273"/>
                  <a:pt x="1860" y="266"/>
                </a:cubicBezTo>
                <a:cubicBezTo>
                  <a:pt x="1859" y="258"/>
                  <a:pt x="1856" y="252"/>
                  <a:pt x="1850" y="246"/>
                </a:cubicBezTo>
                <a:cubicBezTo>
                  <a:pt x="1845" y="241"/>
                  <a:pt x="1839" y="238"/>
                  <a:pt x="1832" y="237"/>
                </a:cubicBezTo>
                <a:cubicBezTo>
                  <a:pt x="1825" y="236"/>
                  <a:pt x="1817" y="238"/>
                  <a:pt x="1807" y="242"/>
                </a:cubicBezTo>
                <a:cubicBezTo>
                  <a:pt x="1801" y="245"/>
                  <a:pt x="1788" y="252"/>
                  <a:pt x="1769" y="264"/>
                </a:cubicBezTo>
                <a:cubicBezTo>
                  <a:pt x="1750" y="276"/>
                  <a:pt x="1735" y="283"/>
                  <a:pt x="1726" y="286"/>
                </a:cubicBezTo>
                <a:cubicBezTo>
                  <a:pt x="1714" y="290"/>
                  <a:pt x="1702" y="291"/>
                  <a:pt x="1692" y="288"/>
                </a:cubicBezTo>
                <a:cubicBezTo>
                  <a:pt x="1682" y="286"/>
                  <a:pt x="1673" y="281"/>
                  <a:pt x="1665" y="273"/>
                </a:cubicBezTo>
                <a:cubicBezTo>
                  <a:pt x="1657" y="265"/>
                  <a:pt x="1651" y="255"/>
                  <a:pt x="1649" y="242"/>
                </a:cubicBezTo>
                <a:cubicBezTo>
                  <a:pt x="1646" y="230"/>
                  <a:pt x="1648" y="218"/>
                  <a:pt x="1653" y="205"/>
                </a:cubicBezTo>
                <a:cubicBezTo>
                  <a:pt x="1659" y="191"/>
                  <a:pt x="1667" y="179"/>
                  <a:pt x="1678" y="168"/>
                </a:cubicBezTo>
                <a:cubicBezTo>
                  <a:pt x="1691" y="155"/>
                  <a:pt x="1704" y="146"/>
                  <a:pt x="1717" y="141"/>
                </a:cubicBezTo>
                <a:cubicBezTo>
                  <a:pt x="1731" y="135"/>
                  <a:pt x="1744" y="134"/>
                  <a:pt x="1757" y="137"/>
                </a:cubicBezTo>
                <a:cubicBezTo>
                  <a:pt x="1770" y="139"/>
                  <a:pt x="1781" y="146"/>
                  <a:pt x="1792" y="155"/>
                </a:cubicBezTo>
                <a:lnTo>
                  <a:pt x="1772" y="178"/>
                </a:lnTo>
                <a:cubicBezTo>
                  <a:pt x="1760" y="168"/>
                  <a:pt x="1748" y="164"/>
                  <a:pt x="1736" y="165"/>
                </a:cubicBezTo>
                <a:cubicBezTo>
                  <a:pt x="1724" y="167"/>
                  <a:pt x="1712" y="174"/>
                  <a:pt x="1699" y="187"/>
                </a:cubicBezTo>
                <a:cubicBezTo>
                  <a:pt x="1685" y="200"/>
                  <a:pt x="1678" y="212"/>
                  <a:pt x="1677" y="223"/>
                </a:cubicBezTo>
                <a:cubicBezTo>
                  <a:pt x="1676" y="234"/>
                  <a:pt x="1678" y="244"/>
                  <a:pt x="1685" y="250"/>
                </a:cubicBezTo>
                <a:cubicBezTo>
                  <a:pt x="1691" y="257"/>
                  <a:pt x="1699" y="259"/>
                  <a:pt x="1707" y="259"/>
                </a:cubicBezTo>
                <a:cubicBezTo>
                  <a:pt x="1715" y="258"/>
                  <a:pt x="1730" y="251"/>
                  <a:pt x="1752" y="237"/>
                </a:cubicBezTo>
                <a:cubicBezTo>
                  <a:pt x="1774" y="223"/>
                  <a:pt x="1790" y="214"/>
                  <a:pt x="1800" y="211"/>
                </a:cubicBezTo>
                <a:cubicBezTo>
                  <a:pt x="1815" y="206"/>
                  <a:pt x="1827" y="204"/>
                  <a:pt x="1839" y="206"/>
                </a:cubicBezTo>
                <a:cubicBezTo>
                  <a:pt x="1851" y="209"/>
                  <a:pt x="1861" y="214"/>
                  <a:pt x="1870" y="223"/>
                </a:cubicBezTo>
                <a:cubicBezTo>
                  <a:pt x="1879" y="232"/>
                  <a:pt x="1885" y="243"/>
                  <a:pt x="1888" y="256"/>
                </a:cubicBezTo>
                <a:cubicBezTo>
                  <a:pt x="1890" y="269"/>
                  <a:pt x="1889" y="283"/>
                  <a:pt x="1884" y="297"/>
                </a:cubicBezTo>
                <a:cubicBezTo>
                  <a:pt x="1879" y="311"/>
                  <a:pt x="1870" y="324"/>
                  <a:pt x="1858" y="336"/>
                </a:cubicBezTo>
                <a:cubicBezTo>
                  <a:pt x="1843" y="351"/>
                  <a:pt x="1828" y="361"/>
                  <a:pt x="1813" y="367"/>
                </a:cubicBezTo>
                <a:cubicBezTo>
                  <a:pt x="1799" y="373"/>
                  <a:pt x="1784" y="374"/>
                  <a:pt x="1769" y="371"/>
                </a:cubicBezTo>
                <a:cubicBezTo>
                  <a:pt x="1754" y="368"/>
                  <a:pt x="1741" y="361"/>
                  <a:pt x="1730" y="350"/>
                </a:cubicBezTo>
                <a:close/>
                <a:moveTo>
                  <a:pt x="2019" y="169"/>
                </a:moveTo>
                <a:lnTo>
                  <a:pt x="1998" y="190"/>
                </a:lnTo>
                <a:lnTo>
                  <a:pt x="1867" y="58"/>
                </a:lnTo>
                <a:cubicBezTo>
                  <a:pt x="1867" y="68"/>
                  <a:pt x="1865" y="79"/>
                  <a:pt x="1861" y="92"/>
                </a:cubicBezTo>
                <a:cubicBezTo>
                  <a:pt x="1858" y="105"/>
                  <a:pt x="1854" y="116"/>
                  <a:pt x="1850" y="124"/>
                </a:cubicBezTo>
                <a:lnTo>
                  <a:pt x="1830" y="104"/>
                </a:lnTo>
                <a:cubicBezTo>
                  <a:pt x="1837" y="87"/>
                  <a:pt x="1840" y="71"/>
                  <a:pt x="1841" y="54"/>
                </a:cubicBezTo>
                <a:cubicBezTo>
                  <a:pt x="1842" y="38"/>
                  <a:pt x="1841" y="25"/>
                  <a:pt x="1837" y="14"/>
                </a:cubicBezTo>
                <a:lnTo>
                  <a:pt x="1850" y="0"/>
                </a:lnTo>
                <a:lnTo>
                  <a:pt x="2019" y="169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9" name="Freeform 85"/>
          <p:cNvSpPr>
            <a:spLocks noEditPoints="1"/>
          </p:cNvSpPr>
          <p:nvPr/>
        </p:nvSpPr>
        <p:spPr bwMode="auto">
          <a:xfrm>
            <a:off x="8172592" y="5034102"/>
            <a:ext cx="781050" cy="771525"/>
          </a:xfrm>
          <a:custGeom>
            <a:avLst/>
            <a:gdLst>
              <a:gd name="T0" fmla="*/ 119 w 2050"/>
              <a:gd name="T1" fmla="*/ 1755 h 2023"/>
              <a:gd name="T2" fmla="*/ 122 w 2050"/>
              <a:gd name="T3" fmla="*/ 1933 h 2023"/>
              <a:gd name="T4" fmla="*/ 168 w 2050"/>
              <a:gd name="T5" fmla="*/ 1831 h 2023"/>
              <a:gd name="T6" fmla="*/ 42 w 2050"/>
              <a:gd name="T7" fmla="*/ 1853 h 2023"/>
              <a:gd name="T8" fmla="*/ 256 w 2050"/>
              <a:gd name="T9" fmla="*/ 1609 h 2023"/>
              <a:gd name="T10" fmla="*/ 370 w 2050"/>
              <a:gd name="T11" fmla="*/ 1673 h 2023"/>
              <a:gd name="T12" fmla="*/ 389 w 2050"/>
              <a:gd name="T13" fmla="*/ 1802 h 2023"/>
              <a:gd name="T14" fmla="*/ 310 w 2050"/>
              <a:gd name="T15" fmla="*/ 1666 h 2023"/>
              <a:gd name="T16" fmla="*/ 199 w 2050"/>
              <a:gd name="T17" fmla="*/ 1695 h 2023"/>
              <a:gd name="T18" fmla="*/ 392 w 2050"/>
              <a:gd name="T19" fmla="*/ 1749 h 2023"/>
              <a:gd name="T20" fmla="*/ 309 w 2050"/>
              <a:gd name="T21" fmla="*/ 1727 h 2023"/>
              <a:gd name="T22" fmla="*/ 371 w 2050"/>
              <a:gd name="T23" fmla="*/ 1483 h 2023"/>
              <a:gd name="T24" fmla="*/ 565 w 2050"/>
              <a:gd name="T25" fmla="*/ 1524 h 2023"/>
              <a:gd name="T26" fmla="*/ 482 w 2050"/>
              <a:gd name="T27" fmla="*/ 1709 h 2023"/>
              <a:gd name="T28" fmla="*/ 540 w 2050"/>
              <a:gd name="T29" fmla="*/ 1545 h 2023"/>
              <a:gd name="T30" fmla="*/ 356 w 2050"/>
              <a:gd name="T31" fmla="*/ 1539 h 2023"/>
              <a:gd name="T32" fmla="*/ 813 w 2050"/>
              <a:gd name="T33" fmla="*/ 1471 h 2023"/>
              <a:gd name="T34" fmla="*/ 707 w 2050"/>
              <a:gd name="T35" fmla="*/ 1151 h 2023"/>
              <a:gd name="T36" fmla="*/ 781 w 2050"/>
              <a:gd name="T37" fmla="*/ 1273 h 2023"/>
              <a:gd name="T38" fmla="*/ 762 w 2050"/>
              <a:gd name="T39" fmla="*/ 1253 h 2023"/>
              <a:gd name="T40" fmla="*/ 701 w 2050"/>
              <a:gd name="T41" fmla="*/ 1193 h 2023"/>
              <a:gd name="T42" fmla="*/ 894 w 2050"/>
              <a:gd name="T43" fmla="*/ 961 h 2023"/>
              <a:gd name="T44" fmla="*/ 978 w 2050"/>
              <a:gd name="T45" fmla="*/ 1059 h 2023"/>
              <a:gd name="T46" fmla="*/ 940 w 2050"/>
              <a:gd name="T47" fmla="*/ 1251 h 2023"/>
              <a:gd name="T48" fmla="*/ 1021 w 2050"/>
              <a:gd name="T49" fmla="*/ 920 h 2023"/>
              <a:gd name="T50" fmla="*/ 1083 w 2050"/>
              <a:gd name="T51" fmla="*/ 931 h 2023"/>
              <a:gd name="T52" fmla="*/ 1091 w 2050"/>
              <a:gd name="T53" fmla="*/ 982 h 2023"/>
              <a:gd name="T54" fmla="*/ 1243 w 2050"/>
              <a:gd name="T55" fmla="*/ 948 h 2023"/>
              <a:gd name="T56" fmla="*/ 1210 w 2050"/>
              <a:gd name="T57" fmla="*/ 736 h 2023"/>
              <a:gd name="T58" fmla="*/ 1126 w 2050"/>
              <a:gd name="T59" fmla="*/ 824 h 2023"/>
              <a:gd name="T60" fmla="*/ 1247 w 2050"/>
              <a:gd name="T61" fmla="*/ 739 h 2023"/>
              <a:gd name="T62" fmla="*/ 1334 w 2050"/>
              <a:gd name="T63" fmla="*/ 817 h 2023"/>
              <a:gd name="T64" fmla="*/ 1273 w 2050"/>
              <a:gd name="T65" fmla="*/ 626 h 2023"/>
              <a:gd name="T66" fmla="*/ 1380 w 2050"/>
              <a:gd name="T67" fmla="*/ 623 h 2023"/>
              <a:gd name="T68" fmla="*/ 1378 w 2050"/>
              <a:gd name="T69" fmla="*/ 781 h 2023"/>
              <a:gd name="T70" fmla="*/ 1358 w 2050"/>
              <a:gd name="T71" fmla="*/ 579 h 2023"/>
              <a:gd name="T72" fmla="*/ 1433 w 2050"/>
              <a:gd name="T73" fmla="*/ 708 h 2023"/>
              <a:gd name="T74" fmla="*/ 1347 w 2050"/>
              <a:gd name="T75" fmla="*/ 735 h 2023"/>
              <a:gd name="T76" fmla="*/ 1435 w 2050"/>
              <a:gd name="T77" fmla="*/ 467 h 2023"/>
              <a:gd name="T78" fmla="*/ 1579 w 2050"/>
              <a:gd name="T79" fmla="*/ 612 h 2023"/>
              <a:gd name="T80" fmla="*/ 1587 w 2050"/>
              <a:gd name="T81" fmla="*/ 287 h 2023"/>
              <a:gd name="T82" fmla="*/ 1589 w 2050"/>
              <a:gd name="T83" fmla="*/ 465 h 2023"/>
              <a:gd name="T84" fmla="*/ 1636 w 2050"/>
              <a:gd name="T85" fmla="*/ 363 h 2023"/>
              <a:gd name="T86" fmla="*/ 1510 w 2050"/>
              <a:gd name="T87" fmla="*/ 385 h 2023"/>
              <a:gd name="T88" fmla="*/ 1806 w 2050"/>
              <a:gd name="T89" fmla="*/ 341 h 2023"/>
              <a:gd name="T90" fmla="*/ 1832 w 2050"/>
              <a:gd name="T91" fmla="*/ 240 h 2023"/>
              <a:gd name="T92" fmla="*/ 1665 w 2050"/>
              <a:gd name="T93" fmla="*/ 276 h 2023"/>
              <a:gd name="T94" fmla="*/ 1757 w 2050"/>
              <a:gd name="T95" fmla="*/ 140 h 2023"/>
              <a:gd name="T96" fmla="*/ 1677 w 2050"/>
              <a:gd name="T97" fmla="*/ 226 h 2023"/>
              <a:gd name="T98" fmla="*/ 1839 w 2050"/>
              <a:gd name="T99" fmla="*/ 209 h 2023"/>
              <a:gd name="T100" fmla="*/ 1813 w 2050"/>
              <a:gd name="T101" fmla="*/ 370 h 2023"/>
              <a:gd name="T102" fmla="*/ 1938 w 2050"/>
              <a:gd name="T103" fmla="*/ 252 h 2023"/>
              <a:gd name="T104" fmla="*/ 1906 w 2050"/>
              <a:gd name="T105" fmla="*/ 40 h 2023"/>
              <a:gd name="T106" fmla="*/ 1822 w 2050"/>
              <a:gd name="T107" fmla="*/ 128 h 2023"/>
              <a:gd name="T108" fmla="*/ 1943 w 2050"/>
              <a:gd name="T109" fmla="*/ 43 h 2023"/>
              <a:gd name="T110" fmla="*/ 2030 w 2050"/>
              <a:gd name="T111" fmla="*/ 122 h 202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</a:cxnLst>
            <a:rect l="0" t="0" r="r" b="b"/>
            <a:pathLst>
              <a:path w="2050" h="2023">
                <a:moveTo>
                  <a:pt x="168" y="2023"/>
                </a:moveTo>
                <a:lnTo>
                  <a:pt x="0" y="1855"/>
                </a:lnTo>
                <a:lnTo>
                  <a:pt x="63" y="1792"/>
                </a:lnTo>
                <a:cubicBezTo>
                  <a:pt x="74" y="1781"/>
                  <a:pt x="83" y="1773"/>
                  <a:pt x="90" y="1768"/>
                </a:cubicBezTo>
                <a:cubicBezTo>
                  <a:pt x="100" y="1761"/>
                  <a:pt x="109" y="1757"/>
                  <a:pt x="119" y="1755"/>
                </a:cubicBezTo>
                <a:cubicBezTo>
                  <a:pt x="128" y="1753"/>
                  <a:pt x="138" y="1754"/>
                  <a:pt x="148" y="1758"/>
                </a:cubicBezTo>
                <a:cubicBezTo>
                  <a:pt x="159" y="1761"/>
                  <a:pt x="168" y="1767"/>
                  <a:pt x="176" y="1776"/>
                </a:cubicBezTo>
                <a:cubicBezTo>
                  <a:pt x="191" y="1790"/>
                  <a:pt x="198" y="1807"/>
                  <a:pt x="199" y="1826"/>
                </a:cubicBezTo>
                <a:cubicBezTo>
                  <a:pt x="200" y="1845"/>
                  <a:pt x="188" y="1866"/>
                  <a:pt x="165" y="1890"/>
                </a:cubicBezTo>
                <a:lnTo>
                  <a:pt x="122" y="1933"/>
                </a:lnTo>
                <a:lnTo>
                  <a:pt x="190" y="2001"/>
                </a:lnTo>
                <a:lnTo>
                  <a:pt x="168" y="2023"/>
                </a:lnTo>
                <a:close/>
                <a:moveTo>
                  <a:pt x="102" y="1913"/>
                </a:moveTo>
                <a:lnTo>
                  <a:pt x="145" y="1870"/>
                </a:lnTo>
                <a:cubicBezTo>
                  <a:pt x="159" y="1855"/>
                  <a:pt x="167" y="1842"/>
                  <a:pt x="168" y="1831"/>
                </a:cubicBezTo>
                <a:cubicBezTo>
                  <a:pt x="168" y="1820"/>
                  <a:pt x="164" y="1809"/>
                  <a:pt x="154" y="1799"/>
                </a:cubicBezTo>
                <a:cubicBezTo>
                  <a:pt x="147" y="1792"/>
                  <a:pt x="139" y="1788"/>
                  <a:pt x="131" y="1787"/>
                </a:cubicBezTo>
                <a:cubicBezTo>
                  <a:pt x="122" y="1785"/>
                  <a:pt x="114" y="1786"/>
                  <a:pt x="107" y="1791"/>
                </a:cubicBezTo>
                <a:cubicBezTo>
                  <a:pt x="102" y="1793"/>
                  <a:pt x="95" y="1800"/>
                  <a:pt x="85" y="1810"/>
                </a:cubicBezTo>
                <a:lnTo>
                  <a:pt x="42" y="1853"/>
                </a:lnTo>
                <a:lnTo>
                  <a:pt x="102" y="1913"/>
                </a:lnTo>
                <a:close/>
                <a:moveTo>
                  <a:pt x="325" y="1866"/>
                </a:moveTo>
                <a:lnTo>
                  <a:pt x="157" y="1698"/>
                </a:lnTo>
                <a:lnTo>
                  <a:pt x="220" y="1635"/>
                </a:lnTo>
                <a:cubicBezTo>
                  <a:pt x="233" y="1622"/>
                  <a:pt x="245" y="1613"/>
                  <a:pt x="256" y="1609"/>
                </a:cubicBezTo>
                <a:cubicBezTo>
                  <a:pt x="267" y="1605"/>
                  <a:pt x="279" y="1604"/>
                  <a:pt x="290" y="1606"/>
                </a:cubicBezTo>
                <a:cubicBezTo>
                  <a:pt x="301" y="1609"/>
                  <a:pt x="311" y="1614"/>
                  <a:pt x="319" y="1622"/>
                </a:cubicBezTo>
                <a:cubicBezTo>
                  <a:pt x="326" y="1629"/>
                  <a:pt x="331" y="1638"/>
                  <a:pt x="333" y="1648"/>
                </a:cubicBezTo>
                <a:cubicBezTo>
                  <a:pt x="336" y="1658"/>
                  <a:pt x="335" y="1669"/>
                  <a:pt x="331" y="1681"/>
                </a:cubicBezTo>
                <a:cubicBezTo>
                  <a:pt x="344" y="1674"/>
                  <a:pt x="357" y="1671"/>
                  <a:pt x="370" y="1673"/>
                </a:cubicBezTo>
                <a:cubicBezTo>
                  <a:pt x="382" y="1675"/>
                  <a:pt x="393" y="1680"/>
                  <a:pt x="403" y="1690"/>
                </a:cubicBezTo>
                <a:cubicBezTo>
                  <a:pt x="411" y="1698"/>
                  <a:pt x="417" y="1707"/>
                  <a:pt x="420" y="1717"/>
                </a:cubicBezTo>
                <a:cubicBezTo>
                  <a:pt x="424" y="1727"/>
                  <a:pt x="425" y="1737"/>
                  <a:pt x="424" y="1745"/>
                </a:cubicBezTo>
                <a:cubicBezTo>
                  <a:pt x="422" y="1754"/>
                  <a:pt x="419" y="1763"/>
                  <a:pt x="413" y="1772"/>
                </a:cubicBezTo>
                <a:cubicBezTo>
                  <a:pt x="408" y="1781"/>
                  <a:pt x="400" y="1791"/>
                  <a:pt x="389" y="1802"/>
                </a:cubicBezTo>
                <a:lnTo>
                  <a:pt x="325" y="1866"/>
                </a:lnTo>
                <a:close/>
                <a:moveTo>
                  <a:pt x="250" y="1746"/>
                </a:moveTo>
                <a:lnTo>
                  <a:pt x="286" y="1710"/>
                </a:lnTo>
                <a:cubicBezTo>
                  <a:pt x="296" y="1700"/>
                  <a:pt x="302" y="1692"/>
                  <a:pt x="305" y="1687"/>
                </a:cubicBezTo>
                <a:cubicBezTo>
                  <a:pt x="309" y="1679"/>
                  <a:pt x="311" y="1672"/>
                  <a:pt x="310" y="1666"/>
                </a:cubicBezTo>
                <a:cubicBezTo>
                  <a:pt x="309" y="1659"/>
                  <a:pt x="305" y="1652"/>
                  <a:pt x="300" y="1647"/>
                </a:cubicBezTo>
                <a:cubicBezTo>
                  <a:pt x="294" y="1641"/>
                  <a:pt x="288" y="1637"/>
                  <a:pt x="281" y="1636"/>
                </a:cubicBezTo>
                <a:cubicBezTo>
                  <a:pt x="274" y="1634"/>
                  <a:pt x="267" y="1635"/>
                  <a:pt x="261" y="1639"/>
                </a:cubicBezTo>
                <a:cubicBezTo>
                  <a:pt x="254" y="1642"/>
                  <a:pt x="245" y="1650"/>
                  <a:pt x="233" y="1662"/>
                </a:cubicBezTo>
                <a:lnTo>
                  <a:pt x="199" y="1695"/>
                </a:lnTo>
                <a:lnTo>
                  <a:pt x="250" y="1746"/>
                </a:lnTo>
                <a:close/>
                <a:moveTo>
                  <a:pt x="327" y="1824"/>
                </a:moveTo>
                <a:lnTo>
                  <a:pt x="369" y="1782"/>
                </a:lnTo>
                <a:cubicBezTo>
                  <a:pt x="376" y="1775"/>
                  <a:pt x="381" y="1769"/>
                  <a:pt x="384" y="1766"/>
                </a:cubicBezTo>
                <a:cubicBezTo>
                  <a:pt x="388" y="1760"/>
                  <a:pt x="391" y="1754"/>
                  <a:pt x="392" y="1749"/>
                </a:cubicBezTo>
                <a:cubicBezTo>
                  <a:pt x="393" y="1743"/>
                  <a:pt x="393" y="1737"/>
                  <a:pt x="391" y="1731"/>
                </a:cubicBezTo>
                <a:cubicBezTo>
                  <a:pt x="389" y="1724"/>
                  <a:pt x="386" y="1719"/>
                  <a:pt x="380" y="1713"/>
                </a:cubicBezTo>
                <a:cubicBezTo>
                  <a:pt x="374" y="1707"/>
                  <a:pt x="367" y="1703"/>
                  <a:pt x="359" y="1702"/>
                </a:cubicBezTo>
                <a:cubicBezTo>
                  <a:pt x="351" y="1700"/>
                  <a:pt x="344" y="1702"/>
                  <a:pt x="336" y="1705"/>
                </a:cubicBezTo>
                <a:cubicBezTo>
                  <a:pt x="328" y="1709"/>
                  <a:pt x="319" y="1716"/>
                  <a:pt x="309" y="1727"/>
                </a:cubicBezTo>
                <a:lnTo>
                  <a:pt x="270" y="1766"/>
                </a:lnTo>
                <a:lnTo>
                  <a:pt x="327" y="1824"/>
                </a:lnTo>
                <a:close/>
                <a:moveTo>
                  <a:pt x="482" y="1709"/>
                </a:moveTo>
                <a:lnTo>
                  <a:pt x="314" y="1541"/>
                </a:lnTo>
                <a:lnTo>
                  <a:pt x="371" y="1483"/>
                </a:lnTo>
                <a:cubicBezTo>
                  <a:pt x="384" y="1470"/>
                  <a:pt x="395" y="1461"/>
                  <a:pt x="404" y="1456"/>
                </a:cubicBezTo>
                <a:cubicBezTo>
                  <a:pt x="416" y="1449"/>
                  <a:pt x="428" y="1444"/>
                  <a:pt x="440" y="1443"/>
                </a:cubicBezTo>
                <a:cubicBezTo>
                  <a:pt x="457" y="1442"/>
                  <a:pt x="473" y="1445"/>
                  <a:pt x="489" y="1452"/>
                </a:cubicBezTo>
                <a:cubicBezTo>
                  <a:pt x="505" y="1459"/>
                  <a:pt x="521" y="1471"/>
                  <a:pt x="536" y="1486"/>
                </a:cubicBezTo>
                <a:cubicBezTo>
                  <a:pt x="548" y="1498"/>
                  <a:pt x="558" y="1511"/>
                  <a:pt x="565" y="1524"/>
                </a:cubicBezTo>
                <a:cubicBezTo>
                  <a:pt x="572" y="1537"/>
                  <a:pt x="576" y="1549"/>
                  <a:pt x="578" y="1560"/>
                </a:cubicBezTo>
                <a:cubicBezTo>
                  <a:pt x="580" y="1571"/>
                  <a:pt x="580" y="1581"/>
                  <a:pt x="578" y="1590"/>
                </a:cubicBezTo>
                <a:cubicBezTo>
                  <a:pt x="576" y="1600"/>
                  <a:pt x="572" y="1609"/>
                  <a:pt x="566" y="1619"/>
                </a:cubicBezTo>
                <a:cubicBezTo>
                  <a:pt x="560" y="1629"/>
                  <a:pt x="552" y="1639"/>
                  <a:pt x="542" y="1649"/>
                </a:cubicBezTo>
                <a:lnTo>
                  <a:pt x="482" y="1709"/>
                </a:lnTo>
                <a:close/>
                <a:moveTo>
                  <a:pt x="484" y="1667"/>
                </a:moveTo>
                <a:lnTo>
                  <a:pt x="520" y="1631"/>
                </a:lnTo>
                <a:cubicBezTo>
                  <a:pt x="531" y="1620"/>
                  <a:pt x="539" y="1611"/>
                  <a:pt x="543" y="1602"/>
                </a:cubicBezTo>
                <a:cubicBezTo>
                  <a:pt x="547" y="1594"/>
                  <a:pt x="549" y="1586"/>
                  <a:pt x="549" y="1579"/>
                </a:cubicBezTo>
                <a:cubicBezTo>
                  <a:pt x="549" y="1568"/>
                  <a:pt x="546" y="1557"/>
                  <a:pt x="540" y="1545"/>
                </a:cubicBezTo>
                <a:cubicBezTo>
                  <a:pt x="534" y="1533"/>
                  <a:pt x="525" y="1521"/>
                  <a:pt x="512" y="1508"/>
                </a:cubicBezTo>
                <a:cubicBezTo>
                  <a:pt x="495" y="1491"/>
                  <a:pt x="478" y="1480"/>
                  <a:pt x="463" y="1476"/>
                </a:cubicBezTo>
                <a:cubicBezTo>
                  <a:pt x="448" y="1473"/>
                  <a:pt x="435" y="1473"/>
                  <a:pt x="423" y="1478"/>
                </a:cubicBezTo>
                <a:cubicBezTo>
                  <a:pt x="415" y="1482"/>
                  <a:pt x="404" y="1490"/>
                  <a:pt x="391" y="1504"/>
                </a:cubicBezTo>
                <a:lnTo>
                  <a:pt x="356" y="1539"/>
                </a:lnTo>
                <a:lnTo>
                  <a:pt x="484" y="1667"/>
                </a:lnTo>
                <a:close/>
                <a:moveTo>
                  <a:pt x="676" y="1608"/>
                </a:moveTo>
                <a:lnTo>
                  <a:pt x="661" y="1593"/>
                </a:lnTo>
                <a:lnTo>
                  <a:pt x="798" y="1456"/>
                </a:lnTo>
                <a:lnTo>
                  <a:pt x="813" y="1471"/>
                </a:lnTo>
                <a:lnTo>
                  <a:pt x="676" y="1608"/>
                </a:lnTo>
                <a:close/>
                <a:moveTo>
                  <a:pt x="784" y="1407"/>
                </a:moveTo>
                <a:lnTo>
                  <a:pt x="616" y="1239"/>
                </a:lnTo>
                <a:lnTo>
                  <a:pt x="680" y="1175"/>
                </a:lnTo>
                <a:cubicBezTo>
                  <a:pt x="691" y="1164"/>
                  <a:pt x="700" y="1156"/>
                  <a:pt x="707" y="1151"/>
                </a:cubicBezTo>
                <a:cubicBezTo>
                  <a:pt x="716" y="1144"/>
                  <a:pt x="726" y="1140"/>
                  <a:pt x="735" y="1138"/>
                </a:cubicBezTo>
                <a:cubicBezTo>
                  <a:pt x="745" y="1137"/>
                  <a:pt x="755" y="1138"/>
                  <a:pt x="765" y="1141"/>
                </a:cubicBezTo>
                <a:cubicBezTo>
                  <a:pt x="775" y="1145"/>
                  <a:pt x="785" y="1151"/>
                  <a:pt x="793" y="1159"/>
                </a:cubicBezTo>
                <a:cubicBezTo>
                  <a:pt x="807" y="1173"/>
                  <a:pt x="815" y="1190"/>
                  <a:pt x="816" y="1209"/>
                </a:cubicBezTo>
                <a:cubicBezTo>
                  <a:pt x="816" y="1228"/>
                  <a:pt x="805" y="1249"/>
                  <a:pt x="781" y="1273"/>
                </a:cubicBezTo>
                <a:lnTo>
                  <a:pt x="738" y="1316"/>
                </a:lnTo>
                <a:lnTo>
                  <a:pt x="806" y="1385"/>
                </a:lnTo>
                <a:lnTo>
                  <a:pt x="784" y="1407"/>
                </a:lnTo>
                <a:close/>
                <a:moveTo>
                  <a:pt x="718" y="1296"/>
                </a:moveTo>
                <a:lnTo>
                  <a:pt x="762" y="1253"/>
                </a:lnTo>
                <a:cubicBezTo>
                  <a:pt x="776" y="1239"/>
                  <a:pt x="784" y="1226"/>
                  <a:pt x="784" y="1214"/>
                </a:cubicBezTo>
                <a:cubicBezTo>
                  <a:pt x="785" y="1203"/>
                  <a:pt x="780" y="1192"/>
                  <a:pt x="771" y="1183"/>
                </a:cubicBezTo>
                <a:cubicBezTo>
                  <a:pt x="764" y="1176"/>
                  <a:pt x="756" y="1171"/>
                  <a:pt x="747" y="1170"/>
                </a:cubicBezTo>
                <a:cubicBezTo>
                  <a:pt x="739" y="1168"/>
                  <a:pt x="731" y="1170"/>
                  <a:pt x="723" y="1174"/>
                </a:cubicBezTo>
                <a:cubicBezTo>
                  <a:pt x="719" y="1177"/>
                  <a:pt x="711" y="1183"/>
                  <a:pt x="701" y="1193"/>
                </a:cubicBezTo>
                <a:lnTo>
                  <a:pt x="658" y="1236"/>
                </a:lnTo>
                <a:lnTo>
                  <a:pt x="718" y="1296"/>
                </a:lnTo>
                <a:close/>
                <a:moveTo>
                  <a:pt x="940" y="1251"/>
                </a:moveTo>
                <a:lnTo>
                  <a:pt x="772" y="1083"/>
                </a:lnTo>
                <a:lnTo>
                  <a:pt x="894" y="961"/>
                </a:lnTo>
                <a:lnTo>
                  <a:pt x="914" y="981"/>
                </a:lnTo>
                <a:lnTo>
                  <a:pt x="814" y="1080"/>
                </a:lnTo>
                <a:lnTo>
                  <a:pt x="866" y="1132"/>
                </a:lnTo>
                <a:lnTo>
                  <a:pt x="959" y="1039"/>
                </a:lnTo>
                <a:lnTo>
                  <a:pt x="978" y="1059"/>
                </a:lnTo>
                <a:lnTo>
                  <a:pt x="885" y="1151"/>
                </a:lnTo>
                <a:lnTo>
                  <a:pt x="943" y="1209"/>
                </a:lnTo>
                <a:lnTo>
                  <a:pt x="1046" y="1106"/>
                </a:lnTo>
                <a:lnTo>
                  <a:pt x="1066" y="1125"/>
                </a:lnTo>
                <a:lnTo>
                  <a:pt x="940" y="1251"/>
                </a:lnTo>
                <a:close/>
                <a:moveTo>
                  <a:pt x="1081" y="1110"/>
                </a:moveTo>
                <a:lnTo>
                  <a:pt x="1058" y="957"/>
                </a:lnTo>
                <a:lnTo>
                  <a:pt x="921" y="934"/>
                </a:lnTo>
                <a:lnTo>
                  <a:pt x="947" y="908"/>
                </a:lnTo>
                <a:lnTo>
                  <a:pt x="1021" y="920"/>
                </a:lnTo>
                <a:cubicBezTo>
                  <a:pt x="1036" y="923"/>
                  <a:pt x="1047" y="925"/>
                  <a:pt x="1055" y="927"/>
                </a:cubicBezTo>
                <a:cubicBezTo>
                  <a:pt x="1053" y="918"/>
                  <a:pt x="1051" y="907"/>
                  <a:pt x="1049" y="895"/>
                </a:cubicBezTo>
                <a:lnTo>
                  <a:pt x="1038" y="817"/>
                </a:lnTo>
                <a:lnTo>
                  <a:pt x="1062" y="792"/>
                </a:lnTo>
                <a:lnTo>
                  <a:pt x="1083" y="931"/>
                </a:lnTo>
                <a:lnTo>
                  <a:pt x="1235" y="956"/>
                </a:lnTo>
                <a:lnTo>
                  <a:pt x="1208" y="983"/>
                </a:lnTo>
                <a:lnTo>
                  <a:pt x="1105" y="966"/>
                </a:lnTo>
                <a:cubicBezTo>
                  <a:pt x="1100" y="965"/>
                  <a:pt x="1093" y="963"/>
                  <a:pt x="1087" y="962"/>
                </a:cubicBezTo>
                <a:cubicBezTo>
                  <a:pt x="1089" y="972"/>
                  <a:pt x="1091" y="979"/>
                  <a:pt x="1091" y="982"/>
                </a:cubicBezTo>
                <a:lnTo>
                  <a:pt x="1108" y="1083"/>
                </a:lnTo>
                <a:lnTo>
                  <a:pt x="1081" y="1110"/>
                </a:lnTo>
                <a:close/>
                <a:moveTo>
                  <a:pt x="1334" y="817"/>
                </a:moveTo>
                <a:lnTo>
                  <a:pt x="1354" y="837"/>
                </a:lnTo>
                <a:lnTo>
                  <a:pt x="1243" y="948"/>
                </a:lnTo>
                <a:cubicBezTo>
                  <a:pt x="1238" y="943"/>
                  <a:pt x="1234" y="938"/>
                  <a:pt x="1231" y="932"/>
                </a:cubicBezTo>
                <a:cubicBezTo>
                  <a:pt x="1226" y="921"/>
                  <a:pt x="1223" y="909"/>
                  <a:pt x="1222" y="896"/>
                </a:cubicBezTo>
                <a:cubicBezTo>
                  <a:pt x="1221" y="882"/>
                  <a:pt x="1221" y="865"/>
                  <a:pt x="1224" y="843"/>
                </a:cubicBezTo>
                <a:cubicBezTo>
                  <a:pt x="1227" y="810"/>
                  <a:pt x="1227" y="786"/>
                  <a:pt x="1225" y="771"/>
                </a:cubicBezTo>
                <a:cubicBezTo>
                  <a:pt x="1223" y="755"/>
                  <a:pt x="1218" y="744"/>
                  <a:pt x="1210" y="736"/>
                </a:cubicBezTo>
                <a:cubicBezTo>
                  <a:pt x="1202" y="728"/>
                  <a:pt x="1192" y="724"/>
                  <a:pt x="1180" y="724"/>
                </a:cubicBezTo>
                <a:cubicBezTo>
                  <a:pt x="1169" y="724"/>
                  <a:pt x="1158" y="729"/>
                  <a:pt x="1149" y="739"/>
                </a:cubicBezTo>
                <a:cubicBezTo>
                  <a:pt x="1139" y="749"/>
                  <a:pt x="1134" y="759"/>
                  <a:pt x="1134" y="771"/>
                </a:cubicBezTo>
                <a:cubicBezTo>
                  <a:pt x="1134" y="783"/>
                  <a:pt x="1139" y="795"/>
                  <a:pt x="1150" y="805"/>
                </a:cubicBezTo>
                <a:lnTo>
                  <a:pt x="1126" y="824"/>
                </a:lnTo>
                <a:cubicBezTo>
                  <a:pt x="1112" y="807"/>
                  <a:pt x="1106" y="789"/>
                  <a:pt x="1107" y="772"/>
                </a:cubicBezTo>
                <a:cubicBezTo>
                  <a:pt x="1108" y="754"/>
                  <a:pt x="1116" y="737"/>
                  <a:pt x="1132" y="721"/>
                </a:cubicBezTo>
                <a:cubicBezTo>
                  <a:pt x="1149" y="705"/>
                  <a:pt x="1166" y="697"/>
                  <a:pt x="1184" y="696"/>
                </a:cubicBezTo>
                <a:cubicBezTo>
                  <a:pt x="1202" y="696"/>
                  <a:pt x="1218" y="702"/>
                  <a:pt x="1231" y="715"/>
                </a:cubicBezTo>
                <a:cubicBezTo>
                  <a:pt x="1238" y="722"/>
                  <a:pt x="1243" y="730"/>
                  <a:pt x="1247" y="739"/>
                </a:cubicBezTo>
                <a:cubicBezTo>
                  <a:pt x="1251" y="749"/>
                  <a:pt x="1253" y="760"/>
                  <a:pt x="1254" y="774"/>
                </a:cubicBezTo>
                <a:cubicBezTo>
                  <a:pt x="1255" y="787"/>
                  <a:pt x="1254" y="808"/>
                  <a:pt x="1252" y="835"/>
                </a:cubicBezTo>
                <a:cubicBezTo>
                  <a:pt x="1250" y="858"/>
                  <a:pt x="1249" y="873"/>
                  <a:pt x="1249" y="880"/>
                </a:cubicBezTo>
                <a:cubicBezTo>
                  <a:pt x="1249" y="887"/>
                  <a:pt x="1250" y="894"/>
                  <a:pt x="1252" y="900"/>
                </a:cubicBezTo>
                <a:lnTo>
                  <a:pt x="1334" y="817"/>
                </a:lnTo>
                <a:close/>
                <a:moveTo>
                  <a:pt x="1358" y="579"/>
                </a:moveTo>
                <a:lnTo>
                  <a:pt x="1340" y="601"/>
                </a:lnTo>
                <a:cubicBezTo>
                  <a:pt x="1330" y="595"/>
                  <a:pt x="1321" y="591"/>
                  <a:pt x="1314" y="591"/>
                </a:cubicBezTo>
                <a:cubicBezTo>
                  <a:pt x="1303" y="591"/>
                  <a:pt x="1293" y="595"/>
                  <a:pt x="1285" y="603"/>
                </a:cubicBezTo>
                <a:cubicBezTo>
                  <a:pt x="1278" y="609"/>
                  <a:pt x="1274" y="617"/>
                  <a:pt x="1273" y="626"/>
                </a:cubicBezTo>
                <a:cubicBezTo>
                  <a:pt x="1271" y="637"/>
                  <a:pt x="1273" y="649"/>
                  <a:pt x="1278" y="662"/>
                </a:cubicBezTo>
                <a:cubicBezTo>
                  <a:pt x="1284" y="675"/>
                  <a:pt x="1295" y="689"/>
                  <a:pt x="1311" y="706"/>
                </a:cubicBezTo>
                <a:cubicBezTo>
                  <a:pt x="1309" y="694"/>
                  <a:pt x="1309" y="682"/>
                  <a:pt x="1313" y="671"/>
                </a:cubicBezTo>
                <a:cubicBezTo>
                  <a:pt x="1316" y="660"/>
                  <a:pt x="1322" y="651"/>
                  <a:pt x="1330" y="643"/>
                </a:cubicBezTo>
                <a:cubicBezTo>
                  <a:pt x="1343" y="630"/>
                  <a:pt x="1360" y="623"/>
                  <a:pt x="1380" y="623"/>
                </a:cubicBezTo>
                <a:cubicBezTo>
                  <a:pt x="1400" y="624"/>
                  <a:pt x="1418" y="632"/>
                  <a:pt x="1434" y="648"/>
                </a:cubicBezTo>
                <a:cubicBezTo>
                  <a:pt x="1444" y="659"/>
                  <a:pt x="1452" y="671"/>
                  <a:pt x="1456" y="684"/>
                </a:cubicBezTo>
                <a:cubicBezTo>
                  <a:pt x="1461" y="698"/>
                  <a:pt x="1462" y="711"/>
                  <a:pt x="1458" y="724"/>
                </a:cubicBezTo>
                <a:cubicBezTo>
                  <a:pt x="1455" y="737"/>
                  <a:pt x="1449" y="748"/>
                  <a:pt x="1439" y="758"/>
                </a:cubicBezTo>
                <a:cubicBezTo>
                  <a:pt x="1421" y="775"/>
                  <a:pt x="1401" y="783"/>
                  <a:pt x="1378" y="781"/>
                </a:cubicBezTo>
                <a:cubicBezTo>
                  <a:pt x="1354" y="779"/>
                  <a:pt x="1328" y="764"/>
                  <a:pt x="1299" y="735"/>
                </a:cubicBezTo>
                <a:cubicBezTo>
                  <a:pt x="1266" y="702"/>
                  <a:pt x="1249" y="673"/>
                  <a:pt x="1246" y="646"/>
                </a:cubicBezTo>
                <a:cubicBezTo>
                  <a:pt x="1244" y="623"/>
                  <a:pt x="1251" y="602"/>
                  <a:pt x="1269" y="585"/>
                </a:cubicBezTo>
                <a:cubicBezTo>
                  <a:pt x="1282" y="571"/>
                  <a:pt x="1297" y="564"/>
                  <a:pt x="1313" y="563"/>
                </a:cubicBezTo>
                <a:cubicBezTo>
                  <a:pt x="1328" y="562"/>
                  <a:pt x="1344" y="567"/>
                  <a:pt x="1358" y="579"/>
                </a:cubicBezTo>
                <a:close/>
                <a:moveTo>
                  <a:pt x="1347" y="735"/>
                </a:moveTo>
                <a:cubicBezTo>
                  <a:pt x="1354" y="743"/>
                  <a:pt x="1362" y="748"/>
                  <a:pt x="1372" y="751"/>
                </a:cubicBezTo>
                <a:cubicBezTo>
                  <a:pt x="1381" y="755"/>
                  <a:pt x="1390" y="755"/>
                  <a:pt x="1399" y="753"/>
                </a:cubicBezTo>
                <a:cubicBezTo>
                  <a:pt x="1408" y="751"/>
                  <a:pt x="1415" y="747"/>
                  <a:pt x="1421" y="741"/>
                </a:cubicBezTo>
                <a:cubicBezTo>
                  <a:pt x="1430" y="733"/>
                  <a:pt x="1434" y="722"/>
                  <a:pt x="1433" y="708"/>
                </a:cubicBezTo>
                <a:cubicBezTo>
                  <a:pt x="1432" y="695"/>
                  <a:pt x="1426" y="683"/>
                  <a:pt x="1414" y="670"/>
                </a:cubicBezTo>
                <a:cubicBezTo>
                  <a:pt x="1402" y="659"/>
                  <a:pt x="1390" y="653"/>
                  <a:pt x="1377" y="652"/>
                </a:cubicBezTo>
                <a:cubicBezTo>
                  <a:pt x="1364" y="652"/>
                  <a:pt x="1353" y="656"/>
                  <a:pt x="1344" y="666"/>
                </a:cubicBezTo>
                <a:cubicBezTo>
                  <a:pt x="1334" y="675"/>
                  <a:pt x="1330" y="686"/>
                  <a:pt x="1330" y="699"/>
                </a:cubicBezTo>
                <a:cubicBezTo>
                  <a:pt x="1330" y="713"/>
                  <a:pt x="1336" y="725"/>
                  <a:pt x="1347" y="735"/>
                </a:cubicBezTo>
                <a:close/>
                <a:moveTo>
                  <a:pt x="1435" y="467"/>
                </a:moveTo>
                <a:lnTo>
                  <a:pt x="1411" y="444"/>
                </a:lnTo>
                <a:lnTo>
                  <a:pt x="1432" y="423"/>
                </a:lnTo>
                <a:lnTo>
                  <a:pt x="1456" y="447"/>
                </a:lnTo>
                <a:lnTo>
                  <a:pt x="1435" y="467"/>
                </a:lnTo>
                <a:close/>
                <a:moveTo>
                  <a:pt x="1579" y="612"/>
                </a:moveTo>
                <a:lnTo>
                  <a:pt x="1458" y="490"/>
                </a:lnTo>
                <a:lnTo>
                  <a:pt x="1478" y="469"/>
                </a:lnTo>
                <a:lnTo>
                  <a:pt x="1600" y="591"/>
                </a:lnTo>
                <a:lnTo>
                  <a:pt x="1579" y="612"/>
                </a:lnTo>
                <a:close/>
                <a:moveTo>
                  <a:pt x="1636" y="555"/>
                </a:moveTo>
                <a:lnTo>
                  <a:pt x="1468" y="387"/>
                </a:lnTo>
                <a:lnTo>
                  <a:pt x="1531" y="324"/>
                </a:lnTo>
                <a:cubicBezTo>
                  <a:pt x="1542" y="313"/>
                  <a:pt x="1551" y="305"/>
                  <a:pt x="1558" y="300"/>
                </a:cubicBezTo>
                <a:cubicBezTo>
                  <a:pt x="1568" y="293"/>
                  <a:pt x="1577" y="289"/>
                  <a:pt x="1587" y="287"/>
                </a:cubicBezTo>
                <a:cubicBezTo>
                  <a:pt x="1596" y="285"/>
                  <a:pt x="1606" y="286"/>
                  <a:pt x="1616" y="290"/>
                </a:cubicBezTo>
                <a:cubicBezTo>
                  <a:pt x="1627" y="293"/>
                  <a:pt x="1636" y="299"/>
                  <a:pt x="1644" y="308"/>
                </a:cubicBezTo>
                <a:cubicBezTo>
                  <a:pt x="1659" y="322"/>
                  <a:pt x="1666" y="339"/>
                  <a:pt x="1667" y="358"/>
                </a:cubicBezTo>
                <a:cubicBezTo>
                  <a:pt x="1668" y="377"/>
                  <a:pt x="1656" y="398"/>
                  <a:pt x="1633" y="422"/>
                </a:cubicBezTo>
                <a:lnTo>
                  <a:pt x="1589" y="465"/>
                </a:lnTo>
                <a:lnTo>
                  <a:pt x="1658" y="533"/>
                </a:lnTo>
                <a:lnTo>
                  <a:pt x="1636" y="555"/>
                </a:lnTo>
                <a:close/>
                <a:moveTo>
                  <a:pt x="1570" y="445"/>
                </a:moveTo>
                <a:lnTo>
                  <a:pt x="1613" y="402"/>
                </a:lnTo>
                <a:cubicBezTo>
                  <a:pt x="1627" y="387"/>
                  <a:pt x="1635" y="374"/>
                  <a:pt x="1636" y="363"/>
                </a:cubicBezTo>
                <a:cubicBezTo>
                  <a:pt x="1636" y="352"/>
                  <a:pt x="1632" y="341"/>
                  <a:pt x="1622" y="331"/>
                </a:cubicBezTo>
                <a:cubicBezTo>
                  <a:pt x="1615" y="324"/>
                  <a:pt x="1607" y="320"/>
                  <a:pt x="1599" y="319"/>
                </a:cubicBezTo>
                <a:cubicBezTo>
                  <a:pt x="1590" y="317"/>
                  <a:pt x="1582" y="319"/>
                  <a:pt x="1575" y="323"/>
                </a:cubicBezTo>
                <a:cubicBezTo>
                  <a:pt x="1570" y="325"/>
                  <a:pt x="1563" y="332"/>
                  <a:pt x="1553" y="342"/>
                </a:cubicBezTo>
                <a:lnTo>
                  <a:pt x="1510" y="385"/>
                </a:lnTo>
                <a:lnTo>
                  <a:pt x="1570" y="445"/>
                </a:lnTo>
                <a:close/>
                <a:moveTo>
                  <a:pt x="1730" y="353"/>
                </a:moveTo>
                <a:lnTo>
                  <a:pt x="1749" y="331"/>
                </a:lnTo>
                <a:cubicBezTo>
                  <a:pt x="1758" y="338"/>
                  <a:pt x="1767" y="343"/>
                  <a:pt x="1776" y="344"/>
                </a:cubicBezTo>
                <a:cubicBezTo>
                  <a:pt x="1785" y="346"/>
                  <a:pt x="1795" y="345"/>
                  <a:pt x="1806" y="341"/>
                </a:cubicBezTo>
                <a:cubicBezTo>
                  <a:pt x="1817" y="336"/>
                  <a:pt x="1828" y="329"/>
                  <a:pt x="1837" y="320"/>
                </a:cubicBezTo>
                <a:cubicBezTo>
                  <a:pt x="1846" y="311"/>
                  <a:pt x="1852" y="302"/>
                  <a:pt x="1856" y="293"/>
                </a:cubicBezTo>
                <a:cubicBezTo>
                  <a:pt x="1860" y="284"/>
                  <a:pt x="1861" y="276"/>
                  <a:pt x="1860" y="269"/>
                </a:cubicBezTo>
                <a:cubicBezTo>
                  <a:pt x="1859" y="261"/>
                  <a:pt x="1855" y="255"/>
                  <a:pt x="1850" y="249"/>
                </a:cubicBezTo>
                <a:cubicBezTo>
                  <a:pt x="1845" y="244"/>
                  <a:pt x="1839" y="241"/>
                  <a:pt x="1832" y="240"/>
                </a:cubicBezTo>
                <a:cubicBezTo>
                  <a:pt x="1825" y="239"/>
                  <a:pt x="1817" y="241"/>
                  <a:pt x="1807" y="245"/>
                </a:cubicBezTo>
                <a:cubicBezTo>
                  <a:pt x="1801" y="248"/>
                  <a:pt x="1788" y="255"/>
                  <a:pt x="1769" y="267"/>
                </a:cubicBezTo>
                <a:cubicBezTo>
                  <a:pt x="1750" y="279"/>
                  <a:pt x="1735" y="286"/>
                  <a:pt x="1726" y="289"/>
                </a:cubicBezTo>
                <a:cubicBezTo>
                  <a:pt x="1714" y="293"/>
                  <a:pt x="1702" y="294"/>
                  <a:pt x="1692" y="291"/>
                </a:cubicBezTo>
                <a:cubicBezTo>
                  <a:pt x="1682" y="289"/>
                  <a:pt x="1673" y="284"/>
                  <a:pt x="1665" y="276"/>
                </a:cubicBezTo>
                <a:cubicBezTo>
                  <a:pt x="1657" y="268"/>
                  <a:pt x="1651" y="258"/>
                  <a:pt x="1649" y="245"/>
                </a:cubicBezTo>
                <a:cubicBezTo>
                  <a:pt x="1646" y="233"/>
                  <a:pt x="1648" y="221"/>
                  <a:pt x="1653" y="208"/>
                </a:cubicBezTo>
                <a:cubicBezTo>
                  <a:pt x="1659" y="194"/>
                  <a:pt x="1667" y="182"/>
                  <a:pt x="1678" y="171"/>
                </a:cubicBezTo>
                <a:cubicBezTo>
                  <a:pt x="1691" y="158"/>
                  <a:pt x="1704" y="149"/>
                  <a:pt x="1717" y="144"/>
                </a:cubicBezTo>
                <a:cubicBezTo>
                  <a:pt x="1731" y="138"/>
                  <a:pt x="1744" y="137"/>
                  <a:pt x="1757" y="140"/>
                </a:cubicBezTo>
                <a:cubicBezTo>
                  <a:pt x="1770" y="142"/>
                  <a:pt x="1781" y="149"/>
                  <a:pt x="1792" y="158"/>
                </a:cubicBezTo>
                <a:lnTo>
                  <a:pt x="1772" y="181"/>
                </a:lnTo>
                <a:cubicBezTo>
                  <a:pt x="1760" y="171"/>
                  <a:pt x="1748" y="167"/>
                  <a:pt x="1736" y="168"/>
                </a:cubicBezTo>
                <a:cubicBezTo>
                  <a:pt x="1724" y="170"/>
                  <a:pt x="1712" y="177"/>
                  <a:pt x="1699" y="190"/>
                </a:cubicBezTo>
                <a:cubicBezTo>
                  <a:pt x="1685" y="203"/>
                  <a:pt x="1678" y="215"/>
                  <a:pt x="1677" y="226"/>
                </a:cubicBezTo>
                <a:cubicBezTo>
                  <a:pt x="1675" y="237"/>
                  <a:pt x="1678" y="247"/>
                  <a:pt x="1685" y="253"/>
                </a:cubicBezTo>
                <a:cubicBezTo>
                  <a:pt x="1691" y="260"/>
                  <a:pt x="1698" y="262"/>
                  <a:pt x="1707" y="262"/>
                </a:cubicBezTo>
                <a:cubicBezTo>
                  <a:pt x="1715" y="261"/>
                  <a:pt x="1730" y="254"/>
                  <a:pt x="1752" y="240"/>
                </a:cubicBezTo>
                <a:cubicBezTo>
                  <a:pt x="1774" y="226"/>
                  <a:pt x="1790" y="217"/>
                  <a:pt x="1800" y="214"/>
                </a:cubicBezTo>
                <a:cubicBezTo>
                  <a:pt x="1814" y="209"/>
                  <a:pt x="1827" y="207"/>
                  <a:pt x="1839" y="209"/>
                </a:cubicBezTo>
                <a:cubicBezTo>
                  <a:pt x="1851" y="212"/>
                  <a:pt x="1861" y="217"/>
                  <a:pt x="1870" y="226"/>
                </a:cubicBezTo>
                <a:cubicBezTo>
                  <a:pt x="1879" y="235"/>
                  <a:pt x="1885" y="246"/>
                  <a:pt x="1887" y="259"/>
                </a:cubicBezTo>
                <a:cubicBezTo>
                  <a:pt x="1890" y="272"/>
                  <a:pt x="1889" y="286"/>
                  <a:pt x="1884" y="300"/>
                </a:cubicBezTo>
                <a:cubicBezTo>
                  <a:pt x="1879" y="314"/>
                  <a:pt x="1870" y="327"/>
                  <a:pt x="1858" y="339"/>
                </a:cubicBezTo>
                <a:cubicBezTo>
                  <a:pt x="1843" y="354"/>
                  <a:pt x="1828" y="364"/>
                  <a:pt x="1813" y="370"/>
                </a:cubicBezTo>
                <a:cubicBezTo>
                  <a:pt x="1798" y="376"/>
                  <a:pt x="1784" y="377"/>
                  <a:pt x="1769" y="374"/>
                </a:cubicBezTo>
                <a:cubicBezTo>
                  <a:pt x="1754" y="371"/>
                  <a:pt x="1741" y="364"/>
                  <a:pt x="1730" y="353"/>
                </a:cubicBezTo>
                <a:close/>
                <a:moveTo>
                  <a:pt x="2030" y="122"/>
                </a:moveTo>
                <a:lnTo>
                  <a:pt x="2050" y="141"/>
                </a:lnTo>
                <a:lnTo>
                  <a:pt x="1938" y="252"/>
                </a:lnTo>
                <a:cubicBezTo>
                  <a:pt x="1933" y="248"/>
                  <a:pt x="1929" y="242"/>
                  <a:pt x="1927" y="236"/>
                </a:cubicBezTo>
                <a:cubicBezTo>
                  <a:pt x="1922" y="225"/>
                  <a:pt x="1919" y="213"/>
                  <a:pt x="1918" y="200"/>
                </a:cubicBezTo>
                <a:cubicBezTo>
                  <a:pt x="1917" y="186"/>
                  <a:pt x="1917" y="169"/>
                  <a:pt x="1919" y="147"/>
                </a:cubicBezTo>
                <a:cubicBezTo>
                  <a:pt x="1923" y="114"/>
                  <a:pt x="1923" y="90"/>
                  <a:pt x="1921" y="75"/>
                </a:cubicBezTo>
                <a:cubicBezTo>
                  <a:pt x="1918" y="60"/>
                  <a:pt x="1913" y="48"/>
                  <a:pt x="1906" y="40"/>
                </a:cubicBezTo>
                <a:cubicBezTo>
                  <a:pt x="1897" y="32"/>
                  <a:pt x="1888" y="28"/>
                  <a:pt x="1876" y="28"/>
                </a:cubicBezTo>
                <a:cubicBezTo>
                  <a:pt x="1865" y="29"/>
                  <a:pt x="1854" y="33"/>
                  <a:pt x="1845" y="43"/>
                </a:cubicBezTo>
                <a:cubicBezTo>
                  <a:pt x="1835" y="53"/>
                  <a:pt x="1830" y="64"/>
                  <a:pt x="1830" y="76"/>
                </a:cubicBezTo>
                <a:cubicBezTo>
                  <a:pt x="1830" y="88"/>
                  <a:pt x="1835" y="99"/>
                  <a:pt x="1846" y="109"/>
                </a:cubicBezTo>
                <a:lnTo>
                  <a:pt x="1822" y="128"/>
                </a:lnTo>
                <a:cubicBezTo>
                  <a:pt x="1808" y="111"/>
                  <a:pt x="1801" y="94"/>
                  <a:pt x="1802" y="76"/>
                </a:cubicBezTo>
                <a:cubicBezTo>
                  <a:pt x="1804" y="58"/>
                  <a:pt x="1812" y="41"/>
                  <a:pt x="1828" y="25"/>
                </a:cubicBezTo>
                <a:cubicBezTo>
                  <a:pt x="1844" y="9"/>
                  <a:pt x="1862" y="1"/>
                  <a:pt x="1880" y="0"/>
                </a:cubicBezTo>
                <a:cubicBezTo>
                  <a:pt x="1898" y="0"/>
                  <a:pt x="1914" y="6"/>
                  <a:pt x="1927" y="20"/>
                </a:cubicBezTo>
                <a:cubicBezTo>
                  <a:pt x="1934" y="26"/>
                  <a:pt x="1939" y="34"/>
                  <a:pt x="1943" y="43"/>
                </a:cubicBezTo>
                <a:cubicBezTo>
                  <a:pt x="1947" y="53"/>
                  <a:pt x="1949" y="64"/>
                  <a:pt x="1950" y="78"/>
                </a:cubicBezTo>
                <a:cubicBezTo>
                  <a:pt x="1951" y="91"/>
                  <a:pt x="1950" y="112"/>
                  <a:pt x="1948" y="139"/>
                </a:cubicBezTo>
                <a:cubicBezTo>
                  <a:pt x="1946" y="162"/>
                  <a:pt x="1945" y="177"/>
                  <a:pt x="1945" y="184"/>
                </a:cubicBezTo>
                <a:cubicBezTo>
                  <a:pt x="1945" y="191"/>
                  <a:pt x="1946" y="198"/>
                  <a:pt x="1947" y="204"/>
                </a:cubicBezTo>
                <a:lnTo>
                  <a:pt x="2030" y="122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0" name="Rectangle 86"/>
          <p:cNvSpPr>
            <a:spLocks noChangeArrowheads="1"/>
          </p:cNvSpPr>
          <p:nvPr/>
        </p:nvSpPr>
        <p:spPr bwMode="auto">
          <a:xfrm rot="16200000">
            <a:off x="-1370324" y="2485408"/>
            <a:ext cx="4178565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400" dirty="0">
                <a:solidFill>
                  <a:srgbClr val="000000"/>
                </a:solidFill>
              </a:rPr>
              <a:t>%</a:t>
            </a:r>
            <a:r>
              <a: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 of </a:t>
            </a:r>
            <a:r>
              <a:rPr kumimoji="0" lang="en-US" altLang="en-US" sz="14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</a:rPr>
              <a:t>embryoid</a:t>
            </a:r>
            <a:r>
              <a:rPr kumimoji="0" lang="en-US" altLang="en-US" sz="1400" b="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 bodies (</a:t>
            </a:r>
            <a:r>
              <a: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EBs) forming neural rosettes</a:t>
            </a:r>
            <a:endParaRPr kumimoji="0" lang="en-US" alt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084" name="TextBox 1083"/>
          <p:cNvSpPr txBox="1"/>
          <p:nvPr/>
        </p:nvSpPr>
        <p:spPr>
          <a:xfrm>
            <a:off x="923739" y="5990244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Box 92"/>
          <p:cNvSpPr txBox="1"/>
          <p:nvPr/>
        </p:nvSpPr>
        <p:spPr>
          <a:xfrm>
            <a:off x="1197442" y="5990244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Box 93"/>
          <p:cNvSpPr txBox="1"/>
          <p:nvPr/>
        </p:nvSpPr>
        <p:spPr>
          <a:xfrm>
            <a:off x="1471145" y="5990244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Box 94"/>
          <p:cNvSpPr txBox="1"/>
          <p:nvPr/>
        </p:nvSpPr>
        <p:spPr>
          <a:xfrm>
            <a:off x="1744848" y="5990244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Box 95"/>
          <p:cNvSpPr txBox="1"/>
          <p:nvPr/>
        </p:nvSpPr>
        <p:spPr>
          <a:xfrm>
            <a:off x="1962565" y="5990244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Box 96"/>
          <p:cNvSpPr txBox="1"/>
          <p:nvPr/>
        </p:nvSpPr>
        <p:spPr>
          <a:xfrm>
            <a:off x="2292254" y="5990244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Box 97"/>
          <p:cNvSpPr txBox="1"/>
          <p:nvPr/>
        </p:nvSpPr>
        <p:spPr>
          <a:xfrm>
            <a:off x="2625085" y="5990244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xtBox 98"/>
          <p:cNvSpPr txBox="1"/>
          <p:nvPr/>
        </p:nvSpPr>
        <p:spPr>
          <a:xfrm>
            <a:off x="2898788" y="5990244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TextBox 99"/>
          <p:cNvSpPr txBox="1"/>
          <p:nvPr/>
        </p:nvSpPr>
        <p:spPr>
          <a:xfrm>
            <a:off x="3125836" y="5990244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TextBox 100"/>
          <p:cNvSpPr txBox="1"/>
          <p:nvPr/>
        </p:nvSpPr>
        <p:spPr>
          <a:xfrm>
            <a:off x="3446194" y="5990244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Box 101"/>
          <p:cNvSpPr txBox="1"/>
          <p:nvPr/>
        </p:nvSpPr>
        <p:spPr>
          <a:xfrm>
            <a:off x="3906517" y="5990244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Box 102"/>
          <p:cNvSpPr txBox="1"/>
          <p:nvPr/>
        </p:nvSpPr>
        <p:spPr>
          <a:xfrm>
            <a:off x="4180220" y="5990244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xtBox 103"/>
          <p:cNvSpPr txBox="1"/>
          <p:nvPr/>
        </p:nvSpPr>
        <p:spPr>
          <a:xfrm>
            <a:off x="4385502" y="5990244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Box 104"/>
          <p:cNvSpPr txBox="1"/>
          <p:nvPr/>
        </p:nvSpPr>
        <p:spPr>
          <a:xfrm>
            <a:off x="4733853" y="5990244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TextBox 105"/>
          <p:cNvSpPr txBox="1"/>
          <p:nvPr/>
        </p:nvSpPr>
        <p:spPr>
          <a:xfrm>
            <a:off x="4939135" y="5990244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TextBox 106"/>
          <p:cNvSpPr txBox="1"/>
          <p:nvPr/>
        </p:nvSpPr>
        <p:spPr>
          <a:xfrm>
            <a:off x="5268824" y="5990244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TextBox 107"/>
          <p:cNvSpPr txBox="1"/>
          <p:nvPr/>
        </p:nvSpPr>
        <p:spPr>
          <a:xfrm>
            <a:off x="5530092" y="5990244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TextBox 109"/>
          <p:cNvSpPr txBox="1"/>
          <p:nvPr/>
        </p:nvSpPr>
        <p:spPr>
          <a:xfrm>
            <a:off x="6214359" y="5990244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TextBox 110"/>
          <p:cNvSpPr txBox="1"/>
          <p:nvPr/>
        </p:nvSpPr>
        <p:spPr>
          <a:xfrm>
            <a:off x="6739999" y="5990244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TextBox 111"/>
          <p:cNvSpPr txBox="1"/>
          <p:nvPr/>
        </p:nvSpPr>
        <p:spPr>
          <a:xfrm>
            <a:off x="7019929" y="5990244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TextBox 112"/>
          <p:cNvSpPr txBox="1"/>
          <p:nvPr/>
        </p:nvSpPr>
        <p:spPr>
          <a:xfrm>
            <a:off x="7293632" y="5990244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TextBox 113"/>
          <p:cNvSpPr txBox="1"/>
          <p:nvPr/>
        </p:nvSpPr>
        <p:spPr>
          <a:xfrm>
            <a:off x="7825499" y="5990244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TextBox 114"/>
          <p:cNvSpPr txBox="1"/>
          <p:nvPr/>
        </p:nvSpPr>
        <p:spPr>
          <a:xfrm>
            <a:off x="8099202" y="5990244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TextBox 119"/>
          <p:cNvSpPr txBox="1"/>
          <p:nvPr/>
        </p:nvSpPr>
        <p:spPr>
          <a:xfrm>
            <a:off x="0" y="5943607"/>
            <a:ext cx="109562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 smtClean="0"/>
              <a:t># of </a:t>
            </a:r>
          </a:p>
          <a:p>
            <a:pPr algn="ctr"/>
            <a:r>
              <a:rPr lang="en-US" sz="1400" dirty="0" smtClean="0"/>
              <a:t>experiments</a:t>
            </a:r>
            <a:endParaRPr lang="en-US" sz="1400" dirty="0"/>
          </a:p>
        </p:txBody>
      </p:sp>
      <p:sp>
        <p:nvSpPr>
          <p:cNvPr id="121" name="TextBox 120"/>
          <p:cNvSpPr txBox="1"/>
          <p:nvPr/>
        </p:nvSpPr>
        <p:spPr>
          <a:xfrm>
            <a:off x="-4326" y="5097634"/>
            <a:ext cx="114159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 err="1" smtClean="0"/>
              <a:t>iPSC</a:t>
            </a:r>
            <a:r>
              <a:rPr lang="en-US" sz="1400" dirty="0" smtClean="0"/>
              <a:t> identity </a:t>
            </a:r>
          </a:p>
          <a:p>
            <a:pPr algn="ctr"/>
            <a:r>
              <a:rPr lang="en-US" sz="1400" dirty="0" smtClean="0"/>
              <a:t>&amp; colony #</a:t>
            </a:r>
            <a:endParaRPr lang="en-US" sz="1400" dirty="0"/>
          </a:p>
        </p:txBody>
      </p:sp>
      <p:sp>
        <p:nvSpPr>
          <p:cNvPr id="65" name="TextBox 64"/>
          <p:cNvSpPr txBox="1"/>
          <p:nvPr/>
        </p:nvSpPr>
        <p:spPr>
          <a:xfrm>
            <a:off x="-9" y="6484769"/>
            <a:ext cx="7631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dditional File </a:t>
            </a:r>
            <a:r>
              <a:rPr lang="en-US" dirty="0" smtClean="0"/>
              <a:t>10A</a:t>
            </a:r>
            <a:r>
              <a:rPr lang="en-US" dirty="0" smtClean="0"/>
              <a:t>. </a:t>
            </a:r>
            <a:r>
              <a:rPr lang="en-US" dirty="0"/>
              <a:t>Differentiation potential of </a:t>
            </a:r>
            <a:r>
              <a:rPr lang="en-US" dirty="0" err="1" smtClean="0"/>
              <a:t>iPSCs</a:t>
            </a:r>
            <a:r>
              <a:rPr lang="en-US" dirty="0" smtClean="0"/>
              <a:t> </a:t>
            </a:r>
            <a:r>
              <a:rPr lang="en-US" dirty="0"/>
              <a:t>to neural </a:t>
            </a:r>
            <a:r>
              <a:rPr lang="en-US" dirty="0" smtClean="0"/>
              <a:t>rosettes (Part 1).</a:t>
            </a:r>
            <a:endParaRPr lang="en-US" dirty="0"/>
          </a:p>
        </p:txBody>
      </p:sp>
      <p:sp>
        <p:nvSpPr>
          <p:cNvPr id="123" name="Rectangle 122"/>
          <p:cNvSpPr/>
          <p:nvPr/>
        </p:nvSpPr>
        <p:spPr>
          <a:xfrm>
            <a:off x="7265152" y="-710"/>
            <a:ext cx="1878848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200" dirty="0" smtClean="0"/>
              <a:t>Error bars represent one</a:t>
            </a:r>
          </a:p>
          <a:p>
            <a:pPr algn="ctr"/>
            <a:r>
              <a:rPr lang="en-US" sz="1200" dirty="0" smtClean="0"/>
              <a:t>standard error of the mean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39722823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8"/>
          <p:cNvSpPr>
            <a:spLocks noChangeArrowheads="1"/>
          </p:cNvSpPr>
          <p:nvPr/>
        </p:nvSpPr>
        <p:spPr bwMode="auto">
          <a:xfrm>
            <a:off x="1739884" y="3041437"/>
            <a:ext cx="207962" cy="1460500"/>
          </a:xfrm>
          <a:prstGeom prst="rect">
            <a:avLst/>
          </a:prstGeom>
          <a:solidFill>
            <a:schemeClr val="accent5">
              <a:lumMod val="40000"/>
              <a:lumOff val="60000"/>
            </a:schemeClr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8" name="Rectangle 9"/>
          <p:cNvSpPr>
            <a:spLocks noChangeArrowheads="1"/>
          </p:cNvSpPr>
          <p:nvPr/>
        </p:nvSpPr>
        <p:spPr bwMode="auto">
          <a:xfrm>
            <a:off x="1979790" y="3203362"/>
            <a:ext cx="206375" cy="1298575"/>
          </a:xfrm>
          <a:prstGeom prst="rect">
            <a:avLst/>
          </a:prstGeom>
          <a:solidFill>
            <a:schemeClr val="accent5">
              <a:lumMod val="40000"/>
              <a:lumOff val="60000"/>
            </a:schemeClr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9" name="Rectangle 10"/>
          <p:cNvSpPr>
            <a:spLocks noChangeArrowheads="1"/>
          </p:cNvSpPr>
          <p:nvPr/>
        </p:nvSpPr>
        <p:spPr bwMode="auto">
          <a:xfrm>
            <a:off x="2227440" y="2916025"/>
            <a:ext cx="207962" cy="1585912"/>
          </a:xfrm>
          <a:prstGeom prst="rect">
            <a:avLst/>
          </a:prstGeom>
          <a:solidFill>
            <a:schemeClr val="accent5">
              <a:lumMod val="40000"/>
              <a:lumOff val="60000"/>
            </a:schemeClr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" name="Rectangle 11"/>
          <p:cNvSpPr>
            <a:spLocks noChangeArrowheads="1"/>
          </p:cNvSpPr>
          <p:nvPr/>
        </p:nvSpPr>
        <p:spPr bwMode="auto">
          <a:xfrm>
            <a:off x="2478265" y="2987462"/>
            <a:ext cx="204787" cy="1514475"/>
          </a:xfrm>
          <a:prstGeom prst="rect">
            <a:avLst/>
          </a:prstGeom>
          <a:solidFill>
            <a:schemeClr val="accent5">
              <a:lumMod val="40000"/>
              <a:lumOff val="60000"/>
            </a:schemeClr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1" name="Rectangle 12"/>
          <p:cNvSpPr>
            <a:spLocks noChangeArrowheads="1"/>
          </p:cNvSpPr>
          <p:nvPr/>
        </p:nvSpPr>
        <p:spPr bwMode="auto">
          <a:xfrm>
            <a:off x="2725915" y="2230225"/>
            <a:ext cx="206375" cy="2271712"/>
          </a:xfrm>
          <a:prstGeom prst="rect">
            <a:avLst/>
          </a:prstGeom>
          <a:solidFill>
            <a:schemeClr val="accent5">
              <a:lumMod val="40000"/>
              <a:lumOff val="60000"/>
            </a:schemeClr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2" name="Rectangle 13"/>
          <p:cNvSpPr>
            <a:spLocks noChangeArrowheads="1"/>
          </p:cNvSpPr>
          <p:nvPr/>
        </p:nvSpPr>
        <p:spPr bwMode="auto">
          <a:xfrm>
            <a:off x="2975153" y="3203362"/>
            <a:ext cx="204787" cy="1298575"/>
          </a:xfrm>
          <a:prstGeom prst="rect">
            <a:avLst/>
          </a:prstGeom>
          <a:solidFill>
            <a:schemeClr val="accent5">
              <a:lumMod val="40000"/>
              <a:lumOff val="60000"/>
            </a:schemeClr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3" name="Rectangle 14"/>
          <p:cNvSpPr>
            <a:spLocks noChangeArrowheads="1"/>
          </p:cNvSpPr>
          <p:nvPr/>
        </p:nvSpPr>
        <p:spPr bwMode="auto">
          <a:xfrm>
            <a:off x="3472040" y="2392150"/>
            <a:ext cx="206375" cy="2109787"/>
          </a:xfrm>
          <a:prstGeom prst="rect">
            <a:avLst/>
          </a:prstGeom>
          <a:solidFill>
            <a:schemeClr val="accent2">
              <a:lumMod val="40000"/>
              <a:lumOff val="60000"/>
            </a:schemeClr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4" name="Rectangle 15"/>
          <p:cNvSpPr>
            <a:spLocks noChangeArrowheads="1"/>
          </p:cNvSpPr>
          <p:nvPr/>
        </p:nvSpPr>
        <p:spPr bwMode="auto">
          <a:xfrm>
            <a:off x="3719690" y="2662025"/>
            <a:ext cx="207962" cy="1839912"/>
          </a:xfrm>
          <a:prstGeom prst="rect">
            <a:avLst/>
          </a:prstGeom>
          <a:solidFill>
            <a:schemeClr val="accent2">
              <a:lumMod val="40000"/>
              <a:lumOff val="60000"/>
            </a:schemeClr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5" name="Rectangle 16"/>
          <p:cNvSpPr>
            <a:spLocks noChangeArrowheads="1"/>
          </p:cNvSpPr>
          <p:nvPr/>
        </p:nvSpPr>
        <p:spPr bwMode="auto">
          <a:xfrm>
            <a:off x="3968928" y="2554075"/>
            <a:ext cx="206375" cy="1947862"/>
          </a:xfrm>
          <a:prstGeom prst="rect">
            <a:avLst/>
          </a:prstGeom>
          <a:solidFill>
            <a:schemeClr val="accent2">
              <a:lumMod val="40000"/>
              <a:lumOff val="60000"/>
            </a:schemeClr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6" name="Rectangle 17"/>
          <p:cNvSpPr>
            <a:spLocks noChangeArrowheads="1"/>
          </p:cNvSpPr>
          <p:nvPr/>
        </p:nvSpPr>
        <p:spPr bwMode="auto">
          <a:xfrm>
            <a:off x="4216578" y="2554075"/>
            <a:ext cx="207962" cy="1947862"/>
          </a:xfrm>
          <a:prstGeom prst="rect">
            <a:avLst/>
          </a:prstGeom>
          <a:solidFill>
            <a:schemeClr val="accent2">
              <a:lumMod val="40000"/>
              <a:lumOff val="60000"/>
            </a:schemeClr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7" name="Rectangle 18"/>
          <p:cNvSpPr>
            <a:spLocks noChangeArrowheads="1"/>
          </p:cNvSpPr>
          <p:nvPr/>
        </p:nvSpPr>
        <p:spPr bwMode="auto">
          <a:xfrm>
            <a:off x="4713465" y="2554075"/>
            <a:ext cx="207962" cy="1947862"/>
          </a:xfrm>
          <a:prstGeom prst="rect">
            <a:avLst/>
          </a:prstGeom>
          <a:solidFill>
            <a:schemeClr val="accent2">
              <a:lumMod val="40000"/>
              <a:lumOff val="60000"/>
            </a:schemeClr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8" name="Rectangle 19"/>
          <p:cNvSpPr>
            <a:spLocks noChangeArrowheads="1"/>
          </p:cNvSpPr>
          <p:nvPr/>
        </p:nvSpPr>
        <p:spPr bwMode="auto">
          <a:xfrm>
            <a:off x="4962703" y="1823825"/>
            <a:ext cx="206375" cy="2678112"/>
          </a:xfrm>
          <a:prstGeom prst="rect">
            <a:avLst/>
          </a:prstGeom>
          <a:solidFill>
            <a:schemeClr val="accent2">
              <a:lumMod val="40000"/>
              <a:lumOff val="60000"/>
            </a:schemeClr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9" name="Rectangle 20"/>
          <p:cNvSpPr>
            <a:spLocks noChangeArrowheads="1"/>
          </p:cNvSpPr>
          <p:nvPr/>
        </p:nvSpPr>
        <p:spPr bwMode="auto">
          <a:xfrm>
            <a:off x="5210353" y="3852650"/>
            <a:ext cx="207962" cy="649287"/>
          </a:xfrm>
          <a:prstGeom prst="rect">
            <a:avLst/>
          </a:prstGeom>
          <a:solidFill>
            <a:schemeClr val="accent2">
              <a:lumMod val="40000"/>
              <a:lumOff val="60000"/>
            </a:schemeClr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" name="Rectangle 21"/>
          <p:cNvSpPr>
            <a:spLocks noChangeArrowheads="1"/>
          </p:cNvSpPr>
          <p:nvPr/>
        </p:nvSpPr>
        <p:spPr bwMode="auto">
          <a:xfrm>
            <a:off x="5459590" y="1904787"/>
            <a:ext cx="206375" cy="2597150"/>
          </a:xfrm>
          <a:prstGeom prst="rect">
            <a:avLst/>
          </a:prstGeom>
          <a:solidFill>
            <a:schemeClr val="accent2">
              <a:lumMod val="40000"/>
              <a:lumOff val="60000"/>
            </a:schemeClr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1" name="Rectangle 22"/>
          <p:cNvSpPr>
            <a:spLocks noChangeArrowheads="1"/>
          </p:cNvSpPr>
          <p:nvPr/>
        </p:nvSpPr>
        <p:spPr bwMode="auto">
          <a:xfrm>
            <a:off x="5707240" y="3203362"/>
            <a:ext cx="207962" cy="1298575"/>
          </a:xfrm>
          <a:prstGeom prst="rect">
            <a:avLst/>
          </a:prstGeom>
          <a:solidFill>
            <a:schemeClr val="accent2">
              <a:lumMod val="40000"/>
              <a:lumOff val="60000"/>
            </a:schemeClr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2" name="Rectangle 23"/>
          <p:cNvSpPr>
            <a:spLocks noChangeArrowheads="1"/>
          </p:cNvSpPr>
          <p:nvPr/>
        </p:nvSpPr>
        <p:spPr bwMode="auto">
          <a:xfrm>
            <a:off x="5956478" y="2769975"/>
            <a:ext cx="206375" cy="1731962"/>
          </a:xfrm>
          <a:prstGeom prst="rect">
            <a:avLst/>
          </a:prstGeom>
          <a:solidFill>
            <a:schemeClr val="accent2">
              <a:lumMod val="40000"/>
              <a:lumOff val="60000"/>
            </a:schemeClr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3" name="Rectangle 24"/>
          <p:cNvSpPr>
            <a:spLocks noChangeArrowheads="1"/>
          </p:cNvSpPr>
          <p:nvPr/>
        </p:nvSpPr>
        <p:spPr bwMode="auto">
          <a:xfrm>
            <a:off x="6453365" y="3203362"/>
            <a:ext cx="206375" cy="1298575"/>
          </a:xfrm>
          <a:prstGeom prst="rect">
            <a:avLst/>
          </a:prstGeom>
          <a:solidFill>
            <a:schemeClr val="accent2">
              <a:lumMod val="40000"/>
              <a:lumOff val="60000"/>
            </a:schemeClr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4" name="Rectangle 25"/>
          <p:cNvSpPr>
            <a:spLocks noChangeArrowheads="1"/>
          </p:cNvSpPr>
          <p:nvPr/>
        </p:nvSpPr>
        <p:spPr bwMode="auto">
          <a:xfrm>
            <a:off x="6950253" y="3852650"/>
            <a:ext cx="206375" cy="649287"/>
          </a:xfrm>
          <a:prstGeom prst="rect">
            <a:avLst/>
          </a:prstGeom>
          <a:solidFill>
            <a:schemeClr val="accent2">
              <a:lumMod val="40000"/>
              <a:lumOff val="60000"/>
            </a:schemeClr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5" name="Rectangle 26"/>
          <p:cNvSpPr>
            <a:spLocks noChangeArrowheads="1"/>
          </p:cNvSpPr>
          <p:nvPr/>
        </p:nvSpPr>
        <p:spPr bwMode="auto">
          <a:xfrm>
            <a:off x="7199490" y="3528800"/>
            <a:ext cx="206375" cy="973137"/>
          </a:xfrm>
          <a:prstGeom prst="rect">
            <a:avLst/>
          </a:prstGeom>
          <a:solidFill>
            <a:schemeClr val="accent2">
              <a:lumMod val="40000"/>
              <a:lumOff val="60000"/>
            </a:schemeClr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" name="Rectangle 27"/>
          <p:cNvSpPr>
            <a:spLocks noChangeArrowheads="1"/>
          </p:cNvSpPr>
          <p:nvPr/>
        </p:nvSpPr>
        <p:spPr bwMode="auto">
          <a:xfrm>
            <a:off x="7447140" y="1833350"/>
            <a:ext cx="206375" cy="2668587"/>
          </a:xfrm>
          <a:prstGeom prst="rect">
            <a:avLst/>
          </a:prstGeom>
          <a:solidFill>
            <a:schemeClr val="accent2">
              <a:lumMod val="40000"/>
              <a:lumOff val="60000"/>
            </a:schemeClr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" name="Rectangle 28"/>
          <p:cNvSpPr>
            <a:spLocks noChangeArrowheads="1"/>
          </p:cNvSpPr>
          <p:nvPr/>
        </p:nvSpPr>
        <p:spPr bwMode="auto">
          <a:xfrm>
            <a:off x="7944028" y="1255500"/>
            <a:ext cx="207962" cy="3246437"/>
          </a:xfrm>
          <a:prstGeom prst="rect">
            <a:avLst/>
          </a:prstGeom>
          <a:solidFill>
            <a:schemeClr val="accent2">
              <a:lumMod val="40000"/>
              <a:lumOff val="60000"/>
            </a:schemeClr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8" name="Rectangle 29"/>
          <p:cNvSpPr>
            <a:spLocks noChangeArrowheads="1"/>
          </p:cNvSpPr>
          <p:nvPr/>
        </p:nvSpPr>
        <p:spPr bwMode="auto">
          <a:xfrm>
            <a:off x="8193265" y="1126912"/>
            <a:ext cx="206375" cy="3375025"/>
          </a:xfrm>
          <a:prstGeom prst="rect">
            <a:avLst/>
          </a:prstGeom>
          <a:solidFill>
            <a:schemeClr val="accent2">
              <a:lumMod val="40000"/>
              <a:lumOff val="60000"/>
            </a:schemeClr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9" name="Freeform 30"/>
          <p:cNvSpPr>
            <a:spLocks noEditPoints="1"/>
          </p:cNvSpPr>
          <p:nvPr/>
        </p:nvSpPr>
        <p:spPr bwMode="auto">
          <a:xfrm>
            <a:off x="1816084" y="2727112"/>
            <a:ext cx="57150" cy="630237"/>
          </a:xfrm>
          <a:custGeom>
            <a:avLst/>
            <a:gdLst>
              <a:gd name="T0" fmla="*/ 15 w 36"/>
              <a:gd name="T1" fmla="*/ 394 h 397"/>
              <a:gd name="T2" fmla="*/ 15 w 36"/>
              <a:gd name="T3" fmla="*/ 198 h 397"/>
              <a:gd name="T4" fmla="*/ 15 w 36"/>
              <a:gd name="T5" fmla="*/ 3 h 397"/>
              <a:gd name="T6" fmla="*/ 20 w 36"/>
              <a:gd name="T7" fmla="*/ 3 h 397"/>
              <a:gd name="T8" fmla="*/ 20 w 36"/>
              <a:gd name="T9" fmla="*/ 198 h 397"/>
              <a:gd name="T10" fmla="*/ 20 w 36"/>
              <a:gd name="T11" fmla="*/ 394 h 397"/>
              <a:gd name="T12" fmla="*/ 15 w 36"/>
              <a:gd name="T13" fmla="*/ 394 h 397"/>
              <a:gd name="T14" fmla="*/ 0 w 36"/>
              <a:gd name="T15" fmla="*/ 391 h 397"/>
              <a:gd name="T16" fmla="*/ 36 w 36"/>
              <a:gd name="T17" fmla="*/ 391 h 397"/>
              <a:gd name="T18" fmla="*/ 36 w 36"/>
              <a:gd name="T19" fmla="*/ 397 h 397"/>
              <a:gd name="T20" fmla="*/ 0 w 36"/>
              <a:gd name="T21" fmla="*/ 397 h 397"/>
              <a:gd name="T22" fmla="*/ 0 w 36"/>
              <a:gd name="T23" fmla="*/ 391 h 397"/>
              <a:gd name="T24" fmla="*/ 0 w 36"/>
              <a:gd name="T25" fmla="*/ 0 h 397"/>
              <a:gd name="T26" fmla="*/ 36 w 36"/>
              <a:gd name="T27" fmla="*/ 0 h 397"/>
              <a:gd name="T28" fmla="*/ 36 w 36"/>
              <a:gd name="T29" fmla="*/ 5 h 397"/>
              <a:gd name="T30" fmla="*/ 0 w 36"/>
              <a:gd name="T31" fmla="*/ 5 h 397"/>
              <a:gd name="T32" fmla="*/ 0 w 36"/>
              <a:gd name="T33" fmla="*/ 0 h 39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6" h="397">
                <a:moveTo>
                  <a:pt x="15" y="394"/>
                </a:moveTo>
                <a:lnTo>
                  <a:pt x="15" y="198"/>
                </a:lnTo>
                <a:lnTo>
                  <a:pt x="15" y="3"/>
                </a:lnTo>
                <a:lnTo>
                  <a:pt x="20" y="3"/>
                </a:lnTo>
                <a:lnTo>
                  <a:pt x="20" y="198"/>
                </a:lnTo>
                <a:lnTo>
                  <a:pt x="20" y="394"/>
                </a:lnTo>
                <a:lnTo>
                  <a:pt x="15" y="394"/>
                </a:lnTo>
                <a:close/>
                <a:moveTo>
                  <a:pt x="0" y="391"/>
                </a:moveTo>
                <a:lnTo>
                  <a:pt x="36" y="391"/>
                </a:lnTo>
                <a:lnTo>
                  <a:pt x="36" y="397"/>
                </a:lnTo>
                <a:lnTo>
                  <a:pt x="0" y="397"/>
                </a:lnTo>
                <a:lnTo>
                  <a:pt x="0" y="391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36" y="5"/>
                </a:lnTo>
                <a:lnTo>
                  <a:pt x="0" y="5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0" name="Freeform 31"/>
          <p:cNvSpPr>
            <a:spLocks noEditPoints="1"/>
          </p:cNvSpPr>
          <p:nvPr/>
        </p:nvSpPr>
        <p:spPr bwMode="auto">
          <a:xfrm>
            <a:off x="2055990" y="2549312"/>
            <a:ext cx="55562" cy="1308100"/>
          </a:xfrm>
          <a:custGeom>
            <a:avLst/>
            <a:gdLst>
              <a:gd name="T0" fmla="*/ 14 w 35"/>
              <a:gd name="T1" fmla="*/ 821 h 824"/>
              <a:gd name="T2" fmla="*/ 14 w 35"/>
              <a:gd name="T3" fmla="*/ 412 h 824"/>
              <a:gd name="T4" fmla="*/ 14 w 35"/>
              <a:gd name="T5" fmla="*/ 3 h 824"/>
              <a:gd name="T6" fmla="*/ 20 w 35"/>
              <a:gd name="T7" fmla="*/ 3 h 824"/>
              <a:gd name="T8" fmla="*/ 20 w 35"/>
              <a:gd name="T9" fmla="*/ 412 h 824"/>
              <a:gd name="T10" fmla="*/ 20 w 35"/>
              <a:gd name="T11" fmla="*/ 821 h 824"/>
              <a:gd name="T12" fmla="*/ 14 w 35"/>
              <a:gd name="T13" fmla="*/ 821 h 824"/>
              <a:gd name="T14" fmla="*/ 0 w 35"/>
              <a:gd name="T15" fmla="*/ 818 h 824"/>
              <a:gd name="T16" fmla="*/ 35 w 35"/>
              <a:gd name="T17" fmla="*/ 818 h 824"/>
              <a:gd name="T18" fmla="*/ 35 w 35"/>
              <a:gd name="T19" fmla="*/ 824 h 824"/>
              <a:gd name="T20" fmla="*/ 0 w 35"/>
              <a:gd name="T21" fmla="*/ 824 h 824"/>
              <a:gd name="T22" fmla="*/ 0 w 35"/>
              <a:gd name="T23" fmla="*/ 818 h 824"/>
              <a:gd name="T24" fmla="*/ 0 w 35"/>
              <a:gd name="T25" fmla="*/ 0 h 824"/>
              <a:gd name="T26" fmla="*/ 35 w 35"/>
              <a:gd name="T27" fmla="*/ 0 h 824"/>
              <a:gd name="T28" fmla="*/ 35 w 35"/>
              <a:gd name="T29" fmla="*/ 6 h 824"/>
              <a:gd name="T30" fmla="*/ 0 w 35"/>
              <a:gd name="T31" fmla="*/ 6 h 824"/>
              <a:gd name="T32" fmla="*/ 0 w 35"/>
              <a:gd name="T33" fmla="*/ 0 h 82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5" h="824">
                <a:moveTo>
                  <a:pt x="14" y="821"/>
                </a:moveTo>
                <a:lnTo>
                  <a:pt x="14" y="412"/>
                </a:lnTo>
                <a:lnTo>
                  <a:pt x="14" y="3"/>
                </a:lnTo>
                <a:lnTo>
                  <a:pt x="20" y="3"/>
                </a:lnTo>
                <a:lnTo>
                  <a:pt x="20" y="412"/>
                </a:lnTo>
                <a:lnTo>
                  <a:pt x="20" y="821"/>
                </a:lnTo>
                <a:lnTo>
                  <a:pt x="14" y="821"/>
                </a:lnTo>
                <a:close/>
                <a:moveTo>
                  <a:pt x="0" y="818"/>
                </a:moveTo>
                <a:lnTo>
                  <a:pt x="35" y="818"/>
                </a:lnTo>
                <a:lnTo>
                  <a:pt x="35" y="824"/>
                </a:lnTo>
                <a:lnTo>
                  <a:pt x="0" y="824"/>
                </a:lnTo>
                <a:lnTo>
                  <a:pt x="0" y="818"/>
                </a:lnTo>
                <a:close/>
                <a:moveTo>
                  <a:pt x="0" y="0"/>
                </a:moveTo>
                <a:lnTo>
                  <a:pt x="35" y="0"/>
                </a:lnTo>
                <a:lnTo>
                  <a:pt x="35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1" name="Freeform 32"/>
          <p:cNvSpPr>
            <a:spLocks noEditPoints="1"/>
          </p:cNvSpPr>
          <p:nvPr/>
        </p:nvSpPr>
        <p:spPr bwMode="auto">
          <a:xfrm>
            <a:off x="2303640" y="2692187"/>
            <a:ext cx="57150" cy="447675"/>
          </a:xfrm>
          <a:custGeom>
            <a:avLst/>
            <a:gdLst>
              <a:gd name="T0" fmla="*/ 15 w 36"/>
              <a:gd name="T1" fmla="*/ 279 h 282"/>
              <a:gd name="T2" fmla="*/ 15 w 36"/>
              <a:gd name="T3" fmla="*/ 141 h 282"/>
              <a:gd name="T4" fmla="*/ 15 w 36"/>
              <a:gd name="T5" fmla="*/ 2 h 282"/>
              <a:gd name="T6" fmla="*/ 20 w 36"/>
              <a:gd name="T7" fmla="*/ 2 h 282"/>
              <a:gd name="T8" fmla="*/ 20 w 36"/>
              <a:gd name="T9" fmla="*/ 141 h 282"/>
              <a:gd name="T10" fmla="*/ 20 w 36"/>
              <a:gd name="T11" fmla="*/ 279 h 282"/>
              <a:gd name="T12" fmla="*/ 15 w 36"/>
              <a:gd name="T13" fmla="*/ 279 h 282"/>
              <a:gd name="T14" fmla="*/ 0 w 36"/>
              <a:gd name="T15" fmla="*/ 276 h 282"/>
              <a:gd name="T16" fmla="*/ 36 w 36"/>
              <a:gd name="T17" fmla="*/ 276 h 282"/>
              <a:gd name="T18" fmla="*/ 36 w 36"/>
              <a:gd name="T19" fmla="*/ 282 h 282"/>
              <a:gd name="T20" fmla="*/ 0 w 36"/>
              <a:gd name="T21" fmla="*/ 282 h 282"/>
              <a:gd name="T22" fmla="*/ 0 w 36"/>
              <a:gd name="T23" fmla="*/ 276 h 282"/>
              <a:gd name="T24" fmla="*/ 0 w 36"/>
              <a:gd name="T25" fmla="*/ 0 h 282"/>
              <a:gd name="T26" fmla="*/ 36 w 36"/>
              <a:gd name="T27" fmla="*/ 0 h 282"/>
              <a:gd name="T28" fmla="*/ 36 w 36"/>
              <a:gd name="T29" fmla="*/ 5 h 282"/>
              <a:gd name="T30" fmla="*/ 0 w 36"/>
              <a:gd name="T31" fmla="*/ 5 h 282"/>
              <a:gd name="T32" fmla="*/ 0 w 36"/>
              <a:gd name="T33" fmla="*/ 0 h 28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6" h="282">
                <a:moveTo>
                  <a:pt x="15" y="279"/>
                </a:moveTo>
                <a:lnTo>
                  <a:pt x="15" y="141"/>
                </a:lnTo>
                <a:lnTo>
                  <a:pt x="15" y="2"/>
                </a:lnTo>
                <a:lnTo>
                  <a:pt x="20" y="2"/>
                </a:lnTo>
                <a:lnTo>
                  <a:pt x="20" y="141"/>
                </a:lnTo>
                <a:lnTo>
                  <a:pt x="20" y="279"/>
                </a:lnTo>
                <a:lnTo>
                  <a:pt x="15" y="279"/>
                </a:lnTo>
                <a:close/>
                <a:moveTo>
                  <a:pt x="0" y="276"/>
                </a:moveTo>
                <a:lnTo>
                  <a:pt x="36" y="276"/>
                </a:lnTo>
                <a:lnTo>
                  <a:pt x="36" y="282"/>
                </a:lnTo>
                <a:lnTo>
                  <a:pt x="0" y="282"/>
                </a:lnTo>
                <a:lnTo>
                  <a:pt x="0" y="276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36" y="5"/>
                </a:lnTo>
                <a:lnTo>
                  <a:pt x="0" y="5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48" name="Freeform 33"/>
          <p:cNvSpPr>
            <a:spLocks noEditPoints="1"/>
          </p:cNvSpPr>
          <p:nvPr/>
        </p:nvSpPr>
        <p:spPr bwMode="auto">
          <a:xfrm>
            <a:off x="2552878" y="2766800"/>
            <a:ext cx="55562" cy="441325"/>
          </a:xfrm>
          <a:custGeom>
            <a:avLst/>
            <a:gdLst>
              <a:gd name="T0" fmla="*/ 14 w 35"/>
              <a:gd name="T1" fmla="*/ 275 h 278"/>
              <a:gd name="T2" fmla="*/ 14 w 35"/>
              <a:gd name="T3" fmla="*/ 139 h 278"/>
              <a:gd name="T4" fmla="*/ 14 w 35"/>
              <a:gd name="T5" fmla="*/ 2 h 278"/>
              <a:gd name="T6" fmla="*/ 20 w 35"/>
              <a:gd name="T7" fmla="*/ 2 h 278"/>
              <a:gd name="T8" fmla="*/ 20 w 35"/>
              <a:gd name="T9" fmla="*/ 139 h 278"/>
              <a:gd name="T10" fmla="*/ 20 w 35"/>
              <a:gd name="T11" fmla="*/ 275 h 278"/>
              <a:gd name="T12" fmla="*/ 14 w 35"/>
              <a:gd name="T13" fmla="*/ 275 h 278"/>
              <a:gd name="T14" fmla="*/ 0 w 35"/>
              <a:gd name="T15" fmla="*/ 272 h 278"/>
              <a:gd name="T16" fmla="*/ 35 w 35"/>
              <a:gd name="T17" fmla="*/ 272 h 278"/>
              <a:gd name="T18" fmla="*/ 35 w 35"/>
              <a:gd name="T19" fmla="*/ 278 h 278"/>
              <a:gd name="T20" fmla="*/ 0 w 35"/>
              <a:gd name="T21" fmla="*/ 278 h 278"/>
              <a:gd name="T22" fmla="*/ 0 w 35"/>
              <a:gd name="T23" fmla="*/ 272 h 278"/>
              <a:gd name="T24" fmla="*/ 0 w 35"/>
              <a:gd name="T25" fmla="*/ 0 h 278"/>
              <a:gd name="T26" fmla="*/ 35 w 35"/>
              <a:gd name="T27" fmla="*/ 0 h 278"/>
              <a:gd name="T28" fmla="*/ 35 w 35"/>
              <a:gd name="T29" fmla="*/ 5 h 278"/>
              <a:gd name="T30" fmla="*/ 0 w 35"/>
              <a:gd name="T31" fmla="*/ 5 h 278"/>
              <a:gd name="T32" fmla="*/ 0 w 35"/>
              <a:gd name="T33" fmla="*/ 0 h 27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5" h="278">
                <a:moveTo>
                  <a:pt x="14" y="275"/>
                </a:moveTo>
                <a:lnTo>
                  <a:pt x="14" y="139"/>
                </a:lnTo>
                <a:lnTo>
                  <a:pt x="14" y="2"/>
                </a:lnTo>
                <a:lnTo>
                  <a:pt x="20" y="2"/>
                </a:lnTo>
                <a:lnTo>
                  <a:pt x="20" y="139"/>
                </a:lnTo>
                <a:lnTo>
                  <a:pt x="20" y="275"/>
                </a:lnTo>
                <a:lnTo>
                  <a:pt x="14" y="275"/>
                </a:lnTo>
                <a:close/>
                <a:moveTo>
                  <a:pt x="0" y="272"/>
                </a:moveTo>
                <a:lnTo>
                  <a:pt x="35" y="272"/>
                </a:lnTo>
                <a:lnTo>
                  <a:pt x="35" y="278"/>
                </a:lnTo>
                <a:lnTo>
                  <a:pt x="0" y="278"/>
                </a:lnTo>
                <a:lnTo>
                  <a:pt x="0" y="272"/>
                </a:lnTo>
                <a:close/>
                <a:moveTo>
                  <a:pt x="0" y="0"/>
                </a:moveTo>
                <a:lnTo>
                  <a:pt x="35" y="0"/>
                </a:lnTo>
                <a:lnTo>
                  <a:pt x="35" y="5"/>
                </a:lnTo>
                <a:lnTo>
                  <a:pt x="0" y="5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49" name="Freeform 34"/>
          <p:cNvSpPr>
            <a:spLocks noEditPoints="1"/>
          </p:cNvSpPr>
          <p:nvPr/>
        </p:nvSpPr>
        <p:spPr bwMode="auto">
          <a:xfrm>
            <a:off x="2800528" y="1947650"/>
            <a:ext cx="57150" cy="565150"/>
          </a:xfrm>
          <a:custGeom>
            <a:avLst/>
            <a:gdLst>
              <a:gd name="T0" fmla="*/ 16 w 36"/>
              <a:gd name="T1" fmla="*/ 353 h 356"/>
              <a:gd name="T2" fmla="*/ 16 w 36"/>
              <a:gd name="T3" fmla="*/ 178 h 356"/>
              <a:gd name="T4" fmla="*/ 16 w 36"/>
              <a:gd name="T5" fmla="*/ 3 h 356"/>
              <a:gd name="T6" fmla="*/ 21 w 36"/>
              <a:gd name="T7" fmla="*/ 3 h 356"/>
              <a:gd name="T8" fmla="*/ 21 w 36"/>
              <a:gd name="T9" fmla="*/ 178 h 356"/>
              <a:gd name="T10" fmla="*/ 21 w 36"/>
              <a:gd name="T11" fmla="*/ 353 h 356"/>
              <a:gd name="T12" fmla="*/ 16 w 36"/>
              <a:gd name="T13" fmla="*/ 353 h 356"/>
              <a:gd name="T14" fmla="*/ 0 w 36"/>
              <a:gd name="T15" fmla="*/ 350 h 356"/>
              <a:gd name="T16" fmla="*/ 36 w 36"/>
              <a:gd name="T17" fmla="*/ 350 h 356"/>
              <a:gd name="T18" fmla="*/ 36 w 36"/>
              <a:gd name="T19" fmla="*/ 356 h 356"/>
              <a:gd name="T20" fmla="*/ 0 w 36"/>
              <a:gd name="T21" fmla="*/ 356 h 356"/>
              <a:gd name="T22" fmla="*/ 0 w 36"/>
              <a:gd name="T23" fmla="*/ 350 h 356"/>
              <a:gd name="T24" fmla="*/ 0 w 36"/>
              <a:gd name="T25" fmla="*/ 0 h 356"/>
              <a:gd name="T26" fmla="*/ 36 w 36"/>
              <a:gd name="T27" fmla="*/ 0 h 356"/>
              <a:gd name="T28" fmla="*/ 36 w 36"/>
              <a:gd name="T29" fmla="*/ 6 h 356"/>
              <a:gd name="T30" fmla="*/ 0 w 36"/>
              <a:gd name="T31" fmla="*/ 6 h 356"/>
              <a:gd name="T32" fmla="*/ 0 w 36"/>
              <a:gd name="T33" fmla="*/ 0 h 35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6" h="356">
                <a:moveTo>
                  <a:pt x="16" y="353"/>
                </a:moveTo>
                <a:lnTo>
                  <a:pt x="16" y="178"/>
                </a:lnTo>
                <a:lnTo>
                  <a:pt x="16" y="3"/>
                </a:lnTo>
                <a:lnTo>
                  <a:pt x="21" y="3"/>
                </a:lnTo>
                <a:lnTo>
                  <a:pt x="21" y="178"/>
                </a:lnTo>
                <a:lnTo>
                  <a:pt x="21" y="353"/>
                </a:lnTo>
                <a:lnTo>
                  <a:pt x="16" y="353"/>
                </a:lnTo>
                <a:close/>
                <a:moveTo>
                  <a:pt x="0" y="350"/>
                </a:moveTo>
                <a:lnTo>
                  <a:pt x="36" y="350"/>
                </a:lnTo>
                <a:lnTo>
                  <a:pt x="36" y="356"/>
                </a:lnTo>
                <a:lnTo>
                  <a:pt x="0" y="356"/>
                </a:lnTo>
                <a:lnTo>
                  <a:pt x="0" y="350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36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53" name="Rectangle 35"/>
          <p:cNvSpPr>
            <a:spLocks noChangeArrowheads="1"/>
          </p:cNvSpPr>
          <p:nvPr/>
        </p:nvSpPr>
        <p:spPr bwMode="auto">
          <a:xfrm>
            <a:off x="3049765" y="3198600"/>
            <a:ext cx="55562" cy="9525"/>
          </a:xfrm>
          <a:prstGeom prst="rect">
            <a:avLst/>
          </a:pr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54" name="Freeform 36"/>
          <p:cNvSpPr>
            <a:spLocks noEditPoints="1"/>
          </p:cNvSpPr>
          <p:nvPr/>
        </p:nvSpPr>
        <p:spPr bwMode="auto">
          <a:xfrm>
            <a:off x="3546653" y="2077825"/>
            <a:ext cx="55562" cy="630237"/>
          </a:xfrm>
          <a:custGeom>
            <a:avLst/>
            <a:gdLst>
              <a:gd name="T0" fmla="*/ 15 w 35"/>
              <a:gd name="T1" fmla="*/ 394 h 397"/>
              <a:gd name="T2" fmla="*/ 15 w 35"/>
              <a:gd name="T3" fmla="*/ 198 h 397"/>
              <a:gd name="T4" fmla="*/ 15 w 35"/>
              <a:gd name="T5" fmla="*/ 3 h 397"/>
              <a:gd name="T6" fmla="*/ 21 w 35"/>
              <a:gd name="T7" fmla="*/ 3 h 397"/>
              <a:gd name="T8" fmla="*/ 21 w 35"/>
              <a:gd name="T9" fmla="*/ 198 h 397"/>
              <a:gd name="T10" fmla="*/ 21 w 35"/>
              <a:gd name="T11" fmla="*/ 394 h 397"/>
              <a:gd name="T12" fmla="*/ 15 w 35"/>
              <a:gd name="T13" fmla="*/ 394 h 397"/>
              <a:gd name="T14" fmla="*/ 0 w 35"/>
              <a:gd name="T15" fmla="*/ 391 h 397"/>
              <a:gd name="T16" fmla="*/ 35 w 35"/>
              <a:gd name="T17" fmla="*/ 391 h 397"/>
              <a:gd name="T18" fmla="*/ 35 w 35"/>
              <a:gd name="T19" fmla="*/ 397 h 397"/>
              <a:gd name="T20" fmla="*/ 0 w 35"/>
              <a:gd name="T21" fmla="*/ 397 h 397"/>
              <a:gd name="T22" fmla="*/ 0 w 35"/>
              <a:gd name="T23" fmla="*/ 391 h 397"/>
              <a:gd name="T24" fmla="*/ 0 w 35"/>
              <a:gd name="T25" fmla="*/ 0 h 397"/>
              <a:gd name="T26" fmla="*/ 35 w 35"/>
              <a:gd name="T27" fmla="*/ 0 h 397"/>
              <a:gd name="T28" fmla="*/ 35 w 35"/>
              <a:gd name="T29" fmla="*/ 5 h 397"/>
              <a:gd name="T30" fmla="*/ 0 w 35"/>
              <a:gd name="T31" fmla="*/ 5 h 397"/>
              <a:gd name="T32" fmla="*/ 0 w 35"/>
              <a:gd name="T33" fmla="*/ 0 h 39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5" h="397">
                <a:moveTo>
                  <a:pt x="15" y="394"/>
                </a:moveTo>
                <a:lnTo>
                  <a:pt x="15" y="198"/>
                </a:lnTo>
                <a:lnTo>
                  <a:pt x="15" y="3"/>
                </a:lnTo>
                <a:lnTo>
                  <a:pt x="21" y="3"/>
                </a:lnTo>
                <a:lnTo>
                  <a:pt x="21" y="198"/>
                </a:lnTo>
                <a:lnTo>
                  <a:pt x="21" y="394"/>
                </a:lnTo>
                <a:lnTo>
                  <a:pt x="15" y="394"/>
                </a:lnTo>
                <a:close/>
                <a:moveTo>
                  <a:pt x="0" y="391"/>
                </a:moveTo>
                <a:lnTo>
                  <a:pt x="35" y="391"/>
                </a:lnTo>
                <a:lnTo>
                  <a:pt x="35" y="397"/>
                </a:lnTo>
                <a:lnTo>
                  <a:pt x="0" y="397"/>
                </a:lnTo>
                <a:lnTo>
                  <a:pt x="0" y="391"/>
                </a:lnTo>
                <a:close/>
                <a:moveTo>
                  <a:pt x="0" y="0"/>
                </a:moveTo>
                <a:lnTo>
                  <a:pt x="35" y="0"/>
                </a:lnTo>
                <a:lnTo>
                  <a:pt x="35" y="5"/>
                </a:lnTo>
                <a:lnTo>
                  <a:pt x="0" y="5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55" name="Freeform 37"/>
          <p:cNvSpPr>
            <a:spLocks noEditPoints="1"/>
          </p:cNvSpPr>
          <p:nvPr/>
        </p:nvSpPr>
        <p:spPr bwMode="auto">
          <a:xfrm>
            <a:off x="3794303" y="2306425"/>
            <a:ext cx="57150" cy="714375"/>
          </a:xfrm>
          <a:custGeom>
            <a:avLst/>
            <a:gdLst>
              <a:gd name="T0" fmla="*/ 16 w 36"/>
              <a:gd name="T1" fmla="*/ 447 h 450"/>
              <a:gd name="T2" fmla="*/ 16 w 36"/>
              <a:gd name="T3" fmla="*/ 224 h 450"/>
              <a:gd name="T4" fmla="*/ 16 w 36"/>
              <a:gd name="T5" fmla="*/ 3 h 450"/>
              <a:gd name="T6" fmla="*/ 21 w 36"/>
              <a:gd name="T7" fmla="*/ 3 h 450"/>
              <a:gd name="T8" fmla="*/ 21 w 36"/>
              <a:gd name="T9" fmla="*/ 224 h 450"/>
              <a:gd name="T10" fmla="*/ 21 w 36"/>
              <a:gd name="T11" fmla="*/ 447 h 450"/>
              <a:gd name="T12" fmla="*/ 16 w 36"/>
              <a:gd name="T13" fmla="*/ 447 h 450"/>
              <a:gd name="T14" fmla="*/ 0 w 36"/>
              <a:gd name="T15" fmla="*/ 444 h 450"/>
              <a:gd name="T16" fmla="*/ 36 w 36"/>
              <a:gd name="T17" fmla="*/ 444 h 450"/>
              <a:gd name="T18" fmla="*/ 36 w 36"/>
              <a:gd name="T19" fmla="*/ 450 h 450"/>
              <a:gd name="T20" fmla="*/ 0 w 36"/>
              <a:gd name="T21" fmla="*/ 450 h 450"/>
              <a:gd name="T22" fmla="*/ 0 w 36"/>
              <a:gd name="T23" fmla="*/ 444 h 450"/>
              <a:gd name="T24" fmla="*/ 0 w 36"/>
              <a:gd name="T25" fmla="*/ 0 h 450"/>
              <a:gd name="T26" fmla="*/ 36 w 36"/>
              <a:gd name="T27" fmla="*/ 0 h 450"/>
              <a:gd name="T28" fmla="*/ 36 w 36"/>
              <a:gd name="T29" fmla="*/ 5 h 450"/>
              <a:gd name="T30" fmla="*/ 0 w 36"/>
              <a:gd name="T31" fmla="*/ 5 h 450"/>
              <a:gd name="T32" fmla="*/ 0 w 36"/>
              <a:gd name="T33" fmla="*/ 0 h 45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6" h="450">
                <a:moveTo>
                  <a:pt x="16" y="447"/>
                </a:moveTo>
                <a:lnTo>
                  <a:pt x="16" y="224"/>
                </a:lnTo>
                <a:lnTo>
                  <a:pt x="16" y="3"/>
                </a:lnTo>
                <a:lnTo>
                  <a:pt x="21" y="3"/>
                </a:lnTo>
                <a:lnTo>
                  <a:pt x="21" y="224"/>
                </a:lnTo>
                <a:lnTo>
                  <a:pt x="21" y="447"/>
                </a:lnTo>
                <a:lnTo>
                  <a:pt x="16" y="447"/>
                </a:lnTo>
                <a:close/>
                <a:moveTo>
                  <a:pt x="0" y="444"/>
                </a:moveTo>
                <a:lnTo>
                  <a:pt x="36" y="444"/>
                </a:lnTo>
                <a:lnTo>
                  <a:pt x="36" y="450"/>
                </a:lnTo>
                <a:lnTo>
                  <a:pt x="0" y="450"/>
                </a:lnTo>
                <a:lnTo>
                  <a:pt x="0" y="444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36" y="5"/>
                </a:lnTo>
                <a:lnTo>
                  <a:pt x="0" y="5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56" name="Freeform 38"/>
          <p:cNvSpPr>
            <a:spLocks noEditPoints="1"/>
          </p:cNvSpPr>
          <p:nvPr/>
        </p:nvSpPr>
        <p:spPr bwMode="auto">
          <a:xfrm>
            <a:off x="4043540" y="2174662"/>
            <a:ext cx="57150" cy="758825"/>
          </a:xfrm>
          <a:custGeom>
            <a:avLst/>
            <a:gdLst>
              <a:gd name="T0" fmla="*/ 15 w 36"/>
              <a:gd name="T1" fmla="*/ 475 h 478"/>
              <a:gd name="T2" fmla="*/ 15 w 36"/>
              <a:gd name="T3" fmla="*/ 239 h 478"/>
              <a:gd name="T4" fmla="*/ 15 w 36"/>
              <a:gd name="T5" fmla="*/ 3 h 478"/>
              <a:gd name="T6" fmla="*/ 21 w 36"/>
              <a:gd name="T7" fmla="*/ 3 h 478"/>
              <a:gd name="T8" fmla="*/ 21 w 36"/>
              <a:gd name="T9" fmla="*/ 239 h 478"/>
              <a:gd name="T10" fmla="*/ 21 w 36"/>
              <a:gd name="T11" fmla="*/ 475 h 478"/>
              <a:gd name="T12" fmla="*/ 15 w 36"/>
              <a:gd name="T13" fmla="*/ 475 h 478"/>
              <a:gd name="T14" fmla="*/ 0 w 36"/>
              <a:gd name="T15" fmla="*/ 472 h 478"/>
              <a:gd name="T16" fmla="*/ 36 w 36"/>
              <a:gd name="T17" fmla="*/ 472 h 478"/>
              <a:gd name="T18" fmla="*/ 36 w 36"/>
              <a:gd name="T19" fmla="*/ 478 h 478"/>
              <a:gd name="T20" fmla="*/ 0 w 36"/>
              <a:gd name="T21" fmla="*/ 478 h 478"/>
              <a:gd name="T22" fmla="*/ 0 w 36"/>
              <a:gd name="T23" fmla="*/ 472 h 478"/>
              <a:gd name="T24" fmla="*/ 0 w 36"/>
              <a:gd name="T25" fmla="*/ 0 h 478"/>
              <a:gd name="T26" fmla="*/ 36 w 36"/>
              <a:gd name="T27" fmla="*/ 0 h 478"/>
              <a:gd name="T28" fmla="*/ 36 w 36"/>
              <a:gd name="T29" fmla="*/ 6 h 478"/>
              <a:gd name="T30" fmla="*/ 0 w 36"/>
              <a:gd name="T31" fmla="*/ 6 h 478"/>
              <a:gd name="T32" fmla="*/ 0 w 36"/>
              <a:gd name="T33" fmla="*/ 0 h 47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6" h="478">
                <a:moveTo>
                  <a:pt x="15" y="475"/>
                </a:moveTo>
                <a:lnTo>
                  <a:pt x="15" y="239"/>
                </a:lnTo>
                <a:lnTo>
                  <a:pt x="15" y="3"/>
                </a:lnTo>
                <a:lnTo>
                  <a:pt x="21" y="3"/>
                </a:lnTo>
                <a:lnTo>
                  <a:pt x="21" y="239"/>
                </a:lnTo>
                <a:lnTo>
                  <a:pt x="21" y="475"/>
                </a:lnTo>
                <a:lnTo>
                  <a:pt x="15" y="475"/>
                </a:lnTo>
                <a:close/>
                <a:moveTo>
                  <a:pt x="0" y="472"/>
                </a:moveTo>
                <a:lnTo>
                  <a:pt x="36" y="472"/>
                </a:lnTo>
                <a:lnTo>
                  <a:pt x="36" y="478"/>
                </a:lnTo>
                <a:lnTo>
                  <a:pt x="0" y="478"/>
                </a:lnTo>
                <a:lnTo>
                  <a:pt x="0" y="472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36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57" name="Freeform 39"/>
          <p:cNvSpPr>
            <a:spLocks noEditPoints="1"/>
          </p:cNvSpPr>
          <p:nvPr/>
        </p:nvSpPr>
        <p:spPr bwMode="auto">
          <a:xfrm>
            <a:off x="4291190" y="2284200"/>
            <a:ext cx="58737" cy="539750"/>
          </a:xfrm>
          <a:custGeom>
            <a:avLst/>
            <a:gdLst>
              <a:gd name="T0" fmla="*/ 16 w 37"/>
              <a:gd name="T1" fmla="*/ 337 h 340"/>
              <a:gd name="T2" fmla="*/ 16 w 37"/>
              <a:gd name="T3" fmla="*/ 170 h 340"/>
              <a:gd name="T4" fmla="*/ 16 w 37"/>
              <a:gd name="T5" fmla="*/ 3 h 340"/>
              <a:gd name="T6" fmla="*/ 21 w 37"/>
              <a:gd name="T7" fmla="*/ 3 h 340"/>
              <a:gd name="T8" fmla="*/ 21 w 37"/>
              <a:gd name="T9" fmla="*/ 170 h 340"/>
              <a:gd name="T10" fmla="*/ 21 w 37"/>
              <a:gd name="T11" fmla="*/ 337 h 340"/>
              <a:gd name="T12" fmla="*/ 16 w 37"/>
              <a:gd name="T13" fmla="*/ 337 h 340"/>
              <a:gd name="T14" fmla="*/ 0 w 37"/>
              <a:gd name="T15" fmla="*/ 334 h 340"/>
              <a:gd name="T16" fmla="*/ 37 w 37"/>
              <a:gd name="T17" fmla="*/ 334 h 340"/>
              <a:gd name="T18" fmla="*/ 37 w 37"/>
              <a:gd name="T19" fmla="*/ 340 h 340"/>
              <a:gd name="T20" fmla="*/ 0 w 37"/>
              <a:gd name="T21" fmla="*/ 340 h 340"/>
              <a:gd name="T22" fmla="*/ 0 w 37"/>
              <a:gd name="T23" fmla="*/ 334 h 340"/>
              <a:gd name="T24" fmla="*/ 0 w 37"/>
              <a:gd name="T25" fmla="*/ 0 h 340"/>
              <a:gd name="T26" fmla="*/ 37 w 37"/>
              <a:gd name="T27" fmla="*/ 0 h 340"/>
              <a:gd name="T28" fmla="*/ 37 w 37"/>
              <a:gd name="T29" fmla="*/ 6 h 340"/>
              <a:gd name="T30" fmla="*/ 0 w 37"/>
              <a:gd name="T31" fmla="*/ 6 h 340"/>
              <a:gd name="T32" fmla="*/ 0 w 37"/>
              <a:gd name="T33" fmla="*/ 0 h 3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7" h="340">
                <a:moveTo>
                  <a:pt x="16" y="337"/>
                </a:moveTo>
                <a:lnTo>
                  <a:pt x="16" y="170"/>
                </a:lnTo>
                <a:lnTo>
                  <a:pt x="16" y="3"/>
                </a:lnTo>
                <a:lnTo>
                  <a:pt x="21" y="3"/>
                </a:lnTo>
                <a:lnTo>
                  <a:pt x="21" y="170"/>
                </a:lnTo>
                <a:lnTo>
                  <a:pt x="21" y="337"/>
                </a:lnTo>
                <a:lnTo>
                  <a:pt x="16" y="337"/>
                </a:lnTo>
                <a:close/>
                <a:moveTo>
                  <a:pt x="0" y="334"/>
                </a:moveTo>
                <a:lnTo>
                  <a:pt x="37" y="334"/>
                </a:lnTo>
                <a:lnTo>
                  <a:pt x="37" y="340"/>
                </a:lnTo>
                <a:lnTo>
                  <a:pt x="0" y="340"/>
                </a:lnTo>
                <a:lnTo>
                  <a:pt x="0" y="334"/>
                </a:lnTo>
                <a:close/>
                <a:moveTo>
                  <a:pt x="0" y="0"/>
                </a:moveTo>
                <a:lnTo>
                  <a:pt x="37" y="0"/>
                </a:lnTo>
                <a:lnTo>
                  <a:pt x="37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58" name="Freeform 40"/>
          <p:cNvSpPr>
            <a:spLocks noEditPoints="1"/>
          </p:cNvSpPr>
          <p:nvPr/>
        </p:nvSpPr>
        <p:spPr bwMode="auto">
          <a:xfrm>
            <a:off x="4788078" y="1969875"/>
            <a:ext cx="58737" cy="1169987"/>
          </a:xfrm>
          <a:custGeom>
            <a:avLst/>
            <a:gdLst>
              <a:gd name="T0" fmla="*/ 16 w 37"/>
              <a:gd name="T1" fmla="*/ 734 h 737"/>
              <a:gd name="T2" fmla="*/ 16 w 37"/>
              <a:gd name="T3" fmla="*/ 368 h 737"/>
              <a:gd name="T4" fmla="*/ 16 w 37"/>
              <a:gd name="T5" fmla="*/ 2 h 737"/>
              <a:gd name="T6" fmla="*/ 21 w 37"/>
              <a:gd name="T7" fmla="*/ 2 h 737"/>
              <a:gd name="T8" fmla="*/ 21 w 37"/>
              <a:gd name="T9" fmla="*/ 368 h 737"/>
              <a:gd name="T10" fmla="*/ 21 w 37"/>
              <a:gd name="T11" fmla="*/ 734 h 737"/>
              <a:gd name="T12" fmla="*/ 16 w 37"/>
              <a:gd name="T13" fmla="*/ 734 h 737"/>
              <a:gd name="T14" fmla="*/ 0 w 37"/>
              <a:gd name="T15" fmla="*/ 731 h 737"/>
              <a:gd name="T16" fmla="*/ 37 w 37"/>
              <a:gd name="T17" fmla="*/ 731 h 737"/>
              <a:gd name="T18" fmla="*/ 37 w 37"/>
              <a:gd name="T19" fmla="*/ 737 h 737"/>
              <a:gd name="T20" fmla="*/ 0 w 37"/>
              <a:gd name="T21" fmla="*/ 737 h 737"/>
              <a:gd name="T22" fmla="*/ 0 w 37"/>
              <a:gd name="T23" fmla="*/ 731 h 737"/>
              <a:gd name="T24" fmla="*/ 0 w 37"/>
              <a:gd name="T25" fmla="*/ 0 h 737"/>
              <a:gd name="T26" fmla="*/ 37 w 37"/>
              <a:gd name="T27" fmla="*/ 0 h 737"/>
              <a:gd name="T28" fmla="*/ 37 w 37"/>
              <a:gd name="T29" fmla="*/ 5 h 737"/>
              <a:gd name="T30" fmla="*/ 0 w 37"/>
              <a:gd name="T31" fmla="*/ 5 h 737"/>
              <a:gd name="T32" fmla="*/ 0 w 37"/>
              <a:gd name="T33" fmla="*/ 0 h 73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7" h="737">
                <a:moveTo>
                  <a:pt x="16" y="734"/>
                </a:moveTo>
                <a:lnTo>
                  <a:pt x="16" y="368"/>
                </a:lnTo>
                <a:lnTo>
                  <a:pt x="16" y="2"/>
                </a:lnTo>
                <a:lnTo>
                  <a:pt x="21" y="2"/>
                </a:lnTo>
                <a:lnTo>
                  <a:pt x="21" y="368"/>
                </a:lnTo>
                <a:lnTo>
                  <a:pt x="21" y="734"/>
                </a:lnTo>
                <a:lnTo>
                  <a:pt x="16" y="734"/>
                </a:lnTo>
                <a:close/>
                <a:moveTo>
                  <a:pt x="0" y="731"/>
                </a:moveTo>
                <a:lnTo>
                  <a:pt x="37" y="731"/>
                </a:lnTo>
                <a:lnTo>
                  <a:pt x="37" y="737"/>
                </a:lnTo>
                <a:lnTo>
                  <a:pt x="0" y="737"/>
                </a:lnTo>
                <a:lnTo>
                  <a:pt x="0" y="731"/>
                </a:lnTo>
                <a:close/>
                <a:moveTo>
                  <a:pt x="0" y="0"/>
                </a:moveTo>
                <a:lnTo>
                  <a:pt x="37" y="0"/>
                </a:lnTo>
                <a:lnTo>
                  <a:pt x="37" y="5"/>
                </a:lnTo>
                <a:lnTo>
                  <a:pt x="0" y="5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59" name="Freeform 41"/>
          <p:cNvSpPr>
            <a:spLocks noEditPoints="1"/>
          </p:cNvSpPr>
          <p:nvPr/>
        </p:nvSpPr>
        <p:spPr bwMode="auto">
          <a:xfrm>
            <a:off x="5037315" y="1628562"/>
            <a:ext cx="57150" cy="392112"/>
          </a:xfrm>
          <a:custGeom>
            <a:avLst/>
            <a:gdLst>
              <a:gd name="T0" fmla="*/ 15 w 36"/>
              <a:gd name="T1" fmla="*/ 244 h 247"/>
              <a:gd name="T2" fmla="*/ 15 w 36"/>
              <a:gd name="T3" fmla="*/ 123 h 247"/>
              <a:gd name="T4" fmla="*/ 15 w 36"/>
              <a:gd name="T5" fmla="*/ 2 h 247"/>
              <a:gd name="T6" fmla="*/ 21 w 36"/>
              <a:gd name="T7" fmla="*/ 2 h 247"/>
              <a:gd name="T8" fmla="*/ 21 w 36"/>
              <a:gd name="T9" fmla="*/ 123 h 247"/>
              <a:gd name="T10" fmla="*/ 21 w 36"/>
              <a:gd name="T11" fmla="*/ 244 h 247"/>
              <a:gd name="T12" fmla="*/ 15 w 36"/>
              <a:gd name="T13" fmla="*/ 244 h 247"/>
              <a:gd name="T14" fmla="*/ 0 w 36"/>
              <a:gd name="T15" fmla="*/ 241 h 247"/>
              <a:gd name="T16" fmla="*/ 36 w 36"/>
              <a:gd name="T17" fmla="*/ 241 h 247"/>
              <a:gd name="T18" fmla="*/ 36 w 36"/>
              <a:gd name="T19" fmla="*/ 247 h 247"/>
              <a:gd name="T20" fmla="*/ 0 w 36"/>
              <a:gd name="T21" fmla="*/ 247 h 247"/>
              <a:gd name="T22" fmla="*/ 0 w 36"/>
              <a:gd name="T23" fmla="*/ 241 h 247"/>
              <a:gd name="T24" fmla="*/ 0 w 36"/>
              <a:gd name="T25" fmla="*/ 0 h 247"/>
              <a:gd name="T26" fmla="*/ 36 w 36"/>
              <a:gd name="T27" fmla="*/ 0 h 247"/>
              <a:gd name="T28" fmla="*/ 36 w 36"/>
              <a:gd name="T29" fmla="*/ 5 h 247"/>
              <a:gd name="T30" fmla="*/ 0 w 36"/>
              <a:gd name="T31" fmla="*/ 5 h 247"/>
              <a:gd name="T32" fmla="*/ 0 w 36"/>
              <a:gd name="T33" fmla="*/ 0 h 24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6" h="247">
                <a:moveTo>
                  <a:pt x="15" y="244"/>
                </a:moveTo>
                <a:lnTo>
                  <a:pt x="15" y="123"/>
                </a:lnTo>
                <a:lnTo>
                  <a:pt x="15" y="2"/>
                </a:lnTo>
                <a:lnTo>
                  <a:pt x="21" y="2"/>
                </a:lnTo>
                <a:lnTo>
                  <a:pt x="21" y="123"/>
                </a:lnTo>
                <a:lnTo>
                  <a:pt x="21" y="244"/>
                </a:lnTo>
                <a:lnTo>
                  <a:pt x="15" y="244"/>
                </a:lnTo>
                <a:close/>
                <a:moveTo>
                  <a:pt x="0" y="241"/>
                </a:moveTo>
                <a:lnTo>
                  <a:pt x="36" y="241"/>
                </a:lnTo>
                <a:lnTo>
                  <a:pt x="36" y="247"/>
                </a:lnTo>
                <a:lnTo>
                  <a:pt x="0" y="247"/>
                </a:lnTo>
                <a:lnTo>
                  <a:pt x="0" y="241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36" y="5"/>
                </a:lnTo>
                <a:lnTo>
                  <a:pt x="0" y="5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60" name="Rectangle 42"/>
          <p:cNvSpPr>
            <a:spLocks noChangeArrowheads="1"/>
          </p:cNvSpPr>
          <p:nvPr/>
        </p:nvSpPr>
        <p:spPr bwMode="auto">
          <a:xfrm>
            <a:off x="5284965" y="3847887"/>
            <a:ext cx="58737" cy="9525"/>
          </a:xfrm>
          <a:prstGeom prst="rect">
            <a:avLst/>
          </a:pr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61" name="Freeform 43"/>
          <p:cNvSpPr>
            <a:spLocks noEditPoints="1"/>
          </p:cNvSpPr>
          <p:nvPr/>
        </p:nvSpPr>
        <p:spPr bwMode="auto">
          <a:xfrm>
            <a:off x="5534203" y="1712700"/>
            <a:ext cx="57150" cy="384175"/>
          </a:xfrm>
          <a:custGeom>
            <a:avLst/>
            <a:gdLst>
              <a:gd name="T0" fmla="*/ 15 w 36"/>
              <a:gd name="T1" fmla="*/ 239 h 242"/>
              <a:gd name="T2" fmla="*/ 15 w 36"/>
              <a:gd name="T3" fmla="*/ 121 h 242"/>
              <a:gd name="T4" fmla="*/ 15 w 36"/>
              <a:gd name="T5" fmla="*/ 3 h 242"/>
              <a:gd name="T6" fmla="*/ 21 w 36"/>
              <a:gd name="T7" fmla="*/ 3 h 242"/>
              <a:gd name="T8" fmla="*/ 21 w 36"/>
              <a:gd name="T9" fmla="*/ 121 h 242"/>
              <a:gd name="T10" fmla="*/ 21 w 36"/>
              <a:gd name="T11" fmla="*/ 239 h 242"/>
              <a:gd name="T12" fmla="*/ 15 w 36"/>
              <a:gd name="T13" fmla="*/ 239 h 242"/>
              <a:gd name="T14" fmla="*/ 0 w 36"/>
              <a:gd name="T15" fmla="*/ 236 h 242"/>
              <a:gd name="T16" fmla="*/ 36 w 36"/>
              <a:gd name="T17" fmla="*/ 236 h 242"/>
              <a:gd name="T18" fmla="*/ 36 w 36"/>
              <a:gd name="T19" fmla="*/ 242 h 242"/>
              <a:gd name="T20" fmla="*/ 0 w 36"/>
              <a:gd name="T21" fmla="*/ 242 h 242"/>
              <a:gd name="T22" fmla="*/ 0 w 36"/>
              <a:gd name="T23" fmla="*/ 236 h 242"/>
              <a:gd name="T24" fmla="*/ 0 w 36"/>
              <a:gd name="T25" fmla="*/ 0 h 242"/>
              <a:gd name="T26" fmla="*/ 36 w 36"/>
              <a:gd name="T27" fmla="*/ 0 h 242"/>
              <a:gd name="T28" fmla="*/ 36 w 36"/>
              <a:gd name="T29" fmla="*/ 6 h 242"/>
              <a:gd name="T30" fmla="*/ 0 w 36"/>
              <a:gd name="T31" fmla="*/ 6 h 242"/>
              <a:gd name="T32" fmla="*/ 0 w 36"/>
              <a:gd name="T33" fmla="*/ 0 h 24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6" h="242">
                <a:moveTo>
                  <a:pt x="15" y="239"/>
                </a:moveTo>
                <a:lnTo>
                  <a:pt x="15" y="121"/>
                </a:lnTo>
                <a:lnTo>
                  <a:pt x="15" y="3"/>
                </a:lnTo>
                <a:lnTo>
                  <a:pt x="21" y="3"/>
                </a:lnTo>
                <a:lnTo>
                  <a:pt x="21" y="121"/>
                </a:lnTo>
                <a:lnTo>
                  <a:pt x="21" y="239"/>
                </a:lnTo>
                <a:lnTo>
                  <a:pt x="15" y="239"/>
                </a:lnTo>
                <a:close/>
                <a:moveTo>
                  <a:pt x="0" y="236"/>
                </a:moveTo>
                <a:lnTo>
                  <a:pt x="36" y="236"/>
                </a:lnTo>
                <a:lnTo>
                  <a:pt x="36" y="242"/>
                </a:lnTo>
                <a:lnTo>
                  <a:pt x="0" y="242"/>
                </a:lnTo>
                <a:lnTo>
                  <a:pt x="0" y="236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36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62" name="Freeform 44"/>
          <p:cNvSpPr>
            <a:spLocks noEditPoints="1"/>
          </p:cNvSpPr>
          <p:nvPr/>
        </p:nvSpPr>
        <p:spPr bwMode="auto">
          <a:xfrm>
            <a:off x="5781853" y="2549312"/>
            <a:ext cx="58737" cy="1308100"/>
          </a:xfrm>
          <a:custGeom>
            <a:avLst/>
            <a:gdLst>
              <a:gd name="T0" fmla="*/ 15 w 37"/>
              <a:gd name="T1" fmla="*/ 821 h 824"/>
              <a:gd name="T2" fmla="*/ 15 w 37"/>
              <a:gd name="T3" fmla="*/ 412 h 824"/>
              <a:gd name="T4" fmla="*/ 15 w 37"/>
              <a:gd name="T5" fmla="*/ 3 h 824"/>
              <a:gd name="T6" fmla="*/ 21 w 37"/>
              <a:gd name="T7" fmla="*/ 3 h 824"/>
              <a:gd name="T8" fmla="*/ 21 w 37"/>
              <a:gd name="T9" fmla="*/ 412 h 824"/>
              <a:gd name="T10" fmla="*/ 21 w 37"/>
              <a:gd name="T11" fmla="*/ 821 h 824"/>
              <a:gd name="T12" fmla="*/ 15 w 37"/>
              <a:gd name="T13" fmla="*/ 821 h 824"/>
              <a:gd name="T14" fmla="*/ 0 w 37"/>
              <a:gd name="T15" fmla="*/ 818 h 824"/>
              <a:gd name="T16" fmla="*/ 37 w 37"/>
              <a:gd name="T17" fmla="*/ 818 h 824"/>
              <a:gd name="T18" fmla="*/ 37 w 37"/>
              <a:gd name="T19" fmla="*/ 824 h 824"/>
              <a:gd name="T20" fmla="*/ 0 w 37"/>
              <a:gd name="T21" fmla="*/ 824 h 824"/>
              <a:gd name="T22" fmla="*/ 0 w 37"/>
              <a:gd name="T23" fmla="*/ 818 h 824"/>
              <a:gd name="T24" fmla="*/ 0 w 37"/>
              <a:gd name="T25" fmla="*/ 0 h 824"/>
              <a:gd name="T26" fmla="*/ 37 w 37"/>
              <a:gd name="T27" fmla="*/ 0 h 824"/>
              <a:gd name="T28" fmla="*/ 37 w 37"/>
              <a:gd name="T29" fmla="*/ 6 h 824"/>
              <a:gd name="T30" fmla="*/ 0 w 37"/>
              <a:gd name="T31" fmla="*/ 6 h 824"/>
              <a:gd name="T32" fmla="*/ 0 w 37"/>
              <a:gd name="T33" fmla="*/ 0 h 82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7" h="824">
                <a:moveTo>
                  <a:pt x="15" y="821"/>
                </a:moveTo>
                <a:lnTo>
                  <a:pt x="15" y="412"/>
                </a:lnTo>
                <a:lnTo>
                  <a:pt x="15" y="3"/>
                </a:lnTo>
                <a:lnTo>
                  <a:pt x="21" y="3"/>
                </a:lnTo>
                <a:lnTo>
                  <a:pt x="21" y="412"/>
                </a:lnTo>
                <a:lnTo>
                  <a:pt x="21" y="821"/>
                </a:lnTo>
                <a:lnTo>
                  <a:pt x="15" y="821"/>
                </a:lnTo>
                <a:close/>
                <a:moveTo>
                  <a:pt x="0" y="818"/>
                </a:moveTo>
                <a:lnTo>
                  <a:pt x="37" y="818"/>
                </a:lnTo>
                <a:lnTo>
                  <a:pt x="37" y="824"/>
                </a:lnTo>
                <a:lnTo>
                  <a:pt x="0" y="824"/>
                </a:lnTo>
                <a:lnTo>
                  <a:pt x="0" y="818"/>
                </a:lnTo>
                <a:close/>
                <a:moveTo>
                  <a:pt x="0" y="0"/>
                </a:moveTo>
                <a:lnTo>
                  <a:pt x="37" y="0"/>
                </a:lnTo>
                <a:lnTo>
                  <a:pt x="37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63" name="Freeform 45"/>
          <p:cNvSpPr>
            <a:spLocks noEditPoints="1"/>
          </p:cNvSpPr>
          <p:nvPr/>
        </p:nvSpPr>
        <p:spPr bwMode="auto">
          <a:xfrm>
            <a:off x="6031090" y="2549312"/>
            <a:ext cx="57150" cy="442912"/>
          </a:xfrm>
          <a:custGeom>
            <a:avLst/>
            <a:gdLst>
              <a:gd name="T0" fmla="*/ 15 w 36"/>
              <a:gd name="T1" fmla="*/ 276 h 279"/>
              <a:gd name="T2" fmla="*/ 15 w 36"/>
              <a:gd name="T3" fmla="*/ 139 h 279"/>
              <a:gd name="T4" fmla="*/ 15 w 36"/>
              <a:gd name="T5" fmla="*/ 3 h 279"/>
              <a:gd name="T6" fmla="*/ 21 w 36"/>
              <a:gd name="T7" fmla="*/ 3 h 279"/>
              <a:gd name="T8" fmla="*/ 21 w 36"/>
              <a:gd name="T9" fmla="*/ 139 h 279"/>
              <a:gd name="T10" fmla="*/ 21 w 36"/>
              <a:gd name="T11" fmla="*/ 276 h 279"/>
              <a:gd name="T12" fmla="*/ 15 w 36"/>
              <a:gd name="T13" fmla="*/ 276 h 279"/>
              <a:gd name="T14" fmla="*/ 0 w 36"/>
              <a:gd name="T15" fmla="*/ 273 h 279"/>
              <a:gd name="T16" fmla="*/ 36 w 36"/>
              <a:gd name="T17" fmla="*/ 273 h 279"/>
              <a:gd name="T18" fmla="*/ 36 w 36"/>
              <a:gd name="T19" fmla="*/ 279 h 279"/>
              <a:gd name="T20" fmla="*/ 0 w 36"/>
              <a:gd name="T21" fmla="*/ 279 h 279"/>
              <a:gd name="T22" fmla="*/ 0 w 36"/>
              <a:gd name="T23" fmla="*/ 273 h 279"/>
              <a:gd name="T24" fmla="*/ 0 w 36"/>
              <a:gd name="T25" fmla="*/ 0 h 279"/>
              <a:gd name="T26" fmla="*/ 36 w 36"/>
              <a:gd name="T27" fmla="*/ 0 h 279"/>
              <a:gd name="T28" fmla="*/ 36 w 36"/>
              <a:gd name="T29" fmla="*/ 6 h 279"/>
              <a:gd name="T30" fmla="*/ 0 w 36"/>
              <a:gd name="T31" fmla="*/ 6 h 279"/>
              <a:gd name="T32" fmla="*/ 0 w 36"/>
              <a:gd name="T33" fmla="*/ 0 h 27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6" h="279">
                <a:moveTo>
                  <a:pt x="15" y="276"/>
                </a:moveTo>
                <a:lnTo>
                  <a:pt x="15" y="139"/>
                </a:lnTo>
                <a:lnTo>
                  <a:pt x="15" y="3"/>
                </a:lnTo>
                <a:lnTo>
                  <a:pt x="21" y="3"/>
                </a:lnTo>
                <a:lnTo>
                  <a:pt x="21" y="139"/>
                </a:lnTo>
                <a:lnTo>
                  <a:pt x="21" y="276"/>
                </a:lnTo>
                <a:lnTo>
                  <a:pt x="15" y="276"/>
                </a:lnTo>
                <a:close/>
                <a:moveTo>
                  <a:pt x="0" y="273"/>
                </a:moveTo>
                <a:lnTo>
                  <a:pt x="36" y="273"/>
                </a:lnTo>
                <a:lnTo>
                  <a:pt x="36" y="279"/>
                </a:lnTo>
                <a:lnTo>
                  <a:pt x="0" y="279"/>
                </a:lnTo>
                <a:lnTo>
                  <a:pt x="0" y="273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36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64" name="Freeform 46"/>
          <p:cNvSpPr>
            <a:spLocks noEditPoints="1"/>
          </p:cNvSpPr>
          <p:nvPr/>
        </p:nvSpPr>
        <p:spPr bwMode="auto">
          <a:xfrm>
            <a:off x="6529565" y="3046200"/>
            <a:ext cx="55562" cy="315912"/>
          </a:xfrm>
          <a:custGeom>
            <a:avLst/>
            <a:gdLst>
              <a:gd name="T0" fmla="*/ 14 w 35"/>
              <a:gd name="T1" fmla="*/ 196 h 199"/>
              <a:gd name="T2" fmla="*/ 14 w 35"/>
              <a:gd name="T3" fmla="*/ 99 h 199"/>
              <a:gd name="T4" fmla="*/ 14 w 35"/>
              <a:gd name="T5" fmla="*/ 3 h 199"/>
              <a:gd name="T6" fmla="*/ 20 w 35"/>
              <a:gd name="T7" fmla="*/ 3 h 199"/>
              <a:gd name="T8" fmla="*/ 20 w 35"/>
              <a:gd name="T9" fmla="*/ 99 h 199"/>
              <a:gd name="T10" fmla="*/ 20 w 35"/>
              <a:gd name="T11" fmla="*/ 196 h 199"/>
              <a:gd name="T12" fmla="*/ 14 w 35"/>
              <a:gd name="T13" fmla="*/ 196 h 199"/>
              <a:gd name="T14" fmla="*/ 0 w 35"/>
              <a:gd name="T15" fmla="*/ 193 h 199"/>
              <a:gd name="T16" fmla="*/ 35 w 35"/>
              <a:gd name="T17" fmla="*/ 193 h 199"/>
              <a:gd name="T18" fmla="*/ 35 w 35"/>
              <a:gd name="T19" fmla="*/ 199 h 199"/>
              <a:gd name="T20" fmla="*/ 0 w 35"/>
              <a:gd name="T21" fmla="*/ 199 h 199"/>
              <a:gd name="T22" fmla="*/ 0 w 35"/>
              <a:gd name="T23" fmla="*/ 193 h 199"/>
              <a:gd name="T24" fmla="*/ 0 w 35"/>
              <a:gd name="T25" fmla="*/ 0 h 199"/>
              <a:gd name="T26" fmla="*/ 35 w 35"/>
              <a:gd name="T27" fmla="*/ 0 h 199"/>
              <a:gd name="T28" fmla="*/ 35 w 35"/>
              <a:gd name="T29" fmla="*/ 6 h 199"/>
              <a:gd name="T30" fmla="*/ 0 w 35"/>
              <a:gd name="T31" fmla="*/ 6 h 199"/>
              <a:gd name="T32" fmla="*/ 0 w 35"/>
              <a:gd name="T33" fmla="*/ 0 h 19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5" h="199">
                <a:moveTo>
                  <a:pt x="14" y="196"/>
                </a:moveTo>
                <a:lnTo>
                  <a:pt x="14" y="99"/>
                </a:lnTo>
                <a:lnTo>
                  <a:pt x="14" y="3"/>
                </a:lnTo>
                <a:lnTo>
                  <a:pt x="20" y="3"/>
                </a:lnTo>
                <a:lnTo>
                  <a:pt x="20" y="99"/>
                </a:lnTo>
                <a:lnTo>
                  <a:pt x="20" y="196"/>
                </a:lnTo>
                <a:lnTo>
                  <a:pt x="14" y="196"/>
                </a:lnTo>
                <a:close/>
                <a:moveTo>
                  <a:pt x="0" y="193"/>
                </a:moveTo>
                <a:lnTo>
                  <a:pt x="35" y="193"/>
                </a:lnTo>
                <a:lnTo>
                  <a:pt x="35" y="199"/>
                </a:lnTo>
                <a:lnTo>
                  <a:pt x="0" y="199"/>
                </a:lnTo>
                <a:lnTo>
                  <a:pt x="0" y="193"/>
                </a:lnTo>
                <a:close/>
                <a:moveTo>
                  <a:pt x="0" y="0"/>
                </a:moveTo>
                <a:lnTo>
                  <a:pt x="35" y="0"/>
                </a:lnTo>
                <a:lnTo>
                  <a:pt x="35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65" name="Rectangle 47"/>
          <p:cNvSpPr>
            <a:spLocks noChangeArrowheads="1"/>
          </p:cNvSpPr>
          <p:nvPr/>
        </p:nvSpPr>
        <p:spPr bwMode="auto">
          <a:xfrm>
            <a:off x="7026453" y="3847887"/>
            <a:ext cx="55562" cy="9525"/>
          </a:xfrm>
          <a:prstGeom prst="rect">
            <a:avLst/>
          </a:pr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66" name="Freeform 48"/>
          <p:cNvSpPr>
            <a:spLocks noEditPoints="1"/>
          </p:cNvSpPr>
          <p:nvPr/>
        </p:nvSpPr>
        <p:spPr bwMode="auto">
          <a:xfrm>
            <a:off x="7274103" y="3303375"/>
            <a:ext cx="57150" cy="452437"/>
          </a:xfrm>
          <a:custGeom>
            <a:avLst/>
            <a:gdLst>
              <a:gd name="T0" fmla="*/ 14 w 36"/>
              <a:gd name="T1" fmla="*/ 282 h 285"/>
              <a:gd name="T2" fmla="*/ 14 w 36"/>
              <a:gd name="T3" fmla="*/ 142 h 285"/>
              <a:gd name="T4" fmla="*/ 14 w 36"/>
              <a:gd name="T5" fmla="*/ 2 h 285"/>
              <a:gd name="T6" fmla="*/ 20 w 36"/>
              <a:gd name="T7" fmla="*/ 2 h 285"/>
              <a:gd name="T8" fmla="*/ 20 w 36"/>
              <a:gd name="T9" fmla="*/ 142 h 285"/>
              <a:gd name="T10" fmla="*/ 20 w 36"/>
              <a:gd name="T11" fmla="*/ 282 h 285"/>
              <a:gd name="T12" fmla="*/ 14 w 36"/>
              <a:gd name="T13" fmla="*/ 282 h 285"/>
              <a:gd name="T14" fmla="*/ 0 w 36"/>
              <a:gd name="T15" fmla="*/ 279 h 285"/>
              <a:gd name="T16" fmla="*/ 36 w 36"/>
              <a:gd name="T17" fmla="*/ 279 h 285"/>
              <a:gd name="T18" fmla="*/ 36 w 36"/>
              <a:gd name="T19" fmla="*/ 285 h 285"/>
              <a:gd name="T20" fmla="*/ 0 w 36"/>
              <a:gd name="T21" fmla="*/ 285 h 285"/>
              <a:gd name="T22" fmla="*/ 0 w 36"/>
              <a:gd name="T23" fmla="*/ 279 h 285"/>
              <a:gd name="T24" fmla="*/ 0 w 36"/>
              <a:gd name="T25" fmla="*/ 0 h 285"/>
              <a:gd name="T26" fmla="*/ 36 w 36"/>
              <a:gd name="T27" fmla="*/ 0 h 285"/>
              <a:gd name="T28" fmla="*/ 36 w 36"/>
              <a:gd name="T29" fmla="*/ 5 h 285"/>
              <a:gd name="T30" fmla="*/ 0 w 36"/>
              <a:gd name="T31" fmla="*/ 5 h 285"/>
              <a:gd name="T32" fmla="*/ 0 w 36"/>
              <a:gd name="T33" fmla="*/ 0 h 28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6" h="285">
                <a:moveTo>
                  <a:pt x="14" y="282"/>
                </a:moveTo>
                <a:lnTo>
                  <a:pt x="14" y="142"/>
                </a:lnTo>
                <a:lnTo>
                  <a:pt x="14" y="2"/>
                </a:lnTo>
                <a:lnTo>
                  <a:pt x="20" y="2"/>
                </a:lnTo>
                <a:lnTo>
                  <a:pt x="20" y="142"/>
                </a:lnTo>
                <a:lnTo>
                  <a:pt x="20" y="282"/>
                </a:lnTo>
                <a:lnTo>
                  <a:pt x="14" y="282"/>
                </a:lnTo>
                <a:close/>
                <a:moveTo>
                  <a:pt x="0" y="279"/>
                </a:moveTo>
                <a:lnTo>
                  <a:pt x="36" y="279"/>
                </a:lnTo>
                <a:lnTo>
                  <a:pt x="36" y="285"/>
                </a:lnTo>
                <a:lnTo>
                  <a:pt x="0" y="285"/>
                </a:lnTo>
                <a:lnTo>
                  <a:pt x="0" y="279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36" y="5"/>
                </a:lnTo>
                <a:lnTo>
                  <a:pt x="0" y="5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67" name="Freeform 49"/>
          <p:cNvSpPr>
            <a:spLocks noEditPoints="1"/>
          </p:cNvSpPr>
          <p:nvPr/>
        </p:nvSpPr>
        <p:spPr bwMode="auto">
          <a:xfrm>
            <a:off x="7521753" y="1417425"/>
            <a:ext cx="57150" cy="831850"/>
          </a:xfrm>
          <a:custGeom>
            <a:avLst/>
            <a:gdLst>
              <a:gd name="T0" fmla="*/ 15 w 36"/>
              <a:gd name="T1" fmla="*/ 521 h 524"/>
              <a:gd name="T2" fmla="*/ 15 w 36"/>
              <a:gd name="T3" fmla="*/ 262 h 524"/>
              <a:gd name="T4" fmla="*/ 15 w 36"/>
              <a:gd name="T5" fmla="*/ 3 h 524"/>
              <a:gd name="T6" fmla="*/ 21 w 36"/>
              <a:gd name="T7" fmla="*/ 3 h 524"/>
              <a:gd name="T8" fmla="*/ 21 w 36"/>
              <a:gd name="T9" fmla="*/ 262 h 524"/>
              <a:gd name="T10" fmla="*/ 21 w 36"/>
              <a:gd name="T11" fmla="*/ 521 h 524"/>
              <a:gd name="T12" fmla="*/ 15 w 36"/>
              <a:gd name="T13" fmla="*/ 521 h 524"/>
              <a:gd name="T14" fmla="*/ 0 w 36"/>
              <a:gd name="T15" fmla="*/ 518 h 524"/>
              <a:gd name="T16" fmla="*/ 36 w 36"/>
              <a:gd name="T17" fmla="*/ 518 h 524"/>
              <a:gd name="T18" fmla="*/ 36 w 36"/>
              <a:gd name="T19" fmla="*/ 524 h 524"/>
              <a:gd name="T20" fmla="*/ 0 w 36"/>
              <a:gd name="T21" fmla="*/ 524 h 524"/>
              <a:gd name="T22" fmla="*/ 0 w 36"/>
              <a:gd name="T23" fmla="*/ 518 h 524"/>
              <a:gd name="T24" fmla="*/ 0 w 36"/>
              <a:gd name="T25" fmla="*/ 0 h 524"/>
              <a:gd name="T26" fmla="*/ 36 w 36"/>
              <a:gd name="T27" fmla="*/ 0 h 524"/>
              <a:gd name="T28" fmla="*/ 36 w 36"/>
              <a:gd name="T29" fmla="*/ 6 h 524"/>
              <a:gd name="T30" fmla="*/ 0 w 36"/>
              <a:gd name="T31" fmla="*/ 6 h 524"/>
              <a:gd name="T32" fmla="*/ 0 w 36"/>
              <a:gd name="T33" fmla="*/ 0 h 52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6" h="524">
                <a:moveTo>
                  <a:pt x="15" y="521"/>
                </a:moveTo>
                <a:lnTo>
                  <a:pt x="15" y="262"/>
                </a:lnTo>
                <a:lnTo>
                  <a:pt x="15" y="3"/>
                </a:lnTo>
                <a:lnTo>
                  <a:pt x="21" y="3"/>
                </a:lnTo>
                <a:lnTo>
                  <a:pt x="21" y="262"/>
                </a:lnTo>
                <a:lnTo>
                  <a:pt x="21" y="521"/>
                </a:lnTo>
                <a:lnTo>
                  <a:pt x="15" y="521"/>
                </a:lnTo>
                <a:close/>
                <a:moveTo>
                  <a:pt x="0" y="518"/>
                </a:moveTo>
                <a:lnTo>
                  <a:pt x="36" y="518"/>
                </a:lnTo>
                <a:lnTo>
                  <a:pt x="36" y="524"/>
                </a:lnTo>
                <a:lnTo>
                  <a:pt x="0" y="524"/>
                </a:lnTo>
                <a:lnTo>
                  <a:pt x="0" y="518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36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68" name="Freeform 50"/>
          <p:cNvSpPr>
            <a:spLocks noEditPoints="1"/>
          </p:cNvSpPr>
          <p:nvPr/>
        </p:nvSpPr>
        <p:spPr bwMode="auto">
          <a:xfrm>
            <a:off x="8267878" y="804650"/>
            <a:ext cx="55562" cy="644525"/>
          </a:xfrm>
          <a:custGeom>
            <a:avLst/>
            <a:gdLst>
              <a:gd name="T0" fmla="*/ 15 w 35"/>
              <a:gd name="T1" fmla="*/ 403 h 406"/>
              <a:gd name="T2" fmla="*/ 15 w 35"/>
              <a:gd name="T3" fmla="*/ 203 h 406"/>
              <a:gd name="T4" fmla="*/ 15 w 35"/>
              <a:gd name="T5" fmla="*/ 3 h 406"/>
              <a:gd name="T6" fmla="*/ 21 w 35"/>
              <a:gd name="T7" fmla="*/ 3 h 406"/>
              <a:gd name="T8" fmla="*/ 21 w 35"/>
              <a:gd name="T9" fmla="*/ 203 h 406"/>
              <a:gd name="T10" fmla="*/ 21 w 35"/>
              <a:gd name="T11" fmla="*/ 403 h 406"/>
              <a:gd name="T12" fmla="*/ 15 w 35"/>
              <a:gd name="T13" fmla="*/ 403 h 406"/>
              <a:gd name="T14" fmla="*/ 0 w 35"/>
              <a:gd name="T15" fmla="*/ 400 h 406"/>
              <a:gd name="T16" fmla="*/ 35 w 35"/>
              <a:gd name="T17" fmla="*/ 400 h 406"/>
              <a:gd name="T18" fmla="*/ 35 w 35"/>
              <a:gd name="T19" fmla="*/ 406 h 406"/>
              <a:gd name="T20" fmla="*/ 0 w 35"/>
              <a:gd name="T21" fmla="*/ 406 h 406"/>
              <a:gd name="T22" fmla="*/ 0 w 35"/>
              <a:gd name="T23" fmla="*/ 400 h 406"/>
              <a:gd name="T24" fmla="*/ 0 w 35"/>
              <a:gd name="T25" fmla="*/ 0 h 406"/>
              <a:gd name="T26" fmla="*/ 35 w 35"/>
              <a:gd name="T27" fmla="*/ 0 h 406"/>
              <a:gd name="T28" fmla="*/ 35 w 35"/>
              <a:gd name="T29" fmla="*/ 6 h 406"/>
              <a:gd name="T30" fmla="*/ 0 w 35"/>
              <a:gd name="T31" fmla="*/ 6 h 406"/>
              <a:gd name="T32" fmla="*/ 0 w 35"/>
              <a:gd name="T33" fmla="*/ 0 h 40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5" h="406">
                <a:moveTo>
                  <a:pt x="15" y="403"/>
                </a:moveTo>
                <a:lnTo>
                  <a:pt x="15" y="203"/>
                </a:lnTo>
                <a:lnTo>
                  <a:pt x="15" y="3"/>
                </a:lnTo>
                <a:lnTo>
                  <a:pt x="21" y="3"/>
                </a:lnTo>
                <a:lnTo>
                  <a:pt x="21" y="203"/>
                </a:lnTo>
                <a:lnTo>
                  <a:pt x="21" y="403"/>
                </a:lnTo>
                <a:lnTo>
                  <a:pt x="15" y="403"/>
                </a:lnTo>
                <a:close/>
                <a:moveTo>
                  <a:pt x="0" y="400"/>
                </a:moveTo>
                <a:lnTo>
                  <a:pt x="35" y="400"/>
                </a:lnTo>
                <a:lnTo>
                  <a:pt x="35" y="406"/>
                </a:lnTo>
                <a:lnTo>
                  <a:pt x="0" y="406"/>
                </a:lnTo>
                <a:lnTo>
                  <a:pt x="0" y="400"/>
                </a:lnTo>
                <a:close/>
                <a:moveTo>
                  <a:pt x="0" y="0"/>
                </a:moveTo>
                <a:lnTo>
                  <a:pt x="35" y="0"/>
                </a:lnTo>
                <a:lnTo>
                  <a:pt x="35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69" name="Rectangle 51"/>
          <p:cNvSpPr>
            <a:spLocks noChangeArrowheads="1"/>
          </p:cNvSpPr>
          <p:nvPr/>
        </p:nvSpPr>
        <p:spPr bwMode="auto">
          <a:xfrm>
            <a:off x="1709915" y="606212"/>
            <a:ext cx="3175" cy="3895725"/>
          </a:xfrm>
          <a:prstGeom prst="rect">
            <a:avLst/>
          </a:pr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70" name="Freeform 52"/>
          <p:cNvSpPr>
            <a:spLocks noEditPoints="1"/>
          </p:cNvSpPr>
          <p:nvPr/>
        </p:nvSpPr>
        <p:spPr bwMode="auto">
          <a:xfrm>
            <a:off x="1673403" y="604625"/>
            <a:ext cx="38100" cy="3898900"/>
          </a:xfrm>
          <a:custGeom>
            <a:avLst/>
            <a:gdLst>
              <a:gd name="T0" fmla="*/ 0 w 24"/>
              <a:gd name="T1" fmla="*/ 2454 h 2456"/>
              <a:gd name="T2" fmla="*/ 24 w 24"/>
              <a:gd name="T3" fmla="*/ 2454 h 2456"/>
              <a:gd name="T4" fmla="*/ 24 w 24"/>
              <a:gd name="T5" fmla="*/ 2456 h 2456"/>
              <a:gd name="T6" fmla="*/ 0 w 24"/>
              <a:gd name="T7" fmla="*/ 2456 h 2456"/>
              <a:gd name="T8" fmla="*/ 0 w 24"/>
              <a:gd name="T9" fmla="*/ 2454 h 2456"/>
              <a:gd name="T10" fmla="*/ 0 w 24"/>
              <a:gd name="T11" fmla="*/ 2045 h 2456"/>
              <a:gd name="T12" fmla="*/ 24 w 24"/>
              <a:gd name="T13" fmla="*/ 2045 h 2456"/>
              <a:gd name="T14" fmla="*/ 24 w 24"/>
              <a:gd name="T15" fmla="*/ 2047 h 2456"/>
              <a:gd name="T16" fmla="*/ 0 w 24"/>
              <a:gd name="T17" fmla="*/ 2047 h 2456"/>
              <a:gd name="T18" fmla="*/ 0 w 24"/>
              <a:gd name="T19" fmla="*/ 2045 h 2456"/>
              <a:gd name="T20" fmla="*/ 0 w 24"/>
              <a:gd name="T21" fmla="*/ 1636 h 2456"/>
              <a:gd name="T22" fmla="*/ 24 w 24"/>
              <a:gd name="T23" fmla="*/ 1636 h 2456"/>
              <a:gd name="T24" fmla="*/ 24 w 24"/>
              <a:gd name="T25" fmla="*/ 1638 h 2456"/>
              <a:gd name="T26" fmla="*/ 0 w 24"/>
              <a:gd name="T27" fmla="*/ 1638 h 2456"/>
              <a:gd name="T28" fmla="*/ 0 w 24"/>
              <a:gd name="T29" fmla="*/ 1636 h 2456"/>
              <a:gd name="T30" fmla="*/ 0 w 24"/>
              <a:gd name="T31" fmla="*/ 1227 h 2456"/>
              <a:gd name="T32" fmla="*/ 24 w 24"/>
              <a:gd name="T33" fmla="*/ 1227 h 2456"/>
              <a:gd name="T34" fmla="*/ 24 w 24"/>
              <a:gd name="T35" fmla="*/ 1229 h 2456"/>
              <a:gd name="T36" fmla="*/ 0 w 24"/>
              <a:gd name="T37" fmla="*/ 1229 h 2456"/>
              <a:gd name="T38" fmla="*/ 0 w 24"/>
              <a:gd name="T39" fmla="*/ 1227 h 2456"/>
              <a:gd name="T40" fmla="*/ 0 w 24"/>
              <a:gd name="T41" fmla="*/ 818 h 2456"/>
              <a:gd name="T42" fmla="*/ 24 w 24"/>
              <a:gd name="T43" fmla="*/ 818 h 2456"/>
              <a:gd name="T44" fmla="*/ 24 w 24"/>
              <a:gd name="T45" fmla="*/ 820 h 2456"/>
              <a:gd name="T46" fmla="*/ 0 w 24"/>
              <a:gd name="T47" fmla="*/ 820 h 2456"/>
              <a:gd name="T48" fmla="*/ 0 w 24"/>
              <a:gd name="T49" fmla="*/ 818 h 2456"/>
              <a:gd name="T50" fmla="*/ 0 w 24"/>
              <a:gd name="T51" fmla="*/ 409 h 2456"/>
              <a:gd name="T52" fmla="*/ 24 w 24"/>
              <a:gd name="T53" fmla="*/ 409 h 2456"/>
              <a:gd name="T54" fmla="*/ 24 w 24"/>
              <a:gd name="T55" fmla="*/ 411 h 2456"/>
              <a:gd name="T56" fmla="*/ 0 w 24"/>
              <a:gd name="T57" fmla="*/ 411 h 2456"/>
              <a:gd name="T58" fmla="*/ 0 w 24"/>
              <a:gd name="T59" fmla="*/ 409 h 2456"/>
              <a:gd name="T60" fmla="*/ 0 w 24"/>
              <a:gd name="T61" fmla="*/ 0 h 2456"/>
              <a:gd name="T62" fmla="*/ 24 w 24"/>
              <a:gd name="T63" fmla="*/ 0 h 2456"/>
              <a:gd name="T64" fmla="*/ 24 w 24"/>
              <a:gd name="T65" fmla="*/ 2 h 2456"/>
              <a:gd name="T66" fmla="*/ 0 w 24"/>
              <a:gd name="T67" fmla="*/ 2 h 2456"/>
              <a:gd name="T68" fmla="*/ 0 w 24"/>
              <a:gd name="T69" fmla="*/ 0 h 245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24" h="2456">
                <a:moveTo>
                  <a:pt x="0" y="2454"/>
                </a:moveTo>
                <a:lnTo>
                  <a:pt x="24" y="2454"/>
                </a:lnTo>
                <a:lnTo>
                  <a:pt x="24" y="2456"/>
                </a:lnTo>
                <a:lnTo>
                  <a:pt x="0" y="2456"/>
                </a:lnTo>
                <a:lnTo>
                  <a:pt x="0" y="2454"/>
                </a:lnTo>
                <a:close/>
                <a:moveTo>
                  <a:pt x="0" y="2045"/>
                </a:moveTo>
                <a:lnTo>
                  <a:pt x="24" y="2045"/>
                </a:lnTo>
                <a:lnTo>
                  <a:pt x="24" y="2047"/>
                </a:lnTo>
                <a:lnTo>
                  <a:pt x="0" y="2047"/>
                </a:lnTo>
                <a:lnTo>
                  <a:pt x="0" y="2045"/>
                </a:lnTo>
                <a:close/>
                <a:moveTo>
                  <a:pt x="0" y="1636"/>
                </a:moveTo>
                <a:lnTo>
                  <a:pt x="24" y="1636"/>
                </a:lnTo>
                <a:lnTo>
                  <a:pt x="24" y="1638"/>
                </a:lnTo>
                <a:lnTo>
                  <a:pt x="0" y="1638"/>
                </a:lnTo>
                <a:lnTo>
                  <a:pt x="0" y="1636"/>
                </a:lnTo>
                <a:close/>
                <a:moveTo>
                  <a:pt x="0" y="1227"/>
                </a:moveTo>
                <a:lnTo>
                  <a:pt x="24" y="1227"/>
                </a:lnTo>
                <a:lnTo>
                  <a:pt x="24" y="1229"/>
                </a:lnTo>
                <a:lnTo>
                  <a:pt x="0" y="1229"/>
                </a:lnTo>
                <a:lnTo>
                  <a:pt x="0" y="1227"/>
                </a:lnTo>
                <a:close/>
                <a:moveTo>
                  <a:pt x="0" y="818"/>
                </a:moveTo>
                <a:lnTo>
                  <a:pt x="24" y="818"/>
                </a:lnTo>
                <a:lnTo>
                  <a:pt x="24" y="820"/>
                </a:lnTo>
                <a:lnTo>
                  <a:pt x="0" y="820"/>
                </a:lnTo>
                <a:lnTo>
                  <a:pt x="0" y="818"/>
                </a:lnTo>
                <a:close/>
                <a:moveTo>
                  <a:pt x="0" y="409"/>
                </a:moveTo>
                <a:lnTo>
                  <a:pt x="24" y="409"/>
                </a:lnTo>
                <a:lnTo>
                  <a:pt x="24" y="411"/>
                </a:lnTo>
                <a:lnTo>
                  <a:pt x="0" y="411"/>
                </a:lnTo>
                <a:lnTo>
                  <a:pt x="0" y="409"/>
                </a:lnTo>
                <a:close/>
                <a:moveTo>
                  <a:pt x="0" y="0"/>
                </a:moveTo>
                <a:lnTo>
                  <a:pt x="24" y="0"/>
                </a:lnTo>
                <a:lnTo>
                  <a:pt x="24" y="2"/>
                </a:lnTo>
                <a:lnTo>
                  <a:pt x="0" y="2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71" name="Rectangle 53"/>
          <p:cNvSpPr>
            <a:spLocks noChangeArrowheads="1"/>
          </p:cNvSpPr>
          <p:nvPr/>
        </p:nvSpPr>
        <p:spPr bwMode="auto">
          <a:xfrm>
            <a:off x="1711503" y="4500350"/>
            <a:ext cx="6708775" cy="3175"/>
          </a:xfrm>
          <a:prstGeom prst="rect">
            <a:avLst/>
          </a:pr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72" name="Freeform 54"/>
          <p:cNvSpPr>
            <a:spLocks noEditPoints="1"/>
          </p:cNvSpPr>
          <p:nvPr/>
        </p:nvSpPr>
        <p:spPr bwMode="auto">
          <a:xfrm>
            <a:off x="1709915" y="4501937"/>
            <a:ext cx="6711950" cy="39687"/>
          </a:xfrm>
          <a:custGeom>
            <a:avLst/>
            <a:gdLst>
              <a:gd name="T0" fmla="*/ 0 w 4228"/>
              <a:gd name="T1" fmla="*/ 25 h 25"/>
              <a:gd name="T2" fmla="*/ 158 w 4228"/>
              <a:gd name="T3" fmla="*/ 0 h 25"/>
              <a:gd name="T4" fmla="*/ 156 w 4228"/>
              <a:gd name="T5" fmla="*/ 0 h 25"/>
              <a:gd name="T6" fmla="*/ 315 w 4228"/>
              <a:gd name="T7" fmla="*/ 25 h 25"/>
              <a:gd name="T8" fmla="*/ 315 w 4228"/>
              <a:gd name="T9" fmla="*/ 0 h 25"/>
              <a:gd name="T10" fmla="*/ 469 w 4228"/>
              <a:gd name="T11" fmla="*/ 25 h 25"/>
              <a:gd name="T12" fmla="*/ 628 w 4228"/>
              <a:gd name="T13" fmla="*/ 0 h 25"/>
              <a:gd name="T14" fmla="*/ 626 w 4228"/>
              <a:gd name="T15" fmla="*/ 0 h 25"/>
              <a:gd name="T16" fmla="*/ 784 w 4228"/>
              <a:gd name="T17" fmla="*/ 25 h 25"/>
              <a:gd name="T18" fmla="*/ 784 w 4228"/>
              <a:gd name="T19" fmla="*/ 0 h 25"/>
              <a:gd name="T20" fmla="*/ 939 w 4228"/>
              <a:gd name="T21" fmla="*/ 25 h 25"/>
              <a:gd name="T22" fmla="*/ 1097 w 4228"/>
              <a:gd name="T23" fmla="*/ 0 h 25"/>
              <a:gd name="T24" fmla="*/ 1095 w 4228"/>
              <a:gd name="T25" fmla="*/ 0 h 25"/>
              <a:gd name="T26" fmla="*/ 1254 w 4228"/>
              <a:gd name="T27" fmla="*/ 25 h 25"/>
              <a:gd name="T28" fmla="*/ 1254 w 4228"/>
              <a:gd name="T29" fmla="*/ 0 h 25"/>
              <a:gd name="T30" fmla="*/ 1408 w 4228"/>
              <a:gd name="T31" fmla="*/ 25 h 25"/>
              <a:gd name="T32" fmla="*/ 1567 w 4228"/>
              <a:gd name="T33" fmla="*/ 0 h 25"/>
              <a:gd name="T34" fmla="*/ 1565 w 4228"/>
              <a:gd name="T35" fmla="*/ 0 h 25"/>
              <a:gd name="T36" fmla="*/ 1723 w 4228"/>
              <a:gd name="T37" fmla="*/ 25 h 25"/>
              <a:gd name="T38" fmla="*/ 1723 w 4228"/>
              <a:gd name="T39" fmla="*/ 0 h 25"/>
              <a:gd name="T40" fmla="*/ 1878 w 4228"/>
              <a:gd name="T41" fmla="*/ 25 h 25"/>
              <a:gd name="T42" fmla="*/ 2036 w 4228"/>
              <a:gd name="T43" fmla="*/ 0 h 25"/>
              <a:gd name="T44" fmla="*/ 2034 w 4228"/>
              <a:gd name="T45" fmla="*/ 0 h 25"/>
              <a:gd name="T46" fmla="*/ 2193 w 4228"/>
              <a:gd name="T47" fmla="*/ 25 h 25"/>
              <a:gd name="T48" fmla="*/ 2193 w 4228"/>
              <a:gd name="T49" fmla="*/ 0 h 25"/>
              <a:gd name="T50" fmla="*/ 2348 w 4228"/>
              <a:gd name="T51" fmla="*/ 25 h 25"/>
              <a:gd name="T52" fmla="*/ 2507 w 4228"/>
              <a:gd name="T53" fmla="*/ 0 h 25"/>
              <a:gd name="T54" fmla="*/ 2505 w 4228"/>
              <a:gd name="T55" fmla="*/ 0 h 25"/>
              <a:gd name="T56" fmla="*/ 2663 w 4228"/>
              <a:gd name="T57" fmla="*/ 25 h 25"/>
              <a:gd name="T58" fmla="*/ 2663 w 4228"/>
              <a:gd name="T59" fmla="*/ 0 h 25"/>
              <a:gd name="T60" fmla="*/ 2818 w 4228"/>
              <a:gd name="T61" fmla="*/ 25 h 25"/>
              <a:gd name="T62" fmla="*/ 2976 w 4228"/>
              <a:gd name="T63" fmla="*/ 0 h 25"/>
              <a:gd name="T64" fmla="*/ 2974 w 4228"/>
              <a:gd name="T65" fmla="*/ 0 h 25"/>
              <a:gd name="T66" fmla="*/ 3132 w 4228"/>
              <a:gd name="T67" fmla="*/ 25 h 25"/>
              <a:gd name="T68" fmla="*/ 3132 w 4228"/>
              <a:gd name="T69" fmla="*/ 0 h 25"/>
              <a:gd name="T70" fmla="*/ 3287 w 4228"/>
              <a:gd name="T71" fmla="*/ 25 h 25"/>
              <a:gd name="T72" fmla="*/ 3445 w 4228"/>
              <a:gd name="T73" fmla="*/ 0 h 25"/>
              <a:gd name="T74" fmla="*/ 3444 w 4228"/>
              <a:gd name="T75" fmla="*/ 0 h 25"/>
              <a:gd name="T76" fmla="*/ 3602 w 4228"/>
              <a:gd name="T77" fmla="*/ 25 h 25"/>
              <a:gd name="T78" fmla="*/ 3602 w 4228"/>
              <a:gd name="T79" fmla="*/ 0 h 25"/>
              <a:gd name="T80" fmla="*/ 3757 w 4228"/>
              <a:gd name="T81" fmla="*/ 25 h 25"/>
              <a:gd name="T82" fmla="*/ 3915 w 4228"/>
              <a:gd name="T83" fmla="*/ 0 h 25"/>
              <a:gd name="T84" fmla="*/ 3913 w 4228"/>
              <a:gd name="T85" fmla="*/ 0 h 25"/>
              <a:gd name="T86" fmla="*/ 4071 w 4228"/>
              <a:gd name="T87" fmla="*/ 25 h 25"/>
              <a:gd name="T88" fmla="*/ 4071 w 4228"/>
              <a:gd name="T89" fmla="*/ 0 h 25"/>
              <a:gd name="T90" fmla="*/ 4226 w 4228"/>
              <a:gd name="T91" fmla="*/ 25 h 2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</a:cxnLst>
            <a:rect l="0" t="0" r="r" b="b"/>
            <a:pathLst>
              <a:path w="4228" h="25">
                <a:moveTo>
                  <a:pt x="2" y="0"/>
                </a:moveTo>
                <a:lnTo>
                  <a:pt x="2" y="25"/>
                </a:lnTo>
                <a:lnTo>
                  <a:pt x="0" y="25"/>
                </a:lnTo>
                <a:lnTo>
                  <a:pt x="0" y="0"/>
                </a:lnTo>
                <a:lnTo>
                  <a:pt x="2" y="0"/>
                </a:lnTo>
                <a:close/>
                <a:moveTo>
                  <a:pt x="158" y="0"/>
                </a:moveTo>
                <a:lnTo>
                  <a:pt x="158" y="25"/>
                </a:lnTo>
                <a:lnTo>
                  <a:pt x="156" y="25"/>
                </a:lnTo>
                <a:lnTo>
                  <a:pt x="156" y="0"/>
                </a:lnTo>
                <a:lnTo>
                  <a:pt x="158" y="0"/>
                </a:lnTo>
                <a:close/>
                <a:moveTo>
                  <a:pt x="315" y="0"/>
                </a:moveTo>
                <a:lnTo>
                  <a:pt x="315" y="25"/>
                </a:lnTo>
                <a:lnTo>
                  <a:pt x="313" y="25"/>
                </a:lnTo>
                <a:lnTo>
                  <a:pt x="313" y="0"/>
                </a:lnTo>
                <a:lnTo>
                  <a:pt x="315" y="0"/>
                </a:lnTo>
                <a:close/>
                <a:moveTo>
                  <a:pt x="471" y="0"/>
                </a:moveTo>
                <a:lnTo>
                  <a:pt x="471" y="25"/>
                </a:lnTo>
                <a:lnTo>
                  <a:pt x="469" y="25"/>
                </a:lnTo>
                <a:lnTo>
                  <a:pt x="469" y="0"/>
                </a:lnTo>
                <a:lnTo>
                  <a:pt x="471" y="0"/>
                </a:lnTo>
                <a:close/>
                <a:moveTo>
                  <a:pt x="628" y="0"/>
                </a:moveTo>
                <a:lnTo>
                  <a:pt x="628" y="25"/>
                </a:lnTo>
                <a:lnTo>
                  <a:pt x="626" y="25"/>
                </a:lnTo>
                <a:lnTo>
                  <a:pt x="626" y="0"/>
                </a:lnTo>
                <a:lnTo>
                  <a:pt x="628" y="0"/>
                </a:lnTo>
                <a:close/>
                <a:moveTo>
                  <a:pt x="784" y="0"/>
                </a:moveTo>
                <a:lnTo>
                  <a:pt x="784" y="25"/>
                </a:lnTo>
                <a:lnTo>
                  <a:pt x="782" y="25"/>
                </a:lnTo>
                <a:lnTo>
                  <a:pt x="782" y="0"/>
                </a:lnTo>
                <a:lnTo>
                  <a:pt x="784" y="0"/>
                </a:lnTo>
                <a:close/>
                <a:moveTo>
                  <a:pt x="941" y="0"/>
                </a:moveTo>
                <a:lnTo>
                  <a:pt x="941" y="25"/>
                </a:lnTo>
                <a:lnTo>
                  <a:pt x="939" y="25"/>
                </a:lnTo>
                <a:lnTo>
                  <a:pt x="939" y="0"/>
                </a:lnTo>
                <a:lnTo>
                  <a:pt x="941" y="0"/>
                </a:lnTo>
                <a:close/>
                <a:moveTo>
                  <a:pt x="1097" y="0"/>
                </a:moveTo>
                <a:lnTo>
                  <a:pt x="1097" y="25"/>
                </a:lnTo>
                <a:lnTo>
                  <a:pt x="1095" y="25"/>
                </a:lnTo>
                <a:lnTo>
                  <a:pt x="1095" y="0"/>
                </a:lnTo>
                <a:lnTo>
                  <a:pt x="1097" y="0"/>
                </a:lnTo>
                <a:close/>
                <a:moveTo>
                  <a:pt x="1254" y="0"/>
                </a:moveTo>
                <a:lnTo>
                  <a:pt x="1254" y="25"/>
                </a:lnTo>
                <a:lnTo>
                  <a:pt x="1252" y="25"/>
                </a:lnTo>
                <a:lnTo>
                  <a:pt x="1252" y="0"/>
                </a:lnTo>
                <a:lnTo>
                  <a:pt x="1254" y="0"/>
                </a:lnTo>
                <a:close/>
                <a:moveTo>
                  <a:pt x="1410" y="0"/>
                </a:moveTo>
                <a:lnTo>
                  <a:pt x="1410" y="25"/>
                </a:lnTo>
                <a:lnTo>
                  <a:pt x="1408" y="25"/>
                </a:lnTo>
                <a:lnTo>
                  <a:pt x="1408" y="0"/>
                </a:lnTo>
                <a:lnTo>
                  <a:pt x="1410" y="0"/>
                </a:lnTo>
                <a:close/>
                <a:moveTo>
                  <a:pt x="1567" y="0"/>
                </a:moveTo>
                <a:lnTo>
                  <a:pt x="1567" y="25"/>
                </a:lnTo>
                <a:lnTo>
                  <a:pt x="1565" y="25"/>
                </a:lnTo>
                <a:lnTo>
                  <a:pt x="1565" y="0"/>
                </a:lnTo>
                <a:lnTo>
                  <a:pt x="1567" y="0"/>
                </a:lnTo>
                <a:close/>
                <a:moveTo>
                  <a:pt x="1723" y="0"/>
                </a:moveTo>
                <a:lnTo>
                  <a:pt x="1723" y="25"/>
                </a:lnTo>
                <a:lnTo>
                  <a:pt x="1721" y="25"/>
                </a:lnTo>
                <a:lnTo>
                  <a:pt x="1721" y="0"/>
                </a:lnTo>
                <a:lnTo>
                  <a:pt x="1723" y="0"/>
                </a:lnTo>
                <a:close/>
                <a:moveTo>
                  <a:pt x="1880" y="0"/>
                </a:moveTo>
                <a:lnTo>
                  <a:pt x="1880" y="25"/>
                </a:lnTo>
                <a:lnTo>
                  <a:pt x="1878" y="25"/>
                </a:lnTo>
                <a:lnTo>
                  <a:pt x="1878" y="0"/>
                </a:lnTo>
                <a:lnTo>
                  <a:pt x="1880" y="0"/>
                </a:lnTo>
                <a:close/>
                <a:moveTo>
                  <a:pt x="2036" y="0"/>
                </a:moveTo>
                <a:lnTo>
                  <a:pt x="2036" y="25"/>
                </a:lnTo>
                <a:lnTo>
                  <a:pt x="2034" y="25"/>
                </a:lnTo>
                <a:lnTo>
                  <a:pt x="2034" y="0"/>
                </a:lnTo>
                <a:lnTo>
                  <a:pt x="2036" y="0"/>
                </a:lnTo>
                <a:close/>
                <a:moveTo>
                  <a:pt x="2193" y="0"/>
                </a:moveTo>
                <a:lnTo>
                  <a:pt x="2193" y="25"/>
                </a:lnTo>
                <a:lnTo>
                  <a:pt x="2191" y="25"/>
                </a:lnTo>
                <a:lnTo>
                  <a:pt x="2191" y="0"/>
                </a:lnTo>
                <a:lnTo>
                  <a:pt x="2193" y="0"/>
                </a:lnTo>
                <a:close/>
                <a:moveTo>
                  <a:pt x="2350" y="0"/>
                </a:moveTo>
                <a:lnTo>
                  <a:pt x="2350" y="25"/>
                </a:lnTo>
                <a:lnTo>
                  <a:pt x="2348" y="25"/>
                </a:lnTo>
                <a:lnTo>
                  <a:pt x="2348" y="0"/>
                </a:lnTo>
                <a:lnTo>
                  <a:pt x="2350" y="0"/>
                </a:lnTo>
                <a:close/>
                <a:moveTo>
                  <a:pt x="2507" y="0"/>
                </a:moveTo>
                <a:lnTo>
                  <a:pt x="2507" y="25"/>
                </a:lnTo>
                <a:lnTo>
                  <a:pt x="2505" y="25"/>
                </a:lnTo>
                <a:lnTo>
                  <a:pt x="2505" y="0"/>
                </a:lnTo>
                <a:lnTo>
                  <a:pt x="2507" y="0"/>
                </a:lnTo>
                <a:close/>
                <a:moveTo>
                  <a:pt x="2663" y="0"/>
                </a:moveTo>
                <a:lnTo>
                  <a:pt x="2663" y="25"/>
                </a:lnTo>
                <a:lnTo>
                  <a:pt x="2661" y="25"/>
                </a:lnTo>
                <a:lnTo>
                  <a:pt x="2661" y="0"/>
                </a:lnTo>
                <a:lnTo>
                  <a:pt x="2663" y="0"/>
                </a:lnTo>
                <a:close/>
                <a:moveTo>
                  <a:pt x="2820" y="0"/>
                </a:moveTo>
                <a:lnTo>
                  <a:pt x="2820" y="25"/>
                </a:lnTo>
                <a:lnTo>
                  <a:pt x="2818" y="25"/>
                </a:lnTo>
                <a:lnTo>
                  <a:pt x="2818" y="0"/>
                </a:lnTo>
                <a:lnTo>
                  <a:pt x="2820" y="0"/>
                </a:lnTo>
                <a:close/>
                <a:moveTo>
                  <a:pt x="2976" y="0"/>
                </a:moveTo>
                <a:lnTo>
                  <a:pt x="2976" y="25"/>
                </a:lnTo>
                <a:lnTo>
                  <a:pt x="2974" y="25"/>
                </a:lnTo>
                <a:lnTo>
                  <a:pt x="2974" y="0"/>
                </a:lnTo>
                <a:lnTo>
                  <a:pt x="2976" y="0"/>
                </a:lnTo>
                <a:close/>
                <a:moveTo>
                  <a:pt x="3132" y="0"/>
                </a:moveTo>
                <a:lnTo>
                  <a:pt x="3132" y="25"/>
                </a:lnTo>
                <a:lnTo>
                  <a:pt x="3131" y="25"/>
                </a:lnTo>
                <a:lnTo>
                  <a:pt x="3131" y="0"/>
                </a:lnTo>
                <a:lnTo>
                  <a:pt x="3132" y="0"/>
                </a:lnTo>
                <a:close/>
                <a:moveTo>
                  <a:pt x="3289" y="0"/>
                </a:moveTo>
                <a:lnTo>
                  <a:pt x="3289" y="25"/>
                </a:lnTo>
                <a:lnTo>
                  <a:pt x="3287" y="25"/>
                </a:lnTo>
                <a:lnTo>
                  <a:pt x="3287" y="0"/>
                </a:lnTo>
                <a:lnTo>
                  <a:pt x="3289" y="0"/>
                </a:lnTo>
                <a:close/>
                <a:moveTo>
                  <a:pt x="3445" y="0"/>
                </a:moveTo>
                <a:lnTo>
                  <a:pt x="3445" y="25"/>
                </a:lnTo>
                <a:lnTo>
                  <a:pt x="3444" y="25"/>
                </a:lnTo>
                <a:lnTo>
                  <a:pt x="3444" y="0"/>
                </a:lnTo>
                <a:lnTo>
                  <a:pt x="3445" y="0"/>
                </a:lnTo>
                <a:close/>
                <a:moveTo>
                  <a:pt x="3602" y="0"/>
                </a:moveTo>
                <a:lnTo>
                  <a:pt x="3602" y="25"/>
                </a:lnTo>
                <a:lnTo>
                  <a:pt x="3600" y="25"/>
                </a:lnTo>
                <a:lnTo>
                  <a:pt x="3600" y="0"/>
                </a:lnTo>
                <a:lnTo>
                  <a:pt x="3602" y="0"/>
                </a:lnTo>
                <a:close/>
                <a:moveTo>
                  <a:pt x="3758" y="0"/>
                </a:moveTo>
                <a:lnTo>
                  <a:pt x="3758" y="25"/>
                </a:lnTo>
                <a:lnTo>
                  <a:pt x="3757" y="25"/>
                </a:lnTo>
                <a:lnTo>
                  <a:pt x="3757" y="0"/>
                </a:lnTo>
                <a:lnTo>
                  <a:pt x="3758" y="0"/>
                </a:lnTo>
                <a:close/>
                <a:moveTo>
                  <a:pt x="3915" y="0"/>
                </a:moveTo>
                <a:lnTo>
                  <a:pt x="3915" y="25"/>
                </a:lnTo>
                <a:lnTo>
                  <a:pt x="3913" y="25"/>
                </a:lnTo>
                <a:lnTo>
                  <a:pt x="3913" y="0"/>
                </a:lnTo>
                <a:lnTo>
                  <a:pt x="3915" y="0"/>
                </a:lnTo>
                <a:close/>
                <a:moveTo>
                  <a:pt x="4071" y="0"/>
                </a:moveTo>
                <a:lnTo>
                  <a:pt x="4071" y="25"/>
                </a:lnTo>
                <a:lnTo>
                  <a:pt x="4070" y="25"/>
                </a:lnTo>
                <a:lnTo>
                  <a:pt x="4070" y="0"/>
                </a:lnTo>
                <a:lnTo>
                  <a:pt x="4071" y="0"/>
                </a:lnTo>
                <a:close/>
                <a:moveTo>
                  <a:pt x="4228" y="0"/>
                </a:moveTo>
                <a:lnTo>
                  <a:pt x="4228" y="25"/>
                </a:lnTo>
                <a:lnTo>
                  <a:pt x="4226" y="25"/>
                </a:lnTo>
                <a:lnTo>
                  <a:pt x="4226" y="0"/>
                </a:lnTo>
                <a:lnTo>
                  <a:pt x="4228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73" name="Rectangle 55"/>
          <p:cNvSpPr>
            <a:spLocks noChangeArrowheads="1"/>
          </p:cNvSpPr>
          <p:nvPr/>
        </p:nvSpPr>
        <p:spPr bwMode="auto">
          <a:xfrm>
            <a:off x="1476129" y="4400919"/>
            <a:ext cx="9938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8</a:t>
            </a:r>
            <a:endParaRPr kumimoji="0" lang="en-US" altLang="en-US" sz="1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074" name="Rectangle 56"/>
          <p:cNvSpPr>
            <a:spLocks noChangeArrowheads="1"/>
          </p:cNvSpPr>
          <p:nvPr/>
        </p:nvSpPr>
        <p:spPr bwMode="auto">
          <a:xfrm>
            <a:off x="1476129" y="3751632"/>
            <a:ext cx="9938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9</a:t>
            </a:r>
            <a:endParaRPr kumimoji="0" lang="en-US" altLang="en-US" sz="1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075" name="Rectangle 57"/>
          <p:cNvSpPr>
            <a:spLocks noChangeArrowheads="1"/>
          </p:cNvSpPr>
          <p:nvPr/>
        </p:nvSpPr>
        <p:spPr bwMode="auto">
          <a:xfrm>
            <a:off x="1404692" y="3102344"/>
            <a:ext cx="19877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0</a:t>
            </a:r>
            <a:endParaRPr kumimoji="0" lang="en-US" altLang="en-US" sz="1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076" name="Rectangle 58"/>
          <p:cNvSpPr>
            <a:spLocks noChangeArrowheads="1"/>
          </p:cNvSpPr>
          <p:nvPr/>
        </p:nvSpPr>
        <p:spPr bwMode="auto">
          <a:xfrm>
            <a:off x="1404692" y="2453057"/>
            <a:ext cx="185435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1</a:t>
            </a:r>
            <a:endParaRPr kumimoji="0" lang="en-US" altLang="en-US" sz="1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077" name="Rectangle 59"/>
          <p:cNvSpPr>
            <a:spLocks noChangeArrowheads="1"/>
          </p:cNvSpPr>
          <p:nvPr/>
        </p:nvSpPr>
        <p:spPr bwMode="auto">
          <a:xfrm>
            <a:off x="1404692" y="1803769"/>
            <a:ext cx="19877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2</a:t>
            </a:r>
            <a:endParaRPr kumimoji="0" lang="en-US" altLang="en-US" sz="1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078" name="Rectangle 60"/>
          <p:cNvSpPr>
            <a:spLocks noChangeArrowheads="1"/>
          </p:cNvSpPr>
          <p:nvPr/>
        </p:nvSpPr>
        <p:spPr bwMode="auto">
          <a:xfrm>
            <a:off x="1404692" y="1154482"/>
            <a:ext cx="19877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3</a:t>
            </a:r>
            <a:endParaRPr kumimoji="0" lang="en-US" altLang="en-US" sz="1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079" name="Rectangle 61"/>
          <p:cNvSpPr>
            <a:spLocks noChangeArrowheads="1"/>
          </p:cNvSpPr>
          <p:nvPr/>
        </p:nvSpPr>
        <p:spPr bwMode="auto">
          <a:xfrm>
            <a:off x="1404692" y="505194"/>
            <a:ext cx="19877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4</a:t>
            </a:r>
            <a:endParaRPr kumimoji="0" lang="en-US" altLang="en-US" sz="1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080" name="Freeform 62"/>
          <p:cNvSpPr>
            <a:spLocks noEditPoints="1"/>
          </p:cNvSpPr>
          <p:nvPr/>
        </p:nvSpPr>
        <p:spPr bwMode="auto">
          <a:xfrm>
            <a:off x="1267003" y="4611475"/>
            <a:ext cx="582612" cy="582612"/>
          </a:xfrm>
          <a:custGeom>
            <a:avLst/>
            <a:gdLst>
              <a:gd name="T0" fmla="*/ 420 w 3055"/>
              <a:gd name="T1" fmla="*/ 2985 h 3059"/>
              <a:gd name="T2" fmla="*/ 14 w 3055"/>
              <a:gd name="T3" fmla="*/ 2855 h 3059"/>
              <a:gd name="T4" fmla="*/ 303 w 3055"/>
              <a:gd name="T5" fmla="*/ 2601 h 3059"/>
              <a:gd name="T6" fmla="*/ 64 w 3055"/>
              <a:gd name="T7" fmla="*/ 2759 h 3059"/>
              <a:gd name="T8" fmla="*/ 305 w 3055"/>
              <a:gd name="T9" fmla="*/ 2991 h 3059"/>
              <a:gd name="T10" fmla="*/ 466 w 3055"/>
              <a:gd name="T11" fmla="*/ 2683 h 3059"/>
              <a:gd name="T12" fmla="*/ 691 w 3055"/>
              <a:gd name="T13" fmla="*/ 2452 h 3059"/>
              <a:gd name="T14" fmla="*/ 592 w 3055"/>
              <a:gd name="T15" fmla="*/ 2746 h 3059"/>
              <a:gd name="T16" fmla="*/ 673 w 3055"/>
              <a:gd name="T17" fmla="*/ 2663 h 3059"/>
              <a:gd name="T18" fmla="*/ 487 w 3055"/>
              <a:gd name="T19" fmla="*/ 2476 h 3059"/>
              <a:gd name="T20" fmla="*/ 625 w 3055"/>
              <a:gd name="T21" fmla="*/ 2280 h 3059"/>
              <a:gd name="T22" fmla="*/ 783 w 3055"/>
              <a:gd name="T23" fmla="*/ 2128 h 3059"/>
              <a:gd name="T24" fmla="*/ 1067 w 3055"/>
              <a:gd name="T25" fmla="*/ 2326 h 3059"/>
              <a:gd name="T26" fmla="*/ 798 w 3055"/>
              <a:gd name="T27" fmla="*/ 2183 h 3059"/>
              <a:gd name="T28" fmla="*/ 910 w 3055"/>
              <a:gd name="T29" fmla="*/ 2483 h 3059"/>
              <a:gd name="T30" fmla="*/ 1197 w 3055"/>
              <a:gd name="T31" fmla="*/ 2202 h 3059"/>
              <a:gd name="T32" fmla="*/ 925 w 3055"/>
              <a:gd name="T33" fmla="*/ 2045 h 3059"/>
              <a:gd name="T34" fmla="*/ 833 w 3055"/>
              <a:gd name="T35" fmla="*/ 1952 h 3059"/>
              <a:gd name="T36" fmla="*/ 1008 w 3055"/>
              <a:gd name="T37" fmla="*/ 1962 h 3059"/>
              <a:gd name="T38" fmla="*/ 1149 w 3055"/>
              <a:gd name="T39" fmla="*/ 2168 h 3059"/>
              <a:gd name="T40" fmla="*/ 1015 w 3055"/>
              <a:gd name="T41" fmla="*/ 1891 h 3059"/>
              <a:gd name="T42" fmla="*/ 1100 w 3055"/>
              <a:gd name="T43" fmla="*/ 1795 h 3059"/>
              <a:gd name="T44" fmla="*/ 1124 w 3055"/>
              <a:gd name="T45" fmla="*/ 1872 h 3059"/>
              <a:gd name="T46" fmla="*/ 1259 w 3055"/>
              <a:gd name="T47" fmla="*/ 2134 h 3059"/>
              <a:gd name="T48" fmla="*/ 1382 w 3055"/>
              <a:gd name="T49" fmla="*/ 1578 h 3059"/>
              <a:gd name="T50" fmla="*/ 1522 w 3055"/>
              <a:gd name="T51" fmla="*/ 1882 h 3059"/>
              <a:gd name="T52" fmla="*/ 1413 w 3055"/>
              <a:gd name="T53" fmla="*/ 1876 h 3059"/>
              <a:gd name="T54" fmla="*/ 1376 w 3055"/>
              <a:gd name="T55" fmla="*/ 1634 h 3059"/>
              <a:gd name="T56" fmla="*/ 1677 w 3055"/>
              <a:gd name="T57" fmla="*/ 1716 h 3059"/>
              <a:gd name="T58" fmla="*/ 1677 w 3055"/>
              <a:gd name="T59" fmla="*/ 1716 h 3059"/>
              <a:gd name="T60" fmla="*/ 1745 w 3055"/>
              <a:gd name="T61" fmla="*/ 1591 h 3059"/>
              <a:gd name="T62" fmla="*/ 1703 w 3055"/>
              <a:gd name="T63" fmla="*/ 1200 h 3059"/>
              <a:gd name="T64" fmla="*/ 1583 w 3055"/>
              <a:gd name="T65" fmla="*/ 1338 h 3059"/>
              <a:gd name="T66" fmla="*/ 1651 w 3055"/>
              <a:gd name="T67" fmla="*/ 1120 h 3059"/>
              <a:gd name="T68" fmla="*/ 1787 w 3055"/>
              <a:gd name="T69" fmla="*/ 1398 h 3059"/>
              <a:gd name="T70" fmla="*/ 1887 w 3055"/>
              <a:gd name="T71" fmla="*/ 928 h 3059"/>
              <a:gd name="T72" fmla="*/ 1887 w 3055"/>
              <a:gd name="T73" fmla="*/ 928 h 3059"/>
              <a:gd name="T74" fmla="*/ 2217 w 3055"/>
              <a:gd name="T75" fmla="*/ 1176 h 3059"/>
              <a:gd name="T76" fmla="*/ 2079 w 3055"/>
              <a:gd name="T77" fmla="*/ 642 h 3059"/>
              <a:gd name="T78" fmla="*/ 2306 w 3055"/>
              <a:gd name="T79" fmla="*/ 609 h 3059"/>
              <a:gd name="T80" fmla="*/ 2333 w 3055"/>
              <a:gd name="T81" fmla="*/ 1060 h 3059"/>
              <a:gd name="T82" fmla="*/ 2289 w 3055"/>
              <a:gd name="T83" fmla="*/ 720 h 3059"/>
              <a:gd name="T84" fmla="*/ 2122 w 3055"/>
              <a:gd name="T85" fmla="*/ 678 h 3059"/>
              <a:gd name="T86" fmla="*/ 2515 w 3055"/>
              <a:gd name="T87" fmla="*/ 655 h 3059"/>
              <a:gd name="T88" fmla="*/ 2729 w 3055"/>
              <a:gd name="T89" fmla="*/ 581 h 3059"/>
              <a:gd name="T90" fmla="*/ 2631 w 3055"/>
              <a:gd name="T91" fmla="*/ 484 h 3059"/>
              <a:gd name="T92" fmla="*/ 2348 w 3055"/>
              <a:gd name="T93" fmla="*/ 546 h 3059"/>
              <a:gd name="T94" fmla="*/ 2452 w 3055"/>
              <a:gd name="T95" fmla="*/ 282 h 3059"/>
              <a:gd name="T96" fmla="*/ 2489 w 3055"/>
              <a:gd name="T97" fmla="*/ 331 h 3059"/>
              <a:gd name="T98" fmla="*/ 2431 w 3055"/>
              <a:gd name="T99" fmla="*/ 517 h 3059"/>
              <a:gd name="T100" fmla="*/ 2757 w 3055"/>
              <a:gd name="T101" fmla="*/ 446 h 3059"/>
              <a:gd name="T102" fmla="*/ 2644 w 3055"/>
              <a:gd name="T103" fmla="*/ 734 h 3059"/>
              <a:gd name="T104" fmla="*/ 3014 w 3055"/>
              <a:gd name="T105" fmla="*/ 379 h 3059"/>
              <a:gd name="T106" fmla="*/ 2678 w 3055"/>
              <a:gd name="T107" fmla="*/ 209 h 3059"/>
              <a:gd name="T108" fmla="*/ 3055 w 3055"/>
              <a:gd name="T109" fmla="*/ 338 h 305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</a:cxnLst>
            <a:rect l="0" t="0" r="r" b="b"/>
            <a:pathLst>
              <a:path w="3055" h="3059">
                <a:moveTo>
                  <a:pt x="391" y="2766"/>
                </a:moveTo>
                <a:lnTo>
                  <a:pt x="446" y="2733"/>
                </a:lnTo>
                <a:cubicBezTo>
                  <a:pt x="474" y="2779"/>
                  <a:pt x="485" y="2824"/>
                  <a:pt x="480" y="2867"/>
                </a:cubicBezTo>
                <a:cubicBezTo>
                  <a:pt x="475" y="2910"/>
                  <a:pt x="455" y="2950"/>
                  <a:pt x="420" y="2985"/>
                </a:cubicBezTo>
                <a:cubicBezTo>
                  <a:pt x="383" y="3021"/>
                  <a:pt x="347" y="3043"/>
                  <a:pt x="309" y="3051"/>
                </a:cubicBezTo>
                <a:cubicBezTo>
                  <a:pt x="272" y="3059"/>
                  <a:pt x="233" y="3055"/>
                  <a:pt x="193" y="3039"/>
                </a:cubicBezTo>
                <a:cubicBezTo>
                  <a:pt x="153" y="3022"/>
                  <a:pt x="117" y="2998"/>
                  <a:pt x="85" y="2966"/>
                </a:cubicBezTo>
                <a:cubicBezTo>
                  <a:pt x="50" y="2931"/>
                  <a:pt x="27" y="2894"/>
                  <a:pt x="14" y="2855"/>
                </a:cubicBezTo>
                <a:cubicBezTo>
                  <a:pt x="1" y="2815"/>
                  <a:pt x="0" y="2776"/>
                  <a:pt x="12" y="2738"/>
                </a:cubicBezTo>
                <a:cubicBezTo>
                  <a:pt x="23" y="2700"/>
                  <a:pt x="43" y="2666"/>
                  <a:pt x="73" y="2636"/>
                </a:cubicBezTo>
                <a:cubicBezTo>
                  <a:pt x="106" y="2603"/>
                  <a:pt x="143" y="2583"/>
                  <a:pt x="183" y="2577"/>
                </a:cubicBezTo>
                <a:cubicBezTo>
                  <a:pt x="223" y="2571"/>
                  <a:pt x="263" y="2579"/>
                  <a:pt x="303" y="2601"/>
                </a:cubicBezTo>
                <a:lnTo>
                  <a:pt x="270" y="2656"/>
                </a:lnTo>
                <a:cubicBezTo>
                  <a:pt x="238" y="2639"/>
                  <a:pt x="209" y="2632"/>
                  <a:pt x="183" y="2636"/>
                </a:cubicBezTo>
                <a:cubicBezTo>
                  <a:pt x="157" y="2640"/>
                  <a:pt x="132" y="2653"/>
                  <a:pt x="110" y="2675"/>
                </a:cubicBezTo>
                <a:cubicBezTo>
                  <a:pt x="84" y="2701"/>
                  <a:pt x="69" y="2729"/>
                  <a:pt x="64" y="2759"/>
                </a:cubicBezTo>
                <a:cubicBezTo>
                  <a:pt x="59" y="2788"/>
                  <a:pt x="63" y="2817"/>
                  <a:pt x="77" y="2845"/>
                </a:cubicBezTo>
                <a:cubicBezTo>
                  <a:pt x="91" y="2873"/>
                  <a:pt x="109" y="2898"/>
                  <a:pt x="131" y="2920"/>
                </a:cubicBezTo>
                <a:cubicBezTo>
                  <a:pt x="160" y="2949"/>
                  <a:pt x="189" y="2969"/>
                  <a:pt x="218" y="2982"/>
                </a:cubicBezTo>
                <a:cubicBezTo>
                  <a:pt x="248" y="2995"/>
                  <a:pt x="277" y="2998"/>
                  <a:pt x="305" y="2991"/>
                </a:cubicBezTo>
                <a:cubicBezTo>
                  <a:pt x="333" y="2984"/>
                  <a:pt x="357" y="2971"/>
                  <a:pt x="378" y="2950"/>
                </a:cubicBezTo>
                <a:cubicBezTo>
                  <a:pt x="403" y="2925"/>
                  <a:pt x="417" y="2897"/>
                  <a:pt x="420" y="2865"/>
                </a:cubicBezTo>
                <a:cubicBezTo>
                  <a:pt x="423" y="2834"/>
                  <a:pt x="413" y="2801"/>
                  <a:pt x="391" y="2766"/>
                </a:cubicBezTo>
                <a:close/>
                <a:moveTo>
                  <a:pt x="466" y="2683"/>
                </a:moveTo>
                <a:cubicBezTo>
                  <a:pt x="421" y="2638"/>
                  <a:pt x="400" y="2592"/>
                  <a:pt x="403" y="2546"/>
                </a:cubicBezTo>
                <a:cubicBezTo>
                  <a:pt x="406" y="2507"/>
                  <a:pt x="423" y="2472"/>
                  <a:pt x="453" y="2442"/>
                </a:cubicBezTo>
                <a:cubicBezTo>
                  <a:pt x="486" y="2409"/>
                  <a:pt x="525" y="2392"/>
                  <a:pt x="568" y="2393"/>
                </a:cubicBezTo>
                <a:cubicBezTo>
                  <a:pt x="611" y="2394"/>
                  <a:pt x="652" y="2413"/>
                  <a:pt x="691" y="2452"/>
                </a:cubicBezTo>
                <a:cubicBezTo>
                  <a:pt x="722" y="2483"/>
                  <a:pt x="742" y="2513"/>
                  <a:pt x="750" y="2540"/>
                </a:cubicBezTo>
                <a:cubicBezTo>
                  <a:pt x="759" y="2567"/>
                  <a:pt x="759" y="2595"/>
                  <a:pt x="751" y="2623"/>
                </a:cubicBezTo>
                <a:cubicBezTo>
                  <a:pt x="743" y="2651"/>
                  <a:pt x="728" y="2675"/>
                  <a:pt x="707" y="2696"/>
                </a:cubicBezTo>
                <a:cubicBezTo>
                  <a:pt x="673" y="2731"/>
                  <a:pt x="635" y="2747"/>
                  <a:pt x="592" y="2746"/>
                </a:cubicBezTo>
                <a:cubicBezTo>
                  <a:pt x="549" y="2746"/>
                  <a:pt x="507" y="2725"/>
                  <a:pt x="466" y="2683"/>
                </a:cubicBezTo>
                <a:close/>
                <a:moveTo>
                  <a:pt x="508" y="2641"/>
                </a:moveTo>
                <a:cubicBezTo>
                  <a:pt x="539" y="2672"/>
                  <a:pt x="570" y="2689"/>
                  <a:pt x="599" y="2691"/>
                </a:cubicBezTo>
                <a:cubicBezTo>
                  <a:pt x="628" y="2693"/>
                  <a:pt x="653" y="2683"/>
                  <a:pt x="673" y="2663"/>
                </a:cubicBezTo>
                <a:cubicBezTo>
                  <a:pt x="694" y="2642"/>
                  <a:pt x="703" y="2617"/>
                  <a:pt x="701" y="2588"/>
                </a:cubicBezTo>
                <a:cubicBezTo>
                  <a:pt x="699" y="2559"/>
                  <a:pt x="682" y="2528"/>
                  <a:pt x="650" y="2496"/>
                </a:cubicBezTo>
                <a:cubicBezTo>
                  <a:pt x="620" y="2466"/>
                  <a:pt x="590" y="2450"/>
                  <a:pt x="561" y="2448"/>
                </a:cubicBezTo>
                <a:cubicBezTo>
                  <a:pt x="532" y="2447"/>
                  <a:pt x="507" y="2456"/>
                  <a:pt x="487" y="2476"/>
                </a:cubicBezTo>
                <a:cubicBezTo>
                  <a:pt x="466" y="2497"/>
                  <a:pt x="457" y="2522"/>
                  <a:pt x="459" y="2551"/>
                </a:cubicBezTo>
                <a:cubicBezTo>
                  <a:pt x="461" y="2580"/>
                  <a:pt x="477" y="2610"/>
                  <a:pt x="508" y="2641"/>
                </a:cubicBezTo>
                <a:close/>
                <a:moveTo>
                  <a:pt x="869" y="2524"/>
                </a:moveTo>
                <a:lnTo>
                  <a:pt x="625" y="2280"/>
                </a:lnTo>
                <a:lnTo>
                  <a:pt x="662" y="2243"/>
                </a:lnTo>
                <a:lnTo>
                  <a:pt x="697" y="2278"/>
                </a:lnTo>
                <a:cubicBezTo>
                  <a:pt x="688" y="2233"/>
                  <a:pt x="701" y="2194"/>
                  <a:pt x="734" y="2160"/>
                </a:cubicBezTo>
                <a:cubicBezTo>
                  <a:pt x="749" y="2146"/>
                  <a:pt x="765" y="2135"/>
                  <a:pt x="783" y="2128"/>
                </a:cubicBezTo>
                <a:cubicBezTo>
                  <a:pt x="800" y="2121"/>
                  <a:pt x="817" y="2118"/>
                  <a:pt x="831" y="2121"/>
                </a:cubicBezTo>
                <a:cubicBezTo>
                  <a:pt x="846" y="2123"/>
                  <a:pt x="860" y="2129"/>
                  <a:pt x="875" y="2139"/>
                </a:cubicBezTo>
                <a:cubicBezTo>
                  <a:pt x="884" y="2145"/>
                  <a:pt x="898" y="2157"/>
                  <a:pt x="917" y="2176"/>
                </a:cubicBezTo>
                <a:lnTo>
                  <a:pt x="1067" y="2326"/>
                </a:lnTo>
                <a:lnTo>
                  <a:pt x="1025" y="2367"/>
                </a:lnTo>
                <a:lnTo>
                  <a:pt x="877" y="2219"/>
                </a:lnTo>
                <a:cubicBezTo>
                  <a:pt x="860" y="2202"/>
                  <a:pt x="846" y="2191"/>
                  <a:pt x="835" y="2186"/>
                </a:cubicBezTo>
                <a:cubicBezTo>
                  <a:pt x="823" y="2181"/>
                  <a:pt x="811" y="2180"/>
                  <a:pt x="798" y="2183"/>
                </a:cubicBezTo>
                <a:cubicBezTo>
                  <a:pt x="785" y="2187"/>
                  <a:pt x="773" y="2194"/>
                  <a:pt x="762" y="2205"/>
                </a:cubicBezTo>
                <a:cubicBezTo>
                  <a:pt x="744" y="2222"/>
                  <a:pt x="734" y="2243"/>
                  <a:pt x="733" y="2267"/>
                </a:cubicBezTo>
                <a:cubicBezTo>
                  <a:pt x="731" y="2291"/>
                  <a:pt x="746" y="2318"/>
                  <a:pt x="777" y="2350"/>
                </a:cubicBezTo>
                <a:lnTo>
                  <a:pt x="910" y="2483"/>
                </a:lnTo>
                <a:lnTo>
                  <a:pt x="869" y="2524"/>
                </a:lnTo>
                <a:close/>
                <a:moveTo>
                  <a:pt x="1182" y="2137"/>
                </a:moveTo>
                <a:lnTo>
                  <a:pt x="1225" y="2167"/>
                </a:lnTo>
                <a:cubicBezTo>
                  <a:pt x="1215" y="2181"/>
                  <a:pt x="1206" y="2193"/>
                  <a:pt x="1197" y="2202"/>
                </a:cubicBezTo>
                <a:cubicBezTo>
                  <a:pt x="1182" y="2217"/>
                  <a:pt x="1168" y="2226"/>
                  <a:pt x="1155" y="2230"/>
                </a:cubicBezTo>
                <a:cubicBezTo>
                  <a:pt x="1142" y="2233"/>
                  <a:pt x="1130" y="2233"/>
                  <a:pt x="1119" y="2229"/>
                </a:cubicBezTo>
                <a:cubicBezTo>
                  <a:pt x="1108" y="2224"/>
                  <a:pt x="1090" y="2210"/>
                  <a:pt x="1065" y="2185"/>
                </a:cubicBezTo>
                <a:lnTo>
                  <a:pt x="925" y="2045"/>
                </a:lnTo>
                <a:lnTo>
                  <a:pt x="895" y="2075"/>
                </a:lnTo>
                <a:lnTo>
                  <a:pt x="863" y="2043"/>
                </a:lnTo>
                <a:lnTo>
                  <a:pt x="893" y="2013"/>
                </a:lnTo>
                <a:lnTo>
                  <a:pt x="833" y="1952"/>
                </a:lnTo>
                <a:lnTo>
                  <a:pt x="849" y="1887"/>
                </a:lnTo>
                <a:lnTo>
                  <a:pt x="934" y="1972"/>
                </a:lnTo>
                <a:lnTo>
                  <a:pt x="976" y="1930"/>
                </a:lnTo>
                <a:lnTo>
                  <a:pt x="1008" y="1962"/>
                </a:lnTo>
                <a:lnTo>
                  <a:pt x="966" y="2004"/>
                </a:lnTo>
                <a:lnTo>
                  <a:pt x="1109" y="2146"/>
                </a:lnTo>
                <a:cubicBezTo>
                  <a:pt x="1120" y="2158"/>
                  <a:pt x="1129" y="2165"/>
                  <a:pt x="1133" y="2167"/>
                </a:cubicBezTo>
                <a:cubicBezTo>
                  <a:pt x="1138" y="2169"/>
                  <a:pt x="1143" y="2169"/>
                  <a:pt x="1149" y="2168"/>
                </a:cubicBezTo>
                <a:cubicBezTo>
                  <a:pt x="1154" y="2166"/>
                  <a:pt x="1160" y="2163"/>
                  <a:pt x="1166" y="2156"/>
                </a:cubicBezTo>
                <a:cubicBezTo>
                  <a:pt x="1170" y="2152"/>
                  <a:pt x="1176" y="2145"/>
                  <a:pt x="1182" y="2137"/>
                </a:cubicBezTo>
                <a:close/>
                <a:moveTo>
                  <a:pt x="1259" y="2134"/>
                </a:moveTo>
                <a:lnTo>
                  <a:pt x="1015" y="1891"/>
                </a:lnTo>
                <a:lnTo>
                  <a:pt x="1052" y="1853"/>
                </a:lnTo>
                <a:lnTo>
                  <a:pt x="1089" y="1890"/>
                </a:lnTo>
                <a:cubicBezTo>
                  <a:pt x="1081" y="1864"/>
                  <a:pt x="1079" y="1843"/>
                  <a:pt x="1081" y="1830"/>
                </a:cubicBezTo>
                <a:cubicBezTo>
                  <a:pt x="1084" y="1816"/>
                  <a:pt x="1090" y="1805"/>
                  <a:pt x="1100" y="1795"/>
                </a:cubicBezTo>
                <a:cubicBezTo>
                  <a:pt x="1113" y="1781"/>
                  <a:pt x="1132" y="1772"/>
                  <a:pt x="1155" y="1766"/>
                </a:cubicBezTo>
                <a:lnTo>
                  <a:pt x="1179" y="1819"/>
                </a:lnTo>
                <a:cubicBezTo>
                  <a:pt x="1163" y="1823"/>
                  <a:pt x="1150" y="1830"/>
                  <a:pt x="1140" y="1840"/>
                </a:cubicBezTo>
                <a:cubicBezTo>
                  <a:pt x="1131" y="1849"/>
                  <a:pt x="1126" y="1860"/>
                  <a:pt x="1124" y="1872"/>
                </a:cubicBezTo>
                <a:cubicBezTo>
                  <a:pt x="1122" y="1885"/>
                  <a:pt x="1125" y="1898"/>
                  <a:pt x="1131" y="1910"/>
                </a:cubicBezTo>
                <a:cubicBezTo>
                  <a:pt x="1141" y="1930"/>
                  <a:pt x="1155" y="1948"/>
                  <a:pt x="1172" y="1965"/>
                </a:cubicBezTo>
                <a:lnTo>
                  <a:pt x="1300" y="2093"/>
                </a:lnTo>
                <a:lnTo>
                  <a:pt x="1259" y="2134"/>
                </a:lnTo>
                <a:close/>
                <a:moveTo>
                  <a:pt x="1280" y="1869"/>
                </a:moveTo>
                <a:cubicBezTo>
                  <a:pt x="1235" y="1824"/>
                  <a:pt x="1214" y="1778"/>
                  <a:pt x="1218" y="1731"/>
                </a:cubicBezTo>
                <a:cubicBezTo>
                  <a:pt x="1221" y="1692"/>
                  <a:pt x="1237" y="1658"/>
                  <a:pt x="1267" y="1627"/>
                </a:cubicBezTo>
                <a:cubicBezTo>
                  <a:pt x="1301" y="1594"/>
                  <a:pt x="1339" y="1578"/>
                  <a:pt x="1382" y="1578"/>
                </a:cubicBezTo>
                <a:cubicBezTo>
                  <a:pt x="1426" y="1579"/>
                  <a:pt x="1466" y="1599"/>
                  <a:pt x="1505" y="1637"/>
                </a:cubicBezTo>
                <a:cubicBezTo>
                  <a:pt x="1536" y="1669"/>
                  <a:pt x="1556" y="1698"/>
                  <a:pt x="1565" y="1725"/>
                </a:cubicBezTo>
                <a:cubicBezTo>
                  <a:pt x="1573" y="1753"/>
                  <a:pt x="1574" y="1780"/>
                  <a:pt x="1566" y="1808"/>
                </a:cubicBezTo>
                <a:cubicBezTo>
                  <a:pt x="1558" y="1836"/>
                  <a:pt x="1543" y="1861"/>
                  <a:pt x="1522" y="1882"/>
                </a:cubicBezTo>
                <a:cubicBezTo>
                  <a:pt x="1488" y="1916"/>
                  <a:pt x="1449" y="1933"/>
                  <a:pt x="1406" y="1932"/>
                </a:cubicBezTo>
                <a:cubicBezTo>
                  <a:pt x="1364" y="1931"/>
                  <a:pt x="1322" y="1910"/>
                  <a:pt x="1280" y="1869"/>
                </a:cubicBezTo>
                <a:close/>
                <a:moveTo>
                  <a:pt x="1323" y="1826"/>
                </a:moveTo>
                <a:cubicBezTo>
                  <a:pt x="1354" y="1858"/>
                  <a:pt x="1384" y="1874"/>
                  <a:pt x="1413" y="1876"/>
                </a:cubicBezTo>
                <a:cubicBezTo>
                  <a:pt x="1442" y="1878"/>
                  <a:pt x="1467" y="1869"/>
                  <a:pt x="1488" y="1848"/>
                </a:cubicBezTo>
                <a:cubicBezTo>
                  <a:pt x="1508" y="1827"/>
                  <a:pt x="1518" y="1803"/>
                  <a:pt x="1516" y="1773"/>
                </a:cubicBezTo>
                <a:cubicBezTo>
                  <a:pt x="1514" y="1744"/>
                  <a:pt x="1497" y="1714"/>
                  <a:pt x="1465" y="1682"/>
                </a:cubicBezTo>
                <a:cubicBezTo>
                  <a:pt x="1435" y="1652"/>
                  <a:pt x="1405" y="1636"/>
                  <a:pt x="1376" y="1634"/>
                </a:cubicBezTo>
                <a:cubicBezTo>
                  <a:pt x="1347" y="1632"/>
                  <a:pt x="1322" y="1641"/>
                  <a:pt x="1302" y="1662"/>
                </a:cubicBezTo>
                <a:cubicBezTo>
                  <a:pt x="1281" y="1682"/>
                  <a:pt x="1271" y="1707"/>
                  <a:pt x="1273" y="1736"/>
                </a:cubicBezTo>
                <a:cubicBezTo>
                  <a:pt x="1275" y="1765"/>
                  <a:pt x="1292" y="1795"/>
                  <a:pt x="1323" y="1826"/>
                </a:cubicBezTo>
                <a:close/>
                <a:moveTo>
                  <a:pt x="1677" y="1716"/>
                </a:moveTo>
                <a:lnTo>
                  <a:pt x="1341" y="1380"/>
                </a:lnTo>
                <a:lnTo>
                  <a:pt x="1382" y="1339"/>
                </a:lnTo>
                <a:lnTo>
                  <a:pt x="1718" y="1675"/>
                </a:lnTo>
                <a:lnTo>
                  <a:pt x="1677" y="1716"/>
                </a:lnTo>
                <a:close/>
                <a:moveTo>
                  <a:pt x="1951" y="1362"/>
                </a:moveTo>
                <a:lnTo>
                  <a:pt x="1991" y="1402"/>
                </a:lnTo>
                <a:lnTo>
                  <a:pt x="1768" y="1624"/>
                </a:lnTo>
                <a:cubicBezTo>
                  <a:pt x="1758" y="1615"/>
                  <a:pt x="1750" y="1603"/>
                  <a:pt x="1745" y="1591"/>
                </a:cubicBezTo>
                <a:cubicBezTo>
                  <a:pt x="1735" y="1570"/>
                  <a:pt x="1729" y="1546"/>
                  <a:pt x="1727" y="1519"/>
                </a:cubicBezTo>
                <a:cubicBezTo>
                  <a:pt x="1725" y="1492"/>
                  <a:pt x="1726" y="1457"/>
                  <a:pt x="1730" y="1414"/>
                </a:cubicBezTo>
                <a:cubicBezTo>
                  <a:pt x="1737" y="1348"/>
                  <a:pt x="1738" y="1299"/>
                  <a:pt x="1733" y="1269"/>
                </a:cubicBezTo>
                <a:cubicBezTo>
                  <a:pt x="1728" y="1238"/>
                  <a:pt x="1718" y="1215"/>
                  <a:pt x="1703" y="1200"/>
                </a:cubicBezTo>
                <a:cubicBezTo>
                  <a:pt x="1686" y="1184"/>
                  <a:pt x="1667" y="1176"/>
                  <a:pt x="1644" y="1176"/>
                </a:cubicBezTo>
                <a:cubicBezTo>
                  <a:pt x="1621" y="1176"/>
                  <a:pt x="1600" y="1186"/>
                  <a:pt x="1581" y="1205"/>
                </a:cubicBezTo>
                <a:cubicBezTo>
                  <a:pt x="1561" y="1225"/>
                  <a:pt x="1551" y="1247"/>
                  <a:pt x="1551" y="1270"/>
                </a:cubicBezTo>
                <a:cubicBezTo>
                  <a:pt x="1551" y="1294"/>
                  <a:pt x="1562" y="1317"/>
                  <a:pt x="1583" y="1338"/>
                </a:cubicBezTo>
                <a:lnTo>
                  <a:pt x="1536" y="1376"/>
                </a:lnTo>
                <a:cubicBezTo>
                  <a:pt x="1507" y="1342"/>
                  <a:pt x="1494" y="1307"/>
                  <a:pt x="1496" y="1271"/>
                </a:cubicBezTo>
                <a:cubicBezTo>
                  <a:pt x="1499" y="1236"/>
                  <a:pt x="1516" y="1202"/>
                  <a:pt x="1548" y="1170"/>
                </a:cubicBezTo>
                <a:cubicBezTo>
                  <a:pt x="1580" y="1138"/>
                  <a:pt x="1615" y="1121"/>
                  <a:pt x="1651" y="1120"/>
                </a:cubicBezTo>
                <a:cubicBezTo>
                  <a:pt x="1688" y="1119"/>
                  <a:pt x="1720" y="1132"/>
                  <a:pt x="1746" y="1158"/>
                </a:cubicBezTo>
                <a:cubicBezTo>
                  <a:pt x="1759" y="1172"/>
                  <a:pt x="1770" y="1188"/>
                  <a:pt x="1777" y="1206"/>
                </a:cubicBezTo>
                <a:cubicBezTo>
                  <a:pt x="1785" y="1225"/>
                  <a:pt x="1789" y="1248"/>
                  <a:pt x="1791" y="1275"/>
                </a:cubicBezTo>
                <a:cubicBezTo>
                  <a:pt x="1793" y="1302"/>
                  <a:pt x="1791" y="1343"/>
                  <a:pt x="1787" y="1398"/>
                </a:cubicBezTo>
                <a:cubicBezTo>
                  <a:pt x="1783" y="1443"/>
                  <a:pt x="1781" y="1473"/>
                  <a:pt x="1781" y="1487"/>
                </a:cubicBezTo>
                <a:cubicBezTo>
                  <a:pt x="1782" y="1502"/>
                  <a:pt x="1783" y="1515"/>
                  <a:pt x="1786" y="1527"/>
                </a:cubicBezTo>
                <a:lnTo>
                  <a:pt x="1951" y="1362"/>
                </a:lnTo>
                <a:close/>
                <a:moveTo>
                  <a:pt x="1887" y="928"/>
                </a:moveTo>
                <a:lnTo>
                  <a:pt x="1840" y="881"/>
                </a:lnTo>
                <a:lnTo>
                  <a:pt x="1881" y="840"/>
                </a:lnTo>
                <a:lnTo>
                  <a:pt x="1928" y="887"/>
                </a:lnTo>
                <a:lnTo>
                  <a:pt x="1887" y="928"/>
                </a:lnTo>
                <a:close/>
                <a:moveTo>
                  <a:pt x="2176" y="1217"/>
                </a:moveTo>
                <a:lnTo>
                  <a:pt x="1932" y="973"/>
                </a:lnTo>
                <a:lnTo>
                  <a:pt x="1974" y="932"/>
                </a:lnTo>
                <a:lnTo>
                  <a:pt x="2217" y="1176"/>
                </a:lnTo>
                <a:lnTo>
                  <a:pt x="2176" y="1217"/>
                </a:lnTo>
                <a:close/>
                <a:moveTo>
                  <a:pt x="2288" y="1104"/>
                </a:moveTo>
                <a:lnTo>
                  <a:pt x="1952" y="768"/>
                </a:lnTo>
                <a:lnTo>
                  <a:pt x="2079" y="642"/>
                </a:lnTo>
                <a:cubicBezTo>
                  <a:pt x="2101" y="619"/>
                  <a:pt x="2119" y="603"/>
                  <a:pt x="2133" y="594"/>
                </a:cubicBezTo>
                <a:cubicBezTo>
                  <a:pt x="2153" y="580"/>
                  <a:pt x="2172" y="571"/>
                  <a:pt x="2191" y="568"/>
                </a:cubicBezTo>
                <a:cubicBezTo>
                  <a:pt x="2209" y="564"/>
                  <a:pt x="2229" y="566"/>
                  <a:pt x="2250" y="573"/>
                </a:cubicBezTo>
                <a:cubicBezTo>
                  <a:pt x="2271" y="580"/>
                  <a:pt x="2289" y="592"/>
                  <a:pt x="2306" y="609"/>
                </a:cubicBezTo>
                <a:cubicBezTo>
                  <a:pt x="2335" y="638"/>
                  <a:pt x="2350" y="671"/>
                  <a:pt x="2351" y="709"/>
                </a:cubicBezTo>
                <a:cubicBezTo>
                  <a:pt x="2353" y="747"/>
                  <a:pt x="2330" y="790"/>
                  <a:pt x="2282" y="837"/>
                </a:cubicBezTo>
                <a:lnTo>
                  <a:pt x="2196" y="923"/>
                </a:lnTo>
                <a:lnTo>
                  <a:pt x="2333" y="1060"/>
                </a:lnTo>
                <a:lnTo>
                  <a:pt x="2288" y="1104"/>
                </a:lnTo>
                <a:close/>
                <a:moveTo>
                  <a:pt x="2156" y="884"/>
                </a:moveTo>
                <a:lnTo>
                  <a:pt x="2243" y="797"/>
                </a:lnTo>
                <a:cubicBezTo>
                  <a:pt x="2272" y="768"/>
                  <a:pt x="2287" y="742"/>
                  <a:pt x="2289" y="720"/>
                </a:cubicBezTo>
                <a:cubicBezTo>
                  <a:pt x="2290" y="697"/>
                  <a:pt x="2281" y="676"/>
                  <a:pt x="2261" y="656"/>
                </a:cubicBezTo>
                <a:cubicBezTo>
                  <a:pt x="2247" y="642"/>
                  <a:pt x="2232" y="634"/>
                  <a:pt x="2215" y="631"/>
                </a:cubicBezTo>
                <a:cubicBezTo>
                  <a:pt x="2198" y="628"/>
                  <a:pt x="2182" y="631"/>
                  <a:pt x="2167" y="639"/>
                </a:cubicBezTo>
                <a:cubicBezTo>
                  <a:pt x="2157" y="645"/>
                  <a:pt x="2142" y="657"/>
                  <a:pt x="2122" y="678"/>
                </a:cubicBezTo>
                <a:lnTo>
                  <a:pt x="2036" y="764"/>
                </a:lnTo>
                <a:lnTo>
                  <a:pt x="2156" y="884"/>
                </a:lnTo>
                <a:close/>
                <a:moveTo>
                  <a:pt x="2476" y="700"/>
                </a:moveTo>
                <a:lnTo>
                  <a:pt x="2515" y="655"/>
                </a:lnTo>
                <a:cubicBezTo>
                  <a:pt x="2533" y="670"/>
                  <a:pt x="2552" y="679"/>
                  <a:pt x="2570" y="682"/>
                </a:cubicBezTo>
                <a:cubicBezTo>
                  <a:pt x="2588" y="686"/>
                  <a:pt x="2608" y="683"/>
                  <a:pt x="2630" y="675"/>
                </a:cubicBezTo>
                <a:cubicBezTo>
                  <a:pt x="2652" y="666"/>
                  <a:pt x="2672" y="652"/>
                  <a:pt x="2691" y="633"/>
                </a:cubicBezTo>
                <a:cubicBezTo>
                  <a:pt x="2708" y="616"/>
                  <a:pt x="2721" y="599"/>
                  <a:pt x="2729" y="581"/>
                </a:cubicBezTo>
                <a:cubicBezTo>
                  <a:pt x="2737" y="563"/>
                  <a:pt x="2739" y="546"/>
                  <a:pt x="2737" y="531"/>
                </a:cubicBezTo>
                <a:cubicBezTo>
                  <a:pt x="2735" y="516"/>
                  <a:pt x="2728" y="503"/>
                  <a:pt x="2718" y="493"/>
                </a:cubicBezTo>
                <a:cubicBezTo>
                  <a:pt x="2707" y="482"/>
                  <a:pt x="2695" y="476"/>
                  <a:pt x="2681" y="474"/>
                </a:cubicBezTo>
                <a:cubicBezTo>
                  <a:pt x="2667" y="472"/>
                  <a:pt x="2650" y="476"/>
                  <a:pt x="2631" y="484"/>
                </a:cubicBezTo>
                <a:cubicBezTo>
                  <a:pt x="2618" y="490"/>
                  <a:pt x="2593" y="504"/>
                  <a:pt x="2555" y="528"/>
                </a:cubicBezTo>
                <a:cubicBezTo>
                  <a:pt x="2516" y="551"/>
                  <a:pt x="2488" y="566"/>
                  <a:pt x="2469" y="572"/>
                </a:cubicBezTo>
                <a:cubicBezTo>
                  <a:pt x="2444" y="579"/>
                  <a:pt x="2422" y="581"/>
                  <a:pt x="2402" y="576"/>
                </a:cubicBezTo>
                <a:cubicBezTo>
                  <a:pt x="2381" y="572"/>
                  <a:pt x="2363" y="562"/>
                  <a:pt x="2348" y="546"/>
                </a:cubicBezTo>
                <a:cubicBezTo>
                  <a:pt x="2331" y="529"/>
                  <a:pt x="2320" y="509"/>
                  <a:pt x="2315" y="484"/>
                </a:cubicBezTo>
                <a:cubicBezTo>
                  <a:pt x="2310" y="460"/>
                  <a:pt x="2313" y="435"/>
                  <a:pt x="2323" y="409"/>
                </a:cubicBezTo>
                <a:cubicBezTo>
                  <a:pt x="2334" y="382"/>
                  <a:pt x="2351" y="358"/>
                  <a:pt x="2374" y="335"/>
                </a:cubicBezTo>
                <a:cubicBezTo>
                  <a:pt x="2399" y="311"/>
                  <a:pt x="2425" y="293"/>
                  <a:pt x="2452" y="282"/>
                </a:cubicBezTo>
                <a:cubicBezTo>
                  <a:pt x="2479" y="271"/>
                  <a:pt x="2505" y="268"/>
                  <a:pt x="2531" y="273"/>
                </a:cubicBezTo>
                <a:cubicBezTo>
                  <a:pt x="2557" y="278"/>
                  <a:pt x="2580" y="291"/>
                  <a:pt x="2600" y="310"/>
                </a:cubicBezTo>
                <a:lnTo>
                  <a:pt x="2561" y="355"/>
                </a:lnTo>
                <a:cubicBezTo>
                  <a:pt x="2537" y="336"/>
                  <a:pt x="2514" y="328"/>
                  <a:pt x="2489" y="331"/>
                </a:cubicBezTo>
                <a:cubicBezTo>
                  <a:pt x="2465" y="333"/>
                  <a:pt x="2440" y="347"/>
                  <a:pt x="2415" y="373"/>
                </a:cubicBezTo>
                <a:cubicBezTo>
                  <a:pt x="2388" y="400"/>
                  <a:pt x="2373" y="424"/>
                  <a:pt x="2371" y="446"/>
                </a:cubicBezTo>
                <a:cubicBezTo>
                  <a:pt x="2368" y="469"/>
                  <a:pt x="2374" y="487"/>
                  <a:pt x="2388" y="501"/>
                </a:cubicBezTo>
                <a:cubicBezTo>
                  <a:pt x="2400" y="513"/>
                  <a:pt x="2414" y="518"/>
                  <a:pt x="2431" y="517"/>
                </a:cubicBezTo>
                <a:cubicBezTo>
                  <a:pt x="2447" y="517"/>
                  <a:pt x="2477" y="502"/>
                  <a:pt x="2522" y="474"/>
                </a:cubicBezTo>
                <a:cubicBezTo>
                  <a:pt x="2566" y="446"/>
                  <a:pt x="2598" y="429"/>
                  <a:pt x="2618" y="421"/>
                </a:cubicBezTo>
                <a:cubicBezTo>
                  <a:pt x="2646" y="411"/>
                  <a:pt x="2672" y="408"/>
                  <a:pt x="2695" y="412"/>
                </a:cubicBezTo>
                <a:cubicBezTo>
                  <a:pt x="2718" y="417"/>
                  <a:pt x="2739" y="428"/>
                  <a:pt x="2757" y="446"/>
                </a:cubicBezTo>
                <a:cubicBezTo>
                  <a:pt x="2775" y="464"/>
                  <a:pt x="2787" y="486"/>
                  <a:pt x="2792" y="512"/>
                </a:cubicBezTo>
                <a:cubicBezTo>
                  <a:pt x="2798" y="538"/>
                  <a:pt x="2795" y="565"/>
                  <a:pt x="2785" y="593"/>
                </a:cubicBezTo>
                <a:cubicBezTo>
                  <a:pt x="2775" y="621"/>
                  <a:pt x="2757" y="647"/>
                  <a:pt x="2733" y="671"/>
                </a:cubicBezTo>
                <a:cubicBezTo>
                  <a:pt x="2703" y="701"/>
                  <a:pt x="2673" y="722"/>
                  <a:pt x="2644" y="734"/>
                </a:cubicBezTo>
                <a:cubicBezTo>
                  <a:pt x="2614" y="746"/>
                  <a:pt x="2585" y="749"/>
                  <a:pt x="2555" y="742"/>
                </a:cubicBezTo>
                <a:cubicBezTo>
                  <a:pt x="2526" y="736"/>
                  <a:pt x="2499" y="722"/>
                  <a:pt x="2476" y="700"/>
                </a:cubicBezTo>
                <a:close/>
                <a:moveTo>
                  <a:pt x="3055" y="338"/>
                </a:moveTo>
                <a:lnTo>
                  <a:pt x="3014" y="379"/>
                </a:lnTo>
                <a:lnTo>
                  <a:pt x="2751" y="116"/>
                </a:lnTo>
                <a:cubicBezTo>
                  <a:pt x="2750" y="136"/>
                  <a:pt x="2747" y="158"/>
                  <a:pt x="2740" y="184"/>
                </a:cubicBezTo>
                <a:cubicBezTo>
                  <a:pt x="2733" y="209"/>
                  <a:pt x="2726" y="231"/>
                  <a:pt x="2718" y="248"/>
                </a:cubicBezTo>
                <a:lnTo>
                  <a:pt x="2678" y="209"/>
                </a:lnTo>
                <a:cubicBezTo>
                  <a:pt x="2690" y="175"/>
                  <a:pt x="2697" y="141"/>
                  <a:pt x="2699" y="109"/>
                </a:cubicBezTo>
                <a:cubicBezTo>
                  <a:pt x="2701" y="76"/>
                  <a:pt x="2698" y="49"/>
                  <a:pt x="2691" y="27"/>
                </a:cubicBezTo>
                <a:lnTo>
                  <a:pt x="2717" y="0"/>
                </a:lnTo>
                <a:lnTo>
                  <a:pt x="3055" y="338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81" name="Freeform 63"/>
          <p:cNvSpPr>
            <a:spLocks noEditPoints="1"/>
          </p:cNvSpPr>
          <p:nvPr/>
        </p:nvSpPr>
        <p:spPr bwMode="auto">
          <a:xfrm>
            <a:off x="1516240" y="4611475"/>
            <a:ext cx="593725" cy="582612"/>
          </a:xfrm>
          <a:custGeom>
            <a:avLst/>
            <a:gdLst>
              <a:gd name="T0" fmla="*/ 419 w 3116"/>
              <a:gd name="T1" fmla="*/ 2992 h 3066"/>
              <a:gd name="T2" fmla="*/ 13 w 3116"/>
              <a:gd name="T3" fmla="*/ 2862 h 3066"/>
              <a:gd name="T4" fmla="*/ 303 w 3116"/>
              <a:gd name="T5" fmla="*/ 2608 h 3066"/>
              <a:gd name="T6" fmla="*/ 63 w 3116"/>
              <a:gd name="T7" fmla="*/ 2766 h 3066"/>
              <a:gd name="T8" fmla="*/ 304 w 3116"/>
              <a:gd name="T9" fmla="*/ 2998 h 3066"/>
              <a:gd name="T10" fmla="*/ 465 w 3116"/>
              <a:gd name="T11" fmla="*/ 2690 h 3066"/>
              <a:gd name="T12" fmla="*/ 690 w 3116"/>
              <a:gd name="T13" fmla="*/ 2459 h 3066"/>
              <a:gd name="T14" fmla="*/ 591 w 3116"/>
              <a:gd name="T15" fmla="*/ 2753 h 3066"/>
              <a:gd name="T16" fmla="*/ 673 w 3116"/>
              <a:gd name="T17" fmla="*/ 2670 h 3066"/>
              <a:gd name="T18" fmla="*/ 486 w 3116"/>
              <a:gd name="T19" fmla="*/ 2483 h 3066"/>
              <a:gd name="T20" fmla="*/ 625 w 3116"/>
              <a:gd name="T21" fmla="*/ 2287 h 3066"/>
              <a:gd name="T22" fmla="*/ 782 w 3116"/>
              <a:gd name="T23" fmla="*/ 2135 h 3066"/>
              <a:gd name="T24" fmla="*/ 1066 w 3116"/>
              <a:gd name="T25" fmla="*/ 2333 h 3066"/>
              <a:gd name="T26" fmla="*/ 797 w 3116"/>
              <a:gd name="T27" fmla="*/ 2190 h 3066"/>
              <a:gd name="T28" fmla="*/ 909 w 3116"/>
              <a:gd name="T29" fmla="*/ 2490 h 3066"/>
              <a:gd name="T30" fmla="*/ 1197 w 3116"/>
              <a:gd name="T31" fmla="*/ 2209 h 3066"/>
              <a:gd name="T32" fmla="*/ 925 w 3116"/>
              <a:gd name="T33" fmla="*/ 2052 h 3066"/>
              <a:gd name="T34" fmla="*/ 832 w 3116"/>
              <a:gd name="T35" fmla="*/ 1959 h 3066"/>
              <a:gd name="T36" fmla="*/ 1007 w 3116"/>
              <a:gd name="T37" fmla="*/ 1969 h 3066"/>
              <a:gd name="T38" fmla="*/ 1148 w 3116"/>
              <a:gd name="T39" fmla="*/ 2175 h 3066"/>
              <a:gd name="T40" fmla="*/ 1015 w 3116"/>
              <a:gd name="T41" fmla="*/ 1898 h 3066"/>
              <a:gd name="T42" fmla="*/ 1099 w 3116"/>
              <a:gd name="T43" fmla="*/ 1802 h 3066"/>
              <a:gd name="T44" fmla="*/ 1123 w 3116"/>
              <a:gd name="T45" fmla="*/ 1879 h 3066"/>
              <a:gd name="T46" fmla="*/ 1258 w 3116"/>
              <a:gd name="T47" fmla="*/ 2141 h 3066"/>
              <a:gd name="T48" fmla="*/ 1382 w 3116"/>
              <a:gd name="T49" fmla="*/ 1585 h 3066"/>
              <a:gd name="T50" fmla="*/ 1521 w 3116"/>
              <a:gd name="T51" fmla="*/ 1889 h 3066"/>
              <a:gd name="T52" fmla="*/ 1413 w 3116"/>
              <a:gd name="T53" fmla="*/ 1883 h 3066"/>
              <a:gd name="T54" fmla="*/ 1375 w 3116"/>
              <a:gd name="T55" fmla="*/ 1641 h 3066"/>
              <a:gd name="T56" fmla="*/ 1676 w 3116"/>
              <a:gd name="T57" fmla="*/ 1723 h 3066"/>
              <a:gd name="T58" fmla="*/ 1676 w 3116"/>
              <a:gd name="T59" fmla="*/ 1723 h 3066"/>
              <a:gd name="T60" fmla="*/ 1744 w 3116"/>
              <a:gd name="T61" fmla="*/ 1598 h 3066"/>
              <a:gd name="T62" fmla="*/ 1702 w 3116"/>
              <a:gd name="T63" fmla="*/ 1207 h 3066"/>
              <a:gd name="T64" fmla="*/ 1582 w 3116"/>
              <a:gd name="T65" fmla="*/ 1345 h 3066"/>
              <a:gd name="T66" fmla="*/ 1651 w 3116"/>
              <a:gd name="T67" fmla="*/ 1127 h 3066"/>
              <a:gd name="T68" fmla="*/ 1786 w 3116"/>
              <a:gd name="T69" fmla="*/ 1405 h 3066"/>
              <a:gd name="T70" fmla="*/ 1887 w 3116"/>
              <a:gd name="T71" fmla="*/ 935 h 3066"/>
              <a:gd name="T72" fmla="*/ 1887 w 3116"/>
              <a:gd name="T73" fmla="*/ 935 h 3066"/>
              <a:gd name="T74" fmla="*/ 2216 w 3116"/>
              <a:gd name="T75" fmla="*/ 1183 h 3066"/>
              <a:gd name="T76" fmla="*/ 2078 w 3116"/>
              <a:gd name="T77" fmla="*/ 649 h 3066"/>
              <a:gd name="T78" fmla="*/ 2305 w 3116"/>
              <a:gd name="T79" fmla="*/ 616 h 3066"/>
              <a:gd name="T80" fmla="*/ 2332 w 3116"/>
              <a:gd name="T81" fmla="*/ 1067 h 3066"/>
              <a:gd name="T82" fmla="*/ 2288 w 3116"/>
              <a:gd name="T83" fmla="*/ 727 h 3066"/>
              <a:gd name="T84" fmla="*/ 2122 w 3116"/>
              <a:gd name="T85" fmla="*/ 685 h 3066"/>
              <a:gd name="T86" fmla="*/ 2514 w 3116"/>
              <a:gd name="T87" fmla="*/ 662 h 3066"/>
              <a:gd name="T88" fmla="*/ 2728 w 3116"/>
              <a:gd name="T89" fmla="*/ 588 h 3066"/>
              <a:gd name="T90" fmla="*/ 2630 w 3116"/>
              <a:gd name="T91" fmla="*/ 491 h 3066"/>
              <a:gd name="T92" fmla="*/ 2347 w 3116"/>
              <a:gd name="T93" fmla="*/ 553 h 3066"/>
              <a:gd name="T94" fmla="*/ 2451 w 3116"/>
              <a:gd name="T95" fmla="*/ 289 h 3066"/>
              <a:gd name="T96" fmla="*/ 2489 w 3116"/>
              <a:gd name="T97" fmla="*/ 338 h 3066"/>
              <a:gd name="T98" fmla="*/ 2430 w 3116"/>
              <a:gd name="T99" fmla="*/ 524 h 3066"/>
              <a:gd name="T100" fmla="*/ 2756 w 3116"/>
              <a:gd name="T101" fmla="*/ 453 h 3066"/>
              <a:gd name="T102" fmla="*/ 2643 w 3116"/>
              <a:gd name="T103" fmla="*/ 741 h 3066"/>
              <a:gd name="T104" fmla="*/ 3116 w 3116"/>
              <a:gd name="T105" fmla="*/ 283 h 3066"/>
              <a:gd name="T106" fmla="*/ 2855 w 3116"/>
              <a:gd name="T107" fmla="*/ 295 h 3066"/>
              <a:gd name="T108" fmla="*/ 2706 w 3116"/>
              <a:gd name="T109" fmla="*/ 86 h 3066"/>
              <a:gd name="T110" fmla="*/ 2622 w 3116"/>
              <a:gd name="T111" fmla="*/ 152 h 3066"/>
              <a:gd name="T112" fmla="*/ 2903 w 3116"/>
              <a:gd name="T113" fmla="*/ 88 h 3066"/>
              <a:gd name="T114" fmla="*/ 2911 w 3116"/>
              <a:gd name="T115" fmla="*/ 409 h 306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</a:cxnLst>
            <a:rect l="0" t="0" r="r" b="b"/>
            <a:pathLst>
              <a:path w="3116" h="3066">
                <a:moveTo>
                  <a:pt x="390" y="2773"/>
                </a:moveTo>
                <a:lnTo>
                  <a:pt x="446" y="2740"/>
                </a:lnTo>
                <a:cubicBezTo>
                  <a:pt x="473" y="2786"/>
                  <a:pt x="484" y="2831"/>
                  <a:pt x="479" y="2874"/>
                </a:cubicBezTo>
                <a:cubicBezTo>
                  <a:pt x="474" y="2917"/>
                  <a:pt x="454" y="2957"/>
                  <a:pt x="419" y="2992"/>
                </a:cubicBezTo>
                <a:cubicBezTo>
                  <a:pt x="383" y="3028"/>
                  <a:pt x="346" y="3050"/>
                  <a:pt x="309" y="3058"/>
                </a:cubicBezTo>
                <a:cubicBezTo>
                  <a:pt x="271" y="3066"/>
                  <a:pt x="232" y="3062"/>
                  <a:pt x="193" y="3046"/>
                </a:cubicBezTo>
                <a:cubicBezTo>
                  <a:pt x="153" y="3029"/>
                  <a:pt x="117" y="3005"/>
                  <a:pt x="85" y="2973"/>
                </a:cubicBezTo>
                <a:cubicBezTo>
                  <a:pt x="50" y="2938"/>
                  <a:pt x="26" y="2901"/>
                  <a:pt x="13" y="2862"/>
                </a:cubicBezTo>
                <a:cubicBezTo>
                  <a:pt x="1" y="2822"/>
                  <a:pt x="0" y="2783"/>
                  <a:pt x="11" y="2745"/>
                </a:cubicBezTo>
                <a:cubicBezTo>
                  <a:pt x="22" y="2707"/>
                  <a:pt x="43" y="2673"/>
                  <a:pt x="72" y="2643"/>
                </a:cubicBezTo>
                <a:cubicBezTo>
                  <a:pt x="106" y="2610"/>
                  <a:pt x="143" y="2590"/>
                  <a:pt x="183" y="2584"/>
                </a:cubicBezTo>
                <a:cubicBezTo>
                  <a:pt x="223" y="2578"/>
                  <a:pt x="263" y="2586"/>
                  <a:pt x="303" y="2608"/>
                </a:cubicBezTo>
                <a:lnTo>
                  <a:pt x="269" y="2663"/>
                </a:lnTo>
                <a:cubicBezTo>
                  <a:pt x="237" y="2646"/>
                  <a:pt x="208" y="2639"/>
                  <a:pt x="182" y="2643"/>
                </a:cubicBezTo>
                <a:cubicBezTo>
                  <a:pt x="156" y="2647"/>
                  <a:pt x="132" y="2660"/>
                  <a:pt x="109" y="2682"/>
                </a:cubicBezTo>
                <a:cubicBezTo>
                  <a:pt x="84" y="2708"/>
                  <a:pt x="68" y="2736"/>
                  <a:pt x="63" y="2766"/>
                </a:cubicBezTo>
                <a:cubicBezTo>
                  <a:pt x="58" y="2795"/>
                  <a:pt x="63" y="2824"/>
                  <a:pt x="76" y="2852"/>
                </a:cubicBezTo>
                <a:cubicBezTo>
                  <a:pt x="90" y="2880"/>
                  <a:pt x="108" y="2905"/>
                  <a:pt x="130" y="2927"/>
                </a:cubicBezTo>
                <a:cubicBezTo>
                  <a:pt x="159" y="2956"/>
                  <a:pt x="188" y="2976"/>
                  <a:pt x="218" y="2989"/>
                </a:cubicBezTo>
                <a:cubicBezTo>
                  <a:pt x="247" y="3002"/>
                  <a:pt x="276" y="3005"/>
                  <a:pt x="304" y="2998"/>
                </a:cubicBezTo>
                <a:cubicBezTo>
                  <a:pt x="333" y="2991"/>
                  <a:pt x="357" y="2978"/>
                  <a:pt x="377" y="2957"/>
                </a:cubicBezTo>
                <a:cubicBezTo>
                  <a:pt x="402" y="2932"/>
                  <a:pt x="416" y="2904"/>
                  <a:pt x="419" y="2872"/>
                </a:cubicBezTo>
                <a:cubicBezTo>
                  <a:pt x="422" y="2841"/>
                  <a:pt x="412" y="2808"/>
                  <a:pt x="390" y="2773"/>
                </a:cubicBezTo>
                <a:close/>
                <a:moveTo>
                  <a:pt x="465" y="2690"/>
                </a:moveTo>
                <a:cubicBezTo>
                  <a:pt x="420" y="2645"/>
                  <a:pt x="399" y="2599"/>
                  <a:pt x="403" y="2553"/>
                </a:cubicBezTo>
                <a:cubicBezTo>
                  <a:pt x="406" y="2514"/>
                  <a:pt x="422" y="2479"/>
                  <a:pt x="452" y="2449"/>
                </a:cubicBezTo>
                <a:cubicBezTo>
                  <a:pt x="486" y="2416"/>
                  <a:pt x="524" y="2399"/>
                  <a:pt x="567" y="2400"/>
                </a:cubicBezTo>
                <a:cubicBezTo>
                  <a:pt x="610" y="2401"/>
                  <a:pt x="651" y="2420"/>
                  <a:pt x="690" y="2459"/>
                </a:cubicBezTo>
                <a:cubicBezTo>
                  <a:pt x="721" y="2490"/>
                  <a:pt x="741" y="2520"/>
                  <a:pt x="750" y="2547"/>
                </a:cubicBezTo>
                <a:cubicBezTo>
                  <a:pt x="758" y="2574"/>
                  <a:pt x="759" y="2602"/>
                  <a:pt x="751" y="2630"/>
                </a:cubicBezTo>
                <a:cubicBezTo>
                  <a:pt x="743" y="2658"/>
                  <a:pt x="728" y="2682"/>
                  <a:pt x="707" y="2703"/>
                </a:cubicBezTo>
                <a:cubicBezTo>
                  <a:pt x="673" y="2738"/>
                  <a:pt x="634" y="2754"/>
                  <a:pt x="591" y="2753"/>
                </a:cubicBezTo>
                <a:cubicBezTo>
                  <a:pt x="548" y="2753"/>
                  <a:pt x="506" y="2732"/>
                  <a:pt x="465" y="2690"/>
                </a:cubicBezTo>
                <a:close/>
                <a:moveTo>
                  <a:pt x="508" y="2648"/>
                </a:moveTo>
                <a:cubicBezTo>
                  <a:pt x="539" y="2679"/>
                  <a:pt x="569" y="2696"/>
                  <a:pt x="598" y="2698"/>
                </a:cubicBezTo>
                <a:cubicBezTo>
                  <a:pt x="627" y="2700"/>
                  <a:pt x="652" y="2690"/>
                  <a:pt x="673" y="2670"/>
                </a:cubicBezTo>
                <a:cubicBezTo>
                  <a:pt x="693" y="2649"/>
                  <a:pt x="702" y="2624"/>
                  <a:pt x="700" y="2595"/>
                </a:cubicBezTo>
                <a:cubicBezTo>
                  <a:pt x="698" y="2566"/>
                  <a:pt x="682" y="2535"/>
                  <a:pt x="650" y="2503"/>
                </a:cubicBezTo>
                <a:cubicBezTo>
                  <a:pt x="619" y="2473"/>
                  <a:pt x="590" y="2457"/>
                  <a:pt x="561" y="2455"/>
                </a:cubicBezTo>
                <a:cubicBezTo>
                  <a:pt x="531" y="2454"/>
                  <a:pt x="507" y="2463"/>
                  <a:pt x="486" y="2483"/>
                </a:cubicBezTo>
                <a:cubicBezTo>
                  <a:pt x="466" y="2504"/>
                  <a:pt x="456" y="2529"/>
                  <a:pt x="458" y="2558"/>
                </a:cubicBezTo>
                <a:cubicBezTo>
                  <a:pt x="460" y="2587"/>
                  <a:pt x="476" y="2617"/>
                  <a:pt x="508" y="2648"/>
                </a:cubicBezTo>
                <a:close/>
                <a:moveTo>
                  <a:pt x="868" y="2531"/>
                </a:moveTo>
                <a:lnTo>
                  <a:pt x="625" y="2287"/>
                </a:lnTo>
                <a:lnTo>
                  <a:pt x="662" y="2250"/>
                </a:lnTo>
                <a:lnTo>
                  <a:pt x="697" y="2285"/>
                </a:lnTo>
                <a:cubicBezTo>
                  <a:pt x="688" y="2240"/>
                  <a:pt x="700" y="2201"/>
                  <a:pt x="734" y="2167"/>
                </a:cubicBezTo>
                <a:cubicBezTo>
                  <a:pt x="749" y="2153"/>
                  <a:pt x="765" y="2142"/>
                  <a:pt x="782" y="2135"/>
                </a:cubicBezTo>
                <a:cubicBezTo>
                  <a:pt x="800" y="2128"/>
                  <a:pt x="816" y="2125"/>
                  <a:pt x="831" y="2128"/>
                </a:cubicBezTo>
                <a:cubicBezTo>
                  <a:pt x="845" y="2130"/>
                  <a:pt x="860" y="2136"/>
                  <a:pt x="874" y="2146"/>
                </a:cubicBezTo>
                <a:cubicBezTo>
                  <a:pt x="883" y="2152"/>
                  <a:pt x="897" y="2164"/>
                  <a:pt x="916" y="2183"/>
                </a:cubicBezTo>
                <a:lnTo>
                  <a:pt x="1066" y="2333"/>
                </a:lnTo>
                <a:lnTo>
                  <a:pt x="1025" y="2374"/>
                </a:lnTo>
                <a:lnTo>
                  <a:pt x="877" y="2226"/>
                </a:lnTo>
                <a:cubicBezTo>
                  <a:pt x="860" y="2209"/>
                  <a:pt x="846" y="2198"/>
                  <a:pt x="834" y="2193"/>
                </a:cubicBezTo>
                <a:cubicBezTo>
                  <a:pt x="823" y="2188"/>
                  <a:pt x="810" y="2187"/>
                  <a:pt x="797" y="2190"/>
                </a:cubicBezTo>
                <a:cubicBezTo>
                  <a:pt x="784" y="2194"/>
                  <a:pt x="772" y="2201"/>
                  <a:pt x="761" y="2212"/>
                </a:cubicBezTo>
                <a:cubicBezTo>
                  <a:pt x="743" y="2229"/>
                  <a:pt x="734" y="2250"/>
                  <a:pt x="732" y="2274"/>
                </a:cubicBezTo>
                <a:cubicBezTo>
                  <a:pt x="731" y="2298"/>
                  <a:pt x="745" y="2325"/>
                  <a:pt x="777" y="2357"/>
                </a:cubicBezTo>
                <a:lnTo>
                  <a:pt x="909" y="2490"/>
                </a:lnTo>
                <a:lnTo>
                  <a:pt x="868" y="2531"/>
                </a:lnTo>
                <a:close/>
                <a:moveTo>
                  <a:pt x="1182" y="2144"/>
                </a:moveTo>
                <a:lnTo>
                  <a:pt x="1224" y="2174"/>
                </a:lnTo>
                <a:cubicBezTo>
                  <a:pt x="1215" y="2188"/>
                  <a:pt x="1206" y="2200"/>
                  <a:pt x="1197" y="2209"/>
                </a:cubicBezTo>
                <a:cubicBezTo>
                  <a:pt x="1182" y="2224"/>
                  <a:pt x="1168" y="2233"/>
                  <a:pt x="1155" y="2237"/>
                </a:cubicBezTo>
                <a:cubicBezTo>
                  <a:pt x="1142" y="2240"/>
                  <a:pt x="1130" y="2240"/>
                  <a:pt x="1118" y="2236"/>
                </a:cubicBezTo>
                <a:cubicBezTo>
                  <a:pt x="1107" y="2231"/>
                  <a:pt x="1089" y="2217"/>
                  <a:pt x="1065" y="2192"/>
                </a:cubicBezTo>
                <a:lnTo>
                  <a:pt x="925" y="2052"/>
                </a:lnTo>
                <a:lnTo>
                  <a:pt x="894" y="2082"/>
                </a:lnTo>
                <a:lnTo>
                  <a:pt x="862" y="2050"/>
                </a:lnTo>
                <a:lnTo>
                  <a:pt x="893" y="2020"/>
                </a:lnTo>
                <a:lnTo>
                  <a:pt x="832" y="1959"/>
                </a:lnTo>
                <a:lnTo>
                  <a:pt x="849" y="1894"/>
                </a:lnTo>
                <a:lnTo>
                  <a:pt x="934" y="1979"/>
                </a:lnTo>
                <a:lnTo>
                  <a:pt x="975" y="1937"/>
                </a:lnTo>
                <a:lnTo>
                  <a:pt x="1007" y="1969"/>
                </a:lnTo>
                <a:lnTo>
                  <a:pt x="966" y="2011"/>
                </a:lnTo>
                <a:lnTo>
                  <a:pt x="1108" y="2153"/>
                </a:lnTo>
                <a:cubicBezTo>
                  <a:pt x="1120" y="2165"/>
                  <a:pt x="1128" y="2172"/>
                  <a:pt x="1133" y="2174"/>
                </a:cubicBezTo>
                <a:cubicBezTo>
                  <a:pt x="1138" y="2176"/>
                  <a:pt x="1143" y="2176"/>
                  <a:pt x="1148" y="2175"/>
                </a:cubicBezTo>
                <a:cubicBezTo>
                  <a:pt x="1153" y="2173"/>
                  <a:pt x="1159" y="2170"/>
                  <a:pt x="1165" y="2163"/>
                </a:cubicBezTo>
                <a:cubicBezTo>
                  <a:pt x="1170" y="2159"/>
                  <a:pt x="1175" y="2152"/>
                  <a:pt x="1182" y="2144"/>
                </a:cubicBezTo>
                <a:close/>
                <a:moveTo>
                  <a:pt x="1258" y="2141"/>
                </a:moveTo>
                <a:lnTo>
                  <a:pt x="1015" y="1898"/>
                </a:lnTo>
                <a:lnTo>
                  <a:pt x="1052" y="1860"/>
                </a:lnTo>
                <a:lnTo>
                  <a:pt x="1089" y="1897"/>
                </a:lnTo>
                <a:cubicBezTo>
                  <a:pt x="1081" y="1871"/>
                  <a:pt x="1078" y="1850"/>
                  <a:pt x="1081" y="1837"/>
                </a:cubicBezTo>
                <a:cubicBezTo>
                  <a:pt x="1083" y="1823"/>
                  <a:pt x="1089" y="1812"/>
                  <a:pt x="1099" y="1802"/>
                </a:cubicBezTo>
                <a:cubicBezTo>
                  <a:pt x="1113" y="1788"/>
                  <a:pt x="1131" y="1779"/>
                  <a:pt x="1155" y="1773"/>
                </a:cubicBezTo>
                <a:lnTo>
                  <a:pt x="1179" y="1826"/>
                </a:lnTo>
                <a:cubicBezTo>
                  <a:pt x="1163" y="1830"/>
                  <a:pt x="1150" y="1837"/>
                  <a:pt x="1140" y="1847"/>
                </a:cubicBezTo>
                <a:cubicBezTo>
                  <a:pt x="1131" y="1856"/>
                  <a:pt x="1125" y="1867"/>
                  <a:pt x="1123" y="1879"/>
                </a:cubicBezTo>
                <a:cubicBezTo>
                  <a:pt x="1122" y="1892"/>
                  <a:pt x="1124" y="1905"/>
                  <a:pt x="1131" y="1917"/>
                </a:cubicBezTo>
                <a:cubicBezTo>
                  <a:pt x="1141" y="1937"/>
                  <a:pt x="1154" y="1955"/>
                  <a:pt x="1172" y="1972"/>
                </a:cubicBezTo>
                <a:lnTo>
                  <a:pt x="1299" y="2100"/>
                </a:lnTo>
                <a:lnTo>
                  <a:pt x="1258" y="2141"/>
                </a:lnTo>
                <a:close/>
                <a:moveTo>
                  <a:pt x="1280" y="1876"/>
                </a:moveTo>
                <a:cubicBezTo>
                  <a:pt x="1235" y="1831"/>
                  <a:pt x="1214" y="1785"/>
                  <a:pt x="1217" y="1738"/>
                </a:cubicBezTo>
                <a:cubicBezTo>
                  <a:pt x="1220" y="1699"/>
                  <a:pt x="1237" y="1665"/>
                  <a:pt x="1267" y="1634"/>
                </a:cubicBezTo>
                <a:cubicBezTo>
                  <a:pt x="1300" y="1601"/>
                  <a:pt x="1339" y="1585"/>
                  <a:pt x="1382" y="1585"/>
                </a:cubicBezTo>
                <a:cubicBezTo>
                  <a:pt x="1425" y="1586"/>
                  <a:pt x="1466" y="1606"/>
                  <a:pt x="1505" y="1644"/>
                </a:cubicBezTo>
                <a:cubicBezTo>
                  <a:pt x="1536" y="1676"/>
                  <a:pt x="1556" y="1705"/>
                  <a:pt x="1564" y="1732"/>
                </a:cubicBezTo>
                <a:cubicBezTo>
                  <a:pt x="1573" y="1760"/>
                  <a:pt x="1573" y="1787"/>
                  <a:pt x="1565" y="1815"/>
                </a:cubicBezTo>
                <a:cubicBezTo>
                  <a:pt x="1557" y="1843"/>
                  <a:pt x="1543" y="1868"/>
                  <a:pt x="1521" y="1889"/>
                </a:cubicBezTo>
                <a:cubicBezTo>
                  <a:pt x="1487" y="1923"/>
                  <a:pt x="1449" y="1940"/>
                  <a:pt x="1406" y="1939"/>
                </a:cubicBezTo>
                <a:cubicBezTo>
                  <a:pt x="1363" y="1938"/>
                  <a:pt x="1321" y="1917"/>
                  <a:pt x="1280" y="1876"/>
                </a:cubicBezTo>
                <a:close/>
                <a:moveTo>
                  <a:pt x="1322" y="1833"/>
                </a:moveTo>
                <a:cubicBezTo>
                  <a:pt x="1353" y="1865"/>
                  <a:pt x="1384" y="1881"/>
                  <a:pt x="1413" y="1883"/>
                </a:cubicBezTo>
                <a:cubicBezTo>
                  <a:pt x="1442" y="1885"/>
                  <a:pt x="1467" y="1876"/>
                  <a:pt x="1487" y="1855"/>
                </a:cubicBezTo>
                <a:cubicBezTo>
                  <a:pt x="1508" y="1834"/>
                  <a:pt x="1517" y="1810"/>
                  <a:pt x="1515" y="1780"/>
                </a:cubicBezTo>
                <a:cubicBezTo>
                  <a:pt x="1513" y="1751"/>
                  <a:pt x="1496" y="1721"/>
                  <a:pt x="1464" y="1689"/>
                </a:cubicBezTo>
                <a:cubicBezTo>
                  <a:pt x="1434" y="1659"/>
                  <a:pt x="1404" y="1643"/>
                  <a:pt x="1375" y="1641"/>
                </a:cubicBezTo>
                <a:cubicBezTo>
                  <a:pt x="1346" y="1639"/>
                  <a:pt x="1321" y="1648"/>
                  <a:pt x="1301" y="1669"/>
                </a:cubicBezTo>
                <a:cubicBezTo>
                  <a:pt x="1280" y="1689"/>
                  <a:pt x="1271" y="1714"/>
                  <a:pt x="1273" y="1743"/>
                </a:cubicBezTo>
                <a:cubicBezTo>
                  <a:pt x="1275" y="1772"/>
                  <a:pt x="1291" y="1802"/>
                  <a:pt x="1322" y="1833"/>
                </a:cubicBezTo>
                <a:close/>
                <a:moveTo>
                  <a:pt x="1676" y="1723"/>
                </a:moveTo>
                <a:lnTo>
                  <a:pt x="1340" y="1387"/>
                </a:lnTo>
                <a:lnTo>
                  <a:pt x="1381" y="1346"/>
                </a:lnTo>
                <a:lnTo>
                  <a:pt x="1718" y="1682"/>
                </a:lnTo>
                <a:lnTo>
                  <a:pt x="1676" y="1723"/>
                </a:lnTo>
                <a:close/>
                <a:moveTo>
                  <a:pt x="1950" y="1369"/>
                </a:moveTo>
                <a:lnTo>
                  <a:pt x="1990" y="1409"/>
                </a:lnTo>
                <a:lnTo>
                  <a:pt x="1768" y="1631"/>
                </a:lnTo>
                <a:cubicBezTo>
                  <a:pt x="1758" y="1622"/>
                  <a:pt x="1750" y="1610"/>
                  <a:pt x="1744" y="1598"/>
                </a:cubicBezTo>
                <a:cubicBezTo>
                  <a:pt x="1735" y="1577"/>
                  <a:pt x="1729" y="1553"/>
                  <a:pt x="1727" y="1526"/>
                </a:cubicBezTo>
                <a:cubicBezTo>
                  <a:pt x="1724" y="1499"/>
                  <a:pt x="1725" y="1464"/>
                  <a:pt x="1730" y="1421"/>
                </a:cubicBezTo>
                <a:cubicBezTo>
                  <a:pt x="1736" y="1355"/>
                  <a:pt x="1737" y="1306"/>
                  <a:pt x="1732" y="1276"/>
                </a:cubicBezTo>
                <a:cubicBezTo>
                  <a:pt x="1728" y="1245"/>
                  <a:pt x="1718" y="1222"/>
                  <a:pt x="1702" y="1207"/>
                </a:cubicBezTo>
                <a:cubicBezTo>
                  <a:pt x="1686" y="1191"/>
                  <a:pt x="1666" y="1183"/>
                  <a:pt x="1643" y="1183"/>
                </a:cubicBezTo>
                <a:cubicBezTo>
                  <a:pt x="1620" y="1183"/>
                  <a:pt x="1599" y="1193"/>
                  <a:pt x="1581" y="1212"/>
                </a:cubicBezTo>
                <a:cubicBezTo>
                  <a:pt x="1561" y="1232"/>
                  <a:pt x="1551" y="1254"/>
                  <a:pt x="1551" y="1277"/>
                </a:cubicBezTo>
                <a:cubicBezTo>
                  <a:pt x="1551" y="1301"/>
                  <a:pt x="1561" y="1324"/>
                  <a:pt x="1582" y="1345"/>
                </a:cubicBezTo>
                <a:lnTo>
                  <a:pt x="1535" y="1383"/>
                </a:lnTo>
                <a:cubicBezTo>
                  <a:pt x="1507" y="1349"/>
                  <a:pt x="1494" y="1314"/>
                  <a:pt x="1496" y="1278"/>
                </a:cubicBezTo>
                <a:cubicBezTo>
                  <a:pt x="1498" y="1243"/>
                  <a:pt x="1515" y="1209"/>
                  <a:pt x="1547" y="1177"/>
                </a:cubicBezTo>
                <a:cubicBezTo>
                  <a:pt x="1580" y="1145"/>
                  <a:pt x="1614" y="1128"/>
                  <a:pt x="1651" y="1127"/>
                </a:cubicBezTo>
                <a:cubicBezTo>
                  <a:pt x="1687" y="1126"/>
                  <a:pt x="1719" y="1139"/>
                  <a:pt x="1745" y="1165"/>
                </a:cubicBezTo>
                <a:cubicBezTo>
                  <a:pt x="1759" y="1179"/>
                  <a:pt x="1769" y="1195"/>
                  <a:pt x="1777" y="1213"/>
                </a:cubicBezTo>
                <a:cubicBezTo>
                  <a:pt x="1784" y="1232"/>
                  <a:pt x="1789" y="1255"/>
                  <a:pt x="1790" y="1282"/>
                </a:cubicBezTo>
                <a:cubicBezTo>
                  <a:pt x="1792" y="1309"/>
                  <a:pt x="1791" y="1350"/>
                  <a:pt x="1786" y="1405"/>
                </a:cubicBezTo>
                <a:cubicBezTo>
                  <a:pt x="1782" y="1450"/>
                  <a:pt x="1780" y="1480"/>
                  <a:pt x="1781" y="1494"/>
                </a:cubicBezTo>
                <a:cubicBezTo>
                  <a:pt x="1781" y="1509"/>
                  <a:pt x="1783" y="1522"/>
                  <a:pt x="1786" y="1534"/>
                </a:cubicBezTo>
                <a:lnTo>
                  <a:pt x="1950" y="1369"/>
                </a:lnTo>
                <a:close/>
                <a:moveTo>
                  <a:pt x="1887" y="935"/>
                </a:moveTo>
                <a:lnTo>
                  <a:pt x="1839" y="888"/>
                </a:lnTo>
                <a:lnTo>
                  <a:pt x="1880" y="847"/>
                </a:lnTo>
                <a:lnTo>
                  <a:pt x="1928" y="894"/>
                </a:lnTo>
                <a:lnTo>
                  <a:pt x="1887" y="935"/>
                </a:lnTo>
                <a:close/>
                <a:moveTo>
                  <a:pt x="2175" y="1224"/>
                </a:moveTo>
                <a:lnTo>
                  <a:pt x="1932" y="980"/>
                </a:lnTo>
                <a:lnTo>
                  <a:pt x="1973" y="939"/>
                </a:lnTo>
                <a:lnTo>
                  <a:pt x="2216" y="1183"/>
                </a:lnTo>
                <a:lnTo>
                  <a:pt x="2175" y="1224"/>
                </a:lnTo>
                <a:close/>
                <a:moveTo>
                  <a:pt x="2288" y="1111"/>
                </a:moveTo>
                <a:lnTo>
                  <a:pt x="1952" y="775"/>
                </a:lnTo>
                <a:lnTo>
                  <a:pt x="2078" y="649"/>
                </a:lnTo>
                <a:cubicBezTo>
                  <a:pt x="2101" y="626"/>
                  <a:pt x="2119" y="610"/>
                  <a:pt x="2133" y="601"/>
                </a:cubicBezTo>
                <a:cubicBezTo>
                  <a:pt x="2152" y="587"/>
                  <a:pt x="2171" y="578"/>
                  <a:pt x="2190" y="575"/>
                </a:cubicBezTo>
                <a:cubicBezTo>
                  <a:pt x="2209" y="571"/>
                  <a:pt x="2229" y="573"/>
                  <a:pt x="2249" y="580"/>
                </a:cubicBezTo>
                <a:cubicBezTo>
                  <a:pt x="2270" y="587"/>
                  <a:pt x="2289" y="599"/>
                  <a:pt x="2305" y="616"/>
                </a:cubicBezTo>
                <a:cubicBezTo>
                  <a:pt x="2334" y="645"/>
                  <a:pt x="2349" y="678"/>
                  <a:pt x="2351" y="716"/>
                </a:cubicBezTo>
                <a:cubicBezTo>
                  <a:pt x="2352" y="754"/>
                  <a:pt x="2329" y="797"/>
                  <a:pt x="2282" y="844"/>
                </a:cubicBezTo>
                <a:lnTo>
                  <a:pt x="2196" y="930"/>
                </a:lnTo>
                <a:lnTo>
                  <a:pt x="2332" y="1067"/>
                </a:lnTo>
                <a:lnTo>
                  <a:pt x="2288" y="1111"/>
                </a:lnTo>
                <a:close/>
                <a:moveTo>
                  <a:pt x="2156" y="891"/>
                </a:moveTo>
                <a:lnTo>
                  <a:pt x="2243" y="804"/>
                </a:lnTo>
                <a:cubicBezTo>
                  <a:pt x="2272" y="775"/>
                  <a:pt x="2287" y="749"/>
                  <a:pt x="2288" y="727"/>
                </a:cubicBezTo>
                <a:cubicBezTo>
                  <a:pt x="2289" y="704"/>
                  <a:pt x="2280" y="683"/>
                  <a:pt x="2261" y="663"/>
                </a:cubicBezTo>
                <a:cubicBezTo>
                  <a:pt x="2247" y="649"/>
                  <a:pt x="2231" y="641"/>
                  <a:pt x="2214" y="638"/>
                </a:cubicBezTo>
                <a:cubicBezTo>
                  <a:pt x="2197" y="635"/>
                  <a:pt x="2181" y="638"/>
                  <a:pt x="2166" y="646"/>
                </a:cubicBezTo>
                <a:cubicBezTo>
                  <a:pt x="2157" y="652"/>
                  <a:pt x="2142" y="664"/>
                  <a:pt x="2122" y="685"/>
                </a:cubicBezTo>
                <a:lnTo>
                  <a:pt x="2036" y="771"/>
                </a:lnTo>
                <a:lnTo>
                  <a:pt x="2156" y="891"/>
                </a:lnTo>
                <a:close/>
                <a:moveTo>
                  <a:pt x="2476" y="707"/>
                </a:moveTo>
                <a:lnTo>
                  <a:pt x="2514" y="662"/>
                </a:lnTo>
                <a:cubicBezTo>
                  <a:pt x="2533" y="677"/>
                  <a:pt x="2551" y="686"/>
                  <a:pt x="2569" y="689"/>
                </a:cubicBezTo>
                <a:cubicBezTo>
                  <a:pt x="2587" y="693"/>
                  <a:pt x="2607" y="690"/>
                  <a:pt x="2629" y="682"/>
                </a:cubicBezTo>
                <a:cubicBezTo>
                  <a:pt x="2651" y="673"/>
                  <a:pt x="2672" y="659"/>
                  <a:pt x="2691" y="640"/>
                </a:cubicBezTo>
                <a:cubicBezTo>
                  <a:pt x="2708" y="623"/>
                  <a:pt x="2720" y="606"/>
                  <a:pt x="2728" y="588"/>
                </a:cubicBezTo>
                <a:cubicBezTo>
                  <a:pt x="2736" y="570"/>
                  <a:pt x="2739" y="553"/>
                  <a:pt x="2736" y="538"/>
                </a:cubicBezTo>
                <a:cubicBezTo>
                  <a:pt x="2734" y="523"/>
                  <a:pt x="2728" y="510"/>
                  <a:pt x="2717" y="500"/>
                </a:cubicBezTo>
                <a:cubicBezTo>
                  <a:pt x="2707" y="489"/>
                  <a:pt x="2694" y="483"/>
                  <a:pt x="2680" y="481"/>
                </a:cubicBezTo>
                <a:cubicBezTo>
                  <a:pt x="2666" y="479"/>
                  <a:pt x="2650" y="483"/>
                  <a:pt x="2630" y="491"/>
                </a:cubicBezTo>
                <a:cubicBezTo>
                  <a:pt x="2618" y="497"/>
                  <a:pt x="2592" y="511"/>
                  <a:pt x="2554" y="535"/>
                </a:cubicBezTo>
                <a:cubicBezTo>
                  <a:pt x="2516" y="558"/>
                  <a:pt x="2487" y="573"/>
                  <a:pt x="2468" y="579"/>
                </a:cubicBezTo>
                <a:cubicBezTo>
                  <a:pt x="2444" y="586"/>
                  <a:pt x="2421" y="588"/>
                  <a:pt x="2401" y="583"/>
                </a:cubicBezTo>
                <a:cubicBezTo>
                  <a:pt x="2381" y="579"/>
                  <a:pt x="2363" y="569"/>
                  <a:pt x="2347" y="553"/>
                </a:cubicBezTo>
                <a:cubicBezTo>
                  <a:pt x="2330" y="536"/>
                  <a:pt x="2319" y="516"/>
                  <a:pt x="2314" y="491"/>
                </a:cubicBezTo>
                <a:cubicBezTo>
                  <a:pt x="2309" y="467"/>
                  <a:pt x="2312" y="442"/>
                  <a:pt x="2323" y="416"/>
                </a:cubicBezTo>
                <a:cubicBezTo>
                  <a:pt x="2334" y="389"/>
                  <a:pt x="2350" y="365"/>
                  <a:pt x="2373" y="342"/>
                </a:cubicBezTo>
                <a:cubicBezTo>
                  <a:pt x="2398" y="318"/>
                  <a:pt x="2424" y="300"/>
                  <a:pt x="2451" y="289"/>
                </a:cubicBezTo>
                <a:cubicBezTo>
                  <a:pt x="2478" y="278"/>
                  <a:pt x="2504" y="275"/>
                  <a:pt x="2530" y="280"/>
                </a:cubicBezTo>
                <a:cubicBezTo>
                  <a:pt x="2556" y="285"/>
                  <a:pt x="2579" y="298"/>
                  <a:pt x="2600" y="317"/>
                </a:cubicBezTo>
                <a:lnTo>
                  <a:pt x="2560" y="362"/>
                </a:lnTo>
                <a:cubicBezTo>
                  <a:pt x="2537" y="343"/>
                  <a:pt x="2513" y="335"/>
                  <a:pt x="2489" y="338"/>
                </a:cubicBezTo>
                <a:cubicBezTo>
                  <a:pt x="2465" y="340"/>
                  <a:pt x="2440" y="354"/>
                  <a:pt x="2414" y="380"/>
                </a:cubicBezTo>
                <a:cubicBezTo>
                  <a:pt x="2387" y="407"/>
                  <a:pt x="2372" y="431"/>
                  <a:pt x="2370" y="453"/>
                </a:cubicBezTo>
                <a:cubicBezTo>
                  <a:pt x="2368" y="476"/>
                  <a:pt x="2373" y="494"/>
                  <a:pt x="2387" y="508"/>
                </a:cubicBezTo>
                <a:cubicBezTo>
                  <a:pt x="2399" y="520"/>
                  <a:pt x="2414" y="525"/>
                  <a:pt x="2430" y="524"/>
                </a:cubicBezTo>
                <a:cubicBezTo>
                  <a:pt x="2446" y="524"/>
                  <a:pt x="2477" y="509"/>
                  <a:pt x="2521" y="481"/>
                </a:cubicBezTo>
                <a:cubicBezTo>
                  <a:pt x="2565" y="453"/>
                  <a:pt x="2597" y="436"/>
                  <a:pt x="2617" y="428"/>
                </a:cubicBezTo>
                <a:cubicBezTo>
                  <a:pt x="2646" y="418"/>
                  <a:pt x="2671" y="415"/>
                  <a:pt x="2695" y="419"/>
                </a:cubicBezTo>
                <a:cubicBezTo>
                  <a:pt x="2718" y="424"/>
                  <a:pt x="2738" y="435"/>
                  <a:pt x="2756" y="453"/>
                </a:cubicBezTo>
                <a:cubicBezTo>
                  <a:pt x="2774" y="471"/>
                  <a:pt x="2786" y="493"/>
                  <a:pt x="2792" y="519"/>
                </a:cubicBezTo>
                <a:cubicBezTo>
                  <a:pt x="2797" y="545"/>
                  <a:pt x="2795" y="572"/>
                  <a:pt x="2784" y="600"/>
                </a:cubicBezTo>
                <a:cubicBezTo>
                  <a:pt x="2774" y="628"/>
                  <a:pt x="2757" y="654"/>
                  <a:pt x="2733" y="678"/>
                </a:cubicBezTo>
                <a:cubicBezTo>
                  <a:pt x="2702" y="708"/>
                  <a:pt x="2672" y="729"/>
                  <a:pt x="2643" y="741"/>
                </a:cubicBezTo>
                <a:cubicBezTo>
                  <a:pt x="2614" y="753"/>
                  <a:pt x="2584" y="756"/>
                  <a:pt x="2555" y="749"/>
                </a:cubicBezTo>
                <a:cubicBezTo>
                  <a:pt x="2525" y="743"/>
                  <a:pt x="2499" y="729"/>
                  <a:pt x="2476" y="707"/>
                </a:cubicBezTo>
                <a:close/>
                <a:moveTo>
                  <a:pt x="3076" y="244"/>
                </a:moveTo>
                <a:lnTo>
                  <a:pt x="3116" y="283"/>
                </a:lnTo>
                <a:lnTo>
                  <a:pt x="2894" y="506"/>
                </a:lnTo>
                <a:cubicBezTo>
                  <a:pt x="2883" y="496"/>
                  <a:pt x="2875" y="485"/>
                  <a:pt x="2870" y="472"/>
                </a:cubicBezTo>
                <a:cubicBezTo>
                  <a:pt x="2860" y="451"/>
                  <a:pt x="2854" y="427"/>
                  <a:pt x="2852" y="400"/>
                </a:cubicBezTo>
                <a:cubicBezTo>
                  <a:pt x="2850" y="373"/>
                  <a:pt x="2851" y="338"/>
                  <a:pt x="2855" y="295"/>
                </a:cubicBezTo>
                <a:cubicBezTo>
                  <a:pt x="2862" y="229"/>
                  <a:pt x="2863" y="180"/>
                  <a:pt x="2858" y="150"/>
                </a:cubicBezTo>
                <a:cubicBezTo>
                  <a:pt x="2854" y="120"/>
                  <a:pt x="2843" y="97"/>
                  <a:pt x="2828" y="81"/>
                </a:cubicBezTo>
                <a:cubicBezTo>
                  <a:pt x="2811" y="65"/>
                  <a:pt x="2792" y="57"/>
                  <a:pt x="2769" y="57"/>
                </a:cubicBezTo>
                <a:cubicBezTo>
                  <a:pt x="2746" y="58"/>
                  <a:pt x="2725" y="67"/>
                  <a:pt x="2706" y="86"/>
                </a:cubicBezTo>
                <a:cubicBezTo>
                  <a:pt x="2686" y="106"/>
                  <a:pt x="2677" y="128"/>
                  <a:pt x="2677" y="152"/>
                </a:cubicBezTo>
                <a:cubicBezTo>
                  <a:pt x="2677" y="176"/>
                  <a:pt x="2687" y="198"/>
                  <a:pt x="2708" y="219"/>
                </a:cubicBezTo>
                <a:lnTo>
                  <a:pt x="2661" y="257"/>
                </a:lnTo>
                <a:cubicBezTo>
                  <a:pt x="2632" y="223"/>
                  <a:pt x="2619" y="188"/>
                  <a:pt x="2622" y="152"/>
                </a:cubicBezTo>
                <a:cubicBezTo>
                  <a:pt x="2624" y="117"/>
                  <a:pt x="2641" y="83"/>
                  <a:pt x="2673" y="51"/>
                </a:cubicBezTo>
                <a:cubicBezTo>
                  <a:pt x="2705" y="19"/>
                  <a:pt x="2740" y="2"/>
                  <a:pt x="2776" y="1"/>
                </a:cubicBezTo>
                <a:cubicBezTo>
                  <a:pt x="2813" y="0"/>
                  <a:pt x="2845" y="13"/>
                  <a:pt x="2871" y="40"/>
                </a:cubicBezTo>
                <a:cubicBezTo>
                  <a:pt x="2885" y="53"/>
                  <a:pt x="2895" y="69"/>
                  <a:pt x="2903" y="88"/>
                </a:cubicBezTo>
                <a:cubicBezTo>
                  <a:pt x="2910" y="106"/>
                  <a:pt x="2915" y="129"/>
                  <a:pt x="2916" y="156"/>
                </a:cubicBezTo>
                <a:cubicBezTo>
                  <a:pt x="2918" y="183"/>
                  <a:pt x="2916" y="224"/>
                  <a:pt x="2912" y="279"/>
                </a:cubicBezTo>
                <a:cubicBezTo>
                  <a:pt x="2908" y="324"/>
                  <a:pt x="2906" y="354"/>
                  <a:pt x="2906" y="369"/>
                </a:cubicBezTo>
                <a:cubicBezTo>
                  <a:pt x="2907" y="383"/>
                  <a:pt x="2908" y="396"/>
                  <a:pt x="2911" y="409"/>
                </a:cubicBezTo>
                <a:lnTo>
                  <a:pt x="3076" y="244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82" name="Freeform 64"/>
          <p:cNvSpPr>
            <a:spLocks noEditPoints="1"/>
          </p:cNvSpPr>
          <p:nvPr/>
        </p:nvSpPr>
        <p:spPr bwMode="auto">
          <a:xfrm>
            <a:off x="1763890" y="4613062"/>
            <a:ext cx="584200" cy="581025"/>
          </a:xfrm>
          <a:custGeom>
            <a:avLst/>
            <a:gdLst>
              <a:gd name="T0" fmla="*/ 419 w 3064"/>
              <a:gd name="T1" fmla="*/ 2982 h 3056"/>
              <a:gd name="T2" fmla="*/ 14 w 3064"/>
              <a:gd name="T3" fmla="*/ 2852 h 3056"/>
              <a:gd name="T4" fmla="*/ 303 w 3064"/>
              <a:gd name="T5" fmla="*/ 2598 h 3056"/>
              <a:gd name="T6" fmla="*/ 64 w 3064"/>
              <a:gd name="T7" fmla="*/ 2756 h 3056"/>
              <a:gd name="T8" fmla="*/ 305 w 3064"/>
              <a:gd name="T9" fmla="*/ 2988 h 3056"/>
              <a:gd name="T10" fmla="*/ 466 w 3064"/>
              <a:gd name="T11" fmla="*/ 2680 h 3056"/>
              <a:gd name="T12" fmla="*/ 690 w 3064"/>
              <a:gd name="T13" fmla="*/ 2449 h 3056"/>
              <a:gd name="T14" fmla="*/ 592 w 3064"/>
              <a:gd name="T15" fmla="*/ 2743 h 3056"/>
              <a:gd name="T16" fmla="*/ 673 w 3064"/>
              <a:gd name="T17" fmla="*/ 2660 h 3056"/>
              <a:gd name="T18" fmla="*/ 487 w 3064"/>
              <a:gd name="T19" fmla="*/ 2473 h 3056"/>
              <a:gd name="T20" fmla="*/ 625 w 3064"/>
              <a:gd name="T21" fmla="*/ 2277 h 3056"/>
              <a:gd name="T22" fmla="*/ 783 w 3064"/>
              <a:gd name="T23" fmla="*/ 2125 h 3056"/>
              <a:gd name="T24" fmla="*/ 1066 w 3064"/>
              <a:gd name="T25" fmla="*/ 2323 h 3056"/>
              <a:gd name="T26" fmla="*/ 798 w 3064"/>
              <a:gd name="T27" fmla="*/ 2180 h 3056"/>
              <a:gd name="T28" fmla="*/ 910 w 3064"/>
              <a:gd name="T29" fmla="*/ 2480 h 3056"/>
              <a:gd name="T30" fmla="*/ 1197 w 3064"/>
              <a:gd name="T31" fmla="*/ 2199 h 3056"/>
              <a:gd name="T32" fmla="*/ 925 w 3064"/>
              <a:gd name="T33" fmla="*/ 2042 h 3056"/>
              <a:gd name="T34" fmla="*/ 833 w 3064"/>
              <a:gd name="T35" fmla="*/ 1949 h 3056"/>
              <a:gd name="T36" fmla="*/ 1008 w 3064"/>
              <a:gd name="T37" fmla="*/ 1959 h 3056"/>
              <a:gd name="T38" fmla="*/ 1148 w 3064"/>
              <a:gd name="T39" fmla="*/ 2165 h 3056"/>
              <a:gd name="T40" fmla="*/ 1015 w 3064"/>
              <a:gd name="T41" fmla="*/ 1888 h 3056"/>
              <a:gd name="T42" fmla="*/ 1099 w 3064"/>
              <a:gd name="T43" fmla="*/ 1792 h 3056"/>
              <a:gd name="T44" fmla="*/ 1124 w 3064"/>
              <a:gd name="T45" fmla="*/ 1869 h 3056"/>
              <a:gd name="T46" fmla="*/ 1259 w 3064"/>
              <a:gd name="T47" fmla="*/ 2131 h 3056"/>
              <a:gd name="T48" fmla="*/ 1382 w 3064"/>
              <a:gd name="T49" fmla="*/ 1575 h 3056"/>
              <a:gd name="T50" fmla="*/ 1522 w 3064"/>
              <a:gd name="T51" fmla="*/ 1879 h 3056"/>
              <a:gd name="T52" fmla="*/ 1413 w 3064"/>
              <a:gd name="T53" fmla="*/ 1873 h 3056"/>
              <a:gd name="T54" fmla="*/ 1376 w 3064"/>
              <a:gd name="T55" fmla="*/ 1631 h 3056"/>
              <a:gd name="T56" fmla="*/ 1677 w 3064"/>
              <a:gd name="T57" fmla="*/ 1713 h 3056"/>
              <a:gd name="T58" fmla="*/ 1677 w 3064"/>
              <a:gd name="T59" fmla="*/ 1713 h 3056"/>
              <a:gd name="T60" fmla="*/ 1744 w 3064"/>
              <a:gd name="T61" fmla="*/ 1588 h 3056"/>
              <a:gd name="T62" fmla="*/ 1703 w 3064"/>
              <a:gd name="T63" fmla="*/ 1197 h 3056"/>
              <a:gd name="T64" fmla="*/ 1583 w 3064"/>
              <a:gd name="T65" fmla="*/ 1335 h 3056"/>
              <a:gd name="T66" fmla="*/ 1651 w 3064"/>
              <a:gd name="T67" fmla="*/ 1117 h 3056"/>
              <a:gd name="T68" fmla="*/ 1786 w 3064"/>
              <a:gd name="T69" fmla="*/ 1395 h 3056"/>
              <a:gd name="T70" fmla="*/ 1887 w 3064"/>
              <a:gd name="T71" fmla="*/ 925 h 3056"/>
              <a:gd name="T72" fmla="*/ 1887 w 3064"/>
              <a:gd name="T73" fmla="*/ 925 h 3056"/>
              <a:gd name="T74" fmla="*/ 2217 w 3064"/>
              <a:gd name="T75" fmla="*/ 1173 h 3056"/>
              <a:gd name="T76" fmla="*/ 2079 w 3064"/>
              <a:gd name="T77" fmla="*/ 639 h 3056"/>
              <a:gd name="T78" fmla="*/ 2306 w 3064"/>
              <a:gd name="T79" fmla="*/ 606 h 3056"/>
              <a:gd name="T80" fmla="*/ 2333 w 3064"/>
              <a:gd name="T81" fmla="*/ 1057 h 3056"/>
              <a:gd name="T82" fmla="*/ 2288 w 3064"/>
              <a:gd name="T83" fmla="*/ 717 h 3056"/>
              <a:gd name="T84" fmla="*/ 2122 w 3064"/>
              <a:gd name="T85" fmla="*/ 675 h 3056"/>
              <a:gd name="T86" fmla="*/ 2514 w 3064"/>
              <a:gd name="T87" fmla="*/ 652 h 3056"/>
              <a:gd name="T88" fmla="*/ 2729 w 3064"/>
              <a:gd name="T89" fmla="*/ 578 h 3056"/>
              <a:gd name="T90" fmla="*/ 2631 w 3064"/>
              <a:gd name="T91" fmla="*/ 481 h 3056"/>
              <a:gd name="T92" fmla="*/ 2348 w 3064"/>
              <a:gd name="T93" fmla="*/ 543 h 3056"/>
              <a:gd name="T94" fmla="*/ 2451 w 3064"/>
              <a:gd name="T95" fmla="*/ 279 h 3056"/>
              <a:gd name="T96" fmla="*/ 2489 w 3064"/>
              <a:gd name="T97" fmla="*/ 328 h 3056"/>
              <a:gd name="T98" fmla="*/ 2431 w 3064"/>
              <a:gd name="T99" fmla="*/ 514 h 3056"/>
              <a:gd name="T100" fmla="*/ 2757 w 3064"/>
              <a:gd name="T101" fmla="*/ 443 h 3056"/>
              <a:gd name="T102" fmla="*/ 2643 w 3064"/>
              <a:gd name="T103" fmla="*/ 731 h 3056"/>
              <a:gd name="T104" fmla="*/ 2847 w 3064"/>
              <a:gd name="T105" fmla="*/ 355 h 3056"/>
              <a:gd name="T106" fmla="*/ 2977 w 3064"/>
              <a:gd name="T107" fmla="*/ 215 h 3056"/>
              <a:gd name="T108" fmla="*/ 2790 w 3064"/>
              <a:gd name="T109" fmla="*/ 209 h 3056"/>
              <a:gd name="T110" fmla="*/ 2757 w 3064"/>
              <a:gd name="T111" fmla="*/ 56 h 3056"/>
              <a:gd name="T112" fmla="*/ 2653 w 3064"/>
              <a:gd name="T113" fmla="*/ 236 h 3056"/>
              <a:gd name="T114" fmla="*/ 2797 w 3064"/>
              <a:gd name="T115" fmla="*/ 5 h 3056"/>
              <a:gd name="T116" fmla="*/ 2950 w 3064"/>
              <a:gd name="T117" fmla="*/ 133 h 3056"/>
              <a:gd name="T118" fmla="*/ 2912 w 3064"/>
              <a:gd name="T119" fmla="*/ 436 h 305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</a:cxnLst>
            <a:rect l="0" t="0" r="r" b="b"/>
            <a:pathLst>
              <a:path w="3064" h="3056">
                <a:moveTo>
                  <a:pt x="391" y="2763"/>
                </a:moveTo>
                <a:lnTo>
                  <a:pt x="446" y="2730"/>
                </a:lnTo>
                <a:cubicBezTo>
                  <a:pt x="474" y="2776"/>
                  <a:pt x="485" y="2821"/>
                  <a:pt x="480" y="2864"/>
                </a:cubicBezTo>
                <a:cubicBezTo>
                  <a:pt x="475" y="2907"/>
                  <a:pt x="454" y="2947"/>
                  <a:pt x="419" y="2982"/>
                </a:cubicBezTo>
                <a:cubicBezTo>
                  <a:pt x="383" y="3018"/>
                  <a:pt x="346" y="3040"/>
                  <a:pt x="309" y="3048"/>
                </a:cubicBezTo>
                <a:cubicBezTo>
                  <a:pt x="272" y="3056"/>
                  <a:pt x="233" y="3052"/>
                  <a:pt x="193" y="3036"/>
                </a:cubicBezTo>
                <a:cubicBezTo>
                  <a:pt x="153" y="3019"/>
                  <a:pt x="117" y="2995"/>
                  <a:pt x="85" y="2963"/>
                </a:cubicBezTo>
                <a:cubicBezTo>
                  <a:pt x="50" y="2928"/>
                  <a:pt x="26" y="2891"/>
                  <a:pt x="14" y="2852"/>
                </a:cubicBezTo>
                <a:cubicBezTo>
                  <a:pt x="1" y="2812"/>
                  <a:pt x="0" y="2773"/>
                  <a:pt x="11" y="2735"/>
                </a:cubicBezTo>
                <a:cubicBezTo>
                  <a:pt x="23" y="2697"/>
                  <a:pt x="43" y="2663"/>
                  <a:pt x="73" y="2633"/>
                </a:cubicBezTo>
                <a:cubicBezTo>
                  <a:pt x="106" y="2600"/>
                  <a:pt x="143" y="2580"/>
                  <a:pt x="183" y="2574"/>
                </a:cubicBezTo>
                <a:cubicBezTo>
                  <a:pt x="223" y="2568"/>
                  <a:pt x="263" y="2576"/>
                  <a:pt x="303" y="2598"/>
                </a:cubicBezTo>
                <a:lnTo>
                  <a:pt x="270" y="2653"/>
                </a:lnTo>
                <a:cubicBezTo>
                  <a:pt x="238" y="2636"/>
                  <a:pt x="208" y="2629"/>
                  <a:pt x="182" y="2633"/>
                </a:cubicBezTo>
                <a:cubicBezTo>
                  <a:pt x="156" y="2637"/>
                  <a:pt x="132" y="2650"/>
                  <a:pt x="110" y="2672"/>
                </a:cubicBezTo>
                <a:cubicBezTo>
                  <a:pt x="84" y="2698"/>
                  <a:pt x="69" y="2726"/>
                  <a:pt x="64" y="2756"/>
                </a:cubicBezTo>
                <a:cubicBezTo>
                  <a:pt x="59" y="2785"/>
                  <a:pt x="63" y="2814"/>
                  <a:pt x="77" y="2842"/>
                </a:cubicBezTo>
                <a:cubicBezTo>
                  <a:pt x="91" y="2870"/>
                  <a:pt x="109" y="2895"/>
                  <a:pt x="131" y="2917"/>
                </a:cubicBezTo>
                <a:cubicBezTo>
                  <a:pt x="159" y="2946"/>
                  <a:pt x="189" y="2966"/>
                  <a:pt x="218" y="2979"/>
                </a:cubicBezTo>
                <a:cubicBezTo>
                  <a:pt x="248" y="2992"/>
                  <a:pt x="277" y="2995"/>
                  <a:pt x="305" y="2988"/>
                </a:cubicBezTo>
                <a:cubicBezTo>
                  <a:pt x="333" y="2981"/>
                  <a:pt x="357" y="2968"/>
                  <a:pt x="378" y="2947"/>
                </a:cubicBezTo>
                <a:cubicBezTo>
                  <a:pt x="403" y="2922"/>
                  <a:pt x="417" y="2894"/>
                  <a:pt x="419" y="2862"/>
                </a:cubicBezTo>
                <a:cubicBezTo>
                  <a:pt x="422" y="2831"/>
                  <a:pt x="413" y="2798"/>
                  <a:pt x="391" y="2763"/>
                </a:cubicBezTo>
                <a:close/>
                <a:moveTo>
                  <a:pt x="466" y="2680"/>
                </a:moveTo>
                <a:cubicBezTo>
                  <a:pt x="421" y="2635"/>
                  <a:pt x="400" y="2589"/>
                  <a:pt x="403" y="2543"/>
                </a:cubicBezTo>
                <a:cubicBezTo>
                  <a:pt x="406" y="2504"/>
                  <a:pt x="423" y="2469"/>
                  <a:pt x="453" y="2439"/>
                </a:cubicBezTo>
                <a:cubicBezTo>
                  <a:pt x="486" y="2406"/>
                  <a:pt x="524" y="2389"/>
                  <a:pt x="568" y="2390"/>
                </a:cubicBezTo>
                <a:cubicBezTo>
                  <a:pt x="611" y="2391"/>
                  <a:pt x="652" y="2410"/>
                  <a:pt x="690" y="2449"/>
                </a:cubicBezTo>
                <a:cubicBezTo>
                  <a:pt x="722" y="2480"/>
                  <a:pt x="742" y="2510"/>
                  <a:pt x="750" y="2537"/>
                </a:cubicBezTo>
                <a:cubicBezTo>
                  <a:pt x="759" y="2564"/>
                  <a:pt x="759" y="2592"/>
                  <a:pt x="751" y="2620"/>
                </a:cubicBezTo>
                <a:cubicBezTo>
                  <a:pt x="743" y="2648"/>
                  <a:pt x="728" y="2672"/>
                  <a:pt x="707" y="2693"/>
                </a:cubicBezTo>
                <a:cubicBezTo>
                  <a:pt x="673" y="2728"/>
                  <a:pt x="635" y="2744"/>
                  <a:pt x="592" y="2743"/>
                </a:cubicBezTo>
                <a:cubicBezTo>
                  <a:pt x="549" y="2743"/>
                  <a:pt x="507" y="2722"/>
                  <a:pt x="466" y="2680"/>
                </a:cubicBezTo>
                <a:close/>
                <a:moveTo>
                  <a:pt x="508" y="2638"/>
                </a:moveTo>
                <a:cubicBezTo>
                  <a:pt x="539" y="2669"/>
                  <a:pt x="569" y="2686"/>
                  <a:pt x="599" y="2688"/>
                </a:cubicBezTo>
                <a:cubicBezTo>
                  <a:pt x="628" y="2690"/>
                  <a:pt x="653" y="2680"/>
                  <a:pt x="673" y="2660"/>
                </a:cubicBezTo>
                <a:cubicBezTo>
                  <a:pt x="694" y="2639"/>
                  <a:pt x="703" y="2614"/>
                  <a:pt x="701" y="2585"/>
                </a:cubicBezTo>
                <a:cubicBezTo>
                  <a:pt x="699" y="2556"/>
                  <a:pt x="682" y="2525"/>
                  <a:pt x="650" y="2493"/>
                </a:cubicBezTo>
                <a:cubicBezTo>
                  <a:pt x="620" y="2463"/>
                  <a:pt x="590" y="2447"/>
                  <a:pt x="561" y="2445"/>
                </a:cubicBezTo>
                <a:cubicBezTo>
                  <a:pt x="532" y="2444"/>
                  <a:pt x="507" y="2453"/>
                  <a:pt x="487" y="2473"/>
                </a:cubicBezTo>
                <a:cubicBezTo>
                  <a:pt x="466" y="2494"/>
                  <a:pt x="457" y="2519"/>
                  <a:pt x="459" y="2548"/>
                </a:cubicBezTo>
                <a:cubicBezTo>
                  <a:pt x="460" y="2577"/>
                  <a:pt x="477" y="2607"/>
                  <a:pt x="508" y="2638"/>
                </a:cubicBezTo>
                <a:close/>
                <a:moveTo>
                  <a:pt x="869" y="2521"/>
                </a:moveTo>
                <a:lnTo>
                  <a:pt x="625" y="2277"/>
                </a:lnTo>
                <a:lnTo>
                  <a:pt x="662" y="2240"/>
                </a:lnTo>
                <a:lnTo>
                  <a:pt x="697" y="2275"/>
                </a:lnTo>
                <a:cubicBezTo>
                  <a:pt x="688" y="2230"/>
                  <a:pt x="701" y="2191"/>
                  <a:pt x="734" y="2157"/>
                </a:cubicBezTo>
                <a:cubicBezTo>
                  <a:pt x="749" y="2143"/>
                  <a:pt x="765" y="2132"/>
                  <a:pt x="783" y="2125"/>
                </a:cubicBezTo>
                <a:cubicBezTo>
                  <a:pt x="800" y="2118"/>
                  <a:pt x="816" y="2115"/>
                  <a:pt x="831" y="2118"/>
                </a:cubicBezTo>
                <a:cubicBezTo>
                  <a:pt x="846" y="2120"/>
                  <a:pt x="860" y="2126"/>
                  <a:pt x="874" y="2136"/>
                </a:cubicBezTo>
                <a:cubicBezTo>
                  <a:pt x="884" y="2142"/>
                  <a:pt x="898" y="2154"/>
                  <a:pt x="917" y="2173"/>
                </a:cubicBezTo>
                <a:lnTo>
                  <a:pt x="1066" y="2323"/>
                </a:lnTo>
                <a:lnTo>
                  <a:pt x="1025" y="2364"/>
                </a:lnTo>
                <a:lnTo>
                  <a:pt x="877" y="2216"/>
                </a:lnTo>
                <a:cubicBezTo>
                  <a:pt x="860" y="2199"/>
                  <a:pt x="846" y="2188"/>
                  <a:pt x="835" y="2183"/>
                </a:cubicBezTo>
                <a:cubicBezTo>
                  <a:pt x="823" y="2178"/>
                  <a:pt x="811" y="2177"/>
                  <a:pt x="798" y="2180"/>
                </a:cubicBezTo>
                <a:cubicBezTo>
                  <a:pt x="784" y="2184"/>
                  <a:pt x="772" y="2191"/>
                  <a:pt x="761" y="2202"/>
                </a:cubicBezTo>
                <a:cubicBezTo>
                  <a:pt x="744" y="2219"/>
                  <a:pt x="734" y="2240"/>
                  <a:pt x="733" y="2264"/>
                </a:cubicBezTo>
                <a:cubicBezTo>
                  <a:pt x="731" y="2288"/>
                  <a:pt x="746" y="2315"/>
                  <a:pt x="777" y="2347"/>
                </a:cubicBezTo>
                <a:lnTo>
                  <a:pt x="910" y="2480"/>
                </a:lnTo>
                <a:lnTo>
                  <a:pt x="869" y="2521"/>
                </a:lnTo>
                <a:close/>
                <a:moveTo>
                  <a:pt x="1182" y="2134"/>
                </a:moveTo>
                <a:lnTo>
                  <a:pt x="1224" y="2164"/>
                </a:lnTo>
                <a:cubicBezTo>
                  <a:pt x="1215" y="2178"/>
                  <a:pt x="1206" y="2190"/>
                  <a:pt x="1197" y="2199"/>
                </a:cubicBezTo>
                <a:cubicBezTo>
                  <a:pt x="1182" y="2214"/>
                  <a:pt x="1168" y="2223"/>
                  <a:pt x="1155" y="2227"/>
                </a:cubicBezTo>
                <a:cubicBezTo>
                  <a:pt x="1142" y="2230"/>
                  <a:pt x="1130" y="2230"/>
                  <a:pt x="1119" y="2226"/>
                </a:cubicBezTo>
                <a:cubicBezTo>
                  <a:pt x="1108" y="2221"/>
                  <a:pt x="1090" y="2207"/>
                  <a:pt x="1065" y="2182"/>
                </a:cubicBezTo>
                <a:lnTo>
                  <a:pt x="925" y="2042"/>
                </a:lnTo>
                <a:lnTo>
                  <a:pt x="895" y="2072"/>
                </a:lnTo>
                <a:lnTo>
                  <a:pt x="863" y="2040"/>
                </a:lnTo>
                <a:lnTo>
                  <a:pt x="893" y="2010"/>
                </a:lnTo>
                <a:lnTo>
                  <a:pt x="833" y="1949"/>
                </a:lnTo>
                <a:lnTo>
                  <a:pt x="849" y="1884"/>
                </a:lnTo>
                <a:lnTo>
                  <a:pt x="934" y="1969"/>
                </a:lnTo>
                <a:lnTo>
                  <a:pt x="975" y="1927"/>
                </a:lnTo>
                <a:lnTo>
                  <a:pt x="1008" y="1959"/>
                </a:lnTo>
                <a:lnTo>
                  <a:pt x="966" y="2001"/>
                </a:lnTo>
                <a:lnTo>
                  <a:pt x="1108" y="2143"/>
                </a:lnTo>
                <a:cubicBezTo>
                  <a:pt x="1120" y="2155"/>
                  <a:pt x="1129" y="2162"/>
                  <a:pt x="1133" y="2164"/>
                </a:cubicBezTo>
                <a:cubicBezTo>
                  <a:pt x="1138" y="2166"/>
                  <a:pt x="1143" y="2166"/>
                  <a:pt x="1148" y="2165"/>
                </a:cubicBezTo>
                <a:cubicBezTo>
                  <a:pt x="1154" y="2163"/>
                  <a:pt x="1159" y="2160"/>
                  <a:pt x="1166" y="2153"/>
                </a:cubicBezTo>
                <a:cubicBezTo>
                  <a:pt x="1170" y="2149"/>
                  <a:pt x="1176" y="2142"/>
                  <a:pt x="1182" y="2134"/>
                </a:cubicBezTo>
                <a:close/>
                <a:moveTo>
                  <a:pt x="1259" y="2131"/>
                </a:moveTo>
                <a:lnTo>
                  <a:pt x="1015" y="1888"/>
                </a:lnTo>
                <a:lnTo>
                  <a:pt x="1052" y="1850"/>
                </a:lnTo>
                <a:lnTo>
                  <a:pt x="1089" y="1887"/>
                </a:lnTo>
                <a:cubicBezTo>
                  <a:pt x="1081" y="1861"/>
                  <a:pt x="1079" y="1840"/>
                  <a:pt x="1081" y="1827"/>
                </a:cubicBezTo>
                <a:cubicBezTo>
                  <a:pt x="1084" y="1813"/>
                  <a:pt x="1090" y="1802"/>
                  <a:pt x="1099" y="1792"/>
                </a:cubicBezTo>
                <a:cubicBezTo>
                  <a:pt x="1113" y="1778"/>
                  <a:pt x="1132" y="1769"/>
                  <a:pt x="1155" y="1763"/>
                </a:cubicBezTo>
                <a:lnTo>
                  <a:pt x="1179" y="1816"/>
                </a:lnTo>
                <a:cubicBezTo>
                  <a:pt x="1163" y="1820"/>
                  <a:pt x="1150" y="1827"/>
                  <a:pt x="1140" y="1837"/>
                </a:cubicBezTo>
                <a:cubicBezTo>
                  <a:pt x="1131" y="1846"/>
                  <a:pt x="1126" y="1857"/>
                  <a:pt x="1124" y="1869"/>
                </a:cubicBezTo>
                <a:cubicBezTo>
                  <a:pt x="1122" y="1882"/>
                  <a:pt x="1124" y="1895"/>
                  <a:pt x="1131" y="1907"/>
                </a:cubicBezTo>
                <a:cubicBezTo>
                  <a:pt x="1141" y="1927"/>
                  <a:pt x="1155" y="1945"/>
                  <a:pt x="1172" y="1962"/>
                </a:cubicBezTo>
                <a:lnTo>
                  <a:pt x="1300" y="2090"/>
                </a:lnTo>
                <a:lnTo>
                  <a:pt x="1259" y="2131"/>
                </a:lnTo>
                <a:close/>
                <a:moveTo>
                  <a:pt x="1280" y="1866"/>
                </a:moveTo>
                <a:cubicBezTo>
                  <a:pt x="1235" y="1821"/>
                  <a:pt x="1214" y="1775"/>
                  <a:pt x="1218" y="1728"/>
                </a:cubicBezTo>
                <a:cubicBezTo>
                  <a:pt x="1221" y="1689"/>
                  <a:pt x="1237" y="1655"/>
                  <a:pt x="1267" y="1624"/>
                </a:cubicBezTo>
                <a:cubicBezTo>
                  <a:pt x="1301" y="1591"/>
                  <a:pt x="1339" y="1575"/>
                  <a:pt x="1382" y="1575"/>
                </a:cubicBezTo>
                <a:cubicBezTo>
                  <a:pt x="1425" y="1576"/>
                  <a:pt x="1466" y="1596"/>
                  <a:pt x="1505" y="1634"/>
                </a:cubicBezTo>
                <a:cubicBezTo>
                  <a:pt x="1536" y="1666"/>
                  <a:pt x="1556" y="1695"/>
                  <a:pt x="1565" y="1722"/>
                </a:cubicBezTo>
                <a:cubicBezTo>
                  <a:pt x="1573" y="1750"/>
                  <a:pt x="1574" y="1777"/>
                  <a:pt x="1566" y="1805"/>
                </a:cubicBezTo>
                <a:cubicBezTo>
                  <a:pt x="1558" y="1833"/>
                  <a:pt x="1543" y="1858"/>
                  <a:pt x="1522" y="1879"/>
                </a:cubicBezTo>
                <a:cubicBezTo>
                  <a:pt x="1488" y="1913"/>
                  <a:pt x="1449" y="1930"/>
                  <a:pt x="1406" y="1929"/>
                </a:cubicBezTo>
                <a:cubicBezTo>
                  <a:pt x="1363" y="1928"/>
                  <a:pt x="1321" y="1907"/>
                  <a:pt x="1280" y="1866"/>
                </a:cubicBezTo>
                <a:close/>
                <a:moveTo>
                  <a:pt x="1323" y="1823"/>
                </a:moveTo>
                <a:cubicBezTo>
                  <a:pt x="1354" y="1855"/>
                  <a:pt x="1384" y="1871"/>
                  <a:pt x="1413" y="1873"/>
                </a:cubicBezTo>
                <a:cubicBezTo>
                  <a:pt x="1442" y="1875"/>
                  <a:pt x="1467" y="1866"/>
                  <a:pt x="1488" y="1845"/>
                </a:cubicBezTo>
                <a:cubicBezTo>
                  <a:pt x="1508" y="1824"/>
                  <a:pt x="1517" y="1800"/>
                  <a:pt x="1515" y="1770"/>
                </a:cubicBezTo>
                <a:cubicBezTo>
                  <a:pt x="1513" y="1741"/>
                  <a:pt x="1497" y="1711"/>
                  <a:pt x="1465" y="1679"/>
                </a:cubicBezTo>
                <a:cubicBezTo>
                  <a:pt x="1434" y="1649"/>
                  <a:pt x="1405" y="1633"/>
                  <a:pt x="1376" y="1631"/>
                </a:cubicBezTo>
                <a:cubicBezTo>
                  <a:pt x="1346" y="1629"/>
                  <a:pt x="1322" y="1638"/>
                  <a:pt x="1301" y="1659"/>
                </a:cubicBezTo>
                <a:cubicBezTo>
                  <a:pt x="1281" y="1679"/>
                  <a:pt x="1271" y="1704"/>
                  <a:pt x="1273" y="1733"/>
                </a:cubicBezTo>
                <a:cubicBezTo>
                  <a:pt x="1275" y="1762"/>
                  <a:pt x="1292" y="1792"/>
                  <a:pt x="1323" y="1823"/>
                </a:cubicBezTo>
                <a:close/>
                <a:moveTo>
                  <a:pt x="1677" y="1713"/>
                </a:moveTo>
                <a:lnTo>
                  <a:pt x="1341" y="1377"/>
                </a:lnTo>
                <a:lnTo>
                  <a:pt x="1382" y="1336"/>
                </a:lnTo>
                <a:lnTo>
                  <a:pt x="1718" y="1672"/>
                </a:lnTo>
                <a:lnTo>
                  <a:pt x="1677" y="1713"/>
                </a:lnTo>
                <a:close/>
                <a:moveTo>
                  <a:pt x="1951" y="1359"/>
                </a:moveTo>
                <a:lnTo>
                  <a:pt x="1990" y="1399"/>
                </a:lnTo>
                <a:lnTo>
                  <a:pt x="1768" y="1621"/>
                </a:lnTo>
                <a:cubicBezTo>
                  <a:pt x="1758" y="1612"/>
                  <a:pt x="1750" y="1600"/>
                  <a:pt x="1744" y="1588"/>
                </a:cubicBezTo>
                <a:cubicBezTo>
                  <a:pt x="1735" y="1567"/>
                  <a:pt x="1729" y="1543"/>
                  <a:pt x="1727" y="1516"/>
                </a:cubicBezTo>
                <a:cubicBezTo>
                  <a:pt x="1725" y="1489"/>
                  <a:pt x="1726" y="1454"/>
                  <a:pt x="1730" y="1411"/>
                </a:cubicBezTo>
                <a:cubicBezTo>
                  <a:pt x="1737" y="1345"/>
                  <a:pt x="1738" y="1296"/>
                  <a:pt x="1733" y="1266"/>
                </a:cubicBezTo>
                <a:cubicBezTo>
                  <a:pt x="1728" y="1235"/>
                  <a:pt x="1718" y="1212"/>
                  <a:pt x="1703" y="1197"/>
                </a:cubicBezTo>
                <a:cubicBezTo>
                  <a:pt x="1686" y="1181"/>
                  <a:pt x="1667" y="1173"/>
                  <a:pt x="1644" y="1173"/>
                </a:cubicBezTo>
                <a:cubicBezTo>
                  <a:pt x="1621" y="1173"/>
                  <a:pt x="1600" y="1183"/>
                  <a:pt x="1581" y="1202"/>
                </a:cubicBezTo>
                <a:cubicBezTo>
                  <a:pt x="1561" y="1222"/>
                  <a:pt x="1551" y="1244"/>
                  <a:pt x="1551" y="1267"/>
                </a:cubicBezTo>
                <a:cubicBezTo>
                  <a:pt x="1551" y="1291"/>
                  <a:pt x="1562" y="1314"/>
                  <a:pt x="1583" y="1335"/>
                </a:cubicBezTo>
                <a:lnTo>
                  <a:pt x="1536" y="1373"/>
                </a:lnTo>
                <a:cubicBezTo>
                  <a:pt x="1507" y="1339"/>
                  <a:pt x="1494" y="1304"/>
                  <a:pt x="1496" y="1268"/>
                </a:cubicBezTo>
                <a:cubicBezTo>
                  <a:pt x="1499" y="1233"/>
                  <a:pt x="1516" y="1199"/>
                  <a:pt x="1548" y="1167"/>
                </a:cubicBezTo>
                <a:cubicBezTo>
                  <a:pt x="1580" y="1135"/>
                  <a:pt x="1614" y="1118"/>
                  <a:pt x="1651" y="1117"/>
                </a:cubicBezTo>
                <a:cubicBezTo>
                  <a:pt x="1688" y="1116"/>
                  <a:pt x="1719" y="1129"/>
                  <a:pt x="1746" y="1155"/>
                </a:cubicBezTo>
                <a:cubicBezTo>
                  <a:pt x="1759" y="1169"/>
                  <a:pt x="1770" y="1185"/>
                  <a:pt x="1777" y="1203"/>
                </a:cubicBezTo>
                <a:cubicBezTo>
                  <a:pt x="1785" y="1222"/>
                  <a:pt x="1789" y="1245"/>
                  <a:pt x="1791" y="1272"/>
                </a:cubicBezTo>
                <a:cubicBezTo>
                  <a:pt x="1793" y="1299"/>
                  <a:pt x="1791" y="1340"/>
                  <a:pt x="1786" y="1395"/>
                </a:cubicBezTo>
                <a:cubicBezTo>
                  <a:pt x="1782" y="1440"/>
                  <a:pt x="1781" y="1470"/>
                  <a:pt x="1781" y="1484"/>
                </a:cubicBezTo>
                <a:cubicBezTo>
                  <a:pt x="1781" y="1499"/>
                  <a:pt x="1783" y="1512"/>
                  <a:pt x="1786" y="1524"/>
                </a:cubicBezTo>
                <a:lnTo>
                  <a:pt x="1951" y="1359"/>
                </a:lnTo>
                <a:close/>
                <a:moveTo>
                  <a:pt x="1887" y="925"/>
                </a:moveTo>
                <a:lnTo>
                  <a:pt x="1840" y="878"/>
                </a:lnTo>
                <a:lnTo>
                  <a:pt x="1881" y="837"/>
                </a:lnTo>
                <a:lnTo>
                  <a:pt x="1928" y="884"/>
                </a:lnTo>
                <a:lnTo>
                  <a:pt x="1887" y="925"/>
                </a:lnTo>
                <a:close/>
                <a:moveTo>
                  <a:pt x="2176" y="1214"/>
                </a:moveTo>
                <a:lnTo>
                  <a:pt x="1932" y="970"/>
                </a:lnTo>
                <a:lnTo>
                  <a:pt x="1973" y="929"/>
                </a:lnTo>
                <a:lnTo>
                  <a:pt x="2217" y="1173"/>
                </a:lnTo>
                <a:lnTo>
                  <a:pt x="2176" y="1214"/>
                </a:lnTo>
                <a:close/>
                <a:moveTo>
                  <a:pt x="2288" y="1101"/>
                </a:moveTo>
                <a:lnTo>
                  <a:pt x="1952" y="765"/>
                </a:lnTo>
                <a:lnTo>
                  <a:pt x="2079" y="639"/>
                </a:lnTo>
                <a:cubicBezTo>
                  <a:pt x="2101" y="616"/>
                  <a:pt x="2119" y="600"/>
                  <a:pt x="2133" y="591"/>
                </a:cubicBezTo>
                <a:cubicBezTo>
                  <a:pt x="2152" y="577"/>
                  <a:pt x="2171" y="568"/>
                  <a:pt x="2190" y="565"/>
                </a:cubicBezTo>
                <a:cubicBezTo>
                  <a:pt x="2209" y="561"/>
                  <a:pt x="2229" y="563"/>
                  <a:pt x="2250" y="570"/>
                </a:cubicBezTo>
                <a:cubicBezTo>
                  <a:pt x="2270" y="577"/>
                  <a:pt x="2289" y="589"/>
                  <a:pt x="2306" y="606"/>
                </a:cubicBezTo>
                <a:cubicBezTo>
                  <a:pt x="2334" y="635"/>
                  <a:pt x="2349" y="668"/>
                  <a:pt x="2351" y="706"/>
                </a:cubicBezTo>
                <a:cubicBezTo>
                  <a:pt x="2353" y="744"/>
                  <a:pt x="2330" y="787"/>
                  <a:pt x="2282" y="834"/>
                </a:cubicBezTo>
                <a:lnTo>
                  <a:pt x="2196" y="920"/>
                </a:lnTo>
                <a:lnTo>
                  <a:pt x="2333" y="1057"/>
                </a:lnTo>
                <a:lnTo>
                  <a:pt x="2288" y="1101"/>
                </a:lnTo>
                <a:close/>
                <a:moveTo>
                  <a:pt x="2156" y="881"/>
                </a:moveTo>
                <a:lnTo>
                  <a:pt x="2243" y="794"/>
                </a:lnTo>
                <a:cubicBezTo>
                  <a:pt x="2272" y="765"/>
                  <a:pt x="2287" y="739"/>
                  <a:pt x="2288" y="717"/>
                </a:cubicBezTo>
                <a:cubicBezTo>
                  <a:pt x="2290" y="694"/>
                  <a:pt x="2281" y="673"/>
                  <a:pt x="2261" y="653"/>
                </a:cubicBezTo>
                <a:cubicBezTo>
                  <a:pt x="2247" y="639"/>
                  <a:pt x="2232" y="631"/>
                  <a:pt x="2215" y="628"/>
                </a:cubicBezTo>
                <a:cubicBezTo>
                  <a:pt x="2197" y="625"/>
                  <a:pt x="2181" y="628"/>
                  <a:pt x="2167" y="636"/>
                </a:cubicBezTo>
                <a:cubicBezTo>
                  <a:pt x="2157" y="642"/>
                  <a:pt x="2142" y="654"/>
                  <a:pt x="2122" y="675"/>
                </a:cubicBezTo>
                <a:lnTo>
                  <a:pt x="2036" y="761"/>
                </a:lnTo>
                <a:lnTo>
                  <a:pt x="2156" y="881"/>
                </a:lnTo>
                <a:close/>
                <a:moveTo>
                  <a:pt x="2476" y="697"/>
                </a:moveTo>
                <a:lnTo>
                  <a:pt x="2514" y="652"/>
                </a:lnTo>
                <a:cubicBezTo>
                  <a:pt x="2533" y="667"/>
                  <a:pt x="2552" y="676"/>
                  <a:pt x="2570" y="679"/>
                </a:cubicBezTo>
                <a:cubicBezTo>
                  <a:pt x="2588" y="683"/>
                  <a:pt x="2608" y="680"/>
                  <a:pt x="2630" y="672"/>
                </a:cubicBezTo>
                <a:cubicBezTo>
                  <a:pt x="2652" y="663"/>
                  <a:pt x="2672" y="649"/>
                  <a:pt x="2691" y="630"/>
                </a:cubicBezTo>
                <a:cubicBezTo>
                  <a:pt x="2708" y="613"/>
                  <a:pt x="2721" y="596"/>
                  <a:pt x="2729" y="578"/>
                </a:cubicBezTo>
                <a:cubicBezTo>
                  <a:pt x="2737" y="560"/>
                  <a:pt x="2739" y="543"/>
                  <a:pt x="2737" y="528"/>
                </a:cubicBezTo>
                <a:cubicBezTo>
                  <a:pt x="2734" y="513"/>
                  <a:pt x="2728" y="500"/>
                  <a:pt x="2718" y="490"/>
                </a:cubicBezTo>
                <a:cubicBezTo>
                  <a:pt x="2707" y="479"/>
                  <a:pt x="2695" y="473"/>
                  <a:pt x="2681" y="471"/>
                </a:cubicBezTo>
                <a:cubicBezTo>
                  <a:pt x="2667" y="469"/>
                  <a:pt x="2650" y="473"/>
                  <a:pt x="2631" y="481"/>
                </a:cubicBezTo>
                <a:cubicBezTo>
                  <a:pt x="2618" y="487"/>
                  <a:pt x="2593" y="501"/>
                  <a:pt x="2554" y="525"/>
                </a:cubicBezTo>
                <a:cubicBezTo>
                  <a:pt x="2516" y="548"/>
                  <a:pt x="2488" y="563"/>
                  <a:pt x="2469" y="569"/>
                </a:cubicBezTo>
                <a:cubicBezTo>
                  <a:pt x="2444" y="576"/>
                  <a:pt x="2422" y="578"/>
                  <a:pt x="2401" y="573"/>
                </a:cubicBezTo>
                <a:cubicBezTo>
                  <a:pt x="2381" y="569"/>
                  <a:pt x="2363" y="559"/>
                  <a:pt x="2348" y="543"/>
                </a:cubicBezTo>
                <a:cubicBezTo>
                  <a:pt x="2331" y="526"/>
                  <a:pt x="2320" y="506"/>
                  <a:pt x="2315" y="481"/>
                </a:cubicBezTo>
                <a:cubicBezTo>
                  <a:pt x="2310" y="457"/>
                  <a:pt x="2312" y="432"/>
                  <a:pt x="2323" y="406"/>
                </a:cubicBezTo>
                <a:cubicBezTo>
                  <a:pt x="2334" y="379"/>
                  <a:pt x="2351" y="355"/>
                  <a:pt x="2373" y="332"/>
                </a:cubicBezTo>
                <a:cubicBezTo>
                  <a:pt x="2398" y="308"/>
                  <a:pt x="2424" y="290"/>
                  <a:pt x="2451" y="279"/>
                </a:cubicBezTo>
                <a:cubicBezTo>
                  <a:pt x="2478" y="268"/>
                  <a:pt x="2505" y="265"/>
                  <a:pt x="2531" y="270"/>
                </a:cubicBezTo>
                <a:cubicBezTo>
                  <a:pt x="2557" y="275"/>
                  <a:pt x="2580" y="288"/>
                  <a:pt x="2600" y="307"/>
                </a:cubicBezTo>
                <a:lnTo>
                  <a:pt x="2561" y="352"/>
                </a:lnTo>
                <a:cubicBezTo>
                  <a:pt x="2537" y="333"/>
                  <a:pt x="2513" y="325"/>
                  <a:pt x="2489" y="328"/>
                </a:cubicBezTo>
                <a:cubicBezTo>
                  <a:pt x="2465" y="330"/>
                  <a:pt x="2440" y="344"/>
                  <a:pt x="2414" y="370"/>
                </a:cubicBezTo>
                <a:cubicBezTo>
                  <a:pt x="2388" y="397"/>
                  <a:pt x="2373" y="421"/>
                  <a:pt x="2370" y="443"/>
                </a:cubicBezTo>
                <a:cubicBezTo>
                  <a:pt x="2368" y="466"/>
                  <a:pt x="2374" y="484"/>
                  <a:pt x="2388" y="498"/>
                </a:cubicBezTo>
                <a:cubicBezTo>
                  <a:pt x="2400" y="510"/>
                  <a:pt x="2414" y="515"/>
                  <a:pt x="2431" y="514"/>
                </a:cubicBezTo>
                <a:cubicBezTo>
                  <a:pt x="2447" y="514"/>
                  <a:pt x="2477" y="499"/>
                  <a:pt x="2522" y="471"/>
                </a:cubicBezTo>
                <a:cubicBezTo>
                  <a:pt x="2566" y="443"/>
                  <a:pt x="2598" y="426"/>
                  <a:pt x="2617" y="418"/>
                </a:cubicBezTo>
                <a:cubicBezTo>
                  <a:pt x="2646" y="408"/>
                  <a:pt x="2672" y="405"/>
                  <a:pt x="2695" y="409"/>
                </a:cubicBezTo>
                <a:cubicBezTo>
                  <a:pt x="2718" y="414"/>
                  <a:pt x="2739" y="425"/>
                  <a:pt x="2757" y="443"/>
                </a:cubicBezTo>
                <a:cubicBezTo>
                  <a:pt x="2775" y="461"/>
                  <a:pt x="2786" y="483"/>
                  <a:pt x="2792" y="509"/>
                </a:cubicBezTo>
                <a:cubicBezTo>
                  <a:pt x="2798" y="535"/>
                  <a:pt x="2795" y="562"/>
                  <a:pt x="2785" y="590"/>
                </a:cubicBezTo>
                <a:cubicBezTo>
                  <a:pt x="2774" y="618"/>
                  <a:pt x="2757" y="644"/>
                  <a:pt x="2733" y="668"/>
                </a:cubicBezTo>
                <a:cubicBezTo>
                  <a:pt x="2703" y="698"/>
                  <a:pt x="2673" y="719"/>
                  <a:pt x="2643" y="731"/>
                </a:cubicBezTo>
                <a:cubicBezTo>
                  <a:pt x="2614" y="743"/>
                  <a:pt x="2585" y="746"/>
                  <a:pt x="2555" y="739"/>
                </a:cubicBezTo>
                <a:cubicBezTo>
                  <a:pt x="2526" y="733"/>
                  <a:pt x="2499" y="719"/>
                  <a:pt x="2476" y="697"/>
                </a:cubicBezTo>
                <a:close/>
                <a:moveTo>
                  <a:pt x="2811" y="401"/>
                </a:moveTo>
                <a:lnTo>
                  <a:pt x="2847" y="355"/>
                </a:lnTo>
                <a:cubicBezTo>
                  <a:pt x="2875" y="373"/>
                  <a:pt x="2900" y="382"/>
                  <a:pt x="2921" y="381"/>
                </a:cubicBezTo>
                <a:cubicBezTo>
                  <a:pt x="2943" y="380"/>
                  <a:pt x="2962" y="371"/>
                  <a:pt x="2978" y="355"/>
                </a:cubicBezTo>
                <a:cubicBezTo>
                  <a:pt x="2998" y="335"/>
                  <a:pt x="3007" y="312"/>
                  <a:pt x="3007" y="285"/>
                </a:cubicBezTo>
                <a:cubicBezTo>
                  <a:pt x="3007" y="259"/>
                  <a:pt x="2997" y="235"/>
                  <a:pt x="2977" y="215"/>
                </a:cubicBezTo>
                <a:cubicBezTo>
                  <a:pt x="2959" y="196"/>
                  <a:pt x="2937" y="187"/>
                  <a:pt x="2912" y="187"/>
                </a:cubicBezTo>
                <a:cubicBezTo>
                  <a:pt x="2887" y="187"/>
                  <a:pt x="2865" y="197"/>
                  <a:pt x="2846" y="216"/>
                </a:cubicBezTo>
                <a:cubicBezTo>
                  <a:pt x="2839" y="224"/>
                  <a:pt x="2830" y="235"/>
                  <a:pt x="2822" y="250"/>
                </a:cubicBezTo>
                <a:lnTo>
                  <a:pt x="2790" y="209"/>
                </a:lnTo>
                <a:cubicBezTo>
                  <a:pt x="2793" y="206"/>
                  <a:pt x="2796" y="204"/>
                  <a:pt x="2797" y="203"/>
                </a:cubicBezTo>
                <a:cubicBezTo>
                  <a:pt x="2815" y="185"/>
                  <a:pt x="2826" y="165"/>
                  <a:pt x="2831" y="141"/>
                </a:cubicBezTo>
                <a:cubicBezTo>
                  <a:pt x="2836" y="118"/>
                  <a:pt x="2829" y="97"/>
                  <a:pt x="2810" y="78"/>
                </a:cubicBezTo>
                <a:cubicBezTo>
                  <a:pt x="2795" y="63"/>
                  <a:pt x="2777" y="55"/>
                  <a:pt x="2757" y="56"/>
                </a:cubicBezTo>
                <a:cubicBezTo>
                  <a:pt x="2737" y="56"/>
                  <a:pt x="2718" y="64"/>
                  <a:pt x="2702" y="80"/>
                </a:cubicBezTo>
                <a:cubicBezTo>
                  <a:pt x="2686" y="96"/>
                  <a:pt x="2678" y="115"/>
                  <a:pt x="2677" y="136"/>
                </a:cubicBezTo>
                <a:cubicBezTo>
                  <a:pt x="2677" y="156"/>
                  <a:pt x="2685" y="178"/>
                  <a:pt x="2702" y="202"/>
                </a:cubicBezTo>
                <a:lnTo>
                  <a:pt x="2653" y="236"/>
                </a:lnTo>
                <a:cubicBezTo>
                  <a:pt x="2631" y="203"/>
                  <a:pt x="2621" y="170"/>
                  <a:pt x="2623" y="137"/>
                </a:cubicBezTo>
                <a:cubicBezTo>
                  <a:pt x="2626" y="104"/>
                  <a:pt x="2641" y="74"/>
                  <a:pt x="2667" y="47"/>
                </a:cubicBezTo>
                <a:cubicBezTo>
                  <a:pt x="2686" y="29"/>
                  <a:pt x="2706" y="16"/>
                  <a:pt x="2730" y="8"/>
                </a:cubicBezTo>
                <a:cubicBezTo>
                  <a:pt x="2753" y="1"/>
                  <a:pt x="2776" y="0"/>
                  <a:pt x="2797" y="5"/>
                </a:cubicBezTo>
                <a:cubicBezTo>
                  <a:pt x="2819" y="11"/>
                  <a:pt x="2838" y="21"/>
                  <a:pt x="2853" y="36"/>
                </a:cubicBezTo>
                <a:cubicBezTo>
                  <a:pt x="2868" y="51"/>
                  <a:pt x="2877" y="68"/>
                  <a:pt x="2881" y="88"/>
                </a:cubicBezTo>
                <a:cubicBezTo>
                  <a:pt x="2885" y="107"/>
                  <a:pt x="2883" y="128"/>
                  <a:pt x="2875" y="151"/>
                </a:cubicBezTo>
                <a:cubicBezTo>
                  <a:pt x="2899" y="135"/>
                  <a:pt x="2924" y="130"/>
                  <a:pt x="2950" y="133"/>
                </a:cubicBezTo>
                <a:cubicBezTo>
                  <a:pt x="2975" y="136"/>
                  <a:pt x="2999" y="149"/>
                  <a:pt x="3020" y="171"/>
                </a:cubicBezTo>
                <a:cubicBezTo>
                  <a:pt x="3050" y="200"/>
                  <a:pt x="3064" y="236"/>
                  <a:pt x="3063" y="277"/>
                </a:cubicBezTo>
                <a:cubicBezTo>
                  <a:pt x="3062" y="319"/>
                  <a:pt x="3045" y="356"/>
                  <a:pt x="3012" y="389"/>
                </a:cubicBezTo>
                <a:cubicBezTo>
                  <a:pt x="2983" y="419"/>
                  <a:pt x="2950" y="434"/>
                  <a:pt x="2912" y="436"/>
                </a:cubicBezTo>
                <a:cubicBezTo>
                  <a:pt x="2875" y="438"/>
                  <a:pt x="2842" y="427"/>
                  <a:pt x="2811" y="401"/>
                </a:cubicBez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83" name="Freeform 65"/>
          <p:cNvSpPr>
            <a:spLocks noEditPoints="1"/>
          </p:cNvSpPr>
          <p:nvPr/>
        </p:nvSpPr>
        <p:spPr bwMode="auto">
          <a:xfrm>
            <a:off x="2013128" y="4611475"/>
            <a:ext cx="582612" cy="582612"/>
          </a:xfrm>
          <a:custGeom>
            <a:avLst/>
            <a:gdLst>
              <a:gd name="T0" fmla="*/ 419 w 3054"/>
              <a:gd name="T1" fmla="*/ 2985 h 3059"/>
              <a:gd name="T2" fmla="*/ 13 w 3054"/>
              <a:gd name="T3" fmla="*/ 2855 h 3059"/>
              <a:gd name="T4" fmla="*/ 303 w 3054"/>
              <a:gd name="T5" fmla="*/ 2601 h 3059"/>
              <a:gd name="T6" fmla="*/ 63 w 3054"/>
              <a:gd name="T7" fmla="*/ 2759 h 3059"/>
              <a:gd name="T8" fmla="*/ 304 w 3054"/>
              <a:gd name="T9" fmla="*/ 2991 h 3059"/>
              <a:gd name="T10" fmla="*/ 465 w 3054"/>
              <a:gd name="T11" fmla="*/ 2683 h 3059"/>
              <a:gd name="T12" fmla="*/ 690 w 3054"/>
              <a:gd name="T13" fmla="*/ 2452 h 3059"/>
              <a:gd name="T14" fmla="*/ 591 w 3054"/>
              <a:gd name="T15" fmla="*/ 2746 h 3059"/>
              <a:gd name="T16" fmla="*/ 673 w 3054"/>
              <a:gd name="T17" fmla="*/ 2663 h 3059"/>
              <a:gd name="T18" fmla="*/ 486 w 3054"/>
              <a:gd name="T19" fmla="*/ 2476 h 3059"/>
              <a:gd name="T20" fmla="*/ 625 w 3054"/>
              <a:gd name="T21" fmla="*/ 2280 h 3059"/>
              <a:gd name="T22" fmla="*/ 782 w 3054"/>
              <a:gd name="T23" fmla="*/ 2128 h 3059"/>
              <a:gd name="T24" fmla="*/ 1066 w 3054"/>
              <a:gd name="T25" fmla="*/ 2326 h 3059"/>
              <a:gd name="T26" fmla="*/ 797 w 3054"/>
              <a:gd name="T27" fmla="*/ 2183 h 3059"/>
              <a:gd name="T28" fmla="*/ 909 w 3054"/>
              <a:gd name="T29" fmla="*/ 2483 h 3059"/>
              <a:gd name="T30" fmla="*/ 1196 w 3054"/>
              <a:gd name="T31" fmla="*/ 2202 h 3059"/>
              <a:gd name="T32" fmla="*/ 924 w 3054"/>
              <a:gd name="T33" fmla="*/ 2045 h 3059"/>
              <a:gd name="T34" fmla="*/ 832 w 3054"/>
              <a:gd name="T35" fmla="*/ 1952 h 3059"/>
              <a:gd name="T36" fmla="*/ 1007 w 3054"/>
              <a:gd name="T37" fmla="*/ 1962 h 3059"/>
              <a:gd name="T38" fmla="*/ 1148 w 3054"/>
              <a:gd name="T39" fmla="*/ 2168 h 3059"/>
              <a:gd name="T40" fmla="*/ 1014 w 3054"/>
              <a:gd name="T41" fmla="*/ 1891 h 3059"/>
              <a:gd name="T42" fmla="*/ 1099 w 3054"/>
              <a:gd name="T43" fmla="*/ 1795 h 3059"/>
              <a:gd name="T44" fmla="*/ 1123 w 3054"/>
              <a:gd name="T45" fmla="*/ 1872 h 3059"/>
              <a:gd name="T46" fmla="*/ 1258 w 3054"/>
              <a:gd name="T47" fmla="*/ 2134 h 3059"/>
              <a:gd name="T48" fmla="*/ 1382 w 3054"/>
              <a:gd name="T49" fmla="*/ 1578 h 3059"/>
              <a:gd name="T50" fmla="*/ 1521 w 3054"/>
              <a:gd name="T51" fmla="*/ 1882 h 3059"/>
              <a:gd name="T52" fmla="*/ 1413 w 3054"/>
              <a:gd name="T53" fmla="*/ 1876 h 3059"/>
              <a:gd name="T54" fmla="*/ 1375 w 3054"/>
              <a:gd name="T55" fmla="*/ 1634 h 3059"/>
              <a:gd name="T56" fmla="*/ 1676 w 3054"/>
              <a:gd name="T57" fmla="*/ 1716 h 3059"/>
              <a:gd name="T58" fmla="*/ 1676 w 3054"/>
              <a:gd name="T59" fmla="*/ 1716 h 3059"/>
              <a:gd name="T60" fmla="*/ 1614 w 3054"/>
              <a:gd name="T61" fmla="*/ 1309 h 3059"/>
              <a:gd name="T62" fmla="*/ 1564 w 3054"/>
              <a:gd name="T63" fmla="*/ 1153 h 3059"/>
              <a:gd name="T64" fmla="*/ 1839 w 3054"/>
              <a:gd name="T65" fmla="*/ 881 h 3059"/>
              <a:gd name="T66" fmla="*/ 2175 w 3054"/>
              <a:gd name="T67" fmla="*/ 1217 h 3059"/>
              <a:gd name="T68" fmla="*/ 2175 w 3054"/>
              <a:gd name="T69" fmla="*/ 1217 h 3059"/>
              <a:gd name="T70" fmla="*/ 2133 w 3054"/>
              <a:gd name="T71" fmla="*/ 594 h 3059"/>
              <a:gd name="T72" fmla="*/ 2350 w 3054"/>
              <a:gd name="T73" fmla="*/ 709 h 3059"/>
              <a:gd name="T74" fmla="*/ 2288 w 3054"/>
              <a:gd name="T75" fmla="*/ 1104 h 3059"/>
              <a:gd name="T76" fmla="*/ 2261 w 3054"/>
              <a:gd name="T77" fmla="*/ 656 h 3059"/>
              <a:gd name="T78" fmla="*/ 2036 w 3054"/>
              <a:gd name="T79" fmla="*/ 764 h 3059"/>
              <a:gd name="T80" fmla="*/ 2569 w 3054"/>
              <a:gd name="T81" fmla="*/ 682 h 3059"/>
              <a:gd name="T82" fmla="*/ 2736 w 3054"/>
              <a:gd name="T83" fmla="*/ 531 h 3059"/>
              <a:gd name="T84" fmla="*/ 2554 w 3054"/>
              <a:gd name="T85" fmla="*/ 528 h 3059"/>
              <a:gd name="T86" fmla="*/ 2314 w 3054"/>
              <a:gd name="T87" fmla="*/ 484 h 3059"/>
              <a:gd name="T88" fmla="*/ 2530 w 3054"/>
              <a:gd name="T89" fmla="*/ 273 h 3059"/>
              <a:gd name="T90" fmla="*/ 2414 w 3054"/>
              <a:gd name="T91" fmla="*/ 373 h 3059"/>
              <a:gd name="T92" fmla="*/ 2521 w 3054"/>
              <a:gd name="T93" fmla="*/ 474 h 3059"/>
              <a:gd name="T94" fmla="*/ 2791 w 3054"/>
              <a:gd name="T95" fmla="*/ 512 h 3059"/>
              <a:gd name="T96" fmla="*/ 2554 w 3054"/>
              <a:gd name="T97" fmla="*/ 742 h 3059"/>
              <a:gd name="T98" fmla="*/ 2750 w 3054"/>
              <a:gd name="T99" fmla="*/ 116 h 3059"/>
              <a:gd name="T100" fmla="*/ 2698 w 3054"/>
              <a:gd name="T101" fmla="*/ 109 h 305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</a:cxnLst>
            <a:rect l="0" t="0" r="r" b="b"/>
            <a:pathLst>
              <a:path w="3054" h="3059">
                <a:moveTo>
                  <a:pt x="390" y="2766"/>
                </a:moveTo>
                <a:lnTo>
                  <a:pt x="446" y="2733"/>
                </a:lnTo>
                <a:cubicBezTo>
                  <a:pt x="473" y="2779"/>
                  <a:pt x="484" y="2824"/>
                  <a:pt x="479" y="2867"/>
                </a:cubicBezTo>
                <a:cubicBezTo>
                  <a:pt x="474" y="2910"/>
                  <a:pt x="454" y="2950"/>
                  <a:pt x="419" y="2985"/>
                </a:cubicBezTo>
                <a:cubicBezTo>
                  <a:pt x="383" y="3021"/>
                  <a:pt x="346" y="3043"/>
                  <a:pt x="308" y="3051"/>
                </a:cubicBezTo>
                <a:cubicBezTo>
                  <a:pt x="271" y="3059"/>
                  <a:pt x="232" y="3055"/>
                  <a:pt x="193" y="3039"/>
                </a:cubicBezTo>
                <a:cubicBezTo>
                  <a:pt x="153" y="3022"/>
                  <a:pt x="117" y="2998"/>
                  <a:pt x="85" y="2966"/>
                </a:cubicBezTo>
                <a:cubicBezTo>
                  <a:pt x="50" y="2931"/>
                  <a:pt x="26" y="2894"/>
                  <a:pt x="13" y="2855"/>
                </a:cubicBezTo>
                <a:cubicBezTo>
                  <a:pt x="0" y="2815"/>
                  <a:pt x="0" y="2776"/>
                  <a:pt x="11" y="2738"/>
                </a:cubicBezTo>
                <a:cubicBezTo>
                  <a:pt x="22" y="2700"/>
                  <a:pt x="42" y="2666"/>
                  <a:pt x="72" y="2636"/>
                </a:cubicBezTo>
                <a:cubicBezTo>
                  <a:pt x="106" y="2603"/>
                  <a:pt x="143" y="2583"/>
                  <a:pt x="183" y="2577"/>
                </a:cubicBezTo>
                <a:cubicBezTo>
                  <a:pt x="223" y="2571"/>
                  <a:pt x="263" y="2579"/>
                  <a:pt x="303" y="2601"/>
                </a:cubicBezTo>
                <a:lnTo>
                  <a:pt x="269" y="2656"/>
                </a:lnTo>
                <a:cubicBezTo>
                  <a:pt x="237" y="2639"/>
                  <a:pt x="208" y="2632"/>
                  <a:pt x="182" y="2636"/>
                </a:cubicBezTo>
                <a:cubicBezTo>
                  <a:pt x="156" y="2640"/>
                  <a:pt x="132" y="2653"/>
                  <a:pt x="109" y="2675"/>
                </a:cubicBezTo>
                <a:cubicBezTo>
                  <a:pt x="83" y="2701"/>
                  <a:pt x="68" y="2729"/>
                  <a:pt x="63" y="2759"/>
                </a:cubicBezTo>
                <a:cubicBezTo>
                  <a:pt x="58" y="2788"/>
                  <a:pt x="62" y="2817"/>
                  <a:pt x="76" y="2845"/>
                </a:cubicBezTo>
                <a:cubicBezTo>
                  <a:pt x="90" y="2873"/>
                  <a:pt x="108" y="2898"/>
                  <a:pt x="130" y="2920"/>
                </a:cubicBezTo>
                <a:cubicBezTo>
                  <a:pt x="159" y="2949"/>
                  <a:pt x="188" y="2969"/>
                  <a:pt x="218" y="2982"/>
                </a:cubicBezTo>
                <a:cubicBezTo>
                  <a:pt x="247" y="2995"/>
                  <a:pt x="276" y="2998"/>
                  <a:pt x="304" y="2991"/>
                </a:cubicBezTo>
                <a:cubicBezTo>
                  <a:pt x="332" y="2984"/>
                  <a:pt x="357" y="2971"/>
                  <a:pt x="377" y="2950"/>
                </a:cubicBezTo>
                <a:cubicBezTo>
                  <a:pt x="402" y="2925"/>
                  <a:pt x="416" y="2897"/>
                  <a:pt x="419" y="2865"/>
                </a:cubicBezTo>
                <a:cubicBezTo>
                  <a:pt x="422" y="2834"/>
                  <a:pt x="412" y="2801"/>
                  <a:pt x="390" y="2766"/>
                </a:cubicBezTo>
                <a:close/>
                <a:moveTo>
                  <a:pt x="465" y="2683"/>
                </a:moveTo>
                <a:cubicBezTo>
                  <a:pt x="420" y="2638"/>
                  <a:pt x="399" y="2592"/>
                  <a:pt x="403" y="2546"/>
                </a:cubicBezTo>
                <a:cubicBezTo>
                  <a:pt x="405" y="2507"/>
                  <a:pt x="422" y="2472"/>
                  <a:pt x="452" y="2442"/>
                </a:cubicBezTo>
                <a:cubicBezTo>
                  <a:pt x="486" y="2409"/>
                  <a:pt x="524" y="2392"/>
                  <a:pt x="567" y="2393"/>
                </a:cubicBezTo>
                <a:cubicBezTo>
                  <a:pt x="610" y="2394"/>
                  <a:pt x="651" y="2413"/>
                  <a:pt x="690" y="2452"/>
                </a:cubicBezTo>
                <a:cubicBezTo>
                  <a:pt x="721" y="2483"/>
                  <a:pt x="741" y="2513"/>
                  <a:pt x="750" y="2540"/>
                </a:cubicBezTo>
                <a:cubicBezTo>
                  <a:pt x="758" y="2567"/>
                  <a:pt x="758" y="2595"/>
                  <a:pt x="750" y="2623"/>
                </a:cubicBezTo>
                <a:cubicBezTo>
                  <a:pt x="742" y="2651"/>
                  <a:pt x="728" y="2675"/>
                  <a:pt x="707" y="2696"/>
                </a:cubicBezTo>
                <a:cubicBezTo>
                  <a:pt x="672" y="2731"/>
                  <a:pt x="634" y="2747"/>
                  <a:pt x="591" y="2746"/>
                </a:cubicBezTo>
                <a:cubicBezTo>
                  <a:pt x="548" y="2746"/>
                  <a:pt x="506" y="2725"/>
                  <a:pt x="465" y="2683"/>
                </a:cubicBezTo>
                <a:close/>
                <a:moveTo>
                  <a:pt x="508" y="2641"/>
                </a:moveTo>
                <a:cubicBezTo>
                  <a:pt x="539" y="2672"/>
                  <a:pt x="569" y="2689"/>
                  <a:pt x="598" y="2691"/>
                </a:cubicBezTo>
                <a:cubicBezTo>
                  <a:pt x="627" y="2693"/>
                  <a:pt x="652" y="2683"/>
                  <a:pt x="673" y="2663"/>
                </a:cubicBezTo>
                <a:cubicBezTo>
                  <a:pt x="693" y="2642"/>
                  <a:pt x="702" y="2617"/>
                  <a:pt x="700" y="2588"/>
                </a:cubicBezTo>
                <a:cubicBezTo>
                  <a:pt x="698" y="2559"/>
                  <a:pt x="681" y="2528"/>
                  <a:pt x="649" y="2496"/>
                </a:cubicBezTo>
                <a:cubicBezTo>
                  <a:pt x="619" y="2466"/>
                  <a:pt x="590" y="2450"/>
                  <a:pt x="560" y="2448"/>
                </a:cubicBezTo>
                <a:cubicBezTo>
                  <a:pt x="531" y="2447"/>
                  <a:pt x="507" y="2456"/>
                  <a:pt x="486" y="2476"/>
                </a:cubicBezTo>
                <a:cubicBezTo>
                  <a:pt x="466" y="2497"/>
                  <a:pt x="456" y="2522"/>
                  <a:pt x="458" y="2551"/>
                </a:cubicBezTo>
                <a:cubicBezTo>
                  <a:pt x="460" y="2580"/>
                  <a:pt x="476" y="2610"/>
                  <a:pt x="508" y="2641"/>
                </a:cubicBezTo>
                <a:close/>
                <a:moveTo>
                  <a:pt x="868" y="2524"/>
                </a:moveTo>
                <a:lnTo>
                  <a:pt x="625" y="2280"/>
                </a:lnTo>
                <a:lnTo>
                  <a:pt x="662" y="2243"/>
                </a:lnTo>
                <a:lnTo>
                  <a:pt x="696" y="2278"/>
                </a:lnTo>
                <a:cubicBezTo>
                  <a:pt x="687" y="2233"/>
                  <a:pt x="700" y="2194"/>
                  <a:pt x="734" y="2160"/>
                </a:cubicBezTo>
                <a:cubicBezTo>
                  <a:pt x="748" y="2146"/>
                  <a:pt x="765" y="2135"/>
                  <a:pt x="782" y="2128"/>
                </a:cubicBezTo>
                <a:cubicBezTo>
                  <a:pt x="800" y="2121"/>
                  <a:pt x="816" y="2118"/>
                  <a:pt x="830" y="2121"/>
                </a:cubicBezTo>
                <a:cubicBezTo>
                  <a:pt x="845" y="2123"/>
                  <a:pt x="860" y="2129"/>
                  <a:pt x="874" y="2139"/>
                </a:cubicBezTo>
                <a:cubicBezTo>
                  <a:pt x="883" y="2145"/>
                  <a:pt x="897" y="2157"/>
                  <a:pt x="916" y="2176"/>
                </a:cubicBezTo>
                <a:lnTo>
                  <a:pt x="1066" y="2326"/>
                </a:lnTo>
                <a:lnTo>
                  <a:pt x="1025" y="2367"/>
                </a:lnTo>
                <a:lnTo>
                  <a:pt x="877" y="2219"/>
                </a:lnTo>
                <a:cubicBezTo>
                  <a:pt x="860" y="2202"/>
                  <a:pt x="846" y="2191"/>
                  <a:pt x="834" y="2186"/>
                </a:cubicBezTo>
                <a:cubicBezTo>
                  <a:pt x="822" y="2181"/>
                  <a:pt x="810" y="2180"/>
                  <a:pt x="797" y="2183"/>
                </a:cubicBezTo>
                <a:cubicBezTo>
                  <a:pt x="784" y="2187"/>
                  <a:pt x="772" y="2194"/>
                  <a:pt x="761" y="2205"/>
                </a:cubicBezTo>
                <a:cubicBezTo>
                  <a:pt x="743" y="2222"/>
                  <a:pt x="734" y="2243"/>
                  <a:pt x="732" y="2267"/>
                </a:cubicBezTo>
                <a:cubicBezTo>
                  <a:pt x="730" y="2291"/>
                  <a:pt x="745" y="2318"/>
                  <a:pt x="776" y="2350"/>
                </a:cubicBezTo>
                <a:lnTo>
                  <a:pt x="909" y="2483"/>
                </a:lnTo>
                <a:lnTo>
                  <a:pt x="868" y="2524"/>
                </a:lnTo>
                <a:close/>
                <a:moveTo>
                  <a:pt x="1181" y="2137"/>
                </a:moveTo>
                <a:lnTo>
                  <a:pt x="1224" y="2167"/>
                </a:lnTo>
                <a:cubicBezTo>
                  <a:pt x="1215" y="2181"/>
                  <a:pt x="1206" y="2193"/>
                  <a:pt x="1196" y="2202"/>
                </a:cubicBezTo>
                <a:cubicBezTo>
                  <a:pt x="1181" y="2217"/>
                  <a:pt x="1167" y="2226"/>
                  <a:pt x="1154" y="2230"/>
                </a:cubicBezTo>
                <a:cubicBezTo>
                  <a:pt x="1141" y="2233"/>
                  <a:pt x="1129" y="2233"/>
                  <a:pt x="1118" y="2229"/>
                </a:cubicBezTo>
                <a:cubicBezTo>
                  <a:pt x="1107" y="2224"/>
                  <a:pt x="1089" y="2210"/>
                  <a:pt x="1065" y="2185"/>
                </a:cubicBezTo>
                <a:lnTo>
                  <a:pt x="924" y="2045"/>
                </a:lnTo>
                <a:lnTo>
                  <a:pt x="894" y="2075"/>
                </a:lnTo>
                <a:lnTo>
                  <a:pt x="862" y="2043"/>
                </a:lnTo>
                <a:lnTo>
                  <a:pt x="892" y="2013"/>
                </a:lnTo>
                <a:lnTo>
                  <a:pt x="832" y="1952"/>
                </a:lnTo>
                <a:lnTo>
                  <a:pt x="848" y="1887"/>
                </a:lnTo>
                <a:lnTo>
                  <a:pt x="933" y="1972"/>
                </a:lnTo>
                <a:lnTo>
                  <a:pt x="975" y="1930"/>
                </a:lnTo>
                <a:lnTo>
                  <a:pt x="1007" y="1962"/>
                </a:lnTo>
                <a:lnTo>
                  <a:pt x="966" y="2004"/>
                </a:lnTo>
                <a:lnTo>
                  <a:pt x="1108" y="2146"/>
                </a:lnTo>
                <a:cubicBezTo>
                  <a:pt x="1120" y="2158"/>
                  <a:pt x="1128" y="2165"/>
                  <a:pt x="1133" y="2167"/>
                </a:cubicBezTo>
                <a:cubicBezTo>
                  <a:pt x="1138" y="2169"/>
                  <a:pt x="1143" y="2169"/>
                  <a:pt x="1148" y="2168"/>
                </a:cubicBezTo>
                <a:cubicBezTo>
                  <a:pt x="1153" y="2166"/>
                  <a:pt x="1159" y="2163"/>
                  <a:pt x="1165" y="2156"/>
                </a:cubicBezTo>
                <a:cubicBezTo>
                  <a:pt x="1170" y="2152"/>
                  <a:pt x="1175" y="2145"/>
                  <a:pt x="1181" y="2137"/>
                </a:cubicBezTo>
                <a:close/>
                <a:moveTo>
                  <a:pt x="1258" y="2134"/>
                </a:moveTo>
                <a:lnTo>
                  <a:pt x="1014" y="1891"/>
                </a:lnTo>
                <a:lnTo>
                  <a:pt x="1052" y="1853"/>
                </a:lnTo>
                <a:lnTo>
                  <a:pt x="1089" y="1890"/>
                </a:lnTo>
                <a:cubicBezTo>
                  <a:pt x="1081" y="1864"/>
                  <a:pt x="1078" y="1843"/>
                  <a:pt x="1081" y="1830"/>
                </a:cubicBezTo>
                <a:cubicBezTo>
                  <a:pt x="1083" y="1816"/>
                  <a:pt x="1089" y="1805"/>
                  <a:pt x="1099" y="1795"/>
                </a:cubicBezTo>
                <a:cubicBezTo>
                  <a:pt x="1113" y="1781"/>
                  <a:pt x="1131" y="1772"/>
                  <a:pt x="1155" y="1766"/>
                </a:cubicBezTo>
                <a:lnTo>
                  <a:pt x="1179" y="1819"/>
                </a:lnTo>
                <a:cubicBezTo>
                  <a:pt x="1163" y="1823"/>
                  <a:pt x="1149" y="1830"/>
                  <a:pt x="1139" y="1840"/>
                </a:cubicBezTo>
                <a:cubicBezTo>
                  <a:pt x="1130" y="1849"/>
                  <a:pt x="1125" y="1860"/>
                  <a:pt x="1123" y="1872"/>
                </a:cubicBezTo>
                <a:cubicBezTo>
                  <a:pt x="1121" y="1885"/>
                  <a:pt x="1124" y="1898"/>
                  <a:pt x="1130" y="1910"/>
                </a:cubicBezTo>
                <a:cubicBezTo>
                  <a:pt x="1141" y="1930"/>
                  <a:pt x="1154" y="1948"/>
                  <a:pt x="1172" y="1965"/>
                </a:cubicBezTo>
                <a:lnTo>
                  <a:pt x="1299" y="2093"/>
                </a:lnTo>
                <a:lnTo>
                  <a:pt x="1258" y="2134"/>
                </a:lnTo>
                <a:close/>
                <a:moveTo>
                  <a:pt x="1280" y="1869"/>
                </a:moveTo>
                <a:cubicBezTo>
                  <a:pt x="1235" y="1824"/>
                  <a:pt x="1214" y="1778"/>
                  <a:pt x="1217" y="1731"/>
                </a:cubicBezTo>
                <a:cubicBezTo>
                  <a:pt x="1220" y="1692"/>
                  <a:pt x="1237" y="1658"/>
                  <a:pt x="1267" y="1627"/>
                </a:cubicBezTo>
                <a:cubicBezTo>
                  <a:pt x="1300" y="1594"/>
                  <a:pt x="1338" y="1578"/>
                  <a:pt x="1382" y="1578"/>
                </a:cubicBezTo>
                <a:cubicBezTo>
                  <a:pt x="1425" y="1579"/>
                  <a:pt x="1466" y="1599"/>
                  <a:pt x="1504" y="1637"/>
                </a:cubicBezTo>
                <a:cubicBezTo>
                  <a:pt x="1536" y="1669"/>
                  <a:pt x="1556" y="1698"/>
                  <a:pt x="1564" y="1725"/>
                </a:cubicBezTo>
                <a:cubicBezTo>
                  <a:pt x="1573" y="1753"/>
                  <a:pt x="1573" y="1780"/>
                  <a:pt x="1565" y="1808"/>
                </a:cubicBezTo>
                <a:cubicBezTo>
                  <a:pt x="1557" y="1836"/>
                  <a:pt x="1542" y="1861"/>
                  <a:pt x="1521" y="1882"/>
                </a:cubicBezTo>
                <a:cubicBezTo>
                  <a:pt x="1487" y="1916"/>
                  <a:pt x="1449" y="1933"/>
                  <a:pt x="1406" y="1932"/>
                </a:cubicBezTo>
                <a:cubicBezTo>
                  <a:pt x="1363" y="1931"/>
                  <a:pt x="1321" y="1910"/>
                  <a:pt x="1280" y="1869"/>
                </a:cubicBezTo>
                <a:close/>
                <a:moveTo>
                  <a:pt x="1322" y="1826"/>
                </a:moveTo>
                <a:cubicBezTo>
                  <a:pt x="1353" y="1858"/>
                  <a:pt x="1383" y="1874"/>
                  <a:pt x="1413" y="1876"/>
                </a:cubicBezTo>
                <a:cubicBezTo>
                  <a:pt x="1442" y="1878"/>
                  <a:pt x="1467" y="1869"/>
                  <a:pt x="1487" y="1848"/>
                </a:cubicBezTo>
                <a:cubicBezTo>
                  <a:pt x="1508" y="1827"/>
                  <a:pt x="1517" y="1803"/>
                  <a:pt x="1515" y="1773"/>
                </a:cubicBezTo>
                <a:cubicBezTo>
                  <a:pt x="1513" y="1744"/>
                  <a:pt x="1496" y="1714"/>
                  <a:pt x="1464" y="1682"/>
                </a:cubicBezTo>
                <a:cubicBezTo>
                  <a:pt x="1434" y="1652"/>
                  <a:pt x="1404" y="1636"/>
                  <a:pt x="1375" y="1634"/>
                </a:cubicBezTo>
                <a:cubicBezTo>
                  <a:pt x="1346" y="1632"/>
                  <a:pt x="1321" y="1641"/>
                  <a:pt x="1301" y="1662"/>
                </a:cubicBezTo>
                <a:cubicBezTo>
                  <a:pt x="1280" y="1682"/>
                  <a:pt x="1271" y="1707"/>
                  <a:pt x="1273" y="1736"/>
                </a:cubicBezTo>
                <a:cubicBezTo>
                  <a:pt x="1274" y="1765"/>
                  <a:pt x="1291" y="1795"/>
                  <a:pt x="1322" y="1826"/>
                </a:cubicBezTo>
                <a:close/>
                <a:moveTo>
                  <a:pt x="1676" y="1716"/>
                </a:moveTo>
                <a:lnTo>
                  <a:pt x="1340" y="1380"/>
                </a:lnTo>
                <a:lnTo>
                  <a:pt x="1381" y="1339"/>
                </a:lnTo>
                <a:lnTo>
                  <a:pt x="1717" y="1675"/>
                </a:lnTo>
                <a:lnTo>
                  <a:pt x="1676" y="1716"/>
                </a:lnTo>
                <a:close/>
                <a:moveTo>
                  <a:pt x="1928" y="1464"/>
                </a:moveTo>
                <a:lnTo>
                  <a:pt x="1887" y="1505"/>
                </a:lnTo>
                <a:lnTo>
                  <a:pt x="1624" y="1242"/>
                </a:lnTo>
                <a:cubicBezTo>
                  <a:pt x="1624" y="1261"/>
                  <a:pt x="1620" y="1284"/>
                  <a:pt x="1614" y="1309"/>
                </a:cubicBezTo>
                <a:cubicBezTo>
                  <a:pt x="1607" y="1335"/>
                  <a:pt x="1600" y="1357"/>
                  <a:pt x="1591" y="1374"/>
                </a:cubicBezTo>
                <a:lnTo>
                  <a:pt x="1552" y="1334"/>
                </a:lnTo>
                <a:cubicBezTo>
                  <a:pt x="1564" y="1300"/>
                  <a:pt x="1571" y="1267"/>
                  <a:pt x="1573" y="1234"/>
                </a:cubicBezTo>
                <a:cubicBezTo>
                  <a:pt x="1574" y="1202"/>
                  <a:pt x="1572" y="1174"/>
                  <a:pt x="1564" y="1153"/>
                </a:cubicBezTo>
                <a:lnTo>
                  <a:pt x="1591" y="1126"/>
                </a:lnTo>
                <a:lnTo>
                  <a:pt x="1928" y="1464"/>
                </a:lnTo>
                <a:close/>
                <a:moveTo>
                  <a:pt x="1886" y="928"/>
                </a:moveTo>
                <a:lnTo>
                  <a:pt x="1839" y="881"/>
                </a:lnTo>
                <a:lnTo>
                  <a:pt x="1880" y="840"/>
                </a:lnTo>
                <a:lnTo>
                  <a:pt x="1928" y="887"/>
                </a:lnTo>
                <a:lnTo>
                  <a:pt x="1886" y="928"/>
                </a:lnTo>
                <a:close/>
                <a:moveTo>
                  <a:pt x="2175" y="1217"/>
                </a:moveTo>
                <a:lnTo>
                  <a:pt x="1932" y="973"/>
                </a:lnTo>
                <a:lnTo>
                  <a:pt x="1973" y="932"/>
                </a:lnTo>
                <a:lnTo>
                  <a:pt x="2216" y="1176"/>
                </a:lnTo>
                <a:lnTo>
                  <a:pt x="2175" y="1217"/>
                </a:lnTo>
                <a:close/>
                <a:moveTo>
                  <a:pt x="2288" y="1104"/>
                </a:moveTo>
                <a:lnTo>
                  <a:pt x="1951" y="768"/>
                </a:lnTo>
                <a:lnTo>
                  <a:pt x="2078" y="642"/>
                </a:lnTo>
                <a:cubicBezTo>
                  <a:pt x="2101" y="619"/>
                  <a:pt x="2119" y="603"/>
                  <a:pt x="2133" y="594"/>
                </a:cubicBezTo>
                <a:cubicBezTo>
                  <a:pt x="2152" y="580"/>
                  <a:pt x="2171" y="571"/>
                  <a:pt x="2190" y="568"/>
                </a:cubicBezTo>
                <a:cubicBezTo>
                  <a:pt x="2209" y="564"/>
                  <a:pt x="2228" y="566"/>
                  <a:pt x="2249" y="573"/>
                </a:cubicBezTo>
                <a:cubicBezTo>
                  <a:pt x="2270" y="580"/>
                  <a:pt x="2289" y="592"/>
                  <a:pt x="2305" y="609"/>
                </a:cubicBezTo>
                <a:cubicBezTo>
                  <a:pt x="2334" y="638"/>
                  <a:pt x="2349" y="671"/>
                  <a:pt x="2350" y="709"/>
                </a:cubicBezTo>
                <a:cubicBezTo>
                  <a:pt x="2352" y="747"/>
                  <a:pt x="2329" y="790"/>
                  <a:pt x="2282" y="837"/>
                </a:cubicBezTo>
                <a:lnTo>
                  <a:pt x="2195" y="923"/>
                </a:lnTo>
                <a:lnTo>
                  <a:pt x="2332" y="1060"/>
                </a:lnTo>
                <a:lnTo>
                  <a:pt x="2288" y="1104"/>
                </a:lnTo>
                <a:close/>
                <a:moveTo>
                  <a:pt x="2156" y="884"/>
                </a:moveTo>
                <a:lnTo>
                  <a:pt x="2243" y="797"/>
                </a:lnTo>
                <a:cubicBezTo>
                  <a:pt x="2271" y="768"/>
                  <a:pt x="2286" y="742"/>
                  <a:pt x="2288" y="720"/>
                </a:cubicBezTo>
                <a:cubicBezTo>
                  <a:pt x="2289" y="697"/>
                  <a:pt x="2280" y="676"/>
                  <a:pt x="2261" y="656"/>
                </a:cubicBezTo>
                <a:cubicBezTo>
                  <a:pt x="2247" y="642"/>
                  <a:pt x="2231" y="634"/>
                  <a:pt x="2214" y="631"/>
                </a:cubicBezTo>
                <a:cubicBezTo>
                  <a:pt x="2197" y="628"/>
                  <a:pt x="2181" y="631"/>
                  <a:pt x="2166" y="639"/>
                </a:cubicBezTo>
                <a:cubicBezTo>
                  <a:pt x="2157" y="645"/>
                  <a:pt x="2142" y="657"/>
                  <a:pt x="2122" y="678"/>
                </a:cubicBezTo>
                <a:lnTo>
                  <a:pt x="2036" y="764"/>
                </a:lnTo>
                <a:lnTo>
                  <a:pt x="2156" y="884"/>
                </a:lnTo>
                <a:close/>
                <a:moveTo>
                  <a:pt x="2476" y="700"/>
                </a:moveTo>
                <a:lnTo>
                  <a:pt x="2514" y="655"/>
                </a:lnTo>
                <a:cubicBezTo>
                  <a:pt x="2533" y="670"/>
                  <a:pt x="2551" y="679"/>
                  <a:pt x="2569" y="682"/>
                </a:cubicBezTo>
                <a:cubicBezTo>
                  <a:pt x="2587" y="686"/>
                  <a:pt x="2607" y="683"/>
                  <a:pt x="2629" y="675"/>
                </a:cubicBezTo>
                <a:cubicBezTo>
                  <a:pt x="2651" y="666"/>
                  <a:pt x="2672" y="652"/>
                  <a:pt x="2691" y="633"/>
                </a:cubicBezTo>
                <a:cubicBezTo>
                  <a:pt x="2708" y="616"/>
                  <a:pt x="2720" y="599"/>
                  <a:pt x="2728" y="581"/>
                </a:cubicBezTo>
                <a:cubicBezTo>
                  <a:pt x="2736" y="563"/>
                  <a:pt x="2739" y="546"/>
                  <a:pt x="2736" y="531"/>
                </a:cubicBezTo>
                <a:cubicBezTo>
                  <a:pt x="2734" y="516"/>
                  <a:pt x="2727" y="503"/>
                  <a:pt x="2717" y="493"/>
                </a:cubicBezTo>
                <a:cubicBezTo>
                  <a:pt x="2706" y="482"/>
                  <a:pt x="2694" y="476"/>
                  <a:pt x="2680" y="474"/>
                </a:cubicBezTo>
                <a:cubicBezTo>
                  <a:pt x="2666" y="472"/>
                  <a:pt x="2649" y="476"/>
                  <a:pt x="2630" y="484"/>
                </a:cubicBezTo>
                <a:cubicBezTo>
                  <a:pt x="2618" y="490"/>
                  <a:pt x="2592" y="504"/>
                  <a:pt x="2554" y="528"/>
                </a:cubicBezTo>
                <a:cubicBezTo>
                  <a:pt x="2516" y="551"/>
                  <a:pt x="2487" y="566"/>
                  <a:pt x="2468" y="572"/>
                </a:cubicBezTo>
                <a:cubicBezTo>
                  <a:pt x="2444" y="579"/>
                  <a:pt x="2421" y="581"/>
                  <a:pt x="2401" y="576"/>
                </a:cubicBezTo>
                <a:cubicBezTo>
                  <a:pt x="2381" y="572"/>
                  <a:pt x="2363" y="562"/>
                  <a:pt x="2347" y="546"/>
                </a:cubicBezTo>
                <a:cubicBezTo>
                  <a:pt x="2330" y="529"/>
                  <a:pt x="2319" y="509"/>
                  <a:pt x="2314" y="484"/>
                </a:cubicBezTo>
                <a:cubicBezTo>
                  <a:pt x="2309" y="460"/>
                  <a:pt x="2312" y="435"/>
                  <a:pt x="2323" y="409"/>
                </a:cubicBezTo>
                <a:cubicBezTo>
                  <a:pt x="2334" y="382"/>
                  <a:pt x="2350" y="358"/>
                  <a:pt x="2373" y="335"/>
                </a:cubicBezTo>
                <a:cubicBezTo>
                  <a:pt x="2398" y="311"/>
                  <a:pt x="2424" y="293"/>
                  <a:pt x="2451" y="282"/>
                </a:cubicBezTo>
                <a:cubicBezTo>
                  <a:pt x="2478" y="271"/>
                  <a:pt x="2504" y="268"/>
                  <a:pt x="2530" y="273"/>
                </a:cubicBezTo>
                <a:cubicBezTo>
                  <a:pt x="2556" y="278"/>
                  <a:pt x="2579" y="291"/>
                  <a:pt x="2600" y="310"/>
                </a:cubicBezTo>
                <a:lnTo>
                  <a:pt x="2560" y="355"/>
                </a:lnTo>
                <a:cubicBezTo>
                  <a:pt x="2537" y="336"/>
                  <a:pt x="2513" y="328"/>
                  <a:pt x="2489" y="331"/>
                </a:cubicBezTo>
                <a:cubicBezTo>
                  <a:pt x="2465" y="333"/>
                  <a:pt x="2440" y="347"/>
                  <a:pt x="2414" y="373"/>
                </a:cubicBezTo>
                <a:cubicBezTo>
                  <a:pt x="2387" y="400"/>
                  <a:pt x="2372" y="424"/>
                  <a:pt x="2370" y="446"/>
                </a:cubicBezTo>
                <a:cubicBezTo>
                  <a:pt x="2367" y="469"/>
                  <a:pt x="2373" y="487"/>
                  <a:pt x="2387" y="501"/>
                </a:cubicBezTo>
                <a:cubicBezTo>
                  <a:pt x="2399" y="513"/>
                  <a:pt x="2413" y="518"/>
                  <a:pt x="2430" y="517"/>
                </a:cubicBezTo>
                <a:cubicBezTo>
                  <a:pt x="2446" y="517"/>
                  <a:pt x="2477" y="502"/>
                  <a:pt x="2521" y="474"/>
                </a:cubicBezTo>
                <a:cubicBezTo>
                  <a:pt x="2565" y="446"/>
                  <a:pt x="2597" y="429"/>
                  <a:pt x="2617" y="421"/>
                </a:cubicBezTo>
                <a:cubicBezTo>
                  <a:pt x="2645" y="411"/>
                  <a:pt x="2671" y="408"/>
                  <a:pt x="2694" y="412"/>
                </a:cubicBezTo>
                <a:cubicBezTo>
                  <a:pt x="2718" y="417"/>
                  <a:pt x="2738" y="428"/>
                  <a:pt x="2756" y="446"/>
                </a:cubicBezTo>
                <a:cubicBezTo>
                  <a:pt x="2774" y="464"/>
                  <a:pt x="2786" y="486"/>
                  <a:pt x="2791" y="512"/>
                </a:cubicBezTo>
                <a:cubicBezTo>
                  <a:pt x="2797" y="538"/>
                  <a:pt x="2795" y="565"/>
                  <a:pt x="2784" y="593"/>
                </a:cubicBezTo>
                <a:cubicBezTo>
                  <a:pt x="2774" y="621"/>
                  <a:pt x="2757" y="647"/>
                  <a:pt x="2733" y="671"/>
                </a:cubicBezTo>
                <a:cubicBezTo>
                  <a:pt x="2702" y="701"/>
                  <a:pt x="2672" y="722"/>
                  <a:pt x="2643" y="734"/>
                </a:cubicBezTo>
                <a:cubicBezTo>
                  <a:pt x="2613" y="746"/>
                  <a:pt x="2584" y="749"/>
                  <a:pt x="2554" y="742"/>
                </a:cubicBezTo>
                <a:cubicBezTo>
                  <a:pt x="2525" y="736"/>
                  <a:pt x="2499" y="722"/>
                  <a:pt x="2476" y="700"/>
                </a:cubicBezTo>
                <a:close/>
                <a:moveTo>
                  <a:pt x="3054" y="338"/>
                </a:moveTo>
                <a:lnTo>
                  <a:pt x="3013" y="379"/>
                </a:lnTo>
                <a:lnTo>
                  <a:pt x="2750" y="116"/>
                </a:lnTo>
                <a:cubicBezTo>
                  <a:pt x="2749" y="136"/>
                  <a:pt x="2746" y="158"/>
                  <a:pt x="2739" y="184"/>
                </a:cubicBezTo>
                <a:cubicBezTo>
                  <a:pt x="2733" y="209"/>
                  <a:pt x="2725" y="231"/>
                  <a:pt x="2717" y="248"/>
                </a:cubicBezTo>
                <a:lnTo>
                  <a:pt x="2677" y="209"/>
                </a:lnTo>
                <a:cubicBezTo>
                  <a:pt x="2689" y="175"/>
                  <a:pt x="2697" y="141"/>
                  <a:pt x="2698" y="109"/>
                </a:cubicBezTo>
                <a:cubicBezTo>
                  <a:pt x="2700" y="76"/>
                  <a:pt x="2697" y="49"/>
                  <a:pt x="2690" y="27"/>
                </a:cubicBezTo>
                <a:lnTo>
                  <a:pt x="2717" y="0"/>
                </a:lnTo>
                <a:lnTo>
                  <a:pt x="3054" y="338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84" name="Freeform 66"/>
          <p:cNvSpPr>
            <a:spLocks noEditPoints="1"/>
          </p:cNvSpPr>
          <p:nvPr/>
        </p:nvSpPr>
        <p:spPr bwMode="auto">
          <a:xfrm>
            <a:off x="2262365" y="4611475"/>
            <a:ext cx="592137" cy="582612"/>
          </a:xfrm>
          <a:custGeom>
            <a:avLst/>
            <a:gdLst>
              <a:gd name="T0" fmla="*/ 419 w 3116"/>
              <a:gd name="T1" fmla="*/ 2992 h 3066"/>
              <a:gd name="T2" fmla="*/ 14 w 3116"/>
              <a:gd name="T3" fmla="*/ 2862 h 3066"/>
              <a:gd name="T4" fmla="*/ 303 w 3116"/>
              <a:gd name="T5" fmla="*/ 2608 h 3066"/>
              <a:gd name="T6" fmla="*/ 63 w 3116"/>
              <a:gd name="T7" fmla="*/ 2766 h 3066"/>
              <a:gd name="T8" fmla="*/ 305 w 3116"/>
              <a:gd name="T9" fmla="*/ 2998 h 3066"/>
              <a:gd name="T10" fmla="*/ 466 w 3116"/>
              <a:gd name="T11" fmla="*/ 2690 h 3066"/>
              <a:gd name="T12" fmla="*/ 690 w 3116"/>
              <a:gd name="T13" fmla="*/ 2459 h 3066"/>
              <a:gd name="T14" fmla="*/ 591 w 3116"/>
              <a:gd name="T15" fmla="*/ 2753 h 3066"/>
              <a:gd name="T16" fmla="*/ 673 w 3116"/>
              <a:gd name="T17" fmla="*/ 2670 h 3066"/>
              <a:gd name="T18" fmla="*/ 487 w 3116"/>
              <a:gd name="T19" fmla="*/ 2483 h 3066"/>
              <a:gd name="T20" fmla="*/ 625 w 3116"/>
              <a:gd name="T21" fmla="*/ 2287 h 3066"/>
              <a:gd name="T22" fmla="*/ 783 w 3116"/>
              <a:gd name="T23" fmla="*/ 2135 h 3066"/>
              <a:gd name="T24" fmla="*/ 1066 w 3116"/>
              <a:gd name="T25" fmla="*/ 2333 h 3066"/>
              <a:gd name="T26" fmla="*/ 797 w 3116"/>
              <a:gd name="T27" fmla="*/ 2190 h 3066"/>
              <a:gd name="T28" fmla="*/ 910 w 3116"/>
              <a:gd name="T29" fmla="*/ 2490 h 3066"/>
              <a:gd name="T30" fmla="*/ 1197 w 3116"/>
              <a:gd name="T31" fmla="*/ 2209 h 3066"/>
              <a:gd name="T32" fmla="*/ 925 w 3116"/>
              <a:gd name="T33" fmla="*/ 2052 h 3066"/>
              <a:gd name="T34" fmla="*/ 833 w 3116"/>
              <a:gd name="T35" fmla="*/ 1959 h 3066"/>
              <a:gd name="T36" fmla="*/ 1007 w 3116"/>
              <a:gd name="T37" fmla="*/ 1969 h 3066"/>
              <a:gd name="T38" fmla="*/ 1148 w 3116"/>
              <a:gd name="T39" fmla="*/ 2175 h 3066"/>
              <a:gd name="T40" fmla="*/ 1015 w 3116"/>
              <a:gd name="T41" fmla="*/ 1898 h 3066"/>
              <a:gd name="T42" fmla="*/ 1099 w 3116"/>
              <a:gd name="T43" fmla="*/ 1802 h 3066"/>
              <a:gd name="T44" fmla="*/ 1124 w 3116"/>
              <a:gd name="T45" fmla="*/ 1879 h 3066"/>
              <a:gd name="T46" fmla="*/ 1258 w 3116"/>
              <a:gd name="T47" fmla="*/ 2141 h 3066"/>
              <a:gd name="T48" fmla="*/ 1382 w 3116"/>
              <a:gd name="T49" fmla="*/ 1585 h 3066"/>
              <a:gd name="T50" fmla="*/ 1522 w 3116"/>
              <a:gd name="T51" fmla="*/ 1889 h 3066"/>
              <a:gd name="T52" fmla="*/ 1413 w 3116"/>
              <a:gd name="T53" fmla="*/ 1883 h 3066"/>
              <a:gd name="T54" fmla="*/ 1375 w 3116"/>
              <a:gd name="T55" fmla="*/ 1641 h 3066"/>
              <a:gd name="T56" fmla="*/ 1677 w 3116"/>
              <a:gd name="T57" fmla="*/ 1723 h 3066"/>
              <a:gd name="T58" fmla="*/ 1677 w 3116"/>
              <a:gd name="T59" fmla="*/ 1723 h 3066"/>
              <a:gd name="T60" fmla="*/ 1614 w 3116"/>
              <a:gd name="T61" fmla="*/ 1316 h 3066"/>
              <a:gd name="T62" fmla="*/ 1565 w 3116"/>
              <a:gd name="T63" fmla="*/ 1160 h 3066"/>
              <a:gd name="T64" fmla="*/ 1839 w 3116"/>
              <a:gd name="T65" fmla="*/ 888 h 3066"/>
              <a:gd name="T66" fmla="*/ 2175 w 3116"/>
              <a:gd name="T67" fmla="*/ 1224 h 3066"/>
              <a:gd name="T68" fmla="*/ 2175 w 3116"/>
              <a:gd name="T69" fmla="*/ 1224 h 3066"/>
              <a:gd name="T70" fmla="*/ 2133 w 3116"/>
              <a:gd name="T71" fmla="*/ 601 h 3066"/>
              <a:gd name="T72" fmla="*/ 2351 w 3116"/>
              <a:gd name="T73" fmla="*/ 716 h 3066"/>
              <a:gd name="T74" fmla="*/ 2288 w 3116"/>
              <a:gd name="T75" fmla="*/ 1111 h 3066"/>
              <a:gd name="T76" fmla="*/ 2261 w 3116"/>
              <a:gd name="T77" fmla="*/ 663 h 3066"/>
              <a:gd name="T78" fmla="*/ 2036 w 3116"/>
              <a:gd name="T79" fmla="*/ 771 h 3066"/>
              <a:gd name="T80" fmla="*/ 2570 w 3116"/>
              <a:gd name="T81" fmla="*/ 689 h 3066"/>
              <a:gd name="T82" fmla="*/ 2737 w 3116"/>
              <a:gd name="T83" fmla="*/ 538 h 3066"/>
              <a:gd name="T84" fmla="*/ 2554 w 3116"/>
              <a:gd name="T85" fmla="*/ 535 h 3066"/>
              <a:gd name="T86" fmla="*/ 2314 w 3116"/>
              <a:gd name="T87" fmla="*/ 491 h 3066"/>
              <a:gd name="T88" fmla="*/ 2531 w 3116"/>
              <a:gd name="T89" fmla="*/ 280 h 3066"/>
              <a:gd name="T90" fmla="*/ 2414 w 3116"/>
              <a:gd name="T91" fmla="*/ 380 h 3066"/>
              <a:gd name="T92" fmla="*/ 2521 w 3116"/>
              <a:gd name="T93" fmla="*/ 481 h 3066"/>
              <a:gd name="T94" fmla="*/ 2792 w 3116"/>
              <a:gd name="T95" fmla="*/ 519 h 3066"/>
              <a:gd name="T96" fmla="*/ 2555 w 3116"/>
              <a:gd name="T97" fmla="*/ 749 h 3066"/>
              <a:gd name="T98" fmla="*/ 2894 w 3116"/>
              <a:gd name="T99" fmla="*/ 506 h 3066"/>
              <a:gd name="T100" fmla="*/ 2858 w 3116"/>
              <a:gd name="T101" fmla="*/ 150 h 3066"/>
              <a:gd name="T102" fmla="*/ 2677 w 3116"/>
              <a:gd name="T103" fmla="*/ 152 h 3066"/>
              <a:gd name="T104" fmla="*/ 2673 w 3116"/>
              <a:gd name="T105" fmla="*/ 51 h 3066"/>
              <a:gd name="T106" fmla="*/ 2916 w 3116"/>
              <a:gd name="T107" fmla="*/ 156 h 3066"/>
              <a:gd name="T108" fmla="*/ 3076 w 3116"/>
              <a:gd name="T109" fmla="*/ 244 h 306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</a:cxnLst>
            <a:rect l="0" t="0" r="r" b="b"/>
            <a:pathLst>
              <a:path w="3116" h="3066">
                <a:moveTo>
                  <a:pt x="390" y="2773"/>
                </a:moveTo>
                <a:lnTo>
                  <a:pt x="446" y="2740"/>
                </a:lnTo>
                <a:cubicBezTo>
                  <a:pt x="473" y="2786"/>
                  <a:pt x="484" y="2831"/>
                  <a:pt x="479" y="2874"/>
                </a:cubicBezTo>
                <a:cubicBezTo>
                  <a:pt x="474" y="2917"/>
                  <a:pt x="454" y="2957"/>
                  <a:pt x="419" y="2992"/>
                </a:cubicBezTo>
                <a:cubicBezTo>
                  <a:pt x="383" y="3028"/>
                  <a:pt x="346" y="3050"/>
                  <a:pt x="309" y="3058"/>
                </a:cubicBezTo>
                <a:cubicBezTo>
                  <a:pt x="271" y="3066"/>
                  <a:pt x="233" y="3062"/>
                  <a:pt x="193" y="3046"/>
                </a:cubicBezTo>
                <a:cubicBezTo>
                  <a:pt x="153" y="3029"/>
                  <a:pt x="117" y="3005"/>
                  <a:pt x="85" y="2973"/>
                </a:cubicBezTo>
                <a:cubicBezTo>
                  <a:pt x="50" y="2938"/>
                  <a:pt x="26" y="2901"/>
                  <a:pt x="14" y="2862"/>
                </a:cubicBezTo>
                <a:cubicBezTo>
                  <a:pt x="1" y="2822"/>
                  <a:pt x="0" y="2783"/>
                  <a:pt x="11" y="2745"/>
                </a:cubicBezTo>
                <a:cubicBezTo>
                  <a:pt x="22" y="2707"/>
                  <a:pt x="43" y="2673"/>
                  <a:pt x="72" y="2643"/>
                </a:cubicBezTo>
                <a:cubicBezTo>
                  <a:pt x="106" y="2610"/>
                  <a:pt x="143" y="2590"/>
                  <a:pt x="183" y="2584"/>
                </a:cubicBezTo>
                <a:cubicBezTo>
                  <a:pt x="223" y="2578"/>
                  <a:pt x="263" y="2586"/>
                  <a:pt x="303" y="2608"/>
                </a:cubicBezTo>
                <a:lnTo>
                  <a:pt x="270" y="2663"/>
                </a:lnTo>
                <a:cubicBezTo>
                  <a:pt x="237" y="2646"/>
                  <a:pt x="208" y="2639"/>
                  <a:pt x="182" y="2643"/>
                </a:cubicBezTo>
                <a:cubicBezTo>
                  <a:pt x="156" y="2647"/>
                  <a:pt x="132" y="2660"/>
                  <a:pt x="110" y="2682"/>
                </a:cubicBezTo>
                <a:cubicBezTo>
                  <a:pt x="84" y="2708"/>
                  <a:pt x="68" y="2736"/>
                  <a:pt x="63" y="2766"/>
                </a:cubicBezTo>
                <a:cubicBezTo>
                  <a:pt x="58" y="2795"/>
                  <a:pt x="63" y="2824"/>
                  <a:pt x="77" y="2852"/>
                </a:cubicBezTo>
                <a:cubicBezTo>
                  <a:pt x="91" y="2880"/>
                  <a:pt x="109" y="2905"/>
                  <a:pt x="131" y="2927"/>
                </a:cubicBezTo>
                <a:cubicBezTo>
                  <a:pt x="159" y="2956"/>
                  <a:pt x="188" y="2976"/>
                  <a:pt x="218" y="2989"/>
                </a:cubicBezTo>
                <a:cubicBezTo>
                  <a:pt x="248" y="3002"/>
                  <a:pt x="277" y="3005"/>
                  <a:pt x="305" y="2998"/>
                </a:cubicBezTo>
                <a:cubicBezTo>
                  <a:pt x="333" y="2991"/>
                  <a:pt x="357" y="2978"/>
                  <a:pt x="378" y="2957"/>
                </a:cubicBezTo>
                <a:cubicBezTo>
                  <a:pt x="403" y="2932"/>
                  <a:pt x="416" y="2904"/>
                  <a:pt x="419" y="2872"/>
                </a:cubicBezTo>
                <a:cubicBezTo>
                  <a:pt x="422" y="2841"/>
                  <a:pt x="413" y="2808"/>
                  <a:pt x="390" y="2773"/>
                </a:cubicBezTo>
                <a:close/>
                <a:moveTo>
                  <a:pt x="466" y="2690"/>
                </a:moveTo>
                <a:cubicBezTo>
                  <a:pt x="420" y="2645"/>
                  <a:pt x="400" y="2599"/>
                  <a:pt x="403" y="2553"/>
                </a:cubicBezTo>
                <a:cubicBezTo>
                  <a:pt x="406" y="2514"/>
                  <a:pt x="422" y="2479"/>
                  <a:pt x="452" y="2449"/>
                </a:cubicBezTo>
                <a:cubicBezTo>
                  <a:pt x="486" y="2416"/>
                  <a:pt x="524" y="2399"/>
                  <a:pt x="567" y="2400"/>
                </a:cubicBezTo>
                <a:cubicBezTo>
                  <a:pt x="611" y="2401"/>
                  <a:pt x="652" y="2420"/>
                  <a:pt x="690" y="2459"/>
                </a:cubicBezTo>
                <a:cubicBezTo>
                  <a:pt x="722" y="2490"/>
                  <a:pt x="741" y="2520"/>
                  <a:pt x="750" y="2547"/>
                </a:cubicBezTo>
                <a:cubicBezTo>
                  <a:pt x="759" y="2574"/>
                  <a:pt x="759" y="2602"/>
                  <a:pt x="751" y="2630"/>
                </a:cubicBezTo>
                <a:cubicBezTo>
                  <a:pt x="743" y="2658"/>
                  <a:pt x="728" y="2682"/>
                  <a:pt x="707" y="2703"/>
                </a:cubicBezTo>
                <a:cubicBezTo>
                  <a:pt x="673" y="2738"/>
                  <a:pt x="634" y="2754"/>
                  <a:pt x="591" y="2753"/>
                </a:cubicBezTo>
                <a:cubicBezTo>
                  <a:pt x="549" y="2753"/>
                  <a:pt x="507" y="2732"/>
                  <a:pt x="466" y="2690"/>
                </a:cubicBezTo>
                <a:close/>
                <a:moveTo>
                  <a:pt x="508" y="2648"/>
                </a:moveTo>
                <a:cubicBezTo>
                  <a:pt x="539" y="2679"/>
                  <a:pt x="569" y="2696"/>
                  <a:pt x="598" y="2698"/>
                </a:cubicBezTo>
                <a:cubicBezTo>
                  <a:pt x="627" y="2700"/>
                  <a:pt x="652" y="2690"/>
                  <a:pt x="673" y="2670"/>
                </a:cubicBezTo>
                <a:cubicBezTo>
                  <a:pt x="693" y="2649"/>
                  <a:pt x="703" y="2624"/>
                  <a:pt x="701" y="2595"/>
                </a:cubicBezTo>
                <a:cubicBezTo>
                  <a:pt x="699" y="2566"/>
                  <a:pt x="682" y="2535"/>
                  <a:pt x="650" y="2503"/>
                </a:cubicBezTo>
                <a:cubicBezTo>
                  <a:pt x="620" y="2473"/>
                  <a:pt x="590" y="2457"/>
                  <a:pt x="561" y="2455"/>
                </a:cubicBezTo>
                <a:cubicBezTo>
                  <a:pt x="532" y="2454"/>
                  <a:pt x="507" y="2463"/>
                  <a:pt x="487" y="2483"/>
                </a:cubicBezTo>
                <a:cubicBezTo>
                  <a:pt x="466" y="2504"/>
                  <a:pt x="457" y="2529"/>
                  <a:pt x="458" y="2558"/>
                </a:cubicBezTo>
                <a:cubicBezTo>
                  <a:pt x="460" y="2587"/>
                  <a:pt x="477" y="2617"/>
                  <a:pt x="508" y="2648"/>
                </a:cubicBezTo>
                <a:close/>
                <a:moveTo>
                  <a:pt x="868" y="2531"/>
                </a:moveTo>
                <a:lnTo>
                  <a:pt x="625" y="2287"/>
                </a:lnTo>
                <a:lnTo>
                  <a:pt x="662" y="2250"/>
                </a:lnTo>
                <a:lnTo>
                  <a:pt x="697" y="2285"/>
                </a:lnTo>
                <a:cubicBezTo>
                  <a:pt x="688" y="2240"/>
                  <a:pt x="700" y="2201"/>
                  <a:pt x="734" y="2167"/>
                </a:cubicBezTo>
                <a:cubicBezTo>
                  <a:pt x="749" y="2153"/>
                  <a:pt x="765" y="2142"/>
                  <a:pt x="783" y="2135"/>
                </a:cubicBezTo>
                <a:cubicBezTo>
                  <a:pt x="800" y="2128"/>
                  <a:pt x="816" y="2125"/>
                  <a:pt x="831" y="2128"/>
                </a:cubicBezTo>
                <a:cubicBezTo>
                  <a:pt x="846" y="2130"/>
                  <a:pt x="860" y="2136"/>
                  <a:pt x="874" y="2146"/>
                </a:cubicBezTo>
                <a:cubicBezTo>
                  <a:pt x="883" y="2152"/>
                  <a:pt x="898" y="2164"/>
                  <a:pt x="917" y="2183"/>
                </a:cubicBezTo>
                <a:lnTo>
                  <a:pt x="1066" y="2333"/>
                </a:lnTo>
                <a:lnTo>
                  <a:pt x="1025" y="2374"/>
                </a:lnTo>
                <a:lnTo>
                  <a:pt x="877" y="2226"/>
                </a:lnTo>
                <a:cubicBezTo>
                  <a:pt x="860" y="2209"/>
                  <a:pt x="846" y="2198"/>
                  <a:pt x="834" y="2193"/>
                </a:cubicBezTo>
                <a:cubicBezTo>
                  <a:pt x="823" y="2188"/>
                  <a:pt x="811" y="2187"/>
                  <a:pt x="797" y="2190"/>
                </a:cubicBezTo>
                <a:cubicBezTo>
                  <a:pt x="784" y="2194"/>
                  <a:pt x="772" y="2201"/>
                  <a:pt x="761" y="2212"/>
                </a:cubicBezTo>
                <a:cubicBezTo>
                  <a:pt x="744" y="2229"/>
                  <a:pt x="734" y="2250"/>
                  <a:pt x="732" y="2274"/>
                </a:cubicBezTo>
                <a:cubicBezTo>
                  <a:pt x="731" y="2298"/>
                  <a:pt x="746" y="2325"/>
                  <a:pt x="777" y="2357"/>
                </a:cubicBezTo>
                <a:lnTo>
                  <a:pt x="910" y="2490"/>
                </a:lnTo>
                <a:lnTo>
                  <a:pt x="868" y="2531"/>
                </a:lnTo>
                <a:close/>
                <a:moveTo>
                  <a:pt x="1182" y="2144"/>
                </a:moveTo>
                <a:lnTo>
                  <a:pt x="1224" y="2174"/>
                </a:lnTo>
                <a:cubicBezTo>
                  <a:pt x="1215" y="2188"/>
                  <a:pt x="1206" y="2200"/>
                  <a:pt x="1197" y="2209"/>
                </a:cubicBezTo>
                <a:cubicBezTo>
                  <a:pt x="1182" y="2224"/>
                  <a:pt x="1168" y="2233"/>
                  <a:pt x="1155" y="2237"/>
                </a:cubicBezTo>
                <a:cubicBezTo>
                  <a:pt x="1142" y="2240"/>
                  <a:pt x="1130" y="2240"/>
                  <a:pt x="1119" y="2236"/>
                </a:cubicBezTo>
                <a:cubicBezTo>
                  <a:pt x="1108" y="2231"/>
                  <a:pt x="1090" y="2217"/>
                  <a:pt x="1065" y="2192"/>
                </a:cubicBezTo>
                <a:lnTo>
                  <a:pt x="925" y="2052"/>
                </a:lnTo>
                <a:lnTo>
                  <a:pt x="895" y="2082"/>
                </a:lnTo>
                <a:lnTo>
                  <a:pt x="863" y="2050"/>
                </a:lnTo>
                <a:lnTo>
                  <a:pt x="893" y="2020"/>
                </a:lnTo>
                <a:lnTo>
                  <a:pt x="833" y="1959"/>
                </a:lnTo>
                <a:lnTo>
                  <a:pt x="849" y="1894"/>
                </a:lnTo>
                <a:lnTo>
                  <a:pt x="934" y="1979"/>
                </a:lnTo>
                <a:lnTo>
                  <a:pt x="975" y="1937"/>
                </a:lnTo>
                <a:lnTo>
                  <a:pt x="1007" y="1969"/>
                </a:lnTo>
                <a:lnTo>
                  <a:pt x="966" y="2011"/>
                </a:lnTo>
                <a:lnTo>
                  <a:pt x="1108" y="2153"/>
                </a:lnTo>
                <a:cubicBezTo>
                  <a:pt x="1120" y="2165"/>
                  <a:pt x="1128" y="2172"/>
                  <a:pt x="1133" y="2174"/>
                </a:cubicBezTo>
                <a:cubicBezTo>
                  <a:pt x="1138" y="2176"/>
                  <a:pt x="1143" y="2176"/>
                  <a:pt x="1148" y="2175"/>
                </a:cubicBezTo>
                <a:cubicBezTo>
                  <a:pt x="1154" y="2173"/>
                  <a:pt x="1159" y="2170"/>
                  <a:pt x="1165" y="2163"/>
                </a:cubicBezTo>
                <a:cubicBezTo>
                  <a:pt x="1170" y="2159"/>
                  <a:pt x="1175" y="2152"/>
                  <a:pt x="1182" y="2144"/>
                </a:cubicBezTo>
                <a:close/>
                <a:moveTo>
                  <a:pt x="1258" y="2141"/>
                </a:moveTo>
                <a:lnTo>
                  <a:pt x="1015" y="1898"/>
                </a:lnTo>
                <a:lnTo>
                  <a:pt x="1052" y="1860"/>
                </a:lnTo>
                <a:lnTo>
                  <a:pt x="1089" y="1897"/>
                </a:lnTo>
                <a:cubicBezTo>
                  <a:pt x="1081" y="1871"/>
                  <a:pt x="1078" y="1850"/>
                  <a:pt x="1081" y="1837"/>
                </a:cubicBezTo>
                <a:cubicBezTo>
                  <a:pt x="1084" y="1823"/>
                  <a:pt x="1090" y="1812"/>
                  <a:pt x="1099" y="1802"/>
                </a:cubicBezTo>
                <a:cubicBezTo>
                  <a:pt x="1113" y="1788"/>
                  <a:pt x="1132" y="1779"/>
                  <a:pt x="1155" y="1773"/>
                </a:cubicBezTo>
                <a:lnTo>
                  <a:pt x="1179" y="1826"/>
                </a:lnTo>
                <a:cubicBezTo>
                  <a:pt x="1163" y="1830"/>
                  <a:pt x="1150" y="1837"/>
                  <a:pt x="1140" y="1847"/>
                </a:cubicBezTo>
                <a:cubicBezTo>
                  <a:pt x="1131" y="1856"/>
                  <a:pt x="1125" y="1867"/>
                  <a:pt x="1124" y="1879"/>
                </a:cubicBezTo>
                <a:cubicBezTo>
                  <a:pt x="1122" y="1892"/>
                  <a:pt x="1124" y="1905"/>
                  <a:pt x="1131" y="1917"/>
                </a:cubicBezTo>
                <a:cubicBezTo>
                  <a:pt x="1141" y="1937"/>
                  <a:pt x="1155" y="1955"/>
                  <a:pt x="1172" y="1972"/>
                </a:cubicBezTo>
                <a:lnTo>
                  <a:pt x="1300" y="2100"/>
                </a:lnTo>
                <a:lnTo>
                  <a:pt x="1258" y="2141"/>
                </a:lnTo>
                <a:close/>
                <a:moveTo>
                  <a:pt x="1280" y="1876"/>
                </a:moveTo>
                <a:cubicBezTo>
                  <a:pt x="1235" y="1831"/>
                  <a:pt x="1214" y="1785"/>
                  <a:pt x="1218" y="1738"/>
                </a:cubicBezTo>
                <a:cubicBezTo>
                  <a:pt x="1220" y="1699"/>
                  <a:pt x="1237" y="1665"/>
                  <a:pt x="1267" y="1634"/>
                </a:cubicBezTo>
                <a:cubicBezTo>
                  <a:pt x="1301" y="1601"/>
                  <a:pt x="1339" y="1585"/>
                  <a:pt x="1382" y="1585"/>
                </a:cubicBezTo>
                <a:cubicBezTo>
                  <a:pt x="1425" y="1586"/>
                  <a:pt x="1466" y="1606"/>
                  <a:pt x="1505" y="1644"/>
                </a:cubicBezTo>
                <a:cubicBezTo>
                  <a:pt x="1536" y="1676"/>
                  <a:pt x="1556" y="1705"/>
                  <a:pt x="1565" y="1732"/>
                </a:cubicBezTo>
                <a:cubicBezTo>
                  <a:pt x="1573" y="1760"/>
                  <a:pt x="1573" y="1787"/>
                  <a:pt x="1565" y="1815"/>
                </a:cubicBezTo>
                <a:cubicBezTo>
                  <a:pt x="1557" y="1843"/>
                  <a:pt x="1543" y="1868"/>
                  <a:pt x="1522" y="1889"/>
                </a:cubicBezTo>
                <a:cubicBezTo>
                  <a:pt x="1487" y="1923"/>
                  <a:pt x="1449" y="1940"/>
                  <a:pt x="1406" y="1939"/>
                </a:cubicBezTo>
                <a:cubicBezTo>
                  <a:pt x="1363" y="1938"/>
                  <a:pt x="1321" y="1917"/>
                  <a:pt x="1280" y="1876"/>
                </a:cubicBezTo>
                <a:close/>
                <a:moveTo>
                  <a:pt x="1323" y="1833"/>
                </a:moveTo>
                <a:cubicBezTo>
                  <a:pt x="1354" y="1865"/>
                  <a:pt x="1384" y="1881"/>
                  <a:pt x="1413" y="1883"/>
                </a:cubicBezTo>
                <a:cubicBezTo>
                  <a:pt x="1442" y="1885"/>
                  <a:pt x="1467" y="1876"/>
                  <a:pt x="1488" y="1855"/>
                </a:cubicBezTo>
                <a:cubicBezTo>
                  <a:pt x="1508" y="1834"/>
                  <a:pt x="1517" y="1810"/>
                  <a:pt x="1515" y="1780"/>
                </a:cubicBezTo>
                <a:cubicBezTo>
                  <a:pt x="1513" y="1751"/>
                  <a:pt x="1496" y="1721"/>
                  <a:pt x="1464" y="1689"/>
                </a:cubicBezTo>
                <a:cubicBezTo>
                  <a:pt x="1434" y="1659"/>
                  <a:pt x="1405" y="1643"/>
                  <a:pt x="1375" y="1641"/>
                </a:cubicBezTo>
                <a:cubicBezTo>
                  <a:pt x="1346" y="1639"/>
                  <a:pt x="1322" y="1648"/>
                  <a:pt x="1301" y="1669"/>
                </a:cubicBezTo>
                <a:cubicBezTo>
                  <a:pt x="1281" y="1689"/>
                  <a:pt x="1271" y="1714"/>
                  <a:pt x="1273" y="1743"/>
                </a:cubicBezTo>
                <a:cubicBezTo>
                  <a:pt x="1275" y="1772"/>
                  <a:pt x="1291" y="1802"/>
                  <a:pt x="1323" y="1833"/>
                </a:cubicBezTo>
                <a:close/>
                <a:moveTo>
                  <a:pt x="1677" y="1723"/>
                </a:moveTo>
                <a:lnTo>
                  <a:pt x="1340" y="1387"/>
                </a:lnTo>
                <a:lnTo>
                  <a:pt x="1382" y="1346"/>
                </a:lnTo>
                <a:lnTo>
                  <a:pt x="1718" y="1682"/>
                </a:lnTo>
                <a:lnTo>
                  <a:pt x="1677" y="1723"/>
                </a:lnTo>
                <a:close/>
                <a:moveTo>
                  <a:pt x="1929" y="1471"/>
                </a:moveTo>
                <a:lnTo>
                  <a:pt x="1888" y="1512"/>
                </a:lnTo>
                <a:lnTo>
                  <a:pt x="1625" y="1249"/>
                </a:lnTo>
                <a:cubicBezTo>
                  <a:pt x="1624" y="1268"/>
                  <a:pt x="1621" y="1291"/>
                  <a:pt x="1614" y="1316"/>
                </a:cubicBezTo>
                <a:cubicBezTo>
                  <a:pt x="1607" y="1342"/>
                  <a:pt x="1600" y="1364"/>
                  <a:pt x="1592" y="1381"/>
                </a:cubicBezTo>
                <a:lnTo>
                  <a:pt x="1552" y="1341"/>
                </a:lnTo>
                <a:cubicBezTo>
                  <a:pt x="1564" y="1307"/>
                  <a:pt x="1571" y="1274"/>
                  <a:pt x="1573" y="1241"/>
                </a:cubicBezTo>
                <a:cubicBezTo>
                  <a:pt x="1575" y="1209"/>
                  <a:pt x="1572" y="1181"/>
                  <a:pt x="1565" y="1160"/>
                </a:cubicBezTo>
                <a:lnTo>
                  <a:pt x="1591" y="1133"/>
                </a:lnTo>
                <a:lnTo>
                  <a:pt x="1929" y="1471"/>
                </a:lnTo>
                <a:close/>
                <a:moveTo>
                  <a:pt x="1887" y="935"/>
                </a:moveTo>
                <a:lnTo>
                  <a:pt x="1839" y="888"/>
                </a:lnTo>
                <a:lnTo>
                  <a:pt x="1881" y="847"/>
                </a:lnTo>
                <a:lnTo>
                  <a:pt x="1928" y="894"/>
                </a:lnTo>
                <a:lnTo>
                  <a:pt x="1887" y="935"/>
                </a:lnTo>
                <a:close/>
                <a:moveTo>
                  <a:pt x="2175" y="1224"/>
                </a:moveTo>
                <a:lnTo>
                  <a:pt x="1932" y="980"/>
                </a:lnTo>
                <a:lnTo>
                  <a:pt x="1973" y="939"/>
                </a:lnTo>
                <a:lnTo>
                  <a:pt x="2217" y="1183"/>
                </a:lnTo>
                <a:lnTo>
                  <a:pt x="2175" y="1224"/>
                </a:lnTo>
                <a:close/>
                <a:moveTo>
                  <a:pt x="2288" y="1111"/>
                </a:moveTo>
                <a:lnTo>
                  <a:pt x="1952" y="775"/>
                </a:lnTo>
                <a:lnTo>
                  <a:pt x="2079" y="649"/>
                </a:lnTo>
                <a:cubicBezTo>
                  <a:pt x="2101" y="626"/>
                  <a:pt x="2119" y="610"/>
                  <a:pt x="2133" y="601"/>
                </a:cubicBezTo>
                <a:cubicBezTo>
                  <a:pt x="2152" y="587"/>
                  <a:pt x="2171" y="578"/>
                  <a:pt x="2190" y="575"/>
                </a:cubicBezTo>
                <a:cubicBezTo>
                  <a:pt x="2209" y="571"/>
                  <a:pt x="2229" y="573"/>
                  <a:pt x="2250" y="580"/>
                </a:cubicBezTo>
                <a:cubicBezTo>
                  <a:pt x="2270" y="587"/>
                  <a:pt x="2289" y="599"/>
                  <a:pt x="2306" y="616"/>
                </a:cubicBezTo>
                <a:cubicBezTo>
                  <a:pt x="2334" y="645"/>
                  <a:pt x="2349" y="678"/>
                  <a:pt x="2351" y="716"/>
                </a:cubicBezTo>
                <a:cubicBezTo>
                  <a:pt x="2353" y="754"/>
                  <a:pt x="2330" y="797"/>
                  <a:pt x="2282" y="844"/>
                </a:cubicBezTo>
                <a:lnTo>
                  <a:pt x="2196" y="930"/>
                </a:lnTo>
                <a:lnTo>
                  <a:pt x="2332" y="1067"/>
                </a:lnTo>
                <a:lnTo>
                  <a:pt x="2288" y="1111"/>
                </a:lnTo>
                <a:close/>
                <a:moveTo>
                  <a:pt x="2156" y="891"/>
                </a:moveTo>
                <a:lnTo>
                  <a:pt x="2243" y="804"/>
                </a:lnTo>
                <a:cubicBezTo>
                  <a:pt x="2272" y="775"/>
                  <a:pt x="2287" y="749"/>
                  <a:pt x="2288" y="727"/>
                </a:cubicBezTo>
                <a:cubicBezTo>
                  <a:pt x="2290" y="704"/>
                  <a:pt x="2281" y="683"/>
                  <a:pt x="2261" y="663"/>
                </a:cubicBezTo>
                <a:cubicBezTo>
                  <a:pt x="2247" y="649"/>
                  <a:pt x="2232" y="641"/>
                  <a:pt x="2214" y="638"/>
                </a:cubicBezTo>
                <a:cubicBezTo>
                  <a:pt x="2197" y="635"/>
                  <a:pt x="2181" y="638"/>
                  <a:pt x="2166" y="646"/>
                </a:cubicBezTo>
                <a:cubicBezTo>
                  <a:pt x="2157" y="652"/>
                  <a:pt x="2142" y="664"/>
                  <a:pt x="2122" y="685"/>
                </a:cubicBezTo>
                <a:lnTo>
                  <a:pt x="2036" y="771"/>
                </a:lnTo>
                <a:lnTo>
                  <a:pt x="2156" y="891"/>
                </a:lnTo>
                <a:close/>
                <a:moveTo>
                  <a:pt x="2476" y="707"/>
                </a:moveTo>
                <a:lnTo>
                  <a:pt x="2514" y="662"/>
                </a:lnTo>
                <a:cubicBezTo>
                  <a:pt x="2533" y="677"/>
                  <a:pt x="2551" y="686"/>
                  <a:pt x="2570" y="689"/>
                </a:cubicBezTo>
                <a:cubicBezTo>
                  <a:pt x="2588" y="693"/>
                  <a:pt x="2608" y="690"/>
                  <a:pt x="2629" y="682"/>
                </a:cubicBezTo>
                <a:cubicBezTo>
                  <a:pt x="2651" y="673"/>
                  <a:pt x="2672" y="659"/>
                  <a:pt x="2691" y="640"/>
                </a:cubicBezTo>
                <a:cubicBezTo>
                  <a:pt x="2708" y="623"/>
                  <a:pt x="2720" y="606"/>
                  <a:pt x="2728" y="588"/>
                </a:cubicBezTo>
                <a:cubicBezTo>
                  <a:pt x="2736" y="570"/>
                  <a:pt x="2739" y="553"/>
                  <a:pt x="2737" y="538"/>
                </a:cubicBezTo>
                <a:cubicBezTo>
                  <a:pt x="2734" y="523"/>
                  <a:pt x="2728" y="510"/>
                  <a:pt x="2717" y="500"/>
                </a:cubicBezTo>
                <a:cubicBezTo>
                  <a:pt x="2707" y="489"/>
                  <a:pt x="2695" y="483"/>
                  <a:pt x="2681" y="481"/>
                </a:cubicBezTo>
                <a:cubicBezTo>
                  <a:pt x="2667" y="479"/>
                  <a:pt x="2650" y="483"/>
                  <a:pt x="2631" y="491"/>
                </a:cubicBezTo>
                <a:cubicBezTo>
                  <a:pt x="2618" y="497"/>
                  <a:pt x="2593" y="511"/>
                  <a:pt x="2554" y="535"/>
                </a:cubicBezTo>
                <a:cubicBezTo>
                  <a:pt x="2516" y="558"/>
                  <a:pt x="2487" y="573"/>
                  <a:pt x="2468" y="579"/>
                </a:cubicBezTo>
                <a:cubicBezTo>
                  <a:pt x="2444" y="586"/>
                  <a:pt x="2422" y="588"/>
                  <a:pt x="2401" y="583"/>
                </a:cubicBezTo>
                <a:cubicBezTo>
                  <a:pt x="2381" y="579"/>
                  <a:pt x="2363" y="569"/>
                  <a:pt x="2348" y="553"/>
                </a:cubicBezTo>
                <a:cubicBezTo>
                  <a:pt x="2331" y="536"/>
                  <a:pt x="2320" y="516"/>
                  <a:pt x="2314" y="491"/>
                </a:cubicBezTo>
                <a:cubicBezTo>
                  <a:pt x="2309" y="467"/>
                  <a:pt x="2312" y="442"/>
                  <a:pt x="2323" y="416"/>
                </a:cubicBezTo>
                <a:cubicBezTo>
                  <a:pt x="2334" y="389"/>
                  <a:pt x="2351" y="365"/>
                  <a:pt x="2373" y="342"/>
                </a:cubicBezTo>
                <a:cubicBezTo>
                  <a:pt x="2398" y="318"/>
                  <a:pt x="2424" y="300"/>
                  <a:pt x="2451" y="289"/>
                </a:cubicBezTo>
                <a:cubicBezTo>
                  <a:pt x="2478" y="278"/>
                  <a:pt x="2505" y="275"/>
                  <a:pt x="2531" y="280"/>
                </a:cubicBezTo>
                <a:cubicBezTo>
                  <a:pt x="2556" y="285"/>
                  <a:pt x="2580" y="298"/>
                  <a:pt x="2600" y="317"/>
                </a:cubicBezTo>
                <a:lnTo>
                  <a:pt x="2561" y="362"/>
                </a:lnTo>
                <a:cubicBezTo>
                  <a:pt x="2537" y="343"/>
                  <a:pt x="2513" y="335"/>
                  <a:pt x="2489" y="338"/>
                </a:cubicBezTo>
                <a:cubicBezTo>
                  <a:pt x="2465" y="340"/>
                  <a:pt x="2440" y="354"/>
                  <a:pt x="2414" y="380"/>
                </a:cubicBezTo>
                <a:cubicBezTo>
                  <a:pt x="2387" y="407"/>
                  <a:pt x="2373" y="431"/>
                  <a:pt x="2370" y="453"/>
                </a:cubicBezTo>
                <a:cubicBezTo>
                  <a:pt x="2368" y="476"/>
                  <a:pt x="2374" y="494"/>
                  <a:pt x="2387" y="508"/>
                </a:cubicBezTo>
                <a:cubicBezTo>
                  <a:pt x="2400" y="520"/>
                  <a:pt x="2414" y="525"/>
                  <a:pt x="2430" y="524"/>
                </a:cubicBezTo>
                <a:cubicBezTo>
                  <a:pt x="2447" y="524"/>
                  <a:pt x="2477" y="509"/>
                  <a:pt x="2521" y="481"/>
                </a:cubicBezTo>
                <a:cubicBezTo>
                  <a:pt x="2566" y="453"/>
                  <a:pt x="2598" y="436"/>
                  <a:pt x="2617" y="428"/>
                </a:cubicBezTo>
                <a:cubicBezTo>
                  <a:pt x="2646" y="418"/>
                  <a:pt x="2672" y="415"/>
                  <a:pt x="2695" y="419"/>
                </a:cubicBezTo>
                <a:cubicBezTo>
                  <a:pt x="2718" y="424"/>
                  <a:pt x="2739" y="435"/>
                  <a:pt x="2757" y="453"/>
                </a:cubicBezTo>
                <a:cubicBezTo>
                  <a:pt x="2774" y="471"/>
                  <a:pt x="2786" y="493"/>
                  <a:pt x="2792" y="519"/>
                </a:cubicBezTo>
                <a:cubicBezTo>
                  <a:pt x="2797" y="545"/>
                  <a:pt x="2795" y="572"/>
                  <a:pt x="2785" y="600"/>
                </a:cubicBezTo>
                <a:cubicBezTo>
                  <a:pt x="2774" y="628"/>
                  <a:pt x="2757" y="654"/>
                  <a:pt x="2733" y="678"/>
                </a:cubicBezTo>
                <a:cubicBezTo>
                  <a:pt x="2703" y="708"/>
                  <a:pt x="2673" y="729"/>
                  <a:pt x="2643" y="741"/>
                </a:cubicBezTo>
                <a:cubicBezTo>
                  <a:pt x="2614" y="753"/>
                  <a:pt x="2584" y="756"/>
                  <a:pt x="2555" y="749"/>
                </a:cubicBezTo>
                <a:cubicBezTo>
                  <a:pt x="2525" y="743"/>
                  <a:pt x="2499" y="729"/>
                  <a:pt x="2476" y="707"/>
                </a:cubicBezTo>
                <a:close/>
                <a:moveTo>
                  <a:pt x="3076" y="244"/>
                </a:moveTo>
                <a:lnTo>
                  <a:pt x="3116" y="283"/>
                </a:lnTo>
                <a:lnTo>
                  <a:pt x="2894" y="506"/>
                </a:lnTo>
                <a:cubicBezTo>
                  <a:pt x="2884" y="496"/>
                  <a:pt x="2876" y="485"/>
                  <a:pt x="2870" y="472"/>
                </a:cubicBezTo>
                <a:cubicBezTo>
                  <a:pt x="2861" y="451"/>
                  <a:pt x="2855" y="427"/>
                  <a:pt x="2852" y="400"/>
                </a:cubicBezTo>
                <a:cubicBezTo>
                  <a:pt x="2850" y="373"/>
                  <a:pt x="2851" y="338"/>
                  <a:pt x="2856" y="295"/>
                </a:cubicBezTo>
                <a:cubicBezTo>
                  <a:pt x="2862" y="229"/>
                  <a:pt x="2863" y="180"/>
                  <a:pt x="2858" y="150"/>
                </a:cubicBezTo>
                <a:cubicBezTo>
                  <a:pt x="2854" y="120"/>
                  <a:pt x="2844" y="97"/>
                  <a:pt x="2828" y="81"/>
                </a:cubicBezTo>
                <a:cubicBezTo>
                  <a:pt x="2812" y="65"/>
                  <a:pt x="2792" y="57"/>
                  <a:pt x="2769" y="57"/>
                </a:cubicBezTo>
                <a:cubicBezTo>
                  <a:pt x="2746" y="58"/>
                  <a:pt x="2725" y="67"/>
                  <a:pt x="2707" y="86"/>
                </a:cubicBezTo>
                <a:cubicBezTo>
                  <a:pt x="2687" y="106"/>
                  <a:pt x="2677" y="128"/>
                  <a:pt x="2677" y="152"/>
                </a:cubicBezTo>
                <a:cubicBezTo>
                  <a:pt x="2677" y="176"/>
                  <a:pt x="2687" y="198"/>
                  <a:pt x="2708" y="219"/>
                </a:cubicBezTo>
                <a:lnTo>
                  <a:pt x="2661" y="257"/>
                </a:lnTo>
                <a:cubicBezTo>
                  <a:pt x="2633" y="223"/>
                  <a:pt x="2619" y="188"/>
                  <a:pt x="2622" y="152"/>
                </a:cubicBezTo>
                <a:cubicBezTo>
                  <a:pt x="2624" y="117"/>
                  <a:pt x="2641" y="83"/>
                  <a:pt x="2673" y="51"/>
                </a:cubicBezTo>
                <a:cubicBezTo>
                  <a:pt x="2706" y="19"/>
                  <a:pt x="2740" y="2"/>
                  <a:pt x="2777" y="1"/>
                </a:cubicBezTo>
                <a:cubicBezTo>
                  <a:pt x="2813" y="0"/>
                  <a:pt x="2845" y="13"/>
                  <a:pt x="2871" y="40"/>
                </a:cubicBezTo>
                <a:cubicBezTo>
                  <a:pt x="2885" y="53"/>
                  <a:pt x="2895" y="69"/>
                  <a:pt x="2903" y="88"/>
                </a:cubicBezTo>
                <a:cubicBezTo>
                  <a:pt x="2910" y="106"/>
                  <a:pt x="2915" y="129"/>
                  <a:pt x="2916" y="156"/>
                </a:cubicBezTo>
                <a:cubicBezTo>
                  <a:pt x="2918" y="183"/>
                  <a:pt x="2917" y="224"/>
                  <a:pt x="2912" y="279"/>
                </a:cubicBezTo>
                <a:cubicBezTo>
                  <a:pt x="2908" y="324"/>
                  <a:pt x="2906" y="354"/>
                  <a:pt x="2907" y="369"/>
                </a:cubicBezTo>
                <a:cubicBezTo>
                  <a:pt x="2907" y="383"/>
                  <a:pt x="2909" y="396"/>
                  <a:pt x="2912" y="409"/>
                </a:cubicBezTo>
                <a:lnTo>
                  <a:pt x="3076" y="244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85" name="Freeform 67"/>
          <p:cNvSpPr>
            <a:spLocks noEditPoints="1"/>
          </p:cNvSpPr>
          <p:nvPr/>
        </p:nvSpPr>
        <p:spPr bwMode="auto">
          <a:xfrm>
            <a:off x="2510015" y="4613062"/>
            <a:ext cx="584200" cy="581025"/>
          </a:xfrm>
          <a:custGeom>
            <a:avLst/>
            <a:gdLst>
              <a:gd name="T0" fmla="*/ 419 w 3063"/>
              <a:gd name="T1" fmla="*/ 2982 h 3056"/>
              <a:gd name="T2" fmla="*/ 13 w 3063"/>
              <a:gd name="T3" fmla="*/ 2852 h 3056"/>
              <a:gd name="T4" fmla="*/ 303 w 3063"/>
              <a:gd name="T5" fmla="*/ 2598 h 3056"/>
              <a:gd name="T6" fmla="*/ 63 w 3063"/>
              <a:gd name="T7" fmla="*/ 2756 h 3056"/>
              <a:gd name="T8" fmla="*/ 304 w 3063"/>
              <a:gd name="T9" fmla="*/ 2988 h 3056"/>
              <a:gd name="T10" fmla="*/ 465 w 3063"/>
              <a:gd name="T11" fmla="*/ 2680 h 3056"/>
              <a:gd name="T12" fmla="*/ 690 w 3063"/>
              <a:gd name="T13" fmla="*/ 2449 h 3056"/>
              <a:gd name="T14" fmla="*/ 591 w 3063"/>
              <a:gd name="T15" fmla="*/ 2743 h 3056"/>
              <a:gd name="T16" fmla="*/ 672 w 3063"/>
              <a:gd name="T17" fmla="*/ 2660 h 3056"/>
              <a:gd name="T18" fmla="*/ 486 w 3063"/>
              <a:gd name="T19" fmla="*/ 2473 h 3056"/>
              <a:gd name="T20" fmla="*/ 624 w 3063"/>
              <a:gd name="T21" fmla="*/ 2277 h 3056"/>
              <a:gd name="T22" fmla="*/ 782 w 3063"/>
              <a:gd name="T23" fmla="*/ 2125 h 3056"/>
              <a:gd name="T24" fmla="*/ 1066 w 3063"/>
              <a:gd name="T25" fmla="*/ 2323 h 3056"/>
              <a:gd name="T26" fmla="*/ 797 w 3063"/>
              <a:gd name="T27" fmla="*/ 2180 h 3056"/>
              <a:gd name="T28" fmla="*/ 909 w 3063"/>
              <a:gd name="T29" fmla="*/ 2480 h 3056"/>
              <a:gd name="T30" fmla="*/ 1196 w 3063"/>
              <a:gd name="T31" fmla="*/ 2199 h 3056"/>
              <a:gd name="T32" fmla="*/ 924 w 3063"/>
              <a:gd name="T33" fmla="*/ 2042 h 3056"/>
              <a:gd name="T34" fmla="*/ 832 w 3063"/>
              <a:gd name="T35" fmla="*/ 1949 h 3056"/>
              <a:gd name="T36" fmla="*/ 1007 w 3063"/>
              <a:gd name="T37" fmla="*/ 1959 h 3056"/>
              <a:gd name="T38" fmla="*/ 1148 w 3063"/>
              <a:gd name="T39" fmla="*/ 2165 h 3056"/>
              <a:gd name="T40" fmla="*/ 1014 w 3063"/>
              <a:gd name="T41" fmla="*/ 1888 h 3056"/>
              <a:gd name="T42" fmla="*/ 1099 w 3063"/>
              <a:gd name="T43" fmla="*/ 1792 h 3056"/>
              <a:gd name="T44" fmla="*/ 1123 w 3063"/>
              <a:gd name="T45" fmla="*/ 1869 h 3056"/>
              <a:gd name="T46" fmla="*/ 1258 w 3063"/>
              <a:gd name="T47" fmla="*/ 2131 h 3056"/>
              <a:gd name="T48" fmla="*/ 1381 w 3063"/>
              <a:gd name="T49" fmla="*/ 1575 h 3056"/>
              <a:gd name="T50" fmla="*/ 1521 w 3063"/>
              <a:gd name="T51" fmla="*/ 1879 h 3056"/>
              <a:gd name="T52" fmla="*/ 1412 w 3063"/>
              <a:gd name="T53" fmla="*/ 1873 h 3056"/>
              <a:gd name="T54" fmla="*/ 1375 w 3063"/>
              <a:gd name="T55" fmla="*/ 1631 h 3056"/>
              <a:gd name="T56" fmla="*/ 1676 w 3063"/>
              <a:gd name="T57" fmla="*/ 1713 h 3056"/>
              <a:gd name="T58" fmla="*/ 1676 w 3063"/>
              <a:gd name="T59" fmla="*/ 1713 h 3056"/>
              <a:gd name="T60" fmla="*/ 1613 w 3063"/>
              <a:gd name="T61" fmla="*/ 1306 h 3056"/>
              <a:gd name="T62" fmla="*/ 1564 w 3063"/>
              <a:gd name="T63" fmla="*/ 1150 h 3056"/>
              <a:gd name="T64" fmla="*/ 1839 w 3063"/>
              <a:gd name="T65" fmla="*/ 878 h 3056"/>
              <a:gd name="T66" fmla="*/ 2175 w 3063"/>
              <a:gd name="T67" fmla="*/ 1214 h 3056"/>
              <a:gd name="T68" fmla="*/ 2175 w 3063"/>
              <a:gd name="T69" fmla="*/ 1214 h 3056"/>
              <a:gd name="T70" fmla="*/ 2132 w 3063"/>
              <a:gd name="T71" fmla="*/ 591 h 3056"/>
              <a:gd name="T72" fmla="*/ 2350 w 3063"/>
              <a:gd name="T73" fmla="*/ 706 h 3056"/>
              <a:gd name="T74" fmla="*/ 2287 w 3063"/>
              <a:gd name="T75" fmla="*/ 1101 h 3056"/>
              <a:gd name="T76" fmla="*/ 2261 w 3063"/>
              <a:gd name="T77" fmla="*/ 653 h 3056"/>
              <a:gd name="T78" fmla="*/ 2035 w 3063"/>
              <a:gd name="T79" fmla="*/ 761 h 3056"/>
              <a:gd name="T80" fmla="*/ 2569 w 3063"/>
              <a:gd name="T81" fmla="*/ 679 h 3056"/>
              <a:gd name="T82" fmla="*/ 2736 w 3063"/>
              <a:gd name="T83" fmla="*/ 528 h 3056"/>
              <a:gd name="T84" fmla="*/ 2554 w 3063"/>
              <a:gd name="T85" fmla="*/ 525 h 3056"/>
              <a:gd name="T86" fmla="*/ 2314 w 3063"/>
              <a:gd name="T87" fmla="*/ 481 h 3056"/>
              <a:gd name="T88" fmla="*/ 2530 w 3063"/>
              <a:gd name="T89" fmla="*/ 270 h 3056"/>
              <a:gd name="T90" fmla="*/ 2414 w 3063"/>
              <a:gd name="T91" fmla="*/ 370 h 3056"/>
              <a:gd name="T92" fmla="*/ 2521 w 3063"/>
              <a:gd name="T93" fmla="*/ 471 h 3056"/>
              <a:gd name="T94" fmla="*/ 2791 w 3063"/>
              <a:gd name="T95" fmla="*/ 509 h 3056"/>
              <a:gd name="T96" fmla="*/ 2554 w 3063"/>
              <a:gd name="T97" fmla="*/ 739 h 3056"/>
              <a:gd name="T98" fmla="*/ 2921 w 3063"/>
              <a:gd name="T99" fmla="*/ 381 h 3056"/>
              <a:gd name="T100" fmla="*/ 2911 w 3063"/>
              <a:gd name="T101" fmla="*/ 187 h 3056"/>
              <a:gd name="T102" fmla="*/ 2797 w 3063"/>
              <a:gd name="T103" fmla="*/ 203 h 3056"/>
              <a:gd name="T104" fmla="*/ 2701 w 3063"/>
              <a:gd name="T105" fmla="*/ 80 h 3056"/>
              <a:gd name="T106" fmla="*/ 2623 w 3063"/>
              <a:gd name="T107" fmla="*/ 137 h 3056"/>
              <a:gd name="T108" fmla="*/ 2852 w 3063"/>
              <a:gd name="T109" fmla="*/ 36 h 3056"/>
              <a:gd name="T110" fmla="*/ 3020 w 3063"/>
              <a:gd name="T111" fmla="*/ 171 h 3056"/>
              <a:gd name="T112" fmla="*/ 2810 w 3063"/>
              <a:gd name="T113" fmla="*/ 401 h 305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</a:cxnLst>
            <a:rect l="0" t="0" r="r" b="b"/>
            <a:pathLst>
              <a:path w="3063" h="3056">
                <a:moveTo>
                  <a:pt x="390" y="2763"/>
                </a:moveTo>
                <a:lnTo>
                  <a:pt x="446" y="2730"/>
                </a:lnTo>
                <a:cubicBezTo>
                  <a:pt x="473" y="2776"/>
                  <a:pt x="484" y="2821"/>
                  <a:pt x="479" y="2864"/>
                </a:cubicBezTo>
                <a:cubicBezTo>
                  <a:pt x="474" y="2907"/>
                  <a:pt x="454" y="2947"/>
                  <a:pt x="419" y="2982"/>
                </a:cubicBezTo>
                <a:cubicBezTo>
                  <a:pt x="383" y="3018"/>
                  <a:pt x="346" y="3040"/>
                  <a:pt x="308" y="3048"/>
                </a:cubicBezTo>
                <a:cubicBezTo>
                  <a:pt x="271" y="3056"/>
                  <a:pt x="232" y="3052"/>
                  <a:pt x="192" y="3036"/>
                </a:cubicBezTo>
                <a:cubicBezTo>
                  <a:pt x="153" y="3019"/>
                  <a:pt x="117" y="2995"/>
                  <a:pt x="84" y="2963"/>
                </a:cubicBezTo>
                <a:cubicBezTo>
                  <a:pt x="49" y="2928"/>
                  <a:pt x="26" y="2891"/>
                  <a:pt x="13" y="2852"/>
                </a:cubicBezTo>
                <a:cubicBezTo>
                  <a:pt x="0" y="2812"/>
                  <a:pt x="0" y="2773"/>
                  <a:pt x="11" y="2735"/>
                </a:cubicBezTo>
                <a:cubicBezTo>
                  <a:pt x="22" y="2697"/>
                  <a:pt x="42" y="2663"/>
                  <a:pt x="72" y="2633"/>
                </a:cubicBezTo>
                <a:cubicBezTo>
                  <a:pt x="106" y="2600"/>
                  <a:pt x="142" y="2580"/>
                  <a:pt x="182" y="2574"/>
                </a:cubicBezTo>
                <a:cubicBezTo>
                  <a:pt x="222" y="2568"/>
                  <a:pt x="262" y="2576"/>
                  <a:pt x="303" y="2598"/>
                </a:cubicBezTo>
                <a:lnTo>
                  <a:pt x="269" y="2653"/>
                </a:lnTo>
                <a:cubicBezTo>
                  <a:pt x="237" y="2636"/>
                  <a:pt x="208" y="2629"/>
                  <a:pt x="182" y="2633"/>
                </a:cubicBezTo>
                <a:cubicBezTo>
                  <a:pt x="156" y="2637"/>
                  <a:pt x="131" y="2650"/>
                  <a:pt x="109" y="2672"/>
                </a:cubicBezTo>
                <a:cubicBezTo>
                  <a:pt x="83" y="2698"/>
                  <a:pt x="68" y="2726"/>
                  <a:pt x="63" y="2756"/>
                </a:cubicBezTo>
                <a:cubicBezTo>
                  <a:pt x="58" y="2785"/>
                  <a:pt x="62" y="2814"/>
                  <a:pt x="76" y="2842"/>
                </a:cubicBezTo>
                <a:cubicBezTo>
                  <a:pt x="90" y="2870"/>
                  <a:pt x="108" y="2895"/>
                  <a:pt x="130" y="2917"/>
                </a:cubicBezTo>
                <a:cubicBezTo>
                  <a:pt x="159" y="2946"/>
                  <a:pt x="188" y="2966"/>
                  <a:pt x="217" y="2979"/>
                </a:cubicBezTo>
                <a:cubicBezTo>
                  <a:pt x="247" y="2992"/>
                  <a:pt x="276" y="2995"/>
                  <a:pt x="304" y="2988"/>
                </a:cubicBezTo>
                <a:cubicBezTo>
                  <a:pt x="332" y="2981"/>
                  <a:pt x="357" y="2968"/>
                  <a:pt x="377" y="2947"/>
                </a:cubicBezTo>
                <a:cubicBezTo>
                  <a:pt x="402" y="2922"/>
                  <a:pt x="416" y="2894"/>
                  <a:pt x="419" y="2862"/>
                </a:cubicBezTo>
                <a:cubicBezTo>
                  <a:pt x="422" y="2831"/>
                  <a:pt x="412" y="2798"/>
                  <a:pt x="390" y="2763"/>
                </a:cubicBezTo>
                <a:close/>
                <a:moveTo>
                  <a:pt x="465" y="2680"/>
                </a:moveTo>
                <a:cubicBezTo>
                  <a:pt x="420" y="2635"/>
                  <a:pt x="399" y="2589"/>
                  <a:pt x="402" y="2543"/>
                </a:cubicBezTo>
                <a:cubicBezTo>
                  <a:pt x="405" y="2504"/>
                  <a:pt x="422" y="2469"/>
                  <a:pt x="452" y="2439"/>
                </a:cubicBezTo>
                <a:cubicBezTo>
                  <a:pt x="485" y="2406"/>
                  <a:pt x="524" y="2389"/>
                  <a:pt x="567" y="2390"/>
                </a:cubicBezTo>
                <a:cubicBezTo>
                  <a:pt x="610" y="2391"/>
                  <a:pt x="651" y="2410"/>
                  <a:pt x="690" y="2449"/>
                </a:cubicBezTo>
                <a:cubicBezTo>
                  <a:pt x="721" y="2480"/>
                  <a:pt x="741" y="2510"/>
                  <a:pt x="749" y="2537"/>
                </a:cubicBezTo>
                <a:cubicBezTo>
                  <a:pt x="758" y="2564"/>
                  <a:pt x="758" y="2592"/>
                  <a:pt x="750" y="2620"/>
                </a:cubicBezTo>
                <a:cubicBezTo>
                  <a:pt x="742" y="2648"/>
                  <a:pt x="728" y="2672"/>
                  <a:pt x="706" y="2693"/>
                </a:cubicBezTo>
                <a:cubicBezTo>
                  <a:pt x="672" y="2728"/>
                  <a:pt x="634" y="2744"/>
                  <a:pt x="591" y="2743"/>
                </a:cubicBezTo>
                <a:cubicBezTo>
                  <a:pt x="548" y="2743"/>
                  <a:pt x="506" y="2722"/>
                  <a:pt x="465" y="2680"/>
                </a:cubicBezTo>
                <a:close/>
                <a:moveTo>
                  <a:pt x="507" y="2638"/>
                </a:moveTo>
                <a:cubicBezTo>
                  <a:pt x="539" y="2669"/>
                  <a:pt x="569" y="2686"/>
                  <a:pt x="598" y="2688"/>
                </a:cubicBezTo>
                <a:cubicBezTo>
                  <a:pt x="627" y="2690"/>
                  <a:pt x="652" y="2680"/>
                  <a:pt x="672" y="2660"/>
                </a:cubicBezTo>
                <a:cubicBezTo>
                  <a:pt x="693" y="2639"/>
                  <a:pt x="702" y="2614"/>
                  <a:pt x="700" y="2585"/>
                </a:cubicBezTo>
                <a:cubicBezTo>
                  <a:pt x="698" y="2556"/>
                  <a:pt x="681" y="2525"/>
                  <a:pt x="649" y="2493"/>
                </a:cubicBezTo>
                <a:cubicBezTo>
                  <a:pt x="619" y="2463"/>
                  <a:pt x="590" y="2447"/>
                  <a:pt x="560" y="2445"/>
                </a:cubicBezTo>
                <a:cubicBezTo>
                  <a:pt x="531" y="2444"/>
                  <a:pt x="506" y="2453"/>
                  <a:pt x="486" y="2473"/>
                </a:cubicBezTo>
                <a:cubicBezTo>
                  <a:pt x="465" y="2494"/>
                  <a:pt x="456" y="2519"/>
                  <a:pt x="458" y="2548"/>
                </a:cubicBezTo>
                <a:cubicBezTo>
                  <a:pt x="460" y="2577"/>
                  <a:pt x="476" y="2607"/>
                  <a:pt x="507" y="2638"/>
                </a:cubicBezTo>
                <a:close/>
                <a:moveTo>
                  <a:pt x="868" y="2521"/>
                </a:moveTo>
                <a:lnTo>
                  <a:pt x="624" y="2277"/>
                </a:lnTo>
                <a:lnTo>
                  <a:pt x="662" y="2240"/>
                </a:lnTo>
                <a:lnTo>
                  <a:pt x="696" y="2275"/>
                </a:lnTo>
                <a:cubicBezTo>
                  <a:pt x="687" y="2230"/>
                  <a:pt x="700" y="2191"/>
                  <a:pt x="734" y="2157"/>
                </a:cubicBezTo>
                <a:cubicBezTo>
                  <a:pt x="748" y="2143"/>
                  <a:pt x="764" y="2132"/>
                  <a:pt x="782" y="2125"/>
                </a:cubicBezTo>
                <a:cubicBezTo>
                  <a:pt x="800" y="2118"/>
                  <a:pt x="816" y="2115"/>
                  <a:pt x="830" y="2118"/>
                </a:cubicBezTo>
                <a:cubicBezTo>
                  <a:pt x="845" y="2120"/>
                  <a:pt x="859" y="2126"/>
                  <a:pt x="874" y="2136"/>
                </a:cubicBezTo>
                <a:cubicBezTo>
                  <a:pt x="883" y="2142"/>
                  <a:pt x="897" y="2154"/>
                  <a:pt x="916" y="2173"/>
                </a:cubicBezTo>
                <a:lnTo>
                  <a:pt x="1066" y="2323"/>
                </a:lnTo>
                <a:lnTo>
                  <a:pt x="1024" y="2364"/>
                </a:lnTo>
                <a:lnTo>
                  <a:pt x="876" y="2216"/>
                </a:lnTo>
                <a:cubicBezTo>
                  <a:pt x="860" y="2199"/>
                  <a:pt x="845" y="2188"/>
                  <a:pt x="834" y="2183"/>
                </a:cubicBezTo>
                <a:cubicBezTo>
                  <a:pt x="822" y="2178"/>
                  <a:pt x="810" y="2177"/>
                  <a:pt x="797" y="2180"/>
                </a:cubicBezTo>
                <a:cubicBezTo>
                  <a:pt x="784" y="2184"/>
                  <a:pt x="772" y="2191"/>
                  <a:pt x="761" y="2202"/>
                </a:cubicBezTo>
                <a:cubicBezTo>
                  <a:pt x="743" y="2219"/>
                  <a:pt x="733" y="2240"/>
                  <a:pt x="732" y="2264"/>
                </a:cubicBezTo>
                <a:cubicBezTo>
                  <a:pt x="730" y="2288"/>
                  <a:pt x="745" y="2315"/>
                  <a:pt x="776" y="2347"/>
                </a:cubicBezTo>
                <a:lnTo>
                  <a:pt x="909" y="2480"/>
                </a:lnTo>
                <a:lnTo>
                  <a:pt x="868" y="2521"/>
                </a:lnTo>
                <a:close/>
                <a:moveTo>
                  <a:pt x="1181" y="2134"/>
                </a:moveTo>
                <a:lnTo>
                  <a:pt x="1224" y="2164"/>
                </a:lnTo>
                <a:cubicBezTo>
                  <a:pt x="1215" y="2178"/>
                  <a:pt x="1205" y="2190"/>
                  <a:pt x="1196" y="2199"/>
                </a:cubicBezTo>
                <a:cubicBezTo>
                  <a:pt x="1181" y="2214"/>
                  <a:pt x="1167" y="2223"/>
                  <a:pt x="1154" y="2227"/>
                </a:cubicBezTo>
                <a:cubicBezTo>
                  <a:pt x="1141" y="2230"/>
                  <a:pt x="1129" y="2230"/>
                  <a:pt x="1118" y="2226"/>
                </a:cubicBezTo>
                <a:cubicBezTo>
                  <a:pt x="1107" y="2221"/>
                  <a:pt x="1089" y="2207"/>
                  <a:pt x="1064" y="2182"/>
                </a:cubicBezTo>
                <a:lnTo>
                  <a:pt x="924" y="2042"/>
                </a:lnTo>
                <a:lnTo>
                  <a:pt x="894" y="2072"/>
                </a:lnTo>
                <a:lnTo>
                  <a:pt x="862" y="2040"/>
                </a:lnTo>
                <a:lnTo>
                  <a:pt x="892" y="2010"/>
                </a:lnTo>
                <a:lnTo>
                  <a:pt x="832" y="1949"/>
                </a:lnTo>
                <a:lnTo>
                  <a:pt x="848" y="1884"/>
                </a:lnTo>
                <a:lnTo>
                  <a:pt x="933" y="1969"/>
                </a:lnTo>
                <a:lnTo>
                  <a:pt x="975" y="1927"/>
                </a:lnTo>
                <a:lnTo>
                  <a:pt x="1007" y="1959"/>
                </a:lnTo>
                <a:lnTo>
                  <a:pt x="965" y="2001"/>
                </a:lnTo>
                <a:lnTo>
                  <a:pt x="1108" y="2143"/>
                </a:lnTo>
                <a:cubicBezTo>
                  <a:pt x="1119" y="2155"/>
                  <a:pt x="1128" y="2162"/>
                  <a:pt x="1133" y="2164"/>
                </a:cubicBezTo>
                <a:cubicBezTo>
                  <a:pt x="1137" y="2166"/>
                  <a:pt x="1142" y="2166"/>
                  <a:pt x="1148" y="2165"/>
                </a:cubicBezTo>
                <a:cubicBezTo>
                  <a:pt x="1153" y="2163"/>
                  <a:pt x="1159" y="2160"/>
                  <a:pt x="1165" y="2153"/>
                </a:cubicBezTo>
                <a:cubicBezTo>
                  <a:pt x="1169" y="2149"/>
                  <a:pt x="1175" y="2142"/>
                  <a:pt x="1181" y="2134"/>
                </a:cubicBezTo>
                <a:close/>
                <a:moveTo>
                  <a:pt x="1258" y="2131"/>
                </a:moveTo>
                <a:lnTo>
                  <a:pt x="1014" y="1888"/>
                </a:lnTo>
                <a:lnTo>
                  <a:pt x="1051" y="1850"/>
                </a:lnTo>
                <a:lnTo>
                  <a:pt x="1088" y="1887"/>
                </a:lnTo>
                <a:cubicBezTo>
                  <a:pt x="1081" y="1861"/>
                  <a:pt x="1078" y="1840"/>
                  <a:pt x="1080" y="1827"/>
                </a:cubicBezTo>
                <a:cubicBezTo>
                  <a:pt x="1083" y="1813"/>
                  <a:pt x="1089" y="1802"/>
                  <a:pt x="1099" y="1792"/>
                </a:cubicBezTo>
                <a:cubicBezTo>
                  <a:pt x="1113" y="1778"/>
                  <a:pt x="1131" y="1769"/>
                  <a:pt x="1154" y="1763"/>
                </a:cubicBezTo>
                <a:lnTo>
                  <a:pt x="1178" y="1816"/>
                </a:lnTo>
                <a:cubicBezTo>
                  <a:pt x="1162" y="1820"/>
                  <a:pt x="1149" y="1827"/>
                  <a:pt x="1139" y="1837"/>
                </a:cubicBezTo>
                <a:cubicBezTo>
                  <a:pt x="1130" y="1846"/>
                  <a:pt x="1125" y="1857"/>
                  <a:pt x="1123" y="1869"/>
                </a:cubicBezTo>
                <a:cubicBezTo>
                  <a:pt x="1121" y="1882"/>
                  <a:pt x="1124" y="1895"/>
                  <a:pt x="1130" y="1907"/>
                </a:cubicBezTo>
                <a:cubicBezTo>
                  <a:pt x="1140" y="1927"/>
                  <a:pt x="1154" y="1945"/>
                  <a:pt x="1172" y="1962"/>
                </a:cubicBezTo>
                <a:lnTo>
                  <a:pt x="1299" y="2090"/>
                </a:lnTo>
                <a:lnTo>
                  <a:pt x="1258" y="2131"/>
                </a:lnTo>
                <a:close/>
                <a:moveTo>
                  <a:pt x="1280" y="1866"/>
                </a:moveTo>
                <a:cubicBezTo>
                  <a:pt x="1234" y="1821"/>
                  <a:pt x="1214" y="1775"/>
                  <a:pt x="1217" y="1728"/>
                </a:cubicBezTo>
                <a:cubicBezTo>
                  <a:pt x="1220" y="1689"/>
                  <a:pt x="1236" y="1655"/>
                  <a:pt x="1266" y="1624"/>
                </a:cubicBezTo>
                <a:cubicBezTo>
                  <a:pt x="1300" y="1591"/>
                  <a:pt x="1338" y="1575"/>
                  <a:pt x="1381" y="1575"/>
                </a:cubicBezTo>
                <a:cubicBezTo>
                  <a:pt x="1425" y="1576"/>
                  <a:pt x="1466" y="1596"/>
                  <a:pt x="1504" y="1634"/>
                </a:cubicBezTo>
                <a:cubicBezTo>
                  <a:pt x="1536" y="1666"/>
                  <a:pt x="1555" y="1695"/>
                  <a:pt x="1564" y="1722"/>
                </a:cubicBezTo>
                <a:cubicBezTo>
                  <a:pt x="1573" y="1750"/>
                  <a:pt x="1573" y="1777"/>
                  <a:pt x="1565" y="1805"/>
                </a:cubicBezTo>
                <a:cubicBezTo>
                  <a:pt x="1557" y="1833"/>
                  <a:pt x="1542" y="1858"/>
                  <a:pt x="1521" y="1879"/>
                </a:cubicBezTo>
                <a:cubicBezTo>
                  <a:pt x="1487" y="1913"/>
                  <a:pt x="1448" y="1930"/>
                  <a:pt x="1406" y="1929"/>
                </a:cubicBezTo>
                <a:cubicBezTo>
                  <a:pt x="1363" y="1928"/>
                  <a:pt x="1321" y="1907"/>
                  <a:pt x="1280" y="1866"/>
                </a:cubicBezTo>
                <a:close/>
                <a:moveTo>
                  <a:pt x="1322" y="1823"/>
                </a:moveTo>
                <a:cubicBezTo>
                  <a:pt x="1353" y="1855"/>
                  <a:pt x="1383" y="1871"/>
                  <a:pt x="1412" y="1873"/>
                </a:cubicBezTo>
                <a:cubicBezTo>
                  <a:pt x="1441" y="1875"/>
                  <a:pt x="1466" y="1866"/>
                  <a:pt x="1487" y="1845"/>
                </a:cubicBezTo>
                <a:cubicBezTo>
                  <a:pt x="1507" y="1824"/>
                  <a:pt x="1517" y="1800"/>
                  <a:pt x="1515" y="1770"/>
                </a:cubicBezTo>
                <a:cubicBezTo>
                  <a:pt x="1513" y="1741"/>
                  <a:pt x="1496" y="1711"/>
                  <a:pt x="1464" y="1679"/>
                </a:cubicBezTo>
                <a:cubicBezTo>
                  <a:pt x="1434" y="1649"/>
                  <a:pt x="1404" y="1633"/>
                  <a:pt x="1375" y="1631"/>
                </a:cubicBezTo>
                <a:cubicBezTo>
                  <a:pt x="1346" y="1629"/>
                  <a:pt x="1321" y="1638"/>
                  <a:pt x="1301" y="1659"/>
                </a:cubicBezTo>
                <a:cubicBezTo>
                  <a:pt x="1280" y="1679"/>
                  <a:pt x="1271" y="1704"/>
                  <a:pt x="1272" y="1733"/>
                </a:cubicBezTo>
                <a:cubicBezTo>
                  <a:pt x="1274" y="1762"/>
                  <a:pt x="1291" y="1792"/>
                  <a:pt x="1322" y="1823"/>
                </a:cubicBezTo>
                <a:close/>
                <a:moveTo>
                  <a:pt x="1676" y="1713"/>
                </a:moveTo>
                <a:lnTo>
                  <a:pt x="1340" y="1377"/>
                </a:lnTo>
                <a:lnTo>
                  <a:pt x="1381" y="1336"/>
                </a:lnTo>
                <a:lnTo>
                  <a:pt x="1717" y="1672"/>
                </a:lnTo>
                <a:lnTo>
                  <a:pt x="1676" y="1713"/>
                </a:lnTo>
                <a:close/>
                <a:moveTo>
                  <a:pt x="1928" y="1461"/>
                </a:moveTo>
                <a:lnTo>
                  <a:pt x="1887" y="1502"/>
                </a:lnTo>
                <a:lnTo>
                  <a:pt x="1624" y="1239"/>
                </a:lnTo>
                <a:cubicBezTo>
                  <a:pt x="1624" y="1258"/>
                  <a:pt x="1620" y="1281"/>
                  <a:pt x="1613" y="1306"/>
                </a:cubicBezTo>
                <a:cubicBezTo>
                  <a:pt x="1607" y="1332"/>
                  <a:pt x="1599" y="1354"/>
                  <a:pt x="1591" y="1371"/>
                </a:cubicBezTo>
                <a:lnTo>
                  <a:pt x="1551" y="1331"/>
                </a:lnTo>
                <a:cubicBezTo>
                  <a:pt x="1564" y="1297"/>
                  <a:pt x="1571" y="1264"/>
                  <a:pt x="1572" y="1231"/>
                </a:cubicBezTo>
                <a:cubicBezTo>
                  <a:pt x="1574" y="1199"/>
                  <a:pt x="1572" y="1171"/>
                  <a:pt x="1564" y="1150"/>
                </a:cubicBezTo>
                <a:lnTo>
                  <a:pt x="1591" y="1123"/>
                </a:lnTo>
                <a:lnTo>
                  <a:pt x="1928" y="1461"/>
                </a:lnTo>
                <a:close/>
                <a:moveTo>
                  <a:pt x="1886" y="925"/>
                </a:moveTo>
                <a:lnTo>
                  <a:pt x="1839" y="878"/>
                </a:lnTo>
                <a:lnTo>
                  <a:pt x="1880" y="837"/>
                </a:lnTo>
                <a:lnTo>
                  <a:pt x="1928" y="884"/>
                </a:lnTo>
                <a:lnTo>
                  <a:pt x="1886" y="925"/>
                </a:lnTo>
                <a:close/>
                <a:moveTo>
                  <a:pt x="2175" y="1214"/>
                </a:moveTo>
                <a:lnTo>
                  <a:pt x="1931" y="970"/>
                </a:lnTo>
                <a:lnTo>
                  <a:pt x="1973" y="929"/>
                </a:lnTo>
                <a:lnTo>
                  <a:pt x="2216" y="1173"/>
                </a:lnTo>
                <a:lnTo>
                  <a:pt x="2175" y="1214"/>
                </a:lnTo>
                <a:close/>
                <a:moveTo>
                  <a:pt x="2287" y="1101"/>
                </a:moveTo>
                <a:lnTo>
                  <a:pt x="1951" y="765"/>
                </a:lnTo>
                <a:lnTo>
                  <a:pt x="2078" y="639"/>
                </a:lnTo>
                <a:cubicBezTo>
                  <a:pt x="2100" y="616"/>
                  <a:pt x="2119" y="600"/>
                  <a:pt x="2132" y="591"/>
                </a:cubicBezTo>
                <a:cubicBezTo>
                  <a:pt x="2152" y="577"/>
                  <a:pt x="2171" y="568"/>
                  <a:pt x="2190" y="565"/>
                </a:cubicBezTo>
                <a:cubicBezTo>
                  <a:pt x="2208" y="561"/>
                  <a:pt x="2228" y="563"/>
                  <a:pt x="2249" y="570"/>
                </a:cubicBezTo>
                <a:cubicBezTo>
                  <a:pt x="2270" y="577"/>
                  <a:pt x="2288" y="589"/>
                  <a:pt x="2305" y="606"/>
                </a:cubicBezTo>
                <a:cubicBezTo>
                  <a:pt x="2334" y="635"/>
                  <a:pt x="2349" y="668"/>
                  <a:pt x="2350" y="706"/>
                </a:cubicBezTo>
                <a:cubicBezTo>
                  <a:pt x="2352" y="744"/>
                  <a:pt x="2329" y="787"/>
                  <a:pt x="2281" y="834"/>
                </a:cubicBezTo>
                <a:lnTo>
                  <a:pt x="2195" y="920"/>
                </a:lnTo>
                <a:lnTo>
                  <a:pt x="2332" y="1057"/>
                </a:lnTo>
                <a:lnTo>
                  <a:pt x="2287" y="1101"/>
                </a:lnTo>
                <a:close/>
                <a:moveTo>
                  <a:pt x="2156" y="881"/>
                </a:moveTo>
                <a:lnTo>
                  <a:pt x="2242" y="794"/>
                </a:lnTo>
                <a:cubicBezTo>
                  <a:pt x="2271" y="765"/>
                  <a:pt x="2286" y="739"/>
                  <a:pt x="2288" y="717"/>
                </a:cubicBezTo>
                <a:cubicBezTo>
                  <a:pt x="2289" y="694"/>
                  <a:pt x="2280" y="673"/>
                  <a:pt x="2261" y="653"/>
                </a:cubicBezTo>
                <a:cubicBezTo>
                  <a:pt x="2247" y="639"/>
                  <a:pt x="2231" y="631"/>
                  <a:pt x="2214" y="628"/>
                </a:cubicBezTo>
                <a:cubicBezTo>
                  <a:pt x="2197" y="625"/>
                  <a:pt x="2181" y="628"/>
                  <a:pt x="2166" y="636"/>
                </a:cubicBezTo>
                <a:cubicBezTo>
                  <a:pt x="2156" y="642"/>
                  <a:pt x="2142" y="654"/>
                  <a:pt x="2121" y="675"/>
                </a:cubicBezTo>
                <a:lnTo>
                  <a:pt x="2035" y="761"/>
                </a:lnTo>
                <a:lnTo>
                  <a:pt x="2156" y="881"/>
                </a:lnTo>
                <a:close/>
                <a:moveTo>
                  <a:pt x="2475" y="697"/>
                </a:moveTo>
                <a:lnTo>
                  <a:pt x="2514" y="652"/>
                </a:lnTo>
                <a:cubicBezTo>
                  <a:pt x="2532" y="667"/>
                  <a:pt x="2551" y="676"/>
                  <a:pt x="2569" y="679"/>
                </a:cubicBezTo>
                <a:cubicBezTo>
                  <a:pt x="2587" y="683"/>
                  <a:pt x="2607" y="680"/>
                  <a:pt x="2629" y="672"/>
                </a:cubicBezTo>
                <a:cubicBezTo>
                  <a:pt x="2651" y="663"/>
                  <a:pt x="2671" y="649"/>
                  <a:pt x="2690" y="630"/>
                </a:cubicBezTo>
                <a:cubicBezTo>
                  <a:pt x="2707" y="613"/>
                  <a:pt x="2720" y="596"/>
                  <a:pt x="2728" y="578"/>
                </a:cubicBezTo>
                <a:cubicBezTo>
                  <a:pt x="2736" y="560"/>
                  <a:pt x="2739" y="543"/>
                  <a:pt x="2736" y="528"/>
                </a:cubicBezTo>
                <a:cubicBezTo>
                  <a:pt x="2734" y="513"/>
                  <a:pt x="2727" y="500"/>
                  <a:pt x="2717" y="490"/>
                </a:cubicBezTo>
                <a:cubicBezTo>
                  <a:pt x="2706" y="479"/>
                  <a:pt x="2694" y="473"/>
                  <a:pt x="2680" y="471"/>
                </a:cubicBezTo>
                <a:cubicBezTo>
                  <a:pt x="2666" y="469"/>
                  <a:pt x="2649" y="473"/>
                  <a:pt x="2630" y="481"/>
                </a:cubicBezTo>
                <a:cubicBezTo>
                  <a:pt x="2617" y="487"/>
                  <a:pt x="2592" y="501"/>
                  <a:pt x="2554" y="525"/>
                </a:cubicBezTo>
                <a:cubicBezTo>
                  <a:pt x="2515" y="548"/>
                  <a:pt x="2487" y="563"/>
                  <a:pt x="2468" y="569"/>
                </a:cubicBezTo>
                <a:cubicBezTo>
                  <a:pt x="2443" y="576"/>
                  <a:pt x="2421" y="578"/>
                  <a:pt x="2401" y="573"/>
                </a:cubicBezTo>
                <a:cubicBezTo>
                  <a:pt x="2380" y="569"/>
                  <a:pt x="2362" y="559"/>
                  <a:pt x="2347" y="543"/>
                </a:cubicBezTo>
                <a:cubicBezTo>
                  <a:pt x="2330" y="526"/>
                  <a:pt x="2319" y="506"/>
                  <a:pt x="2314" y="481"/>
                </a:cubicBezTo>
                <a:cubicBezTo>
                  <a:pt x="2309" y="457"/>
                  <a:pt x="2312" y="432"/>
                  <a:pt x="2322" y="406"/>
                </a:cubicBezTo>
                <a:cubicBezTo>
                  <a:pt x="2333" y="379"/>
                  <a:pt x="2350" y="355"/>
                  <a:pt x="2373" y="332"/>
                </a:cubicBezTo>
                <a:cubicBezTo>
                  <a:pt x="2398" y="308"/>
                  <a:pt x="2424" y="290"/>
                  <a:pt x="2451" y="279"/>
                </a:cubicBezTo>
                <a:cubicBezTo>
                  <a:pt x="2478" y="268"/>
                  <a:pt x="2504" y="265"/>
                  <a:pt x="2530" y="270"/>
                </a:cubicBezTo>
                <a:cubicBezTo>
                  <a:pt x="2556" y="275"/>
                  <a:pt x="2579" y="288"/>
                  <a:pt x="2599" y="307"/>
                </a:cubicBezTo>
                <a:lnTo>
                  <a:pt x="2560" y="352"/>
                </a:lnTo>
                <a:cubicBezTo>
                  <a:pt x="2536" y="333"/>
                  <a:pt x="2513" y="325"/>
                  <a:pt x="2489" y="328"/>
                </a:cubicBezTo>
                <a:cubicBezTo>
                  <a:pt x="2465" y="330"/>
                  <a:pt x="2440" y="344"/>
                  <a:pt x="2414" y="370"/>
                </a:cubicBezTo>
                <a:cubicBezTo>
                  <a:pt x="2387" y="397"/>
                  <a:pt x="2372" y="421"/>
                  <a:pt x="2370" y="443"/>
                </a:cubicBezTo>
                <a:cubicBezTo>
                  <a:pt x="2367" y="466"/>
                  <a:pt x="2373" y="484"/>
                  <a:pt x="2387" y="498"/>
                </a:cubicBezTo>
                <a:cubicBezTo>
                  <a:pt x="2399" y="510"/>
                  <a:pt x="2413" y="515"/>
                  <a:pt x="2430" y="514"/>
                </a:cubicBezTo>
                <a:cubicBezTo>
                  <a:pt x="2446" y="514"/>
                  <a:pt x="2476" y="499"/>
                  <a:pt x="2521" y="471"/>
                </a:cubicBezTo>
                <a:cubicBezTo>
                  <a:pt x="2565" y="443"/>
                  <a:pt x="2597" y="426"/>
                  <a:pt x="2617" y="418"/>
                </a:cubicBezTo>
                <a:cubicBezTo>
                  <a:pt x="2645" y="408"/>
                  <a:pt x="2671" y="405"/>
                  <a:pt x="2694" y="409"/>
                </a:cubicBezTo>
                <a:cubicBezTo>
                  <a:pt x="2717" y="414"/>
                  <a:pt x="2738" y="425"/>
                  <a:pt x="2756" y="443"/>
                </a:cubicBezTo>
                <a:cubicBezTo>
                  <a:pt x="2774" y="461"/>
                  <a:pt x="2786" y="483"/>
                  <a:pt x="2791" y="509"/>
                </a:cubicBezTo>
                <a:cubicBezTo>
                  <a:pt x="2797" y="535"/>
                  <a:pt x="2794" y="562"/>
                  <a:pt x="2784" y="590"/>
                </a:cubicBezTo>
                <a:cubicBezTo>
                  <a:pt x="2774" y="618"/>
                  <a:pt x="2756" y="644"/>
                  <a:pt x="2732" y="668"/>
                </a:cubicBezTo>
                <a:cubicBezTo>
                  <a:pt x="2702" y="698"/>
                  <a:pt x="2672" y="719"/>
                  <a:pt x="2643" y="731"/>
                </a:cubicBezTo>
                <a:cubicBezTo>
                  <a:pt x="2613" y="743"/>
                  <a:pt x="2584" y="746"/>
                  <a:pt x="2554" y="739"/>
                </a:cubicBezTo>
                <a:cubicBezTo>
                  <a:pt x="2525" y="733"/>
                  <a:pt x="2498" y="719"/>
                  <a:pt x="2475" y="697"/>
                </a:cubicBezTo>
                <a:close/>
                <a:moveTo>
                  <a:pt x="2810" y="401"/>
                </a:moveTo>
                <a:lnTo>
                  <a:pt x="2846" y="355"/>
                </a:lnTo>
                <a:cubicBezTo>
                  <a:pt x="2874" y="373"/>
                  <a:pt x="2899" y="382"/>
                  <a:pt x="2921" y="381"/>
                </a:cubicBezTo>
                <a:cubicBezTo>
                  <a:pt x="2942" y="380"/>
                  <a:pt x="2961" y="371"/>
                  <a:pt x="2978" y="355"/>
                </a:cubicBezTo>
                <a:cubicBezTo>
                  <a:pt x="2997" y="335"/>
                  <a:pt x="3007" y="312"/>
                  <a:pt x="3007" y="285"/>
                </a:cubicBezTo>
                <a:cubicBezTo>
                  <a:pt x="3007" y="259"/>
                  <a:pt x="2997" y="235"/>
                  <a:pt x="2977" y="215"/>
                </a:cubicBezTo>
                <a:cubicBezTo>
                  <a:pt x="2958" y="196"/>
                  <a:pt x="2936" y="187"/>
                  <a:pt x="2911" y="187"/>
                </a:cubicBezTo>
                <a:cubicBezTo>
                  <a:pt x="2887" y="187"/>
                  <a:pt x="2865" y="197"/>
                  <a:pt x="2846" y="216"/>
                </a:cubicBezTo>
                <a:cubicBezTo>
                  <a:pt x="2838" y="224"/>
                  <a:pt x="2830" y="235"/>
                  <a:pt x="2821" y="250"/>
                </a:cubicBezTo>
                <a:lnTo>
                  <a:pt x="2789" y="209"/>
                </a:lnTo>
                <a:cubicBezTo>
                  <a:pt x="2792" y="206"/>
                  <a:pt x="2795" y="204"/>
                  <a:pt x="2797" y="203"/>
                </a:cubicBezTo>
                <a:cubicBezTo>
                  <a:pt x="2814" y="185"/>
                  <a:pt x="2825" y="165"/>
                  <a:pt x="2830" y="141"/>
                </a:cubicBezTo>
                <a:cubicBezTo>
                  <a:pt x="2835" y="118"/>
                  <a:pt x="2828" y="97"/>
                  <a:pt x="2809" y="78"/>
                </a:cubicBezTo>
                <a:cubicBezTo>
                  <a:pt x="2794" y="63"/>
                  <a:pt x="2776" y="55"/>
                  <a:pt x="2756" y="56"/>
                </a:cubicBezTo>
                <a:cubicBezTo>
                  <a:pt x="2736" y="56"/>
                  <a:pt x="2718" y="64"/>
                  <a:pt x="2701" y="80"/>
                </a:cubicBezTo>
                <a:cubicBezTo>
                  <a:pt x="2685" y="96"/>
                  <a:pt x="2677" y="115"/>
                  <a:pt x="2676" y="136"/>
                </a:cubicBezTo>
                <a:cubicBezTo>
                  <a:pt x="2676" y="156"/>
                  <a:pt x="2684" y="178"/>
                  <a:pt x="2701" y="202"/>
                </a:cubicBezTo>
                <a:lnTo>
                  <a:pt x="2653" y="236"/>
                </a:lnTo>
                <a:cubicBezTo>
                  <a:pt x="2630" y="203"/>
                  <a:pt x="2620" y="170"/>
                  <a:pt x="2623" y="137"/>
                </a:cubicBezTo>
                <a:cubicBezTo>
                  <a:pt x="2625" y="104"/>
                  <a:pt x="2640" y="74"/>
                  <a:pt x="2667" y="47"/>
                </a:cubicBezTo>
                <a:cubicBezTo>
                  <a:pt x="2685" y="29"/>
                  <a:pt x="2706" y="16"/>
                  <a:pt x="2729" y="8"/>
                </a:cubicBezTo>
                <a:cubicBezTo>
                  <a:pt x="2752" y="1"/>
                  <a:pt x="2775" y="0"/>
                  <a:pt x="2797" y="5"/>
                </a:cubicBezTo>
                <a:cubicBezTo>
                  <a:pt x="2818" y="11"/>
                  <a:pt x="2837" y="21"/>
                  <a:pt x="2852" y="36"/>
                </a:cubicBezTo>
                <a:cubicBezTo>
                  <a:pt x="2867" y="51"/>
                  <a:pt x="2876" y="68"/>
                  <a:pt x="2880" y="88"/>
                </a:cubicBezTo>
                <a:cubicBezTo>
                  <a:pt x="2884" y="107"/>
                  <a:pt x="2882" y="128"/>
                  <a:pt x="2874" y="151"/>
                </a:cubicBezTo>
                <a:cubicBezTo>
                  <a:pt x="2898" y="135"/>
                  <a:pt x="2923" y="130"/>
                  <a:pt x="2949" y="133"/>
                </a:cubicBezTo>
                <a:cubicBezTo>
                  <a:pt x="2974" y="136"/>
                  <a:pt x="2998" y="149"/>
                  <a:pt x="3020" y="171"/>
                </a:cubicBezTo>
                <a:cubicBezTo>
                  <a:pt x="3049" y="200"/>
                  <a:pt x="3063" y="236"/>
                  <a:pt x="3062" y="277"/>
                </a:cubicBezTo>
                <a:cubicBezTo>
                  <a:pt x="3061" y="319"/>
                  <a:pt x="3044" y="356"/>
                  <a:pt x="3012" y="389"/>
                </a:cubicBezTo>
                <a:cubicBezTo>
                  <a:pt x="2982" y="419"/>
                  <a:pt x="2949" y="434"/>
                  <a:pt x="2912" y="436"/>
                </a:cubicBezTo>
                <a:cubicBezTo>
                  <a:pt x="2875" y="438"/>
                  <a:pt x="2841" y="427"/>
                  <a:pt x="2810" y="401"/>
                </a:cubicBez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86" name="Freeform 68"/>
          <p:cNvSpPr>
            <a:spLocks noEditPoints="1"/>
          </p:cNvSpPr>
          <p:nvPr/>
        </p:nvSpPr>
        <p:spPr bwMode="auto">
          <a:xfrm>
            <a:off x="2749728" y="4611475"/>
            <a:ext cx="839787" cy="839787"/>
          </a:xfrm>
          <a:custGeom>
            <a:avLst/>
            <a:gdLst>
              <a:gd name="T0" fmla="*/ 238 w 4406"/>
              <a:gd name="T1" fmla="*/ 3871 h 4408"/>
              <a:gd name="T2" fmla="*/ 243 w 4406"/>
              <a:gd name="T3" fmla="*/ 4227 h 4408"/>
              <a:gd name="T4" fmla="*/ 336 w 4406"/>
              <a:gd name="T5" fmla="*/ 4023 h 4408"/>
              <a:gd name="T6" fmla="*/ 84 w 4406"/>
              <a:gd name="T7" fmla="*/ 4067 h 4408"/>
              <a:gd name="T8" fmla="*/ 513 w 4406"/>
              <a:gd name="T9" fmla="*/ 3579 h 4408"/>
              <a:gd name="T10" fmla="*/ 740 w 4406"/>
              <a:gd name="T11" fmla="*/ 3707 h 4408"/>
              <a:gd name="T12" fmla="*/ 779 w 4406"/>
              <a:gd name="T13" fmla="*/ 3965 h 4408"/>
              <a:gd name="T14" fmla="*/ 620 w 4406"/>
              <a:gd name="T15" fmla="*/ 3692 h 4408"/>
              <a:gd name="T16" fmla="*/ 399 w 4406"/>
              <a:gd name="T17" fmla="*/ 3752 h 4408"/>
              <a:gd name="T18" fmla="*/ 784 w 4406"/>
              <a:gd name="T19" fmla="*/ 3859 h 4408"/>
              <a:gd name="T20" fmla="*/ 618 w 4406"/>
              <a:gd name="T21" fmla="*/ 3816 h 4408"/>
              <a:gd name="T22" fmla="*/ 743 w 4406"/>
              <a:gd name="T23" fmla="*/ 3328 h 4408"/>
              <a:gd name="T24" fmla="*/ 1130 w 4406"/>
              <a:gd name="T25" fmla="*/ 3409 h 4408"/>
              <a:gd name="T26" fmla="*/ 964 w 4406"/>
              <a:gd name="T27" fmla="*/ 3780 h 4408"/>
              <a:gd name="T28" fmla="*/ 1081 w 4406"/>
              <a:gd name="T29" fmla="*/ 3451 h 4408"/>
              <a:gd name="T30" fmla="*/ 712 w 4406"/>
              <a:gd name="T31" fmla="*/ 3439 h 4408"/>
              <a:gd name="T32" fmla="*/ 1626 w 4406"/>
              <a:gd name="T33" fmla="*/ 3304 h 4408"/>
              <a:gd name="T34" fmla="*/ 1414 w 4406"/>
              <a:gd name="T35" fmla="*/ 2664 h 4408"/>
              <a:gd name="T36" fmla="*/ 1563 w 4406"/>
              <a:gd name="T37" fmla="*/ 2908 h 4408"/>
              <a:gd name="T38" fmla="*/ 1524 w 4406"/>
              <a:gd name="T39" fmla="*/ 2867 h 4408"/>
              <a:gd name="T40" fmla="*/ 1403 w 4406"/>
              <a:gd name="T41" fmla="*/ 2748 h 4408"/>
              <a:gd name="T42" fmla="*/ 1788 w 4406"/>
              <a:gd name="T43" fmla="*/ 2284 h 4408"/>
              <a:gd name="T44" fmla="*/ 1957 w 4406"/>
              <a:gd name="T45" fmla="*/ 2478 h 4408"/>
              <a:gd name="T46" fmla="*/ 1881 w 4406"/>
              <a:gd name="T47" fmla="*/ 2863 h 4408"/>
              <a:gd name="T48" fmla="*/ 2042 w 4406"/>
              <a:gd name="T49" fmla="*/ 2202 h 4408"/>
              <a:gd name="T50" fmla="*/ 2166 w 4406"/>
              <a:gd name="T51" fmla="*/ 2223 h 4408"/>
              <a:gd name="T52" fmla="*/ 2183 w 4406"/>
              <a:gd name="T53" fmla="*/ 2326 h 4408"/>
              <a:gd name="T54" fmla="*/ 2342 w 4406"/>
              <a:gd name="T55" fmla="*/ 1875 h 4408"/>
              <a:gd name="T56" fmla="*/ 2282 w 4406"/>
              <a:gd name="T57" fmla="*/ 1786 h 4408"/>
              <a:gd name="T58" fmla="*/ 2530 w 4406"/>
              <a:gd name="T59" fmla="*/ 1790 h 4408"/>
              <a:gd name="T60" fmla="*/ 2472 w 4406"/>
              <a:gd name="T61" fmla="*/ 1608 h 4408"/>
              <a:gd name="T62" fmla="*/ 2531 w 4406"/>
              <a:gd name="T63" fmla="*/ 1621 h 4408"/>
              <a:gd name="T64" fmla="*/ 2608 w 4406"/>
              <a:gd name="T65" fmla="*/ 1713 h 4408"/>
              <a:gd name="T66" fmla="*/ 2901 w 4406"/>
              <a:gd name="T67" fmla="*/ 1760 h 4408"/>
              <a:gd name="T68" fmla="*/ 2884 w 4406"/>
              <a:gd name="T69" fmla="*/ 1653 h 4408"/>
              <a:gd name="T70" fmla="*/ 2685 w 4406"/>
              <a:gd name="T71" fmla="*/ 1595 h 4408"/>
              <a:gd name="T72" fmla="*/ 2894 w 4406"/>
              <a:gd name="T73" fmla="*/ 1488 h 4408"/>
              <a:gd name="T74" fmla="*/ 2745 w 4406"/>
              <a:gd name="T75" fmla="*/ 1631 h 4408"/>
              <a:gd name="T76" fmla="*/ 2968 w 4406"/>
              <a:gd name="T77" fmla="*/ 1562 h 4408"/>
              <a:gd name="T78" fmla="*/ 2900 w 4406"/>
              <a:gd name="T79" fmla="*/ 1816 h 4408"/>
              <a:gd name="T80" fmla="*/ 3096 w 4406"/>
              <a:gd name="T81" fmla="*/ 1591 h 4408"/>
              <a:gd name="T82" fmla="*/ 2995 w 4406"/>
              <a:gd name="T83" fmla="*/ 1176 h 4408"/>
              <a:gd name="T84" fmla="*/ 2847 w 4406"/>
              <a:gd name="T85" fmla="*/ 1271 h 4408"/>
              <a:gd name="T86" fmla="*/ 3142 w 4406"/>
              <a:gd name="T87" fmla="*/ 1275 h 4408"/>
              <a:gd name="T88" fmla="*/ 3238 w 4406"/>
              <a:gd name="T89" fmla="*/ 928 h 4408"/>
              <a:gd name="T90" fmla="*/ 3527 w 4406"/>
              <a:gd name="T91" fmla="*/ 1217 h 4408"/>
              <a:gd name="T92" fmla="*/ 3639 w 4406"/>
              <a:gd name="T93" fmla="*/ 1104 h 4408"/>
              <a:gd name="T94" fmla="*/ 3601 w 4406"/>
              <a:gd name="T95" fmla="*/ 573 h 4408"/>
              <a:gd name="T96" fmla="*/ 3684 w 4406"/>
              <a:gd name="T97" fmla="*/ 1060 h 4408"/>
              <a:gd name="T98" fmla="*/ 3612 w 4406"/>
              <a:gd name="T99" fmla="*/ 656 h 4408"/>
              <a:gd name="T100" fmla="*/ 3507 w 4406"/>
              <a:gd name="T101" fmla="*/ 884 h 4408"/>
              <a:gd name="T102" fmla="*/ 4042 w 4406"/>
              <a:gd name="T103" fmla="*/ 633 h 4408"/>
              <a:gd name="T104" fmla="*/ 3982 w 4406"/>
              <a:gd name="T105" fmla="*/ 484 h 4408"/>
              <a:gd name="T106" fmla="*/ 3666 w 4406"/>
              <a:gd name="T107" fmla="*/ 484 h 4408"/>
              <a:gd name="T108" fmla="*/ 3951 w 4406"/>
              <a:gd name="T109" fmla="*/ 310 h 4408"/>
              <a:gd name="T110" fmla="*/ 3739 w 4406"/>
              <a:gd name="T111" fmla="*/ 501 h 4408"/>
              <a:gd name="T112" fmla="*/ 4108 w 4406"/>
              <a:gd name="T113" fmla="*/ 446 h 4408"/>
              <a:gd name="T114" fmla="*/ 3906 w 4406"/>
              <a:gd name="T115" fmla="*/ 742 h 4408"/>
              <a:gd name="T116" fmla="*/ 4091 w 4406"/>
              <a:gd name="T117" fmla="*/ 184 h 4408"/>
              <a:gd name="T118" fmla="*/ 4068 w 4406"/>
              <a:gd name="T119" fmla="*/ 0 h 440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</a:cxnLst>
            <a:rect l="0" t="0" r="r" b="b"/>
            <a:pathLst>
              <a:path w="4406" h="4408">
                <a:moveTo>
                  <a:pt x="336" y="4408"/>
                </a:moveTo>
                <a:lnTo>
                  <a:pt x="0" y="4072"/>
                </a:lnTo>
                <a:lnTo>
                  <a:pt x="126" y="3945"/>
                </a:lnTo>
                <a:cubicBezTo>
                  <a:pt x="149" y="3923"/>
                  <a:pt x="167" y="3907"/>
                  <a:pt x="181" y="3897"/>
                </a:cubicBezTo>
                <a:cubicBezTo>
                  <a:pt x="200" y="3883"/>
                  <a:pt x="219" y="3875"/>
                  <a:pt x="238" y="3871"/>
                </a:cubicBezTo>
                <a:cubicBezTo>
                  <a:pt x="257" y="3868"/>
                  <a:pt x="277" y="3870"/>
                  <a:pt x="297" y="3877"/>
                </a:cubicBezTo>
                <a:cubicBezTo>
                  <a:pt x="318" y="3884"/>
                  <a:pt x="337" y="3896"/>
                  <a:pt x="353" y="3913"/>
                </a:cubicBezTo>
                <a:cubicBezTo>
                  <a:pt x="382" y="3941"/>
                  <a:pt x="397" y="3974"/>
                  <a:pt x="399" y="4012"/>
                </a:cubicBezTo>
                <a:cubicBezTo>
                  <a:pt x="400" y="4050"/>
                  <a:pt x="377" y="4093"/>
                  <a:pt x="330" y="4141"/>
                </a:cubicBezTo>
                <a:lnTo>
                  <a:pt x="243" y="4227"/>
                </a:lnTo>
                <a:lnTo>
                  <a:pt x="380" y="4364"/>
                </a:lnTo>
                <a:lnTo>
                  <a:pt x="336" y="4408"/>
                </a:lnTo>
                <a:close/>
                <a:moveTo>
                  <a:pt x="204" y="4187"/>
                </a:moveTo>
                <a:lnTo>
                  <a:pt x="291" y="4100"/>
                </a:lnTo>
                <a:cubicBezTo>
                  <a:pt x="319" y="4072"/>
                  <a:pt x="334" y="4046"/>
                  <a:pt x="336" y="4023"/>
                </a:cubicBezTo>
                <a:cubicBezTo>
                  <a:pt x="337" y="4000"/>
                  <a:pt x="328" y="3979"/>
                  <a:pt x="309" y="3960"/>
                </a:cubicBezTo>
                <a:cubicBezTo>
                  <a:pt x="295" y="3946"/>
                  <a:pt x="279" y="3937"/>
                  <a:pt x="262" y="3934"/>
                </a:cubicBezTo>
                <a:cubicBezTo>
                  <a:pt x="245" y="3931"/>
                  <a:pt x="229" y="3934"/>
                  <a:pt x="214" y="3943"/>
                </a:cubicBezTo>
                <a:cubicBezTo>
                  <a:pt x="205" y="3948"/>
                  <a:pt x="190" y="3961"/>
                  <a:pt x="170" y="3981"/>
                </a:cubicBezTo>
                <a:lnTo>
                  <a:pt x="84" y="4067"/>
                </a:lnTo>
                <a:lnTo>
                  <a:pt x="204" y="4187"/>
                </a:lnTo>
                <a:close/>
                <a:moveTo>
                  <a:pt x="651" y="4093"/>
                </a:moveTo>
                <a:lnTo>
                  <a:pt x="314" y="3757"/>
                </a:lnTo>
                <a:lnTo>
                  <a:pt x="441" y="3631"/>
                </a:lnTo>
                <a:cubicBezTo>
                  <a:pt x="466" y="3605"/>
                  <a:pt x="490" y="3588"/>
                  <a:pt x="513" y="3579"/>
                </a:cubicBezTo>
                <a:cubicBezTo>
                  <a:pt x="535" y="3571"/>
                  <a:pt x="557" y="3569"/>
                  <a:pt x="580" y="3574"/>
                </a:cubicBezTo>
                <a:cubicBezTo>
                  <a:pt x="603" y="3580"/>
                  <a:pt x="623" y="3590"/>
                  <a:pt x="638" y="3605"/>
                </a:cubicBezTo>
                <a:cubicBezTo>
                  <a:pt x="652" y="3620"/>
                  <a:pt x="662" y="3637"/>
                  <a:pt x="667" y="3658"/>
                </a:cubicBezTo>
                <a:cubicBezTo>
                  <a:pt x="672" y="3678"/>
                  <a:pt x="670" y="3700"/>
                  <a:pt x="662" y="3724"/>
                </a:cubicBezTo>
                <a:cubicBezTo>
                  <a:pt x="689" y="3709"/>
                  <a:pt x="714" y="3704"/>
                  <a:pt x="740" y="3707"/>
                </a:cubicBezTo>
                <a:cubicBezTo>
                  <a:pt x="765" y="3711"/>
                  <a:pt x="787" y="3722"/>
                  <a:pt x="807" y="3742"/>
                </a:cubicBezTo>
                <a:cubicBezTo>
                  <a:pt x="823" y="3758"/>
                  <a:pt x="834" y="3776"/>
                  <a:pt x="841" y="3796"/>
                </a:cubicBezTo>
                <a:cubicBezTo>
                  <a:pt x="848" y="3816"/>
                  <a:pt x="850" y="3835"/>
                  <a:pt x="848" y="3852"/>
                </a:cubicBezTo>
                <a:cubicBezTo>
                  <a:pt x="845" y="3869"/>
                  <a:pt x="838" y="3887"/>
                  <a:pt x="827" y="3905"/>
                </a:cubicBezTo>
                <a:cubicBezTo>
                  <a:pt x="816" y="3924"/>
                  <a:pt x="800" y="3944"/>
                  <a:pt x="779" y="3965"/>
                </a:cubicBezTo>
                <a:lnTo>
                  <a:pt x="651" y="4093"/>
                </a:lnTo>
                <a:close/>
                <a:moveTo>
                  <a:pt x="500" y="3854"/>
                </a:moveTo>
                <a:lnTo>
                  <a:pt x="573" y="3781"/>
                </a:lnTo>
                <a:cubicBezTo>
                  <a:pt x="593" y="3761"/>
                  <a:pt x="605" y="3746"/>
                  <a:pt x="611" y="3735"/>
                </a:cubicBezTo>
                <a:cubicBezTo>
                  <a:pt x="619" y="3720"/>
                  <a:pt x="622" y="3706"/>
                  <a:pt x="620" y="3692"/>
                </a:cubicBezTo>
                <a:cubicBezTo>
                  <a:pt x="618" y="3679"/>
                  <a:pt x="611" y="3666"/>
                  <a:pt x="599" y="3655"/>
                </a:cubicBezTo>
                <a:cubicBezTo>
                  <a:pt x="588" y="3643"/>
                  <a:pt x="576" y="3636"/>
                  <a:pt x="562" y="3633"/>
                </a:cubicBezTo>
                <a:cubicBezTo>
                  <a:pt x="548" y="3630"/>
                  <a:pt x="535" y="3632"/>
                  <a:pt x="522" y="3639"/>
                </a:cubicBezTo>
                <a:cubicBezTo>
                  <a:pt x="509" y="3645"/>
                  <a:pt x="490" y="3661"/>
                  <a:pt x="466" y="3685"/>
                </a:cubicBezTo>
                <a:lnTo>
                  <a:pt x="399" y="3752"/>
                </a:lnTo>
                <a:lnTo>
                  <a:pt x="500" y="3854"/>
                </a:lnTo>
                <a:close/>
                <a:moveTo>
                  <a:pt x="655" y="4009"/>
                </a:moveTo>
                <a:lnTo>
                  <a:pt x="739" y="3925"/>
                </a:lnTo>
                <a:cubicBezTo>
                  <a:pt x="753" y="3911"/>
                  <a:pt x="763" y="3900"/>
                  <a:pt x="768" y="3893"/>
                </a:cubicBezTo>
                <a:cubicBezTo>
                  <a:pt x="776" y="3881"/>
                  <a:pt x="782" y="3870"/>
                  <a:pt x="784" y="3859"/>
                </a:cubicBezTo>
                <a:cubicBezTo>
                  <a:pt x="787" y="3847"/>
                  <a:pt x="786" y="3836"/>
                  <a:pt x="783" y="3823"/>
                </a:cubicBezTo>
                <a:cubicBezTo>
                  <a:pt x="779" y="3810"/>
                  <a:pt x="772" y="3799"/>
                  <a:pt x="761" y="3788"/>
                </a:cubicBezTo>
                <a:cubicBezTo>
                  <a:pt x="748" y="3775"/>
                  <a:pt x="734" y="3768"/>
                  <a:pt x="719" y="3765"/>
                </a:cubicBezTo>
                <a:cubicBezTo>
                  <a:pt x="703" y="3762"/>
                  <a:pt x="687" y="3764"/>
                  <a:pt x="672" y="3772"/>
                </a:cubicBezTo>
                <a:cubicBezTo>
                  <a:pt x="657" y="3780"/>
                  <a:pt x="639" y="3794"/>
                  <a:pt x="618" y="3816"/>
                </a:cubicBezTo>
                <a:lnTo>
                  <a:pt x="540" y="3893"/>
                </a:lnTo>
                <a:lnTo>
                  <a:pt x="655" y="4009"/>
                </a:lnTo>
                <a:close/>
                <a:moveTo>
                  <a:pt x="964" y="3780"/>
                </a:moveTo>
                <a:lnTo>
                  <a:pt x="627" y="3444"/>
                </a:lnTo>
                <a:lnTo>
                  <a:pt x="743" y="3328"/>
                </a:lnTo>
                <a:cubicBezTo>
                  <a:pt x="769" y="3302"/>
                  <a:pt x="791" y="3284"/>
                  <a:pt x="808" y="3273"/>
                </a:cubicBezTo>
                <a:cubicBezTo>
                  <a:pt x="832" y="3258"/>
                  <a:pt x="856" y="3250"/>
                  <a:pt x="881" y="3248"/>
                </a:cubicBezTo>
                <a:cubicBezTo>
                  <a:pt x="914" y="3245"/>
                  <a:pt x="946" y="3251"/>
                  <a:pt x="978" y="3266"/>
                </a:cubicBezTo>
                <a:cubicBezTo>
                  <a:pt x="1011" y="3280"/>
                  <a:pt x="1042" y="3302"/>
                  <a:pt x="1072" y="3332"/>
                </a:cubicBezTo>
                <a:cubicBezTo>
                  <a:pt x="1097" y="3358"/>
                  <a:pt x="1117" y="3383"/>
                  <a:pt x="1130" y="3409"/>
                </a:cubicBezTo>
                <a:cubicBezTo>
                  <a:pt x="1144" y="3435"/>
                  <a:pt x="1153" y="3459"/>
                  <a:pt x="1156" y="3481"/>
                </a:cubicBezTo>
                <a:cubicBezTo>
                  <a:pt x="1160" y="3503"/>
                  <a:pt x="1160" y="3524"/>
                  <a:pt x="1156" y="3542"/>
                </a:cubicBezTo>
                <a:cubicBezTo>
                  <a:pt x="1153" y="3561"/>
                  <a:pt x="1145" y="3580"/>
                  <a:pt x="1133" y="3599"/>
                </a:cubicBezTo>
                <a:cubicBezTo>
                  <a:pt x="1121" y="3619"/>
                  <a:pt x="1105" y="3639"/>
                  <a:pt x="1085" y="3659"/>
                </a:cubicBezTo>
                <a:lnTo>
                  <a:pt x="964" y="3780"/>
                </a:lnTo>
                <a:close/>
                <a:moveTo>
                  <a:pt x="968" y="3696"/>
                </a:moveTo>
                <a:lnTo>
                  <a:pt x="1040" y="3624"/>
                </a:lnTo>
                <a:cubicBezTo>
                  <a:pt x="1062" y="3602"/>
                  <a:pt x="1078" y="3583"/>
                  <a:pt x="1086" y="3566"/>
                </a:cubicBezTo>
                <a:cubicBezTo>
                  <a:pt x="1095" y="3549"/>
                  <a:pt x="1099" y="3533"/>
                  <a:pt x="1099" y="3518"/>
                </a:cubicBezTo>
                <a:cubicBezTo>
                  <a:pt x="1099" y="3497"/>
                  <a:pt x="1093" y="3475"/>
                  <a:pt x="1081" y="3451"/>
                </a:cubicBezTo>
                <a:cubicBezTo>
                  <a:pt x="1069" y="3427"/>
                  <a:pt x="1050" y="3403"/>
                  <a:pt x="1025" y="3378"/>
                </a:cubicBezTo>
                <a:cubicBezTo>
                  <a:pt x="990" y="3342"/>
                  <a:pt x="957" y="3321"/>
                  <a:pt x="927" y="3314"/>
                </a:cubicBezTo>
                <a:cubicBezTo>
                  <a:pt x="896" y="3306"/>
                  <a:pt x="870" y="3308"/>
                  <a:pt x="847" y="3318"/>
                </a:cubicBezTo>
                <a:cubicBezTo>
                  <a:pt x="830" y="3325"/>
                  <a:pt x="809" y="3342"/>
                  <a:pt x="782" y="3369"/>
                </a:cubicBezTo>
                <a:lnTo>
                  <a:pt x="712" y="3439"/>
                </a:lnTo>
                <a:lnTo>
                  <a:pt x="968" y="3696"/>
                </a:lnTo>
                <a:close/>
                <a:moveTo>
                  <a:pt x="1353" y="3577"/>
                </a:moveTo>
                <a:lnTo>
                  <a:pt x="1323" y="3548"/>
                </a:lnTo>
                <a:lnTo>
                  <a:pt x="1597" y="3274"/>
                </a:lnTo>
                <a:lnTo>
                  <a:pt x="1626" y="3304"/>
                </a:lnTo>
                <a:lnTo>
                  <a:pt x="1353" y="3577"/>
                </a:lnTo>
                <a:close/>
                <a:moveTo>
                  <a:pt x="1569" y="3175"/>
                </a:moveTo>
                <a:lnTo>
                  <a:pt x="1233" y="2839"/>
                </a:lnTo>
                <a:lnTo>
                  <a:pt x="1360" y="2712"/>
                </a:lnTo>
                <a:cubicBezTo>
                  <a:pt x="1382" y="2690"/>
                  <a:pt x="1400" y="2674"/>
                  <a:pt x="1414" y="2664"/>
                </a:cubicBezTo>
                <a:cubicBezTo>
                  <a:pt x="1433" y="2650"/>
                  <a:pt x="1452" y="2642"/>
                  <a:pt x="1471" y="2638"/>
                </a:cubicBezTo>
                <a:cubicBezTo>
                  <a:pt x="1490" y="2635"/>
                  <a:pt x="1510" y="2637"/>
                  <a:pt x="1530" y="2644"/>
                </a:cubicBezTo>
                <a:cubicBezTo>
                  <a:pt x="1551" y="2651"/>
                  <a:pt x="1570" y="2663"/>
                  <a:pt x="1586" y="2679"/>
                </a:cubicBezTo>
                <a:cubicBezTo>
                  <a:pt x="1615" y="2708"/>
                  <a:pt x="1630" y="2741"/>
                  <a:pt x="1632" y="2779"/>
                </a:cubicBezTo>
                <a:cubicBezTo>
                  <a:pt x="1633" y="2817"/>
                  <a:pt x="1610" y="2860"/>
                  <a:pt x="1563" y="2908"/>
                </a:cubicBezTo>
                <a:lnTo>
                  <a:pt x="1477" y="2994"/>
                </a:lnTo>
                <a:lnTo>
                  <a:pt x="1613" y="3130"/>
                </a:lnTo>
                <a:lnTo>
                  <a:pt x="1569" y="3175"/>
                </a:lnTo>
                <a:close/>
                <a:moveTo>
                  <a:pt x="1437" y="2954"/>
                </a:moveTo>
                <a:lnTo>
                  <a:pt x="1524" y="2867"/>
                </a:lnTo>
                <a:cubicBezTo>
                  <a:pt x="1553" y="2838"/>
                  <a:pt x="1568" y="2813"/>
                  <a:pt x="1569" y="2790"/>
                </a:cubicBezTo>
                <a:cubicBezTo>
                  <a:pt x="1570" y="2767"/>
                  <a:pt x="1561" y="2746"/>
                  <a:pt x="1542" y="2727"/>
                </a:cubicBezTo>
                <a:cubicBezTo>
                  <a:pt x="1528" y="2713"/>
                  <a:pt x="1512" y="2704"/>
                  <a:pt x="1495" y="2701"/>
                </a:cubicBezTo>
                <a:cubicBezTo>
                  <a:pt x="1478" y="2698"/>
                  <a:pt x="1462" y="2701"/>
                  <a:pt x="1447" y="2709"/>
                </a:cubicBezTo>
                <a:cubicBezTo>
                  <a:pt x="1438" y="2715"/>
                  <a:pt x="1423" y="2728"/>
                  <a:pt x="1403" y="2748"/>
                </a:cubicBezTo>
                <a:lnTo>
                  <a:pt x="1317" y="2834"/>
                </a:lnTo>
                <a:lnTo>
                  <a:pt x="1437" y="2954"/>
                </a:lnTo>
                <a:close/>
                <a:moveTo>
                  <a:pt x="1881" y="2863"/>
                </a:moveTo>
                <a:lnTo>
                  <a:pt x="1545" y="2527"/>
                </a:lnTo>
                <a:lnTo>
                  <a:pt x="1788" y="2284"/>
                </a:lnTo>
                <a:lnTo>
                  <a:pt x="1827" y="2323"/>
                </a:lnTo>
                <a:lnTo>
                  <a:pt x="1629" y="2522"/>
                </a:lnTo>
                <a:lnTo>
                  <a:pt x="1732" y="2625"/>
                </a:lnTo>
                <a:lnTo>
                  <a:pt x="1918" y="2439"/>
                </a:lnTo>
                <a:lnTo>
                  <a:pt x="1957" y="2478"/>
                </a:lnTo>
                <a:lnTo>
                  <a:pt x="1771" y="2664"/>
                </a:lnTo>
                <a:lnTo>
                  <a:pt x="1886" y="2779"/>
                </a:lnTo>
                <a:lnTo>
                  <a:pt x="2092" y="2572"/>
                </a:lnTo>
                <a:lnTo>
                  <a:pt x="2132" y="2612"/>
                </a:lnTo>
                <a:lnTo>
                  <a:pt x="1881" y="2863"/>
                </a:lnTo>
                <a:close/>
                <a:moveTo>
                  <a:pt x="2163" y="2581"/>
                </a:moveTo>
                <a:lnTo>
                  <a:pt x="2117" y="2276"/>
                </a:lnTo>
                <a:lnTo>
                  <a:pt x="1842" y="2230"/>
                </a:lnTo>
                <a:lnTo>
                  <a:pt x="1895" y="2177"/>
                </a:lnTo>
                <a:lnTo>
                  <a:pt x="2042" y="2202"/>
                </a:lnTo>
                <a:cubicBezTo>
                  <a:pt x="2073" y="2207"/>
                  <a:pt x="2095" y="2212"/>
                  <a:pt x="2110" y="2216"/>
                </a:cubicBezTo>
                <a:cubicBezTo>
                  <a:pt x="2106" y="2196"/>
                  <a:pt x="2102" y="2175"/>
                  <a:pt x="2099" y="2151"/>
                </a:cubicBezTo>
                <a:lnTo>
                  <a:pt x="2077" y="1994"/>
                </a:lnTo>
                <a:lnTo>
                  <a:pt x="2125" y="1946"/>
                </a:lnTo>
                <a:lnTo>
                  <a:pt x="2166" y="2223"/>
                </a:lnTo>
                <a:lnTo>
                  <a:pt x="2471" y="2273"/>
                </a:lnTo>
                <a:lnTo>
                  <a:pt x="2416" y="2328"/>
                </a:lnTo>
                <a:lnTo>
                  <a:pt x="2211" y="2293"/>
                </a:lnTo>
                <a:cubicBezTo>
                  <a:pt x="2200" y="2291"/>
                  <a:pt x="2187" y="2288"/>
                  <a:pt x="2174" y="2285"/>
                </a:cubicBezTo>
                <a:cubicBezTo>
                  <a:pt x="2179" y="2305"/>
                  <a:pt x="2182" y="2318"/>
                  <a:pt x="2183" y="2326"/>
                </a:cubicBezTo>
                <a:lnTo>
                  <a:pt x="2216" y="2528"/>
                </a:lnTo>
                <a:lnTo>
                  <a:pt x="2163" y="2581"/>
                </a:lnTo>
                <a:close/>
                <a:moveTo>
                  <a:pt x="2647" y="2097"/>
                </a:moveTo>
                <a:lnTo>
                  <a:pt x="2605" y="2138"/>
                </a:lnTo>
                <a:lnTo>
                  <a:pt x="2342" y="1875"/>
                </a:lnTo>
                <a:cubicBezTo>
                  <a:pt x="2342" y="1895"/>
                  <a:pt x="2338" y="1917"/>
                  <a:pt x="2332" y="1943"/>
                </a:cubicBezTo>
                <a:cubicBezTo>
                  <a:pt x="2325" y="1969"/>
                  <a:pt x="2318" y="1990"/>
                  <a:pt x="2310" y="2008"/>
                </a:cubicBezTo>
                <a:lnTo>
                  <a:pt x="2270" y="1968"/>
                </a:lnTo>
                <a:cubicBezTo>
                  <a:pt x="2282" y="1934"/>
                  <a:pt x="2289" y="1901"/>
                  <a:pt x="2291" y="1868"/>
                </a:cubicBezTo>
                <a:cubicBezTo>
                  <a:pt x="2293" y="1835"/>
                  <a:pt x="2290" y="1808"/>
                  <a:pt x="2282" y="1786"/>
                </a:cubicBezTo>
                <a:lnTo>
                  <a:pt x="2309" y="1760"/>
                </a:lnTo>
                <a:lnTo>
                  <a:pt x="2647" y="2097"/>
                </a:lnTo>
                <a:close/>
                <a:moveTo>
                  <a:pt x="2778" y="1965"/>
                </a:moveTo>
                <a:lnTo>
                  <a:pt x="2567" y="1754"/>
                </a:lnTo>
                <a:lnTo>
                  <a:pt x="2530" y="1790"/>
                </a:lnTo>
                <a:lnTo>
                  <a:pt x="2498" y="1758"/>
                </a:lnTo>
                <a:lnTo>
                  <a:pt x="2535" y="1722"/>
                </a:lnTo>
                <a:lnTo>
                  <a:pt x="2509" y="1696"/>
                </a:lnTo>
                <a:cubicBezTo>
                  <a:pt x="2493" y="1680"/>
                  <a:pt x="2482" y="1666"/>
                  <a:pt x="2477" y="1655"/>
                </a:cubicBezTo>
                <a:cubicBezTo>
                  <a:pt x="2470" y="1640"/>
                  <a:pt x="2468" y="1625"/>
                  <a:pt x="2472" y="1608"/>
                </a:cubicBezTo>
                <a:cubicBezTo>
                  <a:pt x="2475" y="1591"/>
                  <a:pt x="2486" y="1574"/>
                  <a:pt x="2504" y="1556"/>
                </a:cubicBezTo>
                <a:cubicBezTo>
                  <a:pt x="2516" y="1544"/>
                  <a:pt x="2530" y="1533"/>
                  <a:pt x="2547" y="1522"/>
                </a:cubicBezTo>
                <a:lnTo>
                  <a:pt x="2576" y="1564"/>
                </a:lnTo>
                <a:cubicBezTo>
                  <a:pt x="2566" y="1571"/>
                  <a:pt x="2557" y="1578"/>
                  <a:pt x="2550" y="1586"/>
                </a:cubicBezTo>
                <a:cubicBezTo>
                  <a:pt x="2537" y="1598"/>
                  <a:pt x="2531" y="1610"/>
                  <a:pt x="2531" y="1621"/>
                </a:cubicBezTo>
                <a:cubicBezTo>
                  <a:pt x="2531" y="1631"/>
                  <a:pt x="2539" y="1644"/>
                  <a:pt x="2553" y="1658"/>
                </a:cubicBezTo>
                <a:lnTo>
                  <a:pt x="2576" y="1681"/>
                </a:lnTo>
                <a:lnTo>
                  <a:pt x="2623" y="1633"/>
                </a:lnTo>
                <a:lnTo>
                  <a:pt x="2655" y="1665"/>
                </a:lnTo>
                <a:lnTo>
                  <a:pt x="2608" y="1713"/>
                </a:lnTo>
                <a:lnTo>
                  <a:pt x="2819" y="1924"/>
                </a:lnTo>
                <a:lnTo>
                  <a:pt x="2778" y="1965"/>
                </a:lnTo>
                <a:close/>
                <a:moveTo>
                  <a:pt x="2809" y="1789"/>
                </a:moveTo>
                <a:lnTo>
                  <a:pt x="2844" y="1742"/>
                </a:lnTo>
                <a:cubicBezTo>
                  <a:pt x="2862" y="1756"/>
                  <a:pt x="2881" y="1762"/>
                  <a:pt x="2901" y="1760"/>
                </a:cubicBezTo>
                <a:cubicBezTo>
                  <a:pt x="2920" y="1758"/>
                  <a:pt x="2939" y="1748"/>
                  <a:pt x="2957" y="1729"/>
                </a:cubicBezTo>
                <a:cubicBezTo>
                  <a:pt x="2976" y="1710"/>
                  <a:pt x="2987" y="1692"/>
                  <a:pt x="2988" y="1676"/>
                </a:cubicBezTo>
                <a:cubicBezTo>
                  <a:pt x="2990" y="1659"/>
                  <a:pt x="2985" y="1645"/>
                  <a:pt x="2975" y="1635"/>
                </a:cubicBezTo>
                <a:cubicBezTo>
                  <a:pt x="2965" y="1625"/>
                  <a:pt x="2954" y="1622"/>
                  <a:pt x="2941" y="1625"/>
                </a:cubicBezTo>
                <a:cubicBezTo>
                  <a:pt x="2931" y="1627"/>
                  <a:pt x="2912" y="1636"/>
                  <a:pt x="2884" y="1653"/>
                </a:cubicBezTo>
                <a:cubicBezTo>
                  <a:pt x="2846" y="1676"/>
                  <a:pt x="2819" y="1690"/>
                  <a:pt x="2802" y="1696"/>
                </a:cubicBezTo>
                <a:cubicBezTo>
                  <a:pt x="2784" y="1702"/>
                  <a:pt x="2768" y="1703"/>
                  <a:pt x="2752" y="1700"/>
                </a:cubicBezTo>
                <a:cubicBezTo>
                  <a:pt x="2736" y="1696"/>
                  <a:pt x="2722" y="1688"/>
                  <a:pt x="2710" y="1676"/>
                </a:cubicBezTo>
                <a:cubicBezTo>
                  <a:pt x="2699" y="1665"/>
                  <a:pt x="2692" y="1653"/>
                  <a:pt x="2687" y="1638"/>
                </a:cubicBezTo>
                <a:cubicBezTo>
                  <a:pt x="2683" y="1624"/>
                  <a:pt x="2682" y="1610"/>
                  <a:pt x="2685" y="1595"/>
                </a:cubicBezTo>
                <a:cubicBezTo>
                  <a:pt x="2686" y="1584"/>
                  <a:pt x="2691" y="1571"/>
                  <a:pt x="2699" y="1557"/>
                </a:cubicBezTo>
                <a:cubicBezTo>
                  <a:pt x="2707" y="1542"/>
                  <a:pt x="2717" y="1529"/>
                  <a:pt x="2730" y="1516"/>
                </a:cubicBezTo>
                <a:cubicBezTo>
                  <a:pt x="2749" y="1497"/>
                  <a:pt x="2768" y="1483"/>
                  <a:pt x="2788" y="1474"/>
                </a:cubicBezTo>
                <a:cubicBezTo>
                  <a:pt x="2808" y="1465"/>
                  <a:pt x="2826" y="1462"/>
                  <a:pt x="2843" y="1464"/>
                </a:cubicBezTo>
                <a:cubicBezTo>
                  <a:pt x="2859" y="1467"/>
                  <a:pt x="2876" y="1475"/>
                  <a:pt x="2894" y="1488"/>
                </a:cubicBezTo>
                <a:lnTo>
                  <a:pt x="2860" y="1534"/>
                </a:lnTo>
                <a:cubicBezTo>
                  <a:pt x="2845" y="1523"/>
                  <a:pt x="2830" y="1519"/>
                  <a:pt x="2814" y="1520"/>
                </a:cubicBezTo>
                <a:cubicBezTo>
                  <a:pt x="2798" y="1522"/>
                  <a:pt x="2783" y="1531"/>
                  <a:pt x="2767" y="1547"/>
                </a:cubicBezTo>
                <a:cubicBezTo>
                  <a:pt x="2748" y="1566"/>
                  <a:pt x="2737" y="1583"/>
                  <a:pt x="2735" y="1597"/>
                </a:cubicBezTo>
                <a:cubicBezTo>
                  <a:pt x="2734" y="1611"/>
                  <a:pt x="2737" y="1623"/>
                  <a:pt x="2745" y="1631"/>
                </a:cubicBezTo>
                <a:cubicBezTo>
                  <a:pt x="2751" y="1637"/>
                  <a:pt x="2757" y="1640"/>
                  <a:pt x="2765" y="1641"/>
                </a:cubicBezTo>
                <a:cubicBezTo>
                  <a:pt x="2772" y="1642"/>
                  <a:pt x="2781" y="1640"/>
                  <a:pt x="2792" y="1636"/>
                </a:cubicBezTo>
                <a:cubicBezTo>
                  <a:pt x="2797" y="1633"/>
                  <a:pt x="2813" y="1625"/>
                  <a:pt x="2838" y="1610"/>
                </a:cubicBezTo>
                <a:cubicBezTo>
                  <a:pt x="2875" y="1588"/>
                  <a:pt x="2902" y="1574"/>
                  <a:pt x="2919" y="1568"/>
                </a:cubicBezTo>
                <a:cubicBezTo>
                  <a:pt x="2935" y="1561"/>
                  <a:pt x="2952" y="1560"/>
                  <a:pt x="2968" y="1562"/>
                </a:cubicBezTo>
                <a:cubicBezTo>
                  <a:pt x="2984" y="1565"/>
                  <a:pt x="2999" y="1574"/>
                  <a:pt x="3013" y="1588"/>
                </a:cubicBezTo>
                <a:cubicBezTo>
                  <a:pt x="3026" y="1602"/>
                  <a:pt x="3035" y="1619"/>
                  <a:pt x="3040" y="1639"/>
                </a:cubicBezTo>
                <a:cubicBezTo>
                  <a:pt x="3044" y="1659"/>
                  <a:pt x="3042" y="1680"/>
                  <a:pt x="3033" y="1702"/>
                </a:cubicBezTo>
                <a:cubicBezTo>
                  <a:pt x="3025" y="1723"/>
                  <a:pt x="3011" y="1744"/>
                  <a:pt x="2992" y="1763"/>
                </a:cubicBezTo>
                <a:cubicBezTo>
                  <a:pt x="2960" y="1795"/>
                  <a:pt x="2929" y="1812"/>
                  <a:pt x="2900" y="1816"/>
                </a:cubicBezTo>
                <a:cubicBezTo>
                  <a:pt x="2870" y="1819"/>
                  <a:pt x="2840" y="1810"/>
                  <a:pt x="2809" y="1789"/>
                </a:cubicBezTo>
                <a:close/>
                <a:moveTo>
                  <a:pt x="3302" y="1362"/>
                </a:moveTo>
                <a:lnTo>
                  <a:pt x="3342" y="1402"/>
                </a:lnTo>
                <a:lnTo>
                  <a:pt x="3119" y="1624"/>
                </a:lnTo>
                <a:cubicBezTo>
                  <a:pt x="3109" y="1615"/>
                  <a:pt x="3101" y="1603"/>
                  <a:pt x="3096" y="1591"/>
                </a:cubicBezTo>
                <a:cubicBezTo>
                  <a:pt x="3086" y="1570"/>
                  <a:pt x="3080" y="1546"/>
                  <a:pt x="3078" y="1519"/>
                </a:cubicBezTo>
                <a:cubicBezTo>
                  <a:pt x="3076" y="1492"/>
                  <a:pt x="3077" y="1457"/>
                  <a:pt x="3081" y="1414"/>
                </a:cubicBezTo>
                <a:cubicBezTo>
                  <a:pt x="3088" y="1348"/>
                  <a:pt x="3089" y="1299"/>
                  <a:pt x="3084" y="1269"/>
                </a:cubicBezTo>
                <a:cubicBezTo>
                  <a:pt x="3079" y="1238"/>
                  <a:pt x="3069" y="1215"/>
                  <a:pt x="3054" y="1200"/>
                </a:cubicBezTo>
                <a:cubicBezTo>
                  <a:pt x="3037" y="1184"/>
                  <a:pt x="3018" y="1176"/>
                  <a:pt x="2995" y="1176"/>
                </a:cubicBezTo>
                <a:cubicBezTo>
                  <a:pt x="2972" y="1176"/>
                  <a:pt x="2951" y="1186"/>
                  <a:pt x="2932" y="1205"/>
                </a:cubicBezTo>
                <a:cubicBezTo>
                  <a:pt x="2912" y="1225"/>
                  <a:pt x="2902" y="1247"/>
                  <a:pt x="2902" y="1270"/>
                </a:cubicBezTo>
                <a:cubicBezTo>
                  <a:pt x="2902" y="1294"/>
                  <a:pt x="2913" y="1317"/>
                  <a:pt x="2934" y="1338"/>
                </a:cubicBezTo>
                <a:lnTo>
                  <a:pt x="2887" y="1376"/>
                </a:lnTo>
                <a:cubicBezTo>
                  <a:pt x="2858" y="1342"/>
                  <a:pt x="2845" y="1307"/>
                  <a:pt x="2847" y="1271"/>
                </a:cubicBezTo>
                <a:cubicBezTo>
                  <a:pt x="2850" y="1236"/>
                  <a:pt x="2867" y="1202"/>
                  <a:pt x="2899" y="1170"/>
                </a:cubicBezTo>
                <a:cubicBezTo>
                  <a:pt x="2931" y="1138"/>
                  <a:pt x="2966" y="1121"/>
                  <a:pt x="3002" y="1120"/>
                </a:cubicBezTo>
                <a:cubicBezTo>
                  <a:pt x="3039" y="1119"/>
                  <a:pt x="3071" y="1132"/>
                  <a:pt x="3097" y="1158"/>
                </a:cubicBezTo>
                <a:cubicBezTo>
                  <a:pt x="3110" y="1172"/>
                  <a:pt x="3121" y="1188"/>
                  <a:pt x="3128" y="1206"/>
                </a:cubicBezTo>
                <a:cubicBezTo>
                  <a:pt x="3136" y="1225"/>
                  <a:pt x="3140" y="1248"/>
                  <a:pt x="3142" y="1275"/>
                </a:cubicBezTo>
                <a:cubicBezTo>
                  <a:pt x="3144" y="1302"/>
                  <a:pt x="3142" y="1343"/>
                  <a:pt x="3138" y="1397"/>
                </a:cubicBezTo>
                <a:cubicBezTo>
                  <a:pt x="3134" y="1443"/>
                  <a:pt x="3132" y="1473"/>
                  <a:pt x="3132" y="1487"/>
                </a:cubicBezTo>
                <a:cubicBezTo>
                  <a:pt x="3133" y="1502"/>
                  <a:pt x="3134" y="1515"/>
                  <a:pt x="3137" y="1527"/>
                </a:cubicBezTo>
                <a:lnTo>
                  <a:pt x="3302" y="1362"/>
                </a:lnTo>
                <a:close/>
                <a:moveTo>
                  <a:pt x="3238" y="928"/>
                </a:moveTo>
                <a:lnTo>
                  <a:pt x="3191" y="881"/>
                </a:lnTo>
                <a:lnTo>
                  <a:pt x="3232" y="840"/>
                </a:lnTo>
                <a:lnTo>
                  <a:pt x="3279" y="887"/>
                </a:lnTo>
                <a:lnTo>
                  <a:pt x="3238" y="928"/>
                </a:lnTo>
                <a:close/>
                <a:moveTo>
                  <a:pt x="3527" y="1217"/>
                </a:moveTo>
                <a:lnTo>
                  <a:pt x="3283" y="973"/>
                </a:lnTo>
                <a:lnTo>
                  <a:pt x="3325" y="932"/>
                </a:lnTo>
                <a:lnTo>
                  <a:pt x="3568" y="1176"/>
                </a:lnTo>
                <a:lnTo>
                  <a:pt x="3527" y="1217"/>
                </a:lnTo>
                <a:close/>
                <a:moveTo>
                  <a:pt x="3639" y="1104"/>
                </a:moveTo>
                <a:lnTo>
                  <a:pt x="3303" y="768"/>
                </a:lnTo>
                <a:lnTo>
                  <a:pt x="3430" y="642"/>
                </a:lnTo>
                <a:cubicBezTo>
                  <a:pt x="3452" y="619"/>
                  <a:pt x="3470" y="603"/>
                  <a:pt x="3484" y="594"/>
                </a:cubicBezTo>
                <a:cubicBezTo>
                  <a:pt x="3504" y="580"/>
                  <a:pt x="3523" y="571"/>
                  <a:pt x="3541" y="568"/>
                </a:cubicBezTo>
                <a:cubicBezTo>
                  <a:pt x="3560" y="564"/>
                  <a:pt x="3580" y="566"/>
                  <a:pt x="3601" y="573"/>
                </a:cubicBezTo>
                <a:cubicBezTo>
                  <a:pt x="3622" y="580"/>
                  <a:pt x="3640" y="592"/>
                  <a:pt x="3657" y="609"/>
                </a:cubicBezTo>
                <a:cubicBezTo>
                  <a:pt x="3685" y="638"/>
                  <a:pt x="3701" y="671"/>
                  <a:pt x="3702" y="709"/>
                </a:cubicBezTo>
                <a:cubicBezTo>
                  <a:pt x="3704" y="747"/>
                  <a:pt x="3681" y="790"/>
                  <a:pt x="3633" y="837"/>
                </a:cubicBezTo>
                <a:lnTo>
                  <a:pt x="3547" y="923"/>
                </a:lnTo>
                <a:lnTo>
                  <a:pt x="3684" y="1060"/>
                </a:lnTo>
                <a:lnTo>
                  <a:pt x="3639" y="1104"/>
                </a:lnTo>
                <a:close/>
                <a:moveTo>
                  <a:pt x="3507" y="884"/>
                </a:moveTo>
                <a:lnTo>
                  <a:pt x="3594" y="797"/>
                </a:lnTo>
                <a:cubicBezTo>
                  <a:pt x="3623" y="768"/>
                  <a:pt x="3638" y="742"/>
                  <a:pt x="3639" y="719"/>
                </a:cubicBezTo>
                <a:cubicBezTo>
                  <a:pt x="3641" y="697"/>
                  <a:pt x="3632" y="676"/>
                  <a:pt x="3612" y="656"/>
                </a:cubicBezTo>
                <a:cubicBezTo>
                  <a:pt x="3598" y="642"/>
                  <a:pt x="3583" y="634"/>
                  <a:pt x="3566" y="631"/>
                </a:cubicBezTo>
                <a:cubicBezTo>
                  <a:pt x="3549" y="628"/>
                  <a:pt x="3533" y="631"/>
                  <a:pt x="3518" y="639"/>
                </a:cubicBezTo>
                <a:cubicBezTo>
                  <a:pt x="3508" y="645"/>
                  <a:pt x="3493" y="657"/>
                  <a:pt x="3473" y="678"/>
                </a:cubicBezTo>
                <a:lnTo>
                  <a:pt x="3387" y="764"/>
                </a:lnTo>
                <a:lnTo>
                  <a:pt x="3507" y="884"/>
                </a:lnTo>
                <a:close/>
                <a:moveTo>
                  <a:pt x="3827" y="700"/>
                </a:moveTo>
                <a:lnTo>
                  <a:pt x="3866" y="655"/>
                </a:lnTo>
                <a:cubicBezTo>
                  <a:pt x="3884" y="670"/>
                  <a:pt x="3903" y="679"/>
                  <a:pt x="3921" y="682"/>
                </a:cubicBezTo>
                <a:cubicBezTo>
                  <a:pt x="3939" y="686"/>
                  <a:pt x="3959" y="683"/>
                  <a:pt x="3981" y="675"/>
                </a:cubicBezTo>
                <a:cubicBezTo>
                  <a:pt x="4003" y="666"/>
                  <a:pt x="4023" y="652"/>
                  <a:pt x="4042" y="633"/>
                </a:cubicBezTo>
                <a:cubicBezTo>
                  <a:pt x="4059" y="616"/>
                  <a:pt x="4072" y="599"/>
                  <a:pt x="4080" y="581"/>
                </a:cubicBezTo>
                <a:cubicBezTo>
                  <a:pt x="4088" y="563"/>
                  <a:pt x="4090" y="546"/>
                  <a:pt x="4088" y="531"/>
                </a:cubicBezTo>
                <a:cubicBezTo>
                  <a:pt x="4085" y="516"/>
                  <a:pt x="4079" y="503"/>
                  <a:pt x="4069" y="493"/>
                </a:cubicBezTo>
                <a:cubicBezTo>
                  <a:pt x="4058" y="482"/>
                  <a:pt x="4046" y="476"/>
                  <a:pt x="4032" y="474"/>
                </a:cubicBezTo>
                <a:cubicBezTo>
                  <a:pt x="4018" y="472"/>
                  <a:pt x="4001" y="476"/>
                  <a:pt x="3982" y="484"/>
                </a:cubicBezTo>
                <a:cubicBezTo>
                  <a:pt x="3969" y="490"/>
                  <a:pt x="3944" y="504"/>
                  <a:pt x="3906" y="528"/>
                </a:cubicBezTo>
                <a:cubicBezTo>
                  <a:pt x="3867" y="551"/>
                  <a:pt x="3839" y="566"/>
                  <a:pt x="3820" y="572"/>
                </a:cubicBezTo>
                <a:cubicBezTo>
                  <a:pt x="3795" y="579"/>
                  <a:pt x="3773" y="581"/>
                  <a:pt x="3753" y="576"/>
                </a:cubicBezTo>
                <a:cubicBezTo>
                  <a:pt x="3732" y="572"/>
                  <a:pt x="3714" y="562"/>
                  <a:pt x="3699" y="546"/>
                </a:cubicBezTo>
                <a:cubicBezTo>
                  <a:pt x="3682" y="529"/>
                  <a:pt x="3671" y="509"/>
                  <a:pt x="3666" y="484"/>
                </a:cubicBezTo>
                <a:cubicBezTo>
                  <a:pt x="3661" y="460"/>
                  <a:pt x="3663" y="435"/>
                  <a:pt x="3674" y="409"/>
                </a:cubicBezTo>
                <a:cubicBezTo>
                  <a:pt x="3685" y="382"/>
                  <a:pt x="3702" y="358"/>
                  <a:pt x="3725" y="335"/>
                </a:cubicBezTo>
                <a:cubicBezTo>
                  <a:pt x="3749" y="311"/>
                  <a:pt x="3775" y="293"/>
                  <a:pt x="3802" y="282"/>
                </a:cubicBezTo>
                <a:cubicBezTo>
                  <a:pt x="3830" y="271"/>
                  <a:pt x="3856" y="268"/>
                  <a:pt x="3882" y="273"/>
                </a:cubicBezTo>
                <a:cubicBezTo>
                  <a:pt x="3908" y="278"/>
                  <a:pt x="3931" y="291"/>
                  <a:pt x="3951" y="310"/>
                </a:cubicBezTo>
                <a:lnTo>
                  <a:pt x="3912" y="355"/>
                </a:lnTo>
                <a:cubicBezTo>
                  <a:pt x="3888" y="336"/>
                  <a:pt x="3864" y="328"/>
                  <a:pt x="3840" y="331"/>
                </a:cubicBezTo>
                <a:cubicBezTo>
                  <a:pt x="3816" y="333"/>
                  <a:pt x="3791" y="347"/>
                  <a:pt x="3766" y="373"/>
                </a:cubicBezTo>
                <a:cubicBezTo>
                  <a:pt x="3739" y="400"/>
                  <a:pt x="3724" y="424"/>
                  <a:pt x="3722" y="446"/>
                </a:cubicBezTo>
                <a:cubicBezTo>
                  <a:pt x="3719" y="469"/>
                  <a:pt x="3725" y="487"/>
                  <a:pt x="3739" y="501"/>
                </a:cubicBezTo>
                <a:cubicBezTo>
                  <a:pt x="3751" y="513"/>
                  <a:pt x="3765" y="518"/>
                  <a:pt x="3782" y="517"/>
                </a:cubicBezTo>
                <a:cubicBezTo>
                  <a:pt x="3798" y="517"/>
                  <a:pt x="3828" y="502"/>
                  <a:pt x="3873" y="474"/>
                </a:cubicBezTo>
                <a:cubicBezTo>
                  <a:pt x="3917" y="446"/>
                  <a:pt x="3949" y="429"/>
                  <a:pt x="3968" y="421"/>
                </a:cubicBezTo>
                <a:cubicBezTo>
                  <a:pt x="3997" y="411"/>
                  <a:pt x="4023" y="408"/>
                  <a:pt x="4046" y="412"/>
                </a:cubicBezTo>
                <a:cubicBezTo>
                  <a:pt x="4069" y="417"/>
                  <a:pt x="4090" y="428"/>
                  <a:pt x="4108" y="446"/>
                </a:cubicBezTo>
                <a:cubicBezTo>
                  <a:pt x="4126" y="464"/>
                  <a:pt x="4137" y="486"/>
                  <a:pt x="4143" y="512"/>
                </a:cubicBezTo>
                <a:cubicBezTo>
                  <a:pt x="4149" y="538"/>
                  <a:pt x="4146" y="565"/>
                  <a:pt x="4136" y="593"/>
                </a:cubicBezTo>
                <a:cubicBezTo>
                  <a:pt x="4125" y="621"/>
                  <a:pt x="4108" y="647"/>
                  <a:pt x="4084" y="671"/>
                </a:cubicBezTo>
                <a:cubicBezTo>
                  <a:pt x="4054" y="701"/>
                  <a:pt x="4024" y="722"/>
                  <a:pt x="3994" y="734"/>
                </a:cubicBezTo>
                <a:cubicBezTo>
                  <a:pt x="3965" y="746"/>
                  <a:pt x="3936" y="749"/>
                  <a:pt x="3906" y="742"/>
                </a:cubicBezTo>
                <a:cubicBezTo>
                  <a:pt x="3877" y="736"/>
                  <a:pt x="3850" y="722"/>
                  <a:pt x="3827" y="700"/>
                </a:cubicBezTo>
                <a:close/>
                <a:moveTo>
                  <a:pt x="4406" y="338"/>
                </a:moveTo>
                <a:lnTo>
                  <a:pt x="4365" y="379"/>
                </a:lnTo>
                <a:lnTo>
                  <a:pt x="4102" y="116"/>
                </a:lnTo>
                <a:cubicBezTo>
                  <a:pt x="4101" y="136"/>
                  <a:pt x="4098" y="158"/>
                  <a:pt x="4091" y="184"/>
                </a:cubicBezTo>
                <a:cubicBezTo>
                  <a:pt x="4084" y="209"/>
                  <a:pt x="4077" y="231"/>
                  <a:pt x="4069" y="248"/>
                </a:cubicBezTo>
                <a:lnTo>
                  <a:pt x="4029" y="209"/>
                </a:lnTo>
                <a:cubicBezTo>
                  <a:pt x="4041" y="175"/>
                  <a:pt x="4048" y="141"/>
                  <a:pt x="4050" y="109"/>
                </a:cubicBezTo>
                <a:cubicBezTo>
                  <a:pt x="4052" y="76"/>
                  <a:pt x="4049" y="49"/>
                  <a:pt x="4042" y="27"/>
                </a:cubicBezTo>
                <a:lnTo>
                  <a:pt x="4068" y="0"/>
                </a:lnTo>
                <a:lnTo>
                  <a:pt x="4406" y="338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87" name="Freeform 69"/>
          <p:cNvSpPr>
            <a:spLocks noEditPoints="1"/>
          </p:cNvSpPr>
          <p:nvPr/>
        </p:nvSpPr>
        <p:spPr bwMode="auto">
          <a:xfrm>
            <a:off x="2997378" y="4611475"/>
            <a:ext cx="852487" cy="839787"/>
          </a:xfrm>
          <a:custGeom>
            <a:avLst/>
            <a:gdLst>
              <a:gd name="T0" fmla="*/ 238 w 4468"/>
              <a:gd name="T1" fmla="*/ 3878 h 4415"/>
              <a:gd name="T2" fmla="*/ 244 w 4468"/>
              <a:gd name="T3" fmla="*/ 4234 h 4415"/>
              <a:gd name="T4" fmla="*/ 336 w 4468"/>
              <a:gd name="T5" fmla="*/ 4030 h 4415"/>
              <a:gd name="T6" fmla="*/ 84 w 4468"/>
              <a:gd name="T7" fmla="*/ 4074 h 4415"/>
              <a:gd name="T8" fmla="*/ 513 w 4468"/>
              <a:gd name="T9" fmla="*/ 3586 h 4415"/>
              <a:gd name="T10" fmla="*/ 740 w 4468"/>
              <a:gd name="T11" fmla="*/ 3714 h 4415"/>
              <a:gd name="T12" fmla="*/ 779 w 4468"/>
              <a:gd name="T13" fmla="*/ 3972 h 4415"/>
              <a:gd name="T14" fmla="*/ 621 w 4468"/>
              <a:gd name="T15" fmla="*/ 3699 h 4415"/>
              <a:gd name="T16" fmla="*/ 399 w 4468"/>
              <a:gd name="T17" fmla="*/ 3759 h 4415"/>
              <a:gd name="T18" fmla="*/ 785 w 4468"/>
              <a:gd name="T19" fmla="*/ 3866 h 4415"/>
              <a:gd name="T20" fmla="*/ 618 w 4468"/>
              <a:gd name="T21" fmla="*/ 3823 h 4415"/>
              <a:gd name="T22" fmla="*/ 744 w 4468"/>
              <a:gd name="T23" fmla="*/ 3335 h 4415"/>
              <a:gd name="T24" fmla="*/ 1131 w 4468"/>
              <a:gd name="T25" fmla="*/ 3416 h 4415"/>
              <a:gd name="T26" fmla="*/ 964 w 4468"/>
              <a:gd name="T27" fmla="*/ 3787 h 4415"/>
              <a:gd name="T28" fmla="*/ 1081 w 4468"/>
              <a:gd name="T29" fmla="*/ 3458 h 4415"/>
              <a:gd name="T30" fmla="*/ 712 w 4468"/>
              <a:gd name="T31" fmla="*/ 3446 h 4415"/>
              <a:gd name="T32" fmla="*/ 1627 w 4468"/>
              <a:gd name="T33" fmla="*/ 3311 h 4415"/>
              <a:gd name="T34" fmla="*/ 1414 w 4468"/>
              <a:gd name="T35" fmla="*/ 2671 h 4415"/>
              <a:gd name="T36" fmla="*/ 1563 w 4468"/>
              <a:gd name="T37" fmla="*/ 2915 h 4415"/>
              <a:gd name="T38" fmla="*/ 1524 w 4468"/>
              <a:gd name="T39" fmla="*/ 2874 h 4415"/>
              <a:gd name="T40" fmla="*/ 1403 w 4468"/>
              <a:gd name="T41" fmla="*/ 2755 h 4415"/>
              <a:gd name="T42" fmla="*/ 1788 w 4468"/>
              <a:gd name="T43" fmla="*/ 2291 h 4415"/>
              <a:gd name="T44" fmla="*/ 1958 w 4468"/>
              <a:gd name="T45" fmla="*/ 2485 h 4415"/>
              <a:gd name="T46" fmla="*/ 1881 w 4468"/>
              <a:gd name="T47" fmla="*/ 2870 h 4415"/>
              <a:gd name="T48" fmla="*/ 2042 w 4468"/>
              <a:gd name="T49" fmla="*/ 2209 h 4415"/>
              <a:gd name="T50" fmla="*/ 2166 w 4468"/>
              <a:gd name="T51" fmla="*/ 2230 h 4415"/>
              <a:gd name="T52" fmla="*/ 2184 w 4468"/>
              <a:gd name="T53" fmla="*/ 2333 h 4415"/>
              <a:gd name="T54" fmla="*/ 2343 w 4468"/>
              <a:gd name="T55" fmla="*/ 1882 h 4415"/>
              <a:gd name="T56" fmla="*/ 2283 w 4468"/>
              <a:gd name="T57" fmla="*/ 1793 h 4415"/>
              <a:gd name="T58" fmla="*/ 2531 w 4468"/>
              <a:gd name="T59" fmla="*/ 1797 h 4415"/>
              <a:gd name="T60" fmla="*/ 2472 w 4468"/>
              <a:gd name="T61" fmla="*/ 1615 h 4415"/>
              <a:gd name="T62" fmla="*/ 2532 w 4468"/>
              <a:gd name="T63" fmla="*/ 1628 h 4415"/>
              <a:gd name="T64" fmla="*/ 2608 w 4468"/>
              <a:gd name="T65" fmla="*/ 1720 h 4415"/>
              <a:gd name="T66" fmla="*/ 2901 w 4468"/>
              <a:gd name="T67" fmla="*/ 1767 h 4415"/>
              <a:gd name="T68" fmla="*/ 2885 w 4468"/>
              <a:gd name="T69" fmla="*/ 1660 h 4415"/>
              <a:gd name="T70" fmla="*/ 2685 w 4468"/>
              <a:gd name="T71" fmla="*/ 1602 h 4415"/>
              <a:gd name="T72" fmla="*/ 2895 w 4468"/>
              <a:gd name="T73" fmla="*/ 1495 h 4415"/>
              <a:gd name="T74" fmla="*/ 2746 w 4468"/>
              <a:gd name="T75" fmla="*/ 1638 h 4415"/>
              <a:gd name="T76" fmla="*/ 2968 w 4468"/>
              <a:gd name="T77" fmla="*/ 1569 h 4415"/>
              <a:gd name="T78" fmla="*/ 2900 w 4468"/>
              <a:gd name="T79" fmla="*/ 1823 h 4415"/>
              <a:gd name="T80" fmla="*/ 3096 w 4468"/>
              <a:gd name="T81" fmla="*/ 1598 h 4415"/>
              <a:gd name="T82" fmla="*/ 2995 w 4468"/>
              <a:gd name="T83" fmla="*/ 1183 h 4415"/>
              <a:gd name="T84" fmla="*/ 2848 w 4468"/>
              <a:gd name="T85" fmla="*/ 1278 h 4415"/>
              <a:gd name="T86" fmla="*/ 3142 w 4468"/>
              <a:gd name="T87" fmla="*/ 1282 h 4415"/>
              <a:gd name="T88" fmla="*/ 3238 w 4468"/>
              <a:gd name="T89" fmla="*/ 935 h 4415"/>
              <a:gd name="T90" fmla="*/ 3527 w 4468"/>
              <a:gd name="T91" fmla="*/ 1224 h 4415"/>
              <a:gd name="T92" fmla="*/ 3640 w 4468"/>
              <a:gd name="T93" fmla="*/ 1111 h 4415"/>
              <a:gd name="T94" fmla="*/ 3601 w 4468"/>
              <a:gd name="T95" fmla="*/ 580 h 4415"/>
              <a:gd name="T96" fmla="*/ 3684 w 4468"/>
              <a:gd name="T97" fmla="*/ 1067 h 4415"/>
              <a:gd name="T98" fmla="*/ 3613 w 4468"/>
              <a:gd name="T99" fmla="*/ 663 h 4415"/>
              <a:gd name="T100" fmla="*/ 3508 w 4468"/>
              <a:gd name="T101" fmla="*/ 891 h 4415"/>
              <a:gd name="T102" fmla="*/ 4043 w 4468"/>
              <a:gd name="T103" fmla="*/ 640 h 4415"/>
              <a:gd name="T104" fmla="*/ 3982 w 4468"/>
              <a:gd name="T105" fmla="*/ 491 h 4415"/>
              <a:gd name="T106" fmla="*/ 3666 w 4468"/>
              <a:gd name="T107" fmla="*/ 491 h 4415"/>
              <a:gd name="T108" fmla="*/ 3952 w 4468"/>
              <a:gd name="T109" fmla="*/ 317 h 4415"/>
              <a:gd name="T110" fmla="*/ 3739 w 4468"/>
              <a:gd name="T111" fmla="*/ 508 h 4415"/>
              <a:gd name="T112" fmla="*/ 4108 w 4468"/>
              <a:gd name="T113" fmla="*/ 453 h 4415"/>
              <a:gd name="T114" fmla="*/ 3907 w 4468"/>
              <a:gd name="T115" fmla="*/ 749 h 4415"/>
              <a:gd name="T116" fmla="*/ 4222 w 4468"/>
              <a:gd name="T117" fmla="*/ 472 h 4415"/>
              <a:gd name="T118" fmla="*/ 4121 w 4468"/>
              <a:gd name="T119" fmla="*/ 57 h 4415"/>
              <a:gd name="T120" fmla="*/ 3974 w 4468"/>
              <a:gd name="T121" fmla="*/ 152 h 4415"/>
              <a:gd name="T122" fmla="*/ 4268 w 4468"/>
              <a:gd name="T123" fmla="*/ 156 h 441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  <a:cxn ang="0">
                <a:pos x="T122" y="T123"/>
              </a:cxn>
            </a:cxnLst>
            <a:rect l="0" t="0" r="r" b="b"/>
            <a:pathLst>
              <a:path w="4468" h="4415">
                <a:moveTo>
                  <a:pt x="336" y="4415"/>
                </a:moveTo>
                <a:lnTo>
                  <a:pt x="0" y="4079"/>
                </a:lnTo>
                <a:lnTo>
                  <a:pt x="127" y="3952"/>
                </a:lnTo>
                <a:cubicBezTo>
                  <a:pt x="149" y="3930"/>
                  <a:pt x="167" y="3914"/>
                  <a:pt x="181" y="3904"/>
                </a:cubicBezTo>
                <a:cubicBezTo>
                  <a:pt x="200" y="3890"/>
                  <a:pt x="219" y="3882"/>
                  <a:pt x="238" y="3878"/>
                </a:cubicBezTo>
                <a:cubicBezTo>
                  <a:pt x="257" y="3875"/>
                  <a:pt x="277" y="3877"/>
                  <a:pt x="298" y="3884"/>
                </a:cubicBezTo>
                <a:cubicBezTo>
                  <a:pt x="318" y="3891"/>
                  <a:pt x="337" y="3903"/>
                  <a:pt x="354" y="3920"/>
                </a:cubicBezTo>
                <a:cubicBezTo>
                  <a:pt x="382" y="3948"/>
                  <a:pt x="397" y="3981"/>
                  <a:pt x="399" y="4019"/>
                </a:cubicBezTo>
                <a:cubicBezTo>
                  <a:pt x="401" y="4057"/>
                  <a:pt x="378" y="4100"/>
                  <a:pt x="330" y="4148"/>
                </a:cubicBezTo>
                <a:lnTo>
                  <a:pt x="244" y="4234"/>
                </a:lnTo>
                <a:lnTo>
                  <a:pt x="381" y="4371"/>
                </a:lnTo>
                <a:lnTo>
                  <a:pt x="336" y="4415"/>
                </a:lnTo>
                <a:close/>
                <a:moveTo>
                  <a:pt x="204" y="4194"/>
                </a:moveTo>
                <a:lnTo>
                  <a:pt x="291" y="4107"/>
                </a:lnTo>
                <a:cubicBezTo>
                  <a:pt x="320" y="4079"/>
                  <a:pt x="335" y="4053"/>
                  <a:pt x="336" y="4030"/>
                </a:cubicBezTo>
                <a:cubicBezTo>
                  <a:pt x="338" y="4007"/>
                  <a:pt x="329" y="3986"/>
                  <a:pt x="309" y="3967"/>
                </a:cubicBezTo>
                <a:cubicBezTo>
                  <a:pt x="295" y="3953"/>
                  <a:pt x="280" y="3944"/>
                  <a:pt x="262" y="3941"/>
                </a:cubicBezTo>
                <a:cubicBezTo>
                  <a:pt x="245" y="3938"/>
                  <a:pt x="229" y="3941"/>
                  <a:pt x="215" y="3950"/>
                </a:cubicBezTo>
                <a:cubicBezTo>
                  <a:pt x="205" y="3955"/>
                  <a:pt x="190" y="3968"/>
                  <a:pt x="170" y="3988"/>
                </a:cubicBezTo>
                <a:lnTo>
                  <a:pt x="84" y="4074"/>
                </a:lnTo>
                <a:lnTo>
                  <a:pt x="204" y="4194"/>
                </a:lnTo>
                <a:close/>
                <a:moveTo>
                  <a:pt x="651" y="4100"/>
                </a:moveTo>
                <a:lnTo>
                  <a:pt x="315" y="3764"/>
                </a:lnTo>
                <a:lnTo>
                  <a:pt x="441" y="3638"/>
                </a:lnTo>
                <a:cubicBezTo>
                  <a:pt x="467" y="3612"/>
                  <a:pt x="491" y="3595"/>
                  <a:pt x="513" y="3586"/>
                </a:cubicBezTo>
                <a:cubicBezTo>
                  <a:pt x="535" y="3578"/>
                  <a:pt x="558" y="3576"/>
                  <a:pt x="581" y="3581"/>
                </a:cubicBezTo>
                <a:cubicBezTo>
                  <a:pt x="604" y="3587"/>
                  <a:pt x="623" y="3597"/>
                  <a:pt x="638" y="3612"/>
                </a:cubicBezTo>
                <a:cubicBezTo>
                  <a:pt x="653" y="3627"/>
                  <a:pt x="662" y="3644"/>
                  <a:pt x="667" y="3665"/>
                </a:cubicBezTo>
                <a:cubicBezTo>
                  <a:pt x="672" y="3685"/>
                  <a:pt x="671" y="3707"/>
                  <a:pt x="663" y="3731"/>
                </a:cubicBezTo>
                <a:cubicBezTo>
                  <a:pt x="689" y="3716"/>
                  <a:pt x="715" y="3711"/>
                  <a:pt x="740" y="3714"/>
                </a:cubicBezTo>
                <a:cubicBezTo>
                  <a:pt x="765" y="3718"/>
                  <a:pt x="788" y="3729"/>
                  <a:pt x="807" y="3749"/>
                </a:cubicBezTo>
                <a:cubicBezTo>
                  <a:pt x="823" y="3765"/>
                  <a:pt x="834" y="3783"/>
                  <a:pt x="841" y="3803"/>
                </a:cubicBezTo>
                <a:cubicBezTo>
                  <a:pt x="848" y="3823"/>
                  <a:pt x="850" y="3842"/>
                  <a:pt x="848" y="3859"/>
                </a:cubicBezTo>
                <a:cubicBezTo>
                  <a:pt x="845" y="3876"/>
                  <a:pt x="839" y="3894"/>
                  <a:pt x="828" y="3912"/>
                </a:cubicBezTo>
                <a:cubicBezTo>
                  <a:pt x="817" y="3931"/>
                  <a:pt x="801" y="3951"/>
                  <a:pt x="779" y="3972"/>
                </a:cubicBezTo>
                <a:lnTo>
                  <a:pt x="651" y="4100"/>
                </a:lnTo>
                <a:close/>
                <a:moveTo>
                  <a:pt x="501" y="3861"/>
                </a:moveTo>
                <a:lnTo>
                  <a:pt x="573" y="3788"/>
                </a:lnTo>
                <a:cubicBezTo>
                  <a:pt x="593" y="3768"/>
                  <a:pt x="606" y="3753"/>
                  <a:pt x="612" y="3742"/>
                </a:cubicBezTo>
                <a:cubicBezTo>
                  <a:pt x="620" y="3727"/>
                  <a:pt x="623" y="3713"/>
                  <a:pt x="621" y="3699"/>
                </a:cubicBezTo>
                <a:cubicBezTo>
                  <a:pt x="619" y="3686"/>
                  <a:pt x="612" y="3673"/>
                  <a:pt x="600" y="3662"/>
                </a:cubicBezTo>
                <a:cubicBezTo>
                  <a:pt x="589" y="3650"/>
                  <a:pt x="576" y="3643"/>
                  <a:pt x="562" y="3640"/>
                </a:cubicBezTo>
                <a:cubicBezTo>
                  <a:pt x="549" y="3637"/>
                  <a:pt x="535" y="3639"/>
                  <a:pt x="522" y="3646"/>
                </a:cubicBezTo>
                <a:cubicBezTo>
                  <a:pt x="509" y="3652"/>
                  <a:pt x="490" y="3668"/>
                  <a:pt x="466" y="3692"/>
                </a:cubicBezTo>
                <a:lnTo>
                  <a:pt x="399" y="3759"/>
                </a:lnTo>
                <a:lnTo>
                  <a:pt x="501" y="3861"/>
                </a:lnTo>
                <a:close/>
                <a:moveTo>
                  <a:pt x="656" y="4016"/>
                </a:moveTo>
                <a:lnTo>
                  <a:pt x="739" y="3932"/>
                </a:lnTo>
                <a:cubicBezTo>
                  <a:pt x="754" y="3918"/>
                  <a:pt x="763" y="3907"/>
                  <a:pt x="768" y="3900"/>
                </a:cubicBezTo>
                <a:cubicBezTo>
                  <a:pt x="777" y="3888"/>
                  <a:pt x="782" y="3877"/>
                  <a:pt x="785" y="3866"/>
                </a:cubicBezTo>
                <a:cubicBezTo>
                  <a:pt x="787" y="3854"/>
                  <a:pt x="787" y="3843"/>
                  <a:pt x="783" y="3830"/>
                </a:cubicBezTo>
                <a:cubicBezTo>
                  <a:pt x="779" y="3817"/>
                  <a:pt x="772" y="3806"/>
                  <a:pt x="761" y="3795"/>
                </a:cubicBezTo>
                <a:cubicBezTo>
                  <a:pt x="749" y="3782"/>
                  <a:pt x="735" y="3775"/>
                  <a:pt x="719" y="3772"/>
                </a:cubicBezTo>
                <a:cubicBezTo>
                  <a:pt x="703" y="3769"/>
                  <a:pt x="688" y="3771"/>
                  <a:pt x="673" y="3779"/>
                </a:cubicBezTo>
                <a:cubicBezTo>
                  <a:pt x="658" y="3787"/>
                  <a:pt x="639" y="3801"/>
                  <a:pt x="618" y="3823"/>
                </a:cubicBezTo>
                <a:lnTo>
                  <a:pt x="540" y="3900"/>
                </a:lnTo>
                <a:lnTo>
                  <a:pt x="656" y="4016"/>
                </a:lnTo>
                <a:close/>
                <a:moveTo>
                  <a:pt x="964" y="3787"/>
                </a:moveTo>
                <a:lnTo>
                  <a:pt x="628" y="3451"/>
                </a:lnTo>
                <a:lnTo>
                  <a:pt x="744" y="3335"/>
                </a:lnTo>
                <a:cubicBezTo>
                  <a:pt x="770" y="3309"/>
                  <a:pt x="791" y="3291"/>
                  <a:pt x="808" y="3280"/>
                </a:cubicBezTo>
                <a:cubicBezTo>
                  <a:pt x="832" y="3265"/>
                  <a:pt x="856" y="3257"/>
                  <a:pt x="882" y="3255"/>
                </a:cubicBezTo>
                <a:cubicBezTo>
                  <a:pt x="914" y="3252"/>
                  <a:pt x="947" y="3258"/>
                  <a:pt x="979" y="3273"/>
                </a:cubicBezTo>
                <a:cubicBezTo>
                  <a:pt x="1011" y="3287"/>
                  <a:pt x="1042" y="3309"/>
                  <a:pt x="1072" y="3339"/>
                </a:cubicBezTo>
                <a:cubicBezTo>
                  <a:pt x="1097" y="3365"/>
                  <a:pt x="1117" y="3390"/>
                  <a:pt x="1131" y="3416"/>
                </a:cubicBezTo>
                <a:cubicBezTo>
                  <a:pt x="1145" y="3442"/>
                  <a:pt x="1153" y="3466"/>
                  <a:pt x="1157" y="3488"/>
                </a:cubicBezTo>
                <a:cubicBezTo>
                  <a:pt x="1160" y="3510"/>
                  <a:pt x="1160" y="3531"/>
                  <a:pt x="1157" y="3549"/>
                </a:cubicBezTo>
                <a:cubicBezTo>
                  <a:pt x="1153" y="3568"/>
                  <a:pt x="1145" y="3587"/>
                  <a:pt x="1133" y="3606"/>
                </a:cubicBezTo>
                <a:cubicBezTo>
                  <a:pt x="1122" y="3626"/>
                  <a:pt x="1106" y="3646"/>
                  <a:pt x="1085" y="3666"/>
                </a:cubicBezTo>
                <a:lnTo>
                  <a:pt x="964" y="3787"/>
                </a:lnTo>
                <a:close/>
                <a:moveTo>
                  <a:pt x="969" y="3703"/>
                </a:moveTo>
                <a:lnTo>
                  <a:pt x="1041" y="3631"/>
                </a:lnTo>
                <a:cubicBezTo>
                  <a:pt x="1063" y="3609"/>
                  <a:pt x="1078" y="3590"/>
                  <a:pt x="1086" y="3573"/>
                </a:cubicBezTo>
                <a:cubicBezTo>
                  <a:pt x="1095" y="3556"/>
                  <a:pt x="1099" y="3540"/>
                  <a:pt x="1099" y="3525"/>
                </a:cubicBezTo>
                <a:cubicBezTo>
                  <a:pt x="1099" y="3504"/>
                  <a:pt x="1093" y="3482"/>
                  <a:pt x="1081" y="3458"/>
                </a:cubicBezTo>
                <a:cubicBezTo>
                  <a:pt x="1069" y="3434"/>
                  <a:pt x="1051" y="3410"/>
                  <a:pt x="1025" y="3385"/>
                </a:cubicBezTo>
                <a:cubicBezTo>
                  <a:pt x="990" y="3349"/>
                  <a:pt x="957" y="3328"/>
                  <a:pt x="927" y="3321"/>
                </a:cubicBezTo>
                <a:cubicBezTo>
                  <a:pt x="897" y="3313"/>
                  <a:pt x="870" y="3315"/>
                  <a:pt x="847" y="3325"/>
                </a:cubicBezTo>
                <a:cubicBezTo>
                  <a:pt x="831" y="3332"/>
                  <a:pt x="809" y="3349"/>
                  <a:pt x="783" y="3376"/>
                </a:cubicBezTo>
                <a:lnTo>
                  <a:pt x="712" y="3446"/>
                </a:lnTo>
                <a:lnTo>
                  <a:pt x="969" y="3703"/>
                </a:lnTo>
                <a:close/>
                <a:moveTo>
                  <a:pt x="1353" y="3584"/>
                </a:moveTo>
                <a:lnTo>
                  <a:pt x="1324" y="3555"/>
                </a:lnTo>
                <a:lnTo>
                  <a:pt x="1597" y="3281"/>
                </a:lnTo>
                <a:lnTo>
                  <a:pt x="1627" y="3311"/>
                </a:lnTo>
                <a:lnTo>
                  <a:pt x="1353" y="3584"/>
                </a:lnTo>
                <a:close/>
                <a:moveTo>
                  <a:pt x="1569" y="3182"/>
                </a:moveTo>
                <a:lnTo>
                  <a:pt x="1233" y="2846"/>
                </a:lnTo>
                <a:lnTo>
                  <a:pt x="1360" y="2719"/>
                </a:lnTo>
                <a:cubicBezTo>
                  <a:pt x="1382" y="2697"/>
                  <a:pt x="1400" y="2681"/>
                  <a:pt x="1414" y="2671"/>
                </a:cubicBezTo>
                <a:cubicBezTo>
                  <a:pt x="1434" y="2657"/>
                  <a:pt x="1453" y="2649"/>
                  <a:pt x="1471" y="2645"/>
                </a:cubicBezTo>
                <a:cubicBezTo>
                  <a:pt x="1490" y="2642"/>
                  <a:pt x="1510" y="2644"/>
                  <a:pt x="1531" y="2651"/>
                </a:cubicBezTo>
                <a:cubicBezTo>
                  <a:pt x="1552" y="2658"/>
                  <a:pt x="1570" y="2670"/>
                  <a:pt x="1587" y="2686"/>
                </a:cubicBezTo>
                <a:cubicBezTo>
                  <a:pt x="1615" y="2715"/>
                  <a:pt x="1631" y="2748"/>
                  <a:pt x="1632" y="2786"/>
                </a:cubicBezTo>
                <a:cubicBezTo>
                  <a:pt x="1634" y="2824"/>
                  <a:pt x="1611" y="2867"/>
                  <a:pt x="1563" y="2915"/>
                </a:cubicBezTo>
                <a:lnTo>
                  <a:pt x="1477" y="3001"/>
                </a:lnTo>
                <a:lnTo>
                  <a:pt x="1614" y="3137"/>
                </a:lnTo>
                <a:lnTo>
                  <a:pt x="1569" y="3182"/>
                </a:lnTo>
                <a:close/>
                <a:moveTo>
                  <a:pt x="1437" y="2961"/>
                </a:moveTo>
                <a:lnTo>
                  <a:pt x="1524" y="2874"/>
                </a:lnTo>
                <a:cubicBezTo>
                  <a:pt x="1553" y="2845"/>
                  <a:pt x="1568" y="2820"/>
                  <a:pt x="1569" y="2797"/>
                </a:cubicBezTo>
                <a:cubicBezTo>
                  <a:pt x="1571" y="2774"/>
                  <a:pt x="1562" y="2753"/>
                  <a:pt x="1542" y="2734"/>
                </a:cubicBezTo>
                <a:cubicBezTo>
                  <a:pt x="1528" y="2720"/>
                  <a:pt x="1513" y="2711"/>
                  <a:pt x="1496" y="2708"/>
                </a:cubicBezTo>
                <a:cubicBezTo>
                  <a:pt x="1479" y="2705"/>
                  <a:pt x="1463" y="2708"/>
                  <a:pt x="1448" y="2716"/>
                </a:cubicBezTo>
                <a:cubicBezTo>
                  <a:pt x="1438" y="2722"/>
                  <a:pt x="1423" y="2735"/>
                  <a:pt x="1403" y="2755"/>
                </a:cubicBezTo>
                <a:lnTo>
                  <a:pt x="1317" y="2841"/>
                </a:lnTo>
                <a:lnTo>
                  <a:pt x="1437" y="2961"/>
                </a:lnTo>
                <a:close/>
                <a:moveTo>
                  <a:pt x="1881" y="2870"/>
                </a:moveTo>
                <a:lnTo>
                  <a:pt x="1545" y="2534"/>
                </a:lnTo>
                <a:lnTo>
                  <a:pt x="1788" y="2291"/>
                </a:lnTo>
                <a:lnTo>
                  <a:pt x="1828" y="2330"/>
                </a:lnTo>
                <a:lnTo>
                  <a:pt x="1629" y="2529"/>
                </a:lnTo>
                <a:lnTo>
                  <a:pt x="1732" y="2632"/>
                </a:lnTo>
                <a:lnTo>
                  <a:pt x="1918" y="2446"/>
                </a:lnTo>
                <a:lnTo>
                  <a:pt x="1958" y="2485"/>
                </a:lnTo>
                <a:lnTo>
                  <a:pt x="1772" y="2671"/>
                </a:lnTo>
                <a:lnTo>
                  <a:pt x="1886" y="2786"/>
                </a:lnTo>
                <a:lnTo>
                  <a:pt x="2092" y="2579"/>
                </a:lnTo>
                <a:lnTo>
                  <a:pt x="2132" y="2619"/>
                </a:lnTo>
                <a:lnTo>
                  <a:pt x="1881" y="2870"/>
                </a:lnTo>
                <a:close/>
                <a:moveTo>
                  <a:pt x="2163" y="2588"/>
                </a:moveTo>
                <a:lnTo>
                  <a:pt x="2118" y="2283"/>
                </a:lnTo>
                <a:lnTo>
                  <a:pt x="1842" y="2237"/>
                </a:lnTo>
                <a:lnTo>
                  <a:pt x="1895" y="2184"/>
                </a:lnTo>
                <a:lnTo>
                  <a:pt x="2042" y="2209"/>
                </a:lnTo>
                <a:cubicBezTo>
                  <a:pt x="2073" y="2214"/>
                  <a:pt x="2096" y="2219"/>
                  <a:pt x="2111" y="2223"/>
                </a:cubicBezTo>
                <a:cubicBezTo>
                  <a:pt x="2106" y="2203"/>
                  <a:pt x="2102" y="2182"/>
                  <a:pt x="2099" y="2158"/>
                </a:cubicBezTo>
                <a:lnTo>
                  <a:pt x="2077" y="2001"/>
                </a:lnTo>
                <a:lnTo>
                  <a:pt x="2126" y="1953"/>
                </a:lnTo>
                <a:lnTo>
                  <a:pt x="2166" y="2230"/>
                </a:lnTo>
                <a:lnTo>
                  <a:pt x="2471" y="2280"/>
                </a:lnTo>
                <a:lnTo>
                  <a:pt x="2416" y="2335"/>
                </a:lnTo>
                <a:lnTo>
                  <a:pt x="2212" y="2300"/>
                </a:lnTo>
                <a:cubicBezTo>
                  <a:pt x="2200" y="2298"/>
                  <a:pt x="2188" y="2295"/>
                  <a:pt x="2174" y="2292"/>
                </a:cubicBezTo>
                <a:cubicBezTo>
                  <a:pt x="2179" y="2312"/>
                  <a:pt x="2182" y="2325"/>
                  <a:pt x="2184" y="2333"/>
                </a:cubicBezTo>
                <a:lnTo>
                  <a:pt x="2216" y="2535"/>
                </a:lnTo>
                <a:lnTo>
                  <a:pt x="2163" y="2588"/>
                </a:lnTo>
                <a:close/>
                <a:moveTo>
                  <a:pt x="2647" y="2104"/>
                </a:moveTo>
                <a:lnTo>
                  <a:pt x="2606" y="2145"/>
                </a:lnTo>
                <a:lnTo>
                  <a:pt x="2343" y="1882"/>
                </a:lnTo>
                <a:cubicBezTo>
                  <a:pt x="2342" y="1902"/>
                  <a:pt x="2339" y="1924"/>
                  <a:pt x="2332" y="1950"/>
                </a:cubicBezTo>
                <a:cubicBezTo>
                  <a:pt x="2325" y="1976"/>
                  <a:pt x="2318" y="1997"/>
                  <a:pt x="2310" y="2015"/>
                </a:cubicBezTo>
                <a:lnTo>
                  <a:pt x="2270" y="1975"/>
                </a:lnTo>
                <a:cubicBezTo>
                  <a:pt x="2282" y="1941"/>
                  <a:pt x="2289" y="1908"/>
                  <a:pt x="2291" y="1875"/>
                </a:cubicBezTo>
                <a:cubicBezTo>
                  <a:pt x="2293" y="1842"/>
                  <a:pt x="2290" y="1815"/>
                  <a:pt x="2283" y="1793"/>
                </a:cubicBezTo>
                <a:lnTo>
                  <a:pt x="2310" y="1767"/>
                </a:lnTo>
                <a:lnTo>
                  <a:pt x="2647" y="2104"/>
                </a:lnTo>
                <a:close/>
                <a:moveTo>
                  <a:pt x="2779" y="1972"/>
                </a:moveTo>
                <a:lnTo>
                  <a:pt x="2567" y="1761"/>
                </a:lnTo>
                <a:lnTo>
                  <a:pt x="2531" y="1797"/>
                </a:lnTo>
                <a:lnTo>
                  <a:pt x="2499" y="1765"/>
                </a:lnTo>
                <a:lnTo>
                  <a:pt x="2535" y="1729"/>
                </a:lnTo>
                <a:lnTo>
                  <a:pt x="2509" y="1703"/>
                </a:lnTo>
                <a:cubicBezTo>
                  <a:pt x="2493" y="1687"/>
                  <a:pt x="2482" y="1673"/>
                  <a:pt x="2477" y="1662"/>
                </a:cubicBezTo>
                <a:cubicBezTo>
                  <a:pt x="2471" y="1647"/>
                  <a:pt x="2469" y="1632"/>
                  <a:pt x="2472" y="1615"/>
                </a:cubicBezTo>
                <a:cubicBezTo>
                  <a:pt x="2476" y="1598"/>
                  <a:pt x="2486" y="1581"/>
                  <a:pt x="2504" y="1563"/>
                </a:cubicBezTo>
                <a:cubicBezTo>
                  <a:pt x="2516" y="1551"/>
                  <a:pt x="2530" y="1540"/>
                  <a:pt x="2547" y="1529"/>
                </a:cubicBezTo>
                <a:lnTo>
                  <a:pt x="2577" y="1571"/>
                </a:lnTo>
                <a:cubicBezTo>
                  <a:pt x="2567" y="1578"/>
                  <a:pt x="2558" y="1585"/>
                  <a:pt x="2550" y="1593"/>
                </a:cubicBezTo>
                <a:cubicBezTo>
                  <a:pt x="2538" y="1605"/>
                  <a:pt x="2531" y="1617"/>
                  <a:pt x="2532" y="1628"/>
                </a:cubicBezTo>
                <a:cubicBezTo>
                  <a:pt x="2532" y="1638"/>
                  <a:pt x="2539" y="1651"/>
                  <a:pt x="2554" y="1665"/>
                </a:cubicBezTo>
                <a:lnTo>
                  <a:pt x="2576" y="1688"/>
                </a:lnTo>
                <a:lnTo>
                  <a:pt x="2624" y="1640"/>
                </a:lnTo>
                <a:lnTo>
                  <a:pt x="2656" y="1672"/>
                </a:lnTo>
                <a:lnTo>
                  <a:pt x="2608" y="1720"/>
                </a:lnTo>
                <a:lnTo>
                  <a:pt x="2820" y="1931"/>
                </a:lnTo>
                <a:lnTo>
                  <a:pt x="2779" y="1972"/>
                </a:lnTo>
                <a:close/>
                <a:moveTo>
                  <a:pt x="2810" y="1796"/>
                </a:moveTo>
                <a:lnTo>
                  <a:pt x="2844" y="1749"/>
                </a:lnTo>
                <a:cubicBezTo>
                  <a:pt x="2863" y="1763"/>
                  <a:pt x="2882" y="1769"/>
                  <a:pt x="2901" y="1767"/>
                </a:cubicBezTo>
                <a:cubicBezTo>
                  <a:pt x="2920" y="1765"/>
                  <a:pt x="2939" y="1755"/>
                  <a:pt x="2958" y="1736"/>
                </a:cubicBezTo>
                <a:cubicBezTo>
                  <a:pt x="2977" y="1717"/>
                  <a:pt x="2987" y="1699"/>
                  <a:pt x="2989" y="1683"/>
                </a:cubicBezTo>
                <a:cubicBezTo>
                  <a:pt x="2990" y="1666"/>
                  <a:pt x="2985" y="1652"/>
                  <a:pt x="2975" y="1642"/>
                </a:cubicBezTo>
                <a:cubicBezTo>
                  <a:pt x="2966" y="1632"/>
                  <a:pt x="2954" y="1629"/>
                  <a:pt x="2941" y="1632"/>
                </a:cubicBezTo>
                <a:cubicBezTo>
                  <a:pt x="2932" y="1634"/>
                  <a:pt x="2913" y="1643"/>
                  <a:pt x="2885" y="1660"/>
                </a:cubicBezTo>
                <a:cubicBezTo>
                  <a:pt x="2847" y="1683"/>
                  <a:pt x="2819" y="1697"/>
                  <a:pt x="2802" y="1703"/>
                </a:cubicBezTo>
                <a:cubicBezTo>
                  <a:pt x="2785" y="1709"/>
                  <a:pt x="2768" y="1710"/>
                  <a:pt x="2752" y="1707"/>
                </a:cubicBezTo>
                <a:cubicBezTo>
                  <a:pt x="2736" y="1703"/>
                  <a:pt x="2722" y="1695"/>
                  <a:pt x="2711" y="1683"/>
                </a:cubicBezTo>
                <a:cubicBezTo>
                  <a:pt x="2700" y="1672"/>
                  <a:pt x="2692" y="1660"/>
                  <a:pt x="2688" y="1645"/>
                </a:cubicBezTo>
                <a:cubicBezTo>
                  <a:pt x="2684" y="1631"/>
                  <a:pt x="2683" y="1617"/>
                  <a:pt x="2685" y="1602"/>
                </a:cubicBezTo>
                <a:cubicBezTo>
                  <a:pt x="2687" y="1591"/>
                  <a:pt x="2692" y="1578"/>
                  <a:pt x="2699" y="1564"/>
                </a:cubicBezTo>
                <a:cubicBezTo>
                  <a:pt x="2707" y="1549"/>
                  <a:pt x="2717" y="1536"/>
                  <a:pt x="2730" y="1523"/>
                </a:cubicBezTo>
                <a:cubicBezTo>
                  <a:pt x="2749" y="1504"/>
                  <a:pt x="2769" y="1490"/>
                  <a:pt x="2789" y="1481"/>
                </a:cubicBezTo>
                <a:cubicBezTo>
                  <a:pt x="2809" y="1472"/>
                  <a:pt x="2827" y="1469"/>
                  <a:pt x="2843" y="1471"/>
                </a:cubicBezTo>
                <a:cubicBezTo>
                  <a:pt x="2859" y="1474"/>
                  <a:pt x="2877" y="1482"/>
                  <a:pt x="2895" y="1495"/>
                </a:cubicBezTo>
                <a:lnTo>
                  <a:pt x="2860" y="1541"/>
                </a:lnTo>
                <a:cubicBezTo>
                  <a:pt x="2846" y="1530"/>
                  <a:pt x="2831" y="1526"/>
                  <a:pt x="2815" y="1527"/>
                </a:cubicBezTo>
                <a:cubicBezTo>
                  <a:pt x="2799" y="1529"/>
                  <a:pt x="2783" y="1538"/>
                  <a:pt x="2767" y="1554"/>
                </a:cubicBezTo>
                <a:cubicBezTo>
                  <a:pt x="2748" y="1573"/>
                  <a:pt x="2738" y="1590"/>
                  <a:pt x="2736" y="1604"/>
                </a:cubicBezTo>
                <a:cubicBezTo>
                  <a:pt x="2734" y="1618"/>
                  <a:pt x="2737" y="1630"/>
                  <a:pt x="2746" y="1638"/>
                </a:cubicBezTo>
                <a:cubicBezTo>
                  <a:pt x="2751" y="1644"/>
                  <a:pt x="2757" y="1647"/>
                  <a:pt x="2765" y="1648"/>
                </a:cubicBezTo>
                <a:cubicBezTo>
                  <a:pt x="2773" y="1649"/>
                  <a:pt x="2782" y="1647"/>
                  <a:pt x="2792" y="1643"/>
                </a:cubicBezTo>
                <a:cubicBezTo>
                  <a:pt x="2798" y="1640"/>
                  <a:pt x="2813" y="1632"/>
                  <a:pt x="2839" y="1617"/>
                </a:cubicBezTo>
                <a:cubicBezTo>
                  <a:pt x="2876" y="1595"/>
                  <a:pt x="2903" y="1581"/>
                  <a:pt x="2919" y="1575"/>
                </a:cubicBezTo>
                <a:cubicBezTo>
                  <a:pt x="2936" y="1568"/>
                  <a:pt x="2952" y="1567"/>
                  <a:pt x="2968" y="1569"/>
                </a:cubicBezTo>
                <a:cubicBezTo>
                  <a:pt x="2984" y="1572"/>
                  <a:pt x="2999" y="1581"/>
                  <a:pt x="3013" y="1595"/>
                </a:cubicBezTo>
                <a:cubicBezTo>
                  <a:pt x="3027" y="1609"/>
                  <a:pt x="3036" y="1626"/>
                  <a:pt x="3040" y="1646"/>
                </a:cubicBezTo>
                <a:cubicBezTo>
                  <a:pt x="3044" y="1666"/>
                  <a:pt x="3042" y="1687"/>
                  <a:pt x="3033" y="1709"/>
                </a:cubicBezTo>
                <a:cubicBezTo>
                  <a:pt x="3025" y="1730"/>
                  <a:pt x="3011" y="1751"/>
                  <a:pt x="2992" y="1770"/>
                </a:cubicBezTo>
                <a:cubicBezTo>
                  <a:pt x="2960" y="1802"/>
                  <a:pt x="2930" y="1819"/>
                  <a:pt x="2900" y="1823"/>
                </a:cubicBezTo>
                <a:cubicBezTo>
                  <a:pt x="2870" y="1826"/>
                  <a:pt x="2840" y="1817"/>
                  <a:pt x="2810" y="1796"/>
                </a:cubicBezTo>
                <a:close/>
                <a:moveTo>
                  <a:pt x="3302" y="1369"/>
                </a:moveTo>
                <a:lnTo>
                  <a:pt x="3342" y="1409"/>
                </a:lnTo>
                <a:lnTo>
                  <a:pt x="3120" y="1631"/>
                </a:lnTo>
                <a:cubicBezTo>
                  <a:pt x="3110" y="1622"/>
                  <a:pt x="3102" y="1610"/>
                  <a:pt x="3096" y="1598"/>
                </a:cubicBezTo>
                <a:cubicBezTo>
                  <a:pt x="3087" y="1577"/>
                  <a:pt x="3081" y="1553"/>
                  <a:pt x="3078" y="1526"/>
                </a:cubicBezTo>
                <a:cubicBezTo>
                  <a:pt x="3076" y="1499"/>
                  <a:pt x="3077" y="1464"/>
                  <a:pt x="3082" y="1421"/>
                </a:cubicBezTo>
                <a:cubicBezTo>
                  <a:pt x="3088" y="1355"/>
                  <a:pt x="3089" y="1306"/>
                  <a:pt x="3084" y="1276"/>
                </a:cubicBezTo>
                <a:cubicBezTo>
                  <a:pt x="3080" y="1245"/>
                  <a:pt x="3070" y="1222"/>
                  <a:pt x="3054" y="1207"/>
                </a:cubicBezTo>
                <a:cubicBezTo>
                  <a:pt x="3038" y="1191"/>
                  <a:pt x="3018" y="1183"/>
                  <a:pt x="2995" y="1183"/>
                </a:cubicBezTo>
                <a:cubicBezTo>
                  <a:pt x="2972" y="1183"/>
                  <a:pt x="2951" y="1193"/>
                  <a:pt x="2933" y="1212"/>
                </a:cubicBezTo>
                <a:cubicBezTo>
                  <a:pt x="2913" y="1232"/>
                  <a:pt x="2903" y="1254"/>
                  <a:pt x="2903" y="1277"/>
                </a:cubicBezTo>
                <a:cubicBezTo>
                  <a:pt x="2903" y="1301"/>
                  <a:pt x="2913" y="1324"/>
                  <a:pt x="2934" y="1345"/>
                </a:cubicBezTo>
                <a:lnTo>
                  <a:pt x="2887" y="1383"/>
                </a:lnTo>
                <a:cubicBezTo>
                  <a:pt x="2859" y="1349"/>
                  <a:pt x="2845" y="1314"/>
                  <a:pt x="2848" y="1278"/>
                </a:cubicBezTo>
                <a:cubicBezTo>
                  <a:pt x="2850" y="1243"/>
                  <a:pt x="2867" y="1209"/>
                  <a:pt x="2899" y="1177"/>
                </a:cubicBezTo>
                <a:cubicBezTo>
                  <a:pt x="2932" y="1145"/>
                  <a:pt x="2966" y="1128"/>
                  <a:pt x="3003" y="1127"/>
                </a:cubicBezTo>
                <a:cubicBezTo>
                  <a:pt x="3039" y="1126"/>
                  <a:pt x="3071" y="1139"/>
                  <a:pt x="3097" y="1165"/>
                </a:cubicBezTo>
                <a:cubicBezTo>
                  <a:pt x="3111" y="1179"/>
                  <a:pt x="3121" y="1195"/>
                  <a:pt x="3129" y="1213"/>
                </a:cubicBezTo>
                <a:cubicBezTo>
                  <a:pt x="3136" y="1232"/>
                  <a:pt x="3141" y="1255"/>
                  <a:pt x="3142" y="1282"/>
                </a:cubicBezTo>
                <a:cubicBezTo>
                  <a:pt x="3144" y="1309"/>
                  <a:pt x="3143" y="1350"/>
                  <a:pt x="3138" y="1404"/>
                </a:cubicBezTo>
                <a:cubicBezTo>
                  <a:pt x="3134" y="1450"/>
                  <a:pt x="3132" y="1480"/>
                  <a:pt x="3133" y="1494"/>
                </a:cubicBezTo>
                <a:cubicBezTo>
                  <a:pt x="3133" y="1509"/>
                  <a:pt x="3135" y="1522"/>
                  <a:pt x="3137" y="1534"/>
                </a:cubicBezTo>
                <a:lnTo>
                  <a:pt x="3302" y="1369"/>
                </a:lnTo>
                <a:close/>
                <a:moveTo>
                  <a:pt x="3238" y="935"/>
                </a:moveTo>
                <a:lnTo>
                  <a:pt x="3191" y="888"/>
                </a:lnTo>
                <a:lnTo>
                  <a:pt x="3232" y="847"/>
                </a:lnTo>
                <a:lnTo>
                  <a:pt x="3280" y="894"/>
                </a:lnTo>
                <a:lnTo>
                  <a:pt x="3238" y="935"/>
                </a:lnTo>
                <a:close/>
                <a:moveTo>
                  <a:pt x="3527" y="1224"/>
                </a:moveTo>
                <a:lnTo>
                  <a:pt x="3284" y="980"/>
                </a:lnTo>
                <a:lnTo>
                  <a:pt x="3325" y="939"/>
                </a:lnTo>
                <a:lnTo>
                  <a:pt x="3568" y="1183"/>
                </a:lnTo>
                <a:lnTo>
                  <a:pt x="3527" y="1224"/>
                </a:lnTo>
                <a:close/>
                <a:moveTo>
                  <a:pt x="3640" y="1111"/>
                </a:moveTo>
                <a:lnTo>
                  <a:pt x="3304" y="775"/>
                </a:lnTo>
                <a:lnTo>
                  <a:pt x="3430" y="649"/>
                </a:lnTo>
                <a:cubicBezTo>
                  <a:pt x="3453" y="626"/>
                  <a:pt x="3471" y="610"/>
                  <a:pt x="3485" y="601"/>
                </a:cubicBezTo>
                <a:cubicBezTo>
                  <a:pt x="3504" y="587"/>
                  <a:pt x="3523" y="578"/>
                  <a:pt x="3542" y="575"/>
                </a:cubicBezTo>
                <a:cubicBezTo>
                  <a:pt x="3561" y="571"/>
                  <a:pt x="3581" y="573"/>
                  <a:pt x="3601" y="580"/>
                </a:cubicBezTo>
                <a:cubicBezTo>
                  <a:pt x="3622" y="587"/>
                  <a:pt x="3641" y="599"/>
                  <a:pt x="3657" y="616"/>
                </a:cubicBezTo>
                <a:cubicBezTo>
                  <a:pt x="3686" y="645"/>
                  <a:pt x="3701" y="678"/>
                  <a:pt x="3703" y="716"/>
                </a:cubicBezTo>
                <a:cubicBezTo>
                  <a:pt x="3704" y="754"/>
                  <a:pt x="3681" y="797"/>
                  <a:pt x="3634" y="844"/>
                </a:cubicBezTo>
                <a:lnTo>
                  <a:pt x="3547" y="930"/>
                </a:lnTo>
                <a:lnTo>
                  <a:pt x="3684" y="1067"/>
                </a:lnTo>
                <a:lnTo>
                  <a:pt x="3640" y="1111"/>
                </a:lnTo>
                <a:close/>
                <a:moveTo>
                  <a:pt x="3508" y="891"/>
                </a:moveTo>
                <a:lnTo>
                  <a:pt x="3595" y="804"/>
                </a:lnTo>
                <a:cubicBezTo>
                  <a:pt x="3623" y="775"/>
                  <a:pt x="3639" y="749"/>
                  <a:pt x="3640" y="726"/>
                </a:cubicBezTo>
                <a:cubicBezTo>
                  <a:pt x="3641" y="704"/>
                  <a:pt x="3632" y="683"/>
                  <a:pt x="3613" y="663"/>
                </a:cubicBezTo>
                <a:cubicBezTo>
                  <a:pt x="3599" y="649"/>
                  <a:pt x="3583" y="641"/>
                  <a:pt x="3566" y="638"/>
                </a:cubicBezTo>
                <a:cubicBezTo>
                  <a:pt x="3549" y="635"/>
                  <a:pt x="3533" y="638"/>
                  <a:pt x="3518" y="646"/>
                </a:cubicBezTo>
                <a:cubicBezTo>
                  <a:pt x="3509" y="652"/>
                  <a:pt x="3494" y="664"/>
                  <a:pt x="3474" y="685"/>
                </a:cubicBezTo>
                <a:lnTo>
                  <a:pt x="3388" y="771"/>
                </a:lnTo>
                <a:lnTo>
                  <a:pt x="3508" y="891"/>
                </a:lnTo>
                <a:close/>
                <a:moveTo>
                  <a:pt x="3828" y="707"/>
                </a:moveTo>
                <a:lnTo>
                  <a:pt x="3866" y="662"/>
                </a:lnTo>
                <a:cubicBezTo>
                  <a:pt x="3885" y="677"/>
                  <a:pt x="3903" y="686"/>
                  <a:pt x="3921" y="689"/>
                </a:cubicBezTo>
                <a:cubicBezTo>
                  <a:pt x="3939" y="693"/>
                  <a:pt x="3959" y="690"/>
                  <a:pt x="3981" y="682"/>
                </a:cubicBezTo>
                <a:cubicBezTo>
                  <a:pt x="4003" y="673"/>
                  <a:pt x="4024" y="659"/>
                  <a:pt x="4043" y="640"/>
                </a:cubicBezTo>
                <a:cubicBezTo>
                  <a:pt x="4060" y="623"/>
                  <a:pt x="4072" y="606"/>
                  <a:pt x="4080" y="588"/>
                </a:cubicBezTo>
                <a:cubicBezTo>
                  <a:pt x="4088" y="570"/>
                  <a:pt x="4091" y="553"/>
                  <a:pt x="4088" y="538"/>
                </a:cubicBezTo>
                <a:cubicBezTo>
                  <a:pt x="4086" y="523"/>
                  <a:pt x="4079" y="510"/>
                  <a:pt x="4069" y="500"/>
                </a:cubicBezTo>
                <a:cubicBezTo>
                  <a:pt x="4059" y="489"/>
                  <a:pt x="4046" y="483"/>
                  <a:pt x="4032" y="481"/>
                </a:cubicBezTo>
                <a:cubicBezTo>
                  <a:pt x="4018" y="479"/>
                  <a:pt x="4002" y="483"/>
                  <a:pt x="3982" y="491"/>
                </a:cubicBezTo>
                <a:cubicBezTo>
                  <a:pt x="3970" y="497"/>
                  <a:pt x="3944" y="511"/>
                  <a:pt x="3906" y="535"/>
                </a:cubicBezTo>
                <a:cubicBezTo>
                  <a:pt x="3868" y="558"/>
                  <a:pt x="3839" y="573"/>
                  <a:pt x="3820" y="579"/>
                </a:cubicBezTo>
                <a:cubicBezTo>
                  <a:pt x="3796" y="586"/>
                  <a:pt x="3773" y="588"/>
                  <a:pt x="3753" y="583"/>
                </a:cubicBezTo>
                <a:cubicBezTo>
                  <a:pt x="3733" y="579"/>
                  <a:pt x="3715" y="569"/>
                  <a:pt x="3699" y="553"/>
                </a:cubicBezTo>
                <a:cubicBezTo>
                  <a:pt x="3682" y="536"/>
                  <a:pt x="3671" y="516"/>
                  <a:pt x="3666" y="491"/>
                </a:cubicBezTo>
                <a:cubicBezTo>
                  <a:pt x="3661" y="467"/>
                  <a:pt x="3664" y="442"/>
                  <a:pt x="3675" y="416"/>
                </a:cubicBezTo>
                <a:cubicBezTo>
                  <a:pt x="3686" y="389"/>
                  <a:pt x="3702" y="365"/>
                  <a:pt x="3725" y="342"/>
                </a:cubicBezTo>
                <a:cubicBezTo>
                  <a:pt x="3750" y="318"/>
                  <a:pt x="3776" y="300"/>
                  <a:pt x="3803" y="289"/>
                </a:cubicBezTo>
                <a:cubicBezTo>
                  <a:pt x="3830" y="278"/>
                  <a:pt x="3856" y="275"/>
                  <a:pt x="3882" y="280"/>
                </a:cubicBezTo>
                <a:cubicBezTo>
                  <a:pt x="3908" y="285"/>
                  <a:pt x="3931" y="298"/>
                  <a:pt x="3952" y="317"/>
                </a:cubicBezTo>
                <a:lnTo>
                  <a:pt x="3912" y="362"/>
                </a:lnTo>
                <a:cubicBezTo>
                  <a:pt x="3889" y="343"/>
                  <a:pt x="3865" y="335"/>
                  <a:pt x="3841" y="338"/>
                </a:cubicBezTo>
                <a:cubicBezTo>
                  <a:pt x="3817" y="340"/>
                  <a:pt x="3792" y="354"/>
                  <a:pt x="3766" y="380"/>
                </a:cubicBezTo>
                <a:cubicBezTo>
                  <a:pt x="3739" y="407"/>
                  <a:pt x="3724" y="431"/>
                  <a:pt x="3722" y="453"/>
                </a:cubicBezTo>
                <a:cubicBezTo>
                  <a:pt x="3720" y="476"/>
                  <a:pt x="3725" y="494"/>
                  <a:pt x="3739" y="508"/>
                </a:cubicBezTo>
                <a:cubicBezTo>
                  <a:pt x="3751" y="520"/>
                  <a:pt x="3766" y="525"/>
                  <a:pt x="3782" y="524"/>
                </a:cubicBezTo>
                <a:cubicBezTo>
                  <a:pt x="3798" y="524"/>
                  <a:pt x="3829" y="509"/>
                  <a:pt x="3873" y="481"/>
                </a:cubicBezTo>
                <a:cubicBezTo>
                  <a:pt x="3917" y="453"/>
                  <a:pt x="3949" y="436"/>
                  <a:pt x="3969" y="428"/>
                </a:cubicBezTo>
                <a:cubicBezTo>
                  <a:pt x="3997" y="418"/>
                  <a:pt x="4023" y="415"/>
                  <a:pt x="4046" y="419"/>
                </a:cubicBezTo>
                <a:cubicBezTo>
                  <a:pt x="4070" y="424"/>
                  <a:pt x="4090" y="435"/>
                  <a:pt x="4108" y="453"/>
                </a:cubicBezTo>
                <a:cubicBezTo>
                  <a:pt x="4126" y="471"/>
                  <a:pt x="4138" y="493"/>
                  <a:pt x="4143" y="519"/>
                </a:cubicBezTo>
                <a:cubicBezTo>
                  <a:pt x="4149" y="545"/>
                  <a:pt x="4147" y="572"/>
                  <a:pt x="4136" y="600"/>
                </a:cubicBezTo>
                <a:cubicBezTo>
                  <a:pt x="4126" y="628"/>
                  <a:pt x="4109" y="654"/>
                  <a:pt x="4085" y="678"/>
                </a:cubicBezTo>
                <a:cubicBezTo>
                  <a:pt x="4054" y="708"/>
                  <a:pt x="4024" y="729"/>
                  <a:pt x="3995" y="741"/>
                </a:cubicBezTo>
                <a:cubicBezTo>
                  <a:pt x="3965" y="753"/>
                  <a:pt x="3936" y="756"/>
                  <a:pt x="3907" y="749"/>
                </a:cubicBezTo>
                <a:cubicBezTo>
                  <a:pt x="3877" y="743"/>
                  <a:pt x="3851" y="729"/>
                  <a:pt x="3828" y="707"/>
                </a:cubicBezTo>
                <a:close/>
                <a:moveTo>
                  <a:pt x="4428" y="244"/>
                </a:moveTo>
                <a:lnTo>
                  <a:pt x="4468" y="283"/>
                </a:lnTo>
                <a:lnTo>
                  <a:pt x="4246" y="506"/>
                </a:lnTo>
                <a:cubicBezTo>
                  <a:pt x="4235" y="496"/>
                  <a:pt x="4227" y="485"/>
                  <a:pt x="4222" y="472"/>
                </a:cubicBezTo>
                <a:cubicBezTo>
                  <a:pt x="4212" y="451"/>
                  <a:pt x="4206" y="427"/>
                  <a:pt x="4204" y="400"/>
                </a:cubicBezTo>
                <a:cubicBezTo>
                  <a:pt x="4202" y="373"/>
                  <a:pt x="4203" y="338"/>
                  <a:pt x="4207" y="295"/>
                </a:cubicBezTo>
                <a:cubicBezTo>
                  <a:pt x="4214" y="229"/>
                  <a:pt x="4215" y="180"/>
                  <a:pt x="4210" y="150"/>
                </a:cubicBezTo>
                <a:cubicBezTo>
                  <a:pt x="4205" y="120"/>
                  <a:pt x="4195" y="97"/>
                  <a:pt x="4180" y="81"/>
                </a:cubicBezTo>
                <a:cubicBezTo>
                  <a:pt x="4163" y="65"/>
                  <a:pt x="4144" y="57"/>
                  <a:pt x="4121" y="57"/>
                </a:cubicBezTo>
                <a:cubicBezTo>
                  <a:pt x="4098" y="58"/>
                  <a:pt x="4077" y="67"/>
                  <a:pt x="4058" y="86"/>
                </a:cubicBezTo>
                <a:cubicBezTo>
                  <a:pt x="4038" y="106"/>
                  <a:pt x="4028" y="128"/>
                  <a:pt x="4028" y="152"/>
                </a:cubicBezTo>
                <a:cubicBezTo>
                  <a:pt x="4028" y="176"/>
                  <a:pt x="4039" y="198"/>
                  <a:pt x="4060" y="219"/>
                </a:cubicBezTo>
                <a:lnTo>
                  <a:pt x="4013" y="257"/>
                </a:lnTo>
                <a:cubicBezTo>
                  <a:pt x="3984" y="223"/>
                  <a:pt x="3971" y="188"/>
                  <a:pt x="3974" y="152"/>
                </a:cubicBezTo>
                <a:cubicBezTo>
                  <a:pt x="3976" y="117"/>
                  <a:pt x="3993" y="83"/>
                  <a:pt x="4025" y="51"/>
                </a:cubicBezTo>
                <a:cubicBezTo>
                  <a:pt x="4057" y="19"/>
                  <a:pt x="4092" y="2"/>
                  <a:pt x="4128" y="1"/>
                </a:cubicBezTo>
                <a:cubicBezTo>
                  <a:pt x="4165" y="0"/>
                  <a:pt x="4197" y="13"/>
                  <a:pt x="4223" y="40"/>
                </a:cubicBezTo>
                <a:cubicBezTo>
                  <a:pt x="4237" y="53"/>
                  <a:pt x="4247" y="69"/>
                  <a:pt x="4254" y="88"/>
                </a:cubicBezTo>
                <a:cubicBezTo>
                  <a:pt x="4262" y="106"/>
                  <a:pt x="4267" y="129"/>
                  <a:pt x="4268" y="156"/>
                </a:cubicBezTo>
                <a:cubicBezTo>
                  <a:pt x="4270" y="183"/>
                  <a:pt x="4268" y="224"/>
                  <a:pt x="4264" y="279"/>
                </a:cubicBezTo>
                <a:cubicBezTo>
                  <a:pt x="4260" y="324"/>
                  <a:pt x="4258" y="354"/>
                  <a:pt x="4258" y="369"/>
                </a:cubicBezTo>
                <a:cubicBezTo>
                  <a:pt x="4259" y="383"/>
                  <a:pt x="4260" y="396"/>
                  <a:pt x="4263" y="409"/>
                </a:cubicBezTo>
                <a:lnTo>
                  <a:pt x="4428" y="244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88" name="Freeform 70"/>
          <p:cNvSpPr>
            <a:spLocks noEditPoints="1"/>
          </p:cNvSpPr>
          <p:nvPr/>
        </p:nvSpPr>
        <p:spPr bwMode="auto">
          <a:xfrm>
            <a:off x="3246615" y="4611475"/>
            <a:ext cx="839787" cy="839787"/>
          </a:xfrm>
          <a:custGeom>
            <a:avLst/>
            <a:gdLst>
              <a:gd name="T0" fmla="*/ 239 w 4407"/>
              <a:gd name="T1" fmla="*/ 3871 h 4408"/>
              <a:gd name="T2" fmla="*/ 244 w 4407"/>
              <a:gd name="T3" fmla="*/ 4227 h 4408"/>
              <a:gd name="T4" fmla="*/ 337 w 4407"/>
              <a:gd name="T5" fmla="*/ 4023 h 4408"/>
              <a:gd name="T6" fmla="*/ 85 w 4407"/>
              <a:gd name="T7" fmla="*/ 4067 h 4408"/>
              <a:gd name="T8" fmla="*/ 513 w 4407"/>
              <a:gd name="T9" fmla="*/ 3579 h 4408"/>
              <a:gd name="T10" fmla="*/ 740 w 4407"/>
              <a:gd name="T11" fmla="*/ 3707 h 4408"/>
              <a:gd name="T12" fmla="*/ 780 w 4407"/>
              <a:gd name="T13" fmla="*/ 3965 h 4408"/>
              <a:gd name="T14" fmla="*/ 621 w 4407"/>
              <a:gd name="T15" fmla="*/ 3692 h 4408"/>
              <a:gd name="T16" fmla="*/ 399 w 4407"/>
              <a:gd name="T17" fmla="*/ 3752 h 4408"/>
              <a:gd name="T18" fmla="*/ 785 w 4407"/>
              <a:gd name="T19" fmla="*/ 3859 h 4408"/>
              <a:gd name="T20" fmla="*/ 618 w 4407"/>
              <a:gd name="T21" fmla="*/ 3816 h 4408"/>
              <a:gd name="T22" fmla="*/ 744 w 4407"/>
              <a:gd name="T23" fmla="*/ 3328 h 4408"/>
              <a:gd name="T24" fmla="*/ 1131 w 4407"/>
              <a:gd name="T25" fmla="*/ 3409 h 4408"/>
              <a:gd name="T26" fmla="*/ 964 w 4407"/>
              <a:gd name="T27" fmla="*/ 3780 h 4408"/>
              <a:gd name="T28" fmla="*/ 1082 w 4407"/>
              <a:gd name="T29" fmla="*/ 3451 h 4408"/>
              <a:gd name="T30" fmla="*/ 712 w 4407"/>
              <a:gd name="T31" fmla="*/ 3439 h 4408"/>
              <a:gd name="T32" fmla="*/ 1627 w 4407"/>
              <a:gd name="T33" fmla="*/ 3304 h 4408"/>
              <a:gd name="T34" fmla="*/ 1415 w 4407"/>
              <a:gd name="T35" fmla="*/ 2664 h 4408"/>
              <a:gd name="T36" fmla="*/ 1564 w 4407"/>
              <a:gd name="T37" fmla="*/ 2908 h 4408"/>
              <a:gd name="T38" fmla="*/ 1525 w 4407"/>
              <a:gd name="T39" fmla="*/ 2867 h 4408"/>
              <a:gd name="T40" fmla="*/ 1404 w 4407"/>
              <a:gd name="T41" fmla="*/ 2748 h 4408"/>
              <a:gd name="T42" fmla="*/ 1789 w 4407"/>
              <a:gd name="T43" fmla="*/ 2284 h 4408"/>
              <a:gd name="T44" fmla="*/ 1958 w 4407"/>
              <a:gd name="T45" fmla="*/ 2478 h 4408"/>
              <a:gd name="T46" fmla="*/ 1882 w 4407"/>
              <a:gd name="T47" fmla="*/ 2863 h 4408"/>
              <a:gd name="T48" fmla="*/ 2043 w 4407"/>
              <a:gd name="T49" fmla="*/ 2202 h 4408"/>
              <a:gd name="T50" fmla="*/ 2167 w 4407"/>
              <a:gd name="T51" fmla="*/ 2223 h 4408"/>
              <a:gd name="T52" fmla="*/ 2184 w 4407"/>
              <a:gd name="T53" fmla="*/ 2326 h 4408"/>
              <a:gd name="T54" fmla="*/ 2343 w 4407"/>
              <a:gd name="T55" fmla="*/ 1875 h 4408"/>
              <a:gd name="T56" fmla="*/ 2283 w 4407"/>
              <a:gd name="T57" fmla="*/ 1786 h 4408"/>
              <a:gd name="T58" fmla="*/ 2531 w 4407"/>
              <a:gd name="T59" fmla="*/ 1790 h 4408"/>
              <a:gd name="T60" fmla="*/ 2473 w 4407"/>
              <a:gd name="T61" fmla="*/ 1608 h 4408"/>
              <a:gd name="T62" fmla="*/ 2532 w 4407"/>
              <a:gd name="T63" fmla="*/ 1621 h 4408"/>
              <a:gd name="T64" fmla="*/ 2609 w 4407"/>
              <a:gd name="T65" fmla="*/ 1713 h 4408"/>
              <a:gd name="T66" fmla="*/ 2901 w 4407"/>
              <a:gd name="T67" fmla="*/ 1760 h 4408"/>
              <a:gd name="T68" fmla="*/ 2885 w 4407"/>
              <a:gd name="T69" fmla="*/ 1653 h 4408"/>
              <a:gd name="T70" fmla="*/ 2686 w 4407"/>
              <a:gd name="T71" fmla="*/ 1595 h 4408"/>
              <a:gd name="T72" fmla="*/ 2895 w 4407"/>
              <a:gd name="T73" fmla="*/ 1488 h 4408"/>
              <a:gd name="T74" fmla="*/ 2746 w 4407"/>
              <a:gd name="T75" fmla="*/ 1631 h 4408"/>
              <a:gd name="T76" fmla="*/ 2968 w 4407"/>
              <a:gd name="T77" fmla="*/ 1562 h 4408"/>
              <a:gd name="T78" fmla="*/ 2900 w 4407"/>
              <a:gd name="T79" fmla="*/ 1816 h 4408"/>
              <a:gd name="T80" fmla="*/ 2966 w 4407"/>
              <a:gd name="T81" fmla="*/ 1309 h 4408"/>
              <a:gd name="T82" fmla="*/ 2943 w 4407"/>
              <a:gd name="T83" fmla="*/ 1126 h 4408"/>
              <a:gd name="T84" fmla="*/ 3280 w 4407"/>
              <a:gd name="T85" fmla="*/ 887 h 4408"/>
              <a:gd name="T86" fmla="*/ 3569 w 4407"/>
              <a:gd name="T87" fmla="*/ 1176 h 4408"/>
              <a:gd name="T88" fmla="*/ 3485 w 4407"/>
              <a:gd name="T89" fmla="*/ 594 h 4408"/>
              <a:gd name="T90" fmla="*/ 3634 w 4407"/>
              <a:gd name="T91" fmla="*/ 837 h 4408"/>
              <a:gd name="T92" fmla="*/ 3595 w 4407"/>
              <a:gd name="T93" fmla="*/ 797 h 4408"/>
              <a:gd name="T94" fmla="*/ 3474 w 4407"/>
              <a:gd name="T95" fmla="*/ 678 h 4408"/>
              <a:gd name="T96" fmla="*/ 3922 w 4407"/>
              <a:gd name="T97" fmla="*/ 682 h 4408"/>
              <a:gd name="T98" fmla="*/ 4069 w 4407"/>
              <a:gd name="T99" fmla="*/ 493 h 4408"/>
              <a:gd name="T100" fmla="*/ 3753 w 4407"/>
              <a:gd name="T101" fmla="*/ 576 h 4408"/>
              <a:gd name="T102" fmla="*/ 3803 w 4407"/>
              <a:gd name="T103" fmla="*/ 282 h 4408"/>
              <a:gd name="T104" fmla="*/ 3766 w 4407"/>
              <a:gd name="T105" fmla="*/ 373 h 4408"/>
              <a:gd name="T106" fmla="*/ 3969 w 4407"/>
              <a:gd name="T107" fmla="*/ 421 h 4408"/>
              <a:gd name="T108" fmla="*/ 4085 w 4407"/>
              <a:gd name="T109" fmla="*/ 671 h 4408"/>
              <a:gd name="T110" fmla="*/ 4365 w 4407"/>
              <a:gd name="T111" fmla="*/ 379 h 4408"/>
              <a:gd name="T112" fmla="*/ 4051 w 4407"/>
              <a:gd name="T113" fmla="*/ 109 h 440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</a:cxnLst>
            <a:rect l="0" t="0" r="r" b="b"/>
            <a:pathLst>
              <a:path w="4407" h="4408">
                <a:moveTo>
                  <a:pt x="336" y="4408"/>
                </a:moveTo>
                <a:lnTo>
                  <a:pt x="0" y="4072"/>
                </a:lnTo>
                <a:lnTo>
                  <a:pt x="127" y="3945"/>
                </a:lnTo>
                <a:cubicBezTo>
                  <a:pt x="149" y="3923"/>
                  <a:pt x="168" y="3907"/>
                  <a:pt x="181" y="3897"/>
                </a:cubicBezTo>
                <a:cubicBezTo>
                  <a:pt x="201" y="3883"/>
                  <a:pt x="220" y="3875"/>
                  <a:pt x="239" y="3871"/>
                </a:cubicBezTo>
                <a:cubicBezTo>
                  <a:pt x="258" y="3868"/>
                  <a:pt x="277" y="3870"/>
                  <a:pt x="298" y="3877"/>
                </a:cubicBezTo>
                <a:cubicBezTo>
                  <a:pt x="319" y="3884"/>
                  <a:pt x="337" y="3896"/>
                  <a:pt x="354" y="3913"/>
                </a:cubicBezTo>
                <a:cubicBezTo>
                  <a:pt x="383" y="3941"/>
                  <a:pt x="398" y="3974"/>
                  <a:pt x="399" y="4012"/>
                </a:cubicBezTo>
                <a:cubicBezTo>
                  <a:pt x="401" y="4050"/>
                  <a:pt x="378" y="4093"/>
                  <a:pt x="331" y="4141"/>
                </a:cubicBezTo>
                <a:lnTo>
                  <a:pt x="244" y="4227"/>
                </a:lnTo>
                <a:lnTo>
                  <a:pt x="381" y="4364"/>
                </a:lnTo>
                <a:lnTo>
                  <a:pt x="336" y="4408"/>
                </a:lnTo>
                <a:close/>
                <a:moveTo>
                  <a:pt x="205" y="4187"/>
                </a:moveTo>
                <a:lnTo>
                  <a:pt x="292" y="4100"/>
                </a:lnTo>
                <a:cubicBezTo>
                  <a:pt x="320" y="4072"/>
                  <a:pt x="335" y="4046"/>
                  <a:pt x="337" y="4023"/>
                </a:cubicBezTo>
                <a:cubicBezTo>
                  <a:pt x="338" y="4000"/>
                  <a:pt x="329" y="3979"/>
                  <a:pt x="310" y="3960"/>
                </a:cubicBezTo>
                <a:cubicBezTo>
                  <a:pt x="296" y="3946"/>
                  <a:pt x="280" y="3937"/>
                  <a:pt x="263" y="3934"/>
                </a:cubicBezTo>
                <a:cubicBezTo>
                  <a:pt x="246" y="3931"/>
                  <a:pt x="230" y="3934"/>
                  <a:pt x="215" y="3943"/>
                </a:cubicBezTo>
                <a:cubicBezTo>
                  <a:pt x="205" y="3948"/>
                  <a:pt x="191" y="3961"/>
                  <a:pt x="170" y="3981"/>
                </a:cubicBezTo>
                <a:lnTo>
                  <a:pt x="85" y="4067"/>
                </a:lnTo>
                <a:lnTo>
                  <a:pt x="205" y="4187"/>
                </a:lnTo>
                <a:close/>
                <a:moveTo>
                  <a:pt x="651" y="4093"/>
                </a:moveTo>
                <a:lnTo>
                  <a:pt x="315" y="3757"/>
                </a:lnTo>
                <a:lnTo>
                  <a:pt x="441" y="3631"/>
                </a:lnTo>
                <a:cubicBezTo>
                  <a:pt x="467" y="3605"/>
                  <a:pt x="491" y="3588"/>
                  <a:pt x="513" y="3579"/>
                </a:cubicBezTo>
                <a:cubicBezTo>
                  <a:pt x="536" y="3571"/>
                  <a:pt x="558" y="3569"/>
                  <a:pt x="581" y="3574"/>
                </a:cubicBezTo>
                <a:cubicBezTo>
                  <a:pt x="604" y="3580"/>
                  <a:pt x="623" y="3590"/>
                  <a:pt x="639" y="3605"/>
                </a:cubicBezTo>
                <a:cubicBezTo>
                  <a:pt x="653" y="3620"/>
                  <a:pt x="663" y="3637"/>
                  <a:pt x="668" y="3658"/>
                </a:cubicBezTo>
                <a:cubicBezTo>
                  <a:pt x="673" y="3678"/>
                  <a:pt x="671" y="3700"/>
                  <a:pt x="663" y="3724"/>
                </a:cubicBezTo>
                <a:cubicBezTo>
                  <a:pt x="689" y="3709"/>
                  <a:pt x="715" y="3704"/>
                  <a:pt x="740" y="3707"/>
                </a:cubicBezTo>
                <a:cubicBezTo>
                  <a:pt x="766" y="3711"/>
                  <a:pt x="788" y="3722"/>
                  <a:pt x="808" y="3742"/>
                </a:cubicBezTo>
                <a:cubicBezTo>
                  <a:pt x="824" y="3758"/>
                  <a:pt x="835" y="3776"/>
                  <a:pt x="842" y="3796"/>
                </a:cubicBezTo>
                <a:cubicBezTo>
                  <a:pt x="849" y="3816"/>
                  <a:pt x="851" y="3835"/>
                  <a:pt x="848" y="3852"/>
                </a:cubicBezTo>
                <a:cubicBezTo>
                  <a:pt x="846" y="3869"/>
                  <a:pt x="839" y="3887"/>
                  <a:pt x="828" y="3905"/>
                </a:cubicBezTo>
                <a:cubicBezTo>
                  <a:pt x="817" y="3924"/>
                  <a:pt x="801" y="3944"/>
                  <a:pt x="780" y="3965"/>
                </a:cubicBezTo>
                <a:lnTo>
                  <a:pt x="651" y="4093"/>
                </a:lnTo>
                <a:close/>
                <a:moveTo>
                  <a:pt x="501" y="3854"/>
                </a:moveTo>
                <a:lnTo>
                  <a:pt x="574" y="3781"/>
                </a:lnTo>
                <a:cubicBezTo>
                  <a:pt x="593" y="3761"/>
                  <a:pt x="606" y="3746"/>
                  <a:pt x="612" y="3735"/>
                </a:cubicBezTo>
                <a:cubicBezTo>
                  <a:pt x="620" y="3720"/>
                  <a:pt x="623" y="3706"/>
                  <a:pt x="621" y="3692"/>
                </a:cubicBezTo>
                <a:cubicBezTo>
                  <a:pt x="619" y="3679"/>
                  <a:pt x="612" y="3666"/>
                  <a:pt x="600" y="3655"/>
                </a:cubicBezTo>
                <a:cubicBezTo>
                  <a:pt x="589" y="3643"/>
                  <a:pt x="577" y="3636"/>
                  <a:pt x="563" y="3633"/>
                </a:cubicBezTo>
                <a:cubicBezTo>
                  <a:pt x="549" y="3630"/>
                  <a:pt x="536" y="3632"/>
                  <a:pt x="522" y="3639"/>
                </a:cubicBezTo>
                <a:cubicBezTo>
                  <a:pt x="509" y="3645"/>
                  <a:pt x="491" y="3661"/>
                  <a:pt x="467" y="3685"/>
                </a:cubicBezTo>
                <a:lnTo>
                  <a:pt x="399" y="3752"/>
                </a:lnTo>
                <a:lnTo>
                  <a:pt x="501" y="3854"/>
                </a:lnTo>
                <a:close/>
                <a:moveTo>
                  <a:pt x="656" y="4009"/>
                </a:moveTo>
                <a:lnTo>
                  <a:pt x="740" y="3925"/>
                </a:lnTo>
                <a:cubicBezTo>
                  <a:pt x="754" y="3911"/>
                  <a:pt x="764" y="3900"/>
                  <a:pt x="769" y="3893"/>
                </a:cubicBezTo>
                <a:cubicBezTo>
                  <a:pt x="777" y="3881"/>
                  <a:pt x="782" y="3870"/>
                  <a:pt x="785" y="3859"/>
                </a:cubicBezTo>
                <a:cubicBezTo>
                  <a:pt x="788" y="3847"/>
                  <a:pt x="787" y="3836"/>
                  <a:pt x="783" y="3823"/>
                </a:cubicBezTo>
                <a:cubicBezTo>
                  <a:pt x="780" y="3810"/>
                  <a:pt x="772" y="3799"/>
                  <a:pt x="762" y="3788"/>
                </a:cubicBezTo>
                <a:cubicBezTo>
                  <a:pt x="749" y="3775"/>
                  <a:pt x="735" y="3768"/>
                  <a:pt x="719" y="3765"/>
                </a:cubicBezTo>
                <a:cubicBezTo>
                  <a:pt x="704" y="3762"/>
                  <a:pt x="688" y="3764"/>
                  <a:pt x="673" y="3772"/>
                </a:cubicBezTo>
                <a:cubicBezTo>
                  <a:pt x="658" y="3780"/>
                  <a:pt x="640" y="3794"/>
                  <a:pt x="618" y="3816"/>
                </a:cubicBezTo>
                <a:lnTo>
                  <a:pt x="541" y="3893"/>
                </a:lnTo>
                <a:lnTo>
                  <a:pt x="656" y="4009"/>
                </a:lnTo>
                <a:close/>
                <a:moveTo>
                  <a:pt x="964" y="3780"/>
                </a:moveTo>
                <a:lnTo>
                  <a:pt x="628" y="3444"/>
                </a:lnTo>
                <a:lnTo>
                  <a:pt x="744" y="3328"/>
                </a:lnTo>
                <a:cubicBezTo>
                  <a:pt x="770" y="3302"/>
                  <a:pt x="792" y="3284"/>
                  <a:pt x="809" y="3273"/>
                </a:cubicBezTo>
                <a:cubicBezTo>
                  <a:pt x="832" y="3258"/>
                  <a:pt x="857" y="3250"/>
                  <a:pt x="882" y="3248"/>
                </a:cubicBezTo>
                <a:cubicBezTo>
                  <a:pt x="915" y="3245"/>
                  <a:pt x="947" y="3251"/>
                  <a:pt x="979" y="3266"/>
                </a:cubicBezTo>
                <a:cubicBezTo>
                  <a:pt x="1011" y="3280"/>
                  <a:pt x="1042" y="3302"/>
                  <a:pt x="1072" y="3332"/>
                </a:cubicBezTo>
                <a:cubicBezTo>
                  <a:pt x="1098" y="3358"/>
                  <a:pt x="1118" y="3383"/>
                  <a:pt x="1131" y="3409"/>
                </a:cubicBezTo>
                <a:cubicBezTo>
                  <a:pt x="1145" y="3435"/>
                  <a:pt x="1154" y="3459"/>
                  <a:pt x="1157" y="3481"/>
                </a:cubicBezTo>
                <a:cubicBezTo>
                  <a:pt x="1161" y="3503"/>
                  <a:pt x="1161" y="3524"/>
                  <a:pt x="1157" y="3542"/>
                </a:cubicBezTo>
                <a:cubicBezTo>
                  <a:pt x="1154" y="3561"/>
                  <a:pt x="1146" y="3580"/>
                  <a:pt x="1134" y="3599"/>
                </a:cubicBezTo>
                <a:cubicBezTo>
                  <a:pt x="1122" y="3619"/>
                  <a:pt x="1106" y="3639"/>
                  <a:pt x="1086" y="3659"/>
                </a:cubicBezTo>
                <a:lnTo>
                  <a:pt x="964" y="3780"/>
                </a:lnTo>
                <a:close/>
                <a:moveTo>
                  <a:pt x="969" y="3696"/>
                </a:moveTo>
                <a:lnTo>
                  <a:pt x="1041" y="3624"/>
                </a:lnTo>
                <a:cubicBezTo>
                  <a:pt x="1063" y="3602"/>
                  <a:pt x="1078" y="3583"/>
                  <a:pt x="1087" y="3566"/>
                </a:cubicBezTo>
                <a:cubicBezTo>
                  <a:pt x="1095" y="3549"/>
                  <a:pt x="1100" y="3533"/>
                  <a:pt x="1100" y="3518"/>
                </a:cubicBezTo>
                <a:cubicBezTo>
                  <a:pt x="1100" y="3497"/>
                  <a:pt x="1094" y="3475"/>
                  <a:pt x="1082" y="3451"/>
                </a:cubicBezTo>
                <a:cubicBezTo>
                  <a:pt x="1070" y="3427"/>
                  <a:pt x="1051" y="3403"/>
                  <a:pt x="1026" y="3378"/>
                </a:cubicBezTo>
                <a:cubicBezTo>
                  <a:pt x="991" y="3342"/>
                  <a:pt x="958" y="3321"/>
                  <a:pt x="927" y="3314"/>
                </a:cubicBezTo>
                <a:cubicBezTo>
                  <a:pt x="897" y="3306"/>
                  <a:pt x="870" y="3308"/>
                  <a:pt x="847" y="3318"/>
                </a:cubicBezTo>
                <a:cubicBezTo>
                  <a:pt x="831" y="3325"/>
                  <a:pt x="809" y="3342"/>
                  <a:pt x="783" y="3369"/>
                </a:cubicBezTo>
                <a:lnTo>
                  <a:pt x="712" y="3439"/>
                </a:lnTo>
                <a:lnTo>
                  <a:pt x="969" y="3696"/>
                </a:lnTo>
                <a:close/>
                <a:moveTo>
                  <a:pt x="1354" y="3577"/>
                </a:moveTo>
                <a:lnTo>
                  <a:pt x="1324" y="3548"/>
                </a:lnTo>
                <a:lnTo>
                  <a:pt x="1597" y="3274"/>
                </a:lnTo>
                <a:lnTo>
                  <a:pt x="1627" y="3304"/>
                </a:lnTo>
                <a:lnTo>
                  <a:pt x="1354" y="3577"/>
                </a:lnTo>
                <a:close/>
                <a:moveTo>
                  <a:pt x="1570" y="3175"/>
                </a:moveTo>
                <a:lnTo>
                  <a:pt x="1234" y="2839"/>
                </a:lnTo>
                <a:lnTo>
                  <a:pt x="1360" y="2712"/>
                </a:lnTo>
                <a:cubicBezTo>
                  <a:pt x="1383" y="2690"/>
                  <a:pt x="1401" y="2674"/>
                  <a:pt x="1415" y="2664"/>
                </a:cubicBezTo>
                <a:cubicBezTo>
                  <a:pt x="1434" y="2650"/>
                  <a:pt x="1453" y="2642"/>
                  <a:pt x="1472" y="2638"/>
                </a:cubicBezTo>
                <a:cubicBezTo>
                  <a:pt x="1491" y="2635"/>
                  <a:pt x="1511" y="2637"/>
                  <a:pt x="1531" y="2644"/>
                </a:cubicBezTo>
                <a:cubicBezTo>
                  <a:pt x="1552" y="2651"/>
                  <a:pt x="1571" y="2663"/>
                  <a:pt x="1587" y="2679"/>
                </a:cubicBezTo>
                <a:cubicBezTo>
                  <a:pt x="1616" y="2708"/>
                  <a:pt x="1631" y="2741"/>
                  <a:pt x="1633" y="2779"/>
                </a:cubicBezTo>
                <a:cubicBezTo>
                  <a:pt x="1634" y="2817"/>
                  <a:pt x="1611" y="2860"/>
                  <a:pt x="1564" y="2908"/>
                </a:cubicBezTo>
                <a:lnTo>
                  <a:pt x="1477" y="2994"/>
                </a:lnTo>
                <a:lnTo>
                  <a:pt x="1614" y="3130"/>
                </a:lnTo>
                <a:lnTo>
                  <a:pt x="1570" y="3175"/>
                </a:lnTo>
                <a:close/>
                <a:moveTo>
                  <a:pt x="1438" y="2954"/>
                </a:moveTo>
                <a:lnTo>
                  <a:pt x="1525" y="2867"/>
                </a:lnTo>
                <a:cubicBezTo>
                  <a:pt x="1553" y="2838"/>
                  <a:pt x="1569" y="2813"/>
                  <a:pt x="1570" y="2790"/>
                </a:cubicBezTo>
                <a:cubicBezTo>
                  <a:pt x="1571" y="2767"/>
                  <a:pt x="1562" y="2746"/>
                  <a:pt x="1543" y="2727"/>
                </a:cubicBezTo>
                <a:cubicBezTo>
                  <a:pt x="1529" y="2713"/>
                  <a:pt x="1513" y="2704"/>
                  <a:pt x="1496" y="2701"/>
                </a:cubicBezTo>
                <a:cubicBezTo>
                  <a:pt x="1479" y="2698"/>
                  <a:pt x="1463" y="2701"/>
                  <a:pt x="1448" y="2709"/>
                </a:cubicBezTo>
                <a:cubicBezTo>
                  <a:pt x="1439" y="2715"/>
                  <a:pt x="1424" y="2728"/>
                  <a:pt x="1404" y="2748"/>
                </a:cubicBezTo>
                <a:lnTo>
                  <a:pt x="1318" y="2834"/>
                </a:lnTo>
                <a:lnTo>
                  <a:pt x="1438" y="2954"/>
                </a:lnTo>
                <a:close/>
                <a:moveTo>
                  <a:pt x="1882" y="2863"/>
                </a:moveTo>
                <a:lnTo>
                  <a:pt x="1546" y="2527"/>
                </a:lnTo>
                <a:lnTo>
                  <a:pt x="1789" y="2284"/>
                </a:lnTo>
                <a:lnTo>
                  <a:pt x="1828" y="2323"/>
                </a:lnTo>
                <a:lnTo>
                  <a:pt x="1630" y="2522"/>
                </a:lnTo>
                <a:lnTo>
                  <a:pt x="1733" y="2625"/>
                </a:lnTo>
                <a:lnTo>
                  <a:pt x="1919" y="2439"/>
                </a:lnTo>
                <a:lnTo>
                  <a:pt x="1958" y="2478"/>
                </a:lnTo>
                <a:lnTo>
                  <a:pt x="1772" y="2664"/>
                </a:lnTo>
                <a:lnTo>
                  <a:pt x="1887" y="2779"/>
                </a:lnTo>
                <a:lnTo>
                  <a:pt x="2093" y="2572"/>
                </a:lnTo>
                <a:lnTo>
                  <a:pt x="2133" y="2612"/>
                </a:lnTo>
                <a:lnTo>
                  <a:pt x="1882" y="2863"/>
                </a:lnTo>
                <a:close/>
                <a:moveTo>
                  <a:pt x="2163" y="2581"/>
                </a:moveTo>
                <a:lnTo>
                  <a:pt x="2118" y="2276"/>
                </a:lnTo>
                <a:lnTo>
                  <a:pt x="1843" y="2230"/>
                </a:lnTo>
                <a:lnTo>
                  <a:pt x="1896" y="2177"/>
                </a:lnTo>
                <a:lnTo>
                  <a:pt x="2043" y="2202"/>
                </a:lnTo>
                <a:cubicBezTo>
                  <a:pt x="2073" y="2207"/>
                  <a:pt x="2096" y="2212"/>
                  <a:pt x="2111" y="2216"/>
                </a:cubicBezTo>
                <a:cubicBezTo>
                  <a:pt x="2106" y="2196"/>
                  <a:pt x="2103" y="2175"/>
                  <a:pt x="2099" y="2151"/>
                </a:cubicBezTo>
                <a:lnTo>
                  <a:pt x="2078" y="1994"/>
                </a:lnTo>
                <a:lnTo>
                  <a:pt x="2126" y="1946"/>
                </a:lnTo>
                <a:lnTo>
                  <a:pt x="2167" y="2223"/>
                </a:lnTo>
                <a:lnTo>
                  <a:pt x="2472" y="2273"/>
                </a:lnTo>
                <a:lnTo>
                  <a:pt x="2417" y="2328"/>
                </a:lnTo>
                <a:lnTo>
                  <a:pt x="2212" y="2293"/>
                </a:lnTo>
                <a:cubicBezTo>
                  <a:pt x="2200" y="2291"/>
                  <a:pt x="2188" y="2288"/>
                  <a:pt x="2175" y="2285"/>
                </a:cubicBezTo>
                <a:cubicBezTo>
                  <a:pt x="2180" y="2305"/>
                  <a:pt x="2183" y="2318"/>
                  <a:pt x="2184" y="2326"/>
                </a:cubicBezTo>
                <a:lnTo>
                  <a:pt x="2217" y="2528"/>
                </a:lnTo>
                <a:lnTo>
                  <a:pt x="2163" y="2581"/>
                </a:lnTo>
                <a:close/>
                <a:moveTo>
                  <a:pt x="2647" y="2097"/>
                </a:moveTo>
                <a:lnTo>
                  <a:pt x="2606" y="2138"/>
                </a:lnTo>
                <a:lnTo>
                  <a:pt x="2343" y="1875"/>
                </a:lnTo>
                <a:cubicBezTo>
                  <a:pt x="2343" y="1895"/>
                  <a:pt x="2339" y="1917"/>
                  <a:pt x="2333" y="1943"/>
                </a:cubicBezTo>
                <a:cubicBezTo>
                  <a:pt x="2326" y="1969"/>
                  <a:pt x="2318" y="1990"/>
                  <a:pt x="2310" y="2008"/>
                </a:cubicBezTo>
                <a:lnTo>
                  <a:pt x="2270" y="1968"/>
                </a:lnTo>
                <a:cubicBezTo>
                  <a:pt x="2283" y="1934"/>
                  <a:pt x="2290" y="1901"/>
                  <a:pt x="2292" y="1868"/>
                </a:cubicBezTo>
                <a:cubicBezTo>
                  <a:pt x="2293" y="1835"/>
                  <a:pt x="2291" y="1808"/>
                  <a:pt x="2283" y="1786"/>
                </a:cubicBezTo>
                <a:lnTo>
                  <a:pt x="2310" y="1760"/>
                </a:lnTo>
                <a:lnTo>
                  <a:pt x="2647" y="2097"/>
                </a:lnTo>
                <a:close/>
                <a:moveTo>
                  <a:pt x="2779" y="1965"/>
                </a:moveTo>
                <a:lnTo>
                  <a:pt x="2568" y="1754"/>
                </a:lnTo>
                <a:lnTo>
                  <a:pt x="2531" y="1790"/>
                </a:lnTo>
                <a:lnTo>
                  <a:pt x="2499" y="1758"/>
                </a:lnTo>
                <a:lnTo>
                  <a:pt x="2536" y="1722"/>
                </a:lnTo>
                <a:lnTo>
                  <a:pt x="2510" y="1696"/>
                </a:lnTo>
                <a:cubicBezTo>
                  <a:pt x="2493" y="1680"/>
                  <a:pt x="2483" y="1666"/>
                  <a:pt x="2478" y="1655"/>
                </a:cubicBezTo>
                <a:cubicBezTo>
                  <a:pt x="2471" y="1640"/>
                  <a:pt x="2469" y="1625"/>
                  <a:pt x="2473" y="1608"/>
                </a:cubicBezTo>
                <a:cubicBezTo>
                  <a:pt x="2476" y="1591"/>
                  <a:pt x="2487" y="1574"/>
                  <a:pt x="2505" y="1556"/>
                </a:cubicBezTo>
                <a:cubicBezTo>
                  <a:pt x="2516" y="1544"/>
                  <a:pt x="2531" y="1533"/>
                  <a:pt x="2547" y="1522"/>
                </a:cubicBezTo>
                <a:lnTo>
                  <a:pt x="2577" y="1564"/>
                </a:lnTo>
                <a:cubicBezTo>
                  <a:pt x="2567" y="1571"/>
                  <a:pt x="2558" y="1578"/>
                  <a:pt x="2551" y="1586"/>
                </a:cubicBezTo>
                <a:cubicBezTo>
                  <a:pt x="2538" y="1598"/>
                  <a:pt x="2532" y="1610"/>
                  <a:pt x="2532" y="1621"/>
                </a:cubicBezTo>
                <a:cubicBezTo>
                  <a:pt x="2532" y="1631"/>
                  <a:pt x="2540" y="1644"/>
                  <a:pt x="2554" y="1658"/>
                </a:cubicBezTo>
                <a:lnTo>
                  <a:pt x="2577" y="1681"/>
                </a:lnTo>
                <a:lnTo>
                  <a:pt x="2624" y="1633"/>
                </a:lnTo>
                <a:lnTo>
                  <a:pt x="2656" y="1665"/>
                </a:lnTo>
                <a:lnTo>
                  <a:pt x="2609" y="1713"/>
                </a:lnTo>
                <a:lnTo>
                  <a:pt x="2820" y="1924"/>
                </a:lnTo>
                <a:lnTo>
                  <a:pt x="2779" y="1965"/>
                </a:lnTo>
                <a:close/>
                <a:moveTo>
                  <a:pt x="2810" y="1789"/>
                </a:moveTo>
                <a:lnTo>
                  <a:pt x="2845" y="1742"/>
                </a:lnTo>
                <a:cubicBezTo>
                  <a:pt x="2863" y="1756"/>
                  <a:pt x="2882" y="1762"/>
                  <a:pt x="2901" y="1760"/>
                </a:cubicBezTo>
                <a:cubicBezTo>
                  <a:pt x="2921" y="1758"/>
                  <a:pt x="2940" y="1748"/>
                  <a:pt x="2958" y="1729"/>
                </a:cubicBezTo>
                <a:cubicBezTo>
                  <a:pt x="2977" y="1710"/>
                  <a:pt x="2987" y="1692"/>
                  <a:pt x="2989" y="1676"/>
                </a:cubicBezTo>
                <a:cubicBezTo>
                  <a:pt x="2990" y="1659"/>
                  <a:pt x="2986" y="1645"/>
                  <a:pt x="2976" y="1635"/>
                </a:cubicBezTo>
                <a:cubicBezTo>
                  <a:pt x="2966" y="1625"/>
                  <a:pt x="2955" y="1622"/>
                  <a:pt x="2941" y="1625"/>
                </a:cubicBezTo>
                <a:cubicBezTo>
                  <a:pt x="2932" y="1627"/>
                  <a:pt x="2913" y="1636"/>
                  <a:pt x="2885" y="1653"/>
                </a:cubicBezTo>
                <a:cubicBezTo>
                  <a:pt x="2847" y="1676"/>
                  <a:pt x="2820" y="1690"/>
                  <a:pt x="2802" y="1696"/>
                </a:cubicBezTo>
                <a:cubicBezTo>
                  <a:pt x="2785" y="1702"/>
                  <a:pt x="2769" y="1703"/>
                  <a:pt x="2753" y="1700"/>
                </a:cubicBezTo>
                <a:cubicBezTo>
                  <a:pt x="2737" y="1696"/>
                  <a:pt x="2723" y="1688"/>
                  <a:pt x="2711" y="1676"/>
                </a:cubicBezTo>
                <a:cubicBezTo>
                  <a:pt x="2700" y="1665"/>
                  <a:pt x="2693" y="1653"/>
                  <a:pt x="2688" y="1638"/>
                </a:cubicBezTo>
                <a:cubicBezTo>
                  <a:pt x="2684" y="1624"/>
                  <a:pt x="2683" y="1610"/>
                  <a:pt x="2686" y="1595"/>
                </a:cubicBezTo>
                <a:cubicBezTo>
                  <a:pt x="2687" y="1584"/>
                  <a:pt x="2692" y="1571"/>
                  <a:pt x="2700" y="1557"/>
                </a:cubicBezTo>
                <a:cubicBezTo>
                  <a:pt x="2708" y="1542"/>
                  <a:pt x="2718" y="1529"/>
                  <a:pt x="2730" y="1516"/>
                </a:cubicBezTo>
                <a:cubicBezTo>
                  <a:pt x="2750" y="1497"/>
                  <a:pt x="2769" y="1483"/>
                  <a:pt x="2789" y="1474"/>
                </a:cubicBezTo>
                <a:cubicBezTo>
                  <a:pt x="2809" y="1465"/>
                  <a:pt x="2827" y="1462"/>
                  <a:pt x="2843" y="1464"/>
                </a:cubicBezTo>
                <a:cubicBezTo>
                  <a:pt x="2860" y="1467"/>
                  <a:pt x="2877" y="1475"/>
                  <a:pt x="2895" y="1488"/>
                </a:cubicBezTo>
                <a:lnTo>
                  <a:pt x="2860" y="1534"/>
                </a:lnTo>
                <a:cubicBezTo>
                  <a:pt x="2846" y="1523"/>
                  <a:pt x="2831" y="1519"/>
                  <a:pt x="2815" y="1520"/>
                </a:cubicBezTo>
                <a:cubicBezTo>
                  <a:pt x="2799" y="1522"/>
                  <a:pt x="2783" y="1531"/>
                  <a:pt x="2767" y="1547"/>
                </a:cubicBezTo>
                <a:cubicBezTo>
                  <a:pt x="2748" y="1566"/>
                  <a:pt x="2738" y="1583"/>
                  <a:pt x="2736" y="1597"/>
                </a:cubicBezTo>
                <a:cubicBezTo>
                  <a:pt x="2734" y="1611"/>
                  <a:pt x="2738" y="1623"/>
                  <a:pt x="2746" y="1631"/>
                </a:cubicBezTo>
                <a:cubicBezTo>
                  <a:pt x="2751" y="1637"/>
                  <a:pt x="2758" y="1640"/>
                  <a:pt x="2766" y="1641"/>
                </a:cubicBezTo>
                <a:cubicBezTo>
                  <a:pt x="2773" y="1642"/>
                  <a:pt x="2782" y="1640"/>
                  <a:pt x="2792" y="1636"/>
                </a:cubicBezTo>
                <a:cubicBezTo>
                  <a:pt x="2798" y="1633"/>
                  <a:pt x="2814" y="1625"/>
                  <a:pt x="2839" y="1610"/>
                </a:cubicBezTo>
                <a:cubicBezTo>
                  <a:pt x="2876" y="1588"/>
                  <a:pt x="2903" y="1574"/>
                  <a:pt x="2920" y="1568"/>
                </a:cubicBezTo>
                <a:cubicBezTo>
                  <a:pt x="2936" y="1561"/>
                  <a:pt x="2952" y="1560"/>
                  <a:pt x="2968" y="1562"/>
                </a:cubicBezTo>
                <a:cubicBezTo>
                  <a:pt x="2984" y="1565"/>
                  <a:pt x="3000" y="1574"/>
                  <a:pt x="3014" y="1588"/>
                </a:cubicBezTo>
                <a:cubicBezTo>
                  <a:pt x="3027" y="1602"/>
                  <a:pt x="3036" y="1619"/>
                  <a:pt x="3040" y="1639"/>
                </a:cubicBezTo>
                <a:cubicBezTo>
                  <a:pt x="3045" y="1659"/>
                  <a:pt x="3042" y="1680"/>
                  <a:pt x="3034" y="1702"/>
                </a:cubicBezTo>
                <a:cubicBezTo>
                  <a:pt x="3025" y="1723"/>
                  <a:pt x="3012" y="1744"/>
                  <a:pt x="2992" y="1763"/>
                </a:cubicBezTo>
                <a:cubicBezTo>
                  <a:pt x="2961" y="1795"/>
                  <a:pt x="2930" y="1812"/>
                  <a:pt x="2900" y="1816"/>
                </a:cubicBezTo>
                <a:cubicBezTo>
                  <a:pt x="2871" y="1819"/>
                  <a:pt x="2841" y="1810"/>
                  <a:pt x="2810" y="1789"/>
                </a:cubicBezTo>
                <a:close/>
                <a:moveTo>
                  <a:pt x="3281" y="1464"/>
                </a:moveTo>
                <a:lnTo>
                  <a:pt x="3240" y="1505"/>
                </a:lnTo>
                <a:lnTo>
                  <a:pt x="2977" y="1242"/>
                </a:lnTo>
                <a:cubicBezTo>
                  <a:pt x="2976" y="1261"/>
                  <a:pt x="2973" y="1284"/>
                  <a:pt x="2966" y="1309"/>
                </a:cubicBezTo>
                <a:cubicBezTo>
                  <a:pt x="2959" y="1335"/>
                  <a:pt x="2952" y="1357"/>
                  <a:pt x="2944" y="1374"/>
                </a:cubicBezTo>
                <a:lnTo>
                  <a:pt x="2904" y="1334"/>
                </a:lnTo>
                <a:cubicBezTo>
                  <a:pt x="2916" y="1300"/>
                  <a:pt x="2923" y="1267"/>
                  <a:pt x="2925" y="1234"/>
                </a:cubicBezTo>
                <a:cubicBezTo>
                  <a:pt x="2927" y="1202"/>
                  <a:pt x="2924" y="1174"/>
                  <a:pt x="2917" y="1153"/>
                </a:cubicBezTo>
                <a:lnTo>
                  <a:pt x="2943" y="1126"/>
                </a:lnTo>
                <a:lnTo>
                  <a:pt x="3281" y="1464"/>
                </a:lnTo>
                <a:close/>
                <a:moveTo>
                  <a:pt x="3239" y="928"/>
                </a:moveTo>
                <a:lnTo>
                  <a:pt x="3191" y="881"/>
                </a:lnTo>
                <a:lnTo>
                  <a:pt x="3233" y="840"/>
                </a:lnTo>
                <a:lnTo>
                  <a:pt x="3280" y="887"/>
                </a:lnTo>
                <a:lnTo>
                  <a:pt x="3239" y="928"/>
                </a:lnTo>
                <a:close/>
                <a:moveTo>
                  <a:pt x="3528" y="1217"/>
                </a:moveTo>
                <a:lnTo>
                  <a:pt x="3284" y="973"/>
                </a:lnTo>
                <a:lnTo>
                  <a:pt x="3325" y="932"/>
                </a:lnTo>
                <a:lnTo>
                  <a:pt x="3569" y="1176"/>
                </a:lnTo>
                <a:lnTo>
                  <a:pt x="3528" y="1217"/>
                </a:lnTo>
                <a:close/>
                <a:moveTo>
                  <a:pt x="3640" y="1104"/>
                </a:moveTo>
                <a:lnTo>
                  <a:pt x="3304" y="768"/>
                </a:lnTo>
                <a:lnTo>
                  <a:pt x="3431" y="642"/>
                </a:lnTo>
                <a:cubicBezTo>
                  <a:pt x="3453" y="619"/>
                  <a:pt x="3471" y="603"/>
                  <a:pt x="3485" y="594"/>
                </a:cubicBezTo>
                <a:cubicBezTo>
                  <a:pt x="3504" y="580"/>
                  <a:pt x="3523" y="571"/>
                  <a:pt x="3542" y="568"/>
                </a:cubicBezTo>
                <a:cubicBezTo>
                  <a:pt x="3561" y="564"/>
                  <a:pt x="3581" y="566"/>
                  <a:pt x="3602" y="573"/>
                </a:cubicBezTo>
                <a:cubicBezTo>
                  <a:pt x="3622" y="580"/>
                  <a:pt x="3641" y="592"/>
                  <a:pt x="3658" y="609"/>
                </a:cubicBezTo>
                <a:cubicBezTo>
                  <a:pt x="3686" y="638"/>
                  <a:pt x="3701" y="671"/>
                  <a:pt x="3703" y="709"/>
                </a:cubicBezTo>
                <a:cubicBezTo>
                  <a:pt x="3705" y="747"/>
                  <a:pt x="3682" y="790"/>
                  <a:pt x="3634" y="837"/>
                </a:cubicBezTo>
                <a:lnTo>
                  <a:pt x="3548" y="923"/>
                </a:lnTo>
                <a:lnTo>
                  <a:pt x="3685" y="1060"/>
                </a:lnTo>
                <a:lnTo>
                  <a:pt x="3640" y="1104"/>
                </a:lnTo>
                <a:close/>
                <a:moveTo>
                  <a:pt x="3508" y="884"/>
                </a:moveTo>
                <a:lnTo>
                  <a:pt x="3595" y="797"/>
                </a:lnTo>
                <a:cubicBezTo>
                  <a:pt x="3624" y="768"/>
                  <a:pt x="3639" y="742"/>
                  <a:pt x="3640" y="719"/>
                </a:cubicBezTo>
                <a:cubicBezTo>
                  <a:pt x="3642" y="697"/>
                  <a:pt x="3633" y="676"/>
                  <a:pt x="3613" y="656"/>
                </a:cubicBezTo>
                <a:cubicBezTo>
                  <a:pt x="3599" y="642"/>
                  <a:pt x="3584" y="634"/>
                  <a:pt x="3566" y="631"/>
                </a:cubicBezTo>
                <a:cubicBezTo>
                  <a:pt x="3549" y="628"/>
                  <a:pt x="3533" y="631"/>
                  <a:pt x="3519" y="639"/>
                </a:cubicBezTo>
                <a:cubicBezTo>
                  <a:pt x="3509" y="645"/>
                  <a:pt x="3494" y="657"/>
                  <a:pt x="3474" y="678"/>
                </a:cubicBezTo>
                <a:lnTo>
                  <a:pt x="3388" y="764"/>
                </a:lnTo>
                <a:lnTo>
                  <a:pt x="3508" y="884"/>
                </a:lnTo>
                <a:close/>
                <a:moveTo>
                  <a:pt x="3828" y="700"/>
                </a:moveTo>
                <a:lnTo>
                  <a:pt x="3866" y="655"/>
                </a:lnTo>
                <a:cubicBezTo>
                  <a:pt x="3885" y="670"/>
                  <a:pt x="3904" y="679"/>
                  <a:pt x="3922" y="682"/>
                </a:cubicBezTo>
                <a:cubicBezTo>
                  <a:pt x="3940" y="686"/>
                  <a:pt x="3960" y="683"/>
                  <a:pt x="3982" y="675"/>
                </a:cubicBezTo>
                <a:cubicBezTo>
                  <a:pt x="4004" y="666"/>
                  <a:pt x="4024" y="652"/>
                  <a:pt x="4043" y="633"/>
                </a:cubicBezTo>
                <a:cubicBezTo>
                  <a:pt x="4060" y="616"/>
                  <a:pt x="4073" y="599"/>
                  <a:pt x="4080" y="581"/>
                </a:cubicBezTo>
                <a:cubicBezTo>
                  <a:pt x="4088" y="563"/>
                  <a:pt x="4091" y="546"/>
                  <a:pt x="4089" y="531"/>
                </a:cubicBezTo>
                <a:cubicBezTo>
                  <a:pt x="4086" y="516"/>
                  <a:pt x="4080" y="503"/>
                  <a:pt x="4069" y="493"/>
                </a:cubicBezTo>
                <a:cubicBezTo>
                  <a:pt x="4059" y="482"/>
                  <a:pt x="4047" y="476"/>
                  <a:pt x="4033" y="474"/>
                </a:cubicBezTo>
                <a:cubicBezTo>
                  <a:pt x="4019" y="472"/>
                  <a:pt x="4002" y="476"/>
                  <a:pt x="3983" y="484"/>
                </a:cubicBezTo>
                <a:cubicBezTo>
                  <a:pt x="3970" y="490"/>
                  <a:pt x="3945" y="504"/>
                  <a:pt x="3906" y="528"/>
                </a:cubicBezTo>
                <a:cubicBezTo>
                  <a:pt x="3868" y="551"/>
                  <a:pt x="3839" y="566"/>
                  <a:pt x="3821" y="572"/>
                </a:cubicBezTo>
                <a:cubicBezTo>
                  <a:pt x="3796" y="579"/>
                  <a:pt x="3774" y="581"/>
                  <a:pt x="3753" y="576"/>
                </a:cubicBezTo>
                <a:cubicBezTo>
                  <a:pt x="3733" y="572"/>
                  <a:pt x="3715" y="562"/>
                  <a:pt x="3700" y="546"/>
                </a:cubicBezTo>
                <a:cubicBezTo>
                  <a:pt x="3683" y="529"/>
                  <a:pt x="3672" y="509"/>
                  <a:pt x="3667" y="484"/>
                </a:cubicBezTo>
                <a:cubicBezTo>
                  <a:pt x="3661" y="460"/>
                  <a:pt x="3664" y="435"/>
                  <a:pt x="3675" y="409"/>
                </a:cubicBezTo>
                <a:cubicBezTo>
                  <a:pt x="3686" y="382"/>
                  <a:pt x="3703" y="358"/>
                  <a:pt x="3725" y="335"/>
                </a:cubicBezTo>
                <a:cubicBezTo>
                  <a:pt x="3750" y="311"/>
                  <a:pt x="3776" y="293"/>
                  <a:pt x="3803" y="282"/>
                </a:cubicBezTo>
                <a:cubicBezTo>
                  <a:pt x="3830" y="271"/>
                  <a:pt x="3857" y="268"/>
                  <a:pt x="3883" y="273"/>
                </a:cubicBezTo>
                <a:cubicBezTo>
                  <a:pt x="3908" y="278"/>
                  <a:pt x="3932" y="291"/>
                  <a:pt x="3952" y="310"/>
                </a:cubicBezTo>
                <a:lnTo>
                  <a:pt x="3913" y="355"/>
                </a:lnTo>
                <a:cubicBezTo>
                  <a:pt x="3889" y="336"/>
                  <a:pt x="3865" y="328"/>
                  <a:pt x="3841" y="331"/>
                </a:cubicBezTo>
                <a:cubicBezTo>
                  <a:pt x="3817" y="333"/>
                  <a:pt x="3792" y="347"/>
                  <a:pt x="3766" y="373"/>
                </a:cubicBezTo>
                <a:cubicBezTo>
                  <a:pt x="3740" y="400"/>
                  <a:pt x="3725" y="424"/>
                  <a:pt x="3722" y="446"/>
                </a:cubicBezTo>
                <a:cubicBezTo>
                  <a:pt x="3720" y="469"/>
                  <a:pt x="3726" y="487"/>
                  <a:pt x="3740" y="501"/>
                </a:cubicBezTo>
                <a:cubicBezTo>
                  <a:pt x="3752" y="513"/>
                  <a:pt x="3766" y="518"/>
                  <a:pt x="3782" y="517"/>
                </a:cubicBezTo>
                <a:cubicBezTo>
                  <a:pt x="3799" y="517"/>
                  <a:pt x="3829" y="502"/>
                  <a:pt x="3873" y="474"/>
                </a:cubicBezTo>
                <a:cubicBezTo>
                  <a:pt x="3918" y="446"/>
                  <a:pt x="3950" y="429"/>
                  <a:pt x="3969" y="421"/>
                </a:cubicBezTo>
                <a:cubicBezTo>
                  <a:pt x="3998" y="411"/>
                  <a:pt x="4024" y="408"/>
                  <a:pt x="4047" y="412"/>
                </a:cubicBezTo>
                <a:cubicBezTo>
                  <a:pt x="4070" y="417"/>
                  <a:pt x="4091" y="428"/>
                  <a:pt x="4109" y="446"/>
                </a:cubicBezTo>
                <a:cubicBezTo>
                  <a:pt x="4127" y="464"/>
                  <a:pt x="4138" y="486"/>
                  <a:pt x="4144" y="512"/>
                </a:cubicBezTo>
                <a:cubicBezTo>
                  <a:pt x="4149" y="538"/>
                  <a:pt x="4147" y="565"/>
                  <a:pt x="4137" y="593"/>
                </a:cubicBezTo>
                <a:cubicBezTo>
                  <a:pt x="4126" y="621"/>
                  <a:pt x="4109" y="647"/>
                  <a:pt x="4085" y="671"/>
                </a:cubicBezTo>
                <a:cubicBezTo>
                  <a:pt x="4055" y="701"/>
                  <a:pt x="4025" y="722"/>
                  <a:pt x="3995" y="734"/>
                </a:cubicBezTo>
                <a:cubicBezTo>
                  <a:pt x="3966" y="746"/>
                  <a:pt x="3936" y="749"/>
                  <a:pt x="3907" y="742"/>
                </a:cubicBezTo>
                <a:cubicBezTo>
                  <a:pt x="3877" y="736"/>
                  <a:pt x="3851" y="722"/>
                  <a:pt x="3828" y="700"/>
                </a:cubicBezTo>
                <a:close/>
                <a:moveTo>
                  <a:pt x="4407" y="338"/>
                </a:moveTo>
                <a:lnTo>
                  <a:pt x="4365" y="379"/>
                </a:lnTo>
                <a:lnTo>
                  <a:pt x="4102" y="116"/>
                </a:lnTo>
                <a:cubicBezTo>
                  <a:pt x="4102" y="136"/>
                  <a:pt x="4098" y="158"/>
                  <a:pt x="4092" y="184"/>
                </a:cubicBezTo>
                <a:cubicBezTo>
                  <a:pt x="4085" y="209"/>
                  <a:pt x="4078" y="231"/>
                  <a:pt x="4070" y="248"/>
                </a:cubicBezTo>
                <a:lnTo>
                  <a:pt x="4030" y="209"/>
                </a:lnTo>
                <a:cubicBezTo>
                  <a:pt x="4042" y="175"/>
                  <a:pt x="4049" y="141"/>
                  <a:pt x="4051" y="109"/>
                </a:cubicBezTo>
                <a:cubicBezTo>
                  <a:pt x="4053" y="76"/>
                  <a:pt x="4050" y="49"/>
                  <a:pt x="4043" y="27"/>
                </a:cubicBezTo>
                <a:lnTo>
                  <a:pt x="4069" y="0"/>
                </a:lnTo>
                <a:lnTo>
                  <a:pt x="4407" y="338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89" name="Freeform 71"/>
          <p:cNvSpPr>
            <a:spLocks noEditPoints="1"/>
          </p:cNvSpPr>
          <p:nvPr/>
        </p:nvSpPr>
        <p:spPr bwMode="auto">
          <a:xfrm>
            <a:off x="3495853" y="4611475"/>
            <a:ext cx="850900" cy="839787"/>
          </a:xfrm>
          <a:custGeom>
            <a:avLst/>
            <a:gdLst>
              <a:gd name="T0" fmla="*/ 238 w 4468"/>
              <a:gd name="T1" fmla="*/ 3878 h 4415"/>
              <a:gd name="T2" fmla="*/ 244 w 4468"/>
              <a:gd name="T3" fmla="*/ 4234 h 4415"/>
              <a:gd name="T4" fmla="*/ 336 w 4468"/>
              <a:gd name="T5" fmla="*/ 4030 h 4415"/>
              <a:gd name="T6" fmla="*/ 84 w 4468"/>
              <a:gd name="T7" fmla="*/ 4074 h 4415"/>
              <a:gd name="T8" fmla="*/ 513 w 4468"/>
              <a:gd name="T9" fmla="*/ 3586 h 4415"/>
              <a:gd name="T10" fmla="*/ 740 w 4468"/>
              <a:gd name="T11" fmla="*/ 3714 h 4415"/>
              <a:gd name="T12" fmla="*/ 779 w 4468"/>
              <a:gd name="T13" fmla="*/ 3972 h 4415"/>
              <a:gd name="T14" fmla="*/ 620 w 4468"/>
              <a:gd name="T15" fmla="*/ 3699 h 4415"/>
              <a:gd name="T16" fmla="*/ 399 w 4468"/>
              <a:gd name="T17" fmla="*/ 3759 h 4415"/>
              <a:gd name="T18" fmla="*/ 784 w 4468"/>
              <a:gd name="T19" fmla="*/ 3866 h 4415"/>
              <a:gd name="T20" fmla="*/ 618 w 4468"/>
              <a:gd name="T21" fmla="*/ 3823 h 4415"/>
              <a:gd name="T22" fmla="*/ 743 w 4468"/>
              <a:gd name="T23" fmla="*/ 3335 h 4415"/>
              <a:gd name="T24" fmla="*/ 1131 w 4468"/>
              <a:gd name="T25" fmla="*/ 3416 h 4415"/>
              <a:gd name="T26" fmla="*/ 964 w 4468"/>
              <a:gd name="T27" fmla="*/ 3787 h 4415"/>
              <a:gd name="T28" fmla="*/ 1081 w 4468"/>
              <a:gd name="T29" fmla="*/ 3458 h 4415"/>
              <a:gd name="T30" fmla="*/ 712 w 4468"/>
              <a:gd name="T31" fmla="*/ 3446 h 4415"/>
              <a:gd name="T32" fmla="*/ 1627 w 4468"/>
              <a:gd name="T33" fmla="*/ 3311 h 4415"/>
              <a:gd name="T34" fmla="*/ 1414 w 4468"/>
              <a:gd name="T35" fmla="*/ 2671 h 4415"/>
              <a:gd name="T36" fmla="*/ 1563 w 4468"/>
              <a:gd name="T37" fmla="*/ 2915 h 4415"/>
              <a:gd name="T38" fmla="*/ 1524 w 4468"/>
              <a:gd name="T39" fmla="*/ 2874 h 4415"/>
              <a:gd name="T40" fmla="*/ 1403 w 4468"/>
              <a:gd name="T41" fmla="*/ 2755 h 4415"/>
              <a:gd name="T42" fmla="*/ 1788 w 4468"/>
              <a:gd name="T43" fmla="*/ 2291 h 4415"/>
              <a:gd name="T44" fmla="*/ 1957 w 4468"/>
              <a:gd name="T45" fmla="*/ 2485 h 4415"/>
              <a:gd name="T46" fmla="*/ 1881 w 4468"/>
              <a:gd name="T47" fmla="*/ 2870 h 4415"/>
              <a:gd name="T48" fmla="*/ 2042 w 4468"/>
              <a:gd name="T49" fmla="*/ 2209 h 4415"/>
              <a:gd name="T50" fmla="*/ 2166 w 4468"/>
              <a:gd name="T51" fmla="*/ 2230 h 4415"/>
              <a:gd name="T52" fmla="*/ 2183 w 4468"/>
              <a:gd name="T53" fmla="*/ 2333 h 4415"/>
              <a:gd name="T54" fmla="*/ 2343 w 4468"/>
              <a:gd name="T55" fmla="*/ 1882 h 4415"/>
              <a:gd name="T56" fmla="*/ 2283 w 4468"/>
              <a:gd name="T57" fmla="*/ 1793 h 4415"/>
              <a:gd name="T58" fmla="*/ 2531 w 4468"/>
              <a:gd name="T59" fmla="*/ 1797 h 4415"/>
              <a:gd name="T60" fmla="*/ 2472 w 4468"/>
              <a:gd name="T61" fmla="*/ 1615 h 4415"/>
              <a:gd name="T62" fmla="*/ 2531 w 4468"/>
              <a:gd name="T63" fmla="*/ 1628 h 4415"/>
              <a:gd name="T64" fmla="*/ 2608 w 4468"/>
              <a:gd name="T65" fmla="*/ 1720 h 4415"/>
              <a:gd name="T66" fmla="*/ 2901 w 4468"/>
              <a:gd name="T67" fmla="*/ 1767 h 4415"/>
              <a:gd name="T68" fmla="*/ 2885 w 4468"/>
              <a:gd name="T69" fmla="*/ 1660 h 4415"/>
              <a:gd name="T70" fmla="*/ 2685 w 4468"/>
              <a:gd name="T71" fmla="*/ 1602 h 4415"/>
              <a:gd name="T72" fmla="*/ 2895 w 4468"/>
              <a:gd name="T73" fmla="*/ 1495 h 4415"/>
              <a:gd name="T74" fmla="*/ 2745 w 4468"/>
              <a:gd name="T75" fmla="*/ 1638 h 4415"/>
              <a:gd name="T76" fmla="*/ 2968 w 4468"/>
              <a:gd name="T77" fmla="*/ 1569 h 4415"/>
              <a:gd name="T78" fmla="*/ 2900 w 4468"/>
              <a:gd name="T79" fmla="*/ 1823 h 4415"/>
              <a:gd name="T80" fmla="*/ 2965 w 4468"/>
              <a:gd name="T81" fmla="*/ 1316 h 4415"/>
              <a:gd name="T82" fmla="*/ 2943 w 4468"/>
              <a:gd name="T83" fmla="*/ 1133 h 4415"/>
              <a:gd name="T84" fmla="*/ 3280 w 4468"/>
              <a:gd name="T85" fmla="*/ 894 h 4415"/>
              <a:gd name="T86" fmla="*/ 3568 w 4468"/>
              <a:gd name="T87" fmla="*/ 1183 h 4415"/>
              <a:gd name="T88" fmla="*/ 3485 w 4468"/>
              <a:gd name="T89" fmla="*/ 601 h 4415"/>
              <a:gd name="T90" fmla="*/ 3634 w 4468"/>
              <a:gd name="T91" fmla="*/ 844 h 4415"/>
              <a:gd name="T92" fmla="*/ 3595 w 4468"/>
              <a:gd name="T93" fmla="*/ 804 h 4415"/>
              <a:gd name="T94" fmla="*/ 3474 w 4468"/>
              <a:gd name="T95" fmla="*/ 685 h 4415"/>
              <a:gd name="T96" fmla="*/ 3921 w 4468"/>
              <a:gd name="T97" fmla="*/ 689 h 4415"/>
              <a:gd name="T98" fmla="*/ 4069 w 4468"/>
              <a:gd name="T99" fmla="*/ 500 h 4415"/>
              <a:gd name="T100" fmla="*/ 3753 w 4468"/>
              <a:gd name="T101" fmla="*/ 583 h 4415"/>
              <a:gd name="T102" fmla="*/ 3803 w 4468"/>
              <a:gd name="T103" fmla="*/ 289 h 4415"/>
              <a:gd name="T104" fmla="*/ 3766 w 4468"/>
              <a:gd name="T105" fmla="*/ 380 h 4415"/>
              <a:gd name="T106" fmla="*/ 3969 w 4468"/>
              <a:gd name="T107" fmla="*/ 428 h 4415"/>
              <a:gd name="T108" fmla="*/ 4084 w 4468"/>
              <a:gd name="T109" fmla="*/ 678 h 4415"/>
              <a:gd name="T110" fmla="*/ 4468 w 4468"/>
              <a:gd name="T111" fmla="*/ 283 h 4415"/>
              <a:gd name="T112" fmla="*/ 4210 w 4468"/>
              <a:gd name="T113" fmla="*/ 150 h 4415"/>
              <a:gd name="T114" fmla="*/ 4060 w 4468"/>
              <a:gd name="T115" fmla="*/ 219 h 4415"/>
              <a:gd name="T116" fmla="*/ 4223 w 4468"/>
              <a:gd name="T117" fmla="*/ 40 h 4415"/>
              <a:gd name="T118" fmla="*/ 4263 w 4468"/>
              <a:gd name="T119" fmla="*/ 409 h 441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</a:cxnLst>
            <a:rect l="0" t="0" r="r" b="b"/>
            <a:pathLst>
              <a:path w="4468" h="4415">
                <a:moveTo>
                  <a:pt x="336" y="4415"/>
                </a:moveTo>
                <a:lnTo>
                  <a:pt x="0" y="4079"/>
                </a:lnTo>
                <a:lnTo>
                  <a:pt x="127" y="3952"/>
                </a:lnTo>
                <a:cubicBezTo>
                  <a:pt x="149" y="3930"/>
                  <a:pt x="167" y="3914"/>
                  <a:pt x="181" y="3904"/>
                </a:cubicBezTo>
                <a:cubicBezTo>
                  <a:pt x="200" y="3890"/>
                  <a:pt x="219" y="3882"/>
                  <a:pt x="238" y="3878"/>
                </a:cubicBezTo>
                <a:cubicBezTo>
                  <a:pt x="257" y="3875"/>
                  <a:pt x="277" y="3877"/>
                  <a:pt x="297" y="3884"/>
                </a:cubicBezTo>
                <a:cubicBezTo>
                  <a:pt x="318" y="3891"/>
                  <a:pt x="337" y="3903"/>
                  <a:pt x="354" y="3920"/>
                </a:cubicBezTo>
                <a:cubicBezTo>
                  <a:pt x="382" y="3948"/>
                  <a:pt x="397" y="3981"/>
                  <a:pt x="399" y="4019"/>
                </a:cubicBezTo>
                <a:cubicBezTo>
                  <a:pt x="400" y="4057"/>
                  <a:pt x="377" y="4100"/>
                  <a:pt x="330" y="4148"/>
                </a:cubicBezTo>
                <a:lnTo>
                  <a:pt x="244" y="4234"/>
                </a:lnTo>
                <a:lnTo>
                  <a:pt x="380" y="4371"/>
                </a:lnTo>
                <a:lnTo>
                  <a:pt x="336" y="4415"/>
                </a:lnTo>
                <a:close/>
                <a:moveTo>
                  <a:pt x="204" y="4194"/>
                </a:moveTo>
                <a:lnTo>
                  <a:pt x="291" y="4107"/>
                </a:lnTo>
                <a:cubicBezTo>
                  <a:pt x="320" y="4079"/>
                  <a:pt x="335" y="4053"/>
                  <a:pt x="336" y="4030"/>
                </a:cubicBezTo>
                <a:cubicBezTo>
                  <a:pt x="337" y="4007"/>
                  <a:pt x="328" y="3986"/>
                  <a:pt x="309" y="3967"/>
                </a:cubicBezTo>
                <a:cubicBezTo>
                  <a:pt x="295" y="3953"/>
                  <a:pt x="279" y="3944"/>
                  <a:pt x="262" y="3941"/>
                </a:cubicBezTo>
                <a:cubicBezTo>
                  <a:pt x="245" y="3938"/>
                  <a:pt x="229" y="3941"/>
                  <a:pt x="214" y="3950"/>
                </a:cubicBezTo>
                <a:cubicBezTo>
                  <a:pt x="205" y="3955"/>
                  <a:pt x="190" y="3968"/>
                  <a:pt x="170" y="3988"/>
                </a:cubicBezTo>
                <a:lnTo>
                  <a:pt x="84" y="4074"/>
                </a:lnTo>
                <a:lnTo>
                  <a:pt x="204" y="4194"/>
                </a:lnTo>
                <a:close/>
                <a:moveTo>
                  <a:pt x="651" y="4100"/>
                </a:moveTo>
                <a:lnTo>
                  <a:pt x="315" y="3764"/>
                </a:lnTo>
                <a:lnTo>
                  <a:pt x="441" y="3638"/>
                </a:lnTo>
                <a:cubicBezTo>
                  <a:pt x="467" y="3612"/>
                  <a:pt x="491" y="3595"/>
                  <a:pt x="513" y="3586"/>
                </a:cubicBezTo>
                <a:cubicBezTo>
                  <a:pt x="535" y="3578"/>
                  <a:pt x="558" y="3576"/>
                  <a:pt x="581" y="3581"/>
                </a:cubicBezTo>
                <a:cubicBezTo>
                  <a:pt x="604" y="3587"/>
                  <a:pt x="623" y="3597"/>
                  <a:pt x="638" y="3612"/>
                </a:cubicBezTo>
                <a:cubicBezTo>
                  <a:pt x="653" y="3627"/>
                  <a:pt x="662" y="3644"/>
                  <a:pt x="667" y="3665"/>
                </a:cubicBezTo>
                <a:cubicBezTo>
                  <a:pt x="672" y="3685"/>
                  <a:pt x="670" y="3707"/>
                  <a:pt x="663" y="3731"/>
                </a:cubicBezTo>
                <a:cubicBezTo>
                  <a:pt x="689" y="3716"/>
                  <a:pt x="715" y="3711"/>
                  <a:pt x="740" y="3714"/>
                </a:cubicBezTo>
                <a:cubicBezTo>
                  <a:pt x="765" y="3718"/>
                  <a:pt x="788" y="3729"/>
                  <a:pt x="807" y="3749"/>
                </a:cubicBezTo>
                <a:cubicBezTo>
                  <a:pt x="823" y="3765"/>
                  <a:pt x="834" y="3783"/>
                  <a:pt x="841" y="3803"/>
                </a:cubicBezTo>
                <a:cubicBezTo>
                  <a:pt x="848" y="3823"/>
                  <a:pt x="850" y="3842"/>
                  <a:pt x="848" y="3859"/>
                </a:cubicBezTo>
                <a:cubicBezTo>
                  <a:pt x="845" y="3876"/>
                  <a:pt x="839" y="3894"/>
                  <a:pt x="828" y="3912"/>
                </a:cubicBezTo>
                <a:cubicBezTo>
                  <a:pt x="817" y="3931"/>
                  <a:pt x="800" y="3951"/>
                  <a:pt x="779" y="3972"/>
                </a:cubicBezTo>
                <a:lnTo>
                  <a:pt x="651" y="4100"/>
                </a:lnTo>
                <a:close/>
                <a:moveTo>
                  <a:pt x="500" y="3861"/>
                </a:moveTo>
                <a:lnTo>
                  <a:pt x="573" y="3788"/>
                </a:lnTo>
                <a:cubicBezTo>
                  <a:pt x="593" y="3768"/>
                  <a:pt x="606" y="3753"/>
                  <a:pt x="612" y="3742"/>
                </a:cubicBezTo>
                <a:cubicBezTo>
                  <a:pt x="620" y="3727"/>
                  <a:pt x="623" y="3713"/>
                  <a:pt x="620" y="3699"/>
                </a:cubicBezTo>
                <a:cubicBezTo>
                  <a:pt x="618" y="3686"/>
                  <a:pt x="611" y="3673"/>
                  <a:pt x="600" y="3662"/>
                </a:cubicBezTo>
                <a:cubicBezTo>
                  <a:pt x="589" y="3650"/>
                  <a:pt x="576" y="3643"/>
                  <a:pt x="562" y="3640"/>
                </a:cubicBezTo>
                <a:cubicBezTo>
                  <a:pt x="548" y="3637"/>
                  <a:pt x="535" y="3639"/>
                  <a:pt x="522" y="3646"/>
                </a:cubicBezTo>
                <a:cubicBezTo>
                  <a:pt x="509" y="3652"/>
                  <a:pt x="490" y="3668"/>
                  <a:pt x="466" y="3692"/>
                </a:cubicBezTo>
                <a:lnTo>
                  <a:pt x="399" y="3759"/>
                </a:lnTo>
                <a:lnTo>
                  <a:pt x="500" y="3861"/>
                </a:lnTo>
                <a:close/>
                <a:moveTo>
                  <a:pt x="656" y="4016"/>
                </a:moveTo>
                <a:lnTo>
                  <a:pt x="739" y="3932"/>
                </a:lnTo>
                <a:cubicBezTo>
                  <a:pt x="754" y="3918"/>
                  <a:pt x="763" y="3907"/>
                  <a:pt x="768" y="3900"/>
                </a:cubicBezTo>
                <a:cubicBezTo>
                  <a:pt x="776" y="3888"/>
                  <a:pt x="782" y="3877"/>
                  <a:pt x="784" y="3866"/>
                </a:cubicBezTo>
                <a:cubicBezTo>
                  <a:pt x="787" y="3854"/>
                  <a:pt x="787" y="3843"/>
                  <a:pt x="783" y="3830"/>
                </a:cubicBezTo>
                <a:cubicBezTo>
                  <a:pt x="779" y="3817"/>
                  <a:pt x="772" y="3806"/>
                  <a:pt x="761" y="3795"/>
                </a:cubicBezTo>
                <a:cubicBezTo>
                  <a:pt x="749" y="3782"/>
                  <a:pt x="734" y="3775"/>
                  <a:pt x="719" y="3772"/>
                </a:cubicBezTo>
                <a:cubicBezTo>
                  <a:pt x="703" y="3769"/>
                  <a:pt x="688" y="3771"/>
                  <a:pt x="673" y="3779"/>
                </a:cubicBezTo>
                <a:cubicBezTo>
                  <a:pt x="657" y="3787"/>
                  <a:pt x="639" y="3801"/>
                  <a:pt x="618" y="3823"/>
                </a:cubicBezTo>
                <a:lnTo>
                  <a:pt x="540" y="3900"/>
                </a:lnTo>
                <a:lnTo>
                  <a:pt x="656" y="4016"/>
                </a:lnTo>
                <a:close/>
                <a:moveTo>
                  <a:pt x="964" y="3787"/>
                </a:moveTo>
                <a:lnTo>
                  <a:pt x="628" y="3451"/>
                </a:lnTo>
                <a:lnTo>
                  <a:pt x="743" y="3335"/>
                </a:lnTo>
                <a:cubicBezTo>
                  <a:pt x="770" y="3309"/>
                  <a:pt x="791" y="3291"/>
                  <a:pt x="808" y="3280"/>
                </a:cubicBezTo>
                <a:cubicBezTo>
                  <a:pt x="832" y="3265"/>
                  <a:pt x="856" y="3257"/>
                  <a:pt x="881" y="3255"/>
                </a:cubicBezTo>
                <a:cubicBezTo>
                  <a:pt x="914" y="3252"/>
                  <a:pt x="947" y="3258"/>
                  <a:pt x="979" y="3273"/>
                </a:cubicBezTo>
                <a:cubicBezTo>
                  <a:pt x="1011" y="3287"/>
                  <a:pt x="1042" y="3309"/>
                  <a:pt x="1072" y="3339"/>
                </a:cubicBezTo>
                <a:cubicBezTo>
                  <a:pt x="1097" y="3365"/>
                  <a:pt x="1117" y="3390"/>
                  <a:pt x="1131" y="3416"/>
                </a:cubicBezTo>
                <a:cubicBezTo>
                  <a:pt x="1144" y="3442"/>
                  <a:pt x="1153" y="3466"/>
                  <a:pt x="1157" y="3488"/>
                </a:cubicBezTo>
                <a:cubicBezTo>
                  <a:pt x="1160" y="3510"/>
                  <a:pt x="1160" y="3531"/>
                  <a:pt x="1157" y="3549"/>
                </a:cubicBezTo>
                <a:cubicBezTo>
                  <a:pt x="1153" y="3568"/>
                  <a:pt x="1145" y="3587"/>
                  <a:pt x="1133" y="3606"/>
                </a:cubicBezTo>
                <a:cubicBezTo>
                  <a:pt x="1121" y="3626"/>
                  <a:pt x="1105" y="3646"/>
                  <a:pt x="1085" y="3666"/>
                </a:cubicBezTo>
                <a:lnTo>
                  <a:pt x="964" y="3787"/>
                </a:lnTo>
                <a:close/>
                <a:moveTo>
                  <a:pt x="969" y="3703"/>
                </a:moveTo>
                <a:lnTo>
                  <a:pt x="1040" y="3631"/>
                </a:lnTo>
                <a:cubicBezTo>
                  <a:pt x="1063" y="3609"/>
                  <a:pt x="1078" y="3590"/>
                  <a:pt x="1086" y="3573"/>
                </a:cubicBezTo>
                <a:cubicBezTo>
                  <a:pt x="1095" y="3556"/>
                  <a:pt x="1099" y="3540"/>
                  <a:pt x="1099" y="3525"/>
                </a:cubicBezTo>
                <a:cubicBezTo>
                  <a:pt x="1099" y="3504"/>
                  <a:pt x="1093" y="3482"/>
                  <a:pt x="1081" y="3458"/>
                </a:cubicBezTo>
                <a:cubicBezTo>
                  <a:pt x="1069" y="3434"/>
                  <a:pt x="1051" y="3410"/>
                  <a:pt x="1025" y="3385"/>
                </a:cubicBezTo>
                <a:cubicBezTo>
                  <a:pt x="990" y="3349"/>
                  <a:pt x="957" y="3328"/>
                  <a:pt x="927" y="3321"/>
                </a:cubicBezTo>
                <a:cubicBezTo>
                  <a:pt x="896" y="3313"/>
                  <a:pt x="870" y="3315"/>
                  <a:pt x="847" y="3325"/>
                </a:cubicBezTo>
                <a:cubicBezTo>
                  <a:pt x="830" y="3332"/>
                  <a:pt x="809" y="3349"/>
                  <a:pt x="782" y="3376"/>
                </a:cubicBezTo>
                <a:lnTo>
                  <a:pt x="712" y="3446"/>
                </a:lnTo>
                <a:lnTo>
                  <a:pt x="969" y="3703"/>
                </a:lnTo>
                <a:close/>
                <a:moveTo>
                  <a:pt x="1353" y="3584"/>
                </a:moveTo>
                <a:lnTo>
                  <a:pt x="1323" y="3555"/>
                </a:lnTo>
                <a:lnTo>
                  <a:pt x="1597" y="3281"/>
                </a:lnTo>
                <a:lnTo>
                  <a:pt x="1627" y="3311"/>
                </a:lnTo>
                <a:lnTo>
                  <a:pt x="1353" y="3584"/>
                </a:lnTo>
                <a:close/>
                <a:moveTo>
                  <a:pt x="1569" y="3182"/>
                </a:moveTo>
                <a:lnTo>
                  <a:pt x="1233" y="2846"/>
                </a:lnTo>
                <a:lnTo>
                  <a:pt x="1360" y="2719"/>
                </a:lnTo>
                <a:cubicBezTo>
                  <a:pt x="1382" y="2697"/>
                  <a:pt x="1400" y="2681"/>
                  <a:pt x="1414" y="2671"/>
                </a:cubicBezTo>
                <a:cubicBezTo>
                  <a:pt x="1433" y="2657"/>
                  <a:pt x="1452" y="2649"/>
                  <a:pt x="1471" y="2645"/>
                </a:cubicBezTo>
                <a:cubicBezTo>
                  <a:pt x="1490" y="2642"/>
                  <a:pt x="1510" y="2644"/>
                  <a:pt x="1531" y="2651"/>
                </a:cubicBezTo>
                <a:cubicBezTo>
                  <a:pt x="1551" y="2658"/>
                  <a:pt x="1570" y="2670"/>
                  <a:pt x="1587" y="2686"/>
                </a:cubicBezTo>
                <a:cubicBezTo>
                  <a:pt x="1615" y="2715"/>
                  <a:pt x="1630" y="2748"/>
                  <a:pt x="1632" y="2786"/>
                </a:cubicBezTo>
                <a:cubicBezTo>
                  <a:pt x="1634" y="2824"/>
                  <a:pt x="1611" y="2867"/>
                  <a:pt x="1563" y="2915"/>
                </a:cubicBezTo>
                <a:lnTo>
                  <a:pt x="1477" y="3001"/>
                </a:lnTo>
                <a:lnTo>
                  <a:pt x="1614" y="3137"/>
                </a:lnTo>
                <a:lnTo>
                  <a:pt x="1569" y="3182"/>
                </a:lnTo>
                <a:close/>
                <a:moveTo>
                  <a:pt x="1437" y="2961"/>
                </a:moveTo>
                <a:lnTo>
                  <a:pt x="1524" y="2874"/>
                </a:lnTo>
                <a:cubicBezTo>
                  <a:pt x="1553" y="2845"/>
                  <a:pt x="1568" y="2820"/>
                  <a:pt x="1569" y="2797"/>
                </a:cubicBezTo>
                <a:cubicBezTo>
                  <a:pt x="1571" y="2774"/>
                  <a:pt x="1562" y="2753"/>
                  <a:pt x="1542" y="2734"/>
                </a:cubicBezTo>
                <a:cubicBezTo>
                  <a:pt x="1528" y="2720"/>
                  <a:pt x="1513" y="2711"/>
                  <a:pt x="1495" y="2708"/>
                </a:cubicBezTo>
                <a:cubicBezTo>
                  <a:pt x="1478" y="2705"/>
                  <a:pt x="1462" y="2708"/>
                  <a:pt x="1448" y="2716"/>
                </a:cubicBezTo>
                <a:cubicBezTo>
                  <a:pt x="1438" y="2722"/>
                  <a:pt x="1423" y="2735"/>
                  <a:pt x="1403" y="2755"/>
                </a:cubicBezTo>
                <a:lnTo>
                  <a:pt x="1317" y="2841"/>
                </a:lnTo>
                <a:lnTo>
                  <a:pt x="1437" y="2961"/>
                </a:lnTo>
                <a:close/>
                <a:moveTo>
                  <a:pt x="1881" y="2870"/>
                </a:moveTo>
                <a:lnTo>
                  <a:pt x="1545" y="2534"/>
                </a:lnTo>
                <a:lnTo>
                  <a:pt x="1788" y="2291"/>
                </a:lnTo>
                <a:lnTo>
                  <a:pt x="1828" y="2330"/>
                </a:lnTo>
                <a:lnTo>
                  <a:pt x="1629" y="2529"/>
                </a:lnTo>
                <a:lnTo>
                  <a:pt x="1732" y="2632"/>
                </a:lnTo>
                <a:lnTo>
                  <a:pt x="1918" y="2446"/>
                </a:lnTo>
                <a:lnTo>
                  <a:pt x="1957" y="2485"/>
                </a:lnTo>
                <a:lnTo>
                  <a:pt x="1772" y="2671"/>
                </a:lnTo>
                <a:lnTo>
                  <a:pt x="1886" y="2786"/>
                </a:lnTo>
                <a:lnTo>
                  <a:pt x="2092" y="2579"/>
                </a:lnTo>
                <a:lnTo>
                  <a:pt x="2132" y="2619"/>
                </a:lnTo>
                <a:lnTo>
                  <a:pt x="1881" y="2870"/>
                </a:lnTo>
                <a:close/>
                <a:moveTo>
                  <a:pt x="2163" y="2588"/>
                </a:moveTo>
                <a:lnTo>
                  <a:pt x="2118" y="2283"/>
                </a:lnTo>
                <a:lnTo>
                  <a:pt x="1842" y="2237"/>
                </a:lnTo>
                <a:lnTo>
                  <a:pt x="1895" y="2184"/>
                </a:lnTo>
                <a:lnTo>
                  <a:pt x="2042" y="2209"/>
                </a:lnTo>
                <a:cubicBezTo>
                  <a:pt x="2073" y="2214"/>
                  <a:pt x="2096" y="2219"/>
                  <a:pt x="2111" y="2223"/>
                </a:cubicBezTo>
                <a:cubicBezTo>
                  <a:pt x="2106" y="2203"/>
                  <a:pt x="2102" y="2182"/>
                  <a:pt x="2099" y="2158"/>
                </a:cubicBezTo>
                <a:lnTo>
                  <a:pt x="2077" y="2001"/>
                </a:lnTo>
                <a:lnTo>
                  <a:pt x="2126" y="1953"/>
                </a:lnTo>
                <a:lnTo>
                  <a:pt x="2166" y="2230"/>
                </a:lnTo>
                <a:lnTo>
                  <a:pt x="2471" y="2280"/>
                </a:lnTo>
                <a:lnTo>
                  <a:pt x="2416" y="2335"/>
                </a:lnTo>
                <a:lnTo>
                  <a:pt x="2211" y="2300"/>
                </a:lnTo>
                <a:cubicBezTo>
                  <a:pt x="2200" y="2298"/>
                  <a:pt x="2187" y="2295"/>
                  <a:pt x="2174" y="2292"/>
                </a:cubicBezTo>
                <a:cubicBezTo>
                  <a:pt x="2179" y="2312"/>
                  <a:pt x="2182" y="2325"/>
                  <a:pt x="2183" y="2333"/>
                </a:cubicBezTo>
                <a:lnTo>
                  <a:pt x="2216" y="2535"/>
                </a:lnTo>
                <a:lnTo>
                  <a:pt x="2163" y="2588"/>
                </a:lnTo>
                <a:close/>
                <a:moveTo>
                  <a:pt x="2647" y="2104"/>
                </a:moveTo>
                <a:lnTo>
                  <a:pt x="2606" y="2145"/>
                </a:lnTo>
                <a:lnTo>
                  <a:pt x="2343" y="1882"/>
                </a:lnTo>
                <a:cubicBezTo>
                  <a:pt x="2342" y="1902"/>
                  <a:pt x="2339" y="1924"/>
                  <a:pt x="2332" y="1950"/>
                </a:cubicBezTo>
                <a:cubicBezTo>
                  <a:pt x="2325" y="1976"/>
                  <a:pt x="2318" y="1997"/>
                  <a:pt x="2310" y="2015"/>
                </a:cubicBezTo>
                <a:lnTo>
                  <a:pt x="2270" y="1975"/>
                </a:lnTo>
                <a:cubicBezTo>
                  <a:pt x="2282" y="1941"/>
                  <a:pt x="2289" y="1908"/>
                  <a:pt x="2291" y="1875"/>
                </a:cubicBezTo>
                <a:cubicBezTo>
                  <a:pt x="2293" y="1842"/>
                  <a:pt x="2290" y="1815"/>
                  <a:pt x="2283" y="1793"/>
                </a:cubicBezTo>
                <a:lnTo>
                  <a:pt x="2309" y="1767"/>
                </a:lnTo>
                <a:lnTo>
                  <a:pt x="2647" y="2104"/>
                </a:lnTo>
                <a:close/>
                <a:moveTo>
                  <a:pt x="2779" y="1972"/>
                </a:moveTo>
                <a:lnTo>
                  <a:pt x="2567" y="1761"/>
                </a:lnTo>
                <a:lnTo>
                  <a:pt x="2531" y="1797"/>
                </a:lnTo>
                <a:lnTo>
                  <a:pt x="2499" y="1765"/>
                </a:lnTo>
                <a:lnTo>
                  <a:pt x="2535" y="1729"/>
                </a:lnTo>
                <a:lnTo>
                  <a:pt x="2509" y="1703"/>
                </a:lnTo>
                <a:cubicBezTo>
                  <a:pt x="2493" y="1687"/>
                  <a:pt x="2482" y="1673"/>
                  <a:pt x="2477" y="1662"/>
                </a:cubicBezTo>
                <a:cubicBezTo>
                  <a:pt x="2470" y="1647"/>
                  <a:pt x="2469" y="1632"/>
                  <a:pt x="2472" y="1615"/>
                </a:cubicBezTo>
                <a:cubicBezTo>
                  <a:pt x="2475" y="1598"/>
                  <a:pt x="2486" y="1581"/>
                  <a:pt x="2504" y="1563"/>
                </a:cubicBezTo>
                <a:cubicBezTo>
                  <a:pt x="2516" y="1551"/>
                  <a:pt x="2530" y="1540"/>
                  <a:pt x="2547" y="1529"/>
                </a:cubicBezTo>
                <a:lnTo>
                  <a:pt x="2577" y="1571"/>
                </a:lnTo>
                <a:cubicBezTo>
                  <a:pt x="2567" y="1578"/>
                  <a:pt x="2558" y="1585"/>
                  <a:pt x="2550" y="1593"/>
                </a:cubicBezTo>
                <a:cubicBezTo>
                  <a:pt x="2537" y="1605"/>
                  <a:pt x="2531" y="1617"/>
                  <a:pt x="2531" y="1628"/>
                </a:cubicBezTo>
                <a:cubicBezTo>
                  <a:pt x="2532" y="1638"/>
                  <a:pt x="2539" y="1651"/>
                  <a:pt x="2554" y="1665"/>
                </a:cubicBezTo>
                <a:lnTo>
                  <a:pt x="2576" y="1688"/>
                </a:lnTo>
                <a:lnTo>
                  <a:pt x="2624" y="1640"/>
                </a:lnTo>
                <a:lnTo>
                  <a:pt x="2656" y="1672"/>
                </a:lnTo>
                <a:lnTo>
                  <a:pt x="2608" y="1720"/>
                </a:lnTo>
                <a:lnTo>
                  <a:pt x="2820" y="1931"/>
                </a:lnTo>
                <a:lnTo>
                  <a:pt x="2779" y="1972"/>
                </a:lnTo>
                <a:close/>
                <a:moveTo>
                  <a:pt x="2810" y="1796"/>
                </a:moveTo>
                <a:lnTo>
                  <a:pt x="2844" y="1749"/>
                </a:lnTo>
                <a:cubicBezTo>
                  <a:pt x="2863" y="1763"/>
                  <a:pt x="2882" y="1769"/>
                  <a:pt x="2901" y="1767"/>
                </a:cubicBezTo>
                <a:cubicBezTo>
                  <a:pt x="2920" y="1765"/>
                  <a:pt x="2939" y="1755"/>
                  <a:pt x="2958" y="1736"/>
                </a:cubicBezTo>
                <a:cubicBezTo>
                  <a:pt x="2977" y="1717"/>
                  <a:pt x="2987" y="1699"/>
                  <a:pt x="2988" y="1683"/>
                </a:cubicBezTo>
                <a:cubicBezTo>
                  <a:pt x="2990" y="1666"/>
                  <a:pt x="2985" y="1652"/>
                  <a:pt x="2975" y="1642"/>
                </a:cubicBezTo>
                <a:cubicBezTo>
                  <a:pt x="2966" y="1632"/>
                  <a:pt x="2954" y="1629"/>
                  <a:pt x="2941" y="1632"/>
                </a:cubicBezTo>
                <a:cubicBezTo>
                  <a:pt x="2931" y="1634"/>
                  <a:pt x="2913" y="1643"/>
                  <a:pt x="2885" y="1660"/>
                </a:cubicBezTo>
                <a:cubicBezTo>
                  <a:pt x="2847" y="1683"/>
                  <a:pt x="2819" y="1697"/>
                  <a:pt x="2802" y="1703"/>
                </a:cubicBezTo>
                <a:cubicBezTo>
                  <a:pt x="2785" y="1709"/>
                  <a:pt x="2768" y="1710"/>
                  <a:pt x="2752" y="1707"/>
                </a:cubicBezTo>
                <a:cubicBezTo>
                  <a:pt x="2736" y="1703"/>
                  <a:pt x="2722" y="1695"/>
                  <a:pt x="2710" y="1683"/>
                </a:cubicBezTo>
                <a:cubicBezTo>
                  <a:pt x="2700" y="1672"/>
                  <a:pt x="2692" y="1660"/>
                  <a:pt x="2688" y="1645"/>
                </a:cubicBezTo>
                <a:cubicBezTo>
                  <a:pt x="2683" y="1631"/>
                  <a:pt x="2682" y="1617"/>
                  <a:pt x="2685" y="1602"/>
                </a:cubicBezTo>
                <a:cubicBezTo>
                  <a:pt x="2687" y="1591"/>
                  <a:pt x="2691" y="1578"/>
                  <a:pt x="2699" y="1564"/>
                </a:cubicBezTo>
                <a:cubicBezTo>
                  <a:pt x="2707" y="1549"/>
                  <a:pt x="2717" y="1536"/>
                  <a:pt x="2730" y="1523"/>
                </a:cubicBezTo>
                <a:cubicBezTo>
                  <a:pt x="2749" y="1504"/>
                  <a:pt x="2768" y="1490"/>
                  <a:pt x="2788" y="1481"/>
                </a:cubicBezTo>
                <a:cubicBezTo>
                  <a:pt x="2808" y="1472"/>
                  <a:pt x="2826" y="1469"/>
                  <a:pt x="2843" y="1471"/>
                </a:cubicBezTo>
                <a:cubicBezTo>
                  <a:pt x="2859" y="1474"/>
                  <a:pt x="2876" y="1482"/>
                  <a:pt x="2895" y="1495"/>
                </a:cubicBezTo>
                <a:lnTo>
                  <a:pt x="2860" y="1541"/>
                </a:lnTo>
                <a:cubicBezTo>
                  <a:pt x="2845" y="1530"/>
                  <a:pt x="2830" y="1526"/>
                  <a:pt x="2815" y="1527"/>
                </a:cubicBezTo>
                <a:cubicBezTo>
                  <a:pt x="2799" y="1529"/>
                  <a:pt x="2783" y="1538"/>
                  <a:pt x="2767" y="1554"/>
                </a:cubicBezTo>
                <a:cubicBezTo>
                  <a:pt x="2748" y="1573"/>
                  <a:pt x="2737" y="1590"/>
                  <a:pt x="2736" y="1604"/>
                </a:cubicBezTo>
                <a:cubicBezTo>
                  <a:pt x="2734" y="1618"/>
                  <a:pt x="2737" y="1630"/>
                  <a:pt x="2745" y="1638"/>
                </a:cubicBezTo>
                <a:cubicBezTo>
                  <a:pt x="2751" y="1644"/>
                  <a:pt x="2757" y="1647"/>
                  <a:pt x="2765" y="1648"/>
                </a:cubicBezTo>
                <a:cubicBezTo>
                  <a:pt x="2773" y="1649"/>
                  <a:pt x="2782" y="1647"/>
                  <a:pt x="2792" y="1643"/>
                </a:cubicBezTo>
                <a:cubicBezTo>
                  <a:pt x="2797" y="1640"/>
                  <a:pt x="2813" y="1632"/>
                  <a:pt x="2839" y="1617"/>
                </a:cubicBezTo>
                <a:cubicBezTo>
                  <a:pt x="2876" y="1595"/>
                  <a:pt x="2902" y="1581"/>
                  <a:pt x="2919" y="1575"/>
                </a:cubicBezTo>
                <a:cubicBezTo>
                  <a:pt x="2936" y="1568"/>
                  <a:pt x="2952" y="1567"/>
                  <a:pt x="2968" y="1569"/>
                </a:cubicBezTo>
                <a:cubicBezTo>
                  <a:pt x="2984" y="1572"/>
                  <a:pt x="2999" y="1581"/>
                  <a:pt x="3013" y="1595"/>
                </a:cubicBezTo>
                <a:cubicBezTo>
                  <a:pt x="3027" y="1609"/>
                  <a:pt x="3036" y="1626"/>
                  <a:pt x="3040" y="1646"/>
                </a:cubicBezTo>
                <a:cubicBezTo>
                  <a:pt x="3044" y="1666"/>
                  <a:pt x="3042" y="1687"/>
                  <a:pt x="3033" y="1709"/>
                </a:cubicBezTo>
                <a:cubicBezTo>
                  <a:pt x="3025" y="1730"/>
                  <a:pt x="3011" y="1751"/>
                  <a:pt x="2992" y="1770"/>
                </a:cubicBezTo>
                <a:cubicBezTo>
                  <a:pt x="2960" y="1802"/>
                  <a:pt x="2930" y="1819"/>
                  <a:pt x="2900" y="1823"/>
                </a:cubicBezTo>
                <a:cubicBezTo>
                  <a:pt x="2870" y="1826"/>
                  <a:pt x="2840" y="1817"/>
                  <a:pt x="2810" y="1796"/>
                </a:cubicBezTo>
                <a:close/>
                <a:moveTo>
                  <a:pt x="3280" y="1471"/>
                </a:moveTo>
                <a:lnTo>
                  <a:pt x="3239" y="1512"/>
                </a:lnTo>
                <a:lnTo>
                  <a:pt x="2976" y="1249"/>
                </a:lnTo>
                <a:cubicBezTo>
                  <a:pt x="2976" y="1268"/>
                  <a:pt x="2972" y="1291"/>
                  <a:pt x="2965" y="1316"/>
                </a:cubicBezTo>
                <a:cubicBezTo>
                  <a:pt x="2959" y="1342"/>
                  <a:pt x="2951" y="1364"/>
                  <a:pt x="2943" y="1381"/>
                </a:cubicBezTo>
                <a:lnTo>
                  <a:pt x="2903" y="1341"/>
                </a:lnTo>
                <a:cubicBezTo>
                  <a:pt x="2916" y="1307"/>
                  <a:pt x="2923" y="1274"/>
                  <a:pt x="2925" y="1241"/>
                </a:cubicBezTo>
                <a:cubicBezTo>
                  <a:pt x="2926" y="1209"/>
                  <a:pt x="2924" y="1181"/>
                  <a:pt x="2916" y="1160"/>
                </a:cubicBezTo>
                <a:lnTo>
                  <a:pt x="2943" y="1133"/>
                </a:lnTo>
                <a:lnTo>
                  <a:pt x="3280" y="1471"/>
                </a:lnTo>
                <a:close/>
                <a:moveTo>
                  <a:pt x="3238" y="935"/>
                </a:moveTo>
                <a:lnTo>
                  <a:pt x="3191" y="888"/>
                </a:lnTo>
                <a:lnTo>
                  <a:pt x="3232" y="847"/>
                </a:lnTo>
                <a:lnTo>
                  <a:pt x="3280" y="894"/>
                </a:lnTo>
                <a:lnTo>
                  <a:pt x="3238" y="935"/>
                </a:lnTo>
                <a:close/>
                <a:moveTo>
                  <a:pt x="3527" y="1224"/>
                </a:moveTo>
                <a:lnTo>
                  <a:pt x="3283" y="980"/>
                </a:lnTo>
                <a:lnTo>
                  <a:pt x="3325" y="939"/>
                </a:lnTo>
                <a:lnTo>
                  <a:pt x="3568" y="1183"/>
                </a:lnTo>
                <a:lnTo>
                  <a:pt x="3527" y="1224"/>
                </a:lnTo>
                <a:close/>
                <a:moveTo>
                  <a:pt x="3639" y="1111"/>
                </a:moveTo>
                <a:lnTo>
                  <a:pt x="3303" y="775"/>
                </a:lnTo>
                <a:lnTo>
                  <a:pt x="3430" y="649"/>
                </a:lnTo>
                <a:cubicBezTo>
                  <a:pt x="3452" y="626"/>
                  <a:pt x="3471" y="610"/>
                  <a:pt x="3485" y="601"/>
                </a:cubicBezTo>
                <a:cubicBezTo>
                  <a:pt x="3504" y="587"/>
                  <a:pt x="3523" y="578"/>
                  <a:pt x="3542" y="575"/>
                </a:cubicBezTo>
                <a:cubicBezTo>
                  <a:pt x="3561" y="571"/>
                  <a:pt x="3580" y="573"/>
                  <a:pt x="3601" y="580"/>
                </a:cubicBezTo>
                <a:cubicBezTo>
                  <a:pt x="3622" y="587"/>
                  <a:pt x="3640" y="599"/>
                  <a:pt x="3657" y="616"/>
                </a:cubicBezTo>
                <a:cubicBezTo>
                  <a:pt x="3686" y="645"/>
                  <a:pt x="3701" y="678"/>
                  <a:pt x="3702" y="716"/>
                </a:cubicBezTo>
                <a:cubicBezTo>
                  <a:pt x="3704" y="754"/>
                  <a:pt x="3681" y="797"/>
                  <a:pt x="3634" y="844"/>
                </a:cubicBezTo>
                <a:lnTo>
                  <a:pt x="3547" y="930"/>
                </a:lnTo>
                <a:lnTo>
                  <a:pt x="3684" y="1067"/>
                </a:lnTo>
                <a:lnTo>
                  <a:pt x="3639" y="1111"/>
                </a:lnTo>
                <a:close/>
                <a:moveTo>
                  <a:pt x="3508" y="891"/>
                </a:moveTo>
                <a:lnTo>
                  <a:pt x="3595" y="804"/>
                </a:lnTo>
                <a:cubicBezTo>
                  <a:pt x="3623" y="775"/>
                  <a:pt x="3638" y="749"/>
                  <a:pt x="3640" y="726"/>
                </a:cubicBezTo>
                <a:cubicBezTo>
                  <a:pt x="3641" y="704"/>
                  <a:pt x="3632" y="683"/>
                  <a:pt x="3613" y="663"/>
                </a:cubicBezTo>
                <a:cubicBezTo>
                  <a:pt x="3599" y="649"/>
                  <a:pt x="3583" y="641"/>
                  <a:pt x="3566" y="638"/>
                </a:cubicBezTo>
                <a:cubicBezTo>
                  <a:pt x="3549" y="635"/>
                  <a:pt x="3533" y="638"/>
                  <a:pt x="3518" y="646"/>
                </a:cubicBezTo>
                <a:cubicBezTo>
                  <a:pt x="3509" y="652"/>
                  <a:pt x="3494" y="664"/>
                  <a:pt x="3474" y="685"/>
                </a:cubicBezTo>
                <a:lnTo>
                  <a:pt x="3388" y="771"/>
                </a:lnTo>
                <a:lnTo>
                  <a:pt x="3508" y="891"/>
                </a:lnTo>
                <a:close/>
                <a:moveTo>
                  <a:pt x="3827" y="707"/>
                </a:moveTo>
                <a:lnTo>
                  <a:pt x="3866" y="662"/>
                </a:lnTo>
                <a:cubicBezTo>
                  <a:pt x="3885" y="677"/>
                  <a:pt x="3903" y="686"/>
                  <a:pt x="3921" y="689"/>
                </a:cubicBezTo>
                <a:cubicBezTo>
                  <a:pt x="3939" y="693"/>
                  <a:pt x="3959" y="690"/>
                  <a:pt x="3981" y="682"/>
                </a:cubicBezTo>
                <a:cubicBezTo>
                  <a:pt x="4003" y="673"/>
                  <a:pt x="4023" y="659"/>
                  <a:pt x="4043" y="640"/>
                </a:cubicBezTo>
                <a:cubicBezTo>
                  <a:pt x="4060" y="623"/>
                  <a:pt x="4072" y="606"/>
                  <a:pt x="4080" y="588"/>
                </a:cubicBezTo>
                <a:cubicBezTo>
                  <a:pt x="4088" y="570"/>
                  <a:pt x="4091" y="553"/>
                  <a:pt x="4088" y="538"/>
                </a:cubicBezTo>
                <a:cubicBezTo>
                  <a:pt x="4086" y="523"/>
                  <a:pt x="4079" y="510"/>
                  <a:pt x="4069" y="500"/>
                </a:cubicBezTo>
                <a:cubicBezTo>
                  <a:pt x="4058" y="489"/>
                  <a:pt x="4046" y="483"/>
                  <a:pt x="4032" y="481"/>
                </a:cubicBezTo>
                <a:cubicBezTo>
                  <a:pt x="4018" y="479"/>
                  <a:pt x="4001" y="483"/>
                  <a:pt x="3982" y="491"/>
                </a:cubicBezTo>
                <a:cubicBezTo>
                  <a:pt x="3969" y="497"/>
                  <a:pt x="3944" y="511"/>
                  <a:pt x="3906" y="535"/>
                </a:cubicBezTo>
                <a:cubicBezTo>
                  <a:pt x="3868" y="558"/>
                  <a:pt x="3839" y="573"/>
                  <a:pt x="3820" y="579"/>
                </a:cubicBezTo>
                <a:cubicBezTo>
                  <a:pt x="3795" y="586"/>
                  <a:pt x="3773" y="588"/>
                  <a:pt x="3753" y="583"/>
                </a:cubicBezTo>
                <a:cubicBezTo>
                  <a:pt x="3732" y="579"/>
                  <a:pt x="3715" y="569"/>
                  <a:pt x="3699" y="553"/>
                </a:cubicBezTo>
                <a:cubicBezTo>
                  <a:pt x="3682" y="536"/>
                  <a:pt x="3671" y="516"/>
                  <a:pt x="3666" y="491"/>
                </a:cubicBezTo>
                <a:cubicBezTo>
                  <a:pt x="3661" y="467"/>
                  <a:pt x="3664" y="442"/>
                  <a:pt x="3675" y="416"/>
                </a:cubicBezTo>
                <a:cubicBezTo>
                  <a:pt x="3685" y="389"/>
                  <a:pt x="3702" y="365"/>
                  <a:pt x="3725" y="342"/>
                </a:cubicBezTo>
                <a:cubicBezTo>
                  <a:pt x="3750" y="318"/>
                  <a:pt x="3776" y="300"/>
                  <a:pt x="3803" y="289"/>
                </a:cubicBezTo>
                <a:cubicBezTo>
                  <a:pt x="3830" y="278"/>
                  <a:pt x="3856" y="275"/>
                  <a:pt x="3882" y="280"/>
                </a:cubicBezTo>
                <a:cubicBezTo>
                  <a:pt x="3908" y="285"/>
                  <a:pt x="3931" y="298"/>
                  <a:pt x="3952" y="317"/>
                </a:cubicBezTo>
                <a:lnTo>
                  <a:pt x="3912" y="362"/>
                </a:lnTo>
                <a:cubicBezTo>
                  <a:pt x="3889" y="343"/>
                  <a:pt x="3865" y="335"/>
                  <a:pt x="3841" y="338"/>
                </a:cubicBezTo>
                <a:cubicBezTo>
                  <a:pt x="3817" y="340"/>
                  <a:pt x="3792" y="354"/>
                  <a:pt x="3766" y="380"/>
                </a:cubicBezTo>
                <a:cubicBezTo>
                  <a:pt x="3739" y="407"/>
                  <a:pt x="3724" y="431"/>
                  <a:pt x="3722" y="453"/>
                </a:cubicBezTo>
                <a:cubicBezTo>
                  <a:pt x="3719" y="476"/>
                  <a:pt x="3725" y="494"/>
                  <a:pt x="3739" y="508"/>
                </a:cubicBezTo>
                <a:cubicBezTo>
                  <a:pt x="3751" y="520"/>
                  <a:pt x="3765" y="525"/>
                  <a:pt x="3782" y="524"/>
                </a:cubicBezTo>
                <a:cubicBezTo>
                  <a:pt x="3798" y="524"/>
                  <a:pt x="3829" y="509"/>
                  <a:pt x="3873" y="481"/>
                </a:cubicBezTo>
                <a:cubicBezTo>
                  <a:pt x="3917" y="453"/>
                  <a:pt x="3949" y="436"/>
                  <a:pt x="3969" y="428"/>
                </a:cubicBezTo>
                <a:cubicBezTo>
                  <a:pt x="3997" y="418"/>
                  <a:pt x="4023" y="415"/>
                  <a:pt x="4046" y="419"/>
                </a:cubicBezTo>
                <a:cubicBezTo>
                  <a:pt x="4069" y="424"/>
                  <a:pt x="4090" y="435"/>
                  <a:pt x="4108" y="453"/>
                </a:cubicBezTo>
                <a:cubicBezTo>
                  <a:pt x="4126" y="471"/>
                  <a:pt x="4138" y="493"/>
                  <a:pt x="4143" y="519"/>
                </a:cubicBezTo>
                <a:cubicBezTo>
                  <a:pt x="4149" y="545"/>
                  <a:pt x="4146" y="572"/>
                  <a:pt x="4136" y="600"/>
                </a:cubicBezTo>
                <a:cubicBezTo>
                  <a:pt x="4126" y="628"/>
                  <a:pt x="4108" y="654"/>
                  <a:pt x="4084" y="678"/>
                </a:cubicBezTo>
                <a:cubicBezTo>
                  <a:pt x="4054" y="708"/>
                  <a:pt x="4024" y="729"/>
                  <a:pt x="3995" y="741"/>
                </a:cubicBezTo>
                <a:cubicBezTo>
                  <a:pt x="3965" y="753"/>
                  <a:pt x="3936" y="756"/>
                  <a:pt x="3906" y="749"/>
                </a:cubicBezTo>
                <a:cubicBezTo>
                  <a:pt x="3877" y="743"/>
                  <a:pt x="3851" y="729"/>
                  <a:pt x="3827" y="707"/>
                </a:cubicBezTo>
                <a:close/>
                <a:moveTo>
                  <a:pt x="4428" y="244"/>
                </a:moveTo>
                <a:lnTo>
                  <a:pt x="4468" y="283"/>
                </a:lnTo>
                <a:lnTo>
                  <a:pt x="4245" y="506"/>
                </a:lnTo>
                <a:cubicBezTo>
                  <a:pt x="4235" y="496"/>
                  <a:pt x="4227" y="485"/>
                  <a:pt x="4222" y="472"/>
                </a:cubicBezTo>
                <a:cubicBezTo>
                  <a:pt x="4212" y="451"/>
                  <a:pt x="4206" y="427"/>
                  <a:pt x="4204" y="400"/>
                </a:cubicBezTo>
                <a:cubicBezTo>
                  <a:pt x="4202" y="373"/>
                  <a:pt x="4203" y="338"/>
                  <a:pt x="4207" y="295"/>
                </a:cubicBezTo>
                <a:cubicBezTo>
                  <a:pt x="4214" y="229"/>
                  <a:pt x="4215" y="180"/>
                  <a:pt x="4210" y="150"/>
                </a:cubicBezTo>
                <a:cubicBezTo>
                  <a:pt x="4205" y="120"/>
                  <a:pt x="4195" y="97"/>
                  <a:pt x="4180" y="81"/>
                </a:cubicBezTo>
                <a:cubicBezTo>
                  <a:pt x="4163" y="65"/>
                  <a:pt x="4144" y="57"/>
                  <a:pt x="4121" y="57"/>
                </a:cubicBezTo>
                <a:cubicBezTo>
                  <a:pt x="4098" y="58"/>
                  <a:pt x="4077" y="67"/>
                  <a:pt x="4058" y="86"/>
                </a:cubicBezTo>
                <a:cubicBezTo>
                  <a:pt x="4038" y="106"/>
                  <a:pt x="4028" y="128"/>
                  <a:pt x="4028" y="152"/>
                </a:cubicBezTo>
                <a:cubicBezTo>
                  <a:pt x="4028" y="176"/>
                  <a:pt x="4039" y="198"/>
                  <a:pt x="4060" y="219"/>
                </a:cubicBezTo>
                <a:lnTo>
                  <a:pt x="4013" y="257"/>
                </a:lnTo>
                <a:cubicBezTo>
                  <a:pt x="3984" y="223"/>
                  <a:pt x="3971" y="188"/>
                  <a:pt x="3973" y="152"/>
                </a:cubicBezTo>
                <a:cubicBezTo>
                  <a:pt x="3976" y="117"/>
                  <a:pt x="3993" y="83"/>
                  <a:pt x="4025" y="51"/>
                </a:cubicBezTo>
                <a:cubicBezTo>
                  <a:pt x="4057" y="19"/>
                  <a:pt x="4092" y="2"/>
                  <a:pt x="4128" y="1"/>
                </a:cubicBezTo>
                <a:cubicBezTo>
                  <a:pt x="4165" y="0"/>
                  <a:pt x="4196" y="13"/>
                  <a:pt x="4223" y="40"/>
                </a:cubicBezTo>
                <a:cubicBezTo>
                  <a:pt x="4236" y="53"/>
                  <a:pt x="4247" y="69"/>
                  <a:pt x="4254" y="88"/>
                </a:cubicBezTo>
                <a:cubicBezTo>
                  <a:pt x="4262" y="106"/>
                  <a:pt x="4266" y="129"/>
                  <a:pt x="4268" y="156"/>
                </a:cubicBezTo>
                <a:cubicBezTo>
                  <a:pt x="4270" y="183"/>
                  <a:pt x="4268" y="224"/>
                  <a:pt x="4263" y="279"/>
                </a:cubicBezTo>
                <a:cubicBezTo>
                  <a:pt x="4260" y="324"/>
                  <a:pt x="4258" y="354"/>
                  <a:pt x="4258" y="369"/>
                </a:cubicBezTo>
                <a:cubicBezTo>
                  <a:pt x="4258" y="383"/>
                  <a:pt x="4260" y="396"/>
                  <a:pt x="4263" y="409"/>
                </a:cubicBezTo>
                <a:lnTo>
                  <a:pt x="4428" y="244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90" name="Freeform 72"/>
          <p:cNvSpPr>
            <a:spLocks noEditPoints="1"/>
          </p:cNvSpPr>
          <p:nvPr/>
        </p:nvSpPr>
        <p:spPr bwMode="auto">
          <a:xfrm>
            <a:off x="3941940" y="4613062"/>
            <a:ext cx="889000" cy="889000"/>
          </a:xfrm>
          <a:custGeom>
            <a:avLst/>
            <a:gdLst>
              <a:gd name="T0" fmla="*/ 238 w 4667"/>
              <a:gd name="T1" fmla="*/ 4131 h 4668"/>
              <a:gd name="T2" fmla="*/ 244 w 4667"/>
              <a:gd name="T3" fmla="*/ 4487 h 4668"/>
              <a:gd name="T4" fmla="*/ 336 w 4667"/>
              <a:gd name="T5" fmla="*/ 4283 h 4668"/>
              <a:gd name="T6" fmla="*/ 84 w 4667"/>
              <a:gd name="T7" fmla="*/ 4327 h 4668"/>
              <a:gd name="T8" fmla="*/ 513 w 4667"/>
              <a:gd name="T9" fmla="*/ 3839 h 4668"/>
              <a:gd name="T10" fmla="*/ 740 w 4667"/>
              <a:gd name="T11" fmla="*/ 3967 h 4668"/>
              <a:gd name="T12" fmla="*/ 779 w 4667"/>
              <a:gd name="T13" fmla="*/ 4225 h 4668"/>
              <a:gd name="T14" fmla="*/ 621 w 4667"/>
              <a:gd name="T15" fmla="*/ 3952 h 4668"/>
              <a:gd name="T16" fmla="*/ 399 w 4667"/>
              <a:gd name="T17" fmla="*/ 4012 h 4668"/>
              <a:gd name="T18" fmla="*/ 785 w 4667"/>
              <a:gd name="T19" fmla="*/ 4118 h 4668"/>
              <a:gd name="T20" fmla="*/ 618 w 4667"/>
              <a:gd name="T21" fmla="*/ 4075 h 4668"/>
              <a:gd name="T22" fmla="*/ 744 w 4667"/>
              <a:gd name="T23" fmla="*/ 3588 h 4668"/>
              <a:gd name="T24" fmla="*/ 1131 w 4667"/>
              <a:gd name="T25" fmla="*/ 3669 h 4668"/>
              <a:gd name="T26" fmla="*/ 964 w 4667"/>
              <a:gd name="T27" fmla="*/ 4040 h 4668"/>
              <a:gd name="T28" fmla="*/ 1081 w 4667"/>
              <a:gd name="T29" fmla="*/ 3711 h 4668"/>
              <a:gd name="T30" fmla="*/ 712 w 4667"/>
              <a:gd name="T31" fmla="*/ 3699 h 4668"/>
              <a:gd name="T32" fmla="*/ 1627 w 4667"/>
              <a:gd name="T33" fmla="*/ 3563 h 4668"/>
              <a:gd name="T34" fmla="*/ 1414 w 4667"/>
              <a:gd name="T35" fmla="*/ 2924 h 4668"/>
              <a:gd name="T36" fmla="*/ 1563 w 4667"/>
              <a:gd name="T37" fmla="*/ 3167 h 4668"/>
              <a:gd name="T38" fmla="*/ 1524 w 4667"/>
              <a:gd name="T39" fmla="*/ 3127 h 4668"/>
              <a:gd name="T40" fmla="*/ 1403 w 4667"/>
              <a:gd name="T41" fmla="*/ 3008 h 4668"/>
              <a:gd name="T42" fmla="*/ 1788 w 4667"/>
              <a:gd name="T43" fmla="*/ 2543 h 4668"/>
              <a:gd name="T44" fmla="*/ 1958 w 4667"/>
              <a:gd name="T45" fmla="*/ 2738 h 4668"/>
              <a:gd name="T46" fmla="*/ 1881 w 4667"/>
              <a:gd name="T47" fmla="*/ 3122 h 4668"/>
              <a:gd name="T48" fmla="*/ 2042 w 4667"/>
              <a:gd name="T49" fmla="*/ 2462 h 4668"/>
              <a:gd name="T50" fmla="*/ 2166 w 4667"/>
              <a:gd name="T51" fmla="*/ 2482 h 4668"/>
              <a:gd name="T52" fmla="*/ 2184 w 4667"/>
              <a:gd name="T53" fmla="*/ 2586 h 4668"/>
              <a:gd name="T54" fmla="*/ 2343 w 4667"/>
              <a:gd name="T55" fmla="*/ 2135 h 4668"/>
              <a:gd name="T56" fmla="*/ 2283 w 4667"/>
              <a:gd name="T57" fmla="*/ 2046 h 4668"/>
              <a:gd name="T58" fmla="*/ 2562 w 4667"/>
              <a:gd name="T59" fmla="*/ 1954 h 4668"/>
              <a:gd name="T60" fmla="*/ 2742 w 4667"/>
              <a:gd name="T61" fmla="*/ 1849 h 4668"/>
              <a:gd name="T62" fmla="*/ 3058 w 4667"/>
              <a:gd name="T63" fmla="*/ 1946 h 4668"/>
              <a:gd name="T64" fmla="*/ 2776 w 4667"/>
              <a:gd name="T65" fmla="*/ 1836 h 4668"/>
              <a:gd name="T66" fmla="*/ 2704 w 4667"/>
              <a:gd name="T67" fmla="*/ 1901 h 4668"/>
              <a:gd name="T68" fmla="*/ 2810 w 4667"/>
              <a:gd name="T69" fmla="*/ 2194 h 4668"/>
              <a:gd name="T70" fmla="*/ 3218 w 4667"/>
              <a:gd name="T71" fmla="*/ 1729 h 4668"/>
              <a:gd name="T72" fmla="*/ 3062 w 4667"/>
              <a:gd name="T73" fmla="*/ 1695 h 4668"/>
              <a:gd name="T74" fmla="*/ 2960 w 4667"/>
              <a:gd name="T75" fmla="*/ 1556 h 4668"/>
              <a:gd name="T76" fmla="*/ 3120 w 4667"/>
              <a:gd name="T77" fmla="*/ 1533 h 4668"/>
              <a:gd name="T78" fmla="*/ 3025 w 4667"/>
              <a:gd name="T79" fmla="*/ 1640 h 4668"/>
              <a:gd name="T80" fmla="*/ 3273 w 4667"/>
              <a:gd name="T81" fmla="*/ 1587 h 4668"/>
              <a:gd name="T82" fmla="*/ 3070 w 4667"/>
              <a:gd name="T83" fmla="*/ 1788 h 4668"/>
              <a:gd name="T84" fmla="*/ 3204 w 4667"/>
              <a:gd name="T85" fmla="*/ 1374 h 4668"/>
              <a:gd name="T86" fmla="*/ 3541 w 4667"/>
              <a:gd name="T87" fmla="*/ 1463 h 4668"/>
              <a:gd name="T88" fmla="*/ 3499 w 4667"/>
              <a:gd name="T89" fmla="*/ 928 h 4668"/>
              <a:gd name="T90" fmla="*/ 3787 w 4667"/>
              <a:gd name="T91" fmla="*/ 1216 h 4668"/>
              <a:gd name="T92" fmla="*/ 3802 w 4667"/>
              <a:gd name="T93" fmla="*/ 567 h 4668"/>
              <a:gd name="T94" fmla="*/ 3808 w 4667"/>
              <a:gd name="T95" fmla="*/ 923 h 4668"/>
              <a:gd name="T96" fmla="*/ 3900 w 4667"/>
              <a:gd name="T97" fmla="*/ 719 h 4668"/>
              <a:gd name="T98" fmla="*/ 3648 w 4667"/>
              <a:gd name="T99" fmla="*/ 763 h 4668"/>
              <a:gd name="T100" fmla="*/ 4241 w 4667"/>
              <a:gd name="T101" fmla="*/ 674 h 4668"/>
              <a:gd name="T102" fmla="*/ 4293 w 4667"/>
              <a:gd name="T103" fmla="*/ 473 h 4668"/>
              <a:gd name="T104" fmla="*/ 3960 w 4667"/>
              <a:gd name="T105" fmla="*/ 546 h 4668"/>
              <a:gd name="T106" fmla="*/ 4142 w 4667"/>
              <a:gd name="T107" fmla="*/ 273 h 4668"/>
              <a:gd name="T108" fmla="*/ 3982 w 4667"/>
              <a:gd name="T109" fmla="*/ 446 h 4668"/>
              <a:gd name="T110" fmla="*/ 4307 w 4667"/>
              <a:gd name="T111" fmla="*/ 412 h 4668"/>
              <a:gd name="T112" fmla="*/ 4255 w 4667"/>
              <a:gd name="T113" fmla="*/ 733 h 4668"/>
              <a:gd name="T114" fmla="*/ 4362 w 4667"/>
              <a:gd name="T115" fmla="*/ 116 h 4668"/>
              <a:gd name="T116" fmla="*/ 4302 w 4667"/>
              <a:gd name="T117" fmla="*/ 26 h 466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</a:cxnLst>
            <a:rect l="0" t="0" r="r" b="b"/>
            <a:pathLst>
              <a:path w="4667" h="4668">
                <a:moveTo>
                  <a:pt x="336" y="4668"/>
                </a:moveTo>
                <a:lnTo>
                  <a:pt x="0" y="4332"/>
                </a:lnTo>
                <a:lnTo>
                  <a:pt x="127" y="4205"/>
                </a:lnTo>
                <a:cubicBezTo>
                  <a:pt x="149" y="4182"/>
                  <a:pt x="167" y="4167"/>
                  <a:pt x="181" y="4157"/>
                </a:cubicBezTo>
                <a:cubicBezTo>
                  <a:pt x="200" y="4143"/>
                  <a:pt x="219" y="4135"/>
                  <a:pt x="238" y="4131"/>
                </a:cubicBezTo>
                <a:cubicBezTo>
                  <a:pt x="257" y="4128"/>
                  <a:pt x="277" y="4129"/>
                  <a:pt x="298" y="4137"/>
                </a:cubicBezTo>
                <a:cubicBezTo>
                  <a:pt x="318" y="4144"/>
                  <a:pt x="337" y="4156"/>
                  <a:pt x="354" y="4172"/>
                </a:cubicBezTo>
                <a:cubicBezTo>
                  <a:pt x="382" y="4201"/>
                  <a:pt x="397" y="4234"/>
                  <a:pt x="399" y="4272"/>
                </a:cubicBezTo>
                <a:cubicBezTo>
                  <a:pt x="401" y="4310"/>
                  <a:pt x="378" y="4353"/>
                  <a:pt x="330" y="4400"/>
                </a:cubicBezTo>
                <a:lnTo>
                  <a:pt x="244" y="4487"/>
                </a:lnTo>
                <a:lnTo>
                  <a:pt x="381" y="4623"/>
                </a:lnTo>
                <a:lnTo>
                  <a:pt x="336" y="4668"/>
                </a:lnTo>
                <a:close/>
                <a:moveTo>
                  <a:pt x="204" y="4447"/>
                </a:moveTo>
                <a:lnTo>
                  <a:pt x="291" y="4360"/>
                </a:lnTo>
                <a:cubicBezTo>
                  <a:pt x="320" y="4331"/>
                  <a:pt x="335" y="4306"/>
                  <a:pt x="336" y="4283"/>
                </a:cubicBezTo>
                <a:cubicBezTo>
                  <a:pt x="338" y="4260"/>
                  <a:pt x="329" y="4239"/>
                  <a:pt x="309" y="4219"/>
                </a:cubicBezTo>
                <a:cubicBezTo>
                  <a:pt x="295" y="4205"/>
                  <a:pt x="280" y="4197"/>
                  <a:pt x="263" y="4194"/>
                </a:cubicBezTo>
                <a:cubicBezTo>
                  <a:pt x="245" y="4191"/>
                  <a:pt x="229" y="4194"/>
                  <a:pt x="215" y="4202"/>
                </a:cubicBezTo>
                <a:cubicBezTo>
                  <a:pt x="205" y="4208"/>
                  <a:pt x="190" y="4221"/>
                  <a:pt x="170" y="4241"/>
                </a:cubicBezTo>
                <a:lnTo>
                  <a:pt x="84" y="4327"/>
                </a:lnTo>
                <a:lnTo>
                  <a:pt x="204" y="4447"/>
                </a:lnTo>
                <a:close/>
                <a:moveTo>
                  <a:pt x="651" y="4353"/>
                </a:moveTo>
                <a:lnTo>
                  <a:pt x="315" y="4017"/>
                </a:lnTo>
                <a:lnTo>
                  <a:pt x="441" y="3891"/>
                </a:lnTo>
                <a:cubicBezTo>
                  <a:pt x="467" y="3865"/>
                  <a:pt x="491" y="3848"/>
                  <a:pt x="513" y="3839"/>
                </a:cubicBezTo>
                <a:cubicBezTo>
                  <a:pt x="535" y="3830"/>
                  <a:pt x="558" y="3829"/>
                  <a:pt x="581" y="3834"/>
                </a:cubicBezTo>
                <a:cubicBezTo>
                  <a:pt x="604" y="3839"/>
                  <a:pt x="623" y="3850"/>
                  <a:pt x="638" y="3865"/>
                </a:cubicBezTo>
                <a:cubicBezTo>
                  <a:pt x="653" y="3879"/>
                  <a:pt x="662" y="3897"/>
                  <a:pt x="667" y="3917"/>
                </a:cubicBezTo>
                <a:cubicBezTo>
                  <a:pt x="672" y="3938"/>
                  <a:pt x="671" y="3960"/>
                  <a:pt x="663" y="3983"/>
                </a:cubicBezTo>
                <a:cubicBezTo>
                  <a:pt x="689" y="3969"/>
                  <a:pt x="715" y="3964"/>
                  <a:pt x="740" y="3967"/>
                </a:cubicBezTo>
                <a:cubicBezTo>
                  <a:pt x="765" y="3970"/>
                  <a:pt x="788" y="3982"/>
                  <a:pt x="807" y="4001"/>
                </a:cubicBezTo>
                <a:cubicBezTo>
                  <a:pt x="823" y="4017"/>
                  <a:pt x="834" y="4035"/>
                  <a:pt x="841" y="4055"/>
                </a:cubicBezTo>
                <a:cubicBezTo>
                  <a:pt x="848" y="4076"/>
                  <a:pt x="850" y="4094"/>
                  <a:pt x="848" y="4111"/>
                </a:cubicBezTo>
                <a:cubicBezTo>
                  <a:pt x="846" y="4128"/>
                  <a:pt x="839" y="4146"/>
                  <a:pt x="828" y="4165"/>
                </a:cubicBezTo>
                <a:cubicBezTo>
                  <a:pt x="817" y="4183"/>
                  <a:pt x="801" y="4203"/>
                  <a:pt x="779" y="4225"/>
                </a:cubicBezTo>
                <a:lnTo>
                  <a:pt x="651" y="4353"/>
                </a:lnTo>
                <a:close/>
                <a:moveTo>
                  <a:pt x="501" y="4113"/>
                </a:moveTo>
                <a:lnTo>
                  <a:pt x="573" y="4041"/>
                </a:lnTo>
                <a:cubicBezTo>
                  <a:pt x="593" y="4021"/>
                  <a:pt x="606" y="4006"/>
                  <a:pt x="612" y="3994"/>
                </a:cubicBezTo>
                <a:cubicBezTo>
                  <a:pt x="620" y="3980"/>
                  <a:pt x="623" y="3966"/>
                  <a:pt x="621" y="3952"/>
                </a:cubicBezTo>
                <a:cubicBezTo>
                  <a:pt x="619" y="3939"/>
                  <a:pt x="612" y="3926"/>
                  <a:pt x="600" y="3914"/>
                </a:cubicBezTo>
                <a:cubicBezTo>
                  <a:pt x="589" y="3903"/>
                  <a:pt x="576" y="3896"/>
                  <a:pt x="562" y="3893"/>
                </a:cubicBezTo>
                <a:cubicBezTo>
                  <a:pt x="549" y="3890"/>
                  <a:pt x="535" y="3891"/>
                  <a:pt x="522" y="3898"/>
                </a:cubicBezTo>
                <a:cubicBezTo>
                  <a:pt x="509" y="3905"/>
                  <a:pt x="490" y="3920"/>
                  <a:pt x="466" y="3945"/>
                </a:cubicBezTo>
                <a:lnTo>
                  <a:pt x="399" y="4012"/>
                </a:lnTo>
                <a:lnTo>
                  <a:pt x="501" y="4113"/>
                </a:lnTo>
                <a:close/>
                <a:moveTo>
                  <a:pt x="656" y="4269"/>
                </a:moveTo>
                <a:lnTo>
                  <a:pt x="740" y="4185"/>
                </a:lnTo>
                <a:cubicBezTo>
                  <a:pt x="754" y="4171"/>
                  <a:pt x="763" y="4160"/>
                  <a:pt x="768" y="4153"/>
                </a:cubicBezTo>
                <a:cubicBezTo>
                  <a:pt x="777" y="4141"/>
                  <a:pt x="782" y="4129"/>
                  <a:pt x="785" y="4118"/>
                </a:cubicBezTo>
                <a:cubicBezTo>
                  <a:pt x="787" y="4107"/>
                  <a:pt x="787" y="4095"/>
                  <a:pt x="783" y="4083"/>
                </a:cubicBezTo>
                <a:cubicBezTo>
                  <a:pt x="779" y="4070"/>
                  <a:pt x="772" y="4058"/>
                  <a:pt x="761" y="4048"/>
                </a:cubicBezTo>
                <a:cubicBezTo>
                  <a:pt x="749" y="4035"/>
                  <a:pt x="735" y="4027"/>
                  <a:pt x="719" y="4025"/>
                </a:cubicBezTo>
                <a:cubicBezTo>
                  <a:pt x="703" y="4022"/>
                  <a:pt x="688" y="4024"/>
                  <a:pt x="673" y="4032"/>
                </a:cubicBezTo>
                <a:cubicBezTo>
                  <a:pt x="658" y="4039"/>
                  <a:pt x="639" y="4054"/>
                  <a:pt x="618" y="4075"/>
                </a:cubicBezTo>
                <a:lnTo>
                  <a:pt x="540" y="4153"/>
                </a:lnTo>
                <a:lnTo>
                  <a:pt x="656" y="4269"/>
                </a:lnTo>
                <a:close/>
                <a:moveTo>
                  <a:pt x="964" y="4040"/>
                </a:moveTo>
                <a:lnTo>
                  <a:pt x="628" y="3704"/>
                </a:lnTo>
                <a:lnTo>
                  <a:pt x="744" y="3588"/>
                </a:lnTo>
                <a:cubicBezTo>
                  <a:pt x="770" y="3562"/>
                  <a:pt x="791" y="3543"/>
                  <a:pt x="808" y="3533"/>
                </a:cubicBezTo>
                <a:cubicBezTo>
                  <a:pt x="832" y="3518"/>
                  <a:pt x="856" y="3510"/>
                  <a:pt x="882" y="3508"/>
                </a:cubicBezTo>
                <a:cubicBezTo>
                  <a:pt x="914" y="3505"/>
                  <a:pt x="947" y="3511"/>
                  <a:pt x="979" y="3525"/>
                </a:cubicBezTo>
                <a:cubicBezTo>
                  <a:pt x="1011" y="3540"/>
                  <a:pt x="1042" y="3562"/>
                  <a:pt x="1072" y="3592"/>
                </a:cubicBezTo>
                <a:cubicBezTo>
                  <a:pt x="1098" y="3618"/>
                  <a:pt x="1117" y="3643"/>
                  <a:pt x="1131" y="3669"/>
                </a:cubicBezTo>
                <a:cubicBezTo>
                  <a:pt x="1145" y="3694"/>
                  <a:pt x="1153" y="3718"/>
                  <a:pt x="1157" y="3741"/>
                </a:cubicBezTo>
                <a:cubicBezTo>
                  <a:pt x="1161" y="3763"/>
                  <a:pt x="1160" y="3783"/>
                  <a:pt x="1157" y="3802"/>
                </a:cubicBezTo>
                <a:cubicBezTo>
                  <a:pt x="1153" y="3820"/>
                  <a:pt x="1145" y="3839"/>
                  <a:pt x="1134" y="3859"/>
                </a:cubicBezTo>
                <a:cubicBezTo>
                  <a:pt x="1122" y="3878"/>
                  <a:pt x="1106" y="3898"/>
                  <a:pt x="1085" y="3918"/>
                </a:cubicBezTo>
                <a:lnTo>
                  <a:pt x="964" y="4040"/>
                </a:lnTo>
                <a:close/>
                <a:moveTo>
                  <a:pt x="969" y="3956"/>
                </a:moveTo>
                <a:lnTo>
                  <a:pt x="1041" y="3884"/>
                </a:lnTo>
                <a:cubicBezTo>
                  <a:pt x="1063" y="3862"/>
                  <a:pt x="1078" y="3842"/>
                  <a:pt x="1087" y="3826"/>
                </a:cubicBezTo>
                <a:cubicBezTo>
                  <a:pt x="1095" y="3809"/>
                  <a:pt x="1099" y="3793"/>
                  <a:pt x="1099" y="3778"/>
                </a:cubicBezTo>
                <a:cubicBezTo>
                  <a:pt x="1099" y="3757"/>
                  <a:pt x="1093" y="3734"/>
                  <a:pt x="1081" y="3711"/>
                </a:cubicBezTo>
                <a:cubicBezTo>
                  <a:pt x="1069" y="3687"/>
                  <a:pt x="1051" y="3663"/>
                  <a:pt x="1025" y="3637"/>
                </a:cubicBezTo>
                <a:cubicBezTo>
                  <a:pt x="990" y="3602"/>
                  <a:pt x="958" y="3581"/>
                  <a:pt x="927" y="3573"/>
                </a:cubicBezTo>
                <a:cubicBezTo>
                  <a:pt x="897" y="3566"/>
                  <a:pt x="870" y="3567"/>
                  <a:pt x="847" y="3578"/>
                </a:cubicBezTo>
                <a:cubicBezTo>
                  <a:pt x="831" y="3585"/>
                  <a:pt x="809" y="3602"/>
                  <a:pt x="783" y="3628"/>
                </a:cubicBezTo>
                <a:lnTo>
                  <a:pt x="712" y="3699"/>
                </a:lnTo>
                <a:lnTo>
                  <a:pt x="969" y="3956"/>
                </a:lnTo>
                <a:close/>
                <a:moveTo>
                  <a:pt x="1353" y="3837"/>
                </a:moveTo>
                <a:lnTo>
                  <a:pt x="1324" y="3807"/>
                </a:lnTo>
                <a:lnTo>
                  <a:pt x="1597" y="3534"/>
                </a:lnTo>
                <a:lnTo>
                  <a:pt x="1627" y="3563"/>
                </a:lnTo>
                <a:lnTo>
                  <a:pt x="1353" y="3837"/>
                </a:lnTo>
                <a:close/>
                <a:moveTo>
                  <a:pt x="1569" y="3434"/>
                </a:moveTo>
                <a:lnTo>
                  <a:pt x="1233" y="3098"/>
                </a:lnTo>
                <a:lnTo>
                  <a:pt x="1360" y="2972"/>
                </a:lnTo>
                <a:cubicBezTo>
                  <a:pt x="1382" y="2949"/>
                  <a:pt x="1400" y="2933"/>
                  <a:pt x="1414" y="2924"/>
                </a:cubicBezTo>
                <a:cubicBezTo>
                  <a:pt x="1434" y="2910"/>
                  <a:pt x="1453" y="2901"/>
                  <a:pt x="1472" y="2898"/>
                </a:cubicBezTo>
                <a:cubicBezTo>
                  <a:pt x="1490" y="2894"/>
                  <a:pt x="1510" y="2896"/>
                  <a:pt x="1531" y="2903"/>
                </a:cubicBezTo>
                <a:cubicBezTo>
                  <a:pt x="1552" y="2910"/>
                  <a:pt x="1570" y="2922"/>
                  <a:pt x="1587" y="2939"/>
                </a:cubicBezTo>
                <a:cubicBezTo>
                  <a:pt x="1616" y="2968"/>
                  <a:pt x="1631" y="3001"/>
                  <a:pt x="1632" y="3039"/>
                </a:cubicBezTo>
                <a:cubicBezTo>
                  <a:pt x="1634" y="3077"/>
                  <a:pt x="1611" y="3120"/>
                  <a:pt x="1563" y="3167"/>
                </a:cubicBezTo>
                <a:lnTo>
                  <a:pt x="1477" y="3253"/>
                </a:lnTo>
                <a:lnTo>
                  <a:pt x="1614" y="3390"/>
                </a:lnTo>
                <a:lnTo>
                  <a:pt x="1569" y="3434"/>
                </a:lnTo>
                <a:close/>
                <a:moveTo>
                  <a:pt x="1437" y="3214"/>
                </a:moveTo>
                <a:lnTo>
                  <a:pt x="1524" y="3127"/>
                </a:lnTo>
                <a:cubicBezTo>
                  <a:pt x="1553" y="3098"/>
                  <a:pt x="1568" y="3072"/>
                  <a:pt x="1570" y="3050"/>
                </a:cubicBezTo>
                <a:cubicBezTo>
                  <a:pt x="1571" y="3027"/>
                  <a:pt x="1562" y="3006"/>
                  <a:pt x="1542" y="2986"/>
                </a:cubicBezTo>
                <a:cubicBezTo>
                  <a:pt x="1528" y="2972"/>
                  <a:pt x="1513" y="2964"/>
                  <a:pt x="1496" y="2961"/>
                </a:cubicBezTo>
                <a:cubicBezTo>
                  <a:pt x="1479" y="2958"/>
                  <a:pt x="1463" y="2961"/>
                  <a:pt x="1448" y="2969"/>
                </a:cubicBezTo>
                <a:cubicBezTo>
                  <a:pt x="1438" y="2975"/>
                  <a:pt x="1423" y="2987"/>
                  <a:pt x="1403" y="3008"/>
                </a:cubicBezTo>
                <a:lnTo>
                  <a:pt x="1317" y="3094"/>
                </a:lnTo>
                <a:lnTo>
                  <a:pt x="1437" y="3214"/>
                </a:lnTo>
                <a:close/>
                <a:moveTo>
                  <a:pt x="1881" y="3122"/>
                </a:moveTo>
                <a:lnTo>
                  <a:pt x="1545" y="2786"/>
                </a:lnTo>
                <a:lnTo>
                  <a:pt x="1788" y="2543"/>
                </a:lnTo>
                <a:lnTo>
                  <a:pt x="1828" y="2583"/>
                </a:lnTo>
                <a:lnTo>
                  <a:pt x="1629" y="2782"/>
                </a:lnTo>
                <a:lnTo>
                  <a:pt x="1732" y="2884"/>
                </a:lnTo>
                <a:lnTo>
                  <a:pt x="1918" y="2699"/>
                </a:lnTo>
                <a:lnTo>
                  <a:pt x="1958" y="2738"/>
                </a:lnTo>
                <a:lnTo>
                  <a:pt x="1772" y="2924"/>
                </a:lnTo>
                <a:lnTo>
                  <a:pt x="1886" y="3038"/>
                </a:lnTo>
                <a:lnTo>
                  <a:pt x="2092" y="2832"/>
                </a:lnTo>
                <a:lnTo>
                  <a:pt x="2132" y="2872"/>
                </a:lnTo>
                <a:lnTo>
                  <a:pt x="1881" y="3122"/>
                </a:lnTo>
                <a:close/>
                <a:moveTo>
                  <a:pt x="2163" y="2841"/>
                </a:moveTo>
                <a:lnTo>
                  <a:pt x="2118" y="2536"/>
                </a:lnTo>
                <a:lnTo>
                  <a:pt x="1842" y="2489"/>
                </a:lnTo>
                <a:lnTo>
                  <a:pt x="1895" y="2436"/>
                </a:lnTo>
                <a:lnTo>
                  <a:pt x="2042" y="2462"/>
                </a:lnTo>
                <a:cubicBezTo>
                  <a:pt x="2073" y="2467"/>
                  <a:pt x="2096" y="2471"/>
                  <a:pt x="2111" y="2476"/>
                </a:cubicBezTo>
                <a:cubicBezTo>
                  <a:pt x="2106" y="2456"/>
                  <a:pt x="2102" y="2434"/>
                  <a:pt x="2099" y="2411"/>
                </a:cubicBezTo>
                <a:lnTo>
                  <a:pt x="2078" y="2254"/>
                </a:lnTo>
                <a:lnTo>
                  <a:pt x="2126" y="2206"/>
                </a:lnTo>
                <a:lnTo>
                  <a:pt x="2166" y="2482"/>
                </a:lnTo>
                <a:lnTo>
                  <a:pt x="2471" y="2533"/>
                </a:lnTo>
                <a:lnTo>
                  <a:pt x="2416" y="2588"/>
                </a:lnTo>
                <a:lnTo>
                  <a:pt x="2212" y="2552"/>
                </a:lnTo>
                <a:cubicBezTo>
                  <a:pt x="2200" y="2550"/>
                  <a:pt x="2188" y="2548"/>
                  <a:pt x="2175" y="2545"/>
                </a:cubicBezTo>
                <a:cubicBezTo>
                  <a:pt x="2179" y="2564"/>
                  <a:pt x="2182" y="2578"/>
                  <a:pt x="2184" y="2586"/>
                </a:cubicBezTo>
                <a:lnTo>
                  <a:pt x="2216" y="2787"/>
                </a:lnTo>
                <a:lnTo>
                  <a:pt x="2163" y="2841"/>
                </a:lnTo>
                <a:close/>
                <a:moveTo>
                  <a:pt x="2647" y="2357"/>
                </a:moveTo>
                <a:lnTo>
                  <a:pt x="2606" y="2398"/>
                </a:lnTo>
                <a:lnTo>
                  <a:pt x="2343" y="2135"/>
                </a:lnTo>
                <a:cubicBezTo>
                  <a:pt x="2342" y="2154"/>
                  <a:pt x="2339" y="2177"/>
                  <a:pt x="2332" y="2203"/>
                </a:cubicBezTo>
                <a:cubicBezTo>
                  <a:pt x="2325" y="2228"/>
                  <a:pt x="2318" y="2250"/>
                  <a:pt x="2310" y="2267"/>
                </a:cubicBezTo>
                <a:lnTo>
                  <a:pt x="2270" y="2227"/>
                </a:lnTo>
                <a:cubicBezTo>
                  <a:pt x="2282" y="2193"/>
                  <a:pt x="2289" y="2160"/>
                  <a:pt x="2291" y="2127"/>
                </a:cubicBezTo>
                <a:cubicBezTo>
                  <a:pt x="2293" y="2095"/>
                  <a:pt x="2290" y="2068"/>
                  <a:pt x="2283" y="2046"/>
                </a:cubicBezTo>
                <a:lnTo>
                  <a:pt x="2310" y="2019"/>
                </a:lnTo>
                <a:lnTo>
                  <a:pt x="2647" y="2357"/>
                </a:lnTo>
                <a:close/>
                <a:moveTo>
                  <a:pt x="2769" y="2235"/>
                </a:moveTo>
                <a:lnTo>
                  <a:pt x="2525" y="1991"/>
                </a:lnTo>
                <a:lnTo>
                  <a:pt x="2562" y="1954"/>
                </a:lnTo>
                <a:lnTo>
                  <a:pt x="2597" y="1989"/>
                </a:lnTo>
                <a:cubicBezTo>
                  <a:pt x="2592" y="1969"/>
                  <a:pt x="2593" y="1949"/>
                  <a:pt x="2598" y="1929"/>
                </a:cubicBezTo>
                <a:cubicBezTo>
                  <a:pt x="2604" y="1909"/>
                  <a:pt x="2614" y="1891"/>
                  <a:pt x="2631" y="1875"/>
                </a:cubicBezTo>
                <a:cubicBezTo>
                  <a:pt x="2649" y="1857"/>
                  <a:pt x="2667" y="1846"/>
                  <a:pt x="2686" y="1842"/>
                </a:cubicBezTo>
                <a:cubicBezTo>
                  <a:pt x="2705" y="1838"/>
                  <a:pt x="2724" y="1840"/>
                  <a:pt x="2742" y="1849"/>
                </a:cubicBezTo>
                <a:cubicBezTo>
                  <a:pt x="2733" y="1801"/>
                  <a:pt x="2744" y="1762"/>
                  <a:pt x="2775" y="1731"/>
                </a:cubicBezTo>
                <a:cubicBezTo>
                  <a:pt x="2799" y="1707"/>
                  <a:pt x="2824" y="1695"/>
                  <a:pt x="2850" y="1695"/>
                </a:cubicBezTo>
                <a:cubicBezTo>
                  <a:pt x="2877" y="1696"/>
                  <a:pt x="2904" y="1710"/>
                  <a:pt x="2932" y="1738"/>
                </a:cubicBezTo>
                <a:lnTo>
                  <a:pt x="3099" y="1905"/>
                </a:lnTo>
                <a:lnTo>
                  <a:pt x="3058" y="1946"/>
                </a:lnTo>
                <a:lnTo>
                  <a:pt x="2904" y="1793"/>
                </a:lnTo>
                <a:cubicBezTo>
                  <a:pt x="2888" y="1776"/>
                  <a:pt x="2875" y="1766"/>
                  <a:pt x="2865" y="1761"/>
                </a:cubicBezTo>
                <a:cubicBezTo>
                  <a:pt x="2855" y="1756"/>
                  <a:pt x="2844" y="1755"/>
                  <a:pt x="2833" y="1758"/>
                </a:cubicBezTo>
                <a:cubicBezTo>
                  <a:pt x="2821" y="1761"/>
                  <a:pt x="2811" y="1767"/>
                  <a:pt x="2801" y="1776"/>
                </a:cubicBezTo>
                <a:cubicBezTo>
                  <a:pt x="2784" y="1793"/>
                  <a:pt x="2776" y="1813"/>
                  <a:pt x="2776" y="1836"/>
                </a:cubicBezTo>
                <a:cubicBezTo>
                  <a:pt x="2776" y="1858"/>
                  <a:pt x="2788" y="1882"/>
                  <a:pt x="2813" y="1907"/>
                </a:cubicBezTo>
                <a:lnTo>
                  <a:pt x="2955" y="2049"/>
                </a:lnTo>
                <a:lnTo>
                  <a:pt x="2914" y="2090"/>
                </a:lnTo>
                <a:lnTo>
                  <a:pt x="2755" y="1932"/>
                </a:lnTo>
                <a:cubicBezTo>
                  <a:pt x="2737" y="1914"/>
                  <a:pt x="2720" y="1903"/>
                  <a:pt x="2704" y="1901"/>
                </a:cubicBezTo>
                <a:cubicBezTo>
                  <a:pt x="2688" y="1898"/>
                  <a:pt x="2673" y="1905"/>
                  <a:pt x="2657" y="1920"/>
                </a:cubicBezTo>
                <a:cubicBezTo>
                  <a:pt x="2646" y="1932"/>
                  <a:pt x="2638" y="1945"/>
                  <a:pt x="2634" y="1961"/>
                </a:cubicBezTo>
                <a:cubicBezTo>
                  <a:pt x="2630" y="1977"/>
                  <a:pt x="2632" y="1993"/>
                  <a:pt x="2640" y="2010"/>
                </a:cubicBezTo>
                <a:cubicBezTo>
                  <a:pt x="2647" y="2026"/>
                  <a:pt x="2662" y="2045"/>
                  <a:pt x="2684" y="2067"/>
                </a:cubicBezTo>
                <a:lnTo>
                  <a:pt x="2810" y="2194"/>
                </a:lnTo>
                <a:lnTo>
                  <a:pt x="2769" y="2235"/>
                </a:lnTo>
                <a:close/>
                <a:moveTo>
                  <a:pt x="3070" y="1788"/>
                </a:moveTo>
                <a:lnTo>
                  <a:pt x="3104" y="1741"/>
                </a:lnTo>
                <a:cubicBezTo>
                  <a:pt x="3123" y="1755"/>
                  <a:pt x="3142" y="1761"/>
                  <a:pt x="3161" y="1760"/>
                </a:cubicBezTo>
                <a:cubicBezTo>
                  <a:pt x="3180" y="1758"/>
                  <a:pt x="3199" y="1748"/>
                  <a:pt x="3218" y="1729"/>
                </a:cubicBezTo>
                <a:cubicBezTo>
                  <a:pt x="3237" y="1710"/>
                  <a:pt x="3247" y="1692"/>
                  <a:pt x="3249" y="1675"/>
                </a:cubicBezTo>
                <a:cubicBezTo>
                  <a:pt x="3250" y="1658"/>
                  <a:pt x="3246" y="1644"/>
                  <a:pt x="3235" y="1634"/>
                </a:cubicBezTo>
                <a:cubicBezTo>
                  <a:pt x="3226" y="1625"/>
                  <a:pt x="3215" y="1621"/>
                  <a:pt x="3201" y="1624"/>
                </a:cubicBezTo>
                <a:cubicBezTo>
                  <a:pt x="3192" y="1626"/>
                  <a:pt x="3173" y="1636"/>
                  <a:pt x="3145" y="1652"/>
                </a:cubicBezTo>
                <a:cubicBezTo>
                  <a:pt x="3107" y="1675"/>
                  <a:pt x="3080" y="1689"/>
                  <a:pt x="3062" y="1695"/>
                </a:cubicBezTo>
                <a:cubicBezTo>
                  <a:pt x="3045" y="1702"/>
                  <a:pt x="3028" y="1703"/>
                  <a:pt x="3013" y="1699"/>
                </a:cubicBezTo>
                <a:cubicBezTo>
                  <a:pt x="2997" y="1695"/>
                  <a:pt x="2983" y="1687"/>
                  <a:pt x="2971" y="1675"/>
                </a:cubicBezTo>
                <a:cubicBezTo>
                  <a:pt x="2960" y="1664"/>
                  <a:pt x="2952" y="1652"/>
                  <a:pt x="2948" y="1638"/>
                </a:cubicBezTo>
                <a:cubicBezTo>
                  <a:pt x="2944" y="1623"/>
                  <a:pt x="2943" y="1609"/>
                  <a:pt x="2945" y="1594"/>
                </a:cubicBezTo>
                <a:cubicBezTo>
                  <a:pt x="2947" y="1583"/>
                  <a:pt x="2952" y="1570"/>
                  <a:pt x="2960" y="1556"/>
                </a:cubicBezTo>
                <a:cubicBezTo>
                  <a:pt x="2967" y="1542"/>
                  <a:pt x="2978" y="1528"/>
                  <a:pt x="2990" y="1516"/>
                </a:cubicBezTo>
                <a:cubicBezTo>
                  <a:pt x="3009" y="1496"/>
                  <a:pt x="3029" y="1482"/>
                  <a:pt x="3049" y="1473"/>
                </a:cubicBezTo>
                <a:cubicBezTo>
                  <a:pt x="3069" y="1465"/>
                  <a:pt x="3087" y="1461"/>
                  <a:pt x="3103" y="1464"/>
                </a:cubicBezTo>
                <a:cubicBezTo>
                  <a:pt x="3119" y="1466"/>
                  <a:pt x="3137" y="1474"/>
                  <a:pt x="3155" y="1487"/>
                </a:cubicBezTo>
                <a:lnTo>
                  <a:pt x="3120" y="1533"/>
                </a:lnTo>
                <a:cubicBezTo>
                  <a:pt x="3106" y="1522"/>
                  <a:pt x="3091" y="1518"/>
                  <a:pt x="3075" y="1520"/>
                </a:cubicBezTo>
                <a:cubicBezTo>
                  <a:pt x="3059" y="1522"/>
                  <a:pt x="3043" y="1530"/>
                  <a:pt x="3027" y="1546"/>
                </a:cubicBezTo>
                <a:cubicBezTo>
                  <a:pt x="3008" y="1565"/>
                  <a:pt x="2998" y="1582"/>
                  <a:pt x="2996" y="1596"/>
                </a:cubicBezTo>
                <a:cubicBezTo>
                  <a:pt x="2994" y="1611"/>
                  <a:pt x="2997" y="1622"/>
                  <a:pt x="3006" y="1631"/>
                </a:cubicBezTo>
                <a:cubicBezTo>
                  <a:pt x="3011" y="1636"/>
                  <a:pt x="3018" y="1639"/>
                  <a:pt x="3025" y="1640"/>
                </a:cubicBezTo>
                <a:cubicBezTo>
                  <a:pt x="3033" y="1641"/>
                  <a:pt x="3042" y="1639"/>
                  <a:pt x="3052" y="1635"/>
                </a:cubicBezTo>
                <a:cubicBezTo>
                  <a:pt x="3058" y="1633"/>
                  <a:pt x="3074" y="1624"/>
                  <a:pt x="3099" y="1609"/>
                </a:cubicBezTo>
                <a:cubicBezTo>
                  <a:pt x="3136" y="1588"/>
                  <a:pt x="3163" y="1574"/>
                  <a:pt x="3179" y="1567"/>
                </a:cubicBezTo>
                <a:cubicBezTo>
                  <a:pt x="3196" y="1561"/>
                  <a:pt x="3212" y="1559"/>
                  <a:pt x="3228" y="1562"/>
                </a:cubicBezTo>
                <a:cubicBezTo>
                  <a:pt x="3244" y="1565"/>
                  <a:pt x="3259" y="1573"/>
                  <a:pt x="3273" y="1587"/>
                </a:cubicBezTo>
                <a:cubicBezTo>
                  <a:pt x="3287" y="1601"/>
                  <a:pt x="3296" y="1618"/>
                  <a:pt x="3300" y="1638"/>
                </a:cubicBezTo>
                <a:cubicBezTo>
                  <a:pt x="3304" y="1658"/>
                  <a:pt x="3302" y="1679"/>
                  <a:pt x="3294" y="1701"/>
                </a:cubicBezTo>
                <a:cubicBezTo>
                  <a:pt x="3285" y="1723"/>
                  <a:pt x="3271" y="1743"/>
                  <a:pt x="3252" y="1762"/>
                </a:cubicBezTo>
                <a:cubicBezTo>
                  <a:pt x="3221" y="1794"/>
                  <a:pt x="3190" y="1812"/>
                  <a:pt x="3160" y="1815"/>
                </a:cubicBezTo>
                <a:cubicBezTo>
                  <a:pt x="3131" y="1818"/>
                  <a:pt x="3100" y="1810"/>
                  <a:pt x="3070" y="1788"/>
                </a:cubicBezTo>
                <a:close/>
                <a:moveTo>
                  <a:pt x="3541" y="1463"/>
                </a:moveTo>
                <a:lnTo>
                  <a:pt x="3500" y="1504"/>
                </a:lnTo>
                <a:lnTo>
                  <a:pt x="3237" y="1241"/>
                </a:lnTo>
                <a:cubicBezTo>
                  <a:pt x="3236" y="1261"/>
                  <a:pt x="3233" y="1283"/>
                  <a:pt x="3226" y="1309"/>
                </a:cubicBezTo>
                <a:cubicBezTo>
                  <a:pt x="3219" y="1334"/>
                  <a:pt x="3212" y="1356"/>
                  <a:pt x="3204" y="1374"/>
                </a:cubicBezTo>
                <a:lnTo>
                  <a:pt x="3164" y="1334"/>
                </a:lnTo>
                <a:cubicBezTo>
                  <a:pt x="3176" y="1300"/>
                  <a:pt x="3183" y="1266"/>
                  <a:pt x="3185" y="1234"/>
                </a:cubicBezTo>
                <a:cubicBezTo>
                  <a:pt x="3187" y="1201"/>
                  <a:pt x="3184" y="1174"/>
                  <a:pt x="3177" y="1152"/>
                </a:cubicBezTo>
                <a:lnTo>
                  <a:pt x="3203" y="1125"/>
                </a:lnTo>
                <a:lnTo>
                  <a:pt x="3541" y="1463"/>
                </a:lnTo>
                <a:close/>
                <a:moveTo>
                  <a:pt x="3499" y="928"/>
                </a:moveTo>
                <a:lnTo>
                  <a:pt x="3451" y="880"/>
                </a:lnTo>
                <a:lnTo>
                  <a:pt x="3493" y="839"/>
                </a:lnTo>
                <a:lnTo>
                  <a:pt x="3540" y="886"/>
                </a:lnTo>
                <a:lnTo>
                  <a:pt x="3499" y="928"/>
                </a:lnTo>
                <a:close/>
                <a:moveTo>
                  <a:pt x="3787" y="1216"/>
                </a:moveTo>
                <a:lnTo>
                  <a:pt x="3544" y="973"/>
                </a:lnTo>
                <a:lnTo>
                  <a:pt x="3585" y="932"/>
                </a:lnTo>
                <a:lnTo>
                  <a:pt x="3829" y="1175"/>
                </a:lnTo>
                <a:lnTo>
                  <a:pt x="3787" y="1216"/>
                </a:lnTo>
                <a:close/>
                <a:moveTo>
                  <a:pt x="3900" y="1104"/>
                </a:moveTo>
                <a:lnTo>
                  <a:pt x="3564" y="768"/>
                </a:lnTo>
                <a:lnTo>
                  <a:pt x="3691" y="641"/>
                </a:lnTo>
                <a:cubicBezTo>
                  <a:pt x="3713" y="619"/>
                  <a:pt x="3731" y="603"/>
                  <a:pt x="3745" y="593"/>
                </a:cubicBezTo>
                <a:cubicBezTo>
                  <a:pt x="3764" y="579"/>
                  <a:pt x="3783" y="571"/>
                  <a:pt x="3802" y="567"/>
                </a:cubicBezTo>
                <a:cubicBezTo>
                  <a:pt x="3821" y="564"/>
                  <a:pt x="3841" y="566"/>
                  <a:pt x="3862" y="573"/>
                </a:cubicBezTo>
                <a:cubicBezTo>
                  <a:pt x="3882" y="580"/>
                  <a:pt x="3901" y="592"/>
                  <a:pt x="3918" y="608"/>
                </a:cubicBezTo>
                <a:cubicBezTo>
                  <a:pt x="3946" y="637"/>
                  <a:pt x="3961" y="670"/>
                  <a:pt x="3963" y="708"/>
                </a:cubicBezTo>
                <a:cubicBezTo>
                  <a:pt x="3964" y="746"/>
                  <a:pt x="3941" y="789"/>
                  <a:pt x="3894" y="837"/>
                </a:cubicBezTo>
                <a:lnTo>
                  <a:pt x="3808" y="923"/>
                </a:lnTo>
                <a:lnTo>
                  <a:pt x="3944" y="1059"/>
                </a:lnTo>
                <a:lnTo>
                  <a:pt x="3900" y="1104"/>
                </a:lnTo>
                <a:close/>
                <a:moveTo>
                  <a:pt x="3768" y="883"/>
                </a:moveTo>
                <a:lnTo>
                  <a:pt x="3855" y="796"/>
                </a:lnTo>
                <a:cubicBezTo>
                  <a:pt x="3884" y="767"/>
                  <a:pt x="3899" y="742"/>
                  <a:pt x="3900" y="719"/>
                </a:cubicBezTo>
                <a:cubicBezTo>
                  <a:pt x="3902" y="696"/>
                  <a:pt x="3892" y="675"/>
                  <a:pt x="3873" y="656"/>
                </a:cubicBezTo>
                <a:cubicBezTo>
                  <a:pt x="3859" y="642"/>
                  <a:pt x="3843" y="633"/>
                  <a:pt x="3826" y="630"/>
                </a:cubicBezTo>
                <a:cubicBezTo>
                  <a:pt x="3809" y="627"/>
                  <a:pt x="3793" y="630"/>
                  <a:pt x="3778" y="638"/>
                </a:cubicBezTo>
                <a:cubicBezTo>
                  <a:pt x="3769" y="644"/>
                  <a:pt x="3754" y="657"/>
                  <a:pt x="3734" y="677"/>
                </a:cubicBezTo>
                <a:lnTo>
                  <a:pt x="3648" y="763"/>
                </a:lnTo>
                <a:lnTo>
                  <a:pt x="3768" y="883"/>
                </a:lnTo>
                <a:close/>
                <a:moveTo>
                  <a:pt x="4088" y="700"/>
                </a:moveTo>
                <a:lnTo>
                  <a:pt x="4126" y="654"/>
                </a:lnTo>
                <a:cubicBezTo>
                  <a:pt x="4145" y="669"/>
                  <a:pt x="4163" y="678"/>
                  <a:pt x="4181" y="682"/>
                </a:cubicBezTo>
                <a:cubicBezTo>
                  <a:pt x="4199" y="685"/>
                  <a:pt x="4219" y="683"/>
                  <a:pt x="4241" y="674"/>
                </a:cubicBezTo>
                <a:cubicBezTo>
                  <a:pt x="4263" y="665"/>
                  <a:pt x="4284" y="652"/>
                  <a:pt x="4303" y="632"/>
                </a:cubicBezTo>
                <a:cubicBezTo>
                  <a:pt x="4320" y="615"/>
                  <a:pt x="4332" y="598"/>
                  <a:pt x="4340" y="580"/>
                </a:cubicBezTo>
                <a:cubicBezTo>
                  <a:pt x="4348" y="562"/>
                  <a:pt x="4351" y="545"/>
                  <a:pt x="4349" y="530"/>
                </a:cubicBezTo>
                <a:cubicBezTo>
                  <a:pt x="4346" y="515"/>
                  <a:pt x="4340" y="502"/>
                  <a:pt x="4329" y="492"/>
                </a:cubicBezTo>
                <a:cubicBezTo>
                  <a:pt x="4319" y="481"/>
                  <a:pt x="4307" y="475"/>
                  <a:pt x="4293" y="473"/>
                </a:cubicBezTo>
                <a:cubicBezTo>
                  <a:pt x="4279" y="472"/>
                  <a:pt x="4262" y="475"/>
                  <a:pt x="4242" y="484"/>
                </a:cubicBezTo>
                <a:cubicBezTo>
                  <a:pt x="4230" y="489"/>
                  <a:pt x="4205" y="504"/>
                  <a:pt x="4166" y="527"/>
                </a:cubicBezTo>
                <a:cubicBezTo>
                  <a:pt x="4128" y="551"/>
                  <a:pt x="4099" y="565"/>
                  <a:pt x="4080" y="571"/>
                </a:cubicBezTo>
                <a:cubicBezTo>
                  <a:pt x="4056" y="579"/>
                  <a:pt x="4034" y="580"/>
                  <a:pt x="4013" y="576"/>
                </a:cubicBezTo>
                <a:cubicBezTo>
                  <a:pt x="3993" y="571"/>
                  <a:pt x="3975" y="561"/>
                  <a:pt x="3960" y="546"/>
                </a:cubicBezTo>
                <a:cubicBezTo>
                  <a:pt x="3943" y="529"/>
                  <a:pt x="3932" y="508"/>
                  <a:pt x="3926" y="484"/>
                </a:cubicBezTo>
                <a:cubicBezTo>
                  <a:pt x="3921" y="459"/>
                  <a:pt x="3924" y="434"/>
                  <a:pt x="3935" y="408"/>
                </a:cubicBezTo>
                <a:cubicBezTo>
                  <a:pt x="3946" y="382"/>
                  <a:pt x="3963" y="358"/>
                  <a:pt x="3985" y="335"/>
                </a:cubicBezTo>
                <a:cubicBezTo>
                  <a:pt x="4010" y="310"/>
                  <a:pt x="4036" y="292"/>
                  <a:pt x="4063" y="281"/>
                </a:cubicBezTo>
                <a:cubicBezTo>
                  <a:pt x="4090" y="270"/>
                  <a:pt x="4117" y="267"/>
                  <a:pt x="4142" y="273"/>
                </a:cubicBezTo>
                <a:cubicBezTo>
                  <a:pt x="4168" y="278"/>
                  <a:pt x="4191" y="290"/>
                  <a:pt x="4212" y="309"/>
                </a:cubicBezTo>
                <a:lnTo>
                  <a:pt x="4173" y="355"/>
                </a:lnTo>
                <a:cubicBezTo>
                  <a:pt x="4149" y="336"/>
                  <a:pt x="4125" y="328"/>
                  <a:pt x="4101" y="330"/>
                </a:cubicBezTo>
                <a:cubicBezTo>
                  <a:pt x="4077" y="332"/>
                  <a:pt x="4052" y="346"/>
                  <a:pt x="4026" y="372"/>
                </a:cubicBezTo>
                <a:cubicBezTo>
                  <a:pt x="3999" y="399"/>
                  <a:pt x="3985" y="424"/>
                  <a:pt x="3982" y="446"/>
                </a:cubicBezTo>
                <a:cubicBezTo>
                  <a:pt x="3980" y="468"/>
                  <a:pt x="3986" y="486"/>
                  <a:pt x="3999" y="500"/>
                </a:cubicBezTo>
                <a:cubicBezTo>
                  <a:pt x="4012" y="512"/>
                  <a:pt x="4026" y="518"/>
                  <a:pt x="4042" y="517"/>
                </a:cubicBezTo>
                <a:cubicBezTo>
                  <a:pt x="4059" y="516"/>
                  <a:pt x="4089" y="502"/>
                  <a:pt x="4133" y="474"/>
                </a:cubicBezTo>
                <a:cubicBezTo>
                  <a:pt x="4178" y="446"/>
                  <a:pt x="4210" y="428"/>
                  <a:pt x="4229" y="421"/>
                </a:cubicBezTo>
                <a:cubicBezTo>
                  <a:pt x="4258" y="410"/>
                  <a:pt x="4284" y="407"/>
                  <a:pt x="4307" y="412"/>
                </a:cubicBezTo>
                <a:cubicBezTo>
                  <a:pt x="4330" y="416"/>
                  <a:pt x="4351" y="427"/>
                  <a:pt x="4369" y="445"/>
                </a:cubicBezTo>
                <a:cubicBezTo>
                  <a:pt x="4386" y="463"/>
                  <a:pt x="4398" y="485"/>
                  <a:pt x="4404" y="511"/>
                </a:cubicBezTo>
                <a:cubicBezTo>
                  <a:pt x="4409" y="537"/>
                  <a:pt x="4407" y="564"/>
                  <a:pt x="4397" y="592"/>
                </a:cubicBezTo>
                <a:cubicBezTo>
                  <a:pt x="4386" y="620"/>
                  <a:pt x="4369" y="646"/>
                  <a:pt x="4345" y="670"/>
                </a:cubicBezTo>
                <a:cubicBezTo>
                  <a:pt x="4315" y="701"/>
                  <a:pt x="4285" y="722"/>
                  <a:pt x="4255" y="733"/>
                </a:cubicBezTo>
                <a:cubicBezTo>
                  <a:pt x="4226" y="745"/>
                  <a:pt x="4196" y="748"/>
                  <a:pt x="4167" y="742"/>
                </a:cubicBezTo>
                <a:cubicBezTo>
                  <a:pt x="4137" y="736"/>
                  <a:pt x="4111" y="722"/>
                  <a:pt x="4088" y="700"/>
                </a:cubicBezTo>
                <a:close/>
                <a:moveTo>
                  <a:pt x="4667" y="337"/>
                </a:moveTo>
                <a:lnTo>
                  <a:pt x="4625" y="378"/>
                </a:lnTo>
                <a:lnTo>
                  <a:pt x="4362" y="116"/>
                </a:lnTo>
                <a:cubicBezTo>
                  <a:pt x="4362" y="135"/>
                  <a:pt x="4358" y="157"/>
                  <a:pt x="4352" y="183"/>
                </a:cubicBezTo>
                <a:cubicBezTo>
                  <a:pt x="4345" y="209"/>
                  <a:pt x="4338" y="230"/>
                  <a:pt x="4330" y="248"/>
                </a:cubicBezTo>
                <a:lnTo>
                  <a:pt x="4290" y="208"/>
                </a:lnTo>
                <a:cubicBezTo>
                  <a:pt x="4302" y="174"/>
                  <a:pt x="4309" y="141"/>
                  <a:pt x="4311" y="108"/>
                </a:cubicBezTo>
                <a:cubicBezTo>
                  <a:pt x="4313" y="75"/>
                  <a:pt x="4310" y="48"/>
                  <a:pt x="4302" y="26"/>
                </a:cubicBezTo>
                <a:lnTo>
                  <a:pt x="4329" y="0"/>
                </a:lnTo>
                <a:lnTo>
                  <a:pt x="4667" y="337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91" name="Freeform 73"/>
          <p:cNvSpPr>
            <a:spLocks noEditPoints="1"/>
          </p:cNvSpPr>
          <p:nvPr/>
        </p:nvSpPr>
        <p:spPr bwMode="auto">
          <a:xfrm>
            <a:off x="4191178" y="4613062"/>
            <a:ext cx="890587" cy="889000"/>
          </a:xfrm>
          <a:custGeom>
            <a:avLst/>
            <a:gdLst>
              <a:gd name="T0" fmla="*/ 239 w 4676"/>
              <a:gd name="T1" fmla="*/ 4129 h 4666"/>
              <a:gd name="T2" fmla="*/ 244 w 4676"/>
              <a:gd name="T3" fmla="*/ 4485 h 4666"/>
              <a:gd name="T4" fmla="*/ 337 w 4676"/>
              <a:gd name="T5" fmla="*/ 4281 h 4666"/>
              <a:gd name="T6" fmla="*/ 85 w 4676"/>
              <a:gd name="T7" fmla="*/ 4325 h 4666"/>
              <a:gd name="T8" fmla="*/ 513 w 4676"/>
              <a:gd name="T9" fmla="*/ 3837 h 4666"/>
              <a:gd name="T10" fmla="*/ 741 w 4676"/>
              <a:gd name="T11" fmla="*/ 3965 h 4666"/>
              <a:gd name="T12" fmla="*/ 780 w 4676"/>
              <a:gd name="T13" fmla="*/ 4223 h 4666"/>
              <a:gd name="T14" fmla="*/ 621 w 4676"/>
              <a:gd name="T15" fmla="*/ 3950 h 4666"/>
              <a:gd name="T16" fmla="*/ 400 w 4676"/>
              <a:gd name="T17" fmla="*/ 4010 h 4666"/>
              <a:gd name="T18" fmla="*/ 785 w 4676"/>
              <a:gd name="T19" fmla="*/ 4116 h 4666"/>
              <a:gd name="T20" fmla="*/ 618 w 4676"/>
              <a:gd name="T21" fmla="*/ 4073 h 4666"/>
              <a:gd name="T22" fmla="*/ 744 w 4676"/>
              <a:gd name="T23" fmla="*/ 3586 h 4666"/>
              <a:gd name="T24" fmla="*/ 1131 w 4676"/>
              <a:gd name="T25" fmla="*/ 3667 h 4666"/>
              <a:gd name="T26" fmla="*/ 964 w 4676"/>
              <a:gd name="T27" fmla="*/ 4038 h 4666"/>
              <a:gd name="T28" fmla="*/ 1082 w 4676"/>
              <a:gd name="T29" fmla="*/ 3709 h 4666"/>
              <a:gd name="T30" fmla="*/ 712 w 4676"/>
              <a:gd name="T31" fmla="*/ 3697 h 4666"/>
              <a:gd name="T32" fmla="*/ 1627 w 4676"/>
              <a:gd name="T33" fmla="*/ 3561 h 4666"/>
              <a:gd name="T34" fmla="*/ 1415 w 4676"/>
              <a:gd name="T35" fmla="*/ 2922 h 4666"/>
              <a:gd name="T36" fmla="*/ 1564 w 4676"/>
              <a:gd name="T37" fmla="*/ 3165 h 4666"/>
              <a:gd name="T38" fmla="*/ 1525 w 4676"/>
              <a:gd name="T39" fmla="*/ 3125 h 4666"/>
              <a:gd name="T40" fmla="*/ 1404 w 4676"/>
              <a:gd name="T41" fmla="*/ 3006 h 4666"/>
              <a:gd name="T42" fmla="*/ 1789 w 4676"/>
              <a:gd name="T43" fmla="*/ 2541 h 4666"/>
              <a:gd name="T44" fmla="*/ 1958 w 4676"/>
              <a:gd name="T45" fmla="*/ 2736 h 4666"/>
              <a:gd name="T46" fmla="*/ 1882 w 4676"/>
              <a:gd name="T47" fmla="*/ 3120 h 4666"/>
              <a:gd name="T48" fmla="*/ 2043 w 4676"/>
              <a:gd name="T49" fmla="*/ 2460 h 4666"/>
              <a:gd name="T50" fmla="*/ 2167 w 4676"/>
              <a:gd name="T51" fmla="*/ 2480 h 4666"/>
              <a:gd name="T52" fmla="*/ 2184 w 4676"/>
              <a:gd name="T53" fmla="*/ 2584 h 4666"/>
              <a:gd name="T54" fmla="*/ 2343 w 4676"/>
              <a:gd name="T55" fmla="*/ 2133 h 4666"/>
              <a:gd name="T56" fmla="*/ 2283 w 4676"/>
              <a:gd name="T57" fmla="*/ 2044 h 4666"/>
              <a:gd name="T58" fmla="*/ 2563 w 4676"/>
              <a:gd name="T59" fmla="*/ 1952 h 4666"/>
              <a:gd name="T60" fmla="*/ 2743 w 4676"/>
              <a:gd name="T61" fmla="*/ 1847 h 4666"/>
              <a:gd name="T62" fmla="*/ 3058 w 4676"/>
              <a:gd name="T63" fmla="*/ 1944 h 4666"/>
              <a:gd name="T64" fmla="*/ 2776 w 4676"/>
              <a:gd name="T65" fmla="*/ 1834 h 4666"/>
              <a:gd name="T66" fmla="*/ 2704 w 4676"/>
              <a:gd name="T67" fmla="*/ 1899 h 4666"/>
              <a:gd name="T68" fmla="*/ 2811 w 4676"/>
              <a:gd name="T69" fmla="*/ 2192 h 4666"/>
              <a:gd name="T70" fmla="*/ 3219 w 4676"/>
              <a:gd name="T71" fmla="*/ 1727 h 4666"/>
              <a:gd name="T72" fmla="*/ 3063 w 4676"/>
              <a:gd name="T73" fmla="*/ 1693 h 4666"/>
              <a:gd name="T74" fmla="*/ 2960 w 4676"/>
              <a:gd name="T75" fmla="*/ 1554 h 4666"/>
              <a:gd name="T76" fmla="*/ 3121 w 4676"/>
              <a:gd name="T77" fmla="*/ 1531 h 4666"/>
              <a:gd name="T78" fmla="*/ 3026 w 4676"/>
              <a:gd name="T79" fmla="*/ 1638 h 4666"/>
              <a:gd name="T80" fmla="*/ 3274 w 4676"/>
              <a:gd name="T81" fmla="*/ 1585 h 4666"/>
              <a:gd name="T82" fmla="*/ 3070 w 4676"/>
              <a:gd name="T83" fmla="*/ 1786 h 4666"/>
              <a:gd name="T84" fmla="*/ 3204 w 4676"/>
              <a:gd name="T85" fmla="*/ 1372 h 4666"/>
              <a:gd name="T86" fmla="*/ 3541 w 4676"/>
              <a:gd name="T87" fmla="*/ 1461 h 4666"/>
              <a:gd name="T88" fmla="*/ 3499 w 4676"/>
              <a:gd name="T89" fmla="*/ 926 h 4666"/>
              <a:gd name="T90" fmla="*/ 3788 w 4676"/>
              <a:gd name="T91" fmla="*/ 1214 h 4666"/>
              <a:gd name="T92" fmla="*/ 3803 w 4676"/>
              <a:gd name="T93" fmla="*/ 565 h 4666"/>
              <a:gd name="T94" fmla="*/ 3808 w 4676"/>
              <a:gd name="T95" fmla="*/ 921 h 4666"/>
              <a:gd name="T96" fmla="*/ 3901 w 4676"/>
              <a:gd name="T97" fmla="*/ 717 h 4666"/>
              <a:gd name="T98" fmla="*/ 3648 w 4676"/>
              <a:gd name="T99" fmla="*/ 761 h 4666"/>
              <a:gd name="T100" fmla="*/ 4242 w 4676"/>
              <a:gd name="T101" fmla="*/ 672 h 4666"/>
              <a:gd name="T102" fmla="*/ 4293 w 4676"/>
              <a:gd name="T103" fmla="*/ 471 h 4666"/>
              <a:gd name="T104" fmla="*/ 3960 w 4676"/>
              <a:gd name="T105" fmla="*/ 544 h 4666"/>
              <a:gd name="T106" fmla="*/ 4143 w 4676"/>
              <a:gd name="T107" fmla="*/ 271 h 4666"/>
              <a:gd name="T108" fmla="*/ 3983 w 4676"/>
              <a:gd name="T109" fmla="*/ 444 h 4666"/>
              <a:gd name="T110" fmla="*/ 4307 w 4676"/>
              <a:gd name="T111" fmla="*/ 410 h 4666"/>
              <a:gd name="T112" fmla="*/ 4256 w 4676"/>
              <a:gd name="T113" fmla="*/ 731 h 4666"/>
              <a:gd name="T114" fmla="*/ 4534 w 4676"/>
              <a:gd name="T115" fmla="*/ 381 h 4666"/>
              <a:gd name="T116" fmla="*/ 4459 w 4676"/>
              <a:gd name="T117" fmla="*/ 216 h 4666"/>
              <a:gd name="T118" fmla="*/ 4422 w 4676"/>
              <a:gd name="T119" fmla="*/ 78 h 4666"/>
              <a:gd name="T120" fmla="*/ 4266 w 4676"/>
              <a:gd name="T121" fmla="*/ 236 h 4666"/>
              <a:gd name="T122" fmla="*/ 4465 w 4676"/>
              <a:gd name="T123" fmla="*/ 37 h 4666"/>
              <a:gd name="T124" fmla="*/ 4675 w 4676"/>
              <a:gd name="T125" fmla="*/ 278 h 466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  <a:cxn ang="0">
                <a:pos x="T122" y="T123"/>
              </a:cxn>
              <a:cxn ang="0">
                <a:pos x="T124" y="T125"/>
              </a:cxn>
            </a:cxnLst>
            <a:rect l="0" t="0" r="r" b="b"/>
            <a:pathLst>
              <a:path w="4676" h="4666">
                <a:moveTo>
                  <a:pt x="337" y="4666"/>
                </a:moveTo>
                <a:lnTo>
                  <a:pt x="0" y="4330"/>
                </a:lnTo>
                <a:lnTo>
                  <a:pt x="127" y="4203"/>
                </a:lnTo>
                <a:cubicBezTo>
                  <a:pt x="150" y="4180"/>
                  <a:pt x="168" y="4165"/>
                  <a:pt x="182" y="4155"/>
                </a:cubicBezTo>
                <a:cubicBezTo>
                  <a:pt x="201" y="4141"/>
                  <a:pt x="220" y="4133"/>
                  <a:pt x="239" y="4129"/>
                </a:cubicBezTo>
                <a:cubicBezTo>
                  <a:pt x="258" y="4126"/>
                  <a:pt x="277" y="4127"/>
                  <a:pt x="298" y="4135"/>
                </a:cubicBezTo>
                <a:cubicBezTo>
                  <a:pt x="319" y="4142"/>
                  <a:pt x="338" y="4154"/>
                  <a:pt x="354" y="4170"/>
                </a:cubicBezTo>
                <a:cubicBezTo>
                  <a:pt x="383" y="4199"/>
                  <a:pt x="398" y="4232"/>
                  <a:pt x="399" y="4270"/>
                </a:cubicBezTo>
                <a:cubicBezTo>
                  <a:pt x="401" y="4308"/>
                  <a:pt x="378" y="4351"/>
                  <a:pt x="331" y="4398"/>
                </a:cubicBezTo>
                <a:lnTo>
                  <a:pt x="244" y="4485"/>
                </a:lnTo>
                <a:lnTo>
                  <a:pt x="381" y="4621"/>
                </a:lnTo>
                <a:lnTo>
                  <a:pt x="337" y="4666"/>
                </a:lnTo>
                <a:close/>
                <a:moveTo>
                  <a:pt x="205" y="4445"/>
                </a:moveTo>
                <a:lnTo>
                  <a:pt x="292" y="4358"/>
                </a:lnTo>
                <a:cubicBezTo>
                  <a:pt x="320" y="4329"/>
                  <a:pt x="335" y="4304"/>
                  <a:pt x="337" y="4281"/>
                </a:cubicBezTo>
                <a:cubicBezTo>
                  <a:pt x="338" y="4258"/>
                  <a:pt x="329" y="4237"/>
                  <a:pt x="310" y="4217"/>
                </a:cubicBezTo>
                <a:cubicBezTo>
                  <a:pt x="296" y="4203"/>
                  <a:pt x="280" y="4195"/>
                  <a:pt x="263" y="4192"/>
                </a:cubicBezTo>
                <a:cubicBezTo>
                  <a:pt x="246" y="4189"/>
                  <a:pt x="230" y="4192"/>
                  <a:pt x="215" y="4200"/>
                </a:cubicBezTo>
                <a:cubicBezTo>
                  <a:pt x="206" y="4206"/>
                  <a:pt x="191" y="4219"/>
                  <a:pt x="171" y="4239"/>
                </a:cubicBezTo>
                <a:lnTo>
                  <a:pt x="85" y="4325"/>
                </a:lnTo>
                <a:lnTo>
                  <a:pt x="205" y="4445"/>
                </a:lnTo>
                <a:close/>
                <a:moveTo>
                  <a:pt x="651" y="4351"/>
                </a:moveTo>
                <a:lnTo>
                  <a:pt x="315" y="4015"/>
                </a:lnTo>
                <a:lnTo>
                  <a:pt x="441" y="3889"/>
                </a:lnTo>
                <a:cubicBezTo>
                  <a:pt x="467" y="3863"/>
                  <a:pt x="491" y="3846"/>
                  <a:pt x="513" y="3837"/>
                </a:cubicBezTo>
                <a:cubicBezTo>
                  <a:pt x="536" y="3828"/>
                  <a:pt x="558" y="3827"/>
                  <a:pt x="581" y="3832"/>
                </a:cubicBezTo>
                <a:cubicBezTo>
                  <a:pt x="604" y="3837"/>
                  <a:pt x="623" y="3848"/>
                  <a:pt x="639" y="3863"/>
                </a:cubicBezTo>
                <a:cubicBezTo>
                  <a:pt x="653" y="3877"/>
                  <a:pt x="663" y="3895"/>
                  <a:pt x="668" y="3915"/>
                </a:cubicBezTo>
                <a:cubicBezTo>
                  <a:pt x="673" y="3936"/>
                  <a:pt x="671" y="3958"/>
                  <a:pt x="663" y="3981"/>
                </a:cubicBezTo>
                <a:cubicBezTo>
                  <a:pt x="689" y="3967"/>
                  <a:pt x="715" y="3962"/>
                  <a:pt x="741" y="3965"/>
                </a:cubicBezTo>
                <a:cubicBezTo>
                  <a:pt x="766" y="3968"/>
                  <a:pt x="788" y="3980"/>
                  <a:pt x="808" y="3999"/>
                </a:cubicBezTo>
                <a:cubicBezTo>
                  <a:pt x="824" y="4015"/>
                  <a:pt x="835" y="4033"/>
                  <a:pt x="842" y="4053"/>
                </a:cubicBezTo>
                <a:cubicBezTo>
                  <a:pt x="849" y="4074"/>
                  <a:pt x="851" y="4092"/>
                  <a:pt x="848" y="4109"/>
                </a:cubicBezTo>
                <a:cubicBezTo>
                  <a:pt x="846" y="4126"/>
                  <a:pt x="839" y="4144"/>
                  <a:pt x="828" y="4163"/>
                </a:cubicBezTo>
                <a:cubicBezTo>
                  <a:pt x="817" y="4181"/>
                  <a:pt x="801" y="4201"/>
                  <a:pt x="780" y="4223"/>
                </a:cubicBezTo>
                <a:lnTo>
                  <a:pt x="651" y="4351"/>
                </a:lnTo>
                <a:close/>
                <a:moveTo>
                  <a:pt x="501" y="4111"/>
                </a:moveTo>
                <a:lnTo>
                  <a:pt x="574" y="4039"/>
                </a:lnTo>
                <a:cubicBezTo>
                  <a:pt x="593" y="4019"/>
                  <a:pt x="606" y="4004"/>
                  <a:pt x="612" y="3992"/>
                </a:cubicBezTo>
                <a:cubicBezTo>
                  <a:pt x="620" y="3978"/>
                  <a:pt x="623" y="3964"/>
                  <a:pt x="621" y="3950"/>
                </a:cubicBezTo>
                <a:cubicBezTo>
                  <a:pt x="619" y="3937"/>
                  <a:pt x="612" y="3924"/>
                  <a:pt x="600" y="3912"/>
                </a:cubicBezTo>
                <a:cubicBezTo>
                  <a:pt x="589" y="3901"/>
                  <a:pt x="577" y="3894"/>
                  <a:pt x="563" y="3891"/>
                </a:cubicBezTo>
                <a:cubicBezTo>
                  <a:pt x="549" y="3888"/>
                  <a:pt x="536" y="3889"/>
                  <a:pt x="523" y="3896"/>
                </a:cubicBezTo>
                <a:cubicBezTo>
                  <a:pt x="509" y="3903"/>
                  <a:pt x="491" y="3918"/>
                  <a:pt x="467" y="3943"/>
                </a:cubicBezTo>
                <a:lnTo>
                  <a:pt x="400" y="4010"/>
                </a:lnTo>
                <a:lnTo>
                  <a:pt x="501" y="4111"/>
                </a:lnTo>
                <a:close/>
                <a:moveTo>
                  <a:pt x="656" y="4267"/>
                </a:moveTo>
                <a:lnTo>
                  <a:pt x="740" y="4183"/>
                </a:lnTo>
                <a:cubicBezTo>
                  <a:pt x="754" y="4169"/>
                  <a:pt x="764" y="4158"/>
                  <a:pt x="769" y="4151"/>
                </a:cubicBezTo>
                <a:cubicBezTo>
                  <a:pt x="777" y="4139"/>
                  <a:pt x="783" y="4127"/>
                  <a:pt x="785" y="4116"/>
                </a:cubicBezTo>
                <a:cubicBezTo>
                  <a:pt x="788" y="4105"/>
                  <a:pt x="787" y="4093"/>
                  <a:pt x="783" y="4081"/>
                </a:cubicBezTo>
                <a:cubicBezTo>
                  <a:pt x="780" y="4068"/>
                  <a:pt x="772" y="4056"/>
                  <a:pt x="762" y="4046"/>
                </a:cubicBezTo>
                <a:cubicBezTo>
                  <a:pt x="749" y="4033"/>
                  <a:pt x="735" y="4025"/>
                  <a:pt x="719" y="4023"/>
                </a:cubicBezTo>
                <a:cubicBezTo>
                  <a:pt x="704" y="4020"/>
                  <a:pt x="688" y="4022"/>
                  <a:pt x="673" y="4030"/>
                </a:cubicBezTo>
                <a:cubicBezTo>
                  <a:pt x="658" y="4037"/>
                  <a:pt x="640" y="4052"/>
                  <a:pt x="618" y="4073"/>
                </a:cubicBezTo>
                <a:lnTo>
                  <a:pt x="541" y="4151"/>
                </a:lnTo>
                <a:lnTo>
                  <a:pt x="656" y="4267"/>
                </a:lnTo>
                <a:close/>
                <a:moveTo>
                  <a:pt x="964" y="4038"/>
                </a:moveTo>
                <a:lnTo>
                  <a:pt x="628" y="3702"/>
                </a:lnTo>
                <a:lnTo>
                  <a:pt x="744" y="3586"/>
                </a:lnTo>
                <a:cubicBezTo>
                  <a:pt x="770" y="3560"/>
                  <a:pt x="792" y="3541"/>
                  <a:pt x="809" y="3531"/>
                </a:cubicBezTo>
                <a:cubicBezTo>
                  <a:pt x="832" y="3516"/>
                  <a:pt x="857" y="3508"/>
                  <a:pt x="882" y="3506"/>
                </a:cubicBezTo>
                <a:cubicBezTo>
                  <a:pt x="915" y="3503"/>
                  <a:pt x="947" y="3509"/>
                  <a:pt x="979" y="3523"/>
                </a:cubicBezTo>
                <a:cubicBezTo>
                  <a:pt x="1011" y="3538"/>
                  <a:pt x="1042" y="3560"/>
                  <a:pt x="1072" y="3590"/>
                </a:cubicBezTo>
                <a:cubicBezTo>
                  <a:pt x="1098" y="3616"/>
                  <a:pt x="1118" y="3641"/>
                  <a:pt x="1131" y="3667"/>
                </a:cubicBezTo>
                <a:cubicBezTo>
                  <a:pt x="1145" y="3692"/>
                  <a:pt x="1154" y="3716"/>
                  <a:pt x="1157" y="3739"/>
                </a:cubicBezTo>
                <a:cubicBezTo>
                  <a:pt x="1161" y="3761"/>
                  <a:pt x="1161" y="3781"/>
                  <a:pt x="1157" y="3800"/>
                </a:cubicBezTo>
                <a:cubicBezTo>
                  <a:pt x="1154" y="3818"/>
                  <a:pt x="1146" y="3837"/>
                  <a:pt x="1134" y="3857"/>
                </a:cubicBezTo>
                <a:cubicBezTo>
                  <a:pt x="1122" y="3876"/>
                  <a:pt x="1106" y="3896"/>
                  <a:pt x="1086" y="3916"/>
                </a:cubicBezTo>
                <a:lnTo>
                  <a:pt x="964" y="4038"/>
                </a:lnTo>
                <a:close/>
                <a:moveTo>
                  <a:pt x="969" y="3954"/>
                </a:moveTo>
                <a:lnTo>
                  <a:pt x="1041" y="3882"/>
                </a:lnTo>
                <a:cubicBezTo>
                  <a:pt x="1063" y="3860"/>
                  <a:pt x="1078" y="3840"/>
                  <a:pt x="1087" y="3824"/>
                </a:cubicBezTo>
                <a:cubicBezTo>
                  <a:pt x="1095" y="3807"/>
                  <a:pt x="1100" y="3791"/>
                  <a:pt x="1100" y="3776"/>
                </a:cubicBezTo>
                <a:cubicBezTo>
                  <a:pt x="1100" y="3755"/>
                  <a:pt x="1094" y="3732"/>
                  <a:pt x="1082" y="3709"/>
                </a:cubicBezTo>
                <a:cubicBezTo>
                  <a:pt x="1070" y="3685"/>
                  <a:pt x="1051" y="3661"/>
                  <a:pt x="1026" y="3635"/>
                </a:cubicBezTo>
                <a:cubicBezTo>
                  <a:pt x="991" y="3600"/>
                  <a:pt x="958" y="3579"/>
                  <a:pt x="928" y="3571"/>
                </a:cubicBezTo>
                <a:cubicBezTo>
                  <a:pt x="897" y="3564"/>
                  <a:pt x="870" y="3565"/>
                  <a:pt x="848" y="3576"/>
                </a:cubicBezTo>
                <a:cubicBezTo>
                  <a:pt x="831" y="3583"/>
                  <a:pt x="810" y="3600"/>
                  <a:pt x="783" y="3626"/>
                </a:cubicBezTo>
                <a:lnTo>
                  <a:pt x="712" y="3697"/>
                </a:lnTo>
                <a:lnTo>
                  <a:pt x="969" y="3954"/>
                </a:lnTo>
                <a:close/>
                <a:moveTo>
                  <a:pt x="1354" y="3835"/>
                </a:moveTo>
                <a:lnTo>
                  <a:pt x="1324" y="3805"/>
                </a:lnTo>
                <a:lnTo>
                  <a:pt x="1598" y="3532"/>
                </a:lnTo>
                <a:lnTo>
                  <a:pt x="1627" y="3561"/>
                </a:lnTo>
                <a:lnTo>
                  <a:pt x="1354" y="3835"/>
                </a:lnTo>
                <a:close/>
                <a:moveTo>
                  <a:pt x="1570" y="3432"/>
                </a:moveTo>
                <a:lnTo>
                  <a:pt x="1234" y="3096"/>
                </a:lnTo>
                <a:lnTo>
                  <a:pt x="1360" y="2970"/>
                </a:lnTo>
                <a:cubicBezTo>
                  <a:pt x="1383" y="2947"/>
                  <a:pt x="1401" y="2931"/>
                  <a:pt x="1415" y="2922"/>
                </a:cubicBezTo>
                <a:cubicBezTo>
                  <a:pt x="1434" y="2908"/>
                  <a:pt x="1453" y="2899"/>
                  <a:pt x="1472" y="2896"/>
                </a:cubicBezTo>
                <a:cubicBezTo>
                  <a:pt x="1491" y="2892"/>
                  <a:pt x="1511" y="2894"/>
                  <a:pt x="1531" y="2901"/>
                </a:cubicBezTo>
                <a:cubicBezTo>
                  <a:pt x="1552" y="2908"/>
                  <a:pt x="1571" y="2920"/>
                  <a:pt x="1587" y="2937"/>
                </a:cubicBezTo>
                <a:cubicBezTo>
                  <a:pt x="1616" y="2966"/>
                  <a:pt x="1631" y="2999"/>
                  <a:pt x="1633" y="3037"/>
                </a:cubicBezTo>
                <a:cubicBezTo>
                  <a:pt x="1634" y="3075"/>
                  <a:pt x="1611" y="3118"/>
                  <a:pt x="1564" y="3165"/>
                </a:cubicBezTo>
                <a:lnTo>
                  <a:pt x="1478" y="3251"/>
                </a:lnTo>
                <a:lnTo>
                  <a:pt x="1614" y="3388"/>
                </a:lnTo>
                <a:lnTo>
                  <a:pt x="1570" y="3432"/>
                </a:lnTo>
                <a:close/>
                <a:moveTo>
                  <a:pt x="1438" y="3212"/>
                </a:moveTo>
                <a:lnTo>
                  <a:pt x="1525" y="3125"/>
                </a:lnTo>
                <a:cubicBezTo>
                  <a:pt x="1554" y="3096"/>
                  <a:pt x="1569" y="3070"/>
                  <a:pt x="1570" y="3048"/>
                </a:cubicBezTo>
                <a:cubicBezTo>
                  <a:pt x="1571" y="3025"/>
                  <a:pt x="1562" y="3004"/>
                  <a:pt x="1543" y="2984"/>
                </a:cubicBezTo>
                <a:cubicBezTo>
                  <a:pt x="1529" y="2970"/>
                  <a:pt x="1513" y="2962"/>
                  <a:pt x="1496" y="2959"/>
                </a:cubicBezTo>
                <a:cubicBezTo>
                  <a:pt x="1479" y="2956"/>
                  <a:pt x="1463" y="2959"/>
                  <a:pt x="1448" y="2967"/>
                </a:cubicBezTo>
                <a:cubicBezTo>
                  <a:pt x="1439" y="2973"/>
                  <a:pt x="1424" y="2985"/>
                  <a:pt x="1404" y="3006"/>
                </a:cubicBezTo>
                <a:lnTo>
                  <a:pt x="1318" y="3092"/>
                </a:lnTo>
                <a:lnTo>
                  <a:pt x="1438" y="3212"/>
                </a:lnTo>
                <a:close/>
                <a:moveTo>
                  <a:pt x="1882" y="3120"/>
                </a:moveTo>
                <a:lnTo>
                  <a:pt x="1546" y="2784"/>
                </a:lnTo>
                <a:lnTo>
                  <a:pt x="1789" y="2541"/>
                </a:lnTo>
                <a:lnTo>
                  <a:pt x="1828" y="2581"/>
                </a:lnTo>
                <a:lnTo>
                  <a:pt x="1630" y="2780"/>
                </a:lnTo>
                <a:lnTo>
                  <a:pt x="1733" y="2882"/>
                </a:lnTo>
                <a:lnTo>
                  <a:pt x="1919" y="2697"/>
                </a:lnTo>
                <a:lnTo>
                  <a:pt x="1958" y="2736"/>
                </a:lnTo>
                <a:lnTo>
                  <a:pt x="1772" y="2922"/>
                </a:lnTo>
                <a:lnTo>
                  <a:pt x="1887" y="3036"/>
                </a:lnTo>
                <a:lnTo>
                  <a:pt x="2093" y="2830"/>
                </a:lnTo>
                <a:lnTo>
                  <a:pt x="2133" y="2870"/>
                </a:lnTo>
                <a:lnTo>
                  <a:pt x="1882" y="3120"/>
                </a:lnTo>
                <a:close/>
                <a:moveTo>
                  <a:pt x="2163" y="2839"/>
                </a:moveTo>
                <a:lnTo>
                  <a:pt x="2118" y="2534"/>
                </a:lnTo>
                <a:lnTo>
                  <a:pt x="1843" y="2487"/>
                </a:lnTo>
                <a:lnTo>
                  <a:pt x="1896" y="2434"/>
                </a:lnTo>
                <a:lnTo>
                  <a:pt x="2043" y="2460"/>
                </a:lnTo>
                <a:cubicBezTo>
                  <a:pt x="2073" y="2465"/>
                  <a:pt x="2096" y="2469"/>
                  <a:pt x="2111" y="2474"/>
                </a:cubicBezTo>
                <a:cubicBezTo>
                  <a:pt x="2106" y="2454"/>
                  <a:pt x="2103" y="2432"/>
                  <a:pt x="2099" y="2409"/>
                </a:cubicBezTo>
                <a:lnTo>
                  <a:pt x="2078" y="2252"/>
                </a:lnTo>
                <a:lnTo>
                  <a:pt x="2126" y="2204"/>
                </a:lnTo>
                <a:lnTo>
                  <a:pt x="2167" y="2480"/>
                </a:lnTo>
                <a:lnTo>
                  <a:pt x="2472" y="2531"/>
                </a:lnTo>
                <a:lnTo>
                  <a:pt x="2417" y="2586"/>
                </a:lnTo>
                <a:lnTo>
                  <a:pt x="2212" y="2550"/>
                </a:lnTo>
                <a:cubicBezTo>
                  <a:pt x="2200" y="2548"/>
                  <a:pt x="2188" y="2546"/>
                  <a:pt x="2175" y="2543"/>
                </a:cubicBezTo>
                <a:cubicBezTo>
                  <a:pt x="2180" y="2562"/>
                  <a:pt x="2183" y="2576"/>
                  <a:pt x="2184" y="2584"/>
                </a:cubicBezTo>
                <a:lnTo>
                  <a:pt x="2217" y="2785"/>
                </a:lnTo>
                <a:lnTo>
                  <a:pt x="2163" y="2839"/>
                </a:lnTo>
                <a:close/>
                <a:moveTo>
                  <a:pt x="2647" y="2355"/>
                </a:moveTo>
                <a:lnTo>
                  <a:pt x="2606" y="2396"/>
                </a:lnTo>
                <a:lnTo>
                  <a:pt x="2343" y="2133"/>
                </a:lnTo>
                <a:cubicBezTo>
                  <a:pt x="2343" y="2152"/>
                  <a:pt x="2339" y="2175"/>
                  <a:pt x="2333" y="2201"/>
                </a:cubicBezTo>
                <a:cubicBezTo>
                  <a:pt x="2326" y="2226"/>
                  <a:pt x="2319" y="2248"/>
                  <a:pt x="2310" y="2265"/>
                </a:cubicBezTo>
                <a:lnTo>
                  <a:pt x="2271" y="2225"/>
                </a:lnTo>
                <a:cubicBezTo>
                  <a:pt x="2283" y="2191"/>
                  <a:pt x="2290" y="2158"/>
                  <a:pt x="2292" y="2125"/>
                </a:cubicBezTo>
                <a:cubicBezTo>
                  <a:pt x="2293" y="2093"/>
                  <a:pt x="2291" y="2066"/>
                  <a:pt x="2283" y="2044"/>
                </a:cubicBezTo>
                <a:lnTo>
                  <a:pt x="2310" y="2017"/>
                </a:lnTo>
                <a:lnTo>
                  <a:pt x="2647" y="2355"/>
                </a:lnTo>
                <a:close/>
                <a:moveTo>
                  <a:pt x="2769" y="2233"/>
                </a:moveTo>
                <a:lnTo>
                  <a:pt x="2526" y="1989"/>
                </a:lnTo>
                <a:lnTo>
                  <a:pt x="2563" y="1952"/>
                </a:lnTo>
                <a:lnTo>
                  <a:pt x="2597" y="1987"/>
                </a:lnTo>
                <a:cubicBezTo>
                  <a:pt x="2593" y="1967"/>
                  <a:pt x="2593" y="1947"/>
                  <a:pt x="2599" y="1927"/>
                </a:cubicBezTo>
                <a:cubicBezTo>
                  <a:pt x="2604" y="1907"/>
                  <a:pt x="2615" y="1889"/>
                  <a:pt x="2631" y="1873"/>
                </a:cubicBezTo>
                <a:cubicBezTo>
                  <a:pt x="2649" y="1855"/>
                  <a:pt x="2668" y="1844"/>
                  <a:pt x="2687" y="1840"/>
                </a:cubicBezTo>
                <a:cubicBezTo>
                  <a:pt x="2706" y="1836"/>
                  <a:pt x="2724" y="1838"/>
                  <a:pt x="2743" y="1847"/>
                </a:cubicBezTo>
                <a:cubicBezTo>
                  <a:pt x="2733" y="1799"/>
                  <a:pt x="2744" y="1760"/>
                  <a:pt x="2775" y="1729"/>
                </a:cubicBezTo>
                <a:cubicBezTo>
                  <a:pt x="2799" y="1705"/>
                  <a:pt x="2824" y="1693"/>
                  <a:pt x="2851" y="1693"/>
                </a:cubicBezTo>
                <a:cubicBezTo>
                  <a:pt x="2877" y="1694"/>
                  <a:pt x="2904" y="1708"/>
                  <a:pt x="2932" y="1736"/>
                </a:cubicBezTo>
                <a:lnTo>
                  <a:pt x="3099" y="1903"/>
                </a:lnTo>
                <a:lnTo>
                  <a:pt x="3058" y="1944"/>
                </a:lnTo>
                <a:lnTo>
                  <a:pt x="2905" y="1791"/>
                </a:lnTo>
                <a:cubicBezTo>
                  <a:pt x="2888" y="1774"/>
                  <a:pt x="2875" y="1764"/>
                  <a:pt x="2865" y="1759"/>
                </a:cubicBezTo>
                <a:cubicBezTo>
                  <a:pt x="2855" y="1754"/>
                  <a:pt x="2845" y="1753"/>
                  <a:pt x="2833" y="1756"/>
                </a:cubicBezTo>
                <a:cubicBezTo>
                  <a:pt x="2822" y="1759"/>
                  <a:pt x="2811" y="1765"/>
                  <a:pt x="2802" y="1774"/>
                </a:cubicBezTo>
                <a:cubicBezTo>
                  <a:pt x="2785" y="1791"/>
                  <a:pt x="2776" y="1811"/>
                  <a:pt x="2776" y="1834"/>
                </a:cubicBezTo>
                <a:cubicBezTo>
                  <a:pt x="2776" y="1856"/>
                  <a:pt x="2789" y="1880"/>
                  <a:pt x="2814" y="1905"/>
                </a:cubicBezTo>
                <a:lnTo>
                  <a:pt x="2955" y="2047"/>
                </a:lnTo>
                <a:lnTo>
                  <a:pt x="2914" y="2088"/>
                </a:lnTo>
                <a:lnTo>
                  <a:pt x="2756" y="1930"/>
                </a:lnTo>
                <a:cubicBezTo>
                  <a:pt x="2737" y="1912"/>
                  <a:pt x="2720" y="1901"/>
                  <a:pt x="2704" y="1899"/>
                </a:cubicBezTo>
                <a:cubicBezTo>
                  <a:pt x="2689" y="1896"/>
                  <a:pt x="2673" y="1903"/>
                  <a:pt x="2658" y="1918"/>
                </a:cubicBezTo>
                <a:cubicBezTo>
                  <a:pt x="2646" y="1930"/>
                  <a:pt x="2638" y="1943"/>
                  <a:pt x="2635" y="1959"/>
                </a:cubicBezTo>
                <a:cubicBezTo>
                  <a:pt x="2631" y="1975"/>
                  <a:pt x="2633" y="1991"/>
                  <a:pt x="2640" y="2008"/>
                </a:cubicBezTo>
                <a:cubicBezTo>
                  <a:pt x="2647" y="2024"/>
                  <a:pt x="2662" y="2043"/>
                  <a:pt x="2684" y="2065"/>
                </a:cubicBezTo>
                <a:lnTo>
                  <a:pt x="2811" y="2192"/>
                </a:lnTo>
                <a:lnTo>
                  <a:pt x="2769" y="2233"/>
                </a:lnTo>
                <a:close/>
                <a:moveTo>
                  <a:pt x="3070" y="1786"/>
                </a:moveTo>
                <a:lnTo>
                  <a:pt x="3105" y="1739"/>
                </a:lnTo>
                <a:cubicBezTo>
                  <a:pt x="3124" y="1753"/>
                  <a:pt x="3142" y="1759"/>
                  <a:pt x="3162" y="1758"/>
                </a:cubicBezTo>
                <a:cubicBezTo>
                  <a:pt x="3181" y="1756"/>
                  <a:pt x="3200" y="1746"/>
                  <a:pt x="3219" y="1727"/>
                </a:cubicBezTo>
                <a:cubicBezTo>
                  <a:pt x="3238" y="1708"/>
                  <a:pt x="3248" y="1690"/>
                  <a:pt x="3249" y="1673"/>
                </a:cubicBezTo>
                <a:cubicBezTo>
                  <a:pt x="3251" y="1656"/>
                  <a:pt x="3246" y="1642"/>
                  <a:pt x="3236" y="1632"/>
                </a:cubicBezTo>
                <a:cubicBezTo>
                  <a:pt x="3226" y="1623"/>
                  <a:pt x="3215" y="1619"/>
                  <a:pt x="3202" y="1622"/>
                </a:cubicBezTo>
                <a:cubicBezTo>
                  <a:pt x="3192" y="1624"/>
                  <a:pt x="3174" y="1634"/>
                  <a:pt x="3145" y="1650"/>
                </a:cubicBezTo>
                <a:cubicBezTo>
                  <a:pt x="3108" y="1673"/>
                  <a:pt x="3080" y="1687"/>
                  <a:pt x="3063" y="1693"/>
                </a:cubicBezTo>
                <a:cubicBezTo>
                  <a:pt x="3045" y="1700"/>
                  <a:pt x="3029" y="1701"/>
                  <a:pt x="3013" y="1697"/>
                </a:cubicBezTo>
                <a:cubicBezTo>
                  <a:pt x="2997" y="1693"/>
                  <a:pt x="2983" y="1685"/>
                  <a:pt x="2971" y="1673"/>
                </a:cubicBezTo>
                <a:cubicBezTo>
                  <a:pt x="2960" y="1662"/>
                  <a:pt x="2953" y="1650"/>
                  <a:pt x="2949" y="1636"/>
                </a:cubicBezTo>
                <a:cubicBezTo>
                  <a:pt x="2944" y="1621"/>
                  <a:pt x="2943" y="1607"/>
                  <a:pt x="2946" y="1592"/>
                </a:cubicBezTo>
                <a:cubicBezTo>
                  <a:pt x="2947" y="1581"/>
                  <a:pt x="2952" y="1568"/>
                  <a:pt x="2960" y="1554"/>
                </a:cubicBezTo>
                <a:cubicBezTo>
                  <a:pt x="2968" y="1540"/>
                  <a:pt x="2978" y="1526"/>
                  <a:pt x="2991" y="1514"/>
                </a:cubicBezTo>
                <a:cubicBezTo>
                  <a:pt x="3010" y="1494"/>
                  <a:pt x="3029" y="1480"/>
                  <a:pt x="3049" y="1471"/>
                </a:cubicBezTo>
                <a:cubicBezTo>
                  <a:pt x="3069" y="1463"/>
                  <a:pt x="3087" y="1459"/>
                  <a:pt x="3104" y="1462"/>
                </a:cubicBezTo>
                <a:cubicBezTo>
                  <a:pt x="3120" y="1464"/>
                  <a:pt x="3137" y="1472"/>
                  <a:pt x="3156" y="1485"/>
                </a:cubicBezTo>
                <a:lnTo>
                  <a:pt x="3121" y="1531"/>
                </a:lnTo>
                <a:cubicBezTo>
                  <a:pt x="3106" y="1520"/>
                  <a:pt x="3091" y="1516"/>
                  <a:pt x="3075" y="1518"/>
                </a:cubicBezTo>
                <a:cubicBezTo>
                  <a:pt x="3060" y="1520"/>
                  <a:pt x="3044" y="1528"/>
                  <a:pt x="3028" y="1544"/>
                </a:cubicBezTo>
                <a:cubicBezTo>
                  <a:pt x="3009" y="1563"/>
                  <a:pt x="2998" y="1580"/>
                  <a:pt x="2996" y="1594"/>
                </a:cubicBezTo>
                <a:cubicBezTo>
                  <a:pt x="2995" y="1609"/>
                  <a:pt x="2998" y="1620"/>
                  <a:pt x="3006" y="1629"/>
                </a:cubicBezTo>
                <a:cubicBezTo>
                  <a:pt x="3012" y="1634"/>
                  <a:pt x="3018" y="1637"/>
                  <a:pt x="3026" y="1638"/>
                </a:cubicBezTo>
                <a:cubicBezTo>
                  <a:pt x="3034" y="1639"/>
                  <a:pt x="3043" y="1637"/>
                  <a:pt x="3053" y="1633"/>
                </a:cubicBezTo>
                <a:cubicBezTo>
                  <a:pt x="3058" y="1631"/>
                  <a:pt x="3074" y="1622"/>
                  <a:pt x="3100" y="1607"/>
                </a:cubicBezTo>
                <a:cubicBezTo>
                  <a:pt x="3137" y="1586"/>
                  <a:pt x="3163" y="1572"/>
                  <a:pt x="3180" y="1565"/>
                </a:cubicBezTo>
                <a:cubicBezTo>
                  <a:pt x="3196" y="1559"/>
                  <a:pt x="3213" y="1557"/>
                  <a:pt x="3229" y="1560"/>
                </a:cubicBezTo>
                <a:cubicBezTo>
                  <a:pt x="3245" y="1563"/>
                  <a:pt x="3260" y="1571"/>
                  <a:pt x="3274" y="1585"/>
                </a:cubicBezTo>
                <a:cubicBezTo>
                  <a:pt x="3288" y="1599"/>
                  <a:pt x="3297" y="1616"/>
                  <a:pt x="3301" y="1636"/>
                </a:cubicBezTo>
                <a:cubicBezTo>
                  <a:pt x="3305" y="1656"/>
                  <a:pt x="3303" y="1677"/>
                  <a:pt x="3294" y="1699"/>
                </a:cubicBezTo>
                <a:cubicBezTo>
                  <a:pt x="3286" y="1721"/>
                  <a:pt x="3272" y="1741"/>
                  <a:pt x="3253" y="1760"/>
                </a:cubicBezTo>
                <a:cubicBezTo>
                  <a:pt x="3221" y="1792"/>
                  <a:pt x="3190" y="1810"/>
                  <a:pt x="3161" y="1813"/>
                </a:cubicBezTo>
                <a:cubicBezTo>
                  <a:pt x="3131" y="1816"/>
                  <a:pt x="3101" y="1808"/>
                  <a:pt x="3070" y="1786"/>
                </a:cubicBezTo>
                <a:close/>
                <a:moveTo>
                  <a:pt x="3541" y="1461"/>
                </a:moveTo>
                <a:lnTo>
                  <a:pt x="3500" y="1502"/>
                </a:lnTo>
                <a:lnTo>
                  <a:pt x="3237" y="1239"/>
                </a:lnTo>
                <a:cubicBezTo>
                  <a:pt x="3237" y="1259"/>
                  <a:pt x="3233" y="1281"/>
                  <a:pt x="3226" y="1307"/>
                </a:cubicBezTo>
                <a:cubicBezTo>
                  <a:pt x="3220" y="1332"/>
                  <a:pt x="3212" y="1354"/>
                  <a:pt x="3204" y="1372"/>
                </a:cubicBezTo>
                <a:lnTo>
                  <a:pt x="3164" y="1332"/>
                </a:lnTo>
                <a:cubicBezTo>
                  <a:pt x="3177" y="1298"/>
                  <a:pt x="3184" y="1264"/>
                  <a:pt x="3185" y="1232"/>
                </a:cubicBezTo>
                <a:cubicBezTo>
                  <a:pt x="3187" y="1199"/>
                  <a:pt x="3185" y="1172"/>
                  <a:pt x="3177" y="1150"/>
                </a:cubicBezTo>
                <a:lnTo>
                  <a:pt x="3204" y="1123"/>
                </a:lnTo>
                <a:lnTo>
                  <a:pt x="3541" y="1461"/>
                </a:lnTo>
                <a:close/>
                <a:moveTo>
                  <a:pt x="3499" y="926"/>
                </a:moveTo>
                <a:lnTo>
                  <a:pt x="3452" y="878"/>
                </a:lnTo>
                <a:lnTo>
                  <a:pt x="3493" y="837"/>
                </a:lnTo>
                <a:lnTo>
                  <a:pt x="3540" y="884"/>
                </a:lnTo>
                <a:lnTo>
                  <a:pt x="3499" y="926"/>
                </a:lnTo>
                <a:close/>
                <a:moveTo>
                  <a:pt x="3788" y="1214"/>
                </a:moveTo>
                <a:lnTo>
                  <a:pt x="3544" y="971"/>
                </a:lnTo>
                <a:lnTo>
                  <a:pt x="3586" y="930"/>
                </a:lnTo>
                <a:lnTo>
                  <a:pt x="3829" y="1173"/>
                </a:lnTo>
                <a:lnTo>
                  <a:pt x="3788" y="1214"/>
                </a:lnTo>
                <a:close/>
                <a:moveTo>
                  <a:pt x="3900" y="1102"/>
                </a:moveTo>
                <a:lnTo>
                  <a:pt x="3564" y="766"/>
                </a:lnTo>
                <a:lnTo>
                  <a:pt x="3691" y="639"/>
                </a:lnTo>
                <a:cubicBezTo>
                  <a:pt x="3713" y="617"/>
                  <a:pt x="3731" y="601"/>
                  <a:pt x="3745" y="591"/>
                </a:cubicBezTo>
                <a:cubicBezTo>
                  <a:pt x="3765" y="577"/>
                  <a:pt x="3784" y="569"/>
                  <a:pt x="3803" y="565"/>
                </a:cubicBezTo>
                <a:cubicBezTo>
                  <a:pt x="3821" y="562"/>
                  <a:pt x="3841" y="564"/>
                  <a:pt x="3862" y="571"/>
                </a:cubicBezTo>
                <a:cubicBezTo>
                  <a:pt x="3883" y="578"/>
                  <a:pt x="3901" y="590"/>
                  <a:pt x="3918" y="606"/>
                </a:cubicBezTo>
                <a:cubicBezTo>
                  <a:pt x="3947" y="635"/>
                  <a:pt x="3962" y="668"/>
                  <a:pt x="3963" y="706"/>
                </a:cubicBezTo>
                <a:cubicBezTo>
                  <a:pt x="3965" y="744"/>
                  <a:pt x="3942" y="787"/>
                  <a:pt x="3894" y="835"/>
                </a:cubicBezTo>
                <a:lnTo>
                  <a:pt x="3808" y="921"/>
                </a:lnTo>
                <a:lnTo>
                  <a:pt x="3945" y="1057"/>
                </a:lnTo>
                <a:lnTo>
                  <a:pt x="3900" y="1102"/>
                </a:lnTo>
                <a:close/>
                <a:moveTo>
                  <a:pt x="3769" y="881"/>
                </a:moveTo>
                <a:lnTo>
                  <a:pt x="3855" y="794"/>
                </a:lnTo>
                <a:cubicBezTo>
                  <a:pt x="3884" y="765"/>
                  <a:pt x="3899" y="740"/>
                  <a:pt x="3901" y="717"/>
                </a:cubicBezTo>
                <a:cubicBezTo>
                  <a:pt x="3902" y="694"/>
                  <a:pt x="3893" y="673"/>
                  <a:pt x="3874" y="654"/>
                </a:cubicBezTo>
                <a:cubicBezTo>
                  <a:pt x="3859" y="640"/>
                  <a:pt x="3844" y="631"/>
                  <a:pt x="3827" y="628"/>
                </a:cubicBezTo>
                <a:cubicBezTo>
                  <a:pt x="3810" y="625"/>
                  <a:pt x="3794" y="628"/>
                  <a:pt x="3779" y="636"/>
                </a:cubicBezTo>
                <a:cubicBezTo>
                  <a:pt x="3769" y="642"/>
                  <a:pt x="3755" y="655"/>
                  <a:pt x="3734" y="675"/>
                </a:cubicBezTo>
                <a:lnTo>
                  <a:pt x="3648" y="761"/>
                </a:lnTo>
                <a:lnTo>
                  <a:pt x="3769" y="881"/>
                </a:lnTo>
                <a:close/>
                <a:moveTo>
                  <a:pt x="4088" y="698"/>
                </a:moveTo>
                <a:lnTo>
                  <a:pt x="4127" y="652"/>
                </a:lnTo>
                <a:cubicBezTo>
                  <a:pt x="4145" y="667"/>
                  <a:pt x="4164" y="676"/>
                  <a:pt x="4182" y="680"/>
                </a:cubicBezTo>
                <a:cubicBezTo>
                  <a:pt x="4200" y="683"/>
                  <a:pt x="4220" y="681"/>
                  <a:pt x="4242" y="672"/>
                </a:cubicBezTo>
                <a:cubicBezTo>
                  <a:pt x="4264" y="663"/>
                  <a:pt x="4284" y="650"/>
                  <a:pt x="4303" y="630"/>
                </a:cubicBezTo>
                <a:cubicBezTo>
                  <a:pt x="4320" y="613"/>
                  <a:pt x="4333" y="596"/>
                  <a:pt x="4341" y="578"/>
                </a:cubicBezTo>
                <a:cubicBezTo>
                  <a:pt x="4349" y="560"/>
                  <a:pt x="4351" y="543"/>
                  <a:pt x="4349" y="528"/>
                </a:cubicBezTo>
                <a:cubicBezTo>
                  <a:pt x="4347" y="513"/>
                  <a:pt x="4340" y="500"/>
                  <a:pt x="4330" y="490"/>
                </a:cubicBezTo>
                <a:cubicBezTo>
                  <a:pt x="4319" y="479"/>
                  <a:pt x="4307" y="473"/>
                  <a:pt x="4293" y="471"/>
                </a:cubicBezTo>
                <a:cubicBezTo>
                  <a:pt x="4279" y="470"/>
                  <a:pt x="4262" y="473"/>
                  <a:pt x="4243" y="482"/>
                </a:cubicBezTo>
                <a:cubicBezTo>
                  <a:pt x="4230" y="487"/>
                  <a:pt x="4205" y="502"/>
                  <a:pt x="4167" y="525"/>
                </a:cubicBezTo>
                <a:cubicBezTo>
                  <a:pt x="4128" y="549"/>
                  <a:pt x="4100" y="563"/>
                  <a:pt x="4081" y="569"/>
                </a:cubicBezTo>
                <a:cubicBezTo>
                  <a:pt x="4056" y="577"/>
                  <a:pt x="4034" y="578"/>
                  <a:pt x="4014" y="574"/>
                </a:cubicBezTo>
                <a:cubicBezTo>
                  <a:pt x="3993" y="569"/>
                  <a:pt x="3975" y="559"/>
                  <a:pt x="3960" y="544"/>
                </a:cubicBezTo>
                <a:cubicBezTo>
                  <a:pt x="3943" y="527"/>
                  <a:pt x="3932" y="506"/>
                  <a:pt x="3927" y="482"/>
                </a:cubicBezTo>
                <a:cubicBezTo>
                  <a:pt x="3922" y="457"/>
                  <a:pt x="3925" y="432"/>
                  <a:pt x="3935" y="406"/>
                </a:cubicBezTo>
                <a:cubicBezTo>
                  <a:pt x="3946" y="380"/>
                  <a:pt x="3963" y="356"/>
                  <a:pt x="3986" y="333"/>
                </a:cubicBezTo>
                <a:cubicBezTo>
                  <a:pt x="4011" y="308"/>
                  <a:pt x="4037" y="290"/>
                  <a:pt x="4064" y="279"/>
                </a:cubicBezTo>
                <a:cubicBezTo>
                  <a:pt x="4091" y="268"/>
                  <a:pt x="4117" y="265"/>
                  <a:pt x="4143" y="271"/>
                </a:cubicBezTo>
                <a:cubicBezTo>
                  <a:pt x="4169" y="276"/>
                  <a:pt x="4192" y="288"/>
                  <a:pt x="4212" y="307"/>
                </a:cubicBezTo>
                <a:lnTo>
                  <a:pt x="4173" y="353"/>
                </a:lnTo>
                <a:cubicBezTo>
                  <a:pt x="4149" y="334"/>
                  <a:pt x="4126" y="326"/>
                  <a:pt x="4102" y="328"/>
                </a:cubicBezTo>
                <a:cubicBezTo>
                  <a:pt x="4077" y="330"/>
                  <a:pt x="4053" y="344"/>
                  <a:pt x="4027" y="370"/>
                </a:cubicBezTo>
                <a:cubicBezTo>
                  <a:pt x="4000" y="397"/>
                  <a:pt x="3985" y="422"/>
                  <a:pt x="3983" y="444"/>
                </a:cubicBezTo>
                <a:cubicBezTo>
                  <a:pt x="3980" y="466"/>
                  <a:pt x="3986" y="484"/>
                  <a:pt x="4000" y="498"/>
                </a:cubicBezTo>
                <a:cubicBezTo>
                  <a:pt x="4012" y="510"/>
                  <a:pt x="4026" y="516"/>
                  <a:pt x="4043" y="515"/>
                </a:cubicBezTo>
                <a:cubicBezTo>
                  <a:pt x="4059" y="514"/>
                  <a:pt x="4089" y="500"/>
                  <a:pt x="4134" y="472"/>
                </a:cubicBezTo>
                <a:cubicBezTo>
                  <a:pt x="4178" y="444"/>
                  <a:pt x="4210" y="426"/>
                  <a:pt x="4230" y="419"/>
                </a:cubicBezTo>
                <a:cubicBezTo>
                  <a:pt x="4258" y="408"/>
                  <a:pt x="4284" y="405"/>
                  <a:pt x="4307" y="410"/>
                </a:cubicBezTo>
                <a:cubicBezTo>
                  <a:pt x="4330" y="414"/>
                  <a:pt x="4351" y="425"/>
                  <a:pt x="4369" y="443"/>
                </a:cubicBezTo>
                <a:cubicBezTo>
                  <a:pt x="4387" y="461"/>
                  <a:pt x="4399" y="483"/>
                  <a:pt x="4404" y="509"/>
                </a:cubicBezTo>
                <a:cubicBezTo>
                  <a:pt x="4410" y="535"/>
                  <a:pt x="4407" y="562"/>
                  <a:pt x="4397" y="590"/>
                </a:cubicBezTo>
                <a:cubicBezTo>
                  <a:pt x="4387" y="618"/>
                  <a:pt x="4369" y="644"/>
                  <a:pt x="4345" y="668"/>
                </a:cubicBezTo>
                <a:cubicBezTo>
                  <a:pt x="4315" y="699"/>
                  <a:pt x="4285" y="720"/>
                  <a:pt x="4256" y="731"/>
                </a:cubicBezTo>
                <a:cubicBezTo>
                  <a:pt x="4226" y="743"/>
                  <a:pt x="4197" y="746"/>
                  <a:pt x="4167" y="740"/>
                </a:cubicBezTo>
                <a:cubicBezTo>
                  <a:pt x="4138" y="734"/>
                  <a:pt x="4111" y="720"/>
                  <a:pt x="4088" y="698"/>
                </a:cubicBezTo>
                <a:close/>
                <a:moveTo>
                  <a:pt x="4423" y="402"/>
                </a:moveTo>
                <a:lnTo>
                  <a:pt x="4459" y="355"/>
                </a:lnTo>
                <a:cubicBezTo>
                  <a:pt x="4487" y="374"/>
                  <a:pt x="4512" y="382"/>
                  <a:pt x="4534" y="381"/>
                </a:cubicBezTo>
                <a:cubicBezTo>
                  <a:pt x="4555" y="380"/>
                  <a:pt x="4574" y="372"/>
                  <a:pt x="4591" y="355"/>
                </a:cubicBezTo>
                <a:cubicBezTo>
                  <a:pt x="4610" y="336"/>
                  <a:pt x="4620" y="313"/>
                  <a:pt x="4620" y="286"/>
                </a:cubicBezTo>
                <a:cubicBezTo>
                  <a:pt x="4620" y="259"/>
                  <a:pt x="4610" y="236"/>
                  <a:pt x="4590" y="216"/>
                </a:cubicBezTo>
                <a:cubicBezTo>
                  <a:pt x="4571" y="197"/>
                  <a:pt x="4549" y="187"/>
                  <a:pt x="4524" y="187"/>
                </a:cubicBezTo>
                <a:cubicBezTo>
                  <a:pt x="4500" y="188"/>
                  <a:pt x="4478" y="197"/>
                  <a:pt x="4459" y="216"/>
                </a:cubicBezTo>
                <a:cubicBezTo>
                  <a:pt x="4451" y="224"/>
                  <a:pt x="4443" y="235"/>
                  <a:pt x="4434" y="250"/>
                </a:cubicBezTo>
                <a:lnTo>
                  <a:pt x="4402" y="209"/>
                </a:lnTo>
                <a:cubicBezTo>
                  <a:pt x="4405" y="207"/>
                  <a:pt x="4408" y="205"/>
                  <a:pt x="4409" y="203"/>
                </a:cubicBezTo>
                <a:cubicBezTo>
                  <a:pt x="4427" y="185"/>
                  <a:pt x="4438" y="165"/>
                  <a:pt x="4443" y="142"/>
                </a:cubicBezTo>
                <a:cubicBezTo>
                  <a:pt x="4448" y="119"/>
                  <a:pt x="4441" y="97"/>
                  <a:pt x="4422" y="78"/>
                </a:cubicBezTo>
                <a:cubicBezTo>
                  <a:pt x="4407" y="63"/>
                  <a:pt x="4389" y="56"/>
                  <a:pt x="4369" y="56"/>
                </a:cubicBezTo>
                <a:cubicBezTo>
                  <a:pt x="4349" y="56"/>
                  <a:pt x="4331" y="65"/>
                  <a:pt x="4314" y="81"/>
                </a:cubicBezTo>
                <a:cubicBezTo>
                  <a:pt x="4298" y="97"/>
                  <a:pt x="4290" y="115"/>
                  <a:pt x="4289" y="136"/>
                </a:cubicBezTo>
                <a:cubicBezTo>
                  <a:pt x="4289" y="157"/>
                  <a:pt x="4297" y="179"/>
                  <a:pt x="4314" y="202"/>
                </a:cubicBezTo>
                <a:lnTo>
                  <a:pt x="4266" y="236"/>
                </a:lnTo>
                <a:cubicBezTo>
                  <a:pt x="4243" y="203"/>
                  <a:pt x="4233" y="170"/>
                  <a:pt x="4236" y="137"/>
                </a:cubicBezTo>
                <a:cubicBezTo>
                  <a:pt x="4238" y="104"/>
                  <a:pt x="4253" y="74"/>
                  <a:pt x="4279" y="48"/>
                </a:cubicBezTo>
                <a:cubicBezTo>
                  <a:pt x="4298" y="29"/>
                  <a:pt x="4319" y="16"/>
                  <a:pt x="4342" y="9"/>
                </a:cubicBezTo>
                <a:cubicBezTo>
                  <a:pt x="4365" y="1"/>
                  <a:pt x="4388" y="0"/>
                  <a:pt x="4410" y="6"/>
                </a:cubicBezTo>
                <a:cubicBezTo>
                  <a:pt x="4431" y="11"/>
                  <a:pt x="4450" y="21"/>
                  <a:pt x="4465" y="37"/>
                </a:cubicBezTo>
                <a:cubicBezTo>
                  <a:pt x="4480" y="51"/>
                  <a:pt x="4489" y="68"/>
                  <a:pt x="4493" y="88"/>
                </a:cubicBezTo>
                <a:cubicBezTo>
                  <a:pt x="4497" y="108"/>
                  <a:pt x="4495" y="129"/>
                  <a:pt x="4487" y="151"/>
                </a:cubicBezTo>
                <a:cubicBezTo>
                  <a:pt x="4511" y="136"/>
                  <a:pt x="4536" y="130"/>
                  <a:pt x="4562" y="133"/>
                </a:cubicBezTo>
                <a:cubicBezTo>
                  <a:pt x="4587" y="137"/>
                  <a:pt x="4611" y="149"/>
                  <a:pt x="4633" y="171"/>
                </a:cubicBezTo>
                <a:cubicBezTo>
                  <a:pt x="4662" y="200"/>
                  <a:pt x="4676" y="236"/>
                  <a:pt x="4675" y="278"/>
                </a:cubicBezTo>
                <a:cubicBezTo>
                  <a:pt x="4674" y="320"/>
                  <a:pt x="4657" y="357"/>
                  <a:pt x="4625" y="390"/>
                </a:cubicBezTo>
                <a:cubicBezTo>
                  <a:pt x="4595" y="419"/>
                  <a:pt x="4562" y="435"/>
                  <a:pt x="4525" y="437"/>
                </a:cubicBezTo>
                <a:cubicBezTo>
                  <a:pt x="4488" y="439"/>
                  <a:pt x="4454" y="427"/>
                  <a:pt x="4423" y="402"/>
                </a:cubicBez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92" name="Freeform 74"/>
          <p:cNvSpPr>
            <a:spLocks noEditPoints="1"/>
          </p:cNvSpPr>
          <p:nvPr/>
        </p:nvSpPr>
        <p:spPr bwMode="auto">
          <a:xfrm>
            <a:off x="4438828" y="4609887"/>
            <a:ext cx="892175" cy="892175"/>
          </a:xfrm>
          <a:custGeom>
            <a:avLst/>
            <a:gdLst>
              <a:gd name="T0" fmla="*/ 238 w 4684"/>
              <a:gd name="T1" fmla="*/ 4148 h 4685"/>
              <a:gd name="T2" fmla="*/ 244 w 4684"/>
              <a:gd name="T3" fmla="*/ 4504 h 4685"/>
              <a:gd name="T4" fmla="*/ 336 w 4684"/>
              <a:gd name="T5" fmla="*/ 4300 h 4685"/>
              <a:gd name="T6" fmla="*/ 84 w 4684"/>
              <a:gd name="T7" fmla="*/ 4344 h 4685"/>
              <a:gd name="T8" fmla="*/ 513 w 4684"/>
              <a:gd name="T9" fmla="*/ 3856 h 4685"/>
              <a:gd name="T10" fmla="*/ 740 w 4684"/>
              <a:gd name="T11" fmla="*/ 3984 h 4685"/>
              <a:gd name="T12" fmla="*/ 779 w 4684"/>
              <a:gd name="T13" fmla="*/ 4242 h 4685"/>
              <a:gd name="T14" fmla="*/ 621 w 4684"/>
              <a:gd name="T15" fmla="*/ 3969 h 4685"/>
              <a:gd name="T16" fmla="*/ 399 w 4684"/>
              <a:gd name="T17" fmla="*/ 4029 h 4685"/>
              <a:gd name="T18" fmla="*/ 785 w 4684"/>
              <a:gd name="T19" fmla="*/ 4135 h 4685"/>
              <a:gd name="T20" fmla="*/ 618 w 4684"/>
              <a:gd name="T21" fmla="*/ 4092 h 4685"/>
              <a:gd name="T22" fmla="*/ 744 w 4684"/>
              <a:gd name="T23" fmla="*/ 3605 h 4685"/>
              <a:gd name="T24" fmla="*/ 1131 w 4684"/>
              <a:gd name="T25" fmla="*/ 3686 h 4685"/>
              <a:gd name="T26" fmla="*/ 964 w 4684"/>
              <a:gd name="T27" fmla="*/ 4057 h 4685"/>
              <a:gd name="T28" fmla="*/ 1081 w 4684"/>
              <a:gd name="T29" fmla="*/ 3728 h 4685"/>
              <a:gd name="T30" fmla="*/ 712 w 4684"/>
              <a:gd name="T31" fmla="*/ 3716 h 4685"/>
              <a:gd name="T32" fmla="*/ 1627 w 4684"/>
              <a:gd name="T33" fmla="*/ 3580 h 4685"/>
              <a:gd name="T34" fmla="*/ 1414 w 4684"/>
              <a:gd name="T35" fmla="*/ 2941 h 4685"/>
              <a:gd name="T36" fmla="*/ 1563 w 4684"/>
              <a:gd name="T37" fmla="*/ 3184 h 4685"/>
              <a:gd name="T38" fmla="*/ 1524 w 4684"/>
              <a:gd name="T39" fmla="*/ 3144 h 4685"/>
              <a:gd name="T40" fmla="*/ 1403 w 4684"/>
              <a:gd name="T41" fmla="*/ 3025 h 4685"/>
              <a:gd name="T42" fmla="*/ 1788 w 4684"/>
              <a:gd name="T43" fmla="*/ 2560 h 4685"/>
              <a:gd name="T44" fmla="*/ 1958 w 4684"/>
              <a:gd name="T45" fmla="*/ 2755 h 4685"/>
              <a:gd name="T46" fmla="*/ 1881 w 4684"/>
              <a:gd name="T47" fmla="*/ 3139 h 4685"/>
              <a:gd name="T48" fmla="*/ 2042 w 4684"/>
              <a:gd name="T49" fmla="*/ 2479 h 4685"/>
              <a:gd name="T50" fmla="*/ 2166 w 4684"/>
              <a:gd name="T51" fmla="*/ 2499 h 4685"/>
              <a:gd name="T52" fmla="*/ 2184 w 4684"/>
              <a:gd name="T53" fmla="*/ 2603 h 4685"/>
              <a:gd name="T54" fmla="*/ 2343 w 4684"/>
              <a:gd name="T55" fmla="*/ 2152 h 4685"/>
              <a:gd name="T56" fmla="*/ 2283 w 4684"/>
              <a:gd name="T57" fmla="*/ 2063 h 4685"/>
              <a:gd name="T58" fmla="*/ 2562 w 4684"/>
              <a:gd name="T59" fmla="*/ 1971 h 4685"/>
              <a:gd name="T60" fmla="*/ 2742 w 4684"/>
              <a:gd name="T61" fmla="*/ 1866 h 4685"/>
              <a:gd name="T62" fmla="*/ 3058 w 4684"/>
              <a:gd name="T63" fmla="*/ 1963 h 4685"/>
              <a:gd name="T64" fmla="*/ 2776 w 4684"/>
              <a:gd name="T65" fmla="*/ 1853 h 4685"/>
              <a:gd name="T66" fmla="*/ 2704 w 4684"/>
              <a:gd name="T67" fmla="*/ 1918 h 4685"/>
              <a:gd name="T68" fmla="*/ 2810 w 4684"/>
              <a:gd name="T69" fmla="*/ 2211 h 4685"/>
              <a:gd name="T70" fmla="*/ 3218 w 4684"/>
              <a:gd name="T71" fmla="*/ 1746 h 4685"/>
              <a:gd name="T72" fmla="*/ 3062 w 4684"/>
              <a:gd name="T73" fmla="*/ 1712 h 4685"/>
              <a:gd name="T74" fmla="*/ 2959 w 4684"/>
              <a:gd name="T75" fmla="*/ 1573 h 4685"/>
              <a:gd name="T76" fmla="*/ 3120 w 4684"/>
              <a:gd name="T77" fmla="*/ 1550 h 4685"/>
              <a:gd name="T78" fmla="*/ 3025 w 4684"/>
              <a:gd name="T79" fmla="*/ 1657 h 4685"/>
              <a:gd name="T80" fmla="*/ 3273 w 4684"/>
              <a:gd name="T81" fmla="*/ 1604 h 4685"/>
              <a:gd name="T82" fmla="*/ 3070 w 4684"/>
              <a:gd name="T83" fmla="*/ 1805 h 4685"/>
              <a:gd name="T84" fmla="*/ 3204 w 4684"/>
              <a:gd name="T85" fmla="*/ 1391 h 4685"/>
              <a:gd name="T86" fmla="*/ 3541 w 4684"/>
              <a:gd name="T87" fmla="*/ 1480 h 4685"/>
              <a:gd name="T88" fmla="*/ 3499 w 4684"/>
              <a:gd name="T89" fmla="*/ 945 h 4685"/>
              <a:gd name="T90" fmla="*/ 3787 w 4684"/>
              <a:gd name="T91" fmla="*/ 1233 h 4685"/>
              <a:gd name="T92" fmla="*/ 3802 w 4684"/>
              <a:gd name="T93" fmla="*/ 584 h 4685"/>
              <a:gd name="T94" fmla="*/ 3808 w 4684"/>
              <a:gd name="T95" fmla="*/ 940 h 4685"/>
              <a:gd name="T96" fmla="*/ 3900 w 4684"/>
              <a:gd name="T97" fmla="*/ 736 h 4685"/>
              <a:gd name="T98" fmla="*/ 3648 w 4684"/>
              <a:gd name="T99" fmla="*/ 780 h 4685"/>
              <a:gd name="T100" fmla="*/ 4241 w 4684"/>
              <a:gd name="T101" fmla="*/ 691 h 4685"/>
              <a:gd name="T102" fmla="*/ 4292 w 4684"/>
              <a:gd name="T103" fmla="*/ 490 h 4685"/>
              <a:gd name="T104" fmla="*/ 3959 w 4684"/>
              <a:gd name="T105" fmla="*/ 563 h 4685"/>
              <a:gd name="T106" fmla="*/ 4142 w 4684"/>
              <a:gd name="T107" fmla="*/ 290 h 4685"/>
              <a:gd name="T108" fmla="*/ 3982 w 4684"/>
              <a:gd name="T109" fmla="*/ 463 h 4685"/>
              <a:gd name="T110" fmla="*/ 4307 w 4684"/>
              <a:gd name="T111" fmla="*/ 429 h 4685"/>
              <a:gd name="T112" fmla="*/ 4255 w 4684"/>
              <a:gd name="T113" fmla="*/ 750 h 4685"/>
              <a:gd name="T114" fmla="*/ 4417 w 4684"/>
              <a:gd name="T115" fmla="*/ 443 h 4685"/>
              <a:gd name="T116" fmla="*/ 4612 w 4684"/>
              <a:gd name="T117" fmla="*/ 172 h 4685"/>
              <a:gd name="T118" fmla="*/ 4525 w 4684"/>
              <a:gd name="T119" fmla="*/ 259 h 468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</a:cxnLst>
            <a:rect l="0" t="0" r="r" b="b"/>
            <a:pathLst>
              <a:path w="4684" h="4685">
                <a:moveTo>
                  <a:pt x="336" y="4685"/>
                </a:moveTo>
                <a:lnTo>
                  <a:pt x="0" y="4349"/>
                </a:lnTo>
                <a:lnTo>
                  <a:pt x="127" y="4222"/>
                </a:lnTo>
                <a:cubicBezTo>
                  <a:pt x="149" y="4199"/>
                  <a:pt x="167" y="4184"/>
                  <a:pt x="181" y="4174"/>
                </a:cubicBezTo>
                <a:cubicBezTo>
                  <a:pt x="200" y="4160"/>
                  <a:pt x="219" y="4152"/>
                  <a:pt x="238" y="4148"/>
                </a:cubicBezTo>
                <a:cubicBezTo>
                  <a:pt x="257" y="4145"/>
                  <a:pt x="277" y="4146"/>
                  <a:pt x="298" y="4154"/>
                </a:cubicBezTo>
                <a:cubicBezTo>
                  <a:pt x="318" y="4161"/>
                  <a:pt x="337" y="4173"/>
                  <a:pt x="354" y="4189"/>
                </a:cubicBezTo>
                <a:cubicBezTo>
                  <a:pt x="382" y="4218"/>
                  <a:pt x="397" y="4251"/>
                  <a:pt x="399" y="4289"/>
                </a:cubicBezTo>
                <a:cubicBezTo>
                  <a:pt x="400" y="4327"/>
                  <a:pt x="378" y="4370"/>
                  <a:pt x="330" y="4417"/>
                </a:cubicBezTo>
                <a:lnTo>
                  <a:pt x="244" y="4504"/>
                </a:lnTo>
                <a:lnTo>
                  <a:pt x="380" y="4640"/>
                </a:lnTo>
                <a:lnTo>
                  <a:pt x="336" y="4685"/>
                </a:lnTo>
                <a:close/>
                <a:moveTo>
                  <a:pt x="204" y="4464"/>
                </a:moveTo>
                <a:lnTo>
                  <a:pt x="291" y="4377"/>
                </a:lnTo>
                <a:cubicBezTo>
                  <a:pt x="320" y="4348"/>
                  <a:pt x="335" y="4323"/>
                  <a:pt x="336" y="4300"/>
                </a:cubicBezTo>
                <a:cubicBezTo>
                  <a:pt x="338" y="4277"/>
                  <a:pt x="329" y="4256"/>
                  <a:pt x="309" y="4236"/>
                </a:cubicBezTo>
                <a:cubicBezTo>
                  <a:pt x="295" y="4222"/>
                  <a:pt x="279" y="4214"/>
                  <a:pt x="262" y="4211"/>
                </a:cubicBezTo>
                <a:cubicBezTo>
                  <a:pt x="245" y="4208"/>
                  <a:pt x="229" y="4211"/>
                  <a:pt x="214" y="4219"/>
                </a:cubicBezTo>
                <a:cubicBezTo>
                  <a:pt x="205" y="4225"/>
                  <a:pt x="190" y="4238"/>
                  <a:pt x="170" y="4258"/>
                </a:cubicBezTo>
                <a:lnTo>
                  <a:pt x="84" y="4344"/>
                </a:lnTo>
                <a:lnTo>
                  <a:pt x="204" y="4464"/>
                </a:lnTo>
                <a:close/>
                <a:moveTo>
                  <a:pt x="651" y="4370"/>
                </a:moveTo>
                <a:lnTo>
                  <a:pt x="315" y="4034"/>
                </a:lnTo>
                <a:lnTo>
                  <a:pt x="441" y="3908"/>
                </a:lnTo>
                <a:cubicBezTo>
                  <a:pt x="467" y="3882"/>
                  <a:pt x="491" y="3865"/>
                  <a:pt x="513" y="3856"/>
                </a:cubicBezTo>
                <a:cubicBezTo>
                  <a:pt x="535" y="3847"/>
                  <a:pt x="558" y="3846"/>
                  <a:pt x="581" y="3851"/>
                </a:cubicBezTo>
                <a:cubicBezTo>
                  <a:pt x="604" y="3856"/>
                  <a:pt x="623" y="3867"/>
                  <a:pt x="638" y="3882"/>
                </a:cubicBezTo>
                <a:cubicBezTo>
                  <a:pt x="653" y="3896"/>
                  <a:pt x="662" y="3914"/>
                  <a:pt x="667" y="3934"/>
                </a:cubicBezTo>
                <a:cubicBezTo>
                  <a:pt x="672" y="3955"/>
                  <a:pt x="671" y="3977"/>
                  <a:pt x="663" y="4000"/>
                </a:cubicBezTo>
                <a:cubicBezTo>
                  <a:pt x="689" y="3986"/>
                  <a:pt x="715" y="3981"/>
                  <a:pt x="740" y="3984"/>
                </a:cubicBezTo>
                <a:cubicBezTo>
                  <a:pt x="765" y="3987"/>
                  <a:pt x="788" y="3999"/>
                  <a:pt x="807" y="4018"/>
                </a:cubicBezTo>
                <a:cubicBezTo>
                  <a:pt x="823" y="4034"/>
                  <a:pt x="834" y="4052"/>
                  <a:pt x="841" y="4072"/>
                </a:cubicBezTo>
                <a:cubicBezTo>
                  <a:pt x="848" y="4093"/>
                  <a:pt x="850" y="4111"/>
                  <a:pt x="848" y="4128"/>
                </a:cubicBezTo>
                <a:cubicBezTo>
                  <a:pt x="845" y="4145"/>
                  <a:pt x="839" y="4163"/>
                  <a:pt x="828" y="4182"/>
                </a:cubicBezTo>
                <a:cubicBezTo>
                  <a:pt x="817" y="4200"/>
                  <a:pt x="800" y="4220"/>
                  <a:pt x="779" y="4242"/>
                </a:cubicBezTo>
                <a:lnTo>
                  <a:pt x="651" y="4370"/>
                </a:lnTo>
                <a:close/>
                <a:moveTo>
                  <a:pt x="500" y="4130"/>
                </a:moveTo>
                <a:lnTo>
                  <a:pt x="573" y="4058"/>
                </a:lnTo>
                <a:cubicBezTo>
                  <a:pt x="593" y="4038"/>
                  <a:pt x="606" y="4023"/>
                  <a:pt x="612" y="4011"/>
                </a:cubicBezTo>
                <a:cubicBezTo>
                  <a:pt x="620" y="3997"/>
                  <a:pt x="623" y="3983"/>
                  <a:pt x="621" y="3969"/>
                </a:cubicBezTo>
                <a:cubicBezTo>
                  <a:pt x="618" y="3956"/>
                  <a:pt x="612" y="3943"/>
                  <a:pt x="600" y="3931"/>
                </a:cubicBezTo>
                <a:cubicBezTo>
                  <a:pt x="589" y="3920"/>
                  <a:pt x="576" y="3913"/>
                  <a:pt x="562" y="3910"/>
                </a:cubicBezTo>
                <a:cubicBezTo>
                  <a:pt x="548" y="3907"/>
                  <a:pt x="535" y="3908"/>
                  <a:pt x="522" y="3915"/>
                </a:cubicBezTo>
                <a:cubicBezTo>
                  <a:pt x="509" y="3922"/>
                  <a:pt x="490" y="3937"/>
                  <a:pt x="466" y="3962"/>
                </a:cubicBezTo>
                <a:lnTo>
                  <a:pt x="399" y="4029"/>
                </a:lnTo>
                <a:lnTo>
                  <a:pt x="500" y="4130"/>
                </a:lnTo>
                <a:close/>
                <a:moveTo>
                  <a:pt x="656" y="4286"/>
                </a:moveTo>
                <a:lnTo>
                  <a:pt x="739" y="4202"/>
                </a:lnTo>
                <a:cubicBezTo>
                  <a:pt x="754" y="4188"/>
                  <a:pt x="763" y="4177"/>
                  <a:pt x="768" y="4170"/>
                </a:cubicBezTo>
                <a:cubicBezTo>
                  <a:pt x="776" y="4158"/>
                  <a:pt x="782" y="4146"/>
                  <a:pt x="785" y="4135"/>
                </a:cubicBezTo>
                <a:cubicBezTo>
                  <a:pt x="787" y="4124"/>
                  <a:pt x="787" y="4112"/>
                  <a:pt x="783" y="4100"/>
                </a:cubicBezTo>
                <a:cubicBezTo>
                  <a:pt x="779" y="4087"/>
                  <a:pt x="772" y="4075"/>
                  <a:pt x="761" y="4065"/>
                </a:cubicBezTo>
                <a:cubicBezTo>
                  <a:pt x="749" y="4052"/>
                  <a:pt x="735" y="4044"/>
                  <a:pt x="719" y="4042"/>
                </a:cubicBezTo>
                <a:cubicBezTo>
                  <a:pt x="703" y="4039"/>
                  <a:pt x="688" y="4041"/>
                  <a:pt x="673" y="4049"/>
                </a:cubicBezTo>
                <a:cubicBezTo>
                  <a:pt x="658" y="4056"/>
                  <a:pt x="639" y="4071"/>
                  <a:pt x="618" y="4092"/>
                </a:cubicBezTo>
                <a:lnTo>
                  <a:pt x="540" y="4170"/>
                </a:lnTo>
                <a:lnTo>
                  <a:pt x="656" y="4286"/>
                </a:lnTo>
                <a:close/>
                <a:moveTo>
                  <a:pt x="964" y="4057"/>
                </a:moveTo>
                <a:lnTo>
                  <a:pt x="628" y="3721"/>
                </a:lnTo>
                <a:lnTo>
                  <a:pt x="744" y="3605"/>
                </a:lnTo>
                <a:cubicBezTo>
                  <a:pt x="770" y="3579"/>
                  <a:pt x="791" y="3560"/>
                  <a:pt x="808" y="3550"/>
                </a:cubicBezTo>
                <a:cubicBezTo>
                  <a:pt x="832" y="3535"/>
                  <a:pt x="856" y="3527"/>
                  <a:pt x="882" y="3525"/>
                </a:cubicBezTo>
                <a:cubicBezTo>
                  <a:pt x="914" y="3522"/>
                  <a:pt x="947" y="3528"/>
                  <a:pt x="979" y="3542"/>
                </a:cubicBezTo>
                <a:cubicBezTo>
                  <a:pt x="1011" y="3557"/>
                  <a:pt x="1042" y="3579"/>
                  <a:pt x="1072" y="3609"/>
                </a:cubicBezTo>
                <a:cubicBezTo>
                  <a:pt x="1097" y="3635"/>
                  <a:pt x="1117" y="3660"/>
                  <a:pt x="1131" y="3686"/>
                </a:cubicBezTo>
                <a:cubicBezTo>
                  <a:pt x="1144" y="3711"/>
                  <a:pt x="1153" y="3735"/>
                  <a:pt x="1157" y="3758"/>
                </a:cubicBezTo>
                <a:cubicBezTo>
                  <a:pt x="1160" y="3780"/>
                  <a:pt x="1160" y="3800"/>
                  <a:pt x="1157" y="3819"/>
                </a:cubicBezTo>
                <a:cubicBezTo>
                  <a:pt x="1153" y="3837"/>
                  <a:pt x="1145" y="3856"/>
                  <a:pt x="1133" y="3876"/>
                </a:cubicBezTo>
                <a:cubicBezTo>
                  <a:pt x="1122" y="3895"/>
                  <a:pt x="1105" y="3915"/>
                  <a:pt x="1085" y="3935"/>
                </a:cubicBezTo>
                <a:lnTo>
                  <a:pt x="964" y="4057"/>
                </a:lnTo>
                <a:close/>
                <a:moveTo>
                  <a:pt x="969" y="3973"/>
                </a:moveTo>
                <a:lnTo>
                  <a:pt x="1040" y="3901"/>
                </a:lnTo>
                <a:cubicBezTo>
                  <a:pt x="1063" y="3879"/>
                  <a:pt x="1078" y="3859"/>
                  <a:pt x="1086" y="3843"/>
                </a:cubicBezTo>
                <a:cubicBezTo>
                  <a:pt x="1095" y="3826"/>
                  <a:pt x="1099" y="3810"/>
                  <a:pt x="1099" y="3795"/>
                </a:cubicBezTo>
                <a:cubicBezTo>
                  <a:pt x="1099" y="3774"/>
                  <a:pt x="1093" y="3751"/>
                  <a:pt x="1081" y="3728"/>
                </a:cubicBezTo>
                <a:cubicBezTo>
                  <a:pt x="1069" y="3704"/>
                  <a:pt x="1051" y="3680"/>
                  <a:pt x="1025" y="3654"/>
                </a:cubicBezTo>
                <a:cubicBezTo>
                  <a:pt x="990" y="3619"/>
                  <a:pt x="957" y="3598"/>
                  <a:pt x="927" y="3590"/>
                </a:cubicBezTo>
                <a:cubicBezTo>
                  <a:pt x="897" y="3583"/>
                  <a:pt x="870" y="3584"/>
                  <a:pt x="847" y="3595"/>
                </a:cubicBezTo>
                <a:cubicBezTo>
                  <a:pt x="830" y="3602"/>
                  <a:pt x="809" y="3619"/>
                  <a:pt x="782" y="3645"/>
                </a:cubicBezTo>
                <a:lnTo>
                  <a:pt x="712" y="3716"/>
                </a:lnTo>
                <a:lnTo>
                  <a:pt x="969" y="3973"/>
                </a:lnTo>
                <a:close/>
                <a:moveTo>
                  <a:pt x="1353" y="3854"/>
                </a:moveTo>
                <a:lnTo>
                  <a:pt x="1323" y="3824"/>
                </a:lnTo>
                <a:lnTo>
                  <a:pt x="1597" y="3551"/>
                </a:lnTo>
                <a:lnTo>
                  <a:pt x="1627" y="3580"/>
                </a:lnTo>
                <a:lnTo>
                  <a:pt x="1353" y="3854"/>
                </a:lnTo>
                <a:close/>
                <a:moveTo>
                  <a:pt x="1569" y="3451"/>
                </a:moveTo>
                <a:lnTo>
                  <a:pt x="1233" y="3115"/>
                </a:lnTo>
                <a:lnTo>
                  <a:pt x="1360" y="2989"/>
                </a:lnTo>
                <a:cubicBezTo>
                  <a:pt x="1382" y="2966"/>
                  <a:pt x="1400" y="2950"/>
                  <a:pt x="1414" y="2941"/>
                </a:cubicBezTo>
                <a:cubicBezTo>
                  <a:pt x="1433" y="2927"/>
                  <a:pt x="1452" y="2918"/>
                  <a:pt x="1471" y="2915"/>
                </a:cubicBezTo>
                <a:cubicBezTo>
                  <a:pt x="1490" y="2911"/>
                  <a:pt x="1510" y="2913"/>
                  <a:pt x="1531" y="2920"/>
                </a:cubicBezTo>
                <a:cubicBezTo>
                  <a:pt x="1551" y="2927"/>
                  <a:pt x="1570" y="2939"/>
                  <a:pt x="1587" y="2956"/>
                </a:cubicBezTo>
                <a:cubicBezTo>
                  <a:pt x="1615" y="2985"/>
                  <a:pt x="1630" y="3018"/>
                  <a:pt x="1632" y="3056"/>
                </a:cubicBezTo>
                <a:cubicBezTo>
                  <a:pt x="1634" y="3094"/>
                  <a:pt x="1611" y="3137"/>
                  <a:pt x="1563" y="3184"/>
                </a:cubicBezTo>
                <a:lnTo>
                  <a:pt x="1477" y="3270"/>
                </a:lnTo>
                <a:lnTo>
                  <a:pt x="1614" y="3407"/>
                </a:lnTo>
                <a:lnTo>
                  <a:pt x="1569" y="3451"/>
                </a:lnTo>
                <a:close/>
                <a:moveTo>
                  <a:pt x="1437" y="3231"/>
                </a:moveTo>
                <a:lnTo>
                  <a:pt x="1524" y="3144"/>
                </a:lnTo>
                <a:cubicBezTo>
                  <a:pt x="1553" y="3115"/>
                  <a:pt x="1568" y="3089"/>
                  <a:pt x="1569" y="3067"/>
                </a:cubicBezTo>
                <a:cubicBezTo>
                  <a:pt x="1571" y="3044"/>
                  <a:pt x="1562" y="3023"/>
                  <a:pt x="1542" y="3003"/>
                </a:cubicBezTo>
                <a:cubicBezTo>
                  <a:pt x="1528" y="2989"/>
                  <a:pt x="1513" y="2981"/>
                  <a:pt x="1496" y="2978"/>
                </a:cubicBezTo>
                <a:cubicBezTo>
                  <a:pt x="1478" y="2975"/>
                  <a:pt x="1462" y="2978"/>
                  <a:pt x="1448" y="2986"/>
                </a:cubicBezTo>
                <a:cubicBezTo>
                  <a:pt x="1438" y="2992"/>
                  <a:pt x="1423" y="3004"/>
                  <a:pt x="1403" y="3025"/>
                </a:cubicBezTo>
                <a:lnTo>
                  <a:pt x="1317" y="3111"/>
                </a:lnTo>
                <a:lnTo>
                  <a:pt x="1437" y="3231"/>
                </a:lnTo>
                <a:close/>
                <a:moveTo>
                  <a:pt x="1881" y="3139"/>
                </a:moveTo>
                <a:lnTo>
                  <a:pt x="1545" y="2803"/>
                </a:lnTo>
                <a:lnTo>
                  <a:pt x="1788" y="2560"/>
                </a:lnTo>
                <a:lnTo>
                  <a:pt x="1828" y="2600"/>
                </a:lnTo>
                <a:lnTo>
                  <a:pt x="1629" y="2799"/>
                </a:lnTo>
                <a:lnTo>
                  <a:pt x="1732" y="2901"/>
                </a:lnTo>
                <a:lnTo>
                  <a:pt x="1918" y="2716"/>
                </a:lnTo>
                <a:lnTo>
                  <a:pt x="1958" y="2755"/>
                </a:lnTo>
                <a:lnTo>
                  <a:pt x="1772" y="2941"/>
                </a:lnTo>
                <a:lnTo>
                  <a:pt x="1886" y="3055"/>
                </a:lnTo>
                <a:lnTo>
                  <a:pt x="2092" y="2849"/>
                </a:lnTo>
                <a:lnTo>
                  <a:pt x="2132" y="2889"/>
                </a:lnTo>
                <a:lnTo>
                  <a:pt x="1881" y="3139"/>
                </a:lnTo>
                <a:close/>
                <a:moveTo>
                  <a:pt x="2163" y="2858"/>
                </a:moveTo>
                <a:lnTo>
                  <a:pt x="2118" y="2553"/>
                </a:lnTo>
                <a:lnTo>
                  <a:pt x="1842" y="2506"/>
                </a:lnTo>
                <a:lnTo>
                  <a:pt x="1895" y="2453"/>
                </a:lnTo>
                <a:lnTo>
                  <a:pt x="2042" y="2479"/>
                </a:lnTo>
                <a:cubicBezTo>
                  <a:pt x="2073" y="2484"/>
                  <a:pt x="2096" y="2488"/>
                  <a:pt x="2111" y="2493"/>
                </a:cubicBezTo>
                <a:cubicBezTo>
                  <a:pt x="2106" y="2473"/>
                  <a:pt x="2102" y="2451"/>
                  <a:pt x="2099" y="2428"/>
                </a:cubicBezTo>
                <a:lnTo>
                  <a:pt x="2077" y="2271"/>
                </a:lnTo>
                <a:lnTo>
                  <a:pt x="2126" y="2223"/>
                </a:lnTo>
                <a:lnTo>
                  <a:pt x="2166" y="2499"/>
                </a:lnTo>
                <a:lnTo>
                  <a:pt x="2471" y="2550"/>
                </a:lnTo>
                <a:lnTo>
                  <a:pt x="2416" y="2605"/>
                </a:lnTo>
                <a:lnTo>
                  <a:pt x="2211" y="2569"/>
                </a:lnTo>
                <a:cubicBezTo>
                  <a:pt x="2200" y="2567"/>
                  <a:pt x="2187" y="2565"/>
                  <a:pt x="2174" y="2562"/>
                </a:cubicBezTo>
                <a:cubicBezTo>
                  <a:pt x="2179" y="2581"/>
                  <a:pt x="2182" y="2595"/>
                  <a:pt x="2184" y="2603"/>
                </a:cubicBezTo>
                <a:lnTo>
                  <a:pt x="2216" y="2804"/>
                </a:lnTo>
                <a:lnTo>
                  <a:pt x="2163" y="2858"/>
                </a:lnTo>
                <a:close/>
                <a:moveTo>
                  <a:pt x="2647" y="2374"/>
                </a:moveTo>
                <a:lnTo>
                  <a:pt x="2606" y="2415"/>
                </a:lnTo>
                <a:lnTo>
                  <a:pt x="2343" y="2152"/>
                </a:lnTo>
                <a:cubicBezTo>
                  <a:pt x="2342" y="2171"/>
                  <a:pt x="2339" y="2194"/>
                  <a:pt x="2332" y="2220"/>
                </a:cubicBezTo>
                <a:cubicBezTo>
                  <a:pt x="2325" y="2245"/>
                  <a:pt x="2318" y="2267"/>
                  <a:pt x="2310" y="2284"/>
                </a:cubicBezTo>
                <a:lnTo>
                  <a:pt x="2270" y="2244"/>
                </a:lnTo>
                <a:cubicBezTo>
                  <a:pt x="2282" y="2210"/>
                  <a:pt x="2289" y="2177"/>
                  <a:pt x="2291" y="2144"/>
                </a:cubicBezTo>
                <a:cubicBezTo>
                  <a:pt x="2293" y="2112"/>
                  <a:pt x="2290" y="2085"/>
                  <a:pt x="2283" y="2063"/>
                </a:cubicBezTo>
                <a:lnTo>
                  <a:pt x="2309" y="2036"/>
                </a:lnTo>
                <a:lnTo>
                  <a:pt x="2647" y="2374"/>
                </a:lnTo>
                <a:close/>
                <a:moveTo>
                  <a:pt x="2769" y="2252"/>
                </a:moveTo>
                <a:lnTo>
                  <a:pt x="2525" y="2008"/>
                </a:lnTo>
                <a:lnTo>
                  <a:pt x="2562" y="1971"/>
                </a:lnTo>
                <a:lnTo>
                  <a:pt x="2596" y="2006"/>
                </a:lnTo>
                <a:cubicBezTo>
                  <a:pt x="2592" y="1986"/>
                  <a:pt x="2593" y="1966"/>
                  <a:pt x="2598" y="1946"/>
                </a:cubicBezTo>
                <a:cubicBezTo>
                  <a:pt x="2604" y="1926"/>
                  <a:pt x="2614" y="1908"/>
                  <a:pt x="2631" y="1892"/>
                </a:cubicBezTo>
                <a:cubicBezTo>
                  <a:pt x="2649" y="1874"/>
                  <a:pt x="2667" y="1863"/>
                  <a:pt x="2686" y="1859"/>
                </a:cubicBezTo>
                <a:cubicBezTo>
                  <a:pt x="2705" y="1855"/>
                  <a:pt x="2724" y="1857"/>
                  <a:pt x="2742" y="1866"/>
                </a:cubicBezTo>
                <a:cubicBezTo>
                  <a:pt x="2733" y="1818"/>
                  <a:pt x="2744" y="1779"/>
                  <a:pt x="2774" y="1748"/>
                </a:cubicBezTo>
                <a:cubicBezTo>
                  <a:pt x="2799" y="1724"/>
                  <a:pt x="2824" y="1712"/>
                  <a:pt x="2850" y="1712"/>
                </a:cubicBezTo>
                <a:cubicBezTo>
                  <a:pt x="2877" y="1713"/>
                  <a:pt x="2904" y="1727"/>
                  <a:pt x="2932" y="1755"/>
                </a:cubicBezTo>
                <a:lnTo>
                  <a:pt x="3099" y="1922"/>
                </a:lnTo>
                <a:lnTo>
                  <a:pt x="3058" y="1963"/>
                </a:lnTo>
                <a:lnTo>
                  <a:pt x="2904" y="1810"/>
                </a:lnTo>
                <a:cubicBezTo>
                  <a:pt x="2888" y="1793"/>
                  <a:pt x="2875" y="1783"/>
                  <a:pt x="2865" y="1778"/>
                </a:cubicBezTo>
                <a:cubicBezTo>
                  <a:pt x="2855" y="1773"/>
                  <a:pt x="2844" y="1772"/>
                  <a:pt x="2832" y="1775"/>
                </a:cubicBezTo>
                <a:cubicBezTo>
                  <a:pt x="2821" y="1778"/>
                  <a:pt x="2811" y="1784"/>
                  <a:pt x="2801" y="1793"/>
                </a:cubicBezTo>
                <a:cubicBezTo>
                  <a:pt x="2784" y="1810"/>
                  <a:pt x="2775" y="1830"/>
                  <a:pt x="2776" y="1853"/>
                </a:cubicBezTo>
                <a:cubicBezTo>
                  <a:pt x="2776" y="1875"/>
                  <a:pt x="2788" y="1899"/>
                  <a:pt x="2813" y="1924"/>
                </a:cubicBezTo>
                <a:lnTo>
                  <a:pt x="2955" y="2066"/>
                </a:lnTo>
                <a:lnTo>
                  <a:pt x="2913" y="2107"/>
                </a:lnTo>
                <a:lnTo>
                  <a:pt x="2755" y="1949"/>
                </a:lnTo>
                <a:cubicBezTo>
                  <a:pt x="2737" y="1931"/>
                  <a:pt x="2720" y="1920"/>
                  <a:pt x="2704" y="1918"/>
                </a:cubicBezTo>
                <a:cubicBezTo>
                  <a:pt x="2688" y="1915"/>
                  <a:pt x="2672" y="1922"/>
                  <a:pt x="2657" y="1937"/>
                </a:cubicBezTo>
                <a:cubicBezTo>
                  <a:pt x="2645" y="1949"/>
                  <a:pt x="2638" y="1962"/>
                  <a:pt x="2634" y="1978"/>
                </a:cubicBezTo>
                <a:cubicBezTo>
                  <a:pt x="2630" y="1994"/>
                  <a:pt x="2632" y="2010"/>
                  <a:pt x="2639" y="2027"/>
                </a:cubicBezTo>
                <a:cubicBezTo>
                  <a:pt x="2647" y="2043"/>
                  <a:pt x="2662" y="2062"/>
                  <a:pt x="2684" y="2084"/>
                </a:cubicBezTo>
                <a:lnTo>
                  <a:pt x="2810" y="2211"/>
                </a:lnTo>
                <a:lnTo>
                  <a:pt x="2769" y="2252"/>
                </a:lnTo>
                <a:close/>
                <a:moveTo>
                  <a:pt x="3070" y="1805"/>
                </a:moveTo>
                <a:lnTo>
                  <a:pt x="3104" y="1758"/>
                </a:lnTo>
                <a:cubicBezTo>
                  <a:pt x="3123" y="1772"/>
                  <a:pt x="3142" y="1778"/>
                  <a:pt x="3161" y="1777"/>
                </a:cubicBezTo>
                <a:cubicBezTo>
                  <a:pt x="3180" y="1775"/>
                  <a:pt x="3199" y="1765"/>
                  <a:pt x="3218" y="1746"/>
                </a:cubicBezTo>
                <a:cubicBezTo>
                  <a:pt x="3237" y="1727"/>
                  <a:pt x="3247" y="1709"/>
                  <a:pt x="3249" y="1692"/>
                </a:cubicBezTo>
                <a:cubicBezTo>
                  <a:pt x="3250" y="1675"/>
                  <a:pt x="3246" y="1661"/>
                  <a:pt x="3235" y="1651"/>
                </a:cubicBezTo>
                <a:cubicBezTo>
                  <a:pt x="3226" y="1642"/>
                  <a:pt x="3214" y="1638"/>
                  <a:pt x="3201" y="1641"/>
                </a:cubicBezTo>
                <a:cubicBezTo>
                  <a:pt x="3192" y="1643"/>
                  <a:pt x="3173" y="1653"/>
                  <a:pt x="3145" y="1669"/>
                </a:cubicBezTo>
                <a:cubicBezTo>
                  <a:pt x="3107" y="1692"/>
                  <a:pt x="3079" y="1706"/>
                  <a:pt x="3062" y="1712"/>
                </a:cubicBezTo>
                <a:cubicBezTo>
                  <a:pt x="3045" y="1719"/>
                  <a:pt x="3028" y="1720"/>
                  <a:pt x="3012" y="1716"/>
                </a:cubicBezTo>
                <a:cubicBezTo>
                  <a:pt x="2996" y="1712"/>
                  <a:pt x="2983" y="1704"/>
                  <a:pt x="2971" y="1692"/>
                </a:cubicBezTo>
                <a:cubicBezTo>
                  <a:pt x="2960" y="1681"/>
                  <a:pt x="2952" y="1669"/>
                  <a:pt x="2948" y="1655"/>
                </a:cubicBezTo>
                <a:cubicBezTo>
                  <a:pt x="2944" y="1640"/>
                  <a:pt x="2943" y="1626"/>
                  <a:pt x="2945" y="1611"/>
                </a:cubicBezTo>
                <a:cubicBezTo>
                  <a:pt x="2947" y="1600"/>
                  <a:pt x="2952" y="1587"/>
                  <a:pt x="2959" y="1573"/>
                </a:cubicBezTo>
                <a:cubicBezTo>
                  <a:pt x="2967" y="1559"/>
                  <a:pt x="2977" y="1545"/>
                  <a:pt x="2990" y="1533"/>
                </a:cubicBezTo>
                <a:cubicBezTo>
                  <a:pt x="3009" y="1513"/>
                  <a:pt x="3029" y="1499"/>
                  <a:pt x="3049" y="1490"/>
                </a:cubicBezTo>
                <a:cubicBezTo>
                  <a:pt x="3069" y="1482"/>
                  <a:pt x="3087" y="1478"/>
                  <a:pt x="3103" y="1481"/>
                </a:cubicBezTo>
                <a:cubicBezTo>
                  <a:pt x="3119" y="1483"/>
                  <a:pt x="3137" y="1491"/>
                  <a:pt x="3155" y="1504"/>
                </a:cubicBezTo>
                <a:lnTo>
                  <a:pt x="3120" y="1550"/>
                </a:lnTo>
                <a:cubicBezTo>
                  <a:pt x="3106" y="1539"/>
                  <a:pt x="3091" y="1535"/>
                  <a:pt x="3075" y="1537"/>
                </a:cubicBezTo>
                <a:cubicBezTo>
                  <a:pt x="3059" y="1539"/>
                  <a:pt x="3043" y="1547"/>
                  <a:pt x="3027" y="1563"/>
                </a:cubicBezTo>
                <a:cubicBezTo>
                  <a:pt x="3008" y="1582"/>
                  <a:pt x="2998" y="1599"/>
                  <a:pt x="2996" y="1613"/>
                </a:cubicBezTo>
                <a:cubicBezTo>
                  <a:pt x="2994" y="1628"/>
                  <a:pt x="2997" y="1639"/>
                  <a:pt x="3006" y="1648"/>
                </a:cubicBezTo>
                <a:cubicBezTo>
                  <a:pt x="3011" y="1653"/>
                  <a:pt x="3018" y="1656"/>
                  <a:pt x="3025" y="1657"/>
                </a:cubicBezTo>
                <a:cubicBezTo>
                  <a:pt x="3033" y="1658"/>
                  <a:pt x="3042" y="1656"/>
                  <a:pt x="3052" y="1652"/>
                </a:cubicBezTo>
                <a:cubicBezTo>
                  <a:pt x="3058" y="1650"/>
                  <a:pt x="3073" y="1641"/>
                  <a:pt x="3099" y="1626"/>
                </a:cubicBezTo>
                <a:cubicBezTo>
                  <a:pt x="3136" y="1605"/>
                  <a:pt x="3163" y="1591"/>
                  <a:pt x="3179" y="1584"/>
                </a:cubicBezTo>
                <a:cubicBezTo>
                  <a:pt x="3196" y="1578"/>
                  <a:pt x="3212" y="1576"/>
                  <a:pt x="3228" y="1579"/>
                </a:cubicBezTo>
                <a:cubicBezTo>
                  <a:pt x="3244" y="1582"/>
                  <a:pt x="3259" y="1590"/>
                  <a:pt x="3273" y="1604"/>
                </a:cubicBezTo>
                <a:cubicBezTo>
                  <a:pt x="3287" y="1618"/>
                  <a:pt x="3296" y="1635"/>
                  <a:pt x="3300" y="1655"/>
                </a:cubicBezTo>
                <a:cubicBezTo>
                  <a:pt x="3304" y="1675"/>
                  <a:pt x="3302" y="1696"/>
                  <a:pt x="3294" y="1718"/>
                </a:cubicBezTo>
                <a:cubicBezTo>
                  <a:pt x="3285" y="1740"/>
                  <a:pt x="3271" y="1760"/>
                  <a:pt x="3252" y="1779"/>
                </a:cubicBezTo>
                <a:cubicBezTo>
                  <a:pt x="3221" y="1811"/>
                  <a:pt x="3190" y="1829"/>
                  <a:pt x="3160" y="1832"/>
                </a:cubicBezTo>
                <a:cubicBezTo>
                  <a:pt x="3130" y="1835"/>
                  <a:pt x="3100" y="1827"/>
                  <a:pt x="3070" y="1805"/>
                </a:cubicBezTo>
                <a:close/>
                <a:moveTo>
                  <a:pt x="3541" y="1480"/>
                </a:moveTo>
                <a:lnTo>
                  <a:pt x="3499" y="1521"/>
                </a:lnTo>
                <a:lnTo>
                  <a:pt x="3236" y="1258"/>
                </a:lnTo>
                <a:cubicBezTo>
                  <a:pt x="3236" y="1278"/>
                  <a:pt x="3232" y="1300"/>
                  <a:pt x="3226" y="1326"/>
                </a:cubicBezTo>
                <a:cubicBezTo>
                  <a:pt x="3219" y="1351"/>
                  <a:pt x="3212" y="1373"/>
                  <a:pt x="3204" y="1391"/>
                </a:cubicBezTo>
                <a:lnTo>
                  <a:pt x="3164" y="1351"/>
                </a:lnTo>
                <a:cubicBezTo>
                  <a:pt x="3176" y="1317"/>
                  <a:pt x="3183" y="1283"/>
                  <a:pt x="3185" y="1251"/>
                </a:cubicBezTo>
                <a:cubicBezTo>
                  <a:pt x="3187" y="1218"/>
                  <a:pt x="3184" y="1191"/>
                  <a:pt x="3177" y="1169"/>
                </a:cubicBezTo>
                <a:lnTo>
                  <a:pt x="3203" y="1142"/>
                </a:lnTo>
                <a:lnTo>
                  <a:pt x="3541" y="1480"/>
                </a:lnTo>
                <a:close/>
                <a:moveTo>
                  <a:pt x="3499" y="945"/>
                </a:moveTo>
                <a:lnTo>
                  <a:pt x="3451" y="897"/>
                </a:lnTo>
                <a:lnTo>
                  <a:pt x="3492" y="856"/>
                </a:lnTo>
                <a:lnTo>
                  <a:pt x="3540" y="903"/>
                </a:lnTo>
                <a:lnTo>
                  <a:pt x="3499" y="945"/>
                </a:lnTo>
                <a:close/>
                <a:moveTo>
                  <a:pt x="3787" y="1233"/>
                </a:moveTo>
                <a:lnTo>
                  <a:pt x="3544" y="990"/>
                </a:lnTo>
                <a:lnTo>
                  <a:pt x="3585" y="949"/>
                </a:lnTo>
                <a:lnTo>
                  <a:pt x="3828" y="1192"/>
                </a:lnTo>
                <a:lnTo>
                  <a:pt x="3787" y="1233"/>
                </a:lnTo>
                <a:close/>
                <a:moveTo>
                  <a:pt x="3900" y="1121"/>
                </a:moveTo>
                <a:lnTo>
                  <a:pt x="3564" y="785"/>
                </a:lnTo>
                <a:lnTo>
                  <a:pt x="3690" y="658"/>
                </a:lnTo>
                <a:cubicBezTo>
                  <a:pt x="3713" y="636"/>
                  <a:pt x="3731" y="620"/>
                  <a:pt x="3745" y="610"/>
                </a:cubicBezTo>
                <a:cubicBezTo>
                  <a:pt x="3764" y="596"/>
                  <a:pt x="3783" y="588"/>
                  <a:pt x="3802" y="584"/>
                </a:cubicBezTo>
                <a:cubicBezTo>
                  <a:pt x="3821" y="581"/>
                  <a:pt x="3841" y="583"/>
                  <a:pt x="3861" y="590"/>
                </a:cubicBezTo>
                <a:cubicBezTo>
                  <a:pt x="3882" y="597"/>
                  <a:pt x="3901" y="609"/>
                  <a:pt x="3917" y="625"/>
                </a:cubicBezTo>
                <a:cubicBezTo>
                  <a:pt x="3946" y="654"/>
                  <a:pt x="3961" y="687"/>
                  <a:pt x="3963" y="725"/>
                </a:cubicBezTo>
                <a:cubicBezTo>
                  <a:pt x="3964" y="763"/>
                  <a:pt x="3941" y="806"/>
                  <a:pt x="3894" y="854"/>
                </a:cubicBezTo>
                <a:lnTo>
                  <a:pt x="3808" y="940"/>
                </a:lnTo>
                <a:lnTo>
                  <a:pt x="3944" y="1076"/>
                </a:lnTo>
                <a:lnTo>
                  <a:pt x="3900" y="1121"/>
                </a:lnTo>
                <a:close/>
                <a:moveTo>
                  <a:pt x="3768" y="900"/>
                </a:moveTo>
                <a:lnTo>
                  <a:pt x="3855" y="813"/>
                </a:lnTo>
                <a:cubicBezTo>
                  <a:pt x="3884" y="784"/>
                  <a:pt x="3899" y="759"/>
                  <a:pt x="3900" y="736"/>
                </a:cubicBezTo>
                <a:cubicBezTo>
                  <a:pt x="3901" y="713"/>
                  <a:pt x="3892" y="692"/>
                  <a:pt x="3873" y="673"/>
                </a:cubicBezTo>
                <a:cubicBezTo>
                  <a:pt x="3859" y="659"/>
                  <a:pt x="3843" y="650"/>
                  <a:pt x="3826" y="647"/>
                </a:cubicBezTo>
                <a:cubicBezTo>
                  <a:pt x="3809" y="644"/>
                  <a:pt x="3793" y="647"/>
                  <a:pt x="3778" y="655"/>
                </a:cubicBezTo>
                <a:cubicBezTo>
                  <a:pt x="3769" y="661"/>
                  <a:pt x="3754" y="674"/>
                  <a:pt x="3734" y="694"/>
                </a:cubicBezTo>
                <a:lnTo>
                  <a:pt x="3648" y="780"/>
                </a:lnTo>
                <a:lnTo>
                  <a:pt x="3768" y="900"/>
                </a:lnTo>
                <a:close/>
                <a:moveTo>
                  <a:pt x="4088" y="717"/>
                </a:moveTo>
                <a:lnTo>
                  <a:pt x="4126" y="671"/>
                </a:lnTo>
                <a:cubicBezTo>
                  <a:pt x="4145" y="686"/>
                  <a:pt x="4163" y="695"/>
                  <a:pt x="4181" y="699"/>
                </a:cubicBezTo>
                <a:cubicBezTo>
                  <a:pt x="4199" y="702"/>
                  <a:pt x="4219" y="700"/>
                  <a:pt x="4241" y="691"/>
                </a:cubicBezTo>
                <a:cubicBezTo>
                  <a:pt x="4263" y="682"/>
                  <a:pt x="4284" y="669"/>
                  <a:pt x="4303" y="649"/>
                </a:cubicBezTo>
                <a:cubicBezTo>
                  <a:pt x="4320" y="632"/>
                  <a:pt x="4332" y="615"/>
                  <a:pt x="4340" y="597"/>
                </a:cubicBezTo>
                <a:cubicBezTo>
                  <a:pt x="4348" y="579"/>
                  <a:pt x="4351" y="562"/>
                  <a:pt x="4348" y="547"/>
                </a:cubicBezTo>
                <a:cubicBezTo>
                  <a:pt x="4346" y="532"/>
                  <a:pt x="4340" y="519"/>
                  <a:pt x="4329" y="509"/>
                </a:cubicBezTo>
                <a:cubicBezTo>
                  <a:pt x="4319" y="498"/>
                  <a:pt x="4306" y="492"/>
                  <a:pt x="4292" y="490"/>
                </a:cubicBezTo>
                <a:cubicBezTo>
                  <a:pt x="4278" y="489"/>
                  <a:pt x="4262" y="492"/>
                  <a:pt x="4242" y="501"/>
                </a:cubicBezTo>
                <a:cubicBezTo>
                  <a:pt x="4230" y="506"/>
                  <a:pt x="4204" y="521"/>
                  <a:pt x="4166" y="544"/>
                </a:cubicBezTo>
                <a:cubicBezTo>
                  <a:pt x="4128" y="568"/>
                  <a:pt x="4099" y="582"/>
                  <a:pt x="4080" y="588"/>
                </a:cubicBezTo>
                <a:cubicBezTo>
                  <a:pt x="4056" y="596"/>
                  <a:pt x="4033" y="597"/>
                  <a:pt x="4013" y="593"/>
                </a:cubicBezTo>
                <a:cubicBezTo>
                  <a:pt x="3993" y="588"/>
                  <a:pt x="3975" y="578"/>
                  <a:pt x="3959" y="563"/>
                </a:cubicBezTo>
                <a:cubicBezTo>
                  <a:pt x="3942" y="546"/>
                  <a:pt x="3931" y="525"/>
                  <a:pt x="3926" y="501"/>
                </a:cubicBezTo>
                <a:cubicBezTo>
                  <a:pt x="3921" y="476"/>
                  <a:pt x="3924" y="451"/>
                  <a:pt x="3935" y="425"/>
                </a:cubicBezTo>
                <a:cubicBezTo>
                  <a:pt x="3946" y="399"/>
                  <a:pt x="3962" y="375"/>
                  <a:pt x="3985" y="352"/>
                </a:cubicBezTo>
                <a:cubicBezTo>
                  <a:pt x="4010" y="327"/>
                  <a:pt x="4036" y="309"/>
                  <a:pt x="4063" y="298"/>
                </a:cubicBezTo>
                <a:cubicBezTo>
                  <a:pt x="4090" y="287"/>
                  <a:pt x="4116" y="284"/>
                  <a:pt x="4142" y="290"/>
                </a:cubicBezTo>
                <a:cubicBezTo>
                  <a:pt x="4168" y="295"/>
                  <a:pt x="4191" y="307"/>
                  <a:pt x="4212" y="326"/>
                </a:cubicBezTo>
                <a:lnTo>
                  <a:pt x="4172" y="372"/>
                </a:lnTo>
                <a:cubicBezTo>
                  <a:pt x="4149" y="353"/>
                  <a:pt x="4125" y="345"/>
                  <a:pt x="4101" y="347"/>
                </a:cubicBezTo>
                <a:cubicBezTo>
                  <a:pt x="4077" y="349"/>
                  <a:pt x="4052" y="363"/>
                  <a:pt x="4026" y="389"/>
                </a:cubicBezTo>
                <a:cubicBezTo>
                  <a:pt x="3999" y="416"/>
                  <a:pt x="3985" y="441"/>
                  <a:pt x="3982" y="463"/>
                </a:cubicBezTo>
                <a:cubicBezTo>
                  <a:pt x="3980" y="485"/>
                  <a:pt x="3985" y="503"/>
                  <a:pt x="3999" y="517"/>
                </a:cubicBezTo>
                <a:cubicBezTo>
                  <a:pt x="4011" y="529"/>
                  <a:pt x="4026" y="535"/>
                  <a:pt x="4042" y="534"/>
                </a:cubicBezTo>
                <a:cubicBezTo>
                  <a:pt x="4058" y="533"/>
                  <a:pt x="4089" y="519"/>
                  <a:pt x="4133" y="491"/>
                </a:cubicBezTo>
                <a:cubicBezTo>
                  <a:pt x="4177" y="463"/>
                  <a:pt x="4209" y="445"/>
                  <a:pt x="4229" y="438"/>
                </a:cubicBezTo>
                <a:cubicBezTo>
                  <a:pt x="4258" y="427"/>
                  <a:pt x="4283" y="424"/>
                  <a:pt x="4307" y="429"/>
                </a:cubicBezTo>
                <a:cubicBezTo>
                  <a:pt x="4330" y="433"/>
                  <a:pt x="4350" y="444"/>
                  <a:pt x="4368" y="462"/>
                </a:cubicBezTo>
                <a:cubicBezTo>
                  <a:pt x="4386" y="480"/>
                  <a:pt x="4398" y="502"/>
                  <a:pt x="4404" y="528"/>
                </a:cubicBezTo>
                <a:cubicBezTo>
                  <a:pt x="4409" y="554"/>
                  <a:pt x="4407" y="581"/>
                  <a:pt x="4396" y="609"/>
                </a:cubicBezTo>
                <a:cubicBezTo>
                  <a:pt x="4386" y="637"/>
                  <a:pt x="4369" y="663"/>
                  <a:pt x="4345" y="687"/>
                </a:cubicBezTo>
                <a:cubicBezTo>
                  <a:pt x="4314" y="718"/>
                  <a:pt x="4284" y="739"/>
                  <a:pt x="4255" y="750"/>
                </a:cubicBezTo>
                <a:cubicBezTo>
                  <a:pt x="4226" y="762"/>
                  <a:pt x="4196" y="765"/>
                  <a:pt x="4167" y="759"/>
                </a:cubicBezTo>
                <a:cubicBezTo>
                  <a:pt x="4137" y="753"/>
                  <a:pt x="4111" y="739"/>
                  <a:pt x="4088" y="717"/>
                </a:cubicBezTo>
                <a:close/>
                <a:moveTo>
                  <a:pt x="4643" y="377"/>
                </a:moveTo>
                <a:lnTo>
                  <a:pt x="4563" y="297"/>
                </a:lnTo>
                <a:lnTo>
                  <a:pt x="4417" y="443"/>
                </a:lnTo>
                <a:lnTo>
                  <a:pt x="4379" y="405"/>
                </a:lnTo>
                <a:lnTo>
                  <a:pt x="4315" y="34"/>
                </a:lnTo>
                <a:lnTo>
                  <a:pt x="4348" y="0"/>
                </a:lnTo>
                <a:lnTo>
                  <a:pt x="4566" y="218"/>
                </a:lnTo>
                <a:lnTo>
                  <a:pt x="4612" y="172"/>
                </a:lnTo>
                <a:lnTo>
                  <a:pt x="4649" y="210"/>
                </a:lnTo>
                <a:lnTo>
                  <a:pt x="4604" y="256"/>
                </a:lnTo>
                <a:lnTo>
                  <a:pt x="4684" y="336"/>
                </a:lnTo>
                <a:lnTo>
                  <a:pt x="4643" y="377"/>
                </a:lnTo>
                <a:close/>
                <a:moveTo>
                  <a:pt x="4525" y="259"/>
                </a:moveTo>
                <a:lnTo>
                  <a:pt x="4373" y="108"/>
                </a:lnTo>
                <a:lnTo>
                  <a:pt x="4420" y="364"/>
                </a:lnTo>
                <a:lnTo>
                  <a:pt x="4525" y="259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93" name="Freeform 75"/>
          <p:cNvSpPr>
            <a:spLocks noEditPoints="1"/>
          </p:cNvSpPr>
          <p:nvPr/>
        </p:nvSpPr>
        <p:spPr bwMode="auto">
          <a:xfrm>
            <a:off x="4688065" y="4603537"/>
            <a:ext cx="890587" cy="898525"/>
          </a:xfrm>
          <a:custGeom>
            <a:avLst/>
            <a:gdLst>
              <a:gd name="T0" fmla="*/ 239 w 4678"/>
              <a:gd name="T1" fmla="*/ 4177 h 4714"/>
              <a:gd name="T2" fmla="*/ 244 w 4678"/>
              <a:gd name="T3" fmla="*/ 4533 h 4714"/>
              <a:gd name="T4" fmla="*/ 337 w 4678"/>
              <a:gd name="T5" fmla="*/ 4329 h 4714"/>
              <a:gd name="T6" fmla="*/ 84 w 4678"/>
              <a:gd name="T7" fmla="*/ 4373 h 4714"/>
              <a:gd name="T8" fmla="*/ 513 w 4678"/>
              <a:gd name="T9" fmla="*/ 3885 h 4714"/>
              <a:gd name="T10" fmla="*/ 740 w 4678"/>
              <a:gd name="T11" fmla="*/ 4013 h 4714"/>
              <a:gd name="T12" fmla="*/ 779 w 4678"/>
              <a:gd name="T13" fmla="*/ 4271 h 4714"/>
              <a:gd name="T14" fmla="*/ 621 w 4678"/>
              <a:gd name="T15" fmla="*/ 3998 h 4714"/>
              <a:gd name="T16" fmla="*/ 399 w 4678"/>
              <a:gd name="T17" fmla="*/ 4058 h 4714"/>
              <a:gd name="T18" fmla="*/ 785 w 4678"/>
              <a:gd name="T19" fmla="*/ 4164 h 4714"/>
              <a:gd name="T20" fmla="*/ 618 w 4678"/>
              <a:gd name="T21" fmla="*/ 4121 h 4714"/>
              <a:gd name="T22" fmla="*/ 744 w 4678"/>
              <a:gd name="T23" fmla="*/ 3634 h 4714"/>
              <a:gd name="T24" fmla="*/ 1131 w 4678"/>
              <a:gd name="T25" fmla="*/ 3715 h 4714"/>
              <a:gd name="T26" fmla="*/ 964 w 4678"/>
              <a:gd name="T27" fmla="*/ 4086 h 4714"/>
              <a:gd name="T28" fmla="*/ 1082 w 4678"/>
              <a:gd name="T29" fmla="*/ 3757 h 4714"/>
              <a:gd name="T30" fmla="*/ 712 w 4678"/>
              <a:gd name="T31" fmla="*/ 3745 h 4714"/>
              <a:gd name="T32" fmla="*/ 1627 w 4678"/>
              <a:gd name="T33" fmla="*/ 3609 h 4714"/>
              <a:gd name="T34" fmla="*/ 1415 w 4678"/>
              <a:gd name="T35" fmla="*/ 2970 h 4714"/>
              <a:gd name="T36" fmla="*/ 1564 w 4678"/>
              <a:gd name="T37" fmla="*/ 3213 h 4714"/>
              <a:gd name="T38" fmla="*/ 1525 w 4678"/>
              <a:gd name="T39" fmla="*/ 3173 h 4714"/>
              <a:gd name="T40" fmla="*/ 1404 w 4678"/>
              <a:gd name="T41" fmla="*/ 3054 h 4714"/>
              <a:gd name="T42" fmla="*/ 1789 w 4678"/>
              <a:gd name="T43" fmla="*/ 2589 h 4714"/>
              <a:gd name="T44" fmla="*/ 1958 w 4678"/>
              <a:gd name="T45" fmla="*/ 2784 h 4714"/>
              <a:gd name="T46" fmla="*/ 1882 w 4678"/>
              <a:gd name="T47" fmla="*/ 3168 h 4714"/>
              <a:gd name="T48" fmla="*/ 2043 w 4678"/>
              <a:gd name="T49" fmla="*/ 2508 h 4714"/>
              <a:gd name="T50" fmla="*/ 2167 w 4678"/>
              <a:gd name="T51" fmla="*/ 2528 h 4714"/>
              <a:gd name="T52" fmla="*/ 2184 w 4678"/>
              <a:gd name="T53" fmla="*/ 2632 h 4714"/>
              <a:gd name="T54" fmla="*/ 2343 w 4678"/>
              <a:gd name="T55" fmla="*/ 2181 h 4714"/>
              <a:gd name="T56" fmla="*/ 2283 w 4678"/>
              <a:gd name="T57" fmla="*/ 2092 h 4714"/>
              <a:gd name="T58" fmla="*/ 2563 w 4678"/>
              <a:gd name="T59" fmla="*/ 2000 h 4714"/>
              <a:gd name="T60" fmla="*/ 2742 w 4678"/>
              <a:gd name="T61" fmla="*/ 1895 h 4714"/>
              <a:gd name="T62" fmla="*/ 3058 w 4678"/>
              <a:gd name="T63" fmla="*/ 1992 h 4714"/>
              <a:gd name="T64" fmla="*/ 2776 w 4678"/>
              <a:gd name="T65" fmla="*/ 1882 h 4714"/>
              <a:gd name="T66" fmla="*/ 2704 w 4678"/>
              <a:gd name="T67" fmla="*/ 1947 h 4714"/>
              <a:gd name="T68" fmla="*/ 2810 w 4678"/>
              <a:gd name="T69" fmla="*/ 2240 h 4714"/>
              <a:gd name="T70" fmla="*/ 3218 w 4678"/>
              <a:gd name="T71" fmla="*/ 1775 h 4714"/>
              <a:gd name="T72" fmla="*/ 3063 w 4678"/>
              <a:gd name="T73" fmla="*/ 1741 h 4714"/>
              <a:gd name="T74" fmla="*/ 2960 w 4678"/>
              <a:gd name="T75" fmla="*/ 1602 h 4714"/>
              <a:gd name="T76" fmla="*/ 3121 w 4678"/>
              <a:gd name="T77" fmla="*/ 1579 h 4714"/>
              <a:gd name="T78" fmla="*/ 3026 w 4678"/>
              <a:gd name="T79" fmla="*/ 1686 h 4714"/>
              <a:gd name="T80" fmla="*/ 3274 w 4678"/>
              <a:gd name="T81" fmla="*/ 1633 h 4714"/>
              <a:gd name="T82" fmla="*/ 3070 w 4678"/>
              <a:gd name="T83" fmla="*/ 1834 h 4714"/>
              <a:gd name="T84" fmla="*/ 3204 w 4678"/>
              <a:gd name="T85" fmla="*/ 1420 h 4714"/>
              <a:gd name="T86" fmla="*/ 3541 w 4678"/>
              <a:gd name="T87" fmla="*/ 1509 h 4714"/>
              <a:gd name="T88" fmla="*/ 3499 w 4678"/>
              <a:gd name="T89" fmla="*/ 974 h 4714"/>
              <a:gd name="T90" fmla="*/ 3788 w 4678"/>
              <a:gd name="T91" fmla="*/ 1262 h 4714"/>
              <a:gd name="T92" fmla="*/ 3802 w 4678"/>
              <a:gd name="T93" fmla="*/ 613 h 4714"/>
              <a:gd name="T94" fmla="*/ 3808 w 4678"/>
              <a:gd name="T95" fmla="*/ 969 h 4714"/>
              <a:gd name="T96" fmla="*/ 3900 w 4678"/>
              <a:gd name="T97" fmla="*/ 765 h 4714"/>
              <a:gd name="T98" fmla="*/ 3648 w 4678"/>
              <a:gd name="T99" fmla="*/ 809 h 4714"/>
              <a:gd name="T100" fmla="*/ 4242 w 4678"/>
              <a:gd name="T101" fmla="*/ 720 h 4714"/>
              <a:gd name="T102" fmla="*/ 4293 w 4678"/>
              <a:gd name="T103" fmla="*/ 519 h 4714"/>
              <a:gd name="T104" fmla="*/ 3960 w 4678"/>
              <a:gd name="T105" fmla="*/ 592 h 4714"/>
              <a:gd name="T106" fmla="*/ 4143 w 4678"/>
              <a:gd name="T107" fmla="*/ 319 h 4714"/>
              <a:gd name="T108" fmla="*/ 3982 w 4678"/>
              <a:gd name="T109" fmla="*/ 492 h 4714"/>
              <a:gd name="T110" fmla="*/ 4307 w 4678"/>
              <a:gd name="T111" fmla="*/ 458 h 4714"/>
              <a:gd name="T112" fmla="*/ 4255 w 4678"/>
              <a:gd name="T113" fmla="*/ 779 h 4714"/>
              <a:gd name="T114" fmla="*/ 4533 w 4678"/>
              <a:gd name="T115" fmla="*/ 429 h 4714"/>
              <a:gd name="T116" fmla="*/ 4432 w 4678"/>
              <a:gd name="T117" fmla="*/ 245 h 4714"/>
              <a:gd name="T118" fmla="*/ 4387 w 4678"/>
              <a:gd name="T119" fmla="*/ 0 h 4714"/>
              <a:gd name="T120" fmla="*/ 4512 w 4678"/>
              <a:gd name="T121" fmla="*/ 154 h 4714"/>
              <a:gd name="T122" fmla="*/ 4423 w 4678"/>
              <a:gd name="T123" fmla="*/ 451 h 47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  <a:cxn ang="0">
                <a:pos x="T122" y="T123"/>
              </a:cxn>
            </a:cxnLst>
            <a:rect l="0" t="0" r="r" b="b"/>
            <a:pathLst>
              <a:path w="4678" h="4714">
                <a:moveTo>
                  <a:pt x="336" y="4714"/>
                </a:moveTo>
                <a:lnTo>
                  <a:pt x="0" y="4378"/>
                </a:lnTo>
                <a:lnTo>
                  <a:pt x="127" y="4251"/>
                </a:lnTo>
                <a:cubicBezTo>
                  <a:pt x="149" y="4228"/>
                  <a:pt x="167" y="4213"/>
                  <a:pt x="181" y="4203"/>
                </a:cubicBezTo>
                <a:cubicBezTo>
                  <a:pt x="201" y="4189"/>
                  <a:pt x="220" y="4181"/>
                  <a:pt x="239" y="4177"/>
                </a:cubicBezTo>
                <a:cubicBezTo>
                  <a:pt x="257" y="4174"/>
                  <a:pt x="277" y="4175"/>
                  <a:pt x="298" y="4183"/>
                </a:cubicBezTo>
                <a:cubicBezTo>
                  <a:pt x="319" y="4190"/>
                  <a:pt x="337" y="4202"/>
                  <a:pt x="354" y="4218"/>
                </a:cubicBezTo>
                <a:cubicBezTo>
                  <a:pt x="383" y="4247"/>
                  <a:pt x="398" y="4280"/>
                  <a:pt x="399" y="4318"/>
                </a:cubicBezTo>
                <a:cubicBezTo>
                  <a:pt x="401" y="4356"/>
                  <a:pt x="378" y="4399"/>
                  <a:pt x="330" y="4446"/>
                </a:cubicBezTo>
                <a:lnTo>
                  <a:pt x="244" y="4533"/>
                </a:lnTo>
                <a:lnTo>
                  <a:pt x="381" y="4669"/>
                </a:lnTo>
                <a:lnTo>
                  <a:pt x="336" y="4714"/>
                </a:lnTo>
                <a:close/>
                <a:moveTo>
                  <a:pt x="205" y="4493"/>
                </a:moveTo>
                <a:lnTo>
                  <a:pt x="291" y="4406"/>
                </a:lnTo>
                <a:cubicBezTo>
                  <a:pt x="320" y="4377"/>
                  <a:pt x="335" y="4352"/>
                  <a:pt x="337" y="4329"/>
                </a:cubicBezTo>
                <a:cubicBezTo>
                  <a:pt x="338" y="4306"/>
                  <a:pt x="329" y="4285"/>
                  <a:pt x="310" y="4265"/>
                </a:cubicBezTo>
                <a:cubicBezTo>
                  <a:pt x="295" y="4251"/>
                  <a:pt x="280" y="4243"/>
                  <a:pt x="263" y="4240"/>
                </a:cubicBezTo>
                <a:cubicBezTo>
                  <a:pt x="246" y="4237"/>
                  <a:pt x="230" y="4240"/>
                  <a:pt x="215" y="4248"/>
                </a:cubicBezTo>
                <a:cubicBezTo>
                  <a:pt x="205" y="4254"/>
                  <a:pt x="191" y="4267"/>
                  <a:pt x="170" y="4287"/>
                </a:cubicBezTo>
                <a:lnTo>
                  <a:pt x="84" y="4373"/>
                </a:lnTo>
                <a:lnTo>
                  <a:pt x="205" y="4493"/>
                </a:lnTo>
                <a:close/>
                <a:moveTo>
                  <a:pt x="651" y="4399"/>
                </a:moveTo>
                <a:lnTo>
                  <a:pt x="315" y="4063"/>
                </a:lnTo>
                <a:lnTo>
                  <a:pt x="441" y="3937"/>
                </a:lnTo>
                <a:cubicBezTo>
                  <a:pt x="467" y="3911"/>
                  <a:pt x="491" y="3894"/>
                  <a:pt x="513" y="3885"/>
                </a:cubicBezTo>
                <a:cubicBezTo>
                  <a:pt x="536" y="3876"/>
                  <a:pt x="558" y="3875"/>
                  <a:pt x="581" y="3880"/>
                </a:cubicBezTo>
                <a:cubicBezTo>
                  <a:pt x="604" y="3885"/>
                  <a:pt x="623" y="3896"/>
                  <a:pt x="639" y="3911"/>
                </a:cubicBezTo>
                <a:cubicBezTo>
                  <a:pt x="653" y="3925"/>
                  <a:pt x="663" y="3943"/>
                  <a:pt x="668" y="3963"/>
                </a:cubicBezTo>
                <a:cubicBezTo>
                  <a:pt x="672" y="3984"/>
                  <a:pt x="671" y="4006"/>
                  <a:pt x="663" y="4029"/>
                </a:cubicBezTo>
                <a:cubicBezTo>
                  <a:pt x="689" y="4015"/>
                  <a:pt x="715" y="4010"/>
                  <a:pt x="740" y="4013"/>
                </a:cubicBezTo>
                <a:cubicBezTo>
                  <a:pt x="766" y="4016"/>
                  <a:pt x="788" y="4028"/>
                  <a:pt x="808" y="4047"/>
                </a:cubicBezTo>
                <a:cubicBezTo>
                  <a:pt x="823" y="4063"/>
                  <a:pt x="835" y="4081"/>
                  <a:pt x="842" y="4101"/>
                </a:cubicBezTo>
                <a:cubicBezTo>
                  <a:pt x="848" y="4122"/>
                  <a:pt x="851" y="4140"/>
                  <a:pt x="848" y="4157"/>
                </a:cubicBezTo>
                <a:cubicBezTo>
                  <a:pt x="846" y="4174"/>
                  <a:pt x="839" y="4192"/>
                  <a:pt x="828" y="4211"/>
                </a:cubicBezTo>
                <a:cubicBezTo>
                  <a:pt x="817" y="4229"/>
                  <a:pt x="801" y="4249"/>
                  <a:pt x="779" y="4271"/>
                </a:cubicBezTo>
                <a:lnTo>
                  <a:pt x="651" y="4399"/>
                </a:lnTo>
                <a:close/>
                <a:moveTo>
                  <a:pt x="501" y="4159"/>
                </a:moveTo>
                <a:lnTo>
                  <a:pt x="574" y="4087"/>
                </a:lnTo>
                <a:cubicBezTo>
                  <a:pt x="593" y="4067"/>
                  <a:pt x="606" y="4052"/>
                  <a:pt x="612" y="4040"/>
                </a:cubicBezTo>
                <a:cubicBezTo>
                  <a:pt x="620" y="4026"/>
                  <a:pt x="623" y="4012"/>
                  <a:pt x="621" y="3998"/>
                </a:cubicBezTo>
                <a:cubicBezTo>
                  <a:pt x="619" y="3985"/>
                  <a:pt x="612" y="3972"/>
                  <a:pt x="600" y="3960"/>
                </a:cubicBezTo>
                <a:cubicBezTo>
                  <a:pt x="589" y="3949"/>
                  <a:pt x="577" y="3942"/>
                  <a:pt x="563" y="3939"/>
                </a:cubicBezTo>
                <a:cubicBezTo>
                  <a:pt x="549" y="3936"/>
                  <a:pt x="535" y="3937"/>
                  <a:pt x="522" y="3944"/>
                </a:cubicBezTo>
                <a:cubicBezTo>
                  <a:pt x="509" y="3951"/>
                  <a:pt x="491" y="3966"/>
                  <a:pt x="467" y="3991"/>
                </a:cubicBezTo>
                <a:lnTo>
                  <a:pt x="399" y="4058"/>
                </a:lnTo>
                <a:lnTo>
                  <a:pt x="501" y="4159"/>
                </a:lnTo>
                <a:close/>
                <a:moveTo>
                  <a:pt x="656" y="4315"/>
                </a:moveTo>
                <a:lnTo>
                  <a:pt x="740" y="4231"/>
                </a:lnTo>
                <a:cubicBezTo>
                  <a:pt x="754" y="4217"/>
                  <a:pt x="764" y="4206"/>
                  <a:pt x="768" y="4199"/>
                </a:cubicBezTo>
                <a:cubicBezTo>
                  <a:pt x="777" y="4187"/>
                  <a:pt x="782" y="4175"/>
                  <a:pt x="785" y="4164"/>
                </a:cubicBezTo>
                <a:cubicBezTo>
                  <a:pt x="788" y="4153"/>
                  <a:pt x="787" y="4141"/>
                  <a:pt x="783" y="4129"/>
                </a:cubicBezTo>
                <a:cubicBezTo>
                  <a:pt x="779" y="4116"/>
                  <a:pt x="772" y="4104"/>
                  <a:pt x="762" y="4094"/>
                </a:cubicBezTo>
                <a:cubicBezTo>
                  <a:pt x="749" y="4081"/>
                  <a:pt x="735" y="4073"/>
                  <a:pt x="719" y="4071"/>
                </a:cubicBezTo>
                <a:cubicBezTo>
                  <a:pt x="704" y="4068"/>
                  <a:pt x="688" y="4070"/>
                  <a:pt x="673" y="4078"/>
                </a:cubicBezTo>
                <a:cubicBezTo>
                  <a:pt x="658" y="4085"/>
                  <a:pt x="640" y="4100"/>
                  <a:pt x="618" y="4121"/>
                </a:cubicBezTo>
                <a:lnTo>
                  <a:pt x="541" y="4199"/>
                </a:lnTo>
                <a:lnTo>
                  <a:pt x="656" y="4315"/>
                </a:lnTo>
                <a:close/>
                <a:moveTo>
                  <a:pt x="964" y="4086"/>
                </a:moveTo>
                <a:lnTo>
                  <a:pt x="628" y="3750"/>
                </a:lnTo>
                <a:lnTo>
                  <a:pt x="744" y="3634"/>
                </a:lnTo>
                <a:cubicBezTo>
                  <a:pt x="770" y="3608"/>
                  <a:pt x="792" y="3589"/>
                  <a:pt x="809" y="3579"/>
                </a:cubicBezTo>
                <a:cubicBezTo>
                  <a:pt x="832" y="3564"/>
                  <a:pt x="857" y="3556"/>
                  <a:pt x="882" y="3554"/>
                </a:cubicBezTo>
                <a:cubicBezTo>
                  <a:pt x="915" y="3551"/>
                  <a:pt x="947" y="3557"/>
                  <a:pt x="979" y="3571"/>
                </a:cubicBezTo>
                <a:cubicBezTo>
                  <a:pt x="1011" y="3586"/>
                  <a:pt x="1042" y="3608"/>
                  <a:pt x="1072" y="3638"/>
                </a:cubicBezTo>
                <a:cubicBezTo>
                  <a:pt x="1098" y="3664"/>
                  <a:pt x="1117" y="3689"/>
                  <a:pt x="1131" y="3715"/>
                </a:cubicBezTo>
                <a:cubicBezTo>
                  <a:pt x="1145" y="3740"/>
                  <a:pt x="1154" y="3764"/>
                  <a:pt x="1157" y="3787"/>
                </a:cubicBezTo>
                <a:cubicBezTo>
                  <a:pt x="1161" y="3809"/>
                  <a:pt x="1161" y="3829"/>
                  <a:pt x="1157" y="3848"/>
                </a:cubicBezTo>
                <a:cubicBezTo>
                  <a:pt x="1153" y="3866"/>
                  <a:pt x="1146" y="3885"/>
                  <a:pt x="1134" y="3905"/>
                </a:cubicBezTo>
                <a:cubicBezTo>
                  <a:pt x="1122" y="3924"/>
                  <a:pt x="1106" y="3944"/>
                  <a:pt x="1086" y="3964"/>
                </a:cubicBezTo>
                <a:lnTo>
                  <a:pt x="964" y="4086"/>
                </a:lnTo>
                <a:close/>
                <a:moveTo>
                  <a:pt x="969" y="4002"/>
                </a:moveTo>
                <a:lnTo>
                  <a:pt x="1041" y="3930"/>
                </a:lnTo>
                <a:cubicBezTo>
                  <a:pt x="1063" y="3908"/>
                  <a:pt x="1078" y="3888"/>
                  <a:pt x="1087" y="3872"/>
                </a:cubicBezTo>
                <a:cubicBezTo>
                  <a:pt x="1095" y="3855"/>
                  <a:pt x="1100" y="3839"/>
                  <a:pt x="1100" y="3824"/>
                </a:cubicBezTo>
                <a:cubicBezTo>
                  <a:pt x="1100" y="3803"/>
                  <a:pt x="1094" y="3780"/>
                  <a:pt x="1082" y="3757"/>
                </a:cubicBezTo>
                <a:cubicBezTo>
                  <a:pt x="1070" y="3733"/>
                  <a:pt x="1051" y="3709"/>
                  <a:pt x="1026" y="3683"/>
                </a:cubicBezTo>
                <a:cubicBezTo>
                  <a:pt x="991" y="3648"/>
                  <a:pt x="958" y="3627"/>
                  <a:pt x="927" y="3619"/>
                </a:cubicBezTo>
                <a:cubicBezTo>
                  <a:pt x="897" y="3612"/>
                  <a:pt x="870" y="3613"/>
                  <a:pt x="847" y="3624"/>
                </a:cubicBezTo>
                <a:cubicBezTo>
                  <a:pt x="831" y="3631"/>
                  <a:pt x="809" y="3648"/>
                  <a:pt x="783" y="3674"/>
                </a:cubicBezTo>
                <a:lnTo>
                  <a:pt x="712" y="3745"/>
                </a:lnTo>
                <a:lnTo>
                  <a:pt x="969" y="4002"/>
                </a:lnTo>
                <a:close/>
                <a:moveTo>
                  <a:pt x="1354" y="3883"/>
                </a:moveTo>
                <a:lnTo>
                  <a:pt x="1324" y="3853"/>
                </a:lnTo>
                <a:lnTo>
                  <a:pt x="1597" y="3580"/>
                </a:lnTo>
                <a:lnTo>
                  <a:pt x="1627" y="3609"/>
                </a:lnTo>
                <a:lnTo>
                  <a:pt x="1354" y="3883"/>
                </a:lnTo>
                <a:close/>
                <a:moveTo>
                  <a:pt x="1570" y="3480"/>
                </a:moveTo>
                <a:lnTo>
                  <a:pt x="1233" y="3144"/>
                </a:lnTo>
                <a:lnTo>
                  <a:pt x="1360" y="3018"/>
                </a:lnTo>
                <a:cubicBezTo>
                  <a:pt x="1383" y="2995"/>
                  <a:pt x="1401" y="2979"/>
                  <a:pt x="1415" y="2970"/>
                </a:cubicBezTo>
                <a:cubicBezTo>
                  <a:pt x="1434" y="2956"/>
                  <a:pt x="1453" y="2947"/>
                  <a:pt x="1472" y="2944"/>
                </a:cubicBezTo>
                <a:cubicBezTo>
                  <a:pt x="1491" y="2940"/>
                  <a:pt x="1510" y="2942"/>
                  <a:pt x="1531" y="2949"/>
                </a:cubicBezTo>
                <a:cubicBezTo>
                  <a:pt x="1552" y="2956"/>
                  <a:pt x="1571" y="2968"/>
                  <a:pt x="1587" y="2985"/>
                </a:cubicBezTo>
                <a:cubicBezTo>
                  <a:pt x="1616" y="3014"/>
                  <a:pt x="1631" y="3047"/>
                  <a:pt x="1632" y="3085"/>
                </a:cubicBezTo>
                <a:cubicBezTo>
                  <a:pt x="1634" y="3123"/>
                  <a:pt x="1611" y="3166"/>
                  <a:pt x="1564" y="3213"/>
                </a:cubicBezTo>
                <a:lnTo>
                  <a:pt x="1477" y="3299"/>
                </a:lnTo>
                <a:lnTo>
                  <a:pt x="1614" y="3436"/>
                </a:lnTo>
                <a:lnTo>
                  <a:pt x="1570" y="3480"/>
                </a:lnTo>
                <a:close/>
                <a:moveTo>
                  <a:pt x="1438" y="3260"/>
                </a:moveTo>
                <a:lnTo>
                  <a:pt x="1525" y="3173"/>
                </a:lnTo>
                <a:cubicBezTo>
                  <a:pt x="1553" y="3144"/>
                  <a:pt x="1568" y="3118"/>
                  <a:pt x="1570" y="3096"/>
                </a:cubicBezTo>
                <a:cubicBezTo>
                  <a:pt x="1571" y="3073"/>
                  <a:pt x="1562" y="3052"/>
                  <a:pt x="1543" y="3032"/>
                </a:cubicBezTo>
                <a:cubicBezTo>
                  <a:pt x="1529" y="3018"/>
                  <a:pt x="1513" y="3010"/>
                  <a:pt x="1496" y="3007"/>
                </a:cubicBezTo>
                <a:cubicBezTo>
                  <a:pt x="1479" y="3004"/>
                  <a:pt x="1463" y="3007"/>
                  <a:pt x="1448" y="3015"/>
                </a:cubicBezTo>
                <a:cubicBezTo>
                  <a:pt x="1439" y="3021"/>
                  <a:pt x="1424" y="3033"/>
                  <a:pt x="1404" y="3054"/>
                </a:cubicBezTo>
                <a:lnTo>
                  <a:pt x="1318" y="3140"/>
                </a:lnTo>
                <a:lnTo>
                  <a:pt x="1438" y="3260"/>
                </a:lnTo>
                <a:close/>
                <a:moveTo>
                  <a:pt x="1882" y="3168"/>
                </a:moveTo>
                <a:lnTo>
                  <a:pt x="1545" y="2832"/>
                </a:lnTo>
                <a:lnTo>
                  <a:pt x="1789" y="2589"/>
                </a:lnTo>
                <a:lnTo>
                  <a:pt x="1828" y="2629"/>
                </a:lnTo>
                <a:lnTo>
                  <a:pt x="1630" y="2828"/>
                </a:lnTo>
                <a:lnTo>
                  <a:pt x="1733" y="2930"/>
                </a:lnTo>
                <a:lnTo>
                  <a:pt x="1918" y="2745"/>
                </a:lnTo>
                <a:lnTo>
                  <a:pt x="1958" y="2784"/>
                </a:lnTo>
                <a:lnTo>
                  <a:pt x="1772" y="2970"/>
                </a:lnTo>
                <a:lnTo>
                  <a:pt x="1886" y="3084"/>
                </a:lnTo>
                <a:lnTo>
                  <a:pt x="2093" y="2878"/>
                </a:lnTo>
                <a:lnTo>
                  <a:pt x="2132" y="2918"/>
                </a:lnTo>
                <a:lnTo>
                  <a:pt x="1882" y="3168"/>
                </a:lnTo>
                <a:close/>
                <a:moveTo>
                  <a:pt x="2163" y="2887"/>
                </a:moveTo>
                <a:lnTo>
                  <a:pt x="2118" y="2582"/>
                </a:lnTo>
                <a:lnTo>
                  <a:pt x="1843" y="2535"/>
                </a:lnTo>
                <a:lnTo>
                  <a:pt x="1896" y="2482"/>
                </a:lnTo>
                <a:lnTo>
                  <a:pt x="2043" y="2508"/>
                </a:lnTo>
                <a:cubicBezTo>
                  <a:pt x="2073" y="2513"/>
                  <a:pt x="2096" y="2517"/>
                  <a:pt x="2111" y="2522"/>
                </a:cubicBezTo>
                <a:cubicBezTo>
                  <a:pt x="2106" y="2502"/>
                  <a:pt x="2102" y="2480"/>
                  <a:pt x="2099" y="2457"/>
                </a:cubicBezTo>
                <a:lnTo>
                  <a:pt x="2078" y="2300"/>
                </a:lnTo>
                <a:lnTo>
                  <a:pt x="2126" y="2252"/>
                </a:lnTo>
                <a:lnTo>
                  <a:pt x="2167" y="2528"/>
                </a:lnTo>
                <a:lnTo>
                  <a:pt x="2471" y="2579"/>
                </a:lnTo>
                <a:lnTo>
                  <a:pt x="2416" y="2634"/>
                </a:lnTo>
                <a:lnTo>
                  <a:pt x="2212" y="2598"/>
                </a:lnTo>
                <a:cubicBezTo>
                  <a:pt x="2200" y="2596"/>
                  <a:pt x="2188" y="2594"/>
                  <a:pt x="2175" y="2591"/>
                </a:cubicBezTo>
                <a:cubicBezTo>
                  <a:pt x="2179" y="2610"/>
                  <a:pt x="2183" y="2624"/>
                  <a:pt x="2184" y="2632"/>
                </a:cubicBezTo>
                <a:lnTo>
                  <a:pt x="2217" y="2833"/>
                </a:lnTo>
                <a:lnTo>
                  <a:pt x="2163" y="2887"/>
                </a:lnTo>
                <a:close/>
                <a:moveTo>
                  <a:pt x="2647" y="2403"/>
                </a:moveTo>
                <a:lnTo>
                  <a:pt x="2606" y="2444"/>
                </a:lnTo>
                <a:lnTo>
                  <a:pt x="2343" y="2181"/>
                </a:lnTo>
                <a:cubicBezTo>
                  <a:pt x="2343" y="2200"/>
                  <a:pt x="2339" y="2223"/>
                  <a:pt x="2332" y="2249"/>
                </a:cubicBezTo>
                <a:cubicBezTo>
                  <a:pt x="2326" y="2274"/>
                  <a:pt x="2318" y="2296"/>
                  <a:pt x="2310" y="2313"/>
                </a:cubicBezTo>
                <a:lnTo>
                  <a:pt x="2270" y="2273"/>
                </a:lnTo>
                <a:cubicBezTo>
                  <a:pt x="2283" y="2239"/>
                  <a:pt x="2290" y="2206"/>
                  <a:pt x="2291" y="2173"/>
                </a:cubicBezTo>
                <a:cubicBezTo>
                  <a:pt x="2293" y="2141"/>
                  <a:pt x="2291" y="2114"/>
                  <a:pt x="2283" y="2092"/>
                </a:cubicBezTo>
                <a:lnTo>
                  <a:pt x="2310" y="2065"/>
                </a:lnTo>
                <a:lnTo>
                  <a:pt x="2647" y="2403"/>
                </a:lnTo>
                <a:close/>
                <a:moveTo>
                  <a:pt x="2769" y="2281"/>
                </a:moveTo>
                <a:lnTo>
                  <a:pt x="2526" y="2037"/>
                </a:lnTo>
                <a:lnTo>
                  <a:pt x="2563" y="2000"/>
                </a:lnTo>
                <a:lnTo>
                  <a:pt x="2597" y="2035"/>
                </a:lnTo>
                <a:cubicBezTo>
                  <a:pt x="2592" y="2015"/>
                  <a:pt x="2593" y="1995"/>
                  <a:pt x="2598" y="1975"/>
                </a:cubicBezTo>
                <a:cubicBezTo>
                  <a:pt x="2604" y="1955"/>
                  <a:pt x="2615" y="1937"/>
                  <a:pt x="2631" y="1921"/>
                </a:cubicBezTo>
                <a:cubicBezTo>
                  <a:pt x="2649" y="1903"/>
                  <a:pt x="2668" y="1892"/>
                  <a:pt x="2687" y="1888"/>
                </a:cubicBezTo>
                <a:cubicBezTo>
                  <a:pt x="2706" y="1884"/>
                  <a:pt x="2724" y="1886"/>
                  <a:pt x="2742" y="1895"/>
                </a:cubicBezTo>
                <a:cubicBezTo>
                  <a:pt x="2733" y="1847"/>
                  <a:pt x="2744" y="1808"/>
                  <a:pt x="2775" y="1777"/>
                </a:cubicBezTo>
                <a:cubicBezTo>
                  <a:pt x="2799" y="1753"/>
                  <a:pt x="2824" y="1741"/>
                  <a:pt x="2851" y="1741"/>
                </a:cubicBezTo>
                <a:cubicBezTo>
                  <a:pt x="2877" y="1742"/>
                  <a:pt x="2904" y="1756"/>
                  <a:pt x="2932" y="1784"/>
                </a:cubicBezTo>
                <a:lnTo>
                  <a:pt x="3099" y="1951"/>
                </a:lnTo>
                <a:lnTo>
                  <a:pt x="3058" y="1992"/>
                </a:lnTo>
                <a:lnTo>
                  <a:pt x="2905" y="1839"/>
                </a:lnTo>
                <a:cubicBezTo>
                  <a:pt x="2888" y="1822"/>
                  <a:pt x="2875" y="1812"/>
                  <a:pt x="2865" y="1807"/>
                </a:cubicBezTo>
                <a:cubicBezTo>
                  <a:pt x="2855" y="1802"/>
                  <a:pt x="2844" y="1801"/>
                  <a:pt x="2833" y="1804"/>
                </a:cubicBezTo>
                <a:cubicBezTo>
                  <a:pt x="2821" y="1807"/>
                  <a:pt x="2811" y="1813"/>
                  <a:pt x="2802" y="1822"/>
                </a:cubicBezTo>
                <a:cubicBezTo>
                  <a:pt x="2784" y="1839"/>
                  <a:pt x="2776" y="1859"/>
                  <a:pt x="2776" y="1882"/>
                </a:cubicBezTo>
                <a:cubicBezTo>
                  <a:pt x="2776" y="1904"/>
                  <a:pt x="2789" y="1928"/>
                  <a:pt x="2814" y="1953"/>
                </a:cubicBezTo>
                <a:lnTo>
                  <a:pt x="2955" y="2095"/>
                </a:lnTo>
                <a:lnTo>
                  <a:pt x="2914" y="2136"/>
                </a:lnTo>
                <a:lnTo>
                  <a:pt x="2756" y="1978"/>
                </a:lnTo>
                <a:cubicBezTo>
                  <a:pt x="2737" y="1960"/>
                  <a:pt x="2720" y="1949"/>
                  <a:pt x="2704" y="1947"/>
                </a:cubicBezTo>
                <a:cubicBezTo>
                  <a:pt x="2688" y="1944"/>
                  <a:pt x="2673" y="1951"/>
                  <a:pt x="2658" y="1966"/>
                </a:cubicBezTo>
                <a:cubicBezTo>
                  <a:pt x="2646" y="1978"/>
                  <a:pt x="2638" y="1991"/>
                  <a:pt x="2634" y="2007"/>
                </a:cubicBezTo>
                <a:cubicBezTo>
                  <a:pt x="2631" y="2023"/>
                  <a:pt x="2633" y="2039"/>
                  <a:pt x="2640" y="2056"/>
                </a:cubicBezTo>
                <a:cubicBezTo>
                  <a:pt x="2647" y="2072"/>
                  <a:pt x="2662" y="2091"/>
                  <a:pt x="2684" y="2113"/>
                </a:cubicBezTo>
                <a:lnTo>
                  <a:pt x="2810" y="2240"/>
                </a:lnTo>
                <a:lnTo>
                  <a:pt x="2769" y="2281"/>
                </a:lnTo>
                <a:close/>
                <a:moveTo>
                  <a:pt x="3070" y="1834"/>
                </a:moveTo>
                <a:lnTo>
                  <a:pt x="3105" y="1787"/>
                </a:lnTo>
                <a:cubicBezTo>
                  <a:pt x="3123" y="1801"/>
                  <a:pt x="3142" y="1807"/>
                  <a:pt x="3161" y="1806"/>
                </a:cubicBezTo>
                <a:cubicBezTo>
                  <a:pt x="3181" y="1804"/>
                  <a:pt x="3200" y="1794"/>
                  <a:pt x="3218" y="1775"/>
                </a:cubicBezTo>
                <a:cubicBezTo>
                  <a:pt x="3237" y="1756"/>
                  <a:pt x="3248" y="1738"/>
                  <a:pt x="3249" y="1721"/>
                </a:cubicBezTo>
                <a:cubicBezTo>
                  <a:pt x="3250" y="1704"/>
                  <a:pt x="3246" y="1690"/>
                  <a:pt x="3236" y="1680"/>
                </a:cubicBezTo>
                <a:cubicBezTo>
                  <a:pt x="3226" y="1671"/>
                  <a:pt x="3215" y="1667"/>
                  <a:pt x="3201" y="1670"/>
                </a:cubicBezTo>
                <a:cubicBezTo>
                  <a:pt x="3192" y="1672"/>
                  <a:pt x="3173" y="1682"/>
                  <a:pt x="3145" y="1698"/>
                </a:cubicBezTo>
                <a:cubicBezTo>
                  <a:pt x="3107" y="1721"/>
                  <a:pt x="3080" y="1735"/>
                  <a:pt x="3063" y="1741"/>
                </a:cubicBezTo>
                <a:cubicBezTo>
                  <a:pt x="3045" y="1748"/>
                  <a:pt x="3029" y="1749"/>
                  <a:pt x="3013" y="1745"/>
                </a:cubicBezTo>
                <a:cubicBezTo>
                  <a:pt x="2997" y="1741"/>
                  <a:pt x="2983" y="1733"/>
                  <a:pt x="2971" y="1721"/>
                </a:cubicBezTo>
                <a:cubicBezTo>
                  <a:pt x="2960" y="1710"/>
                  <a:pt x="2953" y="1698"/>
                  <a:pt x="2948" y="1684"/>
                </a:cubicBezTo>
                <a:cubicBezTo>
                  <a:pt x="2944" y="1669"/>
                  <a:pt x="2943" y="1655"/>
                  <a:pt x="2946" y="1640"/>
                </a:cubicBezTo>
                <a:cubicBezTo>
                  <a:pt x="2947" y="1629"/>
                  <a:pt x="2952" y="1616"/>
                  <a:pt x="2960" y="1602"/>
                </a:cubicBezTo>
                <a:cubicBezTo>
                  <a:pt x="2968" y="1588"/>
                  <a:pt x="2978" y="1574"/>
                  <a:pt x="2991" y="1562"/>
                </a:cubicBezTo>
                <a:cubicBezTo>
                  <a:pt x="3010" y="1542"/>
                  <a:pt x="3029" y="1528"/>
                  <a:pt x="3049" y="1519"/>
                </a:cubicBezTo>
                <a:cubicBezTo>
                  <a:pt x="3069" y="1511"/>
                  <a:pt x="3087" y="1507"/>
                  <a:pt x="3103" y="1510"/>
                </a:cubicBezTo>
                <a:cubicBezTo>
                  <a:pt x="3120" y="1512"/>
                  <a:pt x="3137" y="1520"/>
                  <a:pt x="3155" y="1533"/>
                </a:cubicBezTo>
                <a:lnTo>
                  <a:pt x="3121" y="1579"/>
                </a:lnTo>
                <a:cubicBezTo>
                  <a:pt x="3106" y="1568"/>
                  <a:pt x="3091" y="1564"/>
                  <a:pt x="3075" y="1566"/>
                </a:cubicBezTo>
                <a:cubicBezTo>
                  <a:pt x="3059" y="1568"/>
                  <a:pt x="3043" y="1576"/>
                  <a:pt x="3027" y="1592"/>
                </a:cubicBezTo>
                <a:cubicBezTo>
                  <a:pt x="3008" y="1611"/>
                  <a:pt x="2998" y="1628"/>
                  <a:pt x="2996" y="1642"/>
                </a:cubicBezTo>
                <a:cubicBezTo>
                  <a:pt x="2994" y="1657"/>
                  <a:pt x="2998" y="1668"/>
                  <a:pt x="3006" y="1677"/>
                </a:cubicBezTo>
                <a:cubicBezTo>
                  <a:pt x="3011" y="1682"/>
                  <a:pt x="3018" y="1685"/>
                  <a:pt x="3026" y="1686"/>
                </a:cubicBezTo>
                <a:cubicBezTo>
                  <a:pt x="3033" y="1687"/>
                  <a:pt x="3042" y="1685"/>
                  <a:pt x="3052" y="1681"/>
                </a:cubicBezTo>
                <a:cubicBezTo>
                  <a:pt x="3058" y="1679"/>
                  <a:pt x="3074" y="1670"/>
                  <a:pt x="3099" y="1655"/>
                </a:cubicBezTo>
                <a:cubicBezTo>
                  <a:pt x="3136" y="1634"/>
                  <a:pt x="3163" y="1620"/>
                  <a:pt x="3180" y="1613"/>
                </a:cubicBezTo>
                <a:cubicBezTo>
                  <a:pt x="3196" y="1607"/>
                  <a:pt x="3212" y="1605"/>
                  <a:pt x="3229" y="1608"/>
                </a:cubicBezTo>
                <a:cubicBezTo>
                  <a:pt x="3245" y="1611"/>
                  <a:pt x="3260" y="1619"/>
                  <a:pt x="3274" y="1633"/>
                </a:cubicBezTo>
                <a:cubicBezTo>
                  <a:pt x="3287" y="1647"/>
                  <a:pt x="3296" y="1664"/>
                  <a:pt x="3300" y="1684"/>
                </a:cubicBezTo>
                <a:cubicBezTo>
                  <a:pt x="3305" y="1704"/>
                  <a:pt x="3302" y="1725"/>
                  <a:pt x="3294" y="1747"/>
                </a:cubicBezTo>
                <a:cubicBezTo>
                  <a:pt x="3285" y="1769"/>
                  <a:pt x="3272" y="1789"/>
                  <a:pt x="3253" y="1808"/>
                </a:cubicBezTo>
                <a:cubicBezTo>
                  <a:pt x="3221" y="1840"/>
                  <a:pt x="3190" y="1858"/>
                  <a:pt x="3161" y="1861"/>
                </a:cubicBezTo>
                <a:cubicBezTo>
                  <a:pt x="3131" y="1864"/>
                  <a:pt x="3101" y="1856"/>
                  <a:pt x="3070" y="1834"/>
                </a:cubicBezTo>
                <a:close/>
                <a:moveTo>
                  <a:pt x="3541" y="1509"/>
                </a:moveTo>
                <a:lnTo>
                  <a:pt x="3500" y="1550"/>
                </a:lnTo>
                <a:lnTo>
                  <a:pt x="3237" y="1287"/>
                </a:lnTo>
                <a:cubicBezTo>
                  <a:pt x="3236" y="1307"/>
                  <a:pt x="3233" y="1329"/>
                  <a:pt x="3226" y="1355"/>
                </a:cubicBezTo>
                <a:cubicBezTo>
                  <a:pt x="3220" y="1380"/>
                  <a:pt x="3212" y="1402"/>
                  <a:pt x="3204" y="1420"/>
                </a:cubicBezTo>
                <a:lnTo>
                  <a:pt x="3164" y="1380"/>
                </a:lnTo>
                <a:cubicBezTo>
                  <a:pt x="3176" y="1346"/>
                  <a:pt x="3183" y="1312"/>
                  <a:pt x="3185" y="1280"/>
                </a:cubicBezTo>
                <a:cubicBezTo>
                  <a:pt x="3187" y="1247"/>
                  <a:pt x="3184" y="1220"/>
                  <a:pt x="3177" y="1198"/>
                </a:cubicBezTo>
                <a:lnTo>
                  <a:pt x="3204" y="1171"/>
                </a:lnTo>
                <a:lnTo>
                  <a:pt x="3541" y="1509"/>
                </a:lnTo>
                <a:close/>
                <a:moveTo>
                  <a:pt x="3499" y="974"/>
                </a:moveTo>
                <a:lnTo>
                  <a:pt x="3452" y="926"/>
                </a:lnTo>
                <a:lnTo>
                  <a:pt x="3493" y="885"/>
                </a:lnTo>
                <a:lnTo>
                  <a:pt x="3540" y="932"/>
                </a:lnTo>
                <a:lnTo>
                  <a:pt x="3499" y="974"/>
                </a:lnTo>
                <a:close/>
                <a:moveTo>
                  <a:pt x="3788" y="1262"/>
                </a:moveTo>
                <a:lnTo>
                  <a:pt x="3544" y="1019"/>
                </a:lnTo>
                <a:lnTo>
                  <a:pt x="3585" y="978"/>
                </a:lnTo>
                <a:lnTo>
                  <a:pt x="3829" y="1221"/>
                </a:lnTo>
                <a:lnTo>
                  <a:pt x="3788" y="1262"/>
                </a:lnTo>
                <a:close/>
                <a:moveTo>
                  <a:pt x="3900" y="1150"/>
                </a:moveTo>
                <a:lnTo>
                  <a:pt x="3564" y="814"/>
                </a:lnTo>
                <a:lnTo>
                  <a:pt x="3691" y="687"/>
                </a:lnTo>
                <a:cubicBezTo>
                  <a:pt x="3713" y="665"/>
                  <a:pt x="3731" y="649"/>
                  <a:pt x="3745" y="639"/>
                </a:cubicBezTo>
                <a:cubicBezTo>
                  <a:pt x="3764" y="625"/>
                  <a:pt x="3784" y="617"/>
                  <a:pt x="3802" y="613"/>
                </a:cubicBezTo>
                <a:cubicBezTo>
                  <a:pt x="3821" y="610"/>
                  <a:pt x="3841" y="612"/>
                  <a:pt x="3862" y="619"/>
                </a:cubicBezTo>
                <a:cubicBezTo>
                  <a:pt x="3882" y="626"/>
                  <a:pt x="3901" y="638"/>
                  <a:pt x="3918" y="654"/>
                </a:cubicBezTo>
                <a:cubicBezTo>
                  <a:pt x="3946" y="683"/>
                  <a:pt x="3961" y="716"/>
                  <a:pt x="3963" y="754"/>
                </a:cubicBezTo>
                <a:cubicBezTo>
                  <a:pt x="3965" y="792"/>
                  <a:pt x="3942" y="835"/>
                  <a:pt x="3894" y="883"/>
                </a:cubicBezTo>
                <a:lnTo>
                  <a:pt x="3808" y="969"/>
                </a:lnTo>
                <a:lnTo>
                  <a:pt x="3945" y="1105"/>
                </a:lnTo>
                <a:lnTo>
                  <a:pt x="3900" y="1150"/>
                </a:lnTo>
                <a:close/>
                <a:moveTo>
                  <a:pt x="3768" y="929"/>
                </a:moveTo>
                <a:lnTo>
                  <a:pt x="3855" y="842"/>
                </a:lnTo>
                <a:cubicBezTo>
                  <a:pt x="3884" y="813"/>
                  <a:pt x="3899" y="788"/>
                  <a:pt x="3900" y="765"/>
                </a:cubicBezTo>
                <a:cubicBezTo>
                  <a:pt x="3902" y="742"/>
                  <a:pt x="3893" y="721"/>
                  <a:pt x="3873" y="702"/>
                </a:cubicBezTo>
                <a:cubicBezTo>
                  <a:pt x="3859" y="688"/>
                  <a:pt x="3844" y="679"/>
                  <a:pt x="3827" y="676"/>
                </a:cubicBezTo>
                <a:cubicBezTo>
                  <a:pt x="3809" y="673"/>
                  <a:pt x="3793" y="676"/>
                  <a:pt x="3779" y="684"/>
                </a:cubicBezTo>
                <a:cubicBezTo>
                  <a:pt x="3769" y="690"/>
                  <a:pt x="3754" y="703"/>
                  <a:pt x="3734" y="723"/>
                </a:cubicBezTo>
                <a:lnTo>
                  <a:pt x="3648" y="809"/>
                </a:lnTo>
                <a:lnTo>
                  <a:pt x="3768" y="929"/>
                </a:lnTo>
                <a:close/>
                <a:moveTo>
                  <a:pt x="4088" y="746"/>
                </a:moveTo>
                <a:lnTo>
                  <a:pt x="4126" y="700"/>
                </a:lnTo>
                <a:cubicBezTo>
                  <a:pt x="4145" y="715"/>
                  <a:pt x="4164" y="724"/>
                  <a:pt x="4182" y="728"/>
                </a:cubicBezTo>
                <a:cubicBezTo>
                  <a:pt x="4200" y="731"/>
                  <a:pt x="4220" y="729"/>
                  <a:pt x="4242" y="720"/>
                </a:cubicBezTo>
                <a:cubicBezTo>
                  <a:pt x="4264" y="711"/>
                  <a:pt x="4284" y="698"/>
                  <a:pt x="4303" y="678"/>
                </a:cubicBezTo>
                <a:cubicBezTo>
                  <a:pt x="4320" y="661"/>
                  <a:pt x="4333" y="644"/>
                  <a:pt x="4341" y="626"/>
                </a:cubicBezTo>
                <a:cubicBezTo>
                  <a:pt x="4349" y="608"/>
                  <a:pt x="4351" y="591"/>
                  <a:pt x="4349" y="576"/>
                </a:cubicBezTo>
                <a:cubicBezTo>
                  <a:pt x="4346" y="561"/>
                  <a:pt x="4340" y="548"/>
                  <a:pt x="4330" y="538"/>
                </a:cubicBezTo>
                <a:cubicBezTo>
                  <a:pt x="4319" y="527"/>
                  <a:pt x="4307" y="521"/>
                  <a:pt x="4293" y="519"/>
                </a:cubicBezTo>
                <a:cubicBezTo>
                  <a:pt x="4279" y="518"/>
                  <a:pt x="4262" y="521"/>
                  <a:pt x="4243" y="530"/>
                </a:cubicBezTo>
                <a:cubicBezTo>
                  <a:pt x="4230" y="535"/>
                  <a:pt x="4205" y="550"/>
                  <a:pt x="4166" y="573"/>
                </a:cubicBezTo>
                <a:cubicBezTo>
                  <a:pt x="4128" y="597"/>
                  <a:pt x="4100" y="611"/>
                  <a:pt x="4081" y="617"/>
                </a:cubicBezTo>
                <a:cubicBezTo>
                  <a:pt x="4056" y="625"/>
                  <a:pt x="4034" y="626"/>
                  <a:pt x="4013" y="622"/>
                </a:cubicBezTo>
                <a:cubicBezTo>
                  <a:pt x="3993" y="617"/>
                  <a:pt x="3975" y="607"/>
                  <a:pt x="3960" y="592"/>
                </a:cubicBezTo>
                <a:cubicBezTo>
                  <a:pt x="3943" y="575"/>
                  <a:pt x="3932" y="554"/>
                  <a:pt x="3927" y="530"/>
                </a:cubicBezTo>
                <a:cubicBezTo>
                  <a:pt x="3922" y="505"/>
                  <a:pt x="3924" y="480"/>
                  <a:pt x="3935" y="454"/>
                </a:cubicBezTo>
                <a:cubicBezTo>
                  <a:pt x="3946" y="428"/>
                  <a:pt x="3963" y="404"/>
                  <a:pt x="3985" y="381"/>
                </a:cubicBezTo>
                <a:cubicBezTo>
                  <a:pt x="4010" y="356"/>
                  <a:pt x="4036" y="338"/>
                  <a:pt x="4063" y="327"/>
                </a:cubicBezTo>
                <a:cubicBezTo>
                  <a:pt x="4090" y="316"/>
                  <a:pt x="4117" y="313"/>
                  <a:pt x="4143" y="319"/>
                </a:cubicBezTo>
                <a:cubicBezTo>
                  <a:pt x="4169" y="324"/>
                  <a:pt x="4192" y="336"/>
                  <a:pt x="4212" y="355"/>
                </a:cubicBezTo>
                <a:lnTo>
                  <a:pt x="4173" y="401"/>
                </a:lnTo>
                <a:cubicBezTo>
                  <a:pt x="4149" y="382"/>
                  <a:pt x="4125" y="374"/>
                  <a:pt x="4101" y="376"/>
                </a:cubicBezTo>
                <a:cubicBezTo>
                  <a:pt x="4077" y="378"/>
                  <a:pt x="4052" y="392"/>
                  <a:pt x="4027" y="418"/>
                </a:cubicBezTo>
                <a:cubicBezTo>
                  <a:pt x="4000" y="445"/>
                  <a:pt x="3985" y="470"/>
                  <a:pt x="3982" y="492"/>
                </a:cubicBezTo>
                <a:cubicBezTo>
                  <a:pt x="3980" y="514"/>
                  <a:pt x="3986" y="532"/>
                  <a:pt x="4000" y="546"/>
                </a:cubicBezTo>
                <a:cubicBezTo>
                  <a:pt x="4012" y="558"/>
                  <a:pt x="4026" y="564"/>
                  <a:pt x="4043" y="563"/>
                </a:cubicBezTo>
                <a:cubicBezTo>
                  <a:pt x="4059" y="562"/>
                  <a:pt x="4089" y="548"/>
                  <a:pt x="4134" y="520"/>
                </a:cubicBezTo>
                <a:cubicBezTo>
                  <a:pt x="4178" y="492"/>
                  <a:pt x="4210" y="474"/>
                  <a:pt x="4229" y="467"/>
                </a:cubicBezTo>
                <a:cubicBezTo>
                  <a:pt x="4258" y="456"/>
                  <a:pt x="4284" y="453"/>
                  <a:pt x="4307" y="458"/>
                </a:cubicBezTo>
                <a:cubicBezTo>
                  <a:pt x="4330" y="462"/>
                  <a:pt x="4351" y="473"/>
                  <a:pt x="4369" y="491"/>
                </a:cubicBezTo>
                <a:cubicBezTo>
                  <a:pt x="4387" y="509"/>
                  <a:pt x="4398" y="531"/>
                  <a:pt x="4404" y="557"/>
                </a:cubicBezTo>
                <a:cubicBezTo>
                  <a:pt x="4410" y="583"/>
                  <a:pt x="4407" y="610"/>
                  <a:pt x="4397" y="638"/>
                </a:cubicBezTo>
                <a:cubicBezTo>
                  <a:pt x="4386" y="666"/>
                  <a:pt x="4369" y="692"/>
                  <a:pt x="4345" y="716"/>
                </a:cubicBezTo>
                <a:cubicBezTo>
                  <a:pt x="4315" y="747"/>
                  <a:pt x="4285" y="768"/>
                  <a:pt x="4255" y="779"/>
                </a:cubicBezTo>
                <a:cubicBezTo>
                  <a:pt x="4226" y="791"/>
                  <a:pt x="4197" y="794"/>
                  <a:pt x="4167" y="788"/>
                </a:cubicBezTo>
                <a:cubicBezTo>
                  <a:pt x="4138" y="782"/>
                  <a:pt x="4111" y="768"/>
                  <a:pt x="4088" y="746"/>
                </a:cubicBezTo>
                <a:close/>
                <a:moveTo>
                  <a:pt x="4423" y="451"/>
                </a:moveTo>
                <a:lnTo>
                  <a:pt x="4463" y="404"/>
                </a:lnTo>
                <a:cubicBezTo>
                  <a:pt x="4487" y="422"/>
                  <a:pt x="4511" y="430"/>
                  <a:pt x="4533" y="429"/>
                </a:cubicBezTo>
                <a:cubicBezTo>
                  <a:pt x="4555" y="428"/>
                  <a:pt x="4575" y="419"/>
                  <a:pt x="4591" y="402"/>
                </a:cubicBezTo>
                <a:cubicBezTo>
                  <a:pt x="4611" y="383"/>
                  <a:pt x="4620" y="358"/>
                  <a:pt x="4619" y="330"/>
                </a:cubicBezTo>
                <a:cubicBezTo>
                  <a:pt x="4618" y="301"/>
                  <a:pt x="4605" y="274"/>
                  <a:pt x="4580" y="249"/>
                </a:cubicBezTo>
                <a:cubicBezTo>
                  <a:pt x="4557" y="226"/>
                  <a:pt x="4531" y="214"/>
                  <a:pt x="4505" y="213"/>
                </a:cubicBezTo>
                <a:cubicBezTo>
                  <a:pt x="4478" y="213"/>
                  <a:pt x="4454" y="224"/>
                  <a:pt x="4432" y="245"/>
                </a:cubicBezTo>
                <a:cubicBezTo>
                  <a:pt x="4419" y="258"/>
                  <a:pt x="4410" y="273"/>
                  <a:pt x="4405" y="290"/>
                </a:cubicBezTo>
                <a:cubicBezTo>
                  <a:pt x="4401" y="307"/>
                  <a:pt x="4400" y="323"/>
                  <a:pt x="4404" y="339"/>
                </a:cubicBezTo>
                <a:lnTo>
                  <a:pt x="4360" y="372"/>
                </a:lnTo>
                <a:lnTo>
                  <a:pt x="4220" y="167"/>
                </a:lnTo>
                <a:lnTo>
                  <a:pt x="4387" y="0"/>
                </a:lnTo>
                <a:lnTo>
                  <a:pt x="4426" y="40"/>
                </a:lnTo>
                <a:lnTo>
                  <a:pt x="4292" y="174"/>
                </a:lnTo>
                <a:lnTo>
                  <a:pt x="4364" y="282"/>
                </a:lnTo>
                <a:cubicBezTo>
                  <a:pt x="4371" y="248"/>
                  <a:pt x="4385" y="220"/>
                  <a:pt x="4407" y="198"/>
                </a:cubicBezTo>
                <a:cubicBezTo>
                  <a:pt x="4436" y="168"/>
                  <a:pt x="4471" y="154"/>
                  <a:pt x="4512" y="154"/>
                </a:cubicBezTo>
                <a:cubicBezTo>
                  <a:pt x="4552" y="154"/>
                  <a:pt x="4588" y="170"/>
                  <a:pt x="4620" y="202"/>
                </a:cubicBezTo>
                <a:cubicBezTo>
                  <a:pt x="4651" y="232"/>
                  <a:pt x="4668" y="267"/>
                  <a:pt x="4673" y="307"/>
                </a:cubicBezTo>
                <a:cubicBezTo>
                  <a:pt x="4678" y="356"/>
                  <a:pt x="4662" y="399"/>
                  <a:pt x="4625" y="436"/>
                </a:cubicBezTo>
                <a:cubicBezTo>
                  <a:pt x="4594" y="467"/>
                  <a:pt x="4561" y="483"/>
                  <a:pt x="4525" y="486"/>
                </a:cubicBezTo>
                <a:cubicBezTo>
                  <a:pt x="4488" y="488"/>
                  <a:pt x="4454" y="476"/>
                  <a:pt x="4423" y="451"/>
                </a:cubicBez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94" name="Freeform 76"/>
          <p:cNvSpPr>
            <a:spLocks noEditPoints="1"/>
          </p:cNvSpPr>
          <p:nvPr/>
        </p:nvSpPr>
        <p:spPr bwMode="auto">
          <a:xfrm>
            <a:off x="4935715" y="4613062"/>
            <a:ext cx="889000" cy="889000"/>
          </a:xfrm>
          <a:custGeom>
            <a:avLst/>
            <a:gdLst>
              <a:gd name="T0" fmla="*/ 238 w 4666"/>
              <a:gd name="T1" fmla="*/ 4131 h 4668"/>
              <a:gd name="T2" fmla="*/ 244 w 4666"/>
              <a:gd name="T3" fmla="*/ 4487 h 4668"/>
              <a:gd name="T4" fmla="*/ 336 w 4666"/>
              <a:gd name="T5" fmla="*/ 4283 h 4668"/>
              <a:gd name="T6" fmla="*/ 84 w 4666"/>
              <a:gd name="T7" fmla="*/ 4327 h 4668"/>
              <a:gd name="T8" fmla="*/ 513 w 4666"/>
              <a:gd name="T9" fmla="*/ 3839 h 4668"/>
              <a:gd name="T10" fmla="*/ 740 w 4666"/>
              <a:gd name="T11" fmla="*/ 3967 h 4668"/>
              <a:gd name="T12" fmla="*/ 779 w 4666"/>
              <a:gd name="T13" fmla="*/ 4225 h 4668"/>
              <a:gd name="T14" fmla="*/ 620 w 4666"/>
              <a:gd name="T15" fmla="*/ 3952 h 4668"/>
              <a:gd name="T16" fmla="*/ 399 w 4666"/>
              <a:gd name="T17" fmla="*/ 4012 h 4668"/>
              <a:gd name="T18" fmla="*/ 784 w 4666"/>
              <a:gd name="T19" fmla="*/ 4118 h 4668"/>
              <a:gd name="T20" fmla="*/ 618 w 4666"/>
              <a:gd name="T21" fmla="*/ 4075 h 4668"/>
              <a:gd name="T22" fmla="*/ 743 w 4666"/>
              <a:gd name="T23" fmla="*/ 3588 h 4668"/>
              <a:gd name="T24" fmla="*/ 1131 w 4666"/>
              <a:gd name="T25" fmla="*/ 3669 h 4668"/>
              <a:gd name="T26" fmla="*/ 964 w 4666"/>
              <a:gd name="T27" fmla="*/ 4040 h 4668"/>
              <a:gd name="T28" fmla="*/ 1081 w 4666"/>
              <a:gd name="T29" fmla="*/ 3711 h 4668"/>
              <a:gd name="T30" fmla="*/ 712 w 4666"/>
              <a:gd name="T31" fmla="*/ 3699 h 4668"/>
              <a:gd name="T32" fmla="*/ 1627 w 4666"/>
              <a:gd name="T33" fmla="*/ 3563 h 4668"/>
              <a:gd name="T34" fmla="*/ 1414 w 4666"/>
              <a:gd name="T35" fmla="*/ 2924 h 4668"/>
              <a:gd name="T36" fmla="*/ 1563 w 4666"/>
              <a:gd name="T37" fmla="*/ 3167 h 4668"/>
              <a:gd name="T38" fmla="*/ 1524 w 4666"/>
              <a:gd name="T39" fmla="*/ 3127 h 4668"/>
              <a:gd name="T40" fmla="*/ 1403 w 4666"/>
              <a:gd name="T41" fmla="*/ 3008 h 4668"/>
              <a:gd name="T42" fmla="*/ 1788 w 4666"/>
              <a:gd name="T43" fmla="*/ 2543 h 4668"/>
              <a:gd name="T44" fmla="*/ 1957 w 4666"/>
              <a:gd name="T45" fmla="*/ 2738 h 4668"/>
              <a:gd name="T46" fmla="*/ 1881 w 4666"/>
              <a:gd name="T47" fmla="*/ 3122 h 4668"/>
              <a:gd name="T48" fmla="*/ 2042 w 4666"/>
              <a:gd name="T49" fmla="*/ 2462 h 4668"/>
              <a:gd name="T50" fmla="*/ 2166 w 4666"/>
              <a:gd name="T51" fmla="*/ 2482 h 4668"/>
              <a:gd name="T52" fmla="*/ 2183 w 4666"/>
              <a:gd name="T53" fmla="*/ 2586 h 4668"/>
              <a:gd name="T54" fmla="*/ 2342 w 4666"/>
              <a:gd name="T55" fmla="*/ 2135 h 4668"/>
              <a:gd name="T56" fmla="*/ 2283 w 4666"/>
              <a:gd name="T57" fmla="*/ 2046 h 4668"/>
              <a:gd name="T58" fmla="*/ 2562 w 4666"/>
              <a:gd name="T59" fmla="*/ 1954 h 4668"/>
              <a:gd name="T60" fmla="*/ 2742 w 4666"/>
              <a:gd name="T61" fmla="*/ 1849 h 4668"/>
              <a:gd name="T62" fmla="*/ 3057 w 4666"/>
              <a:gd name="T63" fmla="*/ 1946 h 4668"/>
              <a:gd name="T64" fmla="*/ 2775 w 4666"/>
              <a:gd name="T65" fmla="*/ 1836 h 4668"/>
              <a:gd name="T66" fmla="*/ 2704 w 4666"/>
              <a:gd name="T67" fmla="*/ 1901 h 4668"/>
              <a:gd name="T68" fmla="*/ 2810 w 4666"/>
              <a:gd name="T69" fmla="*/ 2194 h 4668"/>
              <a:gd name="T70" fmla="*/ 3218 w 4666"/>
              <a:gd name="T71" fmla="*/ 1729 h 4668"/>
              <a:gd name="T72" fmla="*/ 3062 w 4666"/>
              <a:gd name="T73" fmla="*/ 1695 h 4668"/>
              <a:gd name="T74" fmla="*/ 2959 w 4666"/>
              <a:gd name="T75" fmla="*/ 1556 h 4668"/>
              <a:gd name="T76" fmla="*/ 3120 w 4666"/>
              <a:gd name="T77" fmla="*/ 1533 h 4668"/>
              <a:gd name="T78" fmla="*/ 3025 w 4666"/>
              <a:gd name="T79" fmla="*/ 1640 h 4668"/>
              <a:gd name="T80" fmla="*/ 3273 w 4666"/>
              <a:gd name="T81" fmla="*/ 1587 h 4668"/>
              <a:gd name="T82" fmla="*/ 3070 w 4666"/>
              <a:gd name="T83" fmla="*/ 1788 h 4668"/>
              <a:gd name="T84" fmla="*/ 3338 w 4666"/>
              <a:gd name="T85" fmla="*/ 1518 h 4668"/>
              <a:gd name="T86" fmla="*/ 3192 w 4666"/>
              <a:gd name="T87" fmla="*/ 1204 h 4668"/>
              <a:gd name="T88" fmla="*/ 3159 w 4666"/>
              <a:gd name="T89" fmla="*/ 1169 h 4668"/>
              <a:gd name="T90" fmla="*/ 3398 w 4666"/>
              <a:gd name="T91" fmla="*/ 1397 h 4668"/>
              <a:gd name="T92" fmla="*/ 3451 w 4666"/>
              <a:gd name="T93" fmla="*/ 880 h 4668"/>
              <a:gd name="T94" fmla="*/ 3544 w 4666"/>
              <a:gd name="T95" fmla="*/ 973 h 4668"/>
              <a:gd name="T96" fmla="*/ 3563 w 4666"/>
              <a:gd name="T97" fmla="*/ 768 h 4668"/>
              <a:gd name="T98" fmla="*/ 3917 w 4666"/>
              <a:gd name="T99" fmla="*/ 608 h 4668"/>
              <a:gd name="T100" fmla="*/ 3900 w 4666"/>
              <a:gd name="T101" fmla="*/ 1104 h 4668"/>
              <a:gd name="T102" fmla="*/ 3826 w 4666"/>
              <a:gd name="T103" fmla="*/ 630 h 4668"/>
              <a:gd name="T104" fmla="*/ 4088 w 4666"/>
              <a:gd name="T105" fmla="*/ 700 h 4668"/>
              <a:gd name="T106" fmla="*/ 4340 w 4666"/>
              <a:gd name="T107" fmla="*/ 580 h 4668"/>
              <a:gd name="T108" fmla="*/ 4166 w 4666"/>
              <a:gd name="T109" fmla="*/ 527 h 4668"/>
              <a:gd name="T110" fmla="*/ 3935 w 4666"/>
              <a:gd name="T111" fmla="*/ 408 h 4668"/>
              <a:gd name="T112" fmla="*/ 4172 w 4666"/>
              <a:gd name="T113" fmla="*/ 355 h 4668"/>
              <a:gd name="T114" fmla="*/ 4042 w 4666"/>
              <a:gd name="T115" fmla="*/ 517 h 4668"/>
              <a:gd name="T116" fmla="*/ 4403 w 4666"/>
              <a:gd name="T117" fmla="*/ 511 h 4668"/>
              <a:gd name="T118" fmla="*/ 4088 w 4666"/>
              <a:gd name="T119" fmla="*/ 700 h 4668"/>
              <a:gd name="T120" fmla="*/ 4329 w 4666"/>
              <a:gd name="T121" fmla="*/ 248 h 4668"/>
              <a:gd name="T122" fmla="*/ 4666 w 4666"/>
              <a:gd name="T123" fmla="*/ 337 h 466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  <a:cxn ang="0">
                <a:pos x="T122" y="T123"/>
              </a:cxn>
            </a:cxnLst>
            <a:rect l="0" t="0" r="r" b="b"/>
            <a:pathLst>
              <a:path w="4666" h="4668">
                <a:moveTo>
                  <a:pt x="336" y="4668"/>
                </a:moveTo>
                <a:lnTo>
                  <a:pt x="0" y="4332"/>
                </a:lnTo>
                <a:lnTo>
                  <a:pt x="126" y="4205"/>
                </a:lnTo>
                <a:cubicBezTo>
                  <a:pt x="149" y="4182"/>
                  <a:pt x="167" y="4167"/>
                  <a:pt x="181" y="4157"/>
                </a:cubicBezTo>
                <a:cubicBezTo>
                  <a:pt x="200" y="4143"/>
                  <a:pt x="219" y="4135"/>
                  <a:pt x="238" y="4131"/>
                </a:cubicBezTo>
                <a:cubicBezTo>
                  <a:pt x="257" y="4128"/>
                  <a:pt x="277" y="4129"/>
                  <a:pt x="297" y="4137"/>
                </a:cubicBezTo>
                <a:cubicBezTo>
                  <a:pt x="318" y="4144"/>
                  <a:pt x="337" y="4156"/>
                  <a:pt x="353" y="4172"/>
                </a:cubicBezTo>
                <a:cubicBezTo>
                  <a:pt x="382" y="4201"/>
                  <a:pt x="397" y="4234"/>
                  <a:pt x="399" y="4272"/>
                </a:cubicBezTo>
                <a:cubicBezTo>
                  <a:pt x="400" y="4310"/>
                  <a:pt x="377" y="4353"/>
                  <a:pt x="330" y="4400"/>
                </a:cubicBezTo>
                <a:lnTo>
                  <a:pt x="244" y="4487"/>
                </a:lnTo>
                <a:lnTo>
                  <a:pt x="380" y="4623"/>
                </a:lnTo>
                <a:lnTo>
                  <a:pt x="336" y="4668"/>
                </a:lnTo>
                <a:close/>
                <a:moveTo>
                  <a:pt x="204" y="4447"/>
                </a:moveTo>
                <a:lnTo>
                  <a:pt x="291" y="4360"/>
                </a:lnTo>
                <a:cubicBezTo>
                  <a:pt x="320" y="4331"/>
                  <a:pt x="335" y="4306"/>
                  <a:pt x="336" y="4283"/>
                </a:cubicBezTo>
                <a:cubicBezTo>
                  <a:pt x="337" y="4260"/>
                  <a:pt x="328" y="4239"/>
                  <a:pt x="309" y="4219"/>
                </a:cubicBezTo>
                <a:cubicBezTo>
                  <a:pt x="295" y="4205"/>
                  <a:pt x="279" y="4197"/>
                  <a:pt x="262" y="4194"/>
                </a:cubicBezTo>
                <a:cubicBezTo>
                  <a:pt x="245" y="4191"/>
                  <a:pt x="229" y="4194"/>
                  <a:pt x="214" y="4202"/>
                </a:cubicBezTo>
                <a:cubicBezTo>
                  <a:pt x="205" y="4208"/>
                  <a:pt x="190" y="4221"/>
                  <a:pt x="170" y="4241"/>
                </a:cubicBezTo>
                <a:lnTo>
                  <a:pt x="84" y="4327"/>
                </a:lnTo>
                <a:lnTo>
                  <a:pt x="204" y="4447"/>
                </a:lnTo>
                <a:close/>
                <a:moveTo>
                  <a:pt x="651" y="4353"/>
                </a:moveTo>
                <a:lnTo>
                  <a:pt x="315" y="4017"/>
                </a:lnTo>
                <a:lnTo>
                  <a:pt x="441" y="3891"/>
                </a:lnTo>
                <a:cubicBezTo>
                  <a:pt x="466" y="3865"/>
                  <a:pt x="490" y="3848"/>
                  <a:pt x="513" y="3839"/>
                </a:cubicBezTo>
                <a:cubicBezTo>
                  <a:pt x="535" y="3830"/>
                  <a:pt x="558" y="3829"/>
                  <a:pt x="581" y="3834"/>
                </a:cubicBezTo>
                <a:cubicBezTo>
                  <a:pt x="603" y="3839"/>
                  <a:pt x="623" y="3850"/>
                  <a:pt x="638" y="3865"/>
                </a:cubicBezTo>
                <a:cubicBezTo>
                  <a:pt x="652" y="3879"/>
                  <a:pt x="662" y="3897"/>
                  <a:pt x="667" y="3917"/>
                </a:cubicBezTo>
                <a:cubicBezTo>
                  <a:pt x="672" y="3938"/>
                  <a:pt x="670" y="3960"/>
                  <a:pt x="662" y="3983"/>
                </a:cubicBezTo>
                <a:cubicBezTo>
                  <a:pt x="689" y="3969"/>
                  <a:pt x="714" y="3964"/>
                  <a:pt x="740" y="3967"/>
                </a:cubicBezTo>
                <a:cubicBezTo>
                  <a:pt x="765" y="3970"/>
                  <a:pt x="788" y="3982"/>
                  <a:pt x="807" y="4001"/>
                </a:cubicBezTo>
                <a:cubicBezTo>
                  <a:pt x="823" y="4017"/>
                  <a:pt x="834" y="4035"/>
                  <a:pt x="841" y="4055"/>
                </a:cubicBezTo>
                <a:cubicBezTo>
                  <a:pt x="848" y="4076"/>
                  <a:pt x="850" y="4094"/>
                  <a:pt x="848" y="4111"/>
                </a:cubicBezTo>
                <a:cubicBezTo>
                  <a:pt x="845" y="4128"/>
                  <a:pt x="838" y="4146"/>
                  <a:pt x="827" y="4165"/>
                </a:cubicBezTo>
                <a:cubicBezTo>
                  <a:pt x="816" y="4183"/>
                  <a:pt x="800" y="4203"/>
                  <a:pt x="779" y="4225"/>
                </a:cubicBezTo>
                <a:lnTo>
                  <a:pt x="651" y="4353"/>
                </a:lnTo>
                <a:close/>
                <a:moveTo>
                  <a:pt x="500" y="4113"/>
                </a:moveTo>
                <a:lnTo>
                  <a:pt x="573" y="4041"/>
                </a:lnTo>
                <a:cubicBezTo>
                  <a:pt x="593" y="4021"/>
                  <a:pt x="606" y="4006"/>
                  <a:pt x="612" y="3994"/>
                </a:cubicBezTo>
                <a:cubicBezTo>
                  <a:pt x="619" y="3980"/>
                  <a:pt x="622" y="3966"/>
                  <a:pt x="620" y="3952"/>
                </a:cubicBezTo>
                <a:cubicBezTo>
                  <a:pt x="618" y="3939"/>
                  <a:pt x="611" y="3926"/>
                  <a:pt x="600" y="3914"/>
                </a:cubicBezTo>
                <a:cubicBezTo>
                  <a:pt x="588" y="3903"/>
                  <a:pt x="576" y="3896"/>
                  <a:pt x="562" y="3893"/>
                </a:cubicBezTo>
                <a:cubicBezTo>
                  <a:pt x="548" y="3890"/>
                  <a:pt x="535" y="3891"/>
                  <a:pt x="522" y="3898"/>
                </a:cubicBezTo>
                <a:cubicBezTo>
                  <a:pt x="509" y="3905"/>
                  <a:pt x="490" y="3920"/>
                  <a:pt x="466" y="3945"/>
                </a:cubicBezTo>
                <a:lnTo>
                  <a:pt x="399" y="4012"/>
                </a:lnTo>
                <a:lnTo>
                  <a:pt x="500" y="4113"/>
                </a:lnTo>
                <a:close/>
                <a:moveTo>
                  <a:pt x="656" y="4269"/>
                </a:moveTo>
                <a:lnTo>
                  <a:pt x="739" y="4185"/>
                </a:lnTo>
                <a:cubicBezTo>
                  <a:pt x="754" y="4171"/>
                  <a:pt x="763" y="4160"/>
                  <a:pt x="768" y="4153"/>
                </a:cubicBezTo>
                <a:cubicBezTo>
                  <a:pt x="776" y="4141"/>
                  <a:pt x="782" y="4129"/>
                  <a:pt x="784" y="4118"/>
                </a:cubicBezTo>
                <a:cubicBezTo>
                  <a:pt x="787" y="4107"/>
                  <a:pt x="786" y="4095"/>
                  <a:pt x="783" y="4083"/>
                </a:cubicBezTo>
                <a:cubicBezTo>
                  <a:pt x="779" y="4070"/>
                  <a:pt x="772" y="4058"/>
                  <a:pt x="761" y="4048"/>
                </a:cubicBezTo>
                <a:cubicBezTo>
                  <a:pt x="748" y="4035"/>
                  <a:pt x="734" y="4027"/>
                  <a:pt x="719" y="4025"/>
                </a:cubicBezTo>
                <a:cubicBezTo>
                  <a:pt x="703" y="4022"/>
                  <a:pt x="688" y="4024"/>
                  <a:pt x="672" y="4032"/>
                </a:cubicBezTo>
                <a:cubicBezTo>
                  <a:pt x="657" y="4039"/>
                  <a:pt x="639" y="4054"/>
                  <a:pt x="618" y="4075"/>
                </a:cubicBezTo>
                <a:lnTo>
                  <a:pt x="540" y="4153"/>
                </a:lnTo>
                <a:lnTo>
                  <a:pt x="656" y="4269"/>
                </a:lnTo>
                <a:close/>
                <a:moveTo>
                  <a:pt x="964" y="4040"/>
                </a:moveTo>
                <a:lnTo>
                  <a:pt x="628" y="3704"/>
                </a:lnTo>
                <a:lnTo>
                  <a:pt x="743" y="3588"/>
                </a:lnTo>
                <a:cubicBezTo>
                  <a:pt x="769" y="3562"/>
                  <a:pt x="791" y="3543"/>
                  <a:pt x="808" y="3533"/>
                </a:cubicBezTo>
                <a:cubicBezTo>
                  <a:pt x="832" y="3518"/>
                  <a:pt x="856" y="3510"/>
                  <a:pt x="881" y="3508"/>
                </a:cubicBezTo>
                <a:cubicBezTo>
                  <a:pt x="914" y="3505"/>
                  <a:pt x="946" y="3511"/>
                  <a:pt x="979" y="3525"/>
                </a:cubicBezTo>
                <a:cubicBezTo>
                  <a:pt x="1011" y="3540"/>
                  <a:pt x="1042" y="3562"/>
                  <a:pt x="1072" y="3592"/>
                </a:cubicBezTo>
                <a:cubicBezTo>
                  <a:pt x="1097" y="3618"/>
                  <a:pt x="1117" y="3643"/>
                  <a:pt x="1131" y="3669"/>
                </a:cubicBezTo>
                <a:cubicBezTo>
                  <a:pt x="1144" y="3694"/>
                  <a:pt x="1153" y="3718"/>
                  <a:pt x="1157" y="3741"/>
                </a:cubicBezTo>
                <a:cubicBezTo>
                  <a:pt x="1160" y="3763"/>
                  <a:pt x="1160" y="3783"/>
                  <a:pt x="1156" y="3802"/>
                </a:cubicBezTo>
                <a:cubicBezTo>
                  <a:pt x="1153" y="3820"/>
                  <a:pt x="1145" y="3839"/>
                  <a:pt x="1133" y="3859"/>
                </a:cubicBezTo>
                <a:cubicBezTo>
                  <a:pt x="1121" y="3878"/>
                  <a:pt x="1105" y="3898"/>
                  <a:pt x="1085" y="3918"/>
                </a:cubicBezTo>
                <a:lnTo>
                  <a:pt x="964" y="4040"/>
                </a:lnTo>
                <a:close/>
                <a:moveTo>
                  <a:pt x="968" y="3956"/>
                </a:moveTo>
                <a:lnTo>
                  <a:pt x="1040" y="3884"/>
                </a:lnTo>
                <a:cubicBezTo>
                  <a:pt x="1062" y="3862"/>
                  <a:pt x="1078" y="3842"/>
                  <a:pt x="1086" y="3826"/>
                </a:cubicBezTo>
                <a:cubicBezTo>
                  <a:pt x="1095" y="3809"/>
                  <a:pt x="1099" y="3793"/>
                  <a:pt x="1099" y="3778"/>
                </a:cubicBezTo>
                <a:cubicBezTo>
                  <a:pt x="1099" y="3757"/>
                  <a:pt x="1093" y="3734"/>
                  <a:pt x="1081" y="3711"/>
                </a:cubicBezTo>
                <a:cubicBezTo>
                  <a:pt x="1069" y="3687"/>
                  <a:pt x="1050" y="3663"/>
                  <a:pt x="1025" y="3637"/>
                </a:cubicBezTo>
                <a:cubicBezTo>
                  <a:pt x="990" y="3602"/>
                  <a:pt x="957" y="3581"/>
                  <a:pt x="927" y="3573"/>
                </a:cubicBezTo>
                <a:cubicBezTo>
                  <a:pt x="896" y="3566"/>
                  <a:pt x="870" y="3567"/>
                  <a:pt x="847" y="3578"/>
                </a:cubicBezTo>
                <a:cubicBezTo>
                  <a:pt x="830" y="3585"/>
                  <a:pt x="809" y="3602"/>
                  <a:pt x="782" y="3628"/>
                </a:cubicBezTo>
                <a:lnTo>
                  <a:pt x="712" y="3699"/>
                </a:lnTo>
                <a:lnTo>
                  <a:pt x="968" y="3956"/>
                </a:lnTo>
                <a:close/>
                <a:moveTo>
                  <a:pt x="1353" y="3837"/>
                </a:moveTo>
                <a:lnTo>
                  <a:pt x="1323" y="3807"/>
                </a:lnTo>
                <a:lnTo>
                  <a:pt x="1597" y="3534"/>
                </a:lnTo>
                <a:lnTo>
                  <a:pt x="1627" y="3563"/>
                </a:lnTo>
                <a:lnTo>
                  <a:pt x="1353" y="3837"/>
                </a:lnTo>
                <a:close/>
                <a:moveTo>
                  <a:pt x="1569" y="3434"/>
                </a:moveTo>
                <a:lnTo>
                  <a:pt x="1233" y="3098"/>
                </a:lnTo>
                <a:lnTo>
                  <a:pt x="1360" y="2972"/>
                </a:lnTo>
                <a:cubicBezTo>
                  <a:pt x="1382" y="2949"/>
                  <a:pt x="1400" y="2933"/>
                  <a:pt x="1414" y="2924"/>
                </a:cubicBezTo>
                <a:cubicBezTo>
                  <a:pt x="1433" y="2910"/>
                  <a:pt x="1452" y="2901"/>
                  <a:pt x="1471" y="2898"/>
                </a:cubicBezTo>
                <a:cubicBezTo>
                  <a:pt x="1490" y="2894"/>
                  <a:pt x="1510" y="2896"/>
                  <a:pt x="1531" y="2903"/>
                </a:cubicBezTo>
                <a:cubicBezTo>
                  <a:pt x="1551" y="2910"/>
                  <a:pt x="1570" y="2922"/>
                  <a:pt x="1587" y="2939"/>
                </a:cubicBezTo>
                <a:cubicBezTo>
                  <a:pt x="1615" y="2968"/>
                  <a:pt x="1630" y="3001"/>
                  <a:pt x="1632" y="3039"/>
                </a:cubicBezTo>
                <a:cubicBezTo>
                  <a:pt x="1633" y="3077"/>
                  <a:pt x="1611" y="3120"/>
                  <a:pt x="1563" y="3167"/>
                </a:cubicBezTo>
                <a:lnTo>
                  <a:pt x="1477" y="3253"/>
                </a:lnTo>
                <a:lnTo>
                  <a:pt x="1613" y="3390"/>
                </a:lnTo>
                <a:lnTo>
                  <a:pt x="1569" y="3434"/>
                </a:lnTo>
                <a:close/>
                <a:moveTo>
                  <a:pt x="1437" y="3214"/>
                </a:moveTo>
                <a:lnTo>
                  <a:pt x="1524" y="3127"/>
                </a:lnTo>
                <a:cubicBezTo>
                  <a:pt x="1553" y="3098"/>
                  <a:pt x="1568" y="3072"/>
                  <a:pt x="1569" y="3050"/>
                </a:cubicBezTo>
                <a:cubicBezTo>
                  <a:pt x="1571" y="3027"/>
                  <a:pt x="1562" y="3006"/>
                  <a:pt x="1542" y="2986"/>
                </a:cubicBezTo>
                <a:cubicBezTo>
                  <a:pt x="1528" y="2972"/>
                  <a:pt x="1512" y="2964"/>
                  <a:pt x="1495" y="2961"/>
                </a:cubicBezTo>
                <a:cubicBezTo>
                  <a:pt x="1478" y="2958"/>
                  <a:pt x="1462" y="2961"/>
                  <a:pt x="1447" y="2969"/>
                </a:cubicBezTo>
                <a:cubicBezTo>
                  <a:pt x="1438" y="2975"/>
                  <a:pt x="1423" y="2987"/>
                  <a:pt x="1403" y="3008"/>
                </a:cubicBezTo>
                <a:lnTo>
                  <a:pt x="1317" y="3094"/>
                </a:lnTo>
                <a:lnTo>
                  <a:pt x="1437" y="3214"/>
                </a:lnTo>
                <a:close/>
                <a:moveTo>
                  <a:pt x="1881" y="3122"/>
                </a:moveTo>
                <a:lnTo>
                  <a:pt x="1545" y="2786"/>
                </a:lnTo>
                <a:lnTo>
                  <a:pt x="1788" y="2543"/>
                </a:lnTo>
                <a:lnTo>
                  <a:pt x="1828" y="2583"/>
                </a:lnTo>
                <a:lnTo>
                  <a:pt x="1629" y="2782"/>
                </a:lnTo>
                <a:lnTo>
                  <a:pt x="1732" y="2884"/>
                </a:lnTo>
                <a:lnTo>
                  <a:pt x="1918" y="2699"/>
                </a:lnTo>
                <a:lnTo>
                  <a:pt x="1957" y="2738"/>
                </a:lnTo>
                <a:lnTo>
                  <a:pt x="1771" y="2924"/>
                </a:lnTo>
                <a:lnTo>
                  <a:pt x="1886" y="3038"/>
                </a:lnTo>
                <a:lnTo>
                  <a:pt x="2092" y="2832"/>
                </a:lnTo>
                <a:lnTo>
                  <a:pt x="2132" y="2872"/>
                </a:lnTo>
                <a:lnTo>
                  <a:pt x="1881" y="3122"/>
                </a:lnTo>
                <a:close/>
                <a:moveTo>
                  <a:pt x="2163" y="2841"/>
                </a:moveTo>
                <a:lnTo>
                  <a:pt x="2118" y="2536"/>
                </a:lnTo>
                <a:lnTo>
                  <a:pt x="1842" y="2489"/>
                </a:lnTo>
                <a:lnTo>
                  <a:pt x="1895" y="2436"/>
                </a:lnTo>
                <a:lnTo>
                  <a:pt x="2042" y="2462"/>
                </a:lnTo>
                <a:cubicBezTo>
                  <a:pt x="2073" y="2467"/>
                  <a:pt x="2095" y="2471"/>
                  <a:pt x="2110" y="2476"/>
                </a:cubicBezTo>
                <a:cubicBezTo>
                  <a:pt x="2106" y="2456"/>
                  <a:pt x="2102" y="2434"/>
                  <a:pt x="2099" y="2411"/>
                </a:cubicBezTo>
                <a:lnTo>
                  <a:pt x="2077" y="2254"/>
                </a:lnTo>
                <a:lnTo>
                  <a:pt x="2126" y="2206"/>
                </a:lnTo>
                <a:lnTo>
                  <a:pt x="2166" y="2482"/>
                </a:lnTo>
                <a:lnTo>
                  <a:pt x="2471" y="2533"/>
                </a:lnTo>
                <a:lnTo>
                  <a:pt x="2416" y="2588"/>
                </a:lnTo>
                <a:lnTo>
                  <a:pt x="2211" y="2552"/>
                </a:lnTo>
                <a:cubicBezTo>
                  <a:pt x="2200" y="2550"/>
                  <a:pt x="2187" y="2548"/>
                  <a:pt x="2174" y="2545"/>
                </a:cubicBezTo>
                <a:cubicBezTo>
                  <a:pt x="2179" y="2564"/>
                  <a:pt x="2182" y="2578"/>
                  <a:pt x="2183" y="2586"/>
                </a:cubicBezTo>
                <a:lnTo>
                  <a:pt x="2216" y="2787"/>
                </a:lnTo>
                <a:lnTo>
                  <a:pt x="2163" y="2841"/>
                </a:lnTo>
                <a:close/>
                <a:moveTo>
                  <a:pt x="2647" y="2357"/>
                </a:moveTo>
                <a:lnTo>
                  <a:pt x="2605" y="2398"/>
                </a:lnTo>
                <a:lnTo>
                  <a:pt x="2342" y="2135"/>
                </a:lnTo>
                <a:cubicBezTo>
                  <a:pt x="2342" y="2154"/>
                  <a:pt x="2338" y="2177"/>
                  <a:pt x="2332" y="2203"/>
                </a:cubicBezTo>
                <a:cubicBezTo>
                  <a:pt x="2325" y="2228"/>
                  <a:pt x="2318" y="2250"/>
                  <a:pt x="2310" y="2267"/>
                </a:cubicBezTo>
                <a:lnTo>
                  <a:pt x="2270" y="2227"/>
                </a:lnTo>
                <a:cubicBezTo>
                  <a:pt x="2282" y="2193"/>
                  <a:pt x="2289" y="2160"/>
                  <a:pt x="2291" y="2127"/>
                </a:cubicBezTo>
                <a:cubicBezTo>
                  <a:pt x="2293" y="2095"/>
                  <a:pt x="2290" y="2068"/>
                  <a:pt x="2283" y="2046"/>
                </a:cubicBezTo>
                <a:lnTo>
                  <a:pt x="2309" y="2019"/>
                </a:lnTo>
                <a:lnTo>
                  <a:pt x="2647" y="2357"/>
                </a:lnTo>
                <a:close/>
                <a:moveTo>
                  <a:pt x="2769" y="2235"/>
                </a:moveTo>
                <a:lnTo>
                  <a:pt x="2525" y="1991"/>
                </a:lnTo>
                <a:lnTo>
                  <a:pt x="2562" y="1954"/>
                </a:lnTo>
                <a:lnTo>
                  <a:pt x="2596" y="1989"/>
                </a:lnTo>
                <a:cubicBezTo>
                  <a:pt x="2592" y="1969"/>
                  <a:pt x="2592" y="1949"/>
                  <a:pt x="2598" y="1929"/>
                </a:cubicBezTo>
                <a:cubicBezTo>
                  <a:pt x="2603" y="1909"/>
                  <a:pt x="2614" y="1891"/>
                  <a:pt x="2630" y="1875"/>
                </a:cubicBezTo>
                <a:cubicBezTo>
                  <a:pt x="2648" y="1857"/>
                  <a:pt x="2667" y="1846"/>
                  <a:pt x="2686" y="1842"/>
                </a:cubicBezTo>
                <a:cubicBezTo>
                  <a:pt x="2705" y="1838"/>
                  <a:pt x="2724" y="1840"/>
                  <a:pt x="2742" y="1849"/>
                </a:cubicBezTo>
                <a:cubicBezTo>
                  <a:pt x="2733" y="1801"/>
                  <a:pt x="2743" y="1762"/>
                  <a:pt x="2774" y="1731"/>
                </a:cubicBezTo>
                <a:cubicBezTo>
                  <a:pt x="2798" y="1707"/>
                  <a:pt x="2824" y="1695"/>
                  <a:pt x="2850" y="1695"/>
                </a:cubicBezTo>
                <a:cubicBezTo>
                  <a:pt x="2876" y="1696"/>
                  <a:pt x="2904" y="1710"/>
                  <a:pt x="2931" y="1738"/>
                </a:cubicBezTo>
                <a:lnTo>
                  <a:pt x="3099" y="1905"/>
                </a:lnTo>
                <a:lnTo>
                  <a:pt x="3057" y="1946"/>
                </a:lnTo>
                <a:lnTo>
                  <a:pt x="2904" y="1793"/>
                </a:lnTo>
                <a:cubicBezTo>
                  <a:pt x="2888" y="1776"/>
                  <a:pt x="2874" y="1766"/>
                  <a:pt x="2864" y="1761"/>
                </a:cubicBezTo>
                <a:cubicBezTo>
                  <a:pt x="2854" y="1756"/>
                  <a:pt x="2844" y="1755"/>
                  <a:pt x="2832" y="1758"/>
                </a:cubicBezTo>
                <a:cubicBezTo>
                  <a:pt x="2821" y="1761"/>
                  <a:pt x="2810" y="1767"/>
                  <a:pt x="2801" y="1776"/>
                </a:cubicBezTo>
                <a:cubicBezTo>
                  <a:pt x="2784" y="1793"/>
                  <a:pt x="2775" y="1813"/>
                  <a:pt x="2775" y="1836"/>
                </a:cubicBezTo>
                <a:cubicBezTo>
                  <a:pt x="2775" y="1858"/>
                  <a:pt x="2788" y="1882"/>
                  <a:pt x="2813" y="1907"/>
                </a:cubicBezTo>
                <a:lnTo>
                  <a:pt x="2955" y="2049"/>
                </a:lnTo>
                <a:lnTo>
                  <a:pt x="2913" y="2090"/>
                </a:lnTo>
                <a:lnTo>
                  <a:pt x="2755" y="1932"/>
                </a:lnTo>
                <a:cubicBezTo>
                  <a:pt x="2737" y="1914"/>
                  <a:pt x="2720" y="1903"/>
                  <a:pt x="2704" y="1901"/>
                </a:cubicBezTo>
                <a:cubicBezTo>
                  <a:pt x="2688" y="1898"/>
                  <a:pt x="2672" y="1905"/>
                  <a:pt x="2657" y="1920"/>
                </a:cubicBezTo>
                <a:cubicBezTo>
                  <a:pt x="2645" y="1932"/>
                  <a:pt x="2638" y="1945"/>
                  <a:pt x="2634" y="1961"/>
                </a:cubicBezTo>
                <a:cubicBezTo>
                  <a:pt x="2630" y="1977"/>
                  <a:pt x="2632" y="1993"/>
                  <a:pt x="2639" y="2010"/>
                </a:cubicBezTo>
                <a:cubicBezTo>
                  <a:pt x="2647" y="2026"/>
                  <a:pt x="2661" y="2045"/>
                  <a:pt x="2684" y="2067"/>
                </a:cubicBezTo>
                <a:lnTo>
                  <a:pt x="2810" y="2194"/>
                </a:lnTo>
                <a:lnTo>
                  <a:pt x="2769" y="2235"/>
                </a:lnTo>
                <a:close/>
                <a:moveTo>
                  <a:pt x="3070" y="1788"/>
                </a:moveTo>
                <a:lnTo>
                  <a:pt x="3104" y="1741"/>
                </a:lnTo>
                <a:cubicBezTo>
                  <a:pt x="3123" y="1755"/>
                  <a:pt x="3142" y="1761"/>
                  <a:pt x="3161" y="1760"/>
                </a:cubicBezTo>
                <a:cubicBezTo>
                  <a:pt x="3180" y="1758"/>
                  <a:pt x="3199" y="1748"/>
                  <a:pt x="3218" y="1729"/>
                </a:cubicBezTo>
                <a:cubicBezTo>
                  <a:pt x="3237" y="1710"/>
                  <a:pt x="3247" y="1692"/>
                  <a:pt x="3248" y="1675"/>
                </a:cubicBezTo>
                <a:cubicBezTo>
                  <a:pt x="3250" y="1658"/>
                  <a:pt x="3245" y="1644"/>
                  <a:pt x="3235" y="1634"/>
                </a:cubicBezTo>
                <a:cubicBezTo>
                  <a:pt x="3226" y="1625"/>
                  <a:pt x="3214" y="1621"/>
                  <a:pt x="3201" y="1624"/>
                </a:cubicBezTo>
                <a:cubicBezTo>
                  <a:pt x="3192" y="1626"/>
                  <a:pt x="3173" y="1636"/>
                  <a:pt x="3145" y="1652"/>
                </a:cubicBezTo>
                <a:cubicBezTo>
                  <a:pt x="3107" y="1675"/>
                  <a:pt x="3079" y="1689"/>
                  <a:pt x="3062" y="1695"/>
                </a:cubicBezTo>
                <a:cubicBezTo>
                  <a:pt x="3045" y="1702"/>
                  <a:pt x="3028" y="1703"/>
                  <a:pt x="3012" y="1699"/>
                </a:cubicBezTo>
                <a:cubicBezTo>
                  <a:pt x="2996" y="1695"/>
                  <a:pt x="2982" y="1687"/>
                  <a:pt x="2970" y="1675"/>
                </a:cubicBezTo>
                <a:cubicBezTo>
                  <a:pt x="2960" y="1664"/>
                  <a:pt x="2952" y="1652"/>
                  <a:pt x="2948" y="1638"/>
                </a:cubicBezTo>
                <a:cubicBezTo>
                  <a:pt x="2943" y="1623"/>
                  <a:pt x="2943" y="1609"/>
                  <a:pt x="2945" y="1594"/>
                </a:cubicBezTo>
                <a:cubicBezTo>
                  <a:pt x="2947" y="1583"/>
                  <a:pt x="2951" y="1570"/>
                  <a:pt x="2959" y="1556"/>
                </a:cubicBezTo>
                <a:cubicBezTo>
                  <a:pt x="2967" y="1542"/>
                  <a:pt x="2977" y="1528"/>
                  <a:pt x="2990" y="1516"/>
                </a:cubicBezTo>
                <a:cubicBezTo>
                  <a:pt x="3009" y="1496"/>
                  <a:pt x="3029" y="1482"/>
                  <a:pt x="3049" y="1473"/>
                </a:cubicBezTo>
                <a:cubicBezTo>
                  <a:pt x="3068" y="1465"/>
                  <a:pt x="3087" y="1461"/>
                  <a:pt x="3103" y="1464"/>
                </a:cubicBezTo>
                <a:cubicBezTo>
                  <a:pt x="3119" y="1466"/>
                  <a:pt x="3136" y="1474"/>
                  <a:pt x="3155" y="1487"/>
                </a:cubicBezTo>
                <a:lnTo>
                  <a:pt x="3120" y="1533"/>
                </a:lnTo>
                <a:cubicBezTo>
                  <a:pt x="3106" y="1522"/>
                  <a:pt x="3090" y="1518"/>
                  <a:pt x="3075" y="1520"/>
                </a:cubicBezTo>
                <a:cubicBezTo>
                  <a:pt x="3059" y="1522"/>
                  <a:pt x="3043" y="1530"/>
                  <a:pt x="3027" y="1546"/>
                </a:cubicBezTo>
                <a:cubicBezTo>
                  <a:pt x="3008" y="1565"/>
                  <a:pt x="2998" y="1582"/>
                  <a:pt x="2996" y="1596"/>
                </a:cubicBezTo>
                <a:cubicBezTo>
                  <a:pt x="2994" y="1611"/>
                  <a:pt x="2997" y="1622"/>
                  <a:pt x="3006" y="1631"/>
                </a:cubicBezTo>
                <a:cubicBezTo>
                  <a:pt x="3011" y="1636"/>
                  <a:pt x="3017" y="1639"/>
                  <a:pt x="3025" y="1640"/>
                </a:cubicBezTo>
                <a:cubicBezTo>
                  <a:pt x="3033" y="1641"/>
                  <a:pt x="3042" y="1639"/>
                  <a:pt x="3052" y="1635"/>
                </a:cubicBezTo>
                <a:cubicBezTo>
                  <a:pt x="3058" y="1633"/>
                  <a:pt x="3073" y="1624"/>
                  <a:pt x="3099" y="1609"/>
                </a:cubicBezTo>
                <a:cubicBezTo>
                  <a:pt x="3136" y="1588"/>
                  <a:pt x="3163" y="1574"/>
                  <a:pt x="3179" y="1567"/>
                </a:cubicBezTo>
                <a:cubicBezTo>
                  <a:pt x="3196" y="1561"/>
                  <a:pt x="3212" y="1559"/>
                  <a:pt x="3228" y="1562"/>
                </a:cubicBezTo>
                <a:cubicBezTo>
                  <a:pt x="3244" y="1565"/>
                  <a:pt x="3259" y="1573"/>
                  <a:pt x="3273" y="1587"/>
                </a:cubicBezTo>
                <a:cubicBezTo>
                  <a:pt x="3287" y="1601"/>
                  <a:pt x="3296" y="1618"/>
                  <a:pt x="3300" y="1638"/>
                </a:cubicBezTo>
                <a:cubicBezTo>
                  <a:pt x="3304" y="1658"/>
                  <a:pt x="3302" y="1679"/>
                  <a:pt x="3293" y="1701"/>
                </a:cubicBezTo>
                <a:cubicBezTo>
                  <a:pt x="3285" y="1723"/>
                  <a:pt x="3271" y="1743"/>
                  <a:pt x="3252" y="1762"/>
                </a:cubicBezTo>
                <a:cubicBezTo>
                  <a:pt x="3220" y="1794"/>
                  <a:pt x="3190" y="1812"/>
                  <a:pt x="3160" y="1815"/>
                </a:cubicBezTo>
                <a:cubicBezTo>
                  <a:pt x="3130" y="1818"/>
                  <a:pt x="3100" y="1810"/>
                  <a:pt x="3070" y="1788"/>
                </a:cubicBezTo>
                <a:close/>
                <a:moveTo>
                  <a:pt x="3562" y="1362"/>
                </a:moveTo>
                <a:lnTo>
                  <a:pt x="3602" y="1402"/>
                </a:lnTo>
                <a:lnTo>
                  <a:pt x="3380" y="1624"/>
                </a:lnTo>
                <a:cubicBezTo>
                  <a:pt x="3370" y="1614"/>
                  <a:pt x="3362" y="1603"/>
                  <a:pt x="3356" y="1590"/>
                </a:cubicBezTo>
                <a:cubicBezTo>
                  <a:pt x="3346" y="1569"/>
                  <a:pt x="3341" y="1545"/>
                  <a:pt x="3338" y="1518"/>
                </a:cubicBezTo>
                <a:cubicBezTo>
                  <a:pt x="3336" y="1491"/>
                  <a:pt x="3337" y="1456"/>
                  <a:pt x="3341" y="1413"/>
                </a:cubicBezTo>
                <a:cubicBezTo>
                  <a:pt x="3348" y="1347"/>
                  <a:pt x="3349" y="1299"/>
                  <a:pt x="3344" y="1268"/>
                </a:cubicBezTo>
                <a:cubicBezTo>
                  <a:pt x="3340" y="1238"/>
                  <a:pt x="3330" y="1215"/>
                  <a:pt x="3314" y="1199"/>
                </a:cubicBezTo>
                <a:cubicBezTo>
                  <a:pt x="3298" y="1183"/>
                  <a:pt x="3278" y="1175"/>
                  <a:pt x="3255" y="1175"/>
                </a:cubicBezTo>
                <a:cubicBezTo>
                  <a:pt x="3232" y="1176"/>
                  <a:pt x="3211" y="1186"/>
                  <a:pt x="3192" y="1204"/>
                </a:cubicBezTo>
                <a:cubicBezTo>
                  <a:pt x="3173" y="1224"/>
                  <a:pt x="3163" y="1246"/>
                  <a:pt x="3163" y="1270"/>
                </a:cubicBezTo>
                <a:cubicBezTo>
                  <a:pt x="3163" y="1294"/>
                  <a:pt x="3173" y="1316"/>
                  <a:pt x="3194" y="1338"/>
                </a:cubicBezTo>
                <a:lnTo>
                  <a:pt x="3147" y="1376"/>
                </a:lnTo>
                <a:cubicBezTo>
                  <a:pt x="3119" y="1341"/>
                  <a:pt x="3105" y="1306"/>
                  <a:pt x="3108" y="1270"/>
                </a:cubicBezTo>
                <a:cubicBezTo>
                  <a:pt x="3110" y="1235"/>
                  <a:pt x="3127" y="1201"/>
                  <a:pt x="3159" y="1169"/>
                </a:cubicBezTo>
                <a:cubicBezTo>
                  <a:pt x="3191" y="1137"/>
                  <a:pt x="3226" y="1120"/>
                  <a:pt x="3263" y="1120"/>
                </a:cubicBezTo>
                <a:cubicBezTo>
                  <a:pt x="3299" y="1119"/>
                  <a:pt x="3331" y="1131"/>
                  <a:pt x="3357" y="1158"/>
                </a:cubicBezTo>
                <a:cubicBezTo>
                  <a:pt x="3371" y="1171"/>
                  <a:pt x="3381" y="1187"/>
                  <a:pt x="3389" y="1206"/>
                </a:cubicBezTo>
                <a:cubicBezTo>
                  <a:pt x="3396" y="1224"/>
                  <a:pt x="3401" y="1247"/>
                  <a:pt x="3402" y="1274"/>
                </a:cubicBezTo>
                <a:cubicBezTo>
                  <a:pt x="3404" y="1301"/>
                  <a:pt x="3402" y="1342"/>
                  <a:pt x="3398" y="1397"/>
                </a:cubicBezTo>
                <a:cubicBezTo>
                  <a:pt x="3394" y="1442"/>
                  <a:pt x="3392" y="1472"/>
                  <a:pt x="3392" y="1487"/>
                </a:cubicBezTo>
                <a:cubicBezTo>
                  <a:pt x="3393" y="1501"/>
                  <a:pt x="3395" y="1515"/>
                  <a:pt x="3397" y="1527"/>
                </a:cubicBezTo>
                <a:lnTo>
                  <a:pt x="3562" y="1362"/>
                </a:lnTo>
                <a:close/>
                <a:moveTo>
                  <a:pt x="3498" y="928"/>
                </a:moveTo>
                <a:lnTo>
                  <a:pt x="3451" y="880"/>
                </a:lnTo>
                <a:lnTo>
                  <a:pt x="3492" y="839"/>
                </a:lnTo>
                <a:lnTo>
                  <a:pt x="3540" y="886"/>
                </a:lnTo>
                <a:lnTo>
                  <a:pt x="3498" y="928"/>
                </a:lnTo>
                <a:close/>
                <a:moveTo>
                  <a:pt x="3787" y="1216"/>
                </a:moveTo>
                <a:lnTo>
                  <a:pt x="3544" y="973"/>
                </a:lnTo>
                <a:lnTo>
                  <a:pt x="3585" y="932"/>
                </a:lnTo>
                <a:lnTo>
                  <a:pt x="3828" y="1175"/>
                </a:lnTo>
                <a:lnTo>
                  <a:pt x="3787" y="1216"/>
                </a:lnTo>
                <a:close/>
                <a:moveTo>
                  <a:pt x="3900" y="1104"/>
                </a:moveTo>
                <a:lnTo>
                  <a:pt x="3563" y="768"/>
                </a:lnTo>
                <a:lnTo>
                  <a:pt x="3690" y="641"/>
                </a:lnTo>
                <a:cubicBezTo>
                  <a:pt x="3713" y="619"/>
                  <a:pt x="3731" y="603"/>
                  <a:pt x="3745" y="593"/>
                </a:cubicBezTo>
                <a:cubicBezTo>
                  <a:pt x="3764" y="579"/>
                  <a:pt x="3783" y="571"/>
                  <a:pt x="3802" y="567"/>
                </a:cubicBezTo>
                <a:cubicBezTo>
                  <a:pt x="3821" y="564"/>
                  <a:pt x="3840" y="566"/>
                  <a:pt x="3861" y="573"/>
                </a:cubicBezTo>
                <a:cubicBezTo>
                  <a:pt x="3882" y="580"/>
                  <a:pt x="3901" y="592"/>
                  <a:pt x="3917" y="608"/>
                </a:cubicBezTo>
                <a:cubicBezTo>
                  <a:pt x="3946" y="637"/>
                  <a:pt x="3961" y="670"/>
                  <a:pt x="3963" y="708"/>
                </a:cubicBezTo>
                <a:cubicBezTo>
                  <a:pt x="3964" y="746"/>
                  <a:pt x="3941" y="789"/>
                  <a:pt x="3894" y="837"/>
                </a:cubicBezTo>
                <a:lnTo>
                  <a:pt x="3807" y="923"/>
                </a:lnTo>
                <a:lnTo>
                  <a:pt x="3944" y="1059"/>
                </a:lnTo>
                <a:lnTo>
                  <a:pt x="3900" y="1104"/>
                </a:lnTo>
                <a:close/>
                <a:moveTo>
                  <a:pt x="3768" y="883"/>
                </a:moveTo>
                <a:lnTo>
                  <a:pt x="3855" y="796"/>
                </a:lnTo>
                <a:cubicBezTo>
                  <a:pt x="3883" y="767"/>
                  <a:pt x="3898" y="742"/>
                  <a:pt x="3900" y="719"/>
                </a:cubicBezTo>
                <a:cubicBezTo>
                  <a:pt x="3901" y="696"/>
                  <a:pt x="3892" y="675"/>
                  <a:pt x="3873" y="656"/>
                </a:cubicBezTo>
                <a:cubicBezTo>
                  <a:pt x="3859" y="642"/>
                  <a:pt x="3843" y="633"/>
                  <a:pt x="3826" y="630"/>
                </a:cubicBezTo>
                <a:cubicBezTo>
                  <a:pt x="3809" y="627"/>
                  <a:pt x="3793" y="630"/>
                  <a:pt x="3778" y="638"/>
                </a:cubicBezTo>
                <a:cubicBezTo>
                  <a:pt x="3769" y="644"/>
                  <a:pt x="3754" y="657"/>
                  <a:pt x="3734" y="677"/>
                </a:cubicBezTo>
                <a:lnTo>
                  <a:pt x="3648" y="763"/>
                </a:lnTo>
                <a:lnTo>
                  <a:pt x="3768" y="883"/>
                </a:lnTo>
                <a:close/>
                <a:moveTo>
                  <a:pt x="4088" y="700"/>
                </a:moveTo>
                <a:lnTo>
                  <a:pt x="4126" y="654"/>
                </a:lnTo>
                <a:cubicBezTo>
                  <a:pt x="4145" y="669"/>
                  <a:pt x="4163" y="678"/>
                  <a:pt x="4181" y="682"/>
                </a:cubicBezTo>
                <a:cubicBezTo>
                  <a:pt x="4199" y="685"/>
                  <a:pt x="4219" y="683"/>
                  <a:pt x="4241" y="674"/>
                </a:cubicBezTo>
                <a:cubicBezTo>
                  <a:pt x="4263" y="665"/>
                  <a:pt x="4284" y="652"/>
                  <a:pt x="4303" y="632"/>
                </a:cubicBezTo>
                <a:cubicBezTo>
                  <a:pt x="4320" y="615"/>
                  <a:pt x="4332" y="598"/>
                  <a:pt x="4340" y="580"/>
                </a:cubicBezTo>
                <a:cubicBezTo>
                  <a:pt x="4348" y="562"/>
                  <a:pt x="4351" y="545"/>
                  <a:pt x="4348" y="530"/>
                </a:cubicBezTo>
                <a:cubicBezTo>
                  <a:pt x="4346" y="515"/>
                  <a:pt x="4339" y="502"/>
                  <a:pt x="4329" y="492"/>
                </a:cubicBezTo>
                <a:cubicBezTo>
                  <a:pt x="4318" y="481"/>
                  <a:pt x="4306" y="475"/>
                  <a:pt x="4292" y="473"/>
                </a:cubicBezTo>
                <a:cubicBezTo>
                  <a:pt x="4278" y="472"/>
                  <a:pt x="4262" y="475"/>
                  <a:pt x="4242" y="484"/>
                </a:cubicBezTo>
                <a:cubicBezTo>
                  <a:pt x="4230" y="489"/>
                  <a:pt x="4204" y="504"/>
                  <a:pt x="4166" y="527"/>
                </a:cubicBezTo>
                <a:cubicBezTo>
                  <a:pt x="4128" y="551"/>
                  <a:pt x="4099" y="565"/>
                  <a:pt x="4080" y="571"/>
                </a:cubicBezTo>
                <a:cubicBezTo>
                  <a:pt x="4056" y="579"/>
                  <a:pt x="4033" y="580"/>
                  <a:pt x="4013" y="576"/>
                </a:cubicBezTo>
                <a:cubicBezTo>
                  <a:pt x="3993" y="571"/>
                  <a:pt x="3975" y="561"/>
                  <a:pt x="3959" y="546"/>
                </a:cubicBezTo>
                <a:cubicBezTo>
                  <a:pt x="3942" y="529"/>
                  <a:pt x="3931" y="508"/>
                  <a:pt x="3926" y="484"/>
                </a:cubicBezTo>
                <a:cubicBezTo>
                  <a:pt x="3921" y="459"/>
                  <a:pt x="3924" y="434"/>
                  <a:pt x="3935" y="408"/>
                </a:cubicBezTo>
                <a:cubicBezTo>
                  <a:pt x="3946" y="382"/>
                  <a:pt x="3962" y="358"/>
                  <a:pt x="3985" y="335"/>
                </a:cubicBezTo>
                <a:cubicBezTo>
                  <a:pt x="4010" y="310"/>
                  <a:pt x="4036" y="292"/>
                  <a:pt x="4063" y="281"/>
                </a:cubicBezTo>
                <a:cubicBezTo>
                  <a:pt x="4090" y="270"/>
                  <a:pt x="4116" y="267"/>
                  <a:pt x="4142" y="273"/>
                </a:cubicBezTo>
                <a:cubicBezTo>
                  <a:pt x="4168" y="278"/>
                  <a:pt x="4191" y="290"/>
                  <a:pt x="4212" y="309"/>
                </a:cubicBezTo>
                <a:lnTo>
                  <a:pt x="4172" y="355"/>
                </a:lnTo>
                <a:cubicBezTo>
                  <a:pt x="4149" y="336"/>
                  <a:pt x="4125" y="328"/>
                  <a:pt x="4101" y="330"/>
                </a:cubicBezTo>
                <a:cubicBezTo>
                  <a:pt x="4077" y="332"/>
                  <a:pt x="4052" y="346"/>
                  <a:pt x="4026" y="372"/>
                </a:cubicBezTo>
                <a:cubicBezTo>
                  <a:pt x="3999" y="399"/>
                  <a:pt x="3984" y="424"/>
                  <a:pt x="3982" y="446"/>
                </a:cubicBezTo>
                <a:cubicBezTo>
                  <a:pt x="3979" y="468"/>
                  <a:pt x="3985" y="486"/>
                  <a:pt x="3999" y="500"/>
                </a:cubicBezTo>
                <a:cubicBezTo>
                  <a:pt x="4011" y="512"/>
                  <a:pt x="4025" y="518"/>
                  <a:pt x="4042" y="517"/>
                </a:cubicBezTo>
                <a:cubicBezTo>
                  <a:pt x="4058" y="516"/>
                  <a:pt x="4089" y="502"/>
                  <a:pt x="4133" y="474"/>
                </a:cubicBezTo>
                <a:cubicBezTo>
                  <a:pt x="4177" y="446"/>
                  <a:pt x="4209" y="428"/>
                  <a:pt x="4229" y="421"/>
                </a:cubicBezTo>
                <a:cubicBezTo>
                  <a:pt x="4257" y="410"/>
                  <a:pt x="4283" y="407"/>
                  <a:pt x="4306" y="412"/>
                </a:cubicBezTo>
                <a:cubicBezTo>
                  <a:pt x="4330" y="416"/>
                  <a:pt x="4350" y="427"/>
                  <a:pt x="4368" y="445"/>
                </a:cubicBezTo>
                <a:cubicBezTo>
                  <a:pt x="4386" y="463"/>
                  <a:pt x="4398" y="485"/>
                  <a:pt x="4403" y="511"/>
                </a:cubicBezTo>
                <a:cubicBezTo>
                  <a:pt x="4409" y="537"/>
                  <a:pt x="4407" y="564"/>
                  <a:pt x="4396" y="592"/>
                </a:cubicBezTo>
                <a:cubicBezTo>
                  <a:pt x="4386" y="620"/>
                  <a:pt x="4369" y="646"/>
                  <a:pt x="4345" y="670"/>
                </a:cubicBezTo>
                <a:cubicBezTo>
                  <a:pt x="4314" y="701"/>
                  <a:pt x="4284" y="722"/>
                  <a:pt x="4255" y="733"/>
                </a:cubicBezTo>
                <a:cubicBezTo>
                  <a:pt x="4225" y="745"/>
                  <a:pt x="4196" y="748"/>
                  <a:pt x="4166" y="742"/>
                </a:cubicBezTo>
                <a:cubicBezTo>
                  <a:pt x="4137" y="736"/>
                  <a:pt x="4111" y="722"/>
                  <a:pt x="4088" y="700"/>
                </a:cubicBezTo>
                <a:close/>
                <a:moveTo>
                  <a:pt x="4666" y="337"/>
                </a:moveTo>
                <a:lnTo>
                  <a:pt x="4625" y="378"/>
                </a:lnTo>
                <a:lnTo>
                  <a:pt x="4362" y="116"/>
                </a:lnTo>
                <a:cubicBezTo>
                  <a:pt x="4362" y="135"/>
                  <a:pt x="4358" y="157"/>
                  <a:pt x="4351" y="183"/>
                </a:cubicBezTo>
                <a:cubicBezTo>
                  <a:pt x="4345" y="209"/>
                  <a:pt x="4337" y="230"/>
                  <a:pt x="4329" y="248"/>
                </a:cubicBezTo>
                <a:lnTo>
                  <a:pt x="4289" y="208"/>
                </a:lnTo>
                <a:cubicBezTo>
                  <a:pt x="4302" y="174"/>
                  <a:pt x="4309" y="141"/>
                  <a:pt x="4310" y="108"/>
                </a:cubicBezTo>
                <a:cubicBezTo>
                  <a:pt x="4312" y="75"/>
                  <a:pt x="4309" y="48"/>
                  <a:pt x="4302" y="26"/>
                </a:cubicBezTo>
                <a:lnTo>
                  <a:pt x="4329" y="0"/>
                </a:lnTo>
                <a:lnTo>
                  <a:pt x="4666" y="337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95" name="Freeform 77"/>
          <p:cNvSpPr>
            <a:spLocks noEditPoints="1"/>
          </p:cNvSpPr>
          <p:nvPr/>
        </p:nvSpPr>
        <p:spPr bwMode="auto">
          <a:xfrm>
            <a:off x="5184953" y="4611475"/>
            <a:ext cx="900112" cy="890587"/>
          </a:xfrm>
          <a:custGeom>
            <a:avLst/>
            <a:gdLst>
              <a:gd name="T0" fmla="*/ 298 w 4728"/>
              <a:gd name="T1" fmla="*/ 4144 h 4675"/>
              <a:gd name="T2" fmla="*/ 336 w 4728"/>
              <a:gd name="T3" fmla="*/ 4675 h 4675"/>
              <a:gd name="T4" fmla="*/ 215 w 4728"/>
              <a:gd name="T5" fmla="*/ 4209 h 4675"/>
              <a:gd name="T6" fmla="*/ 441 w 4728"/>
              <a:gd name="T7" fmla="*/ 3898 h 4675"/>
              <a:gd name="T8" fmla="*/ 740 w 4728"/>
              <a:gd name="T9" fmla="*/ 3974 h 4675"/>
              <a:gd name="T10" fmla="*/ 651 w 4728"/>
              <a:gd name="T11" fmla="*/ 4360 h 4675"/>
              <a:gd name="T12" fmla="*/ 563 w 4728"/>
              <a:gd name="T13" fmla="*/ 3900 h 4675"/>
              <a:gd name="T14" fmla="*/ 740 w 4728"/>
              <a:gd name="T15" fmla="*/ 4192 h 4675"/>
              <a:gd name="T16" fmla="*/ 673 w 4728"/>
              <a:gd name="T17" fmla="*/ 4039 h 4675"/>
              <a:gd name="T18" fmla="*/ 744 w 4728"/>
              <a:gd name="T19" fmla="*/ 3595 h 4675"/>
              <a:gd name="T20" fmla="*/ 1157 w 4728"/>
              <a:gd name="T21" fmla="*/ 3748 h 4675"/>
              <a:gd name="T22" fmla="*/ 1041 w 4728"/>
              <a:gd name="T23" fmla="*/ 3891 h 4675"/>
              <a:gd name="T24" fmla="*/ 847 w 4728"/>
              <a:gd name="T25" fmla="*/ 3585 h 4675"/>
              <a:gd name="T26" fmla="*/ 1597 w 4728"/>
              <a:gd name="T27" fmla="*/ 3541 h 4675"/>
              <a:gd name="T28" fmla="*/ 1414 w 4728"/>
              <a:gd name="T29" fmla="*/ 2931 h 4675"/>
              <a:gd name="T30" fmla="*/ 1477 w 4728"/>
              <a:gd name="T31" fmla="*/ 3260 h 4675"/>
              <a:gd name="T32" fmla="*/ 1543 w 4728"/>
              <a:gd name="T33" fmla="*/ 2993 h 4675"/>
              <a:gd name="T34" fmla="*/ 1881 w 4728"/>
              <a:gd name="T35" fmla="*/ 3129 h 4675"/>
              <a:gd name="T36" fmla="*/ 1918 w 4728"/>
              <a:gd name="T37" fmla="*/ 2706 h 4675"/>
              <a:gd name="T38" fmla="*/ 1881 w 4728"/>
              <a:gd name="T39" fmla="*/ 3129 h 4675"/>
              <a:gd name="T40" fmla="*/ 2111 w 4728"/>
              <a:gd name="T41" fmla="*/ 2483 h 4675"/>
              <a:gd name="T42" fmla="*/ 2416 w 4728"/>
              <a:gd name="T43" fmla="*/ 2595 h 4675"/>
              <a:gd name="T44" fmla="*/ 2647 w 4728"/>
              <a:gd name="T45" fmla="*/ 2364 h 4675"/>
              <a:gd name="T46" fmla="*/ 2291 w 4728"/>
              <a:gd name="T47" fmla="*/ 2134 h 4675"/>
              <a:gd name="T48" fmla="*/ 2562 w 4728"/>
              <a:gd name="T49" fmla="*/ 1961 h 4675"/>
              <a:gd name="T50" fmla="*/ 2775 w 4728"/>
              <a:gd name="T51" fmla="*/ 1738 h 4675"/>
              <a:gd name="T52" fmla="*/ 2865 w 4728"/>
              <a:gd name="T53" fmla="*/ 1768 h 4675"/>
              <a:gd name="T54" fmla="*/ 2914 w 4728"/>
              <a:gd name="T55" fmla="*/ 2097 h 4675"/>
              <a:gd name="T56" fmla="*/ 2684 w 4728"/>
              <a:gd name="T57" fmla="*/ 2074 h 4675"/>
              <a:gd name="T58" fmla="*/ 3218 w 4728"/>
              <a:gd name="T59" fmla="*/ 1736 h 4675"/>
              <a:gd name="T60" fmla="*/ 3013 w 4728"/>
              <a:gd name="T61" fmla="*/ 1706 h 4675"/>
              <a:gd name="T62" fmla="*/ 3049 w 4728"/>
              <a:gd name="T63" fmla="*/ 1480 h 4675"/>
              <a:gd name="T64" fmla="*/ 2996 w 4728"/>
              <a:gd name="T65" fmla="*/ 1603 h 4675"/>
              <a:gd name="T66" fmla="*/ 3228 w 4728"/>
              <a:gd name="T67" fmla="*/ 1569 h 4675"/>
              <a:gd name="T68" fmla="*/ 3070 w 4728"/>
              <a:gd name="T69" fmla="*/ 1795 h 4675"/>
              <a:gd name="T70" fmla="*/ 3342 w 4728"/>
              <a:gd name="T71" fmla="*/ 1420 h 4675"/>
              <a:gd name="T72" fmla="*/ 3194 w 4728"/>
              <a:gd name="T73" fmla="*/ 1345 h 4675"/>
              <a:gd name="T74" fmla="*/ 3389 w 4728"/>
              <a:gd name="T75" fmla="*/ 1213 h 4675"/>
              <a:gd name="T76" fmla="*/ 3499 w 4728"/>
              <a:gd name="T77" fmla="*/ 935 h 4675"/>
              <a:gd name="T78" fmla="*/ 3544 w 4728"/>
              <a:gd name="T79" fmla="*/ 980 h 4675"/>
              <a:gd name="T80" fmla="*/ 3691 w 4728"/>
              <a:gd name="T81" fmla="*/ 648 h 4675"/>
              <a:gd name="T82" fmla="*/ 3894 w 4728"/>
              <a:gd name="T83" fmla="*/ 844 h 4675"/>
              <a:gd name="T84" fmla="*/ 3900 w 4728"/>
              <a:gd name="T85" fmla="*/ 726 h 4675"/>
              <a:gd name="T86" fmla="*/ 3768 w 4728"/>
              <a:gd name="T87" fmla="*/ 890 h 4675"/>
              <a:gd name="T88" fmla="*/ 4340 w 4728"/>
              <a:gd name="T89" fmla="*/ 587 h 4675"/>
              <a:gd name="T90" fmla="*/ 4080 w 4728"/>
              <a:gd name="T91" fmla="*/ 578 h 4675"/>
              <a:gd name="T92" fmla="*/ 4063 w 4728"/>
              <a:gd name="T93" fmla="*/ 288 h 4675"/>
              <a:gd name="T94" fmla="*/ 3982 w 4728"/>
              <a:gd name="T95" fmla="*/ 453 h 4675"/>
              <a:gd name="T96" fmla="*/ 4369 w 4728"/>
              <a:gd name="T97" fmla="*/ 452 h 4675"/>
              <a:gd name="T98" fmla="*/ 4088 w 4728"/>
              <a:gd name="T99" fmla="*/ 707 h 4675"/>
              <a:gd name="T100" fmla="*/ 4468 w 4728"/>
              <a:gd name="T101" fmla="*/ 295 h 4675"/>
              <a:gd name="T102" fmla="*/ 4320 w 4728"/>
              <a:gd name="T103" fmla="*/ 219 h 4675"/>
              <a:gd name="T104" fmla="*/ 4515 w 4728"/>
              <a:gd name="T105" fmla="*/ 87 h 467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</a:cxnLst>
            <a:rect l="0" t="0" r="r" b="b"/>
            <a:pathLst>
              <a:path w="4728" h="4675">
                <a:moveTo>
                  <a:pt x="336" y="4675"/>
                </a:moveTo>
                <a:lnTo>
                  <a:pt x="0" y="4339"/>
                </a:lnTo>
                <a:lnTo>
                  <a:pt x="127" y="4212"/>
                </a:lnTo>
                <a:cubicBezTo>
                  <a:pt x="149" y="4189"/>
                  <a:pt x="167" y="4174"/>
                  <a:pt x="181" y="4164"/>
                </a:cubicBezTo>
                <a:cubicBezTo>
                  <a:pt x="200" y="4150"/>
                  <a:pt x="220" y="4142"/>
                  <a:pt x="238" y="4138"/>
                </a:cubicBezTo>
                <a:cubicBezTo>
                  <a:pt x="257" y="4135"/>
                  <a:pt x="277" y="4136"/>
                  <a:pt x="298" y="4144"/>
                </a:cubicBezTo>
                <a:cubicBezTo>
                  <a:pt x="318" y="4151"/>
                  <a:pt x="337" y="4163"/>
                  <a:pt x="354" y="4179"/>
                </a:cubicBezTo>
                <a:cubicBezTo>
                  <a:pt x="382" y="4208"/>
                  <a:pt x="398" y="4241"/>
                  <a:pt x="399" y="4279"/>
                </a:cubicBezTo>
                <a:cubicBezTo>
                  <a:pt x="401" y="4317"/>
                  <a:pt x="378" y="4360"/>
                  <a:pt x="330" y="4407"/>
                </a:cubicBezTo>
                <a:lnTo>
                  <a:pt x="244" y="4494"/>
                </a:lnTo>
                <a:lnTo>
                  <a:pt x="381" y="4630"/>
                </a:lnTo>
                <a:lnTo>
                  <a:pt x="336" y="4675"/>
                </a:lnTo>
                <a:close/>
                <a:moveTo>
                  <a:pt x="204" y="4454"/>
                </a:moveTo>
                <a:lnTo>
                  <a:pt x="291" y="4367"/>
                </a:lnTo>
                <a:cubicBezTo>
                  <a:pt x="320" y="4338"/>
                  <a:pt x="335" y="4313"/>
                  <a:pt x="336" y="4290"/>
                </a:cubicBezTo>
                <a:cubicBezTo>
                  <a:pt x="338" y="4267"/>
                  <a:pt x="329" y="4246"/>
                  <a:pt x="309" y="4226"/>
                </a:cubicBezTo>
                <a:cubicBezTo>
                  <a:pt x="295" y="4212"/>
                  <a:pt x="280" y="4204"/>
                  <a:pt x="263" y="4201"/>
                </a:cubicBezTo>
                <a:cubicBezTo>
                  <a:pt x="245" y="4198"/>
                  <a:pt x="230" y="4201"/>
                  <a:pt x="215" y="4209"/>
                </a:cubicBezTo>
                <a:cubicBezTo>
                  <a:pt x="205" y="4215"/>
                  <a:pt x="190" y="4228"/>
                  <a:pt x="170" y="4248"/>
                </a:cubicBezTo>
                <a:lnTo>
                  <a:pt x="84" y="4334"/>
                </a:lnTo>
                <a:lnTo>
                  <a:pt x="204" y="4454"/>
                </a:lnTo>
                <a:close/>
                <a:moveTo>
                  <a:pt x="651" y="4360"/>
                </a:moveTo>
                <a:lnTo>
                  <a:pt x="315" y="4024"/>
                </a:lnTo>
                <a:lnTo>
                  <a:pt x="441" y="3898"/>
                </a:lnTo>
                <a:cubicBezTo>
                  <a:pt x="467" y="3872"/>
                  <a:pt x="491" y="3855"/>
                  <a:pt x="513" y="3846"/>
                </a:cubicBezTo>
                <a:cubicBezTo>
                  <a:pt x="535" y="3837"/>
                  <a:pt x="558" y="3836"/>
                  <a:pt x="581" y="3841"/>
                </a:cubicBezTo>
                <a:cubicBezTo>
                  <a:pt x="604" y="3846"/>
                  <a:pt x="623" y="3857"/>
                  <a:pt x="639" y="3872"/>
                </a:cubicBezTo>
                <a:cubicBezTo>
                  <a:pt x="653" y="3886"/>
                  <a:pt x="663" y="3904"/>
                  <a:pt x="667" y="3924"/>
                </a:cubicBezTo>
                <a:cubicBezTo>
                  <a:pt x="672" y="3945"/>
                  <a:pt x="671" y="3967"/>
                  <a:pt x="663" y="3990"/>
                </a:cubicBezTo>
                <a:cubicBezTo>
                  <a:pt x="689" y="3976"/>
                  <a:pt x="715" y="3971"/>
                  <a:pt x="740" y="3974"/>
                </a:cubicBezTo>
                <a:cubicBezTo>
                  <a:pt x="765" y="3977"/>
                  <a:pt x="788" y="3989"/>
                  <a:pt x="807" y="4008"/>
                </a:cubicBezTo>
                <a:cubicBezTo>
                  <a:pt x="823" y="4024"/>
                  <a:pt x="835" y="4042"/>
                  <a:pt x="841" y="4062"/>
                </a:cubicBezTo>
                <a:cubicBezTo>
                  <a:pt x="848" y="4083"/>
                  <a:pt x="851" y="4101"/>
                  <a:pt x="848" y="4118"/>
                </a:cubicBezTo>
                <a:cubicBezTo>
                  <a:pt x="846" y="4135"/>
                  <a:pt x="839" y="4153"/>
                  <a:pt x="828" y="4172"/>
                </a:cubicBezTo>
                <a:cubicBezTo>
                  <a:pt x="817" y="4190"/>
                  <a:pt x="801" y="4210"/>
                  <a:pt x="779" y="4232"/>
                </a:cubicBezTo>
                <a:lnTo>
                  <a:pt x="651" y="4360"/>
                </a:lnTo>
                <a:close/>
                <a:moveTo>
                  <a:pt x="501" y="4120"/>
                </a:moveTo>
                <a:lnTo>
                  <a:pt x="573" y="4048"/>
                </a:lnTo>
                <a:cubicBezTo>
                  <a:pt x="593" y="4028"/>
                  <a:pt x="606" y="4013"/>
                  <a:pt x="612" y="4001"/>
                </a:cubicBezTo>
                <a:cubicBezTo>
                  <a:pt x="620" y="3987"/>
                  <a:pt x="623" y="3973"/>
                  <a:pt x="621" y="3959"/>
                </a:cubicBezTo>
                <a:cubicBezTo>
                  <a:pt x="619" y="3946"/>
                  <a:pt x="612" y="3933"/>
                  <a:pt x="600" y="3921"/>
                </a:cubicBezTo>
                <a:cubicBezTo>
                  <a:pt x="589" y="3910"/>
                  <a:pt x="576" y="3903"/>
                  <a:pt x="563" y="3900"/>
                </a:cubicBezTo>
                <a:cubicBezTo>
                  <a:pt x="549" y="3897"/>
                  <a:pt x="535" y="3898"/>
                  <a:pt x="522" y="3905"/>
                </a:cubicBezTo>
                <a:cubicBezTo>
                  <a:pt x="509" y="3912"/>
                  <a:pt x="491" y="3927"/>
                  <a:pt x="466" y="3952"/>
                </a:cubicBezTo>
                <a:lnTo>
                  <a:pt x="399" y="4019"/>
                </a:lnTo>
                <a:lnTo>
                  <a:pt x="501" y="4120"/>
                </a:lnTo>
                <a:close/>
                <a:moveTo>
                  <a:pt x="656" y="4276"/>
                </a:moveTo>
                <a:lnTo>
                  <a:pt x="740" y="4192"/>
                </a:lnTo>
                <a:cubicBezTo>
                  <a:pt x="754" y="4178"/>
                  <a:pt x="764" y="4167"/>
                  <a:pt x="768" y="4160"/>
                </a:cubicBezTo>
                <a:cubicBezTo>
                  <a:pt x="777" y="4148"/>
                  <a:pt x="782" y="4136"/>
                  <a:pt x="785" y="4125"/>
                </a:cubicBezTo>
                <a:cubicBezTo>
                  <a:pt x="787" y="4114"/>
                  <a:pt x="787" y="4102"/>
                  <a:pt x="783" y="4090"/>
                </a:cubicBezTo>
                <a:cubicBezTo>
                  <a:pt x="779" y="4077"/>
                  <a:pt x="772" y="4065"/>
                  <a:pt x="761" y="4055"/>
                </a:cubicBezTo>
                <a:cubicBezTo>
                  <a:pt x="749" y="4042"/>
                  <a:pt x="735" y="4034"/>
                  <a:pt x="719" y="4032"/>
                </a:cubicBezTo>
                <a:cubicBezTo>
                  <a:pt x="703" y="4029"/>
                  <a:pt x="688" y="4031"/>
                  <a:pt x="673" y="4039"/>
                </a:cubicBezTo>
                <a:cubicBezTo>
                  <a:pt x="658" y="4046"/>
                  <a:pt x="640" y="4061"/>
                  <a:pt x="618" y="4082"/>
                </a:cubicBezTo>
                <a:lnTo>
                  <a:pt x="540" y="4160"/>
                </a:lnTo>
                <a:lnTo>
                  <a:pt x="656" y="4276"/>
                </a:lnTo>
                <a:close/>
                <a:moveTo>
                  <a:pt x="964" y="4047"/>
                </a:moveTo>
                <a:lnTo>
                  <a:pt x="628" y="3711"/>
                </a:lnTo>
                <a:lnTo>
                  <a:pt x="744" y="3595"/>
                </a:lnTo>
                <a:cubicBezTo>
                  <a:pt x="770" y="3569"/>
                  <a:pt x="791" y="3550"/>
                  <a:pt x="808" y="3540"/>
                </a:cubicBezTo>
                <a:cubicBezTo>
                  <a:pt x="832" y="3525"/>
                  <a:pt x="857" y="3517"/>
                  <a:pt x="882" y="3515"/>
                </a:cubicBezTo>
                <a:cubicBezTo>
                  <a:pt x="914" y="3512"/>
                  <a:pt x="947" y="3518"/>
                  <a:pt x="979" y="3532"/>
                </a:cubicBezTo>
                <a:cubicBezTo>
                  <a:pt x="1011" y="3547"/>
                  <a:pt x="1042" y="3569"/>
                  <a:pt x="1072" y="3599"/>
                </a:cubicBezTo>
                <a:cubicBezTo>
                  <a:pt x="1098" y="3625"/>
                  <a:pt x="1117" y="3650"/>
                  <a:pt x="1131" y="3676"/>
                </a:cubicBezTo>
                <a:cubicBezTo>
                  <a:pt x="1145" y="3701"/>
                  <a:pt x="1153" y="3725"/>
                  <a:pt x="1157" y="3748"/>
                </a:cubicBezTo>
                <a:cubicBezTo>
                  <a:pt x="1161" y="3770"/>
                  <a:pt x="1161" y="3790"/>
                  <a:pt x="1157" y="3809"/>
                </a:cubicBezTo>
                <a:cubicBezTo>
                  <a:pt x="1153" y="3827"/>
                  <a:pt x="1145" y="3846"/>
                  <a:pt x="1134" y="3866"/>
                </a:cubicBezTo>
                <a:cubicBezTo>
                  <a:pt x="1122" y="3885"/>
                  <a:pt x="1106" y="3905"/>
                  <a:pt x="1085" y="3925"/>
                </a:cubicBezTo>
                <a:lnTo>
                  <a:pt x="964" y="4047"/>
                </a:lnTo>
                <a:close/>
                <a:moveTo>
                  <a:pt x="969" y="3963"/>
                </a:moveTo>
                <a:lnTo>
                  <a:pt x="1041" y="3891"/>
                </a:lnTo>
                <a:cubicBezTo>
                  <a:pt x="1063" y="3869"/>
                  <a:pt x="1078" y="3849"/>
                  <a:pt x="1087" y="3833"/>
                </a:cubicBezTo>
                <a:cubicBezTo>
                  <a:pt x="1095" y="3816"/>
                  <a:pt x="1099" y="3800"/>
                  <a:pt x="1099" y="3785"/>
                </a:cubicBezTo>
                <a:cubicBezTo>
                  <a:pt x="1099" y="3764"/>
                  <a:pt x="1093" y="3741"/>
                  <a:pt x="1081" y="3718"/>
                </a:cubicBezTo>
                <a:cubicBezTo>
                  <a:pt x="1070" y="3694"/>
                  <a:pt x="1051" y="3670"/>
                  <a:pt x="1026" y="3644"/>
                </a:cubicBezTo>
                <a:cubicBezTo>
                  <a:pt x="990" y="3609"/>
                  <a:pt x="958" y="3588"/>
                  <a:pt x="927" y="3580"/>
                </a:cubicBezTo>
                <a:cubicBezTo>
                  <a:pt x="897" y="3573"/>
                  <a:pt x="870" y="3574"/>
                  <a:pt x="847" y="3585"/>
                </a:cubicBezTo>
                <a:cubicBezTo>
                  <a:pt x="831" y="3592"/>
                  <a:pt x="809" y="3609"/>
                  <a:pt x="783" y="3635"/>
                </a:cubicBezTo>
                <a:lnTo>
                  <a:pt x="712" y="3706"/>
                </a:lnTo>
                <a:lnTo>
                  <a:pt x="969" y="3963"/>
                </a:lnTo>
                <a:close/>
                <a:moveTo>
                  <a:pt x="1353" y="3844"/>
                </a:moveTo>
                <a:lnTo>
                  <a:pt x="1324" y="3814"/>
                </a:lnTo>
                <a:lnTo>
                  <a:pt x="1597" y="3541"/>
                </a:lnTo>
                <a:lnTo>
                  <a:pt x="1627" y="3570"/>
                </a:lnTo>
                <a:lnTo>
                  <a:pt x="1353" y="3844"/>
                </a:lnTo>
                <a:close/>
                <a:moveTo>
                  <a:pt x="1569" y="3441"/>
                </a:moveTo>
                <a:lnTo>
                  <a:pt x="1233" y="3105"/>
                </a:lnTo>
                <a:lnTo>
                  <a:pt x="1360" y="2979"/>
                </a:lnTo>
                <a:cubicBezTo>
                  <a:pt x="1382" y="2956"/>
                  <a:pt x="1400" y="2940"/>
                  <a:pt x="1414" y="2931"/>
                </a:cubicBezTo>
                <a:cubicBezTo>
                  <a:pt x="1434" y="2917"/>
                  <a:pt x="1453" y="2908"/>
                  <a:pt x="1472" y="2905"/>
                </a:cubicBezTo>
                <a:cubicBezTo>
                  <a:pt x="1490" y="2901"/>
                  <a:pt x="1510" y="2903"/>
                  <a:pt x="1531" y="2910"/>
                </a:cubicBezTo>
                <a:cubicBezTo>
                  <a:pt x="1552" y="2917"/>
                  <a:pt x="1570" y="2929"/>
                  <a:pt x="1587" y="2946"/>
                </a:cubicBezTo>
                <a:cubicBezTo>
                  <a:pt x="1616" y="2975"/>
                  <a:pt x="1631" y="3008"/>
                  <a:pt x="1632" y="3046"/>
                </a:cubicBezTo>
                <a:cubicBezTo>
                  <a:pt x="1634" y="3084"/>
                  <a:pt x="1611" y="3127"/>
                  <a:pt x="1563" y="3174"/>
                </a:cubicBezTo>
                <a:lnTo>
                  <a:pt x="1477" y="3260"/>
                </a:lnTo>
                <a:lnTo>
                  <a:pt x="1614" y="3397"/>
                </a:lnTo>
                <a:lnTo>
                  <a:pt x="1569" y="3441"/>
                </a:lnTo>
                <a:close/>
                <a:moveTo>
                  <a:pt x="1438" y="3221"/>
                </a:moveTo>
                <a:lnTo>
                  <a:pt x="1524" y="3134"/>
                </a:lnTo>
                <a:cubicBezTo>
                  <a:pt x="1553" y="3105"/>
                  <a:pt x="1568" y="3079"/>
                  <a:pt x="1570" y="3057"/>
                </a:cubicBezTo>
                <a:cubicBezTo>
                  <a:pt x="1571" y="3034"/>
                  <a:pt x="1562" y="3013"/>
                  <a:pt x="1543" y="2993"/>
                </a:cubicBezTo>
                <a:cubicBezTo>
                  <a:pt x="1528" y="2979"/>
                  <a:pt x="1513" y="2971"/>
                  <a:pt x="1496" y="2968"/>
                </a:cubicBezTo>
                <a:cubicBezTo>
                  <a:pt x="1479" y="2965"/>
                  <a:pt x="1463" y="2968"/>
                  <a:pt x="1448" y="2976"/>
                </a:cubicBezTo>
                <a:cubicBezTo>
                  <a:pt x="1438" y="2982"/>
                  <a:pt x="1424" y="2994"/>
                  <a:pt x="1403" y="3015"/>
                </a:cubicBezTo>
                <a:lnTo>
                  <a:pt x="1317" y="3101"/>
                </a:lnTo>
                <a:lnTo>
                  <a:pt x="1438" y="3221"/>
                </a:lnTo>
                <a:close/>
                <a:moveTo>
                  <a:pt x="1881" y="3129"/>
                </a:moveTo>
                <a:lnTo>
                  <a:pt x="1545" y="2793"/>
                </a:lnTo>
                <a:lnTo>
                  <a:pt x="1788" y="2550"/>
                </a:lnTo>
                <a:lnTo>
                  <a:pt x="1828" y="2590"/>
                </a:lnTo>
                <a:lnTo>
                  <a:pt x="1629" y="2789"/>
                </a:lnTo>
                <a:lnTo>
                  <a:pt x="1732" y="2891"/>
                </a:lnTo>
                <a:lnTo>
                  <a:pt x="1918" y="2706"/>
                </a:lnTo>
                <a:lnTo>
                  <a:pt x="1958" y="2745"/>
                </a:lnTo>
                <a:lnTo>
                  <a:pt x="1772" y="2931"/>
                </a:lnTo>
                <a:lnTo>
                  <a:pt x="1886" y="3045"/>
                </a:lnTo>
                <a:lnTo>
                  <a:pt x="2093" y="2839"/>
                </a:lnTo>
                <a:lnTo>
                  <a:pt x="2132" y="2879"/>
                </a:lnTo>
                <a:lnTo>
                  <a:pt x="1881" y="3129"/>
                </a:lnTo>
                <a:close/>
                <a:moveTo>
                  <a:pt x="2163" y="2848"/>
                </a:moveTo>
                <a:lnTo>
                  <a:pt x="2118" y="2543"/>
                </a:lnTo>
                <a:lnTo>
                  <a:pt x="1842" y="2496"/>
                </a:lnTo>
                <a:lnTo>
                  <a:pt x="1895" y="2443"/>
                </a:lnTo>
                <a:lnTo>
                  <a:pt x="2043" y="2469"/>
                </a:lnTo>
                <a:cubicBezTo>
                  <a:pt x="2073" y="2474"/>
                  <a:pt x="2096" y="2478"/>
                  <a:pt x="2111" y="2483"/>
                </a:cubicBezTo>
                <a:cubicBezTo>
                  <a:pt x="2106" y="2463"/>
                  <a:pt x="2102" y="2441"/>
                  <a:pt x="2099" y="2418"/>
                </a:cubicBezTo>
                <a:lnTo>
                  <a:pt x="2078" y="2261"/>
                </a:lnTo>
                <a:lnTo>
                  <a:pt x="2126" y="2213"/>
                </a:lnTo>
                <a:lnTo>
                  <a:pt x="2166" y="2489"/>
                </a:lnTo>
                <a:lnTo>
                  <a:pt x="2471" y="2540"/>
                </a:lnTo>
                <a:lnTo>
                  <a:pt x="2416" y="2595"/>
                </a:lnTo>
                <a:lnTo>
                  <a:pt x="2212" y="2559"/>
                </a:lnTo>
                <a:cubicBezTo>
                  <a:pt x="2200" y="2557"/>
                  <a:pt x="2188" y="2555"/>
                  <a:pt x="2175" y="2552"/>
                </a:cubicBezTo>
                <a:cubicBezTo>
                  <a:pt x="2179" y="2571"/>
                  <a:pt x="2182" y="2585"/>
                  <a:pt x="2184" y="2593"/>
                </a:cubicBezTo>
                <a:lnTo>
                  <a:pt x="2217" y="2794"/>
                </a:lnTo>
                <a:lnTo>
                  <a:pt x="2163" y="2848"/>
                </a:lnTo>
                <a:close/>
                <a:moveTo>
                  <a:pt x="2647" y="2364"/>
                </a:moveTo>
                <a:lnTo>
                  <a:pt x="2606" y="2405"/>
                </a:lnTo>
                <a:lnTo>
                  <a:pt x="2343" y="2142"/>
                </a:lnTo>
                <a:cubicBezTo>
                  <a:pt x="2342" y="2161"/>
                  <a:pt x="2339" y="2184"/>
                  <a:pt x="2332" y="2210"/>
                </a:cubicBezTo>
                <a:cubicBezTo>
                  <a:pt x="2326" y="2235"/>
                  <a:pt x="2318" y="2257"/>
                  <a:pt x="2310" y="2274"/>
                </a:cubicBezTo>
                <a:lnTo>
                  <a:pt x="2270" y="2234"/>
                </a:lnTo>
                <a:cubicBezTo>
                  <a:pt x="2282" y="2200"/>
                  <a:pt x="2289" y="2167"/>
                  <a:pt x="2291" y="2134"/>
                </a:cubicBezTo>
                <a:cubicBezTo>
                  <a:pt x="2293" y="2102"/>
                  <a:pt x="2290" y="2075"/>
                  <a:pt x="2283" y="2053"/>
                </a:cubicBezTo>
                <a:lnTo>
                  <a:pt x="2310" y="2026"/>
                </a:lnTo>
                <a:lnTo>
                  <a:pt x="2647" y="2364"/>
                </a:lnTo>
                <a:close/>
                <a:moveTo>
                  <a:pt x="2769" y="2242"/>
                </a:moveTo>
                <a:lnTo>
                  <a:pt x="2526" y="1998"/>
                </a:lnTo>
                <a:lnTo>
                  <a:pt x="2562" y="1961"/>
                </a:lnTo>
                <a:lnTo>
                  <a:pt x="2597" y="1996"/>
                </a:lnTo>
                <a:cubicBezTo>
                  <a:pt x="2592" y="1976"/>
                  <a:pt x="2593" y="1956"/>
                  <a:pt x="2598" y="1936"/>
                </a:cubicBezTo>
                <a:cubicBezTo>
                  <a:pt x="2604" y="1916"/>
                  <a:pt x="2615" y="1898"/>
                  <a:pt x="2631" y="1882"/>
                </a:cubicBezTo>
                <a:cubicBezTo>
                  <a:pt x="2649" y="1864"/>
                  <a:pt x="2667" y="1853"/>
                  <a:pt x="2686" y="1849"/>
                </a:cubicBezTo>
                <a:cubicBezTo>
                  <a:pt x="2705" y="1845"/>
                  <a:pt x="2724" y="1847"/>
                  <a:pt x="2742" y="1856"/>
                </a:cubicBezTo>
                <a:cubicBezTo>
                  <a:pt x="2733" y="1808"/>
                  <a:pt x="2744" y="1769"/>
                  <a:pt x="2775" y="1738"/>
                </a:cubicBezTo>
                <a:cubicBezTo>
                  <a:pt x="2799" y="1714"/>
                  <a:pt x="2824" y="1702"/>
                  <a:pt x="2851" y="1702"/>
                </a:cubicBezTo>
                <a:cubicBezTo>
                  <a:pt x="2877" y="1703"/>
                  <a:pt x="2904" y="1717"/>
                  <a:pt x="2932" y="1745"/>
                </a:cubicBezTo>
                <a:lnTo>
                  <a:pt x="3099" y="1912"/>
                </a:lnTo>
                <a:lnTo>
                  <a:pt x="3058" y="1953"/>
                </a:lnTo>
                <a:lnTo>
                  <a:pt x="2905" y="1800"/>
                </a:lnTo>
                <a:cubicBezTo>
                  <a:pt x="2888" y="1783"/>
                  <a:pt x="2875" y="1773"/>
                  <a:pt x="2865" y="1768"/>
                </a:cubicBezTo>
                <a:cubicBezTo>
                  <a:pt x="2855" y="1763"/>
                  <a:pt x="2844" y="1762"/>
                  <a:pt x="2833" y="1765"/>
                </a:cubicBezTo>
                <a:cubicBezTo>
                  <a:pt x="2821" y="1768"/>
                  <a:pt x="2811" y="1774"/>
                  <a:pt x="2801" y="1783"/>
                </a:cubicBezTo>
                <a:cubicBezTo>
                  <a:pt x="2784" y="1800"/>
                  <a:pt x="2776" y="1820"/>
                  <a:pt x="2776" y="1843"/>
                </a:cubicBezTo>
                <a:cubicBezTo>
                  <a:pt x="2776" y="1865"/>
                  <a:pt x="2788" y="1889"/>
                  <a:pt x="2813" y="1914"/>
                </a:cubicBezTo>
                <a:lnTo>
                  <a:pt x="2955" y="2056"/>
                </a:lnTo>
                <a:lnTo>
                  <a:pt x="2914" y="2097"/>
                </a:lnTo>
                <a:lnTo>
                  <a:pt x="2755" y="1939"/>
                </a:lnTo>
                <a:cubicBezTo>
                  <a:pt x="2737" y="1921"/>
                  <a:pt x="2720" y="1910"/>
                  <a:pt x="2704" y="1908"/>
                </a:cubicBezTo>
                <a:cubicBezTo>
                  <a:pt x="2688" y="1905"/>
                  <a:pt x="2673" y="1912"/>
                  <a:pt x="2657" y="1927"/>
                </a:cubicBezTo>
                <a:cubicBezTo>
                  <a:pt x="2646" y="1939"/>
                  <a:pt x="2638" y="1952"/>
                  <a:pt x="2634" y="1968"/>
                </a:cubicBezTo>
                <a:cubicBezTo>
                  <a:pt x="2631" y="1984"/>
                  <a:pt x="2632" y="2000"/>
                  <a:pt x="2640" y="2017"/>
                </a:cubicBezTo>
                <a:cubicBezTo>
                  <a:pt x="2647" y="2033"/>
                  <a:pt x="2662" y="2052"/>
                  <a:pt x="2684" y="2074"/>
                </a:cubicBezTo>
                <a:lnTo>
                  <a:pt x="2810" y="2201"/>
                </a:lnTo>
                <a:lnTo>
                  <a:pt x="2769" y="2242"/>
                </a:lnTo>
                <a:close/>
                <a:moveTo>
                  <a:pt x="3070" y="1795"/>
                </a:moveTo>
                <a:lnTo>
                  <a:pt x="3105" y="1748"/>
                </a:lnTo>
                <a:cubicBezTo>
                  <a:pt x="3123" y="1762"/>
                  <a:pt x="3142" y="1768"/>
                  <a:pt x="3161" y="1767"/>
                </a:cubicBezTo>
                <a:cubicBezTo>
                  <a:pt x="3180" y="1765"/>
                  <a:pt x="3199" y="1755"/>
                  <a:pt x="3218" y="1736"/>
                </a:cubicBezTo>
                <a:cubicBezTo>
                  <a:pt x="3237" y="1717"/>
                  <a:pt x="3247" y="1699"/>
                  <a:pt x="3249" y="1682"/>
                </a:cubicBezTo>
                <a:cubicBezTo>
                  <a:pt x="3250" y="1665"/>
                  <a:pt x="3246" y="1651"/>
                  <a:pt x="3235" y="1641"/>
                </a:cubicBezTo>
                <a:cubicBezTo>
                  <a:pt x="3226" y="1632"/>
                  <a:pt x="3215" y="1628"/>
                  <a:pt x="3201" y="1631"/>
                </a:cubicBezTo>
                <a:cubicBezTo>
                  <a:pt x="3192" y="1633"/>
                  <a:pt x="3173" y="1643"/>
                  <a:pt x="3145" y="1659"/>
                </a:cubicBezTo>
                <a:cubicBezTo>
                  <a:pt x="3107" y="1682"/>
                  <a:pt x="3080" y="1696"/>
                  <a:pt x="3062" y="1702"/>
                </a:cubicBezTo>
                <a:cubicBezTo>
                  <a:pt x="3045" y="1709"/>
                  <a:pt x="3029" y="1710"/>
                  <a:pt x="3013" y="1706"/>
                </a:cubicBezTo>
                <a:cubicBezTo>
                  <a:pt x="2997" y="1702"/>
                  <a:pt x="2983" y="1694"/>
                  <a:pt x="2971" y="1682"/>
                </a:cubicBezTo>
                <a:cubicBezTo>
                  <a:pt x="2960" y="1671"/>
                  <a:pt x="2952" y="1659"/>
                  <a:pt x="2948" y="1645"/>
                </a:cubicBezTo>
                <a:cubicBezTo>
                  <a:pt x="2944" y="1630"/>
                  <a:pt x="2943" y="1616"/>
                  <a:pt x="2945" y="1601"/>
                </a:cubicBezTo>
                <a:cubicBezTo>
                  <a:pt x="2947" y="1590"/>
                  <a:pt x="2952" y="1577"/>
                  <a:pt x="2960" y="1563"/>
                </a:cubicBezTo>
                <a:cubicBezTo>
                  <a:pt x="2967" y="1549"/>
                  <a:pt x="2978" y="1535"/>
                  <a:pt x="2990" y="1523"/>
                </a:cubicBezTo>
                <a:cubicBezTo>
                  <a:pt x="3009" y="1503"/>
                  <a:pt x="3029" y="1489"/>
                  <a:pt x="3049" y="1480"/>
                </a:cubicBezTo>
                <a:cubicBezTo>
                  <a:pt x="3069" y="1472"/>
                  <a:pt x="3087" y="1468"/>
                  <a:pt x="3103" y="1471"/>
                </a:cubicBezTo>
                <a:cubicBezTo>
                  <a:pt x="3120" y="1473"/>
                  <a:pt x="3137" y="1481"/>
                  <a:pt x="3155" y="1494"/>
                </a:cubicBezTo>
                <a:lnTo>
                  <a:pt x="3120" y="1540"/>
                </a:lnTo>
                <a:cubicBezTo>
                  <a:pt x="3106" y="1529"/>
                  <a:pt x="3091" y="1525"/>
                  <a:pt x="3075" y="1527"/>
                </a:cubicBezTo>
                <a:cubicBezTo>
                  <a:pt x="3059" y="1529"/>
                  <a:pt x="3043" y="1537"/>
                  <a:pt x="3027" y="1553"/>
                </a:cubicBezTo>
                <a:cubicBezTo>
                  <a:pt x="3008" y="1572"/>
                  <a:pt x="2998" y="1589"/>
                  <a:pt x="2996" y="1603"/>
                </a:cubicBezTo>
                <a:cubicBezTo>
                  <a:pt x="2994" y="1618"/>
                  <a:pt x="2998" y="1629"/>
                  <a:pt x="3006" y="1638"/>
                </a:cubicBezTo>
                <a:cubicBezTo>
                  <a:pt x="3011" y="1643"/>
                  <a:pt x="3018" y="1646"/>
                  <a:pt x="3025" y="1647"/>
                </a:cubicBezTo>
                <a:cubicBezTo>
                  <a:pt x="3033" y="1648"/>
                  <a:pt x="3042" y="1646"/>
                  <a:pt x="3052" y="1642"/>
                </a:cubicBezTo>
                <a:cubicBezTo>
                  <a:pt x="3058" y="1640"/>
                  <a:pt x="3074" y="1631"/>
                  <a:pt x="3099" y="1616"/>
                </a:cubicBezTo>
                <a:cubicBezTo>
                  <a:pt x="3136" y="1595"/>
                  <a:pt x="3163" y="1581"/>
                  <a:pt x="3180" y="1574"/>
                </a:cubicBezTo>
                <a:cubicBezTo>
                  <a:pt x="3196" y="1568"/>
                  <a:pt x="3212" y="1566"/>
                  <a:pt x="3228" y="1569"/>
                </a:cubicBezTo>
                <a:cubicBezTo>
                  <a:pt x="3244" y="1572"/>
                  <a:pt x="3259" y="1580"/>
                  <a:pt x="3274" y="1594"/>
                </a:cubicBezTo>
                <a:cubicBezTo>
                  <a:pt x="3287" y="1608"/>
                  <a:pt x="3296" y="1625"/>
                  <a:pt x="3300" y="1645"/>
                </a:cubicBezTo>
                <a:cubicBezTo>
                  <a:pt x="3304" y="1665"/>
                  <a:pt x="3302" y="1686"/>
                  <a:pt x="3294" y="1708"/>
                </a:cubicBezTo>
                <a:cubicBezTo>
                  <a:pt x="3285" y="1730"/>
                  <a:pt x="3272" y="1750"/>
                  <a:pt x="3252" y="1769"/>
                </a:cubicBezTo>
                <a:cubicBezTo>
                  <a:pt x="3221" y="1801"/>
                  <a:pt x="3190" y="1819"/>
                  <a:pt x="3160" y="1822"/>
                </a:cubicBezTo>
                <a:cubicBezTo>
                  <a:pt x="3131" y="1825"/>
                  <a:pt x="3101" y="1817"/>
                  <a:pt x="3070" y="1795"/>
                </a:cubicBezTo>
                <a:close/>
                <a:moveTo>
                  <a:pt x="3563" y="1369"/>
                </a:moveTo>
                <a:lnTo>
                  <a:pt x="3602" y="1409"/>
                </a:lnTo>
                <a:lnTo>
                  <a:pt x="3380" y="1631"/>
                </a:lnTo>
                <a:cubicBezTo>
                  <a:pt x="3370" y="1621"/>
                  <a:pt x="3362" y="1610"/>
                  <a:pt x="3356" y="1597"/>
                </a:cubicBezTo>
                <a:cubicBezTo>
                  <a:pt x="3347" y="1576"/>
                  <a:pt x="3341" y="1552"/>
                  <a:pt x="3339" y="1525"/>
                </a:cubicBezTo>
                <a:cubicBezTo>
                  <a:pt x="3337" y="1498"/>
                  <a:pt x="3338" y="1463"/>
                  <a:pt x="3342" y="1420"/>
                </a:cubicBezTo>
                <a:cubicBezTo>
                  <a:pt x="3348" y="1354"/>
                  <a:pt x="3349" y="1306"/>
                  <a:pt x="3345" y="1275"/>
                </a:cubicBezTo>
                <a:cubicBezTo>
                  <a:pt x="3340" y="1245"/>
                  <a:pt x="3330" y="1222"/>
                  <a:pt x="3314" y="1206"/>
                </a:cubicBezTo>
                <a:cubicBezTo>
                  <a:pt x="3298" y="1190"/>
                  <a:pt x="3278" y="1182"/>
                  <a:pt x="3255" y="1182"/>
                </a:cubicBezTo>
                <a:cubicBezTo>
                  <a:pt x="3233" y="1183"/>
                  <a:pt x="3212" y="1193"/>
                  <a:pt x="3193" y="1211"/>
                </a:cubicBezTo>
                <a:cubicBezTo>
                  <a:pt x="3173" y="1231"/>
                  <a:pt x="3163" y="1253"/>
                  <a:pt x="3163" y="1277"/>
                </a:cubicBezTo>
                <a:cubicBezTo>
                  <a:pt x="3163" y="1301"/>
                  <a:pt x="3174" y="1323"/>
                  <a:pt x="3194" y="1345"/>
                </a:cubicBezTo>
                <a:lnTo>
                  <a:pt x="3148" y="1383"/>
                </a:lnTo>
                <a:cubicBezTo>
                  <a:pt x="3119" y="1348"/>
                  <a:pt x="3106" y="1313"/>
                  <a:pt x="3108" y="1277"/>
                </a:cubicBezTo>
                <a:cubicBezTo>
                  <a:pt x="3111" y="1242"/>
                  <a:pt x="3128" y="1208"/>
                  <a:pt x="3160" y="1176"/>
                </a:cubicBezTo>
                <a:cubicBezTo>
                  <a:pt x="3192" y="1144"/>
                  <a:pt x="3226" y="1127"/>
                  <a:pt x="3263" y="1127"/>
                </a:cubicBezTo>
                <a:cubicBezTo>
                  <a:pt x="3300" y="1126"/>
                  <a:pt x="3331" y="1138"/>
                  <a:pt x="3358" y="1165"/>
                </a:cubicBezTo>
                <a:cubicBezTo>
                  <a:pt x="3371" y="1178"/>
                  <a:pt x="3382" y="1194"/>
                  <a:pt x="3389" y="1213"/>
                </a:cubicBezTo>
                <a:cubicBezTo>
                  <a:pt x="3397" y="1231"/>
                  <a:pt x="3401" y="1254"/>
                  <a:pt x="3403" y="1281"/>
                </a:cubicBezTo>
                <a:cubicBezTo>
                  <a:pt x="3404" y="1308"/>
                  <a:pt x="3403" y="1349"/>
                  <a:pt x="3398" y="1404"/>
                </a:cubicBezTo>
                <a:cubicBezTo>
                  <a:pt x="3394" y="1449"/>
                  <a:pt x="3393" y="1479"/>
                  <a:pt x="3393" y="1494"/>
                </a:cubicBezTo>
                <a:cubicBezTo>
                  <a:pt x="3393" y="1508"/>
                  <a:pt x="3395" y="1522"/>
                  <a:pt x="3398" y="1534"/>
                </a:cubicBezTo>
                <a:lnTo>
                  <a:pt x="3563" y="1369"/>
                </a:lnTo>
                <a:close/>
                <a:moveTo>
                  <a:pt x="3499" y="935"/>
                </a:moveTo>
                <a:lnTo>
                  <a:pt x="3451" y="887"/>
                </a:lnTo>
                <a:lnTo>
                  <a:pt x="3493" y="846"/>
                </a:lnTo>
                <a:lnTo>
                  <a:pt x="3540" y="893"/>
                </a:lnTo>
                <a:lnTo>
                  <a:pt x="3499" y="935"/>
                </a:lnTo>
                <a:close/>
                <a:moveTo>
                  <a:pt x="3787" y="1223"/>
                </a:moveTo>
                <a:lnTo>
                  <a:pt x="3544" y="980"/>
                </a:lnTo>
                <a:lnTo>
                  <a:pt x="3585" y="939"/>
                </a:lnTo>
                <a:lnTo>
                  <a:pt x="3829" y="1182"/>
                </a:lnTo>
                <a:lnTo>
                  <a:pt x="3787" y="1223"/>
                </a:lnTo>
                <a:close/>
                <a:moveTo>
                  <a:pt x="3900" y="1111"/>
                </a:moveTo>
                <a:lnTo>
                  <a:pt x="3564" y="775"/>
                </a:lnTo>
                <a:lnTo>
                  <a:pt x="3691" y="648"/>
                </a:lnTo>
                <a:cubicBezTo>
                  <a:pt x="3713" y="626"/>
                  <a:pt x="3731" y="610"/>
                  <a:pt x="3745" y="600"/>
                </a:cubicBezTo>
                <a:cubicBezTo>
                  <a:pt x="3764" y="586"/>
                  <a:pt x="3783" y="578"/>
                  <a:pt x="3802" y="574"/>
                </a:cubicBezTo>
                <a:cubicBezTo>
                  <a:pt x="3821" y="571"/>
                  <a:pt x="3841" y="573"/>
                  <a:pt x="3862" y="580"/>
                </a:cubicBezTo>
                <a:cubicBezTo>
                  <a:pt x="3882" y="587"/>
                  <a:pt x="3901" y="599"/>
                  <a:pt x="3918" y="615"/>
                </a:cubicBezTo>
                <a:cubicBezTo>
                  <a:pt x="3946" y="644"/>
                  <a:pt x="3961" y="677"/>
                  <a:pt x="3963" y="715"/>
                </a:cubicBezTo>
                <a:cubicBezTo>
                  <a:pt x="3965" y="753"/>
                  <a:pt x="3942" y="796"/>
                  <a:pt x="3894" y="844"/>
                </a:cubicBezTo>
                <a:lnTo>
                  <a:pt x="3808" y="930"/>
                </a:lnTo>
                <a:lnTo>
                  <a:pt x="3944" y="1066"/>
                </a:lnTo>
                <a:lnTo>
                  <a:pt x="3900" y="1111"/>
                </a:lnTo>
                <a:close/>
                <a:moveTo>
                  <a:pt x="3768" y="890"/>
                </a:moveTo>
                <a:lnTo>
                  <a:pt x="3855" y="803"/>
                </a:lnTo>
                <a:cubicBezTo>
                  <a:pt x="3884" y="774"/>
                  <a:pt x="3899" y="749"/>
                  <a:pt x="3900" y="726"/>
                </a:cubicBezTo>
                <a:cubicBezTo>
                  <a:pt x="3902" y="703"/>
                  <a:pt x="3893" y="682"/>
                  <a:pt x="3873" y="663"/>
                </a:cubicBezTo>
                <a:cubicBezTo>
                  <a:pt x="3859" y="649"/>
                  <a:pt x="3844" y="640"/>
                  <a:pt x="3826" y="637"/>
                </a:cubicBezTo>
                <a:cubicBezTo>
                  <a:pt x="3809" y="634"/>
                  <a:pt x="3793" y="637"/>
                  <a:pt x="3778" y="645"/>
                </a:cubicBezTo>
                <a:cubicBezTo>
                  <a:pt x="3769" y="651"/>
                  <a:pt x="3754" y="664"/>
                  <a:pt x="3734" y="684"/>
                </a:cubicBezTo>
                <a:lnTo>
                  <a:pt x="3648" y="770"/>
                </a:lnTo>
                <a:lnTo>
                  <a:pt x="3768" y="890"/>
                </a:lnTo>
                <a:close/>
                <a:moveTo>
                  <a:pt x="4088" y="707"/>
                </a:moveTo>
                <a:lnTo>
                  <a:pt x="4126" y="661"/>
                </a:lnTo>
                <a:cubicBezTo>
                  <a:pt x="4145" y="676"/>
                  <a:pt x="4164" y="685"/>
                  <a:pt x="4182" y="689"/>
                </a:cubicBezTo>
                <a:cubicBezTo>
                  <a:pt x="4200" y="692"/>
                  <a:pt x="4220" y="690"/>
                  <a:pt x="4242" y="681"/>
                </a:cubicBezTo>
                <a:cubicBezTo>
                  <a:pt x="4263" y="672"/>
                  <a:pt x="4284" y="659"/>
                  <a:pt x="4303" y="639"/>
                </a:cubicBezTo>
                <a:cubicBezTo>
                  <a:pt x="4320" y="622"/>
                  <a:pt x="4332" y="605"/>
                  <a:pt x="4340" y="587"/>
                </a:cubicBezTo>
                <a:cubicBezTo>
                  <a:pt x="4348" y="569"/>
                  <a:pt x="4351" y="552"/>
                  <a:pt x="4349" y="537"/>
                </a:cubicBezTo>
                <a:cubicBezTo>
                  <a:pt x="4346" y="522"/>
                  <a:pt x="4340" y="509"/>
                  <a:pt x="4329" y="499"/>
                </a:cubicBezTo>
                <a:cubicBezTo>
                  <a:pt x="4319" y="488"/>
                  <a:pt x="4307" y="482"/>
                  <a:pt x="4293" y="480"/>
                </a:cubicBezTo>
                <a:cubicBezTo>
                  <a:pt x="4279" y="479"/>
                  <a:pt x="4262" y="482"/>
                  <a:pt x="4243" y="491"/>
                </a:cubicBezTo>
                <a:cubicBezTo>
                  <a:pt x="4230" y="496"/>
                  <a:pt x="4205" y="511"/>
                  <a:pt x="4166" y="534"/>
                </a:cubicBezTo>
                <a:cubicBezTo>
                  <a:pt x="4128" y="558"/>
                  <a:pt x="4099" y="572"/>
                  <a:pt x="4080" y="578"/>
                </a:cubicBezTo>
                <a:cubicBezTo>
                  <a:pt x="4056" y="586"/>
                  <a:pt x="4034" y="587"/>
                  <a:pt x="4013" y="583"/>
                </a:cubicBezTo>
                <a:cubicBezTo>
                  <a:pt x="3993" y="578"/>
                  <a:pt x="3975" y="568"/>
                  <a:pt x="3960" y="553"/>
                </a:cubicBezTo>
                <a:cubicBezTo>
                  <a:pt x="3943" y="536"/>
                  <a:pt x="3932" y="515"/>
                  <a:pt x="3927" y="491"/>
                </a:cubicBezTo>
                <a:cubicBezTo>
                  <a:pt x="3921" y="466"/>
                  <a:pt x="3924" y="441"/>
                  <a:pt x="3935" y="415"/>
                </a:cubicBezTo>
                <a:cubicBezTo>
                  <a:pt x="3946" y="389"/>
                  <a:pt x="3963" y="365"/>
                  <a:pt x="3985" y="342"/>
                </a:cubicBezTo>
                <a:cubicBezTo>
                  <a:pt x="4010" y="317"/>
                  <a:pt x="4036" y="299"/>
                  <a:pt x="4063" y="288"/>
                </a:cubicBezTo>
                <a:cubicBezTo>
                  <a:pt x="4090" y="277"/>
                  <a:pt x="4117" y="274"/>
                  <a:pt x="4143" y="280"/>
                </a:cubicBezTo>
                <a:cubicBezTo>
                  <a:pt x="4168" y="285"/>
                  <a:pt x="4192" y="297"/>
                  <a:pt x="4212" y="316"/>
                </a:cubicBezTo>
                <a:lnTo>
                  <a:pt x="4173" y="362"/>
                </a:lnTo>
                <a:cubicBezTo>
                  <a:pt x="4149" y="343"/>
                  <a:pt x="4125" y="335"/>
                  <a:pt x="4101" y="337"/>
                </a:cubicBezTo>
                <a:cubicBezTo>
                  <a:pt x="4077" y="339"/>
                  <a:pt x="4052" y="353"/>
                  <a:pt x="4026" y="379"/>
                </a:cubicBezTo>
                <a:cubicBezTo>
                  <a:pt x="3999" y="406"/>
                  <a:pt x="3985" y="431"/>
                  <a:pt x="3982" y="453"/>
                </a:cubicBezTo>
                <a:cubicBezTo>
                  <a:pt x="3980" y="475"/>
                  <a:pt x="3986" y="493"/>
                  <a:pt x="4000" y="507"/>
                </a:cubicBezTo>
                <a:cubicBezTo>
                  <a:pt x="4012" y="519"/>
                  <a:pt x="4026" y="525"/>
                  <a:pt x="4042" y="524"/>
                </a:cubicBezTo>
                <a:cubicBezTo>
                  <a:pt x="4059" y="523"/>
                  <a:pt x="4089" y="509"/>
                  <a:pt x="4133" y="481"/>
                </a:cubicBezTo>
                <a:cubicBezTo>
                  <a:pt x="4178" y="453"/>
                  <a:pt x="4210" y="435"/>
                  <a:pt x="4229" y="428"/>
                </a:cubicBezTo>
                <a:cubicBezTo>
                  <a:pt x="4258" y="417"/>
                  <a:pt x="4284" y="414"/>
                  <a:pt x="4307" y="419"/>
                </a:cubicBezTo>
                <a:cubicBezTo>
                  <a:pt x="4330" y="423"/>
                  <a:pt x="4351" y="434"/>
                  <a:pt x="4369" y="452"/>
                </a:cubicBezTo>
                <a:cubicBezTo>
                  <a:pt x="4387" y="470"/>
                  <a:pt x="4398" y="492"/>
                  <a:pt x="4404" y="518"/>
                </a:cubicBezTo>
                <a:cubicBezTo>
                  <a:pt x="4409" y="544"/>
                  <a:pt x="4407" y="571"/>
                  <a:pt x="4397" y="599"/>
                </a:cubicBezTo>
                <a:cubicBezTo>
                  <a:pt x="4386" y="627"/>
                  <a:pt x="4369" y="653"/>
                  <a:pt x="4345" y="677"/>
                </a:cubicBezTo>
                <a:cubicBezTo>
                  <a:pt x="4315" y="708"/>
                  <a:pt x="4285" y="729"/>
                  <a:pt x="4255" y="740"/>
                </a:cubicBezTo>
                <a:cubicBezTo>
                  <a:pt x="4226" y="752"/>
                  <a:pt x="4196" y="755"/>
                  <a:pt x="4167" y="749"/>
                </a:cubicBezTo>
                <a:cubicBezTo>
                  <a:pt x="4137" y="743"/>
                  <a:pt x="4111" y="729"/>
                  <a:pt x="4088" y="707"/>
                </a:cubicBezTo>
                <a:close/>
                <a:moveTo>
                  <a:pt x="4688" y="243"/>
                </a:moveTo>
                <a:lnTo>
                  <a:pt x="4728" y="283"/>
                </a:lnTo>
                <a:lnTo>
                  <a:pt x="4506" y="505"/>
                </a:lnTo>
                <a:cubicBezTo>
                  <a:pt x="4496" y="495"/>
                  <a:pt x="4488" y="484"/>
                  <a:pt x="4482" y="471"/>
                </a:cubicBezTo>
                <a:cubicBezTo>
                  <a:pt x="4473" y="451"/>
                  <a:pt x="4467" y="427"/>
                  <a:pt x="4465" y="400"/>
                </a:cubicBezTo>
                <a:cubicBezTo>
                  <a:pt x="4462" y="372"/>
                  <a:pt x="4463" y="338"/>
                  <a:pt x="4468" y="295"/>
                </a:cubicBezTo>
                <a:cubicBezTo>
                  <a:pt x="4474" y="228"/>
                  <a:pt x="4475" y="180"/>
                  <a:pt x="4470" y="149"/>
                </a:cubicBezTo>
                <a:cubicBezTo>
                  <a:pt x="4466" y="119"/>
                  <a:pt x="4456" y="96"/>
                  <a:pt x="4440" y="81"/>
                </a:cubicBezTo>
                <a:cubicBezTo>
                  <a:pt x="4424" y="64"/>
                  <a:pt x="4404" y="56"/>
                  <a:pt x="4381" y="57"/>
                </a:cubicBezTo>
                <a:cubicBezTo>
                  <a:pt x="4358" y="57"/>
                  <a:pt x="4337" y="67"/>
                  <a:pt x="4319" y="86"/>
                </a:cubicBezTo>
                <a:cubicBezTo>
                  <a:pt x="4299" y="105"/>
                  <a:pt x="4289" y="127"/>
                  <a:pt x="4289" y="151"/>
                </a:cubicBezTo>
                <a:cubicBezTo>
                  <a:pt x="4289" y="175"/>
                  <a:pt x="4299" y="198"/>
                  <a:pt x="4320" y="219"/>
                </a:cubicBezTo>
                <a:lnTo>
                  <a:pt x="4273" y="257"/>
                </a:lnTo>
                <a:cubicBezTo>
                  <a:pt x="4245" y="222"/>
                  <a:pt x="4232" y="187"/>
                  <a:pt x="4234" y="152"/>
                </a:cubicBezTo>
                <a:cubicBezTo>
                  <a:pt x="4236" y="116"/>
                  <a:pt x="4253" y="82"/>
                  <a:pt x="4285" y="51"/>
                </a:cubicBezTo>
                <a:cubicBezTo>
                  <a:pt x="4318" y="18"/>
                  <a:pt x="4352" y="2"/>
                  <a:pt x="4389" y="1"/>
                </a:cubicBezTo>
                <a:cubicBezTo>
                  <a:pt x="4425" y="0"/>
                  <a:pt x="4457" y="13"/>
                  <a:pt x="4483" y="39"/>
                </a:cubicBezTo>
                <a:cubicBezTo>
                  <a:pt x="4497" y="53"/>
                  <a:pt x="4507" y="69"/>
                  <a:pt x="4515" y="87"/>
                </a:cubicBezTo>
                <a:cubicBezTo>
                  <a:pt x="4522" y="105"/>
                  <a:pt x="4527" y="128"/>
                  <a:pt x="4528" y="155"/>
                </a:cubicBezTo>
                <a:cubicBezTo>
                  <a:pt x="4530" y="183"/>
                  <a:pt x="4529" y="223"/>
                  <a:pt x="4524" y="278"/>
                </a:cubicBezTo>
                <a:cubicBezTo>
                  <a:pt x="4520" y="324"/>
                  <a:pt x="4518" y="354"/>
                  <a:pt x="4519" y="368"/>
                </a:cubicBezTo>
                <a:cubicBezTo>
                  <a:pt x="4519" y="383"/>
                  <a:pt x="4521" y="396"/>
                  <a:pt x="4524" y="408"/>
                </a:cubicBezTo>
                <a:lnTo>
                  <a:pt x="4688" y="243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96" name="Freeform 78"/>
          <p:cNvSpPr>
            <a:spLocks noEditPoints="1"/>
          </p:cNvSpPr>
          <p:nvPr/>
        </p:nvSpPr>
        <p:spPr bwMode="auto">
          <a:xfrm>
            <a:off x="5800903" y="4611475"/>
            <a:ext cx="781050" cy="769937"/>
          </a:xfrm>
          <a:custGeom>
            <a:avLst/>
            <a:gdLst>
              <a:gd name="T0" fmla="*/ 239 w 4100"/>
              <a:gd name="T1" fmla="*/ 3511 h 4047"/>
              <a:gd name="T2" fmla="*/ 244 w 4100"/>
              <a:gd name="T3" fmla="*/ 3866 h 4047"/>
              <a:gd name="T4" fmla="*/ 337 w 4100"/>
              <a:gd name="T5" fmla="*/ 3662 h 4047"/>
              <a:gd name="T6" fmla="*/ 84 w 4100"/>
              <a:gd name="T7" fmla="*/ 3706 h 4047"/>
              <a:gd name="T8" fmla="*/ 513 w 4100"/>
              <a:gd name="T9" fmla="*/ 3219 h 4047"/>
              <a:gd name="T10" fmla="*/ 740 w 4100"/>
              <a:gd name="T11" fmla="*/ 3347 h 4047"/>
              <a:gd name="T12" fmla="*/ 780 w 4100"/>
              <a:gd name="T13" fmla="*/ 3604 h 4047"/>
              <a:gd name="T14" fmla="*/ 621 w 4100"/>
              <a:gd name="T15" fmla="*/ 3332 h 4047"/>
              <a:gd name="T16" fmla="*/ 399 w 4100"/>
              <a:gd name="T17" fmla="*/ 3391 h 4047"/>
              <a:gd name="T18" fmla="*/ 785 w 4100"/>
              <a:gd name="T19" fmla="*/ 3498 h 4047"/>
              <a:gd name="T20" fmla="*/ 618 w 4100"/>
              <a:gd name="T21" fmla="*/ 3455 h 4047"/>
              <a:gd name="T22" fmla="*/ 744 w 4100"/>
              <a:gd name="T23" fmla="*/ 2968 h 4047"/>
              <a:gd name="T24" fmla="*/ 1131 w 4100"/>
              <a:gd name="T25" fmla="*/ 3048 h 4047"/>
              <a:gd name="T26" fmla="*/ 964 w 4100"/>
              <a:gd name="T27" fmla="*/ 3419 h 4047"/>
              <a:gd name="T28" fmla="*/ 1082 w 4100"/>
              <a:gd name="T29" fmla="*/ 3090 h 4047"/>
              <a:gd name="T30" fmla="*/ 712 w 4100"/>
              <a:gd name="T31" fmla="*/ 3078 h 4047"/>
              <a:gd name="T32" fmla="*/ 1627 w 4100"/>
              <a:gd name="T33" fmla="*/ 2943 h 4047"/>
              <a:gd name="T34" fmla="*/ 1415 w 4100"/>
              <a:gd name="T35" fmla="*/ 2303 h 4047"/>
              <a:gd name="T36" fmla="*/ 1564 w 4100"/>
              <a:gd name="T37" fmla="*/ 2547 h 4047"/>
              <a:gd name="T38" fmla="*/ 1525 w 4100"/>
              <a:gd name="T39" fmla="*/ 2506 h 4047"/>
              <a:gd name="T40" fmla="*/ 1404 w 4100"/>
              <a:gd name="T41" fmla="*/ 2387 h 4047"/>
              <a:gd name="T42" fmla="*/ 1789 w 4100"/>
              <a:gd name="T43" fmla="*/ 1923 h 4047"/>
              <a:gd name="T44" fmla="*/ 1958 w 4100"/>
              <a:gd name="T45" fmla="*/ 2118 h 4047"/>
              <a:gd name="T46" fmla="*/ 1882 w 4100"/>
              <a:gd name="T47" fmla="*/ 2502 h 4047"/>
              <a:gd name="T48" fmla="*/ 2043 w 4100"/>
              <a:gd name="T49" fmla="*/ 1841 h 4047"/>
              <a:gd name="T50" fmla="*/ 2167 w 4100"/>
              <a:gd name="T51" fmla="*/ 1862 h 4047"/>
              <a:gd name="T52" fmla="*/ 2184 w 4100"/>
              <a:gd name="T53" fmla="*/ 1965 h 4047"/>
              <a:gd name="T54" fmla="*/ 2343 w 4100"/>
              <a:gd name="T55" fmla="*/ 1515 h 4047"/>
              <a:gd name="T56" fmla="*/ 2283 w 4100"/>
              <a:gd name="T57" fmla="*/ 1425 h 4047"/>
              <a:gd name="T58" fmla="*/ 2489 w 4100"/>
              <a:gd name="T59" fmla="*/ 1259 h 4047"/>
              <a:gd name="T60" fmla="*/ 2811 w 4100"/>
              <a:gd name="T61" fmla="*/ 1241 h 4047"/>
              <a:gd name="T62" fmla="*/ 2592 w 4100"/>
              <a:gd name="T63" fmla="*/ 1460 h 4047"/>
              <a:gd name="T64" fmla="*/ 2769 w 4100"/>
              <a:gd name="T65" fmla="*/ 1283 h 4047"/>
              <a:gd name="T66" fmla="*/ 2871 w 4100"/>
              <a:gd name="T67" fmla="*/ 935 h 4047"/>
              <a:gd name="T68" fmla="*/ 3160 w 4100"/>
              <a:gd name="T69" fmla="*/ 1224 h 4047"/>
              <a:gd name="T70" fmla="*/ 3272 w 4100"/>
              <a:gd name="T71" fmla="*/ 1111 h 4047"/>
              <a:gd name="T72" fmla="*/ 3234 w 4100"/>
              <a:gd name="T73" fmla="*/ 580 h 4047"/>
              <a:gd name="T74" fmla="*/ 3317 w 4100"/>
              <a:gd name="T75" fmla="*/ 1067 h 4047"/>
              <a:gd name="T76" fmla="*/ 3245 w 4100"/>
              <a:gd name="T77" fmla="*/ 663 h 4047"/>
              <a:gd name="T78" fmla="*/ 3140 w 4100"/>
              <a:gd name="T79" fmla="*/ 891 h 4047"/>
              <a:gd name="T80" fmla="*/ 3675 w 4100"/>
              <a:gd name="T81" fmla="*/ 640 h 4047"/>
              <a:gd name="T82" fmla="*/ 3615 w 4100"/>
              <a:gd name="T83" fmla="*/ 491 h 4047"/>
              <a:gd name="T84" fmla="*/ 3299 w 4100"/>
              <a:gd name="T85" fmla="*/ 491 h 4047"/>
              <a:gd name="T86" fmla="*/ 3584 w 4100"/>
              <a:gd name="T87" fmla="*/ 317 h 4047"/>
              <a:gd name="T88" fmla="*/ 3372 w 4100"/>
              <a:gd name="T89" fmla="*/ 507 h 4047"/>
              <a:gd name="T90" fmla="*/ 3741 w 4100"/>
              <a:gd name="T91" fmla="*/ 453 h 4047"/>
              <a:gd name="T92" fmla="*/ 3539 w 4100"/>
              <a:gd name="T93" fmla="*/ 749 h 4047"/>
              <a:gd name="T94" fmla="*/ 3854 w 4100"/>
              <a:gd name="T95" fmla="*/ 472 h 4047"/>
              <a:gd name="T96" fmla="*/ 3753 w 4100"/>
              <a:gd name="T97" fmla="*/ 57 h 4047"/>
              <a:gd name="T98" fmla="*/ 3606 w 4100"/>
              <a:gd name="T99" fmla="*/ 152 h 4047"/>
              <a:gd name="T100" fmla="*/ 3901 w 4100"/>
              <a:gd name="T101" fmla="*/ 156 h 404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</a:cxnLst>
            <a:rect l="0" t="0" r="r" b="b"/>
            <a:pathLst>
              <a:path w="4100" h="4047">
                <a:moveTo>
                  <a:pt x="336" y="4047"/>
                </a:moveTo>
                <a:lnTo>
                  <a:pt x="0" y="3711"/>
                </a:lnTo>
                <a:lnTo>
                  <a:pt x="127" y="3584"/>
                </a:lnTo>
                <a:cubicBezTo>
                  <a:pt x="149" y="3562"/>
                  <a:pt x="168" y="3546"/>
                  <a:pt x="181" y="3536"/>
                </a:cubicBezTo>
                <a:cubicBezTo>
                  <a:pt x="201" y="3523"/>
                  <a:pt x="220" y="3514"/>
                  <a:pt x="239" y="3511"/>
                </a:cubicBezTo>
                <a:cubicBezTo>
                  <a:pt x="257" y="3507"/>
                  <a:pt x="277" y="3509"/>
                  <a:pt x="298" y="3516"/>
                </a:cubicBezTo>
                <a:cubicBezTo>
                  <a:pt x="319" y="3523"/>
                  <a:pt x="337" y="3535"/>
                  <a:pt x="354" y="3552"/>
                </a:cubicBezTo>
                <a:cubicBezTo>
                  <a:pt x="383" y="3580"/>
                  <a:pt x="398" y="3614"/>
                  <a:pt x="399" y="3652"/>
                </a:cubicBezTo>
                <a:cubicBezTo>
                  <a:pt x="401" y="3690"/>
                  <a:pt x="378" y="3732"/>
                  <a:pt x="330" y="3780"/>
                </a:cubicBezTo>
                <a:lnTo>
                  <a:pt x="244" y="3866"/>
                </a:lnTo>
                <a:lnTo>
                  <a:pt x="381" y="4003"/>
                </a:lnTo>
                <a:lnTo>
                  <a:pt x="336" y="4047"/>
                </a:lnTo>
                <a:close/>
                <a:moveTo>
                  <a:pt x="205" y="3827"/>
                </a:moveTo>
                <a:lnTo>
                  <a:pt x="291" y="3740"/>
                </a:lnTo>
                <a:cubicBezTo>
                  <a:pt x="320" y="3711"/>
                  <a:pt x="335" y="3685"/>
                  <a:pt x="337" y="3662"/>
                </a:cubicBezTo>
                <a:cubicBezTo>
                  <a:pt x="338" y="3640"/>
                  <a:pt x="329" y="3618"/>
                  <a:pt x="310" y="3599"/>
                </a:cubicBezTo>
                <a:cubicBezTo>
                  <a:pt x="296" y="3585"/>
                  <a:pt x="280" y="3577"/>
                  <a:pt x="263" y="3574"/>
                </a:cubicBezTo>
                <a:cubicBezTo>
                  <a:pt x="246" y="3571"/>
                  <a:pt x="230" y="3573"/>
                  <a:pt x="215" y="3582"/>
                </a:cubicBezTo>
                <a:cubicBezTo>
                  <a:pt x="205" y="3587"/>
                  <a:pt x="191" y="3600"/>
                  <a:pt x="170" y="3620"/>
                </a:cubicBezTo>
                <a:lnTo>
                  <a:pt x="84" y="3706"/>
                </a:lnTo>
                <a:lnTo>
                  <a:pt x="205" y="3827"/>
                </a:lnTo>
                <a:close/>
                <a:moveTo>
                  <a:pt x="651" y="3732"/>
                </a:moveTo>
                <a:lnTo>
                  <a:pt x="315" y="3396"/>
                </a:lnTo>
                <a:lnTo>
                  <a:pt x="441" y="3270"/>
                </a:lnTo>
                <a:cubicBezTo>
                  <a:pt x="467" y="3244"/>
                  <a:pt x="491" y="3227"/>
                  <a:pt x="513" y="3219"/>
                </a:cubicBezTo>
                <a:cubicBezTo>
                  <a:pt x="536" y="3210"/>
                  <a:pt x="558" y="3208"/>
                  <a:pt x="581" y="3214"/>
                </a:cubicBezTo>
                <a:cubicBezTo>
                  <a:pt x="604" y="3219"/>
                  <a:pt x="623" y="3229"/>
                  <a:pt x="639" y="3245"/>
                </a:cubicBezTo>
                <a:cubicBezTo>
                  <a:pt x="653" y="3259"/>
                  <a:pt x="663" y="3276"/>
                  <a:pt x="668" y="3297"/>
                </a:cubicBezTo>
                <a:cubicBezTo>
                  <a:pt x="673" y="3317"/>
                  <a:pt x="671" y="3339"/>
                  <a:pt x="663" y="3363"/>
                </a:cubicBezTo>
                <a:cubicBezTo>
                  <a:pt x="689" y="3349"/>
                  <a:pt x="715" y="3343"/>
                  <a:pt x="740" y="3347"/>
                </a:cubicBezTo>
                <a:cubicBezTo>
                  <a:pt x="766" y="3350"/>
                  <a:pt x="788" y="3362"/>
                  <a:pt x="808" y="3381"/>
                </a:cubicBezTo>
                <a:cubicBezTo>
                  <a:pt x="823" y="3397"/>
                  <a:pt x="835" y="3415"/>
                  <a:pt x="842" y="3435"/>
                </a:cubicBezTo>
                <a:cubicBezTo>
                  <a:pt x="849" y="3455"/>
                  <a:pt x="851" y="3474"/>
                  <a:pt x="848" y="3491"/>
                </a:cubicBezTo>
                <a:cubicBezTo>
                  <a:pt x="846" y="3508"/>
                  <a:pt x="839" y="3526"/>
                  <a:pt x="828" y="3544"/>
                </a:cubicBezTo>
                <a:cubicBezTo>
                  <a:pt x="817" y="3563"/>
                  <a:pt x="801" y="3583"/>
                  <a:pt x="780" y="3604"/>
                </a:cubicBezTo>
                <a:lnTo>
                  <a:pt x="651" y="3732"/>
                </a:lnTo>
                <a:close/>
                <a:moveTo>
                  <a:pt x="501" y="3493"/>
                </a:moveTo>
                <a:lnTo>
                  <a:pt x="574" y="3420"/>
                </a:lnTo>
                <a:cubicBezTo>
                  <a:pt x="593" y="3401"/>
                  <a:pt x="606" y="3385"/>
                  <a:pt x="612" y="3374"/>
                </a:cubicBezTo>
                <a:cubicBezTo>
                  <a:pt x="620" y="3359"/>
                  <a:pt x="623" y="3345"/>
                  <a:pt x="621" y="3332"/>
                </a:cubicBezTo>
                <a:cubicBezTo>
                  <a:pt x="619" y="3318"/>
                  <a:pt x="612" y="3306"/>
                  <a:pt x="600" y="3294"/>
                </a:cubicBezTo>
                <a:cubicBezTo>
                  <a:pt x="589" y="3283"/>
                  <a:pt x="577" y="3275"/>
                  <a:pt x="563" y="3272"/>
                </a:cubicBezTo>
                <a:cubicBezTo>
                  <a:pt x="549" y="3269"/>
                  <a:pt x="535" y="3271"/>
                  <a:pt x="522" y="3278"/>
                </a:cubicBezTo>
                <a:cubicBezTo>
                  <a:pt x="509" y="3285"/>
                  <a:pt x="491" y="3300"/>
                  <a:pt x="467" y="3324"/>
                </a:cubicBezTo>
                <a:lnTo>
                  <a:pt x="399" y="3391"/>
                </a:lnTo>
                <a:lnTo>
                  <a:pt x="501" y="3493"/>
                </a:lnTo>
                <a:close/>
                <a:moveTo>
                  <a:pt x="656" y="3648"/>
                </a:moveTo>
                <a:lnTo>
                  <a:pt x="740" y="3565"/>
                </a:lnTo>
                <a:cubicBezTo>
                  <a:pt x="754" y="3550"/>
                  <a:pt x="764" y="3540"/>
                  <a:pt x="769" y="3533"/>
                </a:cubicBezTo>
                <a:cubicBezTo>
                  <a:pt x="777" y="3521"/>
                  <a:pt x="782" y="3509"/>
                  <a:pt x="785" y="3498"/>
                </a:cubicBezTo>
                <a:cubicBezTo>
                  <a:pt x="788" y="3487"/>
                  <a:pt x="787" y="3475"/>
                  <a:pt x="783" y="3462"/>
                </a:cubicBezTo>
                <a:cubicBezTo>
                  <a:pt x="780" y="3450"/>
                  <a:pt x="772" y="3438"/>
                  <a:pt x="762" y="3427"/>
                </a:cubicBezTo>
                <a:cubicBezTo>
                  <a:pt x="749" y="3415"/>
                  <a:pt x="735" y="3407"/>
                  <a:pt x="719" y="3404"/>
                </a:cubicBezTo>
                <a:cubicBezTo>
                  <a:pt x="704" y="3401"/>
                  <a:pt x="688" y="3404"/>
                  <a:pt x="673" y="3411"/>
                </a:cubicBezTo>
                <a:cubicBezTo>
                  <a:pt x="658" y="3419"/>
                  <a:pt x="640" y="3434"/>
                  <a:pt x="618" y="3455"/>
                </a:cubicBezTo>
                <a:lnTo>
                  <a:pt x="541" y="3533"/>
                </a:lnTo>
                <a:lnTo>
                  <a:pt x="656" y="3648"/>
                </a:lnTo>
                <a:close/>
                <a:moveTo>
                  <a:pt x="964" y="3419"/>
                </a:moveTo>
                <a:lnTo>
                  <a:pt x="628" y="3083"/>
                </a:lnTo>
                <a:lnTo>
                  <a:pt x="744" y="2968"/>
                </a:lnTo>
                <a:cubicBezTo>
                  <a:pt x="770" y="2941"/>
                  <a:pt x="792" y="2923"/>
                  <a:pt x="809" y="2912"/>
                </a:cubicBezTo>
                <a:cubicBezTo>
                  <a:pt x="832" y="2898"/>
                  <a:pt x="857" y="2889"/>
                  <a:pt x="882" y="2887"/>
                </a:cubicBezTo>
                <a:cubicBezTo>
                  <a:pt x="915" y="2885"/>
                  <a:pt x="947" y="2890"/>
                  <a:pt x="979" y="2905"/>
                </a:cubicBezTo>
                <a:cubicBezTo>
                  <a:pt x="1011" y="2919"/>
                  <a:pt x="1042" y="2942"/>
                  <a:pt x="1072" y="2972"/>
                </a:cubicBezTo>
                <a:cubicBezTo>
                  <a:pt x="1098" y="2997"/>
                  <a:pt x="1117" y="3023"/>
                  <a:pt x="1131" y="3048"/>
                </a:cubicBezTo>
                <a:cubicBezTo>
                  <a:pt x="1145" y="3074"/>
                  <a:pt x="1154" y="3098"/>
                  <a:pt x="1157" y="3120"/>
                </a:cubicBezTo>
                <a:cubicBezTo>
                  <a:pt x="1161" y="3143"/>
                  <a:pt x="1161" y="3163"/>
                  <a:pt x="1157" y="3181"/>
                </a:cubicBezTo>
                <a:cubicBezTo>
                  <a:pt x="1153" y="3200"/>
                  <a:pt x="1146" y="3219"/>
                  <a:pt x="1134" y="3238"/>
                </a:cubicBezTo>
                <a:cubicBezTo>
                  <a:pt x="1122" y="3258"/>
                  <a:pt x="1106" y="3278"/>
                  <a:pt x="1086" y="3298"/>
                </a:cubicBezTo>
                <a:lnTo>
                  <a:pt x="964" y="3419"/>
                </a:lnTo>
                <a:close/>
                <a:moveTo>
                  <a:pt x="969" y="3335"/>
                </a:moveTo>
                <a:lnTo>
                  <a:pt x="1041" y="3263"/>
                </a:lnTo>
                <a:cubicBezTo>
                  <a:pt x="1063" y="3241"/>
                  <a:pt x="1078" y="3222"/>
                  <a:pt x="1087" y="3205"/>
                </a:cubicBezTo>
                <a:cubicBezTo>
                  <a:pt x="1095" y="3188"/>
                  <a:pt x="1100" y="3173"/>
                  <a:pt x="1100" y="3158"/>
                </a:cubicBezTo>
                <a:cubicBezTo>
                  <a:pt x="1100" y="3136"/>
                  <a:pt x="1094" y="3114"/>
                  <a:pt x="1082" y="3090"/>
                </a:cubicBezTo>
                <a:cubicBezTo>
                  <a:pt x="1070" y="3067"/>
                  <a:pt x="1051" y="3042"/>
                  <a:pt x="1026" y="3017"/>
                </a:cubicBezTo>
                <a:cubicBezTo>
                  <a:pt x="991" y="2982"/>
                  <a:pt x="958" y="2960"/>
                  <a:pt x="927" y="2953"/>
                </a:cubicBezTo>
                <a:cubicBezTo>
                  <a:pt x="897" y="2946"/>
                  <a:pt x="870" y="2947"/>
                  <a:pt x="847" y="2957"/>
                </a:cubicBezTo>
                <a:cubicBezTo>
                  <a:pt x="831" y="2965"/>
                  <a:pt x="809" y="2981"/>
                  <a:pt x="783" y="3008"/>
                </a:cubicBezTo>
                <a:lnTo>
                  <a:pt x="712" y="3078"/>
                </a:lnTo>
                <a:lnTo>
                  <a:pt x="969" y="3335"/>
                </a:lnTo>
                <a:close/>
                <a:moveTo>
                  <a:pt x="1354" y="3217"/>
                </a:moveTo>
                <a:lnTo>
                  <a:pt x="1324" y="3187"/>
                </a:lnTo>
                <a:lnTo>
                  <a:pt x="1597" y="2913"/>
                </a:lnTo>
                <a:lnTo>
                  <a:pt x="1627" y="2943"/>
                </a:lnTo>
                <a:lnTo>
                  <a:pt x="1354" y="3217"/>
                </a:lnTo>
                <a:close/>
                <a:moveTo>
                  <a:pt x="1570" y="2814"/>
                </a:moveTo>
                <a:lnTo>
                  <a:pt x="1234" y="2478"/>
                </a:lnTo>
                <a:lnTo>
                  <a:pt x="1360" y="2351"/>
                </a:lnTo>
                <a:cubicBezTo>
                  <a:pt x="1383" y="2329"/>
                  <a:pt x="1401" y="2313"/>
                  <a:pt x="1415" y="2303"/>
                </a:cubicBezTo>
                <a:cubicBezTo>
                  <a:pt x="1434" y="2290"/>
                  <a:pt x="1453" y="2281"/>
                  <a:pt x="1472" y="2278"/>
                </a:cubicBezTo>
                <a:cubicBezTo>
                  <a:pt x="1491" y="2274"/>
                  <a:pt x="1510" y="2276"/>
                  <a:pt x="1531" y="2283"/>
                </a:cubicBezTo>
                <a:cubicBezTo>
                  <a:pt x="1552" y="2290"/>
                  <a:pt x="1571" y="2302"/>
                  <a:pt x="1587" y="2319"/>
                </a:cubicBezTo>
                <a:cubicBezTo>
                  <a:pt x="1616" y="2347"/>
                  <a:pt x="1631" y="2381"/>
                  <a:pt x="1633" y="2419"/>
                </a:cubicBezTo>
                <a:cubicBezTo>
                  <a:pt x="1634" y="2456"/>
                  <a:pt x="1611" y="2499"/>
                  <a:pt x="1564" y="2547"/>
                </a:cubicBezTo>
                <a:lnTo>
                  <a:pt x="1477" y="2633"/>
                </a:lnTo>
                <a:lnTo>
                  <a:pt x="1614" y="2770"/>
                </a:lnTo>
                <a:lnTo>
                  <a:pt x="1570" y="2814"/>
                </a:lnTo>
                <a:close/>
                <a:moveTo>
                  <a:pt x="1438" y="2593"/>
                </a:moveTo>
                <a:lnTo>
                  <a:pt x="1525" y="2506"/>
                </a:lnTo>
                <a:cubicBezTo>
                  <a:pt x="1553" y="2478"/>
                  <a:pt x="1568" y="2452"/>
                  <a:pt x="1570" y="2429"/>
                </a:cubicBezTo>
                <a:cubicBezTo>
                  <a:pt x="1571" y="2406"/>
                  <a:pt x="1562" y="2385"/>
                  <a:pt x="1543" y="2366"/>
                </a:cubicBezTo>
                <a:cubicBezTo>
                  <a:pt x="1529" y="2352"/>
                  <a:pt x="1513" y="2343"/>
                  <a:pt x="1496" y="2340"/>
                </a:cubicBezTo>
                <a:cubicBezTo>
                  <a:pt x="1479" y="2338"/>
                  <a:pt x="1463" y="2340"/>
                  <a:pt x="1448" y="2349"/>
                </a:cubicBezTo>
                <a:cubicBezTo>
                  <a:pt x="1439" y="2354"/>
                  <a:pt x="1424" y="2367"/>
                  <a:pt x="1404" y="2387"/>
                </a:cubicBezTo>
                <a:lnTo>
                  <a:pt x="1318" y="2473"/>
                </a:lnTo>
                <a:lnTo>
                  <a:pt x="1438" y="2593"/>
                </a:lnTo>
                <a:close/>
                <a:moveTo>
                  <a:pt x="1882" y="2502"/>
                </a:moveTo>
                <a:lnTo>
                  <a:pt x="1546" y="2166"/>
                </a:lnTo>
                <a:lnTo>
                  <a:pt x="1789" y="1923"/>
                </a:lnTo>
                <a:lnTo>
                  <a:pt x="1828" y="1963"/>
                </a:lnTo>
                <a:lnTo>
                  <a:pt x="1630" y="2161"/>
                </a:lnTo>
                <a:lnTo>
                  <a:pt x="1733" y="2264"/>
                </a:lnTo>
                <a:lnTo>
                  <a:pt x="1919" y="2078"/>
                </a:lnTo>
                <a:lnTo>
                  <a:pt x="1958" y="2118"/>
                </a:lnTo>
                <a:lnTo>
                  <a:pt x="1772" y="2304"/>
                </a:lnTo>
                <a:lnTo>
                  <a:pt x="1886" y="2418"/>
                </a:lnTo>
                <a:lnTo>
                  <a:pt x="2093" y="2212"/>
                </a:lnTo>
                <a:lnTo>
                  <a:pt x="2132" y="2251"/>
                </a:lnTo>
                <a:lnTo>
                  <a:pt x="1882" y="2502"/>
                </a:lnTo>
                <a:close/>
                <a:moveTo>
                  <a:pt x="2163" y="2220"/>
                </a:moveTo>
                <a:lnTo>
                  <a:pt x="2118" y="1915"/>
                </a:lnTo>
                <a:lnTo>
                  <a:pt x="1843" y="1869"/>
                </a:lnTo>
                <a:lnTo>
                  <a:pt x="1896" y="1816"/>
                </a:lnTo>
                <a:lnTo>
                  <a:pt x="2043" y="1841"/>
                </a:lnTo>
                <a:cubicBezTo>
                  <a:pt x="2073" y="1846"/>
                  <a:pt x="2096" y="1851"/>
                  <a:pt x="2111" y="1855"/>
                </a:cubicBezTo>
                <a:cubicBezTo>
                  <a:pt x="2106" y="1836"/>
                  <a:pt x="2102" y="1814"/>
                  <a:pt x="2099" y="1790"/>
                </a:cubicBezTo>
                <a:lnTo>
                  <a:pt x="2078" y="1634"/>
                </a:lnTo>
                <a:lnTo>
                  <a:pt x="2126" y="1585"/>
                </a:lnTo>
                <a:lnTo>
                  <a:pt x="2167" y="1862"/>
                </a:lnTo>
                <a:lnTo>
                  <a:pt x="2471" y="1912"/>
                </a:lnTo>
                <a:lnTo>
                  <a:pt x="2416" y="1967"/>
                </a:lnTo>
                <a:lnTo>
                  <a:pt x="2212" y="1932"/>
                </a:lnTo>
                <a:cubicBezTo>
                  <a:pt x="2200" y="1930"/>
                  <a:pt x="2188" y="1927"/>
                  <a:pt x="2175" y="1924"/>
                </a:cubicBezTo>
                <a:cubicBezTo>
                  <a:pt x="2180" y="1944"/>
                  <a:pt x="2183" y="1958"/>
                  <a:pt x="2184" y="1965"/>
                </a:cubicBezTo>
                <a:lnTo>
                  <a:pt x="2217" y="2167"/>
                </a:lnTo>
                <a:lnTo>
                  <a:pt x="2163" y="2220"/>
                </a:lnTo>
                <a:close/>
                <a:moveTo>
                  <a:pt x="2647" y="1736"/>
                </a:moveTo>
                <a:lnTo>
                  <a:pt x="2606" y="1778"/>
                </a:lnTo>
                <a:lnTo>
                  <a:pt x="2343" y="1515"/>
                </a:lnTo>
                <a:cubicBezTo>
                  <a:pt x="2343" y="1534"/>
                  <a:pt x="2339" y="1557"/>
                  <a:pt x="2332" y="1582"/>
                </a:cubicBezTo>
                <a:cubicBezTo>
                  <a:pt x="2326" y="1608"/>
                  <a:pt x="2318" y="1629"/>
                  <a:pt x="2310" y="1647"/>
                </a:cubicBezTo>
                <a:lnTo>
                  <a:pt x="2270" y="1607"/>
                </a:lnTo>
                <a:cubicBezTo>
                  <a:pt x="2283" y="1573"/>
                  <a:pt x="2290" y="1540"/>
                  <a:pt x="2292" y="1507"/>
                </a:cubicBezTo>
                <a:cubicBezTo>
                  <a:pt x="2293" y="1474"/>
                  <a:pt x="2291" y="1447"/>
                  <a:pt x="2283" y="1425"/>
                </a:cubicBezTo>
                <a:lnTo>
                  <a:pt x="2310" y="1399"/>
                </a:lnTo>
                <a:lnTo>
                  <a:pt x="2647" y="1736"/>
                </a:lnTo>
                <a:close/>
                <a:moveTo>
                  <a:pt x="2592" y="1460"/>
                </a:moveTo>
                <a:cubicBezTo>
                  <a:pt x="2552" y="1420"/>
                  <a:pt x="2524" y="1384"/>
                  <a:pt x="2508" y="1352"/>
                </a:cubicBezTo>
                <a:cubicBezTo>
                  <a:pt x="2492" y="1320"/>
                  <a:pt x="2486" y="1289"/>
                  <a:pt x="2489" y="1259"/>
                </a:cubicBezTo>
                <a:cubicBezTo>
                  <a:pt x="2492" y="1230"/>
                  <a:pt x="2505" y="1203"/>
                  <a:pt x="2530" y="1179"/>
                </a:cubicBezTo>
                <a:cubicBezTo>
                  <a:pt x="2548" y="1161"/>
                  <a:pt x="2567" y="1149"/>
                  <a:pt x="2588" y="1142"/>
                </a:cubicBezTo>
                <a:cubicBezTo>
                  <a:pt x="2609" y="1136"/>
                  <a:pt x="2631" y="1135"/>
                  <a:pt x="2653" y="1140"/>
                </a:cubicBezTo>
                <a:cubicBezTo>
                  <a:pt x="2676" y="1145"/>
                  <a:pt x="2699" y="1155"/>
                  <a:pt x="2724" y="1169"/>
                </a:cubicBezTo>
                <a:cubicBezTo>
                  <a:pt x="2749" y="1184"/>
                  <a:pt x="2778" y="1208"/>
                  <a:pt x="2811" y="1241"/>
                </a:cubicBezTo>
                <a:cubicBezTo>
                  <a:pt x="2851" y="1280"/>
                  <a:pt x="2878" y="1316"/>
                  <a:pt x="2895" y="1349"/>
                </a:cubicBezTo>
                <a:cubicBezTo>
                  <a:pt x="2911" y="1381"/>
                  <a:pt x="2917" y="1412"/>
                  <a:pt x="2914" y="1441"/>
                </a:cubicBezTo>
                <a:cubicBezTo>
                  <a:pt x="2911" y="1470"/>
                  <a:pt x="2898" y="1497"/>
                  <a:pt x="2873" y="1522"/>
                </a:cubicBezTo>
                <a:cubicBezTo>
                  <a:pt x="2841" y="1554"/>
                  <a:pt x="2804" y="1568"/>
                  <a:pt x="2762" y="1564"/>
                </a:cubicBezTo>
                <a:cubicBezTo>
                  <a:pt x="2712" y="1558"/>
                  <a:pt x="2655" y="1523"/>
                  <a:pt x="2592" y="1460"/>
                </a:cubicBezTo>
                <a:close/>
                <a:moveTo>
                  <a:pt x="2634" y="1418"/>
                </a:moveTo>
                <a:cubicBezTo>
                  <a:pt x="2690" y="1473"/>
                  <a:pt x="2733" y="1503"/>
                  <a:pt x="2764" y="1509"/>
                </a:cubicBezTo>
                <a:cubicBezTo>
                  <a:pt x="2795" y="1514"/>
                  <a:pt x="2820" y="1507"/>
                  <a:pt x="2839" y="1488"/>
                </a:cubicBezTo>
                <a:cubicBezTo>
                  <a:pt x="2858" y="1469"/>
                  <a:pt x="2865" y="1444"/>
                  <a:pt x="2859" y="1413"/>
                </a:cubicBezTo>
                <a:cubicBezTo>
                  <a:pt x="2854" y="1382"/>
                  <a:pt x="2824" y="1338"/>
                  <a:pt x="2769" y="1283"/>
                </a:cubicBezTo>
                <a:cubicBezTo>
                  <a:pt x="2713" y="1228"/>
                  <a:pt x="2670" y="1198"/>
                  <a:pt x="2639" y="1193"/>
                </a:cubicBezTo>
                <a:cubicBezTo>
                  <a:pt x="2608" y="1187"/>
                  <a:pt x="2583" y="1194"/>
                  <a:pt x="2564" y="1213"/>
                </a:cubicBezTo>
                <a:cubicBezTo>
                  <a:pt x="2545" y="1232"/>
                  <a:pt x="2538" y="1256"/>
                  <a:pt x="2542" y="1283"/>
                </a:cubicBezTo>
                <a:cubicBezTo>
                  <a:pt x="2549" y="1318"/>
                  <a:pt x="2579" y="1363"/>
                  <a:pt x="2634" y="1418"/>
                </a:cubicBezTo>
                <a:close/>
                <a:moveTo>
                  <a:pt x="2871" y="935"/>
                </a:moveTo>
                <a:lnTo>
                  <a:pt x="2824" y="888"/>
                </a:lnTo>
                <a:lnTo>
                  <a:pt x="2865" y="847"/>
                </a:lnTo>
                <a:lnTo>
                  <a:pt x="2912" y="894"/>
                </a:lnTo>
                <a:lnTo>
                  <a:pt x="2871" y="935"/>
                </a:lnTo>
                <a:close/>
                <a:moveTo>
                  <a:pt x="3160" y="1224"/>
                </a:moveTo>
                <a:lnTo>
                  <a:pt x="2916" y="980"/>
                </a:lnTo>
                <a:lnTo>
                  <a:pt x="2958" y="939"/>
                </a:lnTo>
                <a:lnTo>
                  <a:pt x="3201" y="1183"/>
                </a:lnTo>
                <a:lnTo>
                  <a:pt x="3160" y="1224"/>
                </a:lnTo>
                <a:close/>
                <a:moveTo>
                  <a:pt x="3272" y="1111"/>
                </a:moveTo>
                <a:lnTo>
                  <a:pt x="2936" y="775"/>
                </a:lnTo>
                <a:lnTo>
                  <a:pt x="3063" y="649"/>
                </a:lnTo>
                <a:cubicBezTo>
                  <a:pt x="3085" y="626"/>
                  <a:pt x="3103" y="610"/>
                  <a:pt x="3117" y="601"/>
                </a:cubicBezTo>
                <a:cubicBezTo>
                  <a:pt x="3137" y="587"/>
                  <a:pt x="3156" y="578"/>
                  <a:pt x="3175" y="575"/>
                </a:cubicBezTo>
                <a:cubicBezTo>
                  <a:pt x="3193" y="571"/>
                  <a:pt x="3213" y="573"/>
                  <a:pt x="3234" y="580"/>
                </a:cubicBezTo>
                <a:cubicBezTo>
                  <a:pt x="3255" y="587"/>
                  <a:pt x="3273" y="599"/>
                  <a:pt x="3290" y="616"/>
                </a:cubicBezTo>
                <a:cubicBezTo>
                  <a:pt x="3319" y="645"/>
                  <a:pt x="3334" y="678"/>
                  <a:pt x="3335" y="716"/>
                </a:cubicBezTo>
                <a:cubicBezTo>
                  <a:pt x="3337" y="754"/>
                  <a:pt x="3314" y="797"/>
                  <a:pt x="3266" y="844"/>
                </a:cubicBezTo>
                <a:lnTo>
                  <a:pt x="3180" y="930"/>
                </a:lnTo>
                <a:lnTo>
                  <a:pt x="3317" y="1067"/>
                </a:lnTo>
                <a:lnTo>
                  <a:pt x="3272" y="1111"/>
                </a:lnTo>
                <a:close/>
                <a:moveTo>
                  <a:pt x="3140" y="891"/>
                </a:moveTo>
                <a:lnTo>
                  <a:pt x="3227" y="804"/>
                </a:lnTo>
                <a:cubicBezTo>
                  <a:pt x="3256" y="775"/>
                  <a:pt x="3271" y="749"/>
                  <a:pt x="3273" y="726"/>
                </a:cubicBezTo>
                <a:cubicBezTo>
                  <a:pt x="3274" y="704"/>
                  <a:pt x="3265" y="683"/>
                  <a:pt x="3245" y="663"/>
                </a:cubicBezTo>
                <a:cubicBezTo>
                  <a:pt x="3231" y="649"/>
                  <a:pt x="3216" y="641"/>
                  <a:pt x="3199" y="638"/>
                </a:cubicBezTo>
                <a:cubicBezTo>
                  <a:pt x="3182" y="635"/>
                  <a:pt x="3166" y="638"/>
                  <a:pt x="3151" y="646"/>
                </a:cubicBezTo>
                <a:cubicBezTo>
                  <a:pt x="3141" y="651"/>
                  <a:pt x="3127" y="664"/>
                  <a:pt x="3106" y="684"/>
                </a:cubicBezTo>
                <a:lnTo>
                  <a:pt x="3020" y="770"/>
                </a:lnTo>
                <a:lnTo>
                  <a:pt x="3140" y="891"/>
                </a:lnTo>
                <a:close/>
                <a:moveTo>
                  <a:pt x="3460" y="707"/>
                </a:moveTo>
                <a:lnTo>
                  <a:pt x="3499" y="662"/>
                </a:lnTo>
                <a:cubicBezTo>
                  <a:pt x="3517" y="677"/>
                  <a:pt x="3536" y="686"/>
                  <a:pt x="3554" y="689"/>
                </a:cubicBezTo>
                <a:cubicBezTo>
                  <a:pt x="3572" y="693"/>
                  <a:pt x="3592" y="690"/>
                  <a:pt x="3614" y="682"/>
                </a:cubicBezTo>
                <a:cubicBezTo>
                  <a:pt x="3636" y="673"/>
                  <a:pt x="3656" y="659"/>
                  <a:pt x="3675" y="640"/>
                </a:cubicBezTo>
                <a:cubicBezTo>
                  <a:pt x="3692" y="623"/>
                  <a:pt x="3705" y="606"/>
                  <a:pt x="3713" y="587"/>
                </a:cubicBezTo>
                <a:cubicBezTo>
                  <a:pt x="3721" y="569"/>
                  <a:pt x="3723" y="553"/>
                  <a:pt x="3721" y="538"/>
                </a:cubicBezTo>
                <a:cubicBezTo>
                  <a:pt x="3719" y="523"/>
                  <a:pt x="3712" y="510"/>
                  <a:pt x="3702" y="499"/>
                </a:cubicBezTo>
                <a:cubicBezTo>
                  <a:pt x="3691" y="489"/>
                  <a:pt x="3679" y="483"/>
                  <a:pt x="3665" y="481"/>
                </a:cubicBezTo>
                <a:cubicBezTo>
                  <a:pt x="3651" y="479"/>
                  <a:pt x="3634" y="483"/>
                  <a:pt x="3615" y="491"/>
                </a:cubicBezTo>
                <a:cubicBezTo>
                  <a:pt x="3602" y="497"/>
                  <a:pt x="3577" y="511"/>
                  <a:pt x="3539" y="535"/>
                </a:cubicBezTo>
                <a:cubicBezTo>
                  <a:pt x="3500" y="558"/>
                  <a:pt x="3472" y="573"/>
                  <a:pt x="3453" y="579"/>
                </a:cubicBezTo>
                <a:cubicBezTo>
                  <a:pt x="3428" y="586"/>
                  <a:pt x="3406" y="588"/>
                  <a:pt x="3386" y="583"/>
                </a:cubicBezTo>
                <a:cubicBezTo>
                  <a:pt x="3365" y="579"/>
                  <a:pt x="3347" y="569"/>
                  <a:pt x="3332" y="553"/>
                </a:cubicBezTo>
                <a:cubicBezTo>
                  <a:pt x="3315" y="536"/>
                  <a:pt x="3304" y="516"/>
                  <a:pt x="3299" y="491"/>
                </a:cubicBezTo>
                <a:cubicBezTo>
                  <a:pt x="3294" y="467"/>
                  <a:pt x="3297" y="442"/>
                  <a:pt x="3307" y="416"/>
                </a:cubicBezTo>
                <a:cubicBezTo>
                  <a:pt x="3318" y="389"/>
                  <a:pt x="3335" y="365"/>
                  <a:pt x="3358" y="342"/>
                </a:cubicBezTo>
                <a:cubicBezTo>
                  <a:pt x="3383" y="318"/>
                  <a:pt x="3409" y="300"/>
                  <a:pt x="3436" y="289"/>
                </a:cubicBezTo>
                <a:cubicBezTo>
                  <a:pt x="3463" y="278"/>
                  <a:pt x="3489" y="275"/>
                  <a:pt x="3515" y="280"/>
                </a:cubicBezTo>
                <a:cubicBezTo>
                  <a:pt x="3541" y="285"/>
                  <a:pt x="3564" y="298"/>
                  <a:pt x="3584" y="317"/>
                </a:cubicBezTo>
                <a:lnTo>
                  <a:pt x="3545" y="362"/>
                </a:lnTo>
                <a:cubicBezTo>
                  <a:pt x="3521" y="343"/>
                  <a:pt x="3498" y="335"/>
                  <a:pt x="3474" y="337"/>
                </a:cubicBezTo>
                <a:cubicBezTo>
                  <a:pt x="3449" y="340"/>
                  <a:pt x="3424" y="354"/>
                  <a:pt x="3399" y="380"/>
                </a:cubicBezTo>
                <a:cubicBezTo>
                  <a:pt x="3372" y="407"/>
                  <a:pt x="3357" y="431"/>
                  <a:pt x="3355" y="453"/>
                </a:cubicBezTo>
                <a:cubicBezTo>
                  <a:pt x="3352" y="476"/>
                  <a:pt x="3358" y="494"/>
                  <a:pt x="3372" y="507"/>
                </a:cubicBezTo>
                <a:cubicBezTo>
                  <a:pt x="3384" y="520"/>
                  <a:pt x="3398" y="525"/>
                  <a:pt x="3415" y="524"/>
                </a:cubicBezTo>
                <a:cubicBezTo>
                  <a:pt x="3431" y="523"/>
                  <a:pt x="3461" y="509"/>
                  <a:pt x="3506" y="481"/>
                </a:cubicBezTo>
                <a:cubicBezTo>
                  <a:pt x="3550" y="453"/>
                  <a:pt x="3582" y="435"/>
                  <a:pt x="3602" y="428"/>
                </a:cubicBezTo>
                <a:cubicBezTo>
                  <a:pt x="3630" y="418"/>
                  <a:pt x="3656" y="415"/>
                  <a:pt x="3679" y="419"/>
                </a:cubicBezTo>
                <a:cubicBezTo>
                  <a:pt x="3702" y="424"/>
                  <a:pt x="3723" y="435"/>
                  <a:pt x="3741" y="453"/>
                </a:cubicBezTo>
                <a:cubicBezTo>
                  <a:pt x="3759" y="471"/>
                  <a:pt x="3771" y="493"/>
                  <a:pt x="3776" y="519"/>
                </a:cubicBezTo>
                <a:cubicBezTo>
                  <a:pt x="3782" y="545"/>
                  <a:pt x="3779" y="572"/>
                  <a:pt x="3769" y="600"/>
                </a:cubicBezTo>
                <a:cubicBezTo>
                  <a:pt x="3759" y="628"/>
                  <a:pt x="3741" y="654"/>
                  <a:pt x="3717" y="678"/>
                </a:cubicBezTo>
                <a:cubicBezTo>
                  <a:pt x="3687" y="708"/>
                  <a:pt x="3657" y="729"/>
                  <a:pt x="3628" y="741"/>
                </a:cubicBezTo>
                <a:cubicBezTo>
                  <a:pt x="3598" y="753"/>
                  <a:pt x="3569" y="755"/>
                  <a:pt x="3539" y="749"/>
                </a:cubicBezTo>
                <a:cubicBezTo>
                  <a:pt x="3510" y="743"/>
                  <a:pt x="3483" y="729"/>
                  <a:pt x="3460" y="707"/>
                </a:cubicBezTo>
                <a:close/>
                <a:moveTo>
                  <a:pt x="4061" y="244"/>
                </a:moveTo>
                <a:lnTo>
                  <a:pt x="4100" y="283"/>
                </a:lnTo>
                <a:lnTo>
                  <a:pt x="3878" y="505"/>
                </a:lnTo>
                <a:cubicBezTo>
                  <a:pt x="3868" y="496"/>
                  <a:pt x="3860" y="485"/>
                  <a:pt x="3854" y="472"/>
                </a:cubicBezTo>
                <a:cubicBezTo>
                  <a:pt x="3845" y="451"/>
                  <a:pt x="3839" y="427"/>
                  <a:pt x="3837" y="400"/>
                </a:cubicBezTo>
                <a:cubicBezTo>
                  <a:pt x="3835" y="373"/>
                  <a:pt x="3836" y="338"/>
                  <a:pt x="3840" y="295"/>
                </a:cubicBezTo>
                <a:cubicBezTo>
                  <a:pt x="3846" y="229"/>
                  <a:pt x="3847" y="180"/>
                  <a:pt x="3843" y="150"/>
                </a:cubicBezTo>
                <a:cubicBezTo>
                  <a:pt x="3838" y="120"/>
                  <a:pt x="3828" y="97"/>
                  <a:pt x="3812" y="81"/>
                </a:cubicBezTo>
                <a:cubicBezTo>
                  <a:pt x="3796" y="65"/>
                  <a:pt x="3776" y="57"/>
                  <a:pt x="3753" y="57"/>
                </a:cubicBezTo>
                <a:cubicBezTo>
                  <a:pt x="3731" y="58"/>
                  <a:pt x="3710" y="67"/>
                  <a:pt x="3691" y="86"/>
                </a:cubicBezTo>
                <a:cubicBezTo>
                  <a:pt x="3671" y="106"/>
                  <a:pt x="3661" y="128"/>
                  <a:pt x="3661" y="152"/>
                </a:cubicBezTo>
                <a:cubicBezTo>
                  <a:pt x="3661" y="176"/>
                  <a:pt x="3672" y="198"/>
                  <a:pt x="3693" y="219"/>
                </a:cubicBezTo>
                <a:lnTo>
                  <a:pt x="3646" y="257"/>
                </a:lnTo>
                <a:cubicBezTo>
                  <a:pt x="3617" y="223"/>
                  <a:pt x="3604" y="188"/>
                  <a:pt x="3606" y="152"/>
                </a:cubicBezTo>
                <a:cubicBezTo>
                  <a:pt x="3609" y="117"/>
                  <a:pt x="3626" y="83"/>
                  <a:pt x="3658" y="51"/>
                </a:cubicBezTo>
                <a:cubicBezTo>
                  <a:pt x="3690" y="19"/>
                  <a:pt x="3724" y="2"/>
                  <a:pt x="3761" y="1"/>
                </a:cubicBezTo>
                <a:cubicBezTo>
                  <a:pt x="3798" y="0"/>
                  <a:pt x="3829" y="13"/>
                  <a:pt x="3856" y="40"/>
                </a:cubicBezTo>
                <a:cubicBezTo>
                  <a:pt x="3869" y="53"/>
                  <a:pt x="3880" y="69"/>
                  <a:pt x="3887" y="88"/>
                </a:cubicBezTo>
                <a:cubicBezTo>
                  <a:pt x="3895" y="106"/>
                  <a:pt x="3899" y="129"/>
                  <a:pt x="3901" y="156"/>
                </a:cubicBezTo>
                <a:cubicBezTo>
                  <a:pt x="3902" y="183"/>
                  <a:pt x="3901" y="224"/>
                  <a:pt x="3896" y="279"/>
                </a:cubicBezTo>
                <a:cubicBezTo>
                  <a:pt x="3892" y="324"/>
                  <a:pt x="3891" y="354"/>
                  <a:pt x="3891" y="369"/>
                </a:cubicBezTo>
                <a:cubicBezTo>
                  <a:pt x="3891" y="383"/>
                  <a:pt x="3893" y="396"/>
                  <a:pt x="3896" y="408"/>
                </a:cubicBezTo>
                <a:lnTo>
                  <a:pt x="4061" y="244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97" name="Freeform 79"/>
          <p:cNvSpPr>
            <a:spLocks noEditPoints="1"/>
          </p:cNvSpPr>
          <p:nvPr/>
        </p:nvSpPr>
        <p:spPr bwMode="auto">
          <a:xfrm>
            <a:off x="6299378" y="4613062"/>
            <a:ext cx="768350" cy="768350"/>
          </a:xfrm>
          <a:custGeom>
            <a:avLst/>
            <a:gdLst>
              <a:gd name="T0" fmla="*/ 90 w 2019"/>
              <a:gd name="T1" fmla="*/ 1764 h 2020"/>
              <a:gd name="T2" fmla="*/ 199 w 2019"/>
              <a:gd name="T3" fmla="*/ 1822 h 2020"/>
              <a:gd name="T4" fmla="*/ 168 w 2019"/>
              <a:gd name="T5" fmla="*/ 2020 h 2020"/>
              <a:gd name="T6" fmla="*/ 154 w 2019"/>
              <a:gd name="T7" fmla="*/ 1796 h 2020"/>
              <a:gd name="T8" fmla="*/ 42 w 2019"/>
              <a:gd name="T9" fmla="*/ 1849 h 2020"/>
              <a:gd name="T10" fmla="*/ 220 w 2019"/>
              <a:gd name="T11" fmla="*/ 1631 h 2020"/>
              <a:gd name="T12" fmla="*/ 333 w 2019"/>
              <a:gd name="T13" fmla="*/ 1645 h 2020"/>
              <a:gd name="T14" fmla="*/ 420 w 2019"/>
              <a:gd name="T15" fmla="*/ 1714 h 2020"/>
              <a:gd name="T16" fmla="*/ 325 w 2019"/>
              <a:gd name="T17" fmla="*/ 1862 h 2020"/>
              <a:gd name="T18" fmla="*/ 310 w 2019"/>
              <a:gd name="T19" fmla="*/ 1662 h 2020"/>
              <a:gd name="T20" fmla="*/ 233 w 2019"/>
              <a:gd name="T21" fmla="*/ 1658 h 2020"/>
              <a:gd name="T22" fmla="*/ 370 w 2019"/>
              <a:gd name="T23" fmla="*/ 1778 h 2020"/>
              <a:gd name="T24" fmla="*/ 380 w 2019"/>
              <a:gd name="T25" fmla="*/ 1710 h 2020"/>
              <a:gd name="T26" fmla="*/ 270 w 2019"/>
              <a:gd name="T27" fmla="*/ 1763 h 2020"/>
              <a:gd name="T28" fmla="*/ 372 w 2019"/>
              <a:gd name="T29" fmla="*/ 1480 h 2020"/>
              <a:gd name="T30" fmla="*/ 536 w 2019"/>
              <a:gd name="T31" fmla="*/ 1482 h 2020"/>
              <a:gd name="T32" fmla="*/ 567 w 2019"/>
              <a:gd name="T33" fmla="*/ 1615 h 2020"/>
              <a:gd name="T34" fmla="*/ 520 w 2019"/>
              <a:gd name="T35" fmla="*/ 1628 h 2020"/>
              <a:gd name="T36" fmla="*/ 513 w 2019"/>
              <a:gd name="T37" fmla="*/ 1505 h 2020"/>
              <a:gd name="T38" fmla="*/ 356 w 2019"/>
              <a:gd name="T39" fmla="*/ 1535 h 2020"/>
              <a:gd name="T40" fmla="*/ 798 w 2019"/>
              <a:gd name="T41" fmla="*/ 1453 h 2020"/>
              <a:gd name="T42" fmla="*/ 616 w 2019"/>
              <a:gd name="T43" fmla="*/ 1235 h 2020"/>
              <a:gd name="T44" fmla="*/ 765 w 2019"/>
              <a:gd name="T45" fmla="*/ 1138 h 2020"/>
              <a:gd name="T46" fmla="*/ 738 w 2019"/>
              <a:gd name="T47" fmla="*/ 1313 h 2020"/>
              <a:gd name="T48" fmla="*/ 762 w 2019"/>
              <a:gd name="T49" fmla="*/ 1249 h 2020"/>
              <a:gd name="T50" fmla="*/ 724 w 2019"/>
              <a:gd name="T51" fmla="*/ 1171 h 2020"/>
              <a:gd name="T52" fmla="*/ 940 w 2019"/>
              <a:gd name="T53" fmla="*/ 1247 h 2020"/>
              <a:gd name="T54" fmla="*/ 814 w 2019"/>
              <a:gd name="T55" fmla="*/ 1077 h 2020"/>
              <a:gd name="T56" fmla="*/ 886 w 2019"/>
              <a:gd name="T57" fmla="*/ 1148 h 2020"/>
              <a:gd name="T58" fmla="*/ 940 w 2019"/>
              <a:gd name="T59" fmla="*/ 1247 h 2020"/>
              <a:gd name="T60" fmla="*/ 947 w 2019"/>
              <a:gd name="T61" fmla="*/ 904 h 2020"/>
              <a:gd name="T62" fmla="*/ 1039 w 2019"/>
              <a:gd name="T63" fmla="*/ 813 h 2020"/>
              <a:gd name="T64" fmla="*/ 1208 w 2019"/>
              <a:gd name="T65" fmla="*/ 980 h 2020"/>
              <a:gd name="T66" fmla="*/ 1108 w 2019"/>
              <a:gd name="T67" fmla="*/ 1080 h 2020"/>
              <a:gd name="T68" fmla="*/ 1171 w 2019"/>
              <a:gd name="T69" fmla="*/ 754 h 2020"/>
              <a:gd name="T70" fmla="*/ 1145 w 2019"/>
              <a:gd name="T71" fmla="*/ 750 h 2020"/>
              <a:gd name="T72" fmla="*/ 1467 w 2019"/>
              <a:gd name="T73" fmla="*/ 681 h 2020"/>
              <a:gd name="T74" fmla="*/ 1355 w 2019"/>
              <a:gd name="T75" fmla="*/ 759 h 2020"/>
              <a:gd name="T76" fmla="*/ 1314 w 2019"/>
              <a:gd name="T77" fmla="*/ 588 h 2020"/>
              <a:gd name="T78" fmla="*/ 1260 w 2019"/>
              <a:gd name="T79" fmla="*/ 688 h 2020"/>
              <a:gd name="T80" fmla="*/ 1365 w 2019"/>
              <a:gd name="T81" fmla="*/ 579 h 2020"/>
              <a:gd name="T82" fmla="*/ 1382 w 2019"/>
              <a:gd name="T83" fmla="*/ 743 h 2020"/>
              <a:gd name="T84" fmla="*/ 1411 w 2019"/>
              <a:gd name="T85" fmla="*/ 440 h 2020"/>
              <a:gd name="T86" fmla="*/ 1580 w 2019"/>
              <a:gd name="T87" fmla="*/ 608 h 2020"/>
              <a:gd name="T88" fmla="*/ 1580 w 2019"/>
              <a:gd name="T89" fmla="*/ 608 h 2020"/>
              <a:gd name="T90" fmla="*/ 1558 w 2019"/>
              <a:gd name="T91" fmla="*/ 297 h 2020"/>
              <a:gd name="T92" fmla="*/ 1667 w 2019"/>
              <a:gd name="T93" fmla="*/ 354 h 2020"/>
              <a:gd name="T94" fmla="*/ 1636 w 2019"/>
              <a:gd name="T95" fmla="*/ 552 h 2020"/>
              <a:gd name="T96" fmla="*/ 1622 w 2019"/>
              <a:gd name="T97" fmla="*/ 328 h 2020"/>
              <a:gd name="T98" fmla="*/ 1510 w 2019"/>
              <a:gd name="T99" fmla="*/ 381 h 2020"/>
              <a:gd name="T100" fmla="*/ 1777 w 2019"/>
              <a:gd name="T101" fmla="*/ 341 h 2020"/>
              <a:gd name="T102" fmla="*/ 1860 w 2019"/>
              <a:gd name="T103" fmla="*/ 265 h 2020"/>
              <a:gd name="T104" fmla="*/ 1769 w 2019"/>
              <a:gd name="T105" fmla="*/ 264 h 2020"/>
              <a:gd name="T106" fmla="*/ 1649 w 2019"/>
              <a:gd name="T107" fmla="*/ 242 h 2020"/>
              <a:gd name="T108" fmla="*/ 1757 w 2019"/>
              <a:gd name="T109" fmla="*/ 136 h 2020"/>
              <a:gd name="T110" fmla="*/ 1699 w 2019"/>
              <a:gd name="T111" fmla="*/ 186 h 2020"/>
              <a:gd name="T112" fmla="*/ 1753 w 2019"/>
              <a:gd name="T113" fmla="*/ 237 h 2020"/>
              <a:gd name="T114" fmla="*/ 1888 w 2019"/>
              <a:gd name="T115" fmla="*/ 256 h 2020"/>
              <a:gd name="T116" fmla="*/ 1769 w 2019"/>
              <a:gd name="T117" fmla="*/ 371 h 2020"/>
              <a:gd name="T118" fmla="*/ 1867 w 2019"/>
              <a:gd name="T119" fmla="*/ 58 h 2020"/>
              <a:gd name="T120" fmla="*/ 1841 w 2019"/>
              <a:gd name="T121" fmla="*/ 54 h 202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</a:cxnLst>
            <a:rect l="0" t="0" r="r" b="b"/>
            <a:pathLst>
              <a:path w="2019" h="2020">
                <a:moveTo>
                  <a:pt x="168" y="2020"/>
                </a:moveTo>
                <a:lnTo>
                  <a:pt x="0" y="1852"/>
                </a:lnTo>
                <a:lnTo>
                  <a:pt x="63" y="1788"/>
                </a:lnTo>
                <a:cubicBezTo>
                  <a:pt x="74" y="1777"/>
                  <a:pt x="83" y="1769"/>
                  <a:pt x="90" y="1764"/>
                </a:cubicBezTo>
                <a:cubicBezTo>
                  <a:pt x="100" y="1758"/>
                  <a:pt x="110" y="1753"/>
                  <a:pt x="119" y="1752"/>
                </a:cubicBezTo>
                <a:cubicBezTo>
                  <a:pt x="128" y="1750"/>
                  <a:pt x="138" y="1751"/>
                  <a:pt x="149" y="1754"/>
                </a:cubicBezTo>
                <a:cubicBezTo>
                  <a:pt x="159" y="1758"/>
                  <a:pt x="168" y="1764"/>
                  <a:pt x="177" y="1772"/>
                </a:cubicBezTo>
                <a:cubicBezTo>
                  <a:pt x="191" y="1786"/>
                  <a:pt x="199" y="1803"/>
                  <a:pt x="199" y="1822"/>
                </a:cubicBezTo>
                <a:cubicBezTo>
                  <a:pt x="200" y="1841"/>
                  <a:pt x="189" y="1862"/>
                  <a:pt x="165" y="1886"/>
                </a:cubicBezTo>
                <a:lnTo>
                  <a:pt x="122" y="1929"/>
                </a:lnTo>
                <a:lnTo>
                  <a:pt x="190" y="1998"/>
                </a:lnTo>
                <a:lnTo>
                  <a:pt x="168" y="2020"/>
                </a:lnTo>
                <a:close/>
                <a:moveTo>
                  <a:pt x="102" y="1909"/>
                </a:moveTo>
                <a:lnTo>
                  <a:pt x="145" y="1866"/>
                </a:lnTo>
                <a:cubicBezTo>
                  <a:pt x="160" y="1852"/>
                  <a:pt x="167" y="1839"/>
                  <a:pt x="168" y="1827"/>
                </a:cubicBezTo>
                <a:cubicBezTo>
                  <a:pt x="169" y="1816"/>
                  <a:pt x="164" y="1805"/>
                  <a:pt x="154" y="1796"/>
                </a:cubicBezTo>
                <a:cubicBezTo>
                  <a:pt x="147" y="1789"/>
                  <a:pt x="140" y="1785"/>
                  <a:pt x="131" y="1783"/>
                </a:cubicBezTo>
                <a:cubicBezTo>
                  <a:pt x="122" y="1782"/>
                  <a:pt x="115" y="1783"/>
                  <a:pt x="107" y="1787"/>
                </a:cubicBezTo>
                <a:cubicBezTo>
                  <a:pt x="102" y="1790"/>
                  <a:pt x="95" y="1796"/>
                  <a:pt x="85" y="1806"/>
                </a:cubicBezTo>
                <a:lnTo>
                  <a:pt x="42" y="1849"/>
                </a:lnTo>
                <a:lnTo>
                  <a:pt x="102" y="1909"/>
                </a:lnTo>
                <a:close/>
                <a:moveTo>
                  <a:pt x="325" y="1862"/>
                </a:moveTo>
                <a:lnTo>
                  <a:pt x="157" y="1694"/>
                </a:lnTo>
                <a:lnTo>
                  <a:pt x="220" y="1631"/>
                </a:lnTo>
                <a:cubicBezTo>
                  <a:pt x="233" y="1618"/>
                  <a:pt x="245" y="1610"/>
                  <a:pt x="256" y="1606"/>
                </a:cubicBezTo>
                <a:cubicBezTo>
                  <a:pt x="267" y="1601"/>
                  <a:pt x="279" y="1600"/>
                  <a:pt x="290" y="1603"/>
                </a:cubicBezTo>
                <a:cubicBezTo>
                  <a:pt x="302" y="1606"/>
                  <a:pt x="311" y="1611"/>
                  <a:pt x="319" y="1619"/>
                </a:cubicBezTo>
                <a:cubicBezTo>
                  <a:pt x="326" y="1626"/>
                  <a:pt x="331" y="1634"/>
                  <a:pt x="333" y="1645"/>
                </a:cubicBezTo>
                <a:cubicBezTo>
                  <a:pt x="336" y="1655"/>
                  <a:pt x="335" y="1666"/>
                  <a:pt x="331" y="1678"/>
                </a:cubicBezTo>
                <a:cubicBezTo>
                  <a:pt x="344" y="1671"/>
                  <a:pt x="357" y="1668"/>
                  <a:pt x="370" y="1670"/>
                </a:cubicBezTo>
                <a:cubicBezTo>
                  <a:pt x="383" y="1671"/>
                  <a:pt x="394" y="1677"/>
                  <a:pt x="404" y="1687"/>
                </a:cubicBezTo>
                <a:cubicBezTo>
                  <a:pt x="411" y="1695"/>
                  <a:pt x="417" y="1704"/>
                  <a:pt x="420" y="1714"/>
                </a:cubicBezTo>
                <a:cubicBezTo>
                  <a:pt x="424" y="1724"/>
                  <a:pt x="425" y="1733"/>
                  <a:pt x="424" y="1742"/>
                </a:cubicBezTo>
                <a:cubicBezTo>
                  <a:pt x="423" y="1750"/>
                  <a:pt x="419" y="1759"/>
                  <a:pt x="414" y="1768"/>
                </a:cubicBezTo>
                <a:cubicBezTo>
                  <a:pt x="408" y="1778"/>
                  <a:pt x="400" y="1788"/>
                  <a:pt x="389" y="1798"/>
                </a:cubicBezTo>
                <a:lnTo>
                  <a:pt x="325" y="1862"/>
                </a:lnTo>
                <a:close/>
                <a:moveTo>
                  <a:pt x="250" y="1743"/>
                </a:moveTo>
                <a:lnTo>
                  <a:pt x="286" y="1706"/>
                </a:lnTo>
                <a:cubicBezTo>
                  <a:pt x="296" y="1697"/>
                  <a:pt x="303" y="1689"/>
                  <a:pt x="306" y="1683"/>
                </a:cubicBezTo>
                <a:cubicBezTo>
                  <a:pt x="310" y="1676"/>
                  <a:pt x="311" y="1669"/>
                  <a:pt x="310" y="1662"/>
                </a:cubicBezTo>
                <a:cubicBezTo>
                  <a:pt x="309" y="1655"/>
                  <a:pt x="306" y="1649"/>
                  <a:pt x="300" y="1643"/>
                </a:cubicBezTo>
                <a:cubicBezTo>
                  <a:pt x="294" y="1638"/>
                  <a:pt x="288" y="1634"/>
                  <a:pt x="281" y="1632"/>
                </a:cubicBezTo>
                <a:cubicBezTo>
                  <a:pt x="274" y="1631"/>
                  <a:pt x="267" y="1632"/>
                  <a:pt x="261" y="1635"/>
                </a:cubicBezTo>
                <a:cubicBezTo>
                  <a:pt x="254" y="1639"/>
                  <a:pt x="245" y="1646"/>
                  <a:pt x="233" y="1658"/>
                </a:cubicBezTo>
                <a:lnTo>
                  <a:pt x="199" y="1692"/>
                </a:lnTo>
                <a:lnTo>
                  <a:pt x="250" y="1743"/>
                </a:lnTo>
                <a:close/>
                <a:moveTo>
                  <a:pt x="328" y="1820"/>
                </a:moveTo>
                <a:lnTo>
                  <a:pt x="370" y="1778"/>
                </a:lnTo>
                <a:cubicBezTo>
                  <a:pt x="377" y="1771"/>
                  <a:pt x="382" y="1766"/>
                  <a:pt x="384" y="1763"/>
                </a:cubicBezTo>
                <a:cubicBezTo>
                  <a:pt x="388" y="1757"/>
                  <a:pt x="391" y="1751"/>
                  <a:pt x="392" y="1745"/>
                </a:cubicBezTo>
                <a:cubicBezTo>
                  <a:pt x="393" y="1740"/>
                  <a:pt x="393" y="1734"/>
                  <a:pt x="391" y="1727"/>
                </a:cubicBezTo>
                <a:cubicBezTo>
                  <a:pt x="389" y="1721"/>
                  <a:pt x="386" y="1715"/>
                  <a:pt x="380" y="1710"/>
                </a:cubicBezTo>
                <a:cubicBezTo>
                  <a:pt x="374" y="1704"/>
                  <a:pt x="367" y="1700"/>
                  <a:pt x="359" y="1698"/>
                </a:cubicBezTo>
                <a:cubicBezTo>
                  <a:pt x="351" y="1697"/>
                  <a:pt x="344" y="1698"/>
                  <a:pt x="336" y="1702"/>
                </a:cubicBezTo>
                <a:cubicBezTo>
                  <a:pt x="329" y="1706"/>
                  <a:pt x="320" y="1713"/>
                  <a:pt x="309" y="1724"/>
                </a:cubicBezTo>
                <a:lnTo>
                  <a:pt x="270" y="1763"/>
                </a:lnTo>
                <a:lnTo>
                  <a:pt x="328" y="1820"/>
                </a:lnTo>
                <a:close/>
                <a:moveTo>
                  <a:pt x="482" y="1706"/>
                </a:moveTo>
                <a:lnTo>
                  <a:pt x="314" y="1538"/>
                </a:lnTo>
                <a:lnTo>
                  <a:pt x="372" y="1480"/>
                </a:lnTo>
                <a:cubicBezTo>
                  <a:pt x="385" y="1467"/>
                  <a:pt x="395" y="1458"/>
                  <a:pt x="404" y="1452"/>
                </a:cubicBezTo>
                <a:cubicBezTo>
                  <a:pt x="416" y="1445"/>
                  <a:pt x="428" y="1441"/>
                  <a:pt x="441" y="1440"/>
                </a:cubicBezTo>
                <a:cubicBezTo>
                  <a:pt x="457" y="1438"/>
                  <a:pt x="473" y="1441"/>
                  <a:pt x="489" y="1449"/>
                </a:cubicBezTo>
                <a:cubicBezTo>
                  <a:pt x="505" y="1456"/>
                  <a:pt x="521" y="1467"/>
                  <a:pt x="536" y="1482"/>
                </a:cubicBezTo>
                <a:cubicBezTo>
                  <a:pt x="549" y="1495"/>
                  <a:pt x="558" y="1508"/>
                  <a:pt x="565" y="1520"/>
                </a:cubicBezTo>
                <a:cubicBezTo>
                  <a:pt x="572" y="1533"/>
                  <a:pt x="576" y="1545"/>
                  <a:pt x="578" y="1556"/>
                </a:cubicBezTo>
                <a:cubicBezTo>
                  <a:pt x="580" y="1568"/>
                  <a:pt x="580" y="1578"/>
                  <a:pt x="578" y="1587"/>
                </a:cubicBezTo>
                <a:cubicBezTo>
                  <a:pt x="576" y="1596"/>
                  <a:pt x="572" y="1606"/>
                  <a:pt x="567" y="1615"/>
                </a:cubicBezTo>
                <a:cubicBezTo>
                  <a:pt x="561" y="1625"/>
                  <a:pt x="553" y="1635"/>
                  <a:pt x="542" y="1645"/>
                </a:cubicBezTo>
                <a:lnTo>
                  <a:pt x="482" y="1706"/>
                </a:lnTo>
                <a:close/>
                <a:moveTo>
                  <a:pt x="484" y="1664"/>
                </a:moveTo>
                <a:lnTo>
                  <a:pt x="520" y="1628"/>
                </a:lnTo>
                <a:cubicBezTo>
                  <a:pt x="531" y="1617"/>
                  <a:pt x="539" y="1607"/>
                  <a:pt x="543" y="1599"/>
                </a:cubicBezTo>
                <a:cubicBezTo>
                  <a:pt x="547" y="1590"/>
                  <a:pt x="549" y="1583"/>
                  <a:pt x="549" y="1575"/>
                </a:cubicBezTo>
                <a:cubicBezTo>
                  <a:pt x="549" y="1564"/>
                  <a:pt x="546" y="1553"/>
                  <a:pt x="540" y="1541"/>
                </a:cubicBezTo>
                <a:cubicBezTo>
                  <a:pt x="535" y="1530"/>
                  <a:pt x="525" y="1517"/>
                  <a:pt x="513" y="1505"/>
                </a:cubicBezTo>
                <a:cubicBezTo>
                  <a:pt x="495" y="1487"/>
                  <a:pt x="479" y="1476"/>
                  <a:pt x="463" y="1473"/>
                </a:cubicBezTo>
                <a:cubicBezTo>
                  <a:pt x="448" y="1469"/>
                  <a:pt x="435" y="1470"/>
                  <a:pt x="423" y="1475"/>
                </a:cubicBezTo>
                <a:cubicBezTo>
                  <a:pt x="415" y="1478"/>
                  <a:pt x="404" y="1487"/>
                  <a:pt x="391" y="1500"/>
                </a:cubicBezTo>
                <a:lnTo>
                  <a:pt x="356" y="1535"/>
                </a:lnTo>
                <a:lnTo>
                  <a:pt x="484" y="1664"/>
                </a:lnTo>
                <a:close/>
                <a:moveTo>
                  <a:pt x="677" y="1605"/>
                </a:moveTo>
                <a:lnTo>
                  <a:pt x="662" y="1590"/>
                </a:lnTo>
                <a:lnTo>
                  <a:pt x="798" y="1453"/>
                </a:lnTo>
                <a:lnTo>
                  <a:pt x="813" y="1468"/>
                </a:lnTo>
                <a:lnTo>
                  <a:pt x="677" y="1605"/>
                </a:lnTo>
                <a:close/>
                <a:moveTo>
                  <a:pt x="784" y="1403"/>
                </a:moveTo>
                <a:lnTo>
                  <a:pt x="616" y="1235"/>
                </a:lnTo>
                <a:lnTo>
                  <a:pt x="680" y="1172"/>
                </a:lnTo>
                <a:cubicBezTo>
                  <a:pt x="691" y="1161"/>
                  <a:pt x="700" y="1153"/>
                  <a:pt x="707" y="1148"/>
                </a:cubicBezTo>
                <a:cubicBezTo>
                  <a:pt x="717" y="1141"/>
                  <a:pt x="726" y="1137"/>
                  <a:pt x="736" y="1135"/>
                </a:cubicBezTo>
                <a:cubicBezTo>
                  <a:pt x="745" y="1133"/>
                  <a:pt x="755" y="1134"/>
                  <a:pt x="765" y="1138"/>
                </a:cubicBezTo>
                <a:cubicBezTo>
                  <a:pt x="776" y="1141"/>
                  <a:pt x="785" y="1147"/>
                  <a:pt x="793" y="1156"/>
                </a:cubicBezTo>
                <a:cubicBezTo>
                  <a:pt x="808" y="1170"/>
                  <a:pt x="815" y="1186"/>
                  <a:pt x="816" y="1205"/>
                </a:cubicBezTo>
                <a:cubicBezTo>
                  <a:pt x="817" y="1224"/>
                  <a:pt x="805" y="1246"/>
                  <a:pt x="781" y="1270"/>
                </a:cubicBezTo>
                <a:lnTo>
                  <a:pt x="738" y="1313"/>
                </a:lnTo>
                <a:lnTo>
                  <a:pt x="807" y="1381"/>
                </a:lnTo>
                <a:lnTo>
                  <a:pt x="784" y="1403"/>
                </a:lnTo>
                <a:close/>
                <a:moveTo>
                  <a:pt x="719" y="1293"/>
                </a:moveTo>
                <a:lnTo>
                  <a:pt x="762" y="1249"/>
                </a:lnTo>
                <a:cubicBezTo>
                  <a:pt x="776" y="1235"/>
                  <a:pt x="784" y="1222"/>
                  <a:pt x="785" y="1211"/>
                </a:cubicBezTo>
                <a:cubicBezTo>
                  <a:pt x="785" y="1199"/>
                  <a:pt x="781" y="1189"/>
                  <a:pt x="771" y="1179"/>
                </a:cubicBezTo>
                <a:cubicBezTo>
                  <a:pt x="764" y="1172"/>
                  <a:pt x="756" y="1168"/>
                  <a:pt x="748" y="1166"/>
                </a:cubicBezTo>
                <a:cubicBezTo>
                  <a:pt x="739" y="1165"/>
                  <a:pt x="731" y="1166"/>
                  <a:pt x="724" y="1171"/>
                </a:cubicBezTo>
                <a:cubicBezTo>
                  <a:pt x="719" y="1173"/>
                  <a:pt x="712" y="1180"/>
                  <a:pt x="701" y="1190"/>
                </a:cubicBezTo>
                <a:lnTo>
                  <a:pt x="658" y="1233"/>
                </a:lnTo>
                <a:lnTo>
                  <a:pt x="719" y="1293"/>
                </a:lnTo>
                <a:close/>
                <a:moveTo>
                  <a:pt x="940" y="1247"/>
                </a:moveTo>
                <a:lnTo>
                  <a:pt x="772" y="1079"/>
                </a:lnTo>
                <a:lnTo>
                  <a:pt x="894" y="958"/>
                </a:lnTo>
                <a:lnTo>
                  <a:pt x="914" y="978"/>
                </a:lnTo>
                <a:lnTo>
                  <a:pt x="814" y="1077"/>
                </a:lnTo>
                <a:lnTo>
                  <a:pt x="866" y="1128"/>
                </a:lnTo>
                <a:lnTo>
                  <a:pt x="959" y="1035"/>
                </a:lnTo>
                <a:lnTo>
                  <a:pt x="979" y="1055"/>
                </a:lnTo>
                <a:lnTo>
                  <a:pt x="886" y="1148"/>
                </a:lnTo>
                <a:lnTo>
                  <a:pt x="943" y="1205"/>
                </a:lnTo>
                <a:lnTo>
                  <a:pt x="1046" y="1102"/>
                </a:lnTo>
                <a:lnTo>
                  <a:pt x="1066" y="1122"/>
                </a:lnTo>
                <a:lnTo>
                  <a:pt x="940" y="1247"/>
                </a:lnTo>
                <a:close/>
                <a:moveTo>
                  <a:pt x="1081" y="1106"/>
                </a:moveTo>
                <a:lnTo>
                  <a:pt x="1059" y="954"/>
                </a:lnTo>
                <a:lnTo>
                  <a:pt x="921" y="931"/>
                </a:lnTo>
                <a:lnTo>
                  <a:pt x="947" y="904"/>
                </a:lnTo>
                <a:lnTo>
                  <a:pt x="1021" y="917"/>
                </a:lnTo>
                <a:cubicBezTo>
                  <a:pt x="1036" y="919"/>
                  <a:pt x="1048" y="922"/>
                  <a:pt x="1055" y="924"/>
                </a:cubicBezTo>
                <a:cubicBezTo>
                  <a:pt x="1053" y="914"/>
                  <a:pt x="1051" y="903"/>
                  <a:pt x="1049" y="891"/>
                </a:cubicBezTo>
                <a:lnTo>
                  <a:pt x="1039" y="813"/>
                </a:lnTo>
                <a:lnTo>
                  <a:pt x="1063" y="789"/>
                </a:lnTo>
                <a:lnTo>
                  <a:pt x="1083" y="927"/>
                </a:lnTo>
                <a:lnTo>
                  <a:pt x="1235" y="952"/>
                </a:lnTo>
                <a:lnTo>
                  <a:pt x="1208" y="980"/>
                </a:lnTo>
                <a:lnTo>
                  <a:pt x="1106" y="962"/>
                </a:lnTo>
                <a:cubicBezTo>
                  <a:pt x="1100" y="961"/>
                  <a:pt x="1094" y="960"/>
                  <a:pt x="1087" y="958"/>
                </a:cubicBezTo>
                <a:cubicBezTo>
                  <a:pt x="1089" y="968"/>
                  <a:pt x="1091" y="975"/>
                  <a:pt x="1092" y="979"/>
                </a:cubicBezTo>
                <a:lnTo>
                  <a:pt x="1108" y="1080"/>
                </a:lnTo>
                <a:lnTo>
                  <a:pt x="1081" y="1106"/>
                </a:lnTo>
                <a:close/>
                <a:moveTo>
                  <a:pt x="1323" y="864"/>
                </a:moveTo>
                <a:lnTo>
                  <a:pt x="1303" y="885"/>
                </a:lnTo>
                <a:lnTo>
                  <a:pt x="1171" y="754"/>
                </a:lnTo>
                <a:cubicBezTo>
                  <a:pt x="1171" y="763"/>
                  <a:pt x="1169" y="775"/>
                  <a:pt x="1166" y="787"/>
                </a:cubicBezTo>
                <a:cubicBezTo>
                  <a:pt x="1163" y="800"/>
                  <a:pt x="1159" y="811"/>
                  <a:pt x="1155" y="820"/>
                </a:cubicBezTo>
                <a:lnTo>
                  <a:pt x="1135" y="800"/>
                </a:lnTo>
                <a:cubicBezTo>
                  <a:pt x="1141" y="783"/>
                  <a:pt x="1144" y="766"/>
                  <a:pt x="1145" y="750"/>
                </a:cubicBezTo>
                <a:cubicBezTo>
                  <a:pt x="1146" y="733"/>
                  <a:pt x="1145" y="720"/>
                  <a:pt x="1141" y="709"/>
                </a:cubicBezTo>
                <a:lnTo>
                  <a:pt x="1155" y="696"/>
                </a:lnTo>
                <a:lnTo>
                  <a:pt x="1323" y="864"/>
                </a:lnTo>
                <a:close/>
                <a:moveTo>
                  <a:pt x="1467" y="681"/>
                </a:moveTo>
                <a:lnTo>
                  <a:pt x="1487" y="701"/>
                </a:lnTo>
                <a:lnTo>
                  <a:pt x="1376" y="812"/>
                </a:lnTo>
                <a:cubicBezTo>
                  <a:pt x="1371" y="807"/>
                  <a:pt x="1367" y="801"/>
                  <a:pt x="1364" y="795"/>
                </a:cubicBezTo>
                <a:cubicBezTo>
                  <a:pt x="1359" y="785"/>
                  <a:pt x="1356" y="773"/>
                  <a:pt x="1355" y="759"/>
                </a:cubicBezTo>
                <a:cubicBezTo>
                  <a:pt x="1354" y="746"/>
                  <a:pt x="1355" y="728"/>
                  <a:pt x="1357" y="707"/>
                </a:cubicBezTo>
                <a:cubicBezTo>
                  <a:pt x="1360" y="673"/>
                  <a:pt x="1361" y="649"/>
                  <a:pt x="1358" y="634"/>
                </a:cubicBezTo>
                <a:cubicBezTo>
                  <a:pt x="1356" y="619"/>
                  <a:pt x="1351" y="607"/>
                  <a:pt x="1343" y="600"/>
                </a:cubicBezTo>
                <a:cubicBezTo>
                  <a:pt x="1335" y="591"/>
                  <a:pt x="1325" y="587"/>
                  <a:pt x="1314" y="588"/>
                </a:cubicBezTo>
                <a:cubicBezTo>
                  <a:pt x="1302" y="588"/>
                  <a:pt x="1292" y="593"/>
                  <a:pt x="1282" y="602"/>
                </a:cubicBezTo>
                <a:cubicBezTo>
                  <a:pt x="1272" y="612"/>
                  <a:pt x="1267" y="623"/>
                  <a:pt x="1267" y="635"/>
                </a:cubicBezTo>
                <a:cubicBezTo>
                  <a:pt x="1267" y="647"/>
                  <a:pt x="1273" y="658"/>
                  <a:pt x="1283" y="669"/>
                </a:cubicBezTo>
                <a:lnTo>
                  <a:pt x="1260" y="688"/>
                </a:lnTo>
                <a:cubicBezTo>
                  <a:pt x="1245" y="671"/>
                  <a:pt x="1239" y="653"/>
                  <a:pt x="1240" y="635"/>
                </a:cubicBezTo>
                <a:cubicBezTo>
                  <a:pt x="1241" y="617"/>
                  <a:pt x="1250" y="601"/>
                  <a:pt x="1266" y="585"/>
                </a:cubicBezTo>
                <a:cubicBezTo>
                  <a:pt x="1282" y="569"/>
                  <a:pt x="1299" y="560"/>
                  <a:pt x="1317" y="560"/>
                </a:cubicBezTo>
                <a:cubicBezTo>
                  <a:pt x="1336" y="559"/>
                  <a:pt x="1351" y="566"/>
                  <a:pt x="1365" y="579"/>
                </a:cubicBezTo>
                <a:cubicBezTo>
                  <a:pt x="1371" y="586"/>
                  <a:pt x="1377" y="594"/>
                  <a:pt x="1380" y="603"/>
                </a:cubicBezTo>
                <a:cubicBezTo>
                  <a:pt x="1384" y="612"/>
                  <a:pt x="1386" y="624"/>
                  <a:pt x="1387" y="637"/>
                </a:cubicBezTo>
                <a:cubicBezTo>
                  <a:pt x="1388" y="651"/>
                  <a:pt x="1387" y="671"/>
                  <a:pt x="1385" y="698"/>
                </a:cubicBezTo>
                <a:cubicBezTo>
                  <a:pt x="1383" y="721"/>
                  <a:pt x="1382" y="736"/>
                  <a:pt x="1382" y="743"/>
                </a:cubicBezTo>
                <a:cubicBezTo>
                  <a:pt x="1382" y="751"/>
                  <a:pt x="1383" y="757"/>
                  <a:pt x="1385" y="763"/>
                </a:cubicBezTo>
                <a:lnTo>
                  <a:pt x="1467" y="681"/>
                </a:lnTo>
                <a:close/>
                <a:moveTo>
                  <a:pt x="1435" y="464"/>
                </a:moveTo>
                <a:lnTo>
                  <a:pt x="1411" y="440"/>
                </a:lnTo>
                <a:lnTo>
                  <a:pt x="1432" y="420"/>
                </a:lnTo>
                <a:lnTo>
                  <a:pt x="1456" y="443"/>
                </a:lnTo>
                <a:lnTo>
                  <a:pt x="1435" y="464"/>
                </a:lnTo>
                <a:close/>
                <a:moveTo>
                  <a:pt x="1580" y="608"/>
                </a:moveTo>
                <a:lnTo>
                  <a:pt x="1458" y="486"/>
                </a:lnTo>
                <a:lnTo>
                  <a:pt x="1478" y="466"/>
                </a:lnTo>
                <a:lnTo>
                  <a:pt x="1600" y="588"/>
                </a:lnTo>
                <a:lnTo>
                  <a:pt x="1580" y="608"/>
                </a:lnTo>
                <a:close/>
                <a:moveTo>
                  <a:pt x="1636" y="552"/>
                </a:moveTo>
                <a:lnTo>
                  <a:pt x="1468" y="384"/>
                </a:lnTo>
                <a:lnTo>
                  <a:pt x="1531" y="320"/>
                </a:lnTo>
                <a:cubicBezTo>
                  <a:pt x="1542" y="309"/>
                  <a:pt x="1551" y="301"/>
                  <a:pt x="1558" y="297"/>
                </a:cubicBezTo>
                <a:cubicBezTo>
                  <a:pt x="1568" y="290"/>
                  <a:pt x="1577" y="285"/>
                  <a:pt x="1587" y="284"/>
                </a:cubicBezTo>
                <a:cubicBezTo>
                  <a:pt x="1596" y="282"/>
                  <a:pt x="1606" y="283"/>
                  <a:pt x="1617" y="286"/>
                </a:cubicBezTo>
                <a:cubicBezTo>
                  <a:pt x="1627" y="290"/>
                  <a:pt x="1636" y="296"/>
                  <a:pt x="1645" y="304"/>
                </a:cubicBezTo>
                <a:cubicBezTo>
                  <a:pt x="1659" y="318"/>
                  <a:pt x="1666" y="335"/>
                  <a:pt x="1667" y="354"/>
                </a:cubicBezTo>
                <a:cubicBezTo>
                  <a:pt x="1668" y="373"/>
                  <a:pt x="1657" y="394"/>
                  <a:pt x="1633" y="418"/>
                </a:cubicBezTo>
                <a:lnTo>
                  <a:pt x="1590" y="461"/>
                </a:lnTo>
                <a:lnTo>
                  <a:pt x="1658" y="530"/>
                </a:lnTo>
                <a:lnTo>
                  <a:pt x="1636" y="552"/>
                </a:lnTo>
                <a:close/>
                <a:moveTo>
                  <a:pt x="1570" y="442"/>
                </a:moveTo>
                <a:lnTo>
                  <a:pt x="1613" y="398"/>
                </a:lnTo>
                <a:cubicBezTo>
                  <a:pt x="1628" y="384"/>
                  <a:pt x="1635" y="371"/>
                  <a:pt x="1636" y="359"/>
                </a:cubicBezTo>
                <a:cubicBezTo>
                  <a:pt x="1637" y="348"/>
                  <a:pt x="1632" y="338"/>
                  <a:pt x="1622" y="328"/>
                </a:cubicBezTo>
                <a:cubicBezTo>
                  <a:pt x="1615" y="321"/>
                  <a:pt x="1608" y="317"/>
                  <a:pt x="1599" y="315"/>
                </a:cubicBezTo>
                <a:cubicBezTo>
                  <a:pt x="1590" y="314"/>
                  <a:pt x="1582" y="315"/>
                  <a:pt x="1575" y="319"/>
                </a:cubicBezTo>
                <a:cubicBezTo>
                  <a:pt x="1570" y="322"/>
                  <a:pt x="1563" y="328"/>
                  <a:pt x="1553" y="338"/>
                </a:cubicBezTo>
                <a:lnTo>
                  <a:pt x="1510" y="381"/>
                </a:lnTo>
                <a:lnTo>
                  <a:pt x="1570" y="442"/>
                </a:lnTo>
                <a:close/>
                <a:moveTo>
                  <a:pt x="1730" y="350"/>
                </a:moveTo>
                <a:lnTo>
                  <a:pt x="1749" y="327"/>
                </a:lnTo>
                <a:cubicBezTo>
                  <a:pt x="1758" y="335"/>
                  <a:pt x="1768" y="339"/>
                  <a:pt x="1777" y="341"/>
                </a:cubicBezTo>
                <a:cubicBezTo>
                  <a:pt x="1786" y="343"/>
                  <a:pt x="1796" y="341"/>
                  <a:pt x="1807" y="337"/>
                </a:cubicBezTo>
                <a:cubicBezTo>
                  <a:pt x="1818" y="333"/>
                  <a:pt x="1828" y="326"/>
                  <a:pt x="1837" y="316"/>
                </a:cubicBezTo>
                <a:cubicBezTo>
                  <a:pt x="1846" y="308"/>
                  <a:pt x="1852" y="299"/>
                  <a:pt x="1856" y="290"/>
                </a:cubicBezTo>
                <a:cubicBezTo>
                  <a:pt x="1860" y="281"/>
                  <a:pt x="1861" y="273"/>
                  <a:pt x="1860" y="265"/>
                </a:cubicBezTo>
                <a:cubicBezTo>
                  <a:pt x="1859" y="258"/>
                  <a:pt x="1856" y="251"/>
                  <a:pt x="1851" y="246"/>
                </a:cubicBezTo>
                <a:cubicBezTo>
                  <a:pt x="1845" y="241"/>
                  <a:pt x="1839" y="238"/>
                  <a:pt x="1832" y="237"/>
                </a:cubicBezTo>
                <a:cubicBezTo>
                  <a:pt x="1825" y="236"/>
                  <a:pt x="1817" y="238"/>
                  <a:pt x="1807" y="242"/>
                </a:cubicBezTo>
                <a:cubicBezTo>
                  <a:pt x="1801" y="245"/>
                  <a:pt x="1788" y="252"/>
                  <a:pt x="1769" y="264"/>
                </a:cubicBezTo>
                <a:cubicBezTo>
                  <a:pt x="1750" y="275"/>
                  <a:pt x="1736" y="283"/>
                  <a:pt x="1726" y="286"/>
                </a:cubicBezTo>
                <a:cubicBezTo>
                  <a:pt x="1714" y="289"/>
                  <a:pt x="1703" y="290"/>
                  <a:pt x="1692" y="288"/>
                </a:cubicBezTo>
                <a:cubicBezTo>
                  <a:pt x="1682" y="286"/>
                  <a:pt x="1673" y="281"/>
                  <a:pt x="1666" y="273"/>
                </a:cubicBezTo>
                <a:cubicBezTo>
                  <a:pt x="1657" y="264"/>
                  <a:pt x="1652" y="254"/>
                  <a:pt x="1649" y="242"/>
                </a:cubicBezTo>
                <a:cubicBezTo>
                  <a:pt x="1646" y="230"/>
                  <a:pt x="1648" y="217"/>
                  <a:pt x="1653" y="204"/>
                </a:cubicBezTo>
                <a:cubicBezTo>
                  <a:pt x="1659" y="191"/>
                  <a:pt x="1667" y="179"/>
                  <a:pt x="1678" y="167"/>
                </a:cubicBezTo>
                <a:cubicBezTo>
                  <a:pt x="1691" y="155"/>
                  <a:pt x="1704" y="146"/>
                  <a:pt x="1717" y="141"/>
                </a:cubicBezTo>
                <a:cubicBezTo>
                  <a:pt x="1731" y="135"/>
                  <a:pt x="1744" y="134"/>
                  <a:pt x="1757" y="136"/>
                </a:cubicBezTo>
                <a:cubicBezTo>
                  <a:pt x="1770" y="139"/>
                  <a:pt x="1782" y="145"/>
                  <a:pt x="1792" y="154"/>
                </a:cubicBezTo>
                <a:lnTo>
                  <a:pt x="1772" y="177"/>
                </a:lnTo>
                <a:cubicBezTo>
                  <a:pt x="1760" y="168"/>
                  <a:pt x="1748" y="164"/>
                  <a:pt x="1736" y="165"/>
                </a:cubicBezTo>
                <a:cubicBezTo>
                  <a:pt x="1724" y="166"/>
                  <a:pt x="1712" y="173"/>
                  <a:pt x="1699" y="186"/>
                </a:cubicBezTo>
                <a:cubicBezTo>
                  <a:pt x="1686" y="200"/>
                  <a:pt x="1678" y="212"/>
                  <a:pt x="1677" y="223"/>
                </a:cubicBezTo>
                <a:cubicBezTo>
                  <a:pt x="1676" y="234"/>
                  <a:pt x="1679" y="243"/>
                  <a:pt x="1686" y="250"/>
                </a:cubicBezTo>
                <a:cubicBezTo>
                  <a:pt x="1692" y="256"/>
                  <a:pt x="1699" y="259"/>
                  <a:pt x="1707" y="258"/>
                </a:cubicBezTo>
                <a:cubicBezTo>
                  <a:pt x="1715" y="258"/>
                  <a:pt x="1730" y="251"/>
                  <a:pt x="1753" y="237"/>
                </a:cubicBezTo>
                <a:cubicBezTo>
                  <a:pt x="1775" y="223"/>
                  <a:pt x="1791" y="214"/>
                  <a:pt x="1800" y="210"/>
                </a:cubicBezTo>
                <a:cubicBezTo>
                  <a:pt x="1815" y="205"/>
                  <a:pt x="1828" y="204"/>
                  <a:pt x="1839" y="206"/>
                </a:cubicBezTo>
                <a:cubicBezTo>
                  <a:pt x="1851" y="208"/>
                  <a:pt x="1861" y="214"/>
                  <a:pt x="1870" y="223"/>
                </a:cubicBezTo>
                <a:cubicBezTo>
                  <a:pt x="1879" y="232"/>
                  <a:pt x="1885" y="243"/>
                  <a:pt x="1888" y="256"/>
                </a:cubicBezTo>
                <a:cubicBezTo>
                  <a:pt x="1891" y="269"/>
                  <a:pt x="1889" y="282"/>
                  <a:pt x="1884" y="296"/>
                </a:cubicBezTo>
                <a:cubicBezTo>
                  <a:pt x="1879" y="310"/>
                  <a:pt x="1870" y="323"/>
                  <a:pt x="1858" y="335"/>
                </a:cubicBezTo>
                <a:cubicBezTo>
                  <a:pt x="1843" y="350"/>
                  <a:pt x="1828" y="361"/>
                  <a:pt x="1813" y="367"/>
                </a:cubicBezTo>
                <a:cubicBezTo>
                  <a:pt x="1799" y="373"/>
                  <a:pt x="1784" y="374"/>
                  <a:pt x="1769" y="371"/>
                </a:cubicBezTo>
                <a:cubicBezTo>
                  <a:pt x="1754" y="368"/>
                  <a:pt x="1741" y="361"/>
                  <a:pt x="1730" y="350"/>
                </a:cubicBezTo>
                <a:close/>
                <a:moveTo>
                  <a:pt x="2019" y="169"/>
                </a:moveTo>
                <a:lnTo>
                  <a:pt x="1998" y="189"/>
                </a:lnTo>
                <a:lnTo>
                  <a:pt x="1867" y="58"/>
                </a:lnTo>
                <a:cubicBezTo>
                  <a:pt x="1867" y="67"/>
                  <a:pt x="1865" y="79"/>
                  <a:pt x="1862" y="92"/>
                </a:cubicBezTo>
                <a:cubicBezTo>
                  <a:pt x="1858" y="104"/>
                  <a:pt x="1855" y="115"/>
                  <a:pt x="1851" y="124"/>
                </a:cubicBezTo>
                <a:lnTo>
                  <a:pt x="1831" y="104"/>
                </a:lnTo>
                <a:cubicBezTo>
                  <a:pt x="1837" y="87"/>
                  <a:pt x="1840" y="70"/>
                  <a:pt x="1841" y="54"/>
                </a:cubicBezTo>
                <a:cubicBezTo>
                  <a:pt x="1842" y="38"/>
                  <a:pt x="1841" y="24"/>
                  <a:pt x="1837" y="13"/>
                </a:cubicBezTo>
                <a:lnTo>
                  <a:pt x="1850" y="0"/>
                </a:lnTo>
                <a:lnTo>
                  <a:pt x="2019" y="169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98" name="Freeform 80"/>
          <p:cNvSpPr>
            <a:spLocks noEditPoints="1"/>
          </p:cNvSpPr>
          <p:nvPr/>
        </p:nvSpPr>
        <p:spPr bwMode="auto">
          <a:xfrm>
            <a:off x="6547028" y="4611475"/>
            <a:ext cx="781050" cy="769937"/>
          </a:xfrm>
          <a:custGeom>
            <a:avLst/>
            <a:gdLst>
              <a:gd name="T0" fmla="*/ 119 w 2050"/>
              <a:gd name="T1" fmla="*/ 1756 h 2024"/>
              <a:gd name="T2" fmla="*/ 122 w 2050"/>
              <a:gd name="T3" fmla="*/ 1933 h 2024"/>
              <a:gd name="T4" fmla="*/ 168 w 2050"/>
              <a:gd name="T5" fmla="*/ 1831 h 2024"/>
              <a:gd name="T6" fmla="*/ 42 w 2050"/>
              <a:gd name="T7" fmla="*/ 1853 h 2024"/>
              <a:gd name="T8" fmla="*/ 257 w 2050"/>
              <a:gd name="T9" fmla="*/ 1610 h 2024"/>
              <a:gd name="T10" fmla="*/ 370 w 2050"/>
              <a:gd name="T11" fmla="*/ 1674 h 2024"/>
              <a:gd name="T12" fmla="*/ 390 w 2050"/>
              <a:gd name="T13" fmla="*/ 1802 h 2024"/>
              <a:gd name="T14" fmla="*/ 310 w 2050"/>
              <a:gd name="T15" fmla="*/ 1666 h 2024"/>
              <a:gd name="T16" fmla="*/ 200 w 2050"/>
              <a:gd name="T17" fmla="*/ 1696 h 2024"/>
              <a:gd name="T18" fmla="*/ 392 w 2050"/>
              <a:gd name="T19" fmla="*/ 1749 h 2024"/>
              <a:gd name="T20" fmla="*/ 309 w 2050"/>
              <a:gd name="T21" fmla="*/ 1728 h 2024"/>
              <a:gd name="T22" fmla="*/ 372 w 2050"/>
              <a:gd name="T23" fmla="*/ 1484 h 2024"/>
              <a:gd name="T24" fmla="*/ 565 w 2050"/>
              <a:gd name="T25" fmla="*/ 1524 h 2024"/>
              <a:gd name="T26" fmla="*/ 482 w 2050"/>
              <a:gd name="T27" fmla="*/ 1710 h 2024"/>
              <a:gd name="T28" fmla="*/ 541 w 2050"/>
              <a:gd name="T29" fmla="*/ 1545 h 2024"/>
              <a:gd name="T30" fmla="*/ 356 w 2050"/>
              <a:gd name="T31" fmla="*/ 1539 h 2024"/>
              <a:gd name="T32" fmla="*/ 813 w 2050"/>
              <a:gd name="T33" fmla="*/ 1472 h 2024"/>
              <a:gd name="T34" fmla="*/ 707 w 2050"/>
              <a:gd name="T35" fmla="*/ 1152 h 2024"/>
              <a:gd name="T36" fmla="*/ 782 w 2050"/>
              <a:gd name="T37" fmla="*/ 1274 h 2024"/>
              <a:gd name="T38" fmla="*/ 762 w 2050"/>
              <a:gd name="T39" fmla="*/ 1253 h 2024"/>
              <a:gd name="T40" fmla="*/ 702 w 2050"/>
              <a:gd name="T41" fmla="*/ 1194 h 2024"/>
              <a:gd name="T42" fmla="*/ 894 w 2050"/>
              <a:gd name="T43" fmla="*/ 962 h 2024"/>
              <a:gd name="T44" fmla="*/ 979 w 2050"/>
              <a:gd name="T45" fmla="*/ 1059 h 2024"/>
              <a:gd name="T46" fmla="*/ 941 w 2050"/>
              <a:gd name="T47" fmla="*/ 1251 h 2024"/>
              <a:gd name="T48" fmla="*/ 1021 w 2050"/>
              <a:gd name="T49" fmla="*/ 921 h 2024"/>
              <a:gd name="T50" fmla="*/ 1083 w 2050"/>
              <a:gd name="T51" fmla="*/ 931 h 2024"/>
              <a:gd name="T52" fmla="*/ 1092 w 2050"/>
              <a:gd name="T53" fmla="*/ 983 h 2024"/>
              <a:gd name="T54" fmla="*/ 1171 w 2050"/>
              <a:gd name="T55" fmla="*/ 758 h 2024"/>
              <a:gd name="T56" fmla="*/ 1141 w 2050"/>
              <a:gd name="T57" fmla="*/ 713 h 2024"/>
              <a:gd name="T58" fmla="*/ 1376 w 2050"/>
              <a:gd name="T59" fmla="*/ 816 h 2024"/>
              <a:gd name="T60" fmla="*/ 1343 w 2050"/>
              <a:gd name="T61" fmla="*/ 604 h 2024"/>
              <a:gd name="T62" fmla="*/ 1260 w 2050"/>
              <a:gd name="T63" fmla="*/ 692 h 2024"/>
              <a:gd name="T64" fmla="*/ 1381 w 2050"/>
              <a:gd name="T65" fmla="*/ 607 h 2024"/>
              <a:gd name="T66" fmla="*/ 1467 w 2050"/>
              <a:gd name="T67" fmla="*/ 685 h 2024"/>
              <a:gd name="T68" fmla="*/ 1435 w 2050"/>
              <a:gd name="T69" fmla="*/ 468 h 2024"/>
              <a:gd name="T70" fmla="*/ 1580 w 2050"/>
              <a:gd name="T71" fmla="*/ 612 h 2024"/>
              <a:gd name="T72" fmla="*/ 1587 w 2050"/>
              <a:gd name="T73" fmla="*/ 288 h 2024"/>
              <a:gd name="T74" fmla="*/ 1590 w 2050"/>
              <a:gd name="T75" fmla="*/ 465 h 2024"/>
              <a:gd name="T76" fmla="*/ 1636 w 2050"/>
              <a:gd name="T77" fmla="*/ 363 h 2024"/>
              <a:gd name="T78" fmla="*/ 1510 w 2050"/>
              <a:gd name="T79" fmla="*/ 385 h 2024"/>
              <a:gd name="T80" fmla="*/ 1807 w 2050"/>
              <a:gd name="T81" fmla="*/ 341 h 2024"/>
              <a:gd name="T82" fmla="*/ 1832 w 2050"/>
              <a:gd name="T83" fmla="*/ 241 h 2024"/>
              <a:gd name="T84" fmla="*/ 1666 w 2050"/>
              <a:gd name="T85" fmla="*/ 277 h 2024"/>
              <a:gd name="T86" fmla="*/ 1757 w 2050"/>
              <a:gd name="T87" fmla="*/ 140 h 2024"/>
              <a:gd name="T88" fmla="*/ 1677 w 2050"/>
              <a:gd name="T89" fmla="*/ 227 h 2024"/>
              <a:gd name="T90" fmla="*/ 1839 w 2050"/>
              <a:gd name="T91" fmla="*/ 210 h 2024"/>
              <a:gd name="T92" fmla="*/ 1814 w 2050"/>
              <a:gd name="T93" fmla="*/ 371 h 2024"/>
              <a:gd name="T94" fmla="*/ 1939 w 2050"/>
              <a:gd name="T95" fmla="*/ 253 h 2024"/>
              <a:gd name="T96" fmla="*/ 1906 w 2050"/>
              <a:gd name="T97" fmla="*/ 41 h 2024"/>
              <a:gd name="T98" fmla="*/ 1823 w 2050"/>
              <a:gd name="T99" fmla="*/ 129 h 2024"/>
              <a:gd name="T100" fmla="*/ 1943 w 2050"/>
              <a:gd name="T101" fmla="*/ 44 h 2024"/>
              <a:gd name="T102" fmla="*/ 2030 w 2050"/>
              <a:gd name="T103" fmla="*/ 122 h 202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</a:cxnLst>
            <a:rect l="0" t="0" r="r" b="b"/>
            <a:pathLst>
              <a:path w="2050" h="2024">
                <a:moveTo>
                  <a:pt x="168" y="2024"/>
                </a:moveTo>
                <a:lnTo>
                  <a:pt x="0" y="1856"/>
                </a:lnTo>
                <a:lnTo>
                  <a:pt x="63" y="1792"/>
                </a:lnTo>
                <a:cubicBezTo>
                  <a:pt x="75" y="1781"/>
                  <a:pt x="84" y="1773"/>
                  <a:pt x="91" y="1768"/>
                </a:cubicBezTo>
                <a:cubicBezTo>
                  <a:pt x="100" y="1762"/>
                  <a:pt x="110" y="1757"/>
                  <a:pt x="119" y="1756"/>
                </a:cubicBezTo>
                <a:cubicBezTo>
                  <a:pt x="129" y="1754"/>
                  <a:pt x="139" y="1755"/>
                  <a:pt x="149" y="1758"/>
                </a:cubicBezTo>
                <a:cubicBezTo>
                  <a:pt x="159" y="1762"/>
                  <a:pt x="169" y="1768"/>
                  <a:pt x="177" y="1776"/>
                </a:cubicBezTo>
                <a:cubicBezTo>
                  <a:pt x="191" y="1790"/>
                  <a:pt x="199" y="1807"/>
                  <a:pt x="200" y="1826"/>
                </a:cubicBezTo>
                <a:cubicBezTo>
                  <a:pt x="200" y="1845"/>
                  <a:pt x="189" y="1866"/>
                  <a:pt x="165" y="1890"/>
                </a:cubicBezTo>
                <a:lnTo>
                  <a:pt x="122" y="1933"/>
                </a:lnTo>
                <a:lnTo>
                  <a:pt x="190" y="2002"/>
                </a:lnTo>
                <a:lnTo>
                  <a:pt x="168" y="2024"/>
                </a:lnTo>
                <a:close/>
                <a:moveTo>
                  <a:pt x="102" y="1913"/>
                </a:moveTo>
                <a:lnTo>
                  <a:pt x="146" y="1870"/>
                </a:lnTo>
                <a:cubicBezTo>
                  <a:pt x="160" y="1856"/>
                  <a:pt x="167" y="1843"/>
                  <a:pt x="168" y="1831"/>
                </a:cubicBezTo>
                <a:cubicBezTo>
                  <a:pt x="169" y="1820"/>
                  <a:pt x="164" y="1809"/>
                  <a:pt x="155" y="1800"/>
                </a:cubicBezTo>
                <a:cubicBezTo>
                  <a:pt x="148" y="1793"/>
                  <a:pt x="140" y="1789"/>
                  <a:pt x="131" y="1787"/>
                </a:cubicBezTo>
                <a:cubicBezTo>
                  <a:pt x="123" y="1786"/>
                  <a:pt x="115" y="1787"/>
                  <a:pt x="107" y="1791"/>
                </a:cubicBezTo>
                <a:cubicBezTo>
                  <a:pt x="103" y="1794"/>
                  <a:pt x="95" y="1800"/>
                  <a:pt x="85" y="1810"/>
                </a:cubicBezTo>
                <a:lnTo>
                  <a:pt x="42" y="1853"/>
                </a:lnTo>
                <a:lnTo>
                  <a:pt x="102" y="1913"/>
                </a:lnTo>
                <a:close/>
                <a:moveTo>
                  <a:pt x="326" y="1866"/>
                </a:moveTo>
                <a:lnTo>
                  <a:pt x="157" y="1698"/>
                </a:lnTo>
                <a:lnTo>
                  <a:pt x="221" y="1635"/>
                </a:lnTo>
                <a:cubicBezTo>
                  <a:pt x="233" y="1622"/>
                  <a:pt x="245" y="1614"/>
                  <a:pt x="257" y="1610"/>
                </a:cubicBezTo>
                <a:cubicBezTo>
                  <a:pt x="268" y="1605"/>
                  <a:pt x="279" y="1604"/>
                  <a:pt x="290" y="1607"/>
                </a:cubicBezTo>
                <a:cubicBezTo>
                  <a:pt x="302" y="1610"/>
                  <a:pt x="312" y="1615"/>
                  <a:pt x="319" y="1623"/>
                </a:cubicBezTo>
                <a:cubicBezTo>
                  <a:pt x="326" y="1630"/>
                  <a:pt x="331" y="1638"/>
                  <a:pt x="334" y="1649"/>
                </a:cubicBezTo>
                <a:cubicBezTo>
                  <a:pt x="336" y="1659"/>
                  <a:pt x="335" y="1670"/>
                  <a:pt x="331" y="1682"/>
                </a:cubicBezTo>
                <a:cubicBezTo>
                  <a:pt x="345" y="1675"/>
                  <a:pt x="357" y="1672"/>
                  <a:pt x="370" y="1674"/>
                </a:cubicBezTo>
                <a:cubicBezTo>
                  <a:pt x="383" y="1675"/>
                  <a:pt x="394" y="1681"/>
                  <a:pt x="404" y="1691"/>
                </a:cubicBezTo>
                <a:cubicBezTo>
                  <a:pt x="412" y="1699"/>
                  <a:pt x="417" y="1708"/>
                  <a:pt x="421" y="1718"/>
                </a:cubicBezTo>
                <a:cubicBezTo>
                  <a:pt x="424" y="1728"/>
                  <a:pt x="425" y="1737"/>
                  <a:pt x="424" y="1746"/>
                </a:cubicBezTo>
                <a:cubicBezTo>
                  <a:pt x="423" y="1754"/>
                  <a:pt x="419" y="1763"/>
                  <a:pt x="414" y="1772"/>
                </a:cubicBezTo>
                <a:cubicBezTo>
                  <a:pt x="408" y="1782"/>
                  <a:pt x="400" y="1792"/>
                  <a:pt x="390" y="1802"/>
                </a:cubicBezTo>
                <a:lnTo>
                  <a:pt x="326" y="1866"/>
                </a:lnTo>
                <a:close/>
                <a:moveTo>
                  <a:pt x="250" y="1747"/>
                </a:moveTo>
                <a:lnTo>
                  <a:pt x="287" y="1710"/>
                </a:lnTo>
                <a:cubicBezTo>
                  <a:pt x="297" y="1701"/>
                  <a:pt x="303" y="1693"/>
                  <a:pt x="306" y="1687"/>
                </a:cubicBezTo>
                <a:cubicBezTo>
                  <a:pt x="310" y="1680"/>
                  <a:pt x="311" y="1673"/>
                  <a:pt x="310" y="1666"/>
                </a:cubicBezTo>
                <a:cubicBezTo>
                  <a:pt x="309" y="1659"/>
                  <a:pt x="306" y="1653"/>
                  <a:pt x="300" y="1647"/>
                </a:cubicBezTo>
                <a:cubicBezTo>
                  <a:pt x="294" y="1642"/>
                  <a:pt x="288" y="1638"/>
                  <a:pt x="281" y="1636"/>
                </a:cubicBezTo>
                <a:cubicBezTo>
                  <a:pt x="274" y="1635"/>
                  <a:pt x="268" y="1636"/>
                  <a:pt x="261" y="1639"/>
                </a:cubicBezTo>
                <a:cubicBezTo>
                  <a:pt x="255" y="1643"/>
                  <a:pt x="245" y="1650"/>
                  <a:pt x="233" y="1662"/>
                </a:cubicBezTo>
                <a:lnTo>
                  <a:pt x="200" y="1696"/>
                </a:lnTo>
                <a:lnTo>
                  <a:pt x="250" y="1747"/>
                </a:lnTo>
                <a:close/>
                <a:moveTo>
                  <a:pt x="328" y="1824"/>
                </a:moveTo>
                <a:lnTo>
                  <a:pt x="370" y="1782"/>
                </a:lnTo>
                <a:cubicBezTo>
                  <a:pt x="377" y="1775"/>
                  <a:pt x="382" y="1770"/>
                  <a:pt x="384" y="1767"/>
                </a:cubicBezTo>
                <a:cubicBezTo>
                  <a:pt x="388" y="1761"/>
                  <a:pt x="391" y="1755"/>
                  <a:pt x="392" y="1749"/>
                </a:cubicBezTo>
                <a:cubicBezTo>
                  <a:pt x="394" y="1744"/>
                  <a:pt x="393" y="1738"/>
                  <a:pt x="392" y="1731"/>
                </a:cubicBezTo>
                <a:cubicBezTo>
                  <a:pt x="390" y="1725"/>
                  <a:pt x="386" y="1719"/>
                  <a:pt x="381" y="1714"/>
                </a:cubicBezTo>
                <a:cubicBezTo>
                  <a:pt x="374" y="1708"/>
                  <a:pt x="367" y="1704"/>
                  <a:pt x="360" y="1702"/>
                </a:cubicBezTo>
                <a:cubicBezTo>
                  <a:pt x="352" y="1701"/>
                  <a:pt x="344" y="1702"/>
                  <a:pt x="336" y="1706"/>
                </a:cubicBezTo>
                <a:cubicBezTo>
                  <a:pt x="329" y="1710"/>
                  <a:pt x="320" y="1717"/>
                  <a:pt x="309" y="1728"/>
                </a:cubicBezTo>
                <a:lnTo>
                  <a:pt x="270" y="1767"/>
                </a:lnTo>
                <a:lnTo>
                  <a:pt x="328" y="1824"/>
                </a:lnTo>
                <a:close/>
                <a:moveTo>
                  <a:pt x="482" y="1710"/>
                </a:moveTo>
                <a:lnTo>
                  <a:pt x="314" y="1542"/>
                </a:lnTo>
                <a:lnTo>
                  <a:pt x="372" y="1484"/>
                </a:lnTo>
                <a:cubicBezTo>
                  <a:pt x="385" y="1471"/>
                  <a:pt x="396" y="1462"/>
                  <a:pt x="404" y="1456"/>
                </a:cubicBezTo>
                <a:cubicBezTo>
                  <a:pt x="416" y="1449"/>
                  <a:pt x="428" y="1445"/>
                  <a:pt x="441" y="1444"/>
                </a:cubicBezTo>
                <a:cubicBezTo>
                  <a:pt x="457" y="1442"/>
                  <a:pt x="473" y="1445"/>
                  <a:pt x="489" y="1453"/>
                </a:cubicBezTo>
                <a:cubicBezTo>
                  <a:pt x="506" y="1460"/>
                  <a:pt x="521" y="1471"/>
                  <a:pt x="536" y="1486"/>
                </a:cubicBezTo>
                <a:cubicBezTo>
                  <a:pt x="549" y="1499"/>
                  <a:pt x="559" y="1512"/>
                  <a:pt x="565" y="1524"/>
                </a:cubicBezTo>
                <a:cubicBezTo>
                  <a:pt x="572" y="1537"/>
                  <a:pt x="577" y="1549"/>
                  <a:pt x="578" y="1560"/>
                </a:cubicBezTo>
                <a:cubicBezTo>
                  <a:pt x="580" y="1572"/>
                  <a:pt x="580" y="1582"/>
                  <a:pt x="578" y="1591"/>
                </a:cubicBezTo>
                <a:cubicBezTo>
                  <a:pt x="577" y="1600"/>
                  <a:pt x="573" y="1610"/>
                  <a:pt x="567" y="1619"/>
                </a:cubicBezTo>
                <a:cubicBezTo>
                  <a:pt x="561" y="1629"/>
                  <a:pt x="553" y="1639"/>
                  <a:pt x="543" y="1649"/>
                </a:cubicBezTo>
                <a:lnTo>
                  <a:pt x="482" y="1710"/>
                </a:lnTo>
                <a:close/>
                <a:moveTo>
                  <a:pt x="484" y="1668"/>
                </a:moveTo>
                <a:lnTo>
                  <a:pt x="520" y="1632"/>
                </a:lnTo>
                <a:cubicBezTo>
                  <a:pt x="531" y="1621"/>
                  <a:pt x="539" y="1611"/>
                  <a:pt x="543" y="1603"/>
                </a:cubicBezTo>
                <a:cubicBezTo>
                  <a:pt x="548" y="1594"/>
                  <a:pt x="550" y="1587"/>
                  <a:pt x="550" y="1579"/>
                </a:cubicBezTo>
                <a:cubicBezTo>
                  <a:pt x="550" y="1568"/>
                  <a:pt x="547" y="1557"/>
                  <a:pt x="541" y="1545"/>
                </a:cubicBezTo>
                <a:cubicBezTo>
                  <a:pt x="535" y="1534"/>
                  <a:pt x="525" y="1521"/>
                  <a:pt x="513" y="1509"/>
                </a:cubicBezTo>
                <a:cubicBezTo>
                  <a:pt x="495" y="1491"/>
                  <a:pt x="479" y="1480"/>
                  <a:pt x="464" y="1477"/>
                </a:cubicBezTo>
                <a:cubicBezTo>
                  <a:pt x="448" y="1473"/>
                  <a:pt x="435" y="1474"/>
                  <a:pt x="424" y="1479"/>
                </a:cubicBezTo>
                <a:cubicBezTo>
                  <a:pt x="415" y="1482"/>
                  <a:pt x="405" y="1491"/>
                  <a:pt x="391" y="1504"/>
                </a:cubicBezTo>
                <a:lnTo>
                  <a:pt x="356" y="1539"/>
                </a:lnTo>
                <a:lnTo>
                  <a:pt x="484" y="1668"/>
                </a:lnTo>
                <a:close/>
                <a:moveTo>
                  <a:pt x="677" y="1609"/>
                </a:moveTo>
                <a:lnTo>
                  <a:pt x="662" y="1594"/>
                </a:lnTo>
                <a:lnTo>
                  <a:pt x="799" y="1457"/>
                </a:lnTo>
                <a:lnTo>
                  <a:pt x="813" y="1472"/>
                </a:lnTo>
                <a:lnTo>
                  <a:pt x="677" y="1609"/>
                </a:lnTo>
                <a:close/>
                <a:moveTo>
                  <a:pt x="785" y="1407"/>
                </a:moveTo>
                <a:lnTo>
                  <a:pt x="617" y="1239"/>
                </a:lnTo>
                <a:lnTo>
                  <a:pt x="680" y="1176"/>
                </a:lnTo>
                <a:cubicBezTo>
                  <a:pt x="691" y="1165"/>
                  <a:pt x="700" y="1157"/>
                  <a:pt x="707" y="1152"/>
                </a:cubicBezTo>
                <a:cubicBezTo>
                  <a:pt x="717" y="1145"/>
                  <a:pt x="726" y="1141"/>
                  <a:pt x="736" y="1139"/>
                </a:cubicBezTo>
                <a:cubicBezTo>
                  <a:pt x="745" y="1137"/>
                  <a:pt x="755" y="1138"/>
                  <a:pt x="765" y="1142"/>
                </a:cubicBezTo>
                <a:cubicBezTo>
                  <a:pt x="776" y="1145"/>
                  <a:pt x="785" y="1151"/>
                  <a:pt x="793" y="1160"/>
                </a:cubicBezTo>
                <a:cubicBezTo>
                  <a:pt x="808" y="1174"/>
                  <a:pt x="815" y="1190"/>
                  <a:pt x="816" y="1209"/>
                </a:cubicBezTo>
                <a:cubicBezTo>
                  <a:pt x="817" y="1228"/>
                  <a:pt x="805" y="1250"/>
                  <a:pt x="782" y="1274"/>
                </a:cubicBezTo>
                <a:lnTo>
                  <a:pt x="739" y="1317"/>
                </a:lnTo>
                <a:lnTo>
                  <a:pt x="807" y="1385"/>
                </a:lnTo>
                <a:lnTo>
                  <a:pt x="785" y="1407"/>
                </a:lnTo>
                <a:close/>
                <a:moveTo>
                  <a:pt x="719" y="1297"/>
                </a:moveTo>
                <a:lnTo>
                  <a:pt x="762" y="1253"/>
                </a:lnTo>
                <a:cubicBezTo>
                  <a:pt x="777" y="1239"/>
                  <a:pt x="784" y="1226"/>
                  <a:pt x="785" y="1215"/>
                </a:cubicBezTo>
                <a:cubicBezTo>
                  <a:pt x="785" y="1203"/>
                  <a:pt x="781" y="1193"/>
                  <a:pt x="771" y="1183"/>
                </a:cubicBezTo>
                <a:cubicBezTo>
                  <a:pt x="764" y="1176"/>
                  <a:pt x="756" y="1172"/>
                  <a:pt x="748" y="1170"/>
                </a:cubicBezTo>
                <a:cubicBezTo>
                  <a:pt x="739" y="1169"/>
                  <a:pt x="731" y="1170"/>
                  <a:pt x="724" y="1175"/>
                </a:cubicBezTo>
                <a:cubicBezTo>
                  <a:pt x="719" y="1177"/>
                  <a:pt x="712" y="1184"/>
                  <a:pt x="702" y="1194"/>
                </a:cubicBezTo>
                <a:lnTo>
                  <a:pt x="659" y="1237"/>
                </a:lnTo>
                <a:lnTo>
                  <a:pt x="719" y="1297"/>
                </a:lnTo>
                <a:close/>
                <a:moveTo>
                  <a:pt x="941" y="1251"/>
                </a:moveTo>
                <a:lnTo>
                  <a:pt x="773" y="1083"/>
                </a:lnTo>
                <a:lnTo>
                  <a:pt x="894" y="962"/>
                </a:lnTo>
                <a:lnTo>
                  <a:pt x="914" y="982"/>
                </a:lnTo>
                <a:lnTo>
                  <a:pt x="815" y="1081"/>
                </a:lnTo>
                <a:lnTo>
                  <a:pt x="866" y="1132"/>
                </a:lnTo>
                <a:lnTo>
                  <a:pt x="959" y="1039"/>
                </a:lnTo>
                <a:lnTo>
                  <a:pt x="979" y="1059"/>
                </a:lnTo>
                <a:lnTo>
                  <a:pt x="886" y="1152"/>
                </a:lnTo>
                <a:lnTo>
                  <a:pt x="943" y="1209"/>
                </a:lnTo>
                <a:lnTo>
                  <a:pt x="1046" y="1106"/>
                </a:lnTo>
                <a:lnTo>
                  <a:pt x="1066" y="1126"/>
                </a:lnTo>
                <a:lnTo>
                  <a:pt x="941" y="1251"/>
                </a:lnTo>
                <a:close/>
                <a:moveTo>
                  <a:pt x="1082" y="1110"/>
                </a:moveTo>
                <a:lnTo>
                  <a:pt x="1059" y="958"/>
                </a:lnTo>
                <a:lnTo>
                  <a:pt x="921" y="935"/>
                </a:lnTo>
                <a:lnTo>
                  <a:pt x="948" y="908"/>
                </a:lnTo>
                <a:lnTo>
                  <a:pt x="1021" y="921"/>
                </a:lnTo>
                <a:cubicBezTo>
                  <a:pt x="1037" y="923"/>
                  <a:pt x="1048" y="926"/>
                  <a:pt x="1055" y="928"/>
                </a:cubicBezTo>
                <a:cubicBezTo>
                  <a:pt x="1053" y="918"/>
                  <a:pt x="1051" y="907"/>
                  <a:pt x="1050" y="895"/>
                </a:cubicBezTo>
                <a:lnTo>
                  <a:pt x="1039" y="817"/>
                </a:lnTo>
                <a:lnTo>
                  <a:pt x="1063" y="793"/>
                </a:lnTo>
                <a:lnTo>
                  <a:pt x="1083" y="931"/>
                </a:lnTo>
                <a:lnTo>
                  <a:pt x="1236" y="956"/>
                </a:lnTo>
                <a:lnTo>
                  <a:pt x="1208" y="984"/>
                </a:lnTo>
                <a:lnTo>
                  <a:pt x="1106" y="966"/>
                </a:lnTo>
                <a:cubicBezTo>
                  <a:pt x="1100" y="965"/>
                  <a:pt x="1094" y="964"/>
                  <a:pt x="1087" y="962"/>
                </a:cubicBezTo>
                <a:cubicBezTo>
                  <a:pt x="1090" y="972"/>
                  <a:pt x="1091" y="979"/>
                  <a:pt x="1092" y="983"/>
                </a:cubicBezTo>
                <a:lnTo>
                  <a:pt x="1108" y="1084"/>
                </a:lnTo>
                <a:lnTo>
                  <a:pt x="1082" y="1110"/>
                </a:lnTo>
                <a:close/>
                <a:moveTo>
                  <a:pt x="1324" y="868"/>
                </a:moveTo>
                <a:lnTo>
                  <a:pt x="1303" y="889"/>
                </a:lnTo>
                <a:lnTo>
                  <a:pt x="1171" y="758"/>
                </a:lnTo>
                <a:cubicBezTo>
                  <a:pt x="1171" y="767"/>
                  <a:pt x="1169" y="779"/>
                  <a:pt x="1166" y="791"/>
                </a:cubicBezTo>
                <a:cubicBezTo>
                  <a:pt x="1163" y="804"/>
                  <a:pt x="1159" y="815"/>
                  <a:pt x="1155" y="824"/>
                </a:cubicBezTo>
                <a:lnTo>
                  <a:pt x="1135" y="804"/>
                </a:lnTo>
                <a:cubicBezTo>
                  <a:pt x="1141" y="787"/>
                  <a:pt x="1145" y="770"/>
                  <a:pt x="1146" y="754"/>
                </a:cubicBezTo>
                <a:cubicBezTo>
                  <a:pt x="1147" y="737"/>
                  <a:pt x="1145" y="724"/>
                  <a:pt x="1141" y="713"/>
                </a:cubicBezTo>
                <a:lnTo>
                  <a:pt x="1155" y="700"/>
                </a:lnTo>
                <a:lnTo>
                  <a:pt x="1324" y="868"/>
                </a:lnTo>
                <a:close/>
                <a:moveTo>
                  <a:pt x="1467" y="685"/>
                </a:moveTo>
                <a:lnTo>
                  <a:pt x="1487" y="705"/>
                </a:lnTo>
                <a:lnTo>
                  <a:pt x="1376" y="816"/>
                </a:lnTo>
                <a:cubicBezTo>
                  <a:pt x="1371" y="811"/>
                  <a:pt x="1367" y="805"/>
                  <a:pt x="1364" y="799"/>
                </a:cubicBezTo>
                <a:cubicBezTo>
                  <a:pt x="1359" y="789"/>
                  <a:pt x="1357" y="777"/>
                  <a:pt x="1355" y="763"/>
                </a:cubicBezTo>
                <a:cubicBezTo>
                  <a:pt x="1354" y="750"/>
                  <a:pt x="1355" y="732"/>
                  <a:pt x="1357" y="711"/>
                </a:cubicBezTo>
                <a:cubicBezTo>
                  <a:pt x="1360" y="677"/>
                  <a:pt x="1361" y="653"/>
                  <a:pt x="1358" y="638"/>
                </a:cubicBezTo>
                <a:cubicBezTo>
                  <a:pt x="1356" y="623"/>
                  <a:pt x="1351" y="611"/>
                  <a:pt x="1343" y="604"/>
                </a:cubicBezTo>
                <a:cubicBezTo>
                  <a:pt x="1335" y="595"/>
                  <a:pt x="1325" y="591"/>
                  <a:pt x="1314" y="592"/>
                </a:cubicBezTo>
                <a:cubicBezTo>
                  <a:pt x="1302" y="592"/>
                  <a:pt x="1292" y="597"/>
                  <a:pt x="1282" y="606"/>
                </a:cubicBezTo>
                <a:cubicBezTo>
                  <a:pt x="1273" y="616"/>
                  <a:pt x="1268" y="627"/>
                  <a:pt x="1268" y="639"/>
                </a:cubicBezTo>
                <a:cubicBezTo>
                  <a:pt x="1268" y="651"/>
                  <a:pt x="1273" y="662"/>
                  <a:pt x="1283" y="673"/>
                </a:cubicBezTo>
                <a:lnTo>
                  <a:pt x="1260" y="692"/>
                </a:lnTo>
                <a:cubicBezTo>
                  <a:pt x="1246" y="675"/>
                  <a:pt x="1239" y="657"/>
                  <a:pt x="1240" y="639"/>
                </a:cubicBezTo>
                <a:cubicBezTo>
                  <a:pt x="1241" y="621"/>
                  <a:pt x="1250" y="605"/>
                  <a:pt x="1266" y="589"/>
                </a:cubicBezTo>
                <a:cubicBezTo>
                  <a:pt x="1282" y="573"/>
                  <a:pt x="1299" y="564"/>
                  <a:pt x="1318" y="564"/>
                </a:cubicBezTo>
                <a:cubicBezTo>
                  <a:pt x="1336" y="563"/>
                  <a:pt x="1352" y="570"/>
                  <a:pt x="1365" y="583"/>
                </a:cubicBezTo>
                <a:cubicBezTo>
                  <a:pt x="1372" y="590"/>
                  <a:pt x="1377" y="598"/>
                  <a:pt x="1381" y="607"/>
                </a:cubicBezTo>
                <a:cubicBezTo>
                  <a:pt x="1384" y="616"/>
                  <a:pt x="1387" y="628"/>
                  <a:pt x="1387" y="641"/>
                </a:cubicBezTo>
                <a:cubicBezTo>
                  <a:pt x="1388" y="655"/>
                  <a:pt x="1387" y="675"/>
                  <a:pt x="1385" y="702"/>
                </a:cubicBezTo>
                <a:cubicBezTo>
                  <a:pt x="1383" y="725"/>
                  <a:pt x="1382" y="740"/>
                  <a:pt x="1382" y="747"/>
                </a:cubicBezTo>
                <a:cubicBezTo>
                  <a:pt x="1383" y="755"/>
                  <a:pt x="1383" y="761"/>
                  <a:pt x="1385" y="767"/>
                </a:cubicBezTo>
                <a:lnTo>
                  <a:pt x="1467" y="685"/>
                </a:lnTo>
                <a:close/>
                <a:moveTo>
                  <a:pt x="1435" y="468"/>
                </a:moveTo>
                <a:lnTo>
                  <a:pt x="1412" y="444"/>
                </a:lnTo>
                <a:lnTo>
                  <a:pt x="1432" y="424"/>
                </a:lnTo>
                <a:lnTo>
                  <a:pt x="1456" y="447"/>
                </a:lnTo>
                <a:lnTo>
                  <a:pt x="1435" y="468"/>
                </a:lnTo>
                <a:close/>
                <a:moveTo>
                  <a:pt x="1580" y="612"/>
                </a:moveTo>
                <a:lnTo>
                  <a:pt x="1458" y="490"/>
                </a:lnTo>
                <a:lnTo>
                  <a:pt x="1479" y="470"/>
                </a:lnTo>
                <a:lnTo>
                  <a:pt x="1600" y="592"/>
                </a:lnTo>
                <a:lnTo>
                  <a:pt x="1580" y="612"/>
                </a:lnTo>
                <a:close/>
                <a:moveTo>
                  <a:pt x="1636" y="556"/>
                </a:moveTo>
                <a:lnTo>
                  <a:pt x="1468" y="388"/>
                </a:lnTo>
                <a:lnTo>
                  <a:pt x="1531" y="324"/>
                </a:lnTo>
                <a:cubicBezTo>
                  <a:pt x="1543" y="313"/>
                  <a:pt x="1552" y="305"/>
                  <a:pt x="1559" y="301"/>
                </a:cubicBezTo>
                <a:cubicBezTo>
                  <a:pt x="1568" y="294"/>
                  <a:pt x="1578" y="289"/>
                  <a:pt x="1587" y="288"/>
                </a:cubicBezTo>
                <a:cubicBezTo>
                  <a:pt x="1597" y="286"/>
                  <a:pt x="1606" y="287"/>
                  <a:pt x="1617" y="290"/>
                </a:cubicBezTo>
                <a:cubicBezTo>
                  <a:pt x="1627" y="294"/>
                  <a:pt x="1637" y="300"/>
                  <a:pt x="1645" y="308"/>
                </a:cubicBezTo>
                <a:cubicBezTo>
                  <a:pt x="1659" y="322"/>
                  <a:pt x="1667" y="339"/>
                  <a:pt x="1667" y="358"/>
                </a:cubicBezTo>
                <a:cubicBezTo>
                  <a:pt x="1668" y="377"/>
                  <a:pt x="1657" y="398"/>
                  <a:pt x="1633" y="422"/>
                </a:cubicBezTo>
                <a:lnTo>
                  <a:pt x="1590" y="465"/>
                </a:lnTo>
                <a:lnTo>
                  <a:pt x="1658" y="534"/>
                </a:lnTo>
                <a:lnTo>
                  <a:pt x="1636" y="556"/>
                </a:lnTo>
                <a:close/>
                <a:moveTo>
                  <a:pt x="1570" y="446"/>
                </a:moveTo>
                <a:lnTo>
                  <a:pt x="1614" y="402"/>
                </a:lnTo>
                <a:cubicBezTo>
                  <a:pt x="1628" y="388"/>
                  <a:pt x="1635" y="375"/>
                  <a:pt x="1636" y="363"/>
                </a:cubicBezTo>
                <a:cubicBezTo>
                  <a:pt x="1637" y="352"/>
                  <a:pt x="1632" y="342"/>
                  <a:pt x="1623" y="332"/>
                </a:cubicBezTo>
                <a:cubicBezTo>
                  <a:pt x="1616" y="325"/>
                  <a:pt x="1608" y="321"/>
                  <a:pt x="1599" y="319"/>
                </a:cubicBezTo>
                <a:cubicBezTo>
                  <a:pt x="1591" y="318"/>
                  <a:pt x="1583" y="319"/>
                  <a:pt x="1575" y="323"/>
                </a:cubicBezTo>
                <a:cubicBezTo>
                  <a:pt x="1571" y="326"/>
                  <a:pt x="1563" y="332"/>
                  <a:pt x="1553" y="342"/>
                </a:cubicBezTo>
                <a:lnTo>
                  <a:pt x="1510" y="385"/>
                </a:lnTo>
                <a:lnTo>
                  <a:pt x="1570" y="446"/>
                </a:lnTo>
                <a:close/>
                <a:moveTo>
                  <a:pt x="1730" y="354"/>
                </a:moveTo>
                <a:lnTo>
                  <a:pt x="1749" y="331"/>
                </a:lnTo>
                <a:cubicBezTo>
                  <a:pt x="1759" y="339"/>
                  <a:pt x="1768" y="343"/>
                  <a:pt x="1777" y="345"/>
                </a:cubicBezTo>
                <a:cubicBezTo>
                  <a:pt x="1786" y="347"/>
                  <a:pt x="1796" y="345"/>
                  <a:pt x="1807" y="341"/>
                </a:cubicBezTo>
                <a:cubicBezTo>
                  <a:pt x="1818" y="337"/>
                  <a:pt x="1828" y="330"/>
                  <a:pt x="1838" y="320"/>
                </a:cubicBezTo>
                <a:cubicBezTo>
                  <a:pt x="1846" y="312"/>
                  <a:pt x="1852" y="303"/>
                  <a:pt x="1856" y="294"/>
                </a:cubicBezTo>
                <a:cubicBezTo>
                  <a:pt x="1860" y="285"/>
                  <a:pt x="1862" y="277"/>
                  <a:pt x="1860" y="269"/>
                </a:cubicBezTo>
                <a:cubicBezTo>
                  <a:pt x="1859" y="262"/>
                  <a:pt x="1856" y="255"/>
                  <a:pt x="1851" y="250"/>
                </a:cubicBezTo>
                <a:cubicBezTo>
                  <a:pt x="1845" y="245"/>
                  <a:pt x="1839" y="242"/>
                  <a:pt x="1832" y="241"/>
                </a:cubicBezTo>
                <a:cubicBezTo>
                  <a:pt x="1825" y="240"/>
                  <a:pt x="1817" y="242"/>
                  <a:pt x="1807" y="246"/>
                </a:cubicBezTo>
                <a:cubicBezTo>
                  <a:pt x="1801" y="249"/>
                  <a:pt x="1788" y="256"/>
                  <a:pt x="1769" y="268"/>
                </a:cubicBezTo>
                <a:cubicBezTo>
                  <a:pt x="1750" y="279"/>
                  <a:pt x="1736" y="287"/>
                  <a:pt x="1726" y="290"/>
                </a:cubicBezTo>
                <a:cubicBezTo>
                  <a:pt x="1714" y="293"/>
                  <a:pt x="1703" y="294"/>
                  <a:pt x="1693" y="292"/>
                </a:cubicBezTo>
                <a:cubicBezTo>
                  <a:pt x="1682" y="290"/>
                  <a:pt x="1674" y="285"/>
                  <a:pt x="1666" y="277"/>
                </a:cubicBezTo>
                <a:cubicBezTo>
                  <a:pt x="1657" y="268"/>
                  <a:pt x="1652" y="258"/>
                  <a:pt x="1649" y="246"/>
                </a:cubicBezTo>
                <a:cubicBezTo>
                  <a:pt x="1647" y="234"/>
                  <a:pt x="1648" y="221"/>
                  <a:pt x="1654" y="208"/>
                </a:cubicBezTo>
                <a:cubicBezTo>
                  <a:pt x="1659" y="195"/>
                  <a:pt x="1667" y="183"/>
                  <a:pt x="1679" y="171"/>
                </a:cubicBezTo>
                <a:cubicBezTo>
                  <a:pt x="1691" y="159"/>
                  <a:pt x="1704" y="150"/>
                  <a:pt x="1718" y="145"/>
                </a:cubicBezTo>
                <a:cubicBezTo>
                  <a:pt x="1731" y="139"/>
                  <a:pt x="1744" y="138"/>
                  <a:pt x="1757" y="140"/>
                </a:cubicBezTo>
                <a:cubicBezTo>
                  <a:pt x="1770" y="143"/>
                  <a:pt x="1782" y="149"/>
                  <a:pt x="1792" y="158"/>
                </a:cubicBezTo>
                <a:lnTo>
                  <a:pt x="1772" y="181"/>
                </a:lnTo>
                <a:cubicBezTo>
                  <a:pt x="1761" y="172"/>
                  <a:pt x="1749" y="168"/>
                  <a:pt x="1737" y="169"/>
                </a:cubicBezTo>
                <a:cubicBezTo>
                  <a:pt x="1725" y="170"/>
                  <a:pt x="1712" y="177"/>
                  <a:pt x="1699" y="190"/>
                </a:cubicBezTo>
                <a:cubicBezTo>
                  <a:pt x="1686" y="204"/>
                  <a:pt x="1678" y="216"/>
                  <a:pt x="1677" y="227"/>
                </a:cubicBezTo>
                <a:cubicBezTo>
                  <a:pt x="1676" y="238"/>
                  <a:pt x="1679" y="247"/>
                  <a:pt x="1686" y="254"/>
                </a:cubicBezTo>
                <a:cubicBezTo>
                  <a:pt x="1692" y="260"/>
                  <a:pt x="1699" y="263"/>
                  <a:pt x="1707" y="262"/>
                </a:cubicBezTo>
                <a:cubicBezTo>
                  <a:pt x="1715" y="262"/>
                  <a:pt x="1731" y="255"/>
                  <a:pt x="1753" y="241"/>
                </a:cubicBezTo>
                <a:cubicBezTo>
                  <a:pt x="1775" y="227"/>
                  <a:pt x="1791" y="218"/>
                  <a:pt x="1801" y="214"/>
                </a:cubicBezTo>
                <a:cubicBezTo>
                  <a:pt x="1815" y="209"/>
                  <a:pt x="1828" y="208"/>
                  <a:pt x="1839" y="210"/>
                </a:cubicBezTo>
                <a:cubicBezTo>
                  <a:pt x="1851" y="212"/>
                  <a:pt x="1861" y="218"/>
                  <a:pt x="1870" y="227"/>
                </a:cubicBezTo>
                <a:cubicBezTo>
                  <a:pt x="1879" y="236"/>
                  <a:pt x="1885" y="247"/>
                  <a:pt x="1888" y="260"/>
                </a:cubicBezTo>
                <a:cubicBezTo>
                  <a:pt x="1891" y="273"/>
                  <a:pt x="1890" y="286"/>
                  <a:pt x="1884" y="300"/>
                </a:cubicBezTo>
                <a:cubicBezTo>
                  <a:pt x="1879" y="314"/>
                  <a:pt x="1871" y="327"/>
                  <a:pt x="1859" y="339"/>
                </a:cubicBezTo>
                <a:cubicBezTo>
                  <a:pt x="1843" y="354"/>
                  <a:pt x="1828" y="365"/>
                  <a:pt x="1814" y="371"/>
                </a:cubicBezTo>
                <a:cubicBezTo>
                  <a:pt x="1799" y="377"/>
                  <a:pt x="1784" y="378"/>
                  <a:pt x="1769" y="375"/>
                </a:cubicBezTo>
                <a:cubicBezTo>
                  <a:pt x="1755" y="372"/>
                  <a:pt x="1742" y="365"/>
                  <a:pt x="1730" y="354"/>
                </a:cubicBezTo>
                <a:close/>
                <a:moveTo>
                  <a:pt x="2030" y="122"/>
                </a:moveTo>
                <a:lnTo>
                  <a:pt x="2050" y="142"/>
                </a:lnTo>
                <a:lnTo>
                  <a:pt x="1939" y="253"/>
                </a:lnTo>
                <a:cubicBezTo>
                  <a:pt x="1934" y="248"/>
                  <a:pt x="1930" y="243"/>
                  <a:pt x="1927" y="236"/>
                </a:cubicBezTo>
                <a:cubicBezTo>
                  <a:pt x="1922" y="226"/>
                  <a:pt x="1919" y="214"/>
                  <a:pt x="1918" y="200"/>
                </a:cubicBezTo>
                <a:cubicBezTo>
                  <a:pt x="1917" y="187"/>
                  <a:pt x="1918" y="169"/>
                  <a:pt x="1920" y="148"/>
                </a:cubicBezTo>
                <a:cubicBezTo>
                  <a:pt x="1923" y="115"/>
                  <a:pt x="1924" y="90"/>
                  <a:pt x="1921" y="75"/>
                </a:cubicBezTo>
                <a:cubicBezTo>
                  <a:pt x="1919" y="60"/>
                  <a:pt x="1914" y="49"/>
                  <a:pt x="1906" y="41"/>
                </a:cubicBezTo>
                <a:cubicBezTo>
                  <a:pt x="1898" y="33"/>
                  <a:pt x="1888" y="29"/>
                  <a:pt x="1877" y="29"/>
                </a:cubicBezTo>
                <a:cubicBezTo>
                  <a:pt x="1865" y="29"/>
                  <a:pt x="1855" y="34"/>
                  <a:pt x="1845" y="43"/>
                </a:cubicBezTo>
                <a:cubicBezTo>
                  <a:pt x="1835" y="53"/>
                  <a:pt x="1830" y="64"/>
                  <a:pt x="1830" y="76"/>
                </a:cubicBezTo>
                <a:cubicBezTo>
                  <a:pt x="1830" y="88"/>
                  <a:pt x="1836" y="99"/>
                  <a:pt x="1846" y="110"/>
                </a:cubicBezTo>
                <a:lnTo>
                  <a:pt x="1823" y="129"/>
                </a:lnTo>
                <a:cubicBezTo>
                  <a:pt x="1808" y="112"/>
                  <a:pt x="1802" y="94"/>
                  <a:pt x="1803" y="76"/>
                </a:cubicBezTo>
                <a:cubicBezTo>
                  <a:pt x="1804" y="59"/>
                  <a:pt x="1813" y="42"/>
                  <a:pt x="1829" y="26"/>
                </a:cubicBezTo>
                <a:cubicBezTo>
                  <a:pt x="1845" y="10"/>
                  <a:pt x="1862" y="1"/>
                  <a:pt x="1880" y="1"/>
                </a:cubicBezTo>
                <a:cubicBezTo>
                  <a:pt x="1899" y="0"/>
                  <a:pt x="1915" y="7"/>
                  <a:pt x="1928" y="20"/>
                </a:cubicBezTo>
                <a:cubicBezTo>
                  <a:pt x="1934" y="27"/>
                  <a:pt x="1940" y="35"/>
                  <a:pt x="1943" y="44"/>
                </a:cubicBezTo>
                <a:cubicBezTo>
                  <a:pt x="1947" y="53"/>
                  <a:pt x="1949" y="65"/>
                  <a:pt x="1950" y="78"/>
                </a:cubicBezTo>
                <a:cubicBezTo>
                  <a:pt x="1951" y="92"/>
                  <a:pt x="1950" y="112"/>
                  <a:pt x="1948" y="140"/>
                </a:cubicBezTo>
                <a:cubicBezTo>
                  <a:pt x="1946" y="162"/>
                  <a:pt x="1945" y="177"/>
                  <a:pt x="1945" y="185"/>
                </a:cubicBezTo>
                <a:cubicBezTo>
                  <a:pt x="1946" y="192"/>
                  <a:pt x="1946" y="198"/>
                  <a:pt x="1948" y="204"/>
                </a:cubicBezTo>
                <a:lnTo>
                  <a:pt x="2030" y="122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99" name="Freeform 81"/>
          <p:cNvSpPr>
            <a:spLocks noEditPoints="1"/>
          </p:cNvSpPr>
          <p:nvPr/>
        </p:nvSpPr>
        <p:spPr bwMode="auto">
          <a:xfrm>
            <a:off x="6796265" y="4613062"/>
            <a:ext cx="769937" cy="768350"/>
          </a:xfrm>
          <a:custGeom>
            <a:avLst/>
            <a:gdLst>
              <a:gd name="T0" fmla="*/ 119 w 2024"/>
              <a:gd name="T1" fmla="*/ 1751 h 2019"/>
              <a:gd name="T2" fmla="*/ 122 w 2024"/>
              <a:gd name="T3" fmla="*/ 1928 h 2019"/>
              <a:gd name="T4" fmla="*/ 168 w 2024"/>
              <a:gd name="T5" fmla="*/ 1826 h 2019"/>
              <a:gd name="T6" fmla="*/ 42 w 2024"/>
              <a:gd name="T7" fmla="*/ 1848 h 2019"/>
              <a:gd name="T8" fmla="*/ 257 w 2024"/>
              <a:gd name="T9" fmla="*/ 1605 h 2019"/>
              <a:gd name="T10" fmla="*/ 370 w 2024"/>
              <a:gd name="T11" fmla="*/ 1669 h 2019"/>
              <a:gd name="T12" fmla="*/ 390 w 2024"/>
              <a:gd name="T13" fmla="*/ 1797 h 2019"/>
              <a:gd name="T14" fmla="*/ 311 w 2024"/>
              <a:gd name="T15" fmla="*/ 1661 h 2019"/>
              <a:gd name="T16" fmla="*/ 200 w 2024"/>
              <a:gd name="T17" fmla="*/ 1691 h 2019"/>
              <a:gd name="T18" fmla="*/ 393 w 2024"/>
              <a:gd name="T19" fmla="*/ 1744 h 2019"/>
              <a:gd name="T20" fmla="*/ 309 w 2024"/>
              <a:gd name="T21" fmla="*/ 1723 h 2019"/>
              <a:gd name="T22" fmla="*/ 372 w 2024"/>
              <a:gd name="T23" fmla="*/ 1479 h 2019"/>
              <a:gd name="T24" fmla="*/ 566 w 2024"/>
              <a:gd name="T25" fmla="*/ 1519 h 2019"/>
              <a:gd name="T26" fmla="*/ 482 w 2024"/>
              <a:gd name="T27" fmla="*/ 1705 h 2019"/>
              <a:gd name="T28" fmla="*/ 541 w 2024"/>
              <a:gd name="T29" fmla="*/ 1540 h 2019"/>
              <a:gd name="T30" fmla="*/ 356 w 2024"/>
              <a:gd name="T31" fmla="*/ 1534 h 2019"/>
              <a:gd name="T32" fmla="*/ 814 w 2024"/>
              <a:gd name="T33" fmla="*/ 1467 h 2019"/>
              <a:gd name="T34" fmla="*/ 707 w 2024"/>
              <a:gd name="T35" fmla="*/ 1147 h 2019"/>
              <a:gd name="T36" fmla="*/ 782 w 2024"/>
              <a:gd name="T37" fmla="*/ 1269 h 2019"/>
              <a:gd name="T38" fmla="*/ 762 w 2024"/>
              <a:gd name="T39" fmla="*/ 1248 h 2019"/>
              <a:gd name="T40" fmla="*/ 702 w 2024"/>
              <a:gd name="T41" fmla="*/ 1189 h 2019"/>
              <a:gd name="T42" fmla="*/ 894 w 2024"/>
              <a:gd name="T43" fmla="*/ 957 h 2019"/>
              <a:gd name="T44" fmla="*/ 979 w 2024"/>
              <a:gd name="T45" fmla="*/ 1054 h 2019"/>
              <a:gd name="T46" fmla="*/ 941 w 2024"/>
              <a:gd name="T47" fmla="*/ 1246 h 2019"/>
              <a:gd name="T48" fmla="*/ 1021 w 2024"/>
              <a:gd name="T49" fmla="*/ 916 h 2019"/>
              <a:gd name="T50" fmla="*/ 1083 w 2024"/>
              <a:gd name="T51" fmla="*/ 926 h 2019"/>
              <a:gd name="T52" fmla="*/ 1092 w 2024"/>
              <a:gd name="T53" fmla="*/ 978 h 2019"/>
              <a:gd name="T54" fmla="*/ 1172 w 2024"/>
              <a:gd name="T55" fmla="*/ 753 h 2019"/>
              <a:gd name="T56" fmla="*/ 1142 w 2024"/>
              <a:gd name="T57" fmla="*/ 708 h 2019"/>
              <a:gd name="T58" fmla="*/ 1376 w 2024"/>
              <a:gd name="T59" fmla="*/ 811 h 2019"/>
              <a:gd name="T60" fmla="*/ 1343 w 2024"/>
              <a:gd name="T61" fmla="*/ 599 h 2019"/>
              <a:gd name="T62" fmla="*/ 1260 w 2024"/>
              <a:gd name="T63" fmla="*/ 687 h 2019"/>
              <a:gd name="T64" fmla="*/ 1381 w 2024"/>
              <a:gd name="T65" fmla="*/ 602 h 2019"/>
              <a:gd name="T66" fmla="*/ 1468 w 2024"/>
              <a:gd name="T67" fmla="*/ 680 h 2019"/>
              <a:gd name="T68" fmla="*/ 1436 w 2024"/>
              <a:gd name="T69" fmla="*/ 463 h 2019"/>
              <a:gd name="T70" fmla="*/ 1580 w 2024"/>
              <a:gd name="T71" fmla="*/ 607 h 2019"/>
              <a:gd name="T72" fmla="*/ 1587 w 2024"/>
              <a:gd name="T73" fmla="*/ 283 h 2019"/>
              <a:gd name="T74" fmla="*/ 1590 w 2024"/>
              <a:gd name="T75" fmla="*/ 460 h 2019"/>
              <a:gd name="T76" fmla="*/ 1636 w 2024"/>
              <a:gd name="T77" fmla="*/ 358 h 2019"/>
              <a:gd name="T78" fmla="*/ 1510 w 2024"/>
              <a:gd name="T79" fmla="*/ 380 h 2019"/>
              <a:gd name="T80" fmla="*/ 1807 w 2024"/>
              <a:gd name="T81" fmla="*/ 336 h 2019"/>
              <a:gd name="T82" fmla="*/ 1833 w 2024"/>
              <a:gd name="T83" fmla="*/ 236 h 2019"/>
              <a:gd name="T84" fmla="*/ 1666 w 2024"/>
              <a:gd name="T85" fmla="*/ 272 h 2019"/>
              <a:gd name="T86" fmla="*/ 1758 w 2024"/>
              <a:gd name="T87" fmla="*/ 135 h 2019"/>
              <a:gd name="T88" fmla="*/ 1677 w 2024"/>
              <a:gd name="T89" fmla="*/ 222 h 2019"/>
              <a:gd name="T90" fmla="*/ 1840 w 2024"/>
              <a:gd name="T91" fmla="*/ 205 h 2019"/>
              <a:gd name="T92" fmla="*/ 1814 w 2024"/>
              <a:gd name="T93" fmla="*/ 366 h 2019"/>
              <a:gd name="T94" fmla="*/ 1953 w 2024"/>
              <a:gd name="T95" fmla="*/ 191 h 2019"/>
              <a:gd name="T96" fmla="*/ 1915 w 2024"/>
              <a:gd name="T97" fmla="*/ 108 h 2019"/>
              <a:gd name="T98" fmla="*/ 1897 w 2024"/>
              <a:gd name="T99" fmla="*/ 39 h 2019"/>
              <a:gd name="T100" fmla="*/ 1819 w 2024"/>
              <a:gd name="T101" fmla="*/ 118 h 2019"/>
              <a:gd name="T102" fmla="*/ 1919 w 2024"/>
              <a:gd name="T103" fmla="*/ 18 h 2019"/>
              <a:gd name="T104" fmla="*/ 2024 w 2024"/>
              <a:gd name="T105" fmla="*/ 139 h 201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</a:cxnLst>
            <a:rect l="0" t="0" r="r" b="b"/>
            <a:pathLst>
              <a:path w="2024" h="2019">
                <a:moveTo>
                  <a:pt x="168" y="2019"/>
                </a:moveTo>
                <a:lnTo>
                  <a:pt x="0" y="1851"/>
                </a:lnTo>
                <a:lnTo>
                  <a:pt x="64" y="1787"/>
                </a:lnTo>
                <a:cubicBezTo>
                  <a:pt x="75" y="1776"/>
                  <a:pt x="84" y="1768"/>
                  <a:pt x="91" y="1763"/>
                </a:cubicBezTo>
                <a:cubicBezTo>
                  <a:pt x="100" y="1757"/>
                  <a:pt x="110" y="1752"/>
                  <a:pt x="119" y="1751"/>
                </a:cubicBezTo>
                <a:cubicBezTo>
                  <a:pt x="129" y="1749"/>
                  <a:pt x="139" y="1750"/>
                  <a:pt x="149" y="1753"/>
                </a:cubicBezTo>
                <a:cubicBezTo>
                  <a:pt x="159" y="1757"/>
                  <a:pt x="169" y="1763"/>
                  <a:pt x="177" y="1771"/>
                </a:cubicBezTo>
                <a:cubicBezTo>
                  <a:pt x="191" y="1785"/>
                  <a:pt x="199" y="1802"/>
                  <a:pt x="200" y="1821"/>
                </a:cubicBezTo>
                <a:cubicBezTo>
                  <a:pt x="201" y="1840"/>
                  <a:pt x="189" y="1861"/>
                  <a:pt x="165" y="1885"/>
                </a:cubicBezTo>
                <a:lnTo>
                  <a:pt x="122" y="1928"/>
                </a:lnTo>
                <a:lnTo>
                  <a:pt x="191" y="1997"/>
                </a:lnTo>
                <a:lnTo>
                  <a:pt x="168" y="2019"/>
                </a:lnTo>
                <a:close/>
                <a:moveTo>
                  <a:pt x="102" y="1908"/>
                </a:moveTo>
                <a:lnTo>
                  <a:pt x="146" y="1865"/>
                </a:lnTo>
                <a:cubicBezTo>
                  <a:pt x="160" y="1851"/>
                  <a:pt x="168" y="1838"/>
                  <a:pt x="168" y="1826"/>
                </a:cubicBezTo>
                <a:cubicBezTo>
                  <a:pt x="169" y="1815"/>
                  <a:pt x="165" y="1804"/>
                  <a:pt x="155" y="1795"/>
                </a:cubicBezTo>
                <a:cubicBezTo>
                  <a:pt x="148" y="1788"/>
                  <a:pt x="140" y="1784"/>
                  <a:pt x="131" y="1782"/>
                </a:cubicBezTo>
                <a:cubicBezTo>
                  <a:pt x="123" y="1781"/>
                  <a:pt x="115" y="1782"/>
                  <a:pt x="108" y="1786"/>
                </a:cubicBezTo>
                <a:cubicBezTo>
                  <a:pt x="103" y="1789"/>
                  <a:pt x="95" y="1795"/>
                  <a:pt x="85" y="1805"/>
                </a:cubicBezTo>
                <a:lnTo>
                  <a:pt x="42" y="1848"/>
                </a:lnTo>
                <a:lnTo>
                  <a:pt x="102" y="1908"/>
                </a:lnTo>
                <a:close/>
                <a:moveTo>
                  <a:pt x="326" y="1861"/>
                </a:moveTo>
                <a:lnTo>
                  <a:pt x="158" y="1693"/>
                </a:lnTo>
                <a:lnTo>
                  <a:pt x="221" y="1630"/>
                </a:lnTo>
                <a:cubicBezTo>
                  <a:pt x="234" y="1617"/>
                  <a:pt x="246" y="1609"/>
                  <a:pt x="257" y="1605"/>
                </a:cubicBezTo>
                <a:cubicBezTo>
                  <a:pt x="268" y="1600"/>
                  <a:pt x="279" y="1599"/>
                  <a:pt x="291" y="1602"/>
                </a:cubicBezTo>
                <a:cubicBezTo>
                  <a:pt x="302" y="1605"/>
                  <a:pt x="312" y="1610"/>
                  <a:pt x="319" y="1618"/>
                </a:cubicBezTo>
                <a:cubicBezTo>
                  <a:pt x="327" y="1625"/>
                  <a:pt x="331" y="1633"/>
                  <a:pt x="334" y="1644"/>
                </a:cubicBezTo>
                <a:cubicBezTo>
                  <a:pt x="336" y="1654"/>
                  <a:pt x="336" y="1665"/>
                  <a:pt x="332" y="1677"/>
                </a:cubicBezTo>
                <a:cubicBezTo>
                  <a:pt x="345" y="1670"/>
                  <a:pt x="358" y="1667"/>
                  <a:pt x="370" y="1669"/>
                </a:cubicBezTo>
                <a:cubicBezTo>
                  <a:pt x="383" y="1670"/>
                  <a:pt x="394" y="1676"/>
                  <a:pt x="404" y="1686"/>
                </a:cubicBezTo>
                <a:cubicBezTo>
                  <a:pt x="412" y="1694"/>
                  <a:pt x="417" y="1703"/>
                  <a:pt x="421" y="1713"/>
                </a:cubicBezTo>
                <a:cubicBezTo>
                  <a:pt x="424" y="1723"/>
                  <a:pt x="425" y="1732"/>
                  <a:pt x="424" y="1741"/>
                </a:cubicBezTo>
                <a:cubicBezTo>
                  <a:pt x="423" y="1749"/>
                  <a:pt x="420" y="1758"/>
                  <a:pt x="414" y="1767"/>
                </a:cubicBezTo>
                <a:cubicBezTo>
                  <a:pt x="409" y="1777"/>
                  <a:pt x="401" y="1787"/>
                  <a:pt x="390" y="1797"/>
                </a:cubicBezTo>
                <a:lnTo>
                  <a:pt x="326" y="1861"/>
                </a:lnTo>
                <a:close/>
                <a:moveTo>
                  <a:pt x="251" y="1742"/>
                </a:moveTo>
                <a:lnTo>
                  <a:pt x="287" y="1705"/>
                </a:lnTo>
                <a:cubicBezTo>
                  <a:pt x="297" y="1696"/>
                  <a:pt x="303" y="1688"/>
                  <a:pt x="306" y="1682"/>
                </a:cubicBezTo>
                <a:cubicBezTo>
                  <a:pt x="310" y="1675"/>
                  <a:pt x="312" y="1668"/>
                  <a:pt x="311" y="1661"/>
                </a:cubicBezTo>
                <a:cubicBezTo>
                  <a:pt x="310" y="1654"/>
                  <a:pt x="306" y="1648"/>
                  <a:pt x="300" y="1642"/>
                </a:cubicBezTo>
                <a:cubicBezTo>
                  <a:pt x="295" y="1637"/>
                  <a:pt x="288" y="1633"/>
                  <a:pt x="281" y="1631"/>
                </a:cubicBezTo>
                <a:cubicBezTo>
                  <a:pt x="275" y="1630"/>
                  <a:pt x="268" y="1631"/>
                  <a:pt x="261" y="1634"/>
                </a:cubicBezTo>
                <a:cubicBezTo>
                  <a:pt x="255" y="1638"/>
                  <a:pt x="245" y="1645"/>
                  <a:pt x="233" y="1657"/>
                </a:cubicBezTo>
                <a:lnTo>
                  <a:pt x="200" y="1691"/>
                </a:lnTo>
                <a:lnTo>
                  <a:pt x="251" y="1742"/>
                </a:lnTo>
                <a:close/>
                <a:moveTo>
                  <a:pt x="328" y="1819"/>
                </a:moveTo>
                <a:lnTo>
                  <a:pt x="370" y="1777"/>
                </a:lnTo>
                <a:cubicBezTo>
                  <a:pt x="377" y="1770"/>
                  <a:pt x="382" y="1765"/>
                  <a:pt x="384" y="1762"/>
                </a:cubicBezTo>
                <a:cubicBezTo>
                  <a:pt x="389" y="1756"/>
                  <a:pt x="391" y="1750"/>
                  <a:pt x="393" y="1744"/>
                </a:cubicBezTo>
                <a:cubicBezTo>
                  <a:pt x="394" y="1739"/>
                  <a:pt x="394" y="1733"/>
                  <a:pt x="392" y="1726"/>
                </a:cubicBezTo>
                <a:cubicBezTo>
                  <a:pt x="390" y="1720"/>
                  <a:pt x="386" y="1714"/>
                  <a:pt x="381" y="1709"/>
                </a:cubicBezTo>
                <a:cubicBezTo>
                  <a:pt x="375" y="1703"/>
                  <a:pt x="368" y="1699"/>
                  <a:pt x="360" y="1697"/>
                </a:cubicBezTo>
                <a:cubicBezTo>
                  <a:pt x="352" y="1696"/>
                  <a:pt x="344" y="1697"/>
                  <a:pt x="337" y="1701"/>
                </a:cubicBezTo>
                <a:cubicBezTo>
                  <a:pt x="329" y="1705"/>
                  <a:pt x="320" y="1712"/>
                  <a:pt x="309" y="1723"/>
                </a:cubicBezTo>
                <a:lnTo>
                  <a:pt x="270" y="1762"/>
                </a:lnTo>
                <a:lnTo>
                  <a:pt x="328" y="1819"/>
                </a:lnTo>
                <a:close/>
                <a:moveTo>
                  <a:pt x="482" y="1705"/>
                </a:moveTo>
                <a:lnTo>
                  <a:pt x="314" y="1537"/>
                </a:lnTo>
                <a:lnTo>
                  <a:pt x="372" y="1479"/>
                </a:lnTo>
                <a:cubicBezTo>
                  <a:pt x="385" y="1466"/>
                  <a:pt x="396" y="1457"/>
                  <a:pt x="404" y="1451"/>
                </a:cubicBezTo>
                <a:cubicBezTo>
                  <a:pt x="416" y="1444"/>
                  <a:pt x="428" y="1440"/>
                  <a:pt x="441" y="1439"/>
                </a:cubicBezTo>
                <a:cubicBezTo>
                  <a:pt x="457" y="1437"/>
                  <a:pt x="474" y="1440"/>
                  <a:pt x="490" y="1448"/>
                </a:cubicBezTo>
                <a:cubicBezTo>
                  <a:pt x="506" y="1455"/>
                  <a:pt x="521" y="1466"/>
                  <a:pt x="536" y="1481"/>
                </a:cubicBezTo>
                <a:cubicBezTo>
                  <a:pt x="549" y="1494"/>
                  <a:pt x="559" y="1507"/>
                  <a:pt x="566" y="1519"/>
                </a:cubicBezTo>
                <a:cubicBezTo>
                  <a:pt x="573" y="1532"/>
                  <a:pt x="577" y="1544"/>
                  <a:pt x="579" y="1555"/>
                </a:cubicBezTo>
                <a:cubicBezTo>
                  <a:pt x="580" y="1567"/>
                  <a:pt x="580" y="1577"/>
                  <a:pt x="579" y="1586"/>
                </a:cubicBezTo>
                <a:cubicBezTo>
                  <a:pt x="577" y="1595"/>
                  <a:pt x="573" y="1605"/>
                  <a:pt x="567" y="1614"/>
                </a:cubicBezTo>
                <a:cubicBezTo>
                  <a:pt x="561" y="1624"/>
                  <a:pt x="553" y="1634"/>
                  <a:pt x="543" y="1644"/>
                </a:cubicBezTo>
                <a:lnTo>
                  <a:pt x="482" y="1705"/>
                </a:lnTo>
                <a:close/>
                <a:moveTo>
                  <a:pt x="485" y="1663"/>
                </a:moveTo>
                <a:lnTo>
                  <a:pt x="521" y="1627"/>
                </a:lnTo>
                <a:cubicBezTo>
                  <a:pt x="532" y="1616"/>
                  <a:pt x="539" y="1606"/>
                  <a:pt x="543" y="1598"/>
                </a:cubicBezTo>
                <a:cubicBezTo>
                  <a:pt x="548" y="1589"/>
                  <a:pt x="550" y="1582"/>
                  <a:pt x="550" y="1574"/>
                </a:cubicBezTo>
                <a:cubicBezTo>
                  <a:pt x="550" y="1563"/>
                  <a:pt x="547" y="1552"/>
                  <a:pt x="541" y="1540"/>
                </a:cubicBezTo>
                <a:cubicBezTo>
                  <a:pt x="535" y="1529"/>
                  <a:pt x="526" y="1516"/>
                  <a:pt x="513" y="1504"/>
                </a:cubicBezTo>
                <a:cubicBezTo>
                  <a:pt x="495" y="1486"/>
                  <a:pt x="479" y="1475"/>
                  <a:pt x="464" y="1472"/>
                </a:cubicBezTo>
                <a:cubicBezTo>
                  <a:pt x="449" y="1468"/>
                  <a:pt x="435" y="1469"/>
                  <a:pt x="424" y="1474"/>
                </a:cubicBezTo>
                <a:cubicBezTo>
                  <a:pt x="416" y="1477"/>
                  <a:pt x="405" y="1486"/>
                  <a:pt x="392" y="1499"/>
                </a:cubicBezTo>
                <a:lnTo>
                  <a:pt x="356" y="1534"/>
                </a:lnTo>
                <a:lnTo>
                  <a:pt x="485" y="1663"/>
                </a:lnTo>
                <a:close/>
                <a:moveTo>
                  <a:pt x="677" y="1604"/>
                </a:moveTo>
                <a:lnTo>
                  <a:pt x="662" y="1589"/>
                </a:lnTo>
                <a:lnTo>
                  <a:pt x="799" y="1452"/>
                </a:lnTo>
                <a:lnTo>
                  <a:pt x="814" y="1467"/>
                </a:lnTo>
                <a:lnTo>
                  <a:pt x="677" y="1604"/>
                </a:lnTo>
                <a:close/>
                <a:moveTo>
                  <a:pt x="785" y="1402"/>
                </a:moveTo>
                <a:lnTo>
                  <a:pt x="617" y="1234"/>
                </a:lnTo>
                <a:lnTo>
                  <a:pt x="680" y="1171"/>
                </a:lnTo>
                <a:cubicBezTo>
                  <a:pt x="691" y="1160"/>
                  <a:pt x="700" y="1152"/>
                  <a:pt x="707" y="1147"/>
                </a:cubicBezTo>
                <a:cubicBezTo>
                  <a:pt x="717" y="1140"/>
                  <a:pt x="727" y="1136"/>
                  <a:pt x="736" y="1134"/>
                </a:cubicBezTo>
                <a:cubicBezTo>
                  <a:pt x="745" y="1132"/>
                  <a:pt x="755" y="1133"/>
                  <a:pt x="766" y="1137"/>
                </a:cubicBezTo>
                <a:cubicBezTo>
                  <a:pt x="776" y="1140"/>
                  <a:pt x="785" y="1146"/>
                  <a:pt x="794" y="1155"/>
                </a:cubicBezTo>
                <a:cubicBezTo>
                  <a:pt x="808" y="1169"/>
                  <a:pt x="816" y="1185"/>
                  <a:pt x="816" y="1204"/>
                </a:cubicBezTo>
                <a:cubicBezTo>
                  <a:pt x="817" y="1223"/>
                  <a:pt x="806" y="1245"/>
                  <a:pt x="782" y="1269"/>
                </a:cubicBezTo>
                <a:lnTo>
                  <a:pt x="739" y="1312"/>
                </a:lnTo>
                <a:lnTo>
                  <a:pt x="807" y="1380"/>
                </a:lnTo>
                <a:lnTo>
                  <a:pt x="785" y="1402"/>
                </a:lnTo>
                <a:close/>
                <a:moveTo>
                  <a:pt x="719" y="1292"/>
                </a:moveTo>
                <a:lnTo>
                  <a:pt x="762" y="1248"/>
                </a:lnTo>
                <a:cubicBezTo>
                  <a:pt x="777" y="1234"/>
                  <a:pt x="784" y="1221"/>
                  <a:pt x="785" y="1210"/>
                </a:cubicBezTo>
                <a:cubicBezTo>
                  <a:pt x="786" y="1198"/>
                  <a:pt x="781" y="1188"/>
                  <a:pt x="771" y="1178"/>
                </a:cubicBezTo>
                <a:cubicBezTo>
                  <a:pt x="764" y="1171"/>
                  <a:pt x="757" y="1167"/>
                  <a:pt x="748" y="1165"/>
                </a:cubicBezTo>
                <a:cubicBezTo>
                  <a:pt x="740" y="1164"/>
                  <a:pt x="732" y="1165"/>
                  <a:pt x="724" y="1170"/>
                </a:cubicBezTo>
                <a:cubicBezTo>
                  <a:pt x="719" y="1172"/>
                  <a:pt x="712" y="1179"/>
                  <a:pt x="702" y="1189"/>
                </a:cubicBezTo>
                <a:lnTo>
                  <a:pt x="659" y="1232"/>
                </a:lnTo>
                <a:lnTo>
                  <a:pt x="719" y="1292"/>
                </a:lnTo>
                <a:close/>
                <a:moveTo>
                  <a:pt x="941" y="1246"/>
                </a:moveTo>
                <a:lnTo>
                  <a:pt x="773" y="1078"/>
                </a:lnTo>
                <a:lnTo>
                  <a:pt x="894" y="957"/>
                </a:lnTo>
                <a:lnTo>
                  <a:pt x="914" y="977"/>
                </a:lnTo>
                <a:lnTo>
                  <a:pt x="815" y="1076"/>
                </a:lnTo>
                <a:lnTo>
                  <a:pt x="866" y="1127"/>
                </a:lnTo>
                <a:lnTo>
                  <a:pt x="959" y="1034"/>
                </a:lnTo>
                <a:lnTo>
                  <a:pt x="979" y="1054"/>
                </a:lnTo>
                <a:lnTo>
                  <a:pt x="886" y="1147"/>
                </a:lnTo>
                <a:lnTo>
                  <a:pt x="943" y="1204"/>
                </a:lnTo>
                <a:lnTo>
                  <a:pt x="1046" y="1101"/>
                </a:lnTo>
                <a:lnTo>
                  <a:pt x="1066" y="1121"/>
                </a:lnTo>
                <a:lnTo>
                  <a:pt x="941" y="1246"/>
                </a:lnTo>
                <a:close/>
                <a:moveTo>
                  <a:pt x="1082" y="1105"/>
                </a:moveTo>
                <a:lnTo>
                  <a:pt x="1059" y="953"/>
                </a:lnTo>
                <a:lnTo>
                  <a:pt x="921" y="930"/>
                </a:lnTo>
                <a:lnTo>
                  <a:pt x="948" y="903"/>
                </a:lnTo>
                <a:lnTo>
                  <a:pt x="1021" y="916"/>
                </a:lnTo>
                <a:cubicBezTo>
                  <a:pt x="1037" y="918"/>
                  <a:pt x="1048" y="921"/>
                  <a:pt x="1056" y="923"/>
                </a:cubicBezTo>
                <a:cubicBezTo>
                  <a:pt x="1053" y="913"/>
                  <a:pt x="1051" y="902"/>
                  <a:pt x="1050" y="890"/>
                </a:cubicBezTo>
                <a:lnTo>
                  <a:pt x="1039" y="812"/>
                </a:lnTo>
                <a:lnTo>
                  <a:pt x="1063" y="788"/>
                </a:lnTo>
                <a:lnTo>
                  <a:pt x="1083" y="926"/>
                </a:lnTo>
                <a:lnTo>
                  <a:pt x="1236" y="951"/>
                </a:lnTo>
                <a:lnTo>
                  <a:pt x="1208" y="979"/>
                </a:lnTo>
                <a:lnTo>
                  <a:pt x="1106" y="961"/>
                </a:lnTo>
                <a:cubicBezTo>
                  <a:pt x="1100" y="960"/>
                  <a:pt x="1094" y="959"/>
                  <a:pt x="1087" y="957"/>
                </a:cubicBezTo>
                <a:cubicBezTo>
                  <a:pt x="1090" y="967"/>
                  <a:pt x="1091" y="974"/>
                  <a:pt x="1092" y="978"/>
                </a:cubicBezTo>
                <a:lnTo>
                  <a:pt x="1108" y="1079"/>
                </a:lnTo>
                <a:lnTo>
                  <a:pt x="1082" y="1105"/>
                </a:lnTo>
                <a:close/>
                <a:moveTo>
                  <a:pt x="1324" y="863"/>
                </a:moveTo>
                <a:lnTo>
                  <a:pt x="1303" y="884"/>
                </a:lnTo>
                <a:lnTo>
                  <a:pt x="1172" y="753"/>
                </a:lnTo>
                <a:cubicBezTo>
                  <a:pt x="1171" y="762"/>
                  <a:pt x="1170" y="774"/>
                  <a:pt x="1166" y="786"/>
                </a:cubicBezTo>
                <a:cubicBezTo>
                  <a:pt x="1163" y="799"/>
                  <a:pt x="1159" y="810"/>
                  <a:pt x="1155" y="819"/>
                </a:cubicBezTo>
                <a:lnTo>
                  <a:pt x="1135" y="799"/>
                </a:lnTo>
                <a:cubicBezTo>
                  <a:pt x="1141" y="782"/>
                  <a:pt x="1145" y="765"/>
                  <a:pt x="1146" y="749"/>
                </a:cubicBezTo>
                <a:cubicBezTo>
                  <a:pt x="1147" y="732"/>
                  <a:pt x="1145" y="719"/>
                  <a:pt x="1142" y="708"/>
                </a:cubicBezTo>
                <a:lnTo>
                  <a:pt x="1155" y="695"/>
                </a:lnTo>
                <a:lnTo>
                  <a:pt x="1324" y="863"/>
                </a:lnTo>
                <a:close/>
                <a:moveTo>
                  <a:pt x="1468" y="680"/>
                </a:moveTo>
                <a:lnTo>
                  <a:pt x="1487" y="700"/>
                </a:lnTo>
                <a:lnTo>
                  <a:pt x="1376" y="811"/>
                </a:lnTo>
                <a:cubicBezTo>
                  <a:pt x="1371" y="806"/>
                  <a:pt x="1367" y="800"/>
                  <a:pt x="1364" y="794"/>
                </a:cubicBezTo>
                <a:cubicBezTo>
                  <a:pt x="1360" y="784"/>
                  <a:pt x="1357" y="772"/>
                  <a:pt x="1356" y="758"/>
                </a:cubicBezTo>
                <a:cubicBezTo>
                  <a:pt x="1355" y="745"/>
                  <a:pt x="1355" y="727"/>
                  <a:pt x="1357" y="706"/>
                </a:cubicBezTo>
                <a:cubicBezTo>
                  <a:pt x="1360" y="672"/>
                  <a:pt x="1361" y="648"/>
                  <a:pt x="1359" y="633"/>
                </a:cubicBezTo>
                <a:cubicBezTo>
                  <a:pt x="1356" y="618"/>
                  <a:pt x="1351" y="606"/>
                  <a:pt x="1343" y="599"/>
                </a:cubicBezTo>
                <a:cubicBezTo>
                  <a:pt x="1335" y="590"/>
                  <a:pt x="1325" y="586"/>
                  <a:pt x="1314" y="587"/>
                </a:cubicBezTo>
                <a:cubicBezTo>
                  <a:pt x="1302" y="587"/>
                  <a:pt x="1292" y="592"/>
                  <a:pt x="1283" y="601"/>
                </a:cubicBezTo>
                <a:cubicBezTo>
                  <a:pt x="1273" y="611"/>
                  <a:pt x="1268" y="622"/>
                  <a:pt x="1268" y="634"/>
                </a:cubicBezTo>
                <a:cubicBezTo>
                  <a:pt x="1268" y="646"/>
                  <a:pt x="1273" y="657"/>
                  <a:pt x="1283" y="668"/>
                </a:cubicBezTo>
                <a:lnTo>
                  <a:pt x="1260" y="687"/>
                </a:lnTo>
                <a:cubicBezTo>
                  <a:pt x="1246" y="670"/>
                  <a:pt x="1239" y="652"/>
                  <a:pt x="1240" y="634"/>
                </a:cubicBezTo>
                <a:cubicBezTo>
                  <a:pt x="1241" y="616"/>
                  <a:pt x="1250" y="600"/>
                  <a:pt x="1266" y="584"/>
                </a:cubicBezTo>
                <a:cubicBezTo>
                  <a:pt x="1282" y="568"/>
                  <a:pt x="1299" y="559"/>
                  <a:pt x="1318" y="559"/>
                </a:cubicBezTo>
                <a:cubicBezTo>
                  <a:pt x="1336" y="558"/>
                  <a:pt x="1352" y="565"/>
                  <a:pt x="1365" y="578"/>
                </a:cubicBezTo>
                <a:cubicBezTo>
                  <a:pt x="1372" y="585"/>
                  <a:pt x="1377" y="593"/>
                  <a:pt x="1381" y="602"/>
                </a:cubicBezTo>
                <a:cubicBezTo>
                  <a:pt x="1385" y="611"/>
                  <a:pt x="1387" y="623"/>
                  <a:pt x="1388" y="636"/>
                </a:cubicBezTo>
                <a:cubicBezTo>
                  <a:pt x="1388" y="650"/>
                  <a:pt x="1388" y="670"/>
                  <a:pt x="1385" y="697"/>
                </a:cubicBezTo>
                <a:cubicBezTo>
                  <a:pt x="1383" y="720"/>
                  <a:pt x="1382" y="735"/>
                  <a:pt x="1383" y="742"/>
                </a:cubicBezTo>
                <a:cubicBezTo>
                  <a:pt x="1383" y="750"/>
                  <a:pt x="1384" y="756"/>
                  <a:pt x="1385" y="762"/>
                </a:cubicBezTo>
                <a:lnTo>
                  <a:pt x="1468" y="680"/>
                </a:lnTo>
                <a:close/>
                <a:moveTo>
                  <a:pt x="1436" y="463"/>
                </a:moveTo>
                <a:lnTo>
                  <a:pt x="1412" y="439"/>
                </a:lnTo>
                <a:lnTo>
                  <a:pt x="1433" y="419"/>
                </a:lnTo>
                <a:lnTo>
                  <a:pt x="1456" y="442"/>
                </a:lnTo>
                <a:lnTo>
                  <a:pt x="1436" y="463"/>
                </a:lnTo>
                <a:close/>
                <a:moveTo>
                  <a:pt x="1580" y="607"/>
                </a:moveTo>
                <a:lnTo>
                  <a:pt x="1458" y="485"/>
                </a:lnTo>
                <a:lnTo>
                  <a:pt x="1479" y="465"/>
                </a:lnTo>
                <a:lnTo>
                  <a:pt x="1601" y="587"/>
                </a:lnTo>
                <a:lnTo>
                  <a:pt x="1580" y="607"/>
                </a:lnTo>
                <a:close/>
                <a:moveTo>
                  <a:pt x="1636" y="551"/>
                </a:moveTo>
                <a:lnTo>
                  <a:pt x="1468" y="383"/>
                </a:lnTo>
                <a:lnTo>
                  <a:pt x="1532" y="319"/>
                </a:lnTo>
                <a:cubicBezTo>
                  <a:pt x="1543" y="308"/>
                  <a:pt x="1552" y="300"/>
                  <a:pt x="1559" y="296"/>
                </a:cubicBezTo>
                <a:cubicBezTo>
                  <a:pt x="1568" y="289"/>
                  <a:pt x="1578" y="284"/>
                  <a:pt x="1587" y="283"/>
                </a:cubicBezTo>
                <a:cubicBezTo>
                  <a:pt x="1597" y="281"/>
                  <a:pt x="1607" y="282"/>
                  <a:pt x="1617" y="285"/>
                </a:cubicBezTo>
                <a:cubicBezTo>
                  <a:pt x="1627" y="289"/>
                  <a:pt x="1637" y="295"/>
                  <a:pt x="1645" y="303"/>
                </a:cubicBezTo>
                <a:cubicBezTo>
                  <a:pt x="1659" y="317"/>
                  <a:pt x="1667" y="334"/>
                  <a:pt x="1668" y="353"/>
                </a:cubicBezTo>
                <a:cubicBezTo>
                  <a:pt x="1668" y="372"/>
                  <a:pt x="1657" y="393"/>
                  <a:pt x="1633" y="417"/>
                </a:cubicBezTo>
                <a:lnTo>
                  <a:pt x="1590" y="460"/>
                </a:lnTo>
                <a:lnTo>
                  <a:pt x="1658" y="529"/>
                </a:lnTo>
                <a:lnTo>
                  <a:pt x="1636" y="551"/>
                </a:lnTo>
                <a:close/>
                <a:moveTo>
                  <a:pt x="1570" y="441"/>
                </a:moveTo>
                <a:lnTo>
                  <a:pt x="1614" y="397"/>
                </a:lnTo>
                <a:cubicBezTo>
                  <a:pt x="1628" y="383"/>
                  <a:pt x="1636" y="370"/>
                  <a:pt x="1636" y="358"/>
                </a:cubicBezTo>
                <a:cubicBezTo>
                  <a:pt x="1637" y="347"/>
                  <a:pt x="1633" y="337"/>
                  <a:pt x="1623" y="327"/>
                </a:cubicBezTo>
                <a:cubicBezTo>
                  <a:pt x="1616" y="320"/>
                  <a:pt x="1608" y="316"/>
                  <a:pt x="1599" y="314"/>
                </a:cubicBezTo>
                <a:cubicBezTo>
                  <a:pt x="1591" y="313"/>
                  <a:pt x="1583" y="314"/>
                  <a:pt x="1575" y="318"/>
                </a:cubicBezTo>
                <a:cubicBezTo>
                  <a:pt x="1571" y="321"/>
                  <a:pt x="1563" y="327"/>
                  <a:pt x="1553" y="337"/>
                </a:cubicBezTo>
                <a:lnTo>
                  <a:pt x="1510" y="380"/>
                </a:lnTo>
                <a:lnTo>
                  <a:pt x="1570" y="441"/>
                </a:lnTo>
                <a:close/>
                <a:moveTo>
                  <a:pt x="1730" y="349"/>
                </a:moveTo>
                <a:lnTo>
                  <a:pt x="1749" y="326"/>
                </a:lnTo>
                <a:cubicBezTo>
                  <a:pt x="1759" y="334"/>
                  <a:pt x="1768" y="338"/>
                  <a:pt x="1777" y="340"/>
                </a:cubicBezTo>
                <a:cubicBezTo>
                  <a:pt x="1786" y="342"/>
                  <a:pt x="1796" y="340"/>
                  <a:pt x="1807" y="336"/>
                </a:cubicBezTo>
                <a:cubicBezTo>
                  <a:pt x="1818" y="332"/>
                  <a:pt x="1828" y="325"/>
                  <a:pt x="1838" y="315"/>
                </a:cubicBezTo>
                <a:cubicBezTo>
                  <a:pt x="1846" y="307"/>
                  <a:pt x="1852" y="298"/>
                  <a:pt x="1856" y="289"/>
                </a:cubicBezTo>
                <a:cubicBezTo>
                  <a:pt x="1860" y="280"/>
                  <a:pt x="1862" y="272"/>
                  <a:pt x="1861" y="264"/>
                </a:cubicBezTo>
                <a:cubicBezTo>
                  <a:pt x="1859" y="257"/>
                  <a:pt x="1856" y="250"/>
                  <a:pt x="1851" y="245"/>
                </a:cubicBezTo>
                <a:cubicBezTo>
                  <a:pt x="1846" y="240"/>
                  <a:pt x="1840" y="237"/>
                  <a:pt x="1833" y="236"/>
                </a:cubicBezTo>
                <a:cubicBezTo>
                  <a:pt x="1826" y="235"/>
                  <a:pt x="1817" y="237"/>
                  <a:pt x="1807" y="241"/>
                </a:cubicBezTo>
                <a:cubicBezTo>
                  <a:pt x="1801" y="244"/>
                  <a:pt x="1789" y="251"/>
                  <a:pt x="1769" y="263"/>
                </a:cubicBezTo>
                <a:cubicBezTo>
                  <a:pt x="1750" y="274"/>
                  <a:pt x="1736" y="282"/>
                  <a:pt x="1726" y="285"/>
                </a:cubicBezTo>
                <a:cubicBezTo>
                  <a:pt x="1714" y="288"/>
                  <a:pt x="1703" y="289"/>
                  <a:pt x="1693" y="287"/>
                </a:cubicBezTo>
                <a:cubicBezTo>
                  <a:pt x="1683" y="285"/>
                  <a:pt x="1674" y="280"/>
                  <a:pt x="1666" y="272"/>
                </a:cubicBezTo>
                <a:cubicBezTo>
                  <a:pt x="1658" y="263"/>
                  <a:pt x="1652" y="253"/>
                  <a:pt x="1649" y="241"/>
                </a:cubicBezTo>
                <a:cubicBezTo>
                  <a:pt x="1647" y="229"/>
                  <a:pt x="1648" y="216"/>
                  <a:pt x="1654" y="203"/>
                </a:cubicBezTo>
                <a:cubicBezTo>
                  <a:pt x="1659" y="190"/>
                  <a:pt x="1668" y="178"/>
                  <a:pt x="1679" y="166"/>
                </a:cubicBezTo>
                <a:cubicBezTo>
                  <a:pt x="1691" y="154"/>
                  <a:pt x="1704" y="145"/>
                  <a:pt x="1718" y="140"/>
                </a:cubicBezTo>
                <a:cubicBezTo>
                  <a:pt x="1731" y="134"/>
                  <a:pt x="1745" y="133"/>
                  <a:pt x="1758" y="135"/>
                </a:cubicBezTo>
                <a:cubicBezTo>
                  <a:pt x="1770" y="138"/>
                  <a:pt x="1782" y="144"/>
                  <a:pt x="1792" y="153"/>
                </a:cubicBezTo>
                <a:lnTo>
                  <a:pt x="1773" y="176"/>
                </a:lnTo>
                <a:cubicBezTo>
                  <a:pt x="1761" y="167"/>
                  <a:pt x="1749" y="163"/>
                  <a:pt x="1737" y="164"/>
                </a:cubicBezTo>
                <a:cubicBezTo>
                  <a:pt x="1725" y="165"/>
                  <a:pt x="1712" y="172"/>
                  <a:pt x="1699" y="185"/>
                </a:cubicBezTo>
                <a:cubicBezTo>
                  <a:pt x="1686" y="199"/>
                  <a:pt x="1679" y="211"/>
                  <a:pt x="1677" y="222"/>
                </a:cubicBezTo>
                <a:cubicBezTo>
                  <a:pt x="1676" y="233"/>
                  <a:pt x="1679" y="242"/>
                  <a:pt x="1686" y="249"/>
                </a:cubicBezTo>
                <a:cubicBezTo>
                  <a:pt x="1692" y="255"/>
                  <a:pt x="1699" y="258"/>
                  <a:pt x="1707" y="257"/>
                </a:cubicBezTo>
                <a:cubicBezTo>
                  <a:pt x="1716" y="257"/>
                  <a:pt x="1731" y="250"/>
                  <a:pt x="1753" y="236"/>
                </a:cubicBezTo>
                <a:cubicBezTo>
                  <a:pt x="1775" y="222"/>
                  <a:pt x="1791" y="213"/>
                  <a:pt x="1801" y="209"/>
                </a:cubicBezTo>
                <a:cubicBezTo>
                  <a:pt x="1815" y="204"/>
                  <a:pt x="1828" y="203"/>
                  <a:pt x="1840" y="205"/>
                </a:cubicBezTo>
                <a:cubicBezTo>
                  <a:pt x="1851" y="207"/>
                  <a:pt x="1862" y="213"/>
                  <a:pt x="1871" y="222"/>
                </a:cubicBezTo>
                <a:cubicBezTo>
                  <a:pt x="1879" y="231"/>
                  <a:pt x="1885" y="242"/>
                  <a:pt x="1888" y="255"/>
                </a:cubicBezTo>
                <a:cubicBezTo>
                  <a:pt x="1891" y="268"/>
                  <a:pt x="1890" y="281"/>
                  <a:pt x="1885" y="295"/>
                </a:cubicBezTo>
                <a:cubicBezTo>
                  <a:pt x="1879" y="309"/>
                  <a:pt x="1871" y="322"/>
                  <a:pt x="1859" y="334"/>
                </a:cubicBezTo>
                <a:cubicBezTo>
                  <a:pt x="1844" y="349"/>
                  <a:pt x="1829" y="360"/>
                  <a:pt x="1814" y="366"/>
                </a:cubicBezTo>
                <a:cubicBezTo>
                  <a:pt x="1799" y="372"/>
                  <a:pt x="1784" y="373"/>
                  <a:pt x="1770" y="370"/>
                </a:cubicBezTo>
                <a:cubicBezTo>
                  <a:pt x="1755" y="367"/>
                  <a:pt x="1742" y="360"/>
                  <a:pt x="1730" y="349"/>
                </a:cubicBezTo>
                <a:close/>
                <a:moveTo>
                  <a:pt x="1898" y="201"/>
                </a:moveTo>
                <a:lnTo>
                  <a:pt x="1915" y="177"/>
                </a:lnTo>
                <a:cubicBezTo>
                  <a:pt x="1930" y="187"/>
                  <a:pt x="1942" y="191"/>
                  <a:pt x="1953" y="191"/>
                </a:cubicBezTo>
                <a:cubicBezTo>
                  <a:pt x="1964" y="190"/>
                  <a:pt x="1973" y="186"/>
                  <a:pt x="1981" y="178"/>
                </a:cubicBezTo>
                <a:cubicBezTo>
                  <a:pt x="1991" y="168"/>
                  <a:pt x="1996" y="156"/>
                  <a:pt x="1996" y="143"/>
                </a:cubicBezTo>
                <a:cubicBezTo>
                  <a:pt x="1996" y="130"/>
                  <a:pt x="1991" y="118"/>
                  <a:pt x="1981" y="108"/>
                </a:cubicBezTo>
                <a:cubicBezTo>
                  <a:pt x="1971" y="98"/>
                  <a:pt x="1961" y="94"/>
                  <a:pt x="1948" y="94"/>
                </a:cubicBezTo>
                <a:cubicBezTo>
                  <a:pt x="1936" y="94"/>
                  <a:pt x="1925" y="99"/>
                  <a:pt x="1915" y="108"/>
                </a:cubicBezTo>
                <a:cubicBezTo>
                  <a:pt x="1911" y="112"/>
                  <a:pt x="1907" y="118"/>
                  <a:pt x="1903" y="125"/>
                </a:cubicBezTo>
                <a:lnTo>
                  <a:pt x="1887" y="105"/>
                </a:lnTo>
                <a:cubicBezTo>
                  <a:pt x="1889" y="103"/>
                  <a:pt x="1890" y="102"/>
                  <a:pt x="1891" y="101"/>
                </a:cubicBezTo>
                <a:cubicBezTo>
                  <a:pt x="1900" y="93"/>
                  <a:pt x="1905" y="82"/>
                  <a:pt x="1908" y="71"/>
                </a:cubicBezTo>
                <a:cubicBezTo>
                  <a:pt x="1910" y="59"/>
                  <a:pt x="1907" y="49"/>
                  <a:pt x="1897" y="39"/>
                </a:cubicBezTo>
                <a:cubicBezTo>
                  <a:pt x="1889" y="32"/>
                  <a:pt x="1881" y="28"/>
                  <a:pt x="1871" y="28"/>
                </a:cubicBezTo>
                <a:cubicBezTo>
                  <a:pt x="1860" y="28"/>
                  <a:pt x="1851" y="32"/>
                  <a:pt x="1843" y="40"/>
                </a:cubicBezTo>
                <a:cubicBezTo>
                  <a:pt x="1835" y="48"/>
                  <a:pt x="1831" y="58"/>
                  <a:pt x="1831" y="68"/>
                </a:cubicBezTo>
                <a:cubicBezTo>
                  <a:pt x="1830" y="78"/>
                  <a:pt x="1835" y="89"/>
                  <a:pt x="1843" y="101"/>
                </a:cubicBezTo>
                <a:lnTo>
                  <a:pt x="1819" y="118"/>
                </a:lnTo>
                <a:cubicBezTo>
                  <a:pt x="1808" y="102"/>
                  <a:pt x="1803" y="85"/>
                  <a:pt x="1804" y="69"/>
                </a:cubicBezTo>
                <a:cubicBezTo>
                  <a:pt x="1805" y="52"/>
                  <a:pt x="1813" y="37"/>
                  <a:pt x="1826" y="24"/>
                </a:cubicBezTo>
                <a:cubicBezTo>
                  <a:pt x="1835" y="15"/>
                  <a:pt x="1845" y="8"/>
                  <a:pt x="1857" y="4"/>
                </a:cubicBezTo>
                <a:cubicBezTo>
                  <a:pt x="1869" y="1"/>
                  <a:pt x="1880" y="0"/>
                  <a:pt x="1891" y="3"/>
                </a:cubicBezTo>
                <a:cubicBezTo>
                  <a:pt x="1902" y="6"/>
                  <a:pt x="1911" y="11"/>
                  <a:pt x="1919" y="18"/>
                </a:cubicBezTo>
                <a:cubicBezTo>
                  <a:pt x="1926" y="26"/>
                  <a:pt x="1931" y="34"/>
                  <a:pt x="1933" y="44"/>
                </a:cubicBezTo>
                <a:cubicBezTo>
                  <a:pt x="1935" y="54"/>
                  <a:pt x="1934" y="64"/>
                  <a:pt x="1930" y="76"/>
                </a:cubicBezTo>
                <a:cubicBezTo>
                  <a:pt x="1942" y="68"/>
                  <a:pt x="1954" y="65"/>
                  <a:pt x="1967" y="67"/>
                </a:cubicBezTo>
                <a:cubicBezTo>
                  <a:pt x="1980" y="68"/>
                  <a:pt x="1991" y="75"/>
                  <a:pt x="2002" y="86"/>
                </a:cubicBezTo>
                <a:cubicBezTo>
                  <a:pt x="2017" y="100"/>
                  <a:pt x="2024" y="118"/>
                  <a:pt x="2024" y="139"/>
                </a:cubicBezTo>
                <a:cubicBezTo>
                  <a:pt x="2023" y="160"/>
                  <a:pt x="2015" y="178"/>
                  <a:pt x="1998" y="195"/>
                </a:cubicBezTo>
                <a:cubicBezTo>
                  <a:pt x="1984" y="210"/>
                  <a:pt x="1967" y="217"/>
                  <a:pt x="1948" y="218"/>
                </a:cubicBezTo>
                <a:cubicBezTo>
                  <a:pt x="1930" y="219"/>
                  <a:pt x="1913" y="213"/>
                  <a:pt x="1898" y="201"/>
                </a:cubicBez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100" name="Freeform 82"/>
          <p:cNvSpPr>
            <a:spLocks noEditPoints="1"/>
          </p:cNvSpPr>
          <p:nvPr/>
        </p:nvSpPr>
        <p:spPr bwMode="auto">
          <a:xfrm>
            <a:off x="7293153" y="4613062"/>
            <a:ext cx="768350" cy="768350"/>
          </a:xfrm>
          <a:custGeom>
            <a:avLst/>
            <a:gdLst>
              <a:gd name="T0" fmla="*/ 119 w 2019"/>
              <a:gd name="T1" fmla="*/ 1752 h 2020"/>
              <a:gd name="T2" fmla="*/ 122 w 2019"/>
              <a:gd name="T3" fmla="*/ 1929 h 2020"/>
              <a:gd name="T4" fmla="*/ 168 w 2019"/>
              <a:gd name="T5" fmla="*/ 1827 h 2020"/>
              <a:gd name="T6" fmla="*/ 42 w 2019"/>
              <a:gd name="T7" fmla="*/ 1849 h 2020"/>
              <a:gd name="T8" fmla="*/ 256 w 2019"/>
              <a:gd name="T9" fmla="*/ 1606 h 2020"/>
              <a:gd name="T10" fmla="*/ 370 w 2019"/>
              <a:gd name="T11" fmla="*/ 1670 h 2020"/>
              <a:gd name="T12" fmla="*/ 389 w 2019"/>
              <a:gd name="T13" fmla="*/ 1798 h 2020"/>
              <a:gd name="T14" fmla="*/ 310 w 2019"/>
              <a:gd name="T15" fmla="*/ 1662 h 2020"/>
              <a:gd name="T16" fmla="*/ 199 w 2019"/>
              <a:gd name="T17" fmla="*/ 1692 h 2020"/>
              <a:gd name="T18" fmla="*/ 392 w 2019"/>
              <a:gd name="T19" fmla="*/ 1745 h 2020"/>
              <a:gd name="T20" fmla="*/ 309 w 2019"/>
              <a:gd name="T21" fmla="*/ 1724 h 2020"/>
              <a:gd name="T22" fmla="*/ 371 w 2019"/>
              <a:gd name="T23" fmla="*/ 1480 h 2020"/>
              <a:gd name="T24" fmla="*/ 565 w 2019"/>
              <a:gd name="T25" fmla="*/ 1520 h 2020"/>
              <a:gd name="T26" fmla="*/ 482 w 2019"/>
              <a:gd name="T27" fmla="*/ 1706 h 2020"/>
              <a:gd name="T28" fmla="*/ 540 w 2019"/>
              <a:gd name="T29" fmla="*/ 1541 h 2020"/>
              <a:gd name="T30" fmla="*/ 356 w 2019"/>
              <a:gd name="T31" fmla="*/ 1535 h 2020"/>
              <a:gd name="T32" fmla="*/ 813 w 2019"/>
              <a:gd name="T33" fmla="*/ 1468 h 2020"/>
              <a:gd name="T34" fmla="*/ 707 w 2019"/>
              <a:gd name="T35" fmla="*/ 1148 h 2020"/>
              <a:gd name="T36" fmla="*/ 781 w 2019"/>
              <a:gd name="T37" fmla="*/ 1270 h 2020"/>
              <a:gd name="T38" fmla="*/ 762 w 2019"/>
              <a:gd name="T39" fmla="*/ 1249 h 2020"/>
              <a:gd name="T40" fmla="*/ 701 w 2019"/>
              <a:gd name="T41" fmla="*/ 1190 h 2020"/>
              <a:gd name="T42" fmla="*/ 894 w 2019"/>
              <a:gd name="T43" fmla="*/ 958 h 2020"/>
              <a:gd name="T44" fmla="*/ 978 w 2019"/>
              <a:gd name="T45" fmla="*/ 1055 h 2020"/>
              <a:gd name="T46" fmla="*/ 940 w 2019"/>
              <a:gd name="T47" fmla="*/ 1247 h 2020"/>
              <a:gd name="T48" fmla="*/ 1021 w 2019"/>
              <a:gd name="T49" fmla="*/ 917 h 2020"/>
              <a:gd name="T50" fmla="*/ 1083 w 2019"/>
              <a:gd name="T51" fmla="*/ 927 h 2020"/>
              <a:gd name="T52" fmla="*/ 1091 w 2019"/>
              <a:gd name="T53" fmla="*/ 979 h 2020"/>
              <a:gd name="T54" fmla="*/ 1243 w 2019"/>
              <a:gd name="T55" fmla="*/ 945 h 2020"/>
              <a:gd name="T56" fmla="*/ 1210 w 2019"/>
              <a:gd name="T57" fmla="*/ 733 h 2020"/>
              <a:gd name="T58" fmla="*/ 1127 w 2019"/>
              <a:gd name="T59" fmla="*/ 821 h 2020"/>
              <a:gd name="T60" fmla="*/ 1247 w 2019"/>
              <a:gd name="T61" fmla="*/ 736 h 2020"/>
              <a:gd name="T62" fmla="*/ 1334 w 2019"/>
              <a:gd name="T63" fmla="*/ 814 h 2020"/>
              <a:gd name="T64" fmla="*/ 1273 w 2019"/>
              <a:gd name="T65" fmla="*/ 622 h 2020"/>
              <a:gd name="T66" fmla="*/ 1380 w 2019"/>
              <a:gd name="T67" fmla="*/ 620 h 2020"/>
              <a:gd name="T68" fmla="*/ 1378 w 2019"/>
              <a:gd name="T69" fmla="*/ 778 h 2020"/>
              <a:gd name="T70" fmla="*/ 1359 w 2019"/>
              <a:gd name="T71" fmla="*/ 575 h 2020"/>
              <a:gd name="T72" fmla="*/ 1433 w 2019"/>
              <a:gd name="T73" fmla="*/ 705 h 2020"/>
              <a:gd name="T74" fmla="*/ 1347 w 2019"/>
              <a:gd name="T75" fmla="*/ 732 h 2020"/>
              <a:gd name="T76" fmla="*/ 1435 w 2019"/>
              <a:gd name="T77" fmla="*/ 464 h 2020"/>
              <a:gd name="T78" fmla="*/ 1579 w 2019"/>
              <a:gd name="T79" fmla="*/ 608 h 2020"/>
              <a:gd name="T80" fmla="*/ 1587 w 2019"/>
              <a:gd name="T81" fmla="*/ 284 h 2020"/>
              <a:gd name="T82" fmla="*/ 1590 w 2019"/>
              <a:gd name="T83" fmla="*/ 461 h 2020"/>
              <a:gd name="T84" fmla="*/ 1636 w 2019"/>
              <a:gd name="T85" fmla="*/ 359 h 2020"/>
              <a:gd name="T86" fmla="*/ 1510 w 2019"/>
              <a:gd name="T87" fmla="*/ 381 h 2020"/>
              <a:gd name="T88" fmla="*/ 1806 w 2019"/>
              <a:gd name="T89" fmla="*/ 337 h 2020"/>
              <a:gd name="T90" fmla="*/ 1832 w 2019"/>
              <a:gd name="T91" fmla="*/ 237 h 2020"/>
              <a:gd name="T92" fmla="*/ 1665 w 2019"/>
              <a:gd name="T93" fmla="*/ 273 h 2020"/>
              <a:gd name="T94" fmla="*/ 1757 w 2019"/>
              <a:gd name="T95" fmla="*/ 136 h 2020"/>
              <a:gd name="T96" fmla="*/ 1677 w 2019"/>
              <a:gd name="T97" fmla="*/ 223 h 2020"/>
              <a:gd name="T98" fmla="*/ 1839 w 2019"/>
              <a:gd name="T99" fmla="*/ 206 h 2020"/>
              <a:gd name="T100" fmla="*/ 1813 w 2019"/>
              <a:gd name="T101" fmla="*/ 367 h 2020"/>
              <a:gd name="T102" fmla="*/ 1867 w 2019"/>
              <a:gd name="T103" fmla="*/ 58 h 2020"/>
              <a:gd name="T104" fmla="*/ 1837 w 2019"/>
              <a:gd name="T105" fmla="*/ 13 h 202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</a:cxnLst>
            <a:rect l="0" t="0" r="r" b="b"/>
            <a:pathLst>
              <a:path w="2019" h="2020">
                <a:moveTo>
                  <a:pt x="168" y="2020"/>
                </a:moveTo>
                <a:lnTo>
                  <a:pt x="0" y="1852"/>
                </a:lnTo>
                <a:lnTo>
                  <a:pt x="63" y="1788"/>
                </a:lnTo>
                <a:cubicBezTo>
                  <a:pt x="74" y="1777"/>
                  <a:pt x="83" y="1769"/>
                  <a:pt x="90" y="1764"/>
                </a:cubicBezTo>
                <a:cubicBezTo>
                  <a:pt x="100" y="1758"/>
                  <a:pt x="109" y="1753"/>
                  <a:pt x="119" y="1752"/>
                </a:cubicBezTo>
                <a:cubicBezTo>
                  <a:pt x="128" y="1750"/>
                  <a:pt x="138" y="1751"/>
                  <a:pt x="148" y="1754"/>
                </a:cubicBezTo>
                <a:cubicBezTo>
                  <a:pt x="159" y="1758"/>
                  <a:pt x="168" y="1764"/>
                  <a:pt x="177" y="1772"/>
                </a:cubicBezTo>
                <a:cubicBezTo>
                  <a:pt x="191" y="1786"/>
                  <a:pt x="198" y="1803"/>
                  <a:pt x="199" y="1822"/>
                </a:cubicBezTo>
                <a:cubicBezTo>
                  <a:pt x="200" y="1841"/>
                  <a:pt x="188" y="1862"/>
                  <a:pt x="165" y="1886"/>
                </a:cubicBezTo>
                <a:lnTo>
                  <a:pt x="122" y="1929"/>
                </a:lnTo>
                <a:lnTo>
                  <a:pt x="190" y="1998"/>
                </a:lnTo>
                <a:lnTo>
                  <a:pt x="168" y="2020"/>
                </a:lnTo>
                <a:close/>
                <a:moveTo>
                  <a:pt x="102" y="1909"/>
                </a:moveTo>
                <a:lnTo>
                  <a:pt x="145" y="1866"/>
                </a:lnTo>
                <a:cubicBezTo>
                  <a:pt x="160" y="1852"/>
                  <a:pt x="167" y="1839"/>
                  <a:pt x="168" y="1827"/>
                </a:cubicBezTo>
                <a:cubicBezTo>
                  <a:pt x="168" y="1816"/>
                  <a:pt x="164" y="1805"/>
                  <a:pt x="154" y="1796"/>
                </a:cubicBezTo>
                <a:cubicBezTo>
                  <a:pt x="147" y="1789"/>
                  <a:pt x="139" y="1785"/>
                  <a:pt x="131" y="1783"/>
                </a:cubicBezTo>
                <a:cubicBezTo>
                  <a:pt x="122" y="1782"/>
                  <a:pt x="114" y="1783"/>
                  <a:pt x="107" y="1787"/>
                </a:cubicBezTo>
                <a:cubicBezTo>
                  <a:pt x="102" y="1790"/>
                  <a:pt x="95" y="1796"/>
                  <a:pt x="85" y="1806"/>
                </a:cubicBezTo>
                <a:lnTo>
                  <a:pt x="42" y="1849"/>
                </a:lnTo>
                <a:lnTo>
                  <a:pt x="102" y="1909"/>
                </a:lnTo>
                <a:close/>
                <a:moveTo>
                  <a:pt x="325" y="1862"/>
                </a:moveTo>
                <a:lnTo>
                  <a:pt x="157" y="1694"/>
                </a:lnTo>
                <a:lnTo>
                  <a:pt x="220" y="1631"/>
                </a:lnTo>
                <a:cubicBezTo>
                  <a:pt x="233" y="1618"/>
                  <a:pt x="245" y="1610"/>
                  <a:pt x="256" y="1606"/>
                </a:cubicBezTo>
                <a:cubicBezTo>
                  <a:pt x="267" y="1601"/>
                  <a:pt x="279" y="1600"/>
                  <a:pt x="290" y="1603"/>
                </a:cubicBezTo>
                <a:cubicBezTo>
                  <a:pt x="302" y="1606"/>
                  <a:pt x="311" y="1611"/>
                  <a:pt x="319" y="1619"/>
                </a:cubicBezTo>
                <a:cubicBezTo>
                  <a:pt x="326" y="1626"/>
                  <a:pt x="331" y="1634"/>
                  <a:pt x="333" y="1645"/>
                </a:cubicBezTo>
                <a:cubicBezTo>
                  <a:pt x="336" y="1655"/>
                  <a:pt x="335" y="1666"/>
                  <a:pt x="331" y="1678"/>
                </a:cubicBezTo>
                <a:cubicBezTo>
                  <a:pt x="344" y="1671"/>
                  <a:pt x="357" y="1668"/>
                  <a:pt x="370" y="1670"/>
                </a:cubicBezTo>
                <a:cubicBezTo>
                  <a:pt x="382" y="1671"/>
                  <a:pt x="394" y="1677"/>
                  <a:pt x="403" y="1687"/>
                </a:cubicBezTo>
                <a:cubicBezTo>
                  <a:pt x="411" y="1695"/>
                  <a:pt x="417" y="1704"/>
                  <a:pt x="420" y="1714"/>
                </a:cubicBezTo>
                <a:cubicBezTo>
                  <a:pt x="424" y="1724"/>
                  <a:pt x="425" y="1733"/>
                  <a:pt x="424" y="1742"/>
                </a:cubicBezTo>
                <a:cubicBezTo>
                  <a:pt x="422" y="1750"/>
                  <a:pt x="419" y="1759"/>
                  <a:pt x="414" y="1768"/>
                </a:cubicBezTo>
                <a:cubicBezTo>
                  <a:pt x="408" y="1778"/>
                  <a:pt x="400" y="1788"/>
                  <a:pt x="389" y="1798"/>
                </a:cubicBezTo>
                <a:lnTo>
                  <a:pt x="325" y="1862"/>
                </a:lnTo>
                <a:close/>
                <a:moveTo>
                  <a:pt x="250" y="1743"/>
                </a:moveTo>
                <a:lnTo>
                  <a:pt x="286" y="1706"/>
                </a:lnTo>
                <a:cubicBezTo>
                  <a:pt x="296" y="1697"/>
                  <a:pt x="303" y="1689"/>
                  <a:pt x="306" y="1683"/>
                </a:cubicBezTo>
                <a:cubicBezTo>
                  <a:pt x="310" y="1676"/>
                  <a:pt x="311" y="1669"/>
                  <a:pt x="310" y="1662"/>
                </a:cubicBezTo>
                <a:cubicBezTo>
                  <a:pt x="309" y="1655"/>
                  <a:pt x="305" y="1649"/>
                  <a:pt x="300" y="1643"/>
                </a:cubicBezTo>
                <a:cubicBezTo>
                  <a:pt x="294" y="1638"/>
                  <a:pt x="288" y="1634"/>
                  <a:pt x="281" y="1632"/>
                </a:cubicBezTo>
                <a:cubicBezTo>
                  <a:pt x="274" y="1631"/>
                  <a:pt x="267" y="1632"/>
                  <a:pt x="261" y="1635"/>
                </a:cubicBezTo>
                <a:cubicBezTo>
                  <a:pt x="254" y="1639"/>
                  <a:pt x="245" y="1646"/>
                  <a:pt x="233" y="1658"/>
                </a:cubicBezTo>
                <a:lnTo>
                  <a:pt x="199" y="1692"/>
                </a:lnTo>
                <a:lnTo>
                  <a:pt x="250" y="1743"/>
                </a:lnTo>
                <a:close/>
                <a:moveTo>
                  <a:pt x="328" y="1820"/>
                </a:moveTo>
                <a:lnTo>
                  <a:pt x="369" y="1778"/>
                </a:lnTo>
                <a:cubicBezTo>
                  <a:pt x="377" y="1771"/>
                  <a:pt x="381" y="1766"/>
                  <a:pt x="384" y="1763"/>
                </a:cubicBezTo>
                <a:cubicBezTo>
                  <a:pt x="388" y="1757"/>
                  <a:pt x="391" y="1751"/>
                  <a:pt x="392" y="1745"/>
                </a:cubicBezTo>
                <a:cubicBezTo>
                  <a:pt x="393" y="1740"/>
                  <a:pt x="393" y="1734"/>
                  <a:pt x="391" y="1727"/>
                </a:cubicBezTo>
                <a:cubicBezTo>
                  <a:pt x="389" y="1721"/>
                  <a:pt x="386" y="1715"/>
                  <a:pt x="380" y="1710"/>
                </a:cubicBezTo>
                <a:cubicBezTo>
                  <a:pt x="374" y="1704"/>
                  <a:pt x="367" y="1700"/>
                  <a:pt x="359" y="1698"/>
                </a:cubicBezTo>
                <a:cubicBezTo>
                  <a:pt x="351" y="1697"/>
                  <a:pt x="344" y="1698"/>
                  <a:pt x="336" y="1702"/>
                </a:cubicBezTo>
                <a:cubicBezTo>
                  <a:pt x="328" y="1706"/>
                  <a:pt x="319" y="1713"/>
                  <a:pt x="309" y="1724"/>
                </a:cubicBezTo>
                <a:lnTo>
                  <a:pt x="270" y="1763"/>
                </a:lnTo>
                <a:lnTo>
                  <a:pt x="328" y="1820"/>
                </a:lnTo>
                <a:close/>
                <a:moveTo>
                  <a:pt x="482" y="1706"/>
                </a:moveTo>
                <a:lnTo>
                  <a:pt x="314" y="1538"/>
                </a:lnTo>
                <a:lnTo>
                  <a:pt x="371" y="1480"/>
                </a:lnTo>
                <a:cubicBezTo>
                  <a:pt x="385" y="1467"/>
                  <a:pt x="395" y="1458"/>
                  <a:pt x="404" y="1452"/>
                </a:cubicBezTo>
                <a:cubicBezTo>
                  <a:pt x="416" y="1445"/>
                  <a:pt x="428" y="1441"/>
                  <a:pt x="440" y="1440"/>
                </a:cubicBezTo>
                <a:cubicBezTo>
                  <a:pt x="457" y="1438"/>
                  <a:pt x="473" y="1441"/>
                  <a:pt x="489" y="1449"/>
                </a:cubicBezTo>
                <a:cubicBezTo>
                  <a:pt x="505" y="1456"/>
                  <a:pt x="521" y="1467"/>
                  <a:pt x="536" y="1482"/>
                </a:cubicBezTo>
                <a:cubicBezTo>
                  <a:pt x="548" y="1495"/>
                  <a:pt x="558" y="1508"/>
                  <a:pt x="565" y="1520"/>
                </a:cubicBezTo>
                <a:cubicBezTo>
                  <a:pt x="572" y="1533"/>
                  <a:pt x="576" y="1545"/>
                  <a:pt x="578" y="1556"/>
                </a:cubicBezTo>
                <a:cubicBezTo>
                  <a:pt x="580" y="1568"/>
                  <a:pt x="580" y="1578"/>
                  <a:pt x="578" y="1587"/>
                </a:cubicBezTo>
                <a:cubicBezTo>
                  <a:pt x="576" y="1596"/>
                  <a:pt x="572" y="1606"/>
                  <a:pt x="566" y="1615"/>
                </a:cubicBezTo>
                <a:cubicBezTo>
                  <a:pt x="560" y="1625"/>
                  <a:pt x="552" y="1635"/>
                  <a:pt x="542" y="1645"/>
                </a:cubicBezTo>
                <a:lnTo>
                  <a:pt x="482" y="1706"/>
                </a:lnTo>
                <a:close/>
                <a:moveTo>
                  <a:pt x="484" y="1664"/>
                </a:moveTo>
                <a:lnTo>
                  <a:pt x="520" y="1628"/>
                </a:lnTo>
                <a:cubicBezTo>
                  <a:pt x="531" y="1617"/>
                  <a:pt x="539" y="1607"/>
                  <a:pt x="543" y="1599"/>
                </a:cubicBezTo>
                <a:cubicBezTo>
                  <a:pt x="547" y="1590"/>
                  <a:pt x="549" y="1583"/>
                  <a:pt x="549" y="1575"/>
                </a:cubicBezTo>
                <a:cubicBezTo>
                  <a:pt x="549" y="1564"/>
                  <a:pt x="546" y="1553"/>
                  <a:pt x="540" y="1541"/>
                </a:cubicBezTo>
                <a:cubicBezTo>
                  <a:pt x="534" y="1530"/>
                  <a:pt x="525" y="1517"/>
                  <a:pt x="512" y="1505"/>
                </a:cubicBezTo>
                <a:cubicBezTo>
                  <a:pt x="495" y="1487"/>
                  <a:pt x="478" y="1476"/>
                  <a:pt x="463" y="1473"/>
                </a:cubicBezTo>
                <a:cubicBezTo>
                  <a:pt x="448" y="1469"/>
                  <a:pt x="435" y="1470"/>
                  <a:pt x="423" y="1475"/>
                </a:cubicBezTo>
                <a:cubicBezTo>
                  <a:pt x="415" y="1478"/>
                  <a:pt x="404" y="1487"/>
                  <a:pt x="391" y="1500"/>
                </a:cubicBezTo>
                <a:lnTo>
                  <a:pt x="356" y="1535"/>
                </a:lnTo>
                <a:lnTo>
                  <a:pt x="484" y="1664"/>
                </a:lnTo>
                <a:close/>
                <a:moveTo>
                  <a:pt x="676" y="1605"/>
                </a:moveTo>
                <a:lnTo>
                  <a:pt x="661" y="1590"/>
                </a:lnTo>
                <a:lnTo>
                  <a:pt x="798" y="1453"/>
                </a:lnTo>
                <a:lnTo>
                  <a:pt x="813" y="1468"/>
                </a:lnTo>
                <a:lnTo>
                  <a:pt x="676" y="1605"/>
                </a:lnTo>
                <a:close/>
                <a:moveTo>
                  <a:pt x="784" y="1403"/>
                </a:moveTo>
                <a:lnTo>
                  <a:pt x="616" y="1235"/>
                </a:lnTo>
                <a:lnTo>
                  <a:pt x="680" y="1172"/>
                </a:lnTo>
                <a:cubicBezTo>
                  <a:pt x="691" y="1161"/>
                  <a:pt x="700" y="1153"/>
                  <a:pt x="707" y="1148"/>
                </a:cubicBezTo>
                <a:cubicBezTo>
                  <a:pt x="716" y="1141"/>
                  <a:pt x="726" y="1137"/>
                  <a:pt x="735" y="1135"/>
                </a:cubicBezTo>
                <a:cubicBezTo>
                  <a:pt x="745" y="1133"/>
                  <a:pt x="755" y="1134"/>
                  <a:pt x="765" y="1138"/>
                </a:cubicBezTo>
                <a:cubicBezTo>
                  <a:pt x="775" y="1141"/>
                  <a:pt x="785" y="1147"/>
                  <a:pt x="793" y="1156"/>
                </a:cubicBezTo>
                <a:cubicBezTo>
                  <a:pt x="807" y="1170"/>
                  <a:pt x="815" y="1186"/>
                  <a:pt x="816" y="1205"/>
                </a:cubicBezTo>
                <a:cubicBezTo>
                  <a:pt x="817" y="1224"/>
                  <a:pt x="805" y="1246"/>
                  <a:pt x="781" y="1270"/>
                </a:cubicBezTo>
                <a:lnTo>
                  <a:pt x="738" y="1313"/>
                </a:lnTo>
                <a:lnTo>
                  <a:pt x="807" y="1381"/>
                </a:lnTo>
                <a:lnTo>
                  <a:pt x="784" y="1403"/>
                </a:lnTo>
                <a:close/>
                <a:moveTo>
                  <a:pt x="718" y="1293"/>
                </a:moveTo>
                <a:lnTo>
                  <a:pt x="762" y="1249"/>
                </a:lnTo>
                <a:cubicBezTo>
                  <a:pt x="776" y="1235"/>
                  <a:pt x="784" y="1222"/>
                  <a:pt x="784" y="1211"/>
                </a:cubicBezTo>
                <a:cubicBezTo>
                  <a:pt x="785" y="1199"/>
                  <a:pt x="781" y="1189"/>
                  <a:pt x="771" y="1179"/>
                </a:cubicBezTo>
                <a:cubicBezTo>
                  <a:pt x="764" y="1172"/>
                  <a:pt x="756" y="1168"/>
                  <a:pt x="747" y="1166"/>
                </a:cubicBezTo>
                <a:cubicBezTo>
                  <a:pt x="739" y="1165"/>
                  <a:pt x="731" y="1166"/>
                  <a:pt x="724" y="1171"/>
                </a:cubicBezTo>
                <a:cubicBezTo>
                  <a:pt x="719" y="1173"/>
                  <a:pt x="711" y="1180"/>
                  <a:pt x="701" y="1190"/>
                </a:cubicBezTo>
                <a:lnTo>
                  <a:pt x="658" y="1233"/>
                </a:lnTo>
                <a:lnTo>
                  <a:pt x="718" y="1293"/>
                </a:lnTo>
                <a:close/>
                <a:moveTo>
                  <a:pt x="940" y="1247"/>
                </a:moveTo>
                <a:lnTo>
                  <a:pt x="772" y="1079"/>
                </a:lnTo>
                <a:lnTo>
                  <a:pt x="894" y="958"/>
                </a:lnTo>
                <a:lnTo>
                  <a:pt x="914" y="978"/>
                </a:lnTo>
                <a:lnTo>
                  <a:pt x="814" y="1077"/>
                </a:lnTo>
                <a:lnTo>
                  <a:pt x="866" y="1128"/>
                </a:lnTo>
                <a:lnTo>
                  <a:pt x="959" y="1035"/>
                </a:lnTo>
                <a:lnTo>
                  <a:pt x="978" y="1055"/>
                </a:lnTo>
                <a:lnTo>
                  <a:pt x="886" y="1148"/>
                </a:lnTo>
                <a:lnTo>
                  <a:pt x="943" y="1205"/>
                </a:lnTo>
                <a:lnTo>
                  <a:pt x="1046" y="1102"/>
                </a:lnTo>
                <a:lnTo>
                  <a:pt x="1066" y="1122"/>
                </a:lnTo>
                <a:lnTo>
                  <a:pt x="940" y="1247"/>
                </a:lnTo>
                <a:close/>
                <a:moveTo>
                  <a:pt x="1081" y="1106"/>
                </a:moveTo>
                <a:lnTo>
                  <a:pt x="1059" y="954"/>
                </a:lnTo>
                <a:lnTo>
                  <a:pt x="921" y="931"/>
                </a:lnTo>
                <a:lnTo>
                  <a:pt x="947" y="904"/>
                </a:lnTo>
                <a:lnTo>
                  <a:pt x="1021" y="917"/>
                </a:lnTo>
                <a:cubicBezTo>
                  <a:pt x="1036" y="919"/>
                  <a:pt x="1048" y="922"/>
                  <a:pt x="1055" y="924"/>
                </a:cubicBezTo>
                <a:cubicBezTo>
                  <a:pt x="1053" y="914"/>
                  <a:pt x="1051" y="903"/>
                  <a:pt x="1049" y="891"/>
                </a:cubicBezTo>
                <a:lnTo>
                  <a:pt x="1038" y="813"/>
                </a:lnTo>
                <a:lnTo>
                  <a:pt x="1063" y="789"/>
                </a:lnTo>
                <a:lnTo>
                  <a:pt x="1083" y="927"/>
                </a:lnTo>
                <a:lnTo>
                  <a:pt x="1235" y="952"/>
                </a:lnTo>
                <a:lnTo>
                  <a:pt x="1208" y="980"/>
                </a:lnTo>
                <a:lnTo>
                  <a:pt x="1105" y="962"/>
                </a:lnTo>
                <a:cubicBezTo>
                  <a:pt x="1100" y="961"/>
                  <a:pt x="1093" y="960"/>
                  <a:pt x="1087" y="958"/>
                </a:cubicBezTo>
                <a:cubicBezTo>
                  <a:pt x="1089" y="968"/>
                  <a:pt x="1091" y="975"/>
                  <a:pt x="1091" y="979"/>
                </a:cubicBezTo>
                <a:lnTo>
                  <a:pt x="1108" y="1080"/>
                </a:lnTo>
                <a:lnTo>
                  <a:pt x="1081" y="1106"/>
                </a:lnTo>
                <a:close/>
                <a:moveTo>
                  <a:pt x="1334" y="814"/>
                </a:moveTo>
                <a:lnTo>
                  <a:pt x="1354" y="834"/>
                </a:lnTo>
                <a:lnTo>
                  <a:pt x="1243" y="945"/>
                </a:lnTo>
                <a:cubicBezTo>
                  <a:pt x="1238" y="940"/>
                  <a:pt x="1234" y="934"/>
                  <a:pt x="1231" y="928"/>
                </a:cubicBezTo>
                <a:cubicBezTo>
                  <a:pt x="1226" y="918"/>
                  <a:pt x="1223" y="906"/>
                  <a:pt x="1222" y="892"/>
                </a:cubicBezTo>
                <a:cubicBezTo>
                  <a:pt x="1221" y="879"/>
                  <a:pt x="1222" y="861"/>
                  <a:pt x="1224" y="840"/>
                </a:cubicBezTo>
                <a:cubicBezTo>
                  <a:pt x="1227" y="806"/>
                  <a:pt x="1227" y="782"/>
                  <a:pt x="1225" y="767"/>
                </a:cubicBezTo>
                <a:cubicBezTo>
                  <a:pt x="1223" y="752"/>
                  <a:pt x="1218" y="740"/>
                  <a:pt x="1210" y="733"/>
                </a:cubicBezTo>
                <a:cubicBezTo>
                  <a:pt x="1202" y="724"/>
                  <a:pt x="1192" y="720"/>
                  <a:pt x="1180" y="721"/>
                </a:cubicBezTo>
                <a:cubicBezTo>
                  <a:pt x="1169" y="721"/>
                  <a:pt x="1159" y="726"/>
                  <a:pt x="1149" y="735"/>
                </a:cubicBezTo>
                <a:cubicBezTo>
                  <a:pt x="1139" y="745"/>
                  <a:pt x="1134" y="756"/>
                  <a:pt x="1134" y="768"/>
                </a:cubicBezTo>
                <a:cubicBezTo>
                  <a:pt x="1134" y="780"/>
                  <a:pt x="1139" y="791"/>
                  <a:pt x="1150" y="802"/>
                </a:cubicBezTo>
                <a:lnTo>
                  <a:pt x="1127" y="821"/>
                </a:lnTo>
                <a:cubicBezTo>
                  <a:pt x="1112" y="803"/>
                  <a:pt x="1106" y="786"/>
                  <a:pt x="1107" y="768"/>
                </a:cubicBezTo>
                <a:cubicBezTo>
                  <a:pt x="1108" y="750"/>
                  <a:pt x="1117" y="734"/>
                  <a:pt x="1133" y="718"/>
                </a:cubicBezTo>
                <a:cubicBezTo>
                  <a:pt x="1149" y="701"/>
                  <a:pt x="1166" y="693"/>
                  <a:pt x="1184" y="693"/>
                </a:cubicBezTo>
                <a:cubicBezTo>
                  <a:pt x="1203" y="692"/>
                  <a:pt x="1218" y="699"/>
                  <a:pt x="1232" y="712"/>
                </a:cubicBezTo>
                <a:cubicBezTo>
                  <a:pt x="1238" y="719"/>
                  <a:pt x="1244" y="727"/>
                  <a:pt x="1247" y="736"/>
                </a:cubicBezTo>
                <a:cubicBezTo>
                  <a:pt x="1251" y="745"/>
                  <a:pt x="1253" y="756"/>
                  <a:pt x="1254" y="770"/>
                </a:cubicBezTo>
                <a:cubicBezTo>
                  <a:pt x="1255" y="784"/>
                  <a:pt x="1254" y="804"/>
                  <a:pt x="1252" y="831"/>
                </a:cubicBezTo>
                <a:cubicBezTo>
                  <a:pt x="1250" y="854"/>
                  <a:pt x="1249" y="869"/>
                  <a:pt x="1249" y="876"/>
                </a:cubicBezTo>
                <a:cubicBezTo>
                  <a:pt x="1249" y="884"/>
                  <a:pt x="1250" y="890"/>
                  <a:pt x="1252" y="896"/>
                </a:cubicBezTo>
                <a:lnTo>
                  <a:pt x="1334" y="814"/>
                </a:lnTo>
                <a:close/>
                <a:moveTo>
                  <a:pt x="1359" y="575"/>
                </a:moveTo>
                <a:lnTo>
                  <a:pt x="1340" y="597"/>
                </a:lnTo>
                <a:cubicBezTo>
                  <a:pt x="1330" y="591"/>
                  <a:pt x="1321" y="588"/>
                  <a:pt x="1314" y="587"/>
                </a:cubicBezTo>
                <a:cubicBezTo>
                  <a:pt x="1303" y="587"/>
                  <a:pt x="1293" y="591"/>
                  <a:pt x="1285" y="599"/>
                </a:cubicBezTo>
                <a:cubicBezTo>
                  <a:pt x="1278" y="606"/>
                  <a:pt x="1274" y="613"/>
                  <a:pt x="1273" y="622"/>
                </a:cubicBezTo>
                <a:cubicBezTo>
                  <a:pt x="1271" y="633"/>
                  <a:pt x="1273" y="645"/>
                  <a:pt x="1278" y="658"/>
                </a:cubicBezTo>
                <a:cubicBezTo>
                  <a:pt x="1284" y="671"/>
                  <a:pt x="1295" y="686"/>
                  <a:pt x="1311" y="703"/>
                </a:cubicBezTo>
                <a:cubicBezTo>
                  <a:pt x="1309" y="690"/>
                  <a:pt x="1309" y="679"/>
                  <a:pt x="1313" y="668"/>
                </a:cubicBezTo>
                <a:cubicBezTo>
                  <a:pt x="1316" y="657"/>
                  <a:pt x="1322" y="648"/>
                  <a:pt x="1330" y="640"/>
                </a:cubicBezTo>
                <a:cubicBezTo>
                  <a:pt x="1344" y="626"/>
                  <a:pt x="1360" y="619"/>
                  <a:pt x="1380" y="620"/>
                </a:cubicBezTo>
                <a:cubicBezTo>
                  <a:pt x="1400" y="620"/>
                  <a:pt x="1418" y="629"/>
                  <a:pt x="1434" y="645"/>
                </a:cubicBezTo>
                <a:cubicBezTo>
                  <a:pt x="1444" y="655"/>
                  <a:pt x="1452" y="667"/>
                  <a:pt x="1456" y="681"/>
                </a:cubicBezTo>
                <a:cubicBezTo>
                  <a:pt x="1461" y="694"/>
                  <a:pt x="1462" y="708"/>
                  <a:pt x="1458" y="720"/>
                </a:cubicBezTo>
                <a:cubicBezTo>
                  <a:pt x="1455" y="733"/>
                  <a:pt x="1449" y="745"/>
                  <a:pt x="1439" y="755"/>
                </a:cubicBezTo>
                <a:cubicBezTo>
                  <a:pt x="1421" y="772"/>
                  <a:pt x="1401" y="780"/>
                  <a:pt x="1378" y="778"/>
                </a:cubicBezTo>
                <a:cubicBezTo>
                  <a:pt x="1354" y="776"/>
                  <a:pt x="1328" y="761"/>
                  <a:pt x="1299" y="731"/>
                </a:cubicBezTo>
                <a:cubicBezTo>
                  <a:pt x="1266" y="699"/>
                  <a:pt x="1249" y="669"/>
                  <a:pt x="1246" y="643"/>
                </a:cubicBezTo>
                <a:cubicBezTo>
                  <a:pt x="1244" y="619"/>
                  <a:pt x="1251" y="599"/>
                  <a:pt x="1269" y="581"/>
                </a:cubicBezTo>
                <a:cubicBezTo>
                  <a:pt x="1282" y="568"/>
                  <a:pt x="1297" y="561"/>
                  <a:pt x="1313" y="560"/>
                </a:cubicBezTo>
                <a:cubicBezTo>
                  <a:pt x="1328" y="559"/>
                  <a:pt x="1344" y="564"/>
                  <a:pt x="1359" y="575"/>
                </a:cubicBezTo>
                <a:close/>
                <a:moveTo>
                  <a:pt x="1347" y="732"/>
                </a:moveTo>
                <a:cubicBezTo>
                  <a:pt x="1354" y="739"/>
                  <a:pt x="1362" y="744"/>
                  <a:pt x="1372" y="748"/>
                </a:cubicBezTo>
                <a:cubicBezTo>
                  <a:pt x="1381" y="751"/>
                  <a:pt x="1390" y="752"/>
                  <a:pt x="1399" y="750"/>
                </a:cubicBezTo>
                <a:cubicBezTo>
                  <a:pt x="1408" y="748"/>
                  <a:pt x="1415" y="744"/>
                  <a:pt x="1421" y="738"/>
                </a:cubicBezTo>
                <a:cubicBezTo>
                  <a:pt x="1430" y="729"/>
                  <a:pt x="1434" y="718"/>
                  <a:pt x="1433" y="705"/>
                </a:cubicBezTo>
                <a:cubicBezTo>
                  <a:pt x="1433" y="692"/>
                  <a:pt x="1426" y="679"/>
                  <a:pt x="1414" y="667"/>
                </a:cubicBezTo>
                <a:cubicBezTo>
                  <a:pt x="1402" y="655"/>
                  <a:pt x="1390" y="649"/>
                  <a:pt x="1377" y="649"/>
                </a:cubicBezTo>
                <a:cubicBezTo>
                  <a:pt x="1364" y="648"/>
                  <a:pt x="1353" y="653"/>
                  <a:pt x="1344" y="662"/>
                </a:cubicBezTo>
                <a:cubicBezTo>
                  <a:pt x="1335" y="671"/>
                  <a:pt x="1330" y="683"/>
                  <a:pt x="1330" y="696"/>
                </a:cubicBezTo>
                <a:cubicBezTo>
                  <a:pt x="1330" y="709"/>
                  <a:pt x="1336" y="721"/>
                  <a:pt x="1347" y="732"/>
                </a:cubicBezTo>
                <a:close/>
                <a:moveTo>
                  <a:pt x="1435" y="464"/>
                </a:moveTo>
                <a:lnTo>
                  <a:pt x="1411" y="440"/>
                </a:lnTo>
                <a:lnTo>
                  <a:pt x="1432" y="420"/>
                </a:lnTo>
                <a:lnTo>
                  <a:pt x="1456" y="443"/>
                </a:lnTo>
                <a:lnTo>
                  <a:pt x="1435" y="464"/>
                </a:lnTo>
                <a:close/>
                <a:moveTo>
                  <a:pt x="1579" y="608"/>
                </a:moveTo>
                <a:lnTo>
                  <a:pt x="1458" y="486"/>
                </a:lnTo>
                <a:lnTo>
                  <a:pt x="1478" y="466"/>
                </a:lnTo>
                <a:lnTo>
                  <a:pt x="1600" y="588"/>
                </a:lnTo>
                <a:lnTo>
                  <a:pt x="1579" y="608"/>
                </a:lnTo>
                <a:close/>
                <a:moveTo>
                  <a:pt x="1636" y="552"/>
                </a:moveTo>
                <a:lnTo>
                  <a:pt x="1468" y="384"/>
                </a:lnTo>
                <a:lnTo>
                  <a:pt x="1531" y="320"/>
                </a:lnTo>
                <a:cubicBezTo>
                  <a:pt x="1542" y="309"/>
                  <a:pt x="1551" y="301"/>
                  <a:pt x="1558" y="297"/>
                </a:cubicBezTo>
                <a:cubicBezTo>
                  <a:pt x="1568" y="290"/>
                  <a:pt x="1577" y="285"/>
                  <a:pt x="1587" y="284"/>
                </a:cubicBezTo>
                <a:cubicBezTo>
                  <a:pt x="1596" y="282"/>
                  <a:pt x="1606" y="283"/>
                  <a:pt x="1616" y="286"/>
                </a:cubicBezTo>
                <a:cubicBezTo>
                  <a:pt x="1627" y="290"/>
                  <a:pt x="1636" y="296"/>
                  <a:pt x="1644" y="304"/>
                </a:cubicBezTo>
                <a:cubicBezTo>
                  <a:pt x="1659" y="318"/>
                  <a:pt x="1666" y="335"/>
                  <a:pt x="1667" y="354"/>
                </a:cubicBezTo>
                <a:cubicBezTo>
                  <a:pt x="1668" y="373"/>
                  <a:pt x="1656" y="394"/>
                  <a:pt x="1633" y="418"/>
                </a:cubicBezTo>
                <a:lnTo>
                  <a:pt x="1590" y="461"/>
                </a:lnTo>
                <a:lnTo>
                  <a:pt x="1658" y="530"/>
                </a:lnTo>
                <a:lnTo>
                  <a:pt x="1636" y="552"/>
                </a:lnTo>
                <a:close/>
                <a:moveTo>
                  <a:pt x="1570" y="442"/>
                </a:moveTo>
                <a:lnTo>
                  <a:pt x="1613" y="398"/>
                </a:lnTo>
                <a:cubicBezTo>
                  <a:pt x="1628" y="384"/>
                  <a:pt x="1635" y="371"/>
                  <a:pt x="1636" y="359"/>
                </a:cubicBezTo>
                <a:cubicBezTo>
                  <a:pt x="1636" y="348"/>
                  <a:pt x="1632" y="338"/>
                  <a:pt x="1622" y="328"/>
                </a:cubicBezTo>
                <a:cubicBezTo>
                  <a:pt x="1615" y="321"/>
                  <a:pt x="1607" y="317"/>
                  <a:pt x="1599" y="315"/>
                </a:cubicBezTo>
                <a:cubicBezTo>
                  <a:pt x="1590" y="314"/>
                  <a:pt x="1582" y="315"/>
                  <a:pt x="1575" y="319"/>
                </a:cubicBezTo>
                <a:cubicBezTo>
                  <a:pt x="1570" y="322"/>
                  <a:pt x="1563" y="328"/>
                  <a:pt x="1553" y="338"/>
                </a:cubicBezTo>
                <a:lnTo>
                  <a:pt x="1510" y="381"/>
                </a:lnTo>
                <a:lnTo>
                  <a:pt x="1570" y="442"/>
                </a:lnTo>
                <a:close/>
                <a:moveTo>
                  <a:pt x="1730" y="350"/>
                </a:moveTo>
                <a:lnTo>
                  <a:pt x="1749" y="327"/>
                </a:lnTo>
                <a:cubicBezTo>
                  <a:pt x="1758" y="335"/>
                  <a:pt x="1767" y="339"/>
                  <a:pt x="1776" y="341"/>
                </a:cubicBezTo>
                <a:cubicBezTo>
                  <a:pt x="1785" y="343"/>
                  <a:pt x="1795" y="341"/>
                  <a:pt x="1806" y="337"/>
                </a:cubicBezTo>
                <a:cubicBezTo>
                  <a:pt x="1817" y="333"/>
                  <a:pt x="1828" y="326"/>
                  <a:pt x="1837" y="316"/>
                </a:cubicBezTo>
                <a:cubicBezTo>
                  <a:pt x="1846" y="308"/>
                  <a:pt x="1852" y="299"/>
                  <a:pt x="1856" y="290"/>
                </a:cubicBezTo>
                <a:cubicBezTo>
                  <a:pt x="1860" y="281"/>
                  <a:pt x="1861" y="273"/>
                  <a:pt x="1860" y="265"/>
                </a:cubicBezTo>
                <a:cubicBezTo>
                  <a:pt x="1859" y="258"/>
                  <a:pt x="1856" y="251"/>
                  <a:pt x="1850" y="246"/>
                </a:cubicBezTo>
                <a:cubicBezTo>
                  <a:pt x="1845" y="241"/>
                  <a:pt x="1839" y="238"/>
                  <a:pt x="1832" y="237"/>
                </a:cubicBezTo>
                <a:cubicBezTo>
                  <a:pt x="1825" y="236"/>
                  <a:pt x="1817" y="238"/>
                  <a:pt x="1807" y="242"/>
                </a:cubicBezTo>
                <a:cubicBezTo>
                  <a:pt x="1801" y="245"/>
                  <a:pt x="1788" y="252"/>
                  <a:pt x="1769" y="264"/>
                </a:cubicBezTo>
                <a:cubicBezTo>
                  <a:pt x="1750" y="275"/>
                  <a:pt x="1735" y="283"/>
                  <a:pt x="1726" y="286"/>
                </a:cubicBezTo>
                <a:cubicBezTo>
                  <a:pt x="1714" y="289"/>
                  <a:pt x="1702" y="290"/>
                  <a:pt x="1692" y="288"/>
                </a:cubicBezTo>
                <a:cubicBezTo>
                  <a:pt x="1682" y="286"/>
                  <a:pt x="1673" y="281"/>
                  <a:pt x="1665" y="273"/>
                </a:cubicBezTo>
                <a:cubicBezTo>
                  <a:pt x="1657" y="264"/>
                  <a:pt x="1651" y="254"/>
                  <a:pt x="1649" y="242"/>
                </a:cubicBezTo>
                <a:cubicBezTo>
                  <a:pt x="1646" y="230"/>
                  <a:pt x="1648" y="217"/>
                  <a:pt x="1653" y="204"/>
                </a:cubicBezTo>
                <a:cubicBezTo>
                  <a:pt x="1659" y="191"/>
                  <a:pt x="1667" y="179"/>
                  <a:pt x="1678" y="167"/>
                </a:cubicBezTo>
                <a:cubicBezTo>
                  <a:pt x="1691" y="155"/>
                  <a:pt x="1704" y="146"/>
                  <a:pt x="1717" y="141"/>
                </a:cubicBezTo>
                <a:cubicBezTo>
                  <a:pt x="1731" y="135"/>
                  <a:pt x="1744" y="134"/>
                  <a:pt x="1757" y="136"/>
                </a:cubicBezTo>
                <a:cubicBezTo>
                  <a:pt x="1770" y="139"/>
                  <a:pt x="1781" y="145"/>
                  <a:pt x="1792" y="154"/>
                </a:cubicBezTo>
                <a:lnTo>
                  <a:pt x="1772" y="177"/>
                </a:lnTo>
                <a:cubicBezTo>
                  <a:pt x="1760" y="168"/>
                  <a:pt x="1748" y="164"/>
                  <a:pt x="1736" y="165"/>
                </a:cubicBezTo>
                <a:cubicBezTo>
                  <a:pt x="1724" y="166"/>
                  <a:pt x="1712" y="173"/>
                  <a:pt x="1699" y="186"/>
                </a:cubicBezTo>
                <a:cubicBezTo>
                  <a:pt x="1685" y="200"/>
                  <a:pt x="1678" y="212"/>
                  <a:pt x="1677" y="223"/>
                </a:cubicBezTo>
                <a:cubicBezTo>
                  <a:pt x="1676" y="234"/>
                  <a:pt x="1678" y="243"/>
                  <a:pt x="1685" y="250"/>
                </a:cubicBezTo>
                <a:cubicBezTo>
                  <a:pt x="1691" y="256"/>
                  <a:pt x="1699" y="259"/>
                  <a:pt x="1707" y="258"/>
                </a:cubicBezTo>
                <a:cubicBezTo>
                  <a:pt x="1715" y="258"/>
                  <a:pt x="1730" y="251"/>
                  <a:pt x="1752" y="237"/>
                </a:cubicBezTo>
                <a:cubicBezTo>
                  <a:pt x="1775" y="223"/>
                  <a:pt x="1790" y="214"/>
                  <a:pt x="1800" y="210"/>
                </a:cubicBezTo>
                <a:cubicBezTo>
                  <a:pt x="1815" y="205"/>
                  <a:pt x="1827" y="204"/>
                  <a:pt x="1839" y="206"/>
                </a:cubicBezTo>
                <a:cubicBezTo>
                  <a:pt x="1851" y="208"/>
                  <a:pt x="1861" y="214"/>
                  <a:pt x="1870" y="223"/>
                </a:cubicBezTo>
                <a:cubicBezTo>
                  <a:pt x="1879" y="232"/>
                  <a:pt x="1885" y="243"/>
                  <a:pt x="1888" y="256"/>
                </a:cubicBezTo>
                <a:cubicBezTo>
                  <a:pt x="1890" y="269"/>
                  <a:pt x="1889" y="282"/>
                  <a:pt x="1884" y="296"/>
                </a:cubicBezTo>
                <a:cubicBezTo>
                  <a:pt x="1879" y="310"/>
                  <a:pt x="1870" y="323"/>
                  <a:pt x="1858" y="335"/>
                </a:cubicBezTo>
                <a:cubicBezTo>
                  <a:pt x="1843" y="350"/>
                  <a:pt x="1828" y="361"/>
                  <a:pt x="1813" y="367"/>
                </a:cubicBezTo>
                <a:cubicBezTo>
                  <a:pt x="1799" y="373"/>
                  <a:pt x="1784" y="374"/>
                  <a:pt x="1769" y="371"/>
                </a:cubicBezTo>
                <a:cubicBezTo>
                  <a:pt x="1754" y="368"/>
                  <a:pt x="1741" y="361"/>
                  <a:pt x="1730" y="350"/>
                </a:cubicBezTo>
                <a:close/>
                <a:moveTo>
                  <a:pt x="2019" y="169"/>
                </a:moveTo>
                <a:lnTo>
                  <a:pt x="1998" y="189"/>
                </a:lnTo>
                <a:lnTo>
                  <a:pt x="1867" y="58"/>
                </a:lnTo>
                <a:cubicBezTo>
                  <a:pt x="1867" y="67"/>
                  <a:pt x="1865" y="79"/>
                  <a:pt x="1862" y="92"/>
                </a:cubicBezTo>
                <a:cubicBezTo>
                  <a:pt x="1858" y="104"/>
                  <a:pt x="1854" y="115"/>
                  <a:pt x="1850" y="124"/>
                </a:cubicBezTo>
                <a:lnTo>
                  <a:pt x="1830" y="104"/>
                </a:lnTo>
                <a:cubicBezTo>
                  <a:pt x="1837" y="87"/>
                  <a:pt x="1840" y="70"/>
                  <a:pt x="1841" y="54"/>
                </a:cubicBezTo>
                <a:cubicBezTo>
                  <a:pt x="1842" y="38"/>
                  <a:pt x="1841" y="24"/>
                  <a:pt x="1837" y="13"/>
                </a:cubicBezTo>
                <a:lnTo>
                  <a:pt x="1850" y="0"/>
                </a:lnTo>
                <a:lnTo>
                  <a:pt x="2019" y="169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101" name="Freeform 83"/>
          <p:cNvSpPr>
            <a:spLocks noEditPoints="1"/>
          </p:cNvSpPr>
          <p:nvPr/>
        </p:nvSpPr>
        <p:spPr bwMode="auto">
          <a:xfrm>
            <a:off x="7540803" y="4611475"/>
            <a:ext cx="781050" cy="769937"/>
          </a:xfrm>
          <a:custGeom>
            <a:avLst/>
            <a:gdLst>
              <a:gd name="T0" fmla="*/ 119 w 2050"/>
              <a:gd name="T1" fmla="*/ 1756 h 2024"/>
              <a:gd name="T2" fmla="*/ 122 w 2050"/>
              <a:gd name="T3" fmla="*/ 1933 h 2024"/>
              <a:gd name="T4" fmla="*/ 168 w 2050"/>
              <a:gd name="T5" fmla="*/ 1831 h 2024"/>
              <a:gd name="T6" fmla="*/ 42 w 2050"/>
              <a:gd name="T7" fmla="*/ 1853 h 2024"/>
              <a:gd name="T8" fmla="*/ 256 w 2050"/>
              <a:gd name="T9" fmla="*/ 1610 h 2024"/>
              <a:gd name="T10" fmla="*/ 370 w 2050"/>
              <a:gd name="T11" fmla="*/ 1674 h 2024"/>
              <a:gd name="T12" fmla="*/ 389 w 2050"/>
              <a:gd name="T13" fmla="*/ 1802 h 2024"/>
              <a:gd name="T14" fmla="*/ 310 w 2050"/>
              <a:gd name="T15" fmla="*/ 1666 h 2024"/>
              <a:gd name="T16" fmla="*/ 199 w 2050"/>
              <a:gd name="T17" fmla="*/ 1696 h 2024"/>
              <a:gd name="T18" fmla="*/ 392 w 2050"/>
              <a:gd name="T19" fmla="*/ 1749 h 2024"/>
              <a:gd name="T20" fmla="*/ 309 w 2050"/>
              <a:gd name="T21" fmla="*/ 1728 h 2024"/>
              <a:gd name="T22" fmla="*/ 372 w 2050"/>
              <a:gd name="T23" fmla="*/ 1484 h 2024"/>
              <a:gd name="T24" fmla="*/ 565 w 2050"/>
              <a:gd name="T25" fmla="*/ 1524 h 2024"/>
              <a:gd name="T26" fmla="*/ 482 w 2050"/>
              <a:gd name="T27" fmla="*/ 1710 h 2024"/>
              <a:gd name="T28" fmla="*/ 541 w 2050"/>
              <a:gd name="T29" fmla="*/ 1545 h 2024"/>
              <a:gd name="T30" fmla="*/ 356 w 2050"/>
              <a:gd name="T31" fmla="*/ 1539 h 2024"/>
              <a:gd name="T32" fmla="*/ 813 w 2050"/>
              <a:gd name="T33" fmla="*/ 1472 h 2024"/>
              <a:gd name="T34" fmla="*/ 707 w 2050"/>
              <a:gd name="T35" fmla="*/ 1152 h 2024"/>
              <a:gd name="T36" fmla="*/ 782 w 2050"/>
              <a:gd name="T37" fmla="*/ 1274 h 2024"/>
              <a:gd name="T38" fmla="*/ 762 w 2050"/>
              <a:gd name="T39" fmla="*/ 1253 h 2024"/>
              <a:gd name="T40" fmla="*/ 702 w 2050"/>
              <a:gd name="T41" fmla="*/ 1194 h 2024"/>
              <a:gd name="T42" fmla="*/ 894 w 2050"/>
              <a:gd name="T43" fmla="*/ 962 h 2024"/>
              <a:gd name="T44" fmla="*/ 979 w 2050"/>
              <a:gd name="T45" fmla="*/ 1059 h 2024"/>
              <a:gd name="T46" fmla="*/ 941 w 2050"/>
              <a:gd name="T47" fmla="*/ 1251 h 2024"/>
              <a:gd name="T48" fmla="*/ 1021 w 2050"/>
              <a:gd name="T49" fmla="*/ 921 h 2024"/>
              <a:gd name="T50" fmla="*/ 1083 w 2050"/>
              <a:gd name="T51" fmla="*/ 931 h 2024"/>
              <a:gd name="T52" fmla="*/ 1092 w 2050"/>
              <a:gd name="T53" fmla="*/ 983 h 2024"/>
              <a:gd name="T54" fmla="*/ 1243 w 2050"/>
              <a:gd name="T55" fmla="*/ 949 h 2024"/>
              <a:gd name="T56" fmla="*/ 1210 w 2050"/>
              <a:gd name="T57" fmla="*/ 737 h 2024"/>
              <a:gd name="T58" fmla="*/ 1127 w 2050"/>
              <a:gd name="T59" fmla="*/ 825 h 2024"/>
              <a:gd name="T60" fmla="*/ 1247 w 2050"/>
              <a:gd name="T61" fmla="*/ 740 h 2024"/>
              <a:gd name="T62" fmla="*/ 1334 w 2050"/>
              <a:gd name="T63" fmla="*/ 818 h 2024"/>
              <a:gd name="T64" fmla="*/ 1273 w 2050"/>
              <a:gd name="T65" fmla="*/ 626 h 2024"/>
              <a:gd name="T66" fmla="*/ 1380 w 2050"/>
              <a:gd name="T67" fmla="*/ 624 h 2024"/>
              <a:gd name="T68" fmla="*/ 1378 w 2050"/>
              <a:gd name="T69" fmla="*/ 782 h 2024"/>
              <a:gd name="T70" fmla="*/ 1359 w 2050"/>
              <a:gd name="T71" fmla="*/ 579 h 2024"/>
              <a:gd name="T72" fmla="*/ 1433 w 2050"/>
              <a:gd name="T73" fmla="*/ 709 h 2024"/>
              <a:gd name="T74" fmla="*/ 1347 w 2050"/>
              <a:gd name="T75" fmla="*/ 736 h 2024"/>
              <a:gd name="T76" fmla="*/ 1435 w 2050"/>
              <a:gd name="T77" fmla="*/ 468 h 2024"/>
              <a:gd name="T78" fmla="*/ 1580 w 2050"/>
              <a:gd name="T79" fmla="*/ 612 h 2024"/>
              <a:gd name="T80" fmla="*/ 1587 w 2050"/>
              <a:gd name="T81" fmla="*/ 288 h 2024"/>
              <a:gd name="T82" fmla="*/ 1590 w 2050"/>
              <a:gd name="T83" fmla="*/ 465 h 2024"/>
              <a:gd name="T84" fmla="*/ 1636 w 2050"/>
              <a:gd name="T85" fmla="*/ 363 h 2024"/>
              <a:gd name="T86" fmla="*/ 1510 w 2050"/>
              <a:gd name="T87" fmla="*/ 385 h 2024"/>
              <a:gd name="T88" fmla="*/ 1807 w 2050"/>
              <a:gd name="T89" fmla="*/ 341 h 2024"/>
              <a:gd name="T90" fmla="*/ 1832 w 2050"/>
              <a:gd name="T91" fmla="*/ 241 h 2024"/>
              <a:gd name="T92" fmla="*/ 1666 w 2050"/>
              <a:gd name="T93" fmla="*/ 277 h 2024"/>
              <a:gd name="T94" fmla="*/ 1757 w 2050"/>
              <a:gd name="T95" fmla="*/ 140 h 2024"/>
              <a:gd name="T96" fmla="*/ 1677 w 2050"/>
              <a:gd name="T97" fmla="*/ 227 h 2024"/>
              <a:gd name="T98" fmla="*/ 1839 w 2050"/>
              <a:gd name="T99" fmla="*/ 210 h 2024"/>
              <a:gd name="T100" fmla="*/ 1813 w 2050"/>
              <a:gd name="T101" fmla="*/ 371 h 2024"/>
              <a:gd name="T102" fmla="*/ 1939 w 2050"/>
              <a:gd name="T103" fmla="*/ 253 h 2024"/>
              <a:gd name="T104" fmla="*/ 1906 w 2050"/>
              <a:gd name="T105" fmla="*/ 41 h 2024"/>
              <a:gd name="T106" fmla="*/ 1823 w 2050"/>
              <a:gd name="T107" fmla="*/ 129 h 2024"/>
              <a:gd name="T108" fmla="*/ 1943 w 2050"/>
              <a:gd name="T109" fmla="*/ 44 h 2024"/>
              <a:gd name="T110" fmla="*/ 2030 w 2050"/>
              <a:gd name="T111" fmla="*/ 122 h 202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</a:cxnLst>
            <a:rect l="0" t="0" r="r" b="b"/>
            <a:pathLst>
              <a:path w="2050" h="2024">
                <a:moveTo>
                  <a:pt x="168" y="2024"/>
                </a:moveTo>
                <a:lnTo>
                  <a:pt x="0" y="1856"/>
                </a:lnTo>
                <a:lnTo>
                  <a:pt x="63" y="1792"/>
                </a:lnTo>
                <a:cubicBezTo>
                  <a:pt x="74" y="1781"/>
                  <a:pt x="83" y="1773"/>
                  <a:pt x="90" y="1768"/>
                </a:cubicBezTo>
                <a:cubicBezTo>
                  <a:pt x="100" y="1762"/>
                  <a:pt x="110" y="1757"/>
                  <a:pt x="119" y="1756"/>
                </a:cubicBezTo>
                <a:cubicBezTo>
                  <a:pt x="128" y="1754"/>
                  <a:pt x="138" y="1755"/>
                  <a:pt x="149" y="1758"/>
                </a:cubicBezTo>
                <a:cubicBezTo>
                  <a:pt x="159" y="1762"/>
                  <a:pt x="168" y="1768"/>
                  <a:pt x="177" y="1776"/>
                </a:cubicBezTo>
                <a:cubicBezTo>
                  <a:pt x="191" y="1790"/>
                  <a:pt x="199" y="1807"/>
                  <a:pt x="199" y="1826"/>
                </a:cubicBezTo>
                <a:cubicBezTo>
                  <a:pt x="200" y="1845"/>
                  <a:pt x="189" y="1866"/>
                  <a:pt x="165" y="1890"/>
                </a:cubicBezTo>
                <a:lnTo>
                  <a:pt x="122" y="1933"/>
                </a:lnTo>
                <a:lnTo>
                  <a:pt x="190" y="2002"/>
                </a:lnTo>
                <a:lnTo>
                  <a:pt x="168" y="2024"/>
                </a:lnTo>
                <a:close/>
                <a:moveTo>
                  <a:pt x="102" y="1913"/>
                </a:moveTo>
                <a:lnTo>
                  <a:pt x="145" y="1870"/>
                </a:lnTo>
                <a:cubicBezTo>
                  <a:pt x="160" y="1856"/>
                  <a:pt x="167" y="1843"/>
                  <a:pt x="168" y="1831"/>
                </a:cubicBezTo>
                <a:cubicBezTo>
                  <a:pt x="169" y="1820"/>
                  <a:pt x="164" y="1809"/>
                  <a:pt x="154" y="1800"/>
                </a:cubicBezTo>
                <a:cubicBezTo>
                  <a:pt x="147" y="1793"/>
                  <a:pt x="140" y="1789"/>
                  <a:pt x="131" y="1787"/>
                </a:cubicBezTo>
                <a:cubicBezTo>
                  <a:pt x="123" y="1786"/>
                  <a:pt x="115" y="1787"/>
                  <a:pt x="107" y="1791"/>
                </a:cubicBezTo>
                <a:cubicBezTo>
                  <a:pt x="102" y="1794"/>
                  <a:pt x="95" y="1800"/>
                  <a:pt x="85" y="1810"/>
                </a:cubicBezTo>
                <a:lnTo>
                  <a:pt x="42" y="1853"/>
                </a:lnTo>
                <a:lnTo>
                  <a:pt x="102" y="1913"/>
                </a:lnTo>
                <a:close/>
                <a:moveTo>
                  <a:pt x="325" y="1866"/>
                </a:moveTo>
                <a:lnTo>
                  <a:pt x="157" y="1698"/>
                </a:lnTo>
                <a:lnTo>
                  <a:pt x="220" y="1635"/>
                </a:lnTo>
                <a:cubicBezTo>
                  <a:pt x="233" y="1622"/>
                  <a:pt x="245" y="1614"/>
                  <a:pt x="256" y="1610"/>
                </a:cubicBezTo>
                <a:cubicBezTo>
                  <a:pt x="268" y="1605"/>
                  <a:pt x="279" y="1604"/>
                  <a:pt x="290" y="1607"/>
                </a:cubicBezTo>
                <a:cubicBezTo>
                  <a:pt x="302" y="1610"/>
                  <a:pt x="311" y="1615"/>
                  <a:pt x="319" y="1623"/>
                </a:cubicBezTo>
                <a:cubicBezTo>
                  <a:pt x="326" y="1630"/>
                  <a:pt x="331" y="1638"/>
                  <a:pt x="334" y="1649"/>
                </a:cubicBezTo>
                <a:cubicBezTo>
                  <a:pt x="336" y="1659"/>
                  <a:pt x="335" y="1670"/>
                  <a:pt x="331" y="1682"/>
                </a:cubicBezTo>
                <a:cubicBezTo>
                  <a:pt x="344" y="1675"/>
                  <a:pt x="357" y="1672"/>
                  <a:pt x="370" y="1674"/>
                </a:cubicBezTo>
                <a:cubicBezTo>
                  <a:pt x="383" y="1675"/>
                  <a:pt x="394" y="1681"/>
                  <a:pt x="404" y="1691"/>
                </a:cubicBezTo>
                <a:cubicBezTo>
                  <a:pt x="411" y="1699"/>
                  <a:pt x="417" y="1708"/>
                  <a:pt x="421" y="1718"/>
                </a:cubicBezTo>
                <a:cubicBezTo>
                  <a:pt x="424" y="1728"/>
                  <a:pt x="425" y="1737"/>
                  <a:pt x="424" y="1746"/>
                </a:cubicBezTo>
                <a:cubicBezTo>
                  <a:pt x="423" y="1754"/>
                  <a:pt x="419" y="1763"/>
                  <a:pt x="414" y="1772"/>
                </a:cubicBezTo>
                <a:cubicBezTo>
                  <a:pt x="408" y="1782"/>
                  <a:pt x="400" y="1792"/>
                  <a:pt x="389" y="1802"/>
                </a:cubicBezTo>
                <a:lnTo>
                  <a:pt x="325" y="1866"/>
                </a:lnTo>
                <a:close/>
                <a:moveTo>
                  <a:pt x="250" y="1747"/>
                </a:moveTo>
                <a:lnTo>
                  <a:pt x="287" y="1710"/>
                </a:lnTo>
                <a:cubicBezTo>
                  <a:pt x="296" y="1701"/>
                  <a:pt x="303" y="1693"/>
                  <a:pt x="306" y="1687"/>
                </a:cubicBezTo>
                <a:cubicBezTo>
                  <a:pt x="310" y="1680"/>
                  <a:pt x="311" y="1673"/>
                  <a:pt x="310" y="1666"/>
                </a:cubicBezTo>
                <a:cubicBezTo>
                  <a:pt x="309" y="1659"/>
                  <a:pt x="306" y="1653"/>
                  <a:pt x="300" y="1647"/>
                </a:cubicBezTo>
                <a:cubicBezTo>
                  <a:pt x="294" y="1642"/>
                  <a:pt x="288" y="1638"/>
                  <a:pt x="281" y="1636"/>
                </a:cubicBezTo>
                <a:cubicBezTo>
                  <a:pt x="274" y="1635"/>
                  <a:pt x="267" y="1636"/>
                  <a:pt x="261" y="1639"/>
                </a:cubicBezTo>
                <a:cubicBezTo>
                  <a:pt x="254" y="1643"/>
                  <a:pt x="245" y="1650"/>
                  <a:pt x="233" y="1662"/>
                </a:cubicBezTo>
                <a:lnTo>
                  <a:pt x="199" y="1696"/>
                </a:lnTo>
                <a:lnTo>
                  <a:pt x="250" y="1747"/>
                </a:lnTo>
                <a:close/>
                <a:moveTo>
                  <a:pt x="328" y="1824"/>
                </a:moveTo>
                <a:lnTo>
                  <a:pt x="370" y="1782"/>
                </a:lnTo>
                <a:cubicBezTo>
                  <a:pt x="377" y="1775"/>
                  <a:pt x="382" y="1770"/>
                  <a:pt x="384" y="1767"/>
                </a:cubicBezTo>
                <a:cubicBezTo>
                  <a:pt x="388" y="1761"/>
                  <a:pt x="391" y="1755"/>
                  <a:pt x="392" y="1749"/>
                </a:cubicBezTo>
                <a:cubicBezTo>
                  <a:pt x="394" y="1744"/>
                  <a:pt x="393" y="1738"/>
                  <a:pt x="391" y="1731"/>
                </a:cubicBezTo>
                <a:cubicBezTo>
                  <a:pt x="389" y="1725"/>
                  <a:pt x="386" y="1719"/>
                  <a:pt x="381" y="1714"/>
                </a:cubicBezTo>
                <a:cubicBezTo>
                  <a:pt x="374" y="1708"/>
                  <a:pt x="367" y="1704"/>
                  <a:pt x="359" y="1702"/>
                </a:cubicBezTo>
                <a:cubicBezTo>
                  <a:pt x="352" y="1701"/>
                  <a:pt x="344" y="1702"/>
                  <a:pt x="336" y="1706"/>
                </a:cubicBezTo>
                <a:cubicBezTo>
                  <a:pt x="329" y="1710"/>
                  <a:pt x="320" y="1717"/>
                  <a:pt x="309" y="1728"/>
                </a:cubicBezTo>
                <a:lnTo>
                  <a:pt x="270" y="1767"/>
                </a:lnTo>
                <a:lnTo>
                  <a:pt x="328" y="1824"/>
                </a:lnTo>
                <a:close/>
                <a:moveTo>
                  <a:pt x="482" y="1710"/>
                </a:moveTo>
                <a:lnTo>
                  <a:pt x="314" y="1542"/>
                </a:lnTo>
                <a:lnTo>
                  <a:pt x="372" y="1484"/>
                </a:lnTo>
                <a:cubicBezTo>
                  <a:pt x="385" y="1471"/>
                  <a:pt x="396" y="1462"/>
                  <a:pt x="404" y="1456"/>
                </a:cubicBezTo>
                <a:cubicBezTo>
                  <a:pt x="416" y="1449"/>
                  <a:pt x="428" y="1445"/>
                  <a:pt x="441" y="1444"/>
                </a:cubicBezTo>
                <a:cubicBezTo>
                  <a:pt x="457" y="1442"/>
                  <a:pt x="473" y="1445"/>
                  <a:pt x="489" y="1453"/>
                </a:cubicBezTo>
                <a:cubicBezTo>
                  <a:pt x="505" y="1460"/>
                  <a:pt x="521" y="1471"/>
                  <a:pt x="536" y="1486"/>
                </a:cubicBezTo>
                <a:cubicBezTo>
                  <a:pt x="549" y="1499"/>
                  <a:pt x="558" y="1512"/>
                  <a:pt x="565" y="1524"/>
                </a:cubicBezTo>
                <a:cubicBezTo>
                  <a:pt x="572" y="1537"/>
                  <a:pt x="577" y="1549"/>
                  <a:pt x="578" y="1560"/>
                </a:cubicBezTo>
                <a:cubicBezTo>
                  <a:pt x="580" y="1572"/>
                  <a:pt x="580" y="1582"/>
                  <a:pt x="578" y="1591"/>
                </a:cubicBezTo>
                <a:cubicBezTo>
                  <a:pt x="576" y="1600"/>
                  <a:pt x="573" y="1610"/>
                  <a:pt x="567" y="1619"/>
                </a:cubicBezTo>
                <a:cubicBezTo>
                  <a:pt x="561" y="1629"/>
                  <a:pt x="553" y="1639"/>
                  <a:pt x="542" y="1649"/>
                </a:cubicBezTo>
                <a:lnTo>
                  <a:pt x="482" y="1710"/>
                </a:lnTo>
                <a:close/>
                <a:moveTo>
                  <a:pt x="484" y="1668"/>
                </a:moveTo>
                <a:lnTo>
                  <a:pt x="520" y="1632"/>
                </a:lnTo>
                <a:cubicBezTo>
                  <a:pt x="531" y="1621"/>
                  <a:pt x="539" y="1611"/>
                  <a:pt x="543" y="1603"/>
                </a:cubicBezTo>
                <a:cubicBezTo>
                  <a:pt x="547" y="1594"/>
                  <a:pt x="549" y="1587"/>
                  <a:pt x="549" y="1579"/>
                </a:cubicBezTo>
                <a:cubicBezTo>
                  <a:pt x="549" y="1568"/>
                  <a:pt x="547" y="1557"/>
                  <a:pt x="541" y="1545"/>
                </a:cubicBezTo>
                <a:cubicBezTo>
                  <a:pt x="535" y="1534"/>
                  <a:pt x="525" y="1521"/>
                  <a:pt x="513" y="1509"/>
                </a:cubicBezTo>
                <a:cubicBezTo>
                  <a:pt x="495" y="1491"/>
                  <a:pt x="479" y="1480"/>
                  <a:pt x="463" y="1477"/>
                </a:cubicBezTo>
                <a:cubicBezTo>
                  <a:pt x="448" y="1473"/>
                  <a:pt x="435" y="1474"/>
                  <a:pt x="423" y="1479"/>
                </a:cubicBezTo>
                <a:cubicBezTo>
                  <a:pt x="415" y="1482"/>
                  <a:pt x="404" y="1491"/>
                  <a:pt x="391" y="1504"/>
                </a:cubicBezTo>
                <a:lnTo>
                  <a:pt x="356" y="1539"/>
                </a:lnTo>
                <a:lnTo>
                  <a:pt x="484" y="1668"/>
                </a:lnTo>
                <a:close/>
                <a:moveTo>
                  <a:pt x="677" y="1609"/>
                </a:moveTo>
                <a:lnTo>
                  <a:pt x="662" y="1594"/>
                </a:lnTo>
                <a:lnTo>
                  <a:pt x="798" y="1457"/>
                </a:lnTo>
                <a:lnTo>
                  <a:pt x="813" y="1472"/>
                </a:lnTo>
                <a:lnTo>
                  <a:pt x="677" y="1609"/>
                </a:lnTo>
                <a:close/>
                <a:moveTo>
                  <a:pt x="784" y="1407"/>
                </a:moveTo>
                <a:lnTo>
                  <a:pt x="616" y="1239"/>
                </a:lnTo>
                <a:lnTo>
                  <a:pt x="680" y="1176"/>
                </a:lnTo>
                <a:cubicBezTo>
                  <a:pt x="691" y="1165"/>
                  <a:pt x="700" y="1157"/>
                  <a:pt x="707" y="1152"/>
                </a:cubicBezTo>
                <a:cubicBezTo>
                  <a:pt x="717" y="1145"/>
                  <a:pt x="726" y="1141"/>
                  <a:pt x="736" y="1139"/>
                </a:cubicBezTo>
                <a:cubicBezTo>
                  <a:pt x="745" y="1137"/>
                  <a:pt x="755" y="1138"/>
                  <a:pt x="765" y="1142"/>
                </a:cubicBezTo>
                <a:cubicBezTo>
                  <a:pt x="776" y="1145"/>
                  <a:pt x="785" y="1151"/>
                  <a:pt x="793" y="1160"/>
                </a:cubicBezTo>
                <a:cubicBezTo>
                  <a:pt x="808" y="1174"/>
                  <a:pt x="815" y="1190"/>
                  <a:pt x="816" y="1209"/>
                </a:cubicBezTo>
                <a:cubicBezTo>
                  <a:pt x="817" y="1228"/>
                  <a:pt x="805" y="1250"/>
                  <a:pt x="782" y="1274"/>
                </a:cubicBezTo>
                <a:lnTo>
                  <a:pt x="738" y="1317"/>
                </a:lnTo>
                <a:lnTo>
                  <a:pt x="807" y="1385"/>
                </a:lnTo>
                <a:lnTo>
                  <a:pt x="784" y="1407"/>
                </a:lnTo>
                <a:close/>
                <a:moveTo>
                  <a:pt x="719" y="1297"/>
                </a:moveTo>
                <a:lnTo>
                  <a:pt x="762" y="1253"/>
                </a:lnTo>
                <a:cubicBezTo>
                  <a:pt x="776" y="1239"/>
                  <a:pt x="784" y="1226"/>
                  <a:pt x="785" y="1215"/>
                </a:cubicBezTo>
                <a:cubicBezTo>
                  <a:pt x="785" y="1203"/>
                  <a:pt x="781" y="1193"/>
                  <a:pt x="771" y="1183"/>
                </a:cubicBezTo>
                <a:cubicBezTo>
                  <a:pt x="764" y="1176"/>
                  <a:pt x="756" y="1172"/>
                  <a:pt x="748" y="1170"/>
                </a:cubicBezTo>
                <a:cubicBezTo>
                  <a:pt x="739" y="1169"/>
                  <a:pt x="731" y="1170"/>
                  <a:pt x="724" y="1175"/>
                </a:cubicBezTo>
                <a:cubicBezTo>
                  <a:pt x="719" y="1177"/>
                  <a:pt x="712" y="1184"/>
                  <a:pt x="702" y="1194"/>
                </a:cubicBezTo>
                <a:lnTo>
                  <a:pt x="659" y="1237"/>
                </a:lnTo>
                <a:lnTo>
                  <a:pt x="719" y="1297"/>
                </a:lnTo>
                <a:close/>
                <a:moveTo>
                  <a:pt x="941" y="1251"/>
                </a:moveTo>
                <a:lnTo>
                  <a:pt x="772" y="1083"/>
                </a:lnTo>
                <a:lnTo>
                  <a:pt x="894" y="962"/>
                </a:lnTo>
                <a:lnTo>
                  <a:pt x="914" y="982"/>
                </a:lnTo>
                <a:lnTo>
                  <a:pt x="815" y="1081"/>
                </a:lnTo>
                <a:lnTo>
                  <a:pt x="866" y="1132"/>
                </a:lnTo>
                <a:lnTo>
                  <a:pt x="959" y="1039"/>
                </a:lnTo>
                <a:lnTo>
                  <a:pt x="979" y="1059"/>
                </a:lnTo>
                <a:lnTo>
                  <a:pt x="886" y="1152"/>
                </a:lnTo>
                <a:lnTo>
                  <a:pt x="943" y="1209"/>
                </a:lnTo>
                <a:lnTo>
                  <a:pt x="1046" y="1106"/>
                </a:lnTo>
                <a:lnTo>
                  <a:pt x="1066" y="1126"/>
                </a:lnTo>
                <a:lnTo>
                  <a:pt x="941" y="1251"/>
                </a:lnTo>
                <a:close/>
                <a:moveTo>
                  <a:pt x="1081" y="1110"/>
                </a:moveTo>
                <a:lnTo>
                  <a:pt x="1059" y="958"/>
                </a:lnTo>
                <a:lnTo>
                  <a:pt x="921" y="935"/>
                </a:lnTo>
                <a:lnTo>
                  <a:pt x="947" y="908"/>
                </a:lnTo>
                <a:lnTo>
                  <a:pt x="1021" y="921"/>
                </a:lnTo>
                <a:cubicBezTo>
                  <a:pt x="1036" y="923"/>
                  <a:pt x="1048" y="926"/>
                  <a:pt x="1055" y="928"/>
                </a:cubicBezTo>
                <a:cubicBezTo>
                  <a:pt x="1053" y="918"/>
                  <a:pt x="1051" y="907"/>
                  <a:pt x="1049" y="895"/>
                </a:cubicBezTo>
                <a:lnTo>
                  <a:pt x="1039" y="817"/>
                </a:lnTo>
                <a:lnTo>
                  <a:pt x="1063" y="793"/>
                </a:lnTo>
                <a:lnTo>
                  <a:pt x="1083" y="931"/>
                </a:lnTo>
                <a:lnTo>
                  <a:pt x="1235" y="956"/>
                </a:lnTo>
                <a:lnTo>
                  <a:pt x="1208" y="984"/>
                </a:lnTo>
                <a:lnTo>
                  <a:pt x="1106" y="966"/>
                </a:lnTo>
                <a:cubicBezTo>
                  <a:pt x="1100" y="965"/>
                  <a:pt x="1094" y="964"/>
                  <a:pt x="1087" y="962"/>
                </a:cubicBezTo>
                <a:cubicBezTo>
                  <a:pt x="1089" y="972"/>
                  <a:pt x="1091" y="979"/>
                  <a:pt x="1092" y="983"/>
                </a:cubicBezTo>
                <a:lnTo>
                  <a:pt x="1108" y="1084"/>
                </a:lnTo>
                <a:lnTo>
                  <a:pt x="1081" y="1110"/>
                </a:lnTo>
                <a:close/>
                <a:moveTo>
                  <a:pt x="1334" y="818"/>
                </a:moveTo>
                <a:lnTo>
                  <a:pt x="1354" y="838"/>
                </a:lnTo>
                <a:lnTo>
                  <a:pt x="1243" y="949"/>
                </a:lnTo>
                <a:cubicBezTo>
                  <a:pt x="1238" y="944"/>
                  <a:pt x="1234" y="938"/>
                  <a:pt x="1231" y="932"/>
                </a:cubicBezTo>
                <a:cubicBezTo>
                  <a:pt x="1226" y="922"/>
                  <a:pt x="1223" y="910"/>
                  <a:pt x="1222" y="896"/>
                </a:cubicBezTo>
                <a:cubicBezTo>
                  <a:pt x="1221" y="883"/>
                  <a:pt x="1222" y="865"/>
                  <a:pt x="1224" y="844"/>
                </a:cubicBezTo>
                <a:cubicBezTo>
                  <a:pt x="1227" y="810"/>
                  <a:pt x="1228" y="786"/>
                  <a:pt x="1225" y="771"/>
                </a:cubicBezTo>
                <a:cubicBezTo>
                  <a:pt x="1223" y="756"/>
                  <a:pt x="1218" y="744"/>
                  <a:pt x="1210" y="737"/>
                </a:cubicBezTo>
                <a:cubicBezTo>
                  <a:pt x="1202" y="728"/>
                  <a:pt x="1192" y="724"/>
                  <a:pt x="1181" y="725"/>
                </a:cubicBezTo>
                <a:cubicBezTo>
                  <a:pt x="1169" y="725"/>
                  <a:pt x="1159" y="730"/>
                  <a:pt x="1149" y="739"/>
                </a:cubicBezTo>
                <a:cubicBezTo>
                  <a:pt x="1139" y="749"/>
                  <a:pt x="1134" y="760"/>
                  <a:pt x="1134" y="772"/>
                </a:cubicBezTo>
                <a:cubicBezTo>
                  <a:pt x="1134" y="784"/>
                  <a:pt x="1140" y="795"/>
                  <a:pt x="1150" y="806"/>
                </a:cubicBezTo>
                <a:lnTo>
                  <a:pt x="1127" y="825"/>
                </a:lnTo>
                <a:cubicBezTo>
                  <a:pt x="1112" y="807"/>
                  <a:pt x="1106" y="790"/>
                  <a:pt x="1107" y="772"/>
                </a:cubicBezTo>
                <a:cubicBezTo>
                  <a:pt x="1108" y="754"/>
                  <a:pt x="1117" y="738"/>
                  <a:pt x="1133" y="722"/>
                </a:cubicBezTo>
                <a:cubicBezTo>
                  <a:pt x="1149" y="705"/>
                  <a:pt x="1166" y="697"/>
                  <a:pt x="1184" y="697"/>
                </a:cubicBezTo>
                <a:cubicBezTo>
                  <a:pt x="1203" y="696"/>
                  <a:pt x="1219" y="703"/>
                  <a:pt x="1232" y="716"/>
                </a:cubicBezTo>
                <a:cubicBezTo>
                  <a:pt x="1239" y="723"/>
                  <a:pt x="1244" y="731"/>
                  <a:pt x="1247" y="740"/>
                </a:cubicBezTo>
                <a:cubicBezTo>
                  <a:pt x="1251" y="749"/>
                  <a:pt x="1253" y="760"/>
                  <a:pt x="1254" y="774"/>
                </a:cubicBezTo>
                <a:cubicBezTo>
                  <a:pt x="1255" y="788"/>
                  <a:pt x="1254" y="808"/>
                  <a:pt x="1252" y="835"/>
                </a:cubicBezTo>
                <a:cubicBezTo>
                  <a:pt x="1250" y="858"/>
                  <a:pt x="1249" y="873"/>
                  <a:pt x="1249" y="880"/>
                </a:cubicBezTo>
                <a:cubicBezTo>
                  <a:pt x="1250" y="888"/>
                  <a:pt x="1250" y="894"/>
                  <a:pt x="1252" y="900"/>
                </a:cubicBezTo>
                <a:lnTo>
                  <a:pt x="1334" y="818"/>
                </a:lnTo>
                <a:close/>
                <a:moveTo>
                  <a:pt x="1359" y="579"/>
                </a:moveTo>
                <a:lnTo>
                  <a:pt x="1340" y="601"/>
                </a:lnTo>
                <a:cubicBezTo>
                  <a:pt x="1330" y="595"/>
                  <a:pt x="1321" y="592"/>
                  <a:pt x="1314" y="591"/>
                </a:cubicBezTo>
                <a:cubicBezTo>
                  <a:pt x="1303" y="591"/>
                  <a:pt x="1293" y="595"/>
                  <a:pt x="1285" y="603"/>
                </a:cubicBezTo>
                <a:cubicBezTo>
                  <a:pt x="1278" y="610"/>
                  <a:pt x="1274" y="617"/>
                  <a:pt x="1273" y="626"/>
                </a:cubicBezTo>
                <a:cubicBezTo>
                  <a:pt x="1271" y="637"/>
                  <a:pt x="1273" y="649"/>
                  <a:pt x="1279" y="662"/>
                </a:cubicBezTo>
                <a:cubicBezTo>
                  <a:pt x="1284" y="675"/>
                  <a:pt x="1295" y="690"/>
                  <a:pt x="1312" y="707"/>
                </a:cubicBezTo>
                <a:cubicBezTo>
                  <a:pt x="1309" y="694"/>
                  <a:pt x="1309" y="683"/>
                  <a:pt x="1313" y="672"/>
                </a:cubicBezTo>
                <a:cubicBezTo>
                  <a:pt x="1316" y="661"/>
                  <a:pt x="1322" y="652"/>
                  <a:pt x="1330" y="644"/>
                </a:cubicBezTo>
                <a:cubicBezTo>
                  <a:pt x="1344" y="630"/>
                  <a:pt x="1361" y="623"/>
                  <a:pt x="1380" y="624"/>
                </a:cubicBezTo>
                <a:cubicBezTo>
                  <a:pt x="1400" y="624"/>
                  <a:pt x="1418" y="633"/>
                  <a:pt x="1434" y="649"/>
                </a:cubicBezTo>
                <a:cubicBezTo>
                  <a:pt x="1445" y="659"/>
                  <a:pt x="1452" y="671"/>
                  <a:pt x="1457" y="685"/>
                </a:cubicBezTo>
                <a:cubicBezTo>
                  <a:pt x="1461" y="698"/>
                  <a:pt x="1462" y="712"/>
                  <a:pt x="1459" y="724"/>
                </a:cubicBezTo>
                <a:cubicBezTo>
                  <a:pt x="1456" y="737"/>
                  <a:pt x="1449" y="749"/>
                  <a:pt x="1439" y="759"/>
                </a:cubicBezTo>
                <a:cubicBezTo>
                  <a:pt x="1422" y="776"/>
                  <a:pt x="1401" y="784"/>
                  <a:pt x="1378" y="782"/>
                </a:cubicBezTo>
                <a:cubicBezTo>
                  <a:pt x="1354" y="780"/>
                  <a:pt x="1328" y="765"/>
                  <a:pt x="1299" y="735"/>
                </a:cubicBezTo>
                <a:cubicBezTo>
                  <a:pt x="1267" y="703"/>
                  <a:pt x="1249" y="673"/>
                  <a:pt x="1246" y="647"/>
                </a:cubicBezTo>
                <a:cubicBezTo>
                  <a:pt x="1244" y="623"/>
                  <a:pt x="1251" y="603"/>
                  <a:pt x="1269" y="585"/>
                </a:cubicBezTo>
                <a:cubicBezTo>
                  <a:pt x="1282" y="572"/>
                  <a:pt x="1297" y="565"/>
                  <a:pt x="1313" y="564"/>
                </a:cubicBezTo>
                <a:cubicBezTo>
                  <a:pt x="1329" y="563"/>
                  <a:pt x="1344" y="568"/>
                  <a:pt x="1359" y="579"/>
                </a:cubicBezTo>
                <a:close/>
                <a:moveTo>
                  <a:pt x="1347" y="736"/>
                </a:moveTo>
                <a:cubicBezTo>
                  <a:pt x="1354" y="743"/>
                  <a:pt x="1362" y="748"/>
                  <a:pt x="1372" y="752"/>
                </a:cubicBezTo>
                <a:cubicBezTo>
                  <a:pt x="1381" y="755"/>
                  <a:pt x="1391" y="756"/>
                  <a:pt x="1399" y="754"/>
                </a:cubicBezTo>
                <a:cubicBezTo>
                  <a:pt x="1408" y="752"/>
                  <a:pt x="1416" y="748"/>
                  <a:pt x="1422" y="742"/>
                </a:cubicBezTo>
                <a:cubicBezTo>
                  <a:pt x="1430" y="733"/>
                  <a:pt x="1434" y="722"/>
                  <a:pt x="1433" y="709"/>
                </a:cubicBezTo>
                <a:cubicBezTo>
                  <a:pt x="1433" y="696"/>
                  <a:pt x="1426" y="683"/>
                  <a:pt x="1414" y="671"/>
                </a:cubicBezTo>
                <a:cubicBezTo>
                  <a:pt x="1403" y="659"/>
                  <a:pt x="1390" y="653"/>
                  <a:pt x="1377" y="653"/>
                </a:cubicBezTo>
                <a:cubicBezTo>
                  <a:pt x="1365" y="652"/>
                  <a:pt x="1353" y="657"/>
                  <a:pt x="1344" y="666"/>
                </a:cubicBezTo>
                <a:cubicBezTo>
                  <a:pt x="1335" y="675"/>
                  <a:pt x="1330" y="687"/>
                  <a:pt x="1330" y="700"/>
                </a:cubicBezTo>
                <a:cubicBezTo>
                  <a:pt x="1331" y="713"/>
                  <a:pt x="1336" y="725"/>
                  <a:pt x="1347" y="736"/>
                </a:cubicBezTo>
                <a:close/>
                <a:moveTo>
                  <a:pt x="1435" y="468"/>
                </a:moveTo>
                <a:lnTo>
                  <a:pt x="1412" y="444"/>
                </a:lnTo>
                <a:lnTo>
                  <a:pt x="1432" y="424"/>
                </a:lnTo>
                <a:lnTo>
                  <a:pt x="1456" y="447"/>
                </a:lnTo>
                <a:lnTo>
                  <a:pt x="1435" y="468"/>
                </a:lnTo>
                <a:close/>
                <a:moveTo>
                  <a:pt x="1580" y="612"/>
                </a:moveTo>
                <a:lnTo>
                  <a:pt x="1458" y="490"/>
                </a:lnTo>
                <a:lnTo>
                  <a:pt x="1478" y="470"/>
                </a:lnTo>
                <a:lnTo>
                  <a:pt x="1600" y="592"/>
                </a:lnTo>
                <a:lnTo>
                  <a:pt x="1580" y="612"/>
                </a:lnTo>
                <a:close/>
                <a:moveTo>
                  <a:pt x="1636" y="556"/>
                </a:moveTo>
                <a:lnTo>
                  <a:pt x="1468" y="388"/>
                </a:lnTo>
                <a:lnTo>
                  <a:pt x="1531" y="324"/>
                </a:lnTo>
                <a:cubicBezTo>
                  <a:pt x="1542" y="313"/>
                  <a:pt x="1551" y="305"/>
                  <a:pt x="1558" y="301"/>
                </a:cubicBezTo>
                <a:cubicBezTo>
                  <a:pt x="1568" y="294"/>
                  <a:pt x="1578" y="289"/>
                  <a:pt x="1587" y="288"/>
                </a:cubicBezTo>
                <a:cubicBezTo>
                  <a:pt x="1596" y="286"/>
                  <a:pt x="1606" y="287"/>
                  <a:pt x="1617" y="290"/>
                </a:cubicBezTo>
                <a:cubicBezTo>
                  <a:pt x="1627" y="294"/>
                  <a:pt x="1636" y="300"/>
                  <a:pt x="1645" y="308"/>
                </a:cubicBezTo>
                <a:cubicBezTo>
                  <a:pt x="1659" y="322"/>
                  <a:pt x="1667" y="339"/>
                  <a:pt x="1667" y="358"/>
                </a:cubicBezTo>
                <a:cubicBezTo>
                  <a:pt x="1668" y="377"/>
                  <a:pt x="1657" y="398"/>
                  <a:pt x="1633" y="422"/>
                </a:cubicBezTo>
                <a:lnTo>
                  <a:pt x="1590" y="465"/>
                </a:lnTo>
                <a:lnTo>
                  <a:pt x="1658" y="534"/>
                </a:lnTo>
                <a:lnTo>
                  <a:pt x="1636" y="556"/>
                </a:lnTo>
                <a:close/>
                <a:moveTo>
                  <a:pt x="1570" y="446"/>
                </a:moveTo>
                <a:lnTo>
                  <a:pt x="1613" y="402"/>
                </a:lnTo>
                <a:cubicBezTo>
                  <a:pt x="1628" y="388"/>
                  <a:pt x="1635" y="375"/>
                  <a:pt x="1636" y="363"/>
                </a:cubicBezTo>
                <a:cubicBezTo>
                  <a:pt x="1637" y="352"/>
                  <a:pt x="1632" y="342"/>
                  <a:pt x="1622" y="332"/>
                </a:cubicBezTo>
                <a:cubicBezTo>
                  <a:pt x="1615" y="325"/>
                  <a:pt x="1608" y="321"/>
                  <a:pt x="1599" y="319"/>
                </a:cubicBezTo>
                <a:cubicBezTo>
                  <a:pt x="1590" y="318"/>
                  <a:pt x="1583" y="319"/>
                  <a:pt x="1575" y="323"/>
                </a:cubicBezTo>
                <a:cubicBezTo>
                  <a:pt x="1570" y="326"/>
                  <a:pt x="1563" y="332"/>
                  <a:pt x="1553" y="342"/>
                </a:cubicBezTo>
                <a:lnTo>
                  <a:pt x="1510" y="385"/>
                </a:lnTo>
                <a:lnTo>
                  <a:pt x="1570" y="446"/>
                </a:lnTo>
                <a:close/>
                <a:moveTo>
                  <a:pt x="1730" y="354"/>
                </a:moveTo>
                <a:lnTo>
                  <a:pt x="1749" y="331"/>
                </a:lnTo>
                <a:cubicBezTo>
                  <a:pt x="1758" y="339"/>
                  <a:pt x="1768" y="343"/>
                  <a:pt x="1777" y="345"/>
                </a:cubicBezTo>
                <a:cubicBezTo>
                  <a:pt x="1786" y="347"/>
                  <a:pt x="1796" y="345"/>
                  <a:pt x="1807" y="341"/>
                </a:cubicBezTo>
                <a:cubicBezTo>
                  <a:pt x="1818" y="337"/>
                  <a:pt x="1828" y="330"/>
                  <a:pt x="1837" y="320"/>
                </a:cubicBezTo>
                <a:cubicBezTo>
                  <a:pt x="1846" y="312"/>
                  <a:pt x="1852" y="303"/>
                  <a:pt x="1856" y="294"/>
                </a:cubicBezTo>
                <a:cubicBezTo>
                  <a:pt x="1860" y="285"/>
                  <a:pt x="1861" y="277"/>
                  <a:pt x="1860" y="269"/>
                </a:cubicBezTo>
                <a:cubicBezTo>
                  <a:pt x="1859" y="262"/>
                  <a:pt x="1856" y="255"/>
                  <a:pt x="1851" y="250"/>
                </a:cubicBezTo>
                <a:cubicBezTo>
                  <a:pt x="1845" y="245"/>
                  <a:pt x="1839" y="242"/>
                  <a:pt x="1832" y="241"/>
                </a:cubicBezTo>
                <a:cubicBezTo>
                  <a:pt x="1825" y="240"/>
                  <a:pt x="1817" y="242"/>
                  <a:pt x="1807" y="246"/>
                </a:cubicBezTo>
                <a:cubicBezTo>
                  <a:pt x="1801" y="249"/>
                  <a:pt x="1788" y="256"/>
                  <a:pt x="1769" y="268"/>
                </a:cubicBezTo>
                <a:cubicBezTo>
                  <a:pt x="1750" y="279"/>
                  <a:pt x="1736" y="287"/>
                  <a:pt x="1726" y="290"/>
                </a:cubicBezTo>
                <a:cubicBezTo>
                  <a:pt x="1714" y="293"/>
                  <a:pt x="1703" y="294"/>
                  <a:pt x="1692" y="292"/>
                </a:cubicBezTo>
                <a:cubicBezTo>
                  <a:pt x="1682" y="290"/>
                  <a:pt x="1673" y="285"/>
                  <a:pt x="1666" y="277"/>
                </a:cubicBezTo>
                <a:cubicBezTo>
                  <a:pt x="1657" y="268"/>
                  <a:pt x="1652" y="258"/>
                  <a:pt x="1649" y="246"/>
                </a:cubicBezTo>
                <a:cubicBezTo>
                  <a:pt x="1647" y="234"/>
                  <a:pt x="1648" y="221"/>
                  <a:pt x="1653" y="208"/>
                </a:cubicBezTo>
                <a:cubicBezTo>
                  <a:pt x="1659" y="195"/>
                  <a:pt x="1667" y="183"/>
                  <a:pt x="1679" y="171"/>
                </a:cubicBezTo>
                <a:cubicBezTo>
                  <a:pt x="1691" y="159"/>
                  <a:pt x="1704" y="150"/>
                  <a:pt x="1717" y="145"/>
                </a:cubicBezTo>
                <a:cubicBezTo>
                  <a:pt x="1731" y="139"/>
                  <a:pt x="1744" y="138"/>
                  <a:pt x="1757" y="140"/>
                </a:cubicBezTo>
                <a:cubicBezTo>
                  <a:pt x="1770" y="143"/>
                  <a:pt x="1782" y="149"/>
                  <a:pt x="1792" y="158"/>
                </a:cubicBezTo>
                <a:lnTo>
                  <a:pt x="1772" y="181"/>
                </a:lnTo>
                <a:cubicBezTo>
                  <a:pt x="1760" y="172"/>
                  <a:pt x="1748" y="168"/>
                  <a:pt x="1736" y="169"/>
                </a:cubicBezTo>
                <a:cubicBezTo>
                  <a:pt x="1724" y="170"/>
                  <a:pt x="1712" y="177"/>
                  <a:pt x="1699" y="190"/>
                </a:cubicBezTo>
                <a:cubicBezTo>
                  <a:pt x="1686" y="204"/>
                  <a:pt x="1678" y="216"/>
                  <a:pt x="1677" y="227"/>
                </a:cubicBezTo>
                <a:cubicBezTo>
                  <a:pt x="1676" y="238"/>
                  <a:pt x="1679" y="247"/>
                  <a:pt x="1686" y="254"/>
                </a:cubicBezTo>
                <a:cubicBezTo>
                  <a:pt x="1692" y="260"/>
                  <a:pt x="1699" y="263"/>
                  <a:pt x="1707" y="262"/>
                </a:cubicBezTo>
                <a:cubicBezTo>
                  <a:pt x="1715" y="262"/>
                  <a:pt x="1730" y="255"/>
                  <a:pt x="1753" y="241"/>
                </a:cubicBezTo>
                <a:cubicBezTo>
                  <a:pt x="1775" y="227"/>
                  <a:pt x="1791" y="218"/>
                  <a:pt x="1800" y="214"/>
                </a:cubicBezTo>
                <a:cubicBezTo>
                  <a:pt x="1815" y="209"/>
                  <a:pt x="1828" y="208"/>
                  <a:pt x="1839" y="210"/>
                </a:cubicBezTo>
                <a:cubicBezTo>
                  <a:pt x="1851" y="212"/>
                  <a:pt x="1861" y="218"/>
                  <a:pt x="1870" y="227"/>
                </a:cubicBezTo>
                <a:cubicBezTo>
                  <a:pt x="1879" y="236"/>
                  <a:pt x="1885" y="247"/>
                  <a:pt x="1888" y="260"/>
                </a:cubicBezTo>
                <a:cubicBezTo>
                  <a:pt x="1891" y="273"/>
                  <a:pt x="1889" y="286"/>
                  <a:pt x="1884" y="300"/>
                </a:cubicBezTo>
                <a:cubicBezTo>
                  <a:pt x="1879" y="314"/>
                  <a:pt x="1870" y="327"/>
                  <a:pt x="1858" y="339"/>
                </a:cubicBezTo>
                <a:cubicBezTo>
                  <a:pt x="1843" y="354"/>
                  <a:pt x="1828" y="365"/>
                  <a:pt x="1813" y="371"/>
                </a:cubicBezTo>
                <a:cubicBezTo>
                  <a:pt x="1799" y="377"/>
                  <a:pt x="1784" y="378"/>
                  <a:pt x="1769" y="375"/>
                </a:cubicBezTo>
                <a:cubicBezTo>
                  <a:pt x="1755" y="372"/>
                  <a:pt x="1741" y="365"/>
                  <a:pt x="1730" y="354"/>
                </a:cubicBezTo>
                <a:close/>
                <a:moveTo>
                  <a:pt x="2030" y="122"/>
                </a:moveTo>
                <a:lnTo>
                  <a:pt x="2050" y="142"/>
                </a:lnTo>
                <a:lnTo>
                  <a:pt x="1939" y="253"/>
                </a:lnTo>
                <a:cubicBezTo>
                  <a:pt x="1934" y="248"/>
                  <a:pt x="1930" y="243"/>
                  <a:pt x="1927" y="236"/>
                </a:cubicBezTo>
                <a:cubicBezTo>
                  <a:pt x="1922" y="226"/>
                  <a:pt x="1919" y="214"/>
                  <a:pt x="1918" y="200"/>
                </a:cubicBezTo>
                <a:cubicBezTo>
                  <a:pt x="1917" y="187"/>
                  <a:pt x="1918" y="169"/>
                  <a:pt x="1920" y="148"/>
                </a:cubicBezTo>
                <a:cubicBezTo>
                  <a:pt x="1923" y="115"/>
                  <a:pt x="1923" y="90"/>
                  <a:pt x="1921" y="75"/>
                </a:cubicBezTo>
                <a:cubicBezTo>
                  <a:pt x="1919" y="60"/>
                  <a:pt x="1914" y="49"/>
                  <a:pt x="1906" y="41"/>
                </a:cubicBezTo>
                <a:cubicBezTo>
                  <a:pt x="1898" y="33"/>
                  <a:pt x="1888" y="29"/>
                  <a:pt x="1876" y="29"/>
                </a:cubicBezTo>
                <a:cubicBezTo>
                  <a:pt x="1865" y="29"/>
                  <a:pt x="1855" y="34"/>
                  <a:pt x="1845" y="43"/>
                </a:cubicBezTo>
                <a:cubicBezTo>
                  <a:pt x="1835" y="53"/>
                  <a:pt x="1830" y="64"/>
                  <a:pt x="1830" y="76"/>
                </a:cubicBezTo>
                <a:cubicBezTo>
                  <a:pt x="1830" y="88"/>
                  <a:pt x="1835" y="99"/>
                  <a:pt x="1846" y="110"/>
                </a:cubicBezTo>
                <a:lnTo>
                  <a:pt x="1823" y="129"/>
                </a:lnTo>
                <a:cubicBezTo>
                  <a:pt x="1808" y="112"/>
                  <a:pt x="1802" y="94"/>
                  <a:pt x="1803" y="76"/>
                </a:cubicBezTo>
                <a:cubicBezTo>
                  <a:pt x="1804" y="59"/>
                  <a:pt x="1813" y="42"/>
                  <a:pt x="1829" y="26"/>
                </a:cubicBezTo>
                <a:cubicBezTo>
                  <a:pt x="1845" y="10"/>
                  <a:pt x="1862" y="1"/>
                  <a:pt x="1880" y="1"/>
                </a:cubicBezTo>
                <a:cubicBezTo>
                  <a:pt x="1899" y="0"/>
                  <a:pt x="1914" y="7"/>
                  <a:pt x="1928" y="20"/>
                </a:cubicBezTo>
                <a:cubicBezTo>
                  <a:pt x="1934" y="27"/>
                  <a:pt x="1940" y="35"/>
                  <a:pt x="1943" y="44"/>
                </a:cubicBezTo>
                <a:cubicBezTo>
                  <a:pt x="1947" y="53"/>
                  <a:pt x="1949" y="65"/>
                  <a:pt x="1950" y="78"/>
                </a:cubicBezTo>
                <a:cubicBezTo>
                  <a:pt x="1951" y="92"/>
                  <a:pt x="1950" y="112"/>
                  <a:pt x="1948" y="140"/>
                </a:cubicBezTo>
                <a:cubicBezTo>
                  <a:pt x="1946" y="162"/>
                  <a:pt x="1945" y="177"/>
                  <a:pt x="1945" y="185"/>
                </a:cubicBezTo>
                <a:cubicBezTo>
                  <a:pt x="1945" y="192"/>
                  <a:pt x="1946" y="198"/>
                  <a:pt x="1948" y="204"/>
                </a:cubicBezTo>
                <a:lnTo>
                  <a:pt x="2030" y="122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102" name="Rectangle 84"/>
          <p:cNvSpPr>
            <a:spLocks noChangeArrowheads="1"/>
          </p:cNvSpPr>
          <p:nvPr/>
        </p:nvSpPr>
        <p:spPr bwMode="auto">
          <a:xfrm rot="16200000">
            <a:off x="-492492" y="2268379"/>
            <a:ext cx="2939138" cy="4924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6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Days required for differentiation </a:t>
            </a:r>
          </a:p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6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into neural rosettes</a:t>
            </a:r>
            <a:endParaRPr kumimoji="0" lang="en-US" altLang="en-US" sz="16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9" name="TextBox 88"/>
          <p:cNvSpPr txBox="1"/>
          <p:nvPr/>
        </p:nvSpPr>
        <p:spPr>
          <a:xfrm>
            <a:off x="1213000" y="5617004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Box 89"/>
          <p:cNvSpPr txBox="1"/>
          <p:nvPr/>
        </p:nvSpPr>
        <p:spPr>
          <a:xfrm>
            <a:off x="1430717" y="5617004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Box 90"/>
          <p:cNvSpPr txBox="1"/>
          <p:nvPr/>
        </p:nvSpPr>
        <p:spPr>
          <a:xfrm>
            <a:off x="1676427" y="5617004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Box 91"/>
          <p:cNvSpPr txBox="1"/>
          <p:nvPr/>
        </p:nvSpPr>
        <p:spPr>
          <a:xfrm>
            <a:off x="1903475" y="5617004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Box 92"/>
          <p:cNvSpPr txBox="1"/>
          <p:nvPr/>
        </p:nvSpPr>
        <p:spPr>
          <a:xfrm>
            <a:off x="2102530" y="5617004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Box 93"/>
          <p:cNvSpPr txBox="1"/>
          <p:nvPr/>
        </p:nvSpPr>
        <p:spPr>
          <a:xfrm>
            <a:off x="2394895" y="5617004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Box 94"/>
          <p:cNvSpPr txBox="1"/>
          <p:nvPr/>
        </p:nvSpPr>
        <p:spPr>
          <a:xfrm>
            <a:off x="2690402" y="5617004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Box 95"/>
          <p:cNvSpPr txBox="1"/>
          <p:nvPr/>
        </p:nvSpPr>
        <p:spPr>
          <a:xfrm>
            <a:off x="2926781" y="5617004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Box 96"/>
          <p:cNvSpPr txBox="1"/>
          <p:nvPr/>
        </p:nvSpPr>
        <p:spPr>
          <a:xfrm>
            <a:off x="3153829" y="5617004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Box 97"/>
          <p:cNvSpPr txBox="1"/>
          <p:nvPr/>
        </p:nvSpPr>
        <p:spPr>
          <a:xfrm>
            <a:off x="3464856" y="5617004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xtBox 98"/>
          <p:cNvSpPr txBox="1"/>
          <p:nvPr/>
        </p:nvSpPr>
        <p:spPr>
          <a:xfrm>
            <a:off x="3850531" y="5617004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TextBox 99"/>
          <p:cNvSpPr txBox="1"/>
          <p:nvPr/>
        </p:nvSpPr>
        <p:spPr>
          <a:xfrm>
            <a:off x="4124234" y="5617004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TextBox 100"/>
          <p:cNvSpPr txBox="1"/>
          <p:nvPr/>
        </p:nvSpPr>
        <p:spPr>
          <a:xfrm>
            <a:off x="4338847" y="5617004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Box 101"/>
          <p:cNvSpPr txBox="1"/>
          <p:nvPr/>
        </p:nvSpPr>
        <p:spPr>
          <a:xfrm>
            <a:off x="4603219" y="5617004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Box 102"/>
          <p:cNvSpPr txBox="1"/>
          <p:nvPr/>
        </p:nvSpPr>
        <p:spPr>
          <a:xfrm>
            <a:off x="4864487" y="5617004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xtBox 103"/>
          <p:cNvSpPr txBox="1"/>
          <p:nvPr/>
        </p:nvSpPr>
        <p:spPr>
          <a:xfrm>
            <a:off x="5110197" y="5617004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Box 104"/>
          <p:cNvSpPr txBox="1"/>
          <p:nvPr/>
        </p:nvSpPr>
        <p:spPr>
          <a:xfrm>
            <a:off x="5707372" y="5617004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TextBox 105"/>
          <p:cNvSpPr txBox="1"/>
          <p:nvPr/>
        </p:nvSpPr>
        <p:spPr>
          <a:xfrm>
            <a:off x="6214359" y="5617005"/>
            <a:ext cx="284051" cy="307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TextBox 106"/>
          <p:cNvSpPr txBox="1"/>
          <p:nvPr/>
        </p:nvSpPr>
        <p:spPr>
          <a:xfrm>
            <a:off x="6478731" y="5617005"/>
            <a:ext cx="284051" cy="307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TextBox 107"/>
          <p:cNvSpPr txBox="1"/>
          <p:nvPr/>
        </p:nvSpPr>
        <p:spPr>
          <a:xfrm>
            <a:off x="6730668" y="5617005"/>
            <a:ext cx="284051" cy="307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TextBox 108"/>
          <p:cNvSpPr txBox="1"/>
          <p:nvPr/>
        </p:nvSpPr>
        <p:spPr>
          <a:xfrm>
            <a:off x="7209653" y="5617004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TextBox 109"/>
          <p:cNvSpPr txBox="1"/>
          <p:nvPr/>
        </p:nvSpPr>
        <p:spPr>
          <a:xfrm>
            <a:off x="7480254" y="5617004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TextBox 111"/>
          <p:cNvSpPr txBox="1"/>
          <p:nvPr/>
        </p:nvSpPr>
        <p:spPr>
          <a:xfrm>
            <a:off x="74648" y="5533039"/>
            <a:ext cx="109562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 smtClean="0"/>
              <a:t># of </a:t>
            </a:r>
          </a:p>
          <a:p>
            <a:pPr algn="ctr"/>
            <a:r>
              <a:rPr lang="en-US" sz="1400" dirty="0" smtClean="0"/>
              <a:t>experiments</a:t>
            </a:r>
            <a:endParaRPr lang="en-US" sz="1400" dirty="0"/>
          </a:p>
        </p:txBody>
      </p:sp>
      <p:sp>
        <p:nvSpPr>
          <p:cNvPr id="115" name="TextBox 114"/>
          <p:cNvSpPr txBox="1"/>
          <p:nvPr/>
        </p:nvSpPr>
        <p:spPr>
          <a:xfrm>
            <a:off x="51660" y="4696401"/>
            <a:ext cx="114159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 err="1" smtClean="0"/>
              <a:t>iPSC</a:t>
            </a:r>
            <a:r>
              <a:rPr lang="en-US" sz="1400" dirty="0" smtClean="0"/>
              <a:t> identity </a:t>
            </a:r>
          </a:p>
          <a:p>
            <a:pPr algn="ctr"/>
            <a:r>
              <a:rPr lang="en-US" sz="1400" dirty="0" smtClean="0"/>
              <a:t>and colony #</a:t>
            </a:r>
            <a:endParaRPr lang="en-US" sz="1400" dirty="0"/>
          </a:p>
        </p:txBody>
      </p:sp>
      <p:sp>
        <p:nvSpPr>
          <p:cNvPr id="118" name="TextBox 117"/>
          <p:cNvSpPr txBox="1"/>
          <p:nvPr/>
        </p:nvSpPr>
        <p:spPr>
          <a:xfrm>
            <a:off x="-9" y="6484769"/>
            <a:ext cx="7631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dditional File </a:t>
            </a:r>
            <a:r>
              <a:rPr lang="en-US" dirty="0" smtClean="0"/>
              <a:t>10B</a:t>
            </a:r>
            <a:r>
              <a:rPr lang="en-US" dirty="0" smtClean="0"/>
              <a:t>. </a:t>
            </a:r>
            <a:r>
              <a:rPr lang="en-US" dirty="0"/>
              <a:t>Differentiation potential of </a:t>
            </a:r>
            <a:r>
              <a:rPr lang="en-US" dirty="0" err="1" smtClean="0"/>
              <a:t>iPSCs</a:t>
            </a:r>
            <a:r>
              <a:rPr lang="en-US" dirty="0" smtClean="0"/>
              <a:t> </a:t>
            </a:r>
            <a:r>
              <a:rPr lang="en-US" dirty="0"/>
              <a:t>to neural </a:t>
            </a:r>
            <a:r>
              <a:rPr lang="en-US" dirty="0" smtClean="0"/>
              <a:t>rosettes (Part 2).</a:t>
            </a:r>
            <a:endParaRPr lang="en-US" dirty="0"/>
          </a:p>
        </p:txBody>
      </p:sp>
      <p:sp>
        <p:nvSpPr>
          <p:cNvPr id="119" name="Rectangle 118"/>
          <p:cNvSpPr/>
          <p:nvPr/>
        </p:nvSpPr>
        <p:spPr>
          <a:xfrm>
            <a:off x="7265152" y="64607"/>
            <a:ext cx="1878848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200" dirty="0" smtClean="0"/>
              <a:t>Error bars represent one</a:t>
            </a:r>
          </a:p>
          <a:p>
            <a:pPr algn="ctr"/>
            <a:r>
              <a:rPr lang="en-US" sz="1200" dirty="0" smtClean="0"/>
              <a:t>standard error of the mean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4764055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4</TotalTime>
  <Words>141</Words>
  <Application>Microsoft Office PowerPoint</Application>
  <PresentationFormat>On-screen Show (4:3)</PresentationFormat>
  <Paragraphs>77</Paragraphs>
  <Slides>2</Slides>
  <Notes>2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>USC Health Science I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seph Gerard Hacia</dc:creator>
  <cp:lastModifiedBy>Joseph Gerard Hacia</cp:lastModifiedBy>
  <cp:revision>9</cp:revision>
  <dcterms:created xsi:type="dcterms:W3CDTF">2015-03-11T04:48:23Z</dcterms:created>
  <dcterms:modified xsi:type="dcterms:W3CDTF">2015-05-24T02:37:21Z</dcterms:modified>
</cp:coreProperties>
</file>